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59" r:id="rId3"/>
    <p:sldId id="264" r:id="rId4"/>
    <p:sldId id="263" r:id="rId5"/>
    <p:sldId id="257" r:id="rId6"/>
    <p:sldId id="265" r:id="rId7"/>
    <p:sldId id="258" r:id="rId8"/>
    <p:sldId id="267" r:id="rId9"/>
    <p:sldId id="268" r:id="rId10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699" autoAdjust="0"/>
    <p:restoredTop sz="94711"/>
  </p:normalViewPr>
  <p:slideViewPr>
    <p:cSldViewPr snapToGrid="0">
      <p:cViewPr varScale="1">
        <p:scale>
          <a:sx n="113" d="100"/>
          <a:sy n="113" d="100"/>
        </p:scale>
        <p:origin x="192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14E2E4-1E6D-7F8B-5E9E-31BD051283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91D82EC-877C-0B4B-434E-6A1DF7C6A7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D72FA7-BEA0-900B-5B31-5BCCF97DB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EB77F3-18EA-C1C6-7531-20799231E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F01BA4-7B03-962E-F470-62454A8B1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9158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281D7D-9B2C-C16B-75A1-BD84F891D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D821865-AF6E-B1D9-ACD4-892FBB1AD9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D0B47B-6304-BB84-6F82-F6CED6D84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16D32D-A249-2ACF-6A4B-6BB37BA76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BC8A27-E040-B3C3-2837-A87CB1BB8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34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FEB935F-0609-576F-B5C3-E6B89E6BEE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1FFA7B5-2D10-621A-329C-B9DA90D6B2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72D265A-4D2F-ECA3-690C-A95E17851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A767EC-6F7A-992F-41BC-DF7924F1A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A87FFB-083F-B87E-4112-197560999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3806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DAEA94-2F16-AB56-37D3-175AFF1FD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4340A9-585F-F479-8A7D-E17F513377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B3EC7F-F0B8-7030-4670-EF082CCEC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8C0F45-2678-CC9F-7161-7CBDC128B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5076C7-3B9C-111B-B5D0-03BF0E872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357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FC85A2-2972-AC91-8191-A26F92109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D8FF746-061B-3AD1-5BB9-A11FAE2C9F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8A2224-212D-BC1E-1018-C7F96DF61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38526B-C542-896D-36DA-DC45B0455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1A2A86-B618-9770-06EB-2553C9F99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80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5A929D-CF5B-19E3-8999-1A3953D299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A1700B2-C8E3-F86C-A1D7-EFA5C62184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FED0719-D829-2D93-0B6A-BEB677958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8DC475F-9B8C-4C35-359B-2B2B9C8B3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B306DB-1CD8-E02A-BD30-02CD0E36B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7162D03-0713-D585-CF67-AA18FE255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3384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DDC0EE-638F-FD4C-BE35-195222EF2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5C678F-D656-A471-F810-88F0FADF12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375594-C860-06F4-E339-6E1103CA8A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7DABB52-709D-3BDC-D328-3DCC207A56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916C783-5E9D-ACA4-D1ED-9F5D3C5281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E5A4DA9-F20E-282B-F4BD-EC548FD3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1F64FCB-8A68-5D40-EC4A-067FEAC95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A82DA48-720C-3E2C-F130-4478DC5F9E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972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4DA527-A773-AA1C-1815-94B5A3B61E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75E3DD2-935C-FD7C-7E2F-9BC612216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907ED43-5A2F-F47F-4D22-3DE4722D5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E2FF210-8CEC-AEAE-0682-D48EB4DF9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103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31D9D7F-21E4-4DED-1B70-7378817C6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7EF5970-D2D0-0B49-E1B9-5BAB06B74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25BA307-413B-1182-DB93-B5F37BCD1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384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75F999-4E5F-02A6-5BA0-242E82D3FB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A0A5F5-F6B8-3EA8-2B60-2FBA218731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EEC97A-95EB-8C3E-46C4-28F690A251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964A7BD-A6CF-73AF-710F-A9FF550A2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BE0EF1-B496-DCDA-33B8-B8BA618F31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17758B-D064-30D0-4019-B1FDC87DC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051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F563DB-7852-E2E4-B370-44C629E028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9D5C1B2-1461-7932-B60A-1393AE008D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0EEBE74-0A55-38AB-1610-9D715FA9DD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9EDDE7-E14F-937F-A8CF-EE617AFB6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A02CB91-A1FF-D034-0457-B09388F69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0FBF8A-3820-324A-C7FA-5D7D95613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9467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DF2D712-389F-5435-38FF-9FF516B62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22D0CD-B910-2F0C-4B2C-A7258B154A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713224-9C59-6208-3491-604701CD2F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75D03-C97C-4244-AD37-70B2531AE66C}" type="datetimeFigureOut">
              <a:rPr kumimoji="1" lang="ja-JP" altLang="en-US" smtClean="0"/>
              <a:t>2026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6F9388-D6FB-7427-FAD9-93EF95EFE2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EFF0DA3-7E0E-78D3-BB61-5833DB098A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E25A72-B166-4985-B0F2-AD796AA5C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494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2">
            <a:extLst>
              <a:ext uri="{FF2B5EF4-FFF2-40B4-BE49-F238E27FC236}">
                <a16:creationId xmlns:a16="http://schemas.microsoft.com/office/drawing/2014/main" id="{0672F1D8-31FB-1DED-A600-59211756E7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2399" y="1402665"/>
            <a:ext cx="5831851" cy="3908596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Line 23">
            <a:extLst>
              <a:ext uri="{FF2B5EF4-FFF2-40B4-BE49-F238E27FC236}">
                <a16:creationId xmlns:a16="http://schemas.microsoft.com/office/drawing/2014/main" id="{E0F6B8D5-758A-8D0B-5278-F03CD5C73E65}"/>
              </a:ext>
            </a:extLst>
          </p:cNvPr>
          <p:cNvSpPr>
            <a:spLocks noChangeShapeType="1"/>
          </p:cNvSpPr>
          <p:nvPr/>
        </p:nvSpPr>
        <p:spPr bwMode="auto">
          <a:xfrm>
            <a:off x="2291827" y="5322126"/>
            <a:ext cx="0" cy="130407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Line 25">
            <a:extLst>
              <a:ext uri="{FF2B5EF4-FFF2-40B4-BE49-F238E27FC236}">
                <a16:creationId xmlns:a16="http://schemas.microsoft.com/office/drawing/2014/main" id="{04D08AC2-7ED1-8B20-B437-28943139E761}"/>
              </a:ext>
            </a:extLst>
          </p:cNvPr>
          <p:cNvSpPr>
            <a:spLocks noChangeShapeType="1"/>
          </p:cNvSpPr>
          <p:nvPr/>
        </p:nvSpPr>
        <p:spPr bwMode="auto">
          <a:xfrm>
            <a:off x="3267914" y="5322126"/>
            <a:ext cx="0" cy="130407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Line 27">
            <a:extLst>
              <a:ext uri="{FF2B5EF4-FFF2-40B4-BE49-F238E27FC236}">
                <a16:creationId xmlns:a16="http://schemas.microsoft.com/office/drawing/2014/main" id="{F6A28B73-089C-738F-D9C9-ACEFE9CE26C5}"/>
              </a:ext>
            </a:extLst>
          </p:cNvPr>
          <p:cNvSpPr>
            <a:spLocks noChangeShapeType="1"/>
          </p:cNvSpPr>
          <p:nvPr/>
        </p:nvSpPr>
        <p:spPr bwMode="auto">
          <a:xfrm>
            <a:off x="4243999" y="5322126"/>
            <a:ext cx="0" cy="130407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Line 29">
            <a:extLst>
              <a:ext uri="{FF2B5EF4-FFF2-40B4-BE49-F238E27FC236}">
                <a16:creationId xmlns:a16="http://schemas.microsoft.com/office/drawing/2014/main" id="{CAC953D1-EEF1-02F3-42EA-C73808844AA7}"/>
              </a:ext>
            </a:extLst>
          </p:cNvPr>
          <p:cNvSpPr>
            <a:spLocks noChangeShapeType="1"/>
          </p:cNvSpPr>
          <p:nvPr/>
        </p:nvSpPr>
        <p:spPr bwMode="auto">
          <a:xfrm>
            <a:off x="5216562" y="5322126"/>
            <a:ext cx="0" cy="130407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Line 31">
            <a:extLst>
              <a:ext uri="{FF2B5EF4-FFF2-40B4-BE49-F238E27FC236}">
                <a16:creationId xmlns:a16="http://schemas.microsoft.com/office/drawing/2014/main" id="{FDB6BE18-0053-680D-A822-EE6497099D13}"/>
              </a:ext>
            </a:extLst>
          </p:cNvPr>
          <p:cNvSpPr>
            <a:spLocks noChangeShapeType="1"/>
          </p:cNvSpPr>
          <p:nvPr/>
        </p:nvSpPr>
        <p:spPr bwMode="auto">
          <a:xfrm>
            <a:off x="6192649" y="5322126"/>
            <a:ext cx="0" cy="130407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Line 33">
            <a:extLst>
              <a:ext uri="{FF2B5EF4-FFF2-40B4-BE49-F238E27FC236}">
                <a16:creationId xmlns:a16="http://schemas.microsoft.com/office/drawing/2014/main" id="{8774DC70-29DB-5CEC-2E68-D47E6F704D93}"/>
              </a:ext>
            </a:extLst>
          </p:cNvPr>
          <p:cNvSpPr>
            <a:spLocks noChangeShapeType="1"/>
          </p:cNvSpPr>
          <p:nvPr/>
        </p:nvSpPr>
        <p:spPr bwMode="auto">
          <a:xfrm>
            <a:off x="7168734" y="5322126"/>
            <a:ext cx="0" cy="130407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Line 35">
            <a:extLst>
              <a:ext uri="{FF2B5EF4-FFF2-40B4-BE49-F238E27FC236}">
                <a16:creationId xmlns:a16="http://schemas.microsoft.com/office/drawing/2014/main" id="{62647282-B226-603B-54ED-DAA5E4F5D137}"/>
              </a:ext>
            </a:extLst>
          </p:cNvPr>
          <p:cNvSpPr>
            <a:spLocks noChangeShapeType="1"/>
          </p:cNvSpPr>
          <p:nvPr/>
        </p:nvSpPr>
        <p:spPr bwMode="auto">
          <a:xfrm>
            <a:off x="8144821" y="5322126"/>
            <a:ext cx="0" cy="130407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Line 6">
            <a:extLst>
              <a:ext uri="{FF2B5EF4-FFF2-40B4-BE49-F238E27FC236}">
                <a16:creationId xmlns:a16="http://schemas.microsoft.com/office/drawing/2014/main" id="{290BCA24-D97C-D2B3-BE61-06CA25574B0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168716" y="5317488"/>
            <a:ext cx="126262" cy="0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3C79F122-4342-A0C5-8FAA-86773E67D2B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231844" y="4525307"/>
            <a:ext cx="63130" cy="0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C98B5C33-2B93-A979-28F6-FB3E478D46A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168716" y="3733129"/>
            <a:ext cx="126262" cy="0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3" name="Line 11">
            <a:extLst>
              <a:ext uri="{FF2B5EF4-FFF2-40B4-BE49-F238E27FC236}">
                <a16:creationId xmlns:a16="http://schemas.microsoft.com/office/drawing/2014/main" id="{40A465DF-BBE8-B2A5-2F04-86B81844BA1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231844" y="2940950"/>
            <a:ext cx="63130" cy="0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4" name="Line 12">
            <a:extLst>
              <a:ext uri="{FF2B5EF4-FFF2-40B4-BE49-F238E27FC236}">
                <a16:creationId xmlns:a16="http://schemas.microsoft.com/office/drawing/2014/main" id="{57EF0EAC-BA8E-3D5B-CB3E-A43F595C24D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168716" y="2148772"/>
            <a:ext cx="126262" cy="0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5" name="Line 14">
            <a:extLst>
              <a:ext uri="{FF2B5EF4-FFF2-40B4-BE49-F238E27FC236}">
                <a16:creationId xmlns:a16="http://schemas.microsoft.com/office/drawing/2014/main" id="{5CAEDA0A-46B6-7C0B-C542-D7948597FBB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231844" y="1403069"/>
            <a:ext cx="63130" cy="0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6" name="Line 23">
            <a:extLst>
              <a:ext uri="{FF2B5EF4-FFF2-40B4-BE49-F238E27FC236}">
                <a16:creationId xmlns:a16="http://schemas.microsoft.com/office/drawing/2014/main" id="{6E9D9BDD-7CF4-362E-B5A2-92B0CE69E404}"/>
              </a:ext>
            </a:extLst>
          </p:cNvPr>
          <p:cNvSpPr>
            <a:spLocks noChangeShapeType="1"/>
          </p:cNvSpPr>
          <p:nvPr/>
        </p:nvSpPr>
        <p:spPr bwMode="auto">
          <a:xfrm>
            <a:off x="2294976" y="5317490"/>
            <a:ext cx="0" cy="131573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7" name="Rectangle 10">
            <a:extLst>
              <a:ext uri="{FF2B5EF4-FFF2-40B4-BE49-F238E27FC236}">
                <a16:creationId xmlns:a16="http://schemas.microsoft.com/office/drawing/2014/main" id="{54533C7B-75AA-C31F-2F8C-F9BE39D0C1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88937" y="3566396"/>
            <a:ext cx="25968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2000" dirty="0">
                <a:solidFill>
                  <a:srgbClr val="000000"/>
                </a:solidFill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20</a:t>
            </a:r>
            <a:endParaRPr kumimoji="0" lang="ja-JP" altLang="ja-JP" sz="2000" dirty="0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8" name="Rectangle 13">
            <a:extLst>
              <a:ext uri="{FF2B5EF4-FFF2-40B4-BE49-F238E27FC236}">
                <a16:creationId xmlns:a16="http://schemas.microsoft.com/office/drawing/2014/main" id="{B84242F5-FEB7-AB10-23F0-1F0906D629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88937" y="2022504"/>
            <a:ext cx="25968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2000" dirty="0">
                <a:solidFill>
                  <a:srgbClr val="000000"/>
                </a:solidFill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40</a:t>
            </a:r>
            <a:endParaRPr kumimoji="0" lang="ja-JP" altLang="ja-JP" sz="2000" dirty="0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19" name="Rectangle 10">
            <a:extLst>
              <a:ext uri="{FF2B5EF4-FFF2-40B4-BE49-F238E27FC236}">
                <a16:creationId xmlns:a16="http://schemas.microsoft.com/office/drawing/2014/main" id="{FC206AE6-79C5-40A1-FC05-19F1208E80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8779" y="5176305"/>
            <a:ext cx="12984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2000" dirty="0">
                <a:solidFill>
                  <a:srgbClr val="000000"/>
                </a:solidFill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0</a:t>
            </a:r>
            <a:endParaRPr kumimoji="0" lang="ja-JP" altLang="ja-JP" sz="2000" dirty="0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40A6173-3001-C2E8-A21C-5B2D8E8AF5F6}"/>
              </a:ext>
            </a:extLst>
          </p:cNvPr>
          <p:cNvSpPr txBox="1"/>
          <p:nvPr/>
        </p:nvSpPr>
        <p:spPr>
          <a:xfrm>
            <a:off x="2151138" y="5478688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0</a:t>
            </a:r>
            <a:endParaRPr lang="ja-JP" altLang="en-US" sz="2000" dirty="0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8C6B82F-9F91-48FF-EBF2-A9A07789C974}"/>
              </a:ext>
            </a:extLst>
          </p:cNvPr>
          <p:cNvSpPr txBox="1"/>
          <p:nvPr/>
        </p:nvSpPr>
        <p:spPr>
          <a:xfrm>
            <a:off x="4099776" y="5478688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2</a:t>
            </a:r>
            <a:endParaRPr lang="ja-JP" altLang="en-US" sz="2000" dirty="0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E05BA65-C414-826D-3F95-723BB0D099D9}"/>
              </a:ext>
            </a:extLst>
          </p:cNvPr>
          <p:cNvSpPr txBox="1"/>
          <p:nvPr/>
        </p:nvSpPr>
        <p:spPr>
          <a:xfrm>
            <a:off x="7997052" y="5478688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6</a:t>
            </a:r>
            <a:endParaRPr lang="ja-JP" altLang="en-US" sz="2000" dirty="0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5DA768F-C0A1-2C60-5EF2-325BEB1EE712}"/>
              </a:ext>
            </a:extLst>
          </p:cNvPr>
          <p:cNvSpPr txBox="1"/>
          <p:nvPr/>
        </p:nvSpPr>
        <p:spPr>
          <a:xfrm>
            <a:off x="6048415" y="5478688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4</a:t>
            </a:r>
            <a:endParaRPr lang="ja-JP" altLang="en-US" sz="2000" dirty="0">
              <a:latin typeface="Calibri" panose="020F0502020204030204" pitchFamily="34" charset="0"/>
              <a:ea typeface="MS PGothic" panose="020B0600070205080204" pitchFamily="34" charset="-128"/>
              <a:cs typeface="Calibri" panose="020F050202020403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4D63A2-7285-FC70-D3B9-CD09F43DF53B}"/>
              </a:ext>
            </a:extLst>
          </p:cNvPr>
          <p:cNvSpPr txBox="1"/>
          <p:nvPr/>
        </p:nvSpPr>
        <p:spPr>
          <a:xfrm rot="16200000">
            <a:off x="-22184" y="3486206"/>
            <a:ext cx="27735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Incidence of HCC (%)</a:t>
            </a:r>
            <a:endParaRPr kumimoji="1"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FC8A0E8-68DB-71AA-B060-887037A2AC7A}"/>
              </a:ext>
            </a:extLst>
          </p:cNvPr>
          <p:cNvSpPr txBox="1"/>
          <p:nvPr/>
        </p:nvSpPr>
        <p:spPr>
          <a:xfrm>
            <a:off x="4190318" y="5904953"/>
            <a:ext cx="20560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Years after SVR</a:t>
            </a:r>
            <a:endParaRPr kumimoji="1"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Freeform 19">
            <a:extLst>
              <a:ext uri="{FF2B5EF4-FFF2-40B4-BE49-F238E27FC236}">
                <a16:creationId xmlns:a16="http://schemas.microsoft.com/office/drawing/2014/main" id="{83E0D662-0B2D-1A3B-F2CC-FDA2CCECEDB2}"/>
              </a:ext>
            </a:extLst>
          </p:cNvPr>
          <p:cNvSpPr>
            <a:spLocks/>
          </p:cNvSpPr>
          <p:nvPr/>
        </p:nvSpPr>
        <p:spPr bwMode="auto">
          <a:xfrm>
            <a:off x="2274019" y="4007104"/>
            <a:ext cx="5873944" cy="1304953"/>
          </a:xfrm>
          <a:custGeom>
            <a:avLst/>
            <a:gdLst>
              <a:gd name="T0" fmla="*/ 97 w 1661"/>
              <a:gd name="T1" fmla="*/ 358 h 362"/>
              <a:gd name="T2" fmla="*/ 130 w 1661"/>
              <a:gd name="T3" fmla="*/ 355 h 362"/>
              <a:gd name="T4" fmla="*/ 154 w 1661"/>
              <a:gd name="T5" fmla="*/ 344 h 362"/>
              <a:gd name="T6" fmla="*/ 184 w 1661"/>
              <a:gd name="T7" fmla="*/ 338 h 362"/>
              <a:gd name="T8" fmla="*/ 215 w 1661"/>
              <a:gd name="T9" fmla="*/ 331 h 362"/>
              <a:gd name="T10" fmla="*/ 244 w 1661"/>
              <a:gd name="T11" fmla="*/ 329 h 362"/>
              <a:gd name="T12" fmla="*/ 275 w 1661"/>
              <a:gd name="T13" fmla="*/ 321 h 362"/>
              <a:gd name="T14" fmla="*/ 305 w 1661"/>
              <a:gd name="T15" fmla="*/ 314 h 362"/>
              <a:gd name="T16" fmla="*/ 335 w 1661"/>
              <a:gd name="T17" fmla="*/ 308 h 362"/>
              <a:gd name="T18" fmla="*/ 367 w 1661"/>
              <a:gd name="T19" fmla="*/ 301 h 362"/>
              <a:gd name="T20" fmla="*/ 395 w 1661"/>
              <a:gd name="T21" fmla="*/ 295 h 362"/>
              <a:gd name="T22" fmla="*/ 425 w 1661"/>
              <a:gd name="T23" fmla="*/ 289 h 362"/>
              <a:gd name="T24" fmla="*/ 455 w 1661"/>
              <a:gd name="T25" fmla="*/ 283 h 362"/>
              <a:gd name="T26" fmla="*/ 484 w 1661"/>
              <a:gd name="T27" fmla="*/ 280 h 362"/>
              <a:gd name="T28" fmla="*/ 517 w 1661"/>
              <a:gd name="T29" fmla="*/ 274 h 362"/>
              <a:gd name="T30" fmla="*/ 551 w 1661"/>
              <a:gd name="T31" fmla="*/ 269 h 362"/>
              <a:gd name="T32" fmla="*/ 575 w 1661"/>
              <a:gd name="T33" fmla="*/ 262 h 362"/>
              <a:gd name="T34" fmla="*/ 607 w 1661"/>
              <a:gd name="T35" fmla="*/ 255 h 362"/>
              <a:gd name="T36" fmla="*/ 635 w 1661"/>
              <a:gd name="T37" fmla="*/ 249 h 362"/>
              <a:gd name="T38" fmla="*/ 668 w 1661"/>
              <a:gd name="T39" fmla="*/ 242 h 362"/>
              <a:gd name="T40" fmla="*/ 695 w 1661"/>
              <a:gd name="T41" fmla="*/ 238 h 362"/>
              <a:gd name="T42" fmla="*/ 726 w 1661"/>
              <a:gd name="T43" fmla="*/ 230 h 362"/>
              <a:gd name="T44" fmla="*/ 756 w 1661"/>
              <a:gd name="T45" fmla="*/ 222 h 362"/>
              <a:gd name="T46" fmla="*/ 786 w 1661"/>
              <a:gd name="T47" fmla="*/ 220 h 362"/>
              <a:gd name="T48" fmla="*/ 816 w 1661"/>
              <a:gd name="T49" fmla="*/ 212 h 362"/>
              <a:gd name="T50" fmla="*/ 846 w 1661"/>
              <a:gd name="T51" fmla="*/ 204 h 362"/>
              <a:gd name="T52" fmla="*/ 876 w 1661"/>
              <a:gd name="T53" fmla="*/ 198 h 362"/>
              <a:gd name="T54" fmla="*/ 903 w 1661"/>
              <a:gd name="T55" fmla="*/ 189 h 362"/>
              <a:gd name="T56" fmla="*/ 936 w 1661"/>
              <a:gd name="T57" fmla="*/ 187 h 362"/>
              <a:gd name="T58" fmla="*/ 967 w 1661"/>
              <a:gd name="T59" fmla="*/ 182 h 362"/>
              <a:gd name="T60" fmla="*/ 997 w 1661"/>
              <a:gd name="T61" fmla="*/ 172 h 362"/>
              <a:gd name="T62" fmla="*/ 1027 w 1661"/>
              <a:gd name="T63" fmla="*/ 167 h 362"/>
              <a:gd name="T64" fmla="*/ 1051 w 1661"/>
              <a:gd name="T65" fmla="*/ 159 h 362"/>
              <a:gd name="T66" fmla="*/ 1083 w 1661"/>
              <a:gd name="T67" fmla="*/ 153 h 362"/>
              <a:gd name="T68" fmla="*/ 1117 w 1661"/>
              <a:gd name="T69" fmla="*/ 149 h 362"/>
              <a:gd name="T70" fmla="*/ 1145 w 1661"/>
              <a:gd name="T71" fmla="*/ 140 h 362"/>
              <a:gd name="T72" fmla="*/ 1177 w 1661"/>
              <a:gd name="T73" fmla="*/ 140 h 362"/>
              <a:gd name="T74" fmla="*/ 1213 w 1661"/>
              <a:gd name="T75" fmla="*/ 136 h 362"/>
              <a:gd name="T76" fmla="*/ 1244 w 1661"/>
              <a:gd name="T77" fmla="*/ 130 h 362"/>
              <a:gd name="T78" fmla="*/ 1274 w 1661"/>
              <a:gd name="T79" fmla="*/ 126 h 362"/>
              <a:gd name="T80" fmla="*/ 1298 w 1661"/>
              <a:gd name="T81" fmla="*/ 116 h 362"/>
              <a:gd name="T82" fmla="*/ 1327 w 1661"/>
              <a:gd name="T83" fmla="*/ 106 h 362"/>
              <a:gd name="T84" fmla="*/ 1357 w 1661"/>
              <a:gd name="T85" fmla="*/ 103 h 362"/>
              <a:gd name="T86" fmla="*/ 1393 w 1661"/>
              <a:gd name="T87" fmla="*/ 101 h 362"/>
              <a:gd name="T88" fmla="*/ 1423 w 1661"/>
              <a:gd name="T89" fmla="*/ 94 h 362"/>
              <a:gd name="T90" fmla="*/ 1456 w 1661"/>
              <a:gd name="T91" fmla="*/ 91 h 362"/>
              <a:gd name="T92" fmla="*/ 1490 w 1661"/>
              <a:gd name="T93" fmla="*/ 91 h 362"/>
              <a:gd name="T94" fmla="*/ 1518 w 1661"/>
              <a:gd name="T95" fmla="*/ 77 h 362"/>
              <a:gd name="T96" fmla="*/ 1538 w 1661"/>
              <a:gd name="T97" fmla="*/ 66 h 362"/>
              <a:gd name="T98" fmla="*/ 1557 w 1661"/>
              <a:gd name="T99" fmla="*/ 48 h 362"/>
              <a:gd name="T100" fmla="*/ 1592 w 1661"/>
              <a:gd name="T101" fmla="*/ 48 h 362"/>
              <a:gd name="T102" fmla="*/ 1625 w 1661"/>
              <a:gd name="T103" fmla="*/ 39 h 362"/>
              <a:gd name="T104" fmla="*/ 1646 w 1661"/>
              <a:gd name="T105" fmla="*/ 21 h 3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661" h="362">
                <a:moveTo>
                  <a:pt x="0" y="362"/>
                </a:moveTo>
                <a:lnTo>
                  <a:pt x="79" y="362"/>
                </a:lnTo>
                <a:lnTo>
                  <a:pt x="84" y="360"/>
                </a:lnTo>
                <a:lnTo>
                  <a:pt x="84" y="358"/>
                </a:lnTo>
                <a:lnTo>
                  <a:pt x="90" y="358"/>
                </a:lnTo>
                <a:lnTo>
                  <a:pt x="97" y="358"/>
                </a:lnTo>
                <a:lnTo>
                  <a:pt x="101" y="358"/>
                </a:lnTo>
                <a:lnTo>
                  <a:pt x="111" y="358"/>
                </a:lnTo>
                <a:lnTo>
                  <a:pt x="116" y="357"/>
                </a:lnTo>
                <a:lnTo>
                  <a:pt x="119" y="357"/>
                </a:lnTo>
                <a:lnTo>
                  <a:pt x="124" y="356"/>
                </a:lnTo>
                <a:lnTo>
                  <a:pt x="130" y="355"/>
                </a:lnTo>
                <a:lnTo>
                  <a:pt x="130" y="352"/>
                </a:lnTo>
                <a:lnTo>
                  <a:pt x="137" y="350"/>
                </a:lnTo>
                <a:lnTo>
                  <a:pt x="142" y="347"/>
                </a:lnTo>
                <a:lnTo>
                  <a:pt x="143" y="347"/>
                </a:lnTo>
                <a:lnTo>
                  <a:pt x="148" y="345"/>
                </a:lnTo>
                <a:lnTo>
                  <a:pt x="154" y="344"/>
                </a:lnTo>
                <a:lnTo>
                  <a:pt x="160" y="343"/>
                </a:lnTo>
                <a:lnTo>
                  <a:pt x="166" y="341"/>
                </a:lnTo>
                <a:lnTo>
                  <a:pt x="169" y="341"/>
                </a:lnTo>
                <a:lnTo>
                  <a:pt x="173" y="341"/>
                </a:lnTo>
                <a:lnTo>
                  <a:pt x="179" y="340"/>
                </a:lnTo>
                <a:lnTo>
                  <a:pt x="184" y="338"/>
                </a:lnTo>
                <a:lnTo>
                  <a:pt x="190" y="336"/>
                </a:lnTo>
                <a:lnTo>
                  <a:pt x="190" y="335"/>
                </a:lnTo>
                <a:lnTo>
                  <a:pt x="196" y="334"/>
                </a:lnTo>
                <a:lnTo>
                  <a:pt x="202" y="332"/>
                </a:lnTo>
                <a:lnTo>
                  <a:pt x="208" y="332"/>
                </a:lnTo>
                <a:lnTo>
                  <a:pt x="215" y="331"/>
                </a:lnTo>
                <a:lnTo>
                  <a:pt x="220" y="329"/>
                </a:lnTo>
                <a:lnTo>
                  <a:pt x="224" y="329"/>
                </a:lnTo>
                <a:lnTo>
                  <a:pt x="228" y="329"/>
                </a:lnTo>
                <a:lnTo>
                  <a:pt x="232" y="329"/>
                </a:lnTo>
                <a:lnTo>
                  <a:pt x="243" y="329"/>
                </a:lnTo>
                <a:lnTo>
                  <a:pt x="244" y="329"/>
                </a:lnTo>
                <a:lnTo>
                  <a:pt x="250" y="325"/>
                </a:lnTo>
                <a:lnTo>
                  <a:pt x="256" y="323"/>
                </a:lnTo>
                <a:lnTo>
                  <a:pt x="263" y="323"/>
                </a:lnTo>
                <a:lnTo>
                  <a:pt x="266" y="323"/>
                </a:lnTo>
                <a:lnTo>
                  <a:pt x="270" y="323"/>
                </a:lnTo>
                <a:lnTo>
                  <a:pt x="275" y="321"/>
                </a:lnTo>
                <a:lnTo>
                  <a:pt x="280" y="320"/>
                </a:lnTo>
                <a:lnTo>
                  <a:pt x="286" y="319"/>
                </a:lnTo>
                <a:lnTo>
                  <a:pt x="292" y="318"/>
                </a:lnTo>
                <a:lnTo>
                  <a:pt x="298" y="316"/>
                </a:lnTo>
                <a:lnTo>
                  <a:pt x="299" y="316"/>
                </a:lnTo>
                <a:lnTo>
                  <a:pt x="305" y="314"/>
                </a:lnTo>
                <a:lnTo>
                  <a:pt x="313" y="314"/>
                </a:lnTo>
                <a:lnTo>
                  <a:pt x="319" y="312"/>
                </a:lnTo>
                <a:lnTo>
                  <a:pt x="322" y="312"/>
                </a:lnTo>
                <a:lnTo>
                  <a:pt x="325" y="310"/>
                </a:lnTo>
                <a:lnTo>
                  <a:pt x="328" y="310"/>
                </a:lnTo>
                <a:lnTo>
                  <a:pt x="335" y="308"/>
                </a:lnTo>
                <a:lnTo>
                  <a:pt x="342" y="307"/>
                </a:lnTo>
                <a:lnTo>
                  <a:pt x="346" y="307"/>
                </a:lnTo>
                <a:lnTo>
                  <a:pt x="349" y="304"/>
                </a:lnTo>
                <a:lnTo>
                  <a:pt x="355" y="304"/>
                </a:lnTo>
                <a:lnTo>
                  <a:pt x="361" y="301"/>
                </a:lnTo>
                <a:lnTo>
                  <a:pt x="367" y="301"/>
                </a:lnTo>
                <a:lnTo>
                  <a:pt x="372" y="300"/>
                </a:lnTo>
                <a:lnTo>
                  <a:pt x="376" y="298"/>
                </a:lnTo>
                <a:lnTo>
                  <a:pt x="377" y="298"/>
                </a:lnTo>
                <a:lnTo>
                  <a:pt x="383" y="298"/>
                </a:lnTo>
                <a:lnTo>
                  <a:pt x="389" y="297"/>
                </a:lnTo>
                <a:lnTo>
                  <a:pt x="395" y="295"/>
                </a:lnTo>
                <a:lnTo>
                  <a:pt x="401" y="294"/>
                </a:lnTo>
                <a:lnTo>
                  <a:pt x="408" y="292"/>
                </a:lnTo>
                <a:lnTo>
                  <a:pt x="412" y="292"/>
                </a:lnTo>
                <a:lnTo>
                  <a:pt x="413" y="292"/>
                </a:lnTo>
                <a:lnTo>
                  <a:pt x="419" y="289"/>
                </a:lnTo>
                <a:lnTo>
                  <a:pt x="425" y="289"/>
                </a:lnTo>
                <a:lnTo>
                  <a:pt x="431" y="288"/>
                </a:lnTo>
                <a:lnTo>
                  <a:pt x="437" y="287"/>
                </a:lnTo>
                <a:lnTo>
                  <a:pt x="437" y="286"/>
                </a:lnTo>
                <a:lnTo>
                  <a:pt x="444" y="284"/>
                </a:lnTo>
                <a:lnTo>
                  <a:pt x="449" y="284"/>
                </a:lnTo>
                <a:lnTo>
                  <a:pt x="455" y="283"/>
                </a:lnTo>
                <a:lnTo>
                  <a:pt x="457" y="280"/>
                </a:lnTo>
                <a:lnTo>
                  <a:pt x="461" y="280"/>
                </a:lnTo>
                <a:lnTo>
                  <a:pt x="467" y="280"/>
                </a:lnTo>
                <a:lnTo>
                  <a:pt x="473" y="280"/>
                </a:lnTo>
                <a:lnTo>
                  <a:pt x="481" y="280"/>
                </a:lnTo>
                <a:lnTo>
                  <a:pt x="484" y="280"/>
                </a:lnTo>
                <a:lnTo>
                  <a:pt x="492" y="280"/>
                </a:lnTo>
                <a:lnTo>
                  <a:pt x="497" y="278"/>
                </a:lnTo>
                <a:lnTo>
                  <a:pt x="506" y="277"/>
                </a:lnTo>
                <a:lnTo>
                  <a:pt x="510" y="276"/>
                </a:lnTo>
                <a:lnTo>
                  <a:pt x="515" y="275"/>
                </a:lnTo>
                <a:lnTo>
                  <a:pt x="517" y="274"/>
                </a:lnTo>
                <a:lnTo>
                  <a:pt x="522" y="274"/>
                </a:lnTo>
                <a:lnTo>
                  <a:pt x="527" y="273"/>
                </a:lnTo>
                <a:lnTo>
                  <a:pt x="534" y="273"/>
                </a:lnTo>
                <a:lnTo>
                  <a:pt x="539" y="271"/>
                </a:lnTo>
                <a:lnTo>
                  <a:pt x="546" y="270"/>
                </a:lnTo>
                <a:lnTo>
                  <a:pt x="551" y="269"/>
                </a:lnTo>
                <a:lnTo>
                  <a:pt x="557" y="269"/>
                </a:lnTo>
                <a:lnTo>
                  <a:pt x="557" y="268"/>
                </a:lnTo>
                <a:lnTo>
                  <a:pt x="563" y="265"/>
                </a:lnTo>
                <a:lnTo>
                  <a:pt x="569" y="265"/>
                </a:lnTo>
                <a:lnTo>
                  <a:pt x="575" y="263"/>
                </a:lnTo>
                <a:lnTo>
                  <a:pt x="575" y="262"/>
                </a:lnTo>
                <a:lnTo>
                  <a:pt x="581" y="261"/>
                </a:lnTo>
                <a:lnTo>
                  <a:pt x="588" y="258"/>
                </a:lnTo>
                <a:lnTo>
                  <a:pt x="593" y="258"/>
                </a:lnTo>
                <a:lnTo>
                  <a:pt x="599" y="257"/>
                </a:lnTo>
                <a:lnTo>
                  <a:pt x="602" y="255"/>
                </a:lnTo>
                <a:lnTo>
                  <a:pt x="607" y="255"/>
                </a:lnTo>
                <a:lnTo>
                  <a:pt x="612" y="255"/>
                </a:lnTo>
                <a:lnTo>
                  <a:pt x="618" y="254"/>
                </a:lnTo>
                <a:lnTo>
                  <a:pt x="623" y="254"/>
                </a:lnTo>
                <a:lnTo>
                  <a:pt x="629" y="252"/>
                </a:lnTo>
                <a:lnTo>
                  <a:pt x="635" y="251"/>
                </a:lnTo>
                <a:lnTo>
                  <a:pt x="635" y="249"/>
                </a:lnTo>
                <a:lnTo>
                  <a:pt x="642" y="247"/>
                </a:lnTo>
                <a:lnTo>
                  <a:pt x="648" y="245"/>
                </a:lnTo>
                <a:lnTo>
                  <a:pt x="654" y="245"/>
                </a:lnTo>
                <a:lnTo>
                  <a:pt x="656" y="243"/>
                </a:lnTo>
                <a:lnTo>
                  <a:pt x="660" y="243"/>
                </a:lnTo>
                <a:lnTo>
                  <a:pt x="668" y="242"/>
                </a:lnTo>
                <a:lnTo>
                  <a:pt x="672" y="241"/>
                </a:lnTo>
                <a:lnTo>
                  <a:pt x="678" y="240"/>
                </a:lnTo>
                <a:lnTo>
                  <a:pt x="684" y="240"/>
                </a:lnTo>
                <a:lnTo>
                  <a:pt x="690" y="239"/>
                </a:lnTo>
                <a:lnTo>
                  <a:pt x="693" y="238"/>
                </a:lnTo>
                <a:lnTo>
                  <a:pt x="695" y="238"/>
                </a:lnTo>
                <a:lnTo>
                  <a:pt x="701" y="236"/>
                </a:lnTo>
                <a:lnTo>
                  <a:pt x="709" y="235"/>
                </a:lnTo>
                <a:lnTo>
                  <a:pt x="712" y="232"/>
                </a:lnTo>
                <a:lnTo>
                  <a:pt x="714" y="231"/>
                </a:lnTo>
                <a:lnTo>
                  <a:pt x="721" y="231"/>
                </a:lnTo>
                <a:lnTo>
                  <a:pt x="726" y="230"/>
                </a:lnTo>
                <a:lnTo>
                  <a:pt x="731" y="229"/>
                </a:lnTo>
                <a:lnTo>
                  <a:pt x="737" y="228"/>
                </a:lnTo>
                <a:lnTo>
                  <a:pt x="744" y="226"/>
                </a:lnTo>
                <a:lnTo>
                  <a:pt x="744" y="225"/>
                </a:lnTo>
                <a:lnTo>
                  <a:pt x="750" y="222"/>
                </a:lnTo>
                <a:lnTo>
                  <a:pt x="756" y="222"/>
                </a:lnTo>
                <a:lnTo>
                  <a:pt x="762" y="222"/>
                </a:lnTo>
                <a:lnTo>
                  <a:pt x="766" y="220"/>
                </a:lnTo>
                <a:lnTo>
                  <a:pt x="768" y="220"/>
                </a:lnTo>
                <a:lnTo>
                  <a:pt x="774" y="220"/>
                </a:lnTo>
                <a:lnTo>
                  <a:pt x="780" y="220"/>
                </a:lnTo>
                <a:lnTo>
                  <a:pt x="786" y="220"/>
                </a:lnTo>
                <a:lnTo>
                  <a:pt x="792" y="218"/>
                </a:lnTo>
                <a:lnTo>
                  <a:pt x="801" y="217"/>
                </a:lnTo>
                <a:lnTo>
                  <a:pt x="804" y="216"/>
                </a:lnTo>
                <a:lnTo>
                  <a:pt x="810" y="214"/>
                </a:lnTo>
                <a:lnTo>
                  <a:pt x="812" y="213"/>
                </a:lnTo>
                <a:lnTo>
                  <a:pt x="816" y="212"/>
                </a:lnTo>
                <a:lnTo>
                  <a:pt x="822" y="210"/>
                </a:lnTo>
                <a:lnTo>
                  <a:pt x="828" y="210"/>
                </a:lnTo>
                <a:lnTo>
                  <a:pt x="833" y="208"/>
                </a:lnTo>
                <a:lnTo>
                  <a:pt x="834" y="208"/>
                </a:lnTo>
                <a:lnTo>
                  <a:pt x="842" y="208"/>
                </a:lnTo>
                <a:lnTo>
                  <a:pt x="846" y="204"/>
                </a:lnTo>
                <a:lnTo>
                  <a:pt x="852" y="203"/>
                </a:lnTo>
                <a:lnTo>
                  <a:pt x="858" y="203"/>
                </a:lnTo>
                <a:lnTo>
                  <a:pt x="864" y="203"/>
                </a:lnTo>
                <a:lnTo>
                  <a:pt x="865" y="202"/>
                </a:lnTo>
                <a:lnTo>
                  <a:pt x="870" y="202"/>
                </a:lnTo>
                <a:lnTo>
                  <a:pt x="876" y="198"/>
                </a:lnTo>
                <a:lnTo>
                  <a:pt x="882" y="197"/>
                </a:lnTo>
                <a:lnTo>
                  <a:pt x="887" y="196"/>
                </a:lnTo>
                <a:lnTo>
                  <a:pt x="889" y="196"/>
                </a:lnTo>
                <a:lnTo>
                  <a:pt x="895" y="193"/>
                </a:lnTo>
                <a:lnTo>
                  <a:pt x="900" y="192"/>
                </a:lnTo>
                <a:lnTo>
                  <a:pt x="903" y="189"/>
                </a:lnTo>
                <a:lnTo>
                  <a:pt x="906" y="189"/>
                </a:lnTo>
                <a:lnTo>
                  <a:pt x="912" y="189"/>
                </a:lnTo>
                <a:lnTo>
                  <a:pt x="918" y="188"/>
                </a:lnTo>
                <a:lnTo>
                  <a:pt x="924" y="188"/>
                </a:lnTo>
                <a:lnTo>
                  <a:pt x="930" y="188"/>
                </a:lnTo>
                <a:lnTo>
                  <a:pt x="936" y="187"/>
                </a:lnTo>
                <a:lnTo>
                  <a:pt x="944" y="187"/>
                </a:lnTo>
                <a:lnTo>
                  <a:pt x="949" y="185"/>
                </a:lnTo>
                <a:lnTo>
                  <a:pt x="949" y="184"/>
                </a:lnTo>
                <a:lnTo>
                  <a:pt x="954" y="184"/>
                </a:lnTo>
                <a:lnTo>
                  <a:pt x="961" y="184"/>
                </a:lnTo>
                <a:lnTo>
                  <a:pt x="967" y="182"/>
                </a:lnTo>
                <a:lnTo>
                  <a:pt x="972" y="182"/>
                </a:lnTo>
                <a:lnTo>
                  <a:pt x="976" y="178"/>
                </a:lnTo>
                <a:lnTo>
                  <a:pt x="978" y="178"/>
                </a:lnTo>
                <a:lnTo>
                  <a:pt x="985" y="177"/>
                </a:lnTo>
                <a:lnTo>
                  <a:pt x="991" y="175"/>
                </a:lnTo>
                <a:lnTo>
                  <a:pt x="997" y="172"/>
                </a:lnTo>
                <a:lnTo>
                  <a:pt x="997" y="171"/>
                </a:lnTo>
                <a:lnTo>
                  <a:pt x="1003" y="171"/>
                </a:lnTo>
                <a:lnTo>
                  <a:pt x="1008" y="171"/>
                </a:lnTo>
                <a:lnTo>
                  <a:pt x="1014" y="171"/>
                </a:lnTo>
                <a:lnTo>
                  <a:pt x="1020" y="171"/>
                </a:lnTo>
                <a:lnTo>
                  <a:pt x="1027" y="167"/>
                </a:lnTo>
                <a:lnTo>
                  <a:pt x="1027" y="166"/>
                </a:lnTo>
                <a:lnTo>
                  <a:pt x="1033" y="166"/>
                </a:lnTo>
                <a:lnTo>
                  <a:pt x="1038" y="164"/>
                </a:lnTo>
                <a:lnTo>
                  <a:pt x="1044" y="164"/>
                </a:lnTo>
                <a:lnTo>
                  <a:pt x="1050" y="162"/>
                </a:lnTo>
                <a:lnTo>
                  <a:pt x="1051" y="159"/>
                </a:lnTo>
                <a:lnTo>
                  <a:pt x="1057" y="159"/>
                </a:lnTo>
                <a:lnTo>
                  <a:pt x="1063" y="156"/>
                </a:lnTo>
                <a:lnTo>
                  <a:pt x="1069" y="154"/>
                </a:lnTo>
                <a:lnTo>
                  <a:pt x="1074" y="154"/>
                </a:lnTo>
                <a:lnTo>
                  <a:pt x="1081" y="154"/>
                </a:lnTo>
                <a:lnTo>
                  <a:pt x="1083" y="153"/>
                </a:lnTo>
                <a:lnTo>
                  <a:pt x="1087" y="151"/>
                </a:lnTo>
                <a:lnTo>
                  <a:pt x="1093" y="149"/>
                </a:lnTo>
                <a:lnTo>
                  <a:pt x="1099" y="149"/>
                </a:lnTo>
                <a:lnTo>
                  <a:pt x="1105" y="149"/>
                </a:lnTo>
                <a:lnTo>
                  <a:pt x="1111" y="149"/>
                </a:lnTo>
                <a:lnTo>
                  <a:pt x="1117" y="149"/>
                </a:lnTo>
                <a:lnTo>
                  <a:pt x="1117" y="147"/>
                </a:lnTo>
                <a:lnTo>
                  <a:pt x="1124" y="144"/>
                </a:lnTo>
                <a:lnTo>
                  <a:pt x="1129" y="144"/>
                </a:lnTo>
                <a:lnTo>
                  <a:pt x="1135" y="142"/>
                </a:lnTo>
                <a:lnTo>
                  <a:pt x="1141" y="142"/>
                </a:lnTo>
                <a:lnTo>
                  <a:pt x="1145" y="140"/>
                </a:lnTo>
                <a:lnTo>
                  <a:pt x="1147" y="140"/>
                </a:lnTo>
                <a:lnTo>
                  <a:pt x="1153" y="140"/>
                </a:lnTo>
                <a:lnTo>
                  <a:pt x="1161" y="140"/>
                </a:lnTo>
                <a:lnTo>
                  <a:pt x="1167" y="140"/>
                </a:lnTo>
                <a:lnTo>
                  <a:pt x="1172" y="140"/>
                </a:lnTo>
                <a:lnTo>
                  <a:pt x="1177" y="140"/>
                </a:lnTo>
                <a:lnTo>
                  <a:pt x="1183" y="138"/>
                </a:lnTo>
                <a:lnTo>
                  <a:pt x="1190" y="138"/>
                </a:lnTo>
                <a:lnTo>
                  <a:pt x="1195" y="138"/>
                </a:lnTo>
                <a:lnTo>
                  <a:pt x="1202" y="138"/>
                </a:lnTo>
                <a:lnTo>
                  <a:pt x="1207" y="138"/>
                </a:lnTo>
                <a:lnTo>
                  <a:pt x="1213" y="136"/>
                </a:lnTo>
                <a:lnTo>
                  <a:pt x="1213" y="134"/>
                </a:lnTo>
                <a:lnTo>
                  <a:pt x="1221" y="132"/>
                </a:lnTo>
                <a:lnTo>
                  <a:pt x="1225" y="132"/>
                </a:lnTo>
                <a:lnTo>
                  <a:pt x="1231" y="132"/>
                </a:lnTo>
                <a:lnTo>
                  <a:pt x="1237" y="130"/>
                </a:lnTo>
                <a:lnTo>
                  <a:pt x="1244" y="130"/>
                </a:lnTo>
                <a:lnTo>
                  <a:pt x="1244" y="128"/>
                </a:lnTo>
                <a:lnTo>
                  <a:pt x="1249" y="128"/>
                </a:lnTo>
                <a:lnTo>
                  <a:pt x="1255" y="128"/>
                </a:lnTo>
                <a:lnTo>
                  <a:pt x="1261" y="126"/>
                </a:lnTo>
                <a:lnTo>
                  <a:pt x="1267" y="126"/>
                </a:lnTo>
                <a:lnTo>
                  <a:pt x="1274" y="126"/>
                </a:lnTo>
                <a:lnTo>
                  <a:pt x="1274" y="123"/>
                </a:lnTo>
                <a:lnTo>
                  <a:pt x="1279" y="123"/>
                </a:lnTo>
                <a:lnTo>
                  <a:pt x="1285" y="123"/>
                </a:lnTo>
                <a:lnTo>
                  <a:pt x="1292" y="121"/>
                </a:lnTo>
                <a:lnTo>
                  <a:pt x="1294" y="116"/>
                </a:lnTo>
                <a:lnTo>
                  <a:pt x="1298" y="116"/>
                </a:lnTo>
                <a:lnTo>
                  <a:pt x="1305" y="116"/>
                </a:lnTo>
                <a:lnTo>
                  <a:pt x="1309" y="116"/>
                </a:lnTo>
                <a:lnTo>
                  <a:pt x="1315" y="116"/>
                </a:lnTo>
                <a:lnTo>
                  <a:pt x="1321" y="114"/>
                </a:lnTo>
                <a:lnTo>
                  <a:pt x="1322" y="111"/>
                </a:lnTo>
                <a:lnTo>
                  <a:pt x="1327" y="106"/>
                </a:lnTo>
                <a:lnTo>
                  <a:pt x="1334" y="106"/>
                </a:lnTo>
                <a:lnTo>
                  <a:pt x="1334" y="103"/>
                </a:lnTo>
                <a:lnTo>
                  <a:pt x="1340" y="103"/>
                </a:lnTo>
                <a:lnTo>
                  <a:pt x="1346" y="103"/>
                </a:lnTo>
                <a:lnTo>
                  <a:pt x="1351" y="103"/>
                </a:lnTo>
                <a:lnTo>
                  <a:pt x="1357" y="103"/>
                </a:lnTo>
                <a:lnTo>
                  <a:pt x="1363" y="103"/>
                </a:lnTo>
                <a:lnTo>
                  <a:pt x="1370" y="101"/>
                </a:lnTo>
                <a:lnTo>
                  <a:pt x="1376" y="101"/>
                </a:lnTo>
                <a:lnTo>
                  <a:pt x="1382" y="101"/>
                </a:lnTo>
                <a:lnTo>
                  <a:pt x="1387" y="101"/>
                </a:lnTo>
                <a:lnTo>
                  <a:pt x="1393" y="101"/>
                </a:lnTo>
                <a:lnTo>
                  <a:pt x="1399" y="101"/>
                </a:lnTo>
                <a:lnTo>
                  <a:pt x="1399" y="97"/>
                </a:lnTo>
                <a:lnTo>
                  <a:pt x="1406" y="97"/>
                </a:lnTo>
                <a:lnTo>
                  <a:pt x="1412" y="97"/>
                </a:lnTo>
                <a:lnTo>
                  <a:pt x="1419" y="97"/>
                </a:lnTo>
                <a:lnTo>
                  <a:pt x="1423" y="94"/>
                </a:lnTo>
                <a:lnTo>
                  <a:pt x="1429" y="94"/>
                </a:lnTo>
                <a:lnTo>
                  <a:pt x="1437" y="94"/>
                </a:lnTo>
                <a:lnTo>
                  <a:pt x="1442" y="94"/>
                </a:lnTo>
                <a:lnTo>
                  <a:pt x="1448" y="94"/>
                </a:lnTo>
                <a:lnTo>
                  <a:pt x="1453" y="94"/>
                </a:lnTo>
                <a:lnTo>
                  <a:pt x="1456" y="91"/>
                </a:lnTo>
                <a:lnTo>
                  <a:pt x="1460" y="91"/>
                </a:lnTo>
                <a:lnTo>
                  <a:pt x="1467" y="91"/>
                </a:lnTo>
                <a:lnTo>
                  <a:pt x="1472" y="91"/>
                </a:lnTo>
                <a:lnTo>
                  <a:pt x="1478" y="91"/>
                </a:lnTo>
                <a:lnTo>
                  <a:pt x="1484" y="91"/>
                </a:lnTo>
                <a:lnTo>
                  <a:pt x="1490" y="91"/>
                </a:lnTo>
                <a:lnTo>
                  <a:pt x="1492" y="86"/>
                </a:lnTo>
                <a:lnTo>
                  <a:pt x="1496" y="86"/>
                </a:lnTo>
                <a:lnTo>
                  <a:pt x="1502" y="82"/>
                </a:lnTo>
                <a:lnTo>
                  <a:pt x="1508" y="82"/>
                </a:lnTo>
                <a:lnTo>
                  <a:pt x="1516" y="82"/>
                </a:lnTo>
                <a:lnTo>
                  <a:pt x="1518" y="77"/>
                </a:lnTo>
                <a:lnTo>
                  <a:pt x="1520" y="77"/>
                </a:lnTo>
                <a:lnTo>
                  <a:pt x="1526" y="77"/>
                </a:lnTo>
                <a:lnTo>
                  <a:pt x="1528" y="71"/>
                </a:lnTo>
                <a:lnTo>
                  <a:pt x="1529" y="66"/>
                </a:lnTo>
                <a:lnTo>
                  <a:pt x="1532" y="66"/>
                </a:lnTo>
                <a:lnTo>
                  <a:pt x="1538" y="66"/>
                </a:lnTo>
                <a:lnTo>
                  <a:pt x="1544" y="66"/>
                </a:lnTo>
                <a:lnTo>
                  <a:pt x="1547" y="60"/>
                </a:lnTo>
                <a:lnTo>
                  <a:pt x="1549" y="54"/>
                </a:lnTo>
                <a:lnTo>
                  <a:pt x="1550" y="54"/>
                </a:lnTo>
                <a:lnTo>
                  <a:pt x="1557" y="54"/>
                </a:lnTo>
                <a:lnTo>
                  <a:pt x="1557" y="48"/>
                </a:lnTo>
                <a:lnTo>
                  <a:pt x="1562" y="48"/>
                </a:lnTo>
                <a:lnTo>
                  <a:pt x="1570" y="48"/>
                </a:lnTo>
                <a:lnTo>
                  <a:pt x="1576" y="48"/>
                </a:lnTo>
                <a:lnTo>
                  <a:pt x="1580" y="48"/>
                </a:lnTo>
                <a:lnTo>
                  <a:pt x="1589" y="48"/>
                </a:lnTo>
                <a:lnTo>
                  <a:pt x="1592" y="48"/>
                </a:lnTo>
                <a:lnTo>
                  <a:pt x="1598" y="48"/>
                </a:lnTo>
                <a:lnTo>
                  <a:pt x="1604" y="48"/>
                </a:lnTo>
                <a:lnTo>
                  <a:pt x="1610" y="48"/>
                </a:lnTo>
                <a:lnTo>
                  <a:pt x="1616" y="48"/>
                </a:lnTo>
                <a:lnTo>
                  <a:pt x="1623" y="48"/>
                </a:lnTo>
                <a:lnTo>
                  <a:pt x="1625" y="39"/>
                </a:lnTo>
                <a:lnTo>
                  <a:pt x="1628" y="39"/>
                </a:lnTo>
                <a:lnTo>
                  <a:pt x="1634" y="39"/>
                </a:lnTo>
                <a:lnTo>
                  <a:pt x="1640" y="39"/>
                </a:lnTo>
                <a:lnTo>
                  <a:pt x="1642" y="30"/>
                </a:lnTo>
                <a:lnTo>
                  <a:pt x="1642" y="21"/>
                </a:lnTo>
                <a:lnTo>
                  <a:pt x="1646" y="21"/>
                </a:lnTo>
                <a:lnTo>
                  <a:pt x="1650" y="11"/>
                </a:lnTo>
                <a:lnTo>
                  <a:pt x="1654" y="11"/>
                </a:lnTo>
                <a:lnTo>
                  <a:pt x="1660" y="11"/>
                </a:lnTo>
                <a:lnTo>
                  <a:pt x="1661" y="0"/>
                </a:lnTo>
              </a:path>
            </a:pathLst>
          </a:custGeom>
          <a:noFill/>
          <a:ln w="381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Freeform 20">
            <a:extLst>
              <a:ext uri="{FF2B5EF4-FFF2-40B4-BE49-F238E27FC236}">
                <a16:creationId xmlns:a16="http://schemas.microsoft.com/office/drawing/2014/main" id="{31CF116D-E5F8-5F20-84B0-63DF966C907E}"/>
              </a:ext>
            </a:extLst>
          </p:cNvPr>
          <p:cNvSpPr>
            <a:spLocks/>
          </p:cNvSpPr>
          <p:nvPr/>
        </p:nvSpPr>
        <p:spPr bwMode="auto">
          <a:xfrm>
            <a:off x="2274019" y="4580273"/>
            <a:ext cx="5873944" cy="731784"/>
          </a:xfrm>
          <a:custGeom>
            <a:avLst/>
            <a:gdLst>
              <a:gd name="T0" fmla="*/ 90 w 1661"/>
              <a:gd name="T1" fmla="*/ 200 h 203"/>
              <a:gd name="T2" fmla="*/ 106 w 1661"/>
              <a:gd name="T3" fmla="*/ 194 h 203"/>
              <a:gd name="T4" fmla="*/ 141 w 1661"/>
              <a:gd name="T5" fmla="*/ 188 h 203"/>
              <a:gd name="T6" fmla="*/ 150 w 1661"/>
              <a:gd name="T7" fmla="*/ 180 h 203"/>
              <a:gd name="T8" fmla="*/ 168 w 1661"/>
              <a:gd name="T9" fmla="*/ 174 h 203"/>
              <a:gd name="T10" fmla="*/ 185 w 1661"/>
              <a:gd name="T11" fmla="*/ 165 h 203"/>
              <a:gd name="T12" fmla="*/ 200 w 1661"/>
              <a:gd name="T13" fmla="*/ 156 h 203"/>
              <a:gd name="T14" fmla="*/ 214 w 1661"/>
              <a:gd name="T15" fmla="*/ 150 h 203"/>
              <a:gd name="T16" fmla="*/ 241 w 1661"/>
              <a:gd name="T17" fmla="*/ 144 h 203"/>
              <a:gd name="T18" fmla="*/ 275 w 1661"/>
              <a:gd name="T19" fmla="*/ 141 h 203"/>
              <a:gd name="T20" fmla="*/ 296 w 1661"/>
              <a:gd name="T21" fmla="*/ 138 h 203"/>
              <a:gd name="T22" fmla="*/ 318 w 1661"/>
              <a:gd name="T23" fmla="*/ 138 h 203"/>
              <a:gd name="T24" fmla="*/ 342 w 1661"/>
              <a:gd name="T25" fmla="*/ 129 h 203"/>
              <a:gd name="T26" fmla="*/ 366 w 1661"/>
              <a:gd name="T27" fmla="*/ 129 h 203"/>
              <a:gd name="T28" fmla="*/ 383 w 1661"/>
              <a:gd name="T29" fmla="*/ 122 h 203"/>
              <a:gd name="T30" fmla="*/ 398 w 1661"/>
              <a:gd name="T31" fmla="*/ 113 h 203"/>
              <a:gd name="T32" fmla="*/ 413 w 1661"/>
              <a:gd name="T33" fmla="*/ 109 h 203"/>
              <a:gd name="T34" fmla="*/ 439 w 1661"/>
              <a:gd name="T35" fmla="*/ 106 h 203"/>
              <a:gd name="T36" fmla="*/ 455 w 1661"/>
              <a:gd name="T37" fmla="*/ 103 h 203"/>
              <a:gd name="T38" fmla="*/ 480 w 1661"/>
              <a:gd name="T39" fmla="*/ 103 h 203"/>
              <a:gd name="T40" fmla="*/ 505 w 1661"/>
              <a:gd name="T41" fmla="*/ 103 h 203"/>
              <a:gd name="T42" fmla="*/ 531 w 1661"/>
              <a:gd name="T43" fmla="*/ 99 h 203"/>
              <a:gd name="T44" fmla="*/ 545 w 1661"/>
              <a:gd name="T45" fmla="*/ 95 h 203"/>
              <a:gd name="T46" fmla="*/ 570 w 1661"/>
              <a:gd name="T47" fmla="*/ 92 h 203"/>
              <a:gd name="T48" fmla="*/ 595 w 1661"/>
              <a:gd name="T49" fmla="*/ 92 h 203"/>
              <a:gd name="T50" fmla="*/ 612 w 1661"/>
              <a:gd name="T51" fmla="*/ 87 h 203"/>
              <a:gd name="T52" fmla="*/ 631 w 1661"/>
              <a:gd name="T53" fmla="*/ 83 h 203"/>
              <a:gd name="T54" fmla="*/ 654 w 1661"/>
              <a:gd name="T55" fmla="*/ 83 h 203"/>
              <a:gd name="T56" fmla="*/ 671 w 1661"/>
              <a:gd name="T57" fmla="*/ 74 h 203"/>
              <a:gd name="T58" fmla="*/ 690 w 1661"/>
              <a:gd name="T59" fmla="*/ 70 h 203"/>
              <a:gd name="T60" fmla="*/ 714 w 1661"/>
              <a:gd name="T61" fmla="*/ 70 h 203"/>
              <a:gd name="T62" fmla="*/ 737 w 1661"/>
              <a:gd name="T63" fmla="*/ 70 h 203"/>
              <a:gd name="T64" fmla="*/ 757 w 1661"/>
              <a:gd name="T65" fmla="*/ 64 h 203"/>
              <a:gd name="T66" fmla="*/ 774 w 1661"/>
              <a:gd name="T67" fmla="*/ 58 h 203"/>
              <a:gd name="T68" fmla="*/ 798 w 1661"/>
              <a:gd name="T69" fmla="*/ 58 h 203"/>
              <a:gd name="T70" fmla="*/ 822 w 1661"/>
              <a:gd name="T71" fmla="*/ 58 h 203"/>
              <a:gd name="T72" fmla="*/ 847 w 1661"/>
              <a:gd name="T73" fmla="*/ 58 h 203"/>
              <a:gd name="T74" fmla="*/ 871 w 1661"/>
              <a:gd name="T75" fmla="*/ 58 h 203"/>
              <a:gd name="T76" fmla="*/ 894 w 1661"/>
              <a:gd name="T77" fmla="*/ 58 h 203"/>
              <a:gd name="T78" fmla="*/ 918 w 1661"/>
              <a:gd name="T79" fmla="*/ 58 h 203"/>
              <a:gd name="T80" fmla="*/ 942 w 1661"/>
              <a:gd name="T81" fmla="*/ 58 h 203"/>
              <a:gd name="T82" fmla="*/ 967 w 1661"/>
              <a:gd name="T83" fmla="*/ 58 h 203"/>
              <a:gd name="T84" fmla="*/ 991 w 1661"/>
              <a:gd name="T85" fmla="*/ 58 h 203"/>
              <a:gd name="T86" fmla="*/ 1015 w 1661"/>
              <a:gd name="T87" fmla="*/ 58 h 203"/>
              <a:gd name="T88" fmla="*/ 1038 w 1661"/>
              <a:gd name="T89" fmla="*/ 58 h 203"/>
              <a:gd name="T90" fmla="*/ 1068 w 1661"/>
              <a:gd name="T91" fmla="*/ 58 h 203"/>
              <a:gd name="T92" fmla="*/ 1088 w 1661"/>
              <a:gd name="T93" fmla="*/ 58 h 203"/>
              <a:gd name="T94" fmla="*/ 1122 w 1661"/>
              <a:gd name="T95" fmla="*/ 58 h 203"/>
              <a:gd name="T96" fmla="*/ 1149 w 1661"/>
              <a:gd name="T97" fmla="*/ 58 h 203"/>
              <a:gd name="T98" fmla="*/ 1185 w 1661"/>
              <a:gd name="T99" fmla="*/ 58 h 203"/>
              <a:gd name="T100" fmla="*/ 1203 w 1661"/>
              <a:gd name="T101" fmla="*/ 0 h 203"/>
              <a:gd name="T102" fmla="*/ 1296 w 1661"/>
              <a:gd name="T103" fmla="*/ 0 h 203"/>
              <a:gd name="T104" fmla="*/ 1334 w 1661"/>
              <a:gd name="T105" fmla="*/ 0 h 203"/>
              <a:gd name="T106" fmla="*/ 1379 w 1661"/>
              <a:gd name="T107" fmla="*/ 0 h 203"/>
              <a:gd name="T108" fmla="*/ 1440 w 1661"/>
              <a:gd name="T109" fmla="*/ 0 h 203"/>
              <a:gd name="T110" fmla="*/ 1558 w 1661"/>
              <a:gd name="T111" fmla="*/ 0 h 203"/>
              <a:gd name="T112" fmla="*/ 1636 w 1661"/>
              <a:gd name="T113" fmla="*/ 0 h 2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1661" h="203">
                <a:moveTo>
                  <a:pt x="0" y="203"/>
                </a:moveTo>
                <a:lnTo>
                  <a:pt x="79" y="203"/>
                </a:lnTo>
                <a:lnTo>
                  <a:pt x="82" y="203"/>
                </a:lnTo>
                <a:lnTo>
                  <a:pt x="90" y="200"/>
                </a:lnTo>
                <a:lnTo>
                  <a:pt x="90" y="197"/>
                </a:lnTo>
                <a:lnTo>
                  <a:pt x="95" y="197"/>
                </a:lnTo>
                <a:lnTo>
                  <a:pt x="101" y="197"/>
                </a:lnTo>
                <a:lnTo>
                  <a:pt x="106" y="194"/>
                </a:lnTo>
                <a:lnTo>
                  <a:pt x="106" y="191"/>
                </a:lnTo>
                <a:lnTo>
                  <a:pt x="119" y="188"/>
                </a:lnTo>
                <a:lnTo>
                  <a:pt x="127" y="188"/>
                </a:lnTo>
                <a:lnTo>
                  <a:pt x="141" y="188"/>
                </a:lnTo>
                <a:lnTo>
                  <a:pt x="143" y="188"/>
                </a:lnTo>
                <a:lnTo>
                  <a:pt x="145" y="186"/>
                </a:lnTo>
                <a:lnTo>
                  <a:pt x="149" y="183"/>
                </a:lnTo>
                <a:lnTo>
                  <a:pt x="150" y="180"/>
                </a:lnTo>
                <a:lnTo>
                  <a:pt x="154" y="180"/>
                </a:lnTo>
                <a:lnTo>
                  <a:pt x="159" y="174"/>
                </a:lnTo>
                <a:lnTo>
                  <a:pt x="165" y="174"/>
                </a:lnTo>
                <a:lnTo>
                  <a:pt x="168" y="174"/>
                </a:lnTo>
                <a:lnTo>
                  <a:pt x="175" y="174"/>
                </a:lnTo>
                <a:lnTo>
                  <a:pt x="176" y="168"/>
                </a:lnTo>
                <a:lnTo>
                  <a:pt x="179" y="168"/>
                </a:lnTo>
                <a:lnTo>
                  <a:pt x="185" y="165"/>
                </a:lnTo>
                <a:lnTo>
                  <a:pt x="186" y="162"/>
                </a:lnTo>
                <a:lnTo>
                  <a:pt x="194" y="162"/>
                </a:lnTo>
                <a:lnTo>
                  <a:pt x="196" y="156"/>
                </a:lnTo>
                <a:lnTo>
                  <a:pt x="200" y="156"/>
                </a:lnTo>
                <a:lnTo>
                  <a:pt x="202" y="153"/>
                </a:lnTo>
                <a:lnTo>
                  <a:pt x="202" y="150"/>
                </a:lnTo>
                <a:lnTo>
                  <a:pt x="209" y="150"/>
                </a:lnTo>
                <a:lnTo>
                  <a:pt x="214" y="150"/>
                </a:lnTo>
                <a:lnTo>
                  <a:pt x="223" y="147"/>
                </a:lnTo>
                <a:lnTo>
                  <a:pt x="235" y="147"/>
                </a:lnTo>
                <a:lnTo>
                  <a:pt x="235" y="144"/>
                </a:lnTo>
                <a:lnTo>
                  <a:pt x="241" y="144"/>
                </a:lnTo>
                <a:lnTo>
                  <a:pt x="247" y="144"/>
                </a:lnTo>
                <a:lnTo>
                  <a:pt x="263" y="144"/>
                </a:lnTo>
                <a:lnTo>
                  <a:pt x="271" y="141"/>
                </a:lnTo>
                <a:lnTo>
                  <a:pt x="275" y="141"/>
                </a:lnTo>
                <a:lnTo>
                  <a:pt x="281" y="141"/>
                </a:lnTo>
                <a:lnTo>
                  <a:pt x="289" y="141"/>
                </a:lnTo>
                <a:lnTo>
                  <a:pt x="292" y="141"/>
                </a:lnTo>
                <a:lnTo>
                  <a:pt x="296" y="138"/>
                </a:lnTo>
                <a:lnTo>
                  <a:pt x="300" y="138"/>
                </a:lnTo>
                <a:lnTo>
                  <a:pt x="307" y="138"/>
                </a:lnTo>
                <a:lnTo>
                  <a:pt x="311" y="138"/>
                </a:lnTo>
                <a:lnTo>
                  <a:pt x="318" y="138"/>
                </a:lnTo>
                <a:lnTo>
                  <a:pt x="328" y="135"/>
                </a:lnTo>
                <a:lnTo>
                  <a:pt x="328" y="132"/>
                </a:lnTo>
                <a:lnTo>
                  <a:pt x="335" y="129"/>
                </a:lnTo>
                <a:lnTo>
                  <a:pt x="342" y="129"/>
                </a:lnTo>
                <a:lnTo>
                  <a:pt x="349" y="129"/>
                </a:lnTo>
                <a:lnTo>
                  <a:pt x="352" y="129"/>
                </a:lnTo>
                <a:lnTo>
                  <a:pt x="358" y="129"/>
                </a:lnTo>
                <a:lnTo>
                  <a:pt x="366" y="129"/>
                </a:lnTo>
                <a:lnTo>
                  <a:pt x="369" y="125"/>
                </a:lnTo>
                <a:lnTo>
                  <a:pt x="372" y="125"/>
                </a:lnTo>
                <a:lnTo>
                  <a:pt x="380" y="122"/>
                </a:lnTo>
                <a:lnTo>
                  <a:pt x="383" y="122"/>
                </a:lnTo>
                <a:lnTo>
                  <a:pt x="383" y="119"/>
                </a:lnTo>
                <a:lnTo>
                  <a:pt x="391" y="119"/>
                </a:lnTo>
                <a:lnTo>
                  <a:pt x="398" y="119"/>
                </a:lnTo>
                <a:lnTo>
                  <a:pt x="398" y="113"/>
                </a:lnTo>
                <a:lnTo>
                  <a:pt x="400" y="109"/>
                </a:lnTo>
                <a:lnTo>
                  <a:pt x="406" y="109"/>
                </a:lnTo>
                <a:lnTo>
                  <a:pt x="409" y="109"/>
                </a:lnTo>
                <a:lnTo>
                  <a:pt x="413" y="109"/>
                </a:lnTo>
                <a:lnTo>
                  <a:pt x="421" y="109"/>
                </a:lnTo>
                <a:lnTo>
                  <a:pt x="426" y="109"/>
                </a:lnTo>
                <a:lnTo>
                  <a:pt x="435" y="106"/>
                </a:lnTo>
                <a:lnTo>
                  <a:pt x="439" y="106"/>
                </a:lnTo>
                <a:lnTo>
                  <a:pt x="443" y="106"/>
                </a:lnTo>
                <a:lnTo>
                  <a:pt x="448" y="103"/>
                </a:lnTo>
                <a:lnTo>
                  <a:pt x="452" y="103"/>
                </a:lnTo>
                <a:lnTo>
                  <a:pt x="455" y="103"/>
                </a:lnTo>
                <a:lnTo>
                  <a:pt x="461" y="103"/>
                </a:lnTo>
                <a:lnTo>
                  <a:pt x="471" y="103"/>
                </a:lnTo>
                <a:lnTo>
                  <a:pt x="474" y="103"/>
                </a:lnTo>
                <a:lnTo>
                  <a:pt x="480" y="103"/>
                </a:lnTo>
                <a:lnTo>
                  <a:pt x="489" y="103"/>
                </a:lnTo>
                <a:lnTo>
                  <a:pt x="491" y="103"/>
                </a:lnTo>
                <a:lnTo>
                  <a:pt x="498" y="103"/>
                </a:lnTo>
                <a:lnTo>
                  <a:pt x="505" y="103"/>
                </a:lnTo>
                <a:lnTo>
                  <a:pt x="512" y="99"/>
                </a:lnTo>
                <a:lnTo>
                  <a:pt x="518" y="99"/>
                </a:lnTo>
                <a:lnTo>
                  <a:pt x="522" y="99"/>
                </a:lnTo>
                <a:lnTo>
                  <a:pt x="531" y="99"/>
                </a:lnTo>
                <a:lnTo>
                  <a:pt x="533" y="99"/>
                </a:lnTo>
                <a:lnTo>
                  <a:pt x="536" y="95"/>
                </a:lnTo>
                <a:lnTo>
                  <a:pt x="540" y="95"/>
                </a:lnTo>
                <a:lnTo>
                  <a:pt x="545" y="95"/>
                </a:lnTo>
                <a:lnTo>
                  <a:pt x="552" y="95"/>
                </a:lnTo>
                <a:lnTo>
                  <a:pt x="557" y="92"/>
                </a:lnTo>
                <a:lnTo>
                  <a:pt x="564" y="92"/>
                </a:lnTo>
                <a:lnTo>
                  <a:pt x="570" y="92"/>
                </a:lnTo>
                <a:lnTo>
                  <a:pt x="575" y="92"/>
                </a:lnTo>
                <a:lnTo>
                  <a:pt x="581" y="92"/>
                </a:lnTo>
                <a:lnTo>
                  <a:pt x="587" y="92"/>
                </a:lnTo>
                <a:lnTo>
                  <a:pt x="595" y="92"/>
                </a:lnTo>
                <a:lnTo>
                  <a:pt x="599" y="92"/>
                </a:lnTo>
                <a:lnTo>
                  <a:pt x="606" y="92"/>
                </a:lnTo>
                <a:lnTo>
                  <a:pt x="608" y="87"/>
                </a:lnTo>
                <a:lnTo>
                  <a:pt x="612" y="87"/>
                </a:lnTo>
                <a:lnTo>
                  <a:pt x="613" y="83"/>
                </a:lnTo>
                <a:lnTo>
                  <a:pt x="618" y="83"/>
                </a:lnTo>
                <a:lnTo>
                  <a:pt x="624" y="83"/>
                </a:lnTo>
                <a:lnTo>
                  <a:pt x="631" y="83"/>
                </a:lnTo>
                <a:lnTo>
                  <a:pt x="635" y="83"/>
                </a:lnTo>
                <a:lnTo>
                  <a:pt x="642" y="83"/>
                </a:lnTo>
                <a:lnTo>
                  <a:pt x="648" y="83"/>
                </a:lnTo>
                <a:lnTo>
                  <a:pt x="654" y="83"/>
                </a:lnTo>
                <a:lnTo>
                  <a:pt x="654" y="79"/>
                </a:lnTo>
                <a:lnTo>
                  <a:pt x="661" y="79"/>
                </a:lnTo>
                <a:lnTo>
                  <a:pt x="665" y="79"/>
                </a:lnTo>
                <a:lnTo>
                  <a:pt x="671" y="74"/>
                </a:lnTo>
                <a:lnTo>
                  <a:pt x="678" y="74"/>
                </a:lnTo>
                <a:lnTo>
                  <a:pt x="684" y="74"/>
                </a:lnTo>
                <a:lnTo>
                  <a:pt x="688" y="70"/>
                </a:lnTo>
                <a:lnTo>
                  <a:pt x="690" y="70"/>
                </a:lnTo>
                <a:lnTo>
                  <a:pt x="696" y="70"/>
                </a:lnTo>
                <a:lnTo>
                  <a:pt x="702" y="70"/>
                </a:lnTo>
                <a:lnTo>
                  <a:pt x="709" y="70"/>
                </a:lnTo>
                <a:lnTo>
                  <a:pt x="714" y="70"/>
                </a:lnTo>
                <a:lnTo>
                  <a:pt x="720" y="70"/>
                </a:lnTo>
                <a:lnTo>
                  <a:pt x="727" y="70"/>
                </a:lnTo>
                <a:lnTo>
                  <a:pt x="731" y="70"/>
                </a:lnTo>
                <a:lnTo>
                  <a:pt x="737" y="70"/>
                </a:lnTo>
                <a:lnTo>
                  <a:pt x="740" y="64"/>
                </a:lnTo>
                <a:lnTo>
                  <a:pt x="744" y="64"/>
                </a:lnTo>
                <a:lnTo>
                  <a:pt x="750" y="64"/>
                </a:lnTo>
                <a:lnTo>
                  <a:pt x="757" y="64"/>
                </a:lnTo>
                <a:lnTo>
                  <a:pt x="762" y="64"/>
                </a:lnTo>
                <a:lnTo>
                  <a:pt x="769" y="64"/>
                </a:lnTo>
                <a:lnTo>
                  <a:pt x="773" y="58"/>
                </a:lnTo>
                <a:lnTo>
                  <a:pt x="774" y="58"/>
                </a:lnTo>
                <a:lnTo>
                  <a:pt x="780" y="58"/>
                </a:lnTo>
                <a:lnTo>
                  <a:pt x="786" y="58"/>
                </a:lnTo>
                <a:lnTo>
                  <a:pt x="794" y="58"/>
                </a:lnTo>
                <a:lnTo>
                  <a:pt x="798" y="58"/>
                </a:lnTo>
                <a:lnTo>
                  <a:pt x="804" y="58"/>
                </a:lnTo>
                <a:lnTo>
                  <a:pt x="810" y="58"/>
                </a:lnTo>
                <a:lnTo>
                  <a:pt x="816" y="58"/>
                </a:lnTo>
                <a:lnTo>
                  <a:pt x="822" y="58"/>
                </a:lnTo>
                <a:lnTo>
                  <a:pt x="828" y="58"/>
                </a:lnTo>
                <a:lnTo>
                  <a:pt x="836" y="58"/>
                </a:lnTo>
                <a:lnTo>
                  <a:pt x="841" y="58"/>
                </a:lnTo>
                <a:lnTo>
                  <a:pt x="847" y="58"/>
                </a:lnTo>
                <a:lnTo>
                  <a:pt x="854" y="58"/>
                </a:lnTo>
                <a:lnTo>
                  <a:pt x="860" y="58"/>
                </a:lnTo>
                <a:lnTo>
                  <a:pt x="866" y="58"/>
                </a:lnTo>
                <a:lnTo>
                  <a:pt x="871" y="58"/>
                </a:lnTo>
                <a:lnTo>
                  <a:pt x="877" y="58"/>
                </a:lnTo>
                <a:lnTo>
                  <a:pt x="882" y="58"/>
                </a:lnTo>
                <a:lnTo>
                  <a:pt x="891" y="58"/>
                </a:lnTo>
                <a:lnTo>
                  <a:pt x="894" y="58"/>
                </a:lnTo>
                <a:lnTo>
                  <a:pt x="900" y="58"/>
                </a:lnTo>
                <a:lnTo>
                  <a:pt x="907" y="58"/>
                </a:lnTo>
                <a:lnTo>
                  <a:pt x="913" y="58"/>
                </a:lnTo>
                <a:lnTo>
                  <a:pt x="918" y="58"/>
                </a:lnTo>
                <a:lnTo>
                  <a:pt x="926" y="58"/>
                </a:lnTo>
                <a:lnTo>
                  <a:pt x="931" y="58"/>
                </a:lnTo>
                <a:lnTo>
                  <a:pt x="936" y="58"/>
                </a:lnTo>
                <a:lnTo>
                  <a:pt x="942" y="58"/>
                </a:lnTo>
                <a:lnTo>
                  <a:pt x="948" y="58"/>
                </a:lnTo>
                <a:lnTo>
                  <a:pt x="954" y="58"/>
                </a:lnTo>
                <a:lnTo>
                  <a:pt x="960" y="58"/>
                </a:lnTo>
                <a:lnTo>
                  <a:pt x="967" y="58"/>
                </a:lnTo>
                <a:lnTo>
                  <a:pt x="973" y="58"/>
                </a:lnTo>
                <a:lnTo>
                  <a:pt x="979" y="58"/>
                </a:lnTo>
                <a:lnTo>
                  <a:pt x="986" y="58"/>
                </a:lnTo>
                <a:lnTo>
                  <a:pt x="991" y="58"/>
                </a:lnTo>
                <a:lnTo>
                  <a:pt x="997" y="58"/>
                </a:lnTo>
                <a:lnTo>
                  <a:pt x="1003" y="58"/>
                </a:lnTo>
                <a:lnTo>
                  <a:pt x="1008" y="58"/>
                </a:lnTo>
                <a:lnTo>
                  <a:pt x="1015" y="58"/>
                </a:lnTo>
                <a:lnTo>
                  <a:pt x="1021" y="58"/>
                </a:lnTo>
                <a:lnTo>
                  <a:pt x="1027" y="58"/>
                </a:lnTo>
                <a:lnTo>
                  <a:pt x="1036" y="58"/>
                </a:lnTo>
                <a:lnTo>
                  <a:pt x="1038" y="58"/>
                </a:lnTo>
                <a:lnTo>
                  <a:pt x="1050" y="58"/>
                </a:lnTo>
                <a:lnTo>
                  <a:pt x="1053" y="58"/>
                </a:lnTo>
                <a:lnTo>
                  <a:pt x="1057" y="58"/>
                </a:lnTo>
                <a:lnTo>
                  <a:pt x="1068" y="58"/>
                </a:lnTo>
                <a:lnTo>
                  <a:pt x="1070" y="58"/>
                </a:lnTo>
                <a:lnTo>
                  <a:pt x="1077" y="58"/>
                </a:lnTo>
                <a:lnTo>
                  <a:pt x="1081" y="58"/>
                </a:lnTo>
                <a:lnTo>
                  <a:pt x="1088" y="58"/>
                </a:lnTo>
                <a:lnTo>
                  <a:pt x="1095" y="58"/>
                </a:lnTo>
                <a:lnTo>
                  <a:pt x="1100" y="58"/>
                </a:lnTo>
                <a:lnTo>
                  <a:pt x="1115" y="58"/>
                </a:lnTo>
                <a:lnTo>
                  <a:pt x="1122" y="58"/>
                </a:lnTo>
                <a:lnTo>
                  <a:pt x="1130" y="58"/>
                </a:lnTo>
                <a:lnTo>
                  <a:pt x="1136" y="58"/>
                </a:lnTo>
                <a:lnTo>
                  <a:pt x="1143" y="58"/>
                </a:lnTo>
                <a:lnTo>
                  <a:pt x="1149" y="58"/>
                </a:lnTo>
                <a:lnTo>
                  <a:pt x="1161" y="58"/>
                </a:lnTo>
                <a:lnTo>
                  <a:pt x="1174" y="58"/>
                </a:lnTo>
                <a:lnTo>
                  <a:pt x="1180" y="58"/>
                </a:lnTo>
                <a:lnTo>
                  <a:pt x="1185" y="58"/>
                </a:lnTo>
                <a:lnTo>
                  <a:pt x="1190" y="58"/>
                </a:lnTo>
                <a:lnTo>
                  <a:pt x="1196" y="58"/>
                </a:lnTo>
                <a:lnTo>
                  <a:pt x="1196" y="0"/>
                </a:lnTo>
                <a:lnTo>
                  <a:pt x="1203" y="0"/>
                </a:lnTo>
                <a:lnTo>
                  <a:pt x="1211" y="0"/>
                </a:lnTo>
                <a:lnTo>
                  <a:pt x="1216" y="0"/>
                </a:lnTo>
                <a:lnTo>
                  <a:pt x="1259" y="0"/>
                </a:lnTo>
                <a:lnTo>
                  <a:pt x="1296" y="0"/>
                </a:lnTo>
                <a:lnTo>
                  <a:pt x="1300" y="0"/>
                </a:lnTo>
                <a:lnTo>
                  <a:pt x="1319" y="0"/>
                </a:lnTo>
                <a:lnTo>
                  <a:pt x="1332" y="0"/>
                </a:lnTo>
                <a:lnTo>
                  <a:pt x="1334" y="0"/>
                </a:lnTo>
                <a:lnTo>
                  <a:pt x="1343" y="0"/>
                </a:lnTo>
                <a:lnTo>
                  <a:pt x="1350" y="0"/>
                </a:lnTo>
                <a:lnTo>
                  <a:pt x="1354" y="0"/>
                </a:lnTo>
                <a:lnTo>
                  <a:pt x="1379" y="0"/>
                </a:lnTo>
                <a:lnTo>
                  <a:pt x="1395" y="0"/>
                </a:lnTo>
                <a:lnTo>
                  <a:pt x="1401" y="0"/>
                </a:lnTo>
                <a:lnTo>
                  <a:pt x="1423" y="0"/>
                </a:lnTo>
                <a:lnTo>
                  <a:pt x="1440" y="0"/>
                </a:lnTo>
                <a:lnTo>
                  <a:pt x="1464" y="0"/>
                </a:lnTo>
                <a:lnTo>
                  <a:pt x="1487" y="0"/>
                </a:lnTo>
                <a:lnTo>
                  <a:pt x="1552" y="0"/>
                </a:lnTo>
                <a:lnTo>
                  <a:pt x="1558" y="0"/>
                </a:lnTo>
                <a:lnTo>
                  <a:pt x="1581" y="0"/>
                </a:lnTo>
                <a:lnTo>
                  <a:pt x="1596" y="0"/>
                </a:lnTo>
                <a:lnTo>
                  <a:pt x="1604" y="0"/>
                </a:lnTo>
                <a:lnTo>
                  <a:pt x="1636" y="0"/>
                </a:lnTo>
                <a:lnTo>
                  <a:pt x="1655" y="0"/>
                </a:lnTo>
                <a:lnTo>
                  <a:pt x="1661" y="0"/>
                </a:lnTo>
              </a:path>
            </a:pathLst>
          </a:custGeom>
          <a:noFill/>
          <a:ln w="38100" cap="flat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Freeform 21">
            <a:extLst>
              <a:ext uri="{FF2B5EF4-FFF2-40B4-BE49-F238E27FC236}">
                <a16:creationId xmlns:a16="http://schemas.microsoft.com/office/drawing/2014/main" id="{EDE217B9-F2E3-5E10-C158-B63F5B984B81}"/>
              </a:ext>
            </a:extLst>
          </p:cNvPr>
          <p:cNvSpPr>
            <a:spLocks/>
          </p:cNvSpPr>
          <p:nvPr/>
        </p:nvSpPr>
        <p:spPr bwMode="auto">
          <a:xfrm>
            <a:off x="2274019" y="3992685"/>
            <a:ext cx="5704196" cy="1319371"/>
          </a:xfrm>
          <a:custGeom>
            <a:avLst/>
            <a:gdLst>
              <a:gd name="T0" fmla="*/ 82 w 1613"/>
              <a:gd name="T1" fmla="*/ 366 h 366"/>
              <a:gd name="T2" fmla="*/ 101 w 1613"/>
              <a:gd name="T3" fmla="*/ 366 h 366"/>
              <a:gd name="T4" fmla="*/ 119 w 1613"/>
              <a:gd name="T5" fmla="*/ 366 h 366"/>
              <a:gd name="T6" fmla="*/ 137 w 1613"/>
              <a:gd name="T7" fmla="*/ 366 h 366"/>
              <a:gd name="T8" fmla="*/ 154 w 1613"/>
              <a:gd name="T9" fmla="*/ 363 h 366"/>
              <a:gd name="T10" fmla="*/ 169 w 1613"/>
              <a:gd name="T11" fmla="*/ 362 h 366"/>
              <a:gd name="T12" fmla="*/ 184 w 1613"/>
              <a:gd name="T13" fmla="*/ 362 h 366"/>
              <a:gd name="T14" fmla="*/ 202 w 1613"/>
              <a:gd name="T15" fmla="*/ 359 h 366"/>
              <a:gd name="T16" fmla="*/ 221 w 1613"/>
              <a:gd name="T17" fmla="*/ 358 h 366"/>
              <a:gd name="T18" fmla="*/ 233 w 1613"/>
              <a:gd name="T19" fmla="*/ 356 h 366"/>
              <a:gd name="T20" fmla="*/ 250 w 1613"/>
              <a:gd name="T21" fmla="*/ 355 h 366"/>
              <a:gd name="T22" fmla="*/ 269 w 1613"/>
              <a:gd name="T23" fmla="*/ 353 h 366"/>
              <a:gd name="T24" fmla="*/ 280 w 1613"/>
              <a:gd name="T25" fmla="*/ 345 h 366"/>
              <a:gd name="T26" fmla="*/ 292 w 1613"/>
              <a:gd name="T27" fmla="*/ 342 h 366"/>
              <a:gd name="T28" fmla="*/ 311 w 1613"/>
              <a:gd name="T29" fmla="*/ 339 h 366"/>
              <a:gd name="T30" fmla="*/ 330 w 1613"/>
              <a:gd name="T31" fmla="*/ 339 h 366"/>
              <a:gd name="T32" fmla="*/ 341 w 1613"/>
              <a:gd name="T33" fmla="*/ 337 h 366"/>
              <a:gd name="T34" fmla="*/ 359 w 1613"/>
              <a:gd name="T35" fmla="*/ 337 h 366"/>
              <a:gd name="T36" fmla="*/ 377 w 1613"/>
              <a:gd name="T37" fmla="*/ 337 h 366"/>
              <a:gd name="T38" fmla="*/ 395 w 1613"/>
              <a:gd name="T39" fmla="*/ 334 h 366"/>
              <a:gd name="T40" fmla="*/ 407 w 1613"/>
              <a:gd name="T41" fmla="*/ 331 h 366"/>
              <a:gd name="T42" fmla="*/ 425 w 1613"/>
              <a:gd name="T43" fmla="*/ 331 h 366"/>
              <a:gd name="T44" fmla="*/ 443 w 1613"/>
              <a:gd name="T45" fmla="*/ 330 h 366"/>
              <a:gd name="T46" fmla="*/ 461 w 1613"/>
              <a:gd name="T47" fmla="*/ 327 h 366"/>
              <a:gd name="T48" fmla="*/ 479 w 1613"/>
              <a:gd name="T49" fmla="*/ 327 h 366"/>
              <a:gd name="T50" fmla="*/ 496 w 1613"/>
              <a:gd name="T51" fmla="*/ 325 h 366"/>
              <a:gd name="T52" fmla="*/ 509 w 1613"/>
              <a:gd name="T53" fmla="*/ 325 h 366"/>
              <a:gd name="T54" fmla="*/ 527 w 1613"/>
              <a:gd name="T55" fmla="*/ 325 h 366"/>
              <a:gd name="T56" fmla="*/ 545 w 1613"/>
              <a:gd name="T57" fmla="*/ 325 h 366"/>
              <a:gd name="T58" fmla="*/ 564 w 1613"/>
              <a:gd name="T59" fmla="*/ 325 h 366"/>
              <a:gd name="T60" fmla="*/ 581 w 1613"/>
              <a:gd name="T61" fmla="*/ 325 h 366"/>
              <a:gd name="T62" fmla="*/ 593 w 1613"/>
              <a:gd name="T63" fmla="*/ 319 h 366"/>
              <a:gd name="T64" fmla="*/ 612 w 1613"/>
              <a:gd name="T65" fmla="*/ 319 h 366"/>
              <a:gd name="T66" fmla="*/ 631 w 1613"/>
              <a:gd name="T67" fmla="*/ 319 h 366"/>
              <a:gd name="T68" fmla="*/ 648 w 1613"/>
              <a:gd name="T69" fmla="*/ 319 h 366"/>
              <a:gd name="T70" fmla="*/ 665 w 1613"/>
              <a:gd name="T71" fmla="*/ 319 h 366"/>
              <a:gd name="T72" fmla="*/ 684 w 1613"/>
              <a:gd name="T73" fmla="*/ 319 h 366"/>
              <a:gd name="T74" fmla="*/ 701 w 1613"/>
              <a:gd name="T75" fmla="*/ 319 h 366"/>
              <a:gd name="T76" fmla="*/ 715 w 1613"/>
              <a:gd name="T77" fmla="*/ 311 h 366"/>
              <a:gd name="T78" fmla="*/ 731 w 1613"/>
              <a:gd name="T79" fmla="*/ 311 h 366"/>
              <a:gd name="T80" fmla="*/ 750 w 1613"/>
              <a:gd name="T81" fmla="*/ 311 h 366"/>
              <a:gd name="T82" fmla="*/ 768 w 1613"/>
              <a:gd name="T83" fmla="*/ 311 h 366"/>
              <a:gd name="T84" fmla="*/ 787 w 1613"/>
              <a:gd name="T85" fmla="*/ 311 h 366"/>
              <a:gd name="T86" fmla="*/ 798 w 1613"/>
              <a:gd name="T87" fmla="*/ 305 h 366"/>
              <a:gd name="T88" fmla="*/ 817 w 1613"/>
              <a:gd name="T89" fmla="*/ 305 h 366"/>
              <a:gd name="T90" fmla="*/ 834 w 1613"/>
              <a:gd name="T91" fmla="*/ 305 h 366"/>
              <a:gd name="T92" fmla="*/ 852 w 1613"/>
              <a:gd name="T93" fmla="*/ 305 h 366"/>
              <a:gd name="T94" fmla="*/ 871 w 1613"/>
              <a:gd name="T95" fmla="*/ 305 h 366"/>
              <a:gd name="T96" fmla="*/ 889 w 1613"/>
              <a:gd name="T97" fmla="*/ 305 h 366"/>
              <a:gd name="T98" fmla="*/ 907 w 1613"/>
              <a:gd name="T99" fmla="*/ 305 h 366"/>
              <a:gd name="T100" fmla="*/ 926 w 1613"/>
              <a:gd name="T101" fmla="*/ 305 h 366"/>
              <a:gd name="T102" fmla="*/ 944 w 1613"/>
              <a:gd name="T103" fmla="*/ 305 h 366"/>
              <a:gd name="T104" fmla="*/ 962 w 1613"/>
              <a:gd name="T105" fmla="*/ 305 h 366"/>
              <a:gd name="T106" fmla="*/ 978 w 1613"/>
              <a:gd name="T107" fmla="*/ 305 h 366"/>
              <a:gd name="T108" fmla="*/ 997 w 1613"/>
              <a:gd name="T109" fmla="*/ 305 h 366"/>
              <a:gd name="T110" fmla="*/ 1015 w 1613"/>
              <a:gd name="T111" fmla="*/ 305 h 366"/>
              <a:gd name="T112" fmla="*/ 1034 w 1613"/>
              <a:gd name="T113" fmla="*/ 305 h 366"/>
              <a:gd name="T114" fmla="*/ 1064 w 1613"/>
              <a:gd name="T115" fmla="*/ 165 h 366"/>
              <a:gd name="T116" fmla="*/ 1099 w 1613"/>
              <a:gd name="T117" fmla="*/ 0 h 366"/>
              <a:gd name="T118" fmla="*/ 1125 w 1613"/>
              <a:gd name="T119" fmla="*/ 0 h 366"/>
              <a:gd name="T120" fmla="*/ 1159 w 1613"/>
              <a:gd name="T121" fmla="*/ 0 h 366"/>
              <a:gd name="T122" fmla="*/ 1613 w 1613"/>
              <a:gd name="T123" fmla="*/ 0 h 3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613" h="366">
                <a:moveTo>
                  <a:pt x="0" y="366"/>
                </a:moveTo>
                <a:lnTo>
                  <a:pt x="78" y="366"/>
                </a:lnTo>
                <a:lnTo>
                  <a:pt x="82" y="366"/>
                </a:lnTo>
                <a:lnTo>
                  <a:pt x="88" y="366"/>
                </a:lnTo>
                <a:lnTo>
                  <a:pt x="95" y="366"/>
                </a:lnTo>
                <a:lnTo>
                  <a:pt x="101" y="366"/>
                </a:lnTo>
                <a:lnTo>
                  <a:pt x="107" y="366"/>
                </a:lnTo>
                <a:lnTo>
                  <a:pt x="115" y="366"/>
                </a:lnTo>
                <a:lnTo>
                  <a:pt x="119" y="366"/>
                </a:lnTo>
                <a:lnTo>
                  <a:pt x="126" y="366"/>
                </a:lnTo>
                <a:lnTo>
                  <a:pt x="130" y="366"/>
                </a:lnTo>
                <a:lnTo>
                  <a:pt x="137" y="366"/>
                </a:lnTo>
                <a:lnTo>
                  <a:pt x="142" y="366"/>
                </a:lnTo>
                <a:lnTo>
                  <a:pt x="148" y="366"/>
                </a:lnTo>
                <a:lnTo>
                  <a:pt x="154" y="363"/>
                </a:lnTo>
                <a:lnTo>
                  <a:pt x="160" y="363"/>
                </a:lnTo>
                <a:lnTo>
                  <a:pt x="166" y="363"/>
                </a:lnTo>
                <a:lnTo>
                  <a:pt x="169" y="362"/>
                </a:lnTo>
                <a:lnTo>
                  <a:pt x="172" y="362"/>
                </a:lnTo>
                <a:lnTo>
                  <a:pt x="178" y="362"/>
                </a:lnTo>
                <a:lnTo>
                  <a:pt x="184" y="362"/>
                </a:lnTo>
                <a:lnTo>
                  <a:pt x="192" y="360"/>
                </a:lnTo>
                <a:lnTo>
                  <a:pt x="196" y="359"/>
                </a:lnTo>
                <a:lnTo>
                  <a:pt x="202" y="359"/>
                </a:lnTo>
                <a:lnTo>
                  <a:pt x="210" y="359"/>
                </a:lnTo>
                <a:lnTo>
                  <a:pt x="214" y="358"/>
                </a:lnTo>
                <a:lnTo>
                  <a:pt x="221" y="358"/>
                </a:lnTo>
                <a:lnTo>
                  <a:pt x="226" y="358"/>
                </a:lnTo>
                <a:lnTo>
                  <a:pt x="232" y="358"/>
                </a:lnTo>
                <a:lnTo>
                  <a:pt x="233" y="356"/>
                </a:lnTo>
                <a:lnTo>
                  <a:pt x="238" y="355"/>
                </a:lnTo>
                <a:lnTo>
                  <a:pt x="244" y="355"/>
                </a:lnTo>
                <a:lnTo>
                  <a:pt x="250" y="355"/>
                </a:lnTo>
                <a:lnTo>
                  <a:pt x="256" y="355"/>
                </a:lnTo>
                <a:lnTo>
                  <a:pt x="263" y="353"/>
                </a:lnTo>
                <a:lnTo>
                  <a:pt x="269" y="353"/>
                </a:lnTo>
                <a:lnTo>
                  <a:pt x="270" y="350"/>
                </a:lnTo>
                <a:lnTo>
                  <a:pt x="275" y="350"/>
                </a:lnTo>
                <a:lnTo>
                  <a:pt x="280" y="345"/>
                </a:lnTo>
                <a:lnTo>
                  <a:pt x="286" y="345"/>
                </a:lnTo>
                <a:lnTo>
                  <a:pt x="286" y="344"/>
                </a:lnTo>
                <a:lnTo>
                  <a:pt x="292" y="342"/>
                </a:lnTo>
                <a:lnTo>
                  <a:pt x="299" y="342"/>
                </a:lnTo>
                <a:lnTo>
                  <a:pt x="305" y="341"/>
                </a:lnTo>
                <a:lnTo>
                  <a:pt x="311" y="339"/>
                </a:lnTo>
                <a:lnTo>
                  <a:pt x="317" y="339"/>
                </a:lnTo>
                <a:lnTo>
                  <a:pt x="322" y="339"/>
                </a:lnTo>
                <a:lnTo>
                  <a:pt x="330" y="339"/>
                </a:lnTo>
                <a:lnTo>
                  <a:pt x="330" y="337"/>
                </a:lnTo>
                <a:lnTo>
                  <a:pt x="335" y="337"/>
                </a:lnTo>
                <a:lnTo>
                  <a:pt x="341" y="337"/>
                </a:lnTo>
                <a:lnTo>
                  <a:pt x="347" y="337"/>
                </a:lnTo>
                <a:lnTo>
                  <a:pt x="352" y="337"/>
                </a:lnTo>
                <a:lnTo>
                  <a:pt x="359" y="337"/>
                </a:lnTo>
                <a:lnTo>
                  <a:pt x="365" y="337"/>
                </a:lnTo>
                <a:lnTo>
                  <a:pt x="372" y="337"/>
                </a:lnTo>
                <a:lnTo>
                  <a:pt x="377" y="337"/>
                </a:lnTo>
                <a:lnTo>
                  <a:pt x="383" y="337"/>
                </a:lnTo>
                <a:lnTo>
                  <a:pt x="389" y="334"/>
                </a:lnTo>
                <a:lnTo>
                  <a:pt x="395" y="334"/>
                </a:lnTo>
                <a:lnTo>
                  <a:pt x="401" y="334"/>
                </a:lnTo>
                <a:lnTo>
                  <a:pt x="401" y="331"/>
                </a:lnTo>
                <a:lnTo>
                  <a:pt x="407" y="331"/>
                </a:lnTo>
                <a:lnTo>
                  <a:pt x="413" y="331"/>
                </a:lnTo>
                <a:lnTo>
                  <a:pt x="419" y="331"/>
                </a:lnTo>
                <a:lnTo>
                  <a:pt x="425" y="331"/>
                </a:lnTo>
                <a:lnTo>
                  <a:pt x="431" y="331"/>
                </a:lnTo>
                <a:lnTo>
                  <a:pt x="437" y="331"/>
                </a:lnTo>
                <a:lnTo>
                  <a:pt x="443" y="330"/>
                </a:lnTo>
                <a:lnTo>
                  <a:pt x="449" y="330"/>
                </a:lnTo>
                <a:lnTo>
                  <a:pt x="455" y="327"/>
                </a:lnTo>
                <a:lnTo>
                  <a:pt x="461" y="327"/>
                </a:lnTo>
                <a:lnTo>
                  <a:pt x="467" y="327"/>
                </a:lnTo>
                <a:lnTo>
                  <a:pt x="473" y="327"/>
                </a:lnTo>
                <a:lnTo>
                  <a:pt x="479" y="327"/>
                </a:lnTo>
                <a:lnTo>
                  <a:pt x="486" y="327"/>
                </a:lnTo>
                <a:lnTo>
                  <a:pt x="491" y="327"/>
                </a:lnTo>
                <a:lnTo>
                  <a:pt x="496" y="325"/>
                </a:lnTo>
                <a:lnTo>
                  <a:pt x="498" y="325"/>
                </a:lnTo>
                <a:lnTo>
                  <a:pt x="504" y="325"/>
                </a:lnTo>
                <a:lnTo>
                  <a:pt x="509" y="325"/>
                </a:lnTo>
                <a:lnTo>
                  <a:pt x="515" y="325"/>
                </a:lnTo>
                <a:lnTo>
                  <a:pt x="521" y="325"/>
                </a:lnTo>
                <a:lnTo>
                  <a:pt x="527" y="325"/>
                </a:lnTo>
                <a:lnTo>
                  <a:pt x="534" y="325"/>
                </a:lnTo>
                <a:lnTo>
                  <a:pt x="539" y="325"/>
                </a:lnTo>
                <a:lnTo>
                  <a:pt x="545" y="325"/>
                </a:lnTo>
                <a:lnTo>
                  <a:pt x="551" y="325"/>
                </a:lnTo>
                <a:lnTo>
                  <a:pt x="557" y="325"/>
                </a:lnTo>
                <a:lnTo>
                  <a:pt x="564" y="325"/>
                </a:lnTo>
                <a:lnTo>
                  <a:pt x="569" y="325"/>
                </a:lnTo>
                <a:lnTo>
                  <a:pt x="575" y="325"/>
                </a:lnTo>
                <a:lnTo>
                  <a:pt x="581" y="325"/>
                </a:lnTo>
                <a:lnTo>
                  <a:pt x="587" y="322"/>
                </a:lnTo>
                <a:lnTo>
                  <a:pt x="589" y="319"/>
                </a:lnTo>
                <a:lnTo>
                  <a:pt x="593" y="319"/>
                </a:lnTo>
                <a:lnTo>
                  <a:pt x="600" y="319"/>
                </a:lnTo>
                <a:lnTo>
                  <a:pt x="605" y="319"/>
                </a:lnTo>
                <a:lnTo>
                  <a:pt x="612" y="319"/>
                </a:lnTo>
                <a:lnTo>
                  <a:pt x="618" y="319"/>
                </a:lnTo>
                <a:lnTo>
                  <a:pt x="625" y="319"/>
                </a:lnTo>
                <a:lnTo>
                  <a:pt x="631" y="319"/>
                </a:lnTo>
                <a:lnTo>
                  <a:pt x="635" y="319"/>
                </a:lnTo>
                <a:lnTo>
                  <a:pt x="642" y="319"/>
                </a:lnTo>
                <a:lnTo>
                  <a:pt x="648" y="319"/>
                </a:lnTo>
                <a:lnTo>
                  <a:pt x="654" y="319"/>
                </a:lnTo>
                <a:lnTo>
                  <a:pt x="659" y="319"/>
                </a:lnTo>
                <a:lnTo>
                  <a:pt x="665" y="319"/>
                </a:lnTo>
                <a:lnTo>
                  <a:pt x="671" y="319"/>
                </a:lnTo>
                <a:lnTo>
                  <a:pt x="678" y="319"/>
                </a:lnTo>
                <a:lnTo>
                  <a:pt x="684" y="319"/>
                </a:lnTo>
                <a:lnTo>
                  <a:pt x="690" y="319"/>
                </a:lnTo>
                <a:lnTo>
                  <a:pt x="698" y="319"/>
                </a:lnTo>
                <a:lnTo>
                  <a:pt x="701" y="319"/>
                </a:lnTo>
                <a:lnTo>
                  <a:pt x="707" y="315"/>
                </a:lnTo>
                <a:lnTo>
                  <a:pt x="715" y="315"/>
                </a:lnTo>
                <a:lnTo>
                  <a:pt x="715" y="311"/>
                </a:lnTo>
                <a:lnTo>
                  <a:pt x="720" y="311"/>
                </a:lnTo>
                <a:lnTo>
                  <a:pt x="726" y="311"/>
                </a:lnTo>
                <a:lnTo>
                  <a:pt x="731" y="311"/>
                </a:lnTo>
                <a:lnTo>
                  <a:pt x="737" y="311"/>
                </a:lnTo>
                <a:lnTo>
                  <a:pt x="744" y="311"/>
                </a:lnTo>
                <a:lnTo>
                  <a:pt x="750" y="311"/>
                </a:lnTo>
                <a:lnTo>
                  <a:pt x="756" y="311"/>
                </a:lnTo>
                <a:lnTo>
                  <a:pt x="761" y="311"/>
                </a:lnTo>
                <a:lnTo>
                  <a:pt x="768" y="311"/>
                </a:lnTo>
                <a:lnTo>
                  <a:pt x="774" y="311"/>
                </a:lnTo>
                <a:lnTo>
                  <a:pt x="780" y="311"/>
                </a:lnTo>
                <a:lnTo>
                  <a:pt x="787" y="311"/>
                </a:lnTo>
                <a:lnTo>
                  <a:pt x="792" y="311"/>
                </a:lnTo>
                <a:lnTo>
                  <a:pt x="795" y="305"/>
                </a:lnTo>
                <a:lnTo>
                  <a:pt x="798" y="305"/>
                </a:lnTo>
                <a:lnTo>
                  <a:pt x="804" y="305"/>
                </a:lnTo>
                <a:lnTo>
                  <a:pt x="810" y="305"/>
                </a:lnTo>
                <a:lnTo>
                  <a:pt x="817" y="305"/>
                </a:lnTo>
                <a:lnTo>
                  <a:pt x="822" y="305"/>
                </a:lnTo>
                <a:lnTo>
                  <a:pt x="828" y="305"/>
                </a:lnTo>
                <a:lnTo>
                  <a:pt x="834" y="305"/>
                </a:lnTo>
                <a:lnTo>
                  <a:pt x="841" y="305"/>
                </a:lnTo>
                <a:lnTo>
                  <a:pt x="846" y="305"/>
                </a:lnTo>
                <a:lnTo>
                  <a:pt x="852" y="305"/>
                </a:lnTo>
                <a:lnTo>
                  <a:pt x="858" y="305"/>
                </a:lnTo>
                <a:lnTo>
                  <a:pt x="864" y="305"/>
                </a:lnTo>
                <a:lnTo>
                  <a:pt x="871" y="305"/>
                </a:lnTo>
                <a:lnTo>
                  <a:pt x="876" y="305"/>
                </a:lnTo>
                <a:lnTo>
                  <a:pt x="882" y="305"/>
                </a:lnTo>
                <a:lnTo>
                  <a:pt x="889" y="305"/>
                </a:lnTo>
                <a:lnTo>
                  <a:pt x="894" y="305"/>
                </a:lnTo>
                <a:lnTo>
                  <a:pt x="901" y="305"/>
                </a:lnTo>
                <a:lnTo>
                  <a:pt x="907" y="305"/>
                </a:lnTo>
                <a:lnTo>
                  <a:pt x="912" y="305"/>
                </a:lnTo>
                <a:lnTo>
                  <a:pt x="920" y="305"/>
                </a:lnTo>
                <a:lnTo>
                  <a:pt x="926" y="305"/>
                </a:lnTo>
                <a:lnTo>
                  <a:pt x="930" y="305"/>
                </a:lnTo>
                <a:lnTo>
                  <a:pt x="936" y="305"/>
                </a:lnTo>
                <a:lnTo>
                  <a:pt x="944" y="305"/>
                </a:lnTo>
                <a:lnTo>
                  <a:pt x="950" y="305"/>
                </a:lnTo>
                <a:lnTo>
                  <a:pt x="954" y="305"/>
                </a:lnTo>
                <a:lnTo>
                  <a:pt x="962" y="305"/>
                </a:lnTo>
                <a:lnTo>
                  <a:pt x="971" y="305"/>
                </a:lnTo>
                <a:lnTo>
                  <a:pt x="974" y="305"/>
                </a:lnTo>
                <a:lnTo>
                  <a:pt x="978" y="305"/>
                </a:lnTo>
                <a:lnTo>
                  <a:pt x="986" y="305"/>
                </a:lnTo>
                <a:lnTo>
                  <a:pt x="991" y="305"/>
                </a:lnTo>
                <a:lnTo>
                  <a:pt x="997" y="305"/>
                </a:lnTo>
                <a:lnTo>
                  <a:pt x="1005" y="305"/>
                </a:lnTo>
                <a:lnTo>
                  <a:pt x="1008" y="305"/>
                </a:lnTo>
                <a:lnTo>
                  <a:pt x="1015" y="305"/>
                </a:lnTo>
                <a:lnTo>
                  <a:pt x="1021" y="305"/>
                </a:lnTo>
                <a:lnTo>
                  <a:pt x="1030" y="305"/>
                </a:lnTo>
                <a:lnTo>
                  <a:pt x="1034" y="305"/>
                </a:lnTo>
                <a:lnTo>
                  <a:pt x="1051" y="305"/>
                </a:lnTo>
                <a:lnTo>
                  <a:pt x="1051" y="165"/>
                </a:lnTo>
                <a:lnTo>
                  <a:pt x="1064" y="165"/>
                </a:lnTo>
                <a:lnTo>
                  <a:pt x="1069" y="165"/>
                </a:lnTo>
                <a:lnTo>
                  <a:pt x="1099" y="165"/>
                </a:lnTo>
                <a:lnTo>
                  <a:pt x="1099" y="0"/>
                </a:lnTo>
                <a:lnTo>
                  <a:pt x="1114" y="0"/>
                </a:lnTo>
                <a:lnTo>
                  <a:pt x="1119" y="0"/>
                </a:lnTo>
                <a:lnTo>
                  <a:pt x="1125" y="0"/>
                </a:lnTo>
                <a:lnTo>
                  <a:pt x="1131" y="0"/>
                </a:lnTo>
                <a:lnTo>
                  <a:pt x="1144" y="0"/>
                </a:lnTo>
                <a:lnTo>
                  <a:pt x="1159" y="0"/>
                </a:lnTo>
                <a:lnTo>
                  <a:pt x="1240" y="0"/>
                </a:lnTo>
                <a:lnTo>
                  <a:pt x="1492" y="0"/>
                </a:lnTo>
                <a:lnTo>
                  <a:pt x="1613" y="0"/>
                </a:lnTo>
              </a:path>
            </a:pathLst>
          </a:custGeom>
          <a:noFill/>
          <a:ln w="3810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Freeform 22">
            <a:extLst>
              <a:ext uri="{FF2B5EF4-FFF2-40B4-BE49-F238E27FC236}">
                <a16:creationId xmlns:a16="http://schemas.microsoft.com/office/drawing/2014/main" id="{43D77FFC-4DAB-9A48-A21C-B2A692BD1DD1}"/>
              </a:ext>
            </a:extLst>
          </p:cNvPr>
          <p:cNvSpPr>
            <a:spLocks/>
          </p:cNvSpPr>
          <p:nvPr/>
        </p:nvSpPr>
        <p:spPr bwMode="auto">
          <a:xfrm>
            <a:off x="2274019" y="4043152"/>
            <a:ext cx="5541522" cy="1268905"/>
          </a:xfrm>
          <a:custGeom>
            <a:avLst/>
            <a:gdLst>
              <a:gd name="T0" fmla="*/ 165 w 1567"/>
              <a:gd name="T1" fmla="*/ 350 h 352"/>
              <a:gd name="T2" fmla="*/ 213 w 1567"/>
              <a:gd name="T3" fmla="*/ 350 h 352"/>
              <a:gd name="T4" fmla="*/ 228 w 1567"/>
              <a:gd name="T5" fmla="*/ 348 h 352"/>
              <a:gd name="T6" fmla="*/ 282 w 1567"/>
              <a:gd name="T7" fmla="*/ 346 h 352"/>
              <a:gd name="T8" fmla="*/ 308 w 1567"/>
              <a:gd name="T9" fmla="*/ 343 h 352"/>
              <a:gd name="T10" fmla="*/ 322 w 1567"/>
              <a:gd name="T11" fmla="*/ 342 h 352"/>
              <a:gd name="T12" fmla="*/ 349 w 1567"/>
              <a:gd name="T13" fmla="*/ 339 h 352"/>
              <a:gd name="T14" fmla="*/ 365 w 1567"/>
              <a:gd name="T15" fmla="*/ 337 h 352"/>
              <a:gd name="T16" fmla="*/ 383 w 1567"/>
              <a:gd name="T17" fmla="*/ 335 h 352"/>
              <a:gd name="T18" fmla="*/ 402 w 1567"/>
              <a:gd name="T19" fmla="*/ 335 h 352"/>
              <a:gd name="T20" fmla="*/ 419 w 1567"/>
              <a:gd name="T21" fmla="*/ 333 h 352"/>
              <a:gd name="T22" fmla="*/ 439 w 1567"/>
              <a:gd name="T23" fmla="*/ 333 h 352"/>
              <a:gd name="T24" fmla="*/ 450 w 1567"/>
              <a:gd name="T25" fmla="*/ 331 h 352"/>
              <a:gd name="T26" fmla="*/ 467 w 1567"/>
              <a:gd name="T27" fmla="*/ 328 h 352"/>
              <a:gd name="T28" fmla="*/ 479 w 1567"/>
              <a:gd name="T29" fmla="*/ 324 h 352"/>
              <a:gd name="T30" fmla="*/ 498 w 1567"/>
              <a:gd name="T31" fmla="*/ 319 h 352"/>
              <a:gd name="T32" fmla="*/ 521 w 1567"/>
              <a:gd name="T33" fmla="*/ 319 h 352"/>
              <a:gd name="T34" fmla="*/ 534 w 1567"/>
              <a:gd name="T35" fmla="*/ 317 h 352"/>
              <a:gd name="T36" fmla="*/ 551 w 1567"/>
              <a:gd name="T37" fmla="*/ 314 h 352"/>
              <a:gd name="T38" fmla="*/ 571 w 1567"/>
              <a:gd name="T39" fmla="*/ 314 h 352"/>
              <a:gd name="T40" fmla="*/ 587 w 1567"/>
              <a:gd name="T41" fmla="*/ 314 h 352"/>
              <a:gd name="T42" fmla="*/ 599 w 1567"/>
              <a:gd name="T43" fmla="*/ 312 h 352"/>
              <a:gd name="T44" fmla="*/ 618 w 1567"/>
              <a:gd name="T45" fmla="*/ 312 h 352"/>
              <a:gd name="T46" fmla="*/ 635 w 1567"/>
              <a:gd name="T47" fmla="*/ 309 h 352"/>
              <a:gd name="T48" fmla="*/ 648 w 1567"/>
              <a:gd name="T49" fmla="*/ 306 h 352"/>
              <a:gd name="T50" fmla="*/ 667 w 1567"/>
              <a:gd name="T51" fmla="*/ 303 h 352"/>
              <a:gd name="T52" fmla="*/ 678 w 1567"/>
              <a:gd name="T53" fmla="*/ 296 h 352"/>
              <a:gd name="T54" fmla="*/ 690 w 1567"/>
              <a:gd name="T55" fmla="*/ 293 h 352"/>
              <a:gd name="T56" fmla="*/ 707 w 1567"/>
              <a:gd name="T57" fmla="*/ 293 h 352"/>
              <a:gd name="T58" fmla="*/ 726 w 1567"/>
              <a:gd name="T59" fmla="*/ 289 h 352"/>
              <a:gd name="T60" fmla="*/ 738 w 1567"/>
              <a:gd name="T61" fmla="*/ 285 h 352"/>
              <a:gd name="T62" fmla="*/ 756 w 1567"/>
              <a:gd name="T63" fmla="*/ 285 h 352"/>
              <a:gd name="T64" fmla="*/ 773 w 1567"/>
              <a:gd name="T65" fmla="*/ 279 h 352"/>
              <a:gd name="T66" fmla="*/ 786 w 1567"/>
              <a:gd name="T67" fmla="*/ 279 h 352"/>
              <a:gd name="T68" fmla="*/ 804 w 1567"/>
              <a:gd name="T69" fmla="*/ 279 h 352"/>
              <a:gd name="T70" fmla="*/ 823 w 1567"/>
              <a:gd name="T71" fmla="*/ 279 h 352"/>
              <a:gd name="T72" fmla="*/ 835 w 1567"/>
              <a:gd name="T73" fmla="*/ 270 h 352"/>
              <a:gd name="T74" fmla="*/ 846 w 1567"/>
              <a:gd name="T75" fmla="*/ 260 h 352"/>
              <a:gd name="T76" fmla="*/ 854 w 1567"/>
              <a:gd name="T77" fmla="*/ 240 h 352"/>
              <a:gd name="T78" fmla="*/ 870 w 1567"/>
              <a:gd name="T79" fmla="*/ 240 h 352"/>
              <a:gd name="T80" fmla="*/ 882 w 1567"/>
              <a:gd name="T81" fmla="*/ 227 h 352"/>
              <a:gd name="T82" fmla="*/ 900 w 1567"/>
              <a:gd name="T83" fmla="*/ 227 h 352"/>
              <a:gd name="T84" fmla="*/ 920 w 1567"/>
              <a:gd name="T85" fmla="*/ 227 h 352"/>
              <a:gd name="T86" fmla="*/ 937 w 1567"/>
              <a:gd name="T87" fmla="*/ 227 h 352"/>
              <a:gd name="T88" fmla="*/ 955 w 1567"/>
              <a:gd name="T89" fmla="*/ 227 h 352"/>
              <a:gd name="T90" fmla="*/ 974 w 1567"/>
              <a:gd name="T91" fmla="*/ 227 h 352"/>
              <a:gd name="T92" fmla="*/ 999 w 1567"/>
              <a:gd name="T93" fmla="*/ 227 h 352"/>
              <a:gd name="T94" fmla="*/ 1014 w 1567"/>
              <a:gd name="T95" fmla="*/ 227 h 352"/>
              <a:gd name="T96" fmla="*/ 1036 w 1567"/>
              <a:gd name="T97" fmla="*/ 227 h 352"/>
              <a:gd name="T98" fmla="*/ 1061 w 1567"/>
              <a:gd name="T99" fmla="*/ 227 h 352"/>
              <a:gd name="T100" fmla="*/ 1103 w 1567"/>
              <a:gd name="T101" fmla="*/ 227 h 352"/>
              <a:gd name="T102" fmla="*/ 1120 w 1567"/>
              <a:gd name="T103" fmla="*/ 227 h 352"/>
              <a:gd name="T104" fmla="*/ 1141 w 1567"/>
              <a:gd name="T105" fmla="*/ 227 h 352"/>
              <a:gd name="T106" fmla="*/ 1166 w 1567"/>
              <a:gd name="T107" fmla="*/ 227 h 352"/>
              <a:gd name="T108" fmla="*/ 1193 w 1567"/>
              <a:gd name="T109" fmla="*/ 227 h 352"/>
              <a:gd name="T110" fmla="*/ 1225 w 1567"/>
              <a:gd name="T111" fmla="*/ 227 h 352"/>
              <a:gd name="T112" fmla="*/ 1245 w 1567"/>
              <a:gd name="T113" fmla="*/ 227 h 352"/>
              <a:gd name="T114" fmla="*/ 1265 w 1567"/>
              <a:gd name="T115" fmla="*/ 0 h 352"/>
              <a:gd name="T116" fmla="*/ 1324 w 1567"/>
              <a:gd name="T117" fmla="*/ 0 h 352"/>
              <a:gd name="T118" fmla="*/ 1526 w 1567"/>
              <a:gd name="T119" fmla="*/ 0 h 3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567" h="352">
                <a:moveTo>
                  <a:pt x="0" y="352"/>
                </a:moveTo>
                <a:lnTo>
                  <a:pt x="138" y="352"/>
                </a:lnTo>
                <a:lnTo>
                  <a:pt x="165" y="350"/>
                </a:lnTo>
                <a:lnTo>
                  <a:pt x="166" y="350"/>
                </a:lnTo>
                <a:lnTo>
                  <a:pt x="191" y="350"/>
                </a:lnTo>
                <a:lnTo>
                  <a:pt x="213" y="350"/>
                </a:lnTo>
                <a:lnTo>
                  <a:pt x="216" y="350"/>
                </a:lnTo>
                <a:lnTo>
                  <a:pt x="216" y="348"/>
                </a:lnTo>
                <a:lnTo>
                  <a:pt x="228" y="348"/>
                </a:lnTo>
                <a:lnTo>
                  <a:pt x="254" y="348"/>
                </a:lnTo>
                <a:lnTo>
                  <a:pt x="259" y="346"/>
                </a:lnTo>
                <a:lnTo>
                  <a:pt x="282" y="346"/>
                </a:lnTo>
                <a:lnTo>
                  <a:pt x="288" y="343"/>
                </a:lnTo>
                <a:lnTo>
                  <a:pt x="299" y="343"/>
                </a:lnTo>
                <a:lnTo>
                  <a:pt x="308" y="343"/>
                </a:lnTo>
                <a:lnTo>
                  <a:pt x="315" y="343"/>
                </a:lnTo>
                <a:lnTo>
                  <a:pt x="317" y="343"/>
                </a:lnTo>
                <a:lnTo>
                  <a:pt x="322" y="342"/>
                </a:lnTo>
                <a:lnTo>
                  <a:pt x="325" y="342"/>
                </a:lnTo>
                <a:lnTo>
                  <a:pt x="342" y="342"/>
                </a:lnTo>
                <a:lnTo>
                  <a:pt x="349" y="339"/>
                </a:lnTo>
                <a:lnTo>
                  <a:pt x="353" y="337"/>
                </a:lnTo>
                <a:lnTo>
                  <a:pt x="358" y="337"/>
                </a:lnTo>
                <a:lnTo>
                  <a:pt x="365" y="337"/>
                </a:lnTo>
                <a:lnTo>
                  <a:pt x="378" y="337"/>
                </a:lnTo>
                <a:lnTo>
                  <a:pt x="378" y="335"/>
                </a:lnTo>
                <a:lnTo>
                  <a:pt x="383" y="335"/>
                </a:lnTo>
                <a:lnTo>
                  <a:pt x="389" y="335"/>
                </a:lnTo>
                <a:lnTo>
                  <a:pt x="398" y="335"/>
                </a:lnTo>
                <a:lnTo>
                  <a:pt x="402" y="335"/>
                </a:lnTo>
                <a:lnTo>
                  <a:pt x="407" y="335"/>
                </a:lnTo>
                <a:lnTo>
                  <a:pt x="417" y="335"/>
                </a:lnTo>
                <a:lnTo>
                  <a:pt x="419" y="333"/>
                </a:lnTo>
                <a:lnTo>
                  <a:pt x="425" y="333"/>
                </a:lnTo>
                <a:lnTo>
                  <a:pt x="432" y="333"/>
                </a:lnTo>
                <a:lnTo>
                  <a:pt x="439" y="333"/>
                </a:lnTo>
                <a:lnTo>
                  <a:pt x="445" y="333"/>
                </a:lnTo>
                <a:lnTo>
                  <a:pt x="450" y="333"/>
                </a:lnTo>
                <a:lnTo>
                  <a:pt x="450" y="331"/>
                </a:lnTo>
                <a:lnTo>
                  <a:pt x="457" y="331"/>
                </a:lnTo>
                <a:lnTo>
                  <a:pt x="464" y="328"/>
                </a:lnTo>
                <a:lnTo>
                  <a:pt x="467" y="328"/>
                </a:lnTo>
                <a:lnTo>
                  <a:pt x="474" y="328"/>
                </a:lnTo>
                <a:lnTo>
                  <a:pt x="479" y="326"/>
                </a:lnTo>
                <a:lnTo>
                  <a:pt x="479" y="324"/>
                </a:lnTo>
                <a:lnTo>
                  <a:pt x="484" y="319"/>
                </a:lnTo>
                <a:lnTo>
                  <a:pt x="493" y="319"/>
                </a:lnTo>
                <a:lnTo>
                  <a:pt x="498" y="319"/>
                </a:lnTo>
                <a:lnTo>
                  <a:pt x="509" y="319"/>
                </a:lnTo>
                <a:lnTo>
                  <a:pt x="515" y="319"/>
                </a:lnTo>
                <a:lnTo>
                  <a:pt x="521" y="319"/>
                </a:lnTo>
                <a:lnTo>
                  <a:pt x="522" y="317"/>
                </a:lnTo>
                <a:lnTo>
                  <a:pt x="528" y="317"/>
                </a:lnTo>
                <a:lnTo>
                  <a:pt x="534" y="317"/>
                </a:lnTo>
                <a:lnTo>
                  <a:pt x="542" y="314"/>
                </a:lnTo>
                <a:lnTo>
                  <a:pt x="545" y="314"/>
                </a:lnTo>
                <a:lnTo>
                  <a:pt x="551" y="314"/>
                </a:lnTo>
                <a:lnTo>
                  <a:pt x="557" y="314"/>
                </a:lnTo>
                <a:lnTo>
                  <a:pt x="564" y="314"/>
                </a:lnTo>
                <a:lnTo>
                  <a:pt x="571" y="314"/>
                </a:lnTo>
                <a:lnTo>
                  <a:pt x="575" y="314"/>
                </a:lnTo>
                <a:lnTo>
                  <a:pt x="582" y="314"/>
                </a:lnTo>
                <a:lnTo>
                  <a:pt x="587" y="314"/>
                </a:lnTo>
                <a:lnTo>
                  <a:pt x="593" y="314"/>
                </a:lnTo>
                <a:lnTo>
                  <a:pt x="595" y="312"/>
                </a:lnTo>
                <a:lnTo>
                  <a:pt x="599" y="312"/>
                </a:lnTo>
                <a:lnTo>
                  <a:pt x="606" y="312"/>
                </a:lnTo>
                <a:lnTo>
                  <a:pt x="612" y="312"/>
                </a:lnTo>
                <a:lnTo>
                  <a:pt x="618" y="312"/>
                </a:lnTo>
                <a:lnTo>
                  <a:pt x="623" y="312"/>
                </a:lnTo>
                <a:lnTo>
                  <a:pt x="629" y="309"/>
                </a:lnTo>
                <a:lnTo>
                  <a:pt x="635" y="309"/>
                </a:lnTo>
                <a:lnTo>
                  <a:pt x="642" y="309"/>
                </a:lnTo>
                <a:lnTo>
                  <a:pt x="647" y="306"/>
                </a:lnTo>
                <a:lnTo>
                  <a:pt x="648" y="306"/>
                </a:lnTo>
                <a:lnTo>
                  <a:pt x="654" y="306"/>
                </a:lnTo>
                <a:lnTo>
                  <a:pt x="660" y="306"/>
                </a:lnTo>
                <a:lnTo>
                  <a:pt x="667" y="303"/>
                </a:lnTo>
                <a:lnTo>
                  <a:pt x="672" y="303"/>
                </a:lnTo>
                <a:lnTo>
                  <a:pt x="674" y="300"/>
                </a:lnTo>
                <a:lnTo>
                  <a:pt x="678" y="296"/>
                </a:lnTo>
                <a:lnTo>
                  <a:pt x="683" y="293"/>
                </a:lnTo>
                <a:lnTo>
                  <a:pt x="684" y="293"/>
                </a:lnTo>
                <a:lnTo>
                  <a:pt x="690" y="293"/>
                </a:lnTo>
                <a:lnTo>
                  <a:pt x="695" y="293"/>
                </a:lnTo>
                <a:lnTo>
                  <a:pt x="701" y="293"/>
                </a:lnTo>
                <a:lnTo>
                  <a:pt x="707" y="293"/>
                </a:lnTo>
                <a:lnTo>
                  <a:pt x="714" y="293"/>
                </a:lnTo>
                <a:lnTo>
                  <a:pt x="720" y="289"/>
                </a:lnTo>
                <a:lnTo>
                  <a:pt x="726" y="289"/>
                </a:lnTo>
                <a:lnTo>
                  <a:pt x="731" y="289"/>
                </a:lnTo>
                <a:lnTo>
                  <a:pt x="737" y="289"/>
                </a:lnTo>
                <a:lnTo>
                  <a:pt x="738" y="285"/>
                </a:lnTo>
                <a:lnTo>
                  <a:pt x="744" y="285"/>
                </a:lnTo>
                <a:lnTo>
                  <a:pt x="751" y="285"/>
                </a:lnTo>
                <a:lnTo>
                  <a:pt x="756" y="285"/>
                </a:lnTo>
                <a:lnTo>
                  <a:pt x="761" y="285"/>
                </a:lnTo>
                <a:lnTo>
                  <a:pt x="768" y="285"/>
                </a:lnTo>
                <a:lnTo>
                  <a:pt x="773" y="279"/>
                </a:lnTo>
                <a:lnTo>
                  <a:pt x="774" y="279"/>
                </a:lnTo>
                <a:lnTo>
                  <a:pt x="780" y="279"/>
                </a:lnTo>
                <a:lnTo>
                  <a:pt x="786" y="279"/>
                </a:lnTo>
                <a:lnTo>
                  <a:pt x="792" y="279"/>
                </a:lnTo>
                <a:lnTo>
                  <a:pt x="798" y="279"/>
                </a:lnTo>
                <a:lnTo>
                  <a:pt x="804" y="279"/>
                </a:lnTo>
                <a:lnTo>
                  <a:pt x="810" y="279"/>
                </a:lnTo>
                <a:lnTo>
                  <a:pt x="816" y="279"/>
                </a:lnTo>
                <a:lnTo>
                  <a:pt x="823" y="279"/>
                </a:lnTo>
                <a:lnTo>
                  <a:pt x="824" y="270"/>
                </a:lnTo>
                <a:lnTo>
                  <a:pt x="829" y="270"/>
                </a:lnTo>
                <a:lnTo>
                  <a:pt x="835" y="270"/>
                </a:lnTo>
                <a:lnTo>
                  <a:pt x="841" y="270"/>
                </a:lnTo>
                <a:lnTo>
                  <a:pt x="844" y="260"/>
                </a:lnTo>
                <a:lnTo>
                  <a:pt x="846" y="260"/>
                </a:lnTo>
                <a:lnTo>
                  <a:pt x="846" y="250"/>
                </a:lnTo>
                <a:lnTo>
                  <a:pt x="852" y="250"/>
                </a:lnTo>
                <a:lnTo>
                  <a:pt x="854" y="240"/>
                </a:lnTo>
                <a:lnTo>
                  <a:pt x="860" y="240"/>
                </a:lnTo>
                <a:lnTo>
                  <a:pt x="864" y="240"/>
                </a:lnTo>
                <a:lnTo>
                  <a:pt x="870" y="240"/>
                </a:lnTo>
                <a:lnTo>
                  <a:pt x="870" y="227"/>
                </a:lnTo>
                <a:lnTo>
                  <a:pt x="878" y="227"/>
                </a:lnTo>
                <a:lnTo>
                  <a:pt x="882" y="227"/>
                </a:lnTo>
                <a:lnTo>
                  <a:pt x="888" y="227"/>
                </a:lnTo>
                <a:lnTo>
                  <a:pt x="894" y="227"/>
                </a:lnTo>
                <a:lnTo>
                  <a:pt x="900" y="227"/>
                </a:lnTo>
                <a:lnTo>
                  <a:pt x="906" y="227"/>
                </a:lnTo>
                <a:lnTo>
                  <a:pt x="913" y="227"/>
                </a:lnTo>
                <a:lnTo>
                  <a:pt x="920" y="227"/>
                </a:lnTo>
                <a:lnTo>
                  <a:pt x="927" y="227"/>
                </a:lnTo>
                <a:lnTo>
                  <a:pt x="932" y="227"/>
                </a:lnTo>
                <a:lnTo>
                  <a:pt x="937" y="227"/>
                </a:lnTo>
                <a:lnTo>
                  <a:pt x="942" y="227"/>
                </a:lnTo>
                <a:lnTo>
                  <a:pt x="951" y="227"/>
                </a:lnTo>
                <a:lnTo>
                  <a:pt x="955" y="227"/>
                </a:lnTo>
                <a:lnTo>
                  <a:pt x="961" y="227"/>
                </a:lnTo>
                <a:lnTo>
                  <a:pt x="969" y="227"/>
                </a:lnTo>
                <a:lnTo>
                  <a:pt x="974" y="227"/>
                </a:lnTo>
                <a:lnTo>
                  <a:pt x="990" y="227"/>
                </a:lnTo>
                <a:lnTo>
                  <a:pt x="991" y="227"/>
                </a:lnTo>
                <a:lnTo>
                  <a:pt x="999" y="227"/>
                </a:lnTo>
                <a:lnTo>
                  <a:pt x="1006" y="227"/>
                </a:lnTo>
                <a:lnTo>
                  <a:pt x="1008" y="227"/>
                </a:lnTo>
                <a:lnTo>
                  <a:pt x="1014" y="227"/>
                </a:lnTo>
                <a:lnTo>
                  <a:pt x="1024" y="227"/>
                </a:lnTo>
                <a:lnTo>
                  <a:pt x="1028" y="227"/>
                </a:lnTo>
                <a:lnTo>
                  <a:pt x="1036" y="227"/>
                </a:lnTo>
                <a:lnTo>
                  <a:pt x="1041" y="227"/>
                </a:lnTo>
                <a:lnTo>
                  <a:pt x="1047" y="227"/>
                </a:lnTo>
                <a:lnTo>
                  <a:pt x="1061" y="227"/>
                </a:lnTo>
                <a:lnTo>
                  <a:pt x="1063" y="227"/>
                </a:lnTo>
                <a:lnTo>
                  <a:pt x="1081" y="227"/>
                </a:lnTo>
                <a:lnTo>
                  <a:pt x="1103" y="227"/>
                </a:lnTo>
                <a:lnTo>
                  <a:pt x="1106" y="227"/>
                </a:lnTo>
                <a:lnTo>
                  <a:pt x="1114" y="227"/>
                </a:lnTo>
                <a:lnTo>
                  <a:pt x="1120" y="227"/>
                </a:lnTo>
                <a:lnTo>
                  <a:pt x="1127" y="227"/>
                </a:lnTo>
                <a:lnTo>
                  <a:pt x="1139" y="227"/>
                </a:lnTo>
                <a:lnTo>
                  <a:pt x="1141" y="227"/>
                </a:lnTo>
                <a:lnTo>
                  <a:pt x="1150" y="227"/>
                </a:lnTo>
                <a:lnTo>
                  <a:pt x="1164" y="227"/>
                </a:lnTo>
                <a:lnTo>
                  <a:pt x="1166" y="227"/>
                </a:lnTo>
                <a:lnTo>
                  <a:pt x="1171" y="227"/>
                </a:lnTo>
                <a:lnTo>
                  <a:pt x="1180" y="227"/>
                </a:lnTo>
                <a:lnTo>
                  <a:pt x="1193" y="227"/>
                </a:lnTo>
                <a:lnTo>
                  <a:pt x="1203" y="227"/>
                </a:lnTo>
                <a:lnTo>
                  <a:pt x="1214" y="227"/>
                </a:lnTo>
                <a:lnTo>
                  <a:pt x="1225" y="227"/>
                </a:lnTo>
                <a:lnTo>
                  <a:pt x="1233" y="227"/>
                </a:lnTo>
                <a:lnTo>
                  <a:pt x="1237" y="227"/>
                </a:lnTo>
                <a:lnTo>
                  <a:pt x="1245" y="227"/>
                </a:lnTo>
                <a:lnTo>
                  <a:pt x="1250" y="227"/>
                </a:lnTo>
                <a:lnTo>
                  <a:pt x="1265" y="227"/>
                </a:lnTo>
                <a:lnTo>
                  <a:pt x="1265" y="0"/>
                </a:lnTo>
                <a:lnTo>
                  <a:pt x="1300" y="0"/>
                </a:lnTo>
                <a:lnTo>
                  <a:pt x="1312" y="0"/>
                </a:lnTo>
                <a:lnTo>
                  <a:pt x="1324" y="0"/>
                </a:lnTo>
                <a:lnTo>
                  <a:pt x="1337" y="0"/>
                </a:lnTo>
                <a:lnTo>
                  <a:pt x="1387" y="0"/>
                </a:lnTo>
                <a:lnTo>
                  <a:pt x="1526" y="0"/>
                </a:lnTo>
                <a:lnTo>
                  <a:pt x="1543" y="0"/>
                </a:lnTo>
                <a:lnTo>
                  <a:pt x="1567" y="0"/>
                </a:lnTo>
              </a:path>
            </a:pathLst>
          </a:custGeom>
          <a:noFill/>
          <a:ln w="38100" cap="flat">
            <a:solidFill>
              <a:schemeClr val="accent4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Freeform 23">
            <a:extLst>
              <a:ext uri="{FF2B5EF4-FFF2-40B4-BE49-F238E27FC236}">
                <a16:creationId xmlns:a16="http://schemas.microsoft.com/office/drawing/2014/main" id="{0A2D7F92-68C1-2EEE-BFD1-6086B48E83FA}"/>
              </a:ext>
            </a:extLst>
          </p:cNvPr>
          <p:cNvSpPr>
            <a:spLocks/>
          </p:cNvSpPr>
          <p:nvPr/>
        </p:nvSpPr>
        <p:spPr bwMode="auto">
          <a:xfrm>
            <a:off x="2274019" y="3999893"/>
            <a:ext cx="5873944" cy="1312163"/>
          </a:xfrm>
          <a:custGeom>
            <a:avLst/>
            <a:gdLst>
              <a:gd name="T0" fmla="*/ 111 w 1661"/>
              <a:gd name="T1" fmla="*/ 356 h 364"/>
              <a:gd name="T2" fmla="*/ 148 w 1661"/>
              <a:gd name="T3" fmla="*/ 348 h 364"/>
              <a:gd name="T4" fmla="*/ 179 w 1661"/>
              <a:gd name="T5" fmla="*/ 340 h 364"/>
              <a:gd name="T6" fmla="*/ 208 w 1661"/>
              <a:gd name="T7" fmla="*/ 340 h 364"/>
              <a:gd name="T8" fmla="*/ 242 w 1661"/>
              <a:gd name="T9" fmla="*/ 340 h 364"/>
              <a:gd name="T10" fmla="*/ 269 w 1661"/>
              <a:gd name="T11" fmla="*/ 332 h 364"/>
              <a:gd name="T12" fmla="*/ 289 w 1661"/>
              <a:gd name="T13" fmla="*/ 314 h 364"/>
              <a:gd name="T14" fmla="*/ 361 w 1661"/>
              <a:gd name="T15" fmla="*/ 314 h 364"/>
              <a:gd name="T16" fmla="*/ 414 w 1661"/>
              <a:gd name="T17" fmla="*/ 314 h 364"/>
              <a:gd name="T18" fmla="*/ 458 w 1661"/>
              <a:gd name="T19" fmla="*/ 314 h 364"/>
              <a:gd name="T20" fmla="*/ 486 w 1661"/>
              <a:gd name="T21" fmla="*/ 305 h 364"/>
              <a:gd name="T22" fmla="*/ 524 w 1661"/>
              <a:gd name="T23" fmla="*/ 305 h 364"/>
              <a:gd name="T24" fmla="*/ 542 w 1661"/>
              <a:gd name="T25" fmla="*/ 285 h 364"/>
              <a:gd name="T26" fmla="*/ 555 w 1661"/>
              <a:gd name="T27" fmla="*/ 266 h 364"/>
              <a:gd name="T28" fmla="*/ 580 w 1661"/>
              <a:gd name="T29" fmla="*/ 246 h 364"/>
              <a:gd name="T30" fmla="*/ 604 w 1661"/>
              <a:gd name="T31" fmla="*/ 225 h 364"/>
              <a:gd name="T32" fmla="*/ 662 w 1661"/>
              <a:gd name="T33" fmla="*/ 225 h 364"/>
              <a:gd name="T34" fmla="*/ 685 w 1661"/>
              <a:gd name="T35" fmla="*/ 215 h 364"/>
              <a:gd name="T36" fmla="*/ 714 w 1661"/>
              <a:gd name="T37" fmla="*/ 204 h 364"/>
              <a:gd name="T38" fmla="*/ 741 w 1661"/>
              <a:gd name="T39" fmla="*/ 193 h 364"/>
              <a:gd name="T40" fmla="*/ 759 w 1661"/>
              <a:gd name="T41" fmla="*/ 182 h 364"/>
              <a:gd name="T42" fmla="*/ 778 w 1661"/>
              <a:gd name="T43" fmla="*/ 171 h 364"/>
              <a:gd name="T44" fmla="*/ 806 w 1661"/>
              <a:gd name="T45" fmla="*/ 160 h 364"/>
              <a:gd name="T46" fmla="*/ 832 w 1661"/>
              <a:gd name="T47" fmla="*/ 148 h 364"/>
              <a:gd name="T48" fmla="*/ 860 w 1661"/>
              <a:gd name="T49" fmla="*/ 136 h 364"/>
              <a:gd name="T50" fmla="*/ 897 w 1661"/>
              <a:gd name="T51" fmla="*/ 136 h 364"/>
              <a:gd name="T52" fmla="*/ 921 w 1661"/>
              <a:gd name="T53" fmla="*/ 123 h 364"/>
              <a:gd name="T54" fmla="*/ 951 w 1661"/>
              <a:gd name="T55" fmla="*/ 111 h 364"/>
              <a:gd name="T56" fmla="*/ 980 w 1661"/>
              <a:gd name="T57" fmla="*/ 111 h 364"/>
              <a:gd name="T58" fmla="*/ 1003 w 1661"/>
              <a:gd name="T59" fmla="*/ 111 h 364"/>
              <a:gd name="T60" fmla="*/ 1028 w 1661"/>
              <a:gd name="T61" fmla="*/ 111 h 364"/>
              <a:gd name="T62" fmla="*/ 1070 w 1661"/>
              <a:gd name="T63" fmla="*/ 111 h 364"/>
              <a:gd name="T64" fmla="*/ 1099 w 1661"/>
              <a:gd name="T65" fmla="*/ 95 h 364"/>
              <a:gd name="T66" fmla="*/ 1123 w 1661"/>
              <a:gd name="T67" fmla="*/ 79 h 364"/>
              <a:gd name="T68" fmla="*/ 1161 w 1661"/>
              <a:gd name="T69" fmla="*/ 79 h 364"/>
              <a:gd name="T70" fmla="*/ 1203 w 1661"/>
              <a:gd name="T71" fmla="*/ 79 h 364"/>
              <a:gd name="T72" fmla="*/ 1243 w 1661"/>
              <a:gd name="T73" fmla="*/ 79 h 364"/>
              <a:gd name="T74" fmla="*/ 1295 w 1661"/>
              <a:gd name="T75" fmla="*/ 79 h 364"/>
              <a:gd name="T76" fmla="*/ 1322 w 1661"/>
              <a:gd name="T77" fmla="*/ 79 h 364"/>
              <a:gd name="T78" fmla="*/ 1362 w 1661"/>
              <a:gd name="T79" fmla="*/ 79 h 364"/>
              <a:gd name="T80" fmla="*/ 1390 w 1661"/>
              <a:gd name="T81" fmla="*/ 79 h 364"/>
              <a:gd name="T82" fmla="*/ 1435 w 1661"/>
              <a:gd name="T83" fmla="*/ 79 h 364"/>
              <a:gd name="T84" fmla="*/ 1460 w 1661"/>
              <a:gd name="T85" fmla="*/ 79 h 364"/>
              <a:gd name="T86" fmla="*/ 1490 w 1661"/>
              <a:gd name="T87" fmla="*/ 79 h 364"/>
              <a:gd name="T88" fmla="*/ 1526 w 1661"/>
              <a:gd name="T89" fmla="*/ 79 h 364"/>
              <a:gd name="T90" fmla="*/ 1562 w 1661"/>
              <a:gd name="T91" fmla="*/ 79 h 364"/>
              <a:gd name="T92" fmla="*/ 1596 w 1661"/>
              <a:gd name="T93" fmla="*/ 79 h 364"/>
              <a:gd name="T94" fmla="*/ 1618 w 1661"/>
              <a:gd name="T95" fmla="*/ 0 h 3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1661" h="364">
                <a:moveTo>
                  <a:pt x="0" y="364"/>
                </a:moveTo>
                <a:lnTo>
                  <a:pt x="104" y="364"/>
                </a:lnTo>
                <a:lnTo>
                  <a:pt x="107" y="364"/>
                </a:lnTo>
                <a:lnTo>
                  <a:pt x="111" y="356"/>
                </a:lnTo>
                <a:lnTo>
                  <a:pt x="126" y="356"/>
                </a:lnTo>
                <a:lnTo>
                  <a:pt x="132" y="356"/>
                </a:lnTo>
                <a:lnTo>
                  <a:pt x="132" y="348"/>
                </a:lnTo>
                <a:lnTo>
                  <a:pt x="148" y="348"/>
                </a:lnTo>
                <a:lnTo>
                  <a:pt x="164" y="348"/>
                </a:lnTo>
                <a:lnTo>
                  <a:pt x="177" y="348"/>
                </a:lnTo>
                <a:lnTo>
                  <a:pt x="179" y="348"/>
                </a:lnTo>
                <a:lnTo>
                  <a:pt x="179" y="340"/>
                </a:lnTo>
                <a:lnTo>
                  <a:pt x="185" y="340"/>
                </a:lnTo>
                <a:lnTo>
                  <a:pt x="196" y="340"/>
                </a:lnTo>
                <a:lnTo>
                  <a:pt x="205" y="340"/>
                </a:lnTo>
                <a:lnTo>
                  <a:pt x="208" y="340"/>
                </a:lnTo>
                <a:lnTo>
                  <a:pt x="214" y="340"/>
                </a:lnTo>
                <a:lnTo>
                  <a:pt x="222" y="340"/>
                </a:lnTo>
                <a:lnTo>
                  <a:pt x="233" y="340"/>
                </a:lnTo>
                <a:lnTo>
                  <a:pt x="242" y="340"/>
                </a:lnTo>
                <a:lnTo>
                  <a:pt x="247" y="340"/>
                </a:lnTo>
                <a:lnTo>
                  <a:pt x="247" y="332"/>
                </a:lnTo>
                <a:lnTo>
                  <a:pt x="259" y="332"/>
                </a:lnTo>
                <a:lnTo>
                  <a:pt x="269" y="332"/>
                </a:lnTo>
                <a:lnTo>
                  <a:pt x="269" y="323"/>
                </a:lnTo>
                <a:lnTo>
                  <a:pt x="272" y="314"/>
                </a:lnTo>
                <a:lnTo>
                  <a:pt x="280" y="314"/>
                </a:lnTo>
                <a:lnTo>
                  <a:pt x="289" y="314"/>
                </a:lnTo>
                <a:lnTo>
                  <a:pt x="300" y="314"/>
                </a:lnTo>
                <a:lnTo>
                  <a:pt x="346" y="314"/>
                </a:lnTo>
                <a:lnTo>
                  <a:pt x="354" y="314"/>
                </a:lnTo>
                <a:lnTo>
                  <a:pt x="361" y="314"/>
                </a:lnTo>
                <a:lnTo>
                  <a:pt x="369" y="314"/>
                </a:lnTo>
                <a:lnTo>
                  <a:pt x="386" y="314"/>
                </a:lnTo>
                <a:lnTo>
                  <a:pt x="390" y="314"/>
                </a:lnTo>
                <a:lnTo>
                  <a:pt x="414" y="314"/>
                </a:lnTo>
                <a:lnTo>
                  <a:pt x="427" y="314"/>
                </a:lnTo>
                <a:lnTo>
                  <a:pt x="434" y="314"/>
                </a:lnTo>
                <a:lnTo>
                  <a:pt x="437" y="314"/>
                </a:lnTo>
                <a:lnTo>
                  <a:pt x="458" y="314"/>
                </a:lnTo>
                <a:lnTo>
                  <a:pt x="477" y="314"/>
                </a:lnTo>
                <a:lnTo>
                  <a:pt x="477" y="305"/>
                </a:lnTo>
                <a:lnTo>
                  <a:pt x="482" y="305"/>
                </a:lnTo>
                <a:lnTo>
                  <a:pt x="486" y="305"/>
                </a:lnTo>
                <a:lnTo>
                  <a:pt x="492" y="305"/>
                </a:lnTo>
                <a:lnTo>
                  <a:pt x="500" y="305"/>
                </a:lnTo>
                <a:lnTo>
                  <a:pt x="520" y="305"/>
                </a:lnTo>
                <a:lnTo>
                  <a:pt x="524" y="305"/>
                </a:lnTo>
                <a:lnTo>
                  <a:pt x="524" y="295"/>
                </a:lnTo>
                <a:lnTo>
                  <a:pt x="529" y="295"/>
                </a:lnTo>
                <a:lnTo>
                  <a:pt x="532" y="285"/>
                </a:lnTo>
                <a:lnTo>
                  <a:pt x="542" y="285"/>
                </a:lnTo>
                <a:lnTo>
                  <a:pt x="548" y="285"/>
                </a:lnTo>
                <a:lnTo>
                  <a:pt x="551" y="276"/>
                </a:lnTo>
                <a:lnTo>
                  <a:pt x="554" y="276"/>
                </a:lnTo>
                <a:lnTo>
                  <a:pt x="555" y="266"/>
                </a:lnTo>
                <a:lnTo>
                  <a:pt x="568" y="266"/>
                </a:lnTo>
                <a:lnTo>
                  <a:pt x="578" y="266"/>
                </a:lnTo>
                <a:lnTo>
                  <a:pt x="579" y="256"/>
                </a:lnTo>
                <a:lnTo>
                  <a:pt x="580" y="246"/>
                </a:lnTo>
                <a:lnTo>
                  <a:pt x="598" y="246"/>
                </a:lnTo>
                <a:lnTo>
                  <a:pt x="599" y="246"/>
                </a:lnTo>
                <a:lnTo>
                  <a:pt x="599" y="236"/>
                </a:lnTo>
                <a:lnTo>
                  <a:pt x="604" y="225"/>
                </a:lnTo>
                <a:lnTo>
                  <a:pt x="625" y="225"/>
                </a:lnTo>
                <a:lnTo>
                  <a:pt x="635" y="225"/>
                </a:lnTo>
                <a:lnTo>
                  <a:pt x="651" y="225"/>
                </a:lnTo>
                <a:lnTo>
                  <a:pt x="662" y="225"/>
                </a:lnTo>
                <a:lnTo>
                  <a:pt x="665" y="225"/>
                </a:lnTo>
                <a:lnTo>
                  <a:pt x="669" y="215"/>
                </a:lnTo>
                <a:lnTo>
                  <a:pt x="672" y="215"/>
                </a:lnTo>
                <a:lnTo>
                  <a:pt x="685" y="215"/>
                </a:lnTo>
                <a:lnTo>
                  <a:pt x="702" y="215"/>
                </a:lnTo>
                <a:lnTo>
                  <a:pt x="702" y="204"/>
                </a:lnTo>
                <a:lnTo>
                  <a:pt x="707" y="204"/>
                </a:lnTo>
                <a:lnTo>
                  <a:pt x="714" y="204"/>
                </a:lnTo>
                <a:lnTo>
                  <a:pt x="719" y="193"/>
                </a:lnTo>
                <a:lnTo>
                  <a:pt x="720" y="193"/>
                </a:lnTo>
                <a:lnTo>
                  <a:pt x="729" y="193"/>
                </a:lnTo>
                <a:lnTo>
                  <a:pt x="741" y="193"/>
                </a:lnTo>
                <a:lnTo>
                  <a:pt x="744" y="193"/>
                </a:lnTo>
                <a:lnTo>
                  <a:pt x="744" y="182"/>
                </a:lnTo>
                <a:lnTo>
                  <a:pt x="753" y="182"/>
                </a:lnTo>
                <a:lnTo>
                  <a:pt x="759" y="182"/>
                </a:lnTo>
                <a:lnTo>
                  <a:pt x="759" y="171"/>
                </a:lnTo>
                <a:lnTo>
                  <a:pt x="766" y="171"/>
                </a:lnTo>
                <a:lnTo>
                  <a:pt x="773" y="171"/>
                </a:lnTo>
                <a:lnTo>
                  <a:pt x="778" y="171"/>
                </a:lnTo>
                <a:lnTo>
                  <a:pt x="786" y="171"/>
                </a:lnTo>
                <a:lnTo>
                  <a:pt x="798" y="171"/>
                </a:lnTo>
                <a:lnTo>
                  <a:pt x="802" y="160"/>
                </a:lnTo>
                <a:lnTo>
                  <a:pt x="806" y="160"/>
                </a:lnTo>
                <a:lnTo>
                  <a:pt x="806" y="148"/>
                </a:lnTo>
                <a:lnTo>
                  <a:pt x="817" y="148"/>
                </a:lnTo>
                <a:lnTo>
                  <a:pt x="824" y="148"/>
                </a:lnTo>
                <a:lnTo>
                  <a:pt x="832" y="148"/>
                </a:lnTo>
                <a:lnTo>
                  <a:pt x="838" y="148"/>
                </a:lnTo>
                <a:lnTo>
                  <a:pt x="844" y="148"/>
                </a:lnTo>
                <a:lnTo>
                  <a:pt x="860" y="148"/>
                </a:lnTo>
                <a:lnTo>
                  <a:pt x="860" y="136"/>
                </a:lnTo>
                <a:lnTo>
                  <a:pt x="871" y="136"/>
                </a:lnTo>
                <a:lnTo>
                  <a:pt x="877" y="136"/>
                </a:lnTo>
                <a:lnTo>
                  <a:pt x="889" y="136"/>
                </a:lnTo>
                <a:lnTo>
                  <a:pt x="897" y="136"/>
                </a:lnTo>
                <a:lnTo>
                  <a:pt x="897" y="123"/>
                </a:lnTo>
                <a:lnTo>
                  <a:pt x="905" y="123"/>
                </a:lnTo>
                <a:lnTo>
                  <a:pt x="916" y="123"/>
                </a:lnTo>
                <a:lnTo>
                  <a:pt x="921" y="123"/>
                </a:lnTo>
                <a:lnTo>
                  <a:pt x="925" y="123"/>
                </a:lnTo>
                <a:lnTo>
                  <a:pt x="925" y="111"/>
                </a:lnTo>
                <a:lnTo>
                  <a:pt x="944" y="111"/>
                </a:lnTo>
                <a:lnTo>
                  <a:pt x="951" y="111"/>
                </a:lnTo>
                <a:lnTo>
                  <a:pt x="960" y="111"/>
                </a:lnTo>
                <a:lnTo>
                  <a:pt x="967" y="111"/>
                </a:lnTo>
                <a:lnTo>
                  <a:pt x="973" y="111"/>
                </a:lnTo>
                <a:lnTo>
                  <a:pt x="980" y="111"/>
                </a:lnTo>
                <a:lnTo>
                  <a:pt x="984" y="111"/>
                </a:lnTo>
                <a:lnTo>
                  <a:pt x="996" y="111"/>
                </a:lnTo>
                <a:lnTo>
                  <a:pt x="1000" y="111"/>
                </a:lnTo>
                <a:lnTo>
                  <a:pt x="1003" y="111"/>
                </a:lnTo>
                <a:lnTo>
                  <a:pt x="1011" y="111"/>
                </a:lnTo>
                <a:lnTo>
                  <a:pt x="1020" y="111"/>
                </a:lnTo>
                <a:lnTo>
                  <a:pt x="1024" y="111"/>
                </a:lnTo>
                <a:lnTo>
                  <a:pt x="1028" y="111"/>
                </a:lnTo>
                <a:lnTo>
                  <a:pt x="1044" y="111"/>
                </a:lnTo>
                <a:lnTo>
                  <a:pt x="1052" y="111"/>
                </a:lnTo>
                <a:lnTo>
                  <a:pt x="1061" y="111"/>
                </a:lnTo>
                <a:lnTo>
                  <a:pt x="1070" y="111"/>
                </a:lnTo>
                <a:lnTo>
                  <a:pt x="1073" y="95"/>
                </a:lnTo>
                <a:lnTo>
                  <a:pt x="1092" y="95"/>
                </a:lnTo>
                <a:lnTo>
                  <a:pt x="1096" y="95"/>
                </a:lnTo>
                <a:lnTo>
                  <a:pt x="1099" y="95"/>
                </a:lnTo>
                <a:lnTo>
                  <a:pt x="1099" y="79"/>
                </a:lnTo>
                <a:lnTo>
                  <a:pt x="1107" y="79"/>
                </a:lnTo>
                <a:lnTo>
                  <a:pt x="1114" y="79"/>
                </a:lnTo>
                <a:lnTo>
                  <a:pt x="1123" y="79"/>
                </a:lnTo>
                <a:lnTo>
                  <a:pt x="1129" y="79"/>
                </a:lnTo>
                <a:lnTo>
                  <a:pt x="1136" y="79"/>
                </a:lnTo>
                <a:lnTo>
                  <a:pt x="1148" y="79"/>
                </a:lnTo>
                <a:lnTo>
                  <a:pt x="1161" y="79"/>
                </a:lnTo>
                <a:lnTo>
                  <a:pt x="1180" y="79"/>
                </a:lnTo>
                <a:lnTo>
                  <a:pt x="1184" y="79"/>
                </a:lnTo>
                <a:lnTo>
                  <a:pt x="1189" y="79"/>
                </a:lnTo>
                <a:lnTo>
                  <a:pt x="1203" y="79"/>
                </a:lnTo>
                <a:lnTo>
                  <a:pt x="1210" y="79"/>
                </a:lnTo>
                <a:lnTo>
                  <a:pt x="1214" y="79"/>
                </a:lnTo>
                <a:lnTo>
                  <a:pt x="1237" y="79"/>
                </a:lnTo>
                <a:lnTo>
                  <a:pt x="1243" y="79"/>
                </a:lnTo>
                <a:lnTo>
                  <a:pt x="1253" y="79"/>
                </a:lnTo>
                <a:lnTo>
                  <a:pt x="1261" y="79"/>
                </a:lnTo>
                <a:lnTo>
                  <a:pt x="1290" y="79"/>
                </a:lnTo>
                <a:lnTo>
                  <a:pt x="1295" y="79"/>
                </a:lnTo>
                <a:lnTo>
                  <a:pt x="1297" y="79"/>
                </a:lnTo>
                <a:lnTo>
                  <a:pt x="1306" y="79"/>
                </a:lnTo>
                <a:lnTo>
                  <a:pt x="1311" y="79"/>
                </a:lnTo>
                <a:lnTo>
                  <a:pt x="1322" y="79"/>
                </a:lnTo>
                <a:lnTo>
                  <a:pt x="1332" y="79"/>
                </a:lnTo>
                <a:lnTo>
                  <a:pt x="1336" y="79"/>
                </a:lnTo>
                <a:lnTo>
                  <a:pt x="1340" y="79"/>
                </a:lnTo>
                <a:lnTo>
                  <a:pt x="1362" y="79"/>
                </a:lnTo>
                <a:lnTo>
                  <a:pt x="1369" y="79"/>
                </a:lnTo>
                <a:lnTo>
                  <a:pt x="1373" y="79"/>
                </a:lnTo>
                <a:lnTo>
                  <a:pt x="1377" y="79"/>
                </a:lnTo>
                <a:lnTo>
                  <a:pt x="1390" y="79"/>
                </a:lnTo>
                <a:lnTo>
                  <a:pt x="1400" y="79"/>
                </a:lnTo>
                <a:lnTo>
                  <a:pt x="1406" y="79"/>
                </a:lnTo>
                <a:lnTo>
                  <a:pt x="1419" y="79"/>
                </a:lnTo>
                <a:lnTo>
                  <a:pt x="1435" y="79"/>
                </a:lnTo>
                <a:lnTo>
                  <a:pt x="1437" y="79"/>
                </a:lnTo>
                <a:lnTo>
                  <a:pt x="1443" y="79"/>
                </a:lnTo>
                <a:lnTo>
                  <a:pt x="1449" y="79"/>
                </a:lnTo>
                <a:lnTo>
                  <a:pt x="1460" y="79"/>
                </a:lnTo>
                <a:lnTo>
                  <a:pt x="1477" y="79"/>
                </a:lnTo>
                <a:lnTo>
                  <a:pt x="1479" y="79"/>
                </a:lnTo>
                <a:lnTo>
                  <a:pt x="1489" y="79"/>
                </a:lnTo>
                <a:lnTo>
                  <a:pt x="1490" y="79"/>
                </a:lnTo>
                <a:lnTo>
                  <a:pt x="1501" y="79"/>
                </a:lnTo>
                <a:lnTo>
                  <a:pt x="1502" y="79"/>
                </a:lnTo>
                <a:lnTo>
                  <a:pt x="1520" y="79"/>
                </a:lnTo>
                <a:lnTo>
                  <a:pt x="1526" y="79"/>
                </a:lnTo>
                <a:lnTo>
                  <a:pt x="1532" y="79"/>
                </a:lnTo>
                <a:lnTo>
                  <a:pt x="1539" y="79"/>
                </a:lnTo>
                <a:lnTo>
                  <a:pt x="1557" y="79"/>
                </a:lnTo>
                <a:lnTo>
                  <a:pt x="1562" y="79"/>
                </a:lnTo>
                <a:lnTo>
                  <a:pt x="1571" y="79"/>
                </a:lnTo>
                <a:lnTo>
                  <a:pt x="1575" y="79"/>
                </a:lnTo>
                <a:lnTo>
                  <a:pt x="1582" y="79"/>
                </a:lnTo>
                <a:lnTo>
                  <a:pt x="1596" y="79"/>
                </a:lnTo>
                <a:lnTo>
                  <a:pt x="1599" y="79"/>
                </a:lnTo>
                <a:lnTo>
                  <a:pt x="1614" y="79"/>
                </a:lnTo>
                <a:lnTo>
                  <a:pt x="1618" y="79"/>
                </a:lnTo>
                <a:lnTo>
                  <a:pt x="1618" y="0"/>
                </a:lnTo>
                <a:lnTo>
                  <a:pt x="1645" y="0"/>
                </a:lnTo>
                <a:lnTo>
                  <a:pt x="1647" y="0"/>
                </a:lnTo>
                <a:lnTo>
                  <a:pt x="1661" y="0"/>
                </a:lnTo>
              </a:path>
            </a:pathLst>
          </a:custGeom>
          <a:noFill/>
          <a:ln w="38100" cap="flat">
            <a:solidFill>
              <a:srgbClr val="FF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Freeform 24">
            <a:extLst>
              <a:ext uri="{FF2B5EF4-FFF2-40B4-BE49-F238E27FC236}">
                <a16:creationId xmlns:a16="http://schemas.microsoft.com/office/drawing/2014/main" id="{DD7CCE71-476F-E037-3530-1B46C924B779}"/>
              </a:ext>
            </a:extLst>
          </p:cNvPr>
          <p:cNvSpPr>
            <a:spLocks/>
          </p:cNvSpPr>
          <p:nvPr/>
        </p:nvSpPr>
        <p:spPr bwMode="auto">
          <a:xfrm>
            <a:off x="2274019" y="4021522"/>
            <a:ext cx="4915580" cy="1290534"/>
          </a:xfrm>
          <a:custGeom>
            <a:avLst/>
            <a:gdLst>
              <a:gd name="T0" fmla="*/ 92 w 1390"/>
              <a:gd name="T1" fmla="*/ 351 h 358"/>
              <a:gd name="T2" fmla="*/ 116 w 1390"/>
              <a:gd name="T3" fmla="*/ 344 h 358"/>
              <a:gd name="T4" fmla="*/ 126 w 1390"/>
              <a:gd name="T5" fmla="*/ 334 h 358"/>
              <a:gd name="T6" fmla="*/ 143 w 1390"/>
              <a:gd name="T7" fmla="*/ 319 h 358"/>
              <a:gd name="T8" fmla="*/ 153 w 1390"/>
              <a:gd name="T9" fmla="*/ 305 h 358"/>
              <a:gd name="T10" fmla="*/ 164 w 1390"/>
              <a:gd name="T11" fmla="*/ 291 h 358"/>
              <a:gd name="T12" fmla="*/ 172 w 1390"/>
              <a:gd name="T13" fmla="*/ 281 h 358"/>
              <a:gd name="T14" fmla="*/ 184 w 1390"/>
              <a:gd name="T15" fmla="*/ 267 h 358"/>
              <a:gd name="T16" fmla="*/ 199 w 1390"/>
              <a:gd name="T17" fmla="*/ 256 h 358"/>
              <a:gd name="T18" fmla="*/ 216 w 1390"/>
              <a:gd name="T19" fmla="*/ 249 h 358"/>
              <a:gd name="T20" fmla="*/ 236 w 1390"/>
              <a:gd name="T21" fmla="*/ 245 h 358"/>
              <a:gd name="T22" fmla="*/ 251 w 1390"/>
              <a:gd name="T23" fmla="*/ 234 h 358"/>
              <a:gd name="T24" fmla="*/ 266 w 1390"/>
              <a:gd name="T25" fmla="*/ 219 h 358"/>
              <a:gd name="T26" fmla="*/ 280 w 1390"/>
              <a:gd name="T27" fmla="*/ 215 h 358"/>
              <a:gd name="T28" fmla="*/ 299 w 1390"/>
              <a:gd name="T29" fmla="*/ 207 h 358"/>
              <a:gd name="T30" fmla="*/ 321 w 1390"/>
              <a:gd name="T31" fmla="*/ 203 h 358"/>
              <a:gd name="T32" fmla="*/ 331 w 1390"/>
              <a:gd name="T33" fmla="*/ 192 h 358"/>
              <a:gd name="T34" fmla="*/ 345 w 1390"/>
              <a:gd name="T35" fmla="*/ 180 h 358"/>
              <a:gd name="T36" fmla="*/ 369 w 1390"/>
              <a:gd name="T37" fmla="*/ 175 h 358"/>
              <a:gd name="T38" fmla="*/ 383 w 1390"/>
              <a:gd name="T39" fmla="*/ 171 h 358"/>
              <a:gd name="T40" fmla="*/ 408 w 1390"/>
              <a:gd name="T41" fmla="*/ 171 h 358"/>
              <a:gd name="T42" fmla="*/ 421 w 1390"/>
              <a:gd name="T43" fmla="*/ 158 h 358"/>
              <a:gd name="T44" fmla="*/ 437 w 1390"/>
              <a:gd name="T45" fmla="*/ 153 h 358"/>
              <a:gd name="T46" fmla="*/ 449 w 1390"/>
              <a:gd name="T47" fmla="*/ 139 h 358"/>
              <a:gd name="T48" fmla="*/ 461 w 1390"/>
              <a:gd name="T49" fmla="*/ 130 h 358"/>
              <a:gd name="T50" fmla="*/ 484 w 1390"/>
              <a:gd name="T51" fmla="*/ 121 h 358"/>
              <a:gd name="T52" fmla="*/ 505 w 1390"/>
              <a:gd name="T53" fmla="*/ 116 h 358"/>
              <a:gd name="T54" fmla="*/ 528 w 1390"/>
              <a:gd name="T55" fmla="*/ 111 h 358"/>
              <a:gd name="T56" fmla="*/ 554 w 1390"/>
              <a:gd name="T57" fmla="*/ 111 h 358"/>
              <a:gd name="T58" fmla="*/ 575 w 1390"/>
              <a:gd name="T59" fmla="*/ 111 h 358"/>
              <a:gd name="T60" fmla="*/ 587 w 1390"/>
              <a:gd name="T61" fmla="*/ 100 h 358"/>
              <a:gd name="T62" fmla="*/ 600 w 1390"/>
              <a:gd name="T63" fmla="*/ 89 h 358"/>
              <a:gd name="T64" fmla="*/ 618 w 1390"/>
              <a:gd name="T65" fmla="*/ 84 h 358"/>
              <a:gd name="T66" fmla="*/ 635 w 1390"/>
              <a:gd name="T67" fmla="*/ 78 h 358"/>
              <a:gd name="T68" fmla="*/ 653 w 1390"/>
              <a:gd name="T69" fmla="*/ 65 h 358"/>
              <a:gd name="T70" fmla="*/ 671 w 1390"/>
              <a:gd name="T71" fmla="*/ 65 h 358"/>
              <a:gd name="T72" fmla="*/ 688 w 1390"/>
              <a:gd name="T73" fmla="*/ 51 h 358"/>
              <a:gd name="T74" fmla="*/ 705 w 1390"/>
              <a:gd name="T75" fmla="*/ 44 h 358"/>
              <a:gd name="T76" fmla="*/ 728 w 1390"/>
              <a:gd name="T77" fmla="*/ 44 h 358"/>
              <a:gd name="T78" fmla="*/ 744 w 1390"/>
              <a:gd name="T79" fmla="*/ 36 h 358"/>
              <a:gd name="T80" fmla="*/ 757 w 1390"/>
              <a:gd name="T81" fmla="*/ 19 h 358"/>
              <a:gd name="T82" fmla="*/ 781 w 1390"/>
              <a:gd name="T83" fmla="*/ 19 h 358"/>
              <a:gd name="T84" fmla="*/ 793 w 1390"/>
              <a:gd name="T85" fmla="*/ 0 h 358"/>
              <a:gd name="T86" fmla="*/ 822 w 1390"/>
              <a:gd name="T87" fmla="*/ 0 h 358"/>
              <a:gd name="T88" fmla="*/ 846 w 1390"/>
              <a:gd name="T89" fmla="*/ 0 h 358"/>
              <a:gd name="T90" fmla="*/ 872 w 1390"/>
              <a:gd name="T91" fmla="*/ 0 h 358"/>
              <a:gd name="T92" fmla="*/ 894 w 1390"/>
              <a:gd name="T93" fmla="*/ 0 h 358"/>
              <a:gd name="T94" fmla="*/ 918 w 1390"/>
              <a:gd name="T95" fmla="*/ 0 h 358"/>
              <a:gd name="T96" fmla="*/ 945 w 1390"/>
              <a:gd name="T97" fmla="*/ 0 h 358"/>
              <a:gd name="T98" fmla="*/ 967 w 1390"/>
              <a:gd name="T99" fmla="*/ 0 h 358"/>
              <a:gd name="T100" fmla="*/ 997 w 1390"/>
              <a:gd name="T101" fmla="*/ 0 h 358"/>
              <a:gd name="T102" fmla="*/ 1033 w 1390"/>
              <a:gd name="T103" fmla="*/ 0 h 358"/>
              <a:gd name="T104" fmla="*/ 1071 w 1390"/>
              <a:gd name="T105" fmla="*/ 0 h 358"/>
              <a:gd name="T106" fmla="*/ 1095 w 1390"/>
              <a:gd name="T107" fmla="*/ 0 h 358"/>
              <a:gd name="T108" fmla="*/ 1118 w 1390"/>
              <a:gd name="T109" fmla="*/ 0 h 358"/>
              <a:gd name="T110" fmla="*/ 1156 w 1390"/>
              <a:gd name="T111" fmla="*/ 0 h 358"/>
              <a:gd name="T112" fmla="*/ 1191 w 1390"/>
              <a:gd name="T113" fmla="*/ 0 h 358"/>
              <a:gd name="T114" fmla="*/ 1247 w 1390"/>
              <a:gd name="T115" fmla="*/ 0 h 358"/>
              <a:gd name="T116" fmla="*/ 1286 w 1390"/>
              <a:gd name="T117" fmla="*/ 0 h 358"/>
              <a:gd name="T118" fmla="*/ 1353 w 1390"/>
              <a:gd name="T119" fmla="*/ 0 h 3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390" h="358">
                <a:moveTo>
                  <a:pt x="0" y="358"/>
                </a:moveTo>
                <a:lnTo>
                  <a:pt x="85" y="358"/>
                </a:lnTo>
                <a:lnTo>
                  <a:pt x="85" y="351"/>
                </a:lnTo>
                <a:lnTo>
                  <a:pt x="92" y="351"/>
                </a:lnTo>
                <a:lnTo>
                  <a:pt x="101" y="351"/>
                </a:lnTo>
                <a:lnTo>
                  <a:pt x="105" y="348"/>
                </a:lnTo>
                <a:lnTo>
                  <a:pt x="106" y="348"/>
                </a:lnTo>
                <a:lnTo>
                  <a:pt x="116" y="344"/>
                </a:lnTo>
                <a:lnTo>
                  <a:pt x="116" y="340"/>
                </a:lnTo>
                <a:lnTo>
                  <a:pt x="121" y="337"/>
                </a:lnTo>
                <a:lnTo>
                  <a:pt x="121" y="334"/>
                </a:lnTo>
                <a:lnTo>
                  <a:pt x="126" y="334"/>
                </a:lnTo>
                <a:lnTo>
                  <a:pt x="126" y="330"/>
                </a:lnTo>
                <a:lnTo>
                  <a:pt x="136" y="326"/>
                </a:lnTo>
                <a:lnTo>
                  <a:pt x="136" y="323"/>
                </a:lnTo>
                <a:lnTo>
                  <a:pt x="143" y="319"/>
                </a:lnTo>
                <a:lnTo>
                  <a:pt x="143" y="316"/>
                </a:lnTo>
                <a:lnTo>
                  <a:pt x="147" y="312"/>
                </a:lnTo>
                <a:lnTo>
                  <a:pt x="150" y="312"/>
                </a:lnTo>
                <a:lnTo>
                  <a:pt x="153" y="305"/>
                </a:lnTo>
                <a:lnTo>
                  <a:pt x="157" y="305"/>
                </a:lnTo>
                <a:lnTo>
                  <a:pt x="160" y="305"/>
                </a:lnTo>
                <a:lnTo>
                  <a:pt x="162" y="298"/>
                </a:lnTo>
                <a:lnTo>
                  <a:pt x="164" y="291"/>
                </a:lnTo>
                <a:lnTo>
                  <a:pt x="165" y="288"/>
                </a:lnTo>
                <a:lnTo>
                  <a:pt x="167" y="288"/>
                </a:lnTo>
                <a:lnTo>
                  <a:pt x="172" y="288"/>
                </a:lnTo>
                <a:lnTo>
                  <a:pt x="172" y="281"/>
                </a:lnTo>
                <a:lnTo>
                  <a:pt x="181" y="277"/>
                </a:lnTo>
                <a:lnTo>
                  <a:pt x="181" y="274"/>
                </a:lnTo>
                <a:lnTo>
                  <a:pt x="182" y="270"/>
                </a:lnTo>
                <a:lnTo>
                  <a:pt x="184" y="267"/>
                </a:lnTo>
                <a:lnTo>
                  <a:pt x="190" y="267"/>
                </a:lnTo>
                <a:lnTo>
                  <a:pt x="193" y="259"/>
                </a:lnTo>
                <a:lnTo>
                  <a:pt x="195" y="256"/>
                </a:lnTo>
                <a:lnTo>
                  <a:pt x="199" y="256"/>
                </a:lnTo>
                <a:lnTo>
                  <a:pt x="199" y="252"/>
                </a:lnTo>
                <a:lnTo>
                  <a:pt x="203" y="252"/>
                </a:lnTo>
                <a:lnTo>
                  <a:pt x="208" y="249"/>
                </a:lnTo>
                <a:lnTo>
                  <a:pt x="216" y="249"/>
                </a:lnTo>
                <a:lnTo>
                  <a:pt x="216" y="245"/>
                </a:lnTo>
                <a:lnTo>
                  <a:pt x="220" y="245"/>
                </a:lnTo>
                <a:lnTo>
                  <a:pt x="226" y="245"/>
                </a:lnTo>
                <a:lnTo>
                  <a:pt x="236" y="245"/>
                </a:lnTo>
                <a:lnTo>
                  <a:pt x="241" y="241"/>
                </a:lnTo>
                <a:lnTo>
                  <a:pt x="241" y="234"/>
                </a:lnTo>
                <a:lnTo>
                  <a:pt x="249" y="234"/>
                </a:lnTo>
                <a:lnTo>
                  <a:pt x="251" y="234"/>
                </a:lnTo>
                <a:lnTo>
                  <a:pt x="252" y="226"/>
                </a:lnTo>
                <a:lnTo>
                  <a:pt x="256" y="222"/>
                </a:lnTo>
                <a:lnTo>
                  <a:pt x="266" y="222"/>
                </a:lnTo>
                <a:lnTo>
                  <a:pt x="266" y="219"/>
                </a:lnTo>
                <a:lnTo>
                  <a:pt x="269" y="219"/>
                </a:lnTo>
                <a:lnTo>
                  <a:pt x="269" y="215"/>
                </a:lnTo>
                <a:lnTo>
                  <a:pt x="276" y="215"/>
                </a:lnTo>
                <a:lnTo>
                  <a:pt x="280" y="215"/>
                </a:lnTo>
                <a:lnTo>
                  <a:pt x="286" y="215"/>
                </a:lnTo>
                <a:lnTo>
                  <a:pt x="292" y="211"/>
                </a:lnTo>
                <a:lnTo>
                  <a:pt x="293" y="207"/>
                </a:lnTo>
                <a:lnTo>
                  <a:pt x="299" y="207"/>
                </a:lnTo>
                <a:lnTo>
                  <a:pt x="305" y="207"/>
                </a:lnTo>
                <a:lnTo>
                  <a:pt x="315" y="207"/>
                </a:lnTo>
                <a:lnTo>
                  <a:pt x="316" y="207"/>
                </a:lnTo>
                <a:lnTo>
                  <a:pt x="321" y="203"/>
                </a:lnTo>
                <a:lnTo>
                  <a:pt x="322" y="203"/>
                </a:lnTo>
                <a:lnTo>
                  <a:pt x="328" y="195"/>
                </a:lnTo>
                <a:lnTo>
                  <a:pt x="330" y="195"/>
                </a:lnTo>
                <a:lnTo>
                  <a:pt x="331" y="192"/>
                </a:lnTo>
                <a:lnTo>
                  <a:pt x="339" y="187"/>
                </a:lnTo>
                <a:lnTo>
                  <a:pt x="339" y="183"/>
                </a:lnTo>
                <a:lnTo>
                  <a:pt x="342" y="183"/>
                </a:lnTo>
                <a:lnTo>
                  <a:pt x="345" y="180"/>
                </a:lnTo>
                <a:lnTo>
                  <a:pt x="349" y="180"/>
                </a:lnTo>
                <a:lnTo>
                  <a:pt x="352" y="180"/>
                </a:lnTo>
                <a:lnTo>
                  <a:pt x="358" y="175"/>
                </a:lnTo>
                <a:lnTo>
                  <a:pt x="369" y="175"/>
                </a:lnTo>
                <a:lnTo>
                  <a:pt x="373" y="175"/>
                </a:lnTo>
                <a:lnTo>
                  <a:pt x="378" y="175"/>
                </a:lnTo>
                <a:lnTo>
                  <a:pt x="382" y="171"/>
                </a:lnTo>
                <a:lnTo>
                  <a:pt x="383" y="171"/>
                </a:lnTo>
                <a:lnTo>
                  <a:pt x="391" y="171"/>
                </a:lnTo>
                <a:lnTo>
                  <a:pt x="395" y="171"/>
                </a:lnTo>
                <a:lnTo>
                  <a:pt x="402" y="171"/>
                </a:lnTo>
                <a:lnTo>
                  <a:pt x="408" y="171"/>
                </a:lnTo>
                <a:lnTo>
                  <a:pt x="408" y="167"/>
                </a:lnTo>
                <a:lnTo>
                  <a:pt x="414" y="167"/>
                </a:lnTo>
                <a:lnTo>
                  <a:pt x="420" y="162"/>
                </a:lnTo>
                <a:lnTo>
                  <a:pt x="421" y="158"/>
                </a:lnTo>
                <a:lnTo>
                  <a:pt x="425" y="158"/>
                </a:lnTo>
                <a:lnTo>
                  <a:pt x="434" y="158"/>
                </a:lnTo>
                <a:lnTo>
                  <a:pt x="434" y="153"/>
                </a:lnTo>
                <a:lnTo>
                  <a:pt x="437" y="153"/>
                </a:lnTo>
                <a:lnTo>
                  <a:pt x="445" y="153"/>
                </a:lnTo>
                <a:lnTo>
                  <a:pt x="445" y="149"/>
                </a:lnTo>
                <a:lnTo>
                  <a:pt x="447" y="139"/>
                </a:lnTo>
                <a:lnTo>
                  <a:pt x="449" y="139"/>
                </a:lnTo>
                <a:lnTo>
                  <a:pt x="452" y="135"/>
                </a:lnTo>
                <a:lnTo>
                  <a:pt x="455" y="135"/>
                </a:lnTo>
                <a:lnTo>
                  <a:pt x="458" y="130"/>
                </a:lnTo>
                <a:lnTo>
                  <a:pt x="461" y="130"/>
                </a:lnTo>
                <a:lnTo>
                  <a:pt x="461" y="121"/>
                </a:lnTo>
                <a:lnTo>
                  <a:pt x="471" y="121"/>
                </a:lnTo>
                <a:lnTo>
                  <a:pt x="481" y="121"/>
                </a:lnTo>
                <a:lnTo>
                  <a:pt x="484" y="121"/>
                </a:lnTo>
                <a:lnTo>
                  <a:pt x="492" y="121"/>
                </a:lnTo>
                <a:lnTo>
                  <a:pt x="492" y="116"/>
                </a:lnTo>
                <a:lnTo>
                  <a:pt x="497" y="116"/>
                </a:lnTo>
                <a:lnTo>
                  <a:pt x="505" y="116"/>
                </a:lnTo>
                <a:lnTo>
                  <a:pt x="510" y="116"/>
                </a:lnTo>
                <a:lnTo>
                  <a:pt x="516" y="116"/>
                </a:lnTo>
                <a:lnTo>
                  <a:pt x="518" y="111"/>
                </a:lnTo>
                <a:lnTo>
                  <a:pt x="528" y="111"/>
                </a:lnTo>
                <a:lnTo>
                  <a:pt x="537" y="111"/>
                </a:lnTo>
                <a:lnTo>
                  <a:pt x="540" y="111"/>
                </a:lnTo>
                <a:lnTo>
                  <a:pt x="546" y="111"/>
                </a:lnTo>
                <a:lnTo>
                  <a:pt x="554" y="111"/>
                </a:lnTo>
                <a:lnTo>
                  <a:pt x="558" y="111"/>
                </a:lnTo>
                <a:lnTo>
                  <a:pt x="563" y="111"/>
                </a:lnTo>
                <a:lnTo>
                  <a:pt x="570" y="111"/>
                </a:lnTo>
                <a:lnTo>
                  <a:pt x="575" y="111"/>
                </a:lnTo>
                <a:lnTo>
                  <a:pt x="581" y="111"/>
                </a:lnTo>
                <a:lnTo>
                  <a:pt x="582" y="105"/>
                </a:lnTo>
                <a:lnTo>
                  <a:pt x="585" y="100"/>
                </a:lnTo>
                <a:lnTo>
                  <a:pt x="587" y="100"/>
                </a:lnTo>
                <a:lnTo>
                  <a:pt x="587" y="95"/>
                </a:lnTo>
                <a:lnTo>
                  <a:pt x="593" y="95"/>
                </a:lnTo>
                <a:lnTo>
                  <a:pt x="599" y="95"/>
                </a:lnTo>
                <a:lnTo>
                  <a:pt x="600" y="89"/>
                </a:lnTo>
                <a:lnTo>
                  <a:pt x="605" y="89"/>
                </a:lnTo>
                <a:lnTo>
                  <a:pt x="609" y="84"/>
                </a:lnTo>
                <a:lnTo>
                  <a:pt x="612" y="84"/>
                </a:lnTo>
                <a:lnTo>
                  <a:pt x="618" y="84"/>
                </a:lnTo>
                <a:lnTo>
                  <a:pt x="624" y="84"/>
                </a:lnTo>
                <a:lnTo>
                  <a:pt x="631" y="84"/>
                </a:lnTo>
                <a:lnTo>
                  <a:pt x="633" y="78"/>
                </a:lnTo>
                <a:lnTo>
                  <a:pt x="635" y="78"/>
                </a:lnTo>
                <a:lnTo>
                  <a:pt x="644" y="78"/>
                </a:lnTo>
                <a:lnTo>
                  <a:pt x="644" y="71"/>
                </a:lnTo>
                <a:lnTo>
                  <a:pt x="648" y="71"/>
                </a:lnTo>
                <a:lnTo>
                  <a:pt x="653" y="65"/>
                </a:lnTo>
                <a:lnTo>
                  <a:pt x="654" y="65"/>
                </a:lnTo>
                <a:lnTo>
                  <a:pt x="659" y="65"/>
                </a:lnTo>
                <a:lnTo>
                  <a:pt x="665" y="65"/>
                </a:lnTo>
                <a:lnTo>
                  <a:pt x="671" y="65"/>
                </a:lnTo>
                <a:lnTo>
                  <a:pt x="678" y="65"/>
                </a:lnTo>
                <a:lnTo>
                  <a:pt x="681" y="58"/>
                </a:lnTo>
                <a:lnTo>
                  <a:pt x="685" y="58"/>
                </a:lnTo>
                <a:lnTo>
                  <a:pt x="688" y="51"/>
                </a:lnTo>
                <a:lnTo>
                  <a:pt x="690" y="51"/>
                </a:lnTo>
                <a:lnTo>
                  <a:pt x="697" y="51"/>
                </a:lnTo>
                <a:lnTo>
                  <a:pt x="697" y="44"/>
                </a:lnTo>
                <a:lnTo>
                  <a:pt x="705" y="44"/>
                </a:lnTo>
                <a:lnTo>
                  <a:pt x="709" y="44"/>
                </a:lnTo>
                <a:lnTo>
                  <a:pt x="715" y="44"/>
                </a:lnTo>
                <a:lnTo>
                  <a:pt x="721" y="44"/>
                </a:lnTo>
                <a:lnTo>
                  <a:pt x="728" y="44"/>
                </a:lnTo>
                <a:lnTo>
                  <a:pt x="730" y="36"/>
                </a:lnTo>
                <a:lnTo>
                  <a:pt x="731" y="36"/>
                </a:lnTo>
                <a:lnTo>
                  <a:pt x="737" y="36"/>
                </a:lnTo>
                <a:lnTo>
                  <a:pt x="744" y="36"/>
                </a:lnTo>
                <a:lnTo>
                  <a:pt x="750" y="36"/>
                </a:lnTo>
                <a:lnTo>
                  <a:pt x="755" y="28"/>
                </a:lnTo>
                <a:lnTo>
                  <a:pt x="756" y="28"/>
                </a:lnTo>
                <a:lnTo>
                  <a:pt x="757" y="19"/>
                </a:lnTo>
                <a:lnTo>
                  <a:pt x="764" y="19"/>
                </a:lnTo>
                <a:lnTo>
                  <a:pt x="771" y="19"/>
                </a:lnTo>
                <a:lnTo>
                  <a:pt x="775" y="19"/>
                </a:lnTo>
                <a:lnTo>
                  <a:pt x="781" y="19"/>
                </a:lnTo>
                <a:lnTo>
                  <a:pt x="781" y="10"/>
                </a:lnTo>
                <a:lnTo>
                  <a:pt x="785" y="0"/>
                </a:lnTo>
                <a:lnTo>
                  <a:pt x="788" y="0"/>
                </a:lnTo>
                <a:lnTo>
                  <a:pt x="793" y="0"/>
                </a:lnTo>
                <a:lnTo>
                  <a:pt x="800" y="0"/>
                </a:lnTo>
                <a:lnTo>
                  <a:pt x="807" y="0"/>
                </a:lnTo>
                <a:lnTo>
                  <a:pt x="818" y="0"/>
                </a:lnTo>
                <a:lnTo>
                  <a:pt x="822" y="0"/>
                </a:lnTo>
                <a:lnTo>
                  <a:pt x="832" y="0"/>
                </a:lnTo>
                <a:lnTo>
                  <a:pt x="835" y="0"/>
                </a:lnTo>
                <a:lnTo>
                  <a:pt x="841" y="0"/>
                </a:lnTo>
                <a:lnTo>
                  <a:pt x="846" y="0"/>
                </a:lnTo>
                <a:lnTo>
                  <a:pt x="852" y="0"/>
                </a:lnTo>
                <a:lnTo>
                  <a:pt x="858" y="0"/>
                </a:lnTo>
                <a:lnTo>
                  <a:pt x="867" y="0"/>
                </a:lnTo>
                <a:lnTo>
                  <a:pt x="872" y="0"/>
                </a:lnTo>
                <a:lnTo>
                  <a:pt x="879" y="0"/>
                </a:lnTo>
                <a:lnTo>
                  <a:pt x="882" y="0"/>
                </a:lnTo>
                <a:lnTo>
                  <a:pt x="891" y="0"/>
                </a:lnTo>
                <a:lnTo>
                  <a:pt x="894" y="0"/>
                </a:lnTo>
                <a:lnTo>
                  <a:pt x="900" y="0"/>
                </a:lnTo>
                <a:lnTo>
                  <a:pt x="907" y="0"/>
                </a:lnTo>
                <a:lnTo>
                  <a:pt x="912" y="0"/>
                </a:lnTo>
                <a:lnTo>
                  <a:pt x="918" y="0"/>
                </a:lnTo>
                <a:lnTo>
                  <a:pt x="925" y="0"/>
                </a:lnTo>
                <a:lnTo>
                  <a:pt x="933" y="0"/>
                </a:lnTo>
                <a:lnTo>
                  <a:pt x="937" y="0"/>
                </a:lnTo>
                <a:lnTo>
                  <a:pt x="945" y="0"/>
                </a:lnTo>
                <a:lnTo>
                  <a:pt x="949" y="0"/>
                </a:lnTo>
                <a:lnTo>
                  <a:pt x="960" y="0"/>
                </a:lnTo>
                <a:lnTo>
                  <a:pt x="962" y="0"/>
                </a:lnTo>
                <a:lnTo>
                  <a:pt x="967" y="0"/>
                </a:lnTo>
                <a:lnTo>
                  <a:pt x="975" y="0"/>
                </a:lnTo>
                <a:lnTo>
                  <a:pt x="986" y="0"/>
                </a:lnTo>
                <a:lnTo>
                  <a:pt x="991" y="0"/>
                </a:lnTo>
                <a:lnTo>
                  <a:pt x="997" y="0"/>
                </a:lnTo>
                <a:lnTo>
                  <a:pt x="1003" y="0"/>
                </a:lnTo>
                <a:lnTo>
                  <a:pt x="1009" y="0"/>
                </a:lnTo>
                <a:lnTo>
                  <a:pt x="1027" y="0"/>
                </a:lnTo>
                <a:lnTo>
                  <a:pt x="1033" y="0"/>
                </a:lnTo>
                <a:lnTo>
                  <a:pt x="1041" y="0"/>
                </a:lnTo>
                <a:lnTo>
                  <a:pt x="1058" y="0"/>
                </a:lnTo>
                <a:lnTo>
                  <a:pt x="1065" y="0"/>
                </a:lnTo>
                <a:lnTo>
                  <a:pt x="1071" y="0"/>
                </a:lnTo>
                <a:lnTo>
                  <a:pt x="1078" y="0"/>
                </a:lnTo>
                <a:lnTo>
                  <a:pt x="1081" y="0"/>
                </a:lnTo>
                <a:lnTo>
                  <a:pt x="1087" y="0"/>
                </a:lnTo>
                <a:lnTo>
                  <a:pt x="1095" y="0"/>
                </a:lnTo>
                <a:lnTo>
                  <a:pt x="1100" y="0"/>
                </a:lnTo>
                <a:lnTo>
                  <a:pt x="1109" y="0"/>
                </a:lnTo>
                <a:lnTo>
                  <a:pt x="1115" y="0"/>
                </a:lnTo>
                <a:lnTo>
                  <a:pt x="1118" y="0"/>
                </a:lnTo>
                <a:lnTo>
                  <a:pt x="1128" y="0"/>
                </a:lnTo>
                <a:lnTo>
                  <a:pt x="1138" y="0"/>
                </a:lnTo>
                <a:lnTo>
                  <a:pt x="1150" y="0"/>
                </a:lnTo>
                <a:lnTo>
                  <a:pt x="1156" y="0"/>
                </a:lnTo>
                <a:lnTo>
                  <a:pt x="1161" y="0"/>
                </a:lnTo>
                <a:lnTo>
                  <a:pt x="1174" y="0"/>
                </a:lnTo>
                <a:lnTo>
                  <a:pt x="1177" y="0"/>
                </a:lnTo>
                <a:lnTo>
                  <a:pt x="1191" y="0"/>
                </a:lnTo>
                <a:lnTo>
                  <a:pt x="1197" y="0"/>
                </a:lnTo>
                <a:lnTo>
                  <a:pt x="1223" y="0"/>
                </a:lnTo>
                <a:lnTo>
                  <a:pt x="1230" y="0"/>
                </a:lnTo>
                <a:lnTo>
                  <a:pt x="1247" y="0"/>
                </a:lnTo>
                <a:lnTo>
                  <a:pt x="1253" y="0"/>
                </a:lnTo>
                <a:lnTo>
                  <a:pt x="1259" y="0"/>
                </a:lnTo>
                <a:lnTo>
                  <a:pt x="1281" y="0"/>
                </a:lnTo>
                <a:lnTo>
                  <a:pt x="1286" y="0"/>
                </a:lnTo>
                <a:lnTo>
                  <a:pt x="1300" y="0"/>
                </a:lnTo>
                <a:lnTo>
                  <a:pt x="1321" y="0"/>
                </a:lnTo>
                <a:lnTo>
                  <a:pt x="1343" y="0"/>
                </a:lnTo>
                <a:lnTo>
                  <a:pt x="1353" y="0"/>
                </a:lnTo>
                <a:lnTo>
                  <a:pt x="1374" y="0"/>
                </a:lnTo>
                <a:lnTo>
                  <a:pt x="1390" y="0"/>
                </a:lnTo>
              </a:path>
            </a:pathLst>
          </a:custGeom>
          <a:noFill/>
          <a:ln w="38100" cap="flat">
            <a:solidFill>
              <a:srgbClr val="7030A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B56C0FFB-BCAC-5F5B-A9C5-0FAF77CDE712}"/>
              </a:ext>
            </a:extLst>
          </p:cNvPr>
          <p:cNvCxnSpPr>
            <a:cxnSpLocks/>
          </p:cNvCxnSpPr>
          <p:nvPr/>
        </p:nvCxnSpPr>
        <p:spPr>
          <a:xfrm>
            <a:off x="8416631" y="2690498"/>
            <a:ext cx="900546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28CE763C-EAB7-A75A-FE9B-3DEB4503AEC6}"/>
              </a:ext>
            </a:extLst>
          </p:cNvPr>
          <p:cNvCxnSpPr>
            <a:cxnSpLocks/>
          </p:cNvCxnSpPr>
          <p:nvPr/>
        </p:nvCxnSpPr>
        <p:spPr>
          <a:xfrm>
            <a:off x="8416631" y="3160437"/>
            <a:ext cx="900546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646A725E-12F1-5DCA-555D-ECF751BDF779}"/>
              </a:ext>
            </a:extLst>
          </p:cNvPr>
          <p:cNvCxnSpPr>
            <a:cxnSpLocks/>
          </p:cNvCxnSpPr>
          <p:nvPr/>
        </p:nvCxnSpPr>
        <p:spPr>
          <a:xfrm>
            <a:off x="8416631" y="3630376"/>
            <a:ext cx="900546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62260623-BACD-17F7-5611-29DB77AC2139}"/>
              </a:ext>
            </a:extLst>
          </p:cNvPr>
          <p:cNvCxnSpPr>
            <a:cxnSpLocks/>
          </p:cNvCxnSpPr>
          <p:nvPr/>
        </p:nvCxnSpPr>
        <p:spPr>
          <a:xfrm>
            <a:off x="8416631" y="4100315"/>
            <a:ext cx="900546" cy="0"/>
          </a:xfrm>
          <a:prstGeom prst="line">
            <a:avLst/>
          </a:prstGeom>
          <a:ln w="38100"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AE850ED2-7339-5BF1-EE2D-3230411D5E8F}"/>
              </a:ext>
            </a:extLst>
          </p:cNvPr>
          <p:cNvCxnSpPr>
            <a:cxnSpLocks/>
          </p:cNvCxnSpPr>
          <p:nvPr/>
        </p:nvCxnSpPr>
        <p:spPr>
          <a:xfrm>
            <a:off x="8416631" y="4570254"/>
            <a:ext cx="900546" cy="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CC8A0CC-DD7C-8DE6-485B-A6005E60D442}"/>
              </a:ext>
            </a:extLst>
          </p:cNvPr>
          <p:cNvCxnSpPr>
            <a:cxnSpLocks/>
          </p:cNvCxnSpPr>
          <p:nvPr/>
        </p:nvCxnSpPr>
        <p:spPr>
          <a:xfrm>
            <a:off x="8416631" y="5040191"/>
            <a:ext cx="900546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317FCFA-8871-C602-AB1F-A4D4957896AE}"/>
              </a:ext>
            </a:extLst>
          </p:cNvPr>
          <p:cNvSpPr txBox="1"/>
          <p:nvPr/>
        </p:nvSpPr>
        <p:spPr>
          <a:xfrm>
            <a:off x="9337074" y="2505832"/>
            <a:ext cx="8542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Europe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C3666FD-79F7-53EF-1B1E-47EDF9761B31}"/>
              </a:ext>
            </a:extLst>
          </p:cNvPr>
          <p:cNvSpPr txBox="1"/>
          <p:nvPr/>
        </p:nvSpPr>
        <p:spPr>
          <a:xfrm>
            <a:off x="9337074" y="2973401"/>
            <a:ext cx="1559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North Americ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5D0679D-69A0-A97D-7B97-B26118F04F83}"/>
              </a:ext>
            </a:extLst>
          </p:cNvPr>
          <p:cNvSpPr txBox="1"/>
          <p:nvPr/>
        </p:nvSpPr>
        <p:spPr>
          <a:xfrm>
            <a:off x="9337074" y="3444458"/>
            <a:ext cx="1558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outh Americ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84AC22E-8E9B-9A4D-C355-763EC81C76E8}"/>
              </a:ext>
            </a:extLst>
          </p:cNvPr>
          <p:cNvSpPr txBox="1"/>
          <p:nvPr/>
        </p:nvSpPr>
        <p:spPr>
          <a:xfrm>
            <a:off x="9337074" y="3926256"/>
            <a:ext cx="1282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Middle East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0707454-2704-15E6-ED56-809CC52EA2C4}"/>
              </a:ext>
            </a:extLst>
          </p:cNvPr>
          <p:cNvSpPr txBox="1"/>
          <p:nvPr/>
        </p:nvSpPr>
        <p:spPr>
          <a:xfrm>
            <a:off x="9337074" y="4386032"/>
            <a:ext cx="2570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outh and Southeast Asi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32C0D5B-A972-AD77-7ADA-AD3B6666DD1E}"/>
              </a:ext>
            </a:extLst>
          </p:cNvPr>
          <p:cNvSpPr txBox="1"/>
          <p:nvPr/>
        </p:nvSpPr>
        <p:spPr>
          <a:xfrm>
            <a:off x="9337074" y="4845808"/>
            <a:ext cx="100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East 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si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CB1A0D3-8ADB-D579-C652-01F461ED73C5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9609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グループ化 140">
            <a:extLst>
              <a:ext uri="{FF2B5EF4-FFF2-40B4-BE49-F238E27FC236}">
                <a16:creationId xmlns:a16="http://schemas.microsoft.com/office/drawing/2014/main" id="{F7013330-9E51-8E22-3C03-323BE9318E7C}"/>
              </a:ext>
            </a:extLst>
          </p:cNvPr>
          <p:cNvGrpSpPr/>
          <p:nvPr/>
        </p:nvGrpSpPr>
        <p:grpSpPr>
          <a:xfrm>
            <a:off x="6319428" y="3643330"/>
            <a:ext cx="4141083" cy="2791354"/>
            <a:chOff x="1487880" y="741070"/>
            <a:chExt cx="4141083" cy="2791354"/>
          </a:xfrm>
        </p:grpSpPr>
        <p:sp>
          <p:nvSpPr>
            <p:cNvPr id="142" name="Rectangle 22">
              <a:extLst>
                <a:ext uri="{FF2B5EF4-FFF2-40B4-BE49-F238E27FC236}">
                  <a16:creationId xmlns:a16="http://schemas.microsoft.com/office/drawing/2014/main" id="{BA599720-7E88-3BC8-D301-64D308F850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3" name="Line 23">
              <a:extLst>
                <a:ext uri="{FF2B5EF4-FFF2-40B4-BE49-F238E27FC236}">
                  <a16:creationId xmlns:a16="http://schemas.microsoft.com/office/drawing/2014/main" id="{54DEAE32-F4F5-CA4E-F5B0-3557FAE79E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4" name="Line 25">
              <a:extLst>
                <a:ext uri="{FF2B5EF4-FFF2-40B4-BE49-F238E27FC236}">
                  <a16:creationId xmlns:a16="http://schemas.microsoft.com/office/drawing/2014/main" id="{A2D5E8EE-FAFB-AD4D-5984-3E78F349CA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5" name="Line 27">
              <a:extLst>
                <a:ext uri="{FF2B5EF4-FFF2-40B4-BE49-F238E27FC236}">
                  <a16:creationId xmlns:a16="http://schemas.microsoft.com/office/drawing/2014/main" id="{5DB41BE1-F997-6C3C-9DF0-A0F113C0D5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6" name="Line 29">
              <a:extLst>
                <a:ext uri="{FF2B5EF4-FFF2-40B4-BE49-F238E27FC236}">
                  <a16:creationId xmlns:a16="http://schemas.microsoft.com/office/drawing/2014/main" id="{ED38214D-EC02-E980-804F-6B253959A1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7" name="Line 31">
              <a:extLst>
                <a:ext uri="{FF2B5EF4-FFF2-40B4-BE49-F238E27FC236}">
                  <a16:creationId xmlns:a16="http://schemas.microsoft.com/office/drawing/2014/main" id="{B14879DC-D827-4AE8-1770-2ACD496077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8" name="Line 33">
              <a:extLst>
                <a:ext uri="{FF2B5EF4-FFF2-40B4-BE49-F238E27FC236}">
                  <a16:creationId xmlns:a16="http://schemas.microsoft.com/office/drawing/2014/main" id="{06D5CB23-4E7B-DBCE-1C64-7A1E14BA11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9" name="Line 35">
              <a:extLst>
                <a:ext uri="{FF2B5EF4-FFF2-40B4-BE49-F238E27FC236}">
                  <a16:creationId xmlns:a16="http://schemas.microsoft.com/office/drawing/2014/main" id="{F0FF1A52-FB27-745F-4AD8-59E503BC41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0" name="Line 6">
              <a:extLst>
                <a:ext uri="{FF2B5EF4-FFF2-40B4-BE49-F238E27FC236}">
                  <a16:creationId xmlns:a16="http://schemas.microsoft.com/office/drawing/2014/main" id="{A35DC27F-6280-353B-ADD0-63680D8E82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1" name="Line 8">
              <a:extLst>
                <a:ext uri="{FF2B5EF4-FFF2-40B4-BE49-F238E27FC236}">
                  <a16:creationId xmlns:a16="http://schemas.microsoft.com/office/drawing/2014/main" id="{FAE11857-D275-4593-EEAD-9D5BF52156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2" name="Line 9">
              <a:extLst>
                <a:ext uri="{FF2B5EF4-FFF2-40B4-BE49-F238E27FC236}">
                  <a16:creationId xmlns:a16="http://schemas.microsoft.com/office/drawing/2014/main" id="{D9EAB130-E9BA-8D59-F1D8-87EBAB5350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3" name="Line 11">
              <a:extLst>
                <a:ext uri="{FF2B5EF4-FFF2-40B4-BE49-F238E27FC236}">
                  <a16:creationId xmlns:a16="http://schemas.microsoft.com/office/drawing/2014/main" id="{5B540A3A-E121-9D83-613E-5BE210B171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4" name="Line 12">
              <a:extLst>
                <a:ext uri="{FF2B5EF4-FFF2-40B4-BE49-F238E27FC236}">
                  <a16:creationId xmlns:a16="http://schemas.microsoft.com/office/drawing/2014/main" id="{07C50F6F-81DB-7655-CF0A-1A82665474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5" name="Line 14">
              <a:extLst>
                <a:ext uri="{FF2B5EF4-FFF2-40B4-BE49-F238E27FC236}">
                  <a16:creationId xmlns:a16="http://schemas.microsoft.com/office/drawing/2014/main" id="{29A66B24-4F59-D5EF-A0B8-AC5C114A49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6" name="Line 23">
              <a:extLst>
                <a:ext uri="{FF2B5EF4-FFF2-40B4-BE49-F238E27FC236}">
                  <a16:creationId xmlns:a16="http://schemas.microsoft.com/office/drawing/2014/main" id="{578F6D0E-868B-0015-8109-8009B4C1AE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157" name="図形グループ 54">
              <a:extLst>
                <a:ext uri="{FF2B5EF4-FFF2-40B4-BE49-F238E27FC236}">
                  <a16:creationId xmlns:a16="http://schemas.microsoft.com/office/drawing/2014/main" id="{2AAA6E33-6FBE-54DD-8521-330F1356C1FE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164" name="Rectangle 10">
                <a:extLst>
                  <a:ext uri="{FF2B5EF4-FFF2-40B4-BE49-F238E27FC236}">
                    <a16:creationId xmlns:a16="http://schemas.microsoft.com/office/drawing/2014/main" id="{DFB4CE82-1D5C-1ACD-2B93-926184C7EE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5" name="Rectangle 13">
                <a:extLst>
                  <a:ext uri="{FF2B5EF4-FFF2-40B4-BE49-F238E27FC236}">
                    <a16:creationId xmlns:a16="http://schemas.microsoft.com/office/drawing/2014/main" id="{1748BB5F-7586-9267-8BF8-DA75780CAA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6" name="Rectangle 10">
                <a:extLst>
                  <a:ext uri="{FF2B5EF4-FFF2-40B4-BE49-F238E27FC236}">
                    <a16:creationId xmlns:a16="http://schemas.microsoft.com/office/drawing/2014/main" id="{79F6B16A-4DB0-9E3D-8445-1659B058D3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E8BB3E51-7F27-EE69-B12F-C57CCA54FF56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0DA0F85A-35C4-8E30-4768-E6E7B4F5368D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95BACCAC-61E8-4FFB-783B-2616CA13E45A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EF6BFE75-55E1-DF14-25FF-284C43EDA5FD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8829522B-59E0-DC33-297A-2E7C3B146CF4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9B8576AB-1515-D4B4-9D2F-DC475DD0D944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727B5219-8F5F-042D-2D53-01CA93BA6F7A}"/>
              </a:ext>
            </a:extLst>
          </p:cNvPr>
          <p:cNvGrpSpPr/>
          <p:nvPr/>
        </p:nvGrpSpPr>
        <p:grpSpPr>
          <a:xfrm>
            <a:off x="1200815" y="3636606"/>
            <a:ext cx="4141083" cy="2791354"/>
            <a:chOff x="1487880" y="741070"/>
            <a:chExt cx="4141083" cy="2791354"/>
          </a:xfrm>
        </p:grpSpPr>
        <p:sp>
          <p:nvSpPr>
            <p:cNvPr id="116" name="Rectangle 22">
              <a:extLst>
                <a:ext uri="{FF2B5EF4-FFF2-40B4-BE49-F238E27FC236}">
                  <a16:creationId xmlns:a16="http://schemas.microsoft.com/office/drawing/2014/main" id="{86CC5F82-6578-ADB2-E951-294A39C80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7" name="Line 23">
              <a:extLst>
                <a:ext uri="{FF2B5EF4-FFF2-40B4-BE49-F238E27FC236}">
                  <a16:creationId xmlns:a16="http://schemas.microsoft.com/office/drawing/2014/main" id="{B0C6DC00-D983-811D-BD2B-976B98ADEE9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8" name="Line 25">
              <a:extLst>
                <a:ext uri="{FF2B5EF4-FFF2-40B4-BE49-F238E27FC236}">
                  <a16:creationId xmlns:a16="http://schemas.microsoft.com/office/drawing/2014/main" id="{B51A1053-40ED-2BD1-EBA7-16FD71CD8F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9" name="Line 27">
              <a:extLst>
                <a:ext uri="{FF2B5EF4-FFF2-40B4-BE49-F238E27FC236}">
                  <a16:creationId xmlns:a16="http://schemas.microsoft.com/office/drawing/2014/main" id="{A42BB508-9B4A-1EC0-A182-7B57992B41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0" name="Line 29">
              <a:extLst>
                <a:ext uri="{FF2B5EF4-FFF2-40B4-BE49-F238E27FC236}">
                  <a16:creationId xmlns:a16="http://schemas.microsoft.com/office/drawing/2014/main" id="{B85797AB-B491-3505-1B42-478DC068E9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1" name="Line 31">
              <a:extLst>
                <a:ext uri="{FF2B5EF4-FFF2-40B4-BE49-F238E27FC236}">
                  <a16:creationId xmlns:a16="http://schemas.microsoft.com/office/drawing/2014/main" id="{96A40B12-794E-2D3E-CFE0-A48EA78094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2" name="Line 33">
              <a:extLst>
                <a:ext uri="{FF2B5EF4-FFF2-40B4-BE49-F238E27FC236}">
                  <a16:creationId xmlns:a16="http://schemas.microsoft.com/office/drawing/2014/main" id="{A691B7B5-4CC3-19F8-FF70-A08969CB20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3" name="Line 35">
              <a:extLst>
                <a:ext uri="{FF2B5EF4-FFF2-40B4-BE49-F238E27FC236}">
                  <a16:creationId xmlns:a16="http://schemas.microsoft.com/office/drawing/2014/main" id="{9522A849-1C2E-B86E-8447-2DE0AD8B9C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4" name="Line 6">
              <a:extLst>
                <a:ext uri="{FF2B5EF4-FFF2-40B4-BE49-F238E27FC236}">
                  <a16:creationId xmlns:a16="http://schemas.microsoft.com/office/drawing/2014/main" id="{09FD6458-E5A5-7B5E-EE09-C7225EDBAD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5" name="Line 8">
              <a:extLst>
                <a:ext uri="{FF2B5EF4-FFF2-40B4-BE49-F238E27FC236}">
                  <a16:creationId xmlns:a16="http://schemas.microsoft.com/office/drawing/2014/main" id="{D6E582BD-1987-B8EA-4D4D-9E8C9057FF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6" name="Line 9">
              <a:extLst>
                <a:ext uri="{FF2B5EF4-FFF2-40B4-BE49-F238E27FC236}">
                  <a16:creationId xmlns:a16="http://schemas.microsoft.com/office/drawing/2014/main" id="{D8F2A176-6F40-D599-0534-93643B9A06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7" name="Line 11">
              <a:extLst>
                <a:ext uri="{FF2B5EF4-FFF2-40B4-BE49-F238E27FC236}">
                  <a16:creationId xmlns:a16="http://schemas.microsoft.com/office/drawing/2014/main" id="{34826D9F-C381-21DC-C67F-E25AC466C4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8" name="Line 12">
              <a:extLst>
                <a:ext uri="{FF2B5EF4-FFF2-40B4-BE49-F238E27FC236}">
                  <a16:creationId xmlns:a16="http://schemas.microsoft.com/office/drawing/2014/main" id="{5A346EB4-7796-7FB5-B4C5-8CD8A95D70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9" name="Line 14">
              <a:extLst>
                <a:ext uri="{FF2B5EF4-FFF2-40B4-BE49-F238E27FC236}">
                  <a16:creationId xmlns:a16="http://schemas.microsoft.com/office/drawing/2014/main" id="{B84E56A1-9D7F-D982-1228-58D4D716BB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0" name="Line 23">
              <a:extLst>
                <a:ext uri="{FF2B5EF4-FFF2-40B4-BE49-F238E27FC236}">
                  <a16:creationId xmlns:a16="http://schemas.microsoft.com/office/drawing/2014/main" id="{DCA3F3E8-B0AC-CD00-0D6F-6876D41799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131" name="図形グループ 54">
              <a:extLst>
                <a:ext uri="{FF2B5EF4-FFF2-40B4-BE49-F238E27FC236}">
                  <a16:creationId xmlns:a16="http://schemas.microsoft.com/office/drawing/2014/main" id="{42F24EB9-EF1E-7310-AC27-06D25E7EC66B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138" name="Rectangle 10">
                <a:extLst>
                  <a:ext uri="{FF2B5EF4-FFF2-40B4-BE49-F238E27FC236}">
                    <a16:creationId xmlns:a16="http://schemas.microsoft.com/office/drawing/2014/main" id="{D4F181F8-9E26-E387-DEA4-A57B38691D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9" name="Rectangle 13">
                <a:extLst>
                  <a:ext uri="{FF2B5EF4-FFF2-40B4-BE49-F238E27FC236}">
                    <a16:creationId xmlns:a16="http://schemas.microsoft.com/office/drawing/2014/main" id="{57E168EC-C266-22E3-A5AB-7D46267EA2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40" name="Rectangle 10">
                <a:extLst>
                  <a:ext uri="{FF2B5EF4-FFF2-40B4-BE49-F238E27FC236}">
                    <a16:creationId xmlns:a16="http://schemas.microsoft.com/office/drawing/2014/main" id="{148AAB5F-9D30-0331-B7D5-7735888E12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D8613ACA-EEDC-AC84-BE60-0F98EED04375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F6A0C4B9-00FC-0C16-8276-0C60E7922747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4B4F7F64-2DE7-8CE1-22A6-EE85CA2E6E77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A42B9C6B-D3A7-A6E0-8ECC-CB27EF9E140A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4A0A6227-9745-C377-B5CC-C7968273710A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C4F451DA-853D-0B01-0274-C0A2B21FA6F5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2BFE45B6-E533-F95F-3C01-A1E351B172D7}"/>
              </a:ext>
            </a:extLst>
          </p:cNvPr>
          <p:cNvGrpSpPr/>
          <p:nvPr/>
        </p:nvGrpSpPr>
        <p:grpSpPr>
          <a:xfrm>
            <a:off x="6306822" y="683934"/>
            <a:ext cx="4141083" cy="2791354"/>
            <a:chOff x="1487880" y="741070"/>
            <a:chExt cx="4141083" cy="2791354"/>
          </a:xfrm>
        </p:grpSpPr>
        <p:sp>
          <p:nvSpPr>
            <p:cNvPr id="90" name="Rectangle 22">
              <a:extLst>
                <a:ext uri="{FF2B5EF4-FFF2-40B4-BE49-F238E27FC236}">
                  <a16:creationId xmlns:a16="http://schemas.microsoft.com/office/drawing/2014/main" id="{6653EDF6-DBDC-18E9-54EC-2C99113349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1" name="Line 23">
              <a:extLst>
                <a:ext uri="{FF2B5EF4-FFF2-40B4-BE49-F238E27FC236}">
                  <a16:creationId xmlns:a16="http://schemas.microsoft.com/office/drawing/2014/main" id="{7A14B0D1-A0FA-C99B-EE05-886CB42C88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2" name="Line 25">
              <a:extLst>
                <a:ext uri="{FF2B5EF4-FFF2-40B4-BE49-F238E27FC236}">
                  <a16:creationId xmlns:a16="http://schemas.microsoft.com/office/drawing/2014/main" id="{CD82A4A0-55DB-FAB0-CD62-270C4213BF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3" name="Line 27">
              <a:extLst>
                <a:ext uri="{FF2B5EF4-FFF2-40B4-BE49-F238E27FC236}">
                  <a16:creationId xmlns:a16="http://schemas.microsoft.com/office/drawing/2014/main" id="{5B1322EA-8B19-FCBB-FA1B-52BD432D7F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4" name="Line 29">
              <a:extLst>
                <a:ext uri="{FF2B5EF4-FFF2-40B4-BE49-F238E27FC236}">
                  <a16:creationId xmlns:a16="http://schemas.microsoft.com/office/drawing/2014/main" id="{B5BA4AF1-D3BE-7D5C-FCB9-D2EAF1A71B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5" name="Line 31">
              <a:extLst>
                <a:ext uri="{FF2B5EF4-FFF2-40B4-BE49-F238E27FC236}">
                  <a16:creationId xmlns:a16="http://schemas.microsoft.com/office/drawing/2014/main" id="{DDE3D95B-397B-98B4-3678-41CED84FAA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6" name="Line 33">
              <a:extLst>
                <a:ext uri="{FF2B5EF4-FFF2-40B4-BE49-F238E27FC236}">
                  <a16:creationId xmlns:a16="http://schemas.microsoft.com/office/drawing/2014/main" id="{C8488DE9-C0FD-9DFA-EE9D-FAF6496387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7" name="Line 35">
              <a:extLst>
                <a:ext uri="{FF2B5EF4-FFF2-40B4-BE49-F238E27FC236}">
                  <a16:creationId xmlns:a16="http://schemas.microsoft.com/office/drawing/2014/main" id="{C6CAEDAF-CDD0-E1A8-27EE-9CAF6F7EF8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8" name="Line 6">
              <a:extLst>
                <a:ext uri="{FF2B5EF4-FFF2-40B4-BE49-F238E27FC236}">
                  <a16:creationId xmlns:a16="http://schemas.microsoft.com/office/drawing/2014/main" id="{C5E11D93-2D54-6B07-30E9-F23BD6EB8B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99" name="Line 8">
              <a:extLst>
                <a:ext uri="{FF2B5EF4-FFF2-40B4-BE49-F238E27FC236}">
                  <a16:creationId xmlns:a16="http://schemas.microsoft.com/office/drawing/2014/main" id="{A9FE49C1-9166-F46F-0977-A955EA01E7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0" name="Line 9">
              <a:extLst>
                <a:ext uri="{FF2B5EF4-FFF2-40B4-BE49-F238E27FC236}">
                  <a16:creationId xmlns:a16="http://schemas.microsoft.com/office/drawing/2014/main" id="{FE501BDF-CC37-AA8C-2B63-5587739D67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1" name="Line 11">
              <a:extLst>
                <a:ext uri="{FF2B5EF4-FFF2-40B4-BE49-F238E27FC236}">
                  <a16:creationId xmlns:a16="http://schemas.microsoft.com/office/drawing/2014/main" id="{B65847F9-11E4-F28E-5E6E-D8BCE4ED87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2" name="Line 12">
              <a:extLst>
                <a:ext uri="{FF2B5EF4-FFF2-40B4-BE49-F238E27FC236}">
                  <a16:creationId xmlns:a16="http://schemas.microsoft.com/office/drawing/2014/main" id="{0F349AD5-D599-AE2F-EE00-326BFAA51F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3" name="Line 14">
              <a:extLst>
                <a:ext uri="{FF2B5EF4-FFF2-40B4-BE49-F238E27FC236}">
                  <a16:creationId xmlns:a16="http://schemas.microsoft.com/office/drawing/2014/main" id="{B3858556-5C87-6B9F-D949-AFEB839F54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4" name="Line 23">
              <a:extLst>
                <a:ext uri="{FF2B5EF4-FFF2-40B4-BE49-F238E27FC236}">
                  <a16:creationId xmlns:a16="http://schemas.microsoft.com/office/drawing/2014/main" id="{DF6EC652-0C31-1A60-C3F5-752157CE3A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105" name="図形グループ 54">
              <a:extLst>
                <a:ext uri="{FF2B5EF4-FFF2-40B4-BE49-F238E27FC236}">
                  <a16:creationId xmlns:a16="http://schemas.microsoft.com/office/drawing/2014/main" id="{BE53A381-DA5B-4209-4A2C-EB443E1BFC33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112" name="Rectangle 10">
                <a:extLst>
                  <a:ext uri="{FF2B5EF4-FFF2-40B4-BE49-F238E27FC236}">
                    <a16:creationId xmlns:a16="http://schemas.microsoft.com/office/drawing/2014/main" id="{7CCA53B0-A002-0F8A-FB35-B6ACF41436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13" name="Rectangle 13">
                <a:extLst>
                  <a:ext uri="{FF2B5EF4-FFF2-40B4-BE49-F238E27FC236}">
                    <a16:creationId xmlns:a16="http://schemas.microsoft.com/office/drawing/2014/main" id="{CD40AEC6-7B8C-CD62-B839-37C90C9A2F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14" name="Rectangle 10">
                <a:extLst>
                  <a:ext uri="{FF2B5EF4-FFF2-40B4-BE49-F238E27FC236}">
                    <a16:creationId xmlns:a16="http://schemas.microsoft.com/office/drawing/2014/main" id="{E30CFB6B-0D57-8AA9-E7BC-51AF433287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878806FB-50E9-C350-2932-032E0715DB07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C8A2114D-B23A-BA84-B1C0-14AA9AD0CC6D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F18279BC-FA2D-04E5-254D-79EC479F1DBB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4A1BED16-2948-AC83-6A46-9FD56A631D1C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0F9948E8-E29D-50F5-7EF1-93BD1E0374B3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8B0FABD0-74CD-C38E-C972-FD6D5228EBD8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5E3A1160-F477-F82B-E0FD-99E7D5E5E233}"/>
              </a:ext>
            </a:extLst>
          </p:cNvPr>
          <p:cNvGrpSpPr/>
          <p:nvPr/>
        </p:nvGrpSpPr>
        <p:grpSpPr>
          <a:xfrm>
            <a:off x="1197600" y="697927"/>
            <a:ext cx="4141083" cy="2791354"/>
            <a:chOff x="1487880" y="741070"/>
            <a:chExt cx="4141083" cy="2791354"/>
          </a:xfrm>
        </p:grpSpPr>
        <p:sp>
          <p:nvSpPr>
            <p:cNvPr id="46" name="Rectangle 22">
              <a:extLst>
                <a:ext uri="{FF2B5EF4-FFF2-40B4-BE49-F238E27FC236}">
                  <a16:creationId xmlns:a16="http://schemas.microsoft.com/office/drawing/2014/main" id="{1005C80F-01DD-CD96-144A-B524AE85CC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Line 23">
              <a:extLst>
                <a:ext uri="{FF2B5EF4-FFF2-40B4-BE49-F238E27FC236}">
                  <a16:creationId xmlns:a16="http://schemas.microsoft.com/office/drawing/2014/main" id="{66C4FEED-FC98-D204-5DC3-CFDA55DD2F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Line 25">
              <a:extLst>
                <a:ext uri="{FF2B5EF4-FFF2-40B4-BE49-F238E27FC236}">
                  <a16:creationId xmlns:a16="http://schemas.microsoft.com/office/drawing/2014/main" id="{1E7C67B3-3017-AE5F-EA50-47B5153B01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" name="Line 27">
              <a:extLst>
                <a:ext uri="{FF2B5EF4-FFF2-40B4-BE49-F238E27FC236}">
                  <a16:creationId xmlns:a16="http://schemas.microsoft.com/office/drawing/2014/main" id="{70293940-2A45-4FD8-E418-3C5B5A68B8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" name="Line 29">
              <a:extLst>
                <a:ext uri="{FF2B5EF4-FFF2-40B4-BE49-F238E27FC236}">
                  <a16:creationId xmlns:a16="http://schemas.microsoft.com/office/drawing/2014/main" id="{48269F75-6FCC-E8FC-ACC2-96AA09A377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1" name="Line 31">
              <a:extLst>
                <a:ext uri="{FF2B5EF4-FFF2-40B4-BE49-F238E27FC236}">
                  <a16:creationId xmlns:a16="http://schemas.microsoft.com/office/drawing/2014/main" id="{7AA62F89-1EB8-D8AC-5A42-8E69A28963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Line 33">
              <a:extLst>
                <a:ext uri="{FF2B5EF4-FFF2-40B4-BE49-F238E27FC236}">
                  <a16:creationId xmlns:a16="http://schemas.microsoft.com/office/drawing/2014/main" id="{BE63DC94-515B-09BC-FF41-090BF4DB33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Line 35">
              <a:extLst>
                <a:ext uri="{FF2B5EF4-FFF2-40B4-BE49-F238E27FC236}">
                  <a16:creationId xmlns:a16="http://schemas.microsoft.com/office/drawing/2014/main" id="{B50D588B-952A-ECF4-559A-A13E74C61D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" name="Line 6">
              <a:extLst>
                <a:ext uri="{FF2B5EF4-FFF2-40B4-BE49-F238E27FC236}">
                  <a16:creationId xmlns:a16="http://schemas.microsoft.com/office/drawing/2014/main" id="{B115048B-C350-04CF-A64B-4E7B349DF7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4" name="Line 8">
              <a:extLst>
                <a:ext uri="{FF2B5EF4-FFF2-40B4-BE49-F238E27FC236}">
                  <a16:creationId xmlns:a16="http://schemas.microsoft.com/office/drawing/2014/main" id="{66156174-E97C-4E49-1B8B-84A9BF586B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5" name="Line 9">
              <a:extLst>
                <a:ext uri="{FF2B5EF4-FFF2-40B4-BE49-F238E27FC236}">
                  <a16:creationId xmlns:a16="http://schemas.microsoft.com/office/drawing/2014/main" id="{1DF7AB62-7AB6-E01C-FF2D-2581539BF0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6" name="Line 11">
              <a:extLst>
                <a:ext uri="{FF2B5EF4-FFF2-40B4-BE49-F238E27FC236}">
                  <a16:creationId xmlns:a16="http://schemas.microsoft.com/office/drawing/2014/main" id="{0A06E783-4F34-618E-9A35-14CD94ECBF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7" name="Line 12">
              <a:extLst>
                <a:ext uri="{FF2B5EF4-FFF2-40B4-BE49-F238E27FC236}">
                  <a16:creationId xmlns:a16="http://schemas.microsoft.com/office/drawing/2014/main" id="{69C8ECAF-161B-1201-DB79-786ACBBDCF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8" name="Line 14">
              <a:extLst>
                <a:ext uri="{FF2B5EF4-FFF2-40B4-BE49-F238E27FC236}">
                  <a16:creationId xmlns:a16="http://schemas.microsoft.com/office/drawing/2014/main" id="{35107D5B-F663-DA0D-D5C5-A41FBC4B7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1" name="Line 23">
              <a:extLst>
                <a:ext uri="{FF2B5EF4-FFF2-40B4-BE49-F238E27FC236}">
                  <a16:creationId xmlns:a16="http://schemas.microsoft.com/office/drawing/2014/main" id="{D313D48C-A281-AB44-FC5A-5584226418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23" name="図形グループ 54">
              <a:extLst>
                <a:ext uri="{FF2B5EF4-FFF2-40B4-BE49-F238E27FC236}">
                  <a16:creationId xmlns:a16="http://schemas.microsoft.com/office/drawing/2014/main" id="{2CD3138F-19DF-1E8F-BFB8-A43C19CAE3A5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24" name="Rectangle 10">
                <a:extLst>
                  <a:ext uri="{FF2B5EF4-FFF2-40B4-BE49-F238E27FC236}">
                    <a16:creationId xmlns:a16="http://schemas.microsoft.com/office/drawing/2014/main" id="{0A352005-B8AD-B1C5-D886-F3FD15BF16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5" name="Rectangle 13">
                <a:extLst>
                  <a:ext uri="{FF2B5EF4-FFF2-40B4-BE49-F238E27FC236}">
                    <a16:creationId xmlns:a16="http://schemas.microsoft.com/office/drawing/2014/main" id="{BF811C73-0DDA-AA40-EA59-6964F85B57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6" name="Rectangle 10">
                <a:extLst>
                  <a:ext uri="{FF2B5EF4-FFF2-40B4-BE49-F238E27FC236}">
                    <a16:creationId xmlns:a16="http://schemas.microsoft.com/office/drawing/2014/main" id="{7D42FA6C-38A3-A01E-350D-0418CE05C6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E63BACD-575B-D441-E776-DA76BF561A07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47E0F02C-B3BB-322D-7A99-E09451472718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38265A1-4111-AE59-751C-761448D60547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0D08AA6-78E6-B385-BB9D-A2FB512AE1D4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97F11D48-C1F0-697F-815C-115A0D93D7B1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8F127B2D-EFDD-4E86-0139-9BFCD70DF023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0" name="Freeform 19">
            <a:extLst>
              <a:ext uri="{FF2B5EF4-FFF2-40B4-BE49-F238E27FC236}">
                <a16:creationId xmlns:a16="http://schemas.microsoft.com/office/drawing/2014/main" id="{9BB51C89-FEA3-60D1-6D39-BC637CDA5D39}"/>
              </a:ext>
            </a:extLst>
          </p:cNvPr>
          <p:cNvSpPr>
            <a:spLocks/>
          </p:cNvSpPr>
          <p:nvPr/>
        </p:nvSpPr>
        <p:spPr bwMode="auto">
          <a:xfrm>
            <a:off x="1987002" y="2355744"/>
            <a:ext cx="3091652" cy="365895"/>
          </a:xfrm>
          <a:custGeom>
            <a:avLst/>
            <a:gdLst>
              <a:gd name="T0" fmla="*/ 82 w 1636"/>
              <a:gd name="T1" fmla="*/ 191 h 198"/>
              <a:gd name="T2" fmla="*/ 106 w 1636"/>
              <a:gd name="T3" fmla="*/ 183 h 198"/>
              <a:gd name="T4" fmla="*/ 143 w 1636"/>
              <a:gd name="T5" fmla="*/ 169 h 198"/>
              <a:gd name="T6" fmla="*/ 150 w 1636"/>
              <a:gd name="T7" fmla="*/ 154 h 198"/>
              <a:gd name="T8" fmla="*/ 176 w 1636"/>
              <a:gd name="T9" fmla="*/ 147 h 198"/>
              <a:gd name="T10" fmla="*/ 182 w 1636"/>
              <a:gd name="T11" fmla="*/ 133 h 198"/>
              <a:gd name="T12" fmla="*/ 194 w 1636"/>
              <a:gd name="T13" fmla="*/ 125 h 198"/>
              <a:gd name="T14" fmla="*/ 202 w 1636"/>
              <a:gd name="T15" fmla="*/ 111 h 198"/>
              <a:gd name="T16" fmla="*/ 235 w 1636"/>
              <a:gd name="T17" fmla="*/ 96 h 198"/>
              <a:gd name="T18" fmla="*/ 271 w 1636"/>
              <a:gd name="T19" fmla="*/ 96 h 198"/>
              <a:gd name="T20" fmla="*/ 307 w 1636"/>
              <a:gd name="T21" fmla="*/ 89 h 198"/>
              <a:gd name="T22" fmla="*/ 328 w 1636"/>
              <a:gd name="T23" fmla="*/ 81 h 198"/>
              <a:gd name="T24" fmla="*/ 351 w 1636"/>
              <a:gd name="T25" fmla="*/ 66 h 198"/>
              <a:gd name="T26" fmla="*/ 369 w 1636"/>
              <a:gd name="T27" fmla="*/ 59 h 198"/>
              <a:gd name="T28" fmla="*/ 386 w 1636"/>
              <a:gd name="T29" fmla="*/ 51 h 198"/>
              <a:gd name="T30" fmla="*/ 398 w 1636"/>
              <a:gd name="T31" fmla="*/ 44 h 198"/>
              <a:gd name="T32" fmla="*/ 421 w 1636"/>
              <a:gd name="T33" fmla="*/ 36 h 198"/>
              <a:gd name="T34" fmla="*/ 445 w 1636"/>
              <a:gd name="T35" fmla="*/ 28 h 198"/>
              <a:gd name="T36" fmla="*/ 472 w 1636"/>
              <a:gd name="T37" fmla="*/ 28 h 198"/>
              <a:gd name="T38" fmla="*/ 512 w 1636"/>
              <a:gd name="T39" fmla="*/ 28 h 198"/>
              <a:gd name="T40" fmla="*/ 536 w 1636"/>
              <a:gd name="T41" fmla="*/ 20 h 198"/>
              <a:gd name="T42" fmla="*/ 555 w 1636"/>
              <a:gd name="T43" fmla="*/ 20 h 198"/>
              <a:gd name="T44" fmla="*/ 571 w 1636"/>
              <a:gd name="T45" fmla="*/ 20 h 198"/>
              <a:gd name="T46" fmla="*/ 587 w 1636"/>
              <a:gd name="T47" fmla="*/ 20 h 198"/>
              <a:gd name="T48" fmla="*/ 608 w 1636"/>
              <a:gd name="T49" fmla="*/ 11 h 198"/>
              <a:gd name="T50" fmla="*/ 627 w 1636"/>
              <a:gd name="T51" fmla="*/ 11 h 198"/>
              <a:gd name="T52" fmla="*/ 642 w 1636"/>
              <a:gd name="T53" fmla="*/ 11 h 198"/>
              <a:gd name="T54" fmla="*/ 679 w 1636"/>
              <a:gd name="T55" fmla="*/ 11 h 198"/>
              <a:gd name="T56" fmla="*/ 690 w 1636"/>
              <a:gd name="T57" fmla="*/ 0 h 198"/>
              <a:gd name="T58" fmla="*/ 709 w 1636"/>
              <a:gd name="T59" fmla="*/ 0 h 198"/>
              <a:gd name="T60" fmla="*/ 728 w 1636"/>
              <a:gd name="T61" fmla="*/ 0 h 198"/>
              <a:gd name="T62" fmla="*/ 744 w 1636"/>
              <a:gd name="T63" fmla="*/ 0 h 198"/>
              <a:gd name="T64" fmla="*/ 762 w 1636"/>
              <a:gd name="T65" fmla="*/ 0 h 198"/>
              <a:gd name="T66" fmla="*/ 780 w 1636"/>
              <a:gd name="T67" fmla="*/ 0 h 198"/>
              <a:gd name="T68" fmla="*/ 798 w 1636"/>
              <a:gd name="T69" fmla="*/ 0 h 198"/>
              <a:gd name="T70" fmla="*/ 816 w 1636"/>
              <a:gd name="T71" fmla="*/ 0 h 198"/>
              <a:gd name="T72" fmla="*/ 839 w 1636"/>
              <a:gd name="T73" fmla="*/ 0 h 198"/>
              <a:gd name="T74" fmla="*/ 855 w 1636"/>
              <a:gd name="T75" fmla="*/ 0 h 198"/>
              <a:gd name="T76" fmla="*/ 886 w 1636"/>
              <a:gd name="T77" fmla="*/ 0 h 198"/>
              <a:gd name="T78" fmla="*/ 900 w 1636"/>
              <a:gd name="T79" fmla="*/ 0 h 198"/>
              <a:gd name="T80" fmla="*/ 918 w 1636"/>
              <a:gd name="T81" fmla="*/ 0 h 198"/>
              <a:gd name="T82" fmla="*/ 938 w 1636"/>
              <a:gd name="T83" fmla="*/ 0 h 198"/>
              <a:gd name="T84" fmla="*/ 960 w 1636"/>
              <a:gd name="T85" fmla="*/ 0 h 198"/>
              <a:gd name="T86" fmla="*/ 979 w 1636"/>
              <a:gd name="T87" fmla="*/ 0 h 198"/>
              <a:gd name="T88" fmla="*/ 997 w 1636"/>
              <a:gd name="T89" fmla="*/ 0 h 198"/>
              <a:gd name="T90" fmla="*/ 1027 w 1636"/>
              <a:gd name="T91" fmla="*/ 0 h 198"/>
              <a:gd name="T92" fmla="*/ 1053 w 1636"/>
              <a:gd name="T93" fmla="*/ 0 h 198"/>
              <a:gd name="T94" fmla="*/ 1079 w 1636"/>
              <a:gd name="T95" fmla="*/ 0 h 198"/>
              <a:gd name="T96" fmla="*/ 1095 w 1636"/>
              <a:gd name="T97" fmla="*/ 0 h 198"/>
              <a:gd name="T98" fmla="*/ 1130 w 1636"/>
              <a:gd name="T99" fmla="*/ 0 h 198"/>
              <a:gd name="T100" fmla="*/ 1174 w 1636"/>
              <a:gd name="T101" fmla="*/ 0 h 198"/>
              <a:gd name="T102" fmla="*/ 1379 w 1636"/>
              <a:gd name="T103" fmla="*/ 0 h 198"/>
              <a:gd name="T104" fmla="*/ 1487 w 1636"/>
              <a:gd name="T105" fmla="*/ 0 h 1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636" h="198">
                <a:moveTo>
                  <a:pt x="0" y="198"/>
                </a:moveTo>
                <a:lnTo>
                  <a:pt x="82" y="198"/>
                </a:lnTo>
                <a:lnTo>
                  <a:pt x="82" y="191"/>
                </a:lnTo>
                <a:lnTo>
                  <a:pt x="101" y="191"/>
                </a:lnTo>
                <a:lnTo>
                  <a:pt x="101" y="183"/>
                </a:lnTo>
                <a:lnTo>
                  <a:pt x="106" y="183"/>
                </a:lnTo>
                <a:lnTo>
                  <a:pt x="106" y="176"/>
                </a:lnTo>
                <a:lnTo>
                  <a:pt x="109" y="169"/>
                </a:lnTo>
                <a:lnTo>
                  <a:pt x="143" y="169"/>
                </a:lnTo>
                <a:lnTo>
                  <a:pt x="146" y="162"/>
                </a:lnTo>
                <a:lnTo>
                  <a:pt x="150" y="162"/>
                </a:lnTo>
                <a:lnTo>
                  <a:pt x="150" y="154"/>
                </a:lnTo>
                <a:lnTo>
                  <a:pt x="159" y="154"/>
                </a:lnTo>
                <a:lnTo>
                  <a:pt x="159" y="147"/>
                </a:lnTo>
                <a:lnTo>
                  <a:pt x="176" y="147"/>
                </a:lnTo>
                <a:lnTo>
                  <a:pt x="176" y="140"/>
                </a:lnTo>
                <a:lnTo>
                  <a:pt x="181" y="140"/>
                </a:lnTo>
                <a:lnTo>
                  <a:pt x="182" y="133"/>
                </a:lnTo>
                <a:lnTo>
                  <a:pt x="186" y="133"/>
                </a:lnTo>
                <a:lnTo>
                  <a:pt x="186" y="125"/>
                </a:lnTo>
                <a:lnTo>
                  <a:pt x="194" y="125"/>
                </a:lnTo>
                <a:lnTo>
                  <a:pt x="194" y="118"/>
                </a:lnTo>
                <a:lnTo>
                  <a:pt x="196" y="111"/>
                </a:lnTo>
                <a:lnTo>
                  <a:pt x="202" y="111"/>
                </a:lnTo>
                <a:lnTo>
                  <a:pt x="202" y="104"/>
                </a:lnTo>
                <a:lnTo>
                  <a:pt x="235" y="104"/>
                </a:lnTo>
                <a:lnTo>
                  <a:pt x="235" y="96"/>
                </a:lnTo>
                <a:lnTo>
                  <a:pt x="248" y="96"/>
                </a:lnTo>
                <a:lnTo>
                  <a:pt x="263" y="96"/>
                </a:lnTo>
                <a:lnTo>
                  <a:pt x="271" y="96"/>
                </a:lnTo>
                <a:lnTo>
                  <a:pt x="296" y="96"/>
                </a:lnTo>
                <a:lnTo>
                  <a:pt x="296" y="89"/>
                </a:lnTo>
                <a:lnTo>
                  <a:pt x="307" y="89"/>
                </a:lnTo>
                <a:lnTo>
                  <a:pt x="322" y="89"/>
                </a:lnTo>
                <a:lnTo>
                  <a:pt x="322" y="81"/>
                </a:lnTo>
                <a:lnTo>
                  <a:pt x="328" y="81"/>
                </a:lnTo>
                <a:lnTo>
                  <a:pt x="328" y="74"/>
                </a:lnTo>
                <a:lnTo>
                  <a:pt x="333" y="66"/>
                </a:lnTo>
                <a:lnTo>
                  <a:pt x="351" y="66"/>
                </a:lnTo>
                <a:lnTo>
                  <a:pt x="359" y="66"/>
                </a:lnTo>
                <a:lnTo>
                  <a:pt x="369" y="66"/>
                </a:lnTo>
                <a:lnTo>
                  <a:pt x="369" y="59"/>
                </a:lnTo>
                <a:lnTo>
                  <a:pt x="372" y="59"/>
                </a:lnTo>
                <a:lnTo>
                  <a:pt x="373" y="51"/>
                </a:lnTo>
                <a:lnTo>
                  <a:pt x="386" y="51"/>
                </a:lnTo>
                <a:lnTo>
                  <a:pt x="392" y="51"/>
                </a:lnTo>
                <a:lnTo>
                  <a:pt x="398" y="51"/>
                </a:lnTo>
                <a:lnTo>
                  <a:pt x="398" y="44"/>
                </a:lnTo>
                <a:lnTo>
                  <a:pt x="400" y="36"/>
                </a:lnTo>
                <a:lnTo>
                  <a:pt x="416" y="36"/>
                </a:lnTo>
                <a:lnTo>
                  <a:pt x="421" y="36"/>
                </a:lnTo>
                <a:lnTo>
                  <a:pt x="426" y="36"/>
                </a:lnTo>
                <a:lnTo>
                  <a:pt x="428" y="28"/>
                </a:lnTo>
                <a:lnTo>
                  <a:pt x="445" y="28"/>
                </a:lnTo>
                <a:lnTo>
                  <a:pt x="455" y="28"/>
                </a:lnTo>
                <a:lnTo>
                  <a:pt x="461" y="28"/>
                </a:lnTo>
                <a:lnTo>
                  <a:pt x="472" y="28"/>
                </a:lnTo>
                <a:lnTo>
                  <a:pt x="494" y="28"/>
                </a:lnTo>
                <a:lnTo>
                  <a:pt x="505" y="28"/>
                </a:lnTo>
                <a:lnTo>
                  <a:pt x="512" y="28"/>
                </a:lnTo>
                <a:lnTo>
                  <a:pt x="518" y="28"/>
                </a:lnTo>
                <a:lnTo>
                  <a:pt x="533" y="28"/>
                </a:lnTo>
                <a:lnTo>
                  <a:pt x="536" y="20"/>
                </a:lnTo>
                <a:lnTo>
                  <a:pt x="540" y="20"/>
                </a:lnTo>
                <a:lnTo>
                  <a:pt x="548" y="20"/>
                </a:lnTo>
                <a:lnTo>
                  <a:pt x="555" y="20"/>
                </a:lnTo>
                <a:lnTo>
                  <a:pt x="562" y="20"/>
                </a:lnTo>
                <a:lnTo>
                  <a:pt x="564" y="20"/>
                </a:lnTo>
                <a:lnTo>
                  <a:pt x="571" y="20"/>
                </a:lnTo>
                <a:lnTo>
                  <a:pt x="575" y="20"/>
                </a:lnTo>
                <a:lnTo>
                  <a:pt x="582" y="20"/>
                </a:lnTo>
                <a:lnTo>
                  <a:pt x="587" y="20"/>
                </a:lnTo>
                <a:lnTo>
                  <a:pt x="599" y="20"/>
                </a:lnTo>
                <a:lnTo>
                  <a:pt x="608" y="20"/>
                </a:lnTo>
                <a:lnTo>
                  <a:pt x="608" y="11"/>
                </a:lnTo>
                <a:lnTo>
                  <a:pt x="612" y="11"/>
                </a:lnTo>
                <a:lnTo>
                  <a:pt x="618" y="11"/>
                </a:lnTo>
                <a:lnTo>
                  <a:pt x="627" y="11"/>
                </a:lnTo>
                <a:lnTo>
                  <a:pt x="631" y="11"/>
                </a:lnTo>
                <a:lnTo>
                  <a:pt x="638" y="11"/>
                </a:lnTo>
                <a:lnTo>
                  <a:pt x="642" y="11"/>
                </a:lnTo>
                <a:lnTo>
                  <a:pt x="661" y="11"/>
                </a:lnTo>
                <a:lnTo>
                  <a:pt x="674" y="11"/>
                </a:lnTo>
                <a:lnTo>
                  <a:pt x="679" y="11"/>
                </a:lnTo>
                <a:lnTo>
                  <a:pt x="684" y="11"/>
                </a:lnTo>
                <a:lnTo>
                  <a:pt x="688" y="0"/>
                </a:lnTo>
                <a:lnTo>
                  <a:pt x="690" y="0"/>
                </a:lnTo>
                <a:lnTo>
                  <a:pt x="698" y="0"/>
                </a:lnTo>
                <a:lnTo>
                  <a:pt x="704" y="0"/>
                </a:lnTo>
                <a:lnTo>
                  <a:pt x="709" y="0"/>
                </a:lnTo>
                <a:lnTo>
                  <a:pt x="714" y="0"/>
                </a:lnTo>
                <a:lnTo>
                  <a:pt x="720" y="0"/>
                </a:lnTo>
                <a:lnTo>
                  <a:pt x="728" y="0"/>
                </a:lnTo>
                <a:lnTo>
                  <a:pt x="733" y="0"/>
                </a:lnTo>
                <a:lnTo>
                  <a:pt x="740" y="0"/>
                </a:lnTo>
                <a:lnTo>
                  <a:pt x="744" y="0"/>
                </a:lnTo>
                <a:lnTo>
                  <a:pt x="751" y="0"/>
                </a:lnTo>
                <a:lnTo>
                  <a:pt x="758" y="0"/>
                </a:lnTo>
                <a:lnTo>
                  <a:pt x="762" y="0"/>
                </a:lnTo>
                <a:lnTo>
                  <a:pt x="769" y="0"/>
                </a:lnTo>
                <a:lnTo>
                  <a:pt x="774" y="0"/>
                </a:lnTo>
                <a:lnTo>
                  <a:pt x="780" y="0"/>
                </a:lnTo>
                <a:lnTo>
                  <a:pt x="786" y="0"/>
                </a:lnTo>
                <a:lnTo>
                  <a:pt x="797" y="0"/>
                </a:lnTo>
                <a:lnTo>
                  <a:pt x="798" y="0"/>
                </a:lnTo>
                <a:lnTo>
                  <a:pt x="804" y="0"/>
                </a:lnTo>
                <a:lnTo>
                  <a:pt x="813" y="0"/>
                </a:lnTo>
                <a:lnTo>
                  <a:pt x="816" y="0"/>
                </a:lnTo>
                <a:lnTo>
                  <a:pt x="822" y="0"/>
                </a:lnTo>
                <a:lnTo>
                  <a:pt x="828" y="0"/>
                </a:lnTo>
                <a:lnTo>
                  <a:pt x="839" y="0"/>
                </a:lnTo>
                <a:lnTo>
                  <a:pt x="841" y="0"/>
                </a:lnTo>
                <a:lnTo>
                  <a:pt x="847" y="0"/>
                </a:lnTo>
                <a:lnTo>
                  <a:pt x="855" y="0"/>
                </a:lnTo>
                <a:lnTo>
                  <a:pt x="860" y="0"/>
                </a:lnTo>
                <a:lnTo>
                  <a:pt x="872" y="0"/>
                </a:lnTo>
                <a:lnTo>
                  <a:pt x="886" y="0"/>
                </a:lnTo>
                <a:lnTo>
                  <a:pt x="891" y="0"/>
                </a:lnTo>
                <a:lnTo>
                  <a:pt x="895" y="0"/>
                </a:lnTo>
                <a:lnTo>
                  <a:pt x="900" y="0"/>
                </a:lnTo>
                <a:lnTo>
                  <a:pt x="908" y="0"/>
                </a:lnTo>
                <a:lnTo>
                  <a:pt x="913" y="0"/>
                </a:lnTo>
                <a:lnTo>
                  <a:pt x="918" y="0"/>
                </a:lnTo>
                <a:lnTo>
                  <a:pt x="926" y="0"/>
                </a:lnTo>
                <a:lnTo>
                  <a:pt x="931" y="0"/>
                </a:lnTo>
                <a:lnTo>
                  <a:pt x="938" y="0"/>
                </a:lnTo>
                <a:lnTo>
                  <a:pt x="948" y="0"/>
                </a:lnTo>
                <a:lnTo>
                  <a:pt x="954" y="0"/>
                </a:lnTo>
                <a:lnTo>
                  <a:pt x="960" y="0"/>
                </a:lnTo>
                <a:lnTo>
                  <a:pt x="967" y="0"/>
                </a:lnTo>
                <a:lnTo>
                  <a:pt x="973" y="0"/>
                </a:lnTo>
                <a:lnTo>
                  <a:pt x="979" y="0"/>
                </a:lnTo>
                <a:lnTo>
                  <a:pt x="986" y="0"/>
                </a:lnTo>
                <a:lnTo>
                  <a:pt x="991" y="0"/>
                </a:lnTo>
                <a:lnTo>
                  <a:pt x="997" y="0"/>
                </a:lnTo>
                <a:lnTo>
                  <a:pt x="1008" y="0"/>
                </a:lnTo>
                <a:lnTo>
                  <a:pt x="1017" y="0"/>
                </a:lnTo>
                <a:lnTo>
                  <a:pt x="1027" y="0"/>
                </a:lnTo>
                <a:lnTo>
                  <a:pt x="1039" y="0"/>
                </a:lnTo>
                <a:lnTo>
                  <a:pt x="1050" y="0"/>
                </a:lnTo>
                <a:lnTo>
                  <a:pt x="1053" y="0"/>
                </a:lnTo>
                <a:lnTo>
                  <a:pt x="1057" y="0"/>
                </a:lnTo>
                <a:lnTo>
                  <a:pt x="1068" y="0"/>
                </a:lnTo>
                <a:lnTo>
                  <a:pt x="1079" y="0"/>
                </a:lnTo>
                <a:lnTo>
                  <a:pt x="1081" y="0"/>
                </a:lnTo>
                <a:lnTo>
                  <a:pt x="1088" y="0"/>
                </a:lnTo>
                <a:lnTo>
                  <a:pt x="1095" y="0"/>
                </a:lnTo>
                <a:lnTo>
                  <a:pt x="1101" y="0"/>
                </a:lnTo>
                <a:lnTo>
                  <a:pt x="1115" y="0"/>
                </a:lnTo>
                <a:lnTo>
                  <a:pt x="1130" y="0"/>
                </a:lnTo>
                <a:lnTo>
                  <a:pt x="1136" y="0"/>
                </a:lnTo>
                <a:lnTo>
                  <a:pt x="1150" y="0"/>
                </a:lnTo>
                <a:lnTo>
                  <a:pt x="1174" y="0"/>
                </a:lnTo>
                <a:lnTo>
                  <a:pt x="1190" y="0"/>
                </a:lnTo>
                <a:lnTo>
                  <a:pt x="1211" y="0"/>
                </a:lnTo>
                <a:lnTo>
                  <a:pt x="1379" y="0"/>
                </a:lnTo>
                <a:lnTo>
                  <a:pt x="1395" y="0"/>
                </a:lnTo>
                <a:lnTo>
                  <a:pt x="1440" y="0"/>
                </a:lnTo>
                <a:lnTo>
                  <a:pt x="1487" y="0"/>
                </a:lnTo>
                <a:lnTo>
                  <a:pt x="1581" y="0"/>
                </a:lnTo>
                <a:lnTo>
                  <a:pt x="1636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Freeform 20">
            <a:extLst>
              <a:ext uri="{FF2B5EF4-FFF2-40B4-BE49-F238E27FC236}">
                <a16:creationId xmlns:a16="http://schemas.microsoft.com/office/drawing/2014/main" id="{7D22E2BF-1C3F-D194-69E9-51F7C3BFA938}"/>
              </a:ext>
            </a:extLst>
          </p:cNvPr>
          <p:cNvSpPr>
            <a:spLocks/>
          </p:cNvSpPr>
          <p:nvPr/>
        </p:nvSpPr>
        <p:spPr bwMode="auto">
          <a:xfrm>
            <a:off x="1987002" y="2721639"/>
            <a:ext cx="3138897" cy="0"/>
          </a:xfrm>
          <a:custGeom>
            <a:avLst/>
            <a:gdLst>
              <a:gd name="T0" fmla="*/ 82 w 1661"/>
              <a:gd name="T1" fmla="*/ 189 w 1661"/>
              <a:gd name="T2" fmla="*/ 216 w 1661"/>
              <a:gd name="T3" fmla="*/ 247 w 1661"/>
              <a:gd name="T4" fmla="*/ 274 w 1661"/>
              <a:gd name="T5" fmla="*/ 285 w 1661"/>
              <a:gd name="T6" fmla="*/ 311 w 1661"/>
              <a:gd name="T7" fmla="*/ 363 w 1661"/>
              <a:gd name="T8" fmla="*/ 373 w 1661"/>
              <a:gd name="T9" fmla="*/ 383 w 1661"/>
              <a:gd name="T10" fmla="*/ 417 w 1661"/>
              <a:gd name="T11" fmla="*/ 435 w 1661"/>
              <a:gd name="T12" fmla="*/ 457 w 1661"/>
              <a:gd name="T13" fmla="*/ 478 w 1661"/>
              <a:gd name="T14" fmla="*/ 514 w 1661"/>
              <a:gd name="T15" fmla="*/ 526 w 1661"/>
              <a:gd name="T16" fmla="*/ 534 w 1661"/>
              <a:gd name="T17" fmla="*/ 554 w 1661"/>
              <a:gd name="T18" fmla="*/ 604 w 1661"/>
              <a:gd name="T19" fmla="*/ 634 w 1661"/>
              <a:gd name="T20" fmla="*/ 653 w 1661"/>
              <a:gd name="T21" fmla="*/ 671 w 1661"/>
              <a:gd name="T22" fmla="*/ 684 w 1661"/>
              <a:gd name="T23" fmla="*/ 704 w 1661"/>
              <a:gd name="T24" fmla="*/ 717 w 1661"/>
              <a:gd name="T25" fmla="*/ 734 w 1661"/>
              <a:gd name="T26" fmla="*/ 744 w 1661"/>
              <a:gd name="T27" fmla="*/ 772 w 1661"/>
              <a:gd name="T28" fmla="*/ 804 w 1661"/>
              <a:gd name="T29" fmla="*/ 845 w 1661"/>
              <a:gd name="T30" fmla="*/ 861 w 1661"/>
              <a:gd name="T31" fmla="*/ 896 w 1661"/>
              <a:gd name="T32" fmla="*/ 945 w 1661"/>
              <a:gd name="T33" fmla="*/ 1020 w 1661"/>
              <a:gd name="T34" fmla="*/ 1038 w 1661"/>
              <a:gd name="T35" fmla="*/ 1078 w 1661"/>
              <a:gd name="T36" fmla="*/ 1204 w 1661"/>
              <a:gd name="T37" fmla="*/ 1399 w 1661"/>
              <a:gd name="T38" fmla="*/ 1604 w 1661"/>
              <a:gd name="T39" fmla="*/ 1661 w 166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  <a:cxn ang="0">
                <a:pos x="T9" y="0"/>
              </a:cxn>
              <a:cxn ang="0">
                <a:pos x="T10" y="0"/>
              </a:cxn>
              <a:cxn ang="0">
                <a:pos x="T11" y="0"/>
              </a:cxn>
              <a:cxn ang="0">
                <a:pos x="T12" y="0"/>
              </a:cxn>
              <a:cxn ang="0">
                <a:pos x="T13" y="0"/>
              </a:cxn>
              <a:cxn ang="0">
                <a:pos x="T14" y="0"/>
              </a:cxn>
              <a:cxn ang="0">
                <a:pos x="T15" y="0"/>
              </a:cxn>
              <a:cxn ang="0">
                <a:pos x="T16" y="0"/>
              </a:cxn>
              <a:cxn ang="0">
                <a:pos x="T17" y="0"/>
              </a:cxn>
              <a:cxn ang="0">
                <a:pos x="T18" y="0"/>
              </a:cxn>
              <a:cxn ang="0">
                <a:pos x="T19" y="0"/>
              </a:cxn>
              <a:cxn ang="0">
                <a:pos x="T20" y="0"/>
              </a:cxn>
              <a:cxn ang="0">
                <a:pos x="T21" y="0"/>
              </a:cxn>
              <a:cxn ang="0">
                <a:pos x="T22" y="0"/>
              </a:cxn>
              <a:cxn ang="0">
                <a:pos x="T23" y="0"/>
              </a:cxn>
              <a:cxn ang="0">
                <a:pos x="T24" y="0"/>
              </a:cxn>
              <a:cxn ang="0">
                <a:pos x="T25" y="0"/>
              </a:cxn>
              <a:cxn ang="0">
                <a:pos x="T26" y="0"/>
              </a:cxn>
              <a:cxn ang="0">
                <a:pos x="T27" y="0"/>
              </a:cxn>
              <a:cxn ang="0">
                <a:pos x="T28" y="0"/>
              </a:cxn>
              <a:cxn ang="0">
                <a:pos x="T29" y="0"/>
              </a:cxn>
              <a:cxn ang="0">
                <a:pos x="T30" y="0"/>
              </a:cxn>
              <a:cxn ang="0">
                <a:pos x="T31" y="0"/>
              </a:cxn>
              <a:cxn ang="0">
                <a:pos x="T32" y="0"/>
              </a:cxn>
              <a:cxn ang="0">
                <a:pos x="T33" y="0"/>
              </a:cxn>
              <a:cxn ang="0">
                <a:pos x="T34" y="0"/>
              </a:cxn>
              <a:cxn ang="0">
                <a:pos x="T35" y="0"/>
              </a:cxn>
              <a:cxn ang="0">
                <a:pos x="T36" y="0"/>
              </a:cxn>
              <a:cxn ang="0">
                <a:pos x="T37" y="0"/>
              </a:cxn>
              <a:cxn ang="0">
                <a:pos x="T38" y="0"/>
              </a:cxn>
              <a:cxn ang="0">
                <a:pos x="T39" y="0"/>
              </a:cxn>
            </a:cxnLst>
            <a:rect l="0" t="0" r="r" b="b"/>
            <a:pathLst>
              <a:path w="1661">
                <a:moveTo>
                  <a:pt x="0" y="0"/>
                </a:moveTo>
                <a:lnTo>
                  <a:pt x="82" y="0"/>
                </a:lnTo>
                <a:lnTo>
                  <a:pt x="90" y="0"/>
                </a:lnTo>
                <a:lnTo>
                  <a:pt x="189" y="0"/>
                </a:lnTo>
                <a:lnTo>
                  <a:pt x="213" y="0"/>
                </a:lnTo>
                <a:lnTo>
                  <a:pt x="216" y="0"/>
                </a:lnTo>
                <a:lnTo>
                  <a:pt x="242" y="0"/>
                </a:lnTo>
                <a:lnTo>
                  <a:pt x="247" y="0"/>
                </a:lnTo>
                <a:lnTo>
                  <a:pt x="266" y="0"/>
                </a:lnTo>
                <a:lnTo>
                  <a:pt x="274" y="0"/>
                </a:lnTo>
                <a:lnTo>
                  <a:pt x="275" y="0"/>
                </a:lnTo>
                <a:lnTo>
                  <a:pt x="285" y="0"/>
                </a:lnTo>
                <a:lnTo>
                  <a:pt x="294" y="0"/>
                </a:lnTo>
                <a:lnTo>
                  <a:pt x="311" y="0"/>
                </a:lnTo>
                <a:lnTo>
                  <a:pt x="335" y="0"/>
                </a:lnTo>
                <a:lnTo>
                  <a:pt x="363" y="0"/>
                </a:lnTo>
                <a:lnTo>
                  <a:pt x="366" y="0"/>
                </a:lnTo>
                <a:lnTo>
                  <a:pt x="373" y="0"/>
                </a:lnTo>
                <a:lnTo>
                  <a:pt x="381" y="0"/>
                </a:lnTo>
                <a:lnTo>
                  <a:pt x="383" y="0"/>
                </a:lnTo>
                <a:lnTo>
                  <a:pt x="409" y="0"/>
                </a:lnTo>
                <a:lnTo>
                  <a:pt x="417" y="0"/>
                </a:lnTo>
                <a:lnTo>
                  <a:pt x="424" y="0"/>
                </a:lnTo>
                <a:lnTo>
                  <a:pt x="435" y="0"/>
                </a:lnTo>
                <a:lnTo>
                  <a:pt x="439" y="0"/>
                </a:lnTo>
                <a:lnTo>
                  <a:pt x="457" y="0"/>
                </a:lnTo>
                <a:lnTo>
                  <a:pt x="471" y="0"/>
                </a:lnTo>
                <a:lnTo>
                  <a:pt x="478" y="0"/>
                </a:lnTo>
                <a:lnTo>
                  <a:pt x="500" y="0"/>
                </a:lnTo>
                <a:lnTo>
                  <a:pt x="514" y="0"/>
                </a:lnTo>
                <a:lnTo>
                  <a:pt x="520" y="0"/>
                </a:lnTo>
                <a:lnTo>
                  <a:pt x="526" y="0"/>
                </a:lnTo>
                <a:lnTo>
                  <a:pt x="531" y="0"/>
                </a:lnTo>
                <a:lnTo>
                  <a:pt x="534" y="0"/>
                </a:lnTo>
                <a:lnTo>
                  <a:pt x="548" y="0"/>
                </a:lnTo>
                <a:lnTo>
                  <a:pt x="554" y="0"/>
                </a:lnTo>
                <a:lnTo>
                  <a:pt x="579" y="0"/>
                </a:lnTo>
                <a:lnTo>
                  <a:pt x="604" y="0"/>
                </a:lnTo>
                <a:lnTo>
                  <a:pt x="606" y="0"/>
                </a:lnTo>
                <a:lnTo>
                  <a:pt x="634" y="0"/>
                </a:lnTo>
                <a:lnTo>
                  <a:pt x="647" y="0"/>
                </a:lnTo>
                <a:lnTo>
                  <a:pt x="653" y="0"/>
                </a:lnTo>
                <a:lnTo>
                  <a:pt x="665" y="0"/>
                </a:lnTo>
                <a:lnTo>
                  <a:pt x="671" y="0"/>
                </a:lnTo>
                <a:lnTo>
                  <a:pt x="682" y="0"/>
                </a:lnTo>
                <a:lnTo>
                  <a:pt x="684" y="0"/>
                </a:lnTo>
                <a:lnTo>
                  <a:pt x="700" y="0"/>
                </a:lnTo>
                <a:lnTo>
                  <a:pt x="704" y="0"/>
                </a:lnTo>
                <a:lnTo>
                  <a:pt x="711" y="0"/>
                </a:lnTo>
                <a:lnTo>
                  <a:pt x="717" y="0"/>
                </a:lnTo>
                <a:lnTo>
                  <a:pt x="724" y="0"/>
                </a:lnTo>
                <a:lnTo>
                  <a:pt x="734" y="0"/>
                </a:lnTo>
                <a:lnTo>
                  <a:pt x="738" y="0"/>
                </a:lnTo>
                <a:lnTo>
                  <a:pt x="744" y="0"/>
                </a:lnTo>
                <a:lnTo>
                  <a:pt x="750" y="0"/>
                </a:lnTo>
                <a:lnTo>
                  <a:pt x="772" y="0"/>
                </a:lnTo>
                <a:lnTo>
                  <a:pt x="796" y="0"/>
                </a:lnTo>
                <a:lnTo>
                  <a:pt x="804" y="0"/>
                </a:lnTo>
                <a:lnTo>
                  <a:pt x="830" y="0"/>
                </a:lnTo>
                <a:lnTo>
                  <a:pt x="845" y="0"/>
                </a:lnTo>
                <a:lnTo>
                  <a:pt x="847" y="0"/>
                </a:lnTo>
                <a:lnTo>
                  <a:pt x="861" y="0"/>
                </a:lnTo>
                <a:lnTo>
                  <a:pt x="878" y="0"/>
                </a:lnTo>
                <a:lnTo>
                  <a:pt x="896" y="0"/>
                </a:lnTo>
                <a:lnTo>
                  <a:pt x="923" y="0"/>
                </a:lnTo>
                <a:lnTo>
                  <a:pt x="945" y="0"/>
                </a:lnTo>
                <a:lnTo>
                  <a:pt x="956" y="0"/>
                </a:lnTo>
                <a:lnTo>
                  <a:pt x="1020" y="0"/>
                </a:lnTo>
                <a:lnTo>
                  <a:pt x="1021" y="0"/>
                </a:lnTo>
                <a:lnTo>
                  <a:pt x="1038" y="0"/>
                </a:lnTo>
                <a:lnTo>
                  <a:pt x="1072" y="0"/>
                </a:lnTo>
                <a:lnTo>
                  <a:pt x="1078" y="0"/>
                </a:lnTo>
                <a:lnTo>
                  <a:pt x="1100" y="0"/>
                </a:lnTo>
                <a:lnTo>
                  <a:pt x="1204" y="0"/>
                </a:lnTo>
                <a:lnTo>
                  <a:pt x="1319" y="0"/>
                </a:lnTo>
                <a:lnTo>
                  <a:pt x="1399" y="0"/>
                </a:lnTo>
                <a:lnTo>
                  <a:pt x="1552" y="0"/>
                </a:lnTo>
                <a:lnTo>
                  <a:pt x="1604" y="0"/>
                </a:lnTo>
                <a:lnTo>
                  <a:pt x="1655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Freeform 21">
            <a:extLst>
              <a:ext uri="{FF2B5EF4-FFF2-40B4-BE49-F238E27FC236}">
                <a16:creationId xmlns:a16="http://schemas.microsoft.com/office/drawing/2014/main" id="{BBE7935C-5A32-BC2A-9D22-FF57C87E9B46}"/>
              </a:ext>
            </a:extLst>
          </p:cNvPr>
          <p:cNvSpPr>
            <a:spLocks/>
          </p:cNvSpPr>
          <p:nvPr/>
        </p:nvSpPr>
        <p:spPr bwMode="auto">
          <a:xfrm>
            <a:off x="1987002" y="2222691"/>
            <a:ext cx="3138897" cy="498948"/>
          </a:xfrm>
          <a:custGeom>
            <a:avLst/>
            <a:gdLst>
              <a:gd name="T0" fmla="*/ 90 w 1661"/>
              <a:gd name="T1" fmla="*/ 270 h 270"/>
              <a:gd name="T2" fmla="*/ 108 w 1661"/>
              <a:gd name="T3" fmla="*/ 260 h 270"/>
              <a:gd name="T4" fmla="*/ 149 w 1661"/>
              <a:gd name="T5" fmla="*/ 260 h 270"/>
              <a:gd name="T6" fmla="*/ 194 w 1661"/>
              <a:gd name="T7" fmla="*/ 260 h 270"/>
              <a:gd name="T8" fmla="*/ 205 w 1661"/>
              <a:gd name="T9" fmla="*/ 249 h 270"/>
              <a:gd name="T10" fmla="*/ 214 w 1661"/>
              <a:gd name="T11" fmla="*/ 238 h 270"/>
              <a:gd name="T12" fmla="*/ 263 w 1661"/>
              <a:gd name="T13" fmla="*/ 227 h 270"/>
              <a:gd name="T14" fmla="*/ 292 w 1661"/>
              <a:gd name="T15" fmla="*/ 227 h 270"/>
              <a:gd name="T16" fmla="*/ 358 w 1661"/>
              <a:gd name="T17" fmla="*/ 227 h 270"/>
              <a:gd name="T18" fmla="*/ 383 w 1661"/>
              <a:gd name="T19" fmla="*/ 227 h 270"/>
              <a:gd name="T20" fmla="*/ 413 w 1661"/>
              <a:gd name="T21" fmla="*/ 227 h 270"/>
              <a:gd name="T22" fmla="*/ 452 w 1661"/>
              <a:gd name="T23" fmla="*/ 227 h 270"/>
              <a:gd name="T24" fmla="*/ 480 w 1661"/>
              <a:gd name="T25" fmla="*/ 227 h 270"/>
              <a:gd name="T26" fmla="*/ 506 w 1661"/>
              <a:gd name="T27" fmla="*/ 227 h 270"/>
              <a:gd name="T28" fmla="*/ 522 w 1661"/>
              <a:gd name="T29" fmla="*/ 227 h 270"/>
              <a:gd name="T30" fmla="*/ 547 w 1661"/>
              <a:gd name="T31" fmla="*/ 227 h 270"/>
              <a:gd name="T32" fmla="*/ 584 w 1661"/>
              <a:gd name="T33" fmla="*/ 227 h 270"/>
              <a:gd name="T34" fmla="*/ 602 w 1661"/>
              <a:gd name="T35" fmla="*/ 227 h 270"/>
              <a:gd name="T36" fmla="*/ 624 w 1661"/>
              <a:gd name="T37" fmla="*/ 227 h 270"/>
              <a:gd name="T38" fmla="*/ 654 w 1661"/>
              <a:gd name="T39" fmla="*/ 227 h 270"/>
              <a:gd name="T40" fmla="*/ 672 w 1661"/>
              <a:gd name="T41" fmla="*/ 211 h 270"/>
              <a:gd name="T42" fmla="*/ 694 w 1661"/>
              <a:gd name="T43" fmla="*/ 211 h 270"/>
              <a:gd name="T44" fmla="*/ 711 w 1661"/>
              <a:gd name="T45" fmla="*/ 211 h 270"/>
              <a:gd name="T46" fmla="*/ 727 w 1661"/>
              <a:gd name="T47" fmla="*/ 211 h 270"/>
              <a:gd name="T48" fmla="*/ 751 w 1661"/>
              <a:gd name="T49" fmla="*/ 211 h 270"/>
              <a:gd name="T50" fmla="*/ 771 w 1661"/>
              <a:gd name="T51" fmla="*/ 211 h 270"/>
              <a:gd name="T52" fmla="*/ 794 w 1661"/>
              <a:gd name="T53" fmla="*/ 211 h 270"/>
              <a:gd name="T54" fmla="*/ 817 w 1661"/>
              <a:gd name="T55" fmla="*/ 211 h 270"/>
              <a:gd name="T56" fmla="*/ 841 w 1661"/>
              <a:gd name="T57" fmla="*/ 211 h 270"/>
              <a:gd name="T58" fmla="*/ 863 w 1661"/>
              <a:gd name="T59" fmla="*/ 211 h 270"/>
              <a:gd name="T60" fmla="*/ 882 w 1661"/>
              <a:gd name="T61" fmla="*/ 211 h 270"/>
              <a:gd name="T62" fmla="*/ 900 w 1661"/>
              <a:gd name="T63" fmla="*/ 211 h 270"/>
              <a:gd name="T64" fmla="*/ 919 w 1661"/>
              <a:gd name="T65" fmla="*/ 211 h 270"/>
              <a:gd name="T66" fmla="*/ 936 w 1661"/>
              <a:gd name="T67" fmla="*/ 211 h 270"/>
              <a:gd name="T68" fmla="*/ 955 w 1661"/>
              <a:gd name="T69" fmla="*/ 211 h 270"/>
              <a:gd name="T70" fmla="*/ 1003 w 1661"/>
              <a:gd name="T71" fmla="*/ 211 h 270"/>
              <a:gd name="T72" fmla="*/ 1025 w 1661"/>
              <a:gd name="T73" fmla="*/ 211 h 270"/>
              <a:gd name="T74" fmla="*/ 1044 w 1661"/>
              <a:gd name="T75" fmla="*/ 211 h 270"/>
              <a:gd name="T76" fmla="*/ 1077 w 1661"/>
              <a:gd name="T77" fmla="*/ 211 h 270"/>
              <a:gd name="T78" fmla="*/ 1132 w 1661"/>
              <a:gd name="T79" fmla="*/ 211 h 270"/>
              <a:gd name="T80" fmla="*/ 1161 w 1661"/>
              <a:gd name="T81" fmla="*/ 211 h 270"/>
              <a:gd name="T82" fmla="*/ 1196 w 1661"/>
              <a:gd name="T83" fmla="*/ 211 h 270"/>
              <a:gd name="T84" fmla="*/ 1259 w 1661"/>
              <a:gd name="T85" fmla="*/ 0 h 270"/>
              <a:gd name="T86" fmla="*/ 1343 w 1661"/>
              <a:gd name="T87" fmla="*/ 0 h 270"/>
              <a:gd name="T88" fmla="*/ 1558 w 1661"/>
              <a:gd name="T89" fmla="*/ 0 h 2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661" h="270">
                <a:moveTo>
                  <a:pt x="0" y="270"/>
                </a:moveTo>
                <a:lnTo>
                  <a:pt x="79" y="270"/>
                </a:lnTo>
                <a:lnTo>
                  <a:pt x="90" y="270"/>
                </a:lnTo>
                <a:lnTo>
                  <a:pt x="90" y="260"/>
                </a:lnTo>
                <a:lnTo>
                  <a:pt x="95" y="260"/>
                </a:lnTo>
                <a:lnTo>
                  <a:pt x="108" y="260"/>
                </a:lnTo>
                <a:lnTo>
                  <a:pt x="123" y="260"/>
                </a:lnTo>
                <a:lnTo>
                  <a:pt x="127" y="260"/>
                </a:lnTo>
                <a:lnTo>
                  <a:pt x="149" y="260"/>
                </a:lnTo>
                <a:lnTo>
                  <a:pt x="166" y="260"/>
                </a:lnTo>
                <a:lnTo>
                  <a:pt x="168" y="260"/>
                </a:lnTo>
                <a:lnTo>
                  <a:pt x="194" y="260"/>
                </a:lnTo>
                <a:lnTo>
                  <a:pt x="200" y="260"/>
                </a:lnTo>
                <a:lnTo>
                  <a:pt x="200" y="249"/>
                </a:lnTo>
                <a:lnTo>
                  <a:pt x="205" y="249"/>
                </a:lnTo>
                <a:lnTo>
                  <a:pt x="209" y="249"/>
                </a:lnTo>
                <a:lnTo>
                  <a:pt x="214" y="249"/>
                </a:lnTo>
                <a:lnTo>
                  <a:pt x="214" y="238"/>
                </a:lnTo>
                <a:lnTo>
                  <a:pt x="223" y="238"/>
                </a:lnTo>
                <a:lnTo>
                  <a:pt x="263" y="238"/>
                </a:lnTo>
                <a:lnTo>
                  <a:pt x="263" y="227"/>
                </a:lnTo>
                <a:lnTo>
                  <a:pt x="277" y="227"/>
                </a:lnTo>
                <a:lnTo>
                  <a:pt x="281" y="227"/>
                </a:lnTo>
                <a:lnTo>
                  <a:pt x="292" y="227"/>
                </a:lnTo>
                <a:lnTo>
                  <a:pt x="318" y="227"/>
                </a:lnTo>
                <a:lnTo>
                  <a:pt x="352" y="227"/>
                </a:lnTo>
                <a:lnTo>
                  <a:pt x="358" y="227"/>
                </a:lnTo>
                <a:lnTo>
                  <a:pt x="366" y="227"/>
                </a:lnTo>
                <a:lnTo>
                  <a:pt x="372" y="227"/>
                </a:lnTo>
                <a:lnTo>
                  <a:pt x="383" y="227"/>
                </a:lnTo>
                <a:lnTo>
                  <a:pt x="391" y="227"/>
                </a:lnTo>
                <a:lnTo>
                  <a:pt x="406" y="227"/>
                </a:lnTo>
                <a:lnTo>
                  <a:pt x="413" y="227"/>
                </a:lnTo>
                <a:lnTo>
                  <a:pt x="428" y="227"/>
                </a:lnTo>
                <a:lnTo>
                  <a:pt x="442" y="227"/>
                </a:lnTo>
                <a:lnTo>
                  <a:pt x="452" y="227"/>
                </a:lnTo>
                <a:lnTo>
                  <a:pt x="472" y="227"/>
                </a:lnTo>
                <a:lnTo>
                  <a:pt x="474" y="227"/>
                </a:lnTo>
                <a:lnTo>
                  <a:pt x="480" y="227"/>
                </a:lnTo>
                <a:lnTo>
                  <a:pt x="492" y="227"/>
                </a:lnTo>
                <a:lnTo>
                  <a:pt x="498" y="227"/>
                </a:lnTo>
                <a:lnTo>
                  <a:pt x="506" y="227"/>
                </a:lnTo>
                <a:lnTo>
                  <a:pt x="513" y="227"/>
                </a:lnTo>
                <a:lnTo>
                  <a:pt x="520" y="227"/>
                </a:lnTo>
                <a:lnTo>
                  <a:pt x="522" y="227"/>
                </a:lnTo>
                <a:lnTo>
                  <a:pt x="531" y="227"/>
                </a:lnTo>
                <a:lnTo>
                  <a:pt x="533" y="227"/>
                </a:lnTo>
                <a:lnTo>
                  <a:pt x="547" y="227"/>
                </a:lnTo>
                <a:lnTo>
                  <a:pt x="552" y="227"/>
                </a:lnTo>
                <a:lnTo>
                  <a:pt x="557" y="227"/>
                </a:lnTo>
                <a:lnTo>
                  <a:pt x="584" y="227"/>
                </a:lnTo>
                <a:lnTo>
                  <a:pt x="588" y="227"/>
                </a:lnTo>
                <a:lnTo>
                  <a:pt x="595" y="227"/>
                </a:lnTo>
                <a:lnTo>
                  <a:pt x="602" y="227"/>
                </a:lnTo>
                <a:lnTo>
                  <a:pt x="607" y="227"/>
                </a:lnTo>
                <a:lnTo>
                  <a:pt x="612" y="227"/>
                </a:lnTo>
                <a:lnTo>
                  <a:pt x="624" y="227"/>
                </a:lnTo>
                <a:lnTo>
                  <a:pt x="635" y="227"/>
                </a:lnTo>
                <a:lnTo>
                  <a:pt x="648" y="227"/>
                </a:lnTo>
                <a:lnTo>
                  <a:pt x="654" y="227"/>
                </a:lnTo>
                <a:lnTo>
                  <a:pt x="654" y="211"/>
                </a:lnTo>
                <a:lnTo>
                  <a:pt x="666" y="211"/>
                </a:lnTo>
                <a:lnTo>
                  <a:pt x="672" y="211"/>
                </a:lnTo>
                <a:lnTo>
                  <a:pt x="678" y="211"/>
                </a:lnTo>
                <a:lnTo>
                  <a:pt x="689" y="211"/>
                </a:lnTo>
                <a:lnTo>
                  <a:pt x="694" y="211"/>
                </a:lnTo>
                <a:lnTo>
                  <a:pt x="696" y="211"/>
                </a:lnTo>
                <a:lnTo>
                  <a:pt x="702" y="211"/>
                </a:lnTo>
                <a:lnTo>
                  <a:pt x="711" y="211"/>
                </a:lnTo>
                <a:lnTo>
                  <a:pt x="717" y="211"/>
                </a:lnTo>
                <a:lnTo>
                  <a:pt x="722" y="211"/>
                </a:lnTo>
                <a:lnTo>
                  <a:pt x="727" y="211"/>
                </a:lnTo>
                <a:lnTo>
                  <a:pt x="731" y="211"/>
                </a:lnTo>
                <a:lnTo>
                  <a:pt x="747" y="211"/>
                </a:lnTo>
                <a:lnTo>
                  <a:pt x="751" y="211"/>
                </a:lnTo>
                <a:lnTo>
                  <a:pt x="757" y="211"/>
                </a:lnTo>
                <a:lnTo>
                  <a:pt x="763" y="211"/>
                </a:lnTo>
                <a:lnTo>
                  <a:pt x="771" y="211"/>
                </a:lnTo>
                <a:lnTo>
                  <a:pt x="782" y="211"/>
                </a:lnTo>
                <a:lnTo>
                  <a:pt x="791" y="211"/>
                </a:lnTo>
                <a:lnTo>
                  <a:pt x="794" y="211"/>
                </a:lnTo>
                <a:lnTo>
                  <a:pt x="804" y="211"/>
                </a:lnTo>
                <a:lnTo>
                  <a:pt x="810" y="211"/>
                </a:lnTo>
                <a:lnTo>
                  <a:pt x="817" y="211"/>
                </a:lnTo>
                <a:lnTo>
                  <a:pt x="823" y="211"/>
                </a:lnTo>
                <a:lnTo>
                  <a:pt x="828" y="211"/>
                </a:lnTo>
                <a:lnTo>
                  <a:pt x="841" y="211"/>
                </a:lnTo>
                <a:lnTo>
                  <a:pt x="848" y="211"/>
                </a:lnTo>
                <a:lnTo>
                  <a:pt x="856" y="211"/>
                </a:lnTo>
                <a:lnTo>
                  <a:pt x="863" y="211"/>
                </a:lnTo>
                <a:lnTo>
                  <a:pt x="871" y="211"/>
                </a:lnTo>
                <a:lnTo>
                  <a:pt x="877" y="211"/>
                </a:lnTo>
                <a:lnTo>
                  <a:pt x="882" y="211"/>
                </a:lnTo>
                <a:lnTo>
                  <a:pt x="891" y="211"/>
                </a:lnTo>
                <a:lnTo>
                  <a:pt x="894" y="211"/>
                </a:lnTo>
                <a:lnTo>
                  <a:pt x="900" y="211"/>
                </a:lnTo>
                <a:lnTo>
                  <a:pt x="907" y="211"/>
                </a:lnTo>
                <a:lnTo>
                  <a:pt x="913" y="211"/>
                </a:lnTo>
                <a:lnTo>
                  <a:pt x="919" y="211"/>
                </a:lnTo>
                <a:lnTo>
                  <a:pt x="929" y="211"/>
                </a:lnTo>
                <a:lnTo>
                  <a:pt x="932" y="211"/>
                </a:lnTo>
                <a:lnTo>
                  <a:pt x="936" y="211"/>
                </a:lnTo>
                <a:lnTo>
                  <a:pt x="942" y="211"/>
                </a:lnTo>
                <a:lnTo>
                  <a:pt x="950" y="211"/>
                </a:lnTo>
                <a:lnTo>
                  <a:pt x="955" y="211"/>
                </a:lnTo>
                <a:lnTo>
                  <a:pt x="986" y="211"/>
                </a:lnTo>
                <a:lnTo>
                  <a:pt x="991" y="211"/>
                </a:lnTo>
                <a:lnTo>
                  <a:pt x="1003" y="211"/>
                </a:lnTo>
                <a:lnTo>
                  <a:pt x="1010" y="211"/>
                </a:lnTo>
                <a:lnTo>
                  <a:pt x="1015" y="211"/>
                </a:lnTo>
                <a:lnTo>
                  <a:pt x="1025" y="211"/>
                </a:lnTo>
                <a:lnTo>
                  <a:pt x="1027" y="211"/>
                </a:lnTo>
                <a:lnTo>
                  <a:pt x="1036" y="211"/>
                </a:lnTo>
                <a:lnTo>
                  <a:pt x="1044" y="211"/>
                </a:lnTo>
                <a:lnTo>
                  <a:pt x="1058" y="211"/>
                </a:lnTo>
                <a:lnTo>
                  <a:pt x="1072" y="211"/>
                </a:lnTo>
                <a:lnTo>
                  <a:pt x="1077" y="211"/>
                </a:lnTo>
                <a:lnTo>
                  <a:pt x="1089" y="211"/>
                </a:lnTo>
                <a:lnTo>
                  <a:pt x="1122" y="211"/>
                </a:lnTo>
                <a:lnTo>
                  <a:pt x="1132" y="211"/>
                </a:lnTo>
                <a:lnTo>
                  <a:pt x="1140" y="211"/>
                </a:lnTo>
                <a:lnTo>
                  <a:pt x="1152" y="211"/>
                </a:lnTo>
                <a:lnTo>
                  <a:pt x="1161" y="211"/>
                </a:lnTo>
                <a:lnTo>
                  <a:pt x="1180" y="211"/>
                </a:lnTo>
                <a:lnTo>
                  <a:pt x="1185" y="211"/>
                </a:lnTo>
                <a:lnTo>
                  <a:pt x="1196" y="211"/>
                </a:lnTo>
                <a:lnTo>
                  <a:pt x="1196" y="0"/>
                </a:lnTo>
                <a:lnTo>
                  <a:pt x="1216" y="0"/>
                </a:lnTo>
                <a:lnTo>
                  <a:pt x="1259" y="0"/>
                </a:lnTo>
                <a:lnTo>
                  <a:pt x="1300" y="0"/>
                </a:lnTo>
                <a:lnTo>
                  <a:pt x="1334" y="0"/>
                </a:lnTo>
                <a:lnTo>
                  <a:pt x="1343" y="0"/>
                </a:lnTo>
                <a:lnTo>
                  <a:pt x="1354" y="0"/>
                </a:lnTo>
                <a:lnTo>
                  <a:pt x="1423" y="0"/>
                </a:lnTo>
                <a:lnTo>
                  <a:pt x="1558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Freeform 56">
            <a:extLst>
              <a:ext uri="{FF2B5EF4-FFF2-40B4-BE49-F238E27FC236}">
                <a16:creationId xmlns:a16="http://schemas.microsoft.com/office/drawing/2014/main" id="{24DD335F-C4C1-8B19-6F6A-E010282B0C15}"/>
              </a:ext>
            </a:extLst>
          </p:cNvPr>
          <p:cNvSpPr>
            <a:spLocks/>
          </p:cNvSpPr>
          <p:nvPr/>
        </p:nvSpPr>
        <p:spPr bwMode="auto">
          <a:xfrm>
            <a:off x="7101445" y="2320966"/>
            <a:ext cx="2629932" cy="396177"/>
          </a:xfrm>
          <a:custGeom>
            <a:avLst/>
            <a:gdLst>
              <a:gd name="T0" fmla="*/ 82 w 1395"/>
              <a:gd name="T1" fmla="*/ 203 h 212"/>
              <a:gd name="T2" fmla="*/ 101 w 1395"/>
              <a:gd name="T3" fmla="*/ 194 h 212"/>
              <a:gd name="T4" fmla="*/ 106 w 1395"/>
              <a:gd name="T5" fmla="*/ 175 h 212"/>
              <a:gd name="T6" fmla="*/ 150 w 1395"/>
              <a:gd name="T7" fmla="*/ 166 h 212"/>
              <a:gd name="T8" fmla="*/ 159 w 1395"/>
              <a:gd name="T9" fmla="*/ 147 h 212"/>
              <a:gd name="T10" fmla="*/ 181 w 1395"/>
              <a:gd name="T11" fmla="*/ 138 h 212"/>
              <a:gd name="T12" fmla="*/ 186 w 1395"/>
              <a:gd name="T13" fmla="*/ 119 h 212"/>
              <a:gd name="T14" fmla="*/ 200 w 1395"/>
              <a:gd name="T15" fmla="*/ 110 h 212"/>
              <a:gd name="T16" fmla="*/ 235 w 1395"/>
              <a:gd name="T17" fmla="*/ 92 h 212"/>
              <a:gd name="T18" fmla="*/ 296 w 1395"/>
              <a:gd name="T19" fmla="*/ 83 h 212"/>
              <a:gd name="T20" fmla="*/ 333 w 1395"/>
              <a:gd name="T21" fmla="*/ 73 h 212"/>
              <a:gd name="T22" fmla="*/ 369 w 1395"/>
              <a:gd name="T23" fmla="*/ 73 h 212"/>
              <a:gd name="T24" fmla="*/ 373 w 1395"/>
              <a:gd name="T25" fmla="*/ 54 h 212"/>
              <a:gd name="T26" fmla="*/ 398 w 1395"/>
              <a:gd name="T27" fmla="*/ 44 h 212"/>
              <a:gd name="T28" fmla="*/ 421 w 1395"/>
              <a:gd name="T29" fmla="*/ 34 h 212"/>
              <a:gd name="T30" fmla="*/ 445 w 1395"/>
              <a:gd name="T31" fmla="*/ 24 h 212"/>
              <a:gd name="T32" fmla="*/ 533 w 1395"/>
              <a:gd name="T33" fmla="*/ 24 h 212"/>
              <a:gd name="T34" fmla="*/ 562 w 1395"/>
              <a:gd name="T35" fmla="*/ 24 h 212"/>
              <a:gd name="T36" fmla="*/ 575 w 1395"/>
              <a:gd name="T37" fmla="*/ 24 h 212"/>
              <a:gd name="T38" fmla="*/ 595 w 1395"/>
              <a:gd name="T39" fmla="*/ 24 h 212"/>
              <a:gd name="T40" fmla="*/ 608 w 1395"/>
              <a:gd name="T41" fmla="*/ 13 h 212"/>
              <a:gd name="T42" fmla="*/ 626 w 1395"/>
              <a:gd name="T43" fmla="*/ 13 h 212"/>
              <a:gd name="T44" fmla="*/ 642 w 1395"/>
              <a:gd name="T45" fmla="*/ 13 h 212"/>
              <a:gd name="T46" fmla="*/ 654 w 1395"/>
              <a:gd name="T47" fmla="*/ 0 h 212"/>
              <a:gd name="T48" fmla="*/ 679 w 1395"/>
              <a:gd name="T49" fmla="*/ 0 h 212"/>
              <a:gd name="T50" fmla="*/ 698 w 1395"/>
              <a:gd name="T51" fmla="*/ 0 h 212"/>
              <a:gd name="T52" fmla="*/ 716 w 1395"/>
              <a:gd name="T53" fmla="*/ 0 h 212"/>
              <a:gd name="T54" fmla="*/ 731 w 1395"/>
              <a:gd name="T55" fmla="*/ 0 h 212"/>
              <a:gd name="T56" fmla="*/ 751 w 1395"/>
              <a:gd name="T57" fmla="*/ 0 h 212"/>
              <a:gd name="T58" fmla="*/ 769 w 1395"/>
              <a:gd name="T59" fmla="*/ 0 h 212"/>
              <a:gd name="T60" fmla="*/ 786 w 1395"/>
              <a:gd name="T61" fmla="*/ 0 h 212"/>
              <a:gd name="T62" fmla="*/ 812 w 1395"/>
              <a:gd name="T63" fmla="*/ 0 h 212"/>
              <a:gd name="T64" fmla="*/ 828 w 1395"/>
              <a:gd name="T65" fmla="*/ 0 h 212"/>
              <a:gd name="T66" fmla="*/ 847 w 1395"/>
              <a:gd name="T67" fmla="*/ 0 h 212"/>
              <a:gd name="T68" fmla="*/ 878 w 1395"/>
              <a:gd name="T69" fmla="*/ 0 h 212"/>
              <a:gd name="T70" fmla="*/ 895 w 1395"/>
              <a:gd name="T71" fmla="*/ 0 h 212"/>
              <a:gd name="T72" fmla="*/ 918 w 1395"/>
              <a:gd name="T73" fmla="*/ 0 h 212"/>
              <a:gd name="T74" fmla="*/ 938 w 1395"/>
              <a:gd name="T75" fmla="*/ 0 h 212"/>
              <a:gd name="T76" fmla="*/ 960 w 1395"/>
              <a:gd name="T77" fmla="*/ 0 h 212"/>
              <a:gd name="T78" fmla="*/ 991 w 1395"/>
              <a:gd name="T79" fmla="*/ 0 h 212"/>
              <a:gd name="T80" fmla="*/ 1017 w 1395"/>
              <a:gd name="T81" fmla="*/ 0 h 212"/>
              <a:gd name="T82" fmla="*/ 1039 w 1395"/>
              <a:gd name="T83" fmla="*/ 0 h 212"/>
              <a:gd name="T84" fmla="*/ 1079 w 1395"/>
              <a:gd name="T85" fmla="*/ 0 h 212"/>
              <a:gd name="T86" fmla="*/ 1095 w 1395"/>
              <a:gd name="T87" fmla="*/ 0 h 212"/>
              <a:gd name="T88" fmla="*/ 1136 w 1395"/>
              <a:gd name="T89" fmla="*/ 0 h 2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395" h="212">
                <a:moveTo>
                  <a:pt x="0" y="212"/>
                </a:moveTo>
                <a:lnTo>
                  <a:pt x="82" y="212"/>
                </a:lnTo>
                <a:lnTo>
                  <a:pt x="82" y="203"/>
                </a:lnTo>
                <a:lnTo>
                  <a:pt x="90" y="203"/>
                </a:lnTo>
                <a:lnTo>
                  <a:pt x="90" y="194"/>
                </a:lnTo>
                <a:lnTo>
                  <a:pt x="101" y="194"/>
                </a:lnTo>
                <a:lnTo>
                  <a:pt x="101" y="184"/>
                </a:lnTo>
                <a:lnTo>
                  <a:pt x="106" y="184"/>
                </a:lnTo>
                <a:lnTo>
                  <a:pt x="106" y="175"/>
                </a:lnTo>
                <a:lnTo>
                  <a:pt x="146" y="175"/>
                </a:lnTo>
                <a:lnTo>
                  <a:pt x="146" y="166"/>
                </a:lnTo>
                <a:lnTo>
                  <a:pt x="150" y="166"/>
                </a:lnTo>
                <a:lnTo>
                  <a:pt x="150" y="157"/>
                </a:lnTo>
                <a:lnTo>
                  <a:pt x="159" y="157"/>
                </a:lnTo>
                <a:lnTo>
                  <a:pt x="159" y="147"/>
                </a:lnTo>
                <a:lnTo>
                  <a:pt x="176" y="147"/>
                </a:lnTo>
                <a:lnTo>
                  <a:pt x="176" y="138"/>
                </a:lnTo>
                <a:lnTo>
                  <a:pt x="181" y="138"/>
                </a:lnTo>
                <a:lnTo>
                  <a:pt x="182" y="129"/>
                </a:lnTo>
                <a:lnTo>
                  <a:pt x="186" y="129"/>
                </a:lnTo>
                <a:lnTo>
                  <a:pt x="186" y="119"/>
                </a:lnTo>
                <a:lnTo>
                  <a:pt x="196" y="119"/>
                </a:lnTo>
                <a:lnTo>
                  <a:pt x="196" y="110"/>
                </a:lnTo>
                <a:lnTo>
                  <a:pt x="200" y="110"/>
                </a:lnTo>
                <a:lnTo>
                  <a:pt x="200" y="101"/>
                </a:lnTo>
                <a:lnTo>
                  <a:pt x="235" y="101"/>
                </a:lnTo>
                <a:lnTo>
                  <a:pt x="235" y="92"/>
                </a:lnTo>
                <a:lnTo>
                  <a:pt x="263" y="92"/>
                </a:lnTo>
                <a:lnTo>
                  <a:pt x="296" y="92"/>
                </a:lnTo>
                <a:lnTo>
                  <a:pt x="296" y="83"/>
                </a:lnTo>
                <a:lnTo>
                  <a:pt x="308" y="83"/>
                </a:lnTo>
                <a:lnTo>
                  <a:pt x="329" y="83"/>
                </a:lnTo>
                <a:lnTo>
                  <a:pt x="333" y="73"/>
                </a:lnTo>
                <a:lnTo>
                  <a:pt x="349" y="73"/>
                </a:lnTo>
                <a:lnTo>
                  <a:pt x="359" y="73"/>
                </a:lnTo>
                <a:lnTo>
                  <a:pt x="369" y="73"/>
                </a:lnTo>
                <a:lnTo>
                  <a:pt x="369" y="63"/>
                </a:lnTo>
                <a:lnTo>
                  <a:pt x="373" y="63"/>
                </a:lnTo>
                <a:lnTo>
                  <a:pt x="373" y="54"/>
                </a:lnTo>
                <a:lnTo>
                  <a:pt x="386" y="54"/>
                </a:lnTo>
                <a:lnTo>
                  <a:pt x="398" y="54"/>
                </a:lnTo>
                <a:lnTo>
                  <a:pt x="398" y="44"/>
                </a:lnTo>
                <a:lnTo>
                  <a:pt x="400" y="34"/>
                </a:lnTo>
                <a:lnTo>
                  <a:pt x="413" y="34"/>
                </a:lnTo>
                <a:lnTo>
                  <a:pt x="421" y="34"/>
                </a:lnTo>
                <a:lnTo>
                  <a:pt x="426" y="34"/>
                </a:lnTo>
                <a:lnTo>
                  <a:pt x="428" y="24"/>
                </a:lnTo>
                <a:lnTo>
                  <a:pt x="445" y="24"/>
                </a:lnTo>
                <a:lnTo>
                  <a:pt x="472" y="24"/>
                </a:lnTo>
                <a:lnTo>
                  <a:pt x="522" y="24"/>
                </a:lnTo>
                <a:lnTo>
                  <a:pt x="533" y="24"/>
                </a:lnTo>
                <a:lnTo>
                  <a:pt x="540" y="24"/>
                </a:lnTo>
                <a:lnTo>
                  <a:pt x="555" y="24"/>
                </a:lnTo>
                <a:lnTo>
                  <a:pt x="562" y="24"/>
                </a:lnTo>
                <a:lnTo>
                  <a:pt x="564" y="24"/>
                </a:lnTo>
                <a:lnTo>
                  <a:pt x="571" y="24"/>
                </a:lnTo>
                <a:lnTo>
                  <a:pt x="575" y="24"/>
                </a:lnTo>
                <a:lnTo>
                  <a:pt x="582" y="24"/>
                </a:lnTo>
                <a:lnTo>
                  <a:pt x="587" y="24"/>
                </a:lnTo>
                <a:lnTo>
                  <a:pt x="595" y="24"/>
                </a:lnTo>
                <a:lnTo>
                  <a:pt x="599" y="24"/>
                </a:lnTo>
                <a:lnTo>
                  <a:pt x="607" y="24"/>
                </a:lnTo>
                <a:lnTo>
                  <a:pt x="608" y="13"/>
                </a:lnTo>
                <a:lnTo>
                  <a:pt x="612" y="13"/>
                </a:lnTo>
                <a:lnTo>
                  <a:pt x="621" y="13"/>
                </a:lnTo>
                <a:lnTo>
                  <a:pt x="626" y="13"/>
                </a:lnTo>
                <a:lnTo>
                  <a:pt x="631" y="13"/>
                </a:lnTo>
                <a:lnTo>
                  <a:pt x="639" y="13"/>
                </a:lnTo>
                <a:lnTo>
                  <a:pt x="642" y="13"/>
                </a:lnTo>
                <a:lnTo>
                  <a:pt x="652" y="13"/>
                </a:lnTo>
                <a:lnTo>
                  <a:pt x="654" y="13"/>
                </a:lnTo>
                <a:lnTo>
                  <a:pt x="654" y="0"/>
                </a:lnTo>
                <a:lnTo>
                  <a:pt x="661" y="0"/>
                </a:lnTo>
                <a:lnTo>
                  <a:pt x="672" y="0"/>
                </a:lnTo>
                <a:lnTo>
                  <a:pt x="679" y="0"/>
                </a:lnTo>
                <a:lnTo>
                  <a:pt x="684" y="0"/>
                </a:lnTo>
                <a:lnTo>
                  <a:pt x="690" y="0"/>
                </a:lnTo>
                <a:lnTo>
                  <a:pt x="698" y="0"/>
                </a:lnTo>
                <a:lnTo>
                  <a:pt x="704" y="0"/>
                </a:lnTo>
                <a:lnTo>
                  <a:pt x="709" y="0"/>
                </a:lnTo>
                <a:lnTo>
                  <a:pt x="716" y="0"/>
                </a:lnTo>
                <a:lnTo>
                  <a:pt x="722" y="0"/>
                </a:lnTo>
                <a:lnTo>
                  <a:pt x="728" y="0"/>
                </a:lnTo>
                <a:lnTo>
                  <a:pt x="731" y="0"/>
                </a:lnTo>
                <a:lnTo>
                  <a:pt x="740" y="0"/>
                </a:lnTo>
                <a:lnTo>
                  <a:pt x="744" y="0"/>
                </a:lnTo>
                <a:lnTo>
                  <a:pt x="751" y="0"/>
                </a:lnTo>
                <a:lnTo>
                  <a:pt x="758" y="0"/>
                </a:lnTo>
                <a:lnTo>
                  <a:pt x="762" y="0"/>
                </a:lnTo>
                <a:lnTo>
                  <a:pt x="769" y="0"/>
                </a:lnTo>
                <a:lnTo>
                  <a:pt x="776" y="0"/>
                </a:lnTo>
                <a:lnTo>
                  <a:pt x="782" y="0"/>
                </a:lnTo>
                <a:lnTo>
                  <a:pt x="786" y="0"/>
                </a:lnTo>
                <a:lnTo>
                  <a:pt x="798" y="0"/>
                </a:lnTo>
                <a:lnTo>
                  <a:pt x="804" y="0"/>
                </a:lnTo>
                <a:lnTo>
                  <a:pt x="812" y="0"/>
                </a:lnTo>
                <a:lnTo>
                  <a:pt x="816" y="0"/>
                </a:lnTo>
                <a:lnTo>
                  <a:pt x="822" y="0"/>
                </a:lnTo>
                <a:lnTo>
                  <a:pt x="828" y="0"/>
                </a:lnTo>
                <a:lnTo>
                  <a:pt x="836" y="0"/>
                </a:lnTo>
                <a:lnTo>
                  <a:pt x="845" y="0"/>
                </a:lnTo>
                <a:lnTo>
                  <a:pt x="847" y="0"/>
                </a:lnTo>
                <a:lnTo>
                  <a:pt x="860" y="0"/>
                </a:lnTo>
                <a:lnTo>
                  <a:pt x="871" y="0"/>
                </a:lnTo>
                <a:lnTo>
                  <a:pt x="878" y="0"/>
                </a:lnTo>
                <a:lnTo>
                  <a:pt x="883" y="0"/>
                </a:lnTo>
                <a:lnTo>
                  <a:pt x="891" y="0"/>
                </a:lnTo>
                <a:lnTo>
                  <a:pt x="895" y="0"/>
                </a:lnTo>
                <a:lnTo>
                  <a:pt x="910" y="0"/>
                </a:lnTo>
                <a:lnTo>
                  <a:pt x="913" y="0"/>
                </a:lnTo>
                <a:lnTo>
                  <a:pt x="918" y="0"/>
                </a:lnTo>
                <a:lnTo>
                  <a:pt x="926" y="0"/>
                </a:lnTo>
                <a:lnTo>
                  <a:pt x="931" y="0"/>
                </a:lnTo>
                <a:lnTo>
                  <a:pt x="938" y="0"/>
                </a:lnTo>
                <a:lnTo>
                  <a:pt x="948" y="0"/>
                </a:lnTo>
                <a:lnTo>
                  <a:pt x="954" y="0"/>
                </a:lnTo>
                <a:lnTo>
                  <a:pt x="960" y="0"/>
                </a:lnTo>
                <a:lnTo>
                  <a:pt x="975" y="0"/>
                </a:lnTo>
                <a:lnTo>
                  <a:pt x="986" y="0"/>
                </a:lnTo>
                <a:lnTo>
                  <a:pt x="991" y="0"/>
                </a:lnTo>
                <a:lnTo>
                  <a:pt x="1003" y="0"/>
                </a:lnTo>
                <a:lnTo>
                  <a:pt x="1008" y="0"/>
                </a:lnTo>
                <a:lnTo>
                  <a:pt x="1017" y="0"/>
                </a:lnTo>
                <a:lnTo>
                  <a:pt x="1024" y="0"/>
                </a:lnTo>
                <a:lnTo>
                  <a:pt x="1030" y="0"/>
                </a:lnTo>
                <a:lnTo>
                  <a:pt x="1039" y="0"/>
                </a:lnTo>
                <a:lnTo>
                  <a:pt x="1053" y="0"/>
                </a:lnTo>
                <a:lnTo>
                  <a:pt x="1060" y="0"/>
                </a:lnTo>
                <a:lnTo>
                  <a:pt x="1079" y="0"/>
                </a:lnTo>
                <a:lnTo>
                  <a:pt x="1081" y="0"/>
                </a:lnTo>
                <a:lnTo>
                  <a:pt x="1088" y="0"/>
                </a:lnTo>
                <a:lnTo>
                  <a:pt x="1095" y="0"/>
                </a:lnTo>
                <a:lnTo>
                  <a:pt x="1102" y="0"/>
                </a:lnTo>
                <a:lnTo>
                  <a:pt x="1130" y="0"/>
                </a:lnTo>
                <a:lnTo>
                  <a:pt x="1136" y="0"/>
                </a:lnTo>
                <a:lnTo>
                  <a:pt x="1150" y="0"/>
                </a:lnTo>
                <a:lnTo>
                  <a:pt x="1395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Freeform 57">
            <a:extLst>
              <a:ext uri="{FF2B5EF4-FFF2-40B4-BE49-F238E27FC236}">
                <a16:creationId xmlns:a16="http://schemas.microsoft.com/office/drawing/2014/main" id="{9B19B8C0-B0BA-1279-ADE7-0532CBDC3E89}"/>
              </a:ext>
            </a:extLst>
          </p:cNvPr>
          <p:cNvSpPr>
            <a:spLocks/>
          </p:cNvSpPr>
          <p:nvPr/>
        </p:nvSpPr>
        <p:spPr bwMode="auto">
          <a:xfrm>
            <a:off x="7101445" y="2631180"/>
            <a:ext cx="2925916" cy="85963"/>
          </a:xfrm>
          <a:custGeom>
            <a:avLst/>
            <a:gdLst>
              <a:gd name="T0" fmla="*/ 0 w 1552"/>
              <a:gd name="T1" fmla="*/ 46 h 46"/>
              <a:gd name="T2" fmla="*/ 263 w 1552"/>
              <a:gd name="T3" fmla="*/ 46 h 46"/>
              <a:gd name="T4" fmla="*/ 263 w 1552"/>
              <a:gd name="T5" fmla="*/ 0 h 46"/>
              <a:gd name="T6" fmla="*/ 277 w 1552"/>
              <a:gd name="T7" fmla="*/ 0 h 46"/>
              <a:gd name="T8" fmla="*/ 281 w 1552"/>
              <a:gd name="T9" fmla="*/ 0 h 46"/>
              <a:gd name="T10" fmla="*/ 294 w 1552"/>
              <a:gd name="T11" fmla="*/ 0 h 46"/>
              <a:gd name="T12" fmla="*/ 307 w 1552"/>
              <a:gd name="T13" fmla="*/ 0 h 46"/>
              <a:gd name="T14" fmla="*/ 337 w 1552"/>
              <a:gd name="T15" fmla="*/ 0 h 46"/>
              <a:gd name="T16" fmla="*/ 363 w 1552"/>
              <a:gd name="T17" fmla="*/ 0 h 46"/>
              <a:gd name="T18" fmla="*/ 436 w 1552"/>
              <a:gd name="T19" fmla="*/ 0 h 46"/>
              <a:gd name="T20" fmla="*/ 442 w 1552"/>
              <a:gd name="T21" fmla="*/ 0 h 46"/>
              <a:gd name="T22" fmla="*/ 454 w 1552"/>
              <a:gd name="T23" fmla="*/ 0 h 46"/>
              <a:gd name="T24" fmla="*/ 520 w 1552"/>
              <a:gd name="T25" fmla="*/ 0 h 46"/>
              <a:gd name="T26" fmla="*/ 526 w 1552"/>
              <a:gd name="T27" fmla="*/ 0 h 46"/>
              <a:gd name="T28" fmla="*/ 534 w 1552"/>
              <a:gd name="T29" fmla="*/ 0 h 46"/>
              <a:gd name="T30" fmla="*/ 555 w 1552"/>
              <a:gd name="T31" fmla="*/ 0 h 46"/>
              <a:gd name="T32" fmla="*/ 585 w 1552"/>
              <a:gd name="T33" fmla="*/ 0 h 46"/>
              <a:gd name="T34" fmla="*/ 665 w 1552"/>
              <a:gd name="T35" fmla="*/ 0 h 46"/>
              <a:gd name="T36" fmla="*/ 671 w 1552"/>
              <a:gd name="T37" fmla="*/ 0 h 46"/>
              <a:gd name="T38" fmla="*/ 678 w 1552"/>
              <a:gd name="T39" fmla="*/ 0 h 46"/>
              <a:gd name="T40" fmla="*/ 694 w 1552"/>
              <a:gd name="T41" fmla="*/ 0 h 46"/>
              <a:gd name="T42" fmla="*/ 700 w 1552"/>
              <a:gd name="T43" fmla="*/ 0 h 46"/>
              <a:gd name="T44" fmla="*/ 724 w 1552"/>
              <a:gd name="T45" fmla="*/ 0 h 46"/>
              <a:gd name="T46" fmla="*/ 734 w 1552"/>
              <a:gd name="T47" fmla="*/ 0 h 46"/>
              <a:gd name="T48" fmla="*/ 738 w 1552"/>
              <a:gd name="T49" fmla="*/ 0 h 46"/>
              <a:gd name="T50" fmla="*/ 745 w 1552"/>
              <a:gd name="T51" fmla="*/ 0 h 46"/>
              <a:gd name="T52" fmla="*/ 753 w 1552"/>
              <a:gd name="T53" fmla="*/ 0 h 46"/>
              <a:gd name="T54" fmla="*/ 757 w 1552"/>
              <a:gd name="T55" fmla="*/ 0 h 46"/>
              <a:gd name="T56" fmla="*/ 785 w 1552"/>
              <a:gd name="T57" fmla="*/ 0 h 46"/>
              <a:gd name="T58" fmla="*/ 815 w 1552"/>
              <a:gd name="T59" fmla="*/ 0 h 46"/>
              <a:gd name="T60" fmla="*/ 830 w 1552"/>
              <a:gd name="T61" fmla="*/ 0 h 46"/>
              <a:gd name="T62" fmla="*/ 845 w 1552"/>
              <a:gd name="T63" fmla="*/ 0 h 46"/>
              <a:gd name="T64" fmla="*/ 878 w 1552"/>
              <a:gd name="T65" fmla="*/ 0 h 46"/>
              <a:gd name="T66" fmla="*/ 882 w 1552"/>
              <a:gd name="T67" fmla="*/ 0 h 46"/>
              <a:gd name="T68" fmla="*/ 897 w 1552"/>
              <a:gd name="T69" fmla="*/ 0 h 46"/>
              <a:gd name="T70" fmla="*/ 904 w 1552"/>
              <a:gd name="T71" fmla="*/ 0 h 46"/>
              <a:gd name="T72" fmla="*/ 907 w 1552"/>
              <a:gd name="T73" fmla="*/ 0 h 46"/>
              <a:gd name="T74" fmla="*/ 915 w 1552"/>
              <a:gd name="T75" fmla="*/ 0 h 46"/>
              <a:gd name="T76" fmla="*/ 923 w 1552"/>
              <a:gd name="T77" fmla="*/ 0 h 46"/>
              <a:gd name="T78" fmla="*/ 959 w 1552"/>
              <a:gd name="T79" fmla="*/ 0 h 46"/>
              <a:gd name="T80" fmla="*/ 1020 w 1552"/>
              <a:gd name="T81" fmla="*/ 0 h 46"/>
              <a:gd name="T82" fmla="*/ 1027 w 1552"/>
              <a:gd name="T83" fmla="*/ 0 h 46"/>
              <a:gd name="T84" fmla="*/ 1100 w 1552"/>
              <a:gd name="T85" fmla="*/ 0 h 46"/>
              <a:gd name="T86" fmla="*/ 1399 w 1552"/>
              <a:gd name="T87" fmla="*/ 0 h 46"/>
              <a:gd name="T88" fmla="*/ 1552 w 1552"/>
              <a:gd name="T8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552" h="46">
                <a:moveTo>
                  <a:pt x="0" y="46"/>
                </a:moveTo>
                <a:lnTo>
                  <a:pt x="263" y="46"/>
                </a:lnTo>
                <a:lnTo>
                  <a:pt x="263" y="0"/>
                </a:lnTo>
                <a:lnTo>
                  <a:pt x="277" y="0"/>
                </a:lnTo>
                <a:lnTo>
                  <a:pt x="281" y="0"/>
                </a:lnTo>
                <a:lnTo>
                  <a:pt x="294" y="0"/>
                </a:lnTo>
                <a:lnTo>
                  <a:pt x="307" y="0"/>
                </a:lnTo>
                <a:lnTo>
                  <a:pt x="337" y="0"/>
                </a:lnTo>
                <a:lnTo>
                  <a:pt x="363" y="0"/>
                </a:lnTo>
                <a:lnTo>
                  <a:pt x="436" y="0"/>
                </a:lnTo>
                <a:lnTo>
                  <a:pt x="442" y="0"/>
                </a:lnTo>
                <a:lnTo>
                  <a:pt x="454" y="0"/>
                </a:lnTo>
                <a:lnTo>
                  <a:pt x="520" y="0"/>
                </a:lnTo>
                <a:lnTo>
                  <a:pt x="526" y="0"/>
                </a:lnTo>
                <a:lnTo>
                  <a:pt x="534" y="0"/>
                </a:lnTo>
                <a:lnTo>
                  <a:pt x="555" y="0"/>
                </a:lnTo>
                <a:lnTo>
                  <a:pt x="585" y="0"/>
                </a:lnTo>
                <a:lnTo>
                  <a:pt x="665" y="0"/>
                </a:lnTo>
                <a:lnTo>
                  <a:pt x="671" y="0"/>
                </a:lnTo>
                <a:lnTo>
                  <a:pt x="678" y="0"/>
                </a:lnTo>
                <a:lnTo>
                  <a:pt x="694" y="0"/>
                </a:lnTo>
                <a:lnTo>
                  <a:pt x="700" y="0"/>
                </a:lnTo>
                <a:lnTo>
                  <a:pt x="724" y="0"/>
                </a:lnTo>
                <a:lnTo>
                  <a:pt x="734" y="0"/>
                </a:lnTo>
                <a:lnTo>
                  <a:pt x="738" y="0"/>
                </a:lnTo>
                <a:lnTo>
                  <a:pt x="745" y="0"/>
                </a:lnTo>
                <a:lnTo>
                  <a:pt x="753" y="0"/>
                </a:lnTo>
                <a:lnTo>
                  <a:pt x="757" y="0"/>
                </a:lnTo>
                <a:lnTo>
                  <a:pt x="785" y="0"/>
                </a:lnTo>
                <a:lnTo>
                  <a:pt x="815" y="0"/>
                </a:lnTo>
                <a:lnTo>
                  <a:pt x="830" y="0"/>
                </a:lnTo>
                <a:lnTo>
                  <a:pt x="845" y="0"/>
                </a:lnTo>
                <a:lnTo>
                  <a:pt x="878" y="0"/>
                </a:lnTo>
                <a:lnTo>
                  <a:pt x="882" y="0"/>
                </a:lnTo>
                <a:lnTo>
                  <a:pt x="897" y="0"/>
                </a:lnTo>
                <a:lnTo>
                  <a:pt x="904" y="0"/>
                </a:lnTo>
                <a:lnTo>
                  <a:pt x="907" y="0"/>
                </a:lnTo>
                <a:lnTo>
                  <a:pt x="915" y="0"/>
                </a:lnTo>
                <a:lnTo>
                  <a:pt x="923" y="0"/>
                </a:lnTo>
                <a:lnTo>
                  <a:pt x="959" y="0"/>
                </a:lnTo>
                <a:lnTo>
                  <a:pt x="1020" y="0"/>
                </a:lnTo>
                <a:lnTo>
                  <a:pt x="1027" y="0"/>
                </a:lnTo>
                <a:lnTo>
                  <a:pt x="1100" y="0"/>
                </a:lnTo>
                <a:lnTo>
                  <a:pt x="1399" y="0"/>
                </a:lnTo>
                <a:lnTo>
                  <a:pt x="1552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Freeform 58">
            <a:extLst>
              <a:ext uri="{FF2B5EF4-FFF2-40B4-BE49-F238E27FC236}">
                <a16:creationId xmlns:a16="http://schemas.microsoft.com/office/drawing/2014/main" id="{74FF78CC-BDE5-B3A5-CBC9-EEC65D9A8517}"/>
              </a:ext>
            </a:extLst>
          </p:cNvPr>
          <p:cNvSpPr>
            <a:spLocks/>
          </p:cNvSpPr>
          <p:nvPr/>
        </p:nvSpPr>
        <p:spPr bwMode="auto">
          <a:xfrm>
            <a:off x="7101445" y="2590067"/>
            <a:ext cx="3131410" cy="127076"/>
          </a:xfrm>
          <a:custGeom>
            <a:avLst/>
            <a:gdLst>
              <a:gd name="T0" fmla="*/ 85 w 1661"/>
              <a:gd name="T1" fmla="*/ 68 h 68"/>
              <a:gd name="T2" fmla="*/ 108 w 1661"/>
              <a:gd name="T3" fmla="*/ 68 h 68"/>
              <a:gd name="T4" fmla="*/ 143 w 1661"/>
              <a:gd name="T5" fmla="*/ 68 h 68"/>
              <a:gd name="T6" fmla="*/ 194 w 1661"/>
              <a:gd name="T7" fmla="*/ 68 h 68"/>
              <a:gd name="T8" fmla="*/ 209 w 1661"/>
              <a:gd name="T9" fmla="*/ 53 h 68"/>
              <a:gd name="T10" fmla="*/ 214 w 1661"/>
              <a:gd name="T11" fmla="*/ 37 h 68"/>
              <a:gd name="T12" fmla="*/ 322 w 1661"/>
              <a:gd name="T13" fmla="*/ 37 h 68"/>
              <a:gd name="T14" fmla="*/ 342 w 1661"/>
              <a:gd name="T15" fmla="*/ 21 h 68"/>
              <a:gd name="T16" fmla="*/ 392 w 1661"/>
              <a:gd name="T17" fmla="*/ 21 h 68"/>
              <a:gd name="T18" fmla="*/ 428 w 1661"/>
              <a:gd name="T19" fmla="*/ 21 h 68"/>
              <a:gd name="T20" fmla="*/ 455 w 1661"/>
              <a:gd name="T21" fmla="*/ 21 h 68"/>
              <a:gd name="T22" fmla="*/ 480 w 1661"/>
              <a:gd name="T23" fmla="*/ 21 h 68"/>
              <a:gd name="T24" fmla="*/ 505 w 1661"/>
              <a:gd name="T25" fmla="*/ 21 h 68"/>
              <a:gd name="T26" fmla="*/ 519 w 1661"/>
              <a:gd name="T27" fmla="*/ 21 h 68"/>
              <a:gd name="T28" fmla="*/ 548 w 1661"/>
              <a:gd name="T29" fmla="*/ 21 h 68"/>
              <a:gd name="T30" fmla="*/ 557 w 1661"/>
              <a:gd name="T31" fmla="*/ 21 h 68"/>
              <a:gd name="T32" fmla="*/ 592 w 1661"/>
              <a:gd name="T33" fmla="*/ 21 h 68"/>
              <a:gd name="T34" fmla="*/ 600 w 1661"/>
              <a:gd name="T35" fmla="*/ 21 h 68"/>
              <a:gd name="T36" fmla="*/ 612 w 1661"/>
              <a:gd name="T37" fmla="*/ 21 h 68"/>
              <a:gd name="T38" fmla="*/ 647 w 1661"/>
              <a:gd name="T39" fmla="*/ 21 h 68"/>
              <a:gd name="T40" fmla="*/ 666 w 1661"/>
              <a:gd name="T41" fmla="*/ 21 h 68"/>
              <a:gd name="T42" fmla="*/ 679 w 1661"/>
              <a:gd name="T43" fmla="*/ 21 h 68"/>
              <a:gd name="T44" fmla="*/ 688 w 1661"/>
              <a:gd name="T45" fmla="*/ 0 h 68"/>
              <a:gd name="T46" fmla="*/ 711 w 1661"/>
              <a:gd name="T47" fmla="*/ 0 h 68"/>
              <a:gd name="T48" fmla="*/ 722 w 1661"/>
              <a:gd name="T49" fmla="*/ 0 h 68"/>
              <a:gd name="T50" fmla="*/ 733 w 1661"/>
              <a:gd name="T51" fmla="*/ 0 h 68"/>
              <a:gd name="T52" fmla="*/ 744 w 1661"/>
              <a:gd name="T53" fmla="*/ 0 h 68"/>
              <a:gd name="T54" fmla="*/ 760 w 1661"/>
              <a:gd name="T55" fmla="*/ 0 h 68"/>
              <a:gd name="T56" fmla="*/ 772 w 1661"/>
              <a:gd name="T57" fmla="*/ 0 h 68"/>
              <a:gd name="T58" fmla="*/ 786 w 1661"/>
              <a:gd name="T59" fmla="*/ 0 h 68"/>
              <a:gd name="T60" fmla="*/ 810 w 1661"/>
              <a:gd name="T61" fmla="*/ 0 h 68"/>
              <a:gd name="T62" fmla="*/ 823 w 1661"/>
              <a:gd name="T63" fmla="*/ 0 h 68"/>
              <a:gd name="T64" fmla="*/ 839 w 1661"/>
              <a:gd name="T65" fmla="*/ 0 h 68"/>
              <a:gd name="T66" fmla="*/ 848 w 1661"/>
              <a:gd name="T67" fmla="*/ 0 h 68"/>
              <a:gd name="T68" fmla="*/ 863 w 1661"/>
              <a:gd name="T69" fmla="*/ 0 h 68"/>
              <a:gd name="T70" fmla="*/ 877 w 1661"/>
              <a:gd name="T71" fmla="*/ 0 h 68"/>
              <a:gd name="T72" fmla="*/ 894 w 1661"/>
              <a:gd name="T73" fmla="*/ 0 h 68"/>
              <a:gd name="T74" fmla="*/ 919 w 1661"/>
              <a:gd name="T75" fmla="*/ 0 h 68"/>
              <a:gd name="T76" fmla="*/ 950 w 1661"/>
              <a:gd name="T77" fmla="*/ 0 h 68"/>
              <a:gd name="T78" fmla="*/ 960 w 1661"/>
              <a:gd name="T79" fmla="*/ 0 h 68"/>
              <a:gd name="T80" fmla="*/ 986 w 1661"/>
              <a:gd name="T81" fmla="*/ 0 h 68"/>
              <a:gd name="T82" fmla="*/ 997 w 1661"/>
              <a:gd name="T83" fmla="*/ 0 h 68"/>
              <a:gd name="T84" fmla="*/ 1011 w 1661"/>
              <a:gd name="T85" fmla="*/ 0 h 68"/>
              <a:gd name="T86" fmla="*/ 1021 w 1661"/>
              <a:gd name="T87" fmla="*/ 0 h 68"/>
              <a:gd name="T88" fmla="*/ 1036 w 1661"/>
              <a:gd name="T89" fmla="*/ 0 h 68"/>
              <a:gd name="T90" fmla="*/ 1057 w 1661"/>
              <a:gd name="T91" fmla="*/ 0 h 68"/>
              <a:gd name="T92" fmla="*/ 1101 w 1661"/>
              <a:gd name="T93" fmla="*/ 0 h 68"/>
              <a:gd name="T94" fmla="*/ 1180 w 1661"/>
              <a:gd name="T95" fmla="*/ 0 h 68"/>
              <a:gd name="T96" fmla="*/ 1190 w 1661"/>
              <a:gd name="T97" fmla="*/ 0 h 68"/>
              <a:gd name="T98" fmla="*/ 1581 w 1661"/>
              <a:gd name="T99" fmla="*/ 0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1661" h="68">
                <a:moveTo>
                  <a:pt x="0" y="68"/>
                </a:moveTo>
                <a:lnTo>
                  <a:pt x="85" y="68"/>
                </a:lnTo>
                <a:lnTo>
                  <a:pt x="95" y="68"/>
                </a:lnTo>
                <a:lnTo>
                  <a:pt x="108" y="68"/>
                </a:lnTo>
                <a:lnTo>
                  <a:pt x="127" y="68"/>
                </a:lnTo>
                <a:lnTo>
                  <a:pt x="143" y="68"/>
                </a:lnTo>
                <a:lnTo>
                  <a:pt x="150" y="68"/>
                </a:lnTo>
                <a:lnTo>
                  <a:pt x="194" y="68"/>
                </a:lnTo>
                <a:lnTo>
                  <a:pt x="194" y="53"/>
                </a:lnTo>
                <a:lnTo>
                  <a:pt x="209" y="53"/>
                </a:lnTo>
                <a:lnTo>
                  <a:pt x="214" y="53"/>
                </a:lnTo>
                <a:lnTo>
                  <a:pt x="214" y="37"/>
                </a:lnTo>
                <a:lnTo>
                  <a:pt x="248" y="37"/>
                </a:lnTo>
                <a:lnTo>
                  <a:pt x="322" y="37"/>
                </a:lnTo>
                <a:lnTo>
                  <a:pt x="322" y="21"/>
                </a:lnTo>
                <a:lnTo>
                  <a:pt x="342" y="21"/>
                </a:lnTo>
                <a:lnTo>
                  <a:pt x="358" y="21"/>
                </a:lnTo>
                <a:lnTo>
                  <a:pt x="392" y="21"/>
                </a:lnTo>
                <a:lnTo>
                  <a:pt x="406" y="21"/>
                </a:lnTo>
                <a:lnTo>
                  <a:pt x="428" y="21"/>
                </a:lnTo>
                <a:lnTo>
                  <a:pt x="452" y="21"/>
                </a:lnTo>
                <a:lnTo>
                  <a:pt x="455" y="21"/>
                </a:lnTo>
                <a:lnTo>
                  <a:pt x="461" y="21"/>
                </a:lnTo>
                <a:lnTo>
                  <a:pt x="480" y="21"/>
                </a:lnTo>
                <a:lnTo>
                  <a:pt x="492" y="21"/>
                </a:lnTo>
                <a:lnTo>
                  <a:pt x="505" y="21"/>
                </a:lnTo>
                <a:lnTo>
                  <a:pt x="512" y="21"/>
                </a:lnTo>
                <a:lnTo>
                  <a:pt x="519" y="21"/>
                </a:lnTo>
                <a:lnTo>
                  <a:pt x="531" y="21"/>
                </a:lnTo>
                <a:lnTo>
                  <a:pt x="548" y="21"/>
                </a:lnTo>
                <a:lnTo>
                  <a:pt x="552" y="21"/>
                </a:lnTo>
                <a:lnTo>
                  <a:pt x="557" y="21"/>
                </a:lnTo>
                <a:lnTo>
                  <a:pt x="587" y="21"/>
                </a:lnTo>
                <a:lnTo>
                  <a:pt x="592" y="21"/>
                </a:lnTo>
                <a:lnTo>
                  <a:pt x="595" y="21"/>
                </a:lnTo>
                <a:lnTo>
                  <a:pt x="600" y="21"/>
                </a:lnTo>
                <a:lnTo>
                  <a:pt x="609" y="21"/>
                </a:lnTo>
                <a:lnTo>
                  <a:pt x="612" y="21"/>
                </a:lnTo>
                <a:lnTo>
                  <a:pt x="624" y="21"/>
                </a:lnTo>
                <a:lnTo>
                  <a:pt x="647" y="21"/>
                </a:lnTo>
                <a:lnTo>
                  <a:pt x="648" y="21"/>
                </a:lnTo>
                <a:lnTo>
                  <a:pt x="666" y="21"/>
                </a:lnTo>
                <a:lnTo>
                  <a:pt x="675" y="21"/>
                </a:lnTo>
                <a:lnTo>
                  <a:pt x="679" y="21"/>
                </a:lnTo>
                <a:lnTo>
                  <a:pt x="688" y="21"/>
                </a:lnTo>
                <a:lnTo>
                  <a:pt x="688" y="0"/>
                </a:lnTo>
                <a:lnTo>
                  <a:pt x="702" y="0"/>
                </a:lnTo>
                <a:lnTo>
                  <a:pt x="711" y="0"/>
                </a:lnTo>
                <a:lnTo>
                  <a:pt x="714" y="0"/>
                </a:lnTo>
                <a:lnTo>
                  <a:pt x="722" y="0"/>
                </a:lnTo>
                <a:lnTo>
                  <a:pt x="727" y="0"/>
                </a:lnTo>
                <a:lnTo>
                  <a:pt x="733" y="0"/>
                </a:lnTo>
                <a:lnTo>
                  <a:pt x="740" y="0"/>
                </a:lnTo>
                <a:lnTo>
                  <a:pt x="744" y="0"/>
                </a:lnTo>
                <a:lnTo>
                  <a:pt x="751" y="0"/>
                </a:lnTo>
                <a:lnTo>
                  <a:pt x="760" y="0"/>
                </a:lnTo>
                <a:lnTo>
                  <a:pt x="763" y="0"/>
                </a:lnTo>
                <a:lnTo>
                  <a:pt x="772" y="0"/>
                </a:lnTo>
                <a:lnTo>
                  <a:pt x="781" y="0"/>
                </a:lnTo>
                <a:lnTo>
                  <a:pt x="786" y="0"/>
                </a:lnTo>
                <a:lnTo>
                  <a:pt x="804" y="0"/>
                </a:lnTo>
                <a:lnTo>
                  <a:pt x="810" y="0"/>
                </a:lnTo>
                <a:lnTo>
                  <a:pt x="818" y="0"/>
                </a:lnTo>
                <a:lnTo>
                  <a:pt x="823" y="0"/>
                </a:lnTo>
                <a:lnTo>
                  <a:pt x="828" y="0"/>
                </a:lnTo>
                <a:lnTo>
                  <a:pt x="839" y="0"/>
                </a:lnTo>
                <a:lnTo>
                  <a:pt x="841" y="0"/>
                </a:lnTo>
                <a:lnTo>
                  <a:pt x="848" y="0"/>
                </a:lnTo>
                <a:lnTo>
                  <a:pt x="855" y="0"/>
                </a:lnTo>
                <a:lnTo>
                  <a:pt x="863" y="0"/>
                </a:lnTo>
                <a:lnTo>
                  <a:pt x="874" y="0"/>
                </a:lnTo>
                <a:lnTo>
                  <a:pt x="877" y="0"/>
                </a:lnTo>
                <a:lnTo>
                  <a:pt x="891" y="0"/>
                </a:lnTo>
                <a:lnTo>
                  <a:pt x="894" y="0"/>
                </a:lnTo>
                <a:lnTo>
                  <a:pt x="900" y="0"/>
                </a:lnTo>
                <a:lnTo>
                  <a:pt x="919" y="0"/>
                </a:lnTo>
                <a:lnTo>
                  <a:pt x="929" y="0"/>
                </a:lnTo>
                <a:lnTo>
                  <a:pt x="950" y="0"/>
                </a:lnTo>
                <a:lnTo>
                  <a:pt x="955" y="0"/>
                </a:lnTo>
                <a:lnTo>
                  <a:pt x="960" y="0"/>
                </a:lnTo>
                <a:lnTo>
                  <a:pt x="967" y="0"/>
                </a:lnTo>
                <a:lnTo>
                  <a:pt x="986" y="0"/>
                </a:lnTo>
                <a:lnTo>
                  <a:pt x="991" y="0"/>
                </a:lnTo>
                <a:lnTo>
                  <a:pt x="997" y="0"/>
                </a:lnTo>
                <a:lnTo>
                  <a:pt x="1008" y="0"/>
                </a:lnTo>
                <a:lnTo>
                  <a:pt x="1011" y="0"/>
                </a:lnTo>
                <a:lnTo>
                  <a:pt x="1015" y="0"/>
                </a:lnTo>
                <a:lnTo>
                  <a:pt x="1021" y="0"/>
                </a:lnTo>
                <a:lnTo>
                  <a:pt x="1027" y="0"/>
                </a:lnTo>
                <a:lnTo>
                  <a:pt x="1036" y="0"/>
                </a:lnTo>
                <a:lnTo>
                  <a:pt x="1050" y="0"/>
                </a:lnTo>
                <a:lnTo>
                  <a:pt x="1057" y="0"/>
                </a:lnTo>
                <a:lnTo>
                  <a:pt x="1089" y="0"/>
                </a:lnTo>
                <a:lnTo>
                  <a:pt x="1101" y="0"/>
                </a:lnTo>
                <a:lnTo>
                  <a:pt x="1140" y="0"/>
                </a:lnTo>
                <a:lnTo>
                  <a:pt x="1180" y="0"/>
                </a:lnTo>
                <a:lnTo>
                  <a:pt x="1185" y="0"/>
                </a:lnTo>
                <a:lnTo>
                  <a:pt x="1190" y="0"/>
                </a:lnTo>
                <a:lnTo>
                  <a:pt x="1211" y="0"/>
                </a:lnTo>
                <a:lnTo>
                  <a:pt x="1581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Freeform 93">
            <a:extLst>
              <a:ext uri="{FF2B5EF4-FFF2-40B4-BE49-F238E27FC236}">
                <a16:creationId xmlns:a16="http://schemas.microsoft.com/office/drawing/2014/main" id="{07B8D53D-E3DB-0387-B98C-FFF5974BC0D2}"/>
              </a:ext>
            </a:extLst>
          </p:cNvPr>
          <p:cNvSpPr>
            <a:spLocks/>
          </p:cNvSpPr>
          <p:nvPr/>
        </p:nvSpPr>
        <p:spPr bwMode="auto">
          <a:xfrm>
            <a:off x="1988193" y="5114728"/>
            <a:ext cx="2645807" cy="550050"/>
          </a:xfrm>
          <a:custGeom>
            <a:avLst/>
            <a:gdLst>
              <a:gd name="T0" fmla="*/ 82 w 1395"/>
              <a:gd name="T1" fmla="*/ 294 h 294"/>
              <a:gd name="T2" fmla="*/ 101 w 1395"/>
              <a:gd name="T3" fmla="*/ 271 h 294"/>
              <a:gd name="T4" fmla="*/ 157 w 1395"/>
              <a:gd name="T5" fmla="*/ 247 h 294"/>
              <a:gd name="T6" fmla="*/ 181 w 1395"/>
              <a:gd name="T7" fmla="*/ 224 h 294"/>
              <a:gd name="T8" fmla="*/ 186 w 1395"/>
              <a:gd name="T9" fmla="*/ 200 h 294"/>
              <a:gd name="T10" fmla="*/ 308 w 1395"/>
              <a:gd name="T11" fmla="*/ 177 h 294"/>
              <a:gd name="T12" fmla="*/ 333 w 1395"/>
              <a:gd name="T13" fmla="*/ 153 h 294"/>
              <a:gd name="T14" fmla="*/ 359 w 1395"/>
              <a:gd name="T15" fmla="*/ 153 h 294"/>
              <a:gd name="T16" fmla="*/ 369 w 1395"/>
              <a:gd name="T17" fmla="*/ 128 h 294"/>
              <a:gd name="T18" fmla="*/ 373 w 1395"/>
              <a:gd name="T19" fmla="*/ 104 h 294"/>
              <a:gd name="T20" fmla="*/ 398 w 1395"/>
              <a:gd name="T21" fmla="*/ 79 h 294"/>
              <a:gd name="T22" fmla="*/ 426 w 1395"/>
              <a:gd name="T23" fmla="*/ 54 h 294"/>
              <a:gd name="T24" fmla="*/ 448 w 1395"/>
              <a:gd name="T25" fmla="*/ 29 h 294"/>
              <a:gd name="T26" fmla="*/ 484 w 1395"/>
              <a:gd name="T27" fmla="*/ 29 h 294"/>
              <a:gd name="T28" fmla="*/ 537 w 1395"/>
              <a:gd name="T29" fmla="*/ 29 h 294"/>
              <a:gd name="T30" fmla="*/ 564 w 1395"/>
              <a:gd name="T31" fmla="*/ 29 h 294"/>
              <a:gd name="T32" fmla="*/ 575 w 1395"/>
              <a:gd name="T33" fmla="*/ 29 h 294"/>
              <a:gd name="T34" fmla="*/ 597 w 1395"/>
              <a:gd name="T35" fmla="*/ 29 h 294"/>
              <a:gd name="T36" fmla="*/ 608 w 1395"/>
              <a:gd name="T37" fmla="*/ 0 h 294"/>
              <a:gd name="T38" fmla="*/ 639 w 1395"/>
              <a:gd name="T39" fmla="*/ 0 h 294"/>
              <a:gd name="T40" fmla="*/ 667 w 1395"/>
              <a:gd name="T41" fmla="*/ 0 h 294"/>
              <a:gd name="T42" fmla="*/ 679 w 1395"/>
              <a:gd name="T43" fmla="*/ 0 h 294"/>
              <a:gd name="T44" fmla="*/ 691 w 1395"/>
              <a:gd name="T45" fmla="*/ 0 h 294"/>
              <a:gd name="T46" fmla="*/ 709 w 1395"/>
              <a:gd name="T47" fmla="*/ 0 h 294"/>
              <a:gd name="T48" fmla="*/ 723 w 1395"/>
              <a:gd name="T49" fmla="*/ 0 h 294"/>
              <a:gd name="T50" fmla="*/ 744 w 1395"/>
              <a:gd name="T51" fmla="*/ 0 h 294"/>
              <a:gd name="T52" fmla="*/ 769 w 1395"/>
              <a:gd name="T53" fmla="*/ 0 h 294"/>
              <a:gd name="T54" fmla="*/ 789 w 1395"/>
              <a:gd name="T55" fmla="*/ 0 h 294"/>
              <a:gd name="T56" fmla="*/ 815 w 1395"/>
              <a:gd name="T57" fmla="*/ 0 h 294"/>
              <a:gd name="T58" fmla="*/ 839 w 1395"/>
              <a:gd name="T59" fmla="*/ 0 h 294"/>
              <a:gd name="T60" fmla="*/ 848 w 1395"/>
              <a:gd name="T61" fmla="*/ 0 h 294"/>
              <a:gd name="T62" fmla="*/ 871 w 1395"/>
              <a:gd name="T63" fmla="*/ 0 h 294"/>
              <a:gd name="T64" fmla="*/ 895 w 1395"/>
              <a:gd name="T65" fmla="*/ 0 h 294"/>
              <a:gd name="T66" fmla="*/ 909 w 1395"/>
              <a:gd name="T67" fmla="*/ 0 h 294"/>
              <a:gd name="T68" fmla="*/ 919 w 1395"/>
              <a:gd name="T69" fmla="*/ 0 h 294"/>
              <a:gd name="T70" fmla="*/ 967 w 1395"/>
              <a:gd name="T71" fmla="*/ 0 h 294"/>
              <a:gd name="T72" fmla="*/ 1010 w 1395"/>
              <a:gd name="T73" fmla="*/ 0 h 294"/>
              <a:gd name="T74" fmla="*/ 1030 w 1395"/>
              <a:gd name="T75" fmla="*/ 0 h 294"/>
              <a:gd name="T76" fmla="*/ 1060 w 1395"/>
              <a:gd name="T77" fmla="*/ 0 h 294"/>
              <a:gd name="T78" fmla="*/ 1081 w 1395"/>
              <a:gd name="T79" fmla="*/ 0 h 294"/>
              <a:gd name="T80" fmla="*/ 1185 w 1395"/>
              <a:gd name="T81" fmla="*/ 0 h 294"/>
              <a:gd name="T82" fmla="*/ 1395 w 1395"/>
              <a:gd name="T83" fmla="*/ 0 h 2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</a:cxnLst>
            <a:rect l="0" t="0" r="r" b="b"/>
            <a:pathLst>
              <a:path w="1395" h="294">
                <a:moveTo>
                  <a:pt x="0" y="294"/>
                </a:moveTo>
                <a:lnTo>
                  <a:pt x="82" y="294"/>
                </a:lnTo>
                <a:lnTo>
                  <a:pt x="82" y="271"/>
                </a:lnTo>
                <a:lnTo>
                  <a:pt x="101" y="271"/>
                </a:lnTo>
                <a:lnTo>
                  <a:pt x="101" y="247"/>
                </a:lnTo>
                <a:lnTo>
                  <a:pt x="157" y="247"/>
                </a:lnTo>
                <a:lnTo>
                  <a:pt x="157" y="224"/>
                </a:lnTo>
                <a:lnTo>
                  <a:pt x="181" y="224"/>
                </a:lnTo>
                <a:lnTo>
                  <a:pt x="182" y="200"/>
                </a:lnTo>
                <a:lnTo>
                  <a:pt x="186" y="200"/>
                </a:lnTo>
                <a:lnTo>
                  <a:pt x="186" y="177"/>
                </a:lnTo>
                <a:lnTo>
                  <a:pt x="308" y="177"/>
                </a:lnTo>
                <a:lnTo>
                  <a:pt x="333" y="177"/>
                </a:lnTo>
                <a:lnTo>
                  <a:pt x="333" y="153"/>
                </a:lnTo>
                <a:lnTo>
                  <a:pt x="338" y="153"/>
                </a:lnTo>
                <a:lnTo>
                  <a:pt x="359" y="153"/>
                </a:lnTo>
                <a:lnTo>
                  <a:pt x="369" y="153"/>
                </a:lnTo>
                <a:lnTo>
                  <a:pt x="369" y="128"/>
                </a:lnTo>
                <a:lnTo>
                  <a:pt x="373" y="128"/>
                </a:lnTo>
                <a:lnTo>
                  <a:pt x="373" y="104"/>
                </a:lnTo>
                <a:lnTo>
                  <a:pt x="398" y="104"/>
                </a:lnTo>
                <a:lnTo>
                  <a:pt x="398" y="79"/>
                </a:lnTo>
                <a:lnTo>
                  <a:pt x="400" y="54"/>
                </a:lnTo>
                <a:lnTo>
                  <a:pt x="426" y="54"/>
                </a:lnTo>
                <a:lnTo>
                  <a:pt x="448" y="54"/>
                </a:lnTo>
                <a:lnTo>
                  <a:pt x="448" y="29"/>
                </a:lnTo>
                <a:lnTo>
                  <a:pt x="461" y="29"/>
                </a:lnTo>
                <a:lnTo>
                  <a:pt x="484" y="29"/>
                </a:lnTo>
                <a:lnTo>
                  <a:pt x="512" y="29"/>
                </a:lnTo>
                <a:lnTo>
                  <a:pt x="537" y="29"/>
                </a:lnTo>
                <a:lnTo>
                  <a:pt x="540" y="29"/>
                </a:lnTo>
                <a:lnTo>
                  <a:pt x="564" y="29"/>
                </a:lnTo>
                <a:lnTo>
                  <a:pt x="571" y="29"/>
                </a:lnTo>
                <a:lnTo>
                  <a:pt x="575" y="29"/>
                </a:lnTo>
                <a:lnTo>
                  <a:pt x="583" y="29"/>
                </a:lnTo>
                <a:lnTo>
                  <a:pt x="597" y="29"/>
                </a:lnTo>
                <a:lnTo>
                  <a:pt x="608" y="29"/>
                </a:lnTo>
                <a:lnTo>
                  <a:pt x="608" y="0"/>
                </a:lnTo>
                <a:lnTo>
                  <a:pt x="631" y="0"/>
                </a:lnTo>
                <a:lnTo>
                  <a:pt x="639" y="0"/>
                </a:lnTo>
                <a:lnTo>
                  <a:pt x="664" y="0"/>
                </a:lnTo>
                <a:lnTo>
                  <a:pt x="667" y="0"/>
                </a:lnTo>
                <a:lnTo>
                  <a:pt x="673" y="0"/>
                </a:lnTo>
                <a:lnTo>
                  <a:pt x="679" y="0"/>
                </a:lnTo>
                <a:lnTo>
                  <a:pt x="684" y="0"/>
                </a:lnTo>
                <a:lnTo>
                  <a:pt x="691" y="0"/>
                </a:lnTo>
                <a:lnTo>
                  <a:pt x="700" y="0"/>
                </a:lnTo>
                <a:lnTo>
                  <a:pt x="709" y="0"/>
                </a:lnTo>
                <a:lnTo>
                  <a:pt x="717" y="0"/>
                </a:lnTo>
                <a:lnTo>
                  <a:pt x="723" y="0"/>
                </a:lnTo>
                <a:lnTo>
                  <a:pt x="728" y="0"/>
                </a:lnTo>
                <a:lnTo>
                  <a:pt x="744" y="0"/>
                </a:lnTo>
                <a:lnTo>
                  <a:pt x="760" y="0"/>
                </a:lnTo>
                <a:lnTo>
                  <a:pt x="769" y="0"/>
                </a:lnTo>
                <a:lnTo>
                  <a:pt x="774" y="0"/>
                </a:lnTo>
                <a:lnTo>
                  <a:pt x="789" y="0"/>
                </a:lnTo>
                <a:lnTo>
                  <a:pt x="805" y="0"/>
                </a:lnTo>
                <a:lnTo>
                  <a:pt x="815" y="0"/>
                </a:lnTo>
                <a:lnTo>
                  <a:pt x="816" y="0"/>
                </a:lnTo>
                <a:lnTo>
                  <a:pt x="839" y="0"/>
                </a:lnTo>
                <a:lnTo>
                  <a:pt x="841" y="0"/>
                </a:lnTo>
                <a:lnTo>
                  <a:pt x="848" y="0"/>
                </a:lnTo>
                <a:lnTo>
                  <a:pt x="863" y="0"/>
                </a:lnTo>
                <a:lnTo>
                  <a:pt x="871" y="0"/>
                </a:lnTo>
                <a:lnTo>
                  <a:pt x="891" y="0"/>
                </a:lnTo>
                <a:lnTo>
                  <a:pt x="895" y="0"/>
                </a:lnTo>
                <a:lnTo>
                  <a:pt x="902" y="0"/>
                </a:lnTo>
                <a:lnTo>
                  <a:pt x="909" y="0"/>
                </a:lnTo>
                <a:lnTo>
                  <a:pt x="915" y="0"/>
                </a:lnTo>
                <a:lnTo>
                  <a:pt x="919" y="0"/>
                </a:lnTo>
                <a:lnTo>
                  <a:pt x="954" y="0"/>
                </a:lnTo>
                <a:lnTo>
                  <a:pt x="967" y="0"/>
                </a:lnTo>
                <a:lnTo>
                  <a:pt x="977" y="0"/>
                </a:lnTo>
                <a:lnTo>
                  <a:pt x="1010" y="0"/>
                </a:lnTo>
                <a:lnTo>
                  <a:pt x="1015" y="0"/>
                </a:lnTo>
                <a:lnTo>
                  <a:pt x="1030" y="0"/>
                </a:lnTo>
                <a:lnTo>
                  <a:pt x="1050" y="0"/>
                </a:lnTo>
                <a:lnTo>
                  <a:pt x="1060" y="0"/>
                </a:lnTo>
                <a:lnTo>
                  <a:pt x="1079" y="0"/>
                </a:lnTo>
                <a:lnTo>
                  <a:pt x="1081" y="0"/>
                </a:lnTo>
                <a:lnTo>
                  <a:pt x="1136" y="0"/>
                </a:lnTo>
                <a:lnTo>
                  <a:pt x="1185" y="0"/>
                </a:lnTo>
                <a:lnTo>
                  <a:pt x="1211" y="0"/>
                </a:lnTo>
                <a:lnTo>
                  <a:pt x="1395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Freeform 94">
            <a:extLst>
              <a:ext uri="{FF2B5EF4-FFF2-40B4-BE49-F238E27FC236}">
                <a16:creationId xmlns:a16="http://schemas.microsoft.com/office/drawing/2014/main" id="{5F78229A-B422-6DF6-F9EC-366CB002C1C2}"/>
              </a:ext>
            </a:extLst>
          </p:cNvPr>
          <p:cNvSpPr>
            <a:spLocks/>
          </p:cNvSpPr>
          <p:nvPr/>
        </p:nvSpPr>
        <p:spPr bwMode="auto">
          <a:xfrm>
            <a:off x="1988193" y="5404720"/>
            <a:ext cx="3150311" cy="260058"/>
          </a:xfrm>
          <a:custGeom>
            <a:avLst/>
            <a:gdLst>
              <a:gd name="T0" fmla="*/ 95 w 1661"/>
              <a:gd name="T1" fmla="*/ 139 h 139"/>
              <a:gd name="T2" fmla="*/ 106 w 1661"/>
              <a:gd name="T3" fmla="*/ 129 h 139"/>
              <a:gd name="T4" fmla="*/ 143 w 1661"/>
              <a:gd name="T5" fmla="*/ 129 h 139"/>
              <a:gd name="T6" fmla="*/ 146 w 1661"/>
              <a:gd name="T7" fmla="*/ 109 h 139"/>
              <a:gd name="T8" fmla="*/ 159 w 1661"/>
              <a:gd name="T9" fmla="*/ 109 h 139"/>
              <a:gd name="T10" fmla="*/ 165 w 1661"/>
              <a:gd name="T11" fmla="*/ 99 h 139"/>
              <a:gd name="T12" fmla="*/ 176 w 1661"/>
              <a:gd name="T13" fmla="*/ 89 h 139"/>
              <a:gd name="T14" fmla="*/ 196 w 1661"/>
              <a:gd name="T15" fmla="*/ 79 h 139"/>
              <a:gd name="T16" fmla="*/ 200 w 1661"/>
              <a:gd name="T17" fmla="*/ 69 h 139"/>
              <a:gd name="T18" fmla="*/ 202 w 1661"/>
              <a:gd name="T19" fmla="*/ 59 h 139"/>
              <a:gd name="T20" fmla="*/ 209 w 1661"/>
              <a:gd name="T21" fmla="*/ 49 h 139"/>
              <a:gd name="T22" fmla="*/ 281 w 1661"/>
              <a:gd name="T23" fmla="*/ 49 h 139"/>
              <a:gd name="T24" fmla="*/ 307 w 1661"/>
              <a:gd name="T25" fmla="*/ 49 h 139"/>
              <a:gd name="T26" fmla="*/ 322 w 1661"/>
              <a:gd name="T27" fmla="*/ 39 h 139"/>
              <a:gd name="T28" fmla="*/ 406 w 1661"/>
              <a:gd name="T29" fmla="*/ 39 h 139"/>
              <a:gd name="T30" fmla="*/ 421 w 1661"/>
              <a:gd name="T31" fmla="*/ 39 h 139"/>
              <a:gd name="T32" fmla="*/ 428 w 1661"/>
              <a:gd name="T33" fmla="*/ 28 h 139"/>
              <a:gd name="T34" fmla="*/ 455 w 1661"/>
              <a:gd name="T35" fmla="*/ 28 h 139"/>
              <a:gd name="T36" fmla="*/ 472 w 1661"/>
              <a:gd name="T37" fmla="*/ 28 h 139"/>
              <a:gd name="T38" fmla="*/ 484 w 1661"/>
              <a:gd name="T39" fmla="*/ 28 h 139"/>
              <a:gd name="T40" fmla="*/ 491 w 1661"/>
              <a:gd name="T41" fmla="*/ 28 h 139"/>
              <a:gd name="T42" fmla="*/ 526 w 1661"/>
              <a:gd name="T43" fmla="*/ 28 h 139"/>
              <a:gd name="T44" fmla="*/ 533 w 1661"/>
              <a:gd name="T45" fmla="*/ 28 h 139"/>
              <a:gd name="T46" fmla="*/ 552 w 1661"/>
              <a:gd name="T47" fmla="*/ 28 h 139"/>
              <a:gd name="T48" fmla="*/ 581 w 1661"/>
              <a:gd name="T49" fmla="*/ 28 h 139"/>
              <a:gd name="T50" fmla="*/ 609 w 1661"/>
              <a:gd name="T51" fmla="*/ 28 h 139"/>
              <a:gd name="T52" fmla="*/ 621 w 1661"/>
              <a:gd name="T53" fmla="*/ 28 h 139"/>
              <a:gd name="T54" fmla="*/ 642 w 1661"/>
              <a:gd name="T55" fmla="*/ 28 h 139"/>
              <a:gd name="T56" fmla="*/ 654 w 1661"/>
              <a:gd name="T57" fmla="*/ 28 h 139"/>
              <a:gd name="T58" fmla="*/ 661 w 1661"/>
              <a:gd name="T59" fmla="*/ 15 h 139"/>
              <a:gd name="T60" fmla="*/ 672 w 1661"/>
              <a:gd name="T61" fmla="*/ 15 h 139"/>
              <a:gd name="T62" fmla="*/ 685 w 1661"/>
              <a:gd name="T63" fmla="*/ 15 h 139"/>
              <a:gd name="T64" fmla="*/ 698 w 1661"/>
              <a:gd name="T65" fmla="*/ 0 h 139"/>
              <a:gd name="T66" fmla="*/ 718 w 1661"/>
              <a:gd name="T67" fmla="*/ 0 h 139"/>
              <a:gd name="T68" fmla="*/ 729 w 1661"/>
              <a:gd name="T69" fmla="*/ 0 h 139"/>
              <a:gd name="T70" fmla="*/ 744 w 1661"/>
              <a:gd name="T71" fmla="*/ 0 h 139"/>
              <a:gd name="T72" fmla="*/ 758 w 1661"/>
              <a:gd name="T73" fmla="*/ 0 h 139"/>
              <a:gd name="T74" fmla="*/ 771 w 1661"/>
              <a:gd name="T75" fmla="*/ 0 h 139"/>
              <a:gd name="T76" fmla="*/ 780 w 1661"/>
              <a:gd name="T77" fmla="*/ 0 h 139"/>
              <a:gd name="T78" fmla="*/ 804 w 1661"/>
              <a:gd name="T79" fmla="*/ 0 h 139"/>
              <a:gd name="T80" fmla="*/ 821 w 1661"/>
              <a:gd name="T81" fmla="*/ 0 h 139"/>
              <a:gd name="T82" fmla="*/ 828 w 1661"/>
              <a:gd name="T83" fmla="*/ 0 h 139"/>
              <a:gd name="T84" fmla="*/ 847 w 1661"/>
              <a:gd name="T85" fmla="*/ 0 h 139"/>
              <a:gd name="T86" fmla="*/ 872 w 1661"/>
              <a:gd name="T87" fmla="*/ 0 h 139"/>
              <a:gd name="T88" fmla="*/ 883 w 1661"/>
              <a:gd name="T89" fmla="*/ 0 h 139"/>
              <a:gd name="T90" fmla="*/ 894 w 1661"/>
              <a:gd name="T91" fmla="*/ 0 h 139"/>
              <a:gd name="T92" fmla="*/ 907 w 1661"/>
              <a:gd name="T93" fmla="*/ 0 h 139"/>
              <a:gd name="T94" fmla="*/ 919 w 1661"/>
              <a:gd name="T95" fmla="*/ 0 h 139"/>
              <a:gd name="T96" fmla="*/ 933 w 1661"/>
              <a:gd name="T97" fmla="*/ 0 h 139"/>
              <a:gd name="T98" fmla="*/ 942 w 1661"/>
              <a:gd name="T99" fmla="*/ 0 h 139"/>
              <a:gd name="T100" fmla="*/ 954 w 1661"/>
              <a:gd name="T101" fmla="*/ 0 h 139"/>
              <a:gd name="T102" fmla="*/ 973 w 1661"/>
              <a:gd name="T103" fmla="*/ 0 h 139"/>
              <a:gd name="T104" fmla="*/ 986 w 1661"/>
              <a:gd name="T105" fmla="*/ 0 h 139"/>
              <a:gd name="T106" fmla="*/ 1008 w 1661"/>
              <a:gd name="T107" fmla="*/ 0 h 139"/>
              <a:gd name="T108" fmla="*/ 1021 w 1661"/>
              <a:gd name="T109" fmla="*/ 0 h 139"/>
              <a:gd name="T110" fmla="*/ 1039 w 1661"/>
              <a:gd name="T111" fmla="*/ 0 h 139"/>
              <a:gd name="T112" fmla="*/ 1057 w 1661"/>
              <a:gd name="T113" fmla="*/ 0 h 139"/>
              <a:gd name="T114" fmla="*/ 1095 w 1661"/>
              <a:gd name="T115" fmla="*/ 0 h 139"/>
              <a:gd name="T116" fmla="*/ 1130 w 1661"/>
              <a:gd name="T117" fmla="*/ 0 h 139"/>
              <a:gd name="T118" fmla="*/ 1190 w 1661"/>
              <a:gd name="T119" fmla="*/ 0 h 139"/>
              <a:gd name="T120" fmla="*/ 1661 w 1661"/>
              <a:gd name="T121" fmla="*/ 0 h 1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1661" h="139">
                <a:moveTo>
                  <a:pt x="0" y="139"/>
                </a:moveTo>
                <a:lnTo>
                  <a:pt x="95" y="139"/>
                </a:lnTo>
                <a:lnTo>
                  <a:pt x="106" y="139"/>
                </a:lnTo>
                <a:lnTo>
                  <a:pt x="106" y="129"/>
                </a:lnTo>
                <a:lnTo>
                  <a:pt x="127" y="129"/>
                </a:lnTo>
                <a:lnTo>
                  <a:pt x="143" y="129"/>
                </a:lnTo>
                <a:lnTo>
                  <a:pt x="145" y="119"/>
                </a:lnTo>
                <a:lnTo>
                  <a:pt x="146" y="109"/>
                </a:lnTo>
                <a:lnTo>
                  <a:pt x="150" y="109"/>
                </a:lnTo>
                <a:lnTo>
                  <a:pt x="159" y="109"/>
                </a:lnTo>
                <a:lnTo>
                  <a:pt x="159" y="99"/>
                </a:lnTo>
                <a:lnTo>
                  <a:pt x="165" y="99"/>
                </a:lnTo>
                <a:lnTo>
                  <a:pt x="176" y="99"/>
                </a:lnTo>
                <a:lnTo>
                  <a:pt x="176" y="89"/>
                </a:lnTo>
                <a:lnTo>
                  <a:pt x="176" y="79"/>
                </a:lnTo>
                <a:lnTo>
                  <a:pt x="196" y="79"/>
                </a:lnTo>
                <a:lnTo>
                  <a:pt x="196" y="69"/>
                </a:lnTo>
                <a:lnTo>
                  <a:pt x="200" y="69"/>
                </a:lnTo>
                <a:lnTo>
                  <a:pt x="200" y="59"/>
                </a:lnTo>
                <a:lnTo>
                  <a:pt x="202" y="59"/>
                </a:lnTo>
                <a:lnTo>
                  <a:pt x="202" y="49"/>
                </a:lnTo>
                <a:lnTo>
                  <a:pt x="209" y="49"/>
                </a:lnTo>
                <a:lnTo>
                  <a:pt x="277" y="49"/>
                </a:lnTo>
                <a:lnTo>
                  <a:pt x="281" y="49"/>
                </a:lnTo>
                <a:lnTo>
                  <a:pt x="296" y="49"/>
                </a:lnTo>
                <a:lnTo>
                  <a:pt x="307" y="49"/>
                </a:lnTo>
                <a:lnTo>
                  <a:pt x="322" y="49"/>
                </a:lnTo>
                <a:lnTo>
                  <a:pt x="322" y="39"/>
                </a:lnTo>
                <a:lnTo>
                  <a:pt x="358" y="39"/>
                </a:lnTo>
                <a:lnTo>
                  <a:pt x="406" y="39"/>
                </a:lnTo>
                <a:lnTo>
                  <a:pt x="413" y="39"/>
                </a:lnTo>
                <a:lnTo>
                  <a:pt x="421" y="39"/>
                </a:lnTo>
                <a:lnTo>
                  <a:pt x="428" y="39"/>
                </a:lnTo>
                <a:lnTo>
                  <a:pt x="428" y="28"/>
                </a:lnTo>
                <a:lnTo>
                  <a:pt x="442" y="28"/>
                </a:lnTo>
                <a:lnTo>
                  <a:pt x="455" y="28"/>
                </a:lnTo>
                <a:lnTo>
                  <a:pt x="461" y="28"/>
                </a:lnTo>
                <a:lnTo>
                  <a:pt x="472" y="28"/>
                </a:lnTo>
                <a:lnTo>
                  <a:pt x="474" y="28"/>
                </a:lnTo>
                <a:lnTo>
                  <a:pt x="484" y="28"/>
                </a:lnTo>
                <a:lnTo>
                  <a:pt x="489" y="28"/>
                </a:lnTo>
                <a:lnTo>
                  <a:pt x="491" y="28"/>
                </a:lnTo>
                <a:lnTo>
                  <a:pt x="505" y="28"/>
                </a:lnTo>
                <a:lnTo>
                  <a:pt x="526" y="28"/>
                </a:lnTo>
                <a:lnTo>
                  <a:pt x="531" y="28"/>
                </a:lnTo>
                <a:lnTo>
                  <a:pt x="533" y="28"/>
                </a:lnTo>
                <a:lnTo>
                  <a:pt x="540" y="28"/>
                </a:lnTo>
                <a:lnTo>
                  <a:pt x="552" y="28"/>
                </a:lnTo>
                <a:lnTo>
                  <a:pt x="557" y="28"/>
                </a:lnTo>
                <a:lnTo>
                  <a:pt x="581" y="28"/>
                </a:lnTo>
                <a:lnTo>
                  <a:pt x="595" y="28"/>
                </a:lnTo>
                <a:lnTo>
                  <a:pt x="609" y="28"/>
                </a:lnTo>
                <a:lnTo>
                  <a:pt x="612" y="28"/>
                </a:lnTo>
                <a:lnTo>
                  <a:pt x="621" y="28"/>
                </a:lnTo>
                <a:lnTo>
                  <a:pt x="624" y="28"/>
                </a:lnTo>
                <a:lnTo>
                  <a:pt x="642" y="28"/>
                </a:lnTo>
                <a:lnTo>
                  <a:pt x="652" y="28"/>
                </a:lnTo>
                <a:lnTo>
                  <a:pt x="654" y="28"/>
                </a:lnTo>
                <a:lnTo>
                  <a:pt x="654" y="15"/>
                </a:lnTo>
                <a:lnTo>
                  <a:pt x="661" y="15"/>
                </a:lnTo>
                <a:lnTo>
                  <a:pt x="665" y="15"/>
                </a:lnTo>
                <a:lnTo>
                  <a:pt x="672" y="15"/>
                </a:lnTo>
                <a:lnTo>
                  <a:pt x="679" y="15"/>
                </a:lnTo>
                <a:lnTo>
                  <a:pt x="685" y="15"/>
                </a:lnTo>
                <a:lnTo>
                  <a:pt x="688" y="0"/>
                </a:lnTo>
                <a:lnTo>
                  <a:pt x="698" y="0"/>
                </a:lnTo>
                <a:lnTo>
                  <a:pt x="702" y="0"/>
                </a:lnTo>
                <a:lnTo>
                  <a:pt x="718" y="0"/>
                </a:lnTo>
                <a:lnTo>
                  <a:pt x="720" y="0"/>
                </a:lnTo>
                <a:lnTo>
                  <a:pt x="729" y="0"/>
                </a:lnTo>
                <a:lnTo>
                  <a:pt x="731" y="0"/>
                </a:lnTo>
                <a:lnTo>
                  <a:pt x="744" y="0"/>
                </a:lnTo>
                <a:lnTo>
                  <a:pt x="752" y="0"/>
                </a:lnTo>
                <a:lnTo>
                  <a:pt x="758" y="0"/>
                </a:lnTo>
                <a:lnTo>
                  <a:pt x="762" y="0"/>
                </a:lnTo>
                <a:lnTo>
                  <a:pt x="771" y="0"/>
                </a:lnTo>
                <a:lnTo>
                  <a:pt x="779" y="0"/>
                </a:lnTo>
                <a:lnTo>
                  <a:pt x="780" y="0"/>
                </a:lnTo>
                <a:lnTo>
                  <a:pt x="786" y="0"/>
                </a:lnTo>
                <a:lnTo>
                  <a:pt x="804" y="0"/>
                </a:lnTo>
                <a:lnTo>
                  <a:pt x="810" y="0"/>
                </a:lnTo>
                <a:lnTo>
                  <a:pt x="821" y="0"/>
                </a:lnTo>
                <a:lnTo>
                  <a:pt x="822" y="0"/>
                </a:lnTo>
                <a:lnTo>
                  <a:pt x="828" y="0"/>
                </a:lnTo>
                <a:lnTo>
                  <a:pt x="841" y="0"/>
                </a:lnTo>
                <a:lnTo>
                  <a:pt x="847" y="0"/>
                </a:lnTo>
                <a:lnTo>
                  <a:pt x="861" y="0"/>
                </a:lnTo>
                <a:lnTo>
                  <a:pt x="872" y="0"/>
                </a:lnTo>
                <a:lnTo>
                  <a:pt x="877" y="0"/>
                </a:lnTo>
                <a:lnTo>
                  <a:pt x="883" y="0"/>
                </a:lnTo>
                <a:lnTo>
                  <a:pt x="891" y="0"/>
                </a:lnTo>
                <a:lnTo>
                  <a:pt x="894" y="0"/>
                </a:lnTo>
                <a:lnTo>
                  <a:pt x="900" y="0"/>
                </a:lnTo>
                <a:lnTo>
                  <a:pt x="907" y="0"/>
                </a:lnTo>
                <a:lnTo>
                  <a:pt x="913" y="0"/>
                </a:lnTo>
                <a:lnTo>
                  <a:pt x="919" y="0"/>
                </a:lnTo>
                <a:lnTo>
                  <a:pt x="929" y="0"/>
                </a:lnTo>
                <a:lnTo>
                  <a:pt x="933" y="0"/>
                </a:lnTo>
                <a:lnTo>
                  <a:pt x="936" y="0"/>
                </a:lnTo>
                <a:lnTo>
                  <a:pt x="942" y="0"/>
                </a:lnTo>
                <a:lnTo>
                  <a:pt x="948" y="0"/>
                </a:lnTo>
                <a:lnTo>
                  <a:pt x="954" y="0"/>
                </a:lnTo>
                <a:lnTo>
                  <a:pt x="960" y="0"/>
                </a:lnTo>
                <a:lnTo>
                  <a:pt x="973" y="0"/>
                </a:lnTo>
                <a:lnTo>
                  <a:pt x="979" y="0"/>
                </a:lnTo>
                <a:lnTo>
                  <a:pt x="986" y="0"/>
                </a:lnTo>
                <a:lnTo>
                  <a:pt x="1008" y="0"/>
                </a:lnTo>
                <a:lnTo>
                  <a:pt x="1008" y="0"/>
                </a:lnTo>
                <a:lnTo>
                  <a:pt x="1020" y="0"/>
                </a:lnTo>
                <a:lnTo>
                  <a:pt x="1021" y="0"/>
                </a:lnTo>
                <a:lnTo>
                  <a:pt x="1027" y="0"/>
                </a:lnTo>
                <a:lnTo>
                  <a:pt x="1039" y="0"/>
                </a:lnTo>
                <a:lnTo>
                  <a:pt x="1053" y="0"/>
                </a:lnTo>
                <a:lnTo>
                  <a:pt x="1057" y="0"/>
                </a:lnTo>
                <a:lnTo>
                  <a:pt x="1089" y="0"/>
                </a:lnTo>
                <a:lnTo>
                  <a:pt x="1095" y="0"/>
                </a:lnTo>
                <a:lnTo>
                  <a:pt x="1100" y="0"/>
                </a:lnTo>
                <a:lnTo>
                  <a:pt x="1130" y="0"/>
                </a:lnTo>
                <a:lnTo>
                  <a:pt x="1180" y="0"/>
                </a:lnTo>
                <a:lnTo>
                  <a:pt x="1190" y="0"/>
                </a:lnTo>
                <a:lnTo>
                  <a:pt x="1399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" name="Freeform 95">
            <a:extLst>
              <a:ext uri="{FF2B5EF4-FFF2-40B4-BE49-F238E27FC236}">
                <a16:creationId xmlns:a16="http://schemas.microsoft.com/office/drawing/2014/main" id="{03A8C443-3F03-40EA-B600-2679FB8DB892}"/>
              </a:ext>
            </a:extLst>
          </p:cNvPr>
          <p:cNvSpPr>
            <a:spLocks/>
          </p:cNvSpPr>
          <p:nvPr/>
        </p:nvSpPr>
        <p:spPr bwMode="auto">
          <a:xfrm>
            <a:off x="1988193" y="5451493"/>
            <a:ext cx="3150311" cy="213285"/>
          </a:xfrm>
          <a:custGeom>
            <a:avLst/>
            <a:gdLst>
              <a:gd name="T0" fmla="*/ 85 w 1661"/>
              <a:gd name="T1" fmla="*/ 114 h 114"/>
              <a:gd name="T2" fmla="*/ 90 w 1661"/>
              <a:gd name="T3" fmla="*/ 98 h 114"/>
              <a:gd name="T4" fmla="*/ 150 w 1661"/>
              <a:gd name="T5" fmla="*/ 98 h 114"/>
              <a:gd name="T6" fmla="*/ 194 w 1661"/>
              <a:gd name="T7" fmla="*/ 82 h 114"/>
              <a:gd name="T8" fmla="*/ 214 w 1661"/>
              <a:gd name="T9" fmla="*/ 65 h 114"/>
              <a:gd name="T10" fmla="*/ 235 w 1661"/>
              <a:gd name="T11" fmla="*/ 49 h 114"/>
              <a:gd name="T12" fmla="*/ 248 w 1661"/>
              <a:gd name="T13" fmla="*/ 33 h 114"/>
              <a:gd name="T14" fmla="*/ 263 w 1661"/>
              <a:gd name="T15" fmla="*/ 17 h 114"/>
              <a:gd name="T16" fmla="*/ 296 w 1661"/>
              <a:gd name="T17" fmla="*/ 0 h 114"/>
              <a:gd name="T18" fmla="*/ 361 w 1661"/>
              <a:gd name="T19" fmla="*/ 0 h 114"/>
              <a:gd name="T20" fmla="*/ 428 w 1661"/>
              <a:gd name="T21" fmla="*/ 0 h 114"/>
              <a:gd name="T22" fmla="*/ 445 w 1661"/>
              <a:gd name="T23" fmla="*/ 0 h 114"/>
              <a:gd name="T24" fmla="*/ 519 w 1661"/>
              <a:gd name="T25" fmla="*/ 0 h 114"/>
              <a:gd name="T26" fmla="*/ 555 w 1661"/>
              <a:gd name="T27" fmla="*/ 0 h 114"/>
              <a:gd name="T28" fmla="*/ 587 w 1661"/>
              <a:gd name="T29" fmla="*/ 0 h 114"/>
              <a:gd name="T30" fmla="*/ 600 w 1661"/>
              <a:gd name="T31" fmla="*/ 0 h 114"/>
              <a:gd name="T32" fmla="*/ 612 w 1661"/>
              <a:gd name="T33" fmla="*/ 0 h 114"/>
              <a:gd name="T34" fmla="*/ 627 w 1661"/>
              <a:gd name="T35" fmla="*/ 0 h 114"/>
              <a:gd name="T36" fmla="*/ 653 w 1661"/>
              <a:gd name="T37" fmla="*/ 0 h 114"/>
              <a:gd name="T38" fmla="*/ 671 w 1661"/>
              <a:gd name="T39" fmla="*/ 0 h 114"/>
              <a:gd name="T40" fmla="*/ 687 w 1661"/>
              <a:gd name="T41" fmla="*/ 0 h 114"/>
              <a:gd name="T42" fmla="*/ 704 w 1661"/>
              <a:gd name="T43" fmla="*/ 0 h 114"/>
              <a:gd name="T44" fmla="*/ 722 w 1661"/>
              <a:gd name="T45" fmla="*/ 0 h 114"/>
              <a:gd name="T46" fmla="*/ 733 w 1661"/>
              <a:gd name="T47" fmla="*/ 0 h 114"/>
              <a:gd name="T48" fmla="*/ 746 w 1661"/>
              <a:gd name="T49" fmla="*/ 0 h 114"/>
              <a:gd name="T50" fmla="*/ 757 w 1661"/>
              <a:gd name="T51" fmla="*/ 0 h 114"/>
              <a:gd name="T52" fmla="*/ 776 w 1661"/>
              <a:gd name="T53" fmla="*/ 0 h 114"/>
              <a:gd name="T54" fmla="*/ 797 w 1661"/>
              <a:gd name="T55" fmla="*/ 0 h 114"/>
              <a:gd name="T56" fmla="*/ 808 w 1661"/>
              <a:gd name="T57" fmla="*/ 0 h 114"/>
              <a:gd name="T58" fmla="*/ 823 w 1661"/>
              <a:gd name="T59" fmla="*/ 0 h 114"/>
              <a:gd name="T60" fmla="*/ 836 w 1661"/>
              <a:gd name="T61" fmla="*/ 0 h 114"/>
              <a:gd name="T62" fmla="*/ 855 w 1661"/>
              <a:gd name="T63" fmla="*/ 0 h 114"/>
              <a:gd name="T64" fmla="*/ 872 w 1661"/>
              <a:gd name="T65" fmla="*/ 0 h 114"/>
              <a:gd name="T66" fmla="*/ 886 w 1661"/>
              <a:gd name="T67" fmla="*/ 0 h 114"/>
              <a:gd name="T68" fmla="*/ 895 w 1661"/>
              <a:gd name="T69" fmla="*/ 0 h 114"/>
              <a:gd name="T70" fmla="*/ 910 w 1661"/>
              <a:gd name="T71" fmla="*/ 0 h 114"/>
              <a:gd name="T72" fmla="*/ 931 w 1661"/>
              <a:gd name="T73" fmla="*/ 0 h 114"/>
              <a:gd name="T74" fmla="*/ 950 w 1661"/>
              <a:gd name="T75" fmla="*/ 0 h 114"/>
              <a:gd name="T76" fmla="*/ 960 w 1661"/>
              <a:gd name="T77" fmla="*/ 0 h 114"/>
              <a:gd name="T78" fmla="*/ 991 w 1661"/>
              <a:gd name="T79" fmla="*/ 0 h 114"/>
              <a:gd name="T80" fmla="*/ 1003 w 1661"/>
              <a:gd name="T81" fmla="*/ 0 h 114"/>
              <a:gd name="T82" fmla="*/ 1017 w 1661"/>
              <a:gd name="T83" fmla="*/ 0 h 114"/>
              <a:gd name="T84" fmla="*/ 1036 w 1661"/>
              <a:gd name="T85" fmla="*/ 0 h 114"/>
              <a:gd name="T86" fmla="*/ 1101 w 1661"/>
              <a:gd name="T87" fmla="*/ 0 h 114"/>
              <a:gd name="T88" fmla="*/ 1150 w 1661"/>
              <a:gd name="T89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661" h="114">
                <a:moveTo>
                  <a:pt x="0" y="114"/>
                </a:moveTo>
                <a:lnTo>
                  <a:pt x="85" y="114"/>
                </a:lnTo>
                <a:lnTo>
                  <a:pt x="90" y="114"/>
                </a:lnTo>
                <a:lnTo>
                  <a:pt x="90" y="98"/>
                </a:lnTo>
                <a:lnTo>
                  <a:pt x="108" y="98"/>
                </a:lnTo>
                <a:lnTo>
                  <a:pt x="150" y="98"/>
                </a:lnTo>
                <a:lnTo>
                  <a:pt x="150" y="82"/>
                </a:lnTo>
                <a:lnTo>
                  <a:pt x="194" y="82"/>
                </a:lnTo>
                <a:lnTo>
                  <a:pt x="194" y="65"/>
                </a:lnTo>
                <a:lnTo>
                  <a:pt x="214" y="65"/>
                </a:lnTo>
                <a:lnTo>
                  <a:pt x="214" y="49"/>
                </a:lnTo>
                <a:lnTo>
                  <a:pt x="235" y="49"/>
                </a:lnTo>
                <a:lnTo>
                  <a:pt x="235" y="33"/>
                </a:lnTo>
                <a:lnTo>
                  <a:pt x="248" y="33"/>
                </a:lnTo>
                <a:lnTo>
                  <a:pt x="263" y="33"/>
                </a:lnTo>
                <a:lnTo>
                  <a:pt x="263" y="17"/>
                </a:lnTo>
                <a:lnTo>
                  <a:pt x="294" y="17"/>
                </a:lnTo>
                <a:lnTo>
                  <a:pt x="296" y="0"/>
                </a:lnTo>
                <a:lnTo>
                  <a:pt x="329" y="0"/>
                </a:lnTo>
                <a:lnTo>
                  <a:pt x="361" y="0"/>
                </a:lnTo>
                <a:lnTo>
                  <a:pt x="386" y="0"/>
                </a:lnTo>
                <a:lnTo>
                  <a:pt x="428" y="0"/>
                </a:lnTo>
                <a:lnTo>
                  <a:pt x="436" y="0"/>
                </a:lnTo>
                <a:lnTo>
                  <a:pt x="445" y="0"/>
                </a:lnTo>
                <a:lnTo>
                  <a:pt x="454" y="0"/>
                </a:lnTo>
                <a:lnTo>
                  <a:pt x="519" y="0"/>
                </a:lnTo>
                <a:lnTo>
                  <a:pt x="522" y="0"/>
                </a:lnTo>
                <a:lnTo>
                  <a:pt x="555" y="0"/>
                </a:lnTo>
                <a:lnTo>
                  <a:pt x="576" y="0"/>
                </a:lnTo>
                <a:lnTo>
                  <a:pt x="587" y="0"/>
                </a:lnTo>
                <a:lnTo>
                  <a:pt x="587" y="0"/>
                </a:lnTo>
                <a:lnTo>
                  <a:pt x="600" y="0"/>
                </a:lnTo>
                <a:lnTo>
                  <a:pt x="607" y="0"/>
                </a:lnTo>
                <a:lnTo>
                  <a:pt x="612" y="0"/>
                </a:lnTo>
                <a:lnTo>
                  <a:pt x="618" y="0"/>
                </a:lnTo>
                <a:lnTo>
                  <a:pt x="627" y="0"/>
                </a:lnTo>
                <a:lnTo>
                  <a:pt x="647" y="0"/>
                </a:lnTo>
                <a:lnTo>
                  <a:pt x="653" y="0"/>
                </a:lnTo>
                <a:lnTo>
                  <a:pt x="665" y="0"/>
                </a:lnTo>
                <a:lnTo>
                  <a:pt x="671" y="0"/>
                </a:lnTo>
                <a:lnTo>
                  <a:pt x="678" y="0"/>
                </a:lnTo>
                <a:lnTo>
                  <a:pt x="687" y="0"/>
                </a:lnTo>
                <a:lnTo>
                  <a:pt x="690" y="0"/>
                </a:lnTo>
                <a:lnTo>
                  <a:pt x="704" y="0"/>
                </a:lnTo>
                <a:lnTo>
                  <a:pt x="714" y="0"/>
                </a:lnTo>
                <a:lnTo>
                  <a:pt x="722" y="0"/>
                </a:lnTo>
                <a:lnTo>
                  <a:pt x="727" y="0"/>
                </a:lnTo>
                <a:lnTo>
                  <a:pt x="733" y="0"/>
                </a:lnTo>
                <a:lnTo>
                  <a:pt x="737" y="0"/>
                </a:lnTo>
                <a:lnTo>
                  <a:pt x="746" y="0"/>
                </a:lnTo>
                <a:lnTo>
                  <a:pt x="751" y="0"/>
                </a:lnTo>
                <a:lnTo>
                  <a:pt x="757" y="0"/>
                </a:lnTo>
                <a:lnTo>
                  <a:pt x="763" y="0"/>
                </a:lnTo>
                <a:lnTo>
                  <a:pt x="776" y="0"/>
                </a:lnTo>
                <a:lnTo>
                  <a:pt x="786" y="0"/>
                </a:lnTo>
                <a:lnTo>
                  <a:pt x="797" y="0"/>
                </a:lnTo>
                <a:lnTo>
                  <a:pt x="798" y="0"/>
                </a:lnTo>
                <a:lnTo>
                  <a:pt x="808" y="0"/>
                </a:lnTo>
                <a:lnTo>
                  <a:pt x="812" y="0"/>
                </a:lnTo>
                <a:lnTo>
                  <a:pt x="823" y="0"/>
                </a:lnTo>
                <a:lnTo>
                  <a:pt x="828" y="0"/>
                </a:lnTo>
                <a:lnTo>
                  <a:pt x="836" y="0"/>
                </a:lnTo>
                <a:lnTo>
                  <a:pt x="841" y="0"/>
                </a:lnTo>
                <a:lnTo>
                  <a:pt x="855" y="0"/>
                </a:lnTo>
                <a:lnTo>
                  <a:pt x="860" y="0"/>
                </a:lnTo>
                <a:lnTo>
                  <a:pt x="872" y="0"/>
                </a:lnTo>
                <a:lnTo>
                  <a:pt x="879" y="0"/>
                </a:lnTo>
                <a:lnTo>
                  <a:pt x="886" y="0"/>
                </a:lnTo>
                <a:lnTo>
                  <a:pt x="891" y="0"/>
                </a:lnTo>
                <a:lnTo>
                  <a:pt x="895" y="0"/>
                </a:lnTo>
                <a:lnTo>
                  <a:pt x="900" y="0"/>
                </a:lnTo>
                <a:lnTo>
                  <a:pt x="910" y="0"/>
                </a:lnTo>
                <a:lnTo>
                  <a:pt x="918" y="0"/>
                </a:lnTo>
                <a:lnTo>
                  <a:pt x="931" y="0"/>
                </a:lnTo>
                <a:lnTo>
                  <a:pt x="941" y="0"/>
                </a:lnTo>
                <a:lnTo>
                  <a:pt x="950" y="0"/>
                </a:lnTo>
                <a:lnTo>
                  <a:pt x="955" y="0"/>
                </a:lnTo>
                <a:lnTo>
                  <a:pt x="960" y="0"/>
                </a:lnTo>
                <a:lnTo>
                  <a:pt x="977" y="0"/>
                </a:lnTo>
                <a:lnTo>
                  <a:pt x="991" y="0"/>
                </a:lnTo>
                <a:lnTo>
                  <a:pt x="997" y="0"/>
                </a:lnTo>
                <a:lnTo>
                  <a:pt x="1003" y="0"/>
                </a:lnTo>
                <a:lnTo>
                  <a:pt x="1008" y="0"/>
                </a:lnTo>
                <a:lnTo>
                  <a:pt x="1017" y="0"/>
                </a:lnTo>
                <a:lnTo>
                  <a:pt x="1025" y="0"/>
                </a:lnTo>
                <a:lnTo>
                  <a:pt x="1036" y="0"/>
                </a:lnTo>
                <a:lnTo>
                  <a:pt x="1088" y="0"/>
                </a:lnTo>
                <a:lnTo>
                  <a:pt x="1101" y="0"/>
                </a:lnTo>
                <a:lnTo>
                  <a:pt x="1140" y="0"/>
                </a:lnTo>
                <a:lnTo>
                  <a:pt x="1150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Freeform 130">
            <a:extLst>
              <a:ext uri="{FF2B5EF4-FFF2-40B4-BE49-F238E27FC236}">
                <a16:creationId xmlns:a16="http://schemas.microsoft.com/office/drawing/2014/main" id="{D640D7FF-07B4-4911-7FB3-A3C6CD09EEFD}"/>
              </a:ext>
            </a:extLst>
          </p:cNvPr>
          <p:cNvSpPr>
            <a:spLocks/>
          </p:cNvSpPr>
          <p:nvPr/>
        </p:nvSpPr>
        <p:spPr bwMode="auto">
          <a:xfrm>
            <a:off x="7113073" y="5260517"/>
            <a:ext cx="2626333" cy="413939"/>
          </a:xfrm>
          <a:custGeom>
            <a:avLst/>
            <a:gdLst>
              <a:gd name="T0" fmla="*/ 0 w 1395"/>
              <a:gd name="T1" fmla="*/ 221 h 221"/>
              <a:gd name="T2" fmla="*/ 101 w 1395"/>
              <a:gd name="T3" fmla="*/ 221 h 221"/>
              <a:gd name="T4" fmla="*/ 101 w 1395"/>
              <a:gd name="T5" fmla="*/ 190 h 221"/>
              <a:gd name="T6" fmla="*/ 150 w 1395"/>
              <a:gd name="T7" fmla="*/ 190 h 221"/>
              <a:gd name="T8" fmla="*/ 150 w 1395"/>
              <a:gd name="T9" fmla="*/ 160 h 221"/>
              <a:gd name="T10" fmla="*/ 186 w 1395"/>
              <a:gd name="T11" fmla="*/ 160 h 221"/>
              <a:gd name="T12" fmla="*/ 186 w 1395"/>
              <a:gd name="T13" fmla="*/ 129 h 221"/>
              <a:gd name="T14" fmla="*/ 328 w 1395"/>
              <a:gd name="T15" fmla="*/ 129 h 221"/>
              <a:gd name="T16" fmla="*/ 328 w 1395"/>
              <a:gd name="T17" fmla="*/ 99 h 221"/>
              <a:gd name="T18" fmla="*/ 351 w 1395"/>
              <a:gd name="T19" fmla="*/ 99 h 221"/>
              <a:gd name="T20" fmla="*/ 364 w 1395"/>
              <a:gd name="T21" fmla="*/ 99 h 221"/>
              <a:gd name="T22" fmla="*/ 392 w 1395"/>
              <a:gd name="T23" fmla="*/ 99 h 221"/>
              <a:gd name="T24" fmla="*/ 398 w 1395"/>
              <a:gd name="T25" fmla="*/ 99 h 221"/>
              <a:gd name="T26" fmla="*/ 398 w 1395"/>
              <a:gd name="T27" fmla="*/ 66 h 221"/>
              <a:gd name="T28" fmla="*/ 400 w 1395"/>
              <a:gd name="T29" fmla="*/ 34 h 221"/>
              <a:gd name="T30" fmla="*/ 426 w 1395"/>
              <a:gd name="T31" fmla="*/ 34 h 221"/>
              <a:gd name="T32" fmla="*/ 448 w 1395"/>
              <a:gd name="T33" fmla="*/ 34 h 221"/>
              <a:gd name="T34" fmla="*/ 536 w 1395"/>
              <a:gd name="T35" fmla="*/ 34 h 221"/>
              <a:gd name="T36" fmla="*/ 536 w 1395"/>
              <a:gd name="T37" fmla="*/ 0 h 221"/>
              <a:gd name="T38" fmla="*/ 555 w 1395"/>
              <a:gd name="T39" fmla="*/ 0 h 221"/>
              <a:gd name="T40" fmla="*/ 583 w 1395"/>
              <a:gd name="T41" fmla="*/ 0 h 221"/>
              <a:gd name="T42" fmla="*/ 587 w 1395"/>
              <a:gd name="T43" fmla="*/ 0 h 221"/>
              <a:gd name="T44" fmla="*/ 627 w 1395"/>
              <a:gd name="T45" fmla="*/ 0 h 221"/>
              <a:gd name="T46" fmla="*/ 631 w 1395"/>
              <a:gd name="T47" fmla="*/ 0 h 221"/>
              <a:gd name="T48" fmla="*/ 639 w 1395"/>
              <a:gd name="T49" fmla="*/ 0 h 221"/>
              <a:gd name="T50" fmla="*/ 647 w 1395"/>
              <a:gd name="T51" fmla="*/ 0 h 221"/>
              <a:gd name="T52" fmla="*/ 683 w 1395"/>
              <a:gd name="T53" fmla="*/ 0 h 221"/>
              <a:gd name="T54" fmla="*/ 691 w 1395"/>
              <a:gd name="T55" fmla="*/ 0 h 221"/>
              <a:gd name="T56" fmla="*/ 716 w 1395"/>
              <a:gd name="T57" fmla="*/ 0 h 221"/>
              <a:gd name="T58" fmla="*/ 733 w 1395"/>
              <a:gd name="T59" fmla="*/ 0 h 221"/>
              <a:gd name="T60" fmla="*/ 740 w 1395"/>
              <a:gd name="T61" fmla="*/ 0 h 221"/>
              <a:gd name="T62" fmla="*/ 751 w 1395"/>
              <a:gd name="T63" fmla="*/ 0 h 221"/>
              <a:gd name="T64" fmla="*/ 762 w 1395"/>
              <a:gd name="T65" fmla="*/ 0 h 221"/>
              <a:gd name="T66" fmla="*/ 774 w 1395"/>
              <a:gd name="T67" fmla="*/ 0 h 221"/>
              <a:gd name="T68" fmla="*/ 797 w 1395"/>
              <a:gd name="T69" fmla="*/ 0 h 221"/>
              <a:gd name="T70" fmla="*/ 836 w 1395"/>
              <a:gd name="T71" fmla="*/ 0 h 221"/>
              <a:gd name="T72" fmla="*/ 857 w 1395"/>
              <a:gd name="T73" fmla="*/ 0 h 221"/>
              <a:gd name="T74" fmla="*/ 871 w 1395"/>
              <a:gd name="T75" fmla="*/ 0 h 221"/>
              <a:gd name="T76" fmla="*/ 892 w 1395"/>
              <a:gd name="T77" fmla="*/ 0 h 221"/>
              <a:gd name="T78" fmla="*/ 897 w 1395"/>
              <a:gd name="T79" fmla="*/ 0 h 221"/>
              <a:gd name="T80" fmla="*/ 908 w 1395"/>
              <a:gd name="T81" fmla="*/ 0 h 221"/>
              <a:gd name="T82" fmla="*/ 913 w 1395"/>
              <a:gd name="T83" fmla="*/ 0 h 221"/>
              <a:gd name="T84" fmla="*/ 919 w 1395"/>
              <a:gd name="T85" fmla="*/ 0 h 221"/>
              <a:gd name="T86" fmla="*/ 934 w 1395"/>
              <a:gd name="T87" fmla="*/ 0 h 221"/>
              <a:gd name="T88" fmla="*/ 953 w 1395"/>
              <a:gd name="T89" fmla="*/ 0 h 221"/>
              <a:gd name="T90" fmla="*/ 954 w 1395"/>
              <a:gd name="T91" fmla="*/ 0 h 221"/>
              <a:gd name="T92" fmla="*/ 960 w 1395"/>
              <a:gd name="T93" fmla="*/ 0 h 221"/>
              <a:gd name="T94" fmla="*/ 991 w 1395"/>
              <a:gd name="T95" fmla="*/ 0 h 221"/>
              <a:gd name="T96" fmla="*/ 1010 w 1395"/>
              <a:gd name="T97" fmla="*/ 0 h 221"/>
              <a:gd name="T98" fmla="*/ 1017 w 1395"/>
              <a:gd name="T99" fmla="*/ 0 h 221"/>
              <a:gd name="T100" fmla="*/ 1050 w 1395"/>
              <a:gd name="T101" fmla="*/ 0 h 221"/>
              <a:gd name="T102" fmla="*/ 1081 w 1395"/>
              <a:gd name="T103" fmla="*/ 0 h 221"/>
              <a:gd name="T104" fmla="*/ 1088 w 1395"/>
              <a:gd name="T105" fmla="*/ 0 h 221"/>
              <a:gd name="T106" fmla="*/ 1103 w 1395"/>
              <a:gd name="T107" fmla="*/ 0 h 221"/>
              <a:gd name="T108" fmla="*/ 1136 w 1395"/>
              <a:gd name="T109" fmla="*/ 0 h 221"/>
              <a:gd name="T110" fmla="*/ 1150 w 1395"/>
              <a:gd name="T111" fmla="*/ 0 h 221"/>
              <a:gd name="T112" fmla="*/ 1190 w 1395"/>
              <a:gd name="T113" fmla="*/ 0 h 221"/>
              <a:gd name="T114" fmla="*/ 1395 w 1395"/>
              <a:gd name="T115" fmla="*/ 0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395" h="221">
                <a:moveTo>
                  <a:pt x="0" y="221"/>
                </a:moveTo>
                <a:lnTo>
                  <a:pt x="101" y="221"/>
                </a:lnTo>
                <a:lnTo>
                  <a:pt x="101" y="190"/>
                </a:lnTo>
                <a:lnTo>
                  <a:pt x="150" y="190"/>
                </a:lnTo>
                <a:lnTo>
                  <a:pt x="150" y="160"/>
                </a:lnTo>
                <a:lnTo>
                  <a:pt x="186" y="160"/>
                </a:lnTo>
                <a:lnTo>
                  <a:pt x="186" y="129"/>
                </a:lnTo>
                <a:lnTo>
                  <a:pt x="328" y="129"/>
                </a:lnTo>
                <a:lnTo>
                  <a:pt x="328" y="99"/>
                </a:lnTo>
                <a:lnTo>
                  <a:pt x="351" y="99"/>
                </a:lnTo>
                <a:lnTo>
                  <a:pt x="364" y="99"/>
                </a:lnTo>
                <a:lnTo>
                  <a:pt x="392" y="99"/>
                </a:lnTo>
                <a:lnTo>
                  <a:pt x="398" y="99"/>
                </a:lnTo>
                <a:lnTo>
                  <a:pt x="398" y="66"/>
                </a:lnTo>
                <a:lnTo>
                  <a:pt x="400" y="34"/>
                </a:lnTo>
                <a:lnTo>
                  <a:pt x="426" y="34"/>
                </a:lnTo>
                <a:lnTo>
                  <a:pt x="448" y="34"/>
                </a:lnTo>
                <a:lnTo>
                  <a:pt x="536" y="34"/>
                </a:lnTo>
                <a:lnTo>
                  <a:pt x="536" y="0"/>
                </a:lnTo>
                <a:lnTo>
                  <a:pt x="555" y="0"/>
                </a:lnTo>
                <a:lnTo>
                  <a:pt x="583" y="0"/>
                </a:lnTo>
                <a:lnTo>
                  <a:pt x="587" y="0"/>
                </a:lnTo>
                <a:lnTo>
                  <a:pt x="627" y="0"/>
                </a:lnTo>
                <a:lnTo>
                  <a:pt x="631" y="0"/>
                </a:lnTo>
                <a:lnTo>
                  <a:pt x="639" y="0"/>
                </a:lnTo>
                <a:lnTo>
                  <a:pt x="647" y="0"/>
                </a:lnTo>
                <a:lnTo>
                  <a:pt x="683" y="0"/>
                </a:lnTo>
                <a:lnTo>
                  <a:pt x="691" y="0"/>
                </a:lnTo>
                <a:lnTo>
                  <a:pt x="716" y="0"/>
                </a:lnTo>
                <a:lnTo>
                  <a:pt x="733" y="0"/>
                </a:lnTo>
                <a:lnTo>
                  <a:pt x="740" y="0"/>
                </a:lnTo>
                <a:lnTo>
                  <a:pt x="751" y="0"/>
                </a:lnTo>
                <a:lnTo>
                  <a:pt x="762" y="0"/>
                </a:lnTo>
                <a:lnTo>
                  <a:pt x="774" y="0"/>
                </a:lnTo>
                <a:lnTo>
                  <a:pt x="797" y="0"/>
                </a:lnTo>
                <a:lnTo>
                  <a:pt x="836" y="0"/>
                </a:lnTo>
                <a:lnTo>
                  <a:pt x="857" y="0"/>
                </a:lnTo>
                <a:lnTo>
                  <a:pt x="871" y="0"/>
                </a:lnTo>
                <a:lnTo>
                  <a:pt x="892" y="0"/>
                </a:lnTo>
                <a:lnTo>
                  <a:pt x="897" y="0"/>
                </a:lnTo>
                <a:lnTo>
                  <a:pt x="908" y="0"/>
                </a:lnTo>
                <a:lnTo>
                  <a:pt x="913" y="0"/>
                </a:lnTo>
                <a:lnTo>
                  <a:pt x="919" y="0"/>
                </a:lnTo>
                <a:lnTo>
                  <a:pt x="934" y="0"/>
                </a:lnTo>
                <a:lnTo>
                  <a:pt x="953" y="0"/>
                </a:lnTo>
                <a:lnTo>
                  <a:pt x="954" y="0"/>
                </a:lnTo>
                <a:lnTo>
                  <a:pt x="960" y="0"/>
                </a:lnTo>
                <a:lnTo>
                  <a:pt x="991" y="0"/>
                </a:lnTo>
                <a:lnTo>
                  <a:pt x="1010" y="0"/>
                </a:lnTo>
                <a:lnTo>
                  <a:pt x="1017" y="0"/>
                </a:lnTo>
                <a:lnTo>
                  <a:pt x="1050" y="0"/>
                </a:lnTo>
                <a:lnTo>
                  <a:pt x="1081" y="0"/>
                </a:lnTo>
                <a:lnTo>
                  <a:pt x="1088" y="0"/>
                </a:lnTo>
                <a:lnTo>
                  <a:pt x="1103" y="0"/>
                </a:lnTo>
                <a:lnTo>
                  <a:pt x="1136" y="0"/>
                </a:lnTo>
                <a:lnTo>
                  <a:pt x="1150" y="0"/>
                </a:lnTo>
                <a:lnTo>
                  <a:pt x="1190" y="0"/>
                </a:lnTo>
                <a:lnTo>
                  <a:pt x="1395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Freeform 131">
            <a:extLst>
              <a:ext uri="{FF2B5EF4-FFF2-40B4-BE49-F238E27FC236}">
                <a16:creationId xmlns:a16="http://schemas.microsoft.com/office/drawing/2014/main" id="{8C6D3519-EB44-E4D8-CE84-63F322A110F0}"/>
              </a:ext>
            </a:extLst>
          </p:cNvPr>
          <p:cNvSpPr>
            <a:spLocks/>
          </p:cNvSpPr>
          <p:nvPr/>
        </p:nvSpPr>
        <p:spPr bwMode="auto">
          <a:xfrm>
            <a:off x="7113073" y="5629503"/>
            <a:ext cx="3127124" cy="44953"/>
          </a:xfrm>
          <a:custGeom>
            <a:avLst/>
            <a:gdLst>
              <a:gd name="T0" fmla="*/ 79 w 1661"/>
              <a:gd name="T1" fmla="*/ 24 h 24"/>
              <a:gd name="T2" fmla="*/ 90 w 1661"/>
              <a:gd name="T3" fmla="*/ 24 h 24"/>
              <a:gd name="T4" fmla="*/ 119 w 1661"/>
              <a:gd name="T5" fmla="*/ 24 h 24"/>
              <a:gd name="T6" fmla="*/ 179 w 1661"/>
              <a:gd name="T7" fmla="*/ 24 h 24"/>
              <a:gd name="T8" fmla="*/ 205 w 1661"/>
              <a:gd name="T9" fmla="*/ 24 h 24"/>
              <a:gd name="T10" fmla="*/ 216 w 1661"/>
              <a:gd name="T11" fmla="*/ 24 h 24"/>
              <a:gd name="T12" fmla="*/ 241 w 1661"/>
              <a:gd name="T13" fmla="*/ 24 h 24"/>
              <a:gd name="T14" fmla="*/ 266 w 1661"/>
              <a:gd name="T15" fmla="*/ 24 h 24"/>
              <a:gd name="T16" fmla="*/ 275 w 1661"/>
              <a:gd name="T17" fmla="*/ 24 h 24"/>
              <a:gd name="T18" fmla="*/ 289 w 1661"/>
              <a:gd name="T19" fmla="*/ 24 h 24"/>
              <a:gd name="T20" fmla="*/ 300 w 1661"/>
              <a:gd name="T21" fmla="*/ 24 h 24"/>
              <a:gd name="T22" fmla="*/ 335 w 1661"/>
              <a:gd name="T23" fmla="*/ 24 h 24"/>
              <a:gd name="T24" fmla="*/ 366 w 1661"/>
              <a:gd name="T25" fmla="*/ 24 h 24"/>
              <a:gd name="T26" fmla="*/ 381 w 1661"/>
              <a:gd name="T27" fmla="*/ 24 h 24"/>
              <a:gd name="T28" fmla="*/ 391 w 1661"/>
              <a:gd name="T29" fmla="*/ 24 h 24"/>
              <a:gd name="T30" fmla="*/ 409 w 1661"/>
              <a:gd name="T31" fmla="*/ 24 h 24"/>
              <a:gd name="T32" fmla="*/ 422 w 1661"/>
              <a:gd name="T33" fmla="*/ 24 h 24"/>
              <a:gd name="T34" fmla="*/ 439 w 1661"/>
              <a:gd name="T35" fmla="*/ 24 h 24"/>
              <a:gd name="T36" fmla="*/ 457 w 1661"/>
              <a:gd name="T37" fmla="*/ 24 h 24"/>
              <a:gd name="T38" fmla="*/ 472 w 1661"/>
              <a:gd name="T39" fmla="*/ 24 h 24"/>
              <a:gd name="T40" fmla="*/ 484 w 1661"/>
              <a:gd name="T41" fmla="*/ 24 h 24"/>
              <a:gd name="T42" fmla="*/ 500 w 1661"/>
              <a:gd name="T43" fmla="*/ 24 h 24"/>
              <a:gd name="T44" fmla="*/ 514 w 1661"/>
              <a:gd name="T45" fmla="*/ 24 h 24"/>
              <a:gd name="T46" fmla="*/ 526 w 1661"/>
              <a:gd name="T47" fmla="*/ 24 h 24"/>
              <a:gd name="T48" fmla="*/ 533 w 1661"/>
              <a:gd name="T49" fmla="*/ 24 h 24"/>
              <a:gd name="T50" fmla="*/ 554 w 1661"/>
              <a:gd name="T51" fmla="*/ 24 h 24"/>
              <a:gd name="T52" fmla="*/ 579 w 1661"/>
              <a:gd name="T53" fmla="*/ 24 h 24"/>
              <a:gd name="T54" fmla="*/ 589 w 1661"/>
              <a:gd name="T55" fmla="*/ 24 h 24"/>
              <a:gd name="T56" fmla="*/ 609 w 1661"/>
              <a:gd name="T57" fmla="*/ 24 h 24"/>
              <a:gd name="T58" fmla="*/ 624 w 1661"/>
              <a:gd name="T59" fmla="*/ 24 h 24"/>
              <a:gd name="T60" fmla="*/ 635 w 1661"/>
              <a:gd name="T61" fmla="*/ 24 h 24"/>
              <a:gd name="T62" fmla="*/ 652 w 1661"/>
              <a:gd name="T63" fmla="*/ 24 h 24"/>
              <a:gd name="T64" fmla="*/ 654 w 1661"/>
              <a:gd name="T65" fmla="*/ 0 h 24"/>
              <a:gd name="T66" fmla="*/ 672 w 1661"/>
              <a:gd name="T67" fmla="*/ 0 h 24"/>
              <a:gd name="T68" fmla="*/ 684 w 1661"/>
              <a:gd name="T69" fmla="*/ 0 h 24"/>
              <a:gd name="T70" fmla="*/ 704 w 1661"/>
              <a:gd name="T71" fmla="*/ 0 h 24"/>
              <a:gd name="T72" fmla="*/ 717 w 1661"/>
              <a:gd name="T73" fmla="*/ 0 h 24"/>
              <a:gd name="T74" fmla="*/ 738 w 1661"/>
              <a:gd name="T75" fmla="*/ 0 h 24"/>
              <a:gd name="T76" fmla="*/ 750 w 1661"/>
              <a:gd name="T77" fmla="*/ 0 h 24"/>
              <a:gd name="T78" fmla="*/ 785 w 1661"/>
              <a:gd name="T79" fmla="*/ 0 h 24"/>
              <a:gd name="T80" fmla="*/ 796 w 1661"/>
              <a:gd name="T81" fmla="*/ 0 h 24"/>
              <a:gd name="T82" fmla="*/ 818 w 1661"/>
              <a:gd name="T83" fmla="*/ 0 h 24"/>
              <a:gd name="T84" fmla="*/ 830 w 1661"/>
              <a:gd name="T85" fmla="*/ 0 h 24"/>
              <a:gd name="T86" fmla="*/ 854 w 1661"/>
              <a:gd name="T87" fmla="*/ 0 h 24"/>
              <a:gd name="T88" fmla="*/ 877 w 1661"/>
              <a:gd name="T89" fmla="*/ 0 h 24"/>
              <a:gd name="T90" fmla="*/ 891 w 1661"/>
              <a:gd name="T91" fmla="*/ 0 h 24"/>
              <a:gd name="T92" fmla="*/ 908 w 1661"/>
              <a:gd name="T93" fmla="*/ 0 h 24"/>
              <a:gd name="T94" fmla="*/ 921 w 1661"/>
              <a:gd name="T95" fmla="*/ 0 h 24"/>
              <a:gd name="T96" fmla="*/ 941 w 1661"/>
              <a:gd name="T97" fmla="*/ 0 h 24"/>
              <a:gd name="T98" fmla="*/ 953 w 1661"/>
              <a:gd name="T99" fmla="*/ 0 h 24"/>
              <a:gd name="T100" fmla="*/ 986 w 1661"/>
              <a:gd name="T101" fmla="*/ 0 h 24"/>
              <a:gd name="T102" fmla="*/ 1015 w 1661"/>
              <a:gd name="T103" fmla="*/ 0 h 24"/>
              <a:gd name="T104" fmla="*/ 1038 w 1661"/>
              <a:gd name="T105" fmla="*/ 0 h 24"/>
              <a:gd name="T106" fmla="*/ 1077 w 1661"/>
              <a:gd name="T107" fmla="*/ 0 h 24"/>
              <a:gd name="T108" fmla="*/ 1132 w 1661"/>
              <a:gd name="T109" fmla="*/ 0 h 24"/>
              <a:gd name="T110" fmla="*/ 1152 w 1661"/>
              <a:gd name="T111" fmla="*/ 0 h 24"/>
              <a:gd name="T112" fmla="*/ 1216 w 1661"/>
              <a:gd name="T113" fmla="*/ 0 h 24"/>
              <a:gd name="T114" fmla="*/ 1300 w 1661"/>
              <a:gd name="T115" fmla="*/ 0 h 24"/>
              <a:gd name="T116" fmla="*/ 1334 w 1661"/>
              <a:gd name="T117" fmla="*/ 0 h 24"/>
              <a:gd name="T118" fmla="*/ 1552 w 1661"/>
              <a:gd name="T119" fmla="*/ 0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661" h="24">
                <a:moveTo>
                  <a:pt x="0" y="24"/>
                </a:moveTo>
                <a:lnTo>
                  <a:pt x="79" y="24"/>
                </a:lnTo>
                <a:lnTo>
                  <a:pt x="82" y="24"/>
                </a:lnTo>
                <a:lnTo>
                  <a:pt x="90" y="24"/>
                </a:lnTo>
                <a:lnTo>
                  <a:pt x="95" y="24"/>
                </a:lnTo>
                <a:lnTo>
                  <a:pt x="119" y="24"/>
                </a:lnTo>
                <a:lnTo>
                  <a:pt x="166" y="24"/>
                </a:lnTo>
                <a:lnTo>
                  <a:pt x="179" y="24"/>
                </a:lnTo>
                <a:lnTo>
                  <a:pt x="189" y="24"/>
                </a:lnTo>
                <a:lnTo>
                  <a:pt x="205" y="24"/>
                </a:lnTo>
                <a:lnTo>
                  <a:pt x="213" y="24"/>
                </a:lnTo>
                <a:lnTo>
                  <a:pt x="216" y="24"/>
                </a:lnTo>
                <a:lnTo>
                  <a:pt x="225" y="24"/>
                </a:lnTo>
                <a:lnTo>
                  <a:pt x="241" y="24"/>
                </a:lnTo>
                <a:lnTo>
                  <a:pt x="247" y="24"/>
                </a:lnTo>
                <a:lnTo>
                  <a:pt x="266" y="24"/>
                </a:lnTo>
                <a:lnTo>
                  <a:pt x="274" y="24"/>
                </a:lnTo>
                <a:lnTo>
                  <a:pt x="275" y="24"/>
                </a:lnTo>
                <a:lnTo>
                  <a:pt x="281" y="24"/>
                </a:lnTo>
                <a:lnTo>
                  <a:pt x="289" y="24"/>
                </a:lnTo>
                <a:lnTo>
                  <a:pt x="294" y="24"/>
                </a:lnTo>
                <a:lnTo>
                  <a:pt x="300" y="24"/>
                </a:lnTo>
                <a:lnTo>
                  <a:pt x="311" y="24"/>
                </a:lnTo>
                <a:lnTo>
                  <a:pt x="335" y="24"/>
                </a:lnTo>
                <a:lnTo>
                  <a:pt x="363" y="24"/>
                </a:lnTo>
                <a:lnTo>
                  <a:pt x="366" y="24"/>
                </a:lnTo>
                <a:lnTo>
                  <a:pt x="373" y="24"/>
                </a:lnTo>
                <a:lnTo>
                  <a:pt x="381" y="24"/>
                </a:lnTo>
                <a:lnTo>
                  <a:pt x="383" y="24"/>
                </a:lnTo>
                <a:lnTo>
                  <a:pt x="391" y="24"/>
                </a:lnTo>
                <a:lnTo>
                  <a:pt x="406" y="24"/>
                </a:lnTo>
                <a:lnTo>
                  <a:pt x="409" y="24"/>
                </a:lnTo>
                <a:lnTo>
                  <a:pt x="417" y="24"/>
                </a:lnTo>
                <a:lnTo>
                  <a:pt x="422" y="24"/>
                </a:lnTo>
                <a:lnTo>
                  <a:pt x="435" y="24"/>
                </a:lnTo>
                <a:lnTo>
                  <a:pt x="439" y="24"/>
                </a:lnTo>
                <a:lnTo>
                  <a:pt x="452" y="24"/>
                </a:lnTo>
                <a:lnTo>
                  <a:pt x="457" y="24"/>
                </a:lnTo>
                <a:lnTo>
                  <a:pt x="461" y="24"/>
                </a:lnTo>
                <a:lnTo>
                  <a:pt x="472" y="24"/>
                </a:lnTo>
                <a:lnTo>
                  <a:pt x="474" y="24"/>
                </a:lnTo>
                <a:lnTo>
                  <a:pt x="484" y="24"/>
                </a:lnTo>
                <a:lnTo>
                  <a:pt x="492" y="24"/>
                </a:lnTo>
                <a:lnTo>
                  <a:pt x="500" y="24"/>
                </a:lnTo>
                <a:lnTo>
                  <a:pt x="506" y="24"/>
                </a:lnTo>
                <a:lnTo>
                  <a:pt x="514" y="24"/>
                </a:lnTo>
                <a:lnTo>
                  <a:pt x="520" y="24"/>
                </a:lnTo>
                <a:lnTo>
                  <a:pt x="526" y="24"/>
                </a:lnTo>
                <a:lnTo>
                  <a:pt x="531" y="24"/>
                </a:lnTo>
                <a:lnTo>
                  <a:pt x="533" y="24"/>
                </a:lnTo>
                <a:lnTo>
                  <a:pt x="548" y="24"/>
                </a:lnTo>
                <a:lnTo>
                  <a:pt x="554" y="24"/>
                </a:lnTo>
                <a:lnTo>
                  <a:pt x="557" y="24"/>
                </a:lnTo>
                <a:lnTo>
                  <a:pt x="579" y="24"/>
                </a:lnTo>
                <a:lnTo>
                  <a:pt x="581" y="24"/>
                </a:lnTo>
                <a:lnTo>
                  <a:pt x="589" y="24"/>
                </a:lnTo>
                <a:lnTo>
                  <a:pt x="604" y="24"/>
                </a:lnTo>
                <a:lnTo>
                  <a:pt x="609" y="24"/>
                </a:lnTo>
                <a:lnTo>
                  <a:pt x="618" y="24"/>
                </a:lnTo>
                <a:lnTo>
                  <a:pt x="624" y="24"/>
                </a:lnTo>
                <a:lnTo>
                  <a:pt x="634" y="24"/>
                </a:lnTo>
                <a:lnTo>
                  <a:pt x="635" y="24"/>
                </a:lnTo>
                <a:lnTo>
                  <a:pt x="647" y="24"/>
                </a:lnTo>
                <a:lnTo>
                  <a:pt x="652" y="24"/>
                </a:lnTo>
                <a:lnTo>
                  <a:pt x="654" y="24"/>
                </a:lnTo>
                <a:lnTo>
                  <a:pt x="654" y="0"/>
                </a:lnTo>
                <a:lnTo>
                  <a:pt x="665" y="0"/>
                </a:lnTo>
                <a:lnTo>
                  <a:pt x="672" y="0"/>
                </a:lnTo>
                <a:lnTo>
                  <a:pt x="682" y="0"/>
                </a:lnTo>
                <a:lnTo>
                  <a:pt x="684" y="0"/>
                </a:lnTo>
                <a:lnTo>
                  <a:pt x="700" y="0"/>
                </a:lnTo>
                <a:lnTo>
                  <a:pt x="704" y="0"/>
                </a:lnTo>
                <a:lnTo>
                  <a:pt x="711" y="0"/>
                </a:lnTo>
                <a:lnTo>
                  <a:pt x="717" y="0"/>
                </a:lnTo>
                <a:lnTo>
                  <a:pt x="733" y="0"/>
                </a:lnTo>
                <a:lnTo>
                  <a:pt x="738" y="0"/>
                </a:lnTo>
                <a:lnTo>
                  <a:pt x="744" y="0"/>
                </a:lnTo>
                <a:lnTo>
                  <a:pt x="750" y="0"/>
                </a:lnTo>
                <a:lnTo>
                  <a:pt x="771" y="0"/>
                </a:lnTo>
                <a:lnTo>
                  <a:pt x="785" y="0"/>
                </a:lnTo>
                <a:lnTo>
                  <a:pt x="786" y="0"/>
                </a:lnTo>
                <a:lnTo>
                  <a:pt x="796" y="0"/>
                </a:lnTo>
                <a:lnTo>
                  <a:pt x="804" y="0"/>
                </a:lnTo>
                <a:lnTo>
                  <a:pt x="818" y="0"/>
                </a:lnTo>
                <a:lnTo>
                  <a:pt x="824" y="0"/>
                </a:lnTo>
                <a:lnTo>
                  <a:pt x="830" y="0"/>
                </a:lnTo>
                <a:lnTo>
                  <a:pt x="847" y="0"/>
                </a:lnTo>
                <a:lnTo>
                  <a:pt x="854" y="0"/>
                </a:lnTo>
                <a:lnTo>
                  <a:pt x="861" y="0"/>
                </a:lnTo>
                <a:lnTo>
                  <a:pt x="877" y="0"/>
                </a:lnTo>
                <a:lnTo>
                  <a:pt x="883" y="0"/>
                </a:lnTo>
                <a:lnTo>
                  <a:pt x="891" y="0"/>
                </a:lnTo>
                <a:lnTo>
                  <a:pt x="894" y="0"/>
                </a:lnTo>
                <a:lnTo>
                  <a:pt x="908" y="0"/>
                </a:lnTo>
                <a:lnTo>
                  <a:pt x="913" y="0"/>
                </a:lnTo>
                <a:lnTo>
                  <a:pt x="921" y="0"/>
                </a:lnTo>
                <a:lnTo>
                  <a:pt x="929" y="0"/>
                </a:lnTo>
                <a:lnTo>
                  <a:pt x="941" y="0"/>
                </a:lnTo>
                <a:lnTo>
                  <a:pt x="945" y="0"/>
                </a:lnTo>
                <a:lnTo>
                  <a:pt x="953" y="0"/>
                </a:lnTo>
                <a:lnTo>
                  <a:pt x="956" y="0"/>
                </a:lnTo>
                <a:lnTo>
                  <a:pt x="986" y="0"/>
                </a:lnTo>
                <a:lnTo>
                  <a:pt x="1008" y="0"/>
                </a:lnTo>
                <a:lnTo>
                  <a:pt x="1015" y="0"/>
                </a:lnTo>
                <a:lnTo>
                  <a:pt x="1021" y="0"/>
                </a:lnTo>
                <a:lnTo>
                  <a:pt x="1038" y="0"/>
                </a:lnTo>
                <a:lnTo>
                  <a:pt x="1072" y="0"/>
                </a:lnTo>
                <a:lnTo>
                  <a:pt x="1077" y="0"/>
                </a:lnTo>
                <a:lnTo>
                  <a:pt x="1089" y="0"/>
                </a:lnTo>
                <a:lnTo>
                  <a:pt x="1132" y="0"/>
                </a:lnTo>
                <a:lnTo>
                  <a:pt x="1143" y="0"/>
                </a:lnTo>
                <a:lnTo>
                  <a:pt x="1152" y="0"/>
                </a:lnTo>
                <a:lnTo>
                  <a:pt x="1180" y="0"/>
                </a:lnTo>
                <a:lnTo>
                  <a:pt x="1216" y="0"/>
                </a:lnTo>
                <a:lnTo>
                  <a:pt x="1296" y="0"/>
                </a:lnTo>
                <a:lnTo>
                  <a:pt x="1300" y="0"/>
                </a:lnTo>
                <a:lnTo>
                  <a:pt x="1319" y="0"/>
                </a:lnTo>
                <a:lnTo>
                  <a:pt x="1334" y="0"/>
                </a:lnTo>
                <a:lnTo>
                  <a:pt x="1399" y="0"/>
                </a:lnTo>
                <a:lnTo>
                  <a:pt x="1552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Freeform 132">
            <a:extLst>
              <a:ext uri="{FF2B5EF4-FFF2-40B4-BE49-F238E27FC236}">
                <a16:creationId xmlns:a16="http://schemas.microsoft.com/office/drawing/2014/main" id="{F820F607-5EA0-106A-EC11-0E8032B29DD4}"/>
              </a:ext>
            </a:extLst>
          </p:cNvPr>
          <p:cNvSpPr>
            <a:spLocks/>
          </p:cNvSpPr>
          <p:nvPr/>
        </p:nvSpPr>
        <p:spPr bwMode="auto">
          <a:xfrm>
            <a:off x="7113073" y="5226803"/>
            <a:ext cx="3127124" cy="447653"/>
          </a:xfrm>
          <a:custGeom>
            <a:avLst/>
            <a:gdLst>
              <a:gd name="T0" fmla="*/ 82 w 1661"/>
              <a:gd name="T1" fmla="*/ 234 h 239"/>
              <a:gd name="T2" fmla="*/ 106 w 1661"/>
              <a:gd name="T3" fmla="*/ 229 h 239"/>
              <a:gd name="T4" fmla="*/ 143 w 1661"/>
              <a:gd name="T5" fmla="*/ 219 h 239"/>
              <a:gd name="T6" fmla="*/ 159 w 1661"/>
              <a:gd name="T7" fmla="*/ 209 h 239"/>
              <a:gd name="T8" fmla="*/ 181 w 1661"/>
              <a:gd name="T9" fmla="*/ 203 h 239"/>
              <a:gd name="T10" fmla="*/ 196 w 1661"/>
              <a:gd name="T11" fmla="*/ 187 h 239"/>
              <a:gd name="T12" fmla="*/ 209 w 1661"/>
              <a:gd name="T13" fmla="*/ 177 h 239"/>
              <a:gd name="T14" fmla="*/ 235 w 1661"/>
              <a:gd name="T15" fmla="*/ 172 h 239"/>
              <a:gd name="T16" fmla="*/ 263 w 1661"/>
              <a:gd name="T17" fmla="*/ 161 h 239"/>
              <a:gd name="T18" fmla="*/ 296 w 1661"/>
              <a:gd name="T19" fmla="*/ 156 h 239"/>
              <a:gd name="T20" fmla="*/ 333 w 1661"/>
              <a:gd name="T21" fmla="*/ 151 h 239"/>
              <a:gd name="T22" fmla="*/ 349 w 1661"/>
              <a:gd name="T23" fmla="*/ 145 h 239"/>
              <a:gd name="T24" fmla="*/ 372 w 1661"/>
              <a:gd name="T25" fmla="*/ 140 h 239"/>
              <a:gd name="T26" fmla="*/ 393 w 1661"/>
              <a:gd name="T27" fmla="*/ 134 h 239"/>
              <a:gd name="T28" fmla="*/ 428 w 1661"/>
              <a:gd name="T29" fmla="*/ 128 h 239"/>
              <a:gd name="T30" fmla="*/ 454 w 1661"/>
              <a:gd name="T31" fmla="*/ 128 h 239"/>
              <a:gd name="T32" fmla="*/ 480 w 1661"/>
              <a:gd name="T33" fmla="*/ 128 h 239"/>
              <a:gd name="T34" fmla="*/ 512 w 1661"/>
              <a:gd name="T35" fmla="*/ 128 h 239"/>
              <a:gd name="T36" fmla="*/ 533 w 1661"/>
              <a:gd name="T37" fmla="*/ 128 h 239"/>
              <a:gd name="T38" fmla="*/ 558 w 1661"/>
              <a:gd name="T39" fmla="*/ 128 h 239"/>
              <a:gd name="T40" fmla="*/ 582 w 1661"/>
              <a:gd name="T41" fmla="*/ 128 h 239"/>
              <a:gd name="T42" fmla="*/ 606 w 1661"/>
              <a:gd name="T43" fmla="*/ 128 h 239"/>
              <a:gd name="T44" fmla="*/ 625 w 1661"/>
              <a:gd name="T45" fmla="*/ 122 h 239"/>
              <a:gd name="T46" fmla="*/ 648 w 1661"/>
              <a:gd name="T47" fmla="*/ 122 h 239"/>
              <a:gd name="T48" fmla="*/ 678 w 1661"/>
              <a:gd name="T49" fmla="*/ 122 h 239"/>
              <a:gd name="T50" fmla="*/ 696 w 1661"/>
              <a:gd name="T51" fmla="*/ 114 h 239"/>
              <a:gd name="T52" fmla="*/ 720 w 1661"/>
              <a:gd name="T53" fmla="*/ 114 h 239"/>
              <a:gd name="T54" fmla="*/ 744 w 1661"/>
              <a:gd name="T55" fmla="*/ 114 h 239"/>
              <a:gd name="T56" fmla="*/ 769 w 1661"/>
              <a:gd name="T57" fmla="*/ 114 h 239"/>
              <a:gd name="T58" fmla="*/ 794 w 1661"/>
              <a:gd name="T59" fmla="*/ 114 h 239"/>
              <a:gd name="T60" fmla="*/ 816 w 1661"/>
              <a:gd name="T61" fmla="*/ 114 h 239"/>
              <a:gd name="T62" fmla="*/ 841 w 1661"/>
              <a:gd name="T63" fmla="*/ 114 h 239"/>
              <a:gd name="T64" fmla="*/ 871 w 1661"/>
              <a:gd name="T65" fmla="*/ 114 h 239"/>
              <a:gd name="T66" fmla="*/ 895 w 1661"/>
              <a:gd name="T67" fmla="*/ 114 h 239"/>
              <a:gd name="T68" fmla="*/ 918 w 1661"/>
              <a:gd name="T69" fmla="*/ 114 h 239"/>
              <a:gd name="T70" fmla="*/ 942 w 1661"/>
              <a:gd name="T71" fmla="*/ 114 h 239"/>
              <a:gd name="T72" fmla="*/ 967 w 1661"/>
              <a:gd name="T73" fmla="*/ 114 h 239"/>
              <a:gd name="T74" fmla="*/ 991 w 1661"/>
              <a:gd name="T75" fmla="*/ 114 h 239"/>
              <a:gd name="T76" fmla="*/ 1017 w 1661"/>
              <a:gd name="T77" fmla="*/ 114 h 239"/>
              <a:gd name="T78" fmla="*/ 1039 w 1661"/>
              <a:gd name="T79" fmla="*/ 114 h 239"/>
              <a:gd name="T80" fmla="*/ 1074 w 1661"/>
              <a:gd name="T81" fmla="*/ 114 h 239"/>
              <a:gd name="T82" fmla="*/ 1100 w 1661"/>
              <a:gd name="T83" fmla="*/ 114 h 239"/>
              <a:gd name="T84" fmla="*/ 1140 w 1661"/>
              <a:gd name="T85" fmla="*/ 114 h 239"/>
              <a:gd name="T86" fmla="*/ 1185 w 1661"/>
              <a:gd name="T87" fmla="*/ 114 h 239"/>
              <a:gd name="T88" fmla="*/ 1211 w 1661"/>
              <a:gd name="T89" fmla="*/ 0 h 239"/>
              <a:gd name="T90" fmla="*/ 1354 w 1661"/>
              <a:gd name="T91" fmla="*/ 0 h 239"/>
              <a:gd name="T92" fmla="*/ 1440 w 1661"/>
              <a:gd name="T93" fmla="*/ 0 h 239"/>
              <a:gd name="T94" fmla="*/ 1604 w 1661"/>
              <a:gd name="T95" fmla="*/ 0 h 2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1661" h="239">
                <a:moveTo>
                  <a:pt x="0" y="239"/>
                </a:moveTo>
                <a:lnTo>
                  <a:pt x="79" y="239"/>
                </a:lnTo>
                <a:lnTo>
                  <a:pt x="82" y="239"/>
                </a:lnTo>
                <a:lnTo>
                  <a:pt x="82" y="234"/>
                </a:lnTo>
                <a:lnTo>
                  <a:pt x="90" y="234"/>
                </a:lnTo>
                <a:lnTo>
                  <a:pt x="90" y="229"/>
                </a:lnTo>
                <a:lnTo>
                  <a:pt x="96" y="229"/>
                </a:lnTo>
                <a:lnTo>
                  <a:pt x="106" y="229"/>
                </a:lnTo>
                <a:lnTo>
                  <a:pt x="106" y="224"/>
                </a:lnTo>
                <a:lnTo>
                  <a:pt x="123" y="219"/>
                </a:lnTo>
                <a:lnTo>
                  <a:pt x="127" y="219"/>
                </a:lnTo>
                <a:lnTo>
                  <a:pt x="143" y="219"/>
                </a:lnTo>
                <a:lnTo>
                  <a:pt x="146" y="213"/>
                </a:lnTo>
                <a:lnTo>
                  <a:pt x="149" y="213"/>
                </a:lnTo>
                <a:lnTo>
                  <a:pt x="154" y="213"/>
                </a:lnTo>
                <a:lnTo>
                  <a:pt x="159" y="209"/>
                </a:lnTo>
                <a:lnTo>
                  <a:pt x="168" y="209"/>
                </a:lnTo>
                <a:lnTo>
                  <a:pt x="175" y="209"/>
                </a:lnTo>
                <a:lnTo>
                  <a:pt x="176" y="203"/>
                </a:lnTo>
                <a:lnTo>
                  <a:pt x="181" y="203"/>
                </a:lnTo>
                <a:lnTo>
                  <a:pt x="182" y="198"/>
                </a:lnTo>
                <a:lnTo>
                  <a:pt x="194" y="198"/>
                </a:lnTo>
                <a:lnTo>
                  <a:pt x="194" y="193"/>
                </a:lnTo>
                <a:lnTo>
                  <a:pt x="196" y="187"/>
                </a:lnTo>
                <a:lnTo>
                  <a:pt x="200" y="187"/>
                </a:lnTo>
                <a:lnTo>
                  <a:pt x="202" y="183"/>
                </a:lnTo>
                <a:lnTo>
                  <a:pt x="202" y="177"/>
                </a:lnTo>
                <a:lnTo>
                  <a:pt x="209" y="177"/>
                </a:lnTo>
                <a:lnTo>
                  <a:pt x="214" y="177"/>
                </a:lnTo>
                <a:lnTo>
                  <a:pt x="214" y="172"/>
                </a:lnTo>
                <a:lnTo>
                  <a:pt x="223" y="172"/>
                </a:lnTo>
                <a:lnTo>
                  <a:pt x="235" y="172"/>
                </a:lnTo>
                <a:lnTo>
                  <a:pt x="235" y="167"/>
                </a:lnTo>
                <a:lnTo>
                  <a:pt x="248" y="167"/>
                </a:lnTo>
                <a:lnTo>
                  <a:pt x="263" y="167"/>
                </a:lnTo>
                <a:lnTo>
                  <a:pt x="263" y="161"/>
                </a:lnTo>
                <a:lnTo>
                  <a:pt x="271" y="161"/>
                </a:lnTo>
                <a:lnTo>
                  <a:pt x="277" y="161"/>
                </a:lnTo>
                <a:lnTo>
                  <a:pt x="292" y="161"/>
                </a:lnTo>
                <a:lnTo>
                  <a:pt x="296" y="156"/>
                </a:lnTo>
                <a:lnTo>
                  <a:pt x="307" y="156"/>
                </a:lnTo>
                <a:lnTo>
                  <a:pt x="318" y="156"/>
                </a:lnTo>
                <a:lnTo>
                  <a:pt x="322" y="151"/>
                </a:lnTo>
                <a:lnTo>
                  <a:pt x="333" y="151"/>
                </a:lnTo>
                <a:lnTo>
                  <a:pt x="333" y="145"/>
                </a:lnTo>
                <a:lnTo>
                  <a:pt x="338" y="145"/>
                </a:lnTo>
                <a:lnTo>
                  <a:pt x="342" y="145"/>
                </a:lnTo>
                <a:lnTo>
                  <a:pt x="349" y="145"/>
                </a:lnTo>
                <a:lnTo>
                  <a:pt x="352" y="145"/>
                </a:lnTo>
                <a:lnTo>
                  <a:pt x="358" y="145"/>
                </a:lnTo>
                <a:lnTo>
                  <a:pt x="366" y="145"/>
                </a:lnTo>
                <a:lnTo>
                  <a:pt x="372" y="140"/>
                </a:lnTo>
                <a:lnTo>
                  <a:pt x="373" y="134"/>
                </a:lnTo>
                <a:lnTo>
                  <a:pt x="380" y="134"/>
                </a:lnTo>
                <a:lnTo>
                  <a:pt x="383" y="134"/>
                </a:lnTo>
                <a:lnTo>
                  <a:pt x="393" y="134"/>
                </a:lnTo>
                <a:lnTo>
                  <a:pt x="413" y="134"/>
                </a:lnTo>
                <a:lnTo>
                  <a:pt x="421" y="134"/>
                </a:lnTo>
                <a:lnTo>
                  <a:pt x="428" y="134"/>
                </a:lnTo>
                <a:lnTo>
                  <a:pt x="428" y="128"/>
                </a:lnTo>
                <a:lnTo>
                  <a:pt x="436" y="128"/>
                </a:lnTo>
                <a:lnTo>
                  <a:pt x="442" y="128"/>
                </a:lnTo>
                <a:lnTo>
                  <a:pt x="443" y="128"/>
                </a:lnTo>
                <a:lnTo>
                  <a:pt x="454" y="128"/>
                </a:lnTo>
                <a:lnTo>
                  <a:pt x="455" y="128"/>
                </a:lnTo>
                <a:lnTo>
                  <a:pt x="463" y="128"/>
                </a:lnTo>
                <a:lnTo>
                  <a:pt x="471" y="128"/>
                </a:lnTo>
                <a:lnTo>
                  <a:pt x="480" y="128"/>
                </a:lnTo>
                <a:lnTo>
                  <a:pt x="494" y="128"/>
                </a:lnTo>
                <a:lnTo>
                  <a:pt x="498" y="128"/>
                </a:lnTo>
                <a:lnTo>
                  <a:pt x="505" y="128"/>
                </a:lnTo>
                <a:lnTo>
                  <a:pt x="512" y="128"/>
                </a:lnTo>
                <a:lnTo>
                  <a:pt x="518" y="128"/>
                </a:lnTo>
                <a:lnTo>
                  <a:pt x="522" y="128"/>
                </a:lnTo>
                <a:lnTo>
                  <a:pt x="531" y="128"/>
                </a:lnTo>
                <a:lnTo>
                  <a:pt x="533" y="128"/>
                </a:lnTo>
                <a:lnTo>
                  <a:pt x="540" y="128"/>
                </a:lnTo>
                <a:lnTo>
                  <a:pt x="547" y="128"/>
                </a:lnTo>
                <a:lnTo>
                  <a:pt x="552" y="128"/>
                </a:lnTo>
                <a:lnTo>
                  <a:pt x="558" y="128"/>
                </a:lnTo>
                <a:lnTo>
                  <a:pt x="564" y="128"/>
                </a:lnTo>
                <a:lnTo>
                  <a:pt x="571" y="128"/>
                </a:lnTo>
                <a:lnTo>
                  <a:pt x="575" y="128"/>
                </a:lnTo>
                <a:lnTo>
                  <a:pt x="582" y="128"/>
                </a:lnTo>
                <a:lnTo>
                  <a:pt x="588" y="128"/>
                </a:lnTo>
                <a:lnTo>
                  <a:pt x="595" y="128"/>
                </a:lnTo>
                <a:lnTo>
                  <a:pt x="599" y="128"/>
                </a:lnTo>
                <a:lnTo>
                  <a:pt x="606" y="128"/>
                </a:lnTo>
                <a:lnTo>
                  <a:pt x="608" y="122"/>
                </a:lnTo>
                <a:lnTo>
                  <a:pt x="612" y="122"/>
                </a:lnTo>
                <a:lnTo>
                  <a:pt x="618" y="122"/>
                </a:lnTo>
                <a:lnTo>
                  <a:pt x="625" y="122"/>
                </a:lnTo>
                <a:lnTo>
                  <a:pt x="631" y="122"/>
                </a:lnTo>
                <a:lnTo>
                  <a:pt x="638" y="122"/>
                </a:lnTo>
                <a:lnTo>
                  <a:pt x="642" y="122"/>
                </a:lnTo>
                <a:lnTo>
                  <a:pt x="648" y="122"/>
                </a:lnTo>
                <a:lnTo>
                  <a:pt x="661" y="122"/>
                </a:lnTo>
                <a:lnTo>
                  <a:pt x="667" y="122"/>
                </a:lnTo>
                <a:lnTo>
                  <a:pt x="671" y="122"/>
                </a:lnTo>
                <a:lnTo>
                  <a:pt x="678" y="122"/>
                </a:lnTo>
                <a:lnTo>
                  <a:pt x="684" y="122"/>
                </a:lnTo>
                <a:lnTo>
                  <a:pt x="688" y="114"/>
                </a:lnTo>
                <a:lnTo>
                  <a:pt x="690" y="114"/>
                </a:lnTo>
                <a:lnTo>
                  <a:pt x="696" y="114"/>
                </a:lnTo>
                <a:lnTo>
                  <a:pt x="702" y="114"/>
                </a:lnTo>
                <a:lnTo>
                  <a:pt x="709" y="114"/>
                </a:lnTo>
                <a:lnTo>
                  <a:pt x="714" y="114"/>
                </a:lnTo>
                <a:lnTo>
                  <a:pt x="720" y="114"/>
                </a:lnTo>
                <a:lnTo>
                  <a:pt x="727" y="114"/>
                </a:lnTo>
                <a:lnTo>
                  <a:pt x="731" y="114"/>
                </a:lnTo>
                <a:lnTo>
                  <a:pt x="740" y="114"/>
                </a:lnTo>
                <a:lnTo>
                  <a:pt x="744" y="114"/>
                </a:lnTo>
                <a:lnTo>
                  <a:pt x="752" y="114"/>
                </a:lnTo>
                <a:lnTo>
                  <a:pt x="757" y="114"/>
                </a:lnTo>
                <a:lnTo>
                  <a:pt x="763" y="114"/>
                </a:lnTo>
                <a:lnTo>
                  <a:pt x="769" y="114"/>
                </a:lnTo>
                <a:lnTo>
                  <a:pt x="776" y="114"/>
                </a:lnTo>
                <a:lnTo>
                  <a:pt x="780" y="114"/>
                </a:lnTo>
                <a:lnTo>
                  <a:pt x="786" y="114"/>
                </a:lnTo>
                <a:lnTo>
                  <a:pt x="794" y="114"/>
                </a:lnTo>
                <a:lnTo>
                  <a:pt x="798" y="114"/>
                </a:lnTo>
                <a:lnTo>
                  <a:pt x="804" y="114"/>
                </a:lnTo>
                <a:lnTo>
                  <a:pt x="810" y="114"/>
                </a:lnTo>
                <a:lnTo>
                  <a:pt x="816" y="114"/>
                </a:lnTo>
                <a:lnTo>
                  <a:pt x="822" y="114"/>
                </a:lnTo>
                <a:lnTo>
                  <a:pt x="828" y="114"/>
                </a:lnTo>
                <a:lnTo>
                  <a:pt x="839" y="114"/>
                </a:lnTo>
                <a:lnTo>
                  <a:pt x="841" y="114"/>
                </a:lnTo>
                <a:lnTo>
                  <a:pt x="847" y="114"/>
                </a:lnTo>
                <a:lnTo>
                  <a:pt x="855" y="114"/>
                </a:lnTo>
                <a:lnTo>
                  <a:pt x="860" y="114"/>
                </a:lnTo>
                <a:lnTo>
                  <a:pt x="871" y="114"/>
                </a:lnTo>
                <a:lnTo>
                  <a:pt x="877" y="114"/>
                </a:lnTo>
                <a:lnTo>
                  <a:pt x="882" y="114"/>
                </a:lnTo>
                <a:lnTo>
                  <a:pt x="891" y="114"/>
                </a:lnTo>
                <a:lnTo>
                  <a:pt x="895" y="114"/>
                </a:lnTo>
                <a:lnTo>
                  <a:pt x="900" y="114"/>
                </a:lnTo>
                <a:lnTo>
                  <a:pt x="907" y="114"/>
                </a:lnTo>
                <a:lnTo>
                  <a:pt x="913" y="114"/>
                </a:lnTo>
                <a:lnTo>
                  <a:pt x="918" y="114"/>
                </a:lnTo>
                <a:lnTo>
                  <a:pt x="926" y="114"/>
                </a:lnTo>
                <a:lnTo>
                  <a:pt x="931" y="114"/>
                </a:lnTo>
                <a:lnTo>
                  <a:pt x="936" y="114"/>
                </a:lnTo>
                <a:lnTo>
                  <a:pt x="942" y="114"/>
                </a:lnTo>
                <a:lnTo>
                  <a:pt x="948" y="114"/>
                </a:lnTo>
                <a:lnTo>
                  <a:pt x="954" y="114"/>
                </a:lnTo>
                <a:lnTo>
                  <a:pt x="960" y="114"/>
                </a:lnTo>
                <a:lnTo>
                  <a:pt x="967" y="114"/>
                </a:lnTo>
                <a:lnTo>
                  <a:pt x="973" y="114"/>
                </a:lnTo>
                <a:lnTo>
                  <a:pt x="979" y="114"/>
                </a:lnTo>
                <a:lnTo>
                  <a:pt x="986" y="114"/>
                </a:lnTo>
                <a:lnTo>
                  <a:pt x="991" y="114"/>
                </a:lnTo>
                <a:lnTo>
                  <a:pt x="997" y="114"/>
                </a:lnTo>
                <a:lnTo>
                  <a:pt x="1003" y="114"/>
                </a:lnTo>
                <a:lnTo>
                  <a:pt x="1008" y="114"/>
                </a:lnTo>
                <a:lnTo>
                  <a:pt x="1017" y="114"/>
                </a:lnTo>
                <a:lnTo>
                  <a:pt x="1024" y="114"/>
                </a:lnTo>
                <a:lnTo>
                  <a:pt x="1027" y="114"/>
                </a:lnTo>
                <a:lnTo>
                  <a:pt x="1036" y="114"/>
                </a:lnTo>
                <a:lnTo>
                  <a:pt x="1039" y="114"/>
                </a:lnTo>
                <a:lnTo>
                  <a:pt x="1053" y="114"/>
                </a:lnTo>
                <a:lnTo>
                  <a:pt x="1057" y="114"/>
                </a:lnTo>
                <a:lnTo>
                  <a:pt x="1068" y="114"/>
                </a:lnTo>
                <a:lnTo>
                  <a:pt x="1074" y="114"/>
                </a:lnTo>
                <a:lnTo>
                  <a:pt x="1079" y="114"/>
                </a:lnTo>
                <a:lnTo>
                  <a:pt x="1092" y="114"/>
                </a:lnTo>
                <a:lnTo>
                  <a:pt x="1095" y="114"/>
                </a:lnTo>
                <a:lnTo>
                  <a:pt x="1100" y="114"/>
                </a:lnTo>
                <a:lnTo>
                  <a:pt x="1115" y="114"/>
                </a:lnTo>
                <a:lnTo>
                  <a:pt x="1122" y="114"/>
                </a:lnTo>
                <a:lnTo>
                  <a:pt x="1130" y="114"/>
                </a:lnTo>
                <a:lnTo>
                  <a:pt x="1140" y="114"/>
                </a:lnTo>
                <a:lnTo>
                  <a:pt x="1149" y="114"/>
                </a:lnTo>
                <a:lnTo>
                  <a:pt x="1161" y="114"/>
                </a:lnTo>
                <a:lnTo>
                  <a:pt x="1174" y="114"/>
                </a:lnTo>
                <a:lnTo>
                  <a:pt x="1185" y="114"/>
                </a:lnTo>
                <a:lnTo>
                  <a:pt x="1196" y="114"/>
                </a:lnTo>
                <a:lnTo>
                  <a:pt x="1196" y="0"/>
                </a:lnTo>
                <a:lnTo>
                  <a:pt x="1204" y="0"/>
                </a:lnTo>
                <a:lnTo>
                  <a:pt x="1211" y="0"/>
                </a:lnTo>
                <a:lnTo>
                  <a:pt x="1259" y="0"/>
                </a:lnTo>
                <a:lnTo>
                  <a:pt x="1300" y="0"/>
                </a:lnTo>
                <a:lnTo>
                  <a:pt x="1343" y="0"/>
                </a:lnTo>
                <a:lnTo>
                  <a:pt x="1354" y="0"/>
                </a:lnTo>
                <a:lnTo>
                  <a:pt x="1379" y="0"/>
                </a:lnTo>
                <a:lnTo>
                  <a:pt x="1395" y="0"/>
                </a:lnTo>
                <a:lnTo>
                  <a:pt x="1423" y="0"/>
                </a:lnTo>
                <a:lnTo>
                  <a:pt x="1440" y="0"/>
                </a:lnTo>
                <a:lnTo>
                  <a:pt x="1487" y="0"/>
                </a:lnTo>
                <a:lnTo>
                  <a:pt x="1558" y="0"/>
                </a:lnTo>
                <a:lnTo>
                  <a:pt x="1581" y="0"/>
                </a:lnTo>
                <a:lnTo>
                  <a:pt x="1604" y="0"/>
                </a:lnTo>
                <a:lnTo>
                  <a:pt x="1636" y="0"/>
                </a:lnTo>
                <a:lnTo>
                  <a:pt x="1655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B5309DA-836C-4481-42F7-015D0ED41505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2F77D62-FA62-8938-6EB5-CDEA8F6AC36C}"/>
              </a:ext>
            </a:extLst>
          </p:cNvPr>
          <p:cNvSpPr txBox="1"/>
          <p:nvPr/>
        </p:nvSpPr>
        <p:spPr>
          <a:xfrm>
            <a:off x="886249" y="38268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88AC80C-C2C5-A30B-7AD7-74C8540FA78D}"/>
              </a:ext>
            </a:extLst>
          </p:cNvPr>
          <p:cNvSpPr txBox="1"/>
          <p:nvPr/>
        </p:nvSpPr>
        <p:spPr>
          <a:xfrm>
            <a:off x="6010058" y="382681"/>
            <a:ext cx="38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6AAF834-2F0F-8CEA-F4A5-13BB4CA9EE94}"/>
              </a:ext>
            </a:extLst>
          </p:cNvPr>
          <p:cNvSpPr txBox="1"/>
          <p:nvPr/>
        </p:nvSpPr>
        <p:spPr>
          <a:xfrm>
            <a:off x="886250" y="3325173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BA74821-E980-E0B7-4626-88EABB5E8862}"/>
              </a:ext>
            </a:extLst>
          </p:cNvPr>
          <p:cNvSpPr txBox="1"/>
          <p:nvPr/>
        </p:nvSpPr>
        <p:spPr>
          <a:xfrm>
            <a:off x="6010059" y="3325174"/>
            <a:ext cx="39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D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14860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79B0B7B1-F42A-0DD2-5470-7D5E197FBB36}"/>
              </a:ext>
            </a:extLst>
          </p:cNvPr>
          <p:cNvGrpSpPr/>
          <p:nvPr/>
        </p:nvGrpSpPr>
        <p:grpSpPr>
          <a:xfrm>
            <a:off x="1197600" y="712441"/>
            <a:ext cx="4141083" cy="2791354"/>
            <a:chOff x="1487880" y="988207"/>
            <a:chExt cx="4141083" cy="2791354"/>
          </a:xfrm>
        </p:grpSpPr>
        <p:grpSp>
          <p:nvGrpSpPr>
            <p:cNvPr id="235" name="グループ化 234">
              <a:extLst>
                <a:ext uri="{FF2B5EF4-FFF2-40B4-BE49-F238E27FC236}">
                  <a16:creationId xmlns:a16="http://schemas.microsoft.com/office/drawing/2014/main" id="{7F4B8A62-7819-C60D-A452-1EA5B675DD47}"/>
                </a:ext>
              </a:extLst>
            </p:cNvPr>
            <p:cNvGrpSpPr/>
            <p:nvPr/>
          </p:nvGrpSpPr>
          <p:grpSpPr>
            <a:xfrm>
              <a:off x="1487880" y="988207"/>
              <a:ext cx="4141083" cy="2791354"/>
              <a:chOff x="1487880" y="988207"/>
              <a:chExt cx="4141083" cy="2791354"/>
            </a:xfrm>
          </p:grpSpPr>
          <p:sp>
            <p:nvSpPr>
              <p:cNvPr id="198" name="Rectangle 22">
                <a:extLst>
                  <a:ext uri="{FF2B5EF4-FFF2-40B4-BE49-F238E27FC236}">
                    <a16:creationId xmlns:a16="http://schemas.microsoft.com/office/drawing/2014/main" id="{5388FA6E-EA19-148D-E8E6-996B95FD63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7804" y="994728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9" name="Line 23">
                <a:extLst>
                  <a:ext uri="{FF2B5EF4-FFF2-40B4-BE49-F238E27FC236}">
                    <a16:creationId xmlns:a16="http://schemas.microsoft.com/office/drawing/2014/main" id="{FA4C00BD-ADF2-791B-57D5-B319C6897F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2137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0" name="Line 25">
                <a:extLst>
                  <a:ext uri="{FF2B5EF4-FFF2-40B4-BE49-F238E27FC236}">
                    <a16:creationId xmlns:a16="http://schemas.microsoft.com/office/drawing/2014/main" id="{0C8163BB-9245-1AFB-2E8F-7CD293FF1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5354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1" name="Line 27">
                <a:extLst>
                  <a:ext uri="{FF2B5EF4-FFF2-40B4-BE49-F238E27FC236}">
                    <a16:creationId xmlns:a16="http://schemas.microsoft.com/office/drawing/2014/main" id="{91AF527F-3FDA-975F-40BF-2ABD90628C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8570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2" name="Line 29">
                <a:extLst>
                  <a:ext uri="{FF2B5EF4-FFF2-40B4-BE49-F238E27FC236}">
                    <a16:creationId xmlns:a16="http://schemas.microsoft.com/office/drawing/2014/main" id="{C5394C8F-6EB3-9D26-FCA9-F7E5A163D4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9898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3" name="Line 31">
                <a:extLst>
                  <a:ext uri="{FF2B5EF4-FFF2-40B4-BE49-F238E27FC236}">
                    <a16:creationId xmlns:a16="http://schemas.microsoft.com/office/drawing/2014/main" id="{E8AC5A75-DE4D-65E5-7243-6125D3857B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3115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4" name="Line 33">
                <a:extLst>
                  <a:ext uri="{FF2B5EF4-FFF2-40B4-BE49-F238E27FC236}">
                    <a16:creationId xmlns:a16="http://schemas.microsoft.com/office/drawing/2014/main" id="{D1CECB3F-2FAC-AC99-488A-37F797640A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6331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5" name="Line 35">
                <a:extLst>
                  <a:ext uri="{FF2B5EF4-FFF2-40B4-BE49-F238E27FC236}">
                    <a16:creationId xmlns:a16="http://schemas.microsoft.com/office/drawing/2014/main" id="{D5A25145-9F7A-E4B1-06D1-A4A50BE41A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9548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6" name="Line 6">
                <a:extLst>
                  <a:ext uri="{FF2B5EF4-FFF2-40B4-BE49-F238E27FC236}">
                    <a16:creationId xmlns:a16="http://schemas.microsoft.com/office/drawing/2014/main" id="{99A1571C-AB61-D3D5-8E20-CFC8443DEA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3008505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7" name="Line 8">
                <a:extLst>
                  <a:ext uri="{FF2B5EF4-FFF2-40B4-BE49-F238E27FC236}">
                    <a16:creationId xmlns:a16="http://schemas.microsoft.com/office/drawing/2014/main" id="{50D754FB-9E5E-6F63-17DA-4A741B9366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260100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8" name="Line 9">
                <a:extLst>
                  <a:ext uri="{FF2B5EF4-FFF2-40B4-BE49-F238E27FC236}">
                    <a16:creationId xmlns:a16="http://schemas.microsoft.com/office/drawing/2014/main" id="{42CF292D-1C04-90F7-B05E-C74BD2F14F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219351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9" name="Line 11">
                <a:extLst>
                  <a:ext uri="{FF2B5EF4-FFF2-40B4-BE49-F238E27FC236}">
                    <a16:creationId xmlns:a16="http://schemas.microsoft.com/office/drawing/2014/main" id="{50710CAD-F1A6-DC3E-482A-1926E6E859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178601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0" name="Line 12">
                <a:extLst>
                  <a:ext uri="{FF2B5EF4-FFF2-40B4-BE49-F238E27FC236}">
                    <a16:creationId xmlns:a16="http://schemas.microsoft.com/office/drawing/2014/main" id="{1FDF3B02-06B1-8136-AEC6-14E863595B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137852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1" name="Line 14">
                <a:extLst>
                  <a:ext uri="{FF2B5EF4-FFF2-40B4-BE49-F238E27FC236}">
                    <a16:creationId xmlns:a16="http://schemas.microsoft.com/office/drawing/2014/main" id="{502B873C-7936-FAEB-7775-6EB4EB11F5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99493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2" name="Line 23">
                <a:extLst>
                  <a:ext uri="{FF2B5EF4-FFF2-40B4-BE49-F238E27FC236}">
                    <a16:creationId xmlns:a16="http://schemas.microsoft.com/office/drawing/2014/main" id="{CA0DA39A-24C0-159A-151F-A6A130718C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3825" y="3008506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213" name="図形グループ 54">
                <a:extLst>
                  <a:ext uri="{FF2B5EF4-FFF2-40B4-BE49-F238E27FC236}">
                    <a16:creationId xmlns:a16="http://schemas.microsoft.com/office/drawing/2014/main" id="{0997CE78-3791-D276-976E-9FDF8CF70891}"/>
                  </a:ext>
                </a:extLst>
              </p:cNvPr>
              <p:cNvGrpSpPr/>
              <p:nvPr/>
            </p:nvGrpSpPr>
            <p:grpSpPr>
              <a:xfrm>
                <a:off x="2034219" y="1249429"/>
                <a:ext cx="220989" cy="1868530"/>
                <a:chOff x="510218" y="1348283"/>
                <a:chExt cx="220989" cy="1868530"/>
              </a:xfrm>
            </p:grpSpPr>
            <p:sp>
              <p:nvSpPr>
                <p:cNvPr id="220" name="Rectangle 10">
                  <a:extLst>
                    <a:ext uri="{FF2B5EF4-FFF2-40B4-BE49-F238E27FC236}">
                      <a16:creationId xmlns:a16="http://schemas.microsoft.com/office/drawing/2014/main" id="{0DFC5718-4FEB-0DB7-D1AF-7786EFF9B3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21" name="Rectangle 13">
                  <a:extLst>
                    <a:ext uri="{FF2B5EF4-FFF2-40B4-BE49-F238E27FC236}">
                      <a16:creationId xmlns:a16="http://schemas.microsoft.com/office/drawing/2014/main" id="{12E517D5-2FCD-F7F6-F7BD-7029D49BB4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22" name="Rectangle 10">
                  <a:extLst>
                    <a:ext uri="{FF2B5EF4-FFF2-40B4-BE49-F238E27FC236}">
                      <a16:creationId xmlns:a16="http://schemas.microsoft.com/office/drawing/2014/main" id="{C1CBBAAA-76D1-9F13-8A0E-8204C14F01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D11054CA-3A97-9CC5-E00C-787B698947A4}"/>
                  </a:ext>
                </a:extLst>
              </p:cNvPr>
              <p:cNvSpPr txBox="1"/>
              <p:nvPr/>
            </p:nvSpPr>
            <p:spPr>
              <a:xfrm>
                <a:off x="2206686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6F531A67-BDCB-99B2-3864-58C4325BC24A}"/>
                  </a:ext>
                </a:extLst>
              </p:cNvPr>
              <p:cNvSpPr txBox="1"/>
              <p:nvPr/>
            </p:nvSpPr>
            <p:spPr>
              <a:xfrm>
                <a:off x="3251225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57CB6EFC-68C5-3C57-3B90-FEE9A5798FAA}"/>
                  </a:ext>
                </a:extLst>
              </p:cNvPr>
              <p:cNvSpPr txBox="1"/>
              <p:nvPr/>
            </p:nvSpPr>
            <p:spPr>
              <a:xfrm>
                <a:off x="5340302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D1D7C71C-342A-A05A-B787-E525737597F3}"/>
                  </a:ext>
                </a:extLst>
              </p:cNvPr>
              <p:cNvSpPr txBox="1"/>
              <p:nvPr/>
            </p:nvSpPr>
            <p:spPr>
              <a:xfrm>
                <a:off x="4295764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4DE1D052-EE0D-2C71-3BB8-14E9C2695E08}"/>
                  </a:ext>
                </a:extLst>
              </p:cNvPr>
              <p:cNvSpPr txBox="1"/>
              <p:nvPr/>
            </p:nvSpPr>
            <p:spPr>
              <a:xfrm rot="16200000">
                <a:off x="604785" y="1871302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1655A8F0-C5D7-AA6D-DAAA-FCDDFF8E6541}"/>
                  </a:ext>
                </a:extLst>
              </p:cNvPr>
              <p:cNvSpPr txBox="1"/>
              <p:nvPr/>
            </p:nvSpPr>
            <p:spPr>
              <a:xfrm>
                <a:off x="3108992" y="3410229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5" name="Freeform 19">
              <a:extLst>
                <a:ext uri="{FF2B5EF4-FFF2-40B4-BE49-F238E27FC236}">
                  <a16:creationId xmlns:a16="http://schemas.microsoft.com/office/drawing/2014/main" id="{3542D45D-21EE-D859-433E-34970E2799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538" y="2261396"/>
              <a:ext cx="3120441" cy="751100"/>
            </a:xfrm>
            <a:custGeom>
              <a:avLst/>
              <a:gdLst>
                <a:gd name="T0" fmla="*/ 111 w 1661"/>
                <a:gd name="T1" fmla="*/ 405 h 405"/>
                <a:gd name="T2" fmla="*/ 132 w 1661"/>
                <a:gd name="T3" fmla="*/ 378 h 405"/>
                <a:gd name="T4" fmla="*/ 177 w 1661"/>
                <a:gd name="T5" fmla="*/ 378 h 405"/>
                <a:gd name="T6" fmla="*/ 185 w 1661"/>
                <a:gd name="T7" fmla="*/ 365 h 405"/>
                <a:gd name="T8" fmla="*/ 214 w 1661"/>
                <a:gd name="T9" fmla="*/ 365 h 405"/>
                <a:gd name="T10" fmla="*/ 242 w 1661"/>
                <a:gd name="T11" fmla="*/ 365 h 405"/>
                <a:gd name="T12" fmla="*/ 259 w 1661"/>
                <a:gd name="T13" fmla="*/ 350 h 405"/>
                <a:gd name="T14" fmla="*/ 280 w 1661"/>
                <a:gd name="T15" fmla="*/ 335 h 405"/>
                <a:gd name="T16" fmla="*/ 361 w 1661"/>
                <a:gd name="T17" fmla="*/ 335 h 405"/>
                <a:gd name="T18" fmla="*/ 414 w 1661"/>
                <a:gd name="T19" fmla="*/ 335 h 405"/>
                <a:gd name="T20" fmla="*/ 458 w 1661"/>
                <a:gd name="T21" fmla="*/ 335 h 405"/>
                <a:gd name="T22" fmla="*/ 486 w 1661"/>
                <a:gd name="T23" fmla="*/ 319 h 405"/>
                <a:gd name="T24" fmla="*/ 529 w 1661"/>
                <a:gd name="T25" fmla="*/ 319 h 405"/>
                <a:gd name="T26" fmla="*/ 554 w 1661"/>
                <a:gd name="T27" fmla="*/ 302 h 405"/>
                <a:gd name="T28" fmla="*/ 580 w 1661"/>
                <a:gd name="T29" fmla="*/ 268 h 405"/>
                <a:gd name="T30" fmla="*/ 604 w 1661"/>
                <a:gd name="T31" fmla="*/ 234 h 405"/>
                <a:gd name="T32" fmla="*/ 662 w 1661"/>
                <a:gd name="T33" fmla="*/ 234 h 405"/>
                <a:gd name="T34" fmla="*/ 702 w 1661"/>
                <a:gd name="T35" fmla="*/ 234 h 405"/>
                <a:gd name="T36" fmla="*/ 714 w 1661"/>
                <a:gd name="T37" fmla="*/ 216 h 405"/>
                <a:gd name="T38" fmla="*/ 766 w 1661"/>
                <a:gd name="T39" fmla="*/ 216 h 405"/>
                <a:gd name="T40" fmla="*/ 798 w 1661"/>
                <a:gd name="T41" fmla="*/ 216 h 405"/>
                <a:gd name="T42" fmla="*/ 838 w 1661"/>
                <a:gd name="T43" fmla="*/ 196 h 405"/>
                <a:gd name="T44" fmla="*/ 897 w 1661"/>
                <a:gd name="T45" fmla="*/ 176 h 405"/>
                <a:gd name="T46" fmla="*/ 916 w 1661"/>
                <a:gd name="T47" fmla="*/ 155 h 405"/>
                <a:gd name="T48" fmla="*/ 967 w 1661"/>
                <a:gd name="T49" fmla="*/ 155 h 405"/>
                <a:gd name="T50" fmla="*/ 1011 w 1661"/>
                <a:gd name="T51" fmla="*/ 155 h 405"/>
                <a:gd name="T52" fmla="*/ 1044 w 1661"/>
                <a:gd name="T53" fmla="*/ 155 h 405"/>
                <a:gd name="T54" fmla="*/ 1073 w 1661"/>
                <a:gd name="T55" fmla="*/ 130 h 405"/>
                <a:gd name="T56" fmla="*/ 1099 w 1661"/>
                <a:gd name="T57" fmla="*/ 130 h 405"/>
                <a:gd name="T58" fmla="*/ 1123 w 1661"/>
                <a:gd name="T59" fmla="*/ 104 h 405"/>
                <a:gd name="T60" fmla="*/ 1189 w 1661"/>
                <a:gd name="T61" fmla="*/ 104 h 405"/>
                <a:gd name="T62" fmla="*/ 1253 w 1661"/>
                <a:gd name="T63" fmla="*/ 104 h 405"/>
                <a:gd name="T64" fmla="*/ 1306 w 1661"/>
                <a:gd name="T65" fmla="*/ 104 h 405"/>
                <a:gd name="T66" fmla="*/ 1332 w 1661"/>
                <a:gd name="T67" fmla="*/ 104 h 405"/>
                <a:gd name="T68" fmla="*/ 1362 w 1661"/>
                <a:gd name="T69" fmla="*/ 104 h 405"/>
                <a:gd name="T70" fmla="*/ 1400 w 1661"/>
                <a:gd name="T71" fmla="*/ 104 h 405"/>
                <a:gd name="T72" fmla="*/ 1437 w 1661"/>
                <a:gd name="T73" fmla="*/ 104 h 405"/>
                <a:gd name="T74" fmla="*/ 1460 w 1661"/>
                <a:gd name="T75" fmla="*/ 104 h 405"/>
                <a:gd name="T76" fmla="*/ 1501 w 1661"/>
                <a:gd name="T77" fmla="*/ 104 h 405"/>
                <a:gd name="T78" fmla="*/ 1526 w 1661"/>
                <a:gd name="T79" fmla="*/ 104 h 405"/>
                <a:gd name="T80" fmla="*/ 1557 w 1661"/>
                <a:gd name="T81" fmla="*/ 104 h 405"/>
                <a:gd name="T82" fmla="*/ 1596 w 1661"/>
                <a:gd name="T83" fmla="*/ 104 h 405"/>
                <a:gd name="T84" fmla="*/ 1618 w 1661"/>
                <a:gd name="T85" fmla="*/ 104 h 405"/>
                <a:gd name="T86" fmla="*/ 1661 w 1661"/>
                <a:gd name="T87" fmla="*/ 0 h 4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1661" h="405">
                  <a:moveTo>
                    <a:pt x="0" y="405"/>
                  </a:moveTo>
                  <a:lnTo>
                    <a:pt x="104" y="405"/>
                  </a:lnTo>
                  <a:lnTo>
                    <a:pt x="111" y="405"/>
                  </a:lnTo>
                  <a:lnTo>
                    <a:pt x="111" y="391"/>
                  </a:lnTo>
                  <a:lnTo>
                    <a:pt x="132" y="391"/>
                  </a:lnTo>
                  <a:lnTo>
                    <a:pt x="132" y="378"/>
                  </a:lnTo>
                  <a:lnTo>
                    <a:pt x="152" y="378"/>
                  </a:lnTo>
                  <a:lnTo>
                    <a:pt x="166" y="378"/>
                  </a:lnTo>
                  <a:lnTo>
                    <a:pt x="177" y="378"/>
                  </a:lnTo>
                  <a:lnTo>
                    <a:pt x="179" y="378"/>
                  </a:lnTo>
                  <a:lnTo>
                    <a:pt x="179" y="365"/>
                  </a:lnTo>
                  <a:lnTo>
                    <a:pt x="185" y="365"/>
                  </a:lnTo>
                  <a:lnTo>
                    <a:pt x="196" y="365"/>
                  </a:lnTo>
                  <a:lnTo>
                    <a:pt x="205" y="365"/>
                  </a:lnTo>
                  <a:lnTo>
                    <a:pt x="214" y="365"/>
                  </a:lnTo>
                  <a:lnTo>
                    <a:pt x="222" y="365"/>
                  </a:lnTo>
                  <a:lnTo>
                    <a:pt x="233" y="365"/>
                  </a:lnTo>
                  <a:lnTo>
                    <a:pt x="242" y="365"/>
                  </a:lnTo>
                  <a:lnTo>
                    <a:pt x="247" y="365"/>
                  </a:lnTo>
                  <a:lnTo>
                    <a:pt x="247" y="350"/>
                  </a:lnTo>
                  <a:lnTo>
                    <a:pt x="259" y="350"/>
                  </a:lnTo>
                  <a:lnTo>
                    <a:pt x="272" y="350"/>
                  </a:lnTo>
                  <a:lnTo>
                    <a:pt x="272" y="335"/>
                  </a:lnTo>
                  <a:lnTo>
                    <a:pt x="280" y="335"/>
                  </a:lnTo>
                  <a:lnTo>
                    <a:pt x="300" y="335"/>
                  </a:lnTo>
                  <a:lnTo>
                    <a:pt x="346" y="335"/>
                  </a:lnTo>
                  <a:lnTo>
                    <a:pt x="361" y="335"/>
                  </a:lnTo>
                  <a:lnTo>
                    <a:pt x="369" y="335"/>
                  </a:lnTo>
                  <a:lnTo>
                    <a:pt x="390" y="335"/>
                  </a:lnTo>
                  <a:lnTo>
                    <a:pt x="414" y="335"/>
                  </a:lnTo>
                  <a:lnTo>
                    <a:pt x="428" y="335"/>
                  </a:lnTo>
                  <a:lnTo>
                    <a:pt x="437" y="335"/>
                  </a:lnTo>
                  <a:lnTo>
                    <a:pt x="458" y="335"/>
                  </a:lnTo>
                  <a:lnTo>
                    <a:pt x="477" y="335"/>
                  </a:lnTo>
                  <a:lnTo>
                    <a:pt x="477" y="319"/>
                  </a:lnTo>
                  <a:lnTo>
                    <a:pt x="486" y="319"/>
                  </a:lnTo>
                  <a:lnTo>
                    <a:pt x="492" y="319"/>
                  </a:lnTo>
                  <a:lnTo>
                    <a:pt x="500" y="319"/>
                  </a:lnTo>
                  <a:lnTo>
                    <a:pt x="529" y="319"/>
                  </a:lnTo>
                  <a:lnTo>
                    <a:pt x="551" y="319"/>
                  </a:lnTo>
                  <a:lnTo>
                    <a:pt x="551" y="302"/>
                  </a:lnTo>
                  <a:lnTo>
                    <a:pt x="554" y="302"/>
                  </a:lnTo>
                  <a:lnTo>
                    <a:pt x="579" y="302"/>
                  </a:lnTo>
                  <a:lnTo>
                    <a:pt x="579" y="285"/>
                  </a:lnTo>
                  <a:lnTo>
                    <a:pt x="580" y="268"/>
                  </a:lnTo>
                  <a:lnTo>
                    <a:pt x="599" y="268"/>
                  </a:lnTo>
                  <a:lnTo>
                    <a:pt x="599" y="251"/>
                  </a:lnTo>
                  <a:lnTo>
                    <a:pt x="604" y="234"/>
                  </a:lnTo>
                  <a:lnTo>
                    <a:pt x="635" y="234"/>
                  </a:lnTo>
                  <a:lnTo>
                    <a:pt x="651" y="234"/>
                  </a:lnTo>
                  <a:lnTo>
                    <a:pt x="662" y="234"/>
                  </a:lnTo>
                  <a:lnTo>
                    <a:pt x="665" y="234"/>
                  </a:lnTo>
                  <a:lnTo>
                    <a:pt x="685" y="234"/>
                  </a:lnTo>
                  <a:lnTo>
                    <a:pt x="702" y="234"/>
                  </a:lnTo>
                  <a:lnTo>
                    <a:pt x="702" y="216"/>
                  </a:lnTo>
                  <a:lnTo>
                    <a:pt x="707" y="216"/>
                  </a:lnTo>
                  <a:lnTo>
                    <a:pt x="714" y="216"/>
                  </a:lnTo>
                  <a:lnTo>
                    <a:pt x="741" y="216"/>
                  </a:lnTo>
                  <a:lnTo>
                    <a:pt x="753" y="216"/>
                  </a:lnTo>
                  <a:lnTo>
                    <a:pt x="766" y="216"/>
                  </a:lnTo>
                  <a:lnTo>
                    <a:pt x="773" y="216"/>
                  </a:lnTo>
                  <a:lnTo>
                    <a:pt x="786" y="216"/>
                  </a:lnTo>
                  <a:lnTo>
                    <a:pt x="798" y="216"/>
                  </a:lnTo>
                  <a:lnTo>
                    <a:pt x="802" y="196"/>
                  </a:lnTo>
                  <a:lnTo>
                    <a:pt x="817" y="196"/>
                  </a:lnTo>
                  <a:lnTo>
                    <a:pt x="838" y="196"/>
                  </a:lnTo>
                  <a:lnTo>
                    <a:pt x="860" y="196"/>
                  </a:lnTo>
                  <a:lnTo>
                    <a:pt x="860" y="176"/>
                  </a:lnTo>
                  <a:lnTo>
                    <a:pt x="897" y="176"/>
                  </a:lnTo>
                  <a:lnTo>
                    <a:pt x="897" y="155"/>
                  </a:lnTo>
                  <a:lnTo>
                    <a:pt x="905" y="155"/>
                  </a:lnTo>
                  <a:lnTo>
                    <a:pt x="916" y="155"/>
                  </a:lnTo>
                  <a:lnTo>
                    <a:pt x="921" y="155"/>
                  </a:lnTo>
                  <a:lnTo>
                    <a:pt x="930" y="155"/>
                  </a:lnTo>
                  <a:lnTo>
                    <a:pt x="967" y="155"/>
                  </a:lnTo>
                  <a:lnTo>
                    <a:pt x="980" y="155"/>
                  </a:lnTo>
                  <a:lnTo>
                    <a:pt x="1000" y="155"/>
                  </a:lnTo>
                  <a:lnTo>
                    <a:pt x="1011" y="155"/>
                  </a:lnTo>
                  <a:lnTo>
                    <a:pt x="1024" y="155"/>
                  </a:lnTo>
                  <a:lnTo>
                    <a:pt x="1028" y="155"/>
                  </a:lnTo>
                  <a:lnTo>
                    <a:pt x="1044" y="155"/>
                  </a:lnTo>
                  <a:lnTo>
                    <a:pt x="1061" y="155"/>
                  </a:lnTo>
                  <a:lnTo>
                    <a:pt x="1073" y="155"/>
                  </a:lnTo>
                  <a:lnTo>
                    <a:pt x="1073" y="130"/>
                  </a:lnTo>
                  <a:lnTo>
                    <a:pt x="1092" y="130"/>
                  </a:lnTo>
                  <a:lnTo>
                    <a:pt x="1096" y="130"/>
                  </a:lnTo>
                  <a:lnTo>
                    <a:pt x="1099" y="130"/>
                  </a:lnTo>
                  <a:lnTo>
                    <a:pt x="1099" y="104"/>
                  </a:lnTo>
                  <a:lnTo>
                    <a:pt x="1107" y="104"/>
                  </a:lnTo>
                  <a:lnTo>
                    <a:pt x="1123" y="104"/>
                  </a:lnTo>
                  <a:lnTo>
                    <a:pt x="1129" y="104"/>
                  </a:lnTo>
                  <a:lnTo>
                    <a:pt x="1148" y="104"/>
                  </a:lnTo>
                  <a:lnTo>
                    <a:pt x="1189" y="104"/>
                  </a:lnTo>
                  <a:lnTo>
                    <a:pt x="1203" y="104"/>
                  </a:lnTo>
                  <a:lnTo>
                    <a:pt x="1210" y="104"/>
                  </a:lnTo>
                  <a:lnTo>
                    <a:pt x="1253" y="104"/>
                  </a:lnTo>
                  <a:lnTo>
                    <a:pt x="1261" y="104"/>
                  </a:lnTo>
                  <a:lnTo>
                    <a:pt x="1297" y="104"/>
                  </a:lnTo>
                  <a:lnTo>
                    <a:pt x="1306" y="104"/>
                  </a:lnTo>
                  <a:lnTo>
                    <a:pt x="1311" y="104"/>
                  </a:lnTo>
                  <a:lnTo>
                    <a:pt x="1322" y="104"/>
                  </a:lnTo>
                  <a:lnTo>
                    <a:pt x="1332" y="104"/>
                  </a:lnTo>
                  <a:lnTo>
                    <a:pt x="1336" y="104"/>
                  </a:lnTo>
                  <a:lnTo>
                    <a:pt x="1340" y="104"/>
                  </a:lnTo>
                  <a:lnTo>
                    <a:pt x="1362" y="104"/>
                  </a:lnTo>
                  <a:lnTo>
                    <a:pt x="1378" y="104"/>
                  </a:lnTo>
                  <a:lnTo>
                    <a:pt x="1391" y="104"/>
                  </a:lnTo>
                  <a:lnTo>
                    <a:pt x="1400" y="104"/>
                  </a:lnTo>
                  <a:lnTo>
                    <a:pt x="1406" y="104"/>
                  </a:lnTo>
                  <a:lnTo>
                    <a:pt x="1419" y="104"/>
                  </a:lnTo>
                  <a:lnTo>
                    <a:pt x="1437" y="104"/>
                  </a:lnTo>
                  <a:lnTo>
                    <a:pt x="1443" y="104"/>
                  </a:lnTo>
                  <a:lnTo>
                    <a:pt x="1449" y="104"/>
                  </a:lnTo>
                  <a:lnTo>
                    <a:pt x="1460" y="104"/>
                  </a:lnTo>
                  <a:lnTo>
                    <a:pt x="1479" y="104"/>
                  </a:lnTo>
                  <a:lnTo>
                    <a:pt x="1490" y="104"/>
                  </a:lnTo>
                  <a:lnTo>
                    <a:pt x="1501" y="104"/>
                  </a:lnTo>
                  <a:lnTo>
                    <a:pt x="1502" y="104"/>
                  </a:lnTo>
                  <a:lnTo>
                    <a:pt x="1522" y="104"/>
                  </a:lnTo>
                  <a:lnTo>
                    <a:pt x="1526" y="104"/>
                  </a:lnTo>
                  <a:lnTo>
                    <a:pt x="1532" y="104"/>
                  </a:lnTo>
                  <a:lnTo>
                    <a:pt x="1541" y="104"/>
                  </a:lnTo>
                  <a:lnTo>
                    <a:pt x="1557" y="104"/>
                  </a:lnTo>
                  <a:lnTo>
                    <a:pt x="1562" y="104"/>
                  </a:lnTo>
                  <a:lnTo>
                    <a:pt x="1571" y="104"/>
                  </a:lnTo>
                  <a:lnTo>
                    <a:pt x="1596" y="104"/>
                  </a:lnTo>
                  <a:lnTo>
                    <a:pt x="1599" y="104"/>
                  </a:lnTo>
                  <a:lnTo>
                    <a:pt x="1614" y="104"/>
                  </a:lnTo>
                  <a:lnTo>
                    <a:pt x="1618" y="104"/>
                  </a:lnTo>
                  <a:lnTo>
                    <a:pt x="1618" y="0"/>
                  </a:lnTo>
                  <a:lnTo>
                    <a:pt x="1645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" name="Freeform 20">
              <a:extLst>
                <a:ext uri="{FF2B5EF4-FFF2-40B4-BE49-F238E27FC236}">
                  <a16:creationId xmlns:a16="http://schemas.microsoft.com/office/drawing/2014/main" id="{371BC33C-82B3-D871-00CD-A96496F5752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538" y="3012496"/>
              <a:ext cx="2742832" cy="0"/>
            </a:xfrm>
            <a:custGeom>
              <a:avLst/>
              <a:gdLst>
                <a:gd name="T0" fmla="*/ 0 w 1460"/>
                <a:gd name="T1" fmla="*/ 126 w 1460"/>
                <a:gd name="T2" fmla="*/ 179 w 1460"/>
                <a:gd name="T3" fmla="*/ 354 w 1460"/>
                <a:gd name="T4" fmla="*/ 520 w 1460"/>
                <a:gd name="T5" fmla="*/ 531 w 1460"/>
                <a:gd name="T6" fmla="*/ 542 w 1460"/>
                <a:gd name="T7" fmla="*/ 598 w 1460"/>
                <a:gd name="T8" fmla="*/ 625 w 1460"/>
                <a:gd name="T9" fmla="*/ 668 w 1460"/>
                <a:gd name="T10" fmla="*/ 1052 w 1460"/>
                <a:gd name="T11" fmla="*/ 1136 w 1460"/>
                <a:gd name="T12" fmla="*/ 1184 w 1460"/>
                <a:gd name="T13" fmla="*/ 1237 w 1460"/>
                <a:gd name="T14" fmla="*/ 1326 w 1460"/>
                <a:gd name="T15" fmla="*/ 1460 w 146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</a:cxnLst>
              <a:rect l="0" t="0" r="r" b="b"/>
              <a:pathLst>
                <a:path w="1460">
                  <a:moveTo>
                    <a:pt x="0" y="0"/>
                  </a:moveTo>
                  <a:lnTo>
                    <a:pt x="126" y="0"/>
                  </a:lnTo>
                  <a:lnTo>
                    <a:pt x="179" y="0"/>
                  </a:lnTo>
                  <a:lnTo>
                    <a:pt x="354" y="0"/>
                  </a:lnTo>
                  <a:lnTo>
                    <a:pt x="520" y="0"/>
                  </a:lnTo>
                  <a:lnTo>
                    <a:pt x="531" y="0"/>
                  </a:lnTo>
                  <a:lnTo>
                    <a:pt x="542" y="0"/>
                  </a:lnTo>
                  <a:lnTo>
                    <a:pt x="598" y="0"/>
                  </a:lnTo>
                  <a:lnTo>
                    <a:pt x="625" y="0"/>
                  </a:lnTo>
                  <a:lnTo>
                    <a:pt x="668" y="0"/>
                  </a:lnTo>
                  <a:lnTo>
                    <a:pt x="1052" y="0"/>
                  </a:lnTo>
                  <a:lnTo>
                    <a:pt x="1136" y="0"/>
                  </a:lnTo>
                  <a:lnTo>
                    <a:pt x="1184" y="0"/>
                  </a:lnTo>
                  <a:lnTo>
                    <a:pt x="1237" y="0"/>
                  </a:lnTo>
                  <a:lnTo>
                    <a:pt x="1326" y="0"/>
                  </a:lnTo>
                  <a:lnTo>
                    <a:pt x="1460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" name="Freeform 21">
              <a:extLst>
                <a:ext uri="{FF2B5EF4-FFF2-40B4-BE49-F238E27FC236}">
                  <a16:creationId xmlns:a16="http://schemas.microsoft.com/office/drawing/2014/main" id="{59093F13-D854-D620-094A-378A441B17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538" y="2493217"/>
              <a:ext cx="3120441" cy="519279"/>
            </a:xfrm>
            <a:custGeom>
              <a:avLst/>
              <a:gdLst>
                <a:gd name="T0" fmla="*/ 107 w 1661"/>
                <a:gd name="T1" fmla="*/ 280 h 280"/>
                <a:gd name="T2" fmla="*/ 148 w 1661"/>
                <a:gd name="T3" fmla="*/ 280 h 280"/>
                <a:gd name="T4" fmla="*/ 205 w 1661"/>
                <a:gd name="T5" fmla="*/ 280 h 280"/>
                <a:gd name="T6" fmla="*/ 260 w 1661"/>
                <a:gd name="T7" fmla="*/ 280 h 280"/>
                <a:gd name="T8" fmla="*/ 269 w 1661"/>
                <a:gd name="T9" fmla="*/ 256 h 280"/>
                <a:gd name="T10" fmla="*/ 386 w 1661"/>
                <a:gd name="T11" fmla="*/ 256 h 280"/>
                <a:gd name="T12" fmla="*/ 434 w 1661"/>
                <a:gd name="T13" fmla="*/ 256 h 280"/>
                <a:gd name="T14" fmla="*/ 524 w 1661"/>
                <a:gd name="T15" fmla="*/ 256 h 280"/>
                <a:gd name="T16" fmla="*/ 530 w 1661"/>
                <a:gd name="T17" fmla="*/ 230 h 280"/>
                <a:gd name="T18" fmla="*/ 548 w 1661"/>
                <a:gd name="T19" fmla="*/ 204 h 280"/>
                <a:gd name="T20" fmla="*/ 555 w 1661"/>
                <a:gd name="T21" fmla="*/ 178 h 280"/>
                <a:gd name="T22" fmla="*/ 578 w 1661"/>
                <a:gd name="T23" fmla="*/ 178 h 280"/>
                <a:gd name="T24" fmla="*/ 635 w 1661"/>
                <a:gd name="T25" fmla="*/ 178 h 280"/>
                <a:gd name="T26" fmla="*/ 669 w 1661"/>
                <a:gd name="T27" fmla="*/ 150 h 280"/>
                <a:gd name="T28" fmla="*/ 719 w 1661"/>
                <a:gd name="T29" fmla="*/ 150 h 280"/>
                <a:gd name="T30" fmla="*/ 720 w 1661"/>
                <a:gd name="T31" fmla="*/ 122 h 280"/>
                <a:gd name="T32" fmla="*/ 744 w 1661"/>
                <a:gd name="T33" fmla="*/ 122 h 280"/>
                <a:gd name="T34" fmla="*/ 759 w 1661"/>
                <a:gd name="T35" fmla="*/ 93 h 280"/>
                <a:gd name="T36" fmla="*/ 778 w 1661"/>
                <a:gd name="T37" fmla="*/ 64 h 280"/>
                <a:gd name="T38" fmla="*/ 806 w 1661"/>
                <a:gd name="T39" fmla="*/ 34 h 280"/>
                <a:gd name="T40" fmla="*/ 832 w 1661"/>
                <a:gd name="T41" fmla="*/ 34 h 280"/>
                <a:gd name="T42" fmla="*/ 862 w 1661"/>
                <a:gd name="T43" fmla="*/ 34 h 280"/>
                <a:gd name="T44" fmla="*/ 877 w 1661"/>
                <a:gd name="T45" fmla="*/ 34 h 280"/>
                <a:gd name="T46" fmla="*/ 925 w 1661"/>
                <a:gd name="T47" fmla="*/ 34 h 280"/>
                <a:gd name="T48" fmla="*/ 944 w 1661"/>
                <a:gd name="T49" fmla="*/ 0 h 280"/>
                <a:gd name="T50" fmla="*/ 960 w 1661"/>
                <a:gd name="T51" fmla="*/ 0 h 280"/>
                <a:gd name="T52" fmla="*/ 984 w 1661"/>
                <a:gd name="T53" fmla="*/ 0 h 280"/>
                <a:gd name="T54" fmla="*/ 1003 w 1661"/>
                <a:gd name="T55" fmla="*/ 0 h 280"/>
                <a:gd name="T56" fmla="*/ 1030 w 1661"/>
                <a:gd name="T57" fmla="*/ 0 h 280"/>
                <a:gd name="T58" fmla="*/ 1070 w 1661"/>
                <a:gd name="T59" fmla="*/ 0 h 280"/>
                <a:gd name="T60" fmla="*/ 1114 w 1661"/>
                <a:gd name="T61" fmla="*/ 0 h 280"/>
                <a:gd name="T62" fmla="*/ 1151 w 1661"/>
                <a:gd name="T63" fmla="*/ 0 h 280"/>
                <a:gd name="T64" fmla="*/ 1180 w 1661"/>
                <a:gd name="T65" fmla="*/ 0 h 280"/>
                <a:gd name="T66" fmla="*/ 1194 w 1661"/>
                <a:gd name="T67" fmla="*/ 0 h 280"/>
                <a:gd name="T68" fmla="*/ 1243 w 1661"/>
                <a:gd name="T69" fmla="*/ 0 h 280"/>
                <a:gd name="T70" fmla="*/ 1295 w 1661"/>
                <a:gd name="T71" fmla="*/ 0 h 280"/>
                <a:gd name="T72" fmla="*/ 1369 w 1661"/>
                <a:gd name="T73" fmla="*/ 0 h 280"/>
                <a:gd name="T74" fmla="*/ 1377 w 1661"/>
                <a:gd name="T75" fmla="*/ 0 h 280"/>
                <a:gd name="T76" fmla="*/ 1435 w 1661"/>
                <a:gd name="T77" fmla="*/ 0 h 280"/>
                <a:gd name="T78" fmla="*/ 1489 w 1661"/>
                <a:gd name="T79" fmla="*/ 0 h 280"/>
                <a:gd name="T80" fmla="*/ 1535 w 1661"/>
                <a:gd name="T81" fmla="*/ 0 h 280"/>
                <a:gd name="T82" fmla="*/ 1575 w 1661"/>
                <a:gd name="T83" fmla="*/ 0 h 280"/>
                <a:gd name="T84" fmla="*/ 1596 w 1661"/>
                <a:gd name="T85" fmla="*/ 0 h 280"/>
                <a:gd name="T86" fmla="*/ 1647 w 1661"/>
                <a:gd name="T87" fmla="*/ 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1661" h="280">
                  <a:moveTo>
                    <a:pt x="0" y="280"/>
                  </a:moveTo>
                  <a:lnTo>
                    <a:pt x="107" y="280"/>
                  </a:lnTo>
                  <a:lnTo>
                    <a:pt x="129" y="280"/>
                  </a:lnTo>
                  <a:lnTo>
                    <a:pt x="148" y="280"/>
                  </a:lnTo>
                  <a:lnTo>
                    <a:pt x="164" y="280"/>
                  </a:lnTo>
                  <a:lnTo>
                    <a:pt x="205" y="280"/>
                  </a:lnTo>
                  <a:lnTo>
                    <a:pt x="208" y="280"/>
                  </a:lnTo>
                  <a:lnTo>
                    <a:pt x="260" y="280"/>
                  </a:lnTo>
                  <a:lnTo>
                    <a:pt x="269" y="280"/>
                  </a:lnTo>
                  <a:lnTo>
                    <a:pt x="269" y="256"/>
                  </a:lnTo>
                  <a:lnTo>
                    <a:pt x="289" y="256"/>
                  </a:lnTo>
                  <a:lnTo>
                    <a:pt x="386" y="256"/>
                  </a:lnTo>
                  <a:lnTo>
                    <a:pt x="427" y="256"/>
                  </a:lnTo>
                  <a:lnTo>
                    <a:pt x="434" y="256"/>
                  </a:lnTo>
                  <a:lnTo>
                    <a:pt x="482" y="256"/>
                  </a:lnTo>
                  <a:lnTo>
                    <a:pt x="524" y="256"/>
                  </a:lnTo>
                  <a:lnTo>
                    <a:pt x="524" y="230"/>
                  </a:lnTo>
                  <a:lnTo>
                    <a:pt x="530" y="230"/>
                  </a:lnTo>
                  <a:lnTo>
                    <a:pt x="532" y="204"/>
                  </a:lnTo>
                  <a:lnTo>
                    <a:pt x="548" y="204"/>
                  </a:lnTo>
                  <a:lnTo>
                    <a:pt x="555" y="204"/>
                  </a:lnTo>
                  <a:lnTo>
                    <a:pt x="555" y="178"/>
                  </a:lnTo>
                  <a:lnTo>
                    <a:pt x="568" y="178"/>
                  </a:lnTo>
                  <a:lnTo>
                    <a:pt x="578" y="178"/>
                  </a:lnTo>
                  <a:lnTo>
                    <a:pt x="599" y="178"/>
                  </a:lnTo>
                  <a:lnTo>
                    <a:pt x="635" y="178"/>
                  </a:lnTo>
                  <a:lnTo>
                    <a:pt x="669" y="178"/>
                  </a:lnTo>
                  <a:lnTo>
                    <a:pt x="669" y="150"/>
                  </a:lnTo>
                  <a:lnTo>
                    <a:pt x="672" y="150"/>
                  </a:lnTo>
                  <a:lnTo>
                    <a:pt x="719" y="150"/>
                  </a:lnTo>
                  <a:lnTo>
                    <a:pt x="719" y="122"/>
                  </a:lnTo>
                  <a:lnTo>
                    <a:pt x="720" y="122"/>
                  </a:lnTo>
                  <a:lnTo>
                    <a:pt x="729" y="122"/>
                  </a:lnTo>
                  <a:lnTo>
                    <a:pt x="744" y="122"/>
                  </a:lnTo>
                  <a:lnTo>
                    <a:pt x="744" y="93"/>
                  </a:lnTo>
                  <a:lnTo>
                    <a:pt x="759" y="93"/>
                  </a:lnTo>
                  <a:lnTo>
                    <a:pt x="759" y="64"/>
                  </a:lnTo>
                  <a:lnTo>
                    <a:pt x="778" y="64"/>
                  </a:lnTo>
                  <a:lnTo>
                    <a:pt x="806" y="64"/>
                  </a:lnTo>
                  <a:lnTo>
                    <a:pt x="806" y="34"/>
                  </a:lnTo>
                  <a:lnTo>
                    <a:pt x="824" y="34"/>
                  </a:lnTo>
                  <a:lnTo>
                    <a:pt x="832" y="34"/>
                  </a:lnTo>
                  <a:lnTo>
                    <a:pt x="844" y="34"/>
                  </a:lnTo>
                  <a:lnTo>
                    <a:pt x="862" y="34"/>
                  </a:lnTo>
                  <a:lnTo>
                    <a:pt x="871" y="34"/>
                  </a:lnTo>
                  <a:lnTo>
                    <a:pt x="877" y="34"/>
                  </a:lnTo>
                  <a:lnTo>
                    <a:pt x="889" y="34"/>
                  </a:lnTo>
                  <a:lnTo>
                    <a:pt x="925" y="34"/>
                  </a:lnTo>
                  <a:lnTo>
                    <a:pt x="925" y="0"/>
                  </a:lnTo>
                  <a:lnTo>
                    <a:pt x="944" y="0"/>
                  </a:lnTo>
                  <a:lnTo>
                    <a:pt x="951" y="0"/>
                  </a:lnTo>
                  <a:lnTo>
                    <a:pt x="960" y="0"/>
                  </a:lnTo>
                  <a:lnTo>
                    <a:pt x="973" y="0"/>
                  </a:lnTo>
                  <a:lnTo>
                    <a:pt x="984" y="0"/>
                  </a:lnTo>
                  <a:lnTo>
                    <a:pt x="996" y="0"/>
                  </a:lnTo>
                  <a:lnTo>
                    <a:pt x="1003" y="0"/>
                  </a:lnTo>
                  <a:lnTo>
                    <a:pt x="1020" y="0"/>
                  </a:lnTo>
                  <a:lnTo>
                    <a:pt x="1030" y="0"/>
                  </a:lnTo>
                  <a:lnTo>
                    <a:pt x="1053" y="0"/>
                  </a:lnTo>
                  <a:lnTo>
                    <a:pt x="1070" y="0"/>
                  </a:lnTo>
                  <a:lnTo>
                    <a:pt x="1096" y="0"/>
                  </a:lnTo>
                  <a:lnTo>
                    <a:pt x="1114" y="0"/>
                  </a:lnTo>
                  <a:lnTo>
                    <a:pt x="1136" y="0"/>
                  </a:lnTo>
                  <a:lnTo>
                    <a:pt x="1151" y="0"/>
                  </a:lnTo>
                  <a:lnTo>
                    <a:pt x="1161" y="0"/>
                  </a:lnTo>
                  <a:lnTo>
                    <a:pt x="1180" y="0"/>
                  </a:lnTo>
                  <a:lnTo>
                    <a:pt x="1186" y="0"/>
                  </a:lnTo>
                  <a:lnTo>
                    <a:pt x="1194" y="0"/>
                  </a:lnTo>
                  <a:lnTo>
                    <a:pt x="1214" y="0"/>
                  </a:lnTo>
                  <a:lnTo>
                    <a:pt x="1243" y="0"/>
                  </a:lnTo>
                  <a:lnTo>
                    <a:pt x="1290" y="0"/>
                  </a:lnTo>
                  <a:lnTo>
                    <a:pt x="1295" y="0"/>
                  </a:lnTo>
                  <a:lnTo>
                    <a:pt x="1301" y="0"/>
                  </a:lnTo>
                  <a:lnTo>
                    <a:pt x="1369" y="0"/>
                  </a:lnTo>
                  <a:lnTo>
                    <a:pt x="1373" y="0"/>
                  </a:lnTo>
                  <a:lnTo>
                    <a:pt x="1377" y="0"/>
                  </a:lnTo>
                  <a:lnTo>
                    <a:pt x="1390" y="0"/>
                  </a:lnTo>
                  <a:lnTo>
                    <a:pt x="1435" y="0"/>
                  </a:lnTo>
                  <a:lnTo>
                    <a:pt x="1477" y="0"/>
                  </a:lnTo>
                  <a:lnTo>
                    <a:pt x="1489" y="0"/>
                  </a:lnTo>
                  <a:lnTo>
                    <a:pt x="1520" y="0"/>
                  </a:lnTo>
                  <a:lnTo>
                    <a:pt x="1535" y="0"/>
                  </a:lnTo>
                  <a:lnTo>
                    <a:pt x="1539" y="0"/>
                  </a:lnTo>
                  <a:lnTo>
                    <a:pt x="1575" y="0"/>
                  </a:lnTo>
                  <a:lnTo>
                    <a:pt x="1582" y="0"/>
                  </a:lnTo>
                  <a:lnTo>
                    <a:pt x="1596" y="0"/>
                  </a:lnTo>
                  <a:lnTo>
                    <a:pt x="1618" y="0"/>
                  </a:lnTo>
                  <a:lnTo>
                    <a:pt x="1647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5C086CC9-EE44-5AD9-0829-21C305584E73}"/>
              </a:ext>
            </a:extLst>
          </p:cNvPr>
          <p:cNvGrpSpPr/>
          <p:nvPr/>
        </p:nvGrpSpPr>
        <p:grpSpPr>
          <a:xfrm>
            <a:off x="6306822" y="698448"/>
            <a:ext cx="4141083" cy="2791354"/>
            <a:chOff x="6597102" y="974214"/>
            <a:chExt cx="4141083" cy="2791354"/>
          </a:xfrm>
        </p:grpSpPr>
        <p:grpSp>
          <p:nvGrpSpPr>
            <p:cNvPr id="236" name="グループ化 235">
              <a:extLst>
                <a:ext uri="{FF2B5EF4-FFF2-40B4-BE49-F238E27FC236}">
                  <a16:creationId xmlns:a16="http://schemas.microsoft.com/office/drawing/2014/main" id="{5637447A-A220-9E15-B255-91213D6AE038}"/>
                </a:ext>
              </a:extLst>
            </p:cNvPr>
            <p:cNvGrpSpPr/>
            <p:nvPr/>
          </p:nvGrpSpPr>
          <p:grpSpPr>
            <a:xfrm>
              <a:off x="6597102" y="974214"/>
              <a:ext cx="4141083" cy="2791354"/>
              <a:chOff x="6597102" y="974214"/>
              <a:chExt cx="4141083" cy="2791354"/>
            </a:xfrm>
          </p:grpSpPr>
          <p:sp>
            <p:nvSpPr>
              <p:cNvPr id="172" name="Rectangle 22">
                <a:extLst>
                  <a:ext uri="{FF2B5EF4-FFF2-40B4-BE49-F238E27FC236}">
                    <a16:creationId xmlns:a16="http://schemas.microsoft.com/office/drawing/2014/main" id="{8B2FA7EC-6A41-F975-1900-6BBAC7EB74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7026" y="980735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3" name="Line 23">
                <a:extLst>
                  <a:ext uri="{FF2B5EF4-FFF2-40B4-BE49-F238E27FC236}">
                    <a16:creationId xmlns:a16="http://schemas.microsoft.com/office/drawing/2014/main" id="{9B1228F6-10B8-CE51-971B-C83D8B57E9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1359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4" name="Line 25">
                <a:extLst>
                  <a:ext uri="{FF2B5EF4-FFF2-40B4-BE49-F238E27FC236}">
                    <a16:creationId xmlns:a16="http://schemas.microsoft.com/office/drawing/2014/main" id="{BE0979E1-6978-A11C-8A0F-6744BA0D2E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74576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5" name="Line 27">
                <a:extLst>
                  <a:ext uri="{FF2B5EF4-FFF2-40B4-BE49-F238E27FC236}">
                    <a16:creationId xmlns:a16="http://schemas.microsoft.com/office/drawing/2014/main" id="{A5E73A6A-3798-CF26-F0F0-3A56FCCA63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97792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6" name="Line 29">
                <a:extLst>
                  <a:ext uri="{FF2B5EF4-FFF2-40B4-BE49-F238E27FC236}">
                    <a16:creationId xmlns:a16="http://schemas.microsoft.com/office/drawing/2014/main" id="{4EF827E4-0BAF-1807-0CA1-D011A1E9D1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19120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7" name="Line 31">
                <a:extLst>
                  <a:ext uri="{FF2B5EF4-FFF2-40B4-BE49-F238E27FC236}">
                    <a16:creationId xmlns:a16="http://schemas.microsoft.com/office/drawing/2014/main" id="{E9D05946-352C-06B9-0A68-6C426C283B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42337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8" name="Line 33">
                <a:extLst>
                  <a:ext uri="{FF2B5EF4-FFF2-40B4-BE49-F238E27FC236}">
                    <a16:creationId xmlns:a16="http://schemas.microsoft.com/office/drawing/2014/main" id="{9A44844B-9658-B14F-4AB4-92C5F1E633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65553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9" name="Line 35">
                <a:extLst>
                  <a:ext uri="{FF2B5EF4-FFF2-40B4-BE49-F238E27FC236}">
                    <a16:creationId xmlns:a16="http://schemas.microsoft.com/office/drawing/2014/main" id="{257D179F-218E-ED1F-6358-BDAA2BF30F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588770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80" name="Line 6">
                <a:extLst>
                  <a:ext uri="{FF2B5EF4-FFF2-40B4-BE49-F238E27FC236}">
                    <a16:creationId xmlns:a16="http://schemas.microsoft.com/office/drawing/2014/main" id="{2EB2D15F-50A1-B966-5F57-B72D716B6F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2994512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1" name="Line 8">
                <a:extLst>
                  <a:ext uri="{FF2B5EF4-FFF2-40B4-BE49-F238E27FC236}">
                    <a16:creationId xmlns:a16="http://schemas.microsoft.com/office/drawing/2014/main" id="{537004C1-B131-888B-CB60-D45A204B8B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258701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2" name="Line 9">
                <a:extLst>
                  <a:ext uri="{FF2B5EF4-FFF2-40B4-BE49-F238E27FC236}">
                    <a16:creationId xmlns:a16="http://schemas.microsoft.com/office/drawing/2014/main" id="{BE30B52C-44CB-C821-47FF-D9959D3DE5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2179521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3" name="Line 11">
                <a:extLst>
                  <a:ext uri="{FF2B5EF4-FFF2-40B4-BE49-F238E27FC236}">
                    <a16:creationId xmlns:a16="http://schemas.microsoft.com/office/drawing/2014/main" id="{D4390D76-1247-B684-6ECB-6676FE54F9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177202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4" name="Line 12">
                <a:extLst>
                  <a:ext uri="{FF2B5EF4-FFF2-40B4-BE49-F238E27FC236}">
                    <a16:creationId xmlns:a16="http://schemas.microsoft.com/office/drawing/2014/main" id="{E15154B9-D2FC-9A56-BA46-816AA4D8FB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1364531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5" name="Line 14">
                <a:extLst>
                  <a:ext uri="{FF2B5EF4-FFF2-40B4-BE49-F238E27FC236}">
                    <a16:creationId xmlns:a16="http://schemas.microsoft.com/office/drawing/2014/main" id="{43ECBC04-7BCC-2A1F-2B2A-0D3AE4C012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980943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6" name="Line 23">
                <a:extLst>
                  <a:ext uri="{FF2B5EF4-FFF2-40B4-BE49-F238E27FC236}">
                    <a16:creationId xmlns:a16="http://schemas.microsoft.com/office/drawing/2014/main" id="{DC5C2F81-919D-F4A9-F88A-208C85C8AD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3047" y="2994513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87" name="図形グループ 54">
                <a:extLst>
                  <a:ext uri="{FF2B5EF4-FFF2-40B4-BE49-F238E27FC236}">
                    <a16:creationId xmlns:a16="http://schemas.microsoft.com/office/drawing/2014/main" id="{B7CC5933-C4D8-EC26-F672-31D676DC3041}"/>
                  </a:ext>
                </a:extLst>
              </p:cNvPr>
              <p:cNvGrpSpPr/>
              <p:nvPr/>
            </p:nvGrpSpPr>
            <p:grpSpPr>
              <a:xfrm>
                <a:off x="7143441" y="1235436"/>
                <a:ext cx="220989" cy="1868530"/>
                <a:chOff x="510218" y="1348283"/>
                <a:chExt cx="220989" cy="1868530"/>
              </a:xfrm>
            </p:grpSpPr>
            <p:sp>
              <p:nvSpPr>
                <p:cNvPr id="194" name="Rectangle 10">
                  <a:extLst>
                    <a:ext uri="{FF2B5EF4-FFF2-40B4-BE49-F238E27FC236}">
                      <a16:creationId xmlns:a16="http://schemas.microsoft.com/office/drawing/2014/main" id="{FFB05AF3-CD2A-5065-84F3-EA3BA9E2A1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95" name="Rectangle 13">
                  <a:extLst>
                    <a:ext uri="{FF2B5EF4-FFF2-40B4-BE49-F238E27FC236}">
                      <a16:creationId xmlns:a16="http://schemas.microsoft.com/office/drawing/2014/main" id="{5E9F6F84-7C27-D320-325D-6179E8F732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96" name="Rectangle 10">
                  <a:extLst>
                    <a:ext uri="{FF2B5EF4-FFF2-40B4-BE49-F238E27FC236}">
                      <a16:creationId xmlns:a16="http://schemas.microsoft.com/office/drawing/2014/main" id="{E77A11C9-718F-0743-E009-526F508ABB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4DFF09B6-5300-18D5-8D97-26364E1314E0}"/>
                  </a:ext>
                </a:extLst>
              </p:cNvPr>
              <p:cNvSpPr txBox="1"/>
              <p:nvPr/>
            </p:nvSpPr>
            <p:spPr>
              <a:xfrm>
                <a:off x="7315908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911FBB34-F6DA-3779-34A7-5E4DB663F892}"/>
                  </a:ext>
                </a:extLst>
              </p:cNvPr>
              <p:cNvSpPr txBox="1"/>
              <p:nvPr/>
            </p:nvSpPr>
            <p:spPr>
              <a:xfrm>
                <a:off x="8360447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FDAEB116-47EE-C845-65E6-651DF434A696}"/>
                  </a:ext>
                </a:extLst>
              </p:cNvPr>
              <p:cNvSpPr txBox="1"/>
              <p:nvPr/>
            </p:nvSpPr>
            <p:spPr>
              <a:xfrm>
                <a:off x="10449524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id="{73317B78-8021-CCC0-3AA1-67DB11CD4159}"/>
                  </a:ext>
                </a:extLst>
              </p:cNvPr>
              <p:cNvSpPr txBox="1"/>
              <p:nvPr/>
            </p:nvSpPr>
            <p:spPr>
              <a:xfrm>
                <a:off x="9404986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6E14ACF6-AA47-7BA7-9851-59F5CF5AF153}"/>
                  </a:ext>
                </a:extLst>
              </p:cNvPr>
              <p:cNvSpPr txBox="1"/>
              <p:nvPr/>
            </p:nvSpPr>
            <p:spPr>
              <a:xfrm rot="16200000">
                <a:off x="5714007" y="1857309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F40FD17D-EF94-E95C-F4E2-E468924DC3C4}"/>
                  </a:ext>
                </a:extLst>
              </p:cNvPr>
              <p:cNvSpPr txBox="1"/>
              <p:nvPr/>
            </p:nvSpPr>
            <p:spPr>
              <a:xfrm>
                <a:off x="8218214" y="3396236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1" name="Freeform 56">
              <a:extLst>
                <a:ext uri="{FF2B5EF4-FFF2-40B4-BE49-F238E27FC236}">
                  <a16:creationId xmlns:a16="http://schemas.microsoft.com/office/drawing/2014/main" id="{88DE33B4-8D1E-6F61-9BFD-FD2D0C177347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2899" y="2167167"/>
              <a:ext cx="3130202" cy="828750"/>
            </a:xfrm>
            <a:custGeom>
              <a:avLst/>
              <a:gdLst>
                <a:gd name="T0" fmla="*/ 104 w 1661"/>
                <a:gd name="T1" fmla="*/ 446 h 446"/>
                <a:gd name="T2" fmla="*/ 132 w 1661"/>
                <a:gd name="T3" fmla="*/ 446 h 446"/>
                <a:gd name="T4" fmla="*/ 152 w 1661"/>
                <a:gd name="T5" fmla="*/ 431 h 446"/>
                <a:gd name="T6" fmla="*/ 179 w 1661"/>
                <a:gd name="T7" fmla="*/ 431 h 446"/>
                <a:gd name="T8" fmla="*/ 185 w 1661"/>
                <a:gd name="T9" fmla="*/ 416 h 446"/>
                <a:gd name="T10" fmla="*/ 205 w 1661"/>
                <a:gd name="T11" fmla="*/ 416 h 446"/>
                <a:gd name="T12" fmla="*/ 222 w 1661"/>
                <a:gd name="T13" fmla="*/ 416 h 446"/>
                <a:gd name="T14" fmla="*/ 242 w 1661"/>
                <a:gd name="T15" fmla="*/ 416 h 446"/>
                <a:gd name="T16" fmla="*/ 247 w 1661"/>
                <a:gd name="T17" fmla="*/ 399 h 446"/>
                <a:gd name="T18" fmla="*/ 272 w 1661"/>
                <a:gd name="T19" fmla="*/ 399 h 446"/>
                <a:gd name="T20" fmla="*/ 284 w 1661"/>
                <a:gd name="T21" fmla="*/ 382 h 446"/>
                <a:gd name="T22" fmla="*/ 346 w 1661"/>
                <a:gd name="T23" fmla="*/ 382 h 446"/>
                <a:gd name="T24" fmla="*/ 414 w 1661"/>
                <a:gd name="T25" fmla="*/ 382 h 446"/>
                <a:gd name="T26" fmla="*/ 434 w 1661"/>
                <a:gd name="T27" fmla="*/ 382 h 446"/>
                <a:gd name="T28" fmla="*/ 458 w 1661"/>
                <a:gd name="T29" fmla="*/ 382 h 446"/>
                <a:gd name="T30" fmla="*/ 477 w 1661"/>
                <a:gd name="T31" fmla="*/ 364 h 446"/>
                <a:gd name="T32" fmla="*/ 486 w 1661"/>
                <a:gd name="T33" fmla="*/ 364 h 446"/>
                <a:gd name="T34" fmla="*/ 530 w 1661"/>
                <a:gd name="T35" fmla="*/ 364 h 446"/>
                <a:gd name="T36" fmla="*/ 551 w 1661"/>
                <a:gd name="T37" fmla="*/ 345 h 446"/>
                <a:gd name="T38" fmla="*/ 554 w 1661"/>
                <a:gd name="T39" fmla="*/ 326 h 446"/>
                <a:gd name="T40" fmla="*/ 578 w 1661"/>
                <a:gd name="T41" fmla="*/ 307 h 446"/>
                <a:gd name="T42" fmla="*/ 580 w 1661"/>
                <a:gd name="T43" fmla="*/ 268 h 446"/>
                <a:gd name="T44" fmla="*/ 604 w 1661"/>
                <a:gd name="T45" fmla="*/ 248 h 446"/>
                <a:gd name="T46" fmla="*/ 651 w 1661"/>
                <a:gd name="T47" fmla="*/ 248 h 446"/>
                <a:gd name="T48" fmla="*/ 665 w 1661"/>
                <a:gd name="T49" fmla="*/ 248 h 446"/>
                <a:gd name="T50" fmla="*/ 702 w 1661"/>
                <a:gd name="T51" fmla="*/ 248 h 446"/>
                <a:gd name="T52" fmla="*/ 707 w 1661"/>
                <a:gd name="T53" fmla="*/ 228 h 446"/>
                <a:gd name="T54" fmla="*/ 719 w 1661"/>
                <a:gd name="T55" fmla="*/ 206 h 446"/>
                <a:gd name="T56" fmla="*/ 759 w 1661"/>
                <a:gd name="T57" fmla="*/ 206 h 446"/>
                <a:gd name="T58" fmla="*/ 766 w 1661"/>
                <a:gd name="T59" fmla="*/ 184 h 446"/>
                <a:gd name="T60" fmla="*/ 798 w 1661"/>
                <a:gd name="T61" fmla="*/ 184 h 446"/>
                <a:gd name="T62" fmla="*/ 806 w 1661"/>
                <a:gd name="T63" fmla="*/ 162 h 446"/>
                <a:gd name="T64" fmla="*/ 838 w 1661"/>
                <a:gd name="T65" fmla="*/ 162 h 446"/>
                <a:gd name="T66" fmla="*/ 921 w 1661"/>
                <a:gd name="T67" fmla="*/ 162 h 446"/>
                <a:gd name="T68" fmla="*/ 971 w 1661"/>
                <a:gd name="T69" fmla="*/ 162 h 446"/>
                <a:gd name="T70" fmla="*/ 996 w 1661"/>
                <a:gd name="T71" fmla="*/ 162 h 446"/>
                <a:gd name="T72" fmla="*/ 1011 w 1661"/>
                <a:gd name="T73" fmla="*/ 162 h 446"/>
                <a:gd name="T74" fmla="*/ 1028 w 1661"/>
                <a:gd name="T75" fmla="*/ 162 h 446"/>
                <a:gd name="T76" fmla="*/ 1053 w 1661"/>
                <a:gd name="T77" fmla="*/ 162 h 446"/>
                <a:gd name="T78" fmla="*/ 1092 w 1661"/>
                <a:gd name="T79" fmla="*/ 162 h 446"/>
                <a:gd name="T80" fmla="*/ 1099 w 1661"/>
                <a:gd name="T81" fmla="*/ 162 h 446"/>
                <a:gd name="T82" fmla="*/ 1107 w 1661"/>
                <a:gd name="T83" fmla="*/ 132 h 446"/>
                <a:gd name="T84" fmla="*/ 1129 w 1661"/>
                <a:gd name="T85" fmla="*/ 132 h 446"/>
                <a:gd name="T86" fmla="*/ 1189 w 1661"/>
                <a:gd name="T87" fmla="*/ 132 h 446"/>
                <a:gd name="T88" fmla="*/ 1295 w 1661"/>
                <a:gd name="T89" fmla="*/ 132 h 446"/>
                <a:gd name="T90" fmla="*/ 1306 w 1661"/>
                <a:gd name="T91" fmla="*/ 132 h 446"/>
                <a:gd name="T92" fmla="*/ 1322 w 1661"/>
                <a:gd name="T93" fmla="*/ 132 h 446"/>
                <a:gd name="T94" fmla="*/ 1336 w 1661"/>
                <a:gd name="T95" fmla="*/ 132 h 446"/>
                <a:gd name="T96" fmla="*/ 1362 w 1661"/>
                <a:gd name="T97" fmla="*/ 132 h 446"/>
                <a:gd name="T98" fmla="*/ 1391 w 1661"/>
                <a:gd name="T99" fmla="*/ 132 h 446"/>
                <a:gd name="T100" fmla="*/ 1406 w 1661"/>
                <a:gd name="T101" fmla="*/ 132 h 446"/>
                <a:gd name="T102" fmla="*/ 1437 w 1661"/>
                <a:gd name="T103" fmla="*/ 132 h 446"/>
                <a:gd name="T104" fmla="*/ 1449 w 1661"/>
                <a:gd name="T105" fmla="*/ 132 h 446"/>
                <a:gd name="T106" fmla="*/ 1479 w 1661"/>
                <a:gd name="T107" fmla="*/ 132 h 446"/>
                <a:gd name="T108" fmla="*/ 1501 w 1661"/>
                <a:gd name="T109" fmla="*/ 132 h 446"/>
                <a:gd name="T110" fmla="*/ 1526 w 1661"/>
                <a:gd name="T111" fmla="*/ 132 h 446"/>
                <a:gd name="T112" fmla="*/ 1541 w 1661"/>
                <a:gd name="T113" fmla="*/ 132 h 446"/>
                <a:gd name="T114" fmla="*/ 1562 w 1661"/>
                <a:gd name="T115" fmla="*/ 132 h 446"/>
                <a:gd name="T116" fmla="*/ 1582 w 1661"/>
                <a:gd name="T117" fmla="*/ 132 h 446"/>
                <a:gd name="T118" fmla="*/ 1599 w 1661"/>
                <a:gd name="T119" fmla="*/ 132 h 446"/>
                <a:gd name="T120" fmla="*/ 1618 w 1661"/>
                <a:gd name="T121" fmla="*/ 132 h 446"/>
                <a:gd name="T122" fmla="*/ 1645 w 1661"/>
                <a:gd name="T123" fmla="*/ 0 h 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1661" h="446">
                  <a:moveTo>
                    <a:pt x="0" y="446"/>
                  </a:moveTo>
                  <a:lnTo>
                    <a:pt x="104" y="446"/>
                  </a:lnTo>
                  <a:lnTo>
                    <a:pt x="107" y="446"/>
                  </a:lnTo>
                  <a:lnTo>
                    <a:pt x="132" y="446"/>
                  </a:lnTo>
                  <a:lnTo>
                    <a:pt x="132" y="431"/>
                  </a:lnTo>
                  <a:lnTo>
                    <a:pt x="152" y="431"/>
                  </a:lnTo>
                  <a:lnTo>
                    <a:pt x="177" y="431"/>
                  </a:lnTo>
                  <a:lnTo>
                    <a:pt x="179" y="431"/>
                  </a:lnTo>
                  <a:lnTo>
                    <a:pt x="179" y="416"/>
                  </a:lnTo>
                  <a:lnTo>
                    <a:pt x="185" y="416"/>
                  </a:lnTo>
                  <a:lnTo>
                    <a:pt x="196" y="416"/>
                  </a:lnTo>
                  <a:lnTo>
                    <a:pt x="205" y="416"/>
                  </a:lnTo>
                  <a:lnTo>
                    <a:pt x="208" y="416"/>
                  </a:lnTo>
                  <a:lnTo>
                    <a:pt x="222" y="416"/>
                  </a:lnTo>
                  <a:lnTo>
                    <a:pt x="233" y="416"/>
                  </a:lnTo>
                  <a:lnTo>
                    <a:pt x="242" y="416"/>
                  </a:lnTo>
                  <a:lnTo>
                    <a:pt x="247" y="416"/>
                  </a:lnTo>
                  <a:lnTo>
                    <a:pt x="247" y="399"/>
                  </a:lnTo>
                  <a:lnTo>
                    <a:pt x="259" y="399"/>
                  </a:lnTo>
                  <a:lnTo>
                    <a:pt x="272" y="399"/>
                  </a:lnTo>
                  <a:lnTo>
                    <a:pt x="272" y="382"/>
                  </a:lnTo>
                  <a:lnTo>
                    <a:pt x="284" y="382"/>
                  </a:lnTo>
                  <a:lnTo>
                    <a:pt x="300" y="382"/>
                  </a:lnTo>
                  <a:lnTo>
                    <a:pt x="346" y="382"/>
                  </a:lnTo>
                  <a:lnTo>
                    <a:pt x="369" y="382"/>
                  </a:lnTo>
                  <a:lnTo>
                    <a:pt x="414" y="382"/>
                  </a:lnTo>
                  <a:lnTo>
                    <a:pt x="428" y="382"/>
                  </a:lnTo>
                  <a:lnTo>
                    <a:pt x="434" y="382"/>
                  </a:lnTo>
                  <a:lnTo>
                    <a:pt x="437" y="382"/>
                  </a:lnTo>
                  <a:lnTo>
                    <a:pt x="458" y="382"/>
                  </a:lnTo>
                  <a:lnTo>
                    <a:pt x="477" y="382"/>
                  </a:lnTo>
                  <a:lnTo>
                    <a:pt x="477" y="364"/>
                  </a:lnTo>
                  <a:lnTo>
                    <a:pt x="482" y="364"/>
                  </a:lnTo>
                  <a:lnTo>
                    <a:pt x="486" y="364"/>
                  </a:lnTo>
                  <a:lnTo>
                    <a:pt x="500" y="364"/>
                  </a:lnTo>
                  <a:lnTo>
                    <a:pt x="530" y="364"/>
                  </a:lnTo>
                  <a:lnTo>
                    <a:pt x="532" y="345"/>
                  </a:lnTo>
                  <a:lnTo>
                    <a:pt x="551" y="345"/>
                  </a:lnTo>
                  <a:lnTo>
                    <a:pt x="551" y="326"/>
                  </a:lnTo>
                  <a:lnTo>
                    <a:pt x="554" y="326"/>
                  </a:lnTo>
                  <a:lnTo>
                    <a:pt x="555" y="307"/>
                  </a:lnTo>
                  <a:lnTo>
                    <a:pt x="578" y="307"/>
                  </a:lnTo>
                  <a:lnTo>
                    <a:pt x="579" y="288"/>
                  </a:lnTo>
                  <a:lnTo>
                    <a:pt x="580" y="268"/>
                  </a:lnTo>
                  <a:lnTo>
                    <a:pt x="599" y="268"/>
                  </a:lnTo>
                  <a:lnTo>
                    <a:pt x="604" y="248"/>
                  </a:lnTo>
                  <a:lnTo>
                    <a:pt x="635" y="248"/>
                  </a:lnTo>
                  <a:lnTo>
                    <a:pt x="651" y="248"/>
                  </a:lnTo>
                  <a:lnTo>
                    <a:pt x="662" y="248"/>
                  </a:lnTo>
                  <a:lnTo>
                    <a:pt x="665" y="248"/>
                  </a:lnTo>
                  <a:lnTo>
                    <a:pt x="685" y="248"/>
                  </a:lnTo>
                  <a:lnTo>
                    <a:pt x="702" y="248"/>
                  </a:lnTo>
                  <a:lnTo>
                    <a:pt x="702" y="228"/>
                  </a:lnTo>
                  <a:lnTo>
                    <a:pt x="707" y="228"/>
                  </a:lnTo>
                  <a:lnTo>
                    <a:pt x="714" y="228"/>
                  </a:lnTo>
                  <a:lnTo>
                    <a:pt x="719" y="206"/>
                  </a:lnTo>
                  <a:lnTo>
                    <a:pt x="753" y="206"/>
                  </a:lnTo>
                  <a:lnTo>
                    <a:pt x="759" y="206"/>
                  </a:lnTo>
                  <a:lnTo>
                    <a:pt x="759" y="184"/>
                  </a:lnTo>
                  <a:lnTo>
                    <a:pt x="766" y="184"/>
                  </a:lnTo>
                  <a:lnTo>
                    <a:pt x="773" y="184"/>
                  </a:lnTo>
                  <a:lnTo>
                    <a:pt x="798" y="184"/>
                  </a:lnTo>
                  <a:lnTo>
                    <a:pt x="806" y="184"/>
                  </a:lnTo>
                  <a:lnTo>
                    <a:pt x="806" y="162"/>
                  </a:lnTo>
                  <a:lnTo>
                    <a:pt x="833" y="162"/>
                  </a:lnTo>
                  <a:lnTo>
                    <a:pt x="838" y="162"/>
                  </a:lnTo>
                  <a:lnTo>
                    <a:pt x="860" y="162"/>
                  </a:lnTo>
                  <a:lnTo>
                    <a:pt x="921" y="162"/>
                  </a:lnTo>
                  <a:lnTo>
                    <a:pt x="944" y="162"/>
                  </a:lnTo>
                  <a:lnTo>
                    <a:pt x="971" y="162"/>
                  </a:lnTo>
                  <a:lnTo>
                    <a:pt x="980" y="162"/>
                  </a:lnTo>
                  <a:lnTo>
                    <a:pt x="996" y="162"/>
                  </a:lnTo>
                  <a:lnTo>
                    <a:pt x="1008" y="162"/>
                  </a:lnTo>
                  <a:lnTo>
                    <a:pt x="1011" y="162"/>
                  </a:lnTo>
                  <a:lnTo>
                    <a:pt x="1024" y="162"/>
                  </a:lnTo>
                  <a:lnTo>
                    <a:pt x="1028" y="162"/>
                  </a:lnTo>
                  <a:lnTo>
                    <a:pt x="1044" y="162"/>
                  </a:lnTo>
                  <a:lnTo>
                    <a:pt x="1053" y="162"/>
                  </a:lnTo>
                  <a:lnTo>
                    <a:pt x="1061" y="162"/>
                  </a:lnTo>
                  <a:lnTo>
                    <a:pt x="1092" y="162"/>
                  </a:lnTo>
                  <a:lnTo>
                    <a:pt x="1096" y="162"/>
                  </a:lnTo>
                  <a:lnTo>
                    <a:pt x="1099" y="162"/>
                  </a:lnTo>
                  <a:lnTo>
                    <a:pt x="1099" y="132"/>
                  </a:lnTo>
                  <a:lnTo>
                    <a:pt x="1107" y="132"/>
                  </a:lnTo>
                  <a:lnTo>
                    <a:pt x="1123" y="132"/>
                  </a:lnTo>
                  <a:lnTo>
                    <a:pt x="1129" y="132"/>
                  </a:lnTo>
                  <a:lnTo>
                    <a:pt x="1148" y="132"/>
                  </a:lnTo>
                  <a:lnTo>
                    <a:pt x="1189" y="132"/>
                  </a:lnTo>
                  <a:lnTo>
                    <a:pt x="1210" y="132"/>
                  </a:lnTo>
                  <a:lnTo>
                    <a:pt x="1295" y="132"/>
                  </a:lnTo>
                  <a:lnTo>
                    <a:pt x="1297" y="132"/>
                  </a:lnTo>
                  <a:lnTo>
                    <a:pt x="1306" y="132"/>
                  </a:lnTo>
                  <a:lnTo>
                    <a:pt x="1311" y="132"/>
                  </a:lnTo>
                  <a:lnTo>
                    <a:pt x="1322" y="132"/>
                  </a:lnTo>
                  <a:lnTo>
                    <a:pt x="1332" y="132"/>
                  </a:lnTo>
                  <a:lnTo>
                    <a:pt x="1336" y="132"/>
                  </a:lnTo>
                  <a:lnTo>
                    <a:pt x="1340" y="132"/>
                  </a:lnTo>
                  <a:lnTo>
                    <a:pt x="1362" y="132"/>
                  </a:lnTo>
                  <a:lnTo>
                    <a:pt x="1378" y="132"/>
                  </a:lnTo>
                  <a:lnTo>
                    <a:pt x="1391" y="132"/>
                  </a:lnTo>
                  <a:lnTo>
                    <a:pt x="1400" y="132"/>
                  </a:lnTo>
                  <a:lnTo>
                    <a:pt x="1406" y="132"/>
                  </a:lnTo>
                  <a:lnTo>
                    <a:pt x="1419" y="132"/>
                  </a:lnTo>
                  <a:lnTo>
                    <a:pt x="1437" y="132"/>
                  </a:lnTo>
                  <a:lnTo>
                    <a:pt x="1443" y="132"/>
                  </a:lnTo>
                  <a:lnTo>
                    <a:pt x="1449" y="132"/>
                  </a:lnTo>
                  <a:lnTo>
                    <a:pt x="1460" y="132"/>
                  </a:lnTo>
                  <a:lnTo>
                    <a:pt x="1479" y="132"/>
                  </a:lnTo>
                  <a:lnTo>
                    <a:pt x="1489" y="132"/>
                  </a:lnTo>
                  <a:lnTo>
                    <a:pt x="1501" y="132"/>
                  </a:lnTo>
                  <a:lnTo>
                    <a:pt x="1502" y="132"/>
                  </a:lnTo>
                  <a:lnTo>
                    <a:pt x="1526" y="132"/>
                  </a:lnTo>
                  <a:lnTo>
                    <a:pt x="1532" y="132"/>
                  </a:lnTo>
                  <a:lnTo>
                    <a:pt x="1541" y="132"/>
                  </a:lnTo>
                  <a:lnTo>
                    <a:pt x="1557" y="132"/>
                  </a:lnTo>
                  <a:lnTo>
                    <a:pt x="1562" y="132"/>
                  </a:lnTo>
                  <a:lnTo>
                    <a:pt x="1571" y="132"/>
                  </a:lnTo>
                  <a:lnTo>
                    <a:pt x="1582" y="132"/>
                  </a:lnTo>
                  <a:lnTo>
                    <a:pt x="1596" y="132"/>
                  </a:lnTo>
                  <a:lnTo>
                    <a:pt x="1599" y="132"/>
                  </a:lnTo>
                  <a:lnTo>
                    <a:pt x="1614" y="132"/>
                  </a:lnTo>
                  <a:lnTo>
                    <a:pt x="1618" y="132"/>
                  </a:lnTo>
                  <a:lnTo>
                    <a:pt x="1618" y="0"/>
                  </a:lnTo>
                  <a:lnTo>
                    <a:pt x="1645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Freeform 57">
              <a:extLst>
                <a:ext uri="{FF2B5EF4-FFF2-40B4-BE49-F238E27FC236}">
                  <a16:creationId xmlns:a16="http://schemas.microsoft.com/office/drawing/2014/main" id="{32D6D714-973A-8445-54C7-6DBE9336A2EA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2899" y="2826822"/>
              <a:ext cx="3130202" cy="169095"/>
            </a:xfrm>
            <a:custGeom>
              <a:avLst/>
              <a:gdLst>
                <a:gd name="T0" fmla="*/ 0 w 1661"/>
                <a:gd name="T1" fmla="*/ 91 h 91"/>
                <a:gd name="T2" fmla="*/ 126 w 1661"/>
                <a:gd name="T3" fmla="*/ 91 h 91"/>
                <a:gd name="T4" fmla="*/ 153 w 1661"/>
                <a:gd name="T5" fmla="*/ 91 h 91"/>
                <a:gd name="T6" fmla="*/ 179 w 1661"/>
                <a:gd name="T7" fmla="*/ 91 h 91"/>
                <a:gd name="T8" fmla="*/ 208 w 1661"/>
                <a:gd name="T9" fmla="*/ 91 h 91"/>
                <a:gd name="T10" fmla="*/ 354 w 1661"/>
                <a:gd name="T11" fmla="*/ 91 h 91"/>
                <a:gd name="T12" fmla="*/ 427 w 1661"/>
                <a:gd name="T13" fmla="*/ 91 h 91"/>
                <a:gd name="T14" fmla="*/ 524 w 1661"/>
                <a:gd name="T15" fmla="*/ 91 h 91"/>
                <a:gd name="T16" fmla="*/ 524 w 1661"/>
                <a:gd name="T17" fmla="*/ 0 h 91"/>
                <a:gd name="T18" fmla="*/ 531 w 1661"/>
                <a:gd name="T19" fmla="*/ 0 h 91"/>
                <a:gd name="T20" fmla="*/ 542 w 1661"/>
                <a:gd name="T21" fmla="*/ 0 h 91"/>
                <a:gd name="T22" fmla="*/ 598 w 1661"/>
                <a:gd name="T23" fmla="*/ 0 h 91"/>
                <a:gd name="T24" fmla="*/ 599 w 1661"/>
                <a:gd name="T25" fmla="*/ 0 h 91"/>
                <a:gd name="T26" fmla="*/ 625 w 1661"/>
                <a:gd name="T27" fmla="*/ 0 h 91"/>
                <a:gd name="T28" fmla="*/ 668 w 1661"/>
                <a:gd name="T29" fmla="*/ 0 h 91"/>
                <a:gd name="T30" fmla="*/ 720 w 1661"/>
                <a:gd name="T31" fmla="*/ 0 h 91"/>
                <a:gd name="T32" fmla="*/ 778 w 1661"/>
                <a:gd name="T33" fmla="*/ 0 h 91"/>
                <a:gd name="T34" fmla="*/ 832 w 1661"/>
                <a:gd name="T35" fmla="*/ 0 h 91"/>
                <a:gd name="T36" fmla="*/ 844 w 1661"/>
                <a:gd name="T37" fmla="*/ 0 h 91"/>
                <a:gd name="T38" fmla="*/ 893 w 1661"/>
                <a:gd name="T39" fmla="*/ 0 h 91"/>
                <a:gd name="T40" fmla="*/ 930 w 1661"/>
                <a:gd name="T41" fmla="*/ 0 h 91"/>
                <a:gd name="T42" fmla="*/ 989 w 1661"/>
                <a:gd name="T43" fmla="*/ 0 h 91"/>
                <a:gd name="T44" fmla="*/ 1003 w 1661"/>
                <a:gd name="T45" fmla="*/ 0 h 91"/>
                <a:gd name="T46" fmla="*/ 1052 w 1661"/>
                <a:gd name="T47" fmla="*/ 0 h 91"/>
                <a:gd name="T48" fmla="*/ 1136 w 1661"/>
                <a:gd name="T49" fmla="*/ 0 h 91"/>
                <a:gd name="T50" fmla="*/ 1184 w 1661"/>
                <a:gd name="T51" fmla="*/ 0 h 91"/>
                <a:gd name="T52" fmla="*/ 1243 w 1661"/>
                <a:gd name="T53" fmla="*/ 0 h 91"/>
                <a:gd name="T54" fmla="*/ 1391 w 1661"/>
                <a:gd name="T55" fmla="*/ 0 h 91"/>
                <a:gd name="T56" fmla="*/ 1435 w 1661"/>
                <a:gd name="T57" fmla="*/ 0 h 91"/>
                <a:gd name="T58" fmla="*/ 1477 w 1661"/>
                <a:gd name="T59" fmla="*/ 0 h 91"/>
                <a:gd name="T60" fmla="*/ 1661 w 1661"/>
                <a:gd name="T61" fmla="*/ 0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1661" h="91">
                  <a:moveTo>
                    <a:pt x="0" y="91"/>
                  </a:moveTo>
                  <a:lnTo>
                    <a:pt x="126" y="91"/>
                  </a:lnTo>
                  <a:lnTo>
                    <a:pt x="153" y="91"/>
                  </a:lnTo>
                  <a:lnTo>
                    <a:pt x="179" y="91"/>
                  </a:lnTo>
                  <a:lnTo>
                    <a:pt x="208" y="91"/>
                  </a:lnTo>
                  <a:lnTo>
                    <a:pt x="354" y="91"/>
                  </a:lnTo>
                  <a:lnTo>
                    <a:pt x="427" y="91"/>
                  </a:lnTo>
                  <a:lnTo>
                    <a:pt x="524" y="91"/>
                  </a:lnTo>
                  <a:lnTo>
                    <a:pt x="524" y="0"/>
                  </a:lnTo>
                  <a:lnTo>
                    <a:pt x="531" y="0"/>
                  </a:lnTo>
                  <a:lnTo>
                    <a:pt x="542" y="0"/>
                  </a:lnTo>
                  <a:lnTo>
                    <a:pt x="598" y="0"/>
                  </a:lnTo>
                  <a:lnTo>
                    <a:pt x="599" y="0"/>
                  </a:lnTo>
                  <a:lnTo>
                    <a:pt x="625" y="0"/>
                  </a:lnTo>
                  <a:lnTo>
                    <a:pt x="668" y="0"/>
                  </a:lnTo>
                  <a:lnTo>
                    <a:pt x="720" y="0"/>
                  </a:lnTo>
                  <a:lnTo>
                    <a:pt x="778" y="0"/>
                  </a:lnTo>
                  <a:lnTo>
                    <a:pt x="832" y="0"/>
                  </a:lnTo>
                  <a:lnTo>
                    <a:pt x="844" y="0"/>
                  </a:lnTo>
                  <a:lnTo>
                    <a:pt x="893" y="0"/>
                  </a:lnTo>
                  <a:lnTo>
                    <a:pt x="930" y="0"/>
                  </a:lnTo>
                  <a:lnTo>
                    <a:pt x="989" y="0"/>
                  </a:lnTo>
                  <a:lnTo>
                    <a:pt x="1003" y="0"/>
                  </a:lnTo>
                  <a:lnTo>
                    <a:pt x="1052" y="0"/>
                  </a:lnTo>
                  <a:lnTo>
                    <a:pt x="1136" y="0"/>
                  </a:lnTo>
                  <a:lnTo>
                    <a:pt x="1184" y="0"/>
                  </a:lnTo>
                  <a:lnTo>
                    <a:pt x="1243" y="0"/>
                  </a:lnTo>
                  <a:lnTo>
                    <a:pt x="1391" y="0"/>
                  </a:lnTo>
                  <a:lnTo>
                    <a:pt x="1435" y="0"/>
                  </a:lnTo>
                  <a:lnTo>
                    <a:pt x="1477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Freeform 58">
              <a:extLst>
                <a:ext uri="{FF2B5EF4-FFF2-40B4-BE49-F238E27FC236}">
                  <a16:creationId xmlns:a16="http://schemas.microsoft.com/office/drawing/2014/main" id="{583FA404-AE6F-7CE0-D84D-B00A5DC736BD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2899" y="2455185"/>
              <a:ext cx="3130202" cy="540732"/>
            </a:xfrm>
            <a:custGeom>
              <a:avLst/>
              <a:gdLst>
                <a:gd name="T0" fmla="*/ 111 w 1661"/>
                <a:gd name="T1" fmla="*/ 291 h 291"/>
                <a:gd name="T2" fmla="*/ 129 w 1661"/>
                <a:gd name="T3" fmla="*/ 270 h 291"/>
                <a:gd name="T4" fmla="*/ 164 w 1661"/>
                <a:gd name="T5" fmla="*/ 270 h 291"/>
                <a:gd name="T6" fmla="*/ 205 w 1661"/>
                <a:gd name="T7" fmla="*/ 270 h 291"/>
                <a:gd name="T8" fmla="*/ 260 w 1661"/>
                <a:gd name="T9" fmla="*/ 270 h 291"/>
                <a:gd name="T10" fmla="*/ 269 w 1661"/>
                <a:gd name="T11" fmla="*/ 246 h 291"/>
                <a:gd name="T12" fmla="*/ 289 w 1661"/>
                <a:gd name="T13" fmla="*/ 246 h 291"/>
                <a:gd name="T14" fmla="*/ 386 w 1661"/>
                <a:gd name="T15" fmla="*/ 246 h 291"/>
                <a:gd name="T16" fmla="*/ 492 w 1661"/>
                <a:gd name="T17" fmla="*/ 246 h 291"/>
                <a:gd name="T18" fmla="*/ 548 w 1661"/>
                <a:gd name="T19" fmla="*/ 246 h 291"/>
                <a:gd name="T20" fmla="*/ 579 w 1661"/>
                <a:gd name="T21" fmla="*/ 246 h 291"/>
                <a:gd name="T22" fmla="*/ 599 w 1661"/>
                <a:gd name="T23" fmla="*/ 220 h 291"/>
                <a:gd name="T24" fmla="*/ 669 w 1661"/>
                <a:gd name="T25" fmla="*/ 220 h 291"/>
                <a:gd name="T26" fmla="*/ 672 w 1661"/>
                <a:gd name="T27" fmla="*/ 192 h 291"/>
                <a:gd name="T28" fmla="*/ 741 w 1661"/>
                <a:gd name="T29" fmla="*/ 192 h 291"/>
                <a:gd name="T30" fmla="*/ 744 w 1661"/>
                <a:gd name="T31" fmla="*/ 164 h 291"/>
                <a:gd name="T32" fmla="*/ 802 w 1661"/>
                <a:gd name="T33" fmla="*/ 164 h 291"/>
                <a:gd name="T34" fmla="*/ 817 w 1661"/>
                <a:gd name="T35" fmla="*/ 135 h 291"/>
                <a:gd name="T36" fmla="*/ 860 w 1661"/>
                <a:gd name="T37" fmla="*/ 135 h 291"/>
                <a:gd name="T38" fmla="*/ 871 w 1661"/>
                <a:gd name="T39" fmla="*/ 106 h 291"/>
                <a:gd name="T40" fmla="*/ 889 w 1661"/>
                <a:gd name="T41" fmla="*/ 106 h 291"/>
                <a:gd name="T42" fmla="*/ 897 w 1661"/>
                <a:gd name="T43" fmla="*/ 74 h 291"/>
                <a:gd name="T44" fmla="*/ 916 w 1661"/>
                <a:gd name="T45" fmla="*/ 74 h 291"/>
                <a:gd name="T46" fmla="*/ 925 w 1661"/>
                <a:gd name="T47" fmla="*/ 42 h 291"/>
                <a:gd name="T48" fmla="*/ 960 w 1661"/>
                <a:gd name="T49" fmla="*/ 42 h 291"/>
                <a:gd name="T50" fmla="*/ 973 w 1661"/>
                <a:gd name="T51" fmla="*/ 42 h 291"/>
                <a:gd name="T52" fmla="*/ 1000 w 1661"/>
                <a:gd name="T53" fmla="*/ 42 h 291"/>
                <a:gd name="T54" fmla="*/ 1020 w 1661"/>
                <a:gd name="T55" fmla="*/ 42 h 291"/>
                <a:gd name="T56" fmla="*/ 1061 w 1661"/>
                <a:gd name="T57" fmla="*/ 42 h 291"/>
                <a:gd name="T58" fmla="*/ 1073 w 1661"/>
                <a:gd name="T59" fmla="*/ 0 h 291"/>
                <a:gd name="T60" fmla="*/ 1114 w 1661"/>
                <a:gd name="T61" fmla="*/ 0 h 291"/>
                <a:gd name="T62" fmla="*/ 1151 w 1661"/>
                <a:gd name="T63" fmla="*/ 0 h 291"/>
                <a:gd name="T64" fmla="*/ 1180 w 1661"/>
                <a:gd name="T65" fmla="*/ 0 h 291"/>
                <a:gd name="T66" fmla="*/ 1194 w 1661"/>
                <a:gd name="T67" fmla="*/ 0 h 291"/>
                <a:gd name="T68" fmla="*/ 1214 w 1661"/>
                <a:gd name="T69" fmla="*/ 0 h 291"/>
                <a:gd name="T70" fmla="*/ 1253 w 1661"/>
                <a:gd name="T71" fmla="*/ 0 h 291"/>
                <a:gd name="T72" fmla="*/ 1290 w 1661"/>
                <a:gd name="T73" fmla="*/ 0 h 291"/>
                <a:gd name="T74" fmla="*/ 1301 w 1661"/>
                <a:gd name="T75" fmla="*/ 0 h 291"/>
                <a:gd name="T76" fmla="*/ 1369 w 1661"/>
                <a:gd name="T77" fmla="*/ 0 h 291"/>
                <a:gd name="T78" fmla="*/ 1377 w 1661"/>
                <a:gd name="T79" fmla="*/ 0 h 291"/>
                <a:gd name="T80" fmla="*/ 1460 w 1661"/>
                <a:gd name="T81" fmla="*/ 0 h 291"/>
                <a:gd name="T82" fmla="*/ 1520 w 1661"/>
                <a:gd name="T83" fmla="*/ 0 h 291"/>
                <a:gd name="T84" fmla="*/ 1539 w 1661"/>
                <a:gd name="T85" fmla="*/ 0 h 291"/>
                <a:gd name="T86" fmla="*/ 1575 w 1661"/>
                <a:gd name="T87" fmla="*/ 0 h 291"/>
                <a:gd name="T88" fmla="*/ 1618 w 1661"/>
                <a:gd name="T89" fmla="*/ 0 h 291"/>
                <a:gd name="T90" fmla="*/ 1661 w 1661"/>
                <a:gd name="T91" fmla="*/ 0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1661" h="291">
                  <a:moveTo>
                    <a:pt x="0" y="291"/>
                  </a:moveTo>
                  <a:lnTo>
                    <a:pt x="111" y="291"/>
                  </a:lnTo>
                  <a:lnTo>
                    <a:pt x="111" y="270"/>
                  </a:lnTo>
                  <a:lnTo>
                    <a:pt x="129" y="270"/>
                  </a:lnTo>
                  <a:lnTo>
                    <a:pt x="148" y="270"/>
                  </a:lnTo>
                  <a:lnTo>
                    <a:pt x="164" y="270"/>
                  </a:lnTo>
                  <a:lnTo>
                    <a:pt x="185" y="270"/>
                  </a:lnTo>
                  <a:lnTo>
                    <a:pt x="205" y="270"/>
                  </a:lnTo>
                  <a:lnTo>
                    <a:pt x="214" y="270"/>
                  </a:lnTo>
                  <a:lnTo>
                    <a:pt x="260" y="270"/>
                  </a:lnTo>
                  <a:lnTo>
                    <a:pt x="269" y="270"/>
                  </a:lnTo>
                  <a:lnTo>
                    <a:pt x="269" y="246"/>
                  </a:lnTo>
                  <a:lnTo>
                    <a:pt x="280" y="246"/>
                  </a:lnTo>
                  <a:lnTo>
                    <a:pt x="289" y="246"/>
                  </a:lnTo>
                  <a:lnTo>
                    <a:pt x="361" y="246"/>
                  </a:lnTo>
                  <a:lnTo>
                    <a:pt x="386" y="246"/>
                  </a:lnTo>
                  <a:lnTo>
                    <a:pt x="390" y="246"/>
                  </a:lnTo>
                  <a:lnTo>
                    <a:pt x="492" y="246"/>
                  </a:lnTo>
                  <a:lnTo>
                    <a:pt x="520" y="246"/>
                  </a:lnTo>
                  <a:lnTo>
                    <a:pt x="548" y="246"/>
                  </a:lnTo>
                  <a:lnTo>
                    <a:pt x="568" y="246"/>
                  </a:lnTo>
                  <a:lnTo>
                    <a:pt x="579" y="246"/>
                  </a:lnTo>
                  <a:lnTo>
                    <a:pt x="599" y="246"/>
                  </a:lnTo>
                  <a:lnTo>
                    <a:pt x="599" y="220"/>
                  </a:lnTo>
                  <a:lnTo>
                    <a:pt x="635" y="220"/>
                  </a:lnTo>
                  <a:lnTo>
                    <a:pt x="669" y="220"/>
                  </a:lnTo>
                  <a:lnTo>
                    <a:pt x="669" y="192"/>
                  </a:lnTo>
                  <a:lnTo>
                    <a:pt x="672" y="192"/>
                  </a:lnTo>
                  <a:lnTo>
                    <a:pt x="729" y="192"/>
                  </a:lnTo>
                  <a:lnTo>
                    <a:pt x="741" y="192"/>
                  </a:lnTo>
                  <a:lnTo>
                    <a:pt x="744" y="192"/>
                  </a:lnTo>
                  <a:lnTo>
                    <a:pt x="744" y="164"/>
                  </a:lnTo>
                  <a:lnTo>
                    <a:pt x="786" y="164"/>
                  </a:lnTo>
                  <a:lnTo>
                    <a:pt x="802" y="164"/>
                  </a:lnTo>
                  <a:lnTo>
                    <a:pt x="802" y="135"/>
                  </a:lnTo>
                  <a:lnTo>
                    <a:pt x="817" y="135"/>
                  </a:lnTo>
                  <a:lnTo>
                    <a:pt x="824" y="135"/>
                  </a:lnTo>
                  <a:lnTo>
                    <a:pt x="860" y="135"/>
                  </a:lnTo>
                  <a:lnTo>
                    <a:pt x="860" y="106"/>
                  </a:lnTo>
                  <a:lnTo>
                    <a:pt x="871" y="106"/>
                  </a:lnTo>
                  <a:lnTo>
                    <a:pt x="877" y="106"/>
                  </a:lnTo>
                  <a:lnTo>
                    <a:pt x="889" y="106"/>
                  </a:lnTo>
                  <a:lnTo>
                    <a:pt x="897" y="106"/>
                  </a:lnTo>
                  <a:lnTo>
                    <a:pt x="897" y="74"/>
                  </a:lnTo>
                  <a:lnTo>
                    <a:pt x="905" y="74"/>
                  </a:lnTo>
                  <a:lnTo>
                    <a:pt x="916" y="74"/>
                  </a:lnTo>
                  <a:lnTo>
                    <a:pt x="925" y="74"/>
                  </a:lnTo>
                  <a:lnTo>
                    <a:pt x="925" y="42"/>
                  </a:lnTo>
                  <a:lnTo>
                    <a:pt x="951" y="42"/>
                  </a:lnTo>
                  <a:lnTo>
                    <a:pt x="960" y="42"/>
                  </a:lnTo>
                  <a:lnTo>
                    <a:pt x="967" y="42"/>
                  </a:lnTo>
                  <a:lnTo>
                    <a:pt x="973" y="42"/>
                  </a:lnTo>
                  <a:lnTo>
                    <a:pt x="984" y="42"/>
                  </a:lnTo>
                  <a:lnTo>
                    <a:pt x="1000" y="42"/>
                  </a:lnTo>
                  <a:lnTo>
                    <a:pt x="1005" y="42"/>
                  </a:lnTo>
                  <a:lnTo>
                    <a:pt x="1020" y="42"/>
                  </a:lnTo>
                  <a:lnTo>
                    <a:pt x="1030" y="42"/>
                  </a:lnTo>
                  <a:lnTo>
                    <a:pt x="1061" y="42"/>
                  </a:lnTo>
                  <a:lnTo>
                    <a:pt x="1070" y="42"/>
                  </a:lnTo>
                  <a:lnTo>
                    <a:pt x="1073" y="0"/>
                  </a:lnTo>
                  <a:lnTo>
                    <a:pt x="1096" y="0"/>
                  </a:lnTo>
                  <a:lnTo>
                    <a:pt x="1114" y="0"/>
                  </a:lnTo>
                  <a:lnTo>
                    <a:pt x="1136" y="0"/>
                  </a:lnTo>
                  <a:lnTo>
                    <a:pt x="1151" y="0"/>
                  </a:lnTo>
                  <a:lnTo>
                    <a:pt x="1161" y="0"/>
                  </a:lnTo>
                  <a:lnTo>
                    <a:pt x="1180" y="0"/>
                  </a:lnTo>
                  <a:lnTo>
                    <a:pt x="1186" y="0"/>
                  </a:lnTo>
                  <a:lnTo>
                    <a:pt x="1194" y="0"/>
                  </a:lnTo>
                  <a:lnTo>
                    <a:pt x="1203" y="0"/>
                  </a:lnTo>
                  <a:lnTo>
                    <a:pt x="1214" y="0"/>
                  </a:lnTo>
                  <a:lnTo>
                    <a:pt x="1237" y="0"/>
                  </a:lnTo>
                  <a:lnTo>
                    <a:pt x="1253" y="0"/>
                  </a:lnTo>
                  <a:lnTo>
                    <a:pt x="1261" y="0"/>
                  </a:lnTo>
                  <a:lnTo>
                    <a:pt x="1290" y="0"/>
                  </a:lnTo>
                  <a:lnTo>
                    <a:pt x="1296" y="0"/>
                  </a:lnTo>
                  <a:lnTo>
                    <a:pt x="1301" y="0"/>
                  </a:lnTo>
                  <a:lnTo>
                    <a:pt x="1326" y="0"/>
                  </a:lnTo>
                  <a:lnTo>
                    <a:pt x="1369" y="0"/>
                  </a:lnTo>
                  <a:lnTo>
                    <a:pt x="1373" y="0"/>
                  </a:lnTo>
                  <a:lnTo>
                    <a:pt x="1377" y="0"/>
                  </a:lnTo>
                  <a:lnTo>
                    <a:pt x="1390" y="0"/>
                  </a:lnTo>
                  <a:lnTo>
                    <a:pt x="1460" y="0"/>
                  </a:lnTo>
                  <a:lnTo>
                    <a:pt x="1490" y="0"/>
                  </a:lnTo>
                  <a:lnTo>
                    <a:pt x="1520" y="0"/>
                  </a:lnTo>
                  <a:lnTo>
                    <a:pt x="1535" y="0"/>
                  </a:lnTo>
                  <a:lnTo>
                    <a:pt x="1539" y="0"/>
                  </a:lnTo>
                  <a:lnTo>
                    <a:pt x="1558" y="0"/>
                  </a:lnTo>
                  <a:lnTo>
                    <a:pt x="1575" y="0"/>
                  </a:lnTo>
                  <a:lnTo>
                    <a:pt x="1596" y="0"/>
                  </a:lnTo>
                  <a:lnTo>
                    <a:pt x="1618" y="0"/>
                  </a:lnTo>
                  <a:lnTo>
                    <a:pt x="1647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D5D4D9D0-B751-03E5-EC8D-A42B8949A5D5}"/>
              </a:ext>
            </a:extLst>
          </p:cNvPr>
          <p:cNvGrpSpPr/>
          <p:nvPr/>
        </p:nvGrpSpPr>
        <p:grpSpPr>
          <a:xfrm>
            <a:off x="1200815" y="3651120"/>
            <a:ext cx="4141083" cy="2791354"/>
            <a:chOff x="1491095" y="3926886"/>
            <a:chExt cx="4141083" cy="2791354"/>
          </a:xfrm>
        </p:grpSpPr>
        <p:grpSp>
          <p:nvGrpSpPr>
            <p:cNvPr id="237" name="グループ化 236">
              <a:extLst>
                <a:ext uri="{FF2B5EF4-FFF2-40B4-BE49-F238E27FC236}">
                  <a16:creationId xmlns:a16="http://schemas.microsoft.com/office/drawing/2014/main" id="{A5CFDFD5-C528-AF0C-CA84-2A9A0B7A4D43}"/>
                </a:ext>
              </a:extLst>
            </p:cNvPr>
            <p:cNvGrpSpPr/>
            <p:nvPr/>
          </p:nvGrpSpPr>
          <p:grpSpPr>
            <a:xfrm>
              <a:off x="1491095" y="3926886"/>
              <a:ext cx="4141083" cy="2791354"/>
              <a:chOff x="1491095" y="3926886"/>
              <a:chExt cx="4141083" cy="2791354"/>
            </a:xfrm>
          </p:grpSpPr>
          <p:sp>
            <p:nvSpPr>
              <p:cNvPr id="146" name="Rectangle 22">
                <a:extLst>
                  <a:ext uri="{FF2B5EF4-FFF2-40B4-BE49-F238E27FC236}">
                    <a16:creationId xmlns:a16="http://schemas.microsoft.com/office/drawing/2014/main" id="{F8387F59-90E3-22D9-674A-D80F2E727A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1019" y="3933407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7" name="Line 23">
                <a:extLst>
                  <a:ext uri="{FF2B5EF4-FFF2-40B4-BE49-F238E27FC236}">
                    <a16:creationId xmlns:a16="http://schemas.microsoft.com/office/drawing/2014/main" id="{8F660B38-C356-0E43-ACAD-E5710A6826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5352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8" name="Line 25">
                <a:extLst>
                  <a:ext uri="{FF2B5EF4-FFF2-40B4-BE49-F238E27FC236}">
                    <a16:creationId xmlns:a16="http://schemas.microsoft.com/office/drawing/2014/main" id="{08BE6380-FE7D-4B4F-8EB1-57E96EAA23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8569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9" name="Line 27">
                <a:extLst>
                  <a:ext uri="{FF2B5EF4-FFF2-40B4-BE49-F238E27FC236}">
                    <a16:creationId xmlns:a16="http://schemas.microsoft.com/office/drawing/2014/main" id="{EC850244-69CD-121D-49E3-66B3147B78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91785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0" name="Line 29">
                <a:extLst>
                  <a:ext uri="{FF2B5EF4-FFF2-40B4-BE49-F238E27FC236}">
                    <a16:creationId xmlns:a16="http://schemas.microsoft.com/office/drawing/2014/main" id="{513501E1-7AAC-5D2D-1273-CD6285DE9A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3113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1" name="Line 31">
                <a:extLst>
                  <a:ext uri="{FF2B5EF4-FFF2-40B4-BE49-F238E27FC236}">
                    <a16:creationId xmlns:a16="http://schemas.microsoft.com/office/drawing/2014/main" id="{74967617-1923-FAAD-400B-22B1D5F55E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6330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2" name="Line 33">
                <a:extLst>
                  <a:ext uri="{FF2B5EF4-FFF2-40B4-BE49-F238E27FC236}">
                    <a16:creationId xmlns:a16="http://schemas.microsoft.com/office/drawing/2014/main" id="{944DBB85-1797-64C7-3FF2-B8BB70E024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9546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3" name="Line 35">
                <a:extLst>
                  <a:ext uri="{FF2B5EF4-FFF2-40B4-BE49-F238E27FC236}">
                    <a16:creationId xmlns:a16="http://schemas.microsoft.com/office/drawing/2014/main" id="{D814AC7B-CFED-FCF6-8BFB-D5EE63E99B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2763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4" name="Line 6">
                <a:extLst>
                  <a:ext uri="{FF2B5EF4-FFF2-40B4-BE49-F238E27FC236}">
                    <a16:creationId xmlns:a16="http://schemas.microsoft.com/office/drawing/2014/main" id="{A0EC68A3-26BA-8B73-C15D-EF6FC49B87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594718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5" name="Line 8">
                <a:extLst>
                  <a:ext uri="{FF2B5EF4-FFF2-40B4-BE49-F238E27FC236}">
                    <a16:creationId xmlns:a16="http://schemas.microsoft.com/office/drawing/2014/main" id="{EC0280D7-6ADD-CC2F-0B88-95FCB815BA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5539688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6" name="Line 9">
                <a:extLst>
                  <a:ext uri="{FF2B5EF4-FFF2-40B4-BE49-F238E27FC236}">
                    <a16:creationId xmlns:a16="http://schemas.microsoft.com/office/drawing/2014/main" id="{EA69896F-F9D9-B7F2-952E-08C47FC8D4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5132193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7" name="Line 11">
                <a:extLst>
                  <a:ext uri="{FF2B5EF4-FFF2-40B4-BE49-F238E27FC236}">
                    <a16:creationId xmlns:a16="http://schemas.microsoft.com/office/drawing/2014/main" id="{18DB1E96-AD4A-AA1B-5C2D-8B2E9995B3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4724698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8" name="Line 12">
                <a:extLst>
                  <a:ext uri="{FF2B5EF4-FFF2-40B4-BE49-F238E27FC236}">
                    <a16:creationId xmlns:a16="http://schemas.microsoft.com/office/drawing/2014/main" id="{595A27A6-6837-3E16-AA5C-C8FE7B83C1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4317203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9" name="Line 14">
                <a:extLst>
                  <a:ext uri="{FF2B5EF4-FFF2-40B4-BE49-F238E27FC236}">
                    <a16:creationId xmlns:a16="http://schemas.microsoft.com/office/drawing/2014/main" id="{963DD90A-75CE-BA4F-F5C5-30306D3F11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3933615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0" name="Line 23">
                <a:extLst>
                  <a:ext uri="{FF2B5EF4-FFF2-40B4-BE49-F238E27FC236}">
                    <a16:creationId xmlns:a16="http://schemas.microsoft.com/office/drawing/2014/main" id="{D2884F5F-5470-9CDD-6395-B0632887CF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7040" y="5947185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61" name="図形グループ 54">
                <a:extLst>
                  <a:ext uri="{FF2B5EF4-FFF2-40B4-BE49-F238E27FC236}">
                    <a16:creationId xmlns:a16="http://schemas.microsoft.com/office/drawing/2014/main" id="{DAA5A7E8-DC08-D2CC-A68E-8D50A0E23A42}"/>
                  </a:ext>
                </a:extLst>
              </p:cNvPr>
              <p:cNvGrpSpPr/>
              <p:nvPr/>
            </p:nvGrpSpPr>
            <p:grpSpPr>
              <a:xfrm>
                <a:off x="2037434" y="4188108"/>
                <a:ext cx="220989" cy="1868530"/>
                <a:chOff x="510218" y="1348283"/>
                <a:chExt cx="220989" cy="1868530"/>
              </a:xfrm>
            </p:grpSpPr>
            <p:sp>
              <p:nvSpPr>
                <p:cNvPr id="168" name="Rectangle 10">
                  <a:extLst>
                    <a:ext uri="{FF2B5EF4-FFF2-40B4-BE49-F238E27FC236}">
                      <a16:creationId xmlns:a16="http://schemas.microsoft.com/office/drawing/2014/main" id="{04B18B89-EB45-41FA-6767-D505B5AF25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69" name="Rectangle 13">
                  <a:extLst>
                    <a:ext uri="{FF2B5EF4-FFF2-40B4-BE49-F238E27FC236}">
                      <a16:creationId xmlns:a16="http://schemas.microsoft.com/office/drawing/2014/main" id="{A123525F-AA4E-9481-9187-4BCC019F95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70" name="Rectangle 10">
                  <a:extLst>
                    <a:ext uri="{FF2B5EF4-FFF2-40B4-BE49-F238E27FC236}">
                      <a16:creationId xmlns:a16="http://schemas.microsoft.com/office/drawing/2014/main" id="{B2216C31-71B4-61E1-EF34-40BD89A7E6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62" name="テキスト ボックス 161">
                <a:extLst>
                  <a:ext uri="{FF2B5EF4-FFF2-40B4-BE49-F238E27FC236}">
                    <a16:creationId xmlns:a16="http://schemas.microsoft.com/office/drawing/2014/main" id="{B0D4AA5E-BA4F-16E2-61DB-F9BADD33EDEC}"/>
                  </a:ext>
                </a:extLst>
              </p:cNvPr>
              <p:cNvSpPr txBox="1"/>
              <p:nvPr/>
            </p:nvSpPr>
            <p:spPr>
              <a:xfrm>
                <a:off x="2209901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E3220612-EDD0-EC5B-9A9E-5FC0E2FC4188}"/>
                  </a:ext>
                </a:extLst>
              </p:cNvPr>
              <p:cNvSpPr txBox="1"/>
              <p:nvPr/>
            </p:nvSpPr>
            <p:spPr>
              <a:xfrm>
                <a:off x="3254440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98C8FEAE-35D1-4824-B758-2DA60F197585}"/>
                  </a:ext>
                </a:extLst>
              </p:cNvPr>
              <p:cNvSpPr txBox="1"/>
              <p:nvPr/>
            </p:nvSpPr>
            <p:spPr>
              <a:xfrm>
                <a:off x="5343517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2F3EFF37-BFF0-6777-C6AC-42218627E01D}"/>
                  </a:ext>
                </a:extLst>
              </p:cNvPr>
              <p:cNvSpPr txBox="1"/>
              <p:nvPr/>
            </p:nvSpPr>
            <p:spPr>
              <a:xfrm>
                <a:off x="4298979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DFA09BA2-D80D-23ED-B13B-544DC9FA8CC4}"/>
                  </a:ext>
                </a:extLst>
              </p:cNvPr>
              <p:cNvSpPr txBox="1"/>
              <p:nvPr/>
            </p:nvSpPr>
            <p:spPr>
              <a:xfrm rot="16200000">
                <a:off x="608000" y="4809981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D2558AD1-564A-220A-57ED-8CA740F1401E}"/>
                  </a:ext>
                </a:extLst>
              </p:cNvPr>
              <p:cNvSpPr txBox="1"/>
              <p:nvPr/>
            </p:nvSpPr>
            <p:spPr>
              <a:xfrm>
                <a:off x="3112207" y="6348908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7" name="Freeform 93">
              <a:extLst>
                <a:ext uri="{FF2B5EF4-FFF2-40B4-BE49-F238E27FC236}">
                  <a16:creationId xmlns:a16="http://schemas.microsoft.com/office/drawing/2014/main" id="{0ABE71C9-FB6A-E8BB-F951-ADBDCC59934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809" y="4852156"/>
              <a:ext cx="3118956" cy="1096645"/>
            </a:xfrm>
            <a:custGeom>
              <a:avLst/>
              <a:gdLst>
                <a:gd name="T0" fmla="*/ 132 w 1661"/>
                <a:gd name="T1" fmla="*/ 594 h 594"/>
                <a:gd name="T2" fmla="*/ 164 w 1661"/>
                <a:gd name="T3" fmla="*/ 565 h 594"/>
                <a:gd name="T4" fmla="*/ 189 w 1661"/>
                <a:gd name="T5" fmla="*/ 565 h 594"/>
                <a:gd name="T6" fmla="*/ 233 w 1661"/>
                <a:gd name="T7" fmla="*/ 565 h 594"/>
                <a:gd name="T8" fmla="*/ 259 w 1661"/>
                <a:gd name="T9" fmla="*/ 565 h 594"/>
                <a:gd name="T10" fmla="*/ 302 w 1661"/>
                <a:gd name="T11" fmla="*/ 565 h 594"/>
                <a:gd name="T12" fmla="*/ 354 w 1661"/>
                <a:gd name="T13" fmla="*/ 565 h 594"/>
                <a:gd name="T14" fmla="*/ 414 w 1661"/>
                <a:gd name="T15" fmla="*/ 565 h 594"/>
                <a:gd name="T16" fmla="*/ 477 w 1661"/>
                <a:gd name="T17" fmla="*/ 565 h 594"/>
                <a:gd name="T18" fmla="*/ 482 w 1661"/>
                <a:gd name="T19" fmla="*/ 529 h 594"/>
                <a:gd name="T20" fmla="*/ 500 w 1661"/>
                <a:gd name="T21" fmla="*/ 529 h 594"/>
                <a:gd name="T22" fmla="*/ 554 w 1661"/>
                <a:gd name="T23" fmla="*/ 529 h 594"/>
                <a:gd name="T24" fmla="*/ 604 w 1661"/>
                <a:gd name="T25" fmla="*/ 489 h 594"/>
                <a:gd name="T26" fmla="*/ 651 w 1661"/>
                <a:gd name="T27" fmla="*/ 489 h 594"/>
                <a:gd name="T28" fmla="*/ 685 w 1661"/>
                <a:gd name="T29" fmla="*/ 489 h 594"/>
                <a:gd name="T30" fmla="*/ 714 w 1661"/>
                <a:gd name="T31" fmla="*/ 489 h 594"/>
                <a:gd name="T32" fmla="*/ 802 w 1661"/>
                <a:gd name="T33" fmla="*/ 489 h 594"/>
                <a:gd name="T34" fmla="*/ 860 w 1661"/>
                <a:gd name="T35" fmla="*/ 442 h 594"/>
                <a:gd name="T36" fmla="*/ 889 w 1661"/>
                <a:gd name="T37" fmla="*/ 394 h 594"/>
                <a:gd name="T38" fmla="*/ 921 w 1661"/>
                <a:gd name="T39" fmla="*/ 394 h 594"/>
                <a:gd name="T40" fmla="*/ 1011 w 1661"/>
                <a:gd name="T41" fmla="*/ 394 h 594"/>
                <a:gd name="T42" fmla="*/ 1030 w 1661"/>
                <a:gd name="T43" fmla="*/ 394 h 594"/>
                <a:gd name="T44" fmla="*/ 1062 w 1661"/>
                <a:gd name="T45" fmla="*/ 394 h 594"/>
                <a:gd name="T46" fmla="*/ 1136 w 1661"/>
                <a:gd name="T47" fmla="*/ 394 h 594"/>
                <a:gd name="T48" fmla="*/ 1162 w 1661"/>
                <a:gd name="T49" fmla="*/ 394 h 594"/>
                <a:gd name="T50" fmla="*/ 1210 w 1661"/>
                <a:gd name="T51" fmla="*/ 394 h 594"/>
                <a:gd name="T52" fmla="*/ 1297 w 1661"/>
                <a:gd name="T53" fmla="*/ 394 h 594"/>
                <a:gd name="T54" fmla="*/ 1340 w 1661"/>
                <a:gd name="T55" fmla="*/ 394 h 594"/>
                <a:gd name="T56" fmla="*/ 1369 w 1661"/>
                <a:gd name="T57" fmla="*/ 394 h 594"/>
                <a:gd name="T58" fmla="*/ 1406 w 1661"/>
                <a:gd name="T59" fmla="*/ 394 h 594"/>
                <a:gd name="T60" fmla="*/ 1443 w 1661"/>
                <a:gd name="T61" fmla="*/ 394 h 594"/>
                <a:gd name="T62" fmla="*/ 1480 w 1661"/>
                <a:gd name="T63" fmla="*/ 394 h 594"/>
                <a:gd name="T64" fmla="*/ 1502 w 1661"/>
                <a:gd name="T65" fmla="*/ 394 h 594"/>
                <a:gd name="T66" fmla="*/ 1541 w 1661"/>
                <a:gd name="T67" fmla="*/ 394 h 594"/>
                <a:gd name="T68" fmla="*/ 1599 w 1661"/>
                <a:gd name="T69" fmla="*/ 394 h 594"/>
                <a:gd name="T70" fmla="*/ 1618 w 1661"/>
                <a:gd name="T71" fmla="*/ 394 h 594"/>
                <a:gd name="T72" fmla="*/ 1661 w 1661"/>
                <a:gd name="T73" fmla="*/ 0 h 5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</a:cxnLst>
              <a:rect l="0" t="0" r="r" b="b"/>
              <a:pathLst>
                <a:path w="1661" h="594">
                  <a:moveTo>
                    <a:pt x="0" y="594"/>
                  </a:moveTo>
                  <a:lnTo>
                    <a:pt x="132" y="594"/>
                  </a:lnTo>
                  <a:lnTo>
                    <a:pt x="132" y="565"/>
                  </a:lnTo>
                  <a:lnTo>
                    <a:pt x="164" y="565"/>
                  </a:lnTo>
                  <a:lnTo>
                    <a:pt x="177" y="565"/>
                  </a:lnTo>
                  <a:lnTo>
                    <a:pt x="189" y="565"/>
                  </a:lnTo>
                  <a:lnTo>
                    <a:pt x="222" y="565"/>
                  </a:lnTo>
                  <a:lnTo>
                    <a:pt x="233" y="565"/>
                  </a:lnTo>
                  <a:lnTo>
                    <a:pt x="242" y="565"/>
                  </a:lnTo>
                  <a:lnTo>
                    <a:pt x="259" y="565"/>
                  </a:lnTo>
                  <a:lnTo>
                    <a:pt x="284" y="565"/>
                  </a:lnTo>
                  <a:lnTo>
                    <a:pt x="302" y="565"/>
                  </a:lnTo>
                  <a:lnTo>
                    <a:pt x="346" y="565"/>
                  </a:lnTo>
                  <a:lnTo>
                    <a:pt x="354" y="565"/>
                  </a:lnTo>
                  <a:lnTo>
                    <a:pt x="369" y="565"/>
                  </a:lnTo>
                  <a:lnTo>
                    <a:pt x="414" y="565"/>
                  </a:lnTo>
                  <a:lnTo>
                    <a:pt x="434" y="565"/>
                  </a:lnTo>
                  <a:lnTo>
                    <a:pt x="477" y="565"/>
                  </a:lnTo>
                  <a:lnTo>
                    <a:pt x="477" y="529"/>
                  </a:lnTo>
                  <a:lnTo>
                    <a:pt x="482" y="529"/>
                  </a:lnTo>
                  <a:lnTo>
                    <a:pt x="486" y="529"/>
                  </a:lnTo>
                  <a:lnTo>
                    <a:pt x="500" y="529"/>
                  </a:lnTo>
                  <a:lnTo>
                    <a:pt x="530" y="529"/>
                  </a:lnTo>
                  <a:lnTo>
                    <a:pt x="554" y="529"/>
                  </a:lnTo>
                  <a:lnTo>
                    <a:pt x="604" y="529"/>
                  </a:lnTo>
                  <a:lnTo>
                    <a:pt x="604" y="489"/>
                  </a:lnTo>
                  <a:lnTo>
                    <a:pt x="635" y="489"/>
                  </a:lnTo>
                  <a:lnTo>
                    <a:pt x="651" y="489"/>
                  </a:lnTo>
                  <a:lnTo>
                    <a:pt x="665" y="489"/>
                  </a:lnTo>
                  <a:lnTo>
                    <a:pt x="685" y="489"/>
                  </a:lnTo>
                  <a:lnTo>
                    <a:pt x="707" y="489"/>
                  </a:lnTo>
                  <a:lnTo>
                    <a:pt x="714" y="489"/>
                  </a:lnTo>
                  <a:lnTo>
                    <a:pt x="753" y="489"/>
                  </a:lnTo>
                  <a:lnTo>
                    <a:pt x="802" y="489"/>
                  </a:lnTo>
                  <a:lnTo>
                    <a:pt x="802" y="442"/>
                  </a:lnTo>
                  <a:lnTo>
                    <a:pt x="860" y="442"/>
                  </a:lnTo>
                  <a:lnTo>
                    <a:pt x="860" y="394"/>
                  </a:lnTo>
                  <a:lnTo>
                    <a:pt x="889" y="394"/>
                  </a:lnTo>
                  <a:lnTo>
                    <a:pt x="916" y="394"/>
                  </a:lnTo>
                  <a:lnTo>
                    <a:pt x="921" y="394"/>
                  </a:lnTo>
                  <a:lnTo>
                    <a:pt x="967" y="394"/>
                  </a:lnTo>
                  <a:lnTo>
                    <a:pt x="1011" y="394"/>
                  </a:lnTo>
                  <a:lnTo>
                    <a:pt x="1024" y="394"/>
                  </a:lnTo>
                  <a:lnTo>
                    <a:pt x="1030" y="394"/>
                  </a:lnTo>
                  <a:lnTo>
                    <a:pt x="1044" y="394"/>
                  </a:lnTo>
                  <a:lnTo>
                    <a:pt x="1062" y="394"/>
                  </a:lnTo>
                  <a:lnTo>
                    <a:pt x="1092" y="394"/>
                  </a:lnTo>
                  <a:lnTo>
                    <a:pt x="1136" y="394"/>
                  </a:lnTo>
                  <a:lnTo>
                    <a:pt x="1148" y="394"/>
                  </a:lnTo>
                  <a:lnTo>
                    <a:pt x="1162" y="394"/>
                  </a:lnTo>
                  <a:lnTo>
                    <a:pt x="1188" y="394"/>
                  </a:lnTo>
                  <a:lnTo>
                    <a:pt x="1210" y="394"/>
                  </a:lnTo>
                  <a:lnTo>
                    <a:pt x="1295" y="394"/>
                  </a:lnTo>
                  <a:lnTo>
                    <a:pt x="1297" y="394"/>
                  </a:lnTo>
                  <a:lnTo>
                    <a:pt x="1306" y="394"/>
                  </a:lnTo>
                  <a:lnTo>
                    <a:pt x="1340" y="394"/>
                  </a:lnTo>
                  <a:lnTo>
                    <a:pt x="1362" y="394"/>
                  </a:lnTo>
                  <a:lnTo>
                    <a:pt x="1369" y="394"/>
                  </a:lnTo>
                  <a:lnTo>
                    <a:pt x="1391" y="394"/>
                  </a:lnTo>
                  <a:lnTo>
                    <a:pt x="1406" y="394"/>
                  </a:lnTo>
                  <a:lnTo>
                    <a:pt x="1438" y="394"/>
                  </a:lnTo>
                  <a:lnTo>
                    <a:pt x="1443" y="394"/>
                  </a:lnTo>
                  <a:lnTo>
                    <a:pt x="1449" y="394"/>
                  </a:lnTo>
                  <a:lnTo>
                    <a:pt x="1480" y="394"/>
                  </a:lnTo>
                  <a:lnTo>
                    <a:pt x="1501" y="394"/>
                  </a:lnTo>
                  <a:lnTo>
                    <a:pt x="1502" y="394"/>
                  </a:lnTo>
                  <a:lnTo>
                    <a:pt x="1532" y="394"/>
                  </a:lnTo>
                  <a:lnTo>
                    <a:pt x="1541" y="394"/>
                  </a:lnTo>
                  <a:lnTo>
                    <a:pt x="1558" y="394"/>
                  </a:lnTo>
                  <a:lnTo>
                    <a:pt x="1599" y="394"/>
                  </a:lnTo>
                  <a:lnTo>
                    <a:pt x="1614" y="394"/>
                  </a:lnTo>
                  <a:lnTo>
                    <a:pt x="1618" y="394"/>
                  </a:lnTo>
                  <a:lnTo>
                    <a:pt x="1618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Freeform 94">
              <a:extLst>
                <a:ext uri="{FF2B5EF4-FFF2-40B4-BE49-F238E27FC236}">
                  <a16:creationId xmlns:a16="http://schemas.microsoft.com/office/drawing/2014/main" id="{B0C73063-15D7-0EF3-5692-00277F585ED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809" y="5389401"/>
              <a:ext cx="3118956" cy="559400"/>
            </a:xfrm>
            <a:custGeom>
              <a:avLst/>
              <a:gdLst>
                <a:gd name="T0" fmla="*/ 104 w 1661"/>
                <a:gd name="T1" fmla="*/ 303 h 303"/>
                <a:gd name="T2" fmla="*/ 148 w 1661"/>
                <a:gd name="T3" fmla="*/ 303 h 303"/>
                <a:gd name="T4" fmla="*/ 179 w 1661"/>
                <a:gd name="T5" fmla="*/ 303 h 303"/>
                <a:gd name="T6" fmla="*/ 205 w 1661"/>
                <a:gd name="T7" fmla="*/ 277 h 303"/>
                <a:gd name="T8" fmla="*/ 219 w 1661"/>
                <a:gd name="T9" fmla="*/ 277 h 303"/>
                <a:gd name="T10" fmla="*/ 247 w 1661"/>
                <a:gd name="T11" fmla="*/ 250 h 303"/>
                <a:gd name="T12" fmla="*/ 272 w 1661"/>
                <a:gd name="T13" fmla="*/ 224 h 303"/>
                <a:gd name="T14" fmla="*/ 361 w 1661"/>
                <a:gd name="T15" fmla="*/ 224 h 303"/>
                <a:gd name="T16" fmla="*/ 427 w 1661"/>
                <a:gd name="T17" fmla="*/ 224 h 303"/>
                <a:gd name="T18" fmla="*/ 458 w 1661"/>
                <a:gd name="T19" fmla="*/ 224 h 303"/>
                <a:gd name="T20" fmla="*/ 532 w 1661"/>
                <a:gd name="T21" fmla="*/ 224 h 303"/>
                <a:gd name="T22" fmla="*/ 548 w 1661"/>
                <a:gd name="T23" fmla="*/ 193 h 303"/>
                <a:gd name="T24" fmla="*/ 578 w 1661"/>
                <a:gd name="T25" fmla="*/ 193 h 303"/>
                <a:gd name="T26" fmla="*/ 599 w 1661"/>
                <a:gd name="T27" fmla="*/ 193 h 303"/>
                <a:gd name="T28" fmla="*/ 635 w 1661"/>
                <a:gd name="T29" fmla="*/ 161 h 303"/>
                <a:gd name="T30" fmla="*/ 719 w 1661"/>
                <a:gd name="T31" fmla="*/ 161 h 303"/>
                <a:gd name="T32" fmla="*/ 759 w 1661"/>
                <a:gd name="T33" fmla="*/ 127 h 303"/>
                <a:gd name="T34" fmla="*/ 778 w 1661"/>
                <a:gd name="T35" fmla="*/ 93 h 303"/>
                <a:gd name="T36" fmla="*/ 817 w 1661"/>
                <a:gd name="T37" fmla="*/ 93 h 303"/>
                <a:gd name="T38" fmla="*/ 832 w 1661"/>
                <a:gd name="T39" fmla="*/ 93 h 303"/>
                <a:gd name="T40" fmla="*/ 893 w 1661"/>
                <a:gd name="T41" fmla="*/ 93 h 303"/>
                <a:gd name="T42" fmla="*/ 897 w 1661"/>
                <a:gd name="T43" fmla="*/ 53 h 303"/>
                <a:gd name="T44" fmla="*/ 951 w 1661"/>
                <a:gd name="T45" fmla="*/ 53 h 303"/>
                <a:gd name="T46" fmla="*/ 984 w 1661"/>
                <a:gd name="T47" fmla="*/ 53 h 303"/>
                <a:gd name="T48" fmla="*/ 1003 w 1661"/>
                <a:gd name="T49" fmla="*/ 53 h 303"/>
                <a:gd name="T50" fmla="*/ 1052 w 1661"/>
                <a:gd name="T51" fmla="*/ 53 h 303"/>
                <a:gd name="T52" fmla="*/ 1096 w 1661"/>
                <a:gd name="T53" fmla="*/ 53 h 303"/>
                <a:gd name="T54" fmla="*/ 1099 w 1661"/>
                <a:gd name="T55" fmla="*/ 0 h 303"/>
                <a:gd name="T56" fmla="*/ 1129 w 1661"/>
                <a:gd name="T57" fmla="*/ 0 h 303"/>
                <a:gd name="T58" fmla="*/ 1253 w 1661"/>
                <a:gd name="T59" fmla="*/ 0 h 303"/>
                <a:gd name="T60" fmla="*/ 1311 w 1661"/>
                <a:gd name="T61" fmla="*/ 0 h 303"/>
                <a:gd name="T62" fmla="*/ 1332 w 1661"/>
                <a:gd name="T63" fmla="*/ 0 h 303"/>
                <a:gd name="T64" fmla="*/ 1377 w 1661"/>
                <a:gd name="T65" fmla="*/ 0 h 303"/>
                <a:gd name="T66" fmla="*/ 1419 w 1661"/>
                <a:gd name="T67" fmla="*/ 0 h 303"/>
                <a:gd name="T68" fmla="*/ 1437 w 1661"/>
                <a:gd name="T69" fmla="*/ 0 h 303"/>
                <a:gd name="T70" fmla="*/ 1489 w 1661"/>
                <a:gd name="T71" fmla="*/ 0 h 303"/>
                <a:gd name="T72" fmla="*/ 1539 w 1661"/>
                <a:gd name="T73" fmla="*/ 0 h 303"/>
                <a:gd name="T74" fmla="*/ 1582 w 1661"/>
                <a:gd name="T75" fmla="*/ 0 h 303"/>
                <a:gd name="T76" fmla="*/ 1603 w 1661"/>
                <a:gd name="T77" fmla="*/ 0 h 303"/>
                <a:gd name="T78" fmla="*/ 1647 w 1661"/>
                <a:gd name="T79" fmla="*/ 0 h 3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1661" h="303">
                  <a:moveTo>
                    <a:pt x="0" y="303"/>
                  </a:moveTo>
                  <a:lnTo>
                    <a:pt x="104" y="303"/>
                  </a:lnTo>
                  <a:lnTo>
                    <a:pt x="107" y="303"/>
                  </a:lnTo>
                  <a:lnTo>
                    <a:pt x="148" y="303"/>
                  </a:lnTo>
                  <a:lnTo>
                    <a:pt x="166" y="303"/>
                  </a:lnTo>
                  <a:lnTo>
                    <a:pt x="179" y="303"/>
                  </a:lnTo>
                  <a:lnTo>
                    <a:pt x="179" y="277"/>
                  </a:lnTo>
                  <a:lnTo>
                    <a:pt x="205" y="277"/>
                  </a:lnTo>
                  <a:lnTo>
                    <a:pt x="208" y="277"/>
                  </a:lnTo>
                  <a:lnTo>
                    <a:pt x="219" y="277"/>
                  </a:lnTo>
                  <a:lnTo>
                    <a:pt x="247" y="277"/>
                  </a:lnTo>
                  <a:lnTo>
                    <a:pt x="247" y="250"/>
                  </a:lnTo>
                  <a:lnTo>
                    <a:pt x="272" y="250"/>
                  </a:lnTo>
                  <a:lnTo>
                    <a:pt x="272" y="224"/>
                  </a:lnTo>
                  <a:lnTo>
                    <a:pt x="289" y="224"/>
                  </a:lnTo>
                  <a:lnTo>
                    <a:pt x="361" y="224"/>
                  </a:lnTo>
                  <a:lnTo>
                    <a:pt x="386" y="224"/>
                  </a:lnTo>
                  <a:lnTo>
                    <a:pt x="427" y="224"/>
                  </a:lnTo>
                  <a:lnTo>
                    <a:pt x="437" y="224"/>
                  </a:lnTo>
                  <a:lnTo>
                    <a:pt x="458" y="224"/>
                  </a:lnTo>
                  <a:lnTo>
                    <a:pt x="520" y="224"/>
                  </a:lnTo>
                  <a:lnTo>
                    <a:pt x="532" y="224"/>
                  </a:lnTo>
                  <a:lnTo>
                    <a:pt x="532" y="193"/>
                  </a:lnTo>
                  <a:lnTo>
                    <a:pt x="548" y="193"/>
                  </a:lnTo>
                  <a:lnTo>
                    <a:pt x="568" y="193"/>
                  </a:lnTo>
                  <a:lnTo>
                    <a:pt x="578" y="193"/>
                  </a:lnTo>
                  <a:lnTo>
                    <a:pt x="598" y="193"/>
                  </a:lnTo>
                  <a:lnTo>
                    <a:pt x="599" y="193"/>
                  </a:lnTo>
                  <a:lnTo>
                    <a:pt x="599" y="161"/>
                  </a:lnTo>
                  <a:lnTo>
                    <a:pt x="635" y="161"/>
                  </a:lnTo>
                  <a:lnTo>
                    <a:pt x="672" y="161"/>
                  </a:lnTo>
                  <a:lnTo>
                    <a:pt x="719" y="161"/>
                  </a:lnTo>
                  <a:lnTo>
                    <a:pt x="719" y="127"/>
                  </a:lnTo>
                  <a:lnTo>
                    <a:pt x="759" y="127"/>
                  </a:lnTo>
                  <a:lnTo>
                    <a:pt x="759" y="93"/>
                  </a:lnTo>
                  <a:lnTo>
                    <a:pt x="778" y="93"/>
                  </a:lnTo>
                  <a:lnTo>
                    <a:pt x="798" y="93"/>
                  </a:lnTo>
                  <a:lnTo>
                    <a:pt x="817" y="93"/>
                  </a:lnTo>
                  <a:lnTo>
                    <a:pt x="824" y="93"/>
                  </a:lnTo>
                  <a:lnTo>
                    <a:pt x="832" y="93"/>
                  </a:lnTo>
                  <a:lnTo>
                    <a:pt x="860" y="93"/>
                  </a:lnTo>
                  <a:lnTo>
                    <a:pt x="893" y="93"/>
                  </a:lnTo>
                  <a:lnTo>
                    <a:pt x="897" y="93"/>
                  </a:lnTo>
                  <a:lnTo>
                    <a:pt x="897" y="53"/>
                  </a:lnTo>
                  <a:lnTo>
                    <a:pt x="905" y="53"/>
                  </a:lnTo>
                  <a:lnTo>
                    <a:pt x="951" y="53"/>
                  </a:lnTo>
                  <a:lnTo>
                    <a:pt x="960" y="53"/>
                  </a:lnTo>
                  <a:lnTo>
                    <a:pt x="984" y="53"/>
                  </a:lnTo>
                  <a:lnTo>
                    <a:pt x="1000" y="53"/>
                  </a:lnTo>
                  <a:lnTo>
                    <a:pt x="1003" y="53"/>
                  </a:lnTo>
                  <a:lnTo>
                    <a:pt x="1020" y="53"/>
                  </a:lnTo>
                  <a:lnTo>
                    <a:pt x="1052" y="53"/>
                  </a:lnTo>
                  <a:lnTo>
                    <a:pt x="1070" y="53"/>
                  </a:lnTo>
                  <a:lnTo>
                    <a:pt x="1096" y="53"/>
                  </a:lnTo>
                  <a:lnTo>
                    <a:pt x="1099" y="53"/>
                  </a:lnTo>
                  <a:lnTo>
                    <a:pt x="1099" y="0"/>
                  </a:lnTo>
                  <a:lnTo>
                    <a:pt x="1107" y="0"/>
                  </a:lnTo>
                  <a:lnTo>
                    <a:pt x="1129" y="0"/>
                  </a:lnTo>
                  <a:lnTo>
                    <a:pt x="1136" y="0"/>
                  </a:lnTo>
                  <a:lnTo>
                    <a:pt x="1253" y="0"/>
                  </a:lnTo>
                  <a:lnTo>
                    <a:pt x="1298" y="0"/>
                  </a:lnTo>
                  <a:lnTo>
                    <a:pt x="1311" y="0"/>
                  </a:lnTo>
                  <a:lnTo>
                    <a:pt x="1326" y="0"/>
                  </a:lnTo>
                  <a:lnTo>
                    <a:pt x="1332" y="0"/>
                  </a:lnTo>
                  <a:lnTo>
                    <a:pt x="1337" y="0"/>
                  </a:lnTo>
                  <a:lnTo>
                    <a:pt x="1377" y="0"/>
                  </a:lnTo>
                  <a:lnTo>
                    <a:pt x="1390" y="0"/>
                  </a:lnTo>
                  <a:lnTo>
                    <a:pt x="1419" y="0"/>
                  </a:lnTo>
                  <a:lnTo>
                    <a:pt x="1435" y="0"/>
                  </a:lnTo>
                  <a:lnTo>
                    <a:pt x="1437" y="0"/>
                  </a:lnTo>
                  <a:lnTo>
                    <a:pt x="1460" y="0"/>
                  </a:lnTo>
                  <a:lnTo>
                    <a:pt x="1489" y="0"/>
                  </a:lnTo>
                  <a:lnTo>
                    <a:pt x="1520" y="0"/>
                  </a:lnTo>
                  <a:lnTo>
                    <a:pt x="1539" y="0"/>
                  </a:lnTo>
                  <a:lnTo>
                    <a:pt x="1571" y="0"/>
                  </a:lnTo>
                  <a:lnTo>
                    <a:pt x="1582" y="0"/>
                  </a:lnTo>
                  <a:lnTo>
                    <a:pt x="1596" y="0"/>
                  </a:lnTo>
                  <a:lnTo>
                    <a:pt x="1603" y="0"/>
                  </a:lnTo>
                  <a:lnTo>
                    <a:pt x="1618" y="0"/>
                  </a:lnTo>
                  <a:lnTo>
                    <a:pt x="1647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Freeform 95">
              <a:extLst>
                <a:ext uri="{FF2B5EF4-FFF2-40B4-BE49-F238E27FC236}">
                  <a16:creationId xmlns:a16="http://schemas.microsoft.com/office/drawing/2014/main" id="{7F3C3528-0285-5BA1-BFE2-B4F9A6B5CC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809" y="5156779"/>
              <a:ext cx="3118956" cy="792022"/>
            </a:xfrm>
            <a:custGeom>
              <a:avLst/>
              <a:gdLst>
                <a:gd name="T0" fmla="*/ 111 w 1661"/>
                <a:gd name="T1" fmla="*/ 429 h 429"/>
                <a:gd name="T2" fmla="*/ 129 w 1661"/>
                <a:gd name="T3" fmla="*/ 402 h 429"/>
                <a:gd name="T4" fmla="*/ 179 w 1661"/>
                <a:gd name="T5" fmla="*/ 402 h 429"/>
                <a:gd name="T6" fmla="*/ 196 w 1661"/>
                <a:gd name="T7" fmla="*/ 402 h 429"/>
                <a:gd name="T8" fmla="*/ 214 w 1661"/>
                <a:gd name="T9" fmla="*/ 402 h 429"/>
                <a:gd name="T10" fmla="*/ 269 w 1661"/>
                <a:gd name="T11" fmla="*/ 402 h 429"/>
                <a:gd name="T12" fmla="*/ 280 w 1661"/>
                <a:gd name="T13" fmla="*/ 371 h 429"/>
                <a:gd name="T14" fmla="*/ 390 w 1661"/>
                <a:gd name="T15" fmla="*/ 371 h 429"/>
                <a:gd name="T16" fmla="*/ 524 w 1661"/>
                <a:gd name="T17" fmla="*/ 371 h 429"/>
                <a:gd name="T18" fmla="*/ 551 w 1661"/>
                <a:gd name="T19" fmla="*/ 338 h 429"/>
                <a:gd name="T20" fmla="*/ 555 w 1661"/>
                <a:gd name="T21" fmla="*/ 306 h 429"/>
                <a:gd name="T22" fmla="*/ 579 w 1661"/>
                <a:gd name="T23" fmla="*/ 274 h 429"/>
                <a:gd name="T24" fmla="*/ 599 w 1661"/>
                <a:gd name="T25" fmla="*/ 241 h 429"/>
                <a:gd name="T26" fmla="*/ 637 w 1661"/>
                <a:gd name="T27" fmla="*/ 241 h 429"/>
                <a:gd name="T28" fmla="*/ 669 w 1661"/>
                <a:gd name="T29" fmla="*/ 241 h 429"/>
                <a:gd name="T30" fmla="*/ 702 w 1661"/>
                <a:gd name="T31" fmla="*/ 206 h 429"/>
                <a:gd name="T32" fmla="*/ 720 w 1661"/>
                <a:gd name="T33" fmla="*/ 171 h 429"/>
                <a:gd name="T34" fmla="*/ 741 w 1661"/>
                <a:gd name="T35" fmla="*/ 171 h 429"/>
                <a:gd name="T36" fmla="*/ 744 w 1661"/>
                <a:gd name="T37" fmla="*/ 135 h 429"/>
                <a:gd name="T38" fmla="*/ 773 w 1661"/>
                <a:gd name="T39" fmla="*/ 135 h 429"/>
                <a:gd name="T40" fmla="*/ 806 w 1661"/>
                <a:gd name="T41" fmla="*/ 135 h 429"/>
                <a:gd name="T42" fmla="*/ 838 w 1661"/>
                <a:gd name="T43" fmla="*/ 95 h 429"/>
                <a:gd name="T44" fmla="*/ 871 w 1661"/>
                <a:gd name="T45" fmla="*/ 95 h 429"/>
                <a:gd name="T46" fmla="*/ 925 w 1661"/>
                <a:gd name="T47" fmla="*/ 95 h 429"/>
                <a:gd name="T48" fmla="*/ 944 w 1661"/>
                <a:gd name="T49" fmla="*/ 53 h 429"/>
                <a:gd name="T50" fmla="*/ 980 w 1661"/>
                <a:gd name="T51" fmla="*/ 53 h 429"/>
                <a:gd name="T52" fmla="*/ 1011 w 1661"/>
                <a:gd name="T53" fmla="*/ 53 h 429"/>
                <a:gd name="T54" fmla="*/ 1061 w 1661"/>
                <a:gd name="T55" fmla="*/ 53 h 429"/>
                <a:gd name="T56" fmla="*/ 1073 w 1661"/>
                <a:gd name="T57" fmla="*/ 0 h 429"/>
                <a:gd name="T58" fmla="*/ 1107 w 1661"/>
                <a:gd name="T59" fmla="*/ 0 h 429"/>
                <a:gd name="T60" fmla="*/ 1139 w 1661"/>
                <a:gd name="T61" fmla="*/ 0 h 429"/>
                <a:gd name="T62" fmla="*/ 1189 w 1661"/>
                <a:gd name="T63" fmla="*/ 0 h 429"/>
                <a:gd name="T64" fmla="*/ 1216 w 1661"/>
                <a:gd name="T65" fmla="*/ 0 h 429"/>
                <a:gd name="T66" fmla="*/ 1243 w 1661"/>
                <a:gd name="T67" fmla="*/ 0 h 429"/>
                <a:gd name="T68" fmla="*/ 1290 w 1661"/>
                <a:gd name="T69" fmla="*/ 0 h 429"/>
                <a:gd name="T70" fmla="*/ 1336 w 1661"/>
                <a:gd name="T71" fmla="*/ 0 h 429"/>
                <a:gd name="T72" fmla="*/ 1410 w 1661"/>
                <a:gd name="T73" fmla="*/ 0 h 429"/>
                <a:gd name="T74" fmla="*/ 1479 w 1661"/>
                <a:gd name="T75" fmla="*/ 0 h 429"/>
                <a:gd name="T76" fmla="*/ 1535 w 1661"/>
                <a:gd name="T77" fmla="*/ 0 h 429"/>
                <a:gd name="T78" fmla="*/ 1562 w 1661"/>
                <a:gd name="T79" fmla="*/ 0 h 429"/>
                <a:gd name="T80" fmla="*/ 1583 w 1661"/>
                <a:gd name="T81" fmla="*/ 0 h 429"/>
                <a:gd name="T82" fmla="*/ 1619 w 1661"/>
                <a:gd name="T83" fmla="*/ 0 h 429"/>
                <a:gd name="T84" fmla="*/ 1661 w 1661"/>
                <a:gd name="T85" fmla="*/ 0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661" h="429">
                  <a:moveTo>
                    <a:pt x="0" y="429"/>
                  </a:moveTo>
                  <a:lnTo>
                    <a:pt x="111" y="429"/>
                  </a:lnTo>
                  <a:lnTo>
                    <a:pt x="111" y="402"/>
                  </a:lnTo>
                  <a:lnTo>
                    <a:pt x="129" y="402"/>
                  </a:lnTo>
                  <a:lnTo>
                    <a:pt x="153" y="402"/>
                  </a:lnTo>
                  <a:lnTo>
                    <a:pt x="179" y="402"/>
                  </a:lnTo>
                  <a:lnTo>
                    <a:pt x="185" y="402"/>
                  </a:lnTo>
                  <a:lnTo>
                    <a:pt x="196" y="402"/>
                  </a:lnTo>
                  <a:lnTo>
                    <a:pt x="205" y="402"/>
                  </a:lnTo>
                  <a:lnTo>
                    <a:pt x="214" y="402"/>
                  </a:lnTo>
                  <a:lnTo>
                    <a:pt x="243" y="402"/>
                  </a:lnTo>
                  <a:lnTo>
                    <a:pt x="269" y="402"/>
                  </a:lnTo>
                  <a:lnTo>
                    <a:pt x="269" y="371"/>
                  </a:lnTo>
                  <a:lnTo>
                    <a:pt x="280" y="371"/>
                  </a:lnTo>
                  <a:lnTo>
                    <a:pt x="300" y="371"/>
                  </a:lnTo>
                  <a:lnTo>
                    <a:pt x="390" y="371"/>
                  </a:lnTo>
                  <a:lnTo>
                    <a:pt x="492" y="371"/>
                  </a:lnTo>
                  <a:lnTo>
                    <a:pt x="524" y="371"/>
                  </a:lnTo>
                  <a:lnTo>
                    <a:pt x="524" y="338"/>
                  </a:lnTo>
                  <a:lnTo>
                    <a:pt x="551" y="338"/>
                  </a:lnTo>
                  <a:lnTo>
                    <a:pt x="551" y="306"/>
                  </a:lnTo>
                  <a:lnTo>
                    <a:pt x="555" y="306"/>
                  </a:lnTo>
                  <a:lnTo>
                    <a:pt x="555" y="274"/>
                  </a:lnTo>
                  <a:lnTo>
                    <a:pt x="579" y="274"/>
                  </a:lnTo>
                  <a:lnTo>
                    <a:pt x="579" y="241"/>
                  </a:lnTo>
                  <a:lnTo>
                    <a:pt x="599" y="241"/>
                  </a:lnTo>
                  <a:lnTo>
                    <a:pt x="625" y="241"/>
                  </a:lnTo>
                  <a:lnTo>
                    <a:pt x="637" y="241"/>
                  </a:lnTo>
                  <a:lnTo>
                    <a:pt x="662" y="241"/>
                  </a:lnTo>
                  <a:lnTo>
                    <a:pt x="669" y="241"/>
                  </a:lnTo>
                  <a:lnTo>
                    <a:pt x="669" y="206"/>
                  </a:lnTo>
                  <a:lnTo>
                    <a:pt x="702" y="206"/>
                  </a:lnTo>
                  <a:lnTo>
                    <a:pt x="702" y="171"/>
                  </a:lnTo>
                  <a:lnTo>
                    <a:pt x="720" y="171"/>
                  </a:lnTo>
                  <a:lnTo>
                    <a:pt x="729" y="171"/>
                  </a:lnTo>
                  <a:lnTo>
                    <a:pt x="741" y="171"/>
                  </a:lnTo>
                  <a:lnTo>
                    <a:pt x="744" y="171"/>
                  </a:lnTo>
                  <a:lnTo>
                    <a:pt x="744" y="135"/>
                  </a:lnTo>
                  <a:lnTo>
                    <a:pt x="766" y="135"/>
                  </a:lnTo>
                  <a:lnTo>
                    <a:pt x="773" y="135"/>
                  </a:lnTo>
                  <a:lnTo>
                    <a:pt x="786" y="135"/>
                  </a:lnTo>
                  <a:lnTo>
                    <a:pt x="806" y="135"/>
                  </a:lnTo>
                  <a:lnTo>
                    <a:pt x="806" y="95"/>
                  </a:lnTo>
                  <a:lnTo>
                    <a:pt x="838" y="95"/>
                  </a:lnTo>
                  <a:lnTo>
                    <a:pt x="862" y="95"/>
                  </a:lnTo>
                  <a:lnTo>
                    <a:pt x="871" y="95"/>
                  </a:lnTo>
                  <a:lnTo>
                    <a:pt x="877" y="95"/>
                  </a:lnTo>
                  <a:lnTo>
                    <a:pt x="925" y="95"/>
                  </a:lnTo>
                  <a:lnTo>
                    <a:pt x="925" y="53"/>
                  </a:lnTo>
                  <a:lnTo>
                    <a:pt x="944" y="53"/>
                  </a:lnTo>
                  <a:lnTo>
                    <a:pt x="971" y="53"/>
                  </a:lnTo>
                  <a:lnTo>
                    <a:pt x="980" y="53"/>
                  </a:lnTo>
                  <a:lnTo>
                    <a:pt x="989" y="53"/>
                  </a:lnTo>
                  <a:lnTo>
                    <a:pt x="1011" y="53"/>
                  </a:lnTo>
                  <a:lnTo>
                    <a:pt x="1028" y="53"/>
                  </a:lnTo>
                  <a:lnTo>
                    <a:pt x="1061" y="53"/>
                  </a:lnTo>
                  <a:lnTo>
                    <a:pt x="1073" y="53"/>
                  </a:lnTo>
                  <a:lnTo>
                    <a:pt x="1073" y="0"/>
                  </a:lnTo>
                  <a:lnTo>
                    <a:pt x="1096" y="0"/>
                  </a:lnTo>
                  <a:lnTo>
                    <a:pt x="1107" y="0"/>
                  </a:lnTo>
                  <a:lnTo>
                    <a:pt x="1114" y="0"/>
                  </a:lnTo>
                  <a:lnTo>
                    <a:pt x="1139" y="0"/>
                  </a:lnTo>
                  <a:lnTo>
                    <a:pt x="1161" y="0"/>
                  </a:lnTo>
                  <a:lnTo>
                    <a:pt x="1189" y="0"/>
                  </a:lnTo>
                  <a:lnTo>
                    <a:pt x="1203" y="0"/>
                  </a:lnTo>
                  <a:lnTo>
                    <a:pt x="1216" y="0"/>
                  </a:lnTo>
                  <a:lnTo>
                    <a:pt x="1237" y="0"/>
                  </a:lnTo>
                  <a:lnTo>
                    <a:pt x="1243" y="0"/>
                  </a:lnTo>
                  <a:lnTo>
                    <a:pt x="1261" y="0"/>
                  </a:lnTo>
                  <a:lnTo>
                    <a:pt x="1290" y="0"/>
                  </a:lnTo>
                  <a:lnTo>
                    <a:pt x="1301" y="0"/>
                  </a:lnTo>
                  <a:lnTo>
                    <a:pt x="1336" y="0"/>
                  </a:lnTo>
                  <a:lnTo>
                    <a:pt x="1400" y="0"/>
                  </a:lnTo>
                  <a:lnTo>
                    <a:pt x="1410" y="0"/>
                  </a:lnTo>
                  <a:lnTo>
                    <a:pt x="1477" y="0"/>
                  </a:lnTo>
                  <a:lnTo>
                    <a:pt x="1479" y="0"/>
                  </a:lnTo>
                  <a:lnTo>
                    <a:pt x="1490" y="0"/>
                  </a:lnTo>
                  <a:lnTo>
                    <a:pt x="1535" y="0"/>
                  </a:lnTo>
                  <a:lnTo>
                    <a:pt x="1557" y="0"/>
                  </a:lnTo>
                  <a:lnTo>
                    <a:pt x="1562" y="0"/>
                  </a:lnTo>
                  <a:lnTo>
                    <a:pt x="1575" y="0"/>
                  </a:lnTo>
                  <a:lnTo>
                    <a:pt x="1583" y="0"/>
                  </a:lnTo>
                  <a:lnTo>
                    <a:pt x="1596" y="0"/>
                  </a:lnTo>
                  <a:lnTo>
                    <a:pt x="1619" y="0"/>
                  </a:lnTo>
                  <a:lnTo>
                    <a:pt x="1645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AC99AEC3-1964-C434-F2E0-0705A7A7D4C4}"/>
              </a:ext>
            </a:extLst>
          </p:cNvPr>
          <p:cNvGrpSpPr/>
          <p:nvPr/>
        </p:nvGrpSpPr>
        <p:grpSpPr>
          <a:xfrm>
            <a:off x="6319428" y="3657844"/>
            <a:ext cx="4141083" cy="2791354"/>
            <a:chOff x="6609708" y="3933610"/>
            <a:chExt cx="4141083" cy="2791354"/>
          </a:xfrm>
        </p:grpSpPr>
        <p:grpSp>
          <p:nvGrpSpPr>
            <p:cNvPr id="238" name="グループ化 237">
              <a:extLst>
                <a:ext uri="{FF2B5EF4-FFF2-40B4-BE49-F238E27FC236}">
                  <a16:creationId xmlns:a16="http://schemas.microsoft.com/office/drawing/2014/main" id="{6B300AF1-6B55-2DF3-B1F3-F463643BCFE1}"/>
                </a:ext>
              </a:extLst>
            </p:cNvPr>
            <p:cNvGrpSpPr/>
            <p:nvPr/>
          </p:nvGrpSpPr>
          <p:grpSpPr>
            <a:xfrm>
              <a:off x="6609708" y="3933610"/>
              <a:ext cx="4141083" cy="2791354"/>
              <a:chOff x="6609708" y="3933610"/>
              <a:chExt cx="4141083" cy="2791354"/>
            </a:xfrm>
          </p:grpSpPr>
          <p:sp>
            <p:nvSpPr>
              <p:cNvPr id="120" name="Rectangle 22">
                <a:extLst>
                  <a:ext uri="{FF2B5EF4-FFF2-40B4-BE49-F238E27FC236}">
                    <a16:creationId xmlns:a16="http://schemas.microsoft.com/office/drawing/2014/main" id="{1838B9FE-F8D4-AC5A-2FD0-E12E20C52E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9632" y="3940131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1" name="Line 23">
                <a:extLst>
                  <a:ext uri="{FF2B5EF4-FFF2-40B4-BE49-F238E27FC236}">
                    <a16:creationId xmlns:a16="http://schemas.microsoft.com/office/drawing/2014/main" id="{8B26A866-29A4-F543-962B-A9D019825C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63965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2" name="Line 25">
                <a:extLst>
                  <a:ext uri="{FF2B5EF4-FFF2-40B4-BE49-F238E27FC236}">
                    <a16:creationId xmlns:a16="http://schemas.microsoft.com/office/drawing/2014/main" id="{5C5B984E-8395-78DF-BDB1-DEAA2AA3B1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87182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3" name="Line 27">
                <a:extLst>
                  <a:ext uri="{FF2B5EF4-FFF2-40B4-BE49-F238E27FC236}">
                    <a16:creationId xmlns:a16="http://schemas.microsoft.com/office/drawing/2014/main" id="{642F76FD-7E61-4E59-F6B9-7D1DE33A8D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510398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4" name="Line 29">
                <a:extLst>
                  <a:ext uri="{FF2B5EF4-FFF2-40B4-BE49-F238E27FC236}">
                    <a16:creationId xmlns:a16="http://schemas.microsoft.com/office/drawing/2014/main" id="{ACFAFBD1-4EAA-B8C3-338A-266E0DD86A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1726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5" name="Line 31">
                <a:extLst>
                  <a:ext uri="{FF2B5EF4-FFF2-40B4-BE49-F238E27FC236}">
                    <a16:creationId xmlns:a16="http://schemas.microsoft.com/office/drawing/2014/main" id="{2FFBEF8C-A2BB-3B74-4AA1-51E74EAE0B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54943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6" name="Line 33">
                <a:extLst>
                  <a:ext uri="{FF2B5EF4-FFF2-40B4-BE49-F238E27FC236}">
                    <a16:creationId xmlns:a16="http://schemas.microsoft.com/office/drawing/2014/main" id="{0A155B83-5CB6-BC4E-B1BA-B1995754D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78159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7" name="Line 35">
                <a:extLst>
                  <a:ext uri="{FF2B5EF4-FFF2-40B4-BE49-F238E27FC236}">
                    <a16:creationId xmlns:a16="http://schemas.microsoft.com/office/drawing/2014/main" id="{542A0862-7BB7-96CD-EA65-902C8C049E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01376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8" name="Line 6">
                <a:extLst>
                  <a:ext uri="{FF2B5EF4-FFF2-40B4-BE49-F238E27FC236}">
                    <a16:creationId xmlns:a16="http://schemas.microsoft.com/office/drawing/2014/main" id="{B0A9B99C-6306-078C-AB2E-B9B7267F8E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5953908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9" name="Line 8">
                <a:extLst>
                  <a:ext uri="{FF2B5EF4-FFF2-40B4-BE49-F238E27FC236}">
                    <a16:creationId xmlns:a16="http://schemas.microsoft.com/office/drawing/2014/main" id="{CBC2C354-D538-EC1E-018E-D79A9329CC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554641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0" name="Line 9">
                <a:extLst>
                  <a:ext uri="{FF2B5EF4-FFF2-40B4-BE49-F238E27FC236}">
                    <a16:creationId xmlns:a16="http://schemas.microsoft.com/office/drawing/2014/main" id="{1EC8F8B0-5F55-9CE6-10CC-2DA4508431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513891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1" name="Line 11">
                <a:extLst>
                  <a:ext uri="{FF2B5EF4-FFF2-40B4-BE49-F238E27FC236}">
                    <a16:creationId xmlns:a16="http://schemas.microsoft.com/office/drawing/2014/main" id="{AAEDA363-1454-9FFF-7747-DC060D572E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473142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2" name="Line 12">
                <a:extLst>
                  <a:ext uri="{FF2B5EF4-FFF2-40B4-BE49-F238E27FC236}">
                    <a16:creationId xmlns:a16="http://schemas.microsoft.com/office/drawing/2014/main" id="{0A26C4A2-EE72-09BB-B348-261FA17B53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432392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3" name="Line 14">
                <a:extLst>
                  <a:ext uri="{FF2B5EF4-FFF2-40B4-BE49-F238E27FC236}">
                    <a16:creationId xmlns:a16="http://schemas.microsoft.com/office/drawing/2014/main" id="{6A52C521-A0E8-2101-0701-E7D969C45B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394033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4" name="Line 23">
                <a:extLst>
                  <a:ext uri="{FF2B5EF4-FFF2-40B4-BE49-F238E27FC236}">
                    <a16:creationId xmlns:a16="http://schemas.microsoft.com/office/drawing/2014/main" id="{A4C7B481-EB61-10FE-1936-75724AF5B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65653" y="5953909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35" name="図形グループ 54">
                <a:extLst>
                  <a:ext uri="{FF2B5EF4-FFF2-40B4-BE49-F238E27FC236}">
                    <a16:creationId xmlns:a16="http://schemas.microsoft.com/office/drawing/2014/main" id="{DDF5EE13-DE3C-C916-A17D-A1799195D072}"/>
                  </a:ext>
                </a:extLst>
              </p:cNvPr>
              <p:cNvGrpSpPr/>
              <p:nvPr/>
            </p:nvGrpSpPr>
            <p:grpSpPr>
              <a:xfrm>
                <a:off x="7156047" y="4194832"/>
                <a:ext cx="220989" cy="1868530"/>
                <a:chOff x="510218" y="1348283"/>
                <a:chExt cx="220989" cy="1868530"/>
              </a:xfrm>
            </p:grpSpPr>
            <p:sp>
              <p:nvSpPr>
                <p:cNvPr id="142" name="Rectangle 10">
                  <a:extLst>
                    <a:ext uri="{FF2B5EF4-FFF2-40B4-BE49-F238E27FC236}">
                      <a16:creationId xmlns:a16="http://schemas.microsoft.com/office/drawing/2014/main" id="{25AC9329-2D5A-C9FF-E92B-5ED72AB63F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3" name="Rectangle 13">
                  <a:extLst>
                    <a:ext uri="{FF2B5EF4-FFF2-40B4-BE49-F238E27FC236}">
                      <a16:creationId xmlns:a16="http://schemas.microsoft.com/office/drawing/2014/main" id="{B8F08616-DA6F-E7A0-2CC8-1F2205FD3D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4" name="Rectangle 10">
                  <a:extLst>
                    <a:ext uri="{FF2B5EF4-FFF2-40B4-BE49-F238E27FC236}">
                      <a16:creationId xmlns:a16="http://schemas.microsoft.com/office/drawing/2014/main" id="{74C2AC60-FDBF-B5B2-AB94-35AA396403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E1F98BB6-B268-73FA-CD97-E428D5595D49}"/>
                  </a:ext>
                </a:extLst>
              </p:cNvPr>
              <p:cNvSpPr txBox="1"/>
              <p:nvPr/>
            </p:nvSpPr>
            <p:spPr>
              <a:xfrm>
                <a:off x="7328514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836B5292-5EA9-1754-7B76-E294AA883837}"/>
                  </a:ext>
                </a:extLst>
              </p:cNvPr>
              <p:cNvSpPr txBox="1"/>
              <p:nvPr/>
            </p:nvSpPr>
            <p:spPr>
              <a:xfrm>
                <a:off x="8373053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E506B1AD-0860-1879-1870-F17292AF5315}"/>
                  </a:ext>
                </a:extLst>
              </p:cNvPr>
              <p:cNvSpPr txBox="1"/>
              <p:nvPr/>
            </p:nvSpPr>
            <p:spPr>
              <a:xfrm>
                <a:off x="10462130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E3A09071-C257-2CC4-5A5D-DA1F160CA680}"/>
                  </a:ext>
                </a:extLst>
              </p:cNvPr>
              <p:cNvSpPr txBox="1"/>
              <p:nvPr/>
            </p:nvSpPr>
            <p:spPr>
              <a:xfrm>
                <a:off x="9417592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03E6B8F5-D83C-EF94-C8FB-B0256C6C9A9E}"/>
                  </a:ext>
                </a:extLst>
              </p:cNvPr>
              <p:cNvSpPr txBox="1"/>
              <p:nvPr/>
            </p:nvSpPr>
            <p:spPr>
              <a:xfrm rot="16200000">
                <a:off x="5726613" y="4816705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C589EBFE-257A-D19D-2ADB-1A6C8886FB7B}"/>
                  </a:ext>
                </a:extLst>
              </p:cNvPr>
              <p:cNvSpPr txBox="1"/>
              <p:nvPr/>
            </p:nvSpPr>
            <p:spPr>
              <a:xfrm>
                <a:off x="8230820" y="6355632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3" name="Freeform 130">
              <a:extLst>
                <a:ext uri="{FF2B5EF4-FFF2-40B4-BE49-F238E27FC236}">
                  <a16:creationId xmlns:a16="http://schemas.microsoft.com/office/drawing/2014/main" id="{79417492-CAFE-85DF-0452-C81C868B3C32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5460" y="4239949"/>
              <a:ext cx="3117641" cy="1720446"/>
            </a:xfrm>
            <a:custGeom>
              <a:avLst/>
              <a:gdLst>
                <a:gd name="T0" fmla="*/ 0 w 1661"/>
                <a:gd name="T1" fmla="*/ 931 h 931"/>
                <a:gd name="T2" fmla="*/ 132 w 1661"/>
                <a:gd name="T3" fmla="*/ 931 h 931"/>
                <a:gd name="T4" fmla="*/ 132 w 1661"/>
                <a:gd name="T5" fmla="*/ 881 h 931"/>
                <a:gd name="T6" fmla="*/ 185 w 1661"/>
                <a:gd name="T7" fmla="*/ 881 h 931"/>
                <a:gd name="T8" fmla="*/ 222 w 1661"/>
                <a:gd name="T9" fmla="*/ 881 h 931"/>
                <a:gd name="T10" fmla="*/ 233 w 1661"/>
                <a:gd name="T11" fmla="*/ 881 h 931"/>
                <a:gd name="T12" fmla="*/ 243 w 1661"/>
                <a:gd name="T13" fmla="*/ 881 h 931"/>
                <a:gd name="T14" fmla="*/ 259 w 1661"/>
                <a:gd name="T15" fmla="*/ 881 h 931"/>
                <a:gd name="T16" fmla="*/ 302 w 1661"/>
                <a:gd name="T17" fmla="*/ 881 h 931"/>
                <a:gd name="T18" fmla="*/ 369 w 1661"/>
                <a:gd name="T19" fmla="*/ 881 h 931"/>
                <a:gd name="T20" fmla="*/ 414 w 1661"/>
                <a:gd name="T21" fmla="*/ 881 h 931"/>
                <a:gd name="T22" fmla="*/ 477 w 1661"/>
                <a:gd name="T23" fmla="*/ 881 h 931"/>
                <a:gd name="T24" fmla="*/ 477 w 1661"/>
                <a:gd name="T25" fmla="*/ 818 h 931"/>
                <a:gd name="T26" fmla="*/ 486 w 1661"/>
                <a:gd name="T27" fmla="*/ 818 h 931"/>
                <a:gd name="T28" fmla="*/ 492 w 1661"/>
                <a:gd name="T29" fmla="*/ 818 h 931"/>
                <a:gd name="T30" fmla="*/ 551 w 1661"/>
                <a:gd name="T31" fmla="*/ 818 h 931"/>
                <a:gd name="T32" fmla="*/ 551 w 1661"/>
                <a:gd name="T33" fmla="*/ 752 h 931"/>
                <a:gd name="T34" fmla="*/ 579 w 1661"/>
                <a:gd name="T35" fmla="*/ 752 h 931"/>
                <a:gd name="T36" fmla="*/ 579 w 1661"/>
                <a:gd name="T37" fmla="*/ 686 h 931"/>
                <a:gd name="T38" fmla="*/ 604 w 1661"/>
                <a:gd name="T39" fmla="*/ 686 h 931"/>
                <a:gd name="T40" fmla="*/ 604 w 1661"/>
                <a:gd name="T41" fmla="*/ 619 h 931"/>
                <a:gd name="T42" fmla="*/ 637 w 1661"/>
                <a:gd name="T43" fmla="*/ 619 h 931"/>
                <a:gd name="T44" fmla="*/ 651 w 1661"/>
                <a:gd name="T45" fmla="*/ 619 h 931"/>
                <a:gd name="T46" fmla="*/ 662 w 1661"/>
                <a:gd name="T47" fmla="*/ 619 h 931"/>
                <a:gd name="T48" fmla="*/ 665 w 1661"/>
                <a:gd name="T49" fmla="*/ 619 h 931"/>
                <a:gd name="T50" fmla="*/ 714 w 1661"/>
                <a:gd name="T51" fmla="*/ 619 h 931"/>
                <a:gd name="T52" fmla="*/ 766 w 1661"/>
                <a:gd name="T53" fmla="*/ 619 h 931"/>
                <a:gd name="T54" fmla="*/ 773 w 1661"/>
                <a:gd name="T55" fmla="*/ 619 h 931"/>
                <a:gd name="T56" fmla="*/ 905 w 1661"/>
                <a:gd name="T57" fmla="*/ 619 h 931"/>
                <a:gd name="T58" fmla="*/ 971 w 1661"/>
                <a:gd name="T59" fmla="*/ 619 h 931"/>
                <a:gd name="T60" fmla="*/ 1011 w 1661"/>
                <a:gd name="T61" fmla="*/ 619 h 931"/>
                <a:gd name="T62" fmla="*/ 1044 w 1661"/>
                <a:gd name="T63" fmla="*/ 619 h 931"/>
                <a:gd name="T64" fmla="*/ 1148 w 1661"/>
                <a:gd name="T65" fmla="*/ 619 h 931"/>
                <a:gd name="T66" fmla="*/ 1203 w 1661"/>
                <a:gd name="T67" fmla="*/ 619 h 931"/>
                <a:gd name="T68" fmla="*/ 1210 w 1661"/>
                <a:gd name="T69" fmla="*/ 619 h 931"/>
                <a:gd name="T70" fmla="*/ 1322 w 1661"/>
                <a:gd name="T71" fmla="*/ 619 h 931"/>
                <a:gd name="T72" fmla="*/ 1410 w 1661"/>
                <a:gd name="T73" fmla="*/ 619 h 931"/>
                <a:gd name="T74" fmla="*/ 1479 w 1661"/>
                <a:gd name="T75" fmla="*/ 619 h 931"/>
                <a:gd name="T76" fmla="*/ 1503 w 1661"/>
                <a:gd name="T77" fmla="*/ 619 h 931"/>
                <a:gd name="T78" fmla="*/ 1526 w 1661"/>
                <a:gd name="T79" fmla="*/ 619 h 931"/>
                <a:gd name="T80" fmla="*/ 1532 w 1661"/>
                <a:gd name="T81" fmla="*/ 619 h 931"/>
                <a:gd name="T82" fmla="*/ 1562 w 1661"/>
                <a:gd name="T83" fmla="*/ 619 h 931"/>
                <a:gd name="T84" fmla="*/ 1596 w 1661"/>
                <a:gd name="T85" fmla="*/ 619 h 931"/>
                <a:gd name="T86" fmla="*/ 1599 w 1661"/>
                <a:gd name="T87" fmla="*/ 619 h 931"/>
                <a:gd name="T88" fmla="*/ 1614 w 1661"/>
                <a:gd name="T89" fmla="*/ 619 h 931"/>
                <a:gd name="T90" fmla="*/ 1618 w 1661"/>
                <a:gd name="T91" fmla="*/ 619 h 931"/>
                <a:gd name="T92" fmla="*/ 1618 w 1661"/>
                <a:gd name="T93" fmla="*/ 0 h 931"/>
                <a:gd name="T94" fmla="*/ 1661 w 1661"/>
                <a:gd name="T95" fmla="*/ 0 h 9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661" h="931">
                  <a:moveTo>
                    <a:pt x="0" y="931"/>
                  </a:moveTo>
                  <a:lnTo>
                    <a:pt x="132" y="931"/>
                  </a:lnTo>
                  <a:lnTo>
                    <a:pt x="132" y="881"/>
                  </a:lnTo>
                  <a:lnTo>
                    <a:pt x="185" y="881"/>
                  </a:lnTo>
                  <a:lnTo>
                    <a:pt x="222" y="881"/>
                  </a:lnTo>
                  <a:lnTo>
                    <a:pt x="233" y="881"/>
                  </a:lnTo>
                  <a:lnTo>
                    <a:pt x="243" y="881"/>
                  </a:lnTo>
                  <a:lnTo>
                    <a:pt x="259" y="881"/>
                  </a:lnTo>
                  <a:lnTo>
                    <a:pt x="302" y="881"/>
                  </a:lnTo>
                  <a:lnTo>
                    <a:pt x="369" y="881"/>
                  </a:lnTo>
                  <a:lnTo>
                    <a:pt x="414" y="881"/>
                  </a:lnTo>
                  <a:lnTo>
                    <a:pt x="477" y="881"/>
                  </a:lnTo>
                  <a:lnTo>
                    <a:pt x="477" y="818"/>
                  </a:lnTo>
                  <a:lnTo>
                    <a:pt x="486" y="818"/>
                  </a:lnTo>
                  <a:lnTo>
                    <a:pt x="492" y="818"/>
                  </a:lnTo>
                  <a:lnTo>
                    <a:pt x="551" y="818"/>
                  </a:lnTo>
                  <a:lnTo>
                    <a:pt x="551" y="752"/>
                  </a:lnTo>
                  <a:lnTo>
                    <a:pt x="579" y="752"/>
                  </a:lnTo>
                  <a:lnTo>
                    <a:pt x="579" y="686"/>
                  </a:lnTo>
                  <a:lnTo>
                    <a:pt x="604" y="686"/>
                  </a:lnTo>
                  <a:lnTo>
                    <a:pt x="604" y="619"/>
                  </a:lnTo>
                  <a:lnTo>
                    <a:pt x="637" y="619"/>
                  </a:lnTo>
                  <a:lnTo>
                    <a:pt x="651" y="619"/>
                  </a:lnTo>
                  <a:lnTo>
                    <a:pt x="662" y="619"/>
                  </a:lnTo>
                  <a:lnTo>
                    <a:pt x="665" y="619"/>
                  </a:lnTo>
                  <a:lnTo>
                    <a:pt x="714" y="619"/>
                  </a:lnTo>
                  <a:lnTo>
                    <a:pt x="766" y="619"/>
                  </a:lnTo>
                  <a:lnTo>
                    <a:pt x="773" y="619"/>
                  </a:lnTo>
                  <a:lnTo>
                    <a:pt x="905" y="619"/>
                  </a:lnTo>
                  <a:lnTo>
                    <a:pt x="971" y="619"/>
                  </a:lnTo>
                  <a:lnTo>
                    <a:pt x="1011" y="619"/>
                  </a:lnTo>
                  <a:lnTo>
                    <a:pt x="1044" y="619"/>
                  </a:lnTo>
                  <a:lnTo>
                    <a:pt x="1148" y="619"/>
                  </a:lnTo>
                  <a:lnTo>
                    <a:pt x="1203" y="619"/>
                  </a:lnTo>
                  <a:lnTo>
                    <a:pt x="1210" y="619"/>
                  </a:lnTo>
                  <a:lnTo>
                    <a:pt x="1322" y="619"/>
                  </a:lnTo>
                  <a:lnTo>
                    <a:pt x="1410" y="619"/>
                  </a:lnTo>
                  <a:lnTo>
                    <a:pt x="1479" y="619"/>
                  </a:lnTo>
                  <a:lnTo>
                    <a:pt x="1503" y="619"/>
                  </a:lnTo>
                  <a:lnTo>
                    <a:pt x="1526" y="619"/>
                  </a:lnTo>
                  <a:lnTo>
                    <a:pt x="1532" y="619"/>
                  </a:lnTo>
                  <a:lnTo>
                    <a:pt x="1562" y="619"/>
                  </a:lnTo>
                  <a:lnTo>
                    <a:pt x="1596" y="619"/>
                  </a:lnTo>
                  <a:lnTo>
                    <a:pt x="1599" y="619"/>
                  </a:lnTo>
                  <a:lnTo>
                    <a:pt x="1614" y="619"/>
                  </a:lnTo>
                  <a:lnTo>
                    <a:pt x="1618" y="619"/>
                  </a:lnTo>
                  <a:lnTo>
                    <a:pt x="1618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Freeform 131">
              <a:extLst>
                <a:ext uri="{FF2B5EF4-FFF2-40B4-BE49-F238E27FC236}">
                  <a16:creationId xmlns:a16="http://schemas.microsoft.com/office/drawing/2014/main" id="{A41AE0F6-9669-020E-ED19-E92CE729775C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5460" y="5847669"/>
              <a:ext cx="3117641" cy="112726"/>
            </a:xfrm>
            <a:custGeom>
              <a:avLst/>
              <a:gdLst>
                <a:gd name="T0" fmla="*/ 0 w 1661"/>
                <a:gd name="T1" fmla="*/ 61 h 61"/>
                <a:gd name="T2" fmla="*/ 148 w 1661"/>
                <a:gd name="T3" fmla="*/ 61 h 61"/>
                <a:gd name="T4" fmla="*/ 179 w 1661"/>
                <a:gd name="T5" fmla="*/ 61 h 61"/>
                <a:gd name="T6" fmla="*/ 289 w 1661"/>
                <a:gd name="T7" fmla="*/ 61 h 61"/>
                <a:gd name="T8" fmla="*/ 520 w 1661"/>
                <a:gd name="T9" fmla="*/ 61 h 61"/>
                <a:gd name="T10" fmla="*/ 530 w 1661"/>
                <a:gd name="T11" fmla="*/ 61 h 61"/>
                <a:gd name="T12" fmla="*/ 532 w 1661"/>
                <a:gd name="T13" fmla="*/ 0 h 61"/>
                <a:gd name="T14" fmla="*/ 542 w 1661"/>
                <a:gd name="T15" fmla="*/ 0 h 61"/>
                <a:gd name="T16" fmla="*/ 548 w 1661"/>
                <a:gd name="T17" fmla="*/ 0 h 61"/>
                <a:gd name="T18" fmla="*/ 578 w 1661"/>
                <a:gd name="T19" fmla="*/ 0 h 61"/>
                <a:gd name="T20" fmla="*/ 598 w 1661"/>
                <a:gd name="T21" fmla="*/ 0 h 61"/>
                <a:gd name="T22" fmla="*/ 635 w 1661"/>
                <a:gd name="T23" fmla="*/ 0 h 61"/>
                <a:gd name="T24" fmla="*/ 668 w 1661"/>
                <a:gd name="T25" fmla="*/ 0 h 61"/>
                <a:gd name="T26" fmla="*/ 672 w 1661"/>
                <a:gd name="T27" fmla="*/ 0 h 61"/>
                <a:gd name="T28" fmla="*/ 824 w 1661"/>
                <a:gd name="T29" fmla="*/ 0 h 61"/>
                <a:gd name="T30" fmla="*/ 951 w 1661"/>
                <a:gd name="T31" fmla="*/ 0 h 61"/>
                <a:gd name="T32" fmla="*/ 960 w 1661"/>
                <a:gd name="T33" fmla="*/ 0 h 61"/>
                <a:gd name="T34" fmla="*/ 1003 w 1661"/>
                <a:gd name="T35" fmla="*/ 0 h 61"/>
                <a:gd name="T36" fmla="*/ 1020 w 1661"/>
                <a:gd name="T37" fmla="*/ 0 h 61"/>
                <a:gd name="T38" fmla="*/ 1052 w 1661"/>
                <a:gd name="T39" fmla="*/ 0 h 61"/>
                <a:gd name="T40" fmla="*/ 1136 w 1661"/>
                <a:gd name="T41" fmla="*/ 0 h 61"/>
                <a:gd name="T42" fmla="*/ 1151 w 1661"/>
                <a:gd name="T43" fmla="*/ 0 h 61"/>
                <a:gd name="T44" fmla="*/ 1184 w 1661"/>
                <a:gd name="T45" fmla="*/ 0 h 61"/>
                <a:gd name="T46" fmla="*/ 1214 w 1661"/>
                <a:gd name="T47" fmla="*/ 0 h 61"/>
                <a:gd name="T48" fmla="*/ 1237 w 1661"/>
                <a:gd name="T49" fmla="*/ 0 h 61"/>
                <a:gd name="T50" fmla="*/ 1295 w 1661"/>
                <a:gd name="T51" fmla="*/ 0 h 61"/>
                <a:gd name="T52" fmla="*/ 1301 w 1661"/>
                <a:gd name="T53" fmla="*/ 0 h 61"/>
                <a:gd name="T54" fmla="*/ 1326 w 1661"/>
                <a:gd name="T55" fmla="*/ 0 h 61"/>
                <a:gd name="T56" fmla="*/ 1369 w 1661"/>
                <a:gd name="T57" fmla="*/ 0 h 61"/>
                <a:gd name="T58" fmla="*/ 1391 w 1661"/>
                <a:gd name="T59" fmla="*/ 0 h 61"/>
                <a:gd name="T60" fmla="*/ 1435 w 1661"/>
                <a:gd name="T61" fmla="*/ 0 h 61"/>
                <a:gd name="T62" fmla="*/ 1460 w 1661"/>
                <a:gd name="T63" fmla="*/ 0 h 61"/>
                <a:gd name="T64" fmla="*/ 1520 w 1661"/>
                <a:gd name="T65" fmla="*/ 0 h 61"/>
                <a:gd name="T66" fmla="*/ 1539 w 1661"/>
                <a:gd name="T67" fmla="*/ 0 h 61"/>
                <a:gd name="T68" fmla="*/ 1582 w 1661"/>
                <a:gd name="T69" fmla="*/ 0 h 61"/>
                <a:gd name="T70" fmla="*/ 1596 w 1661"/>
                <a:gd name="T71" fmla="*/ 0 h 61"/>
                <a:gd name="T72" fmla="*/ 1661 w 1661"/>
                <a:gd name="T73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</a:cxnLst>
              <a:rect l="0" t="0" r="r" b="b"/>
              <a:pathLst>
                <a:path w="1661" h="61">
                  <a:moveTo>
                    <a:pt x="0" y="61"/>
                  </a:moveTo>
                  <a:lnTo>
                    <a:pt x="148" y="61"/>
                  </a:lnTo>
                  <a:lnTo>
                    <a:pt x="179" y="61"/>
                  </a:lnTo>
                  <a:lnTo>
                    <a:pt x="289" y="61"/>
                  </a:lnTo>
                  <a:lnTo>
                    <a:pt x="520" y="61"/>
                  </a:lnTo>
                  <a:lnTo>
                    <a:pt x="530" y="61"/>
                  </a:lnTo>
                  <a:lnTo>
                    <a:pt x="532" y="0"/>
                  </a:lnTo>
                  <a:lnTo>
                    <a:pt x="542" y="0"/>
                  </a:lnTo>
                  <a:lnTo>
                    <a:pt x="548" y="0"/>
                  </a:lnTo>
                  <a:lnTo>
                    <a:pt x="578" y="0"/>
                  </a:lnTo>
                  <a:lnTo>
                    <a:pt x="598" y="0"/>
                  </a:lnTo>
                  <a:lnTo>
                    <a:pt x="635" y="0"/>
                  </a:lnTo>
                  <a:lnTo>
                    <a:pt x="668" y="0"/>
                  </a:lnTo>
                  <a:lnTo>
                    <a:pt x="672" y="0"/>
                  </a:lnTo>
                  <a:lnTo>
                    <a:pt x="824" y="0"/>
                  </a:lnTo>
                  <a:lnTo>
                    <a:pt x="951" y="0"/>
                  </a:lnTo>
                  <a:lnTo>
                    <a:pt x="960" y="0"/>
                  </a:lnTo>
                  <a:lnTo>
                    <a:pt x="1003" y="0"/>
                  </a:lnTo>
                  <a:lnTo>
                    <a:pt x="1020" y="0"/>
                  </a:lnTo>
                  <a:lnTo>
                    <a:pt x="1052" y="0"/>
                  </a:lnTo>
                  <a:lnTo>
                    <a:pt x="1136" y="0"/>
                  </a:lnTo>
                  <a:lnTo>
                    <a:pt x="1151" y="0"/>
                  </a:lnTo>
                  <a:lnTo>
                    <a:pt x="1184" y="0"/>
                  </a:lnTo>
                  <a:lnTo>
                    <a:pt x="1214" y="0"/>
                  </a:lnTo>
                  <a:lnTo>
                    <a:pt x="1237" y="0"/>
                  </a:lnTo>
                  <a:lnTo>
                    <a:pt x="1295" y="0"/>
                  </a:lnTo>
                  <a:lnTo>
                    <a:pt x="1301" y="0"/>
                  </a:lnTo>
                  <a:lnTo>
                    <a:pt x="1326" y="0"/>
                  </a:lnTo>
                  <a:lnTo>
                    <a:pt x="1369" y="0"/>
                  </a:lnTo>
                  <a:lnTo>
                    <a:pt x="1391" y="0"/>
                  </a:lnTo>
                  <a:lnTo>
                    <a:pt x="1435" y="0"/>
                  </a:lnTo>
                  <a:lnTo>
                    <a:pt x="1460" y="0"/>
                  </a:lnTo>
                  <a:lnTo>
                    <a:pt x="1520" y="0"/>
                  </a:lnTo>
                  <a:lnTo>
                    <a:pt x="1539" y="0"/>
                  </a:lnTo>
                  <a:lnTo>
                    <a:pt x="1582" y="0"/>
                  </a:lnTo>
                  <a:lnTo>
                    <a:pt x="1596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Freeform 132">
              <a:extLst>
                <a:ext uri="{FF2B5EF4-FFF2-40B4-BE49-F238E27FC236}">
                  <a16:creationId xmlns:a16="http://schemas.microsoft.com/office/drawing/2014/main" id="{B6785FAC-2F8E-FF0A-E564-C9BE9C861885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5460" y="5361658"/>
              <a:ext cx="3117641" cy="598737"/>
            </a:xfrm>
            <a:custGeom>
              <a:avLst/>
              <a:gdLst>
                <a:gd name="T0" fmla="*/ 107 w 1661"/>
                <a:gd name="T1" fmla="*/ 324 h 324"/>
                <a:gd name="T2" fmla="*/ 152 w 1661"/>
                <a:gd name="T3" fmla="*/ 313 h 324"/>
                <a:gd name="T4" fmla="*/ 179 w 1661"/>
                <a:gd name="T5" fmla="*/ 313 h 324"/>
                <a:gd name="T6" fmla="*/ 196 w 1661"/>
                <a:gd name="T7" fmla="*/ 301 h 324"/>
                <a:gd name="T8" fmla="*/ 214 w 1661"/>
                <a:gd name="T9" fmla="*/ 301 h 324"/>
                <a:gd name="T10" fmla="*/ 247 w 1661"/>
                <a:gd name="T11" fmla="*/ 288 h 324"/>
                <a:gd name="T12" fmla="*/ 269 w 1661"/>
                <a:gd name="T13" fmla="*/ 275 h 324"/>
                <a:gd name="T14" fmla="*/ 300 w 1661"/>
                <a:gd name="T15" fmla="*/ 263 h 324"/>
                <a:gd name="T16" fmla="*/ 361 w 1661"/>
                <a:gd name="T17" fmla="*/ 263 h 324"/>
                <a:gd name="T18" fmla="*/ 427 w 1661"/>
                <a:gd name="T19" fmla="*/ 263 h 324"/>
                <a:gd name="T20" fmla="*/ 458 w 1661"/>
                <a:gd name="T21" fmla="*/ 263 h 324"/>
                <a:gd name="T22" fmla="*/ 524 w 1661"/>
                <a:gd name="T23" fmla="*/ 263 h 324"/>
                <a:gd name="T24" fmla="*/ 554 w 1661"/>
                <a:gd name="T25" fmla="*/ 249 h 324"/>
                <a:gd name="T26" fmla="*/ 579 w 1661"/>
                <a:gd name="T27" fmla="*/ 235 h 324"/>
                <a:gd name="T28" fmla="*/ 599 w 1661"/>
                <a:gd name="T29" fmla="*/ 206 h 324"/>
                <a:gd name="T30" fmla="*/ 669 w 1661"/>
                <a:gd name="T31" fmla="*/ 206 h 324"/>
                <a:gd name="T32" fmla="*/ 702 w 1661"/>
                <a:gd name="T33" fmla="*/ 192 h 324"/>
                <a:gd name="T34" fmla="*/ 719 w 1661"/>
                <a:gd name="T35" fmla="*/ 176 h 324"/>
                <a:gd name="T36" fmla="*/ 729 w 1661"/>
                <a:gd name="T37" fmla="*/ 161 h 324"/>
                <a:gd name="T38" fmla="*/ 744 w 1661"/>
                <a:gd name="T39" fmla="*/ 146 h 324"/>
                <a:gd name="T40" fmla="*/ 759 w 1661"/>
                <a:gd name="T41" fmla="*/ 130 h 324"/>
                <a:gd name="T42" fmla="*/ 798 w 1661"/>
                <a:gd name="T43" fmla="*/ 130 h 324"/>
                <a:gd name="T44" fmla="*/ 806 w 1661"/>
                <a:gd name="T45" fmla="*/ 99 h 324"/>
                <a:gd name="T46" fmla="*/ 838 w 1661"/>
                <a:gd name="T47" fmla="*/ 99 h 324"/>
                <a:gd name="T48" fmla="*/ 860 w 1661"/>
                <a:gd name="T49" fmla="*/ 82 h 324"/>
                <a:gd name="T50" fmla="*/ 889 w 1661"/>
                <a:gd name="T51" fmla="*/ 82 h 324"/>
                <a:gd name="T52" fmla="*/ 916 w 1661"/>
                <a:gd name="T53" fmla="*/ 64 h 324"/>
                <a:gd name="T54" fmla="*/ 925 w 1661"/>
                <a:gd name="T55" fmla="*/ 46 h 324"/>
                <a:gd name="T56" fmla="*/ 973 w 1661"/>
                <a:gd name="T57" fmla="*/ 46 h 324"/>
                <a:gd name="T58" fmla="*/ 996 w 1661"/>
                <a:gd name="T59" fmla="*/ 46 h 324"/>
                <a:gd name="T60" fmla="*/ 1011 w 1661"/>
                <a:gd name="T61" fmla="*/ 46 h 324"/>
                <a:gd name="T62" fmla="*/ 1053 w 1661"/>
                <a:gd name="T63" fmla="*/ 46 h 324"/>
                <a:gd name="T64" fmla="*/ 1073 w 1661"/>
                <a:gd name="T65" fmla="*/ 24 h 324"/>
                <a:gd name="T66" fmla="*/ 1099 w 1661"/>
                <a:gd name="T67" fmla="*/ 24 h 324"/>
                <a:gd name="T68" fmla="*/ 1114 w 1661"/>
                <a:gd name="T69" fmla="*/ 0 h 324"/>
                <a:gd name="T70" fmla="*/ 1136 w 1661"/>
                <a:gd name="T71" fmla="*/ 0 h 324"/>
                <a:gd name="T72" fmla="*/ 1186 w 1661"/>
                <a:gd name="T73" fmla="*/ 0 h 324"/>
                <a:gd name="T74" fmla="*/ 1243 w 1661"/>
                <a:gd name="T75" fmla="*/ 0 h 324"/>
                <a:gd name="T76" fmla="*/ 1290 w 1661"/>
                <a:gd name="T77" fmla="*/ 0 h 324"/>
                <a:gd name="T78" fmla="*/ 1306 w 1661"/>
                <a:gd name="T79" fmla="*/ 0 h 324"/>
                <a:gd name="T80" fmla="*/ 1336 w 1661"/>
                <a:gd name="T81" fmla="*/ 0 h 324"/>
                <a:gd name="T82" fmla="*/ 1373 w 1661"/>
                <a:gd name="T83" fmla="*/ 0 h 324"/>
                <a:gd name="T84" fmla="*/ 1400 w 1661"/>
                <a:gd name="T85" fmla="*/ 0 h 324"/>
                <a:gd name="T86" fmla="*/ 1437 w 1661"/>
                <a:gd name="T87" fmla="*/ 0 h 324"/>
                <a:gd name="T88" fmla="*/ 1460 w 1661"/>
                <a:gd name="T89" fmla="*/ 0 h 324"/>
                <a:gd name="T90" fmla="*/ 1489 w 1661"/>
                <a:gd name="T91" fmla="*/ 0 h 324"/>
                <a:gd name="T92" fmla="*/ 1502 w 1661"/>
                <a:gd name="T93" fmla="*/ 0 h 324"/>
                <a:gd name="T94" fmla="*/ 1535 w 1661"/>
                <a:gd name="T95" fmla="*/ 0 h 324"/>
                <a:gd name="T96" fmla="*/ 1571 w 1661"/>
                <a:gd name="T97" fmla="*/ 0 h 324"/>
                <a:gd name="T98" fmla="*/ 1603 w 1661"/>
                <a:gd name="T99" fmla="*/ 0 h 324"/>
                <a:gd name="T100" fmla="*/ 1647 w 1661"/>
                <a:gd name="T101" fmla="*/ 0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661" h="324">
                  <a:moveTo>
                    <a:pt x="0" y="324"/>
                  </a:moveTo>
                  <a:lnTo>
                    <a:pt x="104" y="324"/>
                  </a:lnTo>
                  <a:lnTo>
                    <a:pt x="107" y="324"/>
                  </a:lnTo>
                  <a:lnTo>
                    <a:pt x="111" y="313"/>
                  </a:lnTo>
                  <a:lnTo>
                    <a:pt x="126" y="313"/>
                  </a:lnTo>
                  <a:lnTo>
                    <a:pt x="152" y="313"/>
                  </a:lnTo>
                  <a:lnTo>
                    <a:pt x="164" y="313"/>
                  </a:lnTo>
                  <a:lnTo>
                    <a:pt x="177" y="313"/>
                  </a:lnTo>
                  <a:lnTo>
                    <a:pt x="179" y="313"/>
                  </a:lnTo>
                  <a:lnTo>
                    <a:pt x="179" y="301"/>
                  </a:lnTo>
                  <a:lnTo>
                    <a:pt x="185" y="301"/>
                  </a:lnTo>
                  <a:lnTo>
                    <a:pt x="196" y="301"/>
                  </a:lnTo>
                  <a:lnTo>
                    <a:pt x="205" y="301"/>
                  </a:lnTo>
                  <a:lnTo>
                    <a:pt x="208" y="301"/>
                  </a:lnTo>
                  <a:lnTo>
                    <a:pt x="214" y="301"/>
                  </a:lnTo>
                  <a:lnTo>
                    <a:pt x="242" y="301"/>
                  </a:lnTo>
                  <a:lnTo>
                    <a:pt x="247" y="301"/>
                  </a:lnTo>
                  <a:lnTo>
                    <a:pt x="247" y="288"/>
                  </a:lnTo>
                  <a:lnTo>
                    <a:pt x="260" y="288"/>
                  </a:lnTo>
                  <a:lnTo>
                    <a:pt x="269" y="288"/>
                  </a:lnTo>
                  <a:lnTo>
                    <a:pt x="269" y="275"/>
                  </a:lnTo>
                  <a:lnTo>
                    <a:pt x="272" y="263"/>
                  </a:lnTo>
                  <a:lnTo>
                    <a:pt x="280" y="263"/>
                  </a:lnTo>
                  <a:lnTo>
                    <a:pt x="300" y="263"/>
                  </a:lnTo>
                  <a:lnTo>
                    <a:pt x="346" y="263"/>
                  </a:lnTo>
                  <a:lnTo>
                    <a:pt x="354" y="263"/>
                  </a:lnTo>
                  <a:lnTo>
                    <a:pt x="361" y="263"/>
                  </a:lnTo>
                  <a:lnTo>
                    <a:pt x="386" y="263"/>
                  </a:lnTo>
                  <a:lnTo>
                    <a:pt x="390" y="263"/>
                  </a:lnTo>
                  <a:lnTo>
                    <a:pt x="427" y="263"/>
                  </a:lnTo>
                  <a:lnTo>
                    <a:pt x="434" y="263"/>
                  </a:lnTo>
                  <a:lnTo>
                    <a:pt x="437" y="263"/>
                  </a:lnTo>
                  <a:lnTo>
                    <a:pt x="458" y="263"/>
                  </a:lnTo>
                  <a:lnTo>
                    <a:pt x="482" y="263"/>
                  </a:lnTo>
                  <a:lnTo>
                    <a:pt x="500" y="263"/>
                  </a:lnTo>
                  <a:lnTo>
                    <a:pt x="524" y="263"/>
                  </a:lnTo>
                  <a:lnTo>
                    <a:pt x="524" y="249"/>
                  </a:lnTo>
                  <a:lnTo>
                    <a:pt x="529" y="249"/>
                  </a:lnTo>
                  <a:lnTo>
                    <a:pt x="554" y="249"/>
                  </a:lnTo>
                  <a:lnTo>
                    <a:pt x="555" y="235"/>
                  </a:lnTo>
                  <a:lnTo>
                    <a:pt x="568" y="235"/>
                  </a:lnTo>
                  <a:lnTo>
                    <a:pt x="579" y="235"/>
                  </a:lnTo>
                  <a:lnTo>
                    <a:pt x="580" y="221"/>
                  </a:lnTo>
                  <a:lnTo>
                    <a:pt x="599" y="221"/>
                  </a:lnTo>
                  <a:lnTo>
                    <a:pt x="599" y="206"/>
                  </a:lnTo>
                  <a:lnTo>
                    <a:pt x="625" y="206"/>
                  </a:lnTo>
                  <a:lnTo>
                    <a:pt x="635" y="206"/>
                  </a:lnTo>
                  <a:lnTo>
                    <a:pt x="669" y="206"/>
                  </a:lnTo>
                  <a:lnTo>
                    <a:pt x="669" y="192"/>
                  </a:lnTo>
                  <a:lnTo>
                    <a:pt x="685" y="192"/>
                  </a:lnTo>
                  <a:lnTo>
                    <a:pt x="702" y="192"/>
                  </a:lnTo>
                  <a:lnTo>
                    <a:pt x="702" y="176"/>
                  </a:lnTo>
                  <a:lnTo>
                    <a:pt x="707" y="176"/>
                  </a:lnTo>
                  <a:lnTo>
                    <a:pt x="719" y="176"/>
                  </a:lnTo>
                  <a:lnTo>
                    <a:pt x="719" y="161"/>
                  </a:lnTo>
                  <a:lnTo>
                    <a:pt x="720" y="161"/>
                  </a:lnTo>
                  <a:lnTo>
                    <a:pt x="729" y="161"/>
                  </a:lnTo>
                  <a:lnTo>
                    <a:pt x="741" y="161"/>
                  </a:lnTo>
                  <a:lnTo>
                    <a:pt x="744" y="161"/>
                  </a:lnTo>
                  <a:lnTo>
                    <a:pt x="744" y="146"/>
                  </a:lnTo>
                  <a:lnTo>
                    <a:pt x="753" y="146"/>
                  </a:lnTo>
                  <a:lnTo>
                    <a:pt x="759" y="146"/>
                  </a:lnTo>
                  <a:lnTo>
                    <a:pt x="759" y="130"/>
                  </a:lnTo>
                  <a:lnTo>
                    <a:pt x="778" y="130"/>
                  </a:lnTo>
                  <a:lnTo>
                    <a:pt x="786" y="130"/>
                  </a:lnTo>
                  <a:lnTo>
                    <a:pt x="798" y="130"/>
                  </a:lnTo>
                  <a:lnTo>
                    <a:pt x="802" y="114"/>
                  </a:lnTo>
                  <a:lnTo>
                    <a:pt x="806" y="114"/>
                  </a:lnTo>
                  <a:lnTo>
                    <a:pt x="806" y="99"/>
                  </a:lnTo>
                  <a:lnTo>
                    <a:pt x="817" y="99"/>
                  </a:lnTo>
                  <a:lnTo>
                    <a:pt x="832" y="99"/>
                  </a:lnTo>
                  <a:lnTo>
                    <a:pt x="838" y="99"/>
                  </a:lnTo>
                  <a:lnTo>
                    <a:pt x="844" y="99"/>
                  </a:lnTo>
                  <a:lnTo>
                    <a:pt x="860" y="99"/>
                  </a:lnTo>
                  <a:lnTo>
                    <a:pt x="860" y="82"/>
                  </a:lnTo>
                  <a:lnTo>
                    <a:pt x="871" y="82"/>
                  </a:lnTo>
                  <a:lnTo>
                    <a:pt x="877" y="82"/>
                  </a:lnTo>
                  <a:lnTo>
                    <a:pt x="889" y="82"/>
                  </a:lnTo>
                  <a:lnTo>
                    <a:pt x="897" y="82"/>
                  </a:lnTo>
                  <a:lnTo>
                    <a:pt x="897" y="64"/>
                  </a:lnTo>
                  <a:lnTo>
                    <a:pt x="916" y="64"/>
                  </a:lnTo>
                  <a:lnTo>
                    <a:pt x="921" y="64"/>
                  </a:lnTo>
                  <a:lnTo>
                    <a:pt x="925" y="64"/>
                  </a:lnTo>
                  <a:lnTo>
                    <a:pt x="925" y="46"/>
                  </a:lnTo>
                  <a:lnTo>
                    <a:pt x="944" y="46"/>
                  </a:lnTo>
                  <a:lnTo>
                    <a:pt x="967" y="46"/>
                  </a:lnTo>
                  <a:lnTo>
                    <a:pt x="973" y="46"/>
                  </a:lnTo>
                  <a:lnTo>
                    <a:pt x="980" y="46"/>
                  </a:lnTo>
                  <a:lnTo>
                    <a:pt x="984" y="46"/>
                  </a:lnTo>
                  <a:lnTo>
                    <a:pt x="996" y="46"/>
                  </a:lnTo>
                  <a:lnTo>
                    <a:pt x="1000" y="46"/>
                  </a:lnTo>
                  <a:lnTo>
                    <a:pt x="1008" y="46"/>
                  </a:lnTo>
                  <a:lnTo>
                    <a:pt x="1011" y="46"/>
                  </a:lnTo>
                  <a:lnTo>
                    <a:pt x="1024" y="46"/>
                  </a:lnTo>
                  <a:lnTo>
                    <a:pt x="1028" y="46"/>
                  </a:lnTo>
                  <a:lnTo>
                    <a:pt x="1053" y="46"/>
                  </a:lnTo>
                  <a:lnTo>
                    <a:pt x="1061" y="46"/>
                  </a:lnTo>
                  <a:lnTo>
                    <a:pt x="1070" y="46"/>
                  </a:lnTo>
                  <a:lnTo>
                    <a:pt x="1073" y="24"/>
                  </a:lnTo>
                  <a:lnTo>
                    <a:pt x="1092" y="24"/>
                  </a:lnTo>
                  <a:lnTo>
                    <a:pt x="1096" y="24"/>
                  </a:lnTo>
                  <a:lnTo>
                    <a:pt x="1099" y="24"/>
                  </a:lnTo>
                  <a:lnTo>
                    <a:pt x="1099" y="0"/>
                  </a:lnTo>
                  <a:lnTo>
                    <a:pt x="1107" y="0"/>
                  </a:lnTo>
                  <a:lnTo>
                    <a:pt x="1114" y="0"/>
                  </a:lnTo>
                  <a:lnTo>
                    <a:pt x="1123" y="0"/>
                  </a:lnTo>
                  <a:lnTo>
                    <a:pt x="1129" y="0"/>
                  </a:lnTo>
                  <a:lnTo>
                    <a:pt x="1136" y="0"/>
                  </a:lnTo>
                  <a:lnTo>
                    <a:pt x="1161" y="0"/>
                  </a:lnTo>
                  <a:lnTo>
                    <a:pt x="1180" y="0"/>
                  </a:lnTo>
                  <a:lnTo>
                    <a:pt x="1186" y="0"/>
                  </a:lnTo>
                  <a:lnTo>
                    <a:pt x="1189" y="0"/>
                  </a:lnTo>
                  <a:lnTo>
                    <a:pt x="1216" y="0"/>
                  </a:lnTo>
                  <a:lnTo>
                    <a:pt x="1243" y="0"/>
                  </a:lnTo>
                  <a:lnTo>
                    <a:pt x="1253" y="0"/>
                  </a:lnTo>
                  <a:lnTo>
                    <a:pt x="1261" y="0"/>
                  </a:lnTo>
                  <a:lnTo>
                    <a:pt x="1290" y="0"/>
                  </a:lnTo>
                  <a:lnTo>
                    <a:pt x="1296" y="0"/>
                  </a:lnTo>
                  <a:lnTo>
                    <a:pt x="1297" y="0"/>
                  </a:lnTo>
                  <a:lnTo>
                    <a:pt x="1306" y="0"/>
                  </a:lnTo>
                  <a:lnTo>
                    <a:pt x="1311" y="0"/>
                  </a:lnTo>
                  <a:lnTo>
                    <a:pt x="1332" y="0"/>
                  </a:lnTo>
                  <a:lnTo>
                    <a:pt x="1336" y="0"/>
                  </a:lnTo>
                  <a:lnTo>
                    <a:pt x="1340" y="0"/>
                  </a:lnTo>
                  <a:lnTo>
                    <a:pt x="1362" y="0"/>
                  </a:lnTo>
                  <a:lnTo>
                    <a:pt x="1373" y="0"/>
                  </a:lnTo>
                  <a:lnTo>
                    <a:pt x="1377" y="0"/>
                  </a:lnTo>
                  <a:lnTo>
                    <a:pt x="1390" y="0"/>
                  </a:lnTo>
                  <a:lnTo>
                    <a:pt x="1400" y="0"/>
                  </a:lnTo>
                  <a:lnTo>
                    <a:pt x="1406" y="0"/>
                  </a:lnTo>
                  <a:lnTo>
                    <a:pt x="1419" y="0"/>
                  </a:lnTo>
                  <a:lnTo>
                    <a:pt x="1437" y="0"/>
                  </a:lnTo>
                  <a:lnTo>
                    <a:pt x="1443" y="0"/>
                  </a:lnTo>
                  <a:lnTo>
                    <a:pt x="1449" y="0"/>
                  </a:lnTo>
                  <a:lnTo>
                    <a:pt x="1460" y="0"/>
                  </a:lnTo>
                  <a:lnTo>
                    <a:pt x="1477" y="0"/>
                  </a:lnTo>
                  <a:lnTo>
                    <a:pt x="1480" y="0"/>
                  </a:lnTo>
                  <a:lnTo>
                    <a:pt x="1489" y="0"/>
                  </a:lnTo>
                  <a:lnTo>
                    <a:pt x="1490" y="0"/>
                  </a:lnTo>
                  <a:lnTo>
                    <a:pt x="1501" y="0"/>
                  </a:lnTo>
                  <a:lnTo>
                    <a:pt x="1502" y="0"/>
                  </a:lnTo>
                  <a:lnTo>
                    <a:pt x="1522" y="0"/>
                  </a:lnTo>
                  <a:lnTo>
                    <a:pt x="1526" y="0"/>
                  </a:lnTo>
                  <a:lnTo>
                    <a:pt x="1535" y="0"/>
                  </a:lnTo>
                  <a:lnTo>
                    <a:pt x="1541" y="0"/>
                  </a:lnTo>
                  <a:lnTo>
                    <a:pt x="1557" y="0"/>
                  </a:lnTo>
                  <a:lnTo>
                    <a:pt x="1571" y="0"/>
                  </a:lnTo>
                  <a:lnTo>
                    <a:pt x="1575" y="0"/>
                  </a:lnTo>
                  <a:lnTo>
                    <a:pt x="1583" y="0"/>
                  </a:lnTo>
                  <a:lnTo>
                    <a:pt x="1603" y="0"/>
                  </a:lnTo>
                  <a:lnTo>
                    <a:pt x="1618" y="0"/>
                  </a:lnTo>
                  <a:lnTo>
                    <a:pt x="1645" y="0"/>
                  </a:lnTo>
                  <a:lnTo>
                    <a:pt x="1647" y="0"/>
                  </a:lnTo>
                  <a:lnTo>
                    <a:pt x="1661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B49928B-80C3-6924-A495-9277819FBE4A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53F62A4-DB54-6825-288B-ED492C77C542}"/>
              </a:ext>
            </a:extLst>
          </p:cNvPr>
          <p:cNvSpPr txBox="1"/>
          <p:nvPr/>
        </p:nvSpPr>
        <p:spPr>
          <a:xfrm>
            <a:off x="886249" y="38268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5AC5288-9066-1EC9-1340-5B7B2CB955B8}"/>
              </a:ext>
            </a:extLst>
          </p:cNvPr>
          <p:cNvSpPr txBox="1"/>
          <p:nvPr/>
        </p:nvSpPr>
        <p:spPr>
          <a:xfrm>
            <a:off x="6010058" y="382681"/>
            <a:ext cx="38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E5703E0-0BCB-C4FC-D811-8A6B10D8103E}"/>
              </a:ext>
            </a:extLst>
          </p:cNvPr>
          <p:cNvSpPr txBox="1"/>
          <p:nvPr/>
        </p:nvSpPr>
        <p:spPr>
          <a:xfrm>
            <a:off x="886250" y="3325173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D1EEB7C-D3CC-F962-C4A9-1CCB3948405F}"/>
              </a:ext>
            </a:extLst>
          </p:cNvPr>
          <p:cNvSpPr txBox="1"/>
          <p:nvPr/>
        </p:nvSpPr>
        <p:spPr>
          <a:xfrm>
            <a:off x="6010059" y="3325174"/>
            <a:ext cx="39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D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4941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C503A29E-8008-A2DC-D2F2-7910495FD3D2}"/>
              </a:ext>
            </a:extLst>
          </p:cNvPr>
          <p:cNvGrpSpPr/>
          <p:nvPr/>
        </p:nvGrpSpPr>
        <p:grpSpPr>
          <a:xfrm>
            <a:off x="1197600" y="498289"/>
            <a:ext cx="4141083" cy="2990992"/>
            <a:chOff x="1487880" y="788569"/>
            <a:chExt cx="4141083" cy="2990992"/>
          </a:xfrm>
        </p:grpSpPr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8F127B2D-EFDD-4E86-0139-9BFCD70DF023}"/>
                </a:ext>
              </a:extLst>
            </p:cNvPr>
            <p:cNvSpPr txBox="1"/>
            <p:nvPr/>
          </p:nvSpPr>
          <p:spPr>
            <a:xfrm>
              <a:off x="3108992" y="3410229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Line 23">
              <a:extLst>
                <a:ext uri="{FF2B5EF4-FFF2-40B4-BE49-F238E27FC236}">
                  <a16:creationId xmlns:a16="http://schemas.microsoft.com/office/drawing/2014/main" id="{66C4FEED-FC98-D204-5DC3-CFDA55DD2F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3010891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Line 25">
              <a:extLst>
                <a:ext uri="{FF2B5EF4-FFF2-40B4-BE49-F238E27FC236}">
                  <a16:creationId xmlns:a16="http://schemas.microsoft.com/office/drawing/2014/main" id="{1E7C67B3-3017-AE5F-EA50-47B5153B01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3010891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" name="Line 27">
              <a:extLst>
                <a:ext uri="{FF2B5EF4-FFF2-40B4-BE49-F238E27FC236}">
                  <a16:creationId xmlns:a16="http://schemas.microsoft.com/office/drawing/2014/main" id="{70293940-2A45-4FD8-E418-3C5B5A68B8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3010891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" name="Line 29">
              <a:extLst>
                <a:ext uri="{FF2B5EF4-FFF2-40B4-BE49-F238E27FC236}">
                  <a16:creationId xmlns:a16="http://schemas.microsoft.com/office/drawing/2014/main" id="{48269F75-6FCC-E8FC-ACC2-96AA09A377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3010891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1" name="Line 31">
              <a:extLst>
                <a:ext uri="{FF2B5EF4-FFF2-40B4-BE49-F238E27FC236}">
                  <a16:creationId xmlns:a16="http://schemas.microsoft.com/office/drawing/2014/main" id="{7AA62F89-1EB8-D8AC-5A42-8E69A28963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3010891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Line 33">
              <a:extLst>
                <a:ext uri="{FF2B5EF4-FFF2-40B4-BE49-F238E27FC236}">
                  <a16:creationId xmlns:a16="http://schemas.microsoft.com/office/drawing/2014/main" id="{BE63DC94-515B-09BC-FF41-090BF4DB33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3010891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Line 35">
              <a:extLst>
                <a:ext uri="{FF2B5EF4-FFF2-40B4-BE49-F238E27FC236}">
                  <a16:creationId xmlns:a16="http://schemas.microsoft.com/office/drawing/2014/main" id="{B50D588B-952A-ECF4-559A-A13E74C61D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3010891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" name="Line 6">
              <a:extLst>
                <a:ext uri="{FF2B5EF4-FFF2-40B4-BE49-F238E27FC236}">
                  <a16:creationId xmlns:a16="http://schemas.microsoft.com/office/drawing/2014/main" id="{B115048B-C350-04CF-A64B-4E7B349DF7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3008505"/>
              <a:ext cx="67681" cy="0"/>
            </a:xfrm>
            <a:prstGeom prst="line">
              <a:avLst/>
            </a:prstGeom>
            <a:noFill/>
            <a:ln w="28575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4" name="Line 8">
              <a:extLst>
                <a:ext uri="{FF2B5EF4-FFF2-40B4-BE49-F238E27FC236}">
                  <a16:creationId xmlns:a16="http://schemas.microsoft.com/office/drawing/2014/main" id="{66156174-E97C-4E49-1B8B-84A9BF586B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60100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5" name="Line 9">
              <a:extLst>
                <a:ext uri="{FF2B5EF4-FFF2-40B4-BE49-F238E27FC236}">
                  <a16:creationId xmlns:a16="http://schemas.microsoft.com/office/drawing/2014/main" id="{1DF7AB62-7AB6-E01C-FF2D-2581539BF0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193514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6" name="Line 11">
              <a:extLst>
                <a:ext uri="{FF2B5EF4-FFF2-40B4-BE49-F238E27FC236}">
                  <a16:creationId xmlns:a16="http://schemas.microsoft.com/office/drawing/2014/main" id="{0A06E783-4F34-618E-9A35-14CD94ECBF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78601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7" name="Line 12">
              <a:extLst>
                <a:ext uri="{FF2B5EF4-FFF2-40B4-BE49-F238E27FC236}">
                  <a16:creationId xmlns:a16="http://schemas.microsoft.com/office/drawing/2014/main" id="{69C8ECAF-161B-1201-DB79-786ACBBDCF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378524"/>
              <a:ext cx="67681" cy="0"/>
            </a:xfrm>
            <a:prstGeom prst="line">
              <a:avLst/>
            </a:prstGeom>
            <a:noFill/>
            <a:ln w="12700" cap="flat" cmpd="sng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8" name="Line 14">
              <a:extLst>
                <a:ext uri="{FF2B5EF4-FFF2-40B4-BE49-F238E27FC236}">
                  <a16:creationId xmlns:a16="http://schemas.microsoft.com/office/drawing/2014/main" id="{35107D5B-F663-DA0D-D5C5-A41FBC4B7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994936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1" name="Line 23">
              <a:extLst>
                <a:ext uri="{FF2B5EF4-FFF2-40B4-BE49-F238E27FC236}">
                  <a16:creationId xmlns:a16="http://schemas.microsoft.com/office/drawing/2014/main" id="{D313D48C-A281-AB44-FC5A-5584226418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3008506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23" name="図形グループ 54">
              <a:extLst>
                <a:ext uri="{FF2B5EF4-FFF2-40B4-BE49-F238E27FC236}">
                  <a16:creationId xmlns:a16="http://schemas.microsoft.com/office/drawing/2014/main" id="{2CD3138F-19DF-1E8F-BFB8-A43C19CAE3A5}"/>
                </a:ext>
              </a:extLst>
            </p:cNvPr>
            <p:cNvGrpSpPr/>
            <p:nvPr/>
          </p:nvGrpSpPr>
          <p:grpSpPr>
            <a:xfrm>
              <a:off x="2034219" y="1249429"/>
              <a:ext cx="220989" cy="1868530"/>
              <a:chOff x="510218" y="1348283"/>
              <a:chExt cx="220989" cy="1868530"/>
            </a:xfrm>
          </p:grpSpPr>
          <p:sp>
            <p:nvSpPr>
              <p:cNvPr id="24" name="Rectangle 10">
                <a:extLst>
                  <a:ext uri="{FF2B5EF4-FFF2-40B4-BE49-F238E27FC236}">
                    <a16:creationId xmlns:a16="http://schemas.microsoft.com/office/drawing/2014/main" id="{0A352005-B8AD-B1C5-D886-F3FD15BF16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5" name="Rectangle 13">
                <a:extLst>
                  <a:ext uri="{FF2B5EF4-FFF2-40B4-BE49-F238E27FC236}">
                    <a16:creationId xmlns:a16="http://schemas.microsoft.com/office/drawing/2014/main" id="{BF811C73-0DDA-AA40-EA59-6964F85B57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6" name="Rectangle 10">
                <a:extLst>
                  <a:ext uri="{FF2B5EF4-FFF2-40B4-BE49-F238E27FC236}">
                    <a16:creationId xmlns:a16="http://schemas.microsoft.com/office/drawing/2014/main" id="{7D42FA6C-38A3-A01E-350D-0418CE05C6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E63BACD-575B-D441-E776-DA76BF561A07}"/>
                </a:ext>
              </a:extLst>
            </p:cNvPr>
            <p:cNvSpPr txBox="1"/>
            <p:nvPr/>
          </p:nvSpPr>
          <p:spPr>
            <a:xfrm>
              <a:off x="2206686" y="3148442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47E0F02C-B3BB-322D-7A99-E09451472718}"/>
                </a:ext>
              </a:extLst>
            </p:cNvPr>
            <p:cNvSpPr txBox="1"/>
            <p:nvPr/>
          </p:nvSpPr>
          <p:spPr>
            <a:xfrm>
              <a:off x="3251225" y="3148442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38265A1-4111-AE59-751C-761448D60547}"/>
                </a:ext>
              </a:extLst>
            </p:cNvPr>
            <p:cNvSpPr txBox="1"/>
            <p:nvPr/>
          </p:nvSpPr>
          <p:spPr>
            <a:xfrm>
              <a:off x="5340302" y="3148442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0D08AA6-78E6-B385-BB9D-A2FB512AE1D4}"/>
                </a:ext>
              </a:extLst>
            </p:cNvPr>
            <p:cNvSpPr txBox="1"/>
            <p:nvPr/>
          </p:nvSpPr>
          <p:spPr>
            <a:xfrm>
              <a:off x="4295764" y="3148442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97F11D48-C1F0-697F-815C-115A0D93D7B1}"/>
                </a:ext>
              </a:extLst>
            </p:cNvPr>
            <p:cNvSpPr txBox="1"/>
            <p:nvPr/>
          </p:nvSpPr>
          <p:spPr>
            <a:xfrm rot="16200000">
              <a:off x="604785" y="1871302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Line 14">
              <a:extLst>
                <a:ext uri="{FF2B5EF4-FFF2-40B4-BE49-F238E27FC236}">
                  <a16:creationId xmlns:a16="http://schemas.microsoft.com/office/drawing/2014/main" id="{A87D92DE-2277-267E-EE7C-E5C9A37074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13199" y="981572"/>
              <a:ext cx="34044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Freeform 19">
              <a:extLst>
                <a:ext uri="{FF2B5EF4-FFF2-40B4-BE49-F238E27FC236}">
                  <a16:creationId xmlns:a16="http://schemas.microsoft.com/office/drawing/2014/main" id="{9FD4B693-6277-5ED7-405F-A23FB86FE31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918" y="2270999"/>
              <a:ext cx="3050720" cy="745322"/>
            </a:xfrm>
            <a:custGeom>
              <a:avLst/>
              <a:gdLst>
                <a:gd name="T0" fmla="*/ 90 w 1613"/>
                <a:gd name="T1" fmla="*/ 363 h 363"/>
                <a:gd name="T2" fmla="*/ 115 w 1613"/>
                <a:gd name="T3" fmla="*/ 363 h 363"/>
                <a:gd name="T4" fmla="*/ 137 w 1613"/>
                <a:gd name="T5" fmla="*/ 363 h 363"/>
                <a:gd name="T6" fmla="*/ 149 w 1613"/>
                <a:gd name="T7" fmla="*/ 359 h 363"/>
                <a:gd name="T8" fmla="*/ 168 w 1613"/>
                <a:gd name="T9" fmla="*/ 355 h 363"/>
                <a:gd name="T10" fmla="*/ 189 w 1613"/>
                <a:gd name="T11" fmla="*/ 350 h 363"/>
                <a:gd name="T12" fmla="*/ 202 w 1613"/>
                <a:gd name="T13" fmla="*/ 350 h 363"/>
                <a:gd name="T14" fmla="*/ 224 w 1613"/>
                <a:gd name="T15" fmla="*/ 350 h 363"/>
                <a:gd name="T16" fmla="*/ 237 w 1613"/>
                <a:gd name="T17" fmla="*/ 346 h 363"/>
                <a:gd name="T18" fmla="*/ 252 w 1613"/>
                <a:gd name="T19" fmla="*/ 346 h 363"/>
                <a:gd name="T20" fmla="*/ 263 w 1613"/>
                <a:gd name="T21" fmla="*/ 341 h 363"/>
                <a:gd name="T22" fmla="*/ 288 w 1613"/>
                <a:gd name="T23" fmla="*/ 337 h 363"/>
                <a:gd name="T24" fmla="*/ 301 w 1613"/>
                <a:gd name="T25" fmla="*/ 332 h 363"/>
                <a:gd name="T26" fmla="*/ 311 w 1613"/>
                <a:gd name="T27" fmla="*/ 327 h 363"/>
                <a:gd name="T28" fmla="*/ 332 w 1613"/>
                <a:gd name="T29" fmla="*/ 327 h 363"/>
                <a:gd name="T30" fmla="*/ 349 w 1613"/>
                <a:gd name="T31" fmla="*/ 327 h 363"/>
                <a:gd name="T32" fmla="*/ 366 w 1613"/>
                <a:gd name="T33" fmla="*/ 327 h 363"/>
                <a:gd name="T34" fmla="*/ 383 w 1613"/>
                <a:gd name="T35" fmla="*/ 327 h 363"/>
                <a:gd name="T36" fmla="*/ 392 w 1613"/>
                <a:gd name="T37" fmla="*/ 316 h 363"/>
                <a:gd name="T38" fmla="*/ 401 w 1613"/>
                <a:gd name="T39" fmla="*/ 310 h 363"/>
                <a:gd name="T40" fmla="*/ 425 w 1613"/>
                <a:gd name="T41" fmla="*/ 310 h 363"/>
                <a:gd name="T42" fmla="*/ 443 w 1613"/>
                <a:gd name="T43" fmla="*/ 310 h 363"/>
                <a:gd name="T44" fmla="*/ 462 w 1613"/>
                <a:gd name="T45" fmla="*/ 310 h 363"/>
                <a:gd name="T46" fmla="*/ 486 w 1613"/>
                <a:gd name="T47" fmla="*/ 310 h 363"/>
                <a:gd name="T48" fmla="*/ 498 w 1613"/>
                <a:gd name="T49" fmla="*/ 303 h 363"/>
                <a:gd name="T50" fmla="*/ 518 w 1613"/>
                <a:gd name="T51" fmla="*/ 303 h 363"/>
                <a:gd name="T52" fmla="*/ 534 w 1613"/>
                <a:gd name="T53" fmla="*/ 303 h 363"/>
                <a:gd name="T54" fmla="*/ 553 w 1613"/>
                <a:gd name="T55" fmla="*/ 303 h 363"/>
                <a:gd name="T56" fmla="*/ 569 w 1613"/>
                <a:gd name="T57" fmla="*/ 303 h 363"/>
                <a:gd name="T58" fmla="*/ 588 w 1613"/>
                <a:gd name="T59" fmla="*/ 303 h 363"/>
                <a:gd name="T60" fmla="*/ 600 w 1613"/>
                <a:gd name="T61" fmla="*/ 295 h 363"/>
                <a:gd name="T62" fmla="*/ 620 w 1613"/>
                <a:gd name="T63" fmla="*/ 295 h 363"/>
                <a:gd name="T64" fmla="*/ 635 w 1613"/>
                <a:gd name="T65" fmla="*/ 295 h 363"/>
                <a:gd name="T66" fmla="*/ 654 w 1613"/>
                <a:gd name="T67" fmla="*/ 295 h 363"/>
                <a:gd name="T68" fmla="*/ 671 w 1613"/>
                <a:gd name="T69" fmla="*/ 295 h 363"/>
                <a:gd name="T70" fmla="*/ 690 w 1613"/>
                <a:gd name="T71" fmla="*/ 295 h 363"/>
                <a:gd name="T72" fmla="*/ 702 w 1613"/>
                <a:gd name="T73" fmla="*/ 284 h 363"/>
                <a:gd name="T74" fmla="*/ 728 w 1613"/>
                <a:gd name="T75" fmla="*/ 284 h 363"/>
                <a:gd name="T76" fmla="*/ 750 w 1613"/>
                <a:gd name="T77" fmla="*/ 284 h 363"/>
                <a:gd name="T78" fmla="*/ 768 w 1613"/>
                <a:gd name="T79" fmla="*/ 284 h 363"/>
                <a:gd name="T80" fmla="*/ 787 w 1613"/>
                <a:gd name="T81" fmla="*/ 284 h 363"/>
                <a:gd name="T82" fmla="*/ 800 w 1613"/>
                <a:gd name="T83" fmla="*/ 269 h 363"/>
                <a:gd name="T84" fmla="*/ 817 w 1613"/>
                <a:gd name="T85" fmla="*/ 269 h 363"/>
                <a:gd name="T86" fmla="*/ 835 w 1613"/>
                <a:gd name="T87" fmla="*/ 269 h 363"/>
                <a:gd name="T88" fmla="*/ 852 w 1613"/>
                <a:gd name="T89" fmla="*/ 269 h 363"/>
                <a:gd name="T90" fmla="*/ 877 w 1613"/>
                <a:gd name="T91" fmla="*/ 269 h 363"/>
                <a:gd name="T92" fmla="*/ 895 w 1613"/>
                <a:gd name="T93" fmla="*/ 269 h 363"/>
                <a:gd name="T94" fmla="*/ 912 w 1613"/>
                <a:gd name="T95" fmla="*/ 269 h 363"/>
                <a:gd name="T96" fmla="*/ 931 w 1613"/>
                <a:gd name="T97" fmla="*/ 269 h 363"/>
                <a:gd name="T98" fmla="*/ 950 w 1613"/>
                <a:gd name="T99" fmla="*/ 269 h 363"/>
                <a:gd name="T100" fmla="*/ 986 w 1613"/>
                <a:gd name="T101" fmla="*/ 269 h 363"/>
                <a:gd name="T102" fmla="*/ 1024 w 1613"/>
                <a:gd name="T103" fmla="*/ 269 h 363"/>
                <a:gd name="T104" fmla="*/ 1051 w 1613"/>
                <a:gd name="T105" fmla="*/ 269 h 363"/>
                <a:gd name="T106" fmla="*/ 1119 w 1613"/>
                <a:gd name="T107" fmla="*/ 0 h 363"/>
                <a:gd name="T108" fmla="*/ 1613 w 1613"/>
                <a:gd name="T109" fmla="*/ 0 h 3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1613" h="363">
                  <a:moveTo>
                    <a:pt x="0" y="363"/>
                  </a:moveTo>
                  <a:lnTo>
                    <a:pt x="84" y="363"/>
                  </a:lnTo>
                  <a:lnTo>
                    <a:pt x="90" y="363"/>
                  </a:lnTo>
                  <a:lnTo>
                    <a:pt x="105" y="363"/>
                  </a:lnTo>
                  <a:lnTo>
                    <a:pt x="110" y="363"/>
                  </a:lnTo>
                  <a:lnTo>
                    <a:pt x="115" y="363"/>
                  </a:lnTo>
                  <a:lnTo>
                    <a:pt x="119" y="363"/>
                  </a:lnTo>
                  <a:lnTo>
                    <a:pt x="127" y="363"/>
                  </a:lnTo>
                  <a:lnTo>
                    <a:pt x="137" y="363"/>
                  </a:lnTo>
                  <a:lnTo>
                    <a:pt x="143" y="363"/>
                  </a:lnTo>
                  <a:lnTo>
                    <a:pt x="148" y="363"/>
                  </a:lnTo>
                  <a:lnTo>
                    <a:pt x="149" y="359"/>
                  </a:lnTo>
                  <a:lnTo>
                    <a:pt x="155" y="355"/>
                  </a:lnTo>
                  <a:lnTo>
                    <a:pt x="160" y="355"/>
                  </a:lnTo>
                  <a:lnTo>
                    <a:pt x="168" y="355"/>
                  </a:lnTo>
                  <a:lnTo>
                    <a:pt x="172" y="355"/>
                  </a:lnTo>
                  <a:lnTo>
                    <a:pt x="184" y="355"/>
                  </a:lnTo>
                  <a:lnTo>
                    <a:pt x="189" y="350"/>
                  </a:lnTo>
                  <a:lnTo>
                    <a:pt x="196" y="350"/>
                  </a:lnTo>
                  <a:lnTo>
                    <a:pt x="197" y="350"/>
                  </a:lnTo>
                  <a:lnTo>
                    <a:pt x="202" y="350"/>
                  </a:lnTo>
                  <a:lnTo>
                    <a:pt x="211" y="350"/>
                  </a:lnTo>
                  <a:lnTo>
                    <a:pt x="214" y="350"/>
                  </a:lnTo>
                  <a:lnTo>
                    <a:pt x="224" y="350"/>
                  </a:lnTo>
                  <a:lnTo>
                    <a:pt x="228" y="350"/>
                  </a:lnTo>
                  <a:lnTo>
                    <a:pt x="234" y="350"/>
                  </a:lnTo>
                  <a:lnTo>
                    <a:pt x="237" y="346"/>
                  </a:lnTo>
                  <a:lnTo>
                    <a:pt x="238" y="346"/>
                  </a:lnTo>
                  <a:lnTo>
                    <a:pt x="248" y="346"/>
                  </a:lnTo>
                  <a:lnTo>
                    <a:pt x="252" y="346"/>
                  </a:lnTo>
                  <a:lnTo>
                    <a:pt x="256" y="346"/>
                  </a:lnTo>
                  <a:lnTo>
                    <a:pt x="257" y="341"/>
                  </a:lnTo>
                  <a:lnTo>
                    <a:pt x="263" y="341"/>
                  </a:lnTo>
                  <a:lnTo>
                    <a:pt x="275" y="341"/>
                  </a:lnTo>
                  <a:lnTo>
                    <a:pt x="280" y="337"/>
                  </a:lnTo>
                  <a:lnTo>
                    <a:pt x="288" y="337"/>
                  </a:lnTo>
                  <a:lnTo>
                    <a:pt x="288" y="332"/>
                  </a:lnTo>
                  <a:lnTo>
                    <a:pt x="292" y="332"/>
                  </a:lnTo>
                  <a:lnTo>
                    <a:pt x="301" y="332"/>
                  </a:lnTo>
                  <a:lnTo>
                    <a:pt x="302" y="327"/>
                  </a:lnTo>
                  <a:lnTo>
                    <a:pt x="305" y="327"/>
                  </a:lnTo>
                  <a:lnTo>
                    <a:pt x="311" y="327"/>
                  </a:lnTo>
                  <a:lnTo>
                    <a:pt x="317" y="327"/>
                  </a:lnTo>
                  <a:lnTo>
                    <a:pt x="323" y="327"/>
                  </a:lnTo>
                  <a:lnTo>
                    <a:pt x="332" y="327"/>
                  </a:lnTo>
                  <a:lnTo>
                    <a:pt x="335" y="327"/>
                  </a:lnTo>
                  <a:lnTo>
                    <a:pt x="341" y="327"/>
                  </a:lnTo>
                  <a:lnTo>
                    <a:pt x="349" y="327"/>
                  </a:lnTo>
                  <a:lnTo>
                    <a:pt x="352" y="327"/>
                  </a:lnTo>
                  <a:lnTo>
                    <a:pt x="359" y="327"/>
                  </a:lnTo>
                  <a:lnTo>
                    <a:pt x="366" y="327"/>
                  </a:lnTo>
                  <a:lnTo>
                    <a:pt x="372" y="327"/>
                  </a:lnTo>
                  <a:lnTo>
                    <a:pt x="377" y="327"/>
                  </a:lnTo>
                  <a:lnTo>
                    <a:pt x="383" y="327"/>
                  </a:lnTo>
                  <a:lnTo>
                    <a:pt x="383" y="321"/>
                  </a:lnTo>
                  <a:lnTo>
                    <a:pt x="384" y="316"/>
                  </a:lnTo>
                  <a:lnTo>
                    <a:pt x="392" y="316"/>
                  </a:lnTo>
                  <a:lnTo>
                    <a:pt x="396" y="316"/>
                  </a:lnTo>
                  <a:lnTo>
                    <a:pt x="401" y="316"/>
                  </a:lnTo>
                  <a:lnTo>
                    <a:pt x="401" y="310"/>
                  </a:lnTo>
                  <a:lnTo>
                    <a:pt x="409" y="310"/>
                  </a:lnTo>
                  <a:lnTo>
                    <a:pt x="420" y="310"/>
                  </a:lnTo>
                  <a:lnTo>
                    <a:pt x="425" y="310"/>
                  </a:lnTo>
                  <a:lnTo>
                    <a:pt x="431" y="310"/>
                  </a:lnTo>
                  <a:lnTo>
                    <a:pt x="437" y="310"/>
                  </a:lnTo>
                  <a:lnTo>
                    <a:pt x="443" y="310"/>
                  </a:lnTo>
                  <a:lnTo>
                    <a:pt x="449" y="310"/>
                  </a:lnTo>
                  <a:lnTo>
                    <a:pt x="455" y="310"/>
                  </a:lnTo>
                  <a:lnTo>
                    <a:pt x="462" y="310"/>
                  </a:lnTo>
                  <a:lnTo>
                    <a:pt x="473" y="310"/>
                  </a:lnTo>
                  <a:lnTo>
                    <a:pt x="483" y="310"/>
                  </a:lnTo>
                  <a:lnTo>
                    <a:pt x="486" y="310"/>
                  </a:lnTo>
                  <a:lnTo>
                    <a:pt x="491" y="310"/>
                  </a:lnTo>
                  <a:lnTo>
                    <a:pt x="496" y="303"/>
                  </a:lnTo>
                  <a:lnTo>
                    <a:pt x="498" y="303"/>
                  </a:lnTo>
                  <a:lnTo>
                    <a:pt x="504" y="303"/>
                  </a:lnTo>
                  <a:lnTo>
                    <a:pt x="511" y="303"/>
                  </a:lnTo>
                  <a:lnTo>
                    <a:pt x="518" y="303"/>
                  </a:lnTo>
                  <a:lnTo>
                    <a:pt x="522" y="303"/>
                  </a:lnTo>
                  <a:lnTo>
                    <a:pt x="531" y="303"/>
                  </a:lnTo>
                  <a:lnTo>
                    <a:pt x="534" y="303"/>
                  </a:lnTo>
                  <a:lnTo>
                    <a:pt x="539" y="303"/>
                  </a:lnTo>
                  <a:lnTo>
                    <a:pt x="545" y="303"/>
                  </a:lnTo>
                  <a:lnTo>
                    <a:pt x="553" y="303"/>
                  </a:lnTo>
                  <a:lnTo>
                    <a:pt x="557" y="303"/>
                  </a:lnTo>
                  <a:lnTo>
                    <a:pt x="565" y="303"/>
                  </a:lnTo>
                  <a:lnTo>
                    <a:pt x="569" y="303"/>
                  </a:lnTo>
                  <a:lnTo>
                    <a:pt x="575" y="303"/>
                  </a:lnTo>
                  <a:lnTo>
                    <a:pt x="581" y="303"/>
                  </a:lnTo>
                  <a:lnTo>
                    <a:pt x="588" y="303"/>
                  </a:lnTo>
                  <a:lnTo>
                    <a:pt x="589" y="295"/>
                  </a:lnTo>
                  <a:lnTo>
                    <a:pt x="593" y="295"/>
                  </a:lnTo>
                  <a:lnTo>
                    <a:pt x="600" y="295"/>
                  </a:lnTo>
                  <a:lnTo>
                    <a:pt x="605" y="295"/>
                  </a:lnTo>
                  <a:lnTo>
                    <a:pt x="616" y="295"/>
                  </a:lnTo>
                  <a:lnTo>
                    <a:pt x="620" y="295"/>
                  </a:lnTo>
                  <a:lnTo>
                    <a:pt x="626" y="295"/>
                  </a:lnTo>
                  <a:lnTo>
                    <a:pt x="631" y="295"/>
                  </a:lnTo>
                  <a:lnTo>
                    <a:pt x="635" y="295"/>
                  </a:lnTo>
                  <a:lnTo>
                    <a:pt x="644" y="295"/>
                  </a:lnTo>
                  <a:lnTo>
                    <a:pt x="648" y="295"/>
                  </a:lnTo>
                  <a:lnTo>
                    <a:pt x="654" y="295"/>
                  </a:lnTo>
                  <a:lnTo>
                    <a:pt x="660" y="295"/>
                  </a:lnTo>
                  <a:lnTo>
                    <a:pt x="665" y="295"/>
                  </a:lnTo>
                  <a:lnTo>
                    <a:pt x="671" y="295"/>
                  </a:lnTo>
                  <a:lnTo>
                    <a:pt x="678" y="295"/>
                  </a:lnTo>
                  <a:lnTo>
                    <a:pt x="684" y="295"/>
                  </a:lnTo>
                  <a:lnTo>
                    <a:pt x="690" y="295"/>
                  </a:lnTo>
                  <a:lnTo>
                    <a:pt x="698" y="295"/>
                  </a:lnTo>
                  <a:lnTo>
                    <a:pt x="702" y="295"/>
                  </a:lnTo>
                  <a:lnTo>
                    <a:pt x="702" y="284"/>
                  </a:lnTo>
                  <a:lnTo>
                    <a:pt x="707" y="284"/>
                  </a:lnTo>
                  <a:lnTo>
                    <a:pt x="720" y="284"/>
                  </a:lnTo>
                  <a:lnTo>
                    <a:pt x="728" y="284"/>
                  </a:lnTo>
                  <a:lnTo>
                    <a:pt x="731" y="284"/>
                  </a:lnTo>
                  <a:lnTo>
                    <a:pt x="739" y="284"/>
                  </a:lnTo>
                  <a:lnTo>
                    <a:pt x="750" y="284"/>
                  </a:lnTo>
                  <a:lnTo>
                    <a:pt x="756" y="284"/>
                  </a:lnTo>
                  <a:lnTo>
                    <a:pt x="762" y="284"/>
                  </a:lnTo>
                  <a:lnTo>
                    <a:pt x="768" y="284"/>
                  </a:lnTo>
                  <a:lnTo>
                    <a:pt x="774" y="284"/>
                  </a:lnTo>
                  <a:lnTo>
                    <a:pt x="785" y="284"/>
                  </a:lnTo>
                  <a:lnTo>
                    <a:pt x="787" y="284"/>
                  </a:lnTo>
                  <a:lnTo>
                    <a:pt x="795" y="284"/>
                  </a:lnTo>
                  <a:lnTo>
                    <a:pt x="795" y="269"/>
                  </a:lnTo>
                  <a:lnTo>
                    <a:pt x="800" y="269"/>
                  </a:lnTo>
                  <a:lnTo>
                    <a:pt x="804" y="269"/>
                  </a:lnTo>
                  <a:lnTo>
                    <a:pt x="810" y="269"/>
                  </a:lnTo>
                  <a:lnTo>
                    <a:pt x="817" y="269"/>
                  </a:lnTo>
                  <a:lnTo>
                    <a:pt x="822" y="269"/>
                  </a:lnTo>
                  <a:lnTo>
                    <a:pt x="830" y="269"/>
                  </a:lnTo>
                  <a:lnTo>
                    <a:pt x="835" y="269"/>
                  </a:lnTo>
                  <a:lnTo>
                    <a:pt x="841" y="269"/>
                  </a:lnTo>
                  <a:lnTo>
                    <a:pt x="849" y="269"/>
                  </a:lnTo>
                  <a:lnTo>
                    <a:pt x="852" y="269"/>
                  </a:lnTo>
                  <a:lnTo>
                    <a:pt x="864" y="269"/>
                  </a:lnTo>
                  <a:lnTo>
                    <a:pt x="871" y="269"/>
                  </a:lnTo>
                  <a:lnTo>
                    <a:pt x="877" y="269"/>
                  </a:lnTo>
                  <a:lnTo>
                    <a:pt x="882" y="269"/>
                  </a:lnTo>
                  <a:lnTo>
                    <a:pt x="889" y="269"/>
                  </a:lnTo>
                  <a:lnTo>
                    <a:pt x="895" y="269"/>
                  </a:lnTo>
                  <a:lnTo>
                    <a:pt x="902" y="269"/>
                  </a:lnTo>
                  <a:lnTo>
                    <a:pt x="910" y="269"/>
                  </a:lnTo>
                  <a:lnTo>
                    <a:pt x="912" y="269"/>
                  </a:lnTo>
                  <a:lnTo>
                    <a:pt x="921" y="269"/>
                  </a:lnTo>
                  <a:lnTo>
                    <a:pt x="930" y="269"/>
                  </a:lnTo>
                  <a:lnTo>
                    <a:pt x="931" y="269"/>
                  </a:lnTo>
                  <a:lnTo>
                    <a:pt x="936" y="269"/>
                  </a:lnTo>
                  <a:lnTo>
                    <a:pt x="944" y="269"/>
                  </a:lnTo>
                  <a:lnTo>
                    <a:pt x="950" y="269"/>
                  </a:lnTo>
                  <a:lnTo>
                    <a:pt x="954" y="269"/>
                  </a:lnTo>
                  <a:lnTo>
                    <a:pt x="971" y="269"/>
                  </a:lnTo>
                  <a:lnTo>
                    <a:pt x="986" y="269"/>
                  </a:lnTo>
                  <a:lnTo>
                    <a:pt x="1006" y="269"/>
                  </a:lnTo>
                  <a:lnTo>
                    <a:pt x="1009" y="269"/>
                  </a:lnTo>
                  <a:lnTo>
                    <a:pt x="1024" y="269"/>
                  </a:lnTo>
                  <a:lnTo>
                    <a:pt x="1030" y="269"/>
                  </a:lnTo>
                  <a:lnTo>
                    <a:pt x="1037" y="269"/>
                  </a:lnTo>
                  <a:lnTo>
                    <a:pt x="1051" y="269"/>
                  </a:lnTo>
                  <a:lnTo>
                    <a:pt x="1051" y="0"/>
                  </a:lnTo>
                  <a:lnTo>
                    <a:pt x="1100" y="0"/>
                  </a:lnTo>
                  <a:lnTo>
                    <a:pt x="1119" y="0"/>
                  </a:lnTo>
                  <a:lnTo>
                    <a:pt x="1125" y="0"/>
                  </a:lnTo>
                  <a:lnTo>
                    <a:pt x="1131" y="0"/>
                  </a:lnTo>
                  <a:lnTo>
                    <a:pt x="1613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Freeform 21">
              <a:extLst>
                <a:ext uri="{FF2B5EF4-FFF2-40B4-BE49-F238E27FC236}">
                  <a16:creationId xmlns:a16="http://schemas.microsoft.com/office/drawing/2014/main" id="{99A8C599-B5FD-13DF-48F2-C1AC12BC04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918" y="938455"/>
              <a:ext cx="2192055" cy="2077866"/>
            </a:xfrm>
            <a:custGeom>
              <a:avLst/>
              <a:gdLst>
                <a:gd name="T0" fmla="*/ 90 w 1159"/>
                <a:gd name="T1" fmla="*/ 1012 h 1012"/>
                <a:gd name="T2" fmla="*/ 110 w 1159"/>
                <a:gd name="T3" fmla="*/ 1012 h 1012"/>
                <a:gd name="T4" fmla="*/ 128 w 1159"/>
                <a:gd name="T5" fmla="*/ 1012 h 1012"/>
                <a:gd name="T6" fmla="*/ 143 w 1159"/>
                <a:gd name="T7" fmla="*/ 1012 h 1012"/>
                <a:gd name="T8" fmla="*/ 160 w 1159"/>
                <a:gd name="T9" fmla="*/ 1012 h 1012"/>
                <a:gd name="T10" fmla="*/ 178 w 1159"/>
                <a:gd name="T11" fmla="*/ 1012 h 1012"/>
                <a:gd name="T12" fmla="*/ 196 w 1159"/>
                <a:gd name="T13" fmla="*/ 1012 h 1012"/>
                <a:gd name="T14" fmla="*/ 217 w 1159"/>
                <a:gd name="T15" fmla="*/ 1012 h 1012"/>
                <a:gd name="T16" fmla="*/ 232 w 1159"/>
                <a:gd name="T17" fmla="*/ 1012 h 1012"/>
                <a:gd name="T18" fmla="*/ 251 w 1159"/>
                <a:gd name="T19" fmla="*/ 1012 h 1012"/>
                <a:gd name="T20" fmla="*/ 269 w 1159"/>
                <a:gd name="T21" fmla="*/ 1012 h 1012"/>
                <a:gd name="T22" fmla="*/ 275 w 1159"/>
                <a:gd name="T23" fmla="*/ 1002 h 1012"/>
                <a:gd name="T24" fmla="*/ 289 w 1159"/>
                <a:gd name="T25" fmla="*/ 996 h 1012"/>
                <a:gd name="T26" fmla="*/ 305 w 1159"/>
                <a:gd name="T27" fmla="*/ 996 h 1012"/>
                <a:gd name="T28" fmla="*/ 319 w 1159"/>
                <a:gd name="T29" fmla="*/ 990 h 1012"/>
                <a:gd name="T30" fmla="*/ 330 w 1159"/>
                <a:gd name="T31" fmla="*/ 984 h 1012"/>
                <a:gd name="T32" fmla="*/ 353 w 1159"/>
                <a:gd name="T33" fmla="*/ 984 h 1012"/>
                <a:gd name="T34" fmla="*/ 377 w 1159"/>
                <a:gd name="T35" fmla="*/ 984 h 1012"/>
                <a:gd name="T36" fmla="*/ 395 w 1159"/>
                <a:gd name="T37" fmla="*/ 984 h 1012"/>
                <a:gd name="T38" fmla="*/ 413 w 1159"/>
                <a:gd name="T39" fmla="*/ 984 h 1012"/>
                <a:gd name="T40" fmla="*/ 431 w 1159"/>
                <a:gd name="T41" fmla="*/ 984 h 1012"/>
                <a:gd name="T42" fmla="*/ 444 w 1159"/>
                <a:gd name="T43" fmla="*/ 977 h 1012"/>
                <a:gd name="T44" fmla="*/ 457 w 1159"/>
                <a:gd name="T45" fmla="*/ 969 h 1012"/>
                <a:gd name="T46" fmla="*/ 473 w 1159"/>
                <a:gd name="T47" fmla="*/ 969 h 1012"/>
                <a:gd name="T48" fmla="*/ 491 w 1159"/>
                <a:gd name="T49" fmla="*/ 969 h 1012"/>
                <a:gd name="T50" fmla="*/ 510 w 1159"/>
                <a:gd name="T51" fmla="*/ 969 h 1012"/>
                <a:gd name="T52" fmla="*/ 530 w 1159"/>
                <a:gd name="T53" fmla="*/ 969 h 1012"/>
                <a:gd name="T54" fmla="*/ 559 w 1159"/>
                <a:gd name="T55" fmla="*/ 969 h 1012"/>
                <a:gd name="T56" fmla="*/ 577 w 1159"/>
                <a:gd name="T57" fmla="*/ 969 h 1012"/>
                <a:gd name="T58" fmla="*/ 587 w 1159"/>
                <a:gd name="T59" fmla="*/ 959 h 1012"/>
                <a:gd name="T60" fmla="*/ 607 w 1159"/>
                <a:gd name="T61" fmla="*/ 959 h 1012"/>
                <a:gd name="T62" fmla="*/ 626 w 1159"/>
                <a:gd name="T63" fmla="*/ 959 h 1012"/>
                <a:gd name="T64" fmla="*/ 642 w 1159"/>
                <a:gd name="T65" fmla="*/ 959 h 1012"/>
                <a:gd name="T66" fmla="*/ 669 w 1159"/>
                <a:gd name="T67" fmla="*/ 959 h 1012"/>
                <a:gd name="T68" fmla="*/ 684 w 1159"/>
                <a:gd name="T69" fmla="*/ 959 h 1012"/>
                <a:gd name="T70" fmla="*/ 701 w 1159"/>
                <a:gd name="T71" fmla="*/ 959 h 1012"/>
                <a:gd name="T72" fmla="*/ 726 w 1159"/>
                <a:gd name="T73" fmla="*/ 959 h 1012"/>
                <a:gd name="T74" fmla="*/ 744 w 1159"/>
                <a:gd name="T75" fmla="*/ 959 h 1012"/>
                <a:gd name="T76" fmla="*/ 761 w 1159"/>
                <a:gd name="T77" fmla="*/ 959 h 1012"/>
                <a:gd name="T78" fmla="*/ 780 w 1159"/>
                <a:gd name="T79" fmla="*/ 959 h 1012"/>
                <a:gd name="T80" fmla="*/ 804 w 1159"/>
                <a:gd name="T81" fmla="*/ 959 h 1012"/>
                <a:gd name="T82" fmla="*/ 824 w 1159"/>
                <a:gd name="T83" fmla="*/ 959 h 1012"/>
                <a:gd name="T84" fmla="*/ 844 w 1159"/>
                <a:gd name="T85" fmla="*/ 959 h 1012"/>
                <a:gd name="T86" fmla="*/ 860 w 1159"/>
                <a:gd name="T87" fmla="*/ 959 h 1012"/>
                <a:gd name="T88" fmla="*/ 876 w 1159"/>
                <a:gd name="T89" fmla="*/ 959 h 1012"/>
                <a:gd name="T90" fmla="*/ 896 w 1159"/>
                <a:gd name="T91" fmla="*/ 959 h 1012"/>
                <a:gd name="T92" fmla="*/ 916 w 1159"/>
                <a:gd name="T93" fmla="*/ 959 h 1012"/>
                <a:gd name="T94" fmla="*/ 930 w 1159"/>
                <a:gd name="T95" fmla="*/ 959 h 1012"/>
                <a:gd name="T96" fmla="*/ 952 w 1159"/>
                <a:gd name="T97" fmla="*/ 959 h 1012"/>
                <a:gd name="T98" fmla="*/ 974 w 1159"/>
                <a:gd name="T99" fmla="*/ 959 h 1012"/>
                <a:gd name="T100" fmla="*/ 1023 w 1159"/>
                <a:gd name="T101" fmla="*/ 959 h 1012"/>
                <a:gd name="T102" fmla="*/ 1159 w 1159"/>
                <a:gd name="T103" fmla="*/ 0 h 10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1159" h="1012">
                  <a:moveTo>
                    <a:pt x="0" y="1012"/>
                  </a:moveTo>
                  <a:lnTo>
                    <a:pt x="83" y="1012"/>
                  </a:lnTo>
                  <a:lnTo>
                    <a:pt x="90" y="1012"/>
                  </a:lnTo>
                  <a:lnTo>
                    <a:pt x="95" y="1012"/>
                  </a:lnTo>
                  <a:lnTo>
                    <a:pt x="105" y="1012"/>
                  </a:lnTo>
                  <a:lnTo>
                    <a:pt x="110" y="1012"/>
                  </a:lnTo>
                  <a:lnTo>
                    <a:pt x="117" y="1012"/>
                  </a:lnTo>
                  <a:lnTo>
                    <a:pt x="121" y="1012"/>
                  </a:lnTo>
                  <a:lnTo>
                    <a:pt x="128" y="1012"/>
                  </a:lnTo>
                  <a:lnTo>
                    <a:pt x="130" y="1012"/>
                  </a:lnTo>
                  <a:lnTo>
                    <a:pt x="138" y="1012"/>
                  </a:lnTo>
                  <a:lnTo>
                    <a:pt x="143" y="1012"/>
                  </a:lnTo>
                  <a:lnTo>
                    <a:pt x="148" y="1012"/>
                  </a:lnTo>
                  <a:lnTo>
                    <a:pt x="155" y="1012"/>
                  </a:lnTo>
                  <a:lnTo>
                    <a:pt x="160" y="1012"/>
                  </a:lnTo>
                  <a:lnTo>
                    <a:pt x="166" y="1012"/>
                  </a:lnTo>
                  <a:lnTo>
                    <a:pt x="173" y="1012"/>
                  </a:lnTo>
                  <a:lnTo>
                    <a:pt x="178" y="1012"/>
                  </a:lnTo>
                  <a:lnTo>
                    <a:pt x="185" y="1012"/>
                  </a:lnTo>
                  <a:lnTo>
                    <a:pt x="193" y="1012"/>
                  </a:lnTo>
                  <a:lnTo>
                    <a:pt x="196" y="1012"/>
                  </a:lnTo>
                  <a:lnTo>
                    <a:pt x="204" y="1012"/>
                  </a:lnTo>
                  <a:lnTo>
                    <a:pt x="210" y="1012"/>
                  </a:lnTo>
                  <a:lnTo>
                    <a:pt x="217" y="1012"/>
                  </a:lnTo>
                  <a:lnTo>
                    <a:pt x="224" y="1012"/>
                  </a:lnTo>
                  <a:lnTo>
                    <a:pt x="228" y="1012"/>
                  </a:lnTo>
                  <a:lnTo>
                    <a:pt x="232" y="1012"/>
                  </a:lnTo>
                  <a:lnTo>
                    <a:pt x="238" y="1012"/>
                  </a:lnTo>
                  <a:lnTo>
                    <a:pt x="246" y="1012"/>
                  </a:lnTo>
                  <a:lnTo>
                    <a:pt x="251" y="1012"/>
                  </a:lnTo>
                  <a:lnTo>
                    <a:pt x="256" y="1012"/>
                  </a:lnTo>
                  <a:lnTo>
                    <a:pt x="267" y="1012"/>
                  </a:lnTo>
                  <a:lnTo>
                    <a:pt x="269" y="1012"/>
                  </a:lnTo>
                  <a:lnTo>
                    <a:pt x="269" y="1007"/>
                  </a:lnTo>
                  <a:lnTo>
                    <a:pt x="270" y="1002"/>
                  </a:lnTo>
                  <a:lnTo>
                    <a:pt x="275" y="1002"/>
                  </a:lnTo>
                  <a:lnTo>
                    <a:pt x="275" y="996"/>
                  </a:lnTo>
                  <a:lnTo>
                    <a:pt x="281" y="996"/>
                  </a:lnTo>
                  <a:lnTo>
                    <a:pt x="289" y="996"/>
                  </a:lnTo>
                  <a:lnTo>
                    <a:pt x="292" y="996"/>
                  </a:lnTo>
                  <a:lnTo>
                    <a:pt x="299" y="996"/>
                  </a:lnTo>
                  <a:lnTo>
                    <a:pt x="305" y="996"/>
                  </a:lnTo>
                  <a:lnTo>
                    <a:pt x="307" y="990"/>
                  </a:lnTo>
                  <a:lnTo>
                    <a:pt x="311" y="990"/>
                  </a:lnTo>
                  <a:lnTo>
                    <a:pt x="319" y="990"/>
                  </a:lnTo>
                  <a:lnTo>
                    <a:pt x="322" y="990"/>
                  </a:lnTo>
                  <a:lnTo>
                    <a:pt x="330" y="990"/>
                  </a:lnTo>
                  <a:lnTo>
                    <a:pt x="330" y="984"/>
                  </a:lnTo>
                  <a:lnTo>
                    <a:pt x="335" y="984"/>
                  </a:lnTo>
                  <a:lnTo>
                    <a:pt x="347" y="984"/>
                  </a:lnTo>
                  <a:lnTo>
                    <a:pt x="353" y="984"/>
                  </a:lnTo>
                  <a:lnTo>
                    <a:pt x="360" y="984"/>
                  </a:lnTo>
                  <a:lnTo>
                    <a:pt x="366" y="984"/>
                  </a:lnTo>
                  <a:lnTo>
                    <a:pt x="377" y="984"/>
                  </a:lnTo>
                  <a:lnTo>
                    <a:pt x="383" y="984"/>
                  </a:lnTo>
                  <a:lnTo>
                    <a:pt x="389" y="984"/>
                  </a:lnTo>
                  <a:lnTo>
                    <a:pt x="395" y="984"/>
                  </a:lnTo>
                  <a:lnTo>
                    <a:pt x="403" y="984"/>
                  </a:lnTo>
                  <a:lnTo>
                    <a:pt x="407" y="984"/>
                  </a:lnTo>
                  <a:lnTo>
                    <a:pt x="413" y="984"/>
                  </a:lnTo>
                  <a:lnTo>
                    <a:pt x="419" y="984"/>
                  </a:lnTo>
                  <a:lnTo>
                    <a:pt x="426" y="984"/>
                  </a:lnTo>
                  <a:lnTo>
                    <a:pt x="431" y="984"/>
                  </a:lnTo>
                  <a:lnTo>
                    <a:pt x="438" y="984"/>
                  </a:lnTo>
                  <a:lnTo>
                    <a:pt x="442" y="977"/>
                  </a:lnTo>
                  <a:lnTo>
                    <a:pt x="444" y="977"/>
                  </a:lnTo>
                  <a:lnTo>
                    <a:pt x="452" y="977"/>
                  </a:lnTo>
                  <a:lnTo>
                    <a:pt x="452" y="969"/>
                  </a:lnTo>
                  <a:lnTo>
                    <a:pt x="457" y="969"/>
                  </a:lnTo>
                  <a:lnTo>
                    <a:pt x="464" y="969"/>
                  </a:lnTo>
                  <a:lnTo>
                    <a:pt x="469" y="969"/>
                  </a:lnTo>
                  <a:lnTo>
                    <a:pt x="473" y="969"/>
                  </a:lnTo>
                  <a:lnTo>
                    <a:pt x="479" y="969"/>
                  </a:lnTo>
                  <a:lnTo>
                    <a:pt x="486" y="969"/>
                  </a:lnTo>
                  <a:lnTo>
                    <a:pt x="491" y="969"/>
                  </a:lnTo>
                  <a:lnTo>
                    <a:pt x="500" y="969"/>
                  </a:lnTo>
                  <a:lnTo>
                    <a:pt x="505" y="969"/>
                  </a:lnTo>
                  <a:lnTo>
                    <a:pt x="510" y="969"/>
                  </a:lnTo>
                  <a:lnTo>
                    <a:pt x="518" y="969"/>
                  </a:lnTo>
                  <a:lnTo>
                    <a:pt x="521" y="969"/>
                  </a:lnTo>
                  <a:lnTo>
                    <a:pt x="530" y="969"/>
                  </a:lnTo>
                  <a:lnTo>
                    <a:pt x="539" y="969"/>
                  </a:lnTo>
                  <a:lnTo>
                    <a:pt x="548" y="969"/>
                  </a:lnTo>
                  <a:lnTo>
                    <a:pt x="559" y="969"/>
                  </a:lnTo>
                  <a:lnTo>
                    <a:pt x="564" y="969"/>
                  </a:lnTo>
                  <a:lnTo>
                    <a:pt x="570" y="969"/>
                  </a:lnTo>
                  <a:lnTo>
                    <a:pt x="577" y="969"/>
                  </a:lnTo>
                  <a:lnTo>
                    <a:pt x="582" y="969"/>
                  </a:lnTo>
                  <a:lnTo>
                    <a:pt x="582" y="959"/>
                  </a:lnTo>
                  <a:lnTo>
                    <a:pt x="587" y="959"/>
                  </a:lnTo>
                  <a:lnTo>
                    <a:pt x="596" y="959"/>
                  </a:lnTo>
                  <a:lnTo>
                    <a:pt x="604" y="959"/>
                  </a:lnTo>
                  <a:lnTo>
                    <a:pt x="607" y="959"/>
                  </a:lnTo>
                  <a:lnTo>
                    <a:pt x="612" y="959"/>
                  </a:lnTo>
                  <a:lnTo>
                    <a:pt x="618" y="959"/>
                  </a:lnTo>
                  <a:lnTo>
                    <a:pt x="626" y="959"/>
                  </a:lnTo>
                  <a:lnTo>
                    <a:pt x="634" y="959"/>
                  </a:lnTo>
                  <a:lnTo>
                    <a:pt x="635" y="959"/>
                  </a:lnTo>
                  <a:lnTo>
                    <a:pt x="642" y="959"/>
                  </a:lnTo>
                  <a:lnTo>
                    <a:pt x="648" y="959"/>
                  </a:lnTo>
                  <a:lnTo>
                    <a:pt x="659" y="959"/>
                  </a:lnTo>
                  <a:lnTo>
                    <a:pt x="669" y="959"/>
                  </a:lnTo>
                  <a:lnTo>
                    <a:pt x="673" y="959"/>
                  </a:lnTo>
                  <a:lnTo>
                    <a:pt x="682" y="959"/>
                  </a:lnTo>
                  <a:lnTo>
                    <a:pt x="684" y="959"/>
                  </a:lnTo>
                  <a:lnTo>
                    <a:pt x="690" y="959"/>
                  </a:lnTo>
                  <a:lnTo>
                    <a:pt x="698" y="959"/>
                  </a:lnTo>
                  <a:lnTo>
                    <a:pt x="701" y="959"/>
                  </a:lnTo>
                  <a:lnTo>
                    <a:pt x="707" y="959"/>
                  </a:lnTo>
                  <a:lnTo>
                    <a:pt x="720" y="959"/>
                  </a:lnTo>
                  <a:lnTo>
                    <a:pt x="726" y="959"/>
                  </a:lnTo>
                  <a:lnTo>
                    <a:pt x="732" y="959"/>
                  </a:lnTo>
                  <a:lnTo>
                    <a:pt x="737" y="959"/>
                  </a:lnTo>
                  <a:lnTo>
                    <a:pt x="744" y="959"/>
                  </a:lnTo>
                  <a:lnTo>
                    <a:pt x="751" y="959"/>
                  </a:lnTo>
                  <a:lnTo>
                    <a:pt x="758" y="959"/>
                  </a:lnTo>
                  <a:lnTo>
                    <a:pt x="761" y="959"/>
                  </a:lnTo>
                  <a:lnTo>
                    <a:pt x="768" y="959"/>
                  </a:lnTo>
                  <a:lnTo>
                    <a:pt x="774" y="959"/>
                  </a:lnTo>
                  <a:lnTo>
                    <a:pt x="780" y="959"/>
                  </a:lnTo>
                  <a:lnTo>
                    <a:pt x="787" y="959"/>
                  </a:lnTo>
                  <a:lnTo>
                    <a:pt x="800" y="959"/>
                  </a:lnTo>
                  <a:lnTo>
                    <a:pt x="804" y="959"/>
                  </a:lnTo>
                  <a:lnTo>
                    <a:pt x="811" y="959"/>
                  </a:lnTo>
                  <a:lnTo>
                    <a:pt x="818" y="959"/>
                  </a:lnTo>
                  <a:lnTo>
                    <a:pt x="824" y="959"/>
                  </a:lnTo>
                  <a:lnTo>
                    <a:pt x="828" y="959"/>
                  </a:lnTo>
                  <a:lnTo>
                    <a:pt x="834" y="959"/>
                  </a:lnTo>
                  <a:lnTo>
                    <a:pt x="844" y="959"/>
                  </a:lnTo>
                  <a:lnTo>
                    <a:pt x="846" y="959"/>
                  </a:lnTo>
                  <a:lnTo>
                    <a:pt x="853" y="959"/>
                  </a:lnTo>
                  <a:lnTo>
                    <a:pt x="860" y="959"/>
                  </a:lnTo>
                  <a:lnTo>
                    <a:pt x="865" y="959"/>
                  </a:lnTo>
                  <a:lnTo>
                    <a:pt x="873" y="959"/>
                  </a:lnTo>
                  <a:lnTo>
                    <a:pt x="876" y="959"/>
                  </a:lnTo>
                  <a:lnTo>
                    <a:pt x="882" y="959"/>
                  </a:lnTo>
                  <a:lnTo>
                    <a:pt x="890" y="959"/>
                  </a:lnTo>
                  <a:lnTo>
                    <a:pt x="896" y="959"/>
                  </a:lnTo>
                  <a:lnTo>
                    <a:pt x="901" y="959"/>
                  </a:lnTo>
                  <a:lnTo>
                    <a:pt x="908" y="959"/>
                  </a:lnTo>
                  <a:lnTo>
                    <a:pt x="916" y="959"/>
                  </a:lnTo>
                  <a:lnTo>
                    <a:pt x="922" y="959"/>
                  </a:lnTo>
                  <a:lnTo>
                    <a:pt x="926" y="959"/>
                  </a:lnTo>
                  <a:lnTo>
                    <a:pt x="930" y="959"/>
                  </a:lnTo>
                  <a:lnTo>
                    <a:pt x="936" y="959"/>
                  </a:lnTo>
                  <a:lnTo>
                    <a:pt x="944" y="959"/>
                  </a:lnTo>
                  <a:lnTo>
                    <a:pt x="952" y="959"/>
                  </a:lnTo>
                  <a:lnTo>
                    <a:pt x="957" y="959"/>
                  </a:lnTo>
                  <a:lnTo>
                    <a:pt x="962" y="959"/>
                  </a:lnTo>
                  <a:lnTo>
                    <a:pt x="974" y="959"/>
                  </a:lnTo>
                  <a:lnTo>
                    <a:pt x="991" y="959"/>
                  </a:lnTo>
                  <a:lnTo>
                    <a:pt x="1005" y="959"/>
                  </a:lnTo>
                  <a:lnTo>
                    <a:pt x="1023" y="959"/>
                  </a:lnTo>
                  <a:lnTo>
                    <a:pt x="1099" y="959"/>
                  </a:lnTo>
                  <a:lnTo>
                    <a:pt x="1099" y="0"/>
                  </a:lnTo>
                  <a:lnTo>
                    <a:pt x="1159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Rectangle 22">
              <a:extLst>
                <a:ext uri="{FF2B5EF4-FFF2-40B4-BE49-F238E27FC236}">
                  <a16:creationId xmlns:a16="http://schemas.microsoft.com/office/drawing/2014/main" id="{A7F39B3A-C8A9-8993-C9CB-2C4E7D9235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2918" y="788569"/>
              <a:ext cx="3130156" cy="2215433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Freeform 20">
              <a:extLst>
                <a:ext uri="{FF2B5EF4-FFF2-40B4-BE49-F238E27FC236}">
                  <a16:creationId xmlns:a16="http://schemas.microsoft.com/office/drawing/2014/main" id="{C9E22773-02A2-ED07-C510-B5E277E81E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3112" y="3024052"/>
              <a:ext cx="2005109" cy="0"/>
            </a:xfrm>
            <a:custGeom>
              <a:avLst/>
              <a:gdLst>
                <a:gd name="T0" fmla="*/ 92 w 1064"/>
                <a:gd name="T1" fmla="*/ 126 w 1064"/>
                <a:gd name="T2" fmla="*/ 137 w 1064"/>
                <a:gd name="T3" fmla="*/ 149 w 1064"/>
                <a:gd name="T4" fmla="*/ 163 w 1064"/>
                <a:gd name="T5" fmla="*/ 173 w 1064"/>
                <a:gd name="T6" fmla="*/ 185 w 1064"/>
                <a:gd name="T7" fmla="*/ 199 w 1064"/>
                <a:gd name="T8" fmla="*/ 216 w 1064"/>
                <a:gd name="T9" fmla="*/ 226 w 1064"/>
                <a:gd name="T10" fmla="*/ 238 w 1064"/>
                <a:gd name="T11" fmla="*/ 253 w 1064"/>
                <a:gd name="T12" fmla="*/ 263 w 1064"/>
                <a:gd name="T13" fmla="*/ 277 w 1064"/>
                <a:gd name="T14" fmla="*/ 288 w 1064"/>
                <a:gd name="T15" fmla="*/ 299 w 1064"/>
                <a:gd name="T16" fmla="*/ 323 w 1064"/>
                <a:gd name="T17" fmla="*/ 347 w 1064"/>
                <a:gd name="T18" fmla="*/ 361 w 1064"/>
                <a:gd name="T19" fmla="*/ 382 w 1064"/>
                <a:gd name="T20" fmla="*/ 389 w 1064"/>
                <a:gd name="T21" fmla="*/ 408 w 1064"/>
                <a:gd name="T22" fmla="*/ 423 w 1064"/>
                <a:gd name="T23" fmla="*/ 431 w 1064"/>
                <a:gd name="T24" fmla="*/ 444 w 1064"/>
                <a:gd name="T25" fmla="*/ 469 w 1064"/>
                <a:gd name="T26" fmla="*/ 487 w 1064"/>
                <a:gd name="T27" fmla="*/ 506 w 1064"/>
                <a:gd name="T28" fmla="*/ 527 w 1064"/>
                <a:gd name="T29" fmla="*/ 542 w 1064"/>
                <a:gd name="T30" fmla="*/ 553 w 1064"/>
                <a:gd name="T31" fmla="*/ 571 w 1064"/>
                <a:gd name="T32" fmla="*/ 594 w 1064"/>
                <a:gd name="T33" fmla="*/ 614 w 1064"/>
                <a:gd name="T34" fmla="*/ 634 w 1064"/>
                <a:gd name="T35" fmla="*/ 644 w 1064"/>
                <a:gd name="T36" fmla="*/ 672 w 1064"/>
                <a:gd name="T37" fmla="*/ 685 w 1064"/>
                <a:gd name="T38" fmla="*/ 707 w 1064"/>
                <a:gd name="T39" fmla="*/ 721 w 1064"/>
                <a:gd name="T40" fmla="*/ 733 w 1064"/>
                <a:gd name="T41" fmla="*/ 744 w 1064"/>
                <a:gd name="T42" fmla="*/ 760 w 1064"/>
                <a:gd name="T43" fmla="*/ 783 w 1064"/>
                <a:gd name="T44" fmla="*/ 800 w 1064"/>
                <a:gd name="T45" fmla="*/ 815 w 1064"/>
                <a:gd name="T46" fmla="*/ 833 w 1064"/>
                <a:gd name="T47" fmla="*/ 858 w 1064"/>
                <a:gd name="T48" fmla="*/ 873 w 1064"/>
                <a:gd name="T49" fmla="*/ 886 w 1064"/>
                <a:gd name="T50" fmla="*/ 894 w 1064"/>
                <a:gd name="T51" fmla="*/ 930 w 1064"/>
                <a:gd name="T52" fmla="*/ 951 w 1064"/>
                <a:gd name="T53" fmla="*/ 1015 w 106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</a:cxnLst>
              <a:rect l="0" t="0" r="r" b="b"/>
              <a:pathLst>
                <a:path w="1064">
                  <a:moveTo>
                    <a:pt x="0" y="0"/>
                  </a:moveTo>
                  <a:lnTo>
                    <a:pt x="92" y="0"/>
                  </a:lnTo>
                  <a:lnTo>
                    <a:pt x="99" y="0"/>
                  </a:lnTo>
                  <a:lnTo>
                    <a:pt x="126" y="0"/>
                  </a:lnTo>
                  <a:lnTo>
                    <a:pt x="133" y="0"/>
                  </a:lnTo>
                  <a:lnTo>
                    <a:pt x="137" y="0"/>
                  </a:lnTo>
                  <a:lnTo>
                    <a:pt x="143" y="0"/>
                  </a:lnTo>
                  <a:lnTo>
                    <a:pt x="149" y="0"/>
                  </a:lnTo>
                  <a:lnTo>
                    <a:pt x="154" y="0"/>
                  </a:lnTo>
                  <a:lnTo>
                    <a:pt x="163" y="0"/>
                  </a:lnTo>
                  <a:lnTo>
                    <a:pt x="166" y="0"/>
                  </a:lnTo>
                  <a:lnTo>
                    <a:pt x="173" y="0"/>
                  </a:lnTo>
                  <a:lnTo>
                    <a:pt x="183" y="0"/>
                  </a:lnTo>
                  <a:lnTo>
                    <a:pt x="185" y="0"/>
                  </a:lnTo>
                  <a:lnTo>
                    <a:pt x="192" y="0"/>
                  </a:lnTo>
                  <a:lnTo>
                    <a:pt x="199" y="0"/>
                  </a:lnTo>
                  <a:lnTo>
                    <a:pt x="211" y="0"/>
                  </a:lnTo>
                  <a:lnTo>
                    <a:pt x="216" y="0"/>
                  </a:lnTo>
                  <a:lnTo>
                    <a:pt x="223" y="0"/>
                  </a:lnTo>
                  <a:lnTo>
                    <a:pt x="226" y="0"/>
                  </a:lnTo>
                  <a:lnTo>
                    <a:pt x="234" y="0"/>
                  </a:lnTo>
                  <a:lnTo>
                    <a:pt x="238" y="0"/>
                  </a:lnTo>
                  <a:lnTo>
                    <a:pt x="244" y="0"/>
                  </a:lnTo>
                  <a:lnTo>
                    <a:pt x="253" y="0"/>
                  </a:lnTo>
                  <a:lnTo>
                    <a:pt x="257" y="0"/>
                  </a:lnTo>
                  <a:lnTo>
                    <a:pt x="263" y="0"/>
                  </a:lnTo>
                  <a:lnTo>
                    <a:pt x="269" y="0"/>
                  </a:lnTo>
                  <a:lnTo>
                    <a:pt x="277" y="0"/>
                  </a:lnTo>
                  <a:lnTo>
                    <a:pt x="282" y="0"/>
                  </a:lnTo>
                  <a:lnTo>
                    <a:pt x="288" y="0"/>
                  </a:lnTo>
                  <a:lnTo>
                    <a:pt x="293" y="0"/>
                  </a:lnTo>
                  <a:lnTo>
                    <a:pt x="299" y="0"/>
                  </a:lnTo>
                  <a:lnTo>
                    <a:pt x="305" y="0"/>
                  </a:lnTo>
                  <a:lnTo>
                    <a:pt x="323" y="0"/>
                  </a:lnTo>
                  <a:lnTo>
                    <a:pt x="335" y="0"/>
                  </a:lnTo>
                  <a:lnTo>
                    <a:pt x="347" y="0"/>
                  </a:lnTo>
                  <a:lnTo>
                    <a:pt x="352" y="0"/>
                  </a:lnTo>
                  <a:lnTo>
                    <a:pt x="361" y="0"/>
                  </a:lnTo>
                  <a:lnTo>
                    <a:pt x="366" y="0"/>
                  </a:lnTo>
                  <a:lnTo>
                    <a:pt x="382" y="0"/>
                  </a:lnTo>
                  <a:lnTo>
                    <a:pt x="387" y="0"/>
                  </a:lnTo>
                  <a:lnTo>
                    <a:pt x="389" y="0"/>
                  </a:lnTo>
                  <a:lnTo>
                    <a:pt x="405" y="0"/>
                  </a:lnTo>
                  <a:lnTo>
                    <a:pt x="408" y="0"/>
                  </a:lnTo>
                  <a:lnTo>
                    <a:pt x="413" y="0"/>
                  </a:lnTo>
                  <a:lnTo>
                    <a:pt x="423" y="0"/>
                  </a:lnTo>
                  <a:lnTo>
                    <a:pt x="426" y="0"/>
                  </a:lnTo>
                  <a:lnTo>
                    <a:pt x="431" y="0"/>
                  </a:lnTo>
                  <a:lnTo>
                    <a:pt x="437" y="0"/>
                  </a:lnTo>
                  <a:lnTo>
                    <a:pt x="444" y="0"/>
                  </a:lnTo>
                  <a:lnTo>
                    <a:pt x="455" y="0"/>
                  </a:lnTo>
                  <a:lnTo>
                    <a:pt x="469" y="0"/>
                  </a:lnTo>
                  <a:lnTo>
                    <a:pt x="479" y="0"/>
                  </a:lnTo>
                  <a:lnTo>
                    <a:pt x="487" y="0"/>
                  </a:lnTo>
                  <a:lnTo>
                    <a:pt x="492" y="0"/>
                  </a:lnTo>
                  <a:lnTo>
                    <a:pt x="506" y="0"/>
                  </a:lnTo>
                  <a:lnTo>
                    <a:pt x="524" y="0"/>
                  </a:lnTo>
                  <a:lnTo>
                    <a:pt x="527" y="0"/>
                  </a:lnTo>
                  <a:lnTo>
                    <a:pt x="538" y="0"/>
                  </a:lnTo>
                  <a:lnTo>
                    <a:pt x="542" y="0"/>
                  </a:lnTo>
                  <a:lnTo>
                    <a:pt x="545" y="0"/>
                  </a:lnTo>
                  <a:lnTo>
                    <a:pt x="553" y="0"/>
                  </a:lnTo>
                  <a:lnTo>
                    <a:pt x="562" y="0"/>
                  </a:lnTo>
                  <a:lnTo>
                    <a:pt x="571" y="0"/>
                  </a:lnTo>
                  <a:lnTo>
                    <a:pt x="582" y="0"/>
                  </a:lnTo>
                  <a:lnTo>
                    <a:pt x="594" y="0"/>
                  </a:lnTo>
                  <a:lnTo>
                    <a:pt x="605" y="0"/>
                  </a:lnTo>
                  <a:lnTo>
                    <a:pt x="614" y="0"/>
                  </a:lnTo>
                  <a:lnTo>
                    <a:pt x="618" y="0"/>
                  </a:lnTo>
                  <a:lnTo>
                    <a:pt x="634" y="0"/>
                  </a:lnTo>
                  <a:lnTo>
                    <a:pt x="639" y="0"/>
                  </a:lnTo>
                  <a:lnTo>
                    <a:pt x="644" y="0"/>
                  </a:lnTo>
                  <a:lnTo>
                    <a:pt x="666" y="0"/>
                  </a:lnTo>
                  <a:lnTo>
                    <a:pt x="672" y="0"/>
                  </a:lnTo>
                  <a:lnTo>
                    <a:pt x="683" y="0"/>
                  </a:lnTo>
                  <a:lnTo>
                    <a:pt x="685" y="0"/>
                  </a:lnTo>
                  <a:lnTo>
                    <a:pt x="701" y="0"/>
                  </a:lnTo>
                  <a:lnTo>
                    <a:pt x="707" y="0"/>
                  </a:lnTo>
                  <a:lnTo>
                    <a:pt x="715" y="0"/>
                  </a:lnTo>
                  <a:lnTo>
                    <a:pt x="721" y="0"/>
                  </a:lnTo>
                  <a:lnTo>
                    <a:pt x="730" y="0"/>
                  </a:lnTo>
                  <a:lnTo>
                    <a:pt x="733" y="0"/>
                  </a:lnTo>
                  <a:lnTo>
                    <a:pt x="740" y="0"/>
                  </a:lnTo>
                  <a:lnTo>
                    <a:pt x="744" y="0"/>
                  </a:lnTo>
                  <a:lnTo>
                    <a:pt x="752" y="0"/>
                  </a:lnTo>
                  <a:lnTo>
                    <a:pt x="760" y="0"/>
                  </a:lnTo>
                  <a:lnTo>
                    <a:pt x="765" y="0"/>
                  </a:lnTo>
                  <a:lnTo>
                    <a:pt x="783" y="0"/>
                  </a:lnTo>
                  <a:lnTo>
                    <a:pt x="794" y="0"/>
                  </a:lnTo>
                  <a:lnTo>
                    <a:pt x="800" y="0"/>
                  </a:lnTo>
                  <a:lnTo>
                    <a:pt x="804" y="0"/>
                  </a:lnTo>
                  <a:lnTo>
                    <a:pt x="815" y="0"/>
                  </a:lnTo>
                  <a:lnTo>
                    <a:pt x="824" y="0"/>
                  </a:lnTo>
                  <a:lnTo>
                    <a:pt x="833" y="0"/>
                  </a:lnTo>
                  <a:lnTo>
                    <a:pt x="834" y="0"/>
                  </a:lnTo>
                  <a:lnTo>
                    <a:pt x="858" y="0"/>
                  </a:lnTo>
                  <a:lnTo>
                    <a:pt x="866" y="0"/>
                  </a:lnTo>
                  <a:lnTo>
                    <a:pt x="873" y="0"/>
                  </a:lnTo>
                  <a:lnTo>
                    <a:pt x="876" y="0"/>
                  </a:lnTo>
                  <a:lnTo>
                    <a:pt x="886" y="0"/>
                  </a:lnTo>
                  <a:lnTo>
                    <a:pt x="893" y="0"/>
                  </a:lnTo>
                  <a:lnTo>
                    <a:pt x="894" y="0"/>
                  </a:lnTo>
                  <a:lnTo>
                    <a:pt x="927" y="0"/>
                  </a:lnTo>
                  <a:lnTo>
                    <a:pt x="930" y="0"/>
                  </a:lnTo>
                  <a:lnTo>
                    <a:pt x="938" y="0"/>
                  </a:lnTo>
                  <a:lnTo>
                    <a:pt x="951" y="0"/>
                  </a:lnTo>
                  <a:lnTo>
                    <a:pt x="1005" y="0"/>
                  </a:lnTo>
                  <a:lnTo>
                    <a:pt x="1015" y="0"/>
                  </a:lnTo>
                  <a:lnTo>
                    <a:pt x="1064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E666BFC0-8F3E-BF56-8A22-CAB72CFB57AC}"/>
              </a:ext>
            </a:extLst>
          </p:cNvPr>
          <p:cNvGrpSpPr/>
          <p:nvPr/>
        </p:nvGrpSpPr>
        <p:grpSpPr>
          <a:xfrm>
            <a:off x="1200815" y="3636606"/>
            <a:ext cx="4141083" cy="2791354"/>
            <a:chOff x="1491095" y="3926886"/>
            <a:chExt cx="4141083" cy="2791354"/>
          </a:xfrm>
        </p:grpSpPr>
        <p:grpSp>
          <p:nvGrpSpPr>
            <p:cNvPr id="115" name="グループ化 114">
              <a:extLst>
                <a:ext uri="{FF2B5EF4-FFF2-40B4-BE49-F238E27FC236}">
                  <a16:creationId xmlns:a16="http://schemas.microsoft.com/office/drawing/2014/main" id="{727B5219-8F5F-042D-2D53-01CA93BA6F7A}"/>
                </a:ext>
              </a:extLst>
            </p:cNvPr>
            <p:cNvGrpSpPr/>
            <p:nvPr/>
          </p:nvGrpSpPr>
          <p:grpSpPr>
            <a:xfrm>
              <a:off x="1491095" y="3926886"/>
              <a:ext cx="4141083" cy="2791354"/>
              <a:chOff x="1487880" y="741070"/>
              <a:chExt cx="4141083" cy="2791354"/>
            </a:xfrm>
          </p:grpSpPr>
          <p:sp>
            <p:nvSpPr>
              <p:cNvPr id="116" name="Rectangle 22">
                <a:extLst>
                  <a:ext uri="{FF2B5EF4-FFF2-40B4-BE49-F238E27FC236}">
                    <a16:creationId xmlns:a16="http://schemas.microsoft.com/office/drawing/2014/main" id="{86CC5F82-6578-ADB2-E951-294A39C800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7804" y="747591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7" name="Line 23">
                <a:extLst>
                  <a:ext uri="{FF2B5EF4-FFF2-40B4-BE49-F238E27FC236}">
                    <a16:creationId xmlns:a16="http://schemas.microsoft.com/office/drawing/2014/main" id="{B0C6DC00-D983-811D-BD2B-976B98ADEE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2137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8" name="Line 25">
                <a:extLst>
                  <a:ext uri="{FF2B5EF4-FFF2-40B4-BE49-F238E27FC236}">
                    <a16:creationId xmlns:a16="http://schemas.microsoft.com/office/drawing/2014/main" id="{B51A1053-40ED-2BD1-EBA7-16FD71CD8F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5354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9" name="Line 27">
                <a:extLst>
                  <a:ext uri="{FF2B5EF4-FFF2-40B4-BE49-F238E27FC236}">
                    <a16:creationId xmlns:a16="http://schemas.microsoft.com/office/drawing/2014/main" id="{A42BB508-9B4A-1EC0-A182-7B57992B41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8570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0" name="Line 29">
                <a:extLst>
                  <a:ext uri="{FF2B5EF4-FFF2-40B4-BE49-F238E27FC236}">
                    <a16:creationId xmlns:a16="http://schemas.microsoft.com/office/drawing/2014/main" id="{B85797AB-B491-3505-1B42-478DC068E9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9898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1" name="Line 31">
                <a:extLst>
                  <a:ext uri="{FF2B5EF4-FFF2-40B4-BE49-F238E27FC236}">
                    <a16:creationId xmlns:a16="http://schemas.microsoft.com/office/drawing/2014/main" id="{96A40B12-794E-2D3E-CFE0-A48EA78094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3115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2" name="Line 33">
                <a:extLst>
                  <a:ext uri="{FF2B5EF4-FFF2-40B4-BE49-F238E27FC236}">
                    <a16:creationId xmlns:a16="http://schemas.microsoft.com/office/drawing/2014/main" id="{A691B7B5-4CC3-19F8-FF70-A08969CB20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6331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3" name="Line 35">
                <a:extLst>
                  <a:ext uri="{FF2B5EF4-FFF2-40B4-BE49-F238E27FC236}">
                    <a16:creationId xmlns:a16="http://schemas.microsoft.com/office/drawing/2014/main" id="{9522A849-1C2E-B86E-8447-2DE0AD8B9C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9548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4" name="Line 6">
                <a:extLst>
                  <a:ext uri="{FF2B5EF4-FFF2-40B4-BE49-F238E27FC236}">
                    <a16:creationId xmlns:a16="http://schemas.microsoft.com/office/drawing/2014/main" id="{09FD6458-E5A5-7B5E-EE09-C7225EDBAD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2761368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5" name="Line 8">
                <a:extLst>
                  <a:ext uri="{FF2B5EF4-FFF2-40B4-BE49-F238E27FC236}">
                    <a16:creationId xmlns:a16="http://schemas.microsoft.com/office/drawing/2014/main" id="{D6E582BD-1987-B8EA-4D4D-9E8C9057FF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235387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6" name="Line 9">
                <a:extLst>
                  <a:ext uri="{FF2B5EF4-FFF2-40B4-BE49-F238E27FC236}">
                    <a16:creationId xmlns:a16="http://schemas.microsoft.com/office/drawing/2014/main" id="{D8F2A176-6F40-D599-0534-93643B9A06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194637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7" name="Line 11">
                <a:extLst>
                  <a:ext uri="{FF2B5EF4-FFF2-40B4-BE49-F238E27FC236}">
                    <a16:creationId xmlns:a16="http://schemas.microsoft.com/office/drawing/2014/main" id="{34826D9F-C381-21DC-C67F-E25AC466C4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153888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8" name="Line 12">
                <a:extLst>
                  <a:ext uri="{FF2B5EF4-FFF2-40B4-BE49-F238E27FC236}">
                    <a16:creationId xmlns:a16="http://schemas.microsoft.com/office/drawing/2014/main" id="{5A346EB4-7796-7FB5-B4C5-8CD8A95D70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113138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9" name="Line 14">
                <a:extLst>
                  <a:ext uri="{FF2B5EF4-FFF2-40B4-BE49-F238E27FC236}">
                    <a16:creationId xmlns:a16="http://schemas.microsoft.com/office/drawing/2014/main" id="{B84E56A1-9D7F-D982-1228-58D4D716BB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74779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0" name="Line 23">
                <a:extLst>
                  <a:ext uri="{FF2B5EF4-FFF2-40B4-BE49-F238E27FC236}">
                    <a16:creationId xmlns:a16="http://schemas.microsoft.com/office/drawing/2014/main" id="{DCA3F3E8-B0AC-CD00-0D6F-6876D41799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3825" y="2761369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31" name="図形グループ 54">
                <a:extLst>
                  <a:ext uri="{FF2B5EF4-FFF2-40B4-BE49-F238E27FC236}">
                    <a16:creationId xmlns:a16="http://schemas.microsoft.com/office/drawing/2014/main" id="{42F24EB9-EF1E-7310-AC27-06D25E7EC66B}"/>
                  </a:ext>
                </a:extLst>
              </p:cNvPr>
              <p:cNvGrpSpPr/>
              <p:nvPr/>
            </p:nvGrpSpPr>
            <p:grpSpPr>
              <a:xfrm>
                <a:off x="2034219" y="1002292"/>
                <a:ext cx="220989" cy="1868530"/>
                <a:chOff x="510218" y="1348283"/>
                <a:chExt cx="220989" cy="1868530"/>
              </a:xfrm>
            </p:grpSpPr>
            <p:sp>
              <p:nvSpPr>
                <p:cNvPr id="138" name="Rectangle 10">
                  <a:extLst>
                    <a:ext uri="{FF2B5EF4-FFF2-40B4-BE49-F238E27FC236}">
                      <a16:creationId xmlns:a16="http://schemas.microsoft.com/office/drawing/2014/main" id="{D4F181F8-9E26-E387-DEA4-A57B38691D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39" name="Rectangle 13">
                  <a:extLst>
                    <a:ext uri="{FF2B5EF4-FFF2-40B4-BE49-F238E27FC236}">
                      <a16:creationId xmlns:a16="http://schemas.microsoft.com/office/drawing/2014/main" id="{57E168EC-C266-22E3-A5AB-7D46267EA2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0" name="Rectangle 10">
                  <a:extLst>
                    <a:ext uri="{FF2B5EF4-FFF2-40B4-BE49-F238E27FC236}">
                      <a16:creationId xmlns:a16="http://schemas.microsoft.com/office/drawing/2014/main" id="{148AAB5F-9D30-0331-B7D5-7735888E12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D8613ACA-EEDC-AC84-BE60-0F98EED04375}"/>
                  </a:ext>
                </a:extLst>
              </p:cNvPr>
              <p:cNvSpPr txBox="1"/>
              <p:nvPr/>
            </p:nvSpPr>
            <p:spPr>
              <a:xfrm>
                <a:off x="2206686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F6A0C4B9-00FC-0C16-8276-0C60E7922747}"/>
                  </a:ext>
                </a:extLst>
              </p:cNvPr>
              <p:cNvSpPr txBox="1"/>
              <p:nvPr/>
            </p:nvSpPr>
            <p:spPr>
              <a:xfrm>
                <a:off x="3251225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4B4F7F64-2DE7-8CE1-22A6-EE85CA2E6E77}"/>
                  </a:ext>
                </a:extLst>
              </p:cNvPr>
              <p:cNvSpPr txBox="1"/>
              <p:nvPr/>
            </p:nvSpPr>
            <p:spPr>
              <a:xfrm>
                <a:off x="5340302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A42B9C6B-D3A7-A6E0-8ECC-CB27EF9E140A}"/>
                  </a:ext>
                </a:extLst>
              </p:cNvPr>
              <p:cNvSpPr txBox="1"/>
              <p:nvPr/>
            </p:nvSpPr>
            <p:spPr>
              <a:xfrm>
                <a:off x="4295764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4A0A6227-9745-C377-B5CC-C7968273710A}"/>
                  </a:ext>
                </a:extLst>
              </p:cNvPr>
              <p:cNvSpPr txBox="1"/>
              <p:nvPr/>
            </p:nvSpPr>
            <p:spPr>
              <a:xfrm rot="16200000">
                <a:off x="604785" y="1624165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C4F451DA-853D-0B01-0274-C0A2B21FA6F5}"/>
                  </a:ext>
                </a:extLst>
              </p:cNvPr>
              <p:cNvSpPr txBox="1"/>
              <p:nvPr/>
            </p:nvSpPr>
            <p:spPr>
              <a:xfrm>
                <a:off x="3108992" y="3163092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7" name="Freeform 56">
              <a:extLst>
                <a:ext uri="{FF2B5EF4-FFF2-40B4-BE49-F238E27FC236}">
                  <a16:creationId xmlns:a16="http://schemas.microsoft.com/office/drawing/2014/main" id="{88A43D3F-278B-E2E7-508D-584996AFA56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4329" y="5786608"/>
              <a:ext cx="1928421" cy="165365"/>
            </a:xfrm>
            <a:custGeom>
              <a:avLst/>
              <a:gdLst>
                <a:gd name="T0" fmla="*/ 85 w 1023"/>
                <a:gd name="T1" fmla="*/ 90 h 90"/>
                <a:gd name="T2" fmla="*/ 109 w 1023"/>
                <a:gd name="T3" fmla="*/ 90 h 90"/>
                <a:gd name="T4" fmla="*/ 129 w 1023"/>
                <a:gd name="T5" fmla="*/ 90 h 90"/>
                <a:gd name="T6" fmla="*/ 166 w 1023"/>
                <a:gd name="T7" fmla="*/ 90 h 90"/>
                <a:gd name="T8" fmla="*/ 172 w 1023"/>
                <a:gd name="T9" fmla="*/ 90 h 90"/>
                <a:gd name="T10" fmla="*/ 197 w 1023"/>
                <a:gd name="T11" fmla="*/ 90 h 90"/>
                <a:gd name="T12" fmla="*/ 213 w 1023"/>
                <a:gd name="T13" fmla="*/ 90 h 90"/>
                <a:gd name="T14" fmla="*/ 219 w 1023"/>
                <a:gd name="T15" fmla="*/ 70 h 90"/>
                <a:gd name="T16" fmla="*/ 249 w 1023"/>
                <a:gd name="T17" fmla="*/ 70 h 90"/>
                <a:gd name="T18" fmla="*/ 256 w 1023"/>
                <a:gd name="T19" fmla="*/ 70 h 90"/>
                <a:gd name="T20" fmla="*/ 277 w 1023"/>
                <a:gd name="T21" fmla="*/ 48 h 90"/>
                <a:gd name="T22" fmla="*/ 302 w 1023"/>
                <a:gd name="T23" fmla="*/ 26 h 90"/>
                <a:gd name="T24" fmla="*/ 319 w 1023"/>
                <a:gd name="T25" fmla="*/ 26 h 90"/>
                <a:gd name="T26" fmla="*/ 352 w 1023"/>
                <a:gd name="T27" fmla="*/ 26 h 90"/>
                <a:gd name="T28" fmla="*/ 361 w 1023"/>
                <a:gd name="T29" fmla="*/ 26 h 90"/>
                <a:gd name="T30" fmla="*/ 372 w 1023"/>
                <a:gd name="T31" fmla="*/ 26 h 90"/>
                <a:gd name="T32" fmla="*/ 409 w 1023"/>
                <a:gd name="T33" fmla="*/ 26 h 90"/>
                <a:gd name="T34" fmla="*/ 442 w 1023"/>
                <a:gd name="T35" fmla="*/ 0 h 90"/>
                <a:gd name="T36" fmla="*/ 476 w 1023"/>
                <a:gd name="T37" fmla="*/ 0 h 90"/>
                <a:gd name="T38" fmla="*/ 495 w 1023"/>
                <a:gd name="T39" fmla="*/ 0 h 90"/>
                <a:gd name="T40" fmla="*/ 507 w 1023"/>
                <a:gd name="T41" fmla="*/ 0 h 90"/>
                <a:gd name="T42" fmla="*/ 538 w 1023"/>
                <a:gd name="T43" fmla="*/ 0 h 90"/>
                <a:gd name="T44" fmla="*/ 545 w 1023"/>
                <a:gd name="T45" fmla="*/ 0 h 90"/>
                <a:gd name="T46" fmla="*/ 568 w 1023"/>
                <a:gd name="T47" fmla="*/ 0 h 90"/>
                <a:gd name="T48" fmla="*/ 578 w 1023"/>
                <a:gd name="T49" fmla="*/ 0 h 90"/>
                <a:gd name="T50" fmla="*/ 597 w 1023"/>
                <a:gd name="T51" fmla="*/ 0 h 90"/>
                <a:gd name="T52" fmla="*/ 616 w 1023"/>
                <a:gd name="T53" fmla="*/ 0 h 90"/>
                <a:gd name="T54" fmla="*/ 636 w 1023"/>
                <a:gd name="T55" fmla="*/ 0 h 90"/>
                <a:gd name="T56" fmla="*/ 684 w 1023"/>
                <a:gd name="T57" fmla="*/ 0 h 90"/>
                <a:gd name="T58" fmla="*/ 707 w 1023"/>
                <a:gd name="T59" fmla="*/ 0 h 90"/>
                <a:gd name="T60" fmla="*/ 722 w 1023"/>
                <a:gd name="T61" fmla="*/ 0 h 90"/>
                <a:gd name="T62" fmla="*/ 731 w 1023"/>
                <a:gd name="T63" fmla="*/ 0 h 90"/>
                <a:gd name="T64" fmla="*/ 778 w 1023"/>
                <a:gd name="T65" fmla="*/ 0 h 90"/>
                <a:gd name="T66" fmla="*/ 803 w 1023"/>
                <a:gd name="T67" fmla="*/ 0 h 90"/>
                <a:gd name="T68" fmla="*/ 827 w 1023"/>
                <a:gd name="T69" fmla="*/ 0 h 90"/>
                <a:gd name="T70" fmla="*/ 851 w 1023"/>
                <a:gd name="T71" fmla="*/ 0 h 90"/>
                <a:gd name="T72" fmla="*/ 865 w 1023"/>
                <a:gd name="T73" fmla="*/ 0 h 90"/>
                <a:gd name="T74" fmla="*/ 878 w 1023"/>
                <a:gd name="T75" fmla="*/ 0 h 90"/>
                <a:gd name="T76" fmla="*/ 889 w 1023"/>
                <a:gd name="T77" fmla="*/ 0 h 90"/>
                <a:gd name="T78" fmla="*/ 902 w 1023"/>
                <a:gd name="T79" fmla="*/ 0 h 90"/>
                <a:gd name="T80" fmla="*/ 947 w 1023"/>
                <a:gd name="T81" fmla="*/ 0 h 90"/>
                <a:gd name="T82" fmla="*/ 993 w 1023"/>
                <a:gd name="T83" fmla="*/ 0 h 90"/>
                <a:gd name="T84" fmla="*/ 1009 w 1023"/>
                <a:gd name="T85" fmla="*/ 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023" h="90">
                  <a:moveTo>
                    <a:pt x="0" y="90"/>
                  </a:moveTo>
                  <a:lnTo>
                    <a:pt x="85" y="90"/>
                  </a:lnTo>
                  <a:lnTo>
                    <a:pt x="88" y="90"/>
                  </a:lnTo>
                  <a:lnTo>
                    <a:pt x="109" y="90"/>
                  </a:lnTo>
                  <a:lnTo>
                    <a:pt x="116" y="90"/>
                  </a:lnTo>
                  <a:lnTo>
                    <a:pt x="129" y="90"/>
                  </a:lnTo>
                  <a:lnTo>
                    <a:pt x="138" y="90"/>
                  </a:lnTo>
                  <a:lnTo>
                    <a:pt x="166" y="90"/>
                  </a:lnTo>
                  <a:lnTo>
                    <a:pt x="170" y="90"/>
                  </a:lnTo>
                  <a:lnTo>
                    <a:pt x="172" y="90"/>
                  </a:lnTo>
                  <a:lnTo>
                    <a:pt x="185" y="90"/>
                  </a:lnTo>
                  <a:lnTo>
                    <a:pt x="197" y="90"/>
                  </a:lnTo>
                  <a:lnTo>
                    <a:pt x="202" y="90"/>
                  </a:lnTo>
                  <a:lnTo>
                    <a:pt x="213" y="90"/>
                  </a:lnTo>
                  <a:lnTo>
                    <a:pt x="213" y="70"/>
                  </a:lnTo>
                  <a:lnTo>
                    <a:pt x="219" y="70"/>
                  </a:lnTo>
                  <a:lnTo>
                    <a:pt x="229" y="70"/>
                  </a:lnTo>
                  <a:lnTo>
                    <a:pt x="249" y="70"/>
                  </a:lnTo>
                  <a:lnTo>
                    <a:pt x="251" y="70"/>
                  </a:lnTo>
                  <a:lnTo>
                    <a:pt x="256" y="70"/>
                  </a:lnTo>
                  <a:lnTo>
                    <a:pt x="276" y="70"/>
                  </a:lnTo>
                  <a:lnTo>
                    <a:pt x="277" y="48"/>
                  </a:lnTo>
                  <a:lnTo>
                    <a:pt x="302" y="48"/>
                  </a:lnTo>
                  <a:lnTo>
                    <a:pt x="302" y="26"/>
                  </a:lnTo>
                  <a:lnTo>
                    <a:pt x="308" y="26"/>
                  </a:lnTo>
                  <a:lnTo>
                    <a:pt x="319" y="26"/>
                  </a:lnTo>
                  <a:lnTo>
                    <a:pt x="325" y="26"/>
                  </a:lnTo>
                  <a:lnTo>
                    <a:pt x="352" y="26"/>
                  </a:lnTo>
                  <a:lnTo>
                    <a:pt x="352" y="26"/>
                  </a:lnTo>
                  <a:lnTo>
                    <a:pt x="361" y="26"/>
                  </a:lnTo>
                  <a:lnTo>
                    <a:pt x="365" y="26"/>
                  </a:lnTo>
                  <a:lnTo>
                    <a:pt x="372" y="26"/>
                  </a:lnTo>
                  <a:lnTo>
                    <a:pt x="377" y="26"/>
                  </a:lnTo>
                  <a:lnTo>
                    <a:pt x="409" y="26"/>
                  </a:lnTo>
                  <a:lnTo>
                    <a:pt x="442" y="26"/>
                  </a:lnTo>
                  <a:lnTo>
                    <a:pt x="442" y="0"/>
                  </a:lnTo>
                  <a:lnTo>
                    <a:pt x="464" y="0"/>
                  </a:lnTo>
                  <a:lnTo>
                    <a:pt x="476" y="0"/>
                  </a:lnTo>
                  <a:lnTo>
                    <a:pt x="486" y="0"/>
                  </a:lnTo>
                  <a:lnTo>
                    <a:pt x="495" y="0"/>
                  </a:lnTo>
                  <a:lnTo>
                    <a:pt x="500" y="0"/>
                  </a:lnTo>
                  <a:lnTo>
                    <a:pt x="507" y="0"/>
                  </a:lnTo>
                  <a:lnTo>
                    <a:pt x="509" y="0"/>
                  </a:lnTo>
                  <a:lnTo>
                    <a:pt x="538" y="0"/>
                  </a:lnTo>
                  <a:lnTo>
                    <a:pt x="544" y="0"/>
                  </a:lnTo>
                  <a:lnTo>
                    <a:pt x="545" y="0"/>
                  </a:lnTo>
                  <a:lnTo>
                    <a:pt x="561" y="0"/>
                  </a:lnTo>
                  <a:lnTo>
                    <a:pt x="568" y="0"/>
                  </a:lnTo>
                  <a:lnTo>
                    <a:pt x="570" y="0"/>
                  </a:lnTo>
                  <a:lnTo>
                    <a:pt x="578" y="0"/>
                  </a:lnTo>
                  <a:lnTo>
                    <a:pt x="581" y="0"/>
                  </a:lnTo>
                  <a:lnTo>
                    <a:pt x="597" y="0"/>
                  </a:lnTo>
                  <a:lnTo>
                    <a:pt x="605" y="0"/>
                  </a:lnTo>
                  <a:lnTo>
                    <a:pt x="616" y="0"/>
                  </a:lnTo>
                  <a:lnTo>
                    <a:pt x="628" y="0"/>
                  </a:lnTo>
                  <a:lnTo>
                    <a:pt x="636" y="0"/>
                  </a:lnTo>
                  <a:lnTo>
                    <a:pt x="670" y="0"/>
                  </a:lnTo>
                  <a:lnTo>
                    <a:pt x="684" y="0"/>
                  </a:lnTo>
                  <a:lnTo>
                    <a:pt x="698" y="0"/>
                  </a:lnTo>
                  <a:lnTo>
                    <a:pt x="707" y="0"/>
                  </a:lnTo>
                  <a:lnTo>
                    <a:pt x="710" y="0"/>
                  </a:lnTo>
                  <a:lnTo>
                    <a:pt x="722" y="0"/>
                  </a:lnTo>
                  <a:lnTo>
                    <a:pt x="729" y="0"/>
                  </a:lnTo>
                  <a:lnTo>
                    <a:pt x="731" y="0"/>
                  </a:lnTo>
                  <a:lnTo>
                    <a:pt x="737" y="0"/>
                  </a:lnTo>
                  <a:lnTo>
                    <a:pt x="778" y="0"/>
                  </a:lnTo>
                  <a:lnTo>
                    <a:pt x="788" y="0"/>
                  </a:lnTo>
                  <a:lnTo>
                    <a:pt x="803" y="0"/>
                  </a:lnTo>
                  <a:lnTo>
                    <a:pt x="812" y="0"/>
                  </a:lnTo>
                  <a:lnTo>
                    <a:pt x="827" y="0"/>
                  </a:lnTo>
                  <a:lnTo>
                    <a:pt x="842" y="0"/>
                  </a:lnTo>
                  <a:lnTo>
                    <a:pt x="851" y="0"/>
                  </a:lnTo>
                  <a:lnTo>
                    <a:pt x="860" y="0"/>
                  </a:lnTo>
                  <a:lnTo>
                    <a:pt x="865" y="0"/>
                  </a:lnTo>
                  <a:lnTo>
                    <a:pt x="871" y="0"/>
                  </a:lnTo>
                  <a:lnTo>
                    <a:pt x="878" y="0"/>
                  </a:lnTo>
                  <a:lnTo>
                    <a:pt x="882" y="0"/>
                  </a:lnTo>
                  <a:lnTo>
                    <a:pt x="889" y="0"/>
                  </a:lnTo>
                  <a:lnTo>
                    <a:pt x="899" y="0"/>
                  </a:lnTo>
                  <a:lnTo>
                    <a:pt x="902" y="0"/>
                  </a:lnTo>
                  <a:lnTo>
                    <a:pt x="912" y="0"/>
                  </a:lnTo>
                  <a:lnTo>
                    <a:pt x="947" y="0"/>
                  </a:lnTo>
                  <a:lnTo>
                    <a:pt x="957" y="0"/>
                  </a:lnTo>
                  <a:lnTo>
                    <a:pt x="993" y="0"/>
                  </a:lnTo>
                  <a:lnTo>
                    <a:pt x="997" y="0"/>
                  </a:lnTo>
                  <a:lnTo>
                    <a:pt x="1009" y="0"/>
                  </a:lnTo>
                  <a:lnTo>
                    <a:pt x="1023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Freeform 57">
              <a:extLst>
                <a:ext uri="{FF2B5EF4-FFF2-40B4-BE49-F238E27FC236}">
                  <a16:creationId xmlns:a16="http://schemas.microsoft.com/office/drawing/2014/main" id="{8E057F73-6661-F2CE-DAF0-BF339342E58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4329" y="5885827"/>
              <a:ext cx="2812516" cy="66146"/>
            </a:xfrm>
            <a:custGeom>
              <a:avLst/>
              <a:gdLst>
                <a:gd name="T0" fmla="*/ 90 w 1492"/>
                <a:gd name="T1" fmla="*/ 36 h 36"/>
                <a:gd name="T2" fmla="*/ 110 w 1492"/>
                <a:gd name="T3" fmla="*/ 36 h 36"/>
                <a:gd name="T4" fmla="*/ 126 w 1492"/>
                <a:gd name="T5" fmla="*/ 36 h 36"/>
                <a:gd name="T6" fmla="*/ 143 w 1492"/>
                <a:gd name="T7" fmla="*/ 36 h 36"/>
                <a:gd name="T8" fmla="*/ 162 w 1492"/>
                <a:gd name="T9" fmla="*/ 36 h 36"/>
                <a:gd name="T10" fmla="*/ 184 w 1492"/>
                <a:gd name="T11" fmla="*/ 36 h 36"/>
                <a:gd name="T12" fmla="*/ 205 w 1492"/>
                <a:gd name="T13" fmla="*/ 36 h 36"/>
                <a:gd name="T14" fmla="*/ 229 w 1492"/>
                <a:gd name="T15" fmla="*/ 36 h 36"/>
                <a:gd name="T16" fmla="*/ 238 w 1492"/>
                <a:gd name="T17" fmla="*/ 31 h 36"/>
                <a:gd name="T18" fmla="*/ 256 w 1492"/>
                <a:gd name="T19" fmla="*/ 31 h 36"/>
                <a:gd name="T20" fmla="*/ 270 w 1492"/>
                <a:gd name="T21" fmla="*/ 26 h 36"/>
                <a:gd name="T22" fmla="*/ 287 w 1492"/>
                <a:gd name="T23" fmla="*/ 26 h 36"/>
                <a:gd name="T24" fmla="*/ 305 w 1492"/>
                <a:gd name="T25" fmla="*/ 21 h 36"/>
                <a:gd name="T26" fmla="*/ 323 w 1492"/>
                <a:gd name="T27" fmla="*/ 21 h 36"/>
                <a:gd name="T28" fmla="*/ 347 w 1492"/>
                <a:gd name="T29" fmla="*/ 21 h 36"/>
                <a:gd name="T30" fmla="*/ 366 w 1492"/>
                <a:gd name="T31" fmla="*/ 21 h 36"/>
                <a:gd name="T32" fmla="*/ 383 w 1492"/>
                <a:gd name="T33" fmla="*/ 21 h 36"/>
                <a:gd name="T34" fmla="*/ 395 w 1492"/>
                <a:gd name="T35" fmla="*/ 16 h 36"/>
                <a:gd name="T36" fmla="*/ 413 w 1492"/>
                <a:gd name="T37" fmla="*/ 16 h 36"/>
                <a:gd name="T38" fmla="*/ 434 w 1492"/>
                <a:gd name="T39" fmla="*/ 16 h 36"/>
                <a:gd name="T40" fmla="*/ 451 w 1492"/>
                <a:gd name="T41" fmla="*/ 16 h 36"/>
                <a:gd name="T42" fmla="*/ 463 w 1492"/>
                <a:gd name="T43" fmla="*/ 9 h 36"/>
                <a:gd name="T44" fmla="*/ 479 w 1492"/>
                <a:gd name="T45" fmla="*/ 9 h 36"/>
                <a:gd name="T46" fmla="*/ 498 w 1492"/>
                <a:gd name="T47" fmla="*/ 9 h 36"/>
                <a:gd name="T48" fmla="*/ 518 w 1492"/>
                <a:gd name="T49" fmla="*/ 9 h 36"/>
                <a:gd name="T50" fmla="*/ 534 w 1492"/>
                <a:gd name="T51" fmla="*/ 9 h 36"/>
                <a:gd name="T52" fmla="*/ 553 w 1492"/>
                <a:gd name="T53" fmla="*/ 9 h 36"/>
                <a:gd name="T54" fmla="*/ 570 w 1492"/>
                <a:gd name="T55" fmla="*/ 9 h 36"/>
                <a:gd name="T56" fmla="*/ 588 w 1492"/>
                <a:gd name="T57" fmla="*/ 9 h 36"/>
                <a:gd name="T58" fmla="*/ 602 w 1492"/>
                <a:gd name="T59" fmla="*/ 0 h 36"/>
                <a:gd name="T60" fmla="*/ 618 w 1492"/>
                <a:gd name="T61" fmla="*/ 0 h 36"/>
                <a:gd name="T62" fmla="*/ 635 w 1492"/>
                <a:gd name="T63" fmla="*/ 0 h 36"/>
                <a:gd name="T64" fmla="*/ 657 w 1492"/>
                <a:gd name="T65" fmla="*/ 0 h 36"/>
                <a:gd name="T66" fmla="*/ 675 w 1492"/>
                <a:gd name="T67" fmla="*/ 0 h 36"/>
                <a:gd name="T68" fmla="*/ 690 w 1492"/>
                <a:gd name="T69" fmla="*/ 0 h 36"/>
                <a:gd name="T70" fmla="*/ 707 w 1492"/>
                <a:gd name="T71" fmla="*/ 0 h 36"/>
                <a:gd name="T72" fmla="*/ 728 w 1492"/>
                <a:gd name="T73" fmla="*/ 0 h 36"/>
                <a:gd name="T74" fmla="*/ 744 w 1492"/>
                <a:gd name="T75" fmla="*/ 0 h 36"/>
                <a:gd name="T76" fmla="*/ 761 w 1492"/>
                <a:gd name="T77" fmla="*/ 0 h 36"/>
                <a:gd name="T78" fmla="*/ 781 w 1492"/>
                <a:gd name="T79" fmla="*/ 0 h 36"/>
                <a:gd name="T80" fmla="*/ 804 w 1492"/>
                <a:gd name="T81" fmla="*/ 0 h 36"/>
                <a:gd name="T82" fmla="*/ 823 w 1492"/>
                <a:gd name="T83" fmla="*/ 0 h 36"/>
                <a:gd name="T84" fmla="*/ 841 w 1492"/>
                <a:gd name="T85" fmla="*/ 0 h 36"/>
                <a:gd name="T86" fmla="*/ 859 w 1492"/>
                <a:gd name="T87" fmla="*/ 0 h 36"/>
                <a:gd name="T88" fmla="*/ 877 w 1492"/>
                <a:gd name="T89" fmla="*/ 0 h 36"/>
                <a:gd name="T90" fmla="*/ 896 w 1492"/>
                <a:gd name="T91" fmla="*/ 0 h 36"/>
                <a:gd name="T92" fmla="*/ 913 w 1492"/>
                <a:gd name="T93" fmla="*/ 0 h 36"/>
                <a:gd name="T94" fmla="*/ 936 w 1492"/>
                <a:gd name="T95" fmla="*/ 0 h 36"/>
                <a:gd name="T96" fmla="*/ 954 w 1492"/>
                <a:gd name="T97" fmla="*/ 0 h 36"/>
                <a:gd name="T98" fmla="*/ 1005 w 1492"/>
                <a:gd name="T99" fmla="*/ 0 h 36"/>
                <a:gd name="T100" fmla="*/ 1103 w 1492"/>
                <a:gd name="T101" fmla="*/ 0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492" h="36">
                  <a:moveTo>
                    <a:pt x="0" y="36"/>
                  </a:moveTo>
                  <a:lnTo>
                    <a:pt x="84" y="36"/>
                  </a:lnTo>
                  <a:lnTo>
                    <a:pt x="90" y="36"/>
                  </a:lnTo>
                  <a:lnTo>
                    <a:pt x="95" y="36"/>
                  </a:lnTo>
                  <a:lnTo>
                    <a:pt x="101" y="36"/>
                  </a:lnTo>
                  <a:lnTo>
                    <a:pt x="110" y="36"/>
                  </a:lnTo>
                  <a:lnTo>
                    <a:pt x="116" y="36"/>
                  </a:lnTo>
                  <a:lnTo>
                    <a:pt x="119" y="36"/>
                  </a:lnTo>
                  <a:lnTo>
                    <a:pt x="126" y="36"/>
                  </a:lnTo>
                  <a:lnTo>
                    <a:pt x="130" y="36"/>
                  </a:lnTo>
                  <a:lnTo>
                    <a:pt x="137" y="36"/>
                  </a:lnTo>
                  <a:lnTo>
                    <a:pt x="143" y="36"/>
                  </a:lnTo>
                  <a:lnTo>
                    <a:pt x="148" y="36"/>
                  </a:lnTo>
                  <a:lnTo>
                    <a:pt x="154" y="36"/>
                  </a:lnTo>
                  <a:lnTo>
                    <a:pt x="162" y="36"/>
                  </a:lnTo>
                  <a:lnTo>
                    <a:pt x="166" y="36"/>
                  </a:lnTo>
                  <a:lnTo>
                    <a:pt x="181" y="36"/>
                  </a:lnTo>
                  <a:lnTo>
                    <a:pt x="184" y="36"/>
                  </a:lnTo>
                  <a:lnTo>
                    <a:pt x="192" y="36"/>
                  </a:lnTo>
                  <a:lnTo>
                    <a:pt x="196" y="36"/>
                  </a:lnTo>
                  <a:lnTo>
                    <a:pt x="205" y="36"/>
                  </a:lnTo>
                  <a:lnTo>
                    <a:pt x="214" y="36"/>
                  </a:lnTo>
                  <a:lnTo>
                    <a:pt x="224" y="36"/>
                  </a:lnTo>
                  <a:lnTo>
                    <a:pt x="229" y="36"/>
                  </a:lnTo>
                  <a:lnTo>
                    <a:pt x="234" y="36"/>
                  </a:lnTo>
                  <a:lnTo>
                    <a:pt x="237" y="31"/>
                  </a:lnTo>
                  <a:lnTo>
                    <a:pt x="238" y="31"/>
                  </a:lnTo>
                  <a:lnTo>
                    <a:pt x="244" y="31"/>
                  </a:lnTo>
                  <a:lnTo>
                    <a:pt x="252" y="31"/>
                  </a:lnTo>
                  <a:lnTo>
                    <a:pt x="256" y="31"/>
                  </a:lnTo>
                  <a:lnTo>
                    <a:pt x="263" y="31"/>
                  </a:lnTo>
                  <a:lnTo>
                    <a:pt x="269" y="31"/>
                  </a:lnTo>
                  <a:lnTo>
                    <a:pt x="270" y="26"/>
                  </a:lnTo>
                  <a:lnTo>
                    <a:pt x="277" y="26"/>
                  </a:lnTo>
                  <a:lnTo>
                    <a:pt x="281" y="26"/>
                  </a:lnTo>
                  <a:lnTo>
                    <a:pt x="287" y="26"/>
                  </a:lnTo>
                  <a:lnTo>
                    <a:pt x="292" y="21"/>
                  </a:lnTo>
                  <a:lnTo>
                    <a:pt x="300" y="21"/>
                  </a:lnTo>
                  <a:lnTo>
                    <a:pt x="305" y="21"/>
                  </a:lnTo>
                  <a:lnTo>
                    <a:pt x="311" y="21"/>
                  </a:lnTo>
                  <a:lnTo>
                    <a:pt x="319" y="21"/>
                  </a:lnTo>
                  <a:lnTo>
                    <a:pt x="323" y="21"/>
                  </a:lnTo>
                  <a:lnTo>
                    <a:pt x="336" y="21"/>
                  </a:lnTo>
                  <a:lnTo>
                    <a:pt x="341" y="21"/>
                  </a:lnTo>
                  <a:lnTo>
                    <a:pt x="347" y="21"/>
                  </a:lnTo>
                  <a:lnTo>
                    <a:pt x="352" y="21"/>
                  </a:lnTo>
                  <a:lnTo>
                    <a:pt x="359" y="21"/>
                  </a:lnTo>
                  <a:lnTo>
                    <a:pt x="366" y="21"/>
                  </a:lnTo>
                  <a:lnTo>
                    <a:pt x="372" y="21"/>
                  </a:lnTo>
                  <a:lnTo>
                    <a:pt x="378" y="21"/>
                  </a:lnTo>
                  <a:lnTo>
                    <a:pt x="383" y="21"/>
                  </a:lnTo>
                  <a:lnTo>
                    <a:pt x="384" y="16"/>
                  </a:lnTo>
                  <a:lnTo>
                    <a:pt x="389" y="16"/>
                  </a:lnTo>
                  <a:lnTo>
                    <a:pt x="395" y="16"/>
                  </a:lnTo>
                  <a:lnTo>
                    <a:pt x="402" y="16"/>
                  </a:lnTo>
                  <a:lnTo>
                    <a:pt x="407" y="16"/>
                  </a:lnTo>
                  <a:lnTo>
                    <a:pt x="413" y="16"/>
                  </a:lnTo>
                  <a:lnTo>
                    <a:pt x="419" y="16"/>
                  </a:lnTo>
                  <a:lnTo>
                    <a:pt x="427" y="16"/>
                  </a:lnTo>
                  <a:lnTo>
                    <a:pt x="434" y="16"/>
                  </a:lnTo>
                  <a:lnTo>
                    <a:pt x="437" y="16"/>
                  </a:lnTo>
                  <a:lnTo>
                    <a:pt x="443" y="16"/>
                  </a:lnTo>
                  <a:lnTo>
                    <a:pt x="451" y="16"/>
                  </a:lnTo>
                  <a:lnTo>
                    <a:pt x="452" y="9"/>
                  </a:lnTo>
                  <a:lnTo>
                    <a:pt x="458" y="9"/>
                  </a:lnTo>
                  <a:lnTo>
                    <a:pt x="463" y="9"/>
                  </a:lnTo>
                  <a:lnTo>
                    <a:pt x="469" y="9"/>
                  </a:lnTo>
                  <a:lnTo>
                    <a:pt x="473" y="9"/>
                  </a:lnTo>
                  <a:lnTo>
                    <a:pt x="479" y="9"/>
                  </a:lnTo>
                  <a:lnTo>
                    <a:pt x="486" y="9"/>
                  </a:lnTo>
                  <a:lnTo>
                    <a:pt x="491" y="9"/>
                  </a:lnTo>
                  <a:lnTo>
                    <a:pt x="498" y="9"/>
                  </a:lnTo>
                  <a:lnTo>
                    <a:pt x="504" y="9"/>
                  </a:lnTo>
                  <a:lnTo>
                    <a:pt x="510" y="9"/>
                  </a:lnTo>
                  <a:lnTo>
                    <a:pt x="518" y="9"/>
                  </a:lnTo>
                  <a:lnTo>
                    <a:pt x="521" y="9"/>
                  </a:lnTo>
                  <a:lnTo>
                    <a:pt x="530" y="9"/>
                  </a:lnTo>
                  <a:lnTo>
                    <a:pt x="534" y="9"/>
                  </a:lnTo>
                  <a:lnTo>
                    <a:pt x="539" y="9"/>
                  </a:lnTo>
                  <a:lnTo>
                    <a:pt x="545" y="9"/>
                  </a:lnTo>
                  <a:lnTo>
                    <a:pt x="553" y="9"/>
                  </a:lnTo>
                  <a:lnTo>
                    <a:pt x="557" y="9"/>
                  </a:lnTo>
                  <a:lnTo>
                    <a:pt x="564" y="9"/>
                  </a:lnTo>
                  <a:lnTo>
                    <a:pt x="570" y="9"/>
                  </a:lnTo>
                  <a:lnTo>
                    <a:pt x="578" y="9"/>
                  </a:lnTo>
                  <a:lnTo>
                    <a:pt x="582" y="9"/>
                  </a:lnTo>
                  <a:lnTo>
                    <a:pt x="588" y="9"/>
                  </a:lnTo>
                  <a:lnTo>
                    <a:pt x="589" y="0"/>
                  </a:lnTo>
                  <a:lnTo>
                    <a:pt x="594" y="0"/>
                  </a:lnTo>
                  <a:lnTo>
                    <a:pt x="602" y="0"/>
                  </a:lnTo>
                  <a:lnTo>
                    <a:pt x="607" y="0"/>
                  </a:lnTo>
                  <a:lnTo>
                    <a:pt x="615" y="0"/>
                  </a:lnTo>
                  <a:lnTo>
                    <a:pt x="618" y="0"/>
                  </a:lnTo>
                  <a:lnTo>
                    <a:pt x="626" y="0"/>
                  </a:lnTo>
                  <a:lnTo>
                    <a:pt x="634" y="0"/>
                  </a:lnTo>
                  <a:lnTo>
                    <a:pt x="635" y="0"/>
                  </a:lnTo>
                  <a:lnTo>
                    <a:pt x="644" y="0"/>
                  </a:lnTo>
                  <a:lnTo>
                    <a:pt x="648" y="0"/>
                  </a:lnTo>
                  <a:lnTo>
                    <a:pt x="657" y="0"/>
                  </a:lnTo>
                  <a:lnTo>
                    <a:pt x="660" y="0"/>
                  </a:lnTo>
                  <a:lnTo>
                    <a:pt x="665" y="0"/>
                  </a:lnTo>
                  <a:lnTo>
                    <a:pt x="675" y="0"/>
                  </a:lnTo>
                  <a:lnTo>
                    <a:pt x="678" y="0"/>
                  </a:lnTo>
                  <a:lnTo>
                    <a:pt x="684" y="0"/>
                  </a:lnTo>
                  <a:lnTo>
                    <a:pt x="690" y="0"/>
                  </a:lnTo>
                  <a:lnTo>
                    <a:pt x="698" y="0"/>
                  </a:lnTo>
                  <a:lnTo>
                    <a:pt x="704" y="0"/>
                  </a:lnTo>
                  <a:lnTo>
                    <a:pt x="707" y="0"/>
                  </a:lnTo>
                  <a:lnTo>
                    <a:pt x="718" y="0"/>
                  </a:lnTo>
                  <a:lnTo>
                    <a:pt x="720" y="0"/>
                  </a:lnTo>
                  <a:lnTo>
                    <a:pt x="728" y="0"/>
                  </a:lnTo>
                  <a:lnTo>
                    <a:pt x="731" y="0"/>
                  </a:lnTo>
                  <a:lnTo>
                    <a:pt x="737" y="0"/>
                  </a:lnTo>
                  <a:lnTo>
                    <a:pt x="744" y="0"/>
                  </a:lnTo>
                  <a:lnTo>
                    <a:pt x="750" y="0"/>
                  </a:lnTo>
                  <a:lnTo>
                    <a:pt x="757" y="0"/>
                  </a:lnTo>
                  <a:lnTo>
                    <a:pt x="761" y="0"/>
                  </a:lnTo>
                  <a:lnTo>
                    <a:pt x="769" y="0"/>
                  </a:lnTo>
                  <a:lnTo>
                    <a:pt x="776" y="0"/>
                  </a:lnTo>
                  <a:lnTo>
                    <a:pt x="781" y="0"/>
                  </a:lnTo>
                  <a:lnTo>
                    <a:pt x="787" y="0"/>
                  </a:lnTo>
                  <a:lnTo>
                    <a:pt x="800" y="0"/>
                  </a:lnTo>
                  <a:lnTo>
                    <a:pt x="804" y="0"/>
                  </a:lnTo>
                  <a:lnTo>
                    <a:pt x="811" y="0"/>
                  </a:lnTo>
                  <a:lnTo>
                    <a:pt x="819" y="0"/>
                  </a:lnTo>
                  <a:lnTo>
                    <a:pt x="823" y="0"/>
                  </a:lnTo>
                  <a:lnTo>
                    <a:pt x="828" y="0"/>
                  </a:lnTo>
                  <a:lnTo>
                    <a:pt x="834" y="0"/>
                  </a:lnTo>
                  <a:lnTo>
                    <a:pt x="841" y="0"/>
                  </a:lnTo>
                  <a:lnTo>
                    <a:pt x="846" y="0"/>
                  </a:lnTo>
                  <a:lnTo>
                    <a:pt x="856" y="0"/>
                  </a:lnTo>
                  <a:lnTo>
                    <a:pt x="859" y="0"/>
                  </a:lnTo>
                  <a:lnTo>
                    <a:pt x="865" y="0"/>
                  </a:lnTo>
                  <a:lnTo>
                    <a:pt x="871" y="0"/>
                  </a:lnTo>
                  <a:lnTo>
                    <a:pt x="877" y="0"/>
                  </a:lnTo>
                  <a:lnTo>
                    <a:pt x="882" y="0"/>
                  </a:lnTo>
                  <a:lnTo>
                    <a:pt x="889" y="0"/>
                  </a:lnTo>
                  <a:lnTo>
                    <a:pt x="896" y="0"/>
                  </a:lnTo>
                  <a:lnTo>
                    <a:pt x="903" y="0"/>
                  </a:lnTo>
                  <a:lnTo>
                    <a:pt x="907" y="0"/>
                  </a:lnTo>
                  <a:lnTo>
                    <a:pt x="913" y="0"/>
                  </a:lnTo>
                  <a:lnTo>
                    <a:pt x="922" y="0"/>
                  </a:lnTo>
                  <a:lnTo>
                    <a:pt x="930" y="0"/>
                  </a:lnTo>
                  <a:lnTo>
                    <a:pt x="936" y="0"/>
                  </a:lnTo>
                  <a:lnTo>
                    <a:pt x="944" y="0"/>
                  </a:lnTo>
                  <a:lnTo>
                    <a:pt x="950" y="0"/>
                  </a:lnTo>
                  <a:lnTo>
                    <a:pt x="954" y="0"/>
                  </a:lnTo>
                  <a:lnTo>
                    <a:pt x="962" y="0"/>
                  </a:lnTo>
                  <a:lnTo>
                    <a:pt x="1002" y="0"/>
                  </a:lnTo>
                  <a:lnTo>
                    <a:pt x="1005" y="0"/>
                  </a:lnTo>
                  <a:lnTo>
                    <a:pt x="1037" y="0"/>
                  </a:lnTo>
                  <a:lnTo>
                    <a:pt x="1064" y="0"/>
                  </a:lnTo>
                  <a:lnTo>
                    <a:pt x="1103" y="0"/>
                  </a:lnTo>
                  <a:lnTo>
                    <a:pt x="1492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Freeform 58">
              <a:extLst>
                <a:ext uri="{FF2B5EF4-FFF2-40B4-BE49-F238E27FC236}">
                  <a16:creationId xmlns:a16="http://schemas.microsoft.com/office/drawing/2014/main" id="{AFE877F7-2C83-1326-816D-C8B4E91331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4329" y="5705762"/>
              <a:ext cx="3040609" cy="246211"/>
            </a:xfrm>
            <a:custGeom>
              <a:avLst/>
              <a:gdLst>
                <a:gd name="T0" fmla="*/ 0 w 1613"/>
                <a:gd name="T1" fmla="*/ 134 h 134"/>
                <a:gd name="T2" fmla="*/ 84 w 1613"/>
                <a:gd name="T3" fmla="*/ 134 h 134"/>
                <a:gd name="T4" fmla="*/ 90 w 1613"/>
                <a:gd name="T5" fmla="*/ 134 h 134"/>
                <a:gd name="T6" fmla="*/ 110 w 1613"/>
                <a:gd name="T7" fmla="*/ 134 h 134"/>
                <a:gd name="T8" fmla="*/ 138 w 1613"/>
                <a:gd name="T9" fmla="*/ 134 h 134"/>
                <a:gd name="T10" fmla="*/ 143 w 1613"/>
                <a:gd name="T11" fmla="*/ 134 h 134"/>
                <a:gd name="T12" fmla="*/ 176 w 1613"/>
                <a:gd name="T13" fmla="*/ 134 h 134"/>
                <a:gd name="T14" fmla="*/ 196 w 1613"/>
                <a:gd name="T15" fmla="*/ 134 h 134"/>
                <a:gd name="T16" fmla="*/ 196 w 1613"/>
                <a:gd name="T17" fmla="*/ 95 h 134"/>
                <a:gd name="T18" fmla="*/ 218 w 1613"/>
                <a:gd name="T19" fmla="*/ 95 h 134"/>
                <a:gd name="T20" fmla="*/ 248 w 1613"/>
                <a:gd name="T21" fmla="*/ 95 h 134"/>
                <a:gd name="T22" fmla="*/ 255 w 1613"/>
                <a:gd name="T23" fmla="*/ 95 h 134"/>
                <a:gd name="T24" fmla="*/ 263 w 1613"/>
                <a:gd name="T25" fmla="*/ 95 h 134"/>
                <a:gd name="T26" fmla="*/ 277 w 1613"/>
                <a:gd name="T27" fmla="*/ 95 h 134"/>
                <a:gd name="T28" fmla="*/ 277 w 1613"/>
                <a:gd name="T29" fmla="*/ 52 h 134"/>
                <a:gd name="T30" fmla="*/ 284 w 1613"/>
                <a:gd name="T31" fmla="*/ 52 h 134"/>
                <a:gd name="T32" fmla="*/ 311 w 1613"/>
                <a:gd name="T33" fmla="*/ 52 h 134"/>
                <a:gd name="T34" fmla="*/ 324 w 1613"/>
                <a:gd name="T35" fmla="*/ 52 h 134"/>
                <a:gd name="T36" fmla="*/ 332 w 1613"/>
                <a:gd name="T37" fmla="*/ 52 h 134"/>
                <a:gd name="T38" fmla="*/ 355 w 1613"/>
                <a:gd name="T39" fmla="*/ 52 h 134"/>
                <a:gd name="T40" fmla="*/ 383 w 1613"/>
                <a:gd name="T41" fmla="*/ 52 h 134"/>
                <a:gd name="T42" fmla="*/ 395 w 1613"/>
                <a:gd name="T43" fmla="*/ 52 h 134"/>
                <a:gd name="T44" fmla="*/ 401 w 1613"/>
                <a:gd name="T45" fmla="*/ 52 h 134"/>
                <a:gd name="T46" fmla="*/ 401 w 1613"/>
                <a:gd name="T47" fmla="*/ 0 h 134"/>
                <a:gd name="T48" fmla="*/ 426 w 1613"/>
                <a:gd name="T49" fmla="*/ 0 h 134"/>
                <a:gd name="T50" fmla="*/ 458 w 1613"/>
                <a:gd name="T51" fmla="*/ 0 h 134"/>
                <a:gd name="T52" fmla="*/ 482 w 1613"/>
                <a:gd name="T53" fmla="*/ 0 h 134"/>
                <a:gd name="T54" fmla="*/ 525 w 1613"/>
                <a:gd name="T55" fmla="*/ 0 h 134"/>
                <a:gd name="T56" fmla="*/ 565 w 1613"/>
                <a:gd name="T57" fmla="*/ 0 h 134"/>
                <a:gd name="T58" fmla="*/ 572 w 1613"/>
                <a:gd name="T59" fmla="*/ 0 h 134"/>
                <a:gd name="T60" fmla="*/ 594 w 1613"/>
                <a:gd name="T61" fmla="*/ 0 h 134"/>
                <a:gd name="T62" fmla="*/ 631 w 1613"/>
                <a:gd name="T63" fmla="*/ 0 h 134"/>
                <a:gd name="T64" fmla="*/ 648 w 1613"/>
                <a:gd name="T65" fmla="*/ 0 h 134"/>
                <a:gd name="T66" fmla="*/ 671 w 1613"/>
                <a:gd name="T67" fmla="*/ 0 h 134"/>
                <a:gd name="T68" fmla="*/ 681 w 1613"/>
                <a:gd name="T69" fmla="*/ 0 h 134"/>
                <a:gd name="T70" fmla="*/ 685 w 1613"/>
                <a:gd name="T71" fmla="*/ 0 h 134"/>
                <a:gd name="T72" fmla="*/ 711 w 1613"/>
                <a:gd name="T73" fmla="*/ 0 h 134"/>
                <a:gd name="T74" fmla="*/ 732 w 1613"/>
                <a:gd name="T75" fmla="*/ 0 h 134"/>
                <a:gd name="T76" fmla="*/ 748 w 1613"/>
                <a:gd name="T77" fmla="*/ 0 h 134"/>
                <a:gd name="T78" fmla="*/ 766 w 1613"/>
                <a:gd name="T79" fmla="*/ 0 h 134"/>
                <a:gd name="T80" fmla="*/ 768 w 1613"/>
                <a:gd name="T81" fmla="*/ 0 h 134"/>
                <a:gd name="T82" fmla="*/ 787 w 1613"/>
                <a:gd name="T83" fmla="*/ 0 h 134"/>
                <a:gd name="T84" fmla="*/ 808 w 1613"/>
                <a:gd name="T85" fmla="*/ 0 h 134"/>
                <a:gd name="T86" fmla="*/ 817 w 1613"/>
                <a:gd name="T87" fmla="*/ 0 h 134"/>
                <a:gd name="T88" fmla="*/ 844 w 1613"/>
                <a:gd name="T89" fmla="*/ 0 h 134"/>
                <a:gd name="T90" fmla="*/ 858 w 1613"/>
                <a:gd name="T91" fmla="*/ 0 h 134"/>
                <a:gd name="T92" fmla="*/ 864 w 1613"/>
                <a:gd name="T93" fmla="*/ 0 h 134"/>
                <a:gd name="T94" fmla="*/ 880 w 1613"/>
                <a:gd name="T95" fmla="*/ 0 h 134"/>
                <a:gd name="T96" fmla="*/ 889 w 1613"/>
                <a:gd name="T97" fmla="*/ 0 h 134"/>
                <a:gd name="T98" fmla="*/ 910 w 1613"/>
                <a:gd name="T99" fmla="*/ 0 h 134"/>
                <a:gd name="T100" fmla="*/ 913 w 1613"/>
                <a:gd name="T101" fmla="*/ 0 h 134"/>
                <a:gd name="T102" fmla="*/ 934 w 1613"/>
                <a:gd name="T103" fmla="*/ 0 h 134"/>
                <a:gd name="T104" fmla="*/ 1144 w 1613"/>
                <a:gd name="T105" fmla="*/ 0 h 134"/>
                <a:gd name="T106" fmla="*/ 1613 w 1613"/>
                <a:gd name="T107" fmla="*/ 0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1613" h="134">
                  <a:moveTo>
                    <a:pt x="0" y="134"/>
                  </a:moveTo>
                  <a:lnTo>
                    <a:pt x="84" y="134"/>
                  </a:lnTo>
                  <a:lnTo>
                    <a:pt x="90" y="134"/>
                  </a:lnTo>
                  <a:lnTo>
                    <a:pt x="110" y="134"/>
                  </a:lnTo>
                  <a:lnTo>
                    <a:pt x="138" y="134"/>
                  </a:lnTo>
                  <a:lnTo>
                    <a:pt x="143" y="134"/>
                  </a:lnTo>
                  <a:lnTo>
                    <a:pt x="176" y="134"/>
                  </a:lnTo>
                  <a:lnTo>
                    <a:pt x="196" y="134"/>
                  </a:lnTo>
                  <a:lnTo>
                    <a:pt x="196" y="95"/>
                  </a:lnTo>
                  <a:lnTo>
                    <a:pt x="218" y="95"/>
                  </a:lnTo>
                  <a:lnTo>
                    <a:pt x="248" y="95"/>
                  </a:lnTo>
                  <a:lnTo>
                    <a:pt x="255" y="95"/>
                  </a:lnTo>
                  <a:lnTo>
                    <a:pt x="263" y="95"/>
                  </a:lnTo>
                  <a:lnTo>
                    <a:pt x="277" y="95"/>
                  </a:lnTo>
                  <a:lnTo>
                    <a:pt x="277" y="52"/>
                  </a:lnTo>
                  <a:lnTo>
                    <a:pt x="284" y="52"/>
                  </a:lnTo>
                  <a:lnTo>
                    <a:pt x="311" y="52"/>
                  </a:lnTo>
                  <a:lnTo>
                    <a:pt x="324" y="52"/>
                  </a:lnTo>
                  <a:lnTo>
                    <a:pt x="332" y="52"/>
                  </a:lnTo>
                  <a:lnTo>
                    <a:pt x="355" y="52"/>
                  </a:lnTo>
                  <a:lnTo>
                    <a:pt x="383" y="52"/>
                  </a:lnTo>
                  <a:lnTo>
                    <a:pt x="395" y="52"/>
                  </a:lnTo>
                  <a:lnTo>
                    <a:pt x="401" y="52"/>
                  </a:lnTo>
                  <a:lnTo>
                    <a:pt x="401" y="0"/>
                  </a:lnTo>
                  <a:lnTo>
                    <a:pt x="426" y="0"/>
                  </a:lnTo>
                  <a:lnTo>
                    <a:pt x="458" y="0"/>
                  </a:lnTo>
                  <a:lnTo>
                    <a:pt x="482" y="0"/>
                  </a:lnTo>
                  <a:lnTo>
                    <a:pt x="525" y="0"/>
                  </a:lnTo>
                  <a:lnTo>
                    <a:pt x="565" y="0"/>
                  </a:lnTo>
                  <a:lnTo>
                    <a:pt x="572" y="0"/>
                  </a:lnTo>
                  <a:lnTo>
                    <a:pt x="594" y="0"/>
                  </a:lnTo>
                  <a:lnTo>
                    <a:pt x="631" y="0"/>
                  </a:lnTo>
                  <a:lnTo>
                    <a:pt x="648" y="0"/>
                  </a:lnTo>
                  <a:lnTo>
                    <a:pt x="671" y="0"/>
                  </a:lnTo>
                  <a:lnTo>
                    <a:pt x="681" y="0"/>
                  </a:lnTo>
                  <a:lnTo>
                    <a:pt x="685" y="0"/>
                  </a:lnTo>
                  <a:lnTo>
                    <a:pt x="711" y="0"/>
                  </a:lnTo>
                  <a:lnTo>
                    <a:pt x="732" y="0"/>
                  </a:lnTo>
                  <a:lnTo>
                    <a:pt x="748" y="0"/>
                  </a:lnTo>
                  <a:lnTo>
                    <a:pt x="766" y="0"/>
                  </a:lnTo>
                  <a:lnTo>
                    <a:pt x="768" y="0"/>
                  </a:lnTo>
                  <a:lnTo>
                    <a:pt x="787" y="0"/>
                  </a:lnTo>
                  <a:lnTo>
                    <a:pt x="808" y="0"/>
                  </a:lnTo>
                  <a:lnTo>
                    <a:pt x="817" y="0"/>
                  </a:lnTo>
                  <a:lnTo>
                    <a:pt x="844" y="0"/>
                  </a:lnTo>
                  <a:lnTo>
                    <a:pt x="858" y="0"/>
                  </a:lnTo>
                  <a:lnTo>
                    <a:pt x="864" y="0"/>
                  </a:lnTo>
                  <a:lnTo>
                    <a:pt x="880" y="0"/>
                  </a:lnTo>
                  <a:lnTo>
                    <a:pt x="889" y="0"/>
                  </a:lnTo>
                  <a:lnTo>
                    <a:pt x="910" y="0"/>
                  </a:lnTo>
                  <a:lnTo>
                    <a:pt x="913" y="0"/>
                  </a:lnTo>
                  <a:lnTo>
                    <a:pt x="934" y="0"/>
                  </a:lnTo>
                  <a:lnTo>
                    <a:pt x="1144" y="0"/>
                  </a:lnTo>
                  <a:lnTo>
                    <a:pt x="1613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022563DD-54DC-11A6-22A4-0B112D4DE321}"/>
              </a:ext>
            </a:extLst>
          </p:cNvPr>
          <p:cNvGrpSpPr/>
          <p:nvPr/>
        </p:nvGrpSpPr>
        <p:grpSpPr>
          <a:xfrm>
            <a:off x="6319428" y="3643330"/>
            <a:ext cx="4141083" cy="2791354"/>
            <a:chOff x="6609708" y="3933610"/>
            <a:chExt cx="4141083" cy="2791354"/>
          </a:xfrm>
        </p:grpSpPr>
        <p:grpSp>
          <p:nvGrpSpPr>
            <p:cNvPr id="141" name="グループ化 140">
              <a:extLst>
                <a:ext uri="{FF2B5EF4-FFF2-40B4-BE49-F238E27FC236}">
                  <a16:creationId xmlns:a16="http://schemas.microsoft.com/office/drawing/2014/main" id="{F7013330-9E51-8E22-3C03-323BE9318E7C}"/>
                </a:ext>
              </a:extLst>
            </p:cNvPr>
            <p:cNvGrpSpPr/>
            <p:nvPr/>
          </p:nvGrpSpPr>
          <p:grpSpPr>
            <a:xfrm>
              <a:off x="6609708" y="3933610"/>
              <a:ext cx="4141083" cy="2791354"/>
              <a:chOff x="1487880" y="741070"/>
              <a:chExt cx="4141083" cy="2791354"/>
            </a:xfrm>
          </p:grpSpPr>
          <p:sp>
            <p:nvSpPr>
              <p:cNvPr id="142" name="Rectangle 22">
                <a:extLst>
                  <a:ext uri="{FF2B5EF4-FFF2-40B4-BE49-F238E27FC236}">
                    <a16:creationId xmlns:a16="http://schemas.microsoft.com/office/drawing/2014/main" id="{BA599720-7E88-3BC8-D301-64D308F850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7804" y="747591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3" name="Line 23">
                <a:extLst>
                  <a:ext uri="{FF2B5EF4-FFF2-40B4-BE49-F238E27FC236}">
                    <a16:creationId xmlns:a16="http://schemas.microsoft.com/office/drawing/2014/main" id="{54DEAE32-F4F5-CA4E-F5B0-3557FAE79E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2137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4" name="Line 25">
                <a:extLst>
                  <a:ext uri="{FF2B5EF4-FFF2-40B4-BE49-F238E27FC236}">
                    <a16:creationId xmlns:a16="http://schemas.microsoft.com/office/drawing/2014/main" id="{A2D5E8EE-FAFB-AD4D-5984-3E78F349CA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5354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5" name="Line 27">
                <a:extLst>
                  <a:ext uri="{FF2B5EF4-FFF2-40B4-BE49-F238E27FC236}">
                    <a16:creationId xmlns:a16="http://schemas.microsoft.com/office/drawing/2014/main" id="{5DB41BE1-F997-6C3C-9DF0-A0F113C0D5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8570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6" name="Line 29">
                <a:extLst>
                  <a:ext uri="{FF2B5EF4-FFF2-40B4-BE49-F238E27FC236}">
                    <a16:creationId xmlns:a16="http://schemas.microsoft.com/office/drawing/2014/main" id="{ED38214D-EC02-E980-804F-6B253959A1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9898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7" name="Line 31">
                <a:extLst>
                  <a:ext uri="{FF2B5EF4-FFF2-40B4-BE49-F238E27FC236}">
                    <a16:creationId xmlns:a16="http://schemas.microsoft.com/office/drawing/2014/main" id="{B14879DC-D827-4AE8-1770-2ACD496077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3115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8" name="Line 33">
                <a:extLst>
                  <a:ext uri="{FF2B5EF4-FFF2-40B4-BE49-F238E27FC236}">
                    <a16:creationId xmlns:a16="http://schemas.microsoft.com/office/drawing/2014/main" id="{06D5CB23-4E7B-DBCE-1C64-7A1E14BA11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6331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9" name="Line 35">
                <a:extLst>
                  <a:ext uri="{FF2B5EF4-FFF2-40B4-BE49-F238E27FC236}">
                    <a16:creationId xmlns:a16="http://schemas.microsoft.com/office/drawing/2014/main" id="{F0FF1A52-FB27-745F-4AD8-59E503BC41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9548" y="276375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0" name="Line 6">
                <a:extLst>
                  <a:ext uri="{FF2B5EF4-FFF2-40B4-BE49-F238E27FC236}">
                    <a16:creationId xmlns:a16="http://schemas.microsoft.com/office/drawing/2014/main" id="{A35DC27F-6280-353B-ADD0-63680D8E82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2761368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1" name="Line 8">
                <a:extLst>
                  <a:ext uri="{FF2B5EF4-FFF2-40B4-BE49-F238E27FC236}">
                    <a16:creationId xmlns:a16="http://schemas.microsoft.com/office/drawing/2014/main" id="{FAE11857-D275-4593-EEAD-9D5BF52156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235387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2" name="Line 9">
                <a:extLst>
                  <a:ext uri="{FF2B5EF4-FFF2-40B4-BE49-F238E27FC236}">
                    <a16:creationId xmlns:a16="http://schemas.microsoft.com/office/drawing/2014/main" id="{D9EAB130-E9BA-8D59-F1D8-87EBAB5350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194637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3" name="Line 11">
                <a:extLst>
                  <a:ext uri="{FF2B5EF4-FFF2-40B4-BE49-F238E27FC236}">
                    <a16:creationId xmlns:a16="http://schemas.microsoft.com/office/drawing/2014/main" id="{5B540A3A-E121-9D83-613E-5BE210B171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153888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4" name="Line 12">
                <a:extLst>
                  <a:ext uri="{FF2B5EF4-FFF2-40B4-BE49-F238E27FC236}">
                    <a16:creationId xmlns:a16="http://schemas.microsoft.com/office/drawing/2014/main" id="{07C50F6F-81DB-7655-CF0A-1A82665474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113138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5" name="Line 14">
                <a:extLst>
                  <a:ext uri="{FF2B5EF4-FFF2-40B4-BE49-F238E27FC236}">
                    <a16:creationId xmlns:a16="http://schemas.microsoft.com/office/drawing/2014/main" id="{29A66B24-4F59-D5EF-A0B8-AC5C114A49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74779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6" name="Line 23">
                <a:extLst>
                  <a:ext uri="{FF2B5EF4-FFF2-40B4-BE49-F238E27FC236}">
                    <a16:creationId xmlns:a16="http://schemas.microsoft.com/office/drawing/2014/main" id="{578F6D0E-868B-0015-8109-8009B4C1AE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3825" y="2761369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57" name="図形グループ 54">
                <a:extLst>
                  <a:ext uri="{FF2B5EF4-FFF2-40B4-BE49-F238E27FC236}">
                    <a16:creationId xmlns:a16="http://schemas.microsoft.com/office/drawing/2014/main" id="{2AAA6E33-6FBE-54DD-8521-330F1356C1FE}"/>
                  </a:ext>
                </a:extLst>
              </p:cNvPr>
              <p:cNvGrpSpPr/>
              <p:nvPr/>
            </p:nvGrpSpPr>
            <p:grpSpPr>
              <a:xfrm>
                <a:off x="2034219" y="1002292"/>
                <a:ext cx="220989" cy="1868530"/>
                <a:chOff x="510218" y="1348283"/>
                <a:chExt cx="220989" cy="1868530"/>
              </a:xfrm>
            </p:grpSpPr>
            <p:sp>
              <p:nvSpPr>
                <p:cNvPr id="164" name="Rectangle 10">
                  <a:extLst>
                    <a:ext uri="{FF2B5EF4-FFF2-40B4-BE49-F238E27FC236}">
                      <a16:creationId xmlns:a16="http://schemas.microsoft.com/office/drawing/2014/main" id="{DFB4CE82-1D5C-1ACD-2B93-926184C7EE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65" name="Rectangle 13">
                  <a:extLst>
                    <a:ext uri="{FF2B5EF4-FFF2-40B4-BE49-F238E27FC236}">
                      <a16:creationId xmlns:a16="http://schemas.microsoft.com/office/drawing/2014/main" id="{1748BB5F-7586-9267-8BF8-DA75780CAA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66" name="Rectangle 10">
                  <a:extLst>
                    <a:ext uri="{FF2B5EF4-FFF2-40B4-BE49-F238E27FC236}">
                      <a16:creationId xmlns:a16="http://schemas.microsoft.com/office/drawing/2014/main" id="{79F6B16A-4DB0-9E3D-8445-1659B058D3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58" name="テキスト ボックス 157">
                <a:extLst>
                  <a:ext uri="{FF2B5EF4-FFF2-40B4-BE49-F238E27FC236}">
                    <a16:creationId xmlns:a16="http://schemas.microsoft.com/office/drawing/2014/main" id="{E8BB3E51-7F27-EE69-B12F-C57CCA54FF56}"/>
                  </a:ext>
                </a:extLst>
              </p:cNvPr>
              <p:cNvSpPr txBox="1"/>
              <p:nvPr/>
            </p:nvSpPr>
            <p:spPr>
              <a:xfrm>
                <a:off x="2206686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9" name="テキスト ボックス 158">
                <a:extLst>
                  <a:ext uri="{FF2B5EF4-FFF2-40B4-BE49-F238E27FC236}">
                    <a16:creationId xmlns:a16="http://schemas.microsoft.com/office/drawing/2014/main" id="{0DA0F85A-35C4-8E30-4768-E6E7B4F5368D}"/>
                  </a:ext>
                </a:extLst>
              </p:cNvPr>
              <p:cNvSpPr txBox="1"/>
              <p:nvPr/>
            </p:nvSpPr>
            <p:spPr>
              <a:xfrm>
                <a:off x="3251225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0" name="テキスト ボックス 159">
                <a:extLst>
                  <a:ext uri="{FF2B5EF4-FFF2-40B4-BE49-F238E27FC236}">
                    <a16:creationId xmlns:a16="http://schemas.microsoft.com/office/drawing/2014/main" id="{95BACCAC-61E8-4FFB-783B-2616CA13E45A}"/>
                  </a:ext>
                </a:extLst>
              </p:cNvPr>
              <p:cNvSpPr txBox="1"/>
              <p:nvPr/>
            </p:nvSpPr>
            <p:spPr>
              <a:xfrm>
                <a:off x="5340302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1" name="テキスト ボックス 160">
                <a:extLst>
                  <a:ext uri="{FF2B5EF4-FFF2-40B4-BE49-F238E27FC236}">
                    <a16:creationId xmlns:a16="http://schemas.microsoft.com/office/drawing/2014/main" id="{EF6BFE75-55E1-DF14-25FF-284C43EDA5FD}"/>
                  </a:ext>
                </a:extLst>
              </p:cNvPr>
              <p:cNvSpPr txBox="1"/>
              <p:nvPr/>
            </p:nvSpPr>
            <p:spPr>
              <a:xfrm>
                <a:off x="4295764" y="290130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2" name="テキスト ボックス 161">
                <a:extLst>
                  <a:ext uri="{FF2B5EF4-FFF2-40B4-BE49-F238E27FC236}">
                    <a16:creationId xmlns:a16="http://schemas.microsoft.com/office/drawing/2014/main" id="{8829522B-59E0-DC33-297A-2E7C3B146CF4}"/>
                  </a:ext>
                </a:extLst>
              </p:cNvPr>
              <p:cNvSpPr txBox="1"/>
              <p:nvPr/>
            </p:nvSpPr>
            <p:spPr>
              <a:xfrm rot="16200000">
                <a:off x="604785" y="1624165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9B8576AB-1515-D4B4-9D2F-DC475DD0D944}"/>
                  </a:ext>
                </a:extLst>
              </p:cNvPr>
              <p:cNvSpPr txBox="1"/>
              <p:nvPr/>
            </p:nvSpPr>
            <p:spPr>
              <a:xfrm>
                <a:off x="3108992" y="3163092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37" name="Freeform 93">
              <a:extLst>
                <a:ext uri="{FF2B5EF4-FFF2-40B4-BE49-F238E27FC236}">
                  <a16:creationId xmlns:a16="http://schemas.microsoft.com/office/drawing/2014/main" id="{3B58B4E8-9E73-BCE5-E128-9EFA7E0DA9E0}"/>
                </a:ext>
              </a:extLst>
            </p:cNvPr>
            <p:cNvSpPr>
              <a:spLocks/>
            </p:cNvSpPr>
            <p:nvPr/>
          </p:nvSpPr>
          <p:spPr bwMode="auto">
            <a:xfrm>
              <a:off x="7478762" y="5191230"/>
              <a:ext cx="3032342" cy="750659"/>
            </a:xfrm>
            <a:custGeom>
              <a:avLst/>
              <a:gdLst>
                <a:gd name="T0" fmla="*/ 85 w 1613"/>
                <a:gd name="T1" fmla="*/ 408 h 408"/>
                <a:gd name="T2" fmla="*/ 115 w 1613"/>
                <a:gd name="T3" fmla="*/ 408 h 408"/>
                <a:gd name="T4" fmla="*/ 155 w 1613"/>
                <a:gd name="T5" fmla="*/ 408 h 408"/>
                <a:gd name="T6" fmla="*/ 172 w 1613"/>
                <a:gd name="T7" fmla="*/ 408 h 408"/>
                <a:gd name="T8" fmla="*/ 197 w 1613"/>
                <a:gd name="T9" fmla="*/ 408 h 408"/>
                <a:gd name="T10" fmla="*/ 214 w 1613"/>
                <a:gd name="T11" fmla="*/ 408 h 408"/>
                <a:gd name="T12" fmla="*/ 238 w 1613"/>
                <a:gd name="T13" fmla="*/ 408 h 408"/>
                <a:gd name="T14" fmla="*/ 256 w 1613"/>
                <a:gd name="T15" fmla="*/ 408 h 408"/>
                <a:gd name="T16" fmla="*/ 276 w 1613"/>
                <a:gd name="T17" fmla="*/ 408 h 408"/>
                <a:gd name="T18" fmla="*/ 282 w 1613"/>
                <a:gd name="T19" fmla="*/ 391 h 408"/>
                <a:gd name="T20" fmla="*/ 302 w 1613"/>
                <a:gd name="T21" fmla="*/ 373 h 408"/>
                <a:gd name="T22" fmla="*/ 311 w 1613"/>
                <a:gd name="T23" fmla="*/ 373 h 408"/>
                <a:gd name="T24" fmla="*/ 324 w 1613"/>
                <a:gd name="T25" fmla="*/ 373 h 408"/>
                <a:gd name="T26" fmla="*/ 345 w 1613"/>
                <a:gd name="T27" fmla="*/ 373 h 408"/>
                <a:gd name="T28" fmla="*/ 352 w 1613"/>
                <a:gd name="T29" fmla="*/ 373 h 408"/>
                <a:gd name="T30" fmla="*/ 372 w 1613"/>
                <a:gd name="T31" fmla="*/ 373 h 408"/>
                <a:gd name="T32" fmla="*/ 401 w 1613"/>
                <a:gd name="T33" fmla="*/ 373 h 408"/>
                <a:gd name="T34" fmla="*/ 409 w 1613"/>
                <a:gd name="T35" fmla="*/ 352 h 408"/>
                <a:gd name="T36" fmla="*/ 437 w 1613"/>
                <a:gd name="T37" fmla="*/ 352 h 408"/>
                <a:gd name="T38" fmla="*/ 449 w 1613"/>
                <a:gd name="T39" fmla="*/ 352 h 408"/>
                <a:gd name="T40" fmla="*/ 484 w 1613"/>
                <a:gd name="T41" fmla="*/ 352 h 408"/>
                <a:gd name="T42" fmla="*/ 499 w 1613"/>
                <a:gd name="T43" fmla="*/ 352 h 408"/>
                <a:gd name="T44" fmla="*/ 512 w 1613"/>
                <a:gd name="T45" fmla="*/ 352 h 408"/>
                <a:gd name="T46" fmla="*/ 534 w 1613"/>
                <a:gd name="T47" fmla="*/ 352 h 408"/>
                <a:gd name="T48" fmla="*/ 547 w 1613"/>
                <a:gd name="T49" fmla="*/ 352 h 408"/>
                <a:gd name="T50" fmla="*/ 569 w 1613"/>
                <a:gd name="T51" fmla="*/ 352 h 408"/>
                <a:gd name="T52" fmla="*/ 620 w 1613"/>
                <a:gd name="T53" fmla="*/ 352 h 408"/>
                <a:gd name="T54" fmla="*/ 631 w 1613"/>
                <a:gd name="T55" fmla="*/ 352 h 408"/>
                <a:gd name="T56" fmla="*/ 671 w 1613"/>
                <a:gd name="T57" fmla="*/ 352 h 408"/>
                <a:gd name="T58" fmla="*/ 698 w 1613"/>
                <a:gd name="T59" fmla="*/ 352 h 408"/>
                <a:gd name="T60" fmla="*/ 709 w 1613"/>
                <a:gd name="T61" fmla="*/ 352 h 408"/>
                <a:gd name="T62" fmla="*/ 729 w 1613"/>
                <a:gd name="T63" fmla="*/ 352 h 408"/>
                <a:gd name="T64" fmla="*/ 739 w 1613"/>
                <a:gd name="T65" fmla="*/ 352 h 408"/>
                <a:gd name="T66" fmla="*/ 759 w 1613"/>
                <a:gd name="T67" fmla="*/ 352 h 408"/>
                <a:gd name="T68" fmla="*/ 769 w 1613"/>
                <a:gd name="T69" fmla="*/ 352 h 408"/>
                <a:gd name="T70" fmla="*/ 789 w 1613"/>
                <a:gd name="T71" fmla="*/ 352 h 408"/>
                <a:gd name="T72" fmla="*/ 810 w 1613"/>
                <a:gd name="T73" fmla="*/ 352 h 408"/>
                <a:gd name="T74" fmla="*/ 822 w 1613"/>
                <a:gd name="T75" fmla="*/ 352 h 408"/>
                <a:gd name="T76" fmla="*/ 841 w 1613"/>
                <a:gd name="T77" fmla="*/ 352 h 408"/>
                <a:gd name="T78" fmla="*/ 852 w 1613"/>
                <a:gd name="T79" fmla="*/ 352 h 408"/>
                <a:gd name="T80" fmla="*/ 878 w 1613"/>
                <a:gd name="T81" fmla="*/ 352 h 408"/>
                <a:gd name="T82" fmla="*/ 889 w 1613"/>
                <a:gd name="T83" fmla="*/ 352 h 408"/>
                <a:gd name="T84" fmla="*/ 902 w 1613"/>
                <a:gd name="T85" fmla="*/ 352 h 408"/>
                <a:gd name="T86" fmla="*/ 931 w 1613"/>
                <a:gd name="T87" fmla="*/ 352 h 408"/>
                <a:gd name="T88" fmla="*/ 954 w 1613"/>
                <a:gd name="T89" fmla="*/ 352 h 408"/>
                <a:gd name="T90" fmla="*/ 1009 w 1613"/>
                <a:gd name="T91" fmla="*/ 352 h 408"/>
                <a:gd name="T92" fmla="*/ 1037 w 1613"/>
                <a:gd name="T93" fmla="*/ 352 h 408"/>
                <a:gd name="T94" fmla="*/ 1051 w 1613"/>
                <a:gd name="T95" fmla="*/ 0 h 408"/>
                <a:gd name="T96" fmla="*/ 1100 w 1613"/>
                <a:gd name="T97" fmla="*/ 0 h 408"/>
                <a:gd name="T98" fmla="*/ 1144 w 1613"/>
                <a:gd name="T99" fmla="*/ 0 h 4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1613" h="408">
                  <a:moveTo>
                    <a:pt x="0" y="408"/>
                  </a:moveTo>
                  <a:lnTo>
                    <a:pt x="85" y="408"/>
                  </a:lnTo>
                  <a:lnTo>
                    <a:pt x="110" y="408"/>
                  </a:lnTo>
                  <a:lnTo>
                    <a:pt x="115" y="408"/>
                  </a:lnTo>
                  <a:lnTo>
                    <a:pt x="137" y="408"/>
                  </a:lnTo>
                  <a:lnTo>
                    <a:pt x="155" y="408"/>
                  </a:lnTo>
                  <a:lnTo>
                    <a:pt x="168" y="408"/>
                  </a:lnTo>
                  <a:lnTo>
                    <a:pt x="172" y="408"/>
                  </a:lnTo>
                  <a:lnTo>
                    <a:pt x="186" y="408"/>
                  </a:lnTo>
                  <a:lnTo>
                    <a:pt x="197" y="408"/>
                  </a:lnTo>
                  <a:lnTo>
                    <a:pt x="204" y="408"/>
                  </a:lnTo>
                  <a:lnTo>
                    <a:pt x="214" y="408"/>
                  </a:lnTo>
                  <a:lnTo>
                    <a:pt x="238" y="408"/>
                  </a:lnTo>
                  <a:lnTo>
                    <a:pt x="238" y="408"/>
                  </a:lnTo>
                  <a:lnTo>
                    <a:pt x="248" y="408"/>
                  </a:lnTo>
                  <a:lnTo>
                    <a:pt x="256" y="408"/>
                  </a:lnTo>
                  <a:lnTo>
                    <a:pt x="266" y="408"/>
                  </a:lnTo>
                  <a:lnTo>
                    <a:pt x="276" y="408"/>
                  </a:lnTo>
                  <a:lnTo>
                    <a:pt x="277" y="391"/>
                  </a:lnTo>
                  <a:lnTo>
                    <a:pt x="282" y="391"/>
                  </a:lnTo>
                  <a:lnTo>
                    <a:pt x="301" y="391"/>
                  </a:lnTo>
                  <a:lnTo>
                    <a:pt x="302" y="373"/>
                  </a:lnTo>
                  <a:lnTo>
                    <a:pt x="305" y="373"/>
                  </a:lnTo>
                  <a:lnTo>
                    <a:pt x="311" y="373"/>
                  </a:lnTo>
                  <a:lnTo>
                    <a:pt x="318" y="373"/>
                  </a:lnTo>
                  <a:lnTo>
                    <a:pt x="324" y="373"/>
                  </a:lnTo>
                  <a:lnTo>
                    <a:pt x="332" y="373"/>
                  </a:lnTo>
                  <a:lnTo>
                    <a:pt x="345" y="373"/>
                  </a:lnTo>
                  <a:lnTo>
                    <a:pt x="349" y="373"/>
                  </a:lnTo>
                  <a:lnTo>
                    <a:pt x="352" y="373"/>
                  </a:lnTo>
                  <a:lnTo>
                    <a:pt x="359" y="373"/>
                  </a:lnTo>
                  <a:lnTo>
                    <a:pt x="372" y="373"/>
                  </a:lnTo>
                  <a:lnTo>
                    <a:pt x="388" y="373"/>
                  </a:lnTo>
                  <a:lnTo>
                    <a:pt x="401" y="373"/>
                  </a:lnTo>
                  <a:lnTo>
                    <a:pt x="401" y="352"/>
                  </a:lnTo>
                  <a:lnTo>
                    <a:pt x="409" y="352"/>
                  </a:lnTo>
                  <a:lnTo>
                    <a:pt x="425" y="352"/>
                  </a:lnTo>
                  <a:lnTo>
                    <a:pt x="437" y="352"/>
                  </a:lnTo>
                  <a:lnTo>
                    <a:pt x="443" y="352"/>
                  </a:lnTo>
                  <a:lnTo>
                    <a:pt x="449" y="352"/>
                  </a:lnTo>
                  <a:lnTo>
                    <a:pt x="478" y="352"/>
                  </a:lnTo>
                  <a:lnTo>
                    <a:pt x="484" y="352"/>
                  </a:lnTo>
                  <a:lnTo>
                    <a:pt x="492" y="352"/>
                  </a:lnTo>
                  <a:lnTo>
                    <a:pt x="499" y="352"/>
                  </a:lnTo>
                  <a:lnTo>
                    <a:pt x="506" y="352"/>
                  </a:lnTo>
                  <a:lnTo>
                    <a:pt x="512" y="352"/>
                  </a:lnTo>
                  <a:lnTo>
                    <a:pt x="522" y="352"/>
                  </a:lnTo>
                  <a:lnTo>
                    <a:pt x="534" y="352"/>
                  </a:lnTo>
                  <a:lnTo>
                    <a:pt x="539" y="352"/>
                  </a:lnTo>
                  <a:lnTo>
                    <a:pt x="547" y="352"/>
                  </a:lnTo>
                  <a:lnTo>
                    <a:pt x="561" y="352"/>
                  </a:lnTo>
                  <a:lnTo>
                    <a:pt x="569" y="352"/>
                  </a:lnTo>
                  <a:lnTo>
                    <a:pt x="588" y="352"/>
                  </a:lnTo>
                  <a:lnTo>
                    <a:pt x="620" y="352"/>
                  </a:lnTo>
                  <a:lnTo>
                    <a:pt x="626" y="352"/>
                  </a:lnTo>
                  <a:lnTo>
                    <a:pt x="631" y="352"/>
                  </a:lnTo>
                  <a:lnTo>
                    <a:pt x="635" y="352"/>
                  </a:lnTo>
                  <a:lnTo>
                    <a:pt x="671" y="352"/>
                  </a:lnTo>
                  <a:lnTo>
                    <a:pt x="684" y="352"/>
                  </a:lnTo>
                  <a:lnTo>
                    <a:pt x="698" y="352"/>
                  </a:lnTo>
                  <a:lnTo>
                    <a:pt x="707" y="352"/>
                  </a:lnTo>
                  <a:lnTo>
                    <a:pt x="709" y="352"/>
                  </a:lnTo>
                  <a:lnTo>
                    <a:pt x="720" y="352"/>
                  </a:lnTo>
                  <a:lnTo>
                    <a:pt x="729" y="352"/>
                  </a:lnTo>
                  <a:lnTo>
                    <a:pt x="731" y="352"/>
                  </a:lnTo>
                  <a:lnTo>
                    <a:pt x="739" y="352"/>
                  </a:lnTo>
                  <a:lnTo>
                    <a:pt x="752" y="352"/>
                  </a:lnTo>
                  <a:lnTo>
                    <a:pt x="759" y="352"/>
                  </a:lnTo>
                  <a:lnTo>
                    <a:pt x="762" y="352"/>
                  </a:lnTo>
                  <a:lnTo>
                    <a:pt x="769" y="352"/>
                  </a:lnTo>
                  <a:lnTo>
                    <a:pt x="778" y="352"/>
                  </a:lnTo>
                  <a:lnTo>
                    <a:pt x="789" y="352"/>
                  </a:lnTo>
                  <a:lnTo>
                    <a:pt x="801" y="352"/>
                  </a:lnTo>
                  <a:lnTo>
                    <a:pt x="810" y="352"/>
                  </a:lnTo>
                  <a:lnTo>
                    <a:pt x="817" y="352"/>
                  </a:lnTo>
                  <a:lnTo>
                    <a:pt x="822" y="352"/>
                  </a:lnTo>
                  <a:lnTo>
                    <a:pt x="830" y="352"/>
                  </a:lnTo>
                  <a:lnTo>
                    <a:pt x="841" y="352"/>
                  </a:lnTo>
                  <a:lnTo>
                    <a:pt x="846" y="352"/>
                  </a:lnTo>
                  <a:lnTo>
                    <a:pt x="852" y="352"/>
                  </a:lnTo>
                  <a:lnTo>
                    <a:pt x="872" y="352"/>
                  </a:lnTo>
                  <a:lnTo>
                    <a:pt x="878" y="352"/>
                  </a:lnTo>
                  <a:lnTo>
                    <a:pt x="888" y="352"/>
                  </a:lnTo>
                  <a:lnTo>
                    <a:pt x="889" y="352"/>
                  </a:lnTo>
                  <a:lnTo>
                    <a:pt x="899" y="352"/>
                  </a:lnTo>
                  <a:lnTo>
                    <a:pt x="902" y="352"/>
                  </a:lnTo>
                  <a:lnTo>
                    <a:pt x="912" y="352"/>
                  </a:lnTo>
                  <a:lnTo>
                    <a:pt x="931" y="352"/>
                  </a:lnTo>
                  <a:lnTo>
                    <a:pt x="941" y="352"/>
                  </a:lnTo>
                  <a:lnTo>
                    <a:pt x="954" y="352"/>
                  </a:lnTo>
                  <a:lnTo>
                    <a:pt x="1006" y="352"/>
                  </a:lnTo>
                  <a:lnTo>
                    <a:pt x="1009" y="352"/>
                  </a:lnTo>
                  <a:lnTo>
                    <a:pt x="1024" y="352"/>
                  </a:lnTo>
                  <a:lnTo>
                    <a:pt x="1037" y="352"/>
                  </a:lnTo>
                  <a:lnTo>
                    <a:pt x="1051" y="352"/>
                  </a:lnTo>
                  <a:lnTo>
                    <a:pt x="1051" y="0"/>
                  </a:lnTo>
                  <a:lnTo>
                    <a:pt x="1069" y="0"/>
                  </a:lnTo>
                  <a:lnTo>
                    <a:pt x="1100" y="0"/>
                  </a:lnTo>
                  <a:lnTo>
                    <a:pt x="1131" y="0"/>
                  </a:lnTo>
                  <a:lnTo>
                    <a:pt x="1144" y="0"/>
                  </a:lnTo>
                  <a:lnTo>
                    <a:pt x="1613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Freeform 94">
              <a:extLst>
                <a:ext uri="{FF2B5EF4-FFF2-40B4-BE49-F238E27FC236}">
                  <a16:creationId xmlns:a16="http://schemas.microsoft.com/office/drawing/2014/main" id="{F4D9D117-D498-E596-E1A1-5888A8E50D42}"/>
                </a:ext>
              </a:extLst>
            </p:cNvPr>
            <p:cNvSpPr>
              <a:spLocks/>
            </p:cNvSpPr>
            <p:nvPr/>
          </p:nvSpPr>
          <p:spPr bwMode="auto">
            <a:xfrm>
              <a:off x="7478762" y="5884854"/>
              <a:ext cx="2094252" cy="57036"/>
            </a:xfrm>
            <a:custGeom>
              <a:avLst/>
              <a:gdLst>
                <a:gd name="T0" fmla="*/ 95 w 1114"/>
                <a:gd name="T1" fmla="*/ 31 h 31"/>
                <a:gd name="T2" fmla="*/ 126 w 1114"/>
                <a:gd name="T3" fmla="*/ 31 h 31"/>
                <a:gd name="T4" fmla="*/ 143 w 1114"/>
                <a:gd name="T5" fmla="*/ 31 h 31"/>
                <a:gd name="T6" fmla="*/ 160 w 1114"/>
                <a:gd name="T7" fmla="*/ 31 h 31"/>
                <a:gd name="T8" fmla="*/ 183 w 1114"/>
                <a:gd name="T9" fmla="*/ 31 h 31"/>
                <a:gd name="T10" fmla="*/ 199 w 1114"/>
                <a:gd name="T11" fmla="*/ 31 h 31"/>
                <a:gd name="T12" fmla="*/ 216 w 1114"/>
                <a:gd name="T13" fmla="*/ 31 h 31"/>
                <a:gd name="T14" fmla="*/ 232 w 1114"/>
                <a:gd name="T15" fmla="*/ 31 h 31"/>
                <a:gd name="T16" fmla="*/ 253 w 1114"/>
                <a:gd name="T17" fmla="*/ 31 h 31"/>
                <a:gd name="T18" fmla="*/ 269 w 1114"/>
                <a:gd name="T19" fmla="*/ 31 h 31"/>
                <a:gd name="T20" fmla="*/ 282 w 1114"/>
                <a:gd name="T21" fmla="*/ 23 h 31"/>
                <a:gd name="T22" fmla="*/ 305 w 1114"/>
                <a:gd name="T23" fmla="*/ 23 h 31"/>
                <a:gd name="T24" fmla="*/ 319 w 1114"/>
                <a:gd name="T25" fmla="*/ 14 h 31"/>
                <a:gd name="T26" fmla="*/ 335 w 1114"/>
                <a:gd name="T27" fmla="*/ 14 h 31"/>
                <a:gd name="T28" fmla="*/ 360 w 1114"/>
                <a:gd name="T29" fmla="*/ 14 h 31"/>
                <a:gd name="T30" fmla="*/ 383 w 1114"/>
                <a:gd name="T31" fmla="*/ 14 h 31"/>
                <a:gd name="T32" fmla="*/ 402 w 1114"/>
                <a:gd name="T33" fmla="*/ 14 h 31"/>
                <a:gd name="T34" fmla="*/ 419 w 1114"/>
                <a:gd name="T35" fmla="*/ 14 h 31"/>
                <a:gd name="T36" fmla="*/ 437 w 1114"/>
                <a:gd name="T37" fmla="*/ 14 h 31"/>
                <a:gd name="T38" fmla="*/ 457 w 1114"/>
                <a:gd name="T39" fmla="*/ 14 h 31"/>
                <a:gd name="T40" fmla="*/ 479 w 1114"/>
                <a:gd name="T41" fmla="*/ 14 h 31"/>
                <a:gd name="T42" fmla="*/ 499 w 1114"/>
                <a:gd name="T43" fmla="*/ 14 h 31"/>
                <a:gd name="T44" fmla="*/ 524 w 1114"/>
                <a:gd name="T45" fmla="*/ 14 h 31"/>
                <a:gd name="T46" fmla="*/ 544 w 1114"/>
                <a:gd name="T47" fmla="*/ 14 h 31"/>
                <a:gd name="T48" fmla="*/ 559 w 1114"/>
                <a:gd name="T49" fmla="*/ 14 h 31"/>
                <a:gd name="T50" fmla="*/ 582 w 1114"/>
                <a:gd name="T51" fmla="*/ 0 h 31"/>
                <a:gd name="T52" fmla="*/ 613 w 1114"/>
                <a:gd name="T53" fmla="*/ 0 h 31"/>
                <a:gd name="T54" fmla="*/ 639 w 1114"/>
                <a:gd name="T55" fmla="*/ 0 h 31"/>
                <a:gd name="T56" fmla="*/ 661 w 1114"/>
                <a:gd name="T57" fmla="*/ 0 h 31"/>
                <a:gd name="T58" fmla="*/ 683 w 1114"/>
                <a:gd name="T59" fmla="*/ 0 h 31"/>
                <a:gd name="T60" fmla="*/ 701 w 1114"/>
                <a:gd name="T61" fmla="*/ 0 h 31"/>
                <a:gd name="T62" fmla="*/ 716 w 1114"/>
                <a:gd name="T63" fmla="*/ 0 h 31"/>
                <a:gd name="T64" fmla="*/ 740 w 1114"/>
                <a:gd name="T65" fmla="*/ 0 h 31"/>
                <a:gd name="T66" fmla="*/ 758 w 1114"/>
                <a:gd name="T67" fmla="*/ 0 h 31"/>
                <a:gd name="T68" fmla="*/ 774 w 1114"/>
                <a:gd name="T69" fmla="*/ 0 h 31"/>
                <a:gd name="T70" fmla="*/ 794 w 1114"/>
                <a:gd name="T71" fmla="*/ 0 h 31"/>
                <a:gd name="T72" fmla="*/ 813 w 1114"/>
                <a:gd name="T73" fmla="*/ 0 h 31"/>
                <a:gd name="T74" fmla="*/ 832 w 1114"/>
                <a:gd name="T75" fmla="*/ 0 h 31"/>
                <a:gd name="T76" fmla="*/ 846 w 1114"/>
                <a:gd name="T77" fmla="*/ 0 h 31"/>
                <a:gd name="T78" fmla="*/ 866 w 1114"/>
                <a:gd name="T79" fmla="*/ 0 h 31"/>
                <a:gd name="T80" fmla="*/ 882 w 1114"/>
                <a:gd name="T81" fmla="*/ 0 h 31"/>
                <a:gd name="T82" fmla="*/ 901 w 1114"/>
                <a:gd name="T83" fmla="*/ 0 h 31"/>
                <a:gd name="T84" fmla="*/ 927 w 1114"/>
                <a:gd name="T85" fmla="*/ 0 h 31"/>
                <a:gd name="T86" fmla="*/ 947 w 1114"/>
                <a:gd name="T87" fmla="*/ 0 h 31"/>
                <a:gd name="T88" fmla="*/ 962 w 1114"/>
                <a:gd name="T89" fmla="*/ 0 h 31"/>
                <a:gd name="T90" fmla="*/ 1011 w 1114"/>
                <a:gd name="T91" fmla="*/ 0 h 31"/>
                <a:gd name="T92" fmla="*/ 1114 w 1114"/>
                <a:gd name="T93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1114" h="31">
                  <a:moveTo>
                    <a:pt x="0" y="31"/>
                  </a:moveTo>
                  <a:lnTo>
                    <a:pt x="90" y="31"/>
                  </a:lnTo>
                  <a:lnTo>
                    <a:pt x="95" y="31"/>
                  </a:lnTo>
                  <a:lnTo>
                    <a:pt x="117" y="31"/>
                  </a:lnTo>
                  <a:lnTo>
                    <a:pt x="122" y="31"/>
                  </a:lnTo>
                  <a:lnTo>
                    <a:pt x="126" y="31"/>
                  </a:lnTo>
                  <a:lnTo>
                    <a:pt x="131" y="31"/>
                  </a:lnTo>
                  <a:lnTo>
                    <a:pt x="137" y="31"/>
                  </a:lnTo>
                  <a:lnTo>
                    <a:pt x="143" y="31"/>
                  </a:lnTo>
                  <a:lnTo>
                    <a:pt x="148" y="31"/>
                  </a:lnTo>
                  <a:lnTo>
                    <a:pt x="154" y="31"/>
                  </a:lnTo>
                  <a:lnTo>
                    <a:pt x="160" y="31"/>
                  </a:lnTo>
                  <a:lnTo>
                    <a:pt x="166" y="31"/>
                  </a:lnTo>
                  <a:lnTo>
                    <a:pt x="173" y="31"/>
                  </a:lnTo>
                  <a:lnTo>
                    <a:pt x="183" y="31"/>
                  </a:lnTo>
                  <a:lnTo>
                    <a:pt x="185" y="31"/>
                  </a:lnTo>
                  <a:lnTo>
                    <a:pt x="192" y="31"/>
                  </a:lnTo>
                  <a:lnTo>
                    <a:pt x="199" y="31"/>
                  </a:lnTo>
                  <a:lnTo>
                    <a:pt x="206" y="31"/>
                  </a:lnTo>
                  <a:lnTo>
                    <a:pt x="211" y="31"/>
                  </a:lnTo>
                  <a:lnTo>
                    <a:pt x="216" y="31"/>
                  </a:lnTo>
                  <a:lnTo>
                    <a:pt x="223" y="31"/>
                  </a:lnTo>
                  <a:lnTo>
                    <a:pt x="226" y="31"/>
                  </a:lnTo>
                  <a:lnTo>
                    <a:pt x="232" y="31"/>
                  </a:lnTo>
                  <a:lnTo>
                    <a:pt x="238" y="31"/>
                  </a:lnTo>
                  <a:lnTo>
                    <a:pt x="244" y="31"/>
                  </a:lnTo>
                  <a:lnTo>
                    <a:pt x="253" y="31"/>
                  </a:lnTo>
                  <a:lnTo>
                    <a:pt x="257" y="31"/>
                  </a:lnTo>
                  <a:lnTo>
                    <a:pt x="264" y="31"/>
                  </a:lnTo>
                  <a:lnTo>
                    <a:pt x="269" y="31"/>
                  </a:lnTo>
                  <a:lnTo>
                    <a:pt x="269" y="23"/>
                  </a:lnTo>
                  <a:lnTo>
                    <a:pt x="277" y="23"/>
                  </a:lnTo>
                  <a:lnTo>
                    <a:pt x="282" y="23"/>
                  </a:lnTo>
                  <a:lnTo>
                    <a:pt x="293" y="23"/>
                  </a:lnTo>
                  <a:lnTo>
                    <a:pt x="299" y="23"/>
                  </a:lnTo>
                  <a:lnTo>
                    <a:pt x="305" y="23"/>
                  </a:lnTo>
                  <a:lnTo>
                    <a:pt x="307" y="14"/>
                  </a:lnTo>
                  <a:lnTo>
                    <a:pt x="313" y="14"/>
                  </a:lnTo>
                  <a:lnTo>
                    <a:pt x="319" y="14"/>
                  </a:lnTo>
                  <a:lnTo>
                    <a:pt x="323" y="14"/>
                  </a:lnTo>
                  <a:lnTo>
                    <a:pt x="330" y="14"/>
                  </a:lnTo>
                  <a:lnTo>
                    <a:pt x="335" y="14"/>
                  </a:lnTo>
                  <a:lnTo>
                    <a:pt x="347" y="14"/>
                  </a:lnTo>
                  <a:lnTo>
                    <a:pt x="352" y="14"/>
                  </a:lnTo>
                  <a:lnTo>
                    <a:pt x="360" y="14"/>
                  </a:lnTo>
                  <a:lnTo>
                    <a:pt x="366" y="14"/>
                  </a:lnTo>
                  <a:lnTo>
                    <a:pt x="378" y="14"/>
                  </a:lnTo>
                  <a:lnTo>
                    <a:pt x="383" y="14"/>
                  </a:lnTo>
                  <a:lnTo>
                    <a:pt x="389" y="14"/>
                  </a:lnTo>
                  <a:lnTo>
                    <a:pt x="395" y="14"/>
                  </a:lnTo>
                  <a:lnTo>
                    <a:pt x="402" y="14"/>
                  </a:lnTo>
                  <a:lnTo>
                    <a:pt x="408" y="14"/>
                  </a:lnTo>
                  <a:lnTo>
                    <a:pt x="413" y="14"/>
                  </a:lnTo>
                  <a:lnTo>
                    <a:pt x="419" y="14"/>
                  </a:lnTo>
                  <a:lnTo>
                    <a:pt x="426" y="14"/>
                  </a:lnTo>
                  <a:lnTo>
                    <a:pt x="431" y="14"/>
                  </a:lnTo>
                  <a:lnTo>
                    <a:pt x="437" y="14"/>
                  </a:lnTo>
                  <a:lnTo>
                    <a:pt x="444" y="14"/>
                  </a:lnTo>
                  <a:lnTo>
                    <a:pt x="452" y="14"/>
                  </a:lnTo>
                  <a:lnTo>
                    <a:pt x="457" y="14"/>
                  </a:lnTo>
                  <a:lnTo>
                    <a:pt x="464" y="14"/>
                  </a:lnTo>
                  <a:lnTo>
                    <a:pt x="469" y="14"/>
                  </a:lnTo>
                  <a:lnTo>
                    <a:pt x="479" y="14"/>
                  </a:lnTo>
                  <a:lnTo>
                    <a:pt x="487" y="14"/>
                  </a:lnTo>
                  <a:lnTo>
                    <a:pt x="492" y="14"/>
                  </a:lnTo>
                  <a:lnTo>
                    <a:pt x="499" y="14"/>
                  </a:lnTo>
                  <a:lnTo>
                    <a:pt x="504" y="14"/>
                  </a:lnTo>
                  <a:lnTo>
                    <a:pt x="518" y="14"/>
                  </a:lnTo>
                  <a:lnTo>
                    <a:pt x="524" y="14"/>
                  </a:lnTo>
                  <a:lnTo>
                    <a:pt x="527" y="14"/>
                  </a:lnTo>
                  <a:lnTo>
                    <a:pt x="535" y="14"/>
                  </a:lnTo>
                  <a:lnTo>
                    <a:pt x="544" y="14"/>
                  </a:lnTo>
                  <a:lnTo>
                    <a:pt x="545" y="14"/>
                  </a:lnTo>
                  <a:lnTo>
                    <a:pt x="553" y="14"/>
                  </a:lnTo>
                  <a:lnTo>
                    <a:pt x="559" y="14"/>
                  </a:lnTo>
                  <a:lnTo>
                    <a:pt x="571" y="14"/>
                  </a:lnTo>
                  <a:lnTo>
                    <a:pt x="582" y="14"/>
                  </a:lnTo>
                  <a:lnTo>
                    <a:pt x="582" y="0"/>
                  </a:lnTo>
                  <a:lnTo>
                    <a:pt x="587" y="0"/>
                  </a:lnTo>
                  <a:lnTo>
                    <a:pt x="605" y="0"/>
                  </a:lnTo>
                  <a:lnTo>
                    <a:pt x="613" y="0"/>
                  </a:lnTo>
                  <a:lnTo>
                    <a:pt x="618" y="0"/>
                  </a:lnTo>
                  <a:lnTo>
                    <a:pt x="625" y="0"/>
                  </a:lnTo>
                  <a:lnTo>
                    <a:pt x="639" y="0"/>
                  </a:lnTo>
                  <a:lnTo>
                    <a:pt x="644" y="0"/>
                  </a:lnTo>
                  <a:lnTo>
                    <a:pt x="653" y="0"/>
                  </a:lnTo>
                  <a:lnTo>
                    <a:pt x="661" y="0"/>
                  </a:lnTo>
                  <a:lnTo>
                    <a:pt x="666" y="0"/>
                  </a:lnTo>
                  <a:lnTo>
                    <a:pt x="672" y="0"/>
                  </a:lnTo>
                  <a:lnTo>
                    <a:pt x="683" y="0"/>
                  </a:lnTo>
                  <a:lnTo>
                    <a:pt x="684" y="0"/>
                  </a:lnTo>
                  <a:lnTo>
                    <a:pt x="690" y="0"/>
                  </a:lnTo>
                  <a:lnTo>
                    <a:pt x="701" y="0"/>
                  </a:lnTo>
                  <a:lnTo>
                    <a:pt x="701" y="0"/>
                  </a:lnTo>
                  <a:lnTo>
                    <a:pt x="707" y="0"/>
                  </a:lnTo>
                  <a:lnTo>
                    <a:pt x="716" y="0"/>
                  </a:lnTo>
                  <a:lnTo>
                    <a:pt x="721" y="0"/>
                  </a:lnTo>
                  <a:lnTo>
                    <a:pt x="731" y="0"/>
                  </a:lnTo>
                  <a:lnTo>
                    <a:pt x="740" y="0"/>
                  </a:lnTo>
                  <a:lnTo>
                    <a:pt x="744" y="0"/>
                  </a:lnTo>
                  <a:lnTo>
                    <a:pt x="752" y="0"/>
                  </a:lnTo>
                  <a:lnTo>
                    <a:pt x="758" y="0"/>
                  </a:lnTo>
                  <a:lnTo>
                    <a:pt x="761" y="0"/>
                  </a:lnTo>
                  <a:lnTo>
                    <a:pt x="770" y="0"/>
                  </a:lnTo>
                  <a:lnTo>
                    <a:pt x="774" y="0"/>
                  </a:lnTo>
                  <a:lnTo>
                    <a:pt x="781" y="0"/>
                  </a:lnTo>
                  <a:lnTo>
                    <a:pt x="787" y="0"/>
                  </a:lnTo>
                  <a:lnTo>
                    <a:pt x="794" y="0"/>
                  </a:lnTo>
                  <a:lnTo>
                    <a:pt x="800" y="0"/>
                  </a:lnTo>
                  <a:lnTo>
                    <a:pt x="804" y="0"/>
                  </a:lnTo>
                  <a:lnTo>
                    <a:pt x="813" y="0"/>
                  </a:lnTo>
                  <a:lnTo>
                    <a:pt x="821" y="0"/>
                  </a:lnTo>
                  <a:lnTo>
                    <a:pt x="824" y="0"/>
                  </a:lnTo>
                  <a:lnTo>
                    <a:pt x="832" y="0"/>
                  </a:lnTo>
                  <a:lnTo>
                    <a:pt x="834" y="0"/>
                  </a:lnTo>
                  <a:lnTo>
                    <a:pt x="841" y="0"/>
                  </a:lnTo>
                  <a:lnTo>
                    <a:pt x="846" y="0"/>
                  </a:lnTo>
                  <a:lnTo>
                    <a:pt x="855" y="0"/>
                  </a:lnTo>
                  <a:lnTo>
                    <a:pt x="858" y="0"/>
                  </a:lnTo>
                  <a:lnTo>
                    <a:pt x="866" y="0"/>
                  </a:lnTo>
                  <a:lnTo>
                    <a:pt x="873" y="0"/>
                  </a:lnTo>
                  <a:lnTo>
                    <a:pt x="876" y="0"/>
                  </a:lnTo>
                  <a:lnTo>
                    <a:pt x="882" y="0"/>
                  </a:lnTo>
                  <a:lnTo>
                    <a:pt x="890" y="0"/>
                  </a:lnTo>
                  <a:lnTo>
                    <a:pt x="894" y="0"/>
                  </a:lnTo>
                  <a:lnTo>
                    <a:pt x="901" y="0"/>
                  </a:lnTo>
                  <a:lnTo>
                    <a:pt x="916" y="0"/>
                  </a:lnTo>
                  <a:lnTo>
                    <a:pt x="920" y="0"/>
                  </a:lnTo>
                  <a:lnTo>
                    <a:pt x="927" y="0"/>
                  </a:lnTo>
                  <a:lnTo>
                    <a:pt x="930" y="0"/>
                  </a:lnTo>
                  <a:lnTo>
                    <a:pt x="936" y="0"/>
                  </a:lnTo>
                  <a:lnTo>
                    <a:pt x="947" y="0"/>
                  </a:lnTo>
                  <a:lnTo>
                    <a:pt x="951" y="0"/>
                  </a:lnTo>
                  <a:lnTo>
                    <a:pt x="957" y="0"/>
                  </a:lnTo>
                  <a:lnTo>
                    <a:pt x="962" y="0"/>
                  </a:lnTo>
                  <a:lnTo>
                    <a:pt x="974" y="0"/>
                  </a:lnTo>
                  <a:lnTo>
                    <a:pt x="1005" y="0"/>
                  </a:lnTo>
                  <a:lnTo>
                    <a:pt x="1011" y="0"/>
                  </a:lnTo>
                  <a:lnTo>
                    <a:pt x="1015" y="0"/>
                  </a:lnTo>
                  <a:lnTo>
                    <a:pt x="1064" y="0"/>
                  </a:lnTo>
                  <a:lnTo>
                    <a:pt x="1114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Freeform 95">
              <a:extLst>
                <a:ext uri="{FF2B5EF4-FFF2-40B4-BE49-F238E27FC236}">
                  <a16:creationId xmlns:a16="http://schemas.microsoft.com/office/drawing/2014/main" id="{5C20CC78-8BAE-DCD6-CF8D-F7B5B4464401}"/>
                </a:ext>
              </a:extLst>
            </p:cNvPr>
            <p:cNvSpPr>
              <a:spLocks/>
            </p:cNvSpPr>
            <p:nvPr/>
          </p:nvSpPr>
          <p:spPr bwMode="auto">
            <a:xfrm>
              <a:off x="7478762" y="5014604"/>
              <a:ext cx="2178850" cy="927285"/>
            </a:xfrm>
            <a:custGeom>
              <a:avLst/>
              <a:gdLst>
                <a:gd name="T0" fmla="*/ 90 w 1159"/>
                <a:gd name="T1" fmla="*/ 504 h 504"/>
                <a:gd name="T2" fmla="*/ 110 w 1159"/>
                <a:gd name="T3" fmla="*/ 504 h 504"/>
                <a:gd name="T4" fmla="*/ 127 w 1159"/>
                <a:gd name="T5" fmla="*/ 504 h 504"/>
                <a:gd name="T6" fmla="*/ 143 w 1159"/>
                <a:gd name="T7" fmla="*/ 504 h 504"/>
                <a:gd name="T8" fmla="*/ 155 w 1159"/>
                <a:gd name="T9" fmla="*/ 498 h 504"/>
                <a:gd name="T10" fmla="*/ 173 w 1159"/>
                <a:gd name="T11" fmla="*/ 498 h 504"/>
                <a:gd name="T12" fmla="*/ 189 w 1159"/>
                <a:gd name="T13" fmla="*/ 495 h 504"/>
                <a:gd name="T14" fmla="*/ 202 w 1159"/>
                <a:gd name="T15" fmla="*/ 492 h 504"/>
                <a:gd name="T16" fmla="*/ 224 w 1159"/>
                <a:gd name="T17" fmla="*/ 492 h 504"/>
                <a:gd name="T18" fmla="*/ 237 w 1159"/>
                <a:gd name="T19" fmla="*/ 488 h 504"/>
                <a:gd name="T20" fmla="*/ 251 w 1159"/>
                <a:gd name="T21" fmla="*/ 488 h 504"/>
                <a:gd name="T22" fmla="*/ 269 w 1159"/>
                <a:gd name="T23" fmla="*/ 485 h 504"/>
                <a:gd name="T24" fmla="*/ 280 w 1159"/>
                <a:gd name="T25" fmla="*/ 478 h 504"/>
                <a:gd name="T26" fmla="*/ 292 w 1159"/>
                <a:gd name="T27" fmla="*/ 471 h 504"/>
                <a:gd name="T28" fmla="*/ 311 w 1159"/>
                <a:gd name="T29" fmla="*/ 471 h 504"/>
                <a:gd name="T30" fmla="*/ 330 w 1159"/>
                <a:gd name="T31" fmla="*/ 471 h 504"/>
                <a:gd name="T32" fmla="*/ 341 w 1159"/>
                <a:gd name="T33" fmla="*/ 467 h 504"/>
                <a:gd name="T34" fmla="*/ 360 w 1159"/>
                <a:gd name="T35" fmla="*/ 467 h 504"/>
                <a:gd name="T36" fmla="*/ 377 w 1159"/>
                <a:gd name="T37" fmla="*/ 467 h 504"/>
                <a:gd name="T38" fmla="*/ 389 w 1159"/>
                <a:gd name="T39" fmla="*/ 459 h 504"/>
                <a:gd name="T40" fmla="*/ 407 w 1159"/>
                <a:gd name="T41" fmla="*/ 459 h 504"/>
                <a:gd name="T42" fmla="*/ 427 w 1159"/>
                <a:gd name="T43" fmla="*/ 459 h 504"/>
                <a:gd name="T44" fmla="*/ 442 w 1159"/>
                <a:gd name="T45" fmla="*/ 454 h 504"/>
                <a:gd name="T46" fmla="*/ 452 w 1159"/>
                <a:gd name="T47" fmla="*/ 449 h 504"/>
                <a:gd name="T48" fmla="*/ 470 w 1159"/>
                <a:gd name="T49" fmla="*/ 449 h 504"/>
                <a:gd name="T50" fmla="*/ 486 w 1159"/>
                <a:gd name="T51" fmla="*/ 449 h 504"/>
                <a:gd name="T52" fmla="*/ 498 w 1159"/>
                <a:gd name="T53" fmla="*/ 444 h 504"/>
                <a:gd name="T54" fmla="*/ 518 w 1159"/>
                <a:gd name="T55" fmla="*/ 444 h 504"/>
                <a:gd name="T56" fmla="*/ 536 w 1159"/>
                <a:gd name="T57" fmla="*/ 444 h 504"/>
                <a:gd name="T58" fmla="*/ 553 w 1159"/>
                <a:gd name="T59" fmla="*/ 444 h 504"/>
                <a:gd name="T60" fmla="*/ 569 w 1159"/>
                <a:gd name="T61" fmla="*/ 444 h 504"/>
                <a:gd name="T62" fmla="*/ 588 w 1159"/>
                <a:gd name="T63" fmla="*/ 444 h 504"/>
                <a:gd name="T64" fmla="*/ 600 w 1159"/>
                <a:gd name="T65" fmla="*/ 438 h 504"/>
                <a:gd name="T66" fmla="*/ 618 w 1159"/>
                <a:gd name="T67" fmla="*/ 438 h 504"/>
                <a:gd name="T68" fmla="*/ 635 w 1159"/>
                <a:gd name="T69" fmla="*/ 438 h 504"/>
                <a:gd name="T70" fmla="*/ 654 w 1159"/>
                <a:gd name="T71" fmla="*/ 438 h 504"/>
                <a:gd name="T72" fmla="*/ 673 w 1159"/>
                <a:gd name="T73" fmla="*/ 438 h 504"/>
                <a:gd name="T74" fmla="*/ 690 w 1159"/>
                <a:gd name="T75" fmla="*/ 438 h 504"/>
                <a:gd name="T76" fmla="*/ 702 w 1159"/>
                <a:gd name="T77" fmla="*/ 429 h 504"/>
                <a:gd name="T78" fmla="*/ 720 w 1159"/>
                <a:gd name="T79" fmla="*/ 429 h 504"/>
                <a:gd name="T80" fmla="*/ 737 w 1159"/>
                <a:gd name="T81" fmla="*/ 429 h 504"/>
                <a:gd name="T82" fmla="*/ 756 w 1159"/>
                <a:gd name="T83" fmla="*/ 429 h 504"/>
                <a:gd name="T84" fmla="*/ 774 w 1159"/>
                <a:gd name="T85" fmla="*/ 429 h 504"/>
                <a:gd name="T86" fmla="*/ 795 w 1159"/>
                <a:gd name="T87" fmla="*/ 429 h 504"/>
                <a:gd name="T88" fmla="*/ 804 w 1159"/>
                <a:gd name="T89" fmla="*/ 417 h 504"/>
                <a:gd name="T90" fmla="*/ 823 w 1159"/>
                <a:gd name="T91" fmla="*/ 417 h 504"/>
                <a:gd name="T92" fmla="*/ 841 w 1159"/>
                <a:gd name="T93" fmla="*/ 417 h 504"/>
                <a:gd name="T94" fmla="*/ 859 w 1159"/>
                <a:gd name="T95" fmla="*/ 417 h 504"/>
                <a:gd name="T96" fmla="*/ 876 w 1159"/>
                <a:gd name="T97" fmla="*/ 417 h 504"/>
                <a:gd name="T98" fmla="*/ 895 w 1159"/>
                <a:gd name="T99" fmla="*/ 417 h 504"/>
                <a:gd name="T100" fmla="*/ 913 w 1159"/>
                <a:gd name="T101" fmla="*/ 417 h 504"/>
                <a:gd name="T102" fmla="*/ 930 w 1159"/>
                <a:gd name="T103" fmla="*/ 417 h 504"/>
                <a:gd name="T104" fmla="*/ 950 w 1159"/>
                <a:gd name="T105" fmla="*/ 417 h 504"/>
                <a:gd name="T106" fmla="*/ 986 w 1159"/>
                <a:gd name="T107" fmla="*/ 417 h 504"/>
                <a:gd name="T108" fmla="*/ 1005 w 1159"/>
                <a:gd name="T109" fmla="*/ 417 h 504"/>
                <a:gd name="T110" fmla="*/ 1030 w 1159"/>
                <a:gd name="T111" fmla="*/ 417 h 504"/>
                <a:gd name="T112" fmla="*/ 1119 w 1159"/>
                <a:gd name="T113" fmla="*/ 0 h 5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1159" h="504">
                  <a:moveTo>
                    <a:pt x="0" y="504"/>
                  </a:moveTo>
                  <a:lnTo>
                    <a:pt x="83" y="504"/>
                  </a:lnTo>
                  <a:lnTo>
                    <a:pt x="90" y="504"/>
                  </a:lnTo>
                  <a:lnTo>
                    <a:pt x="98" y="504"/>
                  </a:lnTo>
                  <a:lnTo>
                    <a:pt x="105" y="504"/>
                  </a:lnTo>
                  <a:lnTo>
                    <a:pt x="110" y="504"/>
                  </a:lnTo>
                  <a:lnTo>
                    <a:pt x="116" y="504"/>
                  </a:lnTo>
                  <a:lnTo>
                    <a:pt x="119" y="504"/>
                  </a:lnTo>
                  <a:lnTo>
                    <a:pt x="127" y="504"/>
                  </a:lnTo>
                  <a:lnTo>
                    <a:pt x="130" y="504"/>
                  </a:lnTo>
                  <a:lnTo>
                    <a:pt x="138" y="504"/>
                  </a:lnTo>
                  <a:lnTo>
                    <a:pt x="143" y="504"/>
                  </a:lnTo>
                  <a:lnTo>
                    <a:pt x="148" y="504"/>
                  </a:lnTo>
                  <a:lnTo>
                    <a:pt x="149" y="498"/>
                  </a:lnTo>
                  <a:lnTo>
                    <a:pt x="155" y="498"/>
                  </a:lnTo>
                  <a:lnTo>
                    <a:pt x="160" y="498"/>
                  </a:lnTo>
                  <a:lnTo>
                    <a:pt x="166" y="498"/>
                  </a:lnTo>
                  <a:lnTo>
                    <a:pt x="173" y="498"/>
                  </a:lnTo>
                  <a:lnTo>
                    <a:pt x="178" y="498"/>
                  </a:lnTo>
                  <a:lnTo>
                    <a:pt x="184" y="498"/>
                  </a:lnTo>
                  <a:lnTo>
                    <a:pt x="189" y="495"/>
                  </a:lnTo>
                  <a:lnTo>
                    <a:pt x="193" y="495"/>
                  </a:lnTo>
                  <a:lnTo>
                    <a:pt x="196" y="492"/>
                  </a:lnTo>
                  <a:lnTo>
                    <a:pt x="202" y="492"/>
                  </a:lnTo>
                  <a:lnTo>
                    <a:pt x="210" y="492"/>
                  </a:lnTo>
                  <a:lnTo>
                    <a:pt x="214" y="492"/>
                  </a:lnTo>
                  <a:lnTo>
                    <a:pt x="224" y="492"/>
                  </a:lnTo>
                  <a:lnTo>
                    <a:pt x="228" y="492"/>
                  </a:lnTo>
                  <a:lnTo>
                    <a:pt x="234" y="492"/>
                  </a:lnTo>
                  <a:lnTo>
                    <a:pt x="237" y="488"/>
                  </a:lnTo>
                  <a:lnTo>
                    <a:pt x="238" y="488"/>
                  </a:lnTo>
                  <a:lnTo>
                    <a:pt x="247" y="488"/>
                  </a:lnTo>
                  <a:lnTo>
                    <a:pt x="251" y="488"/>
                  </a:lnTo>
                  <a:lnTo>
                    <a:pt x="256" y="488"/>
                  </a:lnTo>
                  <a:lnTo>
                    <a:pt x="263" y="485"/>
                  </a:lnTo>
                  <a:lnTo>
                    <a:pt x="269" y="485"/>
                  </a:lnTo>
                  <a:lnTo>
                    <a:pt x="270" y="481"/>
                  </a:lnTo>
                  <a:lnTo>
                    <a:pt x="275" y="481"/>
                  </a:lnTo>
                  <a:lnTo>
                    <a:pt x="280" y="478"/>
                  </a:lnTo>
                  <a:lnTo>
                    <a:pt x="286" y="478"/>
                  </a:lnTo>
                  <a:lnTo>
                    <a:pt x="286" y="475"/>
                  </a:lnTo>
                  <a:lnTo>
                    <a:pt x="292" y="471"/>
                  </a:lnTo>
                  <a:lnTo>
                    <a:pt x="299" y="471"/>
                  </a:lnTo>
                  <a:lnTo>
                    <a:pt x="305" y="471"/>
                  </a:lnTo>
                  <a:lnTo>
                    <a:pt x="311" y="471"/>
                  </a:lnTo>
                  <a:lnTo>
                    <a:pt x="317" y="471"/>
                  </a:lnTo>
                  <a:lnTo>
                    <a:pt x="322" y="471"/>
                  </a:lnTo>
                  <a:lnTo>
                    <a:pt x="330" y="471"/>
                  </a:lnTo>
                  <a:lnTo>
                    <a:pt x="330" y="467"/>
                  </a:lnTo>
                  <a:lnTo>
                    <a:pt x="335" y="467"/>
                  </a:lnTo>
                  <a:lnTo>
                    <a:pt x="341" y="467"/>
                  </a:lnTo>
                  <a:lnTo>
                    <a:pt x="347" y="467"/>
                  </a:lnTo>
                  <a:lnTo>
                    <a:pt x="353" y="467"/>
                  </a:lnTo>
                  <a:lnTo>
                    <a:pt x="360" y="467"/>
                  </a:lnTo>
                  <a:lnTo>
                    <a:pt x="366" y="467"/>
                  </a:lnTo>
                  <a:lnTo>
                    <a:pt x="372" y="467"/>
                  </a:lnTo>
                  <a:lnTo>
                    <a:pt x="377" y="467"/>
                  </a:lnTo>
                  <a:lnTo>
                    <a:pt x="383" y="467"/>
                  </a:lnTo>
                  <a:lnTo>
                    <a:pt x="383" y="463"/>
                  </a:lnTo>
                  <a:lnTo>
                    <a:pt x="389" y="459"/>
                  </a:lnTo>
                  <a:lnTo>
                    <a:pt x="395" y="459"/>
                  </a:lnTo>
                  <a:lnTo>
                    <a:pt x="402" y="459"/>
                  </a:lnTo>
                  <a:lnTo>
                    <a:pt x="407" y="459"/>
                  </a:lnTo>
                  <a:lnTo>
                    <a:pt x="414" y="459"/>
                  </a:lnTo>
                  <a:lnTo>
                    <a:pt x="419" y="459"/>
                  </a:lnTo>
                  <a:lnTo>
                    <a:pt x="427" y="459"/>
                  </a:lnTo>
                  <a:lnTo>
                    <a:pt x="431" y="459"/>
                  </a:lnTo>
                  <a:lnTo>
                    <a:pt x="438" y="459"/>
                  </a:lnTo>
                  <a:lnTo>
                    <a:pt x="442" y="454"/>
                  </a:lnTo>
                  <a:lnTo>
                    <a:pt x="444" y="454"/>
                  </a:lnTo>
                  <a:lnTo>
                    <a:pt x="451" y="454"/>
                  </a:lnTo>
                  <a:lnTo>
                    <a:pt x="452" y="449"/>
                  </a:lnTo>
                  <a:lnTo>
                    <a:pt x="455" y="449"/>
                  </a:lnTo>
                  <a:lnTo>
                    <a:pt x="462" y="449"/>
                  </a:lnTo>
                  <a:lnTo>
                    <a:pt x="470" y="449"/>
                  </a:lnTo>
                  <a:lnTo>
                    <a:pt x="473" y="449"/>
                  </a:lnTo>
                  <a:lnTo>
                    <a:pt x="479" y="449"/>
                  </a:lnTo>
                  <a:lnTo>
                    <a:pt x="486" y="449"/>
                  </a:lnTo>
                  <a:lnTo>
                    <a:pt x="491" y="449"/>
                  </a:lnTo>
                  <a:lnTo>
                    <a:pt x="496" y="444"/>
                  </a:lnTo>
                  <a:lnTo>
                    <a:pt x="498" y="444"/>
                  </a:lnTo>
                  <a:lnTo>
                    <a:pt x="506" y="444"/>
                  </a:lnTo>
                  <a:lnTo>
                    <a:pt x="510" y="444"/>
                  </a:lnTo>
                  <a:lnTo>
                    <a:pt x="518" y="444"/>
                  </a:lnTo>
                  <a:lnTo>
                    <a:pt x="521" y="444"/>
                  </a:lnTo>
                  <a:lnTo>
                    <a:pt x="530" y="444"/>
                  </a:lnTo>
                  <a:lnTo>
                    <a:pt x="536" y="444"/>
                  </a:lnTo>
                  <a:lnTo>
                    <a:pt x="539" y="444"/>
                  </a:lnTo>
                  <a:lnTo>
                    <a:pt x="545" y="444"/>
                  </a:lnTo>
                  <a:lnTo>
                    <a:pt x="553" y="444"/>
                  </a:lnTo>
                  <a:lnTo>
                    <a:pt x="557" y="444"/>
                  </a:lnTo>
                  <a:lnTo>
                    <a:pt x="564" y="444"/>
                  </a:lnTo>
                  <a:lnTo>
                    <a:pt x="569" y="444"/>
                  </a:lnTo>
                  <a:lnTo>
                    <a:pt x="575" y="444"/>
                  </a:lnTo>
                  <a:lnTo>
                    <a:pt x="581" y="444"/>
                  </a:lnTo>
                  <a:lnTo>
                    <a:pt x="588" y="444"/>
                  </a:lnTo>
                  <a:lnTo>
                    <a:pt x="589" y="438"/>
                  </a:lnTo>
                  <a:lnTo>
                    <a:pt x="593" y="438"/>
                  </a:lnTo>
                  <a:lnTo>
                    <a:pt x="600" y="438"/>
                  </a:lnTo>
                  <a:lnTo>
                    <a:pt x="605" y="438"/>
                  </a:lnTo>
                  <a:lnTo>
                    <a:pt x="612" y="438"/>
                  </a:lnTo>
                  <a:lnTo>
                    <a:pt x="618" y="438"/>
                  </a:lnTo>
                  <a:lnTo>
                    <a:pt x="626" y="438"/>
                  </a:lnTo>
                  <a:lnTo>
                    <a:pt x="633" y="438"/>
                  </a:lnTo>
                  <a:lnTo>
                    <a:pt x="635" y="438"/>
                  </a:lnTo>
                  <a:lnTo>
                    <a:pt x="642" y="438"/>
                  </a:lnTo>
                  <a:lnTo>
                    <a:pt x="648" y="438"/>
                  </a:lnTo>
                  <a:lnTo>
                    <a:pt x="654" y="438"/>
                  </a:lnTo>
                  <a:lnTo>
                    <a:pt x="659" y="438"/>
                  </a:lnTo>
                  <a:lnTo>
                    <a:pt x="665" y="438"/>
                  </a:lnTo>
                  <a:lnTo>
                    <a:pt x="673" y="438"/>
                  </a:lnTo>
                  <a:lnTo>
                    <a:pt x="678" y="438"/>
                  </a:lnTo>
                  <a:lnTo>
                    <a:pt x="684" y="438"/>
                  </a:lnTo>
                  <a:lnTo>
                    <a:pt x="690" y="438"/>
                  </a:lnTo>
                  <a:lnTo>
                    <a:pt x="698" y="438"/>
                  </a:lnTo>
                  <a:lnTo>
                    <a:pt x="702" y="438"/>
                  </a:lnTo>
                  <a:lnTo>
                    <a:pt x="702" y="429"/>
                  </a:lnTo>
                  <a:lnTo>
                    <a:pt x="707" y="429"/>
                  </a:lnTo>
                  <a:lnTo>
                    <a:pt x="715" y="429"/>
                  </a:lnTo>
                  <a:lnTo>
                    <a:pt x="720" y="429"/>
                  </a:lnTo>
                  <a:lnTo>
                    <a:pt x="726" y="429"/>
                  </a:lnTo>
                  <a:lnTo>
                    <a:pt x="731" y="429"/>
                  </a:lnTo>
                  <a:lnTo>
                    <a:pt x="737" y="429"/>
                  </a:lnTo>
                  <a:lnTo>
                    <a:pt x="744" y="429"/>
                  </a:lnTo>
                  <a:lnTo>
                    <a:pt x="750" y="429"/>
                  </a:lnTo>
                  <a:lnTo>
                    <a:pt x="756" y="429"/>
                  </a:lnTo>
                  <a:lnTo>
                    <a:pt x="762" y="429"/>
                  </a:lnTo>
                  <a:lnTo>
                    <a:pt x="768" y="429"/>
                  </a:lnTo>
                  <a:lnTo>
                    <a:pt x="774" y="429"/>
                  </a:lnTo>
                  <a:lnTo>
                    <a:pt x="780" y="429"/>
                  </a:lnTo>
                  <a:lnTo>
                    <a:pt x="787" y="429"/>
                  </a:lnTo>
                  <a:lnTo>
                    <a:pt x="795" y="429"/>
                  </a:lnTo>
                  <a:lnTo>
                    <a:pt x="795" y="417"/>
                  </a:lnTo>
                  <a:lnTo>
                    <a:pt x="800" y="417"/>
                  </a:lnTo>
                  <a:lnTo>
                    <a:pt x="804" y="417"/>
                  </a:lnTo>
                  <a:lnTo>
                    <a:pt x="811" y="417"/>
                  </a:lnTo>
                  <a:lnTo>
                    <a:pt x="818" y="417"/>
                  </a:lnTo>
                  <a:lnTo>
                    <a:pt x="823" y="417"/>
                  </a:lnTo>
                  <a:lnTo>
                    <a:pt x="828" y="417"/>
                  </a:lnTo>
                  <a:lnTo>
                    <a:pt x="834" y="417"/>
                  </a:lnTo>
                  <a:lnTo>
                    <a:pt x="841" y="417"/>
                  </a:lnTo>
                  <a:lnTo>
                    <a:pt x="846" y="417"/>
                  </a:lnTo>
                  <a:lnTo>
                    <a:pt x="853" y="417"/>
                  </a:lnTo>
                  <a:lnTo>
                    <a:pt x="859" y="417"/>
                  </a:lnTo>
                  <a:lnTo>
                    <a:pt x="864" y="417"/>
                  </a:lnTo>
                  <a:lnTo>
                    <a:pt x="871" y="417"/>
                  </a:lnTo>
                  <a:lnTo>
                    <a:pt x="876" y="417"/>
                  </a:lnTo>
                  <a:lnTo>
                    <a:pt x="882" y="417"/>
                  </a:lnTo>
                  <a:lnTo>
                    <a:pt x="889" y="417"/>
                  </a:lnTo>
                  <a:lnTo>
                    <a:pt x="895" y="417"/>
                  </a:lnTo>
                  <a:lnTo>
                    <a:pt x="902" y="417"/>
                  </a:lnTo>
                  <a:lnTo>
                    <a:pt x="908" y="417"/>
                  </a:lnTo>
                  <a:lnTo>
                    <a:pt x="913" y="417"/>
                  </a:lnTo>
                  <a:lnTo>
                    <a:pt x="921" y="417"/>
                  </a:lnTo>
                  <a:lnTo>
                    <a:pt x="926" y="417"/>
                  </a:lnTo>
                  <a:lnTo>
                    <a:pt x="930" y="417"/>
                  </a:lnTo>
                  <a:lnTo>
                    <a:pt x="936" y="417"/>
                  </a:lnTo>
                  <a:lnTo>
                    <a:pt x="944" y="417"/>
                  </a:lnTo>
                  <a:lnTo>
                    <a:pt x="950" y="417"/>
                  </a:lnTo>
                  <a:lnTo>
                    <a:pt x="954" y="417"/>
                  </a:lnTo>
                  <a:lnTo>
                    <a:pt x="971" y="417"/>
                  </a:lnTo>
                  <a:lnTo>
                    <a:pt x="986" y="417"/>
                  </a:lnTo>
                  <a:lnTo>
                    <a:pt x="991" y="417"/>
                  </a:lnTo>
                  <a:lnTo>
                    <a:pt x="1002" y="417"/>
                  </a:lnTo>
                  <a:lnTo>
                    <a:pt x="1005" y="417"/>
                  </a:lnTo>
                  <a:lnTo>
                    <a:pt x="1008" y="417"/>
                  </a:lnTo>
                  <a:lnTo>
                    <a:pt x="1021" y="417"/>
                  </a:lnTo>
                  <a:lnTo>
                    <a:pt x="1030" y="417"/>
                  </a:lnTo>
                  <a:lnTo>
                    <a:pt x="1099" y="417"/>
                  </a:lnTo>
                  <a:lnTo>
                    <a:pt x="1099" y="0"/>
                  </a:lnTo>
                  <a:lnTo>
                    <a:pt x="1119" y="0"/>
                  </a:lnTo>
                  <a:lnTo>
                    <a:pt x="1125" y="0"/>
                  </a:lnTo>
                  <a:lnTo>
                    <a:pt x="1159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Line 99">
              <a:extLst>
                <a:ext uri="{FF2B5EF4-FFF2-40B4-BE49-F238E27FC236}">
                  <a16:creationId xmlns:a16="http://schemas.microsoft.com/office/drawing/2014/main" id="{8D6B89E0-9C04-34FA-08F6-3D9CE86DD4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93866" y="5936369"/>
              <a:ext cx="0" cy="6623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Line 101">
              <a:extLst>
                <a:ext uri="{FF2B5EF4-FFF2-40B4-BE49-F238E27FC236}">
                  <a16:creationId xmlns:a16="http://schemas.microsoft.com/office/drawing/2014/main" id="{BFB83071-7B2F-FC7F-DAD4-422462C3EC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14608" y="5936369"/>
              <a:ext cx="0" cy="6623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Line 103">
              <a:extLst>
                <a:ext uri="{FF2B5EF4-FFF2-40B4-BE49-F238E27FC236}">
                  <a16:creationId xmlns:a16="http://schemas.microsoft.com/office/drawing/2014/main" id="{5FFEAEA5-FF00-CA9E-6C1C-5FA69BD3FF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33471" y="5936369"/>
              <a:ext cx="0" cy="6623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Line 105">
              <a:extLst>
                <a:ext uri="{FF2B5EF4-FFF2-40B4-BE49-F238E27FC236}">
                  <a16:creationId xmlns:a16="http://schemas.microsoft.com/office/drawing/2014/main" id="{5E049542-BEE9-B7EE-0F29-9F7EDE2026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54215" y="5936369"/>
              <a:ext cx="0" cy="6623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Line 107">
              <a:extLst>
                <a:ext uri="{FF2B5EF4-FFF2-40B4-BE49-F238E27FC236}">
                  <a16:creationId xmlns:a16="http://schemas.microsoft.com/office/drawing/2014/main" id="{C9DF1289-5BF3-38ED-977B-2C4D23B8B0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074957" y="5936369"/>
              <a:ext cx="0" cy="6623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Line 109">
              <a:extLst>
                <a:ext uri="{FF2B5EF4-FFF2-40B4-BE49-F238E27FC236}">
                  <a16:creationId xmlns:a16="http://schemas.microsoft.com/office/drawing/2014/main" id="{8B8A551E-6FC4-EE36-C10B-A4BE2825CF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95701" y="5936369"/>
              <a:ext cx="0" cy="6623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D53DCB7-E902-14E2-A39C-5E863D37B09B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24F6481-27FF-B50D-5D70-3134EA14C450}"/>
              </a:ext>
            </a:extLst>
          </p:cNvPr>
          <p:cNvSpPr txBox="1"/>
          <p:nvPr/>
        </p:nvSpPr>
        <p:spPr>
          <a:xfrm>
            <a:off x="886249" y="38268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E1B116D-0427-DA8A-278E-68661FB433C9}"/>
              </a:ext>
            </a:extLst>
          </p:cNvPr>
          <p:cNvSpPr txBox="1"/>
          <p:nvPr/>
        </p:nvSpPr>
        <p:spPr>
          <a:xfrm>
            <a:off x="886250" y="3325173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2149D86-104E-D38E-C8B0-6503A5AAA615}"/>
              </a:ext>
            </a:extLst>
          </p:cNvPr>
          <p:cNvSpPr txBox="1"/>
          <p:nvPr/>
        </p:nvSpPr>
        <p:spPr>
          <a:xfrm>
            <a:off x="6010059" y="3325174"/>
            <a:ext cx="39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D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93231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013DC16C-9928-0CEA-70CE-208580129969}"/>
              </a:ext>
            </a:extLst>
          </p:cNvPr>
          <p:cNvGrpSpPr/>
          <p:nvPr/>
        </p:nvGrpSpPr>
        <p:grpSpPr>
          <a:xfrm>
            <a:off x="1197600" y="712441"/>
            <a:ext cx="4141083" cy="2791354"/>
            <a:chOff x="1487880" y="988207"/>
            <a:chExt cx="4141083" cy="2791354"/>
          </a:xfrm>
        </p:grpSpPr>
        <p:grpSp>
          <p:nvGrpSpPr>
            <p:cNvPr id="235" name="グループ化 234">
              <a:extLst>
                <a:ext uri="{FF2B5EF4-FFF2-40B4-BE49-F238E27FC236}">
                  <a16:creationId xmlns:a16="http://schemas.microsoft.com/office/drawing/2014/main" id="{7F4B8A62-7819-C60D-A452-1EA5B675DD47}"/>
                </a:ext>
              </a:extLst>
            </p:cNvPr>
            <p:cNvGrpSpPr/>
            <p:nvPr/>
          </p:nvGrpSpPr>
          <p:grpSpPr>
            <a:xfrm>
              <a:off x="1487880" y="988207"/>
              <a:ext cx="4141083" cy="2791354"/>
              <a:chOff x="1487880" y="988207"/>
              <a:chExt cx="4141083" cy="2791354"/>
            </a:xfrm>
          </p:grpSpPr>
          <p:sp>
            <p:nvSpPr>
              <p:cNvPr id="198" name="Rectangle 22">
                <a:extLst>
                  <a:ext uri="{FF2B5EF4-FFF2-40B4-BE49-F238E27FC236}">
                    <a16:creationId xmlns:a16="http://schemas.microsoft.com/office/drawing/2014/main" id="{5388FA6E-EA19-148D-E8E6-996B95FD63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7804" y="994728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9" name="Line 23">
                <a:extLst>
                  <a:ext uri="{FF2B5EF4-FFF2-40B4-BE49-F238E27FC236}">
                    <a16:creationId xmlns:a16="http://schemas.microsoft.com/office/drawing/2014/main" id="{FA4C00BD-ADF2-791B-57D5-B319C6897F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2137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0" name="Line 25">
                <a:extLst>
                  <a:ext uri="{FF2B5EF4-FFF2-40B4-BE49-F238E27FC236}">
                    <a16:creationId xmlns:a16="http://schemas.microsoft.com/office/drawing/2014/main" id="{0C8163BB-9245-1AFB-2E8F-7CD293FF1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5354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1" name="Line 27">
                <a:extLst>
                  <a:ext uri="{FF2B5EF4-FFF2-40B4-BE49-F238E27FC236}">
                    <a16:creationId xmlns:a16="http://schemas.microsoft.com/office/drawing/2014/main" id="{91AF527F-3FDA-975F-40BF-2ABD90628C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8570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2" name="Line 29">
                <a:extLst>
                  <a:ext uri="{FF2B5EF4-FFF2-40B4-BE49-F238E27FC236}">
                    <a16:creationId xmlns:a16="http://schemas.microsoft.com/office/drawing/2014/main" id="{C5394C8F-6EB3-9D26-FCA9-F7E5A163D4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9898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3" name="Line 31">
                <a:extLst>
                  <a:ext uri="{FF2B5EF4-FFF2-40B4-BE49-F238E27FC236}">
                    <a16:creationId xmlns:a16="http://schemas.microsoft.com/office/drawing/2014/main" id="{E8AC5A75-DE4D-65E5-7243-6125D3857B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3115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4" name="Line 33">
                <a:extLst>
                  <a:ext uri="{FF2B5EF4-FFF2-40B4-BE49-F238E27FC236}">
                    <a16:creationId xmlns:a16="http://schemas.microsoft.com/office/drawing/2014/main" id="{D1CECB3F-2FAC-AC99-488A-37F797640A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6331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5" name="Line 35">
                <a:extLst>
                  <a:ext uri="{FF2B5EF4-FFF2-40B4-BE49-F238E27FC236}">
                    <a16:creationId xmlns:a16="http://schemas.microsoft.com/office/drawing/2014/main" id="{D5A25145-9F7A-E4B1-06D1-A4A50BE41A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9548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6" name="Line 6">
                <a:extLst>
                  <a:ext uri="{FF2B5EF4-FFF2-40B4-BE49-F238E27FC236}">
                    <a16:creationId xmlns:a16="http://schemas.microsoft.com/office/drawing/2014/main" id="{99A1571C-AB61-D3D5-8E20-CFC8443DEA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3008505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7" name="Line 8">
                <a:extLst>
                  <a:ext uri="{FF2B5EF4-FFF2-40B4-BE49-F238E27FC236}">
                    <a16:creationId xmlns:a16="http://schemas.microsoft.com/office/drawing/2014/main" id="{50D754FB-9E5E-6F63-17DA-4A741B9366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260100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8" name="Line 9">
                <a:extLst>
                  <a:ext uri="{FF2B5EF4-FFF2-40B4-BE49-F238E27FC236}">
                    <a16:creationId xmlns:a16="http://schemas.microsoft.com/office/drawing/2014/main" id="{42CF292D-1C04-90F7-B05E-C74BD2F14F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219351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9" name="Line 11">
                <a:extLst>
                  <a:ext uri="{FF2B5EF4-FFF2-40B4-BE49-F238E27FC236}">
                    <a16:creationId xmlns:a16="http://schemas.microsoft.com/office/drawing/2014/main" id="{50710CAD-F1A6-DC3E-482A-1926E6E859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178601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0" name="Line 12">
                <a:extLst>
                  <a:ext uri="{FF2B5EF4-FFF2-40B4-BE49-F238E27FC236}">
                    <a16:creationId xmlns:a16="http://schemas.microsoft.com/office/drawing/2014/main" id="{1FDF3B02-06B1-8136-AEC6-14E863595B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137852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1" name="Line 14">
                <a:extLst>
                  <a:ext uri="{FF2B5EF4-FFF2-40B4-BE49-F238E27FC236}">
                    <a16:creationId xmlns:a16="http://schemas.microsoft.com/office/drawing/2014/main" id="{502B873C-7936-FAEB-7775-6EB4EB11F5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99493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2" name="Line 23">
                <a:extLst>
                  <a:ext uri="{FF2B5EF4-FFF2-40B4-BE49-F238E27FC236}">
                    <a16:creationId xmlns:a16="http://schemas.microsoft.com/office/drawing/2014/main" id="{CA0DA39A-24C0-159A-151F-A6A130718C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3825" y="3008506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213" name="図形グループ 54">
                <a:extLst>
                  <a:ext uri="{FF2B5EF4-FFF2-40B4-BE49-F238E27FC236}">
                    <a16:creationId xmlns:a16="http://schemas.microsoft.com/office/drawing/2014/main" id="{0997CE78-3791-D276-976E-9FDF8CF70891}"/>
                  </a:ext>
                </a:extLst>
              </p:cNvPr>
              <p:cNvGrpSpPr/>
              <p:nvPr/>
            </p:nvGrpSpPr>
            <p:grpSpPr>
              <a:xfrm>
                <a:off x="2034219" y="1249429"/>
                <a:ext cx="220989" cy="1868530"/>
                <a:chOff x="510218" y="1348283"/>
                <a:chExt cx="220989" cy="1868530"/>
              </a:xfrm>
            </p:grpSpPr>
            <p:sp>
              <p:nvSpPr>
                <p:cNvPr id="220" name="Rectangle 10">
                  <a:extLst>
                    <a:ext uri="{FF2B5EF4-FFF2-40B4-BE49-F238E27FC236}">
                      <a16:creationId xmlns:a16="http://schemas.microsoft.com/office/drawing/2014/main" id="{0DFC5718-4FEB-0DB7-D1AF-7786EFF9B3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21" name="Rectangle 13">
                  <a:extLst>
                    <a:ext uri="{FF2B5EF4-FFF2-40B4-BE49-F238E27FC236}">
                      <a16:creationId xmlns:a16="http://schemas.microsoft.com/office/drawing/2014/main" id="{12E517D5-2FCD-F7F6-F7BD-7029D49BB4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22" name="Rectangle 10">
                  <a:extLst>
                    <a:ext uri="{FF2B5EF4-FFF2-40B4-BE49-F238E27FC236}">
                      <a16:creationId xmlns:a16="http://schemas.microsoft.com/office/drawing/2014/main" id="{C1CBBAAA-76D1-9F13-8A0E-8204C14F01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D11054CA-3A97-9CC5-E00C-787B698947A4}"/>
                  </a:ext>
                </a:extLst>
              </p:cNvPr>
              <p:cNvSpPr txBox="1"/>
              <p:nvPr/>
            </p:nvSpPr>
            <p:spPr>
              <a:xfrm>
                <a:off x="2206686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6F531A67-BDCB-99B2-3864-58C4325BC24A}"/>
                  </a:ext>
                </a:extLst>
              </p:cNvPr>
              <p:cNvSpPr txBox="1"/>
              <p:nvPr/>
            </p:nvSpPr>
            <p:spPr>
              <a:xfrm>
                <a:off x="3251225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57CB6EFC-68C5-3C57-3B90-FEE9A5798FAA}"/>
                  </a:ext>
                </a:extLst>
              </p:cNvPr>
              <p:cNvSpPr txBox="1"/>
              <p:nvPr/>
            </p:nvSpPr>
            <p:spPr>
              <a:xfrm>
                <a:off x="5340302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D1D7C71C-342A-A05A-B787-E525737597F3}"/>
                  </a:ext>
                </a:extLst>
              </p:cNvPr>
              <p:cNvSpPr txBox="1"/>
              <p:nvPr/>
            </p:nvSpPr>
            <p:spPr>
              <a:xfrm>
                <a:off x="4295764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4DE1D052-EE0D-2C71-3BB8-14E9C2695E08}"/>
                  </a:ext>
                </a:extLst>
              </p:cNvPr>
              <p:cNvSpPr txBox="1"/>
              <p:nvPr/>
            </p:nvSpPr>
            <p:spPr>
              <a:xfrm rot="16200000">
                <a:off x="604785" y="1871302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1655A8F0-C5D7-AA6D-DAAA-FCDDFF8E6541}"/>
                  </a:ext>
                </a:extLst>
              </p:cNvPr>
              <p:cNvSpPr txBox="1"/>
              <p:nvPr/>
            </p:nvSpPr>
            <p:spPr>
              <a:xfrm>
                <a:off x="3108992" y="3410229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42" name="Freeform 19">
              <a:extLst>
                <a:ext uri="{FF2B5EF4-FFF2-40B4-BE49-F238E27FC236}">
                  <a16:creationId xmlns:a16="http://schemas.microsoft.com/office/drawing/2014/main" id="{1D9CAB75-FCFF-0824-6E13-429536EFC7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3274" y="2583950"/>
              <a:ext cx="2949165" cy="421334"/>
            </a:xfrm>
            <a:custGeom>
              <a:avLst/>
              <a:gdLst>
                <a:gd name="T0" fmla="*/ 138 w 1567"/>
                <a:gd name="T1" fmla="*/ 222 h 228"/>
                <a:gd name="T2" fmla="*/ 216 w 1567"/>
                <a:gd name="T3" fmla="*/ 222 h 228"/>
                <a:gd name="T4" fmla="*/ 254 w 1567"/>
                <a:gd name="T5" fmla="*/ 210 h 228"/>
                <a:gd name="T6" fmla="*/ 288 w 1567"/>
                <a:gd name="T7" fmla="*/ 204 h 228"/>
                <a:gd name="T8" fmla="*/ 325 w 1567"/>
                <a:gd name="T9" fmla="*/ 198 h 228"/>
                <a:gd name="T10" fmla="*/ 349 w 1567"/>
                <a:gd name="T11" fmla="*/ 192 h 228"/>
                <a:gd name="T12" fmla="*/ 378 w 1567"/>
                <a:gd name="T13" fmla="*/ 180 h 228"/>
                <a:gd name="T14" fmla="*/ 405 w 1567"/>
                <a:gd name="T15" fmla="*/ 180 h 228"/>
                <a:gd name="T16" fmla="*/ 417 w 1567"/>
                <a:gd name="T17" fmla="*/ 174 h 228"/>
                <a:gd name="T18" fmla="*/ 441 w 1567"/>
                <a:gd name="T19" fmla="*/ 174 h 228"/>
                <a:gd name="T20" fmla="*/ 457 w 1567"/>
                <a:gd name="T21" fmla="*/ 167 h 228"/>
                <a:gd name="T22" fmla="*/ 474 w 1567"/>
                <a:gd name="T23" fmla="*/ 161 h 228"/>
                <a:gd name="T24" fmla="*/ 479 w 1567"/>
                <a:gd name="T25" fmla="*/ 149 h 228"/>
                <a:gd name="T26" fmla="*/ 484 w 1567"/>
                <a:gd name="T27" fmla="*/ 136 h 228"/>
                <a:gd name="T28" fmla="*/ 509 w 1567"/>
                <a:gd name="T29" fmla="*/ 136 h 228"/>
                <a:gd name="T30" fmla="*/ 522 w 1567"/>
                <a:gd name="T31" fmla="*/ 130 h 228"/>
                <a:gd name="T32" fmla="*/ 552 w 1567"/>
                <a:gd name="T33" fmla="*/ 123 h 228"/>
                <a:gd name="T34" fmla="*/ 575 w 1567"/>
                <a:gd name="T35" fmla="*/ 123 h 228"/>
                <a:gd name="T36" fmla="*/ 593 w 1567"/>
                <a:gd name="T37" fmla="*/ 123 h 228"/>
                <a:gd name="T38" fmla="*/ 613 w 1567"/>
                <a:gd name="T39" fmla="*/ 123 h 228"/>
                <a:gd name="T40" fmla="*/ 629 w 1567"/>
                <a:gd name="T41" fmla="*/ 123 h 228"/>
                <a:gd name="T42" fmla="*/ 647 w 1567"/>
                <a:gd name="T43" fmla="*/ 115 h 228"/>
                <a:gd name="T44" fmla="*/ 664 w 1567"/>
                <a:gd name="T45" fmla="*/ 115 h 228"/>
                <a:gd name="T46" fmla="*/ 672 w 1567"/>
                <a:gd name="T47" fmla="*/ 107 h 228"/>
                <a:gd name="T48" fmla="*/ 678 w 1567"/>
                <a:gd name="T49" fmla="*/ 90 h 228"/>
                <a:gd name="T50" fmla="*/ 695 w 1567"/>
                <a:gd name="T51" fmla="*/ 90 h 228"/>
                <a:gd name="T52" fmla="*/ 717 w 1567"/>
                <a:gd name="T53" fmla="*/ 90 h 228"/>
                <a:gd name="T54" fmla="*/ 726 w 1567"/>
                <a:gd name="T55" fmla="*/ 80 h 228"/>
                <a:gd name="T56" fmla="*/ 738 w 1567"/>
                <a:gd name="T57" fmla="*/ 69 h 228"/>
                <a:gd name="T58" fmla="*/ 756 w 1567"/>
                <a:gd name="T59" fmla="*/ 69 h 228"/>
                <a:gd name="T60" fmla="*/ 774 w 1567"/>
                <a:gd name="T61" fmla="*/ 69 h 228"/>
                <a:gd name="T62" fmla="*/ 792 w 1567"/>
                <a:gd name="T63" fmla="*/ 69 h 228"/>
                <a:gd name="T64" fmla="*/ 813 w 1567"/>
                <a:gd name="T65" fmla="*/ 69 h 228"/>
                <a:gd name="T66" fmla="*/ 824 w 1567"/>
                <a:gd name="T67" fmla="*/ 47 h 228"/>
                <a:gd name="T68" fmla="*/ 841 w 1567"/>
                <a:gd name="T69" fmla="*/ 47 h 228"/>
                <a:gd name="T70" fmla="*/ 846 w 1567"/>
                <a:gd name="T71" fmla="*/ 0 h 228"/>
                <a:gd name="T72" fmla="*/ 864 w 1567"/>
                <a:gd name="T73" fmla="*/ 0 h 228"/>
                <a:gd name="T74" fmla="*/ 882 w 1567"/>
                <a:gd name="T75" fmla="*/ 0 h 228"/>
                <a:gd name="T76" fmla="*/ 900 w 1567"/>
                <a:gd name="T77" fmla="*/ 0 h 228"/>
                <a:gd name="T78" fmla="*/ 924 w 1567"/>
                <a:gd name="T79" fmla="*/ 0 h 228"/>
                <a:gd name="T80" fmla="*/ 942 w 1567"/>
                <a:gd name="T81" fmla="*/ 0 h 228"/>
                <a:gd name="T82" fmla="*/ 971 w 1567"/>
                <a:gd name="T83" fmla="*/ 0 h 228"/>
                <a:gd name="T84" fmla="*/ 1014 w 1567"/>
                <a:gd name="T85" fmla="*/ 0 h 228"/>
                <a:gd name="T86" fmla="*/ 1041 w 1567"/>
                <a:gd name="T87" fmla="*/ 0 h 228"/>
                <a:gd name="T88" fmla="*/ 1106 w 1567"/>
                <a:gd name="T89" fmla="*/ 0 h 228"/>
                <a:gd name="T90" fmla="*/ 1141 w 1567"/>
                <a:gd name="T91" fmla="*/ 0 h 228"/>
                <a:gd name="T92" fmla="*/ 1171 w 1567"/>
                <a:gd name="T93" fmla="*/ 0 h 228"/>
                <a:gd name="T94" fmla="*/ 1225 w 1567"/>
                <a:gd name="T95" fmla="*/ 0 h 228"/>
                <a:gd name="T96" fmla="*/ 1312 w 1567"/>
                <a:gd name="T97" fmla="*/ 0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1567" h="228">
                  <a:moveTo>
                    <a:pt x="0" y="228"/>
                  </a:moveTo>
                  <a:lnTo>
                    <a:pt x="138" y="228"/>
                  </a:lnTo>
                  <a:lnTo>
                    <a:pt x="138" y="222"/>
                  </a:lnTo>
                  <a:lnTo>
                    <a:pt x="193" y="222"/>
                  </a:lnTo>
                  <a:lnTo>
                    <a:pt x="213" y="222"/>
                  </a:lnTo>
                  <a:lnTo>
                    <a:pt x="216" y="222"/>
                  </a:lnTo>
                  <a:lnTo>
                    <a:pt x="216" y="216"/>
                  </a:lnTo>
                  <a:lnTo>
                    <a:pt x="254" y="216"/>
                  </a:lnTo>
                  <a:lnTo>
                    <a:pt x="254" y="210"/>
                  </a:lnTo>
                  <a:lnTo>
                    <a:pt x="285" y="210"/>
                  </a:lnTo>
                  <a:lnTo>
                    <a:pt x="285" y="204"/>
                  </a:lnTo>
                  <a:lnTo>
                    <a:pt x="288" y="204"/>
                  </a:lnTo>
                  <a:lnTo>
                    <a:pt x="322" y="204"/>
                  </a:lnTo>
                  <a:lnTo>
                    <a:pt x="322" y="198"/>
                  </a:lnTo>
                  <a:lnTo>
                    <a:pt x="325" y="198"/>
                  </a:lnTo>
                  <a:lnTo>
                    <a:pt x="342" y="198"/>
                  </a:lnTo>
                  <a:lnTo>
                    <a:pt x="342" y="192"/>
                  </a:lnTo>
                  <a:lnTo>
                    <a:pt x="349" y="192"/>
                  </a:lnTo>
                  <a:lnTo>
                    <a:pt x="349" y="186"/>
                  </a:lnTo>
                  <a:lnTo>
                    <a:pt x="378" y="186"/>
                  </a:lnTo>
                  <a:lnTo>
                    <a:pt x="378" y="180"/>
                  </a:lnTo>
                  <a:lnTo>
                    <a:pt x="388" y="180"/>
                  </a:lnTo>
                  <a:lnTo>
                    <a:pt x="400" y="180"/>
                  </a:lnTo>
                  <a:lnTo>
                    <a:pt x="405" y="180"/>
                  </a:lnTo>
                  <a:lnTo>
                    <a:pt x="407" y="180"/>
                  </a:lnTo>
                  <a:lnTo>
                    <a:pt x="417" y="180"/>
                  </a:lnTo>
                  <a:lnTo>
                    <a:pt x="417" y="174"/>
                  </a:lnTo>
                  <a:lnTo>
                    <a:pt x="428" y="174"/>
                  </a:lnTo>
                  <a:lnTo>
                    <a:pt x="436" y="174"/>
                  </a:lnTo>
                  <a:lnTo>
                    <a:pt x="441" y="174"/>
                  </a:lnTo>
                  <a:lnTo>
                    <a:pt x="450" y="174"/>
                  </a:lnTo>
                  <a:lnTo>
                    <a:pt x="450" y="167"/>
                  </a:lnTo>
                  <a:lnTo>
                    <a:pt x="457" y="167"/>
                  </a:lnTo>
                  <a:lnTo>
                    <a:pt x="457" y="161"/>
                  </a:lnTo>
                  <a:lnTo>
                    <a:pt x="464" y="161"/>
                  </a:lnTo>
                  <a:lnTo>
                    <a:pt x="474" y="161"/>
                  </a:lnTo>
                  <a:lnTo>
                    <a:pt x="474" y="155"/>
                  </a:lnTo>
                  <a:lnTo>
                    <a:pt x="479" y="155"/>
                  </a:lnTo>
                  <a:lnTo>
                    <a:pt x="479" y="149"/>
                  </a:lnTo>
                  <a:lnTo>
                    <a:pt x="481" y="143"/>
                  </a:lnTo>
                  <a:lnTo>
                    <a:pt x="484" y="136"/>
                  </a:lnTo>
                  <a:lnTo>
                    <a:pt x="484" y="136"/>
                  </a:lnTo>
                  <a:lnTo>
                    <a:pt x="495" y="136"/>
                  </a:lnTo>
                  <a:lnTo>
                    <a:pt x="500" y="136"/>
                  </a:lnTo>
                  <a:lnTo>
                    <a:pt x="509" y="136"/>
                  </a:lnTo>
                  <a:lnTo>
                    <a:pt x="515" y="136"/>
                  </a:lnTo>
                  <a:lnTo>
                    <a:pt x="521" y="136"/>
                  </a:lnTo>
                  <a:lnTo>
                    <a:pt x="522" y="130"/>
                  </a:lnTo>
                  <a:lnTo>
                    <a:pt x="534" y="130"/>
                  </a:lnTo>
                  <a:lnTo>
                    <a:pt x="536" y="123"/>
                  </a:lnTo>
                  <a:lnTo>
                    <a:pt x="552" y="123"/>
                  </a:lnTo>
                  <a:lnTo>
                    <a:pt x="564" y="123"/>
                  </a:lnTo>
                  <a:lnTo>
                    <a:pt x="571" y="123"/>
                  </a:lnTo>
                  <a:lnTo>
                    <a:pt x="575" y="123"/>
                  </a:lnTo>
                  <a:lnTo>
                    <a:pt x="582" y="123"/>
                  </a:lnTo>
                  <a:lnTo>
                    <a:pt x="590" y="123"/>
                  </a:lnTo>
                  <a:lnTo>
                    <a:pt x="593" y="123"/>
                  </a:lnTo>
                  <a:lnTo>
                    <a:pt x="601" y="123"/>
                  </a:lnTo>
                  <a:lnTo>
                    <a:pt x="608" y="123"/>
                  </a:lnTo>
                  <a:lnTo>
                    <a:pt x="613" y="123"/>
                  </a:lnTo>
                  <a:lnTo>
                    <a:pt x="618" y="123"/>
                  </a:lnTo>
                  <a:lnTo>
                    <a:pt x="625" y="123"/>
                  </a:lnTo>
                  <a:lnTo>
                    <a:pt x="629" y="123"/>
                  </a:lnTo>
                  <a:lnTo>
                    <a:pt x="636" y="123"/>
                  </a:lnTo>
                  <a:lnTo>
                    <a:pt x="642" y="123"/>
                  </a:lnTo>
                  <a:lnTo>
                    <a:pt x="647" y="115"/>
                  </a:lnTo>
                  <a:lnTo>
                    <a:pt x="649" y="115"/>
                  </a:lnTo>
                  <a:lnTo>
                    <a:pt x="654" y="115"/>
                  </a:lnTo>
                  <a:lnTo>
                    <a:pt x="664" y="115"/>
                  </a:lnTo>
                  <a:lnTo>
                    <a:pt x="664" y="107"/>
                  </a:lnTo>
                  <a:lnTo>
                    <a:pt x="669" y="107"/>
                  </a:lnTo>
                  <a:lnTo>
                    <a:pt x="672" y="107"/>
                  </a:lnTo>
                  <a:lnTo>
                    <a:pt x="674" y="99"/>
                  </a:lnTo>
                  <a:lnTo>
                    <a:pt x="675" y="90"/>
                  </a:lnTo>
                  <a:lnTo>
                    <a:pt x="678" y="90"/>
                  </a:lnTo>
                  <a:lnTo>
                    <a:pt x="684" y="90"/>
                  </a:lnTo>
                  <a:lnTo>
                    <a:pt x="690" y="90"/>
                  </a:lnTo>
                  <a:lnTo>
                    <a:pt x="695" y="90"/>
                  </a:lnTo>
                  <a:lnTo>
                    <a:pt x="703" y="90"/>
                  </a:lnTo>
                  <a:lnTo>
                    <a:pt x="708" y="90"/>
                  </a:lnTo>
                  <a:lnTo>
                    <a:pt x="717" y="90"/>
                  </a:lnTo>
                  <a:lnTo>
                    <a:pt x="717" y="80"/>
                  </a:lnTo>
                  <a:lnTo>
                    <a:pt x="723" y="80"/>
                  </a:lnTo>
                  <a:lnTo>
                    <a:pt x="726" y="80"/>
                  </a:lnTo>
                  <a:lnTo>
                    <a:pt x="732" y="80"/>
                  </a:lnTo>
                  <a:lnTo>
                    <a:pt x="738" y="80"/>
                  </a:lnTo>
                  <a:lnTo>
                    <a:pt x="738" y="69"/>
                  </a:lnTo>
                  <a:lnTo>
                    <a:pt x="744" y="69"/>
                  </a:lnTo>
                  <a:lnTo>
                    <a:pt x="751" y="69"/>
                  </a:lnTo>
                  <a:lnTo>
                    <a:pt x="756" y="69"/>
                  </a:lnTo>
                  <a:lnTo>
                    <a:pt x="761" y="69"/>
                  </a:lnTo>
                  <a:lnTo>
                    <a:pt x="768" y="69"/>
                  </a:lnTo>
                  <a:lnTo>
                    <a:pt x="774" y="69"/>
                  </a:lnTo>
                  <a:lnTo>
                    <a:pt x="781" y="69"/>
                  </a:lnTo>
                  <a:lnTo>
                    <a:pt x="786" y="69"/>
                  </a:lnTo>
                  <a:lnTo>
                    <a:pt x="792" y="69"/>
                  </a:lnTo>
                  <a:lnTo>
                    <a:pt x="800" y="69"/>
                  </a:lnTo>
                  <a:lnTo>
                    <a:pt x="804" y="69"/>
                  </a:lnTo>
                  <a:lnTo>
                    <a:pt x="813" y="69"/>
                  </a:lnTo>
                  <a:lnTo>
                    <a:pt x="816" y="69"/>
                  </a:lnTo>
                  <a:lnTo>
                    <a:pt x="823" y="69"/>
                  </a:lnTo>
                  <a:lnTo>
                    <a:pt x="824" y="47"/>
                  </a:lnTo>
                  <a:lnTo>
                    <a:pt x="829" y="47"/>
                  </a:lnTo>
                  <a:lnTo>
                    <a:pt x="835" y="47"/>
                  </a:lnTo>
                  <a:lnTo>
                    <a:pt x="841" y="47"/>
                  </a:lnTo>
                  <a:lnTo>
                    <a:pt x="844" y="24"/>
                  </a:lnTo>
                  <a:lnTo>
                    <a:pt x="846" y="24"/>
                  </a:lnTo>
                  <a:lnTo>
                    <a:pt x="846" y="0"/>
                  </a:lnTo>
                  <a:lnTo>
                    <a:pt x="853" y="0"/>
                  </a:lnTo>
                  <a:lnTo>
                    <a:pt x="860" y="0"/>
                  </a:lnTo>
                  <a:lnTo>
                    <a:pt x="864" y="0"/>
                  </a:lnTo>
                  <a:lnTo>
                    <a:pt x="870" y="0"/>
                  </a:lnTo>
                  <a:lnTo>
                    <a:pt x="878" y="0"/>
                  </a:lnTo>
                  <a:lnTo>
                    <a:pt x="882" y="0"/>
                  </a:lnTo>
                  <a:lnTo>
                    <a:pt x="894" y="0"/>
                  </a:lnTo>
                  <a:lnTo>
                    <a:pt x="895" y="0"/>
                  </a:lnTo>
                  <a:lnTo>
                    <a:pt x="900" y="0"/>
                  </a:lnTo>
                  <a:lnTo>
                    <a:pt x="908" y="0"/>
                  </a:lnTo>
                  <a:lnTo>
                    <a:pt x="913" y="0"/>
                  </a:lnTo>
                  <a:lnTo>
                    <a:pt x="924" y="0"/>
                  </a:lnTo>
                  <a:lnTo>
                    <a:pt x="932" y="0"/>
                  </a:lnTo>
                  <a:lnTo>
                    <a:pt x="937" y="0"/>
                  </a:lnTo>
                  <a:lnTo>
                    <a:pt x="942" y="0"/>
                  </a:lnTo>
                  <a:lnTo>
                    <a:pt x="951" y="0"/>
                  </a:lnTo>
                  <a:lnTo>
                    <a:pt x="963" y="0"/>
                  </a:lnTo>
                  <a:lnTo>
                    <a:pt x="971" y="0"/>
                  </a:lnTo>
                  <a:lnTo>
                    <a:pt x="974" y="0"/>
                  </a:lnTo>
                  <a:lnTo>
                    <a:pt x="994" y="0"/>
                  </a:lnTo>
                  <a:lnTo>
                    <a:pt x="1014" y="0"/>
                  </a:lnTo>
                  <a:lnTo>
                    <a:pt x="1024" y="0"/>
                  </a:lnTo>
                  <a:lnTo>
                    <a:pt x="1028" y="0"/>
                  </a:lnTo>
                  <a:lnTo>
                    <a:pt x="1041" y="0"/>
                  </a:lnTo>
                  <a:lnTo>
                    <a:pt x="1047" y="0"/>
                  </a:lnTo>
                  <a:lnTo>
                    <a:pt x="1062" y="0"/>
                  </a:lnTo>
                  <a:lnTo>
                    <a:pt x="1106" y="0"/>
                  </a:lnTo>
                  <a:lnTo>
                    <a:pt x="1120" y="0"/>
                  </a:lnTo>
                  <a:lnTo>
                    <a:pt x="1139" y="0"/>
                  </a:lnTo>
                  <a:lnTo>
                    <a:pt x="1141" y="0"/>
                  </a:lnTo>
                  <a:lnTo>
                    <a:pt x="1150" y="0"/>
                  </a:lnTo>
                  <a:lnTo>
                    <a:pt x="1166" y="0"/>
                  </a:lnTo>
                  <a:lnTo>
                    <a:pt x="1171" y="0"/>
                  </a:lnTo>
                  <a:lnTo>
                    <a:pt x="1203" y="0"/>
                  </a:lnTo>
                  <a:lnTo>
                    <a:pt x="1214" y="0"/>
                  </a:lnTo>
                  <a:lnTo>
                    <a:pt x="1225" y="0"/>
                  </a:lnTo>
                  <a:lnTo>
                    <a:pt x="1233" y="0"/>
                  </a:lnTo>
                  <a:lnTo>
                    <a:pt x="1245" y="0"/>
                  </a:lnTo>
                  <a:lnTo>
                    <a:pt x="1312" y="0"/>
                  </a:lnTo>
                  <a:lnTo>
                    <a:pt x="1324" y="0"/>
                  </a:lnTo>
                  <a:lnTo>
                    <a:pt x="1567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Freeform 20">
              <a:extLst>
                <a:ext uri="{FF2B5EF4-FFF2-40B4-BE49-F238E27FC236}">
                  <a16:creationId xmlns:a16="http://schemas.microsoft.com/office/drawing/2014/main" id="{DE5042B0-1DD6-399B-9BAA-B63EC449358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3274" y="3005284"/>
              <a:ext cx="2446658" cy="0"/>
            </a:xfrm>
            <a:custGeom>
              <a:avLst/>
              <a:gdLst>
                <a:gd name="T0" fmla="*/ 317 w 1300"/>
                <a:gd name="T1" fmla="*/ 388 w 1300"/>
                <a:gd name="T2" fmla="*/ 400 w 1300"/>
                <a:gd name="T3" fmla="*/ 408 w 1300"/>
                <a:gd name="T4" fmla="*/ 439 w 1300"/>
                <a:gd name="T5" fmla="*/ 464 w 1300"/>
                <a:gd name="T6" fmla="*/ 484 w 1300"/>
                <a:gd name="T7" fmla="*/ 498 w 1300"/>
                <a:gd name="T8" fmla="*/ 537 w 1300"/>
                <a:gd name="T9" fmla="*/ 545 w 1300"/>
                <a:gd name="T10" fmla="*/ 557 w 1300"/>
                <a:gd name="T11" fmla="*/ 577 w 1300"/>
                <a:gd name="T12" fmla="*/ 587 w 1300"/>
                <a:gd name="T13" fmla="*/ 600 w 1300"/>
                <a:gd name="T14" fmla="*/ 615 w 1300"/>
                <a:gd name="T15" fmla="*/ 625 w 1300"/>
                <a:gd name="T16" fmla="*/ 636 w 1300"/>
                <a:gd name="T17" fmla="*/ 648 w 1300"/>
                <a:gd name="T18" fmla="*/ 660 w 1300"/>
                <a:gd name="T19" fmla="*/ 672 w 1300"/>
                <a:gd name="T20" fmla="*/ 695 w 1300"/>
                <a:gd name="T21" fmla="*/ 710 w 1300"/>
                <a:gd name="T22" fmla="*/ 721 w 1300"/>
                <a:gd name="T23" fmla="*/ 732 w 1300"/>
                <a:gd name="T24" fmla="*/ 748 w 1300"/>
                <a:gd name="T25" fmla="*/ 759 w 1300"/>
                <a:gd name="T26" fmla="*/ 771 w 1300"/>
                <a:gd name="T27" fmla="*/ 787 w 1300"/>
                <a:gd name="T28" fmla="*/ 798 w 1300"/>
                <a:gd name="T29" fmla="*/ 813 w 1300"/>
                <a:gd name="T30" fmla="*/ 841 w 1300"/>
                <a:gd name="T31" fmla="*/ 854 w 1300"/>
                <a:gd name="T32" fmla="*/ 880 w 1300"/>
                <a:gd name="T33" fmla="*/ 890 w 1300"/>
                <a:gd name="T34" fmla="*/ 908 w 1300"/>
                <a:gd name="T35" fmla="*/ 969 w 1300"/>
                <a:gd name="T36" fmla="*/ 1002 w 1300"/>
                <a:gd name="T37" fmla="*/ 1193 w 1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</a:cxnLst>
              <a:rect l="0" t="0" r="r" b="b"/>
              <a:pathLst>
                <a:path w="1300">
                  <a:moveTo>
                    <a:pt x="0" y="0"/>
                  </a:moveTo>
                  <a:lnTo>
                    <a:pt x="317" y="0"/>
                  </a:lnTo>
                  <a:lnTo>
                    <a:pt x="353" y="0"/>
                  </a:lnTo>
                  <a:lnTo>
                    <a:pt x="388" y="0"/>
                  </a:lnTo>
                  <a:lnTo>
                    <a:pt x="389" y="0"/>
                  </a:lnTo>
                  <a:lnTo>
                    <a:pt x="400" y="0"/>
                  </a:lnTo>
                  <a:lnTo>
                    <a:pt x="402" y="0"/>
                  </a:lnTo>
                  <a:lnTo>
                    <a:pt x="408" y="0"/>
                  </a:lnTo>
                  <a:lnTo>
                    <a:pt x="419" y="0"/>
                  </a:lnTo>
                  <a:lnTo>
                    <a:pt x="439" y="0"/>
                  </a:lnTo>
                  <a:lnTo>
                    <a:pt x="448" y="0"/>
                  </a:lnTo>
                  <a:lnTo>
                    <a:pt x="464" y="0"/>
                  </a:lnTo>
                  <a:lnTo>
                    <a:pt x="478" y="0"/>
                  </a:lnTo>
                  <a:lnTo>
                    <a:pt x="484" y="0"/>
                  </a:lnTo>
                  <a:lnTo>
                    <a:pt x="495" y="0"/>
                  </a:lnTo>
                  <a:lnTo>
                    <a:pt x="498" y="0"/>
                  </a:lnTo>
                  <a:lnTo>
                    <a:pt x="510" y="0"/>
                  </a:lnTo>
                  <a:lnTo>
                    <a:pt x="537" y="0"/>
                  </a:lnTo>
                  <a:lnTo>
                    <a:pt x="543" y="0"/>
                  </a:lnTo>
                  <a:lnTo>
                    <a:pt x="545" y="0"/>
                  </a:lnTo>
                  <a:lnTo>
                    <a:pt x="556" y="0"/>
                  </a:lnTo>
                  <a:lnTo>
                    <a:pt x="557" y="0"/>
                  </a:lnTo>
                  <a:lnTo>
                    <a:pt x="565" y="0"/>
                  </a:lnTo>
                  <a:lnTo>
                    <a:pt x="577" y="0"/>
                  </a:lnTo>
                  <a:lnTo>
                    <a:pt x="585" y="0"/>
                  </a:lnTo>
                  <a:lnTo>
                    <a:pt x="587" y="0"/>
                  </a:lnTo>
                  <a:lnTo>
                    <a:pt x="593" y="0"/>
                  </a:lnTo>
                  <a:lnTo>
                    <a:pt x="600" y="0"/>
                  </a:lnTo>
                  <a:lnTo>
                    <a:pt x="607" y="0"/>
                  </a:lnTo>
                  <a:lnTo>
                    <a:pt x="615" y="0"/>
                  </a:lnTo>
                  <a:lnTo>
                    <a:pt x="622" y="0"/>
                  </a:lnTo>
                  <a:lnTo>
                    <a:pt x="625" y="0"/>
                  </a:lnTo>
                  <a:lnTo>
                    <a:pt x="629" y="0"/>
                  </a:lnTo>
                  <a:lnTo>
                    <a:pt x="636" y="0"/>
                  </a:lnTo>
                  <a:lnTo>
                    <a:pt x="643" y="0"/>
                  </a:lnTo>
                  <a:lnTo>
                    <a:pt x="648" y="0"/>
                  </a:lnTo>
                  <a:lnTo>
                    <a:pt x="655" y="0"/>
                  </a:lnTo>
                  <a:lnTo>
                    <a:pt x="660" y="0"/>
                  </a:lnTo>
                  <a:lnTo>
                    <a:pt x="667" y="0"/>
                  </a:lnTo>
                  <a:lnTo>
                    <a:pt x="672" y="0"/>
                  </a:lnTo>
                  <a:lnTo>
                    <a:pt x="680" y="0"/>
                  </a:lnTo>
                  <a:lnTo>
                    <a:pt x="695" y="0"/>
                  </a:lnTo>
                  <a:lnTo>
                    <a:pt x="705" y="0"/>
                  </a:lnTo>
                  <a:lnTo>
                    <a:pt x="710" y="0"/>
                  </a:lnTo>
                  <a:lnTo>
                    <a:pt x="718" y="0"/>
                  </a:lnTo>
                  <a:lnTo>
                    <a:pt x="721" y="0"/>
                  </a:lnTo>
                  <a:lnTo>
                    <a:pt x="730" y="0"/>
                  </a:lnTo>
                  <a:lnTo>
                    <a:pt x="732" y="0"/>
                  </a:lnTo>
                  <a:lnTo>
                    <a:pt x="740" y="0"/>
                  </a:lnTo>
                  <a:lnTo>
                    <a:pt x="748" y="0"/>
                  </a:lnTo>
                  <a:lnTo>
                    <a:pt x="751" y="0"/>
                  </a:lnTo>
                  <a:lnTo>
                    <a:pt x="759" y="0"/>
                  </a:lnTo>
                  <a:lnTo>
                    <a:pt x="764" y="0"/>
                  </a:lnTo>
                  <a:lnTo>
                    <a:pt x="771" y="0"/>
                  </a:lnTo>
                  <a:lnTo>
                    <a:pt x="784" y="0"/>
                  </a:lnTo>
                  <a:lnTo>
                    <a:pt x="787" y="0"/>
                  </a:lnTo>
                  <a:lnTo>
                    <a:pt x="794" y="0"/>
                  </a:lnTo>
                  <a:lnTo>
                    <a:pt x="798" y="0"/>
                  </a:lnTo>
                  <a:lnTo>
                    <a:pt x="804" y="0"/>
                  </a:lnTo>
                  <a:lnTo>
                    <a:pt x="813" y="0"/>
                  </a:lnTo>
                  <a:lnTo>
                    <a:pt x="830" y="0"/>
                  </a:lnTo>
                  <a:lnTo>
                    <a:pt x="841" y="0"/>
                  </a:lnTo>
                  <a:lnTo>
                    <a:pt x="851" y="0"/>
                  </a:lnTo>
                  <a:lnTo>
                    <a:pt x="854" y="0"/>
                  </a:lnTo>
                  <a:lnTo>
                    <a:pt x="860" y="0"/>
                  </a:lnTo>
                  <a:lnTo>
                    <a:pt x="880" y="0"/>
                  </a:lnTo>
                  <a:lnTo>
                    <a:pt x="883" y="0"/>
                  </a:lnTo>
                  <a:lnTo>
                    <a:pt x="890" y="0"/>
                  </a:lnTo>
                  <a:lnTo>
                    <a:pt x="899" y="0"/>
                  </a:lnTo>
                  <a:lnTo>
                    <a:pt x="908" y="0"/>
                  </a:lnTo>
                  <a:lnTo>
                    <a:pt x="913" y="0"/>
                  </a:lnTo>
                  <a:lnTo>
                    <a:pt x="969" y="0"/>
                  </a:lnTo>
                  <a:lnTo>
                    <a:pt x="991" y="0"/>
                  </a:lnTo>
                  <a:lnTo>
                    <a:pt x="1002" y="0"/>
                  </a:lnTo>
                  <a:lnTo>
                    <a:pt x="1036" y="0"/>
                  </a:lnTo>
                  <a:lnTo>
                    <a:pt x="1193" y="0"/>
                  </a:lnTo>
                  <a:lnTo>
                    <a:pt x="1300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Freeform 21">
              <a:extLst>
                <a:ext uri="{FF2B5EF4-FFF2-40B4-BE49-F238E27FC236}">
                  <a16:creationId xmlns:a16="http://schemas.microsoft.com/office/drawing/2014/main" id="{DE768221-33F8-8361-7B11-E261765905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3274" y="2955389"/>
              <a:ext cx="2903996" cy="49895"/>
            </a:xfrm>
            <a:custGeom>
              <a:avLst/>
              <a:gdLst>
                <a:gd name="T0" fmla="*/ 167 w 1543"/>
                <a:gd name="T1" fmla="*/ 27 h 27"/>
                <a:gd name="T2" fmla="*/ 282 w 1543"/>
                <a:gd name="T3" fmla="*/ 27 h 27"/>
                <a:gd name="T4" fmla="*/ 303 w 1543"/>
                <a:gd name="T5" fmla="*/ 27 h 27"/>
                <a:gd name="T6" fmla="*/ 345 w 1543"/>
                <a:gd name="T7" fmla="*/ 27 h 27"/>
                <a:gd name="T8" fmla="*/ 393 w 1543"/>
                <a:gd name="T9" fmla="*/ 27 h 27"/>
                <a:gd name="T10" fmla="*/ 408 w 1543"/>
                <a:gd name="T11" fmla="*/ 27 h 27"/>
                <a:gd name="T12" fmla="*/ 425 w 1543"/>
                <a:gd name="T13" fmla="*/ 27 h 27"/>
                <a:gd name="T14" fmla="*/ 450 w 1543"/>
                <a:gd name="T15" fmla="*/ 27 h 27"/>
                <a:gd name="T16" fmla="*/ 475 w 1543"/>
                <a:gd name="T17" fmla="*/ 27 h 27"/>
                <a:gd name="T18" fmla="*/ 501 w 1543"/>
                <a:gd name="T19" fmla="*/ 27 h 27"/>
                <a:gd name="T20" fmla="*/ 525 w 1543"/>
                <a:gd name="T21" fmla="*/ 27 h 27"/>
                <a:gd name="T22" fmla="*/ 542 w 1543"/>
                <a:gd name="T23" fmla="*/ 27 h 27"/>
                <a:gd name="T24" fmla="*/ 559 w 1543"/>
                <a:gd name="T25" fmla="*/ 27 h 27"/>
                <a:gd name="T26" fmla="*/ 575 w 1543"/>
                <a:gd name="T27" fmla="*/ 27 h 27"/>
                <a:gd name="T28" fmla="*/ 587 w 1543"/>
                <a:gd name="T29" fmla="*/ 27 h 27"/>
                <a:gd name="T30" fmla="*/ 599 w 1543"/>
                <a:gd name="T31" fmla="*/ 27 h 27"/>
                <a:gd name="T32" fmla="*/ 615 w 1543"/>
                <a:gd name="T33" fmla="*/ 27 h 27"/>
                <a:gd name="T34" fmla="*/ 623 w 1543"/>
                <a:gd name="T35" fmla="*/ 27 h 27"/>
                <a:gd name="T36" fmla="*/ 631 w 1543"/>
                <a:gd name="T37" fmla="*/ 20 h 27"/>
                <a:gd name="T38" fmla="*/ 644 w 1543"/>
                <a:gd name="T39" fmla="*/ 20 h 27"/>
                <a:gd name="T40" fmla="*/ 654 w 1543"/>
                <a:gd name="T41" fmla="*/ 20 h 27"/>
                <a:gd name="T42" fmla="*/ 669 w 1543"/>
                <a:gd name="T43" fmla="*/ 20 h 27"/>
                <a:gd name="T44" fmla="*/ 678 w 1543"/>
                <a:gd name="T45" fmla="*/ 20 h 27"/>
                <a:gd name="T46" fmla="*/ 689 w 1543"/>
                <a:gd name="T47" fmla="*/ 13 h 27"/>
                <a:gd name="T48" fmla="*/ 695 w 1543"/>
                <a:gd name="T49" fmla="*/ 13 h 27"/>
                <a:gd name="T50" fmla="*/ 707 w 1543"/>
                <a:gd name="T51" fmla="*/ 13 h 27"/>
                <a:gd name="T52" fmla="*/ 720 w 1543"/>
                <a:gd name="T53" fmla="*/ 13 h 27"/>
                <a:gd name="T54" fmla="*/ 731 w 1543"/>
                <a:gd name="T55" fmla="*/ 13 h 27"/>
                <a:gd name="T56" fmla="*/ 744 w 1543"/>
                <a:gd name="T57" fmla="*/ 13 h 27"/>
                <a:gd name="T58" fmla="*/ 756 w 1543"/>
                <a:gd name="T59" fmla="*/ 13 h 27"/>
                <a:gd name="T60" fmla="*/ 768 w 1543"/>
                <a:gd name="T61" fmla="*/ 13 h 27"/>
                <a:gd name="T62" fmla="*/ 774 w 1543"/>
                <a:gd name="T63" fmla="*/ 0 h 27"/>
                <a:gd name="T64" fmla="*/ 786 w 1543"/>
                <a:gd name="T65" fmla="*/ 0 h 27"/>
                <a:gd name="T66" fmla="*/ 800 w 1543"/>
                <a:gd name="T67" fmla="*/ 0 h 27"/>
                <a:gd name="T68" fmla="*/ 810 w 1543"/>
                <a:gd name="T69" fmla="*/ 0 h 27"/>
                <a:gd name="T70" fmla="*/ 823 w 1543"/>
                <a:gd name="T71" fmla="*/ 0 h 27"/>
                <a:gd name="T72" fmla="*/ 835 w 1543"/>
                <a:gd name="T73" fmla="*/ 0 h 27"/>
                <a:gd name="T74" fmla="*/ 847 w 1543"/>
                <a:gd name="T75" fmla="*/ 0 h 27"/>
                <a:gd name="T76" fmla="*/ 860 w 1543"/>
                <a:gd name="T77" fmla="*/ 0 h 27"/>
                <a:gd name="T78" fmla="*/ 870 w 1543"/>
                <a:gd name="T79" fmla="*/ 0 h 27"/>
                <a:gd name="T80" fmla="*/ 885 w 1543"/>
                <a:gd name="T81" fmla="*/ 0 h 27"/>
                <a:gd name="T82" fmla="*/ 894 w 1543"/>
                <a:gd name="T83" fmla="*/ 0 h 27"/>
                <a:gd name="T84" fmla="*/ 906 w 1543"/>
                <a:gd name="T85" fmla="*/ 0 h 27"/>
                <a:gd name="T86" fmla="*/ 920 w 1543"/>
                <a:gd name="T87" fmla="*/ 0 h 27"/>
                <a:gd name="T88" fmla="*/ 932 w 1543"/>
                <a:gd name="T89" fmla="*/ 0 h 27"/>
                <a:gd name="T90" fmla="*/ 955 w 1543"/>
                <a:gd name="T91" fmla="*/ 0 h 27"/>
                <a:gd name="T92" fmla="*/ 970 w 1543"/>
                <a:gd name="T93" fmla="*/ 0 h 27"/>
                <a:gd name="T94" fmla="*/ 990 w 1543"/>
                <a:gd name="T95" fmla="*/ 0 h 27"/>
                <a:gd name="T96" fmla="*/ 1006 w 1543"/>
                <a:gd name="T97" fmla="*/ 0 h 27"/>
                <a:gd name="T98" fmla="*/ 1017 w 1543"/>
                <a:gd name="T99" fmla="*/ 0 h 27"/>
                <a:gd name="T100" fmla="*/ 1044 w 1543"/>
                <a:gd name="T101" fmla="*/ 0 h 27"/>
                <a:gd name="T102" fmla="*/ 1063 w 1543"/>
                <a:gd name="T103" fmla="*/ 0 h 27"/>
                <a:gd name="T104" fmla="*/ 1106 w 1543"/>
                <a:gd name="T105" fmla="*/ 0 h 27"/>
                <a:gd name="T106" fmla="*/ 1142 w 1543"/>
                <a:gd name="T107" fmla="*/ 0 h 27"/>
                <a:gd name="T108" fmla="*/ 1172 w 1543"/>
                <a:gd name="T109" fmla="*/ 0 h 27"/>
                <a:gd name="T110" fmla="*/ 1227 w 1543"/>
                <a:gd name="T111" fmla="*/ 0 h 27"/>
                <a:gd name="T112" fmla="*/ 1237 w 1543"/>
                <a:gd name="T113" fmla="*/ 0 h 27"/>
                <a:gd name="T114" fmla="*/ 1526 w 1543"/>
                <a:gd name="T11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543" h="27">
                  <a:moveTo>
                    <a:pt x="0" y="27"/>
                  </a:moveTo>
                  <a:lnTo>
                    <a:pt x="167" y="27"/>
                  </a:lnTo>
                  <a:lnTo>
                    <a:pt x="191" y="27"/>
                  </a:lnTo>
                  <a:lnTo>
                    <a:pt x="282" y="27"/>
                  </a:lnTo>
                  <a:lnTo>
                    <a:pt x="290" y="27"/>
                  </a:lnTo>
                  <a:lnTo>
                    <a:pt x="303" y="27"/>
                  </a:lnTo>
                  <a:lnTo>
                    <a:pt x="315" y="27"/>
                  </a:lnTo>
                  <a:lnTo>
                    <a:pt x="345" y="27"/>
                  </a:lnTo>
                  <a:lnTo>
                    <a:pt x="351" y="27"/>
                  </a:lnTo>
                  <a:lnTo>
                    <a:pt x="393" y="27"/>
                  </a:lnTo>
                  <a:lnTo>
                    <a:pt x="398" y="27"/>
                  </a:lnTo>
                  <a:lnTo>
                    <a:pt x="408" y="27"/>
                  </a:lnTo>
                  <a:lnTo>
                    <a:pt x="420" y="27"/>
                  </a:lnTo>
                  <a:lnTo>
                    <a:pt x="425" y="27"/>
                  </a:lnTo>
                  <a:lnTo>
                    <a:pt x="445" y="27"/>
                  </a:lnTo>
                  <a:lnTo>
                    <a:pt x="450" y="27"/>
                  </a:lnTo>
                  <a:lnTo>
                    <a:pt x="467" y="27"/>
                  </a:lnTo>
                  <a:lnTo>
                    <a:pt x="475" y="27"/>
                  </a:lnTo>
                  <a:lnTo>
                    <a:pt x="493" y="27"/>
                  </a:lnTo>
                  <a:lnTo>
                    <a:pt x="501" y="27"/>
                  </a:lnTo>
                  <a:lnTo>
                    <a:pt x="510" y="27"/>
                  </a:lnTo>
                  <a:lnTo>
                    <a:pt x="525" y="27"/>
                  </a:lnTo>
                  <a:lnTo>
                    <a:pt x="528" y="27"/>
                  </a:lnTo>
                  <a:lnTo>
                    <a:pt x="542" y="27"/>
                  </a:lnTo>
                  <a:lnTo>
                    <a:pt x="545" y="27"/>
                  </a:lnTo>
                  <a:lnTo>
                    <a:pt x="559" y="27"/>
                  </a:lnTo>
                  <a:lnTo>
                    <a:pt x="573" y="27"/>
                  </a:lnTo>
                  <a:lnTo>
                    <a:pt x="575" y="27"/>
                  </a:lnTo>
                  <a:lnTo>
                    <a:pt x="582" y="27"/>
                  </a:lnTo>
                  <a:lnTo>
                    <a:pt x="587" y="27"/>
                  </a:lnTo>
                  <a:lnTo>
                    <a:pt x="593" y="27"/>
                  </a:lnTo>
                  <a:lnTo>
                    <a:pt x="599" y="27"/>
                  </a:lnTo>
                  <a:lnTo>
                    <a:pt x="606" y="27"/>
                  </a:lnTo>
                  <a:lnTo>
                    <a:pt x="615" y="27"/>
                  </a:lnTo>
                  <a:lnTo>
                    <a:pt x="618" y="27"/>
                  </a:lnTo>
                  <a:lnTo>
                    <a:pt x="623" y="27"/>
                  </a:lnTo>
                  <a:lnTo>
                    <a:pt x="626" y="20"/>
                  </a:lnTo>
                  <a:lnTo>
                    <a:pt x="631" y="20"/>
                  </a:lnTo>
                  <a:lnTo>
                    <a:pt x="635" y="20"/>
                  </a:lnTo>
                  <a:lnTo>
                    <a:pt x="644" y="20"/>
                  </a:lnTo>
                  <a:lnTo>
                    <a:pt x="649" y="20"/>
                  </a:lnTo>
                  <a:lnTo>
                    <a:pt x="654" y="20"/>
                  </a:lnTo>
                  <a:lnTo>
                    <a:pt x="660" y="20"/>
                  </a:lnTo>
                  <a:lnTo>
                    <a:pt x="669" y="20"/>
                  </a:lnTo>
                  <a:lnTo>
                    <a:pt x="672" y="20"/>
                  </a:lnTo>
                  <a:lnTo>
                    <a:pt x="678" y="20"/>
                  </a:lnTo>
                  <a:lnTo>
                    <a:pt x="683" y="13"/>
                  </a:lnTo>
                  <a:lnTo>
                    <a:pt x="689" y="13"/>
                  </a:lnTo>
                  <a:lnTo>
                    <a:pt x="690" y="13"/>
                  </a:lnTo>
                  <a:lnTo>
                    <a:pt x="695" y="13"/>
                  </a:lnTo>
                  <a:lnTo>
                    <a:pt x="701" y="13"/>
                  </a:lnTo>
                  <a:lnTo>
                    <a:pt x="707" y="13"/>
                  </a:lnTo>
                  <a:lnTo>
                    <a:pt x="714" y="13"/>
                  </a:lnTo>
                  <a:lnTo>
                    <a:pt x="720" y="13"/>
                  </a:lnTo>
                  <a:lnTo>
                    <a:pt x="726" y="13"/>
                  </a:lnTo>
                  <a:lnTo>
                    <a:pt x="731" y="13"/>
                  </a:lnTo>
                  <a:lnTo>
                    <a:pt x="737" y="13"/>
                  </a:lnTo>
                  <a:lnTo>
                    <a:pt x="744" y="13"/>
                  </a:lnTo>
                  <a:lnTo>
                    <a:pt x="751" y="13"/>
                  </a:lnTo>
                  <a:lnTo>
                    <a:pt x="756" y="13"/>
                  </a:lnTo>
                  <a:lnTo>
                    <a:pt x="763" y="13"/>
                  </a:lnTo>
                  <a:lnTo>
                    <a:pt x="768" y="13"/>
                  </a:lnTo>
                  <a:lnTo>
                    <a:pt x="773" y="0"/>
                  </a:lnTo>
                  <a:lnTo>
                    <a:pt x="774" y="0"/>
                  </a:lnTo>
                  <a:lnTo>
                    <a:pt x="780" y="0"/>
                  </a:lnTo>
                  <a:lnTo>
                    <a:pt x="786" y="0"/>
                  </a:lnTo>
                  <a:lnTo>
                    <a:pt x="792" y="0"/>
                  </a:lnTo>
                  <a:lnTo>
                    <a:pt x="800" y="0"/>
                  </a:lnTo>
                  <a:lnTo>
                    <a:pt x="804" y="0"/>
                  </a:lnTo>
                  <a:lnTo>
                    <a:pt x="810" y="0"/>
                  </a:lnTo>
                  <a:lnTo>
                    <a:pt x="816" y="0"/>
                  </a:lnTo>
                  <a:lnTo>
                    <a:pt x="823" y="0"/>
                  </a:lnTo>
                  <a:lnTo>
                    <a:pt x="829" y="0"/>
                  </a:lnTo>
                  <a:lnTo>
                    <a:pt x="835" y="0"/>
                  </a:lnTo>
                  <a:lnTo>
                    <a:pt x="844" y="0"/>
                  </a:lnTo>
                  <a:lnTo>
                    <a:pt x="847" y="0"/>
                  </a:lnTo>
                  <a:lnTo>
                    <a:pt x="852" y="0"/>
                  </a:lnTo>
                  <a:lnTo>
                    <a:pt x="860" y="0"/>
                  </a:lnTo>
                  <a:lnTo>
                    <a:pt x="864" y="0"/>
                  </a:lnTo>
                  <a:lnTo>
                    <a:pt x="870" y="0"/>
                  </a:lnTo>
                  <a:lnTo>
                    <a:pt x="880" y="0"/>
                  </a:lnTo>
                  <a:lnTo>
                    <a:pt x="885" y="0"/>
                  </a:lnTo>
                  <a:lnTo>
                    <a:pt x="888" y="0"/>
                  </a:lnTo>
                  <a:lnTo>
                    <a:pt x="894" y="0"/>
                  </a:lnTo>
                  <a:lnTo>
                    <a:pt x="901" y="0"/>
                  </a:lnTo>
                  <a:lnTo>
                    <a:pt x="906" y="0"/>
                  </a:lnTo>
                  <a:lnTo>
                    <a:pt x="913" y="0"/>
                  </a:lnTo>
                  <a:lnTo>
                    <a:pt x="920" y="0"/>
                  </a:lnTo>
                  <a:lnTo>
                    <a:pt x="927" y="0"/>
                  </a:lnTo>
                  <a:lnTo>
                    <a:pt x="932" y="0"/>
                  </a:lnTo>
                  <a:lnTo>
                    <a:pt x="943" y="0"/>
                  </a:lnTo>
                  <a:lnTo>
                    <a:pt x="955" y="0"/>
                  </a:lnTo>
                  <a:lnTo>
                    <a:pt x="961" y="0"/>
                  </a:lnTo>
                  <a:lnTo>
                    <a:pt x="970" y="0"/>
                  </a:lnTo>
                  <a:lnTo>
                    <a:pt x="977" y="0"/>
                  </a:lnTo>
                  <a:lnTo>
                    <a:pt x="990" y="0"/>
                  </a:lnTo>
                  <a:lnTo>
                    <a:pt x="999" y="0"/>
                  </a:lnTo>
                  <a:lnTo>
                    <a:pt x="1006" y="0"/>
                  </a:lnTo>
                  <a:lnTo>
                    <a:pt x="1008" y="0"/>
                  </a:lnTo>
                  <a:lnTo>
                    <a:pt x="1017" y="0"/>
                  </a:lnTo>
                  <a:lnTo>
                    <a:pt x="1029" y="0"/>
                  </a:lnTo>
                  <a:lnTo>
                    <a:pt x="1044" y="0"/>
                  </a:lnTo>
                  <a:lnTo>
                    <a:pt x="1061" y="0"/>
                  </a:lnTo>
                  <a:lnTo>
                    <a:pt x="1063" y="0"/>
                  </a:lnTo>
                  <a:lnTo>
                    <a:pt x="1103" y="0"/>
                  </a:lnTo>
                  <a:lnTo>
                    <a:pt x="1106" y="0"/>
                  </a:lnTo>
                  <a:lnTo>
                    <a:pt x="1127" y="0"/>
                  </a:lnTo>
                  <a:lnTo>
                    <a:pt x="1142" y="0"/>
                  </a:lnTo>
                  <a:lnTo>
                    <a:pt x="1164" y="0"/>
                  </a:lnTo>
                  <a:lnTo>
                    <a:pt x="1172" y="0"/>
                  </a:lnTo>
                  <a:lnTo>
                    <a:pt x="1180" y="0"/>
                  </a:lnTo>
                  <a:lnTo>
                    <a:pt x="1227" y="0"/>
                  </a:lnTo>
                  <a:lnTo>
                    <a:pt x="1235" y="0"/>
                  </a:lnTo>
                  <a:lnTo>
                    <a:pt x="1237" y="0"/>
                  </a:lnTo>
                  <a:lnTo>
                    <a:pt x="1337" y="0"/>
                  </a:lnTo>
                  <a:lnTo>
                    <a:pt x="1526" y="0"/>
                  </a:lnTo>
                  <a:lnTo>
                    <a:pt x="1543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96211E9B-D2B9-86B9-7F67-20FFE3C0D322}"/>
              </a:ext>
            </a:extLst>
          </p:cNvPr>
          <p:cNvGrpSpPr/>
          <p:nvPr/>
        </p:nvGrpSpPr>
        <p:grpSpPr>
          <a:xfrm>
            <a:off x="6306822" y="698448"/>
            <a:ext cx="4141083" cy="2791354"/>
            <a:chOff x="6597102" y="974214"/>
            <a:chExt cx="4141083" cy="2791354"/>
          </a:xfrm>
        </p:grpSpPr>
        <p:grpSp>
          <p:nvGrpSpPr>
            <p:cNvPr id="236" name="グループ化 235">
              <a:extLst>
                <a:ext uri="{FF2B5EF4-FFF2-40B4-BE49-F238E27FC236}">
                  <a16:creationId xmlns:a16="http://schemas.microsoft.com/office/drawing/2014/main" id="{5637447A-A220-9E15-B255-91213D6AE038}"/>
                </a:ext>
              </a:extLst>
            </p:cNvPr>
            <p:cNvGrpSpPr/>
            <p:nvPr/>
          </p:nvGrpSpPr>
          <p:grpSpPr>
            <a:xfrm>
              <a:off x="6597102" y="974214"/>
              <a:ext cx="4141083" cy="2791354"/>
              <a:chOff x="6597102" y="974214"/>
              <a:chExt cx="4141083" cy="2791354"/>
            </a:xfrm>
          </p:grpSpPr>
          <p:sp>
            <p:nvSpPr>
              <p:cNvPr id="172" name="Rectangle 22">
                <a:extLst>
                  <a:ext uri="{FF2B5EF4-FFF2-40B4-BE49-F238E27FC236}">
                    <a16:creationId xmlns:a16="http://schemas.microsoft.com/office/drawing/2014/main" id="{8B2FA7EC-6A41-F975-1900-6BBAC7EB74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7026" y="980735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3" name="Line 23">
                <a:extLst>
                  <a:ext uri="{FF2B5EF4-FFF2-40B4-BE49-F238E27FC236}">
                    <a16:creationId xmlns:a16="http://schemas.microsoft.com/office/drawing/2014/main" id="{9B1228F6-10B8-CE51-971B-C83D8B57E9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1359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4" name="Line 25">
                <a:extLst>
                  <a:ext uri="{FF2B5EF4-FFF2-40B4-BE49-F238E27FC236}">
                    <a16:creationId xmlns:a16="http://schemas.microsoft.com/office/drawing/2014/main" id="{BE0979E1-6978-A11C-8A0F-6744BA0D2E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74576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5" name="Line 27">
                <a:extLst>
                  <a:ext uri="{FF2B5EF4-FFF2-40B4-BE49-F238E27FC236}">
                    <a16:creationId xmlns:a16="http://schemas.microsoft.com/office/drawing/2014/main" id="{A5E73A6A-3798-CF26-F0F0-3A56FCCA63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97792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6" name="Line 29">
                <a:extLst>
                  <a:ext uri="{FF2B5EF4-FFF2-40B4-BE49-F238E27FC236}">
                    <a16:creationId xmlns:a16="http://schemas.microsoft.com/office/drawing/2014/main" id="{4EF827E4-0BAF-1807-0CA1-D011A1E9D1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19120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7" name="Line 31">
                <a:extLst>
                  <a:ext uri="{FF2B5EF4-FFF2-40B4-BE49-F238E27FC236}">
                    <a16:creationId xmlns:a16="http://schemas.microsoft.com/office/drawing/2014/main" id="{E9D05946-352C-06B9-0A68-6C426C283B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42337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8" name="Line 33">
                <a:extLst>
                  <a:ext uri="{FF2B5EF4-FFF2-40B4-BE49-F238E27FC236}">
                    <a16:creationId xmlns:a16="http://schemas.microsoft.com/office/drawing/2014/main" id="{9A44844B-9658-B14F-4AB4-92C5F1E633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65553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9" name="Line 35">
                <a:extLst>
                  <a:ext uri="{FF2B5EF4-FFF2-40B4-BE49-F238E27FC236}">
                    <a16:creationId xmlns:a16="http://schemas.microsoft.com/office/drawing/2014/main" id="{257D179F-218E-ED1F-6358-BDAA2BF30F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588770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80" name="Line 6">
                <a:extLst>
                  <a:ext uri="{FF2B5EF4-FFF2-40B4-BE49-F238E27FC236}">
                    <a16:creationId xmlns:a16="http://schemas.microsoft.com/office/drawing/2014/main" id="{2EB2D15F-50A1-B966-5F57-B72D716B6F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2994512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1" name="Line 8">
                <a:extLst>
                  <a:ext uri="{FF2B5EF4-FFF2-40B4-BE49-F238E27FC236}">
                    <a16:creationId xmlns:a16="http://schemas.microsoft.com/office/drawing/2014/main" id="{537004C1-B131-888B-CB60-D45A204B8B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258701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2" name="Line 9">
                <a:extLst>
                  <a:ext uri="{FF2B5EF4-FFF2-40B4-BE49-F238E27FC236}">
                    <a16:creationId xmlns:a16="http://schemas.microsoft.com/office/drawing/2014/main" id="{BE30B52C-44CB-C821-47FF-D9959D3DE5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2179521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3" name="Line 11">
                <a:extLst>
                  <a:ext uri="{FF2B5EF4-FFF2-40B4-BE49-F238E27FC236}">
                    <a16:creationId xmlns:a16="http://schemas.microsoft.com/office/drawing/2014/main" id="{D4390D76-1247-B684-6ECB-6676FE54F9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177202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4" name="Line 12">
                <a:extLst>
                  <a:ext uri="{FF2B5EF4-FFF2-40B4-BE49-F238E27FC236}">
                    <a16:creationId xmlns:a16="http://schemas.microsoft.com/office/drawing/2014/main" id="{E15154B9-D2FC-9A56-BA46-816AA4D8FB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1364531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5" name="Line 14">
                <a:extLst>
                  <a:ext uri="{FF2B5EF4-FFF2-40B4-BE49-F238E27FC236}">
                    <a16:creationId xmlns:a16="http://schemas.microsoft.com/office/drawing/2014/main" id="{43ECBC04-7BCC-2A1F-2B2A-0D3AE4C012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980943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6" name="Line 23">
                <a:extLst>
                  <a:ext uri="{FF2B5EF4-FFF2-40B4-BE49-F238E27FC236}">
                    <a16:creationId xmlns:a16="http://schemas.microsoft.com/office/drawing/2014/main" id="{DC5C2F81-919D-F4A9-F88A-208C85C8AD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3047" y="2994513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87" name="図形グループ 54">
                <a:extLst>
                  <a:ext uri="{FF2B5EF4-FFF2-40B4-BE49-F238E27FC236}">
                    <a16:creationId xmlns:a16="http://schemas.microsoft.com/office/drawing/2014/main" id="{B7CC5933-C4D8-EC26-F672-31D676DC3041}"/>
                  </a:ext>
                </a:extLst>
              </p:cNvPr>
              <p:cNvGrpSpPr/>
              <p:nvPr/>
            </p:nvGrpSpPr>
            <p:grpSpPr>
              <a:xfrm>
                <a:off x="7143441" y="1235436"/>
                <a:ext cx="220989" cy="1868530"/>
                <a:chOff x="510218" y="1348283"/>
                <a:chExt cx="220989" cy="1868530"/>
              </a:xfrm>
            </p:grpSpPr>
            <p:sp>
              <p:nvSpPr>
                <p:cNvPr id="194" name="Rectangle 10">
                  <a:extLst>
                    <a:ext uri="{FF2B5EF4-FFF2-40B4-BE49-F238E27FC236}">
                      <a16:creationId xmlns:a16="http://schemas.microsoft.com/office/drawing/2014/main" id="{FFB05AF3-CD2A-5065-84F3-EA3BA9E2A1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95" name="Rectangle 13">
                  <a:extLst>
                    <a:ext uri="{FF2B5EF4-FFF2-40B4-BE49-F238E27FC236}">
                      <a16:creationId xmlns:a16="http://schemas.microsoft.com/office/drawing/2014/main" id="{5E9F6F84-7C27-D320-325D-6179E8F732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96" name="Rectangle 10">
                  <a:extLst>
                    <a:ext uri="{FF2B5EF4-FFF2-40B4-BE49-F238E27FC236}">
                      <a16:creationId xmlns:a16="http://schemas.microsoft.com/office/drawing/2014/main" id="{E77A11C9-718F-0743-E009-526F508ABB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4DFF09B6-5300-18D5-8D97-26364E1314E0}"/>
                  </a:ext>
                </a:extLst>
              </p:cNvPr>
              <p:cNvSpPr txBox="1"/>
              <p:nvPr/>
            </p:nvSpPr>
            <p:spPr>
              <a:xfrm>
                <a:off x="7315908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911FBB34-F6DA-3779-34A7-5E4DB663F892}"/>
                  </a:ext>
                </a:extLst>
              </p:cNvPr>
              <p:cNvSpPr txBox="1"/>
              <p:nvPr/>
            </p:nvSpPr>
            <p:spPr>
              <a:xfrm>
                <a:off x="8360447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FDAEB116-47EE-C845-65E6-651DF434A696}"/>
                  </a:ext>
                </a:extLst>
              </p:cNvPr>
              <p:cNvSpPr txBox="1"/>
              <p:nvPr/>
            </p:nvSpPr>
            <p:spPr>
              <a:xfrm>
                <a:off x="10449524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id="{73317B78-8021-CCC0-3AA1-67DB11CD4159}"/>
                  </a:ext>
                </a:extLst>
              </p:cNvPr>
              <p:cNvSpPr txBox="1"/>
              <p:nvPr/>
            </p:nvSpPr>
            <p:spPr>
              <a:xfrm>
                <a:off x="9404986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6E14ACF6-AA47-7BA7-9851-59F5CF5AF153}"/>
                  </a:ext>
                </a:extLst>
              </p:cNvPr>
              <p:cNvSpPr txBox="1"/>
              <p:nvPr/>
            </p:nvSpPr>
            <p:spPr>
              <a:xfrm rot="16200000">
                <a:off x="5714007" y="1857309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F40FD17D-EF94-E95C-F4E2-E468924DC3C4}"/>
                  </a:ext>
                </a:extLst>
              </p:cNvPr>
              <p:cNvSpPr txBox="1"/>
              <p:nvPr/>
            </p:nvSpPr>
            <p:spPr>
              <a:xfrm>
                <a:off x="8218214" y="3396236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48" name="Freeform 56">
              <a:extLst>
                <a:ext uri="{FF2B5EF4-FFF2-40B4-BE49-F238E27FC236}">
                  <a16:creationId xmlns:a16="http://schemas.microsoft.com/office/drawing/2014/main" id="{321E7B85-FBF5-E988-16CE-FC4BE591A153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9377" y="2648262"/>
              <a:ext cx="2952280" cy="342967"/>
            </a:xfrm>
            <a:custGeom>
              <a:avLst/>
              <a:gdLst>
                <a:gd name="T0" fmla="*/ 138 w 1567"/>
                <a:gd name="T1" fmla="*/ 180 h 185"/>
                <a:gd name="T2" fmla="*/ 213 w 1567"/>
                <a:gd name="T3" fmla="*/ 180 h 185"/>
                <a:gd name="T4" fmla="*/ 228 w 1567"/>
                <a:gd name="T5" fmla="*/ 175 h 185"/>
                <a:gd name="T6" fmla="*/ 285 w 1567"/>
                <a:gd name="T7" fmla="*/ 170 h 185"/>
                <a:gd name="T8" fmla="*/ 322 w 1567"/>
                <a:gd name="T9" fmla="*/ 159 h 185"/>
                <a:gd name="T10" fmla="*/ 342 w 1567"/>
                <a:gd name="T11" fmla="*/ 154 h 185"/>
                <a:gd name="T12" fmla="*/ 358 w 1567"/>
                <a:gd name="T13" fmla="*/ 149 h 185"/>
                <a:gd name="T14" fmla="*/ 383 w 1567"/>
                <a:gd name="T15" fmla="*/ 144 h 185"/>
                <a:gd name="T16" fmla="*/ 407 w 1567"/>
                <a:gd name="T17" fmla="*/ 144 h 185"/>
                <a:gd name="T18" fmla="*/ 419 w 1567"/>
                <a:gd name="T19" fmla="*/ 139 h 185"/>
                <a:gd name="T20" fmla="*/ 445 w 1567"/>
                <a:gd name="T21" fmla="*/ 139 h 185"/>
                <a:gd name="T22" fmla="*/ 457 w 1567"/>
                <a:gd name="T23" fmla="*/ 133 h 185"/>
                <a:gd name="T24" fmla="*/ 479 w 1567"/>
                <a:gd name="T25" fmla="*/ 123 h 185"/>
                <a:gd name="T26" fmla="*/ 484 w 1567"/>
                <a:gd name="T27" fmla="*/ 112 h 185"/>
                <a:gd name="T28" fmla="*/ 509 w 1567"/>
                <a:gd name="T29" fmla="*/ 112 h 185"/>
                <a:gd name="T30" fmla="*/ 528 w 1567"/>
                <a:gd name="T31" fmla="*/ 107 h 185"/>
                <a:gd name="T32" fmla="*/ 543 w 1567"/>
                <a:gd name="T33" fmla="*/ 101 h 185"/>
                <a:gd name="T34" fmla="*/ 564 w 1567"/>
                <a:gd name="T35" fmla="*/ 101 h 185"/>
                <a:gd name="T36" fmla="*/ 582 w 1567"/>
                <a:gd name="T37" fmla="*/ 101 h 185"/>
                <a:gd name="T38" fmla="*/ 595 w 1567"/>
                <a:gd name="T39" fmla="*/ 95 h 185"/>
                <a:gd name="T40" fmla="*/ 613 w 1567"/>
                <a:gd name="T41" fmla="*/ 95 h 185"/>
                <a:gd name="T42" fmla="*/ 626 w 1567"/>
                <a:gd name="T43" fmla="*/ 89 h 185"/>
                <a:gd name="T44" fmla="*/ 642 w 1567"/>
                <a:gd name="T45" fmla="*/ 89 h 185"/>
                <a:gd name="T46" fmla="*/ 660 w 1567"/>
                <a:gd name="T47" fmla="*/ 89 h 185"/>
                <a:gd name="T48" fmla="*/ 672 w 1567"/>
                <a:gd name="T49" fmla="*/ 82 h 185"/>
                <a:gd name="T50" fmla="*/ 678 w 1567"/>
                <a:gd name="T51" fmla="*/ 67 h 185"/>
                <a:gd name="T52" fmla="*/ 695 w 1567"/>
                <a:gd name="T53" fmla="*/ 67 h 185"/>
                <a:gd name="T54" fmla="*/ 714 w 1567"/>
                <a:gd name="T55" fmla="*/ 67 h 185"/>
                <a:gd name="T56" fmla="*/ 731 w 1567"/>
                <a:gd name="T57" fmla="*/ 67 h 185"/>
                <a:gd name="T58" fmla="*/ 744 w 1567"/>
                <a:gd name="T59" fmla="*/ 58 h 185"/>
                <a:gd name="T60" fmla="*/ 761 w 1567"/>
                <a:gd name="T61" fmla="*/ 58 h 185"/>
                <a:gd name="T62" fmla="*/ 781 w 1567"/>
                <a:gd name="T63" fmla="*/ 58 h 185"/>
                <a:gd name="T64" fmla="*/ 800 w 1567"/>
                <a:gd name="T65" fmla="*/ 58 h 185"/>
                <a:gd name="T66" fmla="*/ 823 w 1567"/>
                <a:gd name="T67" fmla="*/ 58 h 185"/>
                <a:gd name="T68" fmla="*/ 835 w 1567"/>
                <a:gd name="T69" fmla="*/ 42 h 185"/>
                <a:gd name="T70" fmla="*/ 847 w 1567"/>
                <a:gd name="T71" fmla="*/ 24 h 185"/>
                <a:gd name="T72" fmla="*/ 864 w 1567"/>
                <a:gd name="T73" fmla="*/ 24 h 185"/>
                <a:gd name="T74" fmla="*/ 878 w 1567"/>
                <a:gd name="T75" fmla="*/ 0 h 185"/>
                <a:gd name="T76" fmla="*/ 898 w 1567"/>
                <a:gd name="T77" fmla="*/ 0 h 185"/>
                <a:gd name="T78" fmla="*/ 913 w 1567"/>
                <a:gd name="T79" fmla="*/ 0 h 185"/>
                <a:gd name="T80" fmla="*/ 932 w 1567"/>
                <a:gd name="T81" fmla="*/ 0 h 185"/>
                <a:gd name="T82" fmla="*/ 963 w 1567"/>
                <a:gd name="T83" fmla="*/ 0 h 185"/>
                <a:gd name="T84" fmla="*/ 994 w 1567"/>
                <a:gd name="T85" fmla="*/ 0 h 185"/>
                <a:gd name="T86" fmla="*/ 1024 w 1567"/>
                <a:gd name="T87" fmla="*/ 0 h 185"/>
                <a:gd name="T88" fmla="*/ 1047 w 1567"/>
                <a:gd name="T89" fmla="*/ 0 h 185"/>
                <a:gd name="T90" fmla="*/ 1103 w 1567"/>
                <a:gd name="T91" fmla="*/ 0 h 185"/>
                <a:gd name="T92" fmla="*/ 1139 w 1567"/>
                <a:gd name="T93" fmla="*/ 0 h 185"/>
                <a:gd name="T94" fmla="*/ 1164 w 1567"/>
                <a:gd name="T95" fmla="*/ 0 h 185"/>
                <a:gd name="T96" fmla="*/ 1180 w 1567"/>
                <a:gd name="T97" fmla="*/ 0 h 185"/>
                <a:gd name="T98" fmla="*/ 1225 w 1567"/>
                <a:gd name="T99" fmla="*/ 0 h 185"/>
                <a:gd name="T100" fmla="*/ 1543 w 1567"/>
                <a:gd name="T101" fmla="*/ 0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567" h="185">
                  <a:moveTo>
                    <a:pt x="0" y="185"/>
                  </a:moveTo>
                  <a:lnTo>
                    <a:pt x="138" y="185"/>
                  </a:lnTo>
                  <a:lnTo>
                    <a:pt x="138" y="180"/>
                  </a:lnTo>
                  <a:lnTo>
                    <a:pt x="167" y="180"/>
                  </a:lnTo>
                  <a:lnTo>
                    <a:pt x="193" y="180"/>
                  </a:lnTo>
                  <a:lnTo>
                    <a:pt x="213" y="180"/>
                  </a:lnTo>
                  <a:lnTo>
                    <a:pt x="216" y="180"/>
                  </a:lnTo>
                  <a:lnTo>
                    <a:pt x="216" y="175"/>
                  </a:lnTo>
                  <a:lnTo>
                    <a:pt x="228" y="175"/>
                  </a:lnTo>
                  <a:lnTo>
                    <a:pt x="254" y="175"/>
                  </a:lnTo>
                  <a:lnTo>
                    <a:pt x="254" y="170"/>
                  </a:lnTo>
                  <a:lnTo>
                    <a:pt x="285" y="170"/>
                  </a:lnTo>
                  <a:lnTo>
                    <a:pt x="288" y="165"/>
                  </a:lnTo>
                  <a:lnTo>
                    <a:pt x="322" y="165"/>
                  </a:lnTo>
                  <a:lnTo>
                    <a:pt x="322" y="159"/>
                  </a:lnTo>
                  <a:lnTo>
                    <a:pt x="325" y="159"/>
                  </a:lnTo>
                  <a:lnTo>
                    <a:pt x="342" y="159"/>
                  </a:lnTo>
                  <a:lnTo>
                    <a:pt x="342" y="154"/>
                  </a:lnTo>
                  <a:lnTo>
                    <a:pt x="349" y="154"/>
                  </a:lnTo>
                  <a:lnTo>
                    <a:pt x="349" y="149"/>
                  </a:lnTo>
                  <a:lnTo>
                    <a:pt x="358" y="149"/>
                  </a:lnTo>
                  <a:lnTo>
                    <a:pt x="378" y="149"/>
                  </a:lnTo>
                  <a:lnTo>
                    <a:pt x="378" y="144"/>
                  </a:lnTo>
                  <a:lnTo>
                    <a:pt x="383" y="144"/>
                  </a:lnTo>
                  <a:lnTo>
                    <a:pt x="400" y="144"/>
                  </a:lnTo>
                  <a:lnTo>
                    <a:pt x="405" y="144"/>
                  </a:lnTo>
                  <a:lnTo>
                    <a:pt x="407" y="144"/>
                  </a:lnTo>
                  <a:lnTo>
                    <a:pt x="417" y="144"/>
                  </a:lnTo>
                  <a:lnTo>
                    <a:pt x="417" y="139"/>
                  </a:lnTo>
                  <a:lnTo>
                    <a:pt x="419" y="139"/>
                  </a:lnTo>
                  <a:lnTo>
                    <a:pt x="428" y="139"/>
                  </a:lnTo>
                  <a:lnTo>
                    <a:pt x="441" y="139"/>
                  </a:lnTo>
                  <a:lnTo>
                    <a:pt x="445" y="139"/>
                  </a:lnTo>
                  <a:lnTo>
                    <a:pt x="450" y="139"/>
                  </a:lnTo>
                  <a:lnTo>
                    <a:pt x="450" y="133"/>
                  </a:lnTo>
                  <a:lnTo>
                    <a:pt x="457" y="133"/>
                  </a:lnTo>
                  <a:lnTo>
                    <a:pt x="464" y="128"/>
                  </a:lnTo>
                  <a:lnTo>
                    <a:pt x="479" y="128"/>
                  </a:lnTo>
                  <a:lnTo>
                    <a:pt x="479" y="123"/>
                  </a:lnTo>
                  <a:lnTo>
                    <a:pt x="481" y="118"/>
                  </a:lnTo>
                  <a:lnTo>
                    <a:pt x="484" y="112"/>
                  </a:lnTo>
                  <a:lnTo>
                    <a:pt x="484" y="112"/>
                  </a:lnTo>
                  <a:lnTo>
                    <a:pt x="494" y="112"/>
                  </a:lnTo>
                  <a:lnTo>
                    <a:pt x="502" y="112"/>
                  </a:lnTo>
                  <a:lnTo>
                    <a:pt x="509" y="112"/>
                  </a:lnTo>
                  <a:lnTo>
                    <a:pt x="521" y="112"/>
                  </a:lnTo>
                  <a:lnTo>
                    <a:pt x="522" y="107"/>
                  </a:lnTo>
                  <a:lnTo>
                    <a:pt x="528" y="107"/>
                  </a:lnTo>
                  <a:lnTo>
                    <a:pt x="534" y="107"/>
                  </a:lnTo>
                  <a:lnTo>
                    <a:pt x="536" y="101"/>
                  </a:lnTo>
                  <a:lnTo>
                    <a:pt x="543" y="101"/>
                  </a:lnTo>
                  <a:lnTo>
                    <a:pt x="549" y="101"/>
                  </a:lnTo>
                  <a:lnTo>
                    <a:pt x="552" y="101"/>
                  </a:lnTo>
                  <a:lnTo>
                    <a:pt x="564" y="101"/>
                  </a:lnTo>
                  <a:lnTo>
                    <a:pt x="573" y="101"/>
                  </a:lnTo>
                  <a:lnTo>
                    <a:pt x="576" y="101"/>
                  </a:lnTo>
                  <a:lnTo>
                    <a:pt x="582" y="101"/>
                  </a:lnTo>
                  <a:lnTo>
                    <a:pt x="590" y="101"/>
                  </a:lnTo>
                  <a:lnTo>
                    <a:pt x="593" y="101"/>
                  </a:lnTo>
                  <a:lnTo>
                    <a:pt x="595" y="95"/>
                  </a:lnTo>
                  <a:lnTo>
                    <a:pt x="601" y="95"/>
                  </a:lnTo>
                  <a:lnTo>
                    <a:pt x="606" y="95"/>
                  </a:lnTo>
                  <a:lnTo>
                    <a:pt x="613" y="95"/>
                  </a:lnTo>
                  <a:lnTo>
                    <a:pt x="618" y="95"/>
                  </a:lnTo>
                  <a:lnTo>
                    <a:pt x="625" y="95"/>
                  </a:lnTo>
                  <a:lnTo>
                    <a:pt x="626" y="89"/>
                  </a:lnTo>
                  <a:lnTo>
                    <a:pt x="629" y="89"/>
                  </a:lnTo>
                  <a:lnTo>
                    <a:pt x="636" y="89"/>
                  </a:lnTo>
                  <a:lnTo>
                    <a:pt x="642" y="89"/>
                  </a:lnTo>
                  <a:lnTo>
                    <a:pt x="651" y="89"/>
                  </a:lnTo>
                  <a:lnTo>
                    <a:pt x="654" y="89"/>
                  </a:lnTo>
                  <a:lnTo>
                    <a:pt x="660" y="89"/>
                  </a:lnTo>
                  <a:lnTo>
                    <a:pt x="664" y="82"/>
                  </a:lnTo>
                  <a:lnTo>
                    <a:pt x="669" y="82"/>
                  </a:lnTo>
                  <a:lnTo>
                    <a:pt x="672" y="82"/>
                  </a:lnTo>
                  <a:lnTo>
                    <a:pt x="674" y="75"/>
                  </a:lnTo>
                  <a:lnTo>
                    <a:pt x="675" y="67"/>
                  </a:lnTo>
                  <a:lnTo>
                    <a:pt x="678" y="67"/>
                  </a:lnTo>
                  <a:lnTo>
                    <a:pt x="684" y="67"/>
                  </a:lnTo>
                  <a:lnTo>
                    <a:pt x="690" y="67"/>
                  </a:lnTo>
                  <a:lnTo>
                    <a:pt x="695" y="67"/>
                  </a:lnTo>
                  <a:lnTo>
                    <a:pt x="701" y="67"/>
                  </a:lnTo>
                  <a:lnTo>
                    <a:pt x="708" y="67"/>
                  </a:lnTo>
                  <a:lnTo>
                    <a:pt x="714" y="67"/>
                  </a:lnTo>
                  <a:lnTo>
                    <a:pt x="723" y="67"/>
                  </a:lnTo>
                  <a:lnTo>
                    <a:pt x="727" y="67"/>
                  </a:lnTo>
                  <a:lnTo>
                    <a:pt x="731" y="67"/>
                  </a:lnTo>
                  <a:lnTo>
                    <a:pt x="737" y="67"/>
                  </a:lnTo>
                  <a:lnTo>
                    <a:pt x="738" y="58"/>
                  </a:lnTo>
                  <a:lnTo>
                    <a:pt x="744" y="58"/>
                  </a:lnTo>
                  <a:lnTo>
                    <a:pt x="751" y="58"/>
                  </a:lnTo>
                  <a:lnTo>
                    <a:pt x="756" y="58"/>
                  </a:lnTo>
                  <a:lnTo>
                    <a:pt x="761" y="58"/>
                  </a:lnTo>
                  <a:lnTo>
                    <a:pt x="768" y="58"/>
                  </a:lnTo>
                  <a:lnTo>
                    <a:pt x="774" y="58"/>
                  </a:lnTo>
                  <a:lnTo>
                    <a:pt x="781" y="58"/>
                  </a:lnTo>
                  <a:lnTo>
                    <a:pt x="786" y="58"/>
                  </a:lnTo>
                  <a:lnTo>
                    <a:pt x="794" y="58"/>
                  </a:lnTo>
                  <a:lnTo>
                    <a:pt x="800" y="58"/>
                  </a:lnTo>
                  <a:lnTo>
                    <a:pt x="804" y="58"/>
                  </a:lnTo>
                  <a:lnTo>
                    <a:pt x="816" y="58"/>
                  </a:lnTo>
                  <a:lnTo>
                    <a:pt x="823" y="58"/>
                  </a:lnTo>
                  <a:lnTo>
                    <a:pt x="824" y="42"/>
                  </a:lnTo>
                  <a:lnTo>
                    <a:pt x="829" y="42"/>
                  </a:lnTo>
                  <a:lnTo>
                    <a:pt x="835" y="42"/>
                  </a:lnTo>
                  <a:lnTo>
                    <a:pt x="841" y="42"/>
                  </a:lnTo>
                  <a:lnTo>
                    <a:pt x="844" y="24"/>
                  </a:lnTo>
                  <a:lnTo>
                    <a:pt x="847" y="24"/>
                  </a:lnTo>
                  <a:lnTo>
                    <a:pt x="853" y="24"/>
                  </a:lnTo>
                  <a:lnTo>
                    <a:pt x="860" y="24"/>
                  </a:lnTo>
                  <a:lnTo>
                    <a:pt x="864" y="24"/>
                  </a:lnTo>
                  <a:lnTo>
                    <a:pt x="870" y="24"/>
                  </a:lnTo>
                  <a:lnTo>
                    <a:pt x="870" y="0"/>
                  </a:lnTo>
                  <a:lnTo>
                    <a:pt x="878" y="0"/>
                  </a:lnTo>
                  <a:lnTo>
                    <a:pt x="882" y="0"/>
                  </a:lnTo>
                  <a:lnTo>
                    <a:pt x="888" y="0"/>
                  </a:lnTo>
                  <a:lnTo>
                    <a:pt x="898" y="0"/>
                  </a:lnTo>
                  <a:lnTo>
                    <a:pt x="900" y="0"/>
                  </a:lnTo>
                  <a:lnTo>
                    <a:pt x="906" y="0"/>
                  </a:lnTo>
                  <a:lnTo>
                    <a:pt x="913" y="0"/>
                  </a:lnTo>
                  <a:lnTo>
                    <a:pt x="924" y="0"/>
                  </a:lnTo>
                  <a:lnTo>
                    <a:pt x="927" y="0"/>
                  </a:lnTo>
                  <a:lnTo>
                    <a:pt x="932" y="0"/>
                  </a:lnTo>
                  <a:lnTo>
                    <a:pt x="942" y="0"/>
                  </a:lnTo>
                  <a:lnTo>
                    <a:pt x="951" y="0"/>
                  </a:lnTo>
                  <a:lnTo>
                    <a:pt x="963" y="0"/>
                  </a:lnTo>
                  <a:lnTo>
                    <a:pt x="971" y="0"/>
                  </a:lnTo>
                  <a:lnTo>
                    <a:pt x="974" y="0"/>
                  </a:lnTo>
                  <a:lnTo>
                    <a:pt x="994" y="0"/>
                  </a:lnTo>
                  <a:lnTo>
                    <a:pt x="999" y="0"/>
                  </a:lnTo>
                  <a:lnTo>
                    <a:pt x="1014" y="0"/>
                  </a:lnTo>
                  <a:lnTo>
                    <a:pt x="1024" y="0"/>
                  </a:lnTo>
                  <a:lnTo>
                    <a:pt x="1028" y="0"/>
                  </a:lnTo>
                  <a:lnTo>
                    <a:pt x="1041" y="0"/>
                  </a:lnTo>
                  <a:lnTo>
                    <a:pt x="1047" y="0"/>
                  </a:lnTo>
                  <a:lnTo>
                    <a:pt x="1062" y="0"/>
                  </a:lnTo>
                  <a:lnTo>
                    <a:pt x="1063" y="0"/>
                  </a:lnTo>
                  <a:lnTo>
                    <a:pt x="1103" y="0"/>
                  </a:lnTo>
                  <a:lnTo>
                    <a:pt x="1106" y="0"/>
                  </a:lnTo>
                  <a:lnTo>
                    <a:pt x="1121" y="0"/>
                  </a:lnTo>
                  <a:lnTo>
                    <a:pt x="1139" y="0"/>
                  </a:lnTo>
                  <a:lnTo>
                    <a:pt x="1141" y="0"/>
                  </a:lnTo>
                  <a:lnTo>
                    <a:pt x="1150" y="0"/>
                  </a:lnTo>
                  <a:lnTo>
                    <a:pt x="1164" y="0"/>
                  </a:lnTo>
                  <a:lnTo>
                    <a:pt x="1166" y="0"/>
                  </a:lnTo>
                  <a:lnTo>
                    <a:pt x="1171" y="0"/>
                  </a:lnTo>
                  <a:lnTo>
                    <a:pt x="1180" y="0"/>
                  </a:lnTo>
                  <a:lnTo>
                    <a:pt x="1193" y="0"/>
                  </a:lnTo>
                  <a:lnTo>
                    <a:pt x="1203" y="0"/>
                  </a:lnTo>
                  <a:lnTo>
                    <a:pt x="1225" y="0"/>
                  </a:lnTo>
                  <a:lnTo>
                    <a:pt x="1245" y="0"/>
                  </a:lnTo>
                  <a:lnTo>
                    <a:pt x="1312" y="0"/>
                  </a:lnTo>
                  <a:lnTo>
                    <a:pt x="1543" y="0"/>
                  </a:lnTo>
                  <a:lnTo>
                    <a:pt x="1567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Freeform 57">
              <a:extLst>
                <a:ext uri="{FF2B5EF4-FFF2-40B4-BE49-F238E27FC236}">
                  <a16:creationId xmlns:a16="http://schemas.microsoft.com/office/drawing/2014/main" id="{73F9E932-65CA-CABD-27F4-BDB681ED3CD9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9377" y="2991229"/>
              <a:ext cx="1998959" cy="0"/>
            </a:xfrm>
            <a:custGeom>
              <a:avLst/>
              <a:gdLst>
                <a:gd name="T0" fmla="*/ 165 w 1061"/>
                <a:gd name="T1" fmla="*/ 282 w 1061"/>
                <a:gd name="T2" fmla="*/ 351 w 1061"/>
                <a:gd name="T3" fmla="*/ 389 w 1061"/>
                <a:gd name="T4" fmla="*/ 403 w 1061"/>
                <a:gd name="T5" fmla="*/ 419 w 1061"/>
                <a:gd name="T6" fmla="*/ 448 w 1061"/>
                <a:gd name="T7" fmla="*/ 464 w 1061"/>
                <a:gd name="T8" fmla="*/ 478 w 1061"/>
                <a:gd name="T9" fmla="*/ 494 w 1061"/>
                <a:gd name="T10" fmla="*/ 510 w 1061"/>
                <a:gd name="T11" fmla="*/ 543 w 1061"/>
                <a:gd name="T12" fmla="*/ 556 w 1061"/>
                <a:gd name="T13" fmla="*/ 577 w 1061"/>
                <a:gd name="T14" fmla="*/ 592 w 1061"/>
                <a:gd name="T15" fmla="*/ 600 w 1061"/>
                <a:gd name="T16" fmla="*/ 612 w 1061"/>
                <a:gd name="T17" fmla="*/ 623 w 1061"/>
                <a:gd name="T18" fmla="*/ 636 w 1061"/>
                <a:gd name="T19" fmla="*/ 648 w 1061"/>
                <a:gd name="T20" fmla="*/ 660 w 1061"/>
                <a:gd name="T21" fmla="*/ 672 w 1061"/>
                <a:gd name="T22" fmla="*/ 692 w 1061"/>
                <a:gd name="T23" fmla="*/ 702 w 1061"/>
                <a:gd name="T24" fmla="*/ 718 w 1061"/>
                <a:gd name="T25" fmla="*/ 726 w 1061"/>
                <a:gd name="T26" fmla="*/ 740 w 1061"/>
                <a:gd name="T27" fmla="*/ 751 w 1061"/>
                <a:gd name="T28" fmla="*/ 763 w 1061"/>
                <a:gd name="T29" fmla="*/ 774 w 1061"/>
                <a:gd name="T30" fmla="*/ 788 w 1061"/>
                <a:gd name="T31" fmla="*/ 800 w 1061"/>
                <a:gd name="T32" fmla="*/ 829 w 1061"/>
                <a:gd name="T33" fmla="*/ 841 w 1061"/>
                <a:gd name="T34" fmla="*/ 852 w 1061"/>
                <a:gd name="T35" fmla="*/ 883 w 1061"/>
                <a:gd name="T36" fmla="*/ 897 w 1061"/>
                <a:gd name="T37" fmla="*/ 908 w 1061"/>
                <a:gd name="T38" fmla="*/ 933 w 1061"/>
                <a:gd name="T39" fmla="*/ 966 w 1061"/>
                <a:gd name="T40" fmla="*/ 991 w 1061"/>
                <a:gd name="T41" fmla="*/ 1061 w 106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</a:cxnLst>
              <a:rect l="0" t="0" r="r" b="b"/>
              <a:pathLst>
                <a:path w="1061">
                  <a:moveTo>
                    <a:pt x="0" y="0"/>
                  </a:moveTo>
                  <a:lnTo>
                    <a:pt x="165" y="0"/>
                  </a:lnTo>
                  <a:lnTo>
                    <a:pt x="259" y="0"/>
                  </a:lnTo>
                  <a:lnTo>
                    <a:pt x="282" y="0"/>
                  </a:lnTo>
                  <a:lnTo>
                    <a:pt x="303" y="0"/>
                  </a:lnTo>
                  <a:lnTo>
                    <a:pt x="351" y="0"/>
                  </a:lnTo>
                  <a:lnTo>
                    <a:pt x="353" y="0"/>
                  </a:lnTo>
                  <a:lnTo>
                    <a:pt x="389" y="0"/>
                  </a:lnTo>
                  <a:lnTo>
                    <a:pt x="400" y="0"/>
                  </a:lnTo>
                  <a:lnTo>
                    <a:pt x="403" y="0"/>
                  </a:lnTo>
                  <a:lnTo>
                    <a:pt x="408" y="0"/>
                  </a:lnTo>
                  <a:lnTo>
                    <a:pt x="419" y="0"/>
                  </a:lnTo>
                  <a:lnTo>
                    <a:pt x="425" y="0"/>
                  </a:lnTo>
                  <a:lnTo>
                    <a:pt x="448" y="0"/>
                  </a:lnTo>
                  <a:lnTo>
                    <a:pt x="454" y="0"/>
                  </a:lnTo>
                  <a:lnTo>
                    <a:pt x="464" y="0"/>
                  </a:lnTo>
                  <a:lnTo>
                    <a:pt x="467" y="0"/>
                  </a:lnTo>
                  <a:lnTo>
                    <a:pt x="478" y="0"/>
                  </a:lnTo>
                  <a:lnTo>
                    <a:pt x="484" y="0"/>
                  </a:lnTo>
                  <a:lnTo>
                    <a:pt x="494" y="0"/>
                  </a:lnTo>
                  <a:lnTo>
                    <a:pt x="498" y="0"/>
                  </a:lnTo>
                  <a:lnTo>
                    <a:pt x="510" y="0"/>
                  </a:lnTo>
                  <a:lnTo>
                    <a:pt x="518" y="0"/>
                  </a:lnTo>
                  <a:lnTo>
                    <a:pt x="543" y="0"/>
                  </a:lnTo>
                  <a:lnTo>
                    <a:pt x="545" y="0"/>
                  </a:lnTo>
                  <a:lnTo>
                    <a:pt x="556" y="0"/>
                  </a:lnTo>
                  <a:lnTo>
                    <a:pt x="565" y="0"/>
                  </a:lnTo>
                  <a:lnTo>
                    <a:pt x="577" y="0"/>
                  </a:lnTo>
                  <a:lnTo>
                    <a:pt x="582" y="0"/>
                  </a:lnTo>
                  <a:lnTo>
                    <a:pt x="592" y="0"/>
                  </a:lnTo>
                  <a:lnTo>
                    <a:pt x="594" y="0"/>
                  </a:lnTo>
                  <a:lnTo>
                    <a:pt x="600" y="0"/>
                  </a:lnTo>
                  <a:lnTo>
                    <a:pt x="607" y="0"/>
                  </a:lnTo>
                  <a:lnTo>
                    <a:pt x="612" y="0"/>
                  </a:lnTo>
                  <a:lnTo>
                    <a:pt x="622" y="0"/>
                  </a:lnTo>
                  <a:lnTo>
                    <a:pt x="623" y="0"/>
                  </a:lnTo>
                  <a:lnTo>
                    <a:pt x="631" y="0"/>
                  </a:lnTo>
                  <a:lnTo>
                    <a:pt x="636" y="0"/>
                  </a:lnTo>
                  <a:lnTo>
                    <a:pt x="643" y="0"/>
                  </a:lnTo>
                  <a:lnTo>
                    <a:pt x="648" y="0"/>
                  </a:lnTo>
                  <a:lnTo>
                    <a:pt x="654" y="0"/>
                  </a:lnTo>
                  <a:lnTo>
                    <a:pt x="660" y="0"/>
                  </a:lnTo>
                  <a:lnTo>
                    <a:pt x="667" y="0"/>
                  </a:lnTo>
                  <a:lnTo>
                    <a:pt x="672" y="0"/>
                  </a:lnTo>
                  <a:lnTo>
                    <a:pt x="680" y="0"/>
                  </a:lnTo>
                  <a:lnTo>
                    <a:pt x="692" y="0"/>
                  </a:lnTo>
                  <a:lnTo>
                    <a:pt x="695" y="0"/>
                  </a:lnTo>
                  <a:lnTo>
                    <a:pt x="702" y="0"/>
                  </a:lnTo>
                  <a:lnTo>
                    <a:pt x="711" y="0"/>
                  </a:lnTo>
                  <a:lnTo>
                    <a:pt x="718" y="0"/>
                  </a:lnTo>
                  <a:lnTo>
                    <a:pt x="721" y="0"/>
                  </a:lnTo>
                  <a:lnTo>
                    <a:pt x="726" y="0"/>
                  </a:lnTo>
                  <a:lnTo>
                    <a:pt x="732" y="0"/>
                  </a:lnTo>
                  <a:lnTo>
                    <a:pt x="740" y="0"/>
                  </a:lnTo>
                  <a:lnTo>
                    <a:pt x="747" y="0"/>
                  </a:lnTo>
                  <a:lnTo>
                    <a:pt x="751" y="0"/>
                  </a:lnTo>
                  <a:lnTo>
                    <a:pt x="759" y="0"/>
                  </a:lnTo>
                  <a:lnTo>
                    <a:pt x="763" y="0"/>
                  </a:lnTo>
                  <a:lnTo>
                    <a:pt x="768" y="0"/>
                  </a:lnTo>
                  <a:lnTo>
                    <a:pt x="774" y="0"/>
                  </a:lnTo>
                  <a:lnTo>
                    <a:pt x="783" y="0"/>
                  </a:lnTo>
                  <a:lnTo>
                    <a:pt x="788" y="0"/>
                  </a:lnTo>
                  <a:lnTo>
                    <a:pt x="794" y="0"/>
                  </a:lnTo>
                  <a:lnTo>
                    <a:pt x="800" y="0"/>
                  </a:lnTo>
                  <a:lnTo>
                    <a:pt x="804" y="0"/>
                  </a:lnTo>
                  <a:lnTo>
                    <a:pt x="829" y="0"/>
                  </a:lnTo>
                  <a:lnTo>
                    <a:pt x="836" y="0"/>
                  </a:lnTo>
                  <a:lnTo>
                    <a:pt x="841" y="0"/>
                  </a:lnTo>
                  <a:lnTo>
                    <a:pt x="846" y="0"/>
                  </a:lnTo>
                  <a:lnTo>
                    <a:pt x="852" y="0"/>
                  </a:lnTo>
                  <a:lnTo>
                    <a:pt x="880" y="0"/>
                  </a:lnTo>
                  <a:lnTo>
                    <a:pt x="883" y="0"/>
                  </a:lnTo>
                  <a:lnTo>
                    <a:pt x="890" y="0"/>
                  </a:lnTo>
                  <a:lnTo>
                    <a:pt x="897" y="0"/>
                  </a:lnTo>
                  <a:lnTo>
                    <a:pt x="902" y="0"/>
                  </a:lnTo>
                  <a:lnTo>
                    <a:pt x="908" y="0"/>
                  </a:lnTo>
                  <a:lnTo>
                    <a:pt x="917" y="0"/>
                  </a:lnTo>
                  <a:lnTo>
                    <a:pt x="933" y="0"/>
                  </a:lnTo>
                  <a:lnTo>
                    <a:pt x="955" y="0"/>
                  </a:lnTo>
                  <a:lnTo>
                    <a:pt x="966" y="0"/>
                  </a:lnTo>
                  <a:lnTo>
                    <a:pt x="975" y="0"/>
                  </a:lnTo>
                  <a:lnTo>
                    <a:pt x="991" y="0"/>
                  </a:lnTo>
                  <a:lnTo>
                    <a:pt x="1020" y="0"/>
                  </a:lnTo>
                  <a:lnTo>
                    <a:pt x="1061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Freeform 58">
              <a:extLst>
                <a:ext uri="{FF2B5EF4-FFF2-40B4-BE49-F238E27FC236}">
                  <a16:creationId xmlns:a16="http://schemas.microsoft.com/office/drawing/2014/main" id="{A3DD5FC9-6876-6C69-DDE8-B7144496F566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9377" y="2155131"/>
              <a:ext cx="2875034" cy="836098"/>
            </a:xfrm>
            <a:custGeom>
              <a:avLst/>
              <a:gdLst>
                <a:gd name="T0" fmla="*/ 191 w 1526"/>
                <a:gd name="T1" fmla="*/ 451 h 451"/>
                <a:gd name="T2" fmla="*/ 308 w 1526"/>
                <a:gd name="T3" fmla="*/ 451 h 451"/>
                <a:gd name="T4" fmla="*/ 345 w 1526"/>
                <a:gd name="T5" fmla="*/ 451 h 451"/>
                <a:gd name="T6" fmla="*/ 383 w 1526"/>
                <a:gd name="T7" fmla="*/ 451 h 451"/>
                <a:gd name="T8" fmla="*/ 402 w 1526"/>
                <a:gd name="T9" fmla="*/ 451 h 451"/>
                <a:gd name="T10" fmla="*/ 432 w 1526"/>
                <a:gd name="T11" fmla="*/ 451 h 451"/>
                <a:gd name="T12" fmla="*/ 450 w 1526"/>
                <a:gd name="T13" fmla="*/ 451 h 451"/>
                <a:gd name="T14" fmla="*/ 474 w 1526"/>
                <a:gd name="T15" fmla="*/ 451 h 451"/>
                <a:gd name="T16" fmla="*/ 493 w 1526"/>
                <a:gd name="T17" fmla="*/ 445 h 451"/>
                <a:gd name="T18" fmla="*/ 515 w 1526"/>
                <a:gd name="T19" fmla="*/ 445 h 451"/>
                <a:gd name="T20" fmla="*/ 542 w 1526"/>
                <a:gd name="T21" fmla="*/ 445 h 451"/>
                <a:gd name="T22" fmla="*/ 565 w 1526"/>
                <a:gd name="T23" fmla="*/ 445 h 451"/>
                <a:gd name="T24" fmla="*/ 582 w 1526"/>
                <a:gd name="T25" fmla="*/ 445 h 451"/>
                <a:gd name="T26" fmla="*/ 599 w 1526"/>
                <a:gd name="T27" fmla="*/ 445 h 451"/>
                <a:gd name="T28" fmla="*/ 618 w 1526"/>
                <a:gd name="T29" fmla="*/ 445 h 451"/>
                <a:gd name="T30" fmla="*/ 635 w 1526"/>
                <a:gd name="T31" fmla="*/ 445 h 451"/>
                <a:gd name="T32" fmla="*/ 649 w 1526"/>
                <a:gd name="T33" fmla="*/ 437 h 451"/>
                <a:gd name="T34" fmla="*/ 668 w 1526"/>
                <a:gd name="T35" fmla="*/ 437 h 451"/>
                <a:gd name="T36" fmla="*/ 683 w 1526"/>
                <a:gd name="T37" fmla="*/ 428 h 451"/>
                <a:gd name="T38" fmla="*/ 695 w 1526"/>
                <a:gd name="T39" fmla="*/ 428 h 451"/>
                <a:gd name="T40" fmla="*/ 717 w 1526"/>
                <a:gd name="T41" fmla="*/ 428 h 451"/>
                <a:gd name="T42" fmla="*/ 726 w 1526"/>
                <a:gd name="T43" fmla="*/ 419 h 451"/>
                <a:gd name="T44" fmla="*/ 744 w 1526"/>
                <a:gd name="T45" fmla="*/ 419 h 451"/>
                <a:gd name="T46" fmla="*/ 763 w 1526"/>
                <a:gd name="T47" fmla="*/ 419 h 451"/>
                <a:gd name="T48" fmla="*/ 774 w 1526"/>
                <a:gd name="T49" fmla="*/ 402 h 451"/>
                <a:gd name="T50" fmla="*/ 792 w 1526"/>
                <a:gd name="T51" fmla="*/ 402 h 451"/>
                <a:gd name="T52" fmla="*/ 810 w 1526"/>
                <a:gd name="T53" fmla="*/ 402 h 451"/>
                <a:gd name="T54" fmla="*/ 830 w 1526"/>
                <a:gd name="T55" fmla="*/ 402 h 451"/>
                <a:gd name="T56" fmla="*/ 846 w 1526"/>
                <a:gd name="T57" fmla="*/ 402 h 451"/>
                <a:gd name="T58" fmla="*/ 854 w 1526"/>
                <a:gd name="T59" fmla="*/ 344 h 451"/>
                <a:gd name="T60" fmla="*/ 870 w 1526"/>
                <a:gd name="T61" fmla="*/ 344 h 451"/>
                <a:gd name="T62" fmla="*/ 894 w 1526"/>
                <a:gd name="T63" fmla="*/ 344 h 451"/>
                <a:gd name="T64" fmla="*/ 913 w 1526"/>
                <a:gd name="T65" fmla="*/ 344 h 451"/>
                <a:gd name="T66" fmla="*/ 933 w 1526"/>
                <a:gd name="T67" fmla="*/ 344 h 451"/>
                <a:gd name="T68" fmla="*/ 960 w 1526"/>
                <a:gd name="T69" fmla="*/ 344 h 451"/>
                <a:gd name="T70" fmla="*/ 977 w 1526"/>
                <a:gd name="T71" fmla="*/ 344 h 451"/>
                <a:gd name="T72" fmla="*/ 999 w 1526"/>
                <a:gd name="T73" fmla="*/ 344 h 451"/>
                <a:gd name="T74" fmla="*/ 1017 w 1526"/>
                <a:gd name="T75" fmla="*/ 344 h 451"/>
                <a:gd name="T76" fmla="*/ 1106 w 1526"/>
                <a:gd name="T77" fmla="*/ 344 h 451"/>
                <a:gd name="T78" fmla="*/ 1172 w 1526"/>
                <a:gd name="T79" fmla="*/ 344 h 451"/>
                <a:gd name="T80" fmla="*/ 1237 w 1526"/>
                <a:gd name="T81" fmla="*/ 344 h 451"/>
                <a:gd name="T82" fmla="*/ 1300 w 1526"/>
                <a:gd name="T83" fmla="*/ 0 h 451"/>
                <a:gd name="T84" fmla="*/ 1387 w 1526"/>
                <a:gd name="T85" fmla="*/ 0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526" h="451">
                  <a:moveTo>
                    <a:pt x="0" y="451"/>
                  </a:moveTo>
                  <a:lnTo>
                    <a:pt x="166" y="451"/>
                  </a:lnTo>
                  <a:lnTo>
                    <a:pt x="191" y="451"/>
                  </a:lnTo>
                  <a:lnTo>
                    <a:pt x="290" y="451"/>
                  </a:lnTo>
                  <a:lnTo>
                    <a:pt x="299" y="451"/>
                  </a:lnTo>
                  <a:lnTo>
                    <a:pt x="308" y="451"/>
                  </a:lnTo>
                  <a:lnTo>
                    <a:pt x="315" y="451"/>
                  </a:lnTo>
                  <a:lnTo>
                    <a:pt x="317" y="451"/>
                  </a:lnTo>
                  <a:lnTo>
                    <a:pt x="345" y="451"/>
                  </a:lnTo>
                  <a:lnTo>
                    <a:pt x="354" y="451"/>
                  </a:lnTo>
                  <a:lnTo>
                    <a:pt x="365" y="451"/>
                  </a:lnTo>
                  <a:lnTo>
                    <a:pt x="383" y="451"/>
                  </a:lnTo>
                  <a:lnTo>
                    <a:pt x="393" y="451"/>
                  </a:lnTo>
                  <a:lnTo>
                    <a:pt x="398" y="451"/>
                  </a:lnTo>
                  <a:lnTo>
                    <a:pt x="402" y="451"/>
                  </a:lnTo>
                  <a:lnTo>
                    <a:pt x="408" y="451"/>
                  </a:lnTo>
                  <a:lnTo>
                    <a:pt x="420" y="451"/>
                  </a:lnTo>
                  <a:lnTo>
                    <a:pt x="432" y="451"/>
                  </a:lnTo>
                  <a:lnTo>
                    <a:pt x="439" y="451"/>
                  </a:lnTo>
                  <a:lnTo>
                    <a:pt x="448" y="451"/>
                  </a:lnTo>
                  <a:lnTo>
                    <a:pt x="450" y="451"/>
                  </a:lnTo>
                  <a:lnTo>
                    <a:pt x="458" y="451"/>
                  </a:lnTo>
                  <a:lnTo>
                    <a:pt x="467" y="451"/>
                  </a:lnTo>
                  <a:lnTo>
                    <a:pt x="474" y="451"/>
                  </a:lnTo>
                  <a:lnTo>
                    <a:pt x="474" y="445"/>
                  </a:lnTo>
                  <a:lnTo>
                    <a:pt x="484" y="445"/>
                  </a:lnTo>
                  <a:lnTo>
                    <a:pt x="493" y="445"/>
                  </a:lnTo>
                  <a:lnTo>
                    <a:pt x="500" y="445"/>
                  </a:lnTo>
                  <a:lnTo>
                    <a:pt x="510" y="445"/>
                  </a:lnTo>
                  <a:lnTo>
                    <a:pt x="515" y="445"/>
                  </a:lnTo>
                  <a:lnTo>
                    <a:pt x="528" y="445"/>
                  </a:lnTo>
                  <a:lnTo>
                    <a:pt x="537" y="445"/>
                  </a:lnTo>
                  <a:lnTo>
                    <a:pt x="542" y="445"/>
                  </a:lnTo>
                  <a:lnTo>
                    <a:pt x="546" y="445"/>
                  </a:lnTo>
                  <a:lnTo>
                    <a:pt x="557" y="445"/>
                  </a:lnTo>
                  <a:lnTo>
                    <a:pt x="565" y="445"/>
                  </a:lnTo>
                  <a:lnTo>
                    <a:pt x="571" y="445"/>
                  </a:lnTo>
                  <a:lnTo>
                    <a:pt x="575" y="445"/>
                  </a:lnTo>
                  <a:lnTo>
                    <a:pt x="582" y="445"/>
                  </a:lnTo>
                  <a:lnTo>
                    <a:pt x="587" y="445"/>
                  </a:lnTo>
                  <a:lnTo>
                    <a:pt x="593" y="445"/>
                  </a:lnTo>
                  <a:lnTo>
                    <a:pt x="599" y="445"/>
                  </a:lnTo>
                  <a:lnTo>
                    <a:pt x="606" y="445"/>
                  </a:lnTo>
                  <a:lnTo>
                    <a:pt x="615" y="445"/>
                  </a:lnTo>
                  <a:lnTo>
                    <a:pt x="618" y="445"/>
                  </a:lnTo>
                  <a:lnTo>
                    <a:pt x="627" y="445"/>
                  </a:lnTo>
                  <a:lnTo>
                    <a:pt x="629" y="445"/>
                  </a:lnTo>
                  <a:lnTo>
                    <a:pt x="635" y="445"/>
                  </a:lnTo>
                  <a:lnTo>
                    <a:pt x="643" y="445"/>
                  </a:lnTo>
                  <a:lnTo>
                    <a:pt x="647" y="437"/>
                  </a:lnTo>
                  <a:lnTo>
                    <a:pt x="649" y="437"/>
                  </a:lnTo>
                  <a:lnTo>
                    <a:pt x="655" y="437"/>
                  </a:lnTo>
                  <a:lnTo>
                    <a:pt x="660" y="437"/>
                  </a:lnTo>
                  <a:lnTo>
                    <a:pt x="668" y="437"/>
                  </a:lnTo>
                  <a:lnTo>
                    <a:pt x="672" y="437"/>
                  </a:lnTo>
                  <a:lnTo>
                    <a:pt x="678" y="437"/>
                  </a:lnTo>
                  <a:lnTo>
                    <a:pt x="683" y="428"/>
                  </a:lnTo>
                  <a:lnTo>
                    <a:pt x="689" y="428"/>
                  </a:lnTo>
                  <a:lnTo>
                    <a:pt x="690" y="428"/>
                  </a:lnTo>
                  <a:lnTo>
                    <a:pt x="695" y="428"/>
                  </a:lnTo>
                  <a:lnTo>
                    <a:pt x="701" y="428"/>
                  </a:lnTo>
                  <a:lnTo>
                    <a:pt x="707" y="428"/>
                  </a:lnTo>
                  <a:lnTo>
                    <a:pt x="717" y="428"/>
                  </a:lnTo>
                  <a:lnTo>
                    <a:pt x="717" y="419"/>
                  </a:lnTo>
                  <a:lnTo>
                    <a:pt x="720" y="419"/>
                  </a:lnTo>
                  <a:lnTo>
                    <a:pt x="726" y="419"/>
                  </a:lnTo>
                  <a:lnTo>
                    <a:pt x="732" y="419"/>
                  </a:lnTo>
                  <a:lnTo>
                    <a:pt x="737" y="419"/>
                  </a:lnTo>
                  <a:lnTo>
                    <a:pt x="744" y="419"/>
                  </a:lnTo>
                  <a:lnTo>
                    <a:pt x="751" y="419"/>
                  </a:lnTo>
                  <a:lnTo>
                    <a:pt x="756" y="419"/>
                  </a:lnTo>
                  <a:lnTo>
                    <a:pt x="763" y="419"/>
                  </a:lnTo>
                  <a:lnTo>
                    <a:pt x="768" y="419"/>
                  </a:lnTo>
                  <a:lnTo>
                    <a:pt x="773" y="402"/>
                  </a:lnTo>
                  <a:lnTo>
                    <a:pt x="774" y="402"/>
                  </a:lnTo>
                  <a:lnTo>
                    <a:pt x="780" y="402"/>
                  </a:lnTo>
                  <a:lnTo>
                    <a:pt x="786" y="402"/>
                  </a:lnTo>
                  <a:lnTo>
                    <a:pt x="792" y="402"/>
                  </a:lnTo>
                  <a:lnTo>
                    <a:pt x="798" y="402"/>
                  </a:lnTo>
                  <a:lnTo>
                    <a:pt x="804" y="402"/>
                  </a:lnTo>
                  <a:lnTo>
                    <a:pt x="810" y="402"/>
                  </a:lnTo>
                  <a:lnTo>
                    <a:pt x="819" y="402"/>
                  </a:lnTo>
                  <a:lnTo>
                    <a:pt x="824" y="402"/>
                  </a:lnTo>
                  <a:lnTo>
                    <a:pt x="830" y="402"/>
                  </a:lnTo>
                  <a:lnTo>
                    <a:pt x="837" y="402"/>
                  </a:lnTo>
                  <a:lnTo>
                    <a:pt x="842" y="402"/>
                  </a:lnTo>
                  <a:lnTo>
                    <a:pt x="846" y="402"/>
                  </a:lnTo>
                  <a:lnTo>
                    <a:pt x="846" y="373"/>
                  </a:lnTo>
                  <a:lnTo>
                    <a:pt x="854" y="373"/>
                  </a:lnTo>
                  <a:lnTo>
                    <a:pt x="854" y="344"/>
                  </a:lnTo>
                  <a:lnTo>
                    <a:pt x="860" y="344"/>
                  </a:lnTo>
                  <a:lnTo>
                    <a:pt x="865" y="344"/>
                  </a:lnTo>
                  <a:lnTo>
                    <a:pt x="870" y="344"/>
                  </a:lnTo>
                  <a:lnTo>
                    <a:pt x="885" y="344"/>
                  </a:lnTo>
                  <a:lnTo>
                    <a:pt x="890" y="344"/>
                  </a:lnTo>
                  <a:lnTo>
                    <a:pt x="894" y="344"/>
                  </a:lnTo>
                  <a:lnTo>
                    <a:pt x="901" y="344"/>
                  </a:lnTo>
                  <a:lnTo>
                    <a:pt x="907" y="344"/>
                  </a:lnTo>
                  <a:lnTo>
                    <a:pt x="913" y="344"/>
                  </a:lnTo>
                  <a:lnTo>
                    <a:pt x="920" y="344"/>
                  </a:lnTo>
                  <a:lnTo>
                    <a:pt x="927" y="344"/>
                  </a:lnTo>
                  <a:lnTo>
                    <a:pt x="933" y="344"/>
                  </a:lnTo>
                  <a:lnTo>
                    <a:pt x="937" y="344"/>
                  </a:lnTo>
                  <a:lnTo>
                    <a:pt x="943" y="344"/>
                  </a:lnTo>
                  <a:lnTo>
                    <a:pt x="960" y="344"/>
                  </a:lnTo>
                  <a:lnTo>
                    <a:pt x="961" y="344"/>
                  </a:lnTo>
                  <a:lnTo>
                    <a:pt x="969" y="344"/>
                  </a:lnTo>
                  <a:lnTo>
                    <a:pt x="977" y="344"/>
                  </a:lnTo>
                  <a:lnTo>
                    <a:pt x="990" y="344"/>
                  </a:lnTo>
                  <a:lnTo>
                    <a:pt x="991" y="344"/>
                  </a:lnTo>
                  <a:lnTo>
                    <a:pt x="999" y="344"/>
                  </a:lnTo>
                  <a:lnTo>
                    <a:pt x="1006" y="344"/>
                  </a:lnTo>
                  <a:lnTo>
                    <a:pt x="1008" y="344"/>
                  </a:lnTo>
                  <a:lnTo>
                    <a:pt x="1017" y="344"/>
                  </a:lnTo>
                  <a:lnTo>
                    <a:pt x="1029" y="344"/>
                  </a:lnTo>
                  <a:lnTo>
                    <a:pt x="1036" y="344"/>
                  </a:lnTo>
                  <a:lnTo>
                    <a:pt x="1106" y="344"/>
                  </a:lnTo>
                  <a:lnTo>
                    <a:pt x="1120" y="344"/>
                  </a:lnTo>
                  <a:lnTo>
                    <a:pt x="1127" y="344"/>
                  </a:lnTo>
                  <a:lnTo>
                    <a:pt x="1172" y="344"/>
                  </a:lnTo>
                  <a:lnTo>
                    <a:pt x="1214" y="344"/>
                  </a:lnTo>
                  <a:lnTo>
                    <a:pt x="1233" y="344"/>
                  </a:lnTo>
                  <a:lnTo>
                    <a:pt x="1237" y="344"/>
                  </a:lnTo>
                  <a:lnTo>
                    <a:pt x="1265" y="344"/>
                  </a:lnTo>
                  <a:lnTo>
                    <a:pt x="1265" y="0"/>
                  </a:lnTo>
                  <a:lnTo>
                    <a:pt x="1300" y="0"/>
                  </a:lnTo>
                  <a:lnTo>
                    <a:pt x="1324" y="0"/>
                  </a:lnTo>
                  <a:lnTo>
                    <a:pt x="1337" y="0"/>
                  </a:lnTo>
                  <a:lnTo>
                    <a:pt x="1387" y="0"/>
                  </a:lnTo>
                  <a:lnTo>
                    <a:pt x="1526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53798EDA-073C-A4AD-BFC9-34B2BC08137F}"/>
              </a:ext>
            </a:extLst>
          </p:cNvPr>
          <p:cNvGrpSpPr/>
          <p:nvPr/>
        </p:nvGrpSpPr>
        <p:grpSpPr>
          <a:xfrm>
            <a:off x="1200815" y="3651120"/>
            <a:ext cx="4141083" cy="2791354"/>
            <a:chOff x="1491095" y="3926886"/>
            <a:chExt cx="4141083" cy="2791354"/>
          </a:xfrm>
        </p:grpSpPr>
        <p:grpSp>
          <p:nvGrpSpPr>
            <p:cNvPr id="237" name="グループ化 236">
              <a:extLst>
                <a:ext uri="{FF2B5EF4-FFF2-40B4-BE49-F238E27FC236}">
                  <a16:creationId xmlns:a16="http://schemas.microsoft.com/office/drawing/2014/main" id="{A5CFDFD5-C528-AF0C-CA84-2A9A0B7A4D43}"/>
                </a:ext>
              </a:extLst>
            </p:cNvPr>
            <p:cNvGrpSpPr/>
            <p:nvPr/>
          </p:nvGrpSpPr>
          <p:grpSpPr>
            <a:xfrm>
              <a:off x="1491095" y="3926886"/>
              <a:ext cx="4141083" cy="2791354"/>
              <a:chOff x="1491095" y="3926886"/>
              <a:chExt cx="4141083" cy="2791354"/>
            </a:xfrm>
          </p:grpSpPr>
          <p:sp>
            <p:nvSpPr>
              <p:cNvPr id="146" name="Rectangle 22">
                <a:extLst>
                  <a:ext uri="{FF2B5EF4-FFF2-40B4-BE49-F238E27FC236}">
                    <a16:creationId xmlns:a16="http://schemas.microsoft.com/office/drawing/2014/main" id="{F8387F59-90E3-22D9-674A-D80F2E727A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1019" y="3933407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7" name="Line 23">
                <a:extLst>
                  <a:ext uri="{FF2B5EF4-FFF2-40B4-BE49-F238E27FC236}">
                    <a16:creationId xmlns:a16="http://schemas.microsoft.com/office/drawing/2014/main" id="{8F660B38-C356-0E43-ACAD-E5710A6826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5352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8" name="Line 25">
                <a:extLst>
                  <a:ext uri="{FF2B5EF4-FFF2-40B4-BE49-F238E27FC236}">
                    <a16:creationId xmlns:a16="http://schemas.microsoft.com/office/drawing/2014/main" id="{08BE6380-FE7D-4B4F-8EB1-57E96EAA23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8569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9" name="Line 27">
                <a:extLst>
                  <a:ext uri="{FF2B5EF4-FFF2-40B4-BE49-F238E27FC236}">
                    <a16:creationId xmlns:a16="http://schemas.microsoft.com/office/drawing/2014/main" id="{EC850244-69CD-121D-49E3-66B3147B78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91785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0" name="Line 29">
                <a:extLst>
                  <a:ext uri="{FF2B5EF4-FFF2-40B4-BE49-F238E27FC236}">
                    <a16:creationId xmlns:a16="http://schemas.microsoft.com/office/drawing/2014/main" id="{513501E1-7AAC-5D2D-1273-CD6285DE9A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3113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1" name="Line 31">
                <a:extLst>
                  <a:ext uri="{FF2B5EF4-FFF2-40B4-BE49-F238E27FC236}">
                    <a16:creationId xmlns:a16="http://schemas.microsoft.com/office/drawing/2014/main" id="{74967617-1923-FAAD-400B-22B1D5F55E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6330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2" name="Line 33">
                <a:extLst>
                  <a:ext uri="{FF2B5EF4-FFF2-40B4-BE49-F238E27FC236}">
                    <a16:creationId xmlns:a16="http://schemas.microsoft.com/office/drawing/2014/main" id="{944DBB85-1797-64C7-3FF2-B8BB70E024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9546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3" name="Line 35">
                <a:extLst>
                  <a:ext uri="{FF2B5EF4-FFF2-40B4-BE49-F238E27FC236}">
                    <a16:creationId xmlns:a16="http://schemas.microsoft.com/office/drawing/2014/main" id="{D814AC7B-CFED-FCF6-8BFB-D5EE63E99B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2763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4" name="Line 6">
                <a:extLst>
                  <a:ext uri="{FF2B5EF4-FFF2-40B4-BE49-F238E27FC236}">
                    <a16:creationId xmlns:a16="http://schemas.microsoft.com/office/drawing/2014/main" id="{A0EC68A3-26BA-8B73-C15D-EF6FC49B87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594718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5" name="Line 8">
                <a:extLst>
                  <a:ext uri="{FF2B5EF4-FFF2-40B4-BE49-F238E27FC236}">
                    <a16:creationId xmlns:a16="http://schemas.microsoft.com/office/drawing/2014/main" id="{EC0280D7-6ADD-CC2F-0B88-95FCB815BA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5539688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6" name="Line 9">
                <a:extLst>
                  <a:ext uri="{FF2B5EF4-FFF2-40B4-BE49-F238E27FC236}">
                    <a16:creationId xmlns:a16="http://schemas.microsoft.com/office/drawing/2014/main" id="{EA69896F-F9D9-B7F2-952E-08C47FC8D4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5132193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7" name="Line 11">
                <a:extLst>
                  <a:ext uri="{FF2B5EF4-FFF2-40B4-BE49-F238E27FC236}">
                    <a16:creationId xmlns:a16="http://schemas.microsoft.com/office/drawing/2014/main" id="{18DB1E96-AD4A-AA1B-5C2D-8B2E9995B3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4724698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8" name="Line 12">
                <a:extLst>
                  <a:ext uri="{FF2B5EF4-FFF2-40B4-BE49-F238E27FC236}">
                    <a16:creationId xmlns:a16="http://schemas.microsoft.com/office/drawing/2014/main" id="{595A27A6-6837-3E16-AA5C-C8FE7B83C1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4317203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9" name="Line 14">
                <a:extLst>
                  <a:ext uri="{FF2B5EF4-FFF2-40B4-BE49-F238E27FC236}">
                    <a16:creationId xmlns:a16="http://schemas.microsoft.com/office/drawing/2014/main" id="{963DD90A-75CE-BA4F-F5C5-30306D3F11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3933615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0" name="Line 23">
                <a:extLst>
                  <a:ext uri="{FF2B5EF4-FFF2-40B4-BE49-F238E27FC236}">
                    <a16:creationId xmlns:a16="http://schemas.microsoft.com/office/drawing/2014/main" id="{D2884F5F-5470-9CDD-6395-B0632887CF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7040" y="5947185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61" name="図形グループ 54">
                <a:extLst>
                  <a:ext uri="{FF2B5EF4-FFF2-40B4-BE49-F238E27FC236}">
                    <a16:creationId xmlns:a16="http://schemas.microsoft.com/office/drawing/2014/main" id="{DAA5A7E8-DC08-D2CC-A68E-8D50A0E23A42}"/>
                  </a:ext>
                </a:extLst>
              </p:cNvPr>
              <p:cNvGrpSpPr/>
              <p:nvPr/>
            </p:nvGrpSpPr>
            <p:grpSpPr>
              <a:xfrm>
                <a:off x="2037434" y="4188108"/>
                <a:ext cx="220989" cy="1868530"/>
                <a:chOff x="510218" y="1348283"/>
                <a:chExt cx="220989" cy="1868530"/>
              </a:xfrm>
            </p:grpSpPr>
            <p:sp>
              <p:nvSpPr>
                <p:cNvPr id="168" name="Rectangle 10">
                  <a:extLst>
                    <a:ext uri="{FF2B5EF4-FFF2-40B4-BE49-F238E27FC236}">
                      <a16:creationId xmlns:a16="http://schemas.microsoft.com/office/drawing/2014/main" id="{04B18B89-EB45-41FA-6767-D505B5AF25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69" name="Rectangle 13">
                  <a:extLst>
                    <a:ext uri="{FF2B5EF4-FFF2-40B4-BE49-F238E27FC236}">
                      <a16:creationId xmlns:a16="http://schemas.microsoft.com/office/drawing/2014/main" id="{A123525F-AA4E-9481-9187-4BCC019F95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70" name="Rectangle 10">
                  <a:extLst>
                    <a:ext uri="{FF2B5EF4-FFF2-40B4-BE49-F238E27FC236}">
                      <a16:creationId xmlns:a16="http://schemas.microsoft.com/office/drawing/2014/main" id="{B2216C31-71B4-61E1-EF34-40BD89A7E6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62" name="テキスト ボックス 161">
                <a:extLst>
                  <a:ext uri="{FF2B5EF4-FFF2-40B4-BE49-F238E27FC236}">
                    <a16:creationId xmlns:a16="http://schemas.microsoft.com/office/drawing/2014/main" id="{B0D4AA5E-BA4F-16E2-61DB-F9BADD33EDEC}"/>
                  </a:ext>
                </a:extLst>
              </p:cNvPr>
              <p:cNvSpPr txBox="1"/>
              <p:nvPr/>
            </p:nvSpPr>
            <p:spPr>
              <a:xfrm>
                <a:off x="2209901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E3220612-EDD0-EC5B-9A9E-5FC0E2FC4188}"/>
                  </a:ext>
                </a:extLst>
              </p:cNvPr>
              <p:cNvSpPr txBox="1"/>
              <p:nvPr/>
            </p:nvSpPr>
            <p:spPr>
              <a:xfrm>
                <a:off x="3254440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98C8FEAE-35D1-4824-B758-2DA60F197585}"/>
                  </a:ext>
                </a:extLst>
              </p:cNvPr>
              <p:cNvSpPr txBox="1"/>
              <p:nvPr/>
            </p:nvSpPr>
            <p:spPr>
              <a:xfrm>
                <a:off x="5343517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2F3EFF37-BFF0-6777-C6AC-42218627E01D}"/>
                  </a:ext>
                </a:extLst>
              </p:cNvPr>
              <p:cNvSpPr txBox="1"/>
              <p:nvPr/>
            </p:nvSpPr>
            <p:spPr>
              <a:xfrm>
                <a:off x="4298979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DFA09BA2-D80D-23ED-B13B-544DC9FA8CC4}"/>
                  </a:ext>
                </a:extLst>
              </p:cNvPr>
              <p:cNvSpPr txBox="1"/>
              <p:nvPr/>
            </p:nvSpPr>
            <p:spPr>
              <a:xfrm rot="16200000">
                <a:off x="608000" y="4809981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D2558AD1-564A-220A-57ED-8CA740F1401E}"/>
                  </a:ext>
                </a:extLst>
              </p:cNvPr>
              <p:cNvSpPr txBox="1"/>
              <p:nvPr/>
            </p:nvSpPr>
            <p:spPr>
              <a:xfrm>
                <a:off x="3112207" y="6348908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54" name="Freeform 101">
              <a:extLst>
                <a:ext uri="{FF2B5EF4-FFF2-40B4-BE49-F238E27FC236}">
                  <a16:creationId xmlns:a16="http://schemas.microsoft.com/office/drawing/2014/main" id="{FC0E0860-1938-0B0A-C049-F7F6C826622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8537" y="5484183"/>
              <a:ext cx="2916835" cy="465048"/>
            </a:xfrm>
            <a:custGeom>
              <a:avLst/>
              <a:gdLst>
                <a:gd name="T0" fmla="*/ 0 w 1543"/>
                <a:gd name="T1" fmla="*/ 251 h 251"/>
                <a:gd name="T2" fmla="*/ 213 w 1543"/>
                <a:gd name="T3" fmla="*/ 251 h 251"/>
                <a:gd name="T4" fmla="*/ 254 w 1543"/>
                <a:gd name="T5" fmla="*/ 251 h 251"/>
                <a:gd name="T6" fmla="*/ 254 w 1543"/>
                <a:gd name="T7" fmla="*/ 233 h 251"/>
                <a:gd name="T8" fmla="*/ 289 w 1543"/>
                <a:gd name="T9" fmla="*/ 233 h 251"/>
                <a:gd name="T10" fmla="*/ 308 w 1543"/>
                <a:gd name="T11" fmla="*/ 233 h 251"/>
                <a:gd name="T12" fmla="*/ 325 w 1543"/>
                <a:gd name="T13" fmla="*/ 233 h 251"/>
                <a:gd name="T14" fmla="*/ 349 w 1543"/>
                <a:gd name="T15" fmla="*/ 233 h 251"/>
                <a:gd name="T16" fmla="*/ 349 w 1543"/>
                <a:gd name="T17" fmla="*/ 215 h 251"/>
                <a:gd name="T18" fmla="*/ 398 w 1543"/>
                <a:gd name="T19" fmla="*/ 215 h 251"/>
                <a:gd name="T20" fmla="*/ 405 w 1543"/>
                <a:gd name="T21" fmla="*/ 215 h 251"/>
                <a:gd name="T22" fmla="*/ 417 w 1543"/>
                <a:gd name="T23" fmla="*/ 215 h 251"/>
                <a:gd name="T24" fmla="*/ 417 w 1543"/>
                <a:gd name="T25" fmla="*/ 196 h 251"/>
                <a:gd name="T26" fmla="*/ 451 w 1543"/>
                <a:gd name="T27" fmla="*/ 196 h 251"/>
                <a:gd name="T28" fmla="*/ 494 w 1543"/>
                <a:gd name="T29" fmla="*/ 196 h 251"/>
                <a:gd name="T30" fmla="*/ 500 w 1543"/>
                <a:gd name="T31" fmla="*/ 196 h 251"/>
                <a:gd name="T32" fmla="*/ 509 w 1543"/>
                <a:gd name="T33" fmla="*/ 196 h 251"/>
                <a:gd name="T34" fmla="*/ 536 w 1543"/>
                <a:gd name="T35" fmla="*/ 196 h 251"/>
                <a:gd name="T36" fmla="*/ 536 w 1543"/>
                <a:gd name="T37" fmla="*/ 175 h 251"/>
                <a:gd name="T38" fmla="*/ 571 w 1543"/>
                <a:gd name="T39" fmla="*/ 175 h 251"/>
                <a:gd name="T40" fmla="*/ 580 w 1543"/>
                <a:gd name="T41" fmla="*/ 175 h 251"/>
                <a:gd name="T42" fmla="*/ 613 w 1543"/>
                <a:gd name="T43" fmla="*/ 175 h 251"/>
                <a:gd name="T44" fmla="*/ 622 w 1543"/>
                <a:gd name="T45" fmla="*/ 175 h 251"/>
                <a:gd name="T46" fmla="*/ 628 w 1543"/>
                <a:gd name="T47" fmla="*/ 175 h 251"/>
                <a:gd name="T48" fmla="*/ 629 w 1543"/>
                <a:gd name="T49" fmla="*/ 175 h 251"/>
                <a:gd name="T50" fmla="*/ 642 w 1543"/>
                <a:gd name="T51" fmla="*/ 175 h 251"/>
                <a:gd name="T52" fmla="*/ 669 w 1543"/>
                <a:gd name="T53" fmla="*/ 175 h 251"/>
                <a:gd name="T54" fmla="*/ 674 w 1543"/>
                <a:gd name="T55" fmla="*/ 175 h 251"/>
                <a:gd name="T56" fmla="*/ 674 w 1543"/>
                <a:gd name="T57" fmla="*/ 149 h 251"/>
                <a:gd name="T58" fmla="*/ 675 w 1543"/>
                <a:gd name="T59" fmla="*/ 122 h 251"/>
                <a:gd name="T60" fmla="*/ 695 w 1543"/>
                <a:gd name="T61" fmla="*/ 122 h 251"/>
                <a:gd name="T62" fmla="*/ 723 w 1543"/>
                <a:gd name="T63" fmla="*/ 122 h 251"/>
                <a:gd name="T64" fmla="*/ 744 w 1543"/>
                <a:gd name="T65" fmla="*/ 122 h 251"/>
                <a:gd name="T66" fmla="*/ 753 w 1543"/>
                <a:gd name="T67" fmla="*/ 122 h 251"/>
                <a:gd name="T68" fmla="*/ 757 w 1543"/>
                <a:gd name="T69" fmla="*/ 122 h 251"/>
                <a:gd name="T70" fmla="*/ 761 w 1543"/>
                <a:gd name="T71" fmla="*/ 122 h 251"/>
                <a:gd name="T72" fmla="*/ 768 w 1543"/>
                <a:gd name="T73" fmla="*/ 122 h 251"/>
                <a:gd name="T74" fmla="*/ 776 w 1543"/>
                <a:gd name="T75" fmla="*/ 122 h 251"/>
                <a:gd name="T76" fmla="*/ 781 w 1543"/>
                <a:gd name="T77" fmla="*/ 122 h 251"/>
                <a:gd name="T78" fmla="*/ 791 w 1543"/>
                <a:gd name="T79" fmla="*/ 122 h 251"/>
                <a:gd name="T80" fmla="*/ 805 w 1543"/>
                <a:gd name="T81" fmla="*/ 122 h 251"/>
                <a:gd name="T82" fmla="*/ 816 w 1543"/>
                <a:gd name="T83" fmla="*/ 122 h 251"/>
                <a:gd name="T84" fmla="*/ 846 w 1543"/>
                <a:gd name="T85" fmla="*/ 122 h 251"/>
                <a:gd name="T86" fmla="*/ 846 w 1543"/>
                <a:gd name="T87" fmla="*/ 69 h 251"/>
                <a:gd name="T88" fmla="*/ 868 w 1543"/>
                <a:gd name="T89" fmla="*/ 69 h 251"/>
                <a:gd name="T90" fmla="*/ 870 w 1543"/>
                <a:gd name="T91" fmla="*/ 69 h 251"/>
                <a:gd name="T92" fmla="*/ 870 w 1543"/>
                <a:gd name="T93" fmla="*/ 0 h 251"/>
                <a:gd name="T94" fmla="*/ 878 w 1543"/>
                <a:gd name="T95" fmla="*/ 0 h 251"/>
                <a:gd name="T96" fmla="*/ 883 w 1543"/>
                <a:gd name="T97" fmla="*/ 0 h 251"/>
                <a:gd name="T98" fmla="*/ 901 w 1543"/>
                <a:gd name="T99" fmla="*/ 0 h 251"/>
                <a:gd name="T100" fmla="*/ 907 w 1543"/>
                <a:gd name="T101" fmla="*/ 0 h 251"/>
                <a:gd name="T102" fmla="*/ 932 w 1543"/>
                <a:gd name="T103" fmla="*/ 0 h 251"/>
                <a:gd name="T104" fmla="*/ 1036 w 1543"/>
                <a:gd name="T105" fmla="*/ 0 h 251"/>
                <a:gd name="T106" fmla="*/ 1106 w 1543"/>
                <a:gd name="T107" fmla="*/ 0 h 251"/>
                <a:gd name="T108" fmla="*/ 1203 w 1543"/>
                <a:gd name="T109" fmla="*/ 0 h 251"/>
                <a:gd name="T110" fmla="*/ 1225 w 1543"/>
                <a:gd name="T111" fmla="*/ 0 h 251"/>
                <a:gd name="T112" fmla="*/ 1235 w 1543"/>
                <a:gd name="T113" fmla="*/ 0 h 251"/>
                <a:gd name="T114" fmla="*/ 1387 w 1543"/>
                <a:gd name="T115" fmla="*/ 0 h 251"/>
                <a:gd name="T116" fmla="*/ 1543 w 1543"/>
                <a:gd name="T117" fmla="*/ 0 h 2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1543" h="251">
                  <a:moveTo>
                    <a:pt x="0" y="251"/>
                  </a:moveTo>
                  <a:lnTo>
                    <a:pt x="213" y="251"/>
                  </a:lnTo>
                  <a:lnTo>
                    <a:pt x="254" y="251"/>
                  </a:lnTo>
                  <a:lnTo>
                    <a:pt x="254" y="233"/>
                  </a:lnTo>
                  <a:lnTo>
                    <a:pt x="289" y="233"/>
                  </a:lnTo>
                  <a:lnTo>
                    <a:pt x="308" y="233"/>
                  </a:lnTo>
                  <a:lnTo>
                    <a:pt x="325" y="233"/>
                  </a:lnTo>
                  <a:lnTo>
                    <a:pt x="349" y="233"/>
                  </a:lnTo>
                  <a:lnTo>
                    <a:pt x="349" y="215"/>
                  </a:lnTo>
                  <a:lnTo>
                    <a:pt x="398" y="215"/>
                  </a:lnTo>
                  <a:lnTo>
                    <a:pt x="405" y="215"/>
                  </a:lnTo>
                  <a:lnTo>
                    <a:pt x="417" y="215"/>
                  </a:lnTo>
                  <a:lnTo>
                    <a:pt x="417" y="196"/>
                  </a:lnTo>
                  <a:lnTo>
                    <a:pt x="451" y="196"/>
                  </a:lnTo>
                  <a:lnTo>
                    <a:pt x="494" y="196"/>
                  </a:lnTo>
                  <a:lnTo>
                    <a:pt x="500" y="196"/>
                  </a:lnTo>
                  <a:lnTo>
                    <a:pt x="509" y="196"/>
                  </a:lnTo>
                  <a:lnTo>
                    <a:pt x="536" y="196"/>
                  </a:lnTo>
                  <a:lnTo>
                    <a:pt x="536" y="175"/>
                  </a:lnTo>
                  <a:lnTo>
                    <a:pt x="571" y="175"/>
                  </a:lnTo>
                  <a:lnTo>
                    <a:pt x="580" y="175"/>
                  </a:lnTo>
                  <a:lnTo>
                    <a:pt x="613" y="175"/>
                  </a:lnTo>
                  <a:lnTo>
                    <a:pt x="622" y="175"/>
                  </a:lnTo>
                  <a:lnTo>
                    <a:pt x="628" y="175"/>
                  </a:lnTo>
                  <a:lnTo>
                    <a:pt x="629" y="175"/>
                  </a:lnTo>
                  <a:lnTo>
                    <a:pt x="642" y="175"/>
                  </a:lnTo>
                  <a:lnTo>
                    <a:pt x="669" y="175"/>
                  </a:lnTo>
                  <a:lnTo>
                    <a:pt x="674" y="175"/>
                  </a:lnTo>
                  <a:lnTo>
                    <a:pt x="674" y="149"/>
                  </a:lnTo>
                  <a:lnTo>
                    <a:pt x="675" y="122"/>
                  </a:lnTo>
                  <a:lnTo>
                    <a:pt x="695" y="122"/>
                  </a:lnTo>
                  <a:lnTo>
                    <a:pt x="723" y="122"/>
                  </a:lnTo>
                  <a:lnTo>
                    <a:pt x="744" y="122"/>
                  </a:lnTo>
                  <a:lnTo>
                    <a:pt x="753" y="122"/>
                  </a:lnTo>
                  <a:lnTo>
                    <a:pt x="757" y="122"/>
                  </a:lnTo>
                  <a:lnTo>
                    <a:pt x="761" y="122"/>
                  </a:lnTo>
                  <a:lnTo>
                    <a:pt x="768" y="122"/>
                  </a:lnTo>
                  <a:lnTo>
                    <a:pt x="776" y="122"/>
                  </a:lnTo>
                  <a:lnTo>
                    <a:pt x="781" y="122"/>
                  </a:lnTo>
                  <a:lnTo>
                    <a:pt x="791" y="122"/>
                  </a:lnTo>
                  <a:lnTo>
                    <a:pt x="805" y="122"/>
                  </a:lnTo>
                  <a:lnTo>
                    <a:pt x="816" y="122"/>
                  </a:lnTo>
                  <a:lnTo>
                    <a:pt x="846" y="122"/>
                  </a:lnTo>
                  <a:lnTo>
                    <a:pt x="846" y="69"/>
                  </a:lnTo>
                  <a:lnTo>
                    <a:pt x="868" y="69"/>
                  </a:lnTo>
                  <a:lnTo>
                    <a:pt x="870" y="69"/>
                  </a:lnTo>
                  <a:lnTo>
                    <a:pt x="870" y="0"/>
                  </a:lnTo>
                  <a:lnTo>
                    <a:pt x="878" y="0"/>
                  </a:lnTo>
                  <a:lnTo>
                    <a:pt x="883" y="0"/>
                  </a:lnTo>
                  <a:lnTo>
                    <a:pt x="901" y="0"/>
                  </a:lnTo>
                  <a:lnTo>
                    <a:pt x="907" y="0"/>
                  </a:lnTo>
                  <a:lnTo>
                    <a:pt x="932" y="0"/>
                  </a:lnTo>
                  <a:lnTo>
                    <a:pt x="1036" y="0"/>
                  </a:lnTo>
                  <a:lnTo>
                    <a:pt x="1106" y="0"/>
                  </a:lnTo>
                  <a:lnTo>
                    <a:pt x="1203" y="0"/>
                  </a:lnTo>
                  <a:lnTo>
                    <a:pt x="1225" y="0"/>
                  </a:lnTo>
                  <a:lnTo>
                    <a:pt x="1235" y="0"/>
                  </a:lnTo>
                  <a:lnTo>
                    <a:pt x="1387" y="0"/>
                  </a:lnTo>
                  <a:lnTo>
                    <a:pt x="1543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Freeform 102">
              <a:extLst>
                <a:ext uri="{FF2B5EF4-FFF2-40B4-BE49-F238E27FC236}">
                  <a16:creationId xmlns:a16="http://schemas.microsoft.com/office/drawing/2014/main" id="{CDE496AB-E0E9-0CC6-D452-27DE3C891C6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8537" y="5417483"/>
              <a:ext cx="2884698" cy="531748"/>
            </a:xfrm>
            <a:custGeom>
              <a:avLst/>
              <a:gdLst>
                <a:gd name="T0" fmla="*/ 165 w 1526"/>
                <a:gd name="T1" fmla="*/ 287 h 287"/>
                <a:gd name="T2" fmla="*/ 191 w 1526"/>
                <a:gd name="T3" fmla="*/ 287 h 287"/>
                <a:gd name="T4" fmla="*/ 282 w 1526"/>
                <a:gd name="T5" fmla="*/ 287 h 287"/>
                <a:gd name="T6" fmla="*/ 299 w 1526"/>
                <a:gd name="T7" fmla="*/ 287 h 287"/>
                <a:gd name="T8" fmla="*/ 351 w 1526"/>
                <a:gd name="T9" fmla="*/ 287 h 287"/>
                <a:gd name="T10" fmla="*/ 358 w 1526"/>
                <a:gd name="T11" fmla="*/ 287 h 287"/>
                <a:gd name="T12" fmla="*/ 383 w 1526"/>
                <a:gd name="T13" fmla="*/ 287 h 287"/>
                <a:gd name="T14" fmla="*/ 403 w 1526"/>
                <a:gd name="T15" fmla="*/ 287 h 287"/>
                <a:gd name="T16" fmla="*/ 432 w 1526"/>
                <a:gd name="T17" fmla="*/ 287 h 287"/>
                <a:gd name="T18" fmla="*/ 445 w 1526"/>
                <a:gd name="T19" fmla="*/ 287 h 287"/>
                <a:gd name="T20" fmla="*/ 458 w 1526"/>
                <a:gd name="T21" fmla="*/ 287 h 287"/>
                <a:gd name="T22" fmla="*/ 467 w 1526"/>
                <a:gd name="T23" fmla="*/ 287 h 287"/>
                <a:gd name="T24" fmla="*/ 479 w 1526"/>
                <a:gd name="T25" fmla="*/ 287 h 287"/>
                <a:gd name="T26" fmla="*/ 484 w 1526"/>
                <a:gd name="T27" fmla="*/ 280 h 287"/>
                <a:gd name="T28" fmla="*/ 500 w 1526"/>
                <a:gd name="T29" fmla="*/ 280 h 287"/>
                <a:gd name="T30" fmla="*/ 522 w 1526"/>
                <a:gd name="T31" fmla="*/ 280 h 287"/>
                <a:gd name="T32" fmla="*/ 543 w 1526"/>
                <a:gd name="T33" fmla="*/ 280 h 287"/>
                <a:gd name="T34" fmla="*/ 556 w 1526"/>
                <a:gd name="T35" fmla="*/ 280 h 287"/>
                <a:gd name="T36" fmla="*/ 576 w 1526"/>
                <a:gd name="T37" fmla="*/ 280 h 287"/>
                <a:gd name="T38" fmla="*/ 587 w 1526"/>
                <a:gd name="T39" fmla="*/ 280 h 287"/>
                <a:gd name="T40" fmla="*/ 612 w 1526"/>
                <a:gd name="T41" fmla="*/ 280 h 287"/>
                <a:gd name="T42" fmla="*/ 623 w 1526"/>
                <a:gd name="T43" fmla="*/ 280 h 287"/>
                <a:gd name="T44" fmla="*/ 636 w 1526"/>
                <a:gd name="T45" fmla="*/ 280 h 287"/>
                <a:gd name="T46" fmla="*/ 681 w 1526"/>
                <a:gd name="T47" fmla="*/ 280 h 287"/>
                <a:gd name="T48" fmla="*/ 701 w 1526"/>
                <a:gd name="T49" fmla="*/ 280 h 287"/>
                <a:gd name="T50" fmla="*/ 715 w 1526"/>
                <a:gd name="T51" fmla="*/ 280 h 287"/>
                <a:gd name="T52" fmla="*/ 727 w 1526"/>
                <a:gd name="T53" fmla="*/ 280 h 287"/>
                <a:gd name="T54" fmla="*/ 751 w 1526"/>
                <a:gd name="T55" fmla="*/ 280 h 287"/>
                <a:gd name="T56" fmla="*/ 770 w 1526"/>
                <a:gd name="T57" fmla="*/ 280 h 287"/>
                <a:gd name="T58" fmla="*/ 779 w 1526"/>
                <a:gd name="T59" fmla="*/ 265 h 287"/>
                <a:gd name="T60" fmla="*/ 786 w 1526"/>
                <a:gd name="T61" fmla="*/ 265 h 287"/>
                <a:gd name="T62" fmla="*/ 798 w 1526"/>
                <a:gd name="T63" fmla="*/ 265 h 287"/>
                <a:gd name="T64" fmla="*/ 816 w 1526"/>
                <a:gd name="T65" fmla="*/ 265 h 287"/>
                <a:gd name="T66" fmla="*/ 829 w 1526"/>
                <a:gd name="T67" fmla="*/ 265 h 287"/>
                <a:gd name="T68" fmla="*/ 854 w 1526"/>
                <a:gd name="T69" fmla="*/ 265 h 287"/>
                <a:gd name="T70" fmla="*/ 865 w 1526"/>
                <a:gd name="T71" fmla="*/ 265 h 287"/>
                <a:gd name="T72" fmla="*/ 880 w 1526"/>
                <a:gd name="T73" fmla="*/ 265 h 287"/>
                <a:gd name="T74" fmla="*/ 894 w 1526"/>
                <a:gd name="T75" fmla="*/ 265 h 287"/>
                <a:gd name="T76" fmla="*/ 902 w 1526"/>
                <a:gd name="T77" fmla="*/ 265 h 287"/>
                <a:gd name="T78" fmla="*/ 913 w 1526"/>
                <a:gd name="T79" fmla="*/ 265 h 287"/>
                <a:gd name="T80" fmla="*/ 927 w 1526"/>
                <a:gd name="T81" fmla="*/ 265 h 287"/>
                <a:gd name="T82" fmla="*/ 944 w 1526"/>
                <a:gd name="T83" fmla="*/ 265 h 287"/>
                <a:gd name="T84" fmla="*/ 977 w 1526"/>
                <a:gd name="T85" fmla="*/ 265 h 287"/>
                <a:gd name="T86" fmla="*/ 1017 w 1526"/>
                <a:gd name="T87" fmla="*/ 265 h 287"/>
                <a:gd name="T88" fmla="*/ 1063 w 1526"/>
                <a:gd name="T89" fmla="*/ 265 h 287"/>
                <a:gd name="T90" fmla="*/ 1172 w 1526"/>
                <a:gd name="T91" fmla="*/ 265 h 287"/>
                <a:gd name="T92" fmla="*/ 1227 w 1526"/>
                <a:gd name="T93" fmla="*/ 265 h 287"/>
                <a:gd name="T94" fmla="*/ 1265 w 1526"/>
                <a:gd name="T95" fmla="*/ 0 h 287"/>
                <a:gd name="T96" fmla="*/ 1337 w 1526"/>
                <a:gd name="T97" fmla="*/ 0 h 2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1526" h="287">
                  <a:moveTo>
                    <a:pt x="0" y="287"/>
                  </a:moveTo>
                  <a:lnTo>
                    <a:pt x="165" y="287"/>
                  </a:lnTo>
                  <a:lnTo>
                    <a:pt x="166" y="287"/>
                  </a:lnTo>
                  <a:lnTo>
                    <a:pt x="191" y="287"/>
                  </a:lnTo>
                  <a:lnTo>
                    <a:pt x="228" y="287"/>
                  </a:lnTo>
                  <a:lnTo>
                    <a:pt x="282" y="287"/>
                  </a:lnTo>
                  <a:lnTo>
                    <a:pt x="290" y="287"/>
                  </a:lnTo>
                  <a:lnTo>
                    <a:pt x="299" y="287"/>
                  </a:lnTo>
                  <a:lnTo>
                    <a:pt x="345" y="287"/>
                  </a:lnTo>
                  <a:lnTo>
                    <a:pt x="351" y="287"/>
                  </a:lnTo>
                  <a:lnTo>
                    <a:pt x="354" y="287"/>
                  </a:lnTo>
                  <a:lnTo>
                    <a:pt x="358" y="287"/>
                  </a:lnTo>
                  <a:lnTo>
                    <a:pt x="365" y="287"/>
                  </a:lnTo>
                  <a:lnTo>
                    <a:pt x="383" y="287"/>
                  </a:lnTo>
                  <a:lnTo>
                    <a:pt x="398" y="287"/>
                  </a:lnTo>
                  <a:lnTo>
                    <a:pt x="403" y="287"/>
                  </a:lnTo>
                  <a:lnTo>
                    <a:pt x="408" y="287"/>
                  </a:lnTo>
                  <a:lnTo>
                    <a:pt x="432" y="287"/>
                  </a:lnTo>
                  <a:lnTo>
                    <a:pt x="441" y="287"/>
                  </a:lnTo>
                  <a:lnTo>
                    <a:pt x="445" y="287"/>
                  </a:lnTo>
                  <a:lnTo>
                    <a:pt x="451" y="287"/>
                  </a:lnTo>
                  <a:lnTo>
                    <a:pt x="458" y="287"/>
                  </a:lnTo>
                  <a:lnTo>
                    <a:pt x="464" y="287"/>
                  </a:lnTo>
                  <a:lnTo>
                    <a:pt x="467" y="287"/>
                  </a:lnTo>
                  <a:lnTo>
                    <a:pt x="478" y="287"/>
                  </a:lnTo>
                  <a:lnTo>
                    <a:pt x="479" y="287"/>
                  </a:lnTo>
                  <a:lnTo>
                    <a:pt x="479" y="280"/>
                  </a:lnTo>
                  <a:lnTo>
                    <a:pt x="484" y="280"/>
                  </a:lnTo>
                  <a:lnTo>
                    <a:pt x="495" y="280"/>
                  </a:lnTo>
                  <a:lnTo>
                    <a:pt x="500" y="280"/>
                  </a:lnTo>
                  <a:lnTo>
                    <a:pt x="510" y="280"/>
                  </a:lnTo>
                  <a:lnTo>
                    <a:pt x="522" y="280"/>
                  </a:lnTo>
                  <a:lnTo>
                    <a:pt x="537" y="280"/>
                  </a:lnTo>
                  <a:lnTo>
                    <a:pt x="543" y="280"/>
                  </a:lnTo>
                  <a:lnTo>
                    <a:pt x="546" y="280"/>
                  </a:lnTo>
                  <a:lnTo>
                    <a:pt x="556" y="280"/>
                  </a:lnTo>
                  <a:lnTo>
                    <a:pt x="559" y="280"/>
                  </a:lnTo>
                  <a:lnTo>
                    <a:pt x="576" y="280"/>
                  </a:lnTo>
                  <a:lnTo>
                    <a:pt x="582" y="280"/>
                  </a:lnTo>
                  <a:lnTo>
                    <a:pt x="587" y="280"/>
                  </a:lnTo>
                  <a:lnTo>
                    <a:pt x="601" y="280"/>
                  </a:lnTo>
                  <a:lnTo>
                    <a:pt x="612" y="280"/>
                  </a:lnTo>
                  <a:lnTo>
                    <a:pt x="618" y="280"/>
                  </a:lnTo>
                  <a:lnTo>
                    <a:pt x="623" y="280"/>
                  </a:lnTo>
                  <a:lnTo>
                    <a:pt x="629" y="280"/>
                  </a:lnTo>
                  <a:lnTo>
                    <a:pt x="636" y="280"/>
                  </a:lnTo>
                  <a:lnTo>
                    <a:pt x="654" y="280"/>
                  </a:lnTo>
                  <a:lnTo>
                    <a:pt x="681" y="280"/>
                  </a:lnTo>
                  <a:lnTo>
                    <a:pt x="690" y="280"/>
                  </a:lnTo>
                  <a:lnTo>
                    <a:pt x="701" y="280"/>
                  </a:lnTo>
                  <a:lnTo>
                    <a:pt x="707" y="280"/>
                  </a:lnTo>
                  <a:lnTo>
                    <a:pt x="715" y="280"/>
                  </a:lnTo>
                  <a:lnTo>
                    <a:pt x="722" y="280"/>
                  </a:lnTo>
                  <a:lnTo>
                    <a:pt x="727" y="280"/>
                  </a:lnTo>
                  <a:lnTo>
                    <a:pt x="749" y="280"/>
                  </a:lnTo>
                  <a:lnTo>
                    <a:pt x="751" y="280"/>
                  </a:lnTo>
                  <a:lnTo>
                    <a:pt x="758" y="280"/>
                  </a:lnTo>
                  <a:lnTo>
                    <a:pt x="770" y="280"/>
                  </a:lnTo>
                  <a:lnTo>
                    <a:pt x="773" y="265"/>
                  </a:lnTo>
                  <a:lnTo>
                    <a:pt x="779" y="265"/>
                  </a:lnTo>
                  <a:lnTo>
                    <a:pt x="782" y="265"/>
                  </a:lnTo>
                  <a:lnTo>
                    <a:pt x="786" y="265"/>
                  </a:lnTo>
                  <a:lnTo>
                    <a:pt x="792" y="265"/>
                  </a:lnTo>
                  <a:lnTo>
                    <a:pt x="798" y="265"/>
                  </a:lnTo>
                  <a:lnTo>
                    <a:pt x="804" y="265"/>
                  </a:lnTo>
                  <a:lnTo>
                    <a:pt x="816" y="265"/>
                  </a:lnTo>
                  <a:lnTo>
                    <a:pt x="824" y="265"/>
                  </a:lnTo>
                  <a:lnTo>
                    <a:pt x="829" y="265"/>
                  </a:lnTo>
                  <a:lnTo>
                    <a:pt x="838" y="265"/>
                  </a:lnTo>
                  <a:lnTo>
                    <a:pt x="854" y="265"/>
                  </a:lnTo>
                  <a:lnTo>
                    <a:pt x="860" y="265"/>
                  </a:lnTo>
                  <a:lnTo>
                    <a:pt x="865" y="265"/>
                  </a:lnTo>
                  <a:lnTo>
                    <a:pt x="872" y="265"/>
                  </a:lnTo>
                  <a:lnTo>
                    <a:pt x="880" y="265"/>
                  </a:lnTo>
                  <a:lnTo>
                    <a:pt x="885" y="265"/>
                  </a:lnTo>
                  <a:lnTo>
                    <a:pt x="894" y="265"/>
                  </a:lnTo>
                  <a:lnTo>
                    <a:pt x="898" y="265"/>
                  </a:lnTo>
                  <a:lnTo>
                    <a:pt x="902" y="265"/>
                  </a:lnTo>
                  <a:lnTo>
                    <a:pt x="909" y="265"/>
                  </a:lnTo>
                  <a:lnTo>
                    <a:pt x="913" y="265"/>
                  </a:lnTo>
                  <a:lnTo>
                    <a:pt x="920" y="265"/>
                  </a:lnTo>
                  <a:lnTo>
                    <a:pt x="927" y="265"/>
                  </a:lnTo>
                  <a:lnTo>
                    <a:pt x="935" y="265"/>
                  </a:lnTo>
                  <a:lnTo>
                    <a:pt x="944" y="265"/>
                  </a:lnTo>
                  <a:lnTo>
                    <a:pt x="961" y="265"/>
                  </a:lnTo>
                  <a:lnTo>
                    <a:pt x="977" y="265"/>
                  </a:lnTo>
                  <a:lnTo>
                    <a:pt x="994" y="265"/>
                  </a:lnTo>
                  <a:lnTo>
                    <a:pt x="1017" y="265"/>
                  </a:lnTo>
                  <a:lnTo>
                    <a:pt x="1044" y="265"/>
                  </a:lnTo>
                  <a:lnTo>
                    <a:pt x="1063" y="265"/>
                  </a:lnTo>
                  <a:lnTo>
                    <a:pt x="1142" y="265"/>
                  </a:lnTo>
                  <a:lnTo>
                    <a:pt x="1172" y="265"/>
                  </a:lnTo>
                  <a:lnTo>
                    <a:pt x="1214" y="265"/>
                  </a:lnTo>
                  <a:lnTo>
                    <a:pt x="1227" y="265"/>
                  </a:lnTo>
                  <a:lnTo>
                    <a:pt x="1265" y="265"/>
                  </a:lnTo>
                  <a:lnTo>
                    <a:pt x="1265" y="0"/>
                  </a:lnTo>
                  <a:lnTo>
                    <a:pt x="1300" y="0"/>
                  </a:lnTo>
                  <a:lnTo>
                    <a:pt x="1337" y="0"/>
                  </a:lnTo>
                  <a:lnTo>
                    <a:pt x="1526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" name="Freeform 103">
              <a:extLst>
                <a:ext uri="{FF2B5EF4-FFF2-40B4-BE49-F238E27FC236}">
                  <a16:creationId xmlns:a16="http://schemas.microsoft.com/office/drawing/2014/main" id="{52A1E76C-1B78-6A8F-924A-08B02EFAEA7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8537" y="5891794"/>
              <a:ext cx="2962204" cy="57437"/>
            </a:xfrm>
            <a:custGeom>
              <a:avLst/>
              <a:gdLst>
                <a:gd name="T0" fmla="*/ 0 w 1567"/>
                <a:gd name="T1" fmla="*/ 31 h 31"/>
                <a:gd name="T2" fmla="*/ 167 w 1567"/>
                <a:gd name="T3" fmla="*/ 31 h 31"/>
                <a:gd name="T4" fmla="*/ 464 w 1567"/>
                <a:gd name="T5" fmla="*/ 31 h 31"/>
                <a:gd name="T6" fmla="*/ 494 w 1567"/>
                <a:gd name="T7" fmla="*/ 31 h 31"/>
                <a:gd name="T8" fmla="*/ 498 w 1567"/>
                <a:gd name="T9" fmla="*/ 31 h 31"/>
                <a:gd name="T10" fmla="*/ 509 w 1567"/>
                <a:gd name="T11" fmla="*/ 31 h 31"/>
                <a:gd name="T12" fmla="*/ 515 w 1567"/>
                <a:gd name="T13" fmla="*/ 31 h 31"/>
                <a:gd name="T14" fmla="*/ 522 w 1567"/>
                <a:gd name="T15" fmla="*/ 31 h 31"/>
                <a:gd name="T16" fmla="*/ 522 w 1567"/>
                <a:gd name="T17" fmla="*/ 17 h 31"/>
                <a:gd name="T18" fmla="*/ 587 w 1567"/>
                <a:gd name="T19" fmla="*/ 17 h 31"/>
                <a:gd name="T20" fmla="*/ 587 w 1567"/>
                <a:gd name="T21" fmla="*/ 17 h 31"/>
                <a:gd name="T22" fmla="*/ 594 w 1567"/>
                <a:gd name="T23" fmla="*/ 17 h 31"/>
                <a:gd name="T24" fmla="*/ 615 w 1567"/>
                <a:gd name="T25" fmla="*/ 17 h 31"/>
                <a:gd name="T26" fmla="*/ 622 w 1567"/>
                <a:gd name="T27" fmla="*/ 17 h 31"/>
                <a:gd name="T28" fmla="*/ 631 w 1567"/>
                <a:gd name="T29" fmla="*/ 17 h 31"/>
                <a:gd name="T30" fmla="*/ 652 w 1567"/>
                <a:gd name="T31" fmla="*/ 17 h 31"/>
                <a:gd name="T32" fmla="*/ 678 w 1567"/>
                <a:gd name="T33" fmla="*/ 17 h 31"/>
                <a:gd name="T34" fmla="*/ 693 w 1567"/>
                <a:gd name="T35" fmla="*/ 17 h 31"/>
                <a:gd name="T36" fmla="*/ 697 w 1567"/>
                <a:gd name="T37" fmla="*/ 17 h 31"/>
                <a:gd name="T38" fmla="*/ 719 w 1567"/>
                <a:gd name="T39" fmla="*/ 17 h 31"/>
                <a:gd name="T40" fmla="*/ 732 w 1567"/>
                <a:gd name="T41" fmla="*/ 17 h 31"/>
                <a:gd name="T42" fmla="*/ 738 w 1567"/>
                <a:gd name="T43" fmla="*/ 17 h 31"/>
                <a:gd name="T44" fmla="*/ 738 w 1567"/>
                <a:gd name="T45" fmla="*/ 0 h 31"/>
                <a:gd name="T46" fmla="*/ 751 w 1567"/>
                <a:gd name="T47" fmla="*/ 0 h 31"/>
                <a:gd name="T48" fmla="*/ 769 w 1567"/>
                <a:gd name="T49" fmla="*/ 0 h 31"/>
                <a:gd name="T50" fmla="*/ 774 w 1567"/>
                <a:gd name="T51" fmla="*/ 0 h 31"/>
                <a:gd name="T52" fmla="*/ 781 w 1567"/>
                <a:gd name="T53" fmla="*/ 0 h 31"/>
                <a:gd name="T54" fmla="*/ 786 w 1567"/>
                <a:gd name="T55" fmla="*/ 0 h 31"/>
                <a:gd name="T56" fmla="*/ 794 w 1567"/>
                <a:gd name="T57" fmla="*/ 0 h 31"/>
                <a:gd name="T58" fmla="*/ 800 w 1567"/>
                <a:gd name="T59" fmla="*/ 0 h 31"/>
                <a:gd name="T60" fmla="*/ 804 w 1567"/>
                <a:gd name="T61" fmla="*/ 0 h 31"/>
                <a:gd name="T62" fmla="*/ 819 w 1567"/>
                <a:gd name="T63" fmla="*/ 0 h 31"/>
                <a:gd name="T64" fmla="*/ 824 w 1567"/>
                <a:gd name="T65" fmla="*/ 0 h 31"/>
                <a:gd name="T66" fmla="*/ 829 w 1567"/>
                <a:gd name="T67" fmla="*/ 0 h 31"/>
                <a:gd name="T68" fmla="*/ 835 w 1567"/>
                <a:gd name="T69" fmla="*/ 0 h 31"/>
                <a:gd name="T70" fmla="*/ 841 w 1567"/>
                <a:gd name="T71" fmla="*/ 0 h 31"/>
                <a:gd name="T72" fmla="*/ 851 w 1567"/>
                <a:gd name="T73" fmla="*/ 0 h 31"/>
                <a:gd name="T74" fmla="*/ 862 w 1567"/>
                <a:gd name="T75" fmla="*/ 0 h 31"/>
                <a:gd name="T76" fmla="*/ 865 w 1567"/>
                <a:gd name="T77" fmla="*/ 0 h 31"/>
                <a:gd name="T78" fmla="*/ 870 w 1567"/>
                <a:gd name="T79" fmla="*/ 0 h 31"/>
                <a:gd name="T80" fmla="*/ 883 w 1567"/>
                <a:gd name="T81" fmla="*/ 0 h 31"/>
                <a:gd name="T82" fmla="*/ 888 w 1567"/>
                <a:gd name="T83" fmla="*/ 0 h 31"/>
                <a:gd name="T84" fmla="*/ 895 w 1567"/>
                <a:gd name="T85" fmla="*/ 0 h 31"/>
                <a:gd name="T86" fmla="*/ 900 w 1567"/>
                <a:gd name="T87" fmla="*/ 0 h 31"/>
                <a:gd name="T88" fmla="*/ 913 w 1567"/>
                <a:gd name="T89" fmla="*/ 0 h 31"/>
                <a:gd name="T90" fmla="*/ 971 w 1567"/>
                <a:gd name="T91" fmla="*/ 0 h 31"/>
                <a:gd name="T92" fmla="*/ 1139 w 1567"/>
                <a:gd name="T93" fmla="*/ 0 h 31"/>
                <a:gd name="T94" fmla="*/ 1150 w 1567"/>
                <a:gd name="T95" fmla="*/ 0 h 31"/>
                <a:gd name="T96" fmla="*/ 1237 w 1567"/>
                <a:gd name="T97" fmla="*/ 0 h 31"/>
                <a:gd name="T98" fmla="*/ 1324 w 1567"/>
                <a:gd name="T99" fmla="*/ 0 h 31"/>
                <a:gd name="T100" fmla="*/ 1567 w 1567"/>
                <a:gd name="T101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567" h="31">
                  <a:moveTo>
                    <a:pt x="0" y="31"/>
                  </a:moveTo>
                  <a:lnTo>
                    <a:pt x="167" y="31"/>
                  </a:lnTo>
                  <a:lnTo>
                    <a:pt x="464" y="31"/>
                  </a:lnTo>
                  <a:lnTo>
                    <a:pt x="494" y="31"/>
                  </a:lnTo>
                  <a:lnTo>
                    <a:pt x="498" y="31"/>
                  </a:lnTo>
                  <a:lnTo>
                    <a:pt x="509" y="31"/>
                  </a:lnTo>
                  <a:lnTo>
                    <a:pt x="515" y="31"/>
                  </a:lnTo>
                  <a:lnTo>
                    <a:pt x="522" y="31"/>
                  </a:lnTo>
                  <a:lnTo>
                    <a:pt x="522" y="17"/>
                  </a:lnTo>
                  <a:lnTo>
                    <a:pt x="587" y="17"/>
                  </a:lnTo>
                  <a:lnTo>
                    <a:pt x="587" y="17"/>
                  </a:lnTo>
                  <a:lnTo>
                    <a:pt x="594" y="17"/>
                  </a:lnTo>
                  <a:lnTo>
                    <a:pt x="615" y="17"/>
                  </a:lnTo>
                  <a:lnTo>
                    <a:pt x="622" y="17"/>
                  </a:lnTo>
                  <a:lnTo>
                    <a:pt x="631" y="17"/>
                  </a:lnTo>
                  <a:lnTo>
                    <a:pt x="652" y="17"/>
                  </a:lnTo>
                  <a:lnTo>
                    <a:pt x="678" y="17"/>
                  </a:lnTo>
                  <a:lnTo>
                    <a:pt x="693" y="17"/>
                  </a:lnTo>
                  <a:lnTo>
                    <a:pt x="697" y="17"/>
                  </a:lnTo>
                  <a:lnTo>
                    <a:pt x="719" y="17"/>
                  </a:lnTo>
                  <a:lnTo>
                    <a:pt x="732" y="17"/>
                  </a:lnTo>
                  <a:lnTo>
                    <a:pt x="738" y="17"/>
                  </a:lnTo>
                  <a:lnTo>
                    <a:pt x="738" y="0"/>
                  </a:lnTo>
                  <a:lnTo>
                    <a:pt x="751" y="0"/>
                  </a:lnTo>
                  <a:lnTo>
                    <a:pt x="769" y="0"/>
                  </a:lnTo>
                  <a:lnTo>
                    <a:pt x="774" y="0"/>
                  </a:lnTo>
                  <a:lnTo>
                    <a:pt x="781" y="0"/>
                  </a:lnTo>
                  <a:lnTo>
                    <a:pt x="786" y="0"/>
                  </a:lnTo>
                  <a:lnTo>
                    <a:pt x="794" y="0"/>
                  </a:lnTo>
                  <a:lnTo>
                    <a:pt x="800" y="0"/>
                  </a:lnTo>
                  <a:lnTo>
                    <a:pt x="804" y="0"/>
                  </a:lnTo>
                  <a:lnTo>
                    <a:pt x="819" y="0"/>
                  </a:lnTo>
                  <a:lnTo>
                    <a:pt x="824" y="0"/>
                  </a:lnTo>
                  <a:lnTo>
                    <a:pt x="829" y="0"/>
                  </a:lnTo>
                  <a:lnTo>
                    <a:pt x="835" y="0"/>
                  </a:lnTo>
                  <a:lnTo>
                    <a:pt x="841" y="0"/>
                  </a:lnTo>
                  <a:lnTo>
                    <a:pt x="851" y="0"/>
                  </a:lnTo>
                  <a:lnTo>
                    <a:pt x="862" y="0"/>
                  </a:lnTo>
                  <a:lnTo>
                    <a:pt x="865" y="0"/>
                  </a:lnTo>
                  <a:lnTo>
                    <a:pt x="870" y="0"/>
                  </a:lnTo>
                  <a:lnTo>
                    <a:pt x="883" y="0"/>
                  </a:lnTo>
                  <a:lnTo>
                    <a:pt x="888" y="0"/>
                  </a:lnTo>
                  <a:lnTo>
                    <a:pt x="895" y="0"/>
                  </a:lnTo>
                  <a:lnTo>
                    <a:pt x="900" y="0"/>
                  </a:lnTo>
                  <a:lnTo>
                    <a:pt x="913" y="0"/>
                  </a:lnTo>
                  <a:lnTo>
                    <a:pt x="971" y="0"/>
                  </a:lnTo>
                  <a:lnTo>
                    <a:pt x="1139" y="0"/>
                  </a:lnTo>
                  <a:lnTo>
                    <a:pt x="1150" y="0"/>
                  </a:lnTo>
                  <a:lnTo>
                    <a:pt x="1237" y="0"/>
                  </a:lnTo>
                  <a:lnTo>
                    <a:pt x="1324" y="0"/>
                  </a:lnTo>
                  <a:lnTo>
                    <a:pt x="1567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5D26E6B-12B9-7E6A-8D37-F7D54178734A}"/>
              </a:ext>
            </a:extLst>
          </p:cNvPr>
          <p:cNvGrpSpPr/>
          <p:nvPr/>
        </p:nvGrpSpPr>
        <p:grpSpPr>
          <a:xfrm>
            <a:off x="6319428" y="3657844"/>
            <a:ext cx="4141083" cy="2791354"/>
            <a:chOff x="6609708" y="3933610"/>
            <a:chExt cx="4141083" cy="2791354"/>
          </a:xfrm>
        </p:grpSpPr>
        <p:grpSp>
          <p:nvGrpSpPr>
            <p:cNvPr id="238" name="グループ化 237">
              <a:extLst>
                <a:ext uri="{FF2B5EF4-FFF2-40B4-BE49-F238E27FC236}">
                  <a16:creationId xmlns:a16="http://schemas.microsoft.com/office/drawing/2014/main" id="{6B300AF1-6B55-2DF3-B1F3-F463643BCFE1}"/>
                </a:ext>
              </a:extLst>
            </p:cNvPr>
            <p:cNvGrpSpPr/>
            <p:nvPr/>
          </p:nvGrpSpPr>
          <p:grpSpPr>
            <a:xfrm>
              <a:off x="6609708" y="3933610"/>
              <a:ext cx="4141083" cy="2791354"/>
              <a:chOff x="6609708" y="3933610"/>
              <a:chExt cx="4141083" cy="2791354"/>
            </a:xfrm>
          </p:grpSpPr>
          <p:sp>
            <p:nvSpPr>
              <p:cNvPr id="120" name="Rectangle 22">
                <a:extLst>
                  <a:ext uri="{FF2B5EF4-FFF2-40B4-BE49-F238E27FC236}">
                    <a16:creationId xmlns:a16="http://schemas.microsoft.com/office/drawing/2014/main" id="{1838B9FE-F8D4-AC5A-2FD0-E12E20C52E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9632" y="3940131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1" name="Line 23">
                <a:extLst>
                  <a:ext uri="{FF2B5EF4-FFF2-40B4-BE49-F238E27FC236}">
                    <a16:creationId xmlns:a16="http://schemas.microsoft.com/office/drawing/2014/main" id="{8B26A866-29A4-F543-962B-A9D019825C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63965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2" name="Line 25">
                <a:extLst>
                  <a:ext uri="{FF2B5EF4-FFF2-40B4-BE49-F238E27FC236}">
                    <a16:creationId xmlns:a16="http://schemas.microsoft.com/office/drawing/2014/main" id="{5C5B984E-8395-78DF-BDB1-DEAA2AA3B1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87182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3" name="Line 27">
                <a:extLst>
                  <a:ext uri="{FF2B5EF4-FFF2-40B4-BE49-F238E27FC236}">
                    <a16:creationId xmlns:a16="http://schemas.microsoft.com/office/drawing/2014/main" id="{642F76FD-7E61-4E59-F6B9-7D1DE33A8D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510398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4" name="Line 29">
                <a:extLst>
                  <a:ext uri="{FF2B5EF4-FFF2-40B4-BE49-F238E27FC236}">
                    <a16:creationId xmlns:a16="http://schemas.microsoft.com/office/drawing/2014/main" id="{ACFAFBD1-4EAA-B8C3-338A-266E0DD86A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1726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5" name="Line 31">
                <a:extLst>
                  <a:ext uri="{FF2B5EF4-FFF2-40B4-BE49-F238E27FC236}">
                    <a16:creationId xmlns:a16="http://schemas.microsoft.com/office/drawing/2014/main" id="{2FFBEF8C-A2BB-3B74-4AA1-51E74EAE0B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54943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6" name="Line 33">
                <a:extLst>
                  <a:ext uri="{FF2B5EF4-FFF2-40B4-BE49-F238E27FC236}">
                    <a16:creationId xmlns:a16="http://schemas.microsoft.com/office/drawing/2014/main" id="{0A155B83-5CB6-BC4E-B1BA-B1995754D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78159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7" name="Line 35">
                <a:extLst>
                  <a:ext uri="{FF2B5EF4-FFF2-40B4-BE49-F238E27FC236}">
                    <a16:creationId xmlns:a16="http://schemas.microsoft.com/office/drawing/2014/main" id="{542A0862-7BB7-96CD-EA65-902C8C049E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01376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8" name="Line 6">
                <a:extLst>
                  <a:ext uri="{FF2B5EF4-FFF2-40B4-BE49-F238E27FC236}">
                    <a16:creationId xmlns:a16="http://schemas.microsoft.com/office/drawing/2014/main" id="{B0A9B99C-6306-078C-AB2E-B9B7267F8E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5953908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9" name="Line 8">
                <a:extLst>
                  <a:ext uri="{FF2B5EF4-FFF2-40B4-BE49-F238E27FC236}">
                    <a16:creationId xmlns:a16="http://schemas.microsoft.com/office/drawing/2014/main" id="{CBC2C354-D538-EC1E-018E-D79A9329CC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554641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0" name="Line 9">
                <a:extLst>
                  <a:ext uri="{FF2B5EF4-FFF2-40B4-BE49-F238E27FC236}">
                    <a16:creationId xmlns:a16="http://schemas.microsoft.com/office/drawing/2014/main" id="{1EC8F8B0-5F55-9CE6-10CC-2DA4508431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513891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1" name="Line 11">
                <a:extLst>
                  <a:ext uri="{FF2B5EF4-FFF2-40B4-BE49-F238E27FC236}">
                    <a16:creationId xmlns:a16="http://schemas.microsoft.com/office/drawing/2014/main" id="{AAEDA363-1454-9FFF-7747-DC060D572E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473142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2" name="Line 12">
                <a:extLst>
                  <a:ext uri="{FF2B5EF4-FFF2-40B4-BE49-F238E27FC236}">
                    <a16:creationId xmlns:a16="http://schemas.microsoft.com/office/drawing/2014/main" id="{0A26C4A2-EE72-09BB-B348-261FA17B53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432392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3" name="Line 14">
                <a:extLst>
                  <a:ext uri="{FF2B5EF4-FFF2-40B4-BE49-F238E27FC236}">
                    <a16:creationId xmlns:a16="http://schemas.microsoft.com/office/drawing/2014/main" id="{6A52C521-A0E8-2101-0701-E7D969C45B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394033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4" name="Line 23">
                <a:extLst>
                  <a:ext uri="{FF2B5EF4-FFF2-40B4-BE49-F238E27FC236}">
                    <a16:creationId xmlns:a16="http://schemas.microsoft.com/office/drawing/2014/main" id="{A4C7B481-EB61-10FE-1936-75724AF5B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65653" y="5953909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35" name="図形グループ 54">
                <a:extLst>
                  <a:ext uri="{FF2B5EF4-FFF2-40B4-BE49-F238E27FC236}">
                    <a16:creationId xmlns:a16="http://schemas.microsoft.com/office/drawing/2014/main" id="{DDF5EE13-DE3C-C916-A17D-A1799195D072}"/>
                  </a:ext>
                </a:extLst>
              </p:cNvPr>
              <p:cNvGrpSpPr/>
              <p:nvPr/>
            </p:nvGrpSpPr>
            <p:grpSpPr>
              <a:xfrm>
                <a:off x="7156047" y="4194832"/>
                <a:ext cx="220989" cy="1868530"/>
                <a:chOff x="510218" y="1348283"/>
                <a:chExt cx="220989" cy="1868530"/>
              </a:xfrm>
            </p:grpSpPr>
            <p:sp>
              <p:nvSpPr>
                <p:cNvPr id="142" name="Rectangle 10">
                  <a:extLst>
                    <a:ext uri="{FF2B5EF4-FFF2-40B4-BE49-F238E27FC236}">
                      <a16:creationId xmlns:a16="http://schemas.microsoft.com/office/drawing/2014/main" id="{25AC9329-2D5A-C9FF-E92B-5ED72AB63F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3" name="Rectangle 13">
                  <a:extLst>
                    <a:ext uri="{FF2B5EF4-FFF2-40B4-BE49-F238E27FC236}">
                      <a16:creationId xmlns:a16="http://schemas.microsoft.com/office/drawing/2014/main" id="{B8F08616-DA6F-E7A0-2CC8-1F2205FD3D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4" name="Rectangle 10">
                  <a:extLst>
                    <a:ext uri="{FF2B5EF4-FFF2-40B4-BE49-F238E27FC236}">
                      <a16:creationId xmlns:a16="http://schemas.microsoft.com/office/drawing/2014/main" id="{74C2AC60-FDBF-B5B2-AB94-35AA396403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E1F98BB6-B268-73FA-CD97-E428D5595D49}"/>
                  </a:ext>
                </a:extLst>
              </p:cNvPr>
              <p:cNvSpPr txBox="1"/>
              <p:nvPr/>
            </p:nvSpPr>
            <p:spPr>
              <a:xfrm>
                <a:off x="7328514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836B5292-5EA9-1754-7B76-E294AA883837}"/>
                  </a:ext>
                </a:extLst>
              </p:cNvPr>
              <p:cNvSpPr txBox="1"/>
              <p:nvPr/>
            </p:nvSpPr>
            <p:spPr>
              <a:xfrm>
                <a:off x="8373053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E506B1AD-0860-1879-1870-F17292AF5315}"/>
                  </a:ext>
                </a:extLst>
              </p:cNvPr>
              <p:cNvSpPr txBox="1"/>
              <p:nvPr/>
            </p:nvSpPr>
            <p:spPr>
              <a:xfrm>
                <a:off x="10462130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E3A09071-C257-2CC4-5A5D-DA1F160CA680}"/>
                  </a:ext>
                </a:extLst>
              </p:cNvPr>
              <p:cNvSpPr txBox="1"/>
              <p:nvPr/>
            </p:nvSpPr>
            <p:spPr>
              <a:xfrm>
                <a:off x="9417592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03E6B8F5-D83C-EF94-C8FB-B0256C6C9A9E}"/>
                  </a:ext>
                </a:extLst>
              </p:cNvPr>
              <p:cNvSpPr txBox="1"/>
              <p:nvPr/>
            </p:nvSpPr>
            <p:spPr>
              <a:xfrm rot="16200000">
                <a:off x="5726613" y="4816705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C589EBFE-257A-D19D-2ADB-1A6C8886FB7B}"/>
                  </a:ext>
                </a:extLst>
              </p:cNvPr>
              <p:cNvSpPr txBox="1"/>
              <p:nvPr/>
            </p:nvSpPr>
            <p:spPr>
              <a:xfrm>
                <a:off x="8230820" y="6355632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60" name="Freeform 138">
              <a:extLst>
                <a:ext uri="{FF2B5EF4-FFF2-40B4-BE49-F238E27FC236}">
                  <a16:creationId xmlns:a16="http://schemas.microsoft.com/office/drawing/2014/main" id="{A0C1BB8D-E01D-AB6F-C767-1EABC1627DB6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3108" y="5559959"/>
              <a:ext cx="2154639" cy="389761"/>
            </a:xfrm>
            <a:custGeom>
              <a:avLst/>
              <a:gdLst>
                <a:gd name="T0" fmla="*/ 0 w 1145"/>
                <a:gd name="T1" fmla="*/ 212 h 212"/>
                <a:gd name="T2" fmla="*/ 138 w 1145"/>
                <a:gd name="T3" fmla="*/ 212 h 212"/>
                <a:gd name="T4" fmla="*/ 138 w 1145"/>
                <a:gd name="T5" fmla="*/ 178 h 212"/>
                <a:gd name="T6" fmla="*/ 289 w 1145"/>
                <a:gd name="T7" fmla="*/ 178 h 212"/>
                <a:gd name="T8" fmla="*/ 342 w 1145"/>
                <a:gd name="T9" fmla="*/ 178 h 212"/>
                <a:gd name="T10" fmla="*/ 342 w 1145"/>
                <a:gd name="T11" fmla="*/ 144 h 212"/>
                <a:gd name="T12" fmla="*/ 349 w 1145"/>
                <a:gd name="T13" fmla="*/ 144 h 212"/>
                <a:gd name="T14" fmla="*/ 349 w 1145"/>
                <a:gd name="T15" fmla="*/ 109 h 212"/>
                <a:gd name="T16" fmla="*/ 400 w 1145"/>
                <a:gd name="T17" fmla="*/ 109 h 212"/>
                <a:gd name="T18" fmla="*/ 436 w 1145"/>
                <a:gd name="T19" fmla="*/ 109 h 212"/>
                <a:gd name="T20" fmla="*/ 457 w 1145"/>
                <a:gd name="T21" fmla="*/ 109 h 212"/>
                <a:gd name="T22" fmla="*/ 457 w 1145"/>
                <a:gd name="T23" fmla="*/ 73 h 212"/>
                <a:gd name="T24" fmla="*/ 474 w 1145"/>
                <a:gd name="T25" fmla="*/ 73 h 212"/>
                <a:gd name="T26" fmla="*/ 474 w 1145"/>
                <a:gd name="T27" fmla="*/ 38 h 212"/>
                <a:gd name="T28" fmla="*/ 522 w 1145"/>
                <a:gd name="T29" fmla="*/ 38 h 212"/>
                <a:gd name="T30" fmla="*/ 579 w 1145"/>
                <a:gd name="T31" fmla="*/ 38 h 212"/>
                <a:gd name="T32" fmla="*/ 590 w 1145"/>
                <a:gd name="T33" fmla="*/ 38 h 212"/>
                <a:gd name="T34" fmla="*/ 595 w 1145"/>
                <a:gd name="T35" fmla="*/ 38 h 212"/>
                <a:gd name="T36" fmla="*/ 595 w 1145"/>
                <a:gd name="T37" fmla="*/ 0 h 212"/>
                <a:gd name="T38" fmla="*/ 613 w 1145"/>
                <a:gd name="T39" fmla="*/ 0 h 212"/>
                <a:gd name="T40" fmla="*/ 625 w 1145"/>
                <a:gd name="T41" fmla="*/ 0 h 212"/>
                <a:gd name="T42" fmla="*/ 638 w 1145"/>
                <a:gd name="T43" fmla="*/ 0 h 212"/>
                <a:gd name="T44" fmla="*/ 642 w 1145"/>
                <a:gd name="T45" fmla="*/ 0 h 212"/>
                <a:gd name="T46" fmla="*/ 649 w 1145"/>
                <a:gd name="T47" fmla="*/ 0 h 212"/>
                <a:gd name="T48" fmla="*/ 654 w 1145"/>
                <a:gd name="T49" fmla="*/ 0 h 212"/>
                <a:gd name="T50" fmla="*/ 669 w 1145"/>
                <a:gd name="T51" fmla="*/ 0 h 212"/>
                <a:gd name="T52" fmla="*/ 674 w 1145"/>
                <a:gd name="T53" fmla="*/ 0 h 212"/>
                <a:gd name="T54" fmla="*/ 678 w 1145"/>
                <a:gd name="T55" fmla="*/ 0 h 212"/>
                <a:gd name="T56" fmla="*/ 687 w 1145"/>
                <a:gd name="T57" fmla="*/ 0 h 212"/>
                <a:gd name="T58" fmla="*/ 691 w 1145"/>
                <a:gd name="T59" fmla="*/ 0 h 212"/>
                <a:gd name="T60" fmla="*/ 729 w 1145"/>
                <a:gd name="T61" fmla="*/ 0 h 212"/>
                <a:gd name="T62" fmla="*/ 740 w 1145"/>
                <a:gd name="T63" fmla="*/ 0 h 212"/>
                <a:gd name="T64" fmla="*/ 748 w 1145"/>
                <a:gd name="T65" fmla="*/ 0 h 212"/>
                <a:gd name="T66" fmla="*/ 759 w 1145"/>
                <a:gd name="T67" fmla="*/ 0 h 212"/>
                <a:gd name="T68" fmla="*/ 763 w 1145"/>
                <a:gd name="T69" fmla="*/ 0 h 212"/>
                <a:gd name="T70" fmla="*/ 769 w 1145"/>
                <a:gd name="T71" fmla="*/ 0 h 212"/>
                <a:gd name="T72" fmla="*/ 774 w 1145"/>
                <a:gd name="T73" fmla="*/ 0 h 212"/>
                <a:gd name="T74" fmla="*/ 785 w 1145"/>
                <a:gd name="T75" fmla="*/ 0 h 212"/>
                <a:gd name="T76" fmla="*/ 791 w 1145"/>
                <a:gd name="T77" fmla="*/ 0 h 212"/>
                <a:gd name="T78" fmla="*/ 804 w 1145"/>
                <a:gd name="T79" fmla="*/ 0 h 212"/>
                <a:gd name="T80" fmla="*/ 835 w 1145"/>
                <a:gd name="T81" fmla="*/ 0 h 212"/>
                <a:gd name="T82" fmla="*/ 860 w 1145"/>
                <a:gd name="T83" fmla="*/ 0 h 212"/>
                <a:gd name="T84" fmla="*/ 870 w 1145"/>
                <a:gd name="T85" fmla="*/ 0 h 212"/>
                <a:gd name="T86" fmla="*/ 882 w 1145"/>
                <a:gd name="T87" fmla="*/ 0 h 212"/>
                <a:gd name="T88" fmla="*/ 894 w 1145"/>
                <a:gd name="T89" fmla="*/ 0 h 212"/>
                <a:gd name="T90" fmla="*/ 895 w 1145"/>
                <a:gd name="T91" fmla="*/ 0 h 212"/>
                <a:gd name="T92" fmla="*/ 942 w 1145"/>
                <a:gd name="T93" fmla="*/ 0 h 212"/>
                <a:gd name="T94" fmla="*/ 963 w 1145"/>
                <a:gd name="T95" fmla="*/ 0 h 212"/>
                <a:gd name="T96" fmla="*/ 1014 w 1145"/>
                <a:gd name="T97" fmla="*/ 0 h 212"/>
                <a:gd name="T98" fmla="*/ 1062 w 1145"/>
                <a:gd name="T99" fmla="*/ 0 h 212"/>
                <a:gd name="T100" fmla="*/ 1121 w 1145"/>
                <a:gd name="T101" fmla="*/ 0 h 212"/>
                <a:gd name="T102" fmla="*/ 1139 w 1145"/>
                <a:gd name="T103" fmla="*/ 0 h 212"/>
                <a:gd name="T104" fmla="*/ 1145 w 1145"/>
                <a:gd name="T105" fmla="*/ 0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1145" h="212">
                  <a:moveTo>
                    <a:pt x="0" y="212"/>
                  </a:moveTo>
                  <a:lnTo>
                    <a:pt x="138" y="212"/>
                  </a:lnTo>
                  <a:lnTo>
                    <a:pt x="138" y="178"/>
                  </a:lnTo>
                  <a:lnTo>
                    <a:pt x="289" y="178"/>
                  </a:lnTo>
                  <a:lnTo>
                    <a:pt x="342" y="178"/>
                  </a:lnTo>
                  <a:lnTo>
                    <a:pt x="342" y="144"/>
                  </a:lnTo>
                  <a:lnTo>
                    <a:pt x="349" y="144"/>
                  </a:lnTo>
                  <a:lnTo>
                    <a:pt x="349" y="109"/>
                  </a:lnTo>
                  <a:lnTo>
                    <a:pt x="400" y="109"/>
                  </a:lnTo>
                  <a:lnTo>
                    <a:pt x="436" y="109"/>
                  </a:lnTo>
                  <a:lnTo>
                    <a:pt x="457" y="109"/>
                  </a:lnTo>
                  <a:lnTo>
                    <a:pt x="457" y="73"/>
                  </a:lnTo>
                  <a:lnTo>
                    <a:pt x="474" y="73"/>
                  </a:lnTo>
                  <a:lnTo>
                    <a:pt x="474" y="38"/>
                  </a:lnTo>
                  <a:lnTo>
                    <a:pt x="522" y="38"/>
                  </a:lnTo>
                  <a:lnTo>
                    <a:pt x="579" y="38"/>
                  </a:lnTo>
                  <a:lnTo>
                    <a:pt x="590" y="38"/>
                  </a:lnTo>
                  <a:lnTo>
                    <a:pt x="595" y="38"/>
                  </a:lnTo>
                  <a:lnTo>
                    <a:pt x="595" y="0"/>
                  </a:lnTo>
                  <a:lnTo>
                    <a:pt x="613" y="0"/>
                  </a:lnTo>
                  <a:lnTo>
                    <a:pt x="625" y="0"/>
                  </a:lnTo>
                  <a:lnTo>
                    <a:pt x="638" y="0"/>
                  </a:lnTo>
                  <a:lnTo>
                    <a:pt x="642" y="0"/>
                  </a:lnTo>
                  <a:lnTo>
                    <a:pt x="649" y="0"/>
                  </a:lnTo>
                  <a:lnTo>
                    <a:pt x="654" y="0"/>
                  </a:lnTo>
                  <a:lnTo>
                    <a:pt x="669" y="0"/>
                  </a:lnTo>
                  <a:lnTo>
                    <a:pt x="674" y="0"/>
                  </a:lnTo>
                  <a:lnTo>
                    <a:pt x="678" y="0"/>
                  </a:lnTo>
                  <a:lnTo>
                    <a:pt x="687" y="0"/>
                  </a:lnTo>
                  <a:lnTo>
                    <a:pt x="691" y="0"/>
                  </a:lnTo>
                  <a:lnTo>
                    <a:pt x="729" y="0"/>
                  </a:lnTo>
                  <a:lnTo>
                    <a:pt x="740" y="0"/>
                  </a:lnTo>
                  <a:lnTo>
                    <a:pt x="748" y="0"/>
                  </a:lnTo>
                  <a:lnTo>
                    <a:pt x="759" y="0"/>
                  </a:lnTo>
                  <a:lnTo>
                    <a:pt x="763" y="0"/>
                  </a:lnTo>
                  <a:lnTo>
                    <a:pt x="769" y="0"/>
                  </a:lnTo>
                  <a:lnTo>
                    <a:pt x="774" y="0"/>
                  </a:lnTo>
                  <a:lnTo>
                    <a:pt x="785" y="0"/>
                  </a:lnTo>
                  <a:lnTo>
                    <a:pt x="791" y="0"/>
                  </a:lnTo>
                  <a:lnTo>
                    <a:pt x="804" y="0"/>
                  </a:lnTo>
                  <a:lnTo>
                    <a:pt x="835" y="0"/>
                  </a:lnTo>
                  <a:lnTo>
                    <a:pt x="860" y="0"/>
                  </a:lnTo>
                  <a:lnTo>
                    <a:pt x="870" y="0"/>
                  </a:lnTo>
                  <a:lnTo>
                    <a:pt x="882" y="0"/>
                  </a:lnTo>
                  <a:lnTo>
                    <a:pt x="894" y="0"/>
                  </a:lnTo>
                  <a:lnTo>
                    <a:pt x="895" y="0"/>
                  </a:lnTo>
                  <a:lnTo>
                    <a:pt x="942" y="0"/>
                  </a:lnTo>
                  <a:lnTo>
                    <a:pt x="963" y="0"/>
                  </a:lnTo>
                  <a:lnTo>
                    <a:pt x="1014" y="0"/>
                  </a:lnTo>
                  <a:lnTo>
                    <a:pt x="1062" y="0"/>
                  </a:lnTo>
                  <a:lnTo>
                    <a:pt x="1121" y="0"/>
                  </a:lnTo>
                  <a:lnTo>
                    <a:pt x="1139" y="0"/>
                  </a:lnTo>
                  <a:lnTo>
                    <a:pt x="1145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Freeform 139">
              <a:extLst>
                <a:ext uri="{FF2B5EF4-FFF2-40B4-BE49-F238E27FC236}">
                  <a16:creationId xmlns:a16="http://schemas.microsoft.com/office/drawing/2014/main" id="{8CD97336-4955-3C6F-2F2C-038F90F0E1BF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3108" y="5949720"/>
              <a:ext cx="2903587" cy="0"/>
            </a:xfrm>
            <a:custGeom>
              <a:avLst/>
              <a:gdLst>
                <a:gd name="T0" fmla="*/ 191 w 1543"/>
                <a:gd name="T1" fmla="*/ 317 w 1543"/>
                <a:gd name="T2" fmla="*/ 388 w 1543"/>
                <a:gd name="T3" fmla="*/ 398 w 1543"/>
                <a:gd name="T4" fmla="*/ 408 w 1543"/>
                <a:gd name="T5" fmla="*/ 448 w 1543"/>
                <a:gd name="T6" fmla="*/ 464 w 1543"/>
                <a:gd name="T7" fmla="*/ 476 w 1543"/>
                <a:gd name="T8" fmla="*/ 493 w 1543"/>
                <a:gd name="T9" fmla="*/ 510 w 1543"/>
                <a:gd name="T10" fmla="*/ 528 w 1543"/>
                <a:gd name="T11" fmla="*/ 542 w 1543"/>
                <a:gd name="T12" fmla="*/ 556 w 1543"/>
                <a:gd name="T13" fmla="*/ 565 w 1543"/>
                <a:gd name="T14" fmla="*/ 582 w 1543"/>
                <a:gd name="T15" fmla="*/ 593 w 1543"/>
                <a:gd name="T16" fmla="*/ 606 w 1543"/>
                <a:gd name="T17" fmla="*/ 618 w 1543"/>
                <a:gd name="T18" fmla="*/ 629 w 1543"/>
                <a:gd name="T19" fmla="*/ 643 w 1543"/>
                <a:gd name="T20" fmla="*/ 654 w 1543"/>
                <a:gd name="T21" fmla="*/ 672 w 1543"/>
                <a:gd name="T22" fmla="*/ 689 w 1543"/>
                <a:gd name="T23" fmla="*/ 695 w 1543"/>
                <a:gd name="T24" fmla="*/ 707 w 1543"/>
                <a:gd name="T25" fmla="*/ 721 w 1543"/>
                <a:gd name="T26" fmla="*/ 732 w 1543"/>
                <a:gd name="T27" fmla="*/ 747 w 1543"/>
                <a:gd name="T28" fmla="*/ 756 w 1543"/>
                <a:gd name="T29" fmla="*/ 770 w 1543"/>
                <a:gd name="T30" fmla="*/ 781 w 1543"/>
                <a:gd name="T31" fmla="*/ 794 w 1543"/>
                <a:gd name="T32" fmla="*/ 804 w 1543"/>
                <a:gd name="T33" fmla="*/ 820 w 1543"/>
                <a:gd name="T34" fmla="*/ 830 w 1543"/>
                <a:gd name="T35" fmla="*/ 846 w 1543"/>
                <a:gd name="T36" fmla="*/ 860 w 1543"/>
                <a:gd name="T37" fmla="*/ 880 w 1543"/>
                <a:gd name="T38" fmla="*/ 896 w 1543"/>
                <a:gd name="T39" fmla="*/ 908 w 1543"/>
                <a:gd name="T40" fmla="*/ 921 w 1543"/>
                <a:gd name="T41" fmla="*/ 944 w 1543"/>
                <a:gd name="T42" fmla="*/ 961 w 1543"/>
                <a:gd name="T43" fmla="*/ 975 w 1543"/>
                <a:gd name="T44" fmla="*/ 991 w 1543"/>
                <a:gd name="T45" fmla="*/ 1008 w 1543"/>
                <a:gd name="T46" fmla="*/ 1036 w 1543"/>
                <a:gd name="T47" fmla="*/ 1127 w 1543"/>
                <a:gd name="T48" fmla="*/ 1172 w 1543"/>
                <a:gd name="T49" fmla="*/ 1300 w 15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</a:cxnLst>
              <a:rect l="0" t="0" r="r" b="b"/>
              <a:pathLst>
                <a:path w="1543">
                  <a:moveTo>
                    <a:pt x="0" y="0"/>
                  </a:moveTo>
                  <a:lnTo>
                    <a:pt x="191" y="0"/>
                  </a:lnTo>
                  <a:lnTo>
                    <a:pt x="259" y="0"/>
                  </a:lnTo>
                  <a:lnTo>
                    <a:pt x="317" y="0"/>
                  </a:lnTo>
                  <a:lnTo>
                    <a:pt x="353" y="0"/>
                  </a:lnTo>
                  <a:lnTo>
                    <a:pt x="388" y="0"/>
                  </a:lnTo>
                  <a:lnTo>
                    <a:pt x="389" y="0"/>
                  </a:lnTo>
                  <a:lnTo>
                    <a:pt x="398" y="0"/>
                  </a:lnTo>
                  <a:lnTo>
                    <a:pt x="402" y="0"/>
                  </a:lnTo>
                  <a:lnTo>
                    <a:pt x="408" y="0"/>
                  </a:lnTo>
                  <a:lnTo>
                    <a:pt x="419" y="0"/>
                  </a:lnTo>
                  <a:lnTo>
                    <a:pt x="448" y="0"/>
                  </a:lnTo>
                  <a:lnTo>
                    <a:pt x="454" y="0"/>
                  </a:lnTo>
                  <a:lnTo>
                    <a:pt x="464" y="0"/>
                  </a:lnTo>
                  <a:lnTo>
                    <a:pt x="467" y="0"/>
                  </a:lnTo>
                  <a:lnTo>
                    <a:pt x="476" y="0"/>
                  </a:lnTo>
                  <a:lnTo>
                    <a:pt x="484" y="0"/>
                  </a:lnTo>
                  <a:lnTo>
                    <a:pt x="493" y="0"/>
                  </a:lnTo>
                  <a:lnTo>
                    <a:pt x="498" y="0"/>
                  </a:lnTo>
                  <a:lnTo>
                    <a:pt x="510" y="0"/>
                  </a:lnTo>
                  <a:lnTo>
                    <a:pt x="518" y="0"/>
                  </a:lnTo>
                  <a:lnTo>
                    <a:pt x="528" y="0"/>
                  </a:lnTo>
                  <a:lnTo>
                    <a:pt x="537" y="0"/>
                  </a:lnTo>
                  <a:lnTo>
                    <a:pt x="542" y="0"/>
                  </a:lnTo>
                  <a:lnTo>
                    <a:pt x="545" y="0"/>
                  </a:lnTo>
                  <a:lnTo>
                    <a:pt x="556" y="0"/>
                  </a:lnTo>
                  <a:lnTo>
                    <a:pt x="557" y="0"/>
                  </a:lnTo>
                  <a:lnTo>
                    <a:pt x="565" y="0"/>
                  </a:lnTo>
                  <a:lnTo>
                    <a:pt x="576" y="0"/>
                  </a:lnTo>
                  <a:lnTo>
                    <a:pt x="582" y="0"/>
                  </a:lnTo>
                  <a:lnTo>
                    <a:pt x="587" y="0"/>
                  </a:lnTo>
                  <a:lnTo>
                    <a:pt x="593" y="0"/>
                  </a:lnTo>
                  <a:lnTo>
                    <a:pt x="599" y="0"/>
                  </a:lnTo>
                  <a:lnTo>
                    <a:pt x="606" y="0"/>
                  </a:lnTo>
                  <a:lnTo>
                    <a:pt x="612" y="0"/>
                  </a:lnTo>
                  <a:lnTo>
                    <a:pt x="618" y="0"/>
                  </a:lnTo>
                  <a:lnTo>
                    <a:pt x="625" y="0"/>
                  </a:lnTo>
                  <a:lnTo>
                    <a:pt x="629" y="0"/>
                  </a:lnTo>
                  <a:lnTo>
                    <a:pt x="636" y="0"/>
                  </a:lnTo>
                  <a:lnTo>
                    <a:pt x="643" y="0"/>
                  </a:lnTo>
                  <a:lnTo>
                    <a:pt x="652" y="0"/>
                  </a:lnTo>
                  <a:lnTo>
                    <a:pt x="654" y="0"/>
                  </a:lnTo>
                  <a:lnTo>
                    <a:pt x="667" y="0"/>
                  </a:lnTo>
                  <a:lnTo>
                    <a:pt x="672" y="0"/>
                  </a:lnTo>
                  <a:lnTo>
                    <a:pt x="679" y="0"/>
                  </a:lnTo>
                  <a:lnTo>
                    <a:pt x="689" y="0"/>
                  </a:lnTo>
                  <a:lnTo>
                    <a:pt x="690" y="0"/>
                  </a:lnTo>
                  <a:lnTo>
                    <a:pt x="695" y="0"/>
                  </a:lnTo>
                  <a:lnTo>
                    <a:pt x="701" y="0"/>
                  </a:lnTo>
                  <a:lnTo>
                    <a:pt x="707" y="0"/>
                  </a:lnTo>
                  <a:lnTo>
                    <a:pt x="718" y="0"/>
                  </a:lnTo>
                  <a:lnTo>
                    <a:pt x="721" y="0"/>
                  </a:lnTo>
                  <a:lnTo>
                    <a:pt x="726" y="0"/>
                  </a:lnTo>
                  <a:lnTo>
                    <a:pt x="732" y="0"/>
                  </a:lnTo>
                  <a:lnTo>
                    <a:pt x="740" y="0"/>
                  </a:lnTo>
                  <a:lnTo>
                    <a:pt x="747" y="0"/>
                  </a:lnTo>
                  <a:lnTo>
                    <a:pt x="751" y="0"/>
                  </a:lnTo>
                  <a:lnTo>
                    <a:pt x="756" y="0"/>
                  </a:lnTo>
                  <a:lnTo>
                    <a:pt x="764" y="0"/>
                  </a:lnTo>
                  <a:lnTo>
                    <a:pt x="770" y="0"/>
                  </a:lnTo>
                  <a:lnTo>
                    <a:pt x="779" y="0"/>
                  </a:lnTo>
                  <a:lnTo>
                    <a:pt x="781" y="0"/>
                  </a:lnTo>
                  <a:lnTo>
                    <a:pt x="786" y="0"/>
                  </a:lnTo>
                  <a:lnTo>
                    <a:pt x="794" y="0"/>
                  </a:lnTo>
                  <a:lnTo>
                    <a:pt x="798" y="0"/>
                  </a:lnTo>
                  <a:lnTo>
                    <a:pt x="804" y="0"/>
                  </a:lnTo>
                  <a:lnTo>
                    <a:pt x="810" y="0"/>
                  </a:lnTo>
                  <a:lnTo>
                    <a:pt x="820" y="0"/>
                  </a:lnTo>
                  <a:lnTo>
                    <a:pt x="823" y="0"/>
                  </a:lnTo>
                  <a:lnTo>
                    <a:pt x="830" y="0"/>
                  </a:lnTo>
                  <a:lnTo>
                    <a:pt x="841" y="0"/>
                  </a:lnTo>
                  <a:lnTo>
                    <a:pt x="846" y="0"/>
                  </a:lnTo>
                  <a:lnTo>
                    <a:pt x="852" y="0"/>
                  </a:lnTo>
                  <a:lnTo>
                    <a:pt x="860" y="0"/>
                  </a:lnTo>
                  <a:lnTo>
                    <a:pt x="865" y="0"/>
                  </a:lnTo>
                  <a:lnTo>
                    <a:pt x="880" y="0"/>
                  </a:lnTo>
                  <a:lnTo>
                    <a:pt x="883" y="0"/>
                  </a:lnTo>
                  <a:lnTo>
                    <a:pt x="896" y="0"/>
                  </a:lnTo>
                  <a:lnTo>
                    <a:pt x="904" y="0"/>
                  </a:lnTo>
                  <a:lnTo>
                    <a:pt x="908" y="0"/>
                  </a:lnTo>
                  <a:lnTo>
                    <a:pt x="913" y="0"/>
                  </a:lnTo>
                  <a:lnTo>
                    <a:pt x="921" y="0"/>
                  </a:lnTo>
                  <a:lnTo>
                    <a:pt x="933" y="0"/>
                  </a:lnTo>
                  <a:lnTo>
                    <a:pt x="944" y="0"/>
                  </a:lnTo>
                  <a:lnTo>
                    <a:pt x="955" y="0"/>
                  </a:lnTo>
                  <a:lnTo>
                    <a:pt x="961" y="0"/>
                  </a:lnTo>
                  <a:lnTo>
                    <a:pt x="969" y="0"/>
                  </a:lnTo>
                  <a:lnTo>
                    <a:pt x="975" y="0"/>
                  </a:lnTo>
                  <a:lnTo>
                    <a:pt x="990" y="0"/>
                  </a:lnTo>
                  <a:lnTo>
                    <a:pt x="991" y="0"/>
                  </a:lnTo>
                  <a:lnTo>
                    <a:pt x="999" y="0"/>
                  </a:lnTo>
                  <a:lnTo>
                    <a:pt x="1008" y="0"/>
                  </a:lnTo>
                  <a:lnTo>
                    <a:pt x="1020" y="0"/>
                  </a:lnTo>
                  <a:lnTo>
                    <a:pt x="1036" y="0"/>
                  </a:lnTo>
                  <a:lnTo>
                    <a:pt x="1106" y="0"/>
                  </a:lnTo>
                  <a:lnTo>
                    <a:pt x="1127" y="0"/>
                  </a:lnTo>
                  <a:lnTo>
                    <a:pt x="1164" y="0"/>
                  </a:lnTo>
                  <a:lnTo>
                    <a:pt x="1172" y="0"/>
                  </a:lnTo>
                  <a:lnTo>
                    <a:pt x="1193" y="0"/>
                  </a:lnTo>
                  <a:lnTo>
                    <a:pt x="1300" y="0"/>
                  </a:lnTo>
                  <a:lnTo>
                    <a:pt x="1543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Freeform 140">
              <a:extLst>
                <a:ext uri="{FF2B5EF4-FFF2-40B4-BE49-F238E27FC236}">
                  <a16:creationId xmlns:a16="http://schemas.microsoft.com/office/drawing/2014/main" id="{3A46C4F4-355F-9E14-CF0F-3F713DDEE14B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3108" y="5120559"/>
              <a:ext cx="2948750" cy="829161"/>
            </a:xfrm>
            <a:custGeom>
              <a:avLst/>
              <a:gdLst>
                <a:gd name="T0" fmla="*/ 166 w 1567"/>
                <a:gd name="T1" fmla="*/ 451 h 451"/>
                <a:gd name="T2" fmla="*/ 216 w 1567"/>
                <a:gd name="T3" fmla="*/ 451 h 451"/>
                <a:gd name="T4" fmla="*/ 254 w 1567"/>
                <a:gd name="T5" fmla="*/ 448 h 451"/>
                <a:gd name="T6" fmla="*/ 288 w 1567"/>
                <a:gd name="T7" fmla="*/ 441 h 451"/>
                <a:gd name="T8" fmla="*/ 315 w 1567"/>
                <a:gd name="T9" fmla="*/ 441 h 451"/>
                <a:gd name="T10" fmla="*/ 345 w 1567"/>
                <a:gd name="T11" fmla="*/ 437 h 451"/>
                <a:gd name="T12" fmla="*/ 365 w 1567"/>
                <a:gd name="T13" fmla="*/ 437 h 451"/>
                <a:gd name="T14" fmla="*/ 383 w 1567"/>
                <a:gd name="T15" fmla="*/ 434 h 451"/>
                <a:gd name="T16" fmla="*/ 407 w 1567"/>
                <a:gd name="T17" fmla="*/ 434 h 451"/>
                <a:gd name="T18" fmla="*/ 425 w 1567"/>
                <a:gd name="T19" fmla="*/ 430 h 451"/>
                <a:gd name="T20" fmla="*/ 445 w 1567"/>
                <a:gd name="T21" fmla="*/ 430 h 451"/>
                <a:gd name="T22" fmla="*/ 458 w 1567"/>
                <a:gd name="T23" fmla="*/ 427 h 451"/>
                <a:gd name="T24" fmla="*/ 475 w 1567"/>
                <a:gd name="T25" fmla="*/ 427 h 451"/>
                <a:gd name="T26" fmla="*/ 484 w 1567"/>
                <a:gd name="T27" fmla="*/ 416 h 451"/>
                <a:gd name="T28" fmla="*/ 500 w 1567"/>
                <a:gd name="T29" fmla="*/ 416 h 451"/>
                <a:gd name="T30" fmla="*/ 521 w 1567"/>
                <a:gd name="T31" fmla="*/ 416 h 451"/>
                <a:gd name="T32" fmla="*/ 536 w 1567"/>
                <a:gd name="T33" fmla="*/ 409 h 451"/>
                <a:gd name="T34" fmla="*/ 552 w 1567"/>
                <a:gd name="T35" fmla="*/ 409 h 451"/>
                <a:gd name="T36" fmla="*/ 571 w 1567"/>
                <a:gd name="T37" fmla="*/ 409 h 451"/>
                <a:gd name="T38" fmla="*/ 589 w 1567"/>
                <a:gd name="T39" fmla="*/ 409 h 451"/>
                <a:gd name="T40" fmla="*/ 606 w 1567"/>
                <a:gd name="T41" fmla="*/ 409 h 451"/>
                <a:gd name="T42" fmla="*/ 623 w 1567"/>
                <a:gd name="T43" fmla="*/ 409 h 451"/>
                <a:gd name="T44" fmla="*/ 635 w 1567"/>
                <a:gd name="T45" fmla="*/ 404 h 451"/>
                <a:gd name="T46" fmla="*/ 654 w 1567"/>
                <a:gd name="T47" fmla="*/ 400 h 451"/>
                <a:gd name="T48" fmla="*/ 669 w 1567"/>
                <a:gd name="T49" fmla="*/ 395 h 451"/>
                <a:gd name="T50" fmla="*/ 675 w 1567"/>
                <a:gd name="T51" fmla="*/ 385 h 451"/>
                <a:gd name="T52" fmla="*/ 684 w 1567"/>
                <a:gd name="T53" fmla="*/ 380 h 451"/>
                <a:gd name="T54" fmla="*/ 701 w 1567"/>
                <a:gd name="T55" fmla="*/ 380 h 451"/>
                <a:gd name="T56" fmla="*/ 717 w 1567"/>
                <a:gd name="T57" fmla="*/ 374 h 451"/>
                <a:gd name="T58" fmla="*/ 731 w 1567"/>
                <a:gd name="T59" fmla="*/ 374 h 451"/>
                <a:gd name="T60" fmla="*/ 744 w 1567"/>
                <a:gd name="T61" fmla="*/ 368 h 451"/>
                <a:gd name="T62" fmla="*/ 761 w 1567"/>
                <a:gd name="T63" fmla="*/ 368 h 451"/>
                <a:gd name="T64" fmla="*/ 774 w 1567"/>
                <a:gd name="T65" fmla="*/ 359 h 451"/>
                <a:gd name="T66" fmla="*/ 792 w 1567"/>
                <a:gd name="T67" fmla="*/ 359 h 451"/>
                <a:gd name="T68" fmla="*/ 813 w 1567"/>
                <a:gd name="T69" fmla="*/ 359 h 451"/>
                <a:gd name="T70" fmla="*/ 824 w 1567"/>
                <a:gd name="T71" fmla="*/ 347 h 451"/>
                <a:gd name="T72" fmla="*/ 841 w 1567"/>
                <a:gd name="T73" fmla="*/ 347 h 451"/>
                <a:gd name="T74" fmla="*/ 846 w 1567"/>
                <a:gd name="T75" fmla="*/ 319 h 451"/>
                <a:gd name="T76" fmla="*/ 860 w 1567"/>
                <a:gd name="T77" fmla="*/ 304 h 451"/>
                <a:gd name="T78" fmla="*/ 870 w 1567"/>
                <a:gd name="T79" fmla="*/ 287 h 451"/>
                <a:gd name="T80" fmla="*/ 888 w 1567"/>
                <a:gd name="T81" fmla="*/ 287 h 451"/>
                <a:gd name="T82" fmla="*/ 906 w 1567"/>
                <a:gd name="T83" fmla="*/ 287 h 451"/>
                <a:gd name="T84" fmla="*/ 927 w 1567"/>
                <a:gd name="T85" fmla="*/ 287 h 451"/>
                <a:gd name="T86" fmla="*/ 943 w 1567"/>
                <a:gd name="T87" fmla="*/ 287 h 451"/>
                <a:gd name="T88" fmla="*/ 964 w 1567"/>
                <a:gd name="T89" fmla="*/ 287 h 451"/>
                <a:gd name="T90" fmla="*/ 990 w 1567"/>
                <a:gd name="T91" fmla="*/ 287 h 451"/>
                <a:gd name="T92" fmla="*/ 1006 w 1567"/>
                <a:gd name="T93" fmla="*/ 287 h 451"/>
                <a:gd name="T94" fmla="*/ 1028 w 1567"/>
                <a:gd name="T95" fmla="*/ 287 h 451"/>
                <a:gd name="T96" fmla="*/ 1061 w 1567"/>
                <a:gd name="T97" fmla="*/ 287 h 451"/>
                <a:gd name="T98" fmla="*/ 1106 w 1567"/>
                <a:gd name="T99" fmla="*/ 287 h 451"/>
                <a:gd name="T100" fmla="*/ 1150 w 1567"/>
                <a:gd name="T101" fmla="*/ 287 h 451"/>
                <a:gd name="T102" fmla="*/ 1180 w 1567"/>
                <a:gd name="T103" fmla="*/ 287 h 451"/>
                <a:gd name="T104" fmla="*/ 1225 w 1567"/>
                <a:gd name="T105" fmla="*/ 287 h 451"/>
                <a:gd name="T106" fmla="*/ 1245 w 1567"/>
                <a:gd name="T107" fmla="*/ 287 h 451"/>
                <a:gd name="T108" fmla="*/ 1312 w 1567"/>
                <a:gd name="T109" fmla="*/ 0 h 451"/>
                <a:gd name="T110" fmla="*/ 1387 w 1567"/>
                <a:gd name="T111" fmla="*/ 0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1567" h="451">
                  <a:moveTo>
                    <a:pt x="0" y="451"/>
                  </a:moveTo>
                  <a:lnTo>
                    <a:pt x="165" y="451"/>
                  </a:lnTo>
                  <a:lnTo>
                    <a:pt x="166" y="451"/>
                  </a:lnTo>
                  <a:lnTo>
                    <a:pt x="193" y="451"/>
                  </a:lnTo>
                  <a:lnTo>
                    <a:pt x="213" y="451"/>
                  </a:lnTo>
                  <a:lnTo>
                    <a:pt x="216" y="451"/>
                  </a:lnTo>
                  <a:lnTo>
                    <a:pt x="216" y="448"/>
                  </a:lnTo>
                  <a:lnTo>
                    <a:pt x="228" y="448"/>
                  </a:lnTo>
                  <a:lnTo>
                    <a:pt x="254" y="448"/>
                  </a:lnTo>
                  <a:lnTo>
                    <a:pt x="282" y="444"/>
                  </a:lnTo>
                  <a:lnTo>
                    <a:pt x="285" y="441"/>
                  </a:lnTo>
                  <a:lnTo>
                    <a:pt x="288" y="441"/>
                  </a:lnTo>
                  <a:lnTo>
                    <a:pt x="299" y="441"/>
                  </a:lnTo>
                  <a:lnTo>
                    <a:pt x="308" y="441"/>
                  </a:lnTo>
                  <a:lnTo>
                    <a:pt x="315" y="441"/>
                  </a:lnTo>
                  <a:lnTo>
                    <a:pt x="322" y="441"/>
                  </a:lnTo>
                  <a:lnTo>
                    <a:pt x="325" y="437"/>
                  </a:lnTo>
                  <a:lnTo>
                    <a:pt x="345" y="437"/>
                  </a:lnTo>
                  <a:lnTo>
                    <a:pt x="351" y="437"/>
                  </a:lnTo>
                  <a:lnTo>
                    <a:pt x="358" y="437"/>
                  </a:lnTo>
                  <a:lnTo>
                    <a:pt x="365" y="437"/>
                  </a:lnTo>
                  <a:lnTo>
                    <a:pt x="378" y="437"/>
                  </a:lnTo>
                  <a:lnTo>
                    <a:pt x="378" y="434"/>
                  </a:lnTo>
                  <a:lnTo>
                    <a:pt x="383" y="434"/>
                  </a:lnTo>
                  <a:lnTo>
                    <a:pt x="398" y="434"/>
                  </a:lnTo>
                  <a:lnTo>
                    <a:pt x="403" y="434"/>
                  </a:lnTo>
                  <a:lnTo>
                    <a:pt x="407" y="434"/>
                  </a:lnTo>
                  <a:lnTo>
                    <a:pt x="417" y="434"/>
                  </a:lnTo>
                  <a:lnTo>
                    <a:pt x="420" y="430"/>
                  </a:lnTo>
                  <a:lnTo>
                    <a:pt x="425" y="430"/>
                  </a:lnTo>
                  <a:lnTo>
                    <a:pt x="432" y="430"/>
                  </a:lnTo>
                  <a:lnTo>
                    <a:pt x="439" y="430"/>
                  </a:lnTo>
                  <a:lnTo>
                    <a:pt x="445" y="430"/>
                  </a:lnTo>
                  <a:lnTo>
                    <a:pt x="450" y="430"/>
                  </a:lnTo>
                  <a:lnTo>
                    <a:pt x="450" y="427"/>
                  </a:lnTo>
                  <a:lnTo>
                    <a:pt x="458" y="427"/>
                  </a:lnTo>
                  <a:lnTo>
                    <a:pt x="464" y="427"/>
                  </a:lnTo>
                  <a:lnTo>
                    <a:pt x="467" y="427"/>
                  </a:lnTo>
                  <a:lnTo>
                    <a:pt x="475" y="427"/>
                  </a:lnTo>
                  <a:lnTo>
                    <a:pt x="479" y="427"/>
                  </a:lnTo>
                  <a:lnTo>
                    <a:pt x="479" y="423"/>
                  </a:lnTo>
                  <a:lnTo>
                    <a:pt x="484" y="416"/>
                  </a:lnTo>
                  <a:lnTo>
                    <a:pt x="484" y="416"/>
                  </a:lnTo>
                  <a:lnTo>
                    <a:pt x="494" y="416"/>
                  </a:lnTo>
                  <a:lnTo>
                    <a:pt x="500" y="416"/>
                  </a:lnTo>
                  <a:lnTo>
                    <a:pt x="509" y="416"/>
                  </a:lnTo>
                  <a:lnTo>
                    <a:pt x="515" y="416"/>
                  </a:lnTo>
                  <a:lnTo>
                    <a:pt x="521" y="416"/>
                  </a:lnTo>
                  <a:lnTo>
                    <a:pt x="528" y="412"/>
                  </a:lnTo>
                  <a:lnTo>
                    <a:pt x="534" y="412"/>
                  </a:lnTo>
                  <a:lnTo>
                    <a:pt x="536" y="409"/>
                  </a:lnTo>
                  <a:lnTo>
                    <a:pt x="543" y="409"/>
                  </a:lnTo>
                  <a:lnTo>
                    <a:pt x="546" y="409"/>
                  </a:lnTo>
                  <a:lnTo>
                    <a:pt x="552" y="409"/>
                  </a:lnTo>
                  <a:lnTo>
                    <a:pt x="559" y="409"/>
                  </a:lnTo>
                  <a:lnTo>
                    <a:pt x="564" y="409"/>
                  </a:lnTo>
                  <a:lnTo>
                    <a:pt x="571" y="409"/>
                  </a:lnTo>
                  <a:lnTo>
                    <a:pt x="575" y="409"/>
                  </a:lnTo>
                  <a:lnTo>
                    <a:pt x="582" y="409"/>
                  </a:lnTo>
                  <a:lnTo>
                    <a:pt x="589" y="409"/>
                  </a:lnTo>
                  <a:lnTo>
                    <a:pt x="593" y="409"/>
                  </a:lnTo>
                  <a:lnTo>
                    <a:pt x="600" y="409"/>
                  </a:lnTo>
                  <a:lnTo>
                    <a:pt x="606" y="409"/>
                  </a:lnTo>
                  <a:lnTo>
                    <a:pt x="612" y="409"/>
                  </a:lnTo>
                  <a:lnTo>
                    <a:pt x="618" y="409"/>
                  </a:lnTo>
                  <a:lnTo>
                    <a:pt x="623" y="409"/>
                  </a:lnTo>
                  <a:lnTo>
                    <a:pt x="626" y="404"/>
                  </a:lnTo>
                  <a:lnTo>
                    <a:pt x="629" y="404"/>
                  </a:lnTo>
                  <a:lnTo>
                    <a:pt x="635" y="404"/>
                  </a:lnTo>
                  <a:lnTo>
                    <a:pt x="643" y="404"/>
                  </a:lnTo>
                  <a:lnTo>
                    <a:pt x="648" y="400"/>
                  </a:lnTo>
                  <a:lnTo>
                    <a:pt x="654" y="400"/>
                  </a:lnTo>
                  <a:lnTo>
                    <a:pt x="660" y="400"/>
                  </a:lnTo>
                  <a:lnTo>
                    <a:pt x="664" y="395"/>
                  </a:lnTo>
                  <a:lnTo>
                    <a:pt x="669" y="395"/>
                  </a:lnTo>
                  <a:lnTo>
                    <a:pt x="672" y="395"/>
                  </a:lnTo>
                  <a:lnTo>
                    <a:pt x="674" y="390"/>
                  </a:lnTo>
                  <a:lnTo>
                    <a:pt x="675" y="385"/>
                  </a:lnTo>
                  <a:lnTo>
                    <a:pt x="678" y="385"/>
                  </a:lnTo>
                  <a:lnTo>
                    <a:pt x="683" y="380"/>
                  </a:lnTo>
                  <a:lnTo>
                    <a:pt x="684" y="380"/>
                  </a:lnTo>
                  <a:lnTo>
                    <a:pt x="690" y="380"/>
                  </a:lnTo>
                  <a:lnTo>
                    <a:pt x="695" y="380"/>
                  </a:lnTo>
                  <a:lnTo>
                    <a:pt x="701" y="380"/>
                  </a:lnTo>
                  <a:lnTo>
                    <a:pt x="708" y="380"/>
                  </a:lnTo>
                  <a:lnTo>
                    <a:pt x="714" y="380"/>
                  </a:lnTo>
                  <a:lnTo>
                    <a:pt x="717" y="374"/>
                  </a:lnTo>
                  <a:lnTo>
                    <a:pt x="720" y="374"/>
                  </a:lnTo>
                  <a:lnTo>
                    <a:pt x="726" y="374"/>
                  </a:lnTo>
                  <a:lnTo>
                    <a:pt x="731" y="374"/>
                  </a:lnTo>
                  <a:lnTo>
                    <a:pt x="737" y="374"/>
                  </a:lnTo>
                  <a:lnTo>
                    <a:pt x="738" y="368"/>
                  </a:lnTo>
                  <a:lnTo>
                    <a:pt x="744" y="368"/>
                  </a:lnTo>
                  <a:lnTo>
                    <a:pt x="751" y="368"/>
                  </a:lnTo>
                  <a:lnTo>
                    <a:pt x="756" y="368"/>
                  </a:lnTo>
                  <a:lnTo>
                    <a:pt x="761" y="368"/>
                  </a:lnTo>
                  <a:lnTo>
                    <a:pt x="768" y="368"/>
                  </a:lnTo>
                  <a:lnTo>
                    <a:pt x="773" y="359"/>
                  </a:lnTo>
                  <a:lnTo>
                    <a:pt x="774" y="359"/>
                  </a:lnTo>
                  <a:lnTo>
                    <a:pt x="780" y="359"/>
                  </a:lnTo>
                  <a:lnTo>
                    <a:pt x="786" y="359"/>
                  </a:lnTo>
                  <a:lnTo>
                    <a:pt x="792" y="359"/>
                  </a:lnTo>
                  <a:lnTo>
                    <a:pt x="800" y="359"/>
                  </a:lnTo>
                  <a:lnTo>
                    <a:pt x="804" y="359"/>
                  </a:lnTo>
                  <a:lnTo>
                    <a:pt x="813" y="359"/>
                  </a:lnTo>
                  <a:lnTo>
                    <a:pt x="816" y="359"/>
                  </a:lnTo>
                  <a:lnTo>
                    <a:pt x="823" y="359"/>
                  </a:lnTo>
                  <a:lnTo>
                    <a:pt x="824" y="347"/>
                  </a:lnTo>
                  <a:lnTo>
                    <a:pt x="829" y="347"/>
                  </a:lnTo>
                  <a:lnTo>
                    <a:pt x="835" y="347"/>
                  </a:lnTo>
                  <a:lnTo>
                    <a:pt x="841" y="347"/>
                  </a:lnTo>
                  <a:lnTo>
                    <a:pt x="844" y="333"/>
                  </a:lnTo>
                  <a:lnTo>
                    <a:pt x="846" y="333"/>
                  </a:lnTo>
                  <a:lnTo>
                    <a:pt x="846" y="319"/>
                  </a:lnTo>
                  <a:lnTo>
                    <a:pt x="853" y="319"/>
                  </a:lnTo>
                  <a:lnTo>
                    <a:pt x="854" y="304"/>
                  </a:lnTo>
                  <a:lnTo>
                    <a:pt x="860" y="304"/>
                  </a:lnTo>
                  <a:lnTo>
                    <a:pt x="864" y="304"/>
                  </a:lnTo>
                  <a:lnTo>
                    <a:pt x="870" y="304"/>
                  </a:lnTo>
                  <a:lnTo>
                    <a:pt x="870" y="287"/>
                  </a:lnTo>
                  <a:lnTo>
                    <a:pt x="878" y="287"/>
                  </a:lnTo>
                  <a:lnTo>
                    <a:pt x="883" y="287"/>
                  </a:lnTo>
                  <a:lnTo>
                    <a:pt x="888" y="287"/>
                  </a:lnTo>
                  <a:lnTo>
                    <a:pt x="894" y="287"/>
                  </a:lnTo>
                  <a:lnTo>
                    <a:pt x="900" y="287"/>
                  </a:lnTo>
                  <a:lnTo>
                    <a:pt x="906" y="287"/>
                  </a:lnTo>
                  <a:lnTo>
                    <a:pt x="913" y="287"/>
                  </a:lnTo>
                  <a:lnTo>
                    <a:pt x="920" y="287"/>
                  </a:lnTo>
                  <a:lnTo>
                    <a:pt x="927" y="287"/>
                  </a:lnTo>
                  <a:lnTo>
                    <a:pt x="932" y="287"/>
                  </a:lnTo>
                  <a:lnTo>
                    <a:pt x="937" y="287"/>
                  </a:lnTo>
                  <a:lnTo>
                    <a:pt x="943" y="287"/>
                  </a:lnTo>
                  <a:lnTo>
                    <a:pt x="951" y="287"/>
                  </a:lnTo>
                  <a:lnTo>
                    <a:pt x="960" y="287"/>
                  </a:lnTo>
                  <a:lnTo>
                    <a:pt x="964" y="287"/>
                  </a:lnTo>
                  <a:lnTo>
                    <a:pt x="970" y="287"/>
                  </a:lnTo>
                  <a:lnTo>
                    <a:pt x="974" y="287"/>
                  </a:lnTo>
                  <a:lnTo>
                    <a:pt x="990" y="287"/>
                  </a:lnTo>
                  <a:lnTo>
                    <a:pt x="994" y="287"/>
                  </a:lnTo>
                  <a:lnTo>
                    <a:pt x="999" y="287"/>
                  </a:lnTo>
                  <a:lnTo>
                    <a:pt x="1006" y="287"/>
                  </a:lnTo>
                  <a:lnTo>
                    <a:pt x="1017" y="287"/>
                  </a:lnTo>
                  <a:lnTo>
                    <a:pt x="1024" y="287"/>
                  </a:lnTo>
                  <a:lnTo>
                    <a:pt x="1028" y="287"/>
                  </a:lnTo>
                  <a:lnTo>
                    <a:pt x="1041" y="287"/>
                  </a:lnTo>
                  <a:lnTo>
                    <a:pt x="1047" y="287"/>
                  </a:lnTo>
                  <a:lnTo>
                    <a:pt x="1061" y="287"/>
                  </a:lnTo>
                  <a:lnTo>
                    <a:pt x="1063" y="287"/>
                  </a:lnTo>
                  <a:lnTo>
                    <a:pt x="1103" y="287"/>
                  </a:lnTo>
                  <a:lnTo>
                    <a:pt x="1106" y="287"/>
                  </a:lnTo>
                  <a:lnTo>
                    <a:pt x="1120" y="287"/>
                  </a:lnTo>
                  <a:lnTo>
                    <a:pt x="1141" y="287"/>
                  </a:lnTo>
                  <a:lnTo>
                    <a:pt x="1150" y="287"/>
                  </a:lnTo>
                  <a:lnTo>
                    <a:pt x="1166" y="287"/>
                  </a:lnTo>
                  <a:lnTo>
                    <a:pt x="1171" y="287"/>
                  </a:lnTo>
                  <a:lnTo>
                    <a:pt x="1180" y="287"/>
                  </a:lnTo>
                  <a:lnTo>
                    <a:pt x="1203" y="287"/>
                  </a:lnTo>
                  <a:lnTo>
                    <a:pt x="1214" y="287"/>
                  </a:lnTo>
                  <a:lnTo>
                    <a:pt x="1225" y="287"/>
                  </a:lnTo>
                  <a:lnTo>
                    <a:pt x="1233" y="287"/>
                  </a:lnTo>
                  <a:lnTo>
                    <a:pt x="1237" y="287"/>
                  </a:lnTo>
                  <a:lnTo>
                    <a:pt x="1245" y="287"/>
                  </a:lnTo>
                  <a:lnTo>
                    <a:pt x="1265" y="287"/>
                  </a:lnTo>
                  <a:lnTo>
                    <a:pt x="1265" y="0"/>
                  </a:lnTo>
                  <a:lnTo>
                    <a:pt x="1312" y="0"/>
                  </a:lnTo>
                  <a:lnTo>
                    <a:pt x="1324" y="0"/>
                  </a:lnTo>
                  <a:lnTo>
                    <a:pt x="1337" y="0"/>
                  </a:lnTo>
                  <a:lnTo>
                    <a:pt x="1387" y="0"/>
                  </a:lnTo>
                  <a:lnTo>
                    <a:pt x="1526" y="0"/>
                  </a:lnTo>
                  <a:lnTo>
                    <a:pt x="1567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BB5F5E8-63D4-3184-0970-182F64D03F98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E962DE1-BBE5-480F-9D5D-A2F4F8BFF3EB}"/>
              </a:ext>
            </a:extLst>
          </p:cNvPr>
          <p:cNvSpPr txBox="1"/>
          <p:nvPr/>
        </p:nvSpPr>
        <p:spPr>
          <a:xfrm>
            <a:off x="886249" y="38268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E385E99-40C6-5F8D-22CB-695E03A05B4D}"/>
              </a:ext>
            </a:extLst>
          </p:cNvPr>
          <p:cNvSpPr txBox="1"/>
          <p:nvPr/>
        </p:nvSpPr>
        <p:spPr>
          <a:xfrm>
            <a:off x="6010058" y="382681"/>
            <a:ext cx="38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1625853-D621-70EE-FD68-B4B3235C771C}"/>
              </a:ext>
            </a:extLst>
          </p:cNvPr>
          <p:cNvSpPr txBox="1"/>
          <p:nvPr/>
        </p:nvSpPr>
        <p:spPr>
          <a:xfrm>
            <a:off x="886250" y="3325173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2F2B3CC-EB74-58D0-D7B7-004F9170838C}"/>
              </a:ext>
            </a:extLst>
          </p:cNvPr>
          <p:cNvSpPr txBox="1"/>
          <p:nvPr/>
        </p:nvSpPr>
        <p:spPr>
          <a:xfrm>
            <a:off x="6010059" y="3325174"/>
            <a:ext cx="39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D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73737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445A7A07-D0A2-3300-CA64-D8C4E043A290}"/>
              </a:ext>
            </a:extLst>
          </p:cNvPr>
          <p:cNvGrpSpPr/>
          <p:nvPr/>
        </p:nvGrpSpPr>
        <p:grpSpPr>
          <a:xfrm>
            <a:off x="1197600" y="712441"/>
            <a:ext cx="4141083" cy="2791354"/>
            <a:chOff x="1487880" y="988207"/>
            <a:chExt cx="4141083" cy="2791354"/>
          </a:xfrm>
        </p:grpSpPr>
        <p:grpSp>
          <p:nvGrpSpPr>
            <p:cNvPr id="235" name="グループ化 234">
              <a:extLst>
                <a:ext uri="{FF2B5EF4-FFF2-40B4-BE49-F238E27FC236}">
                  <a16:creationId xmlns:a16="http://schemas.microsoft.com/office/drawing/2014/main" id="{7F4B8A62-7819-C60D-A452-1EA5B675DD47}"/>
                </a:ext>
              </a:extLst>
            </p:cNvPr>
            <p:cNvGrpSpPr/>
            <p:nvPr/>
          </p:nvGrpSpPr>
          <p:grpSpPr>
            <a:xfrm>
              <a:off x="1487880" y="988207"/>
              <a:ext cx="4141083" cy="2791354"/>
              <a:chOff x="1487880" y="988207"/>
              <a:chExt cx="4141083" cy="2791354"/>
            </a:xfrm>
          </p:grpSpPr>
          <p:sp>
            <p:nvSpPr>
              <p:cNvPr id="198" name="Rectangle 22">
                <a:extLst>
                  <a:ext uri="{FF2B5EF4-FFF2-40B4-BE49-F238E27FC236}">
                    <a16:creationId xmlns:a16="http://schemas.microsoft.com/office/drawing/2014/main" id="{5388FA6E-EA19-148D-E8E6-996B95FD63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7804" y="994728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9" name="Line 23">
                <a:extLst>
                  <a:ext uri="{FF2B5EF4-FFF2-40B4-BE49-F238E27FC236}">
                    <a16:creationId xmlns:a16="http://schemas.microsoft.com/office/drawing/2014/main" id="{FA4C00BD-ADF2-791B-57D5-B319C6897F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2137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0" name="Line 25">
                <a:extLst>
                  <a:ext uri="{FF2B5EF4-FFF2-40B4-BE49-F238E27FC236}">
                    <a16:creationId xmlns:a16="http://schemas.microsoft.com/office/drawing/2014/main" id="{0C8163BB-9245-1AFB-2E8F-7CD293FF1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5354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1" name="Line 27">
                <a:extLst>
                  <a:ext uri="{FF2B5EF4-FFF2-40B4-BE49-F238E27FC236}">
                    <a16:creationId xmlns:a16="http://schemas.microsoft.com/office/drawing/2014/main" id="{91AF527F-3FDA-975F-40BF-2ABD90628C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8570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2" name="Line 29">
                <a:extLst>
                  <a:ext uri="{FF2B5EF4-FFF2-40B4-BE49-F238E27FC236}">
                    <a16:creationId xmlns:a16="http://schemas.microsoft.com/office/drawing/2014/main" id="{C5394C8F-6EB3-9D26-FCA9-F7E5A163D4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9898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3" name="Line 31">
                <a:extLst>
                  <a:ext uri="{FF2B5EF4-FFF2-40B4-BE49-F238E27FC236}">
                    <a16:creationId xmlns:a16="http://schemas.microsoft.com/office/drawing/2014/main" id="{E8AC5A75-DE4D-65E5-7243-6125D3857B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3115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4" name="Line 33">
                <a:extLst>
                  <a:ext uri="{FF2B5EF4-FFF2-40B4-BE49-F238E27FC236}">
                    <a16:creationId xmlns:a16="http://schemas.microsoft.com/office/drawing/2014/main" id="{D1CECB3F-2FAC-AC99-488A-37F797640A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6331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5" name="Line 35">
                <a:extLst>
                  <a:ext uri="{FF2B5EF4-FFF2-40B4-BE49-F238E27FC236}">
                    <a16:creationId xmlns:a16="http://schemas.microsoft.com/office/drawing/2014/main" id="{D5A25145-9F7A-E4B1-06D1-A4A50BE41A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9548" y="3010891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6" name="Line 6">
                <a:extLst>
                  <a:ext uri="{FF2B5EF4-FFF2-40B4-BE49-F238E27FC236}">
                    <a16:creationId xmlns:a16="http://schemas.microsoft.com/office/drawing/2014/main" id="{99A1571C-AB61-D3D5-8E20-CFC8443DEA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3008505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7" name="Line 8">
                <a:extLst>
                  <a:ext uri="{FF2B5EF4-FFF2-40B4-BE49-F238E27FC236}">
                    <a16:creationId xmlns:a16="http://schemas.microsoft.com/office/drawing/2014/main" id="{50D754FB-9E5E-6F63-17DA-4A741B9366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260100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8" name="Line 9">
                <a:extLst>
                  <a:ext uri="{FF2B5EF4-FFF2-40B4-BE49-F238E27FC236}">
                    <a16:creationId xmlns:a16="http://schemas.microsoft.com/office/drawing/2014/main" id="{42CF292D-1C04-90F7-B05E-C74BD2F14F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219351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09" name="Line 11">
                <a:extLst>
                  <a:ext uri="{FF2B5EF4-FFF2-40B4-BE49-F238E27FC236}">
                    <a16:creationId xmlns:a16="http://schemas.microsoft.com/office/drawing/2014/main" id="{50710CAD-F1A6-DC3E-482A-1926E6E859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178601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0" name="Line 12">
                <a:extLst>
                  <a:ext uri="{FF2B5EF4-FFF2-40B4-BE49-F238E27FC236}">
                    <a16:creationId xmlns:a16="http://schemas.microsoft.com/office/drawing/2014/main" id="{1FDF3B02-06B1-8136-AEC6-14E863595B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6145" y="137852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1" name="Line 14">
                <a:extLst>
                  <a:ext uri="{FF2B5EF4-FFF2-40B4-BE49-F238E27FC236}">
                    <a16:creationId xmlns:a16="http://schemas.microsoft.com/office/drawing/2014/main" id="{502B873C-7936-FAEB-7775-6EB4EB11F5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9984" y="99493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2" name="Line 23">
                <a:extLst>
                  <a:ext uri="{FF2B5EF4-FFF2-40B4-BE49-F238E27FC236}">
                    <a16:creationId xmlns:a16="http://schemas.microsoft.com/office/drawing/2014/main" id="{CA0DA39A-24C0-159A-151F-A6A130718C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3825" y="3008506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213" name="図形グループ 54">
                <a:extLst>
                  <a:ext uri="{FF2B5EF4-FFF2-40B4-BE49-F238E27FC236}">
                    <a16:creationId xmlns:a16="http://schemas.microsoft.com/office/drawing/2014/main" id="{0997CE78-3791-D276-976E-9FDF8CF70891}"/>
                  </a:ext>
                </a:extLst>
              </p:cNvPr>
              <p:cNvGrpSpPr/>
              <p:nvPr/>
            </p:nvGrpSpPr>
            <p:grpSpPr>
              <a:xfrm>
                <a:off x="2034219" y="1249429"/>
                <a:ext cx="220989" cy="1868530"/>
                <a:chOff x="510218" y="1348283"/>
                <a:chExt cx="220989" cy="1868530"/>
              </a:xfrm>
            </p:grpSpPr>
            <p:sp>
              <p:nvSpPr>
                <p:cNvPr id="220" name="Rectangle 10">
                  <a:extLst>
                    <a:ext uri="{FF2B5EF4-FFF2-40B4-BE49-F238E27FC236}">
                      <a16:creationId xmlns:a16="http://schemas.microsoft.com/office/drawing/2014/main" id="{0DFC5718-4FEB-0DB7-D1AF-7786EFF9B3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21" name="Rectangle 13">
                  <a:extLst>
                    <a:ext uri="{FF2B5EF4-FFF2-40B4-BE49-F238E27FC236}">
                      <a16:creationId xmlns:a16="http://schemas.microsoft.com/office/drawing/2014/main" id="{12E517D5-2FCD-F7F6-F7BD-7029D49BB4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22" name="Rectangle 10">
                  <a:extLst>
                    <a:ext uri="{FF2B5EF4-FFF2-40B4-BE49-F238E27FC236}">
                      <a16:creationId xmlns:a16="http://schemas.microsoft.com/office/drawing/2014/main" id="{C1CBBAAA-76D1-9F13-8A0E-8204C14F01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D11054CA-3A97-9CC5-E00C-787B698947A4}"/>
                  </a:ext>
                </a:extLst>
              </p:cNvPr>
              <p:cNvSpPr txBox="1"/>
              <p:nvPr/>
            </p:nvSpPr>
            <p:spPr>
              <a:xfrm>
                <a:off x="2206686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6F531A67-BDCB-99B2-3864-58C4325BC24A}"/>
                  </a:ext>
                </a:extLst>
              </p:cNvPr>
              <p:cNvSpPr txBox="1"/>
              <p:nvPr/>
            </p:nvSpPr>
            <p:spPr>
              <a:xfrm>
                <a:off x="3251225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57CB6EFC-68C5-3C57-3B90-FEE9A5798FAA}"/>
                  </a:ext>
                </a:extLst>
              </p:cNvPr>
              <p:cNvSpPr txBox="1"/>
              <p:nvPr/>
            </p:nvSpPr>
            <p:spPr>
              <a:xfrm>
                <a:off x="5340302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D1D7C71C-342A-A05A-B787-E525737597F3}"/>
                  </a:ext>
                </a:extLst>
              </p:cNvPr>
              <p:cNvSpPr txBox="1"/>
              <p:nvPr/>
            </p:nvSpPr>
            <p:spPr>
              <a:xfrm>
                <a:off x="4295764" y="3148442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4DE1D052-EE0D-2C71-3BB8-14E9C2695E08}"/>
                  </a:ext>
                </a:extLst>
              </p:cNvPr>
              <p:cNvSpPr txBox="1"/>
              <p:nvPr/>
            </p:nvSpPr>
            <p:spPr>
              <a:xfrm rot="16200000">
                <a:off x="604785" y="1871302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1655A8F0-C5D7-AA6D-DAAA-FCDDFF8E6541}"/>
                  </a:ext>
                </a:extLst>
              </p:cNvPr>
              <p:cNvSpPr txBox="1"/>
              <p:nvPr/>
            </p:nvSpPr>
            <p:spPr>
              <a:xfrm>
                <a:off x="3108992" y="3410229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6" name="Freeform 27">
              <a:extLst>
                <a:ext uri="{FF2B5EF4-FFF2-40B4-BE49-F238E27FC236}">
                  <a16:creationId xmlns:a16="http://schemas.microsoft.com/office/drawing/2014/main" id="{19C41AAD-FA4E-F411-E7D8-3E7B573B0B4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1397" y="2560470"/>
              <a:ext cx="2440045" cy="447884"/>
            </a:xfrm>
            <a:custGeom>
              <a:avLst/>
              <a:gdLst>
                <a:gd name="T0" fmla="*/ 105 w 1302"/>
                <a:gd name="T1" fmla="*/ 242 h 242"/>
                <a:gd name="T2" fmla="*/ 121 w 1302"/>
                <a:gd name="T3" fmla="*/ 233 h 242"/>
                <a:gd name="T4" fmla="*/ 138 w 1302"/>
                <a:gd name="T5" fmla="*/ 224 h 242"/>
                <a:gd name="T6" fmla="*/ 153 w 1302"/>
                <a:gd name="T7" fmla="*/ 212 h 242"/>
                <a:gd name="T8" fmla="*/ 167 w 1302"/>
                <a:gd name="T9" fmla="*/ 200 h 242"/>
                <a:gd name="T10" fmla="*/ 181 w 1302"/>
                <a:gd name="T11" fmla="*/ 189 h 242"/>
                <a:gd name="T12" fmla="*/ 199 w 1302"/>
                <a:gd name="T13" fmla="*/ 174 h 242"/>
                <a:gd name="T14" fmla="*/ 216 w 1302"/>
                <a:gd name="T15" fmla="*/ 167 h 242"/>
                <a:gd name="T16" fmla="*/ 241 w 1302"/>
                <a:gd name="T17" fmla="*/ 164 h 242"/>
                <a:gd name="T18" fmla="*/ 252 w 1302"/>
                <a:gd name="T19" fmla="*/ 152 h 242"/>
                <a:gd name="T20" fmla="*/ 269 w 1302"/>
                <a:gd name="T21" fmla="*/ 145 h 242"/>
                <a:gd name="T22" fmla="*/ 293 w 1302"/>
                <a:gd name="T23" fmla="*/ 145 h 242"/>
                <a:gd name="T24" fmla="*/ 316 w 1302"/>
                <a:gd name="T25" fmla="*/ 142 h 242"/>
                <a:gd name="T26" fmla="*/ 331 w 1302"/>
                <a:gd name="T27" fmla="*/ 129 h 242"/>
                <a:gd name="T28" fmla="*/ 349 w 1302"/>
                <a:gd name="T29" fmla="*/ 122 h 242"/>
                <a:gd name="T30" fmla="*/ 373 w 1302"/>
                <a:gd name="T31" fmla="*/ 122 h 242"/>
                <a:gd name="T32" fmla="*/ 398 w 1302"/>
                <a:gd name="T33" fmla="*/ 118 h 242"/>
                <a:gd name="T34" fmla="*/ 417 w 1302"/>
                <a:gd name="T35" fmla="*/ 114 h 242"/>
                <a:gd name="T36" fmla="*/ 434 w 1302"/>
                <a:gd name="T37" fmla="*/ 111 h 242"/>
                <a:gd name="T38" fmla="*/ 449 w 1302"/>
                <a:gd name="T39" fmla="*/ 103 h 242"/>
                <a:gd name="T40" fmla="*/ 461 w 1302"/>
                <a:gd name="T41" fmla="*/ 90 h 242"/>
                <a:gd name="T42" fmla="*/ 492 w 1302"/>
                <a:gd name="T43" fmla="*/ 90 h 242"/>
                <a:gd name="T44" fmla="*/ 516 w 1302"/>
                <a:gd name="T45" fmla="*/ 86 h 242"/>
                <a:gd name="T46" fmla="*/ 546 w 1302"/>
                <a:gd name="T47" fmla="*/ 86 h 242"/>
                <a:gd name="T48" fmla="*/ 575 w 1302"/>
                <a:gd name="T49" fmla="*/ 86 h 242"/>
                <a:gd name="T50" fmla="*/ 587 w 1302"/>
                <a:gd name="T51" fmla="*/ 72 h 242"/>
                <a:gd name="T52" fmla="*/ 605 w 1302"/>
                <a:gd name="T53" fmla="*/ 67 h 242"/>
                <a:gd name="T54" fmla="*/ 624 w 1302"/>
                <a:gd name="T55" fmla="*/ 62 h 242"/>
                <a:gd name="T56" fmla="*/ 644 w 1302"/>
                <a:gd name="T57" fmla="*/ 57 h 242"/>
                <a:gd name="T58" fmla="*/ 654 w 1302"/>
                <a:gd name="T59" fmla="*/ 45 h 242"/>
                <a:gd name="T60" fmla="*/ 681 w 1302"/>
                <a:gd name="T61" fmla="*/ 39 h 242"/>
                <a:gd name="T62" fmla="*/ 697 w 1302"/>
                <a:gd name="T63" fmla="*/ 33 h 242"/>
                <a:gd name="T64" fmla="*/ 728 w 1302"/>
                <a:gd name="T65" fmla="*/ 33 h 242"/>
                <a:gd name="T66" fmla="*/ 744 w 1302"/>
                <a:gd name="T67" fmla="*/ 26 h 242"/>
                <a:gd name="T68" fmla="*/ 765 w 1302"/>
                <a:gd name="T69" fmla="*/ 18 h 242"/>
                <a:gd name="T70" fmla="*/ 781 w 1302"/>
                <a:gd name="T71" fmla="*/ 9 h 242"/>
                <a:gd name="T72" fmla="*/ 800 w 1302"/>
                <a:gd name="T73" fmla="*/ 0 h 242"/>
                <a:gd name="T74" fmla="*/ 838 w 1302"/>
                <a:gd name="T75" fmla="*/ 0 h 242"/>
                <a:gd name="T76" fmla="*/ 872 w 1302"/>
                <a:gd name="T77" fmla="*/ 0 h 242"/>
                <a:gd name="T78" fmla="*/ 894 w 1302"/>
                <a:gd name="T79" fmla="*/ 0 h 242"/>
                <a:gd name="T80" fmla="*/ 918 w 1302"/>
                <a:gd name="T81" fmla="*/ 0 h 242"/>
                <a:gd name="T82" fmla="*/ 945 w 1302"/>
                <a:gd name="T83" fmla="*/ 0 h 242"/>
                <a:gd name="T84" fmla="*/ 969 w 1302"/>
                <a:gd name="T85" fmla="*/ 0 h 242"/>
                <a:gd name="T86" fmla="*/ 1003 w 1302"/>
                <a:gd name="T87" fmla="*/ 0 h 242"/>
                <a:gd name="T88" fmla="*/ 1041 w 1302"/>
                <a:gd name="T89" fmla="*/ 0 h 242"/>
                <a:gd name="T90" fmla="*/ 1087 w 1302"/>
                <a:gd name="T91" fmla="*/ 0 h 242"/>
                <a:gd name="T92" fmla="*/ 1120 w 1302"/>
                <a:gd name="T93" fmla="*/ 0 h 242"/>
                <a:gd name="T94" fmla="*/ 1174 w 1302"/>
                <a:gd name="T95" fmla="*/ 0 h 242"/>
                <a:gd name="T96" fmla="*/ 1223 w 1302"/>
                <a:gd name="T97" fmla="*/ 0 h 242"/>
                <a:gd name="T98" fmla="*/ 1286 w 1302"/>
                <a:gd name="T99" fmla="*/ 0 h 2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1302" h="242">
                  <a:moveTo>
                    <a:pt x="0" y="242"/>
                  </a:moveTo>
                  <a:lnTo>
                    <a:pt x="85" y="242"/>
                  </a:lnTo>
                  <a:lnTo>
                    <a:pt x="92" y="242"/>
                  </a:lnTo>
                  <a:lnTo>
                    <a:pt x="105" y="242"/>
                  </a:lnTo>
                  <a:lnTo>
                    <a:pt x="110" y="239"/>
                  </a:lnTo>
                  <a:lnTo>
                    <a:pt x="110" y="236"/>
                  </a:lnTo>
                  <a:lnTo>
                    <a:pt x="117" y="236"/>
                  </a:lnTo>
                  <a:lnTo>
                    <a:pt x="121" y="233"/>
                  </a:lnTo>
                  <a:lnTo>
                    <a:pt x="121" y="230"/>
                  </a:lnTo>
                  <a:lnTo>
                    <a:pt x="126" y="230"/>
                  </a:lnTo>
                  <a:lnTo>
                    <a:pt x="129" y="224"/>
                  </a:lnTo>
                  <a:lnTo>
                    <a:pt x="138" y="224"/>
                  </a:lnTo>
                  <a:lnTo>
                    <a:pt x="147" y="221"/>
                  </a:lnTo>
                  <a:lnTo>
                    <a:pt x="147" y="218"/>
                  </a:lnTo>
                  <a:lnTo>
                    <a:pt x="150" y="218"/>
                  </a:lnTo>
                  <a:lnTo>
                    <a:pt x="153" y="212"/>
                  </a:lnTo>
                  <a:lnTo>
                    <a:pt x="160" y="212"/>
                  </a:lnTo>
                  <a:lnTo>
                    <a:pt x="163" y="206"/>
                  </a:lnTo>
                  <a:lnTo>
                    <a:pt x="165" y="200"/>
                  </a:lnTo>
                  <a:lnTo>
                    <a:pt x="167" y="200"/>
                  </a:lnTo>
                  <a:lnTo>
                    <a:pt x="172" y="200"/>
                  </a:lnTo>
                  <a:lnTo>
                    <a:pt x="172" y="194"/>
                  </a:lnTo>
                  <a:lnTo>
                    <a:pt x="181" y="191"/>
                  </a:lnTo>
                  <a:lnTo>
                    <a:pt x="181" y="189"/>
                  </a:lnTo>
                  <a:lnTo>
                    <a:pt x="183" y="183"/>
                  </a:lnTo>
                  <a:lnTo>
                    <a:pt x="190" y="183"/>
                  </a:lnTo>
                  <a:lnTo>
                    <a:pt x="193" y="177"/>
                  </a:lnTo>
                  <a:lnTo>
                    <a:pt x="199" y="174"/>
                  </a:lnTo>
                  <a:lnTo>
                    <a:pt x="199" y="171"/>
                  </a:lnTo>
                  <a:lnTo>
                    <a:pt x="203" y="171"/>
                  </a:lnTo>
                  <a:lnTo>
                    <a:pt x="208" y="167"/>
                  </a:lnTo>
                  <a:lnTo>
                    <a:pt x="216" y="167"/>
                  </a:lnTo>
                  <a:lnTo>
                    <a:pt x="216" y="164"/>
                  </a:lnTo>
                  <a:lnTo>
                    <a:pt x="220" y="164"/>
                  </a:lnTo>
                  <a:lnTo>
                    <a:pt x="229" y="164"/>
                  </a:lnTo>
                  <a:lnTo>
                    <a:pt x="241" y="164"/>
                  </a:lnTo>
                  <a:lnTo>
                    <a:pt x="241" y="158"/>
                  </a:lnTo>
                  <a:lnTo>
                    <a:pt x="249" y="158"/>
                  </a:lnTo>
                  <a:lnTo>
                    <a:pt x="251" y="158"/>
                  </a:lnTo>
                  <a:lnTo>
                    <a:pt x="252" y="152"/>
                  </a:lnTo>
                  <a:lnTo>
                    <a:pt x="256" y="152"/>
                  </a:lnTo>
                  <a:lnTo>
                    <a:pt x="266" y="152"/>
                  </a:lnTo>
                  <a:lnTo>
                    <a:pt x="269" y="149"/>
                  </a:lnTo>
                  <a:lnTo>
                    <a:pt x="269" y="145"/>
                  </a:lnTo>
                  <a:lnTo>
                    <a:pt x="279" y="145"/>
                  </a:lnTo>
                  <a:lnTo>
                    <a:pt x="281" y="145"/>
                  </a:lnTo>
                  <a:lnTo>
                    <a:pt x="286" y="145"/>
                  </a:lnTo>
                  <a:lnTo>
                    <a:pt x="293" y="145"/>
                  </a:lnTo>
                  <a:lnTo>
                    <a:pt x="293" y="142"/>
                  </a:lnTo>
                  <a:lnTo>
                    <a:pt x="299" y="142"/>
                  </a:lnTo>
                  <a:lnTo>
                    <a:pt x="308" y="142"/>
                  </a:lnTo>
                  <a:lnTo>
                    <a:pt x="316" y="142"/>
                  </a:lnTo>
                  <a:lnTo>
                    <a:pt x="322" y="139"/>
                  </a:lnTo>
                  <a:lnTo>
                    <a:pt x="325" y="135"/>
                  </a:lnTo>
                  <a:lnTo>
                    <a:pt x="330" y="132"/>
                  </a:lnTo>
                  <a:lnTo>
                    <a:pt x="331" y="129"/>
                  </a:lnTo>
                  <a:lnTo>
                    <a:pt x="339" y="125"/>
                  </a:lnTo>
                  <a:lnTo>
                    <a:pt x="345" y="125"/>
                  </a:lnTo>
                  <a:lnTo>
                    <a:pt x="345" y="122"/>
                  </a:lnTo>
                  <a:lnTo>
                    <a:pt x="349" y="122"/>
                  </a:lnTo>
                  <a:lnTo>
                    <a:pt x="352" y="122"/>
                  </a:lnTo>
                  <a:lnTo>
                    <a:pt x="358" y="122"/>
                  </a:lnTo>
                  <a:lnTo>
                    <a:pt x="369" y="122"/>
                  </a:lnTo>
                  <a:lnTo>
                    <a:pt x="373" y="122"/>
                  </a:lnTo>
                  <a:lnTo>
                    <a:pt x="378" y="122"/>
                  </a:lnTo>
                  <a:lnTo>
                    <a:pt x="383" y="118"/>
                  </a:lnTo>
                  <a:lnTo>
                    <a:pt x="391" y="118"/>
                  </a:lnTo>
                  <a:lnTo>
                    <a:pt x="398" y="118"/>
                  </a:lnTo>
                  <a:lnTo>
                    <a:pt x="402" y="118"/>
                  </a:lnTo>
                  <a:lnTo>
                    <a:pt x="408" y="118"/>
                  </a:lnTo>
                  <a:lnTo>
                    <a:pt x="408" y="114"/>
                  </a:lnTo>
                  <a:lnTo>
                    <a:pt x="417" y="114"/>
                  </a:lnTo>
                  <a:lnTo>
                    <a:pt x="420" y="114"/>
                  </a:lnTo>
                  <a:lnTo>
                    <a:pt x="421" y="111"/>
                  </a:lnTo>
                  <a:lnTo>
                    <a:pt x="425" y="111"/>
                  </a:lnTo>
                  <a:lnTo>
                    <a:pt x="434" y="111"/>
                  </a:lnTo>
                  <a:lnTo>
                    <a:pt x="437" y="107"/>
                  </a:lnTo>
                  <a:lnTo>
                    <a:pt x="445" y="107"/>
                  </a:lnTo>
                  <a:lnTo>
                    <a:pt x="445" y="103"/>
                  </a:lnTo>
                  <a:lnTo>
                    <a:pt x="449" y="103"/>
                  </a:lnTo>
                  <a:lnTo>
                    <a:pt x="452" y="99"/>
                  </a:lnTo>
                  <a:lnTo>
                    <a:pt x="455" y="99"/>
                  </a:lnTo>
                  <a:lnTo>
                    <a:pt x="461" y="94"/>
                  </a:lnTo>
                  <a:lnTo>
                    <a:pt x="461" y="90"/>
                  </a:lnTo>
                  <a:lnTo>
                    <a:pt x="471" y="90"/>
                  </a:lnTo>
                  <a:lnTo>
                    <a:pt x="481" y="90"/>
                  </a:lnTo>
                  <a:lnTo>
                    <a:pt x="484" y="90"/>
                  </a:lnTo>
                  <a:lnTo>
                    <a:pt x="492" y="90"/>
                  </a:lnTo>
                  <a:lnTo>
                    <a:pt x="492" y="86"/>
                  </a:lnTo>
                  <a:lnTo>
                    <a:pt x="498" y="86"/>
                  </a:lnTo>
                  <a:lnTo>
                    <a:pt x="511" y="86"/>
                  </a:lnTo>
                  <a:lnTo>
                    <a:pt x="516" y="86"/>
                  </a:lnTo>
                  <a:lnTo>
                    <a:pt x="528" y="86"/>
                  </a:lnTo>
                  <a:lnTo>
                    <a:pt x="537" y="86"/>
                  </a:lnTo>
                  <a:lnTo>
                    <a:pt x="540" y="86"/>
                  </a:lnTo>
                  <a:lnTo>
                    <a:pt x="546" y="86"/>
                  </a:lnTo>
                  <a:lnTo>
                    <a:pt x="554" y="86"/>
                  </a:lnTo>
                  <a:lnTo>
                    <a:pt x="558" y="86"/>
                  </a:lnTo>
                  <a:lnTo>
                    <a:pt x="570" y="86"/>
                  </a:lnTo>
                  <a:lnTo>
                    <a:pt x="575" y="86"/>
                  </a:lnTo>
                  <a:lnTo>
                    <a:pt x="581" y="86"/>
                  </a:lnTo>
                  <a:lnTo>
                    <a:pt x="582" y="82"/>
                  </a:lnTo>
                  <a:lnTo>
                    <a:pt x="587" y="77"/>
                  </a:lnTo>
                  <a:lnTo>
                    <a:pt x="587" y="72"/>
                  </a:lnTo>
                  <a:lnTo>
                    <a:pt x="593" y="72"/>
                  </a:lnTo>
                  <a:lnTo>
                    <a:pt x="599" y="72"/>
                  </a:lnTo>
                  <a:lnTo>
                    <a:pt x="600" y="67"/>
                  </a:lnTo>
                  <a:lnTo>
                    <a:pt x="605" y="67"/>
                  </a:lnTo>
                  <a:lnTo>
                    <a:pt x="609" y="62"/>
                  </a:lnTo>
                  <a:lnTo>
                    <a:pt x="612" y="62"/>
                  </a:lnTo>
                  <a:lnTo>
                    <a:pt x="618" y="62"/>
                  </a:lnTo>
                  <a:lnTo>
                    <a:pt x="624" y="62"/>
                  </a:lnTo>
                  <a:lnTo>
                    <a:pt x="631" y="62"/>
                  </a:lnTo>
                  <a:lnTo>
                    <a:pt x="633" y="57"/>
                  </a:lnTo>
                  <a:lnTo>
                    <a:pt x="635" y="57"/>
                  </a:lnTo>
                  <a:lnTo>
                    <a:pt x="644" y="57"/>
                  </a:lnTo>
                  <a:lnTo>
                    <a:pt x="644" y="51"/>
                  </a:lnTo>
                  <a:lnTo>
                    <a:pt x="648" y="51"/>
                  </a:lnTo>
                  <a:lnTo>
                    <a:pt x="653" y="45"/>
                  </a:lnTo>
                  <a:lnTo>
                    <a:pt x="654" y="45"/>
                  </a:lnTo>
                  <a:lnTo>
                    <a:pt x="660" y="45"/>
                  </a:lnTo>
                  <a:lnTo>
                    <a:pt x="675" y="45"/>
                  </a:lnTo>
                  <a:lnTo>
                    <a:pt x="678" y="45"/>
                  </a:lnTo>
                  <a:lnTo>
                    <a:pt x="681" y="39"/>
                  </a:lnTo>
                  <a:lnTo>
                    <a:pt x="685" y="39"/>
                  </a:lnTo>
                  <a:lnTo>
                    <a:pt x="690" y="39"/>
                  </a:lnTo>
                  <a:lnTo>
                    <a:pt x="697" y="39"/>
                  </a:lnTo>
                  <a:lnTo>
                    <a:pt x="697" y="33"/>
                  </a:lnTo>
                  <a:lnTo>
                    <a:pt x="710" y="33"/>
                  </a:lnTo>
                  <a:lnTo>
                    <a:pt x="715" y="33"/>
                  </a:lnTo>
                  <a:lnTo>
                    <a:pt x="721" y="33"/>
                  </a:lnTo>
                  <a:lnTo>
                    <a:pt x="728" y="33"/>
                  </a:lnTo>
                  <a:lnTo>
                    <a:pt x="730" y="26"/>
                  </a:lnTo>
                  <a:lnTo>
                    <a:pt x="731" y="26"/>
                  </a:lnTo>
                  <a:lnTo>
                    <a:pt x="737" y="26"/>
                  </a:lnTo>
                  <a:lnTo>
                    <a:pt x="744" y="26"/>
                  </a:lnTo>
                  <a:lnTo>
                    <a:pt x="750" y="26"/>
                  </a:lnTo>
                  <a:lnTo>
                    <a:pt x="755" y="18"/>
                  </a:lnTo>
                  <a:lnTo>
                    <a:pt x="756" y="18"/>
                  </a:lnTo>
                  <a:lnTo>
                    <a:pt x="765" y="18"/>
                  </a:lnTo>
                  <a:lnTo>
                    <a:pt x="771" y="18"/>
                  </a:lnTo>
                  <a:lnTo>
                    <a:pt x="775" y="18"/>
                  </a:lnTo>
                  <a:lnTo>
                    <a:pt x="781" y="18"/>
                  </a:lnTo>
                  <a:lnTo>
                    <a:pt x="781" y="9"/>
                  </a:lnTo>
                  <a:lnTo>
                    <a:pt x="785" y="0"/>
                  </a:lnTo>
                  <a:lnTo>
                    <a:pt x="788" y="0"/>
                  </a:lnTo>
                  <a:lnTo>
                    <a:pt x="793" y="0"/>
                  </a:lnTo>
                  <a:lnTo>
                    <a:pt x="800" y="0"/>
                  </a:lnTo>
                  <a:lnTo>
                    <a:pt x="807" y="0"/>
                  </a:lnTo>
                  <a:lnTo>
                    <a:pt x="823" y="0"/>
                  </a:lnTo>
                  <a:lnTo>
                    <a:pt x="832" y="0"/>
                  </a:lnTo>
                  <a:lnTo>
                    <a:pt x="838" y="0"/>
                  </a:lnTo>
                  <a:lnTo>
                    <a:pt x="847" y="0"/>
                  </a:lnTo>
                  <a:lnTo>
                    <a:pt x="853" y="0"/>
                  </a:lnTo>
                  <a:lnTo>
                    <a:pt x="860" y="0"/>
                  </a:lnTo>
                  <a:lnTo>
                    <a:pt x="872" y="0"/>
                  </a:lnTo>
                  <a:lnTo>
                    <a:pt x="879" y="0"/>
                  </a:lnTo>
                  <a:lnTo>
                    <a:pt x="882" y="0"/>
                  </a:lnTo>
                  <a:lnTo>
                    <a:pt x="891" y="0"/>
                  </a:lnTo>
                  <a:lnTo>
                    <a:pt x="894" y="0"/>
                  </a:lnTo>
                  <a:lnTo>
                    <a:pt x="900" y="0"/>
                  </a:lnTo>
                  <a:lnTo>
                    <a:pt x="911" y="0"/>
                  </a:lnTo>
                  <a:lnTo>
                    <a:pt x="912" y="0"/>
                  </a:lnTo>
                  <a:lnTo>
                    <a:pt x="918" y="0"/>
                  </a:lnTo>
                  <a:lnTo>
                    <a:pt x="927" y="0"/>
                  </a:lnTo>
                  <a:lnTo>
                    <a:pt x="934" y="0"/>
                  </a:lnTo>
                  <a:lnTo>
                    <a:pt x="937" y="0"/>
                  </a:lnTo>
                  <a:lnTo>
                    <a:pt x="945" y="0"/>
                  </a:lnTo>
                  <a:lnTo>
                    <a:pt x="949" y="0"/>
                  </a:lnTo>
                  <a:lnTo>
                    <a:pt x="960" y="0"/>
                  </a:lnTo>
                  <a:lnTo>
                    <a:pt x="962" y="0"/>
                  </a:lnTo>
                  <a:lnTo>
                    <a:pt x="969" y="0"/>
                  </a:lnTo>
                  <a:lnTo>
                    <a:pt x="975" y="0"/>
                  </a:lnTo>
                  <a:lnTo>
                    <a:pt x="991" y="0"/>
                  </a:lnTo>
                  <a:lnTo>
                    <a:pt x="997" y="0"/>
                  </a:lnTo>
                  <a:lnTo>
                    <a:pt x="1003" y="0"/>
                  </a:lnTo>
                  <a:lnTo>
                    <a:pt x="1009" y="0"/>
                  </a:lnTo>
                  <a:lnTo>
                    <a:pt x="1027" y="0"/>
                  </a:lnTo>
                  <a:lnTo>
                    <a:pt x="1033" y="0"/>
                  </a:lnTo>
                  <a:lnTo>
                    <a:pt x="1041" y="0"/>
                  </a:lnTo>
                  <a:lnTo>
                    <a:pt x="1058" y="0"/>
                  </a:lnTo>
                  <a:lnTo>
                    <a:pt x="1072" y="0"/>
                  </a:lnTo>
                  <a:lnTo>
                    <a:pt x="1081" y="0"/>
                  </a:lnTo>
                  <a:lnTo>
                    <a:pt x="1087" y="0"/>
                  </a:lnTo>
                  <a:lnTo>
                    <a:pt x="1097" y="0"/>
                  </a:lnTo>
                  <a:lnTo>
                    <a:pt x="1102" y="0"/>
                  </a:lnTo>
                  <a:lnTo>
                    <a:pt x="1109" y="0"/>
                  </a:lnTo>
                  <a:lnTo>
                    <a:pt x="1120" y="0"/>
                  </a:lnTo>
                  <a:lnTo>
                    <a:pt x="1128" y="0"/>
                  </a:lnTo>
                  <a:lnTo>
                    <a:pt x="1138" y="0"/>
                  </a:lnTo>
                  <a:lnTo>
                    <a:pt x="1156" y="0"/>
                  </a:lnTo>
                  <a:lnTo>
                    <a:pt x="1174" y="0"/>
                  </a:lnTo>
                  <a:lnTo>
                    <a:pt x="1177" y="0"/>
                  </a:lnTo>
                  <a:lnTo>
                    <a:pt x="1191" y="0"/>
                  </a:lnTo>
                  <a:lnTo>
                    <a:pt x="1197" y="0"/>
                  </a:lnTo>
                  <a:lnTo>
                    <a:pt x="1223" y="0"/>
                  </a:lnTo>
                  <a:lnTo>
                    <a:pt x="1253" y="0"/>
                  </a:lnTo>
                  <a:lnTo>
                    <a:pt x="1259" y="0"/>
                  </a:lnTo>
                  <a:lnTo>
                    <a:pt x="1281" y="0"/>
                  </a:lnTo>
                  <a:lnTo>
                    <a:pt x="1286" y="0"/>
                  </a:lnTo>
                  <a:lnTo>
                    <a:pt x="1302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" name="Freeform 28">
              <a:extLst>
                <a:ext uri="{FF2B5EF4-FFF2-40B4-BE49-F238E27FC236}">
                  <a16:creationId xmlns:a16="http://schemas.microsoft.com/office/drawing/2014/main" id="{747C94C2-7C05-2E24-9D01-F8430F0AB4D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1397" y="2949130"/>
              <a:ext cx="2095215" cy="59224"/>
            </a:xfrm>
            <a:custGeom>
              <a:avLst/>
              <a:gdLst>
                <a:gd name="T0" fmla="*/ 0 w 1118"/>
                <a:gd name="T1" fmla="*/ 32 h 32"/>
                <a:gd name="T2" fmla="*/ 176 w 1118"/>
                <a:gd name="T3" fmla="*/ 32 h 32"/>
                <a:gd name="T4" fmla="*/ 184 w 1118"/>
                <a:gd name="T5" fmla="*/ 32 h 32"/>
                <a:gd name="T6" fmla="*/ 210 w 1118"/>
                <a:gd name="T7" fmla="*/ 32 h 32"/>
                <a:gd name="T8" fmla="*/ 217 w 1118"/>
                <a:gd name="T9" fmla="*/ 32 h 32"/>
                <a:gd name="T10" fmla="*/ 241 w 1118"/>
                <a:gd name="T11" fmla="*/ 32 h 32"/>
                <a:gd name="T12" fmla="*/ 288 w 1118"/>
                <a:gd name="T13" fmla="*/ 32 h 32"/>
                <a:gd name="T14" fmla="*/ 288 w 1118"/>
                <a:gd name="T15" fmla="*/ 0 h 32"/>
                <a:gd name="T16" fmla="*/ 302 w 1118"/>
                <a:gd name="T17" fmla="*/ 0 h 32"/>
                <a:gd name="T18" fmla="*/ 405 w 1118"/>
                <a:gd name="T19" fmla="*/ 0 h 32"/>
                <a:gd name="T20" fmla="*/ 464 w 1118"/>
                <a:gd name="T21" fmla="*/ 0 h 32"/>
                <a:gd name="T22" fmla="*/ 486 w 1118"/>
                <a:gd name="T23" fmla="*/ 0 h 32"/>
                <a:gd name="T24" fmla="*/ 587 w 1118"/>
                <a:gd name="T25" fmla="*/ 0 h 32"/>
                <a:gd name="T26" fmla="*/ 603 w 1118"/>
                <a:gd name="T27" fmla="*/ 0 h 32"/>
                <a:gd name="T28" fmla="*/ 612 w 1118"/>
                <a:gd name="T29" fmla="*/ 0 h 32"/>
                <a:gd name="T30" fmla="*/ 627 w 1118"/>
                <a:gd name="T31" fmla="*/ 0 h 32"/>
                <a:gd name="T32" fmla="*/ 632 w 1118"/>
                <a:gd name="T33" fmla="*/ 0 h 32"/>
                <a:gd name="T34" fmla="*/ 649 w 1118"/>
                <a:gd name="T35" fmla="*/ 0 h 32"/>
                <a:gd name="T36" fmla="*/ 659 w 1118"/>
                <a:gd name="T37" fmla="*/ 0 h 32"/>
                <a:gd name="T38" fmla="*/ 668 w 1118"/>
                <a:gd name="T39" fmla="*/ 0 h 32"/>
                <a:gd name="T40" fmla="*/ 671 w 1118"/>
                <a:gd name="T41" fmla="*/ 0 h 32"/>
                <a:gd name="T42" fmla="*/ 741 w 1118"/>
                <a:gd name="T43" fmla="*/ 0 h 32"/>
                <a:gd name="T44" fmla="*/ 744 w 1118"/>
                <a:gd name="T45" fmla="*/ 0 h 32"/>
                <a:gd name="T46" fmla="*/ 765 w 1118"/>
                <a:gd name="T47" fmla="*/ 0 h 32"/>
                <a:gd name="T48" fmla="*/ 781 w 1118"/>
                <a:gd name="T49" fmla="*/ 0 h 32"/>
                <a:gd name="T50" fmla="*/ 841 w 1118"/>
                <a:gd name="T51" fmla="*/ 0 h 32"/>
                <a:gd name="T52" fmla="*/ 855 w 1118"/>
                <a:gd name="T53" fmla="*/ 0 h 32"/>
                <a:gd name="T54" fmla="*/ 867 w 1118"/>
                <a:gd name="T55" fmla="*/ 0 h 32"/>
                <a:gd name="T56" fmla="*/ 900 w 1118"/>
                <a:gd name="T57" fmla="*/ 0 h 32"/>
                <a:gd name="T58" fmla="*/ 930 w 1118"/>
                <a:gd name="T59" fmla="*/ 0 h 32"/>
                <a:gd name="T60" fmla="*/ 950 w 1118"/>
                <a:gd name="T61" fmla="*/ 0 h 32"/>
                <a:gd name="T62" fmla="*/ 1036 w 1118"/>
                <a:gd name="T63" fmla="*/ 0 h 32"/>
                <a:gd name="T64" fmla="*/ 1118 w 1118"/>
                <a:gd name="T6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118" h="32">
                  <a:moveTo>
                    <a:pt x="0" y="32"/>
                  </a:moveTo>
                  <a:lnTo>
                    <a:pt x="176" y="32"/>
                  </a:lnTo>
                  <a:lnTo>
                    <a:pt x="184" y="32"/>
                  </a:lnTo>
                  <a:lnTo>
                    <a:pt x="210" y="32"/>
                  </a:lnTo>
                  <a:lnTo>
                    <a:pt x="217" y="32"/>
                  </a:lnTo>
                  <a:lnTo>
                    <a:pt x="241" y="32"/>
                  </a:lnTo>
                  <a:lnTo>
                    <a:pt x="288" y="32"/>
                  </a:lnTo>
                  <a:lnTo>
                    <a:pt x="288" y="0"/>
                  </a:lnTo>
                  <a:lnTo>
                    <a:pt x="302" y="0"/>
                  </a:lnTo>
                  <a:lnTo>
                    <a:pt x="405" y="0"/>
                  </a:lnTo>
                  <a:lnTo>
                    <a:pt x="464" y="0"/>
                  </a:lnTo>
                  <a:lnTo>
                    <a:pt x="486" y="0"/>
                  </a:lnTo>
                  <a:lnTo>
                    <a:pt x="587" y="0"/>
                  </a:lnTo>
                  <a:lnTo>
                    <a:pt x="603" y="0"/>
                  </a:lnTo>
                  <a:lnTo>
                    <a:pt x="612" y="0"/>
                  </a:lnTo>
                  <a:lnTo>
                    <a:pt x="627" y="0"/>
                  </a:lnTo>
                  <a:lnTo>
                    <a:pt x="632" y="0"/>
                  </a:lnTo>
                  <a:lnTo>
                    <a:pt x="649" y="0"/>
                  </a:lnTo>
                  <a:lnTo>
                    <a:pt x="659" y="0"/>
                  </a:lnTo>
                  <a:lnTo>
                    <a:pt x="668" y="0"/>
                  </a:lnTo>
                  <a:lnTo>
                    <a:pt x="671" y="0"/>
                  </a:lnTo>
                  <a:lnTo>
                    <a:pt x="741" y="0"/>
                  </a:lnTo>
                  <a:lnTo>
                    <a:pt x="744" y="0"/>
                  </a:lnTo>
                  <a:lnTo>
                    <a:pt x="765" y="0"/>
                  </a:lnTo>
                  <a:lnTo>
                    <a:pt x="781" y="0"/>
                  </a:lnTo>
                  <a:lnTo>
                    <a:pt x="841" y="0"/>
                  </a:lnTo>
                  <a:lnTo>
                    <a:pt x="855" y="0"/>
                  </a:lnTo>
                  <a:lnTo>
                    <a:pt x="867" y="0"/>
                  </a:lnTo>
                  <a:lnTo>
                    <a:pt x="900" y="0"/>
                  </a:lnTo>
                  <a:lnTo>
                    <a:pt x="930" y="0"/>
                  </a:lnTo>
                  <a:lnTo>
                    <a:pt x="950" y="0"/>
                  </a:lnTo>
                  <a:lnTo>
                    <a:pt x="1036" y="0"/>
                  </a:lnTo>
                  <a:lnTo>
                    <a:pt x="1118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Freeform 29">
              <a:extLst>
                <a:ext uri="{FF2B5EF4-FFF2-40B4-BE49-F238E27FC236}">
                  <a16:creationId xmlns:a16="http://schemas.microsoft.com/office/drawing/2014/main" id="{E95C0FEF-F6AC-4D1A-DF46-95506BE722D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1397" y="2867696"/>
              <a:ext cx="2417556" cy="140658"/>
            </a:xfrm>
            <a:custGeom>
              <a:avLst/>
              <a:gdLst>
                <a:gd name="T0" fmla="*/ 85 w 1290"/>
                <a:gd name="T1" fmla="*/ 76 h 76"/>
                <a:gd name="T2" fmla="*/ 101 w 1290"/>
                <a:gd name="T3" fmla="*/ 62 h 76"/>
                <a:gd name="T4" fmla="*/ 116 w 1290"/>
                <a:gd name="T5" fmla="*/ 62 h 76"/>
                <a:gd name="T6" fmla="*/ 136 w 1290"/>
                <a:gd name="T7" fmla="*/ 55 h 76"/>
                <a:gd name="T8" fmla="*/ 143 w 1290"/>
                <a:gd name="T9" fmla="*/ 47 h 76"/>
                <a:gd name="T10" fmla="*/ 157 w 1290"/>
                <a:gd name="T11" fmla="*/ 40 h 76"/>
                <a:gd name="T12" fmla="*/ 160 w 1290"/>
                <a:gd name="T13" fmla="*/ 33 h 76"/>
                <a:gd name="T14" fmla="*/ 216 w 1290"/>
                <a:gd name="T15" fmla="*/ 33 h 76"/>
                <a:gd name="T16" fmla="*/ 242 w 1290"/>
                <a:gd name="T17" fmla="*/ 33 h 76"/>
                <a:gd name="T18" fmla="*/ 266 w 1290"/>
                <a:gd name="T19" fmla="*/ 33 h 76"/>
                <a:gd name="T20" fmla="*/ 292 w 1290"/>
                <a:gd name="T21" fmla="*/ 33 h 76"/>
                <a:gd name="T22" fmla="*/ 305 w 1290"/>
                <a:gd name="T23" fmla="*/ 33 h 76"/>
                <a:gd name="T24" fmla="*/ 327 w 1290"/>
                <a:gd name="T25" fmla="*/ 33 h 76"/>
                <a:gd name="T26" fmla="*/ 351 w 1290"/>
                <a:gd name="T27" fmla="*/ 33 h 76"/>
                <a:gd name="T28" fmla="*/ 361 w 1290"/>
                <a:gd name="T29" fmla="*/ 33 h 76"/>
                <a:gd name="T30" fmla="*/ 373 w 1290"/>
                <a:gd name="T31" fmla="*/ 33 h 76"/>
                <a:gd name="T32" fmla="*/ 386 w 1290"/>
                <a:gd name="T33" fmla="*/ 33 h 76"/>
                <a:gd name="T34" fmla="*/ 402 w 1290"/>
                <a:gd name="T35" fmla="*/ 33 h 76"/>
                <a:gd name="T36" fmla="*/ 415 w 1290"/>
                <a:gd name="T37" fmla="*/ 33 h 76"/>
                <a:gd name="T38" fmla="*/ 438 w 1290"/>
                <a:gd name="T39" fmla="*/ 33 h 76"/>
                <a:gd name="T40" fmla="*/ 451 w 1290"/>
                <a:gd name="T41" fmla="*/ 33 h 76"/>
                <a:gd name="T42" fmla="*/ 484 w 1290"/>
                <a:gd name="T43" fmla="*/ 33 h 76"/>
                <a:gd name="T44" fmla="*/ 494 w 1290"/>
                <a:gd name="T45" fmla="*/ 33 h 76"/>
                <a:gd name="T46" fmla="*/ 541 w 1290"/>
                <a:gd name="T47" fmla="*/ 33 h 76"/>
                <a:gd name="T48" fmla="*/ 563 w 1290"/>
                <a:gd name="T49" fmla="*/ 33 h 76"/>
                <a:gd name="T50" fmla="*/ 575 w 1290"/>
                <a:gd name="T51" fmla="*/ 33 h 76"/>
                <a:gd name="T52" fmla="*/ 589 w 1290"/>
                <a:gd name="T53" fmla="*/ 33 h 76"/>
                <a:gd name="T54" fmla="*/ 612 w 1290"/>
                <a:gd name="T55" fmla="*/ 33 h 76"/>
                <a:gd name="T56" fmla="*/ 637 w 1290"/>
                <a:gd name="T57" fmla="*/ 33 h 76"/>
                <a:gd name="T58" fmla="*/ 654 w 1290"/>
                <a:gd name="T59" fmla="*/ 33 h 76"/>
                <a:gd name="T60" fmla="*/ 665 w 1290"/>
                <a:gd name="T61" fmla="*/ 33 h 76"/>
                <a:gd name="T62" fmla="*/ 688 w 1290"/>
                <a:gd name="T63" fmla="*/ 33 h 76"/>
                <a:gd name="T64" fmla="*/ 692 w 1290"/>
                <a:gd name="T65" fmla="*/ 19 h 76"/>
                <a:gd name="T66" fmla="*/ 709 w 1290"/>
                <a:gd name="T67" fmla="*/ 19 h 76"/>
                <a:gd name="T68" fmla="*/ 734 w 1290"/>
                <a:gd name="T69" fmla="*/ 19 h 76"/>
                <a:gd name="T70" fmla="*/ 746 w 1290"/>
                <a:gd name="T71" fmla="*/ 19 h 76"/>
                <a:gd name="T72" fmla="*/ 757 w 1290"/>
                <a:gd name="T73" fmla="*/ 0 h 76"/>
                <a:gd name="T74" fmla="*/ 771 w 1290"/>
                <a:gd name="T75" fmla="*/ 0 h 76"/>
                <a:gd name="T76" fmla="*/ 790 w 1290"/>
                <a:gd name="T77" fmla="*/ 0 h 76"/>
                <a:gd name="T78" fmla="*/ 818 w 1290"/>
                <a:gd name="T79" fmla="*/ 0 h 76"/>
                <a:gd name="T80" fmla="*/ 835 w 1290"/>
                <a:gd name="T81" fmla="*/ 0 h 76"/>
                <a:gd name="T82" fmla="*/ 846 w 1290"/>
                <a:gd name="T83" fmla="*/ 0 h 76"/>
                <a:gd name="T84" fmla="*/ 858 w 1290"/>
                <a:gd name="T85" fmla="*/ 0 h 76"/>
                <a:gd name="T86" fmla="*/ 881 w 1290"/>
                <a:gd name="T87" fmla="*/ 0 h 76"/>
                <a:gd name="T88" fmla="*/ 892 w 1290"/>
                <a:gd name="T89" fmla="*/ 0 h 76"/>
                <a:gd name="T90" fmla="*/ 900 w 1290"/>
                <a:gd name="T91" fmla="*/ 0 h 76"/>
                <a:gd name="T92" fmla="*/ 916 w 1290"/>
                <a:gd name="T93" fmla="*/ 0 h 76"/>
                <a:gd name="T94" fmla="*/ 925 w 1290"/>
                <a:gd name="T95" fmla="*/ 0 h 76"/>
                <a:gd name="T96" fmla="*/ 954 w 1290"/>
                <a:gd name="T97" fmla="*/ 0 h 76"/>
                <a:gd name="T98" fmla="*/ 991 w 1290"/>
                <a:gd name="T99" fmla="*/ 0 h 76"/>
                <a:gd name="T100" fmla="*/ 1029 w 1290"/>
                <a:gd name="T101" fmla="*/ 0 h 76"/>
                <a:gd name="T102" fmla="*/ 1089 w 1290"/>
                <a:gd name="T103" fmla="*/ 0 h 76"/>
                <a:gd name="T104" fmla="*/ 1115 w 1290"/>
                <a:gd name="T105" fmla="*/ 0 h 76"/>
                <a:gd name="T106" fmla="*/ 1151 w 1290"/>
                <a:gd name="T107" fmla="*/ 0 h 76"/>
                <a:gd name="T108" fmla="*/ 1161 w 1290"/>
                <a:gd name="T109" fmla="*/ 0 h 76"/>
                <a:gd name="T110" fmla="*/ 1290 w 1290"/>
                <a:gd name="T111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1290" h="76">
                  <a:moveTo>
                    <a:pt x="0" y="76"/>
                  </a:moveTo>
                  <a:lnTo>
                    <a:pt x="85" y="76"/>
                  </a:lnTo>
                  <a:lnTo>
                    <a:pt x="85" y="62"/>
                  </a:lnTo>
                  <a:lnTo>
                    <a:pt x="101" y="62"/>
                  </a:lnTo>
                  <a:lnTo>
                    <a:pt x="106" y="62"/>
                  </a:lnTo>
                  <a:lnTo>
                    <a:pt x="116" y="62"/>
                  </a:lnTo>
                  <a:lnTo>
                    <a:pt x="116" y="55"/>
                  </a:lnTo>
                  <a:lnTo>
                    <a:pt x="136" y="55"/>
                  </a:lnTo>
                  <a:lnTo>
                    <a:pt x="136" y="47"/>
                  </a:lnTo>
                  <a:lnTo>
                    <a:pt x="143" y="47"/>
                  </a:lnTo>
                  <a:lnTo>
                    <a:pt x="143" y="40"/>
                  </a:lnTo>
                  <a:lnTo>
                    <a:pt x="157" y="40"/>
                  </a:lnTo>
                  <a:lnTo>
                    <a:pt x="160" y="40"/>
                  </a:lnTo>
                  <a:lnTo>
                    <a:pt x="160" y="33"/>
                  </a:lnTo>
                  <a:lnTo>
                    <a:pt x="185" y="33"/>
                  </a:lnTo>
                  <a:lnTo>
                    <a:pt x="216" y="33"/>
                  </a:lnTo>
                  <a:lnTo>
                    <a:pt x="226" y="33"/>
                  </a:lnTo>
                  <a:lnTo>
                    <a:pt x="242" y="33"/>
                  </a:lnTo>
                  <a:lnTo>
                    <a:pt x="255" y="33"/>
                  </a:lnTo>
                  <a:lnTo>
                    <a:pt x="266" y="33"/>
                  </a:lnTo>
                  <a:lnTo>
                    <a:pt x="284" y="33"/>
                  </a:lnTo>
                  <a:lnTo>
                    <a:pt x="292" y="33"/>
                  </a:lnTo>
                  <a:lnTo>
                    <a:pt x="302" y="33"/>
                  </a:lnTo>
                  <a:lnTo>
                    <a:pt x="305" y="33"/>
                  </a:lnTo>
                  <a:lnTo>
                    <a:pt x="315" y="33"/>
                  </a:lnTo>
                  <a:lnTo>
                    <a:pt x="327" y="33"/>
                  </a:lnTo>
                  <a:lnTo>
                    <a:pt x="342" y="33"/>
                  </a:lnTo>
                  <a:lnTo>
                    <a:pt x="351" y="33"/>
                  </a:lnTo>
                  <a:lnTo>
                    <a:pt x="353" y="33"/>
                  </a:lnTo>
                  <a:lnTo>
                    <a:pt x="361" y="33"/>
                  </a:lnTo>
                  <a:lnTo>
                    <a:pt x="370" y="33"/>
                  </a:lnTo>
                  <a:lnTo>
                    <a:pt x="373" y="33"/>
                  </a:lnTo>
                  <a:lnTo>
                    <a:pt x="380" y="33"/>
                  </a:lnTo>
                  <a:lnTo>
                    <a:pt x="386" y="33"/>
                  </a:lnTo>
                  <a:lnTo>
                    <a:pt x="395" y="33"/>
                  </a:lnTo>
                  <a:lnTo>
                    <a:pt x="402" y="33"/>
                  </a:lnTo>
                  <a:lnTo>
                    <a:pt x="411" y="33"/>
                  </a:lnTo>
                  <a:lnTo>
                    <a:pt x="415" y="33"/>
                  </a:lnTo>
                  <a:lnTo>
                    <a:pt x="425" y="33"/>
                  </a:lnTo>
                  <a:lnTo>
                    <a:pt x="438" y="33"/>
                  </a:lnTo>
                  <a:lnTo>
                    <a:pt x="445" y="33"/>
                  </a:lnTo>
                  <a:lnTo>
                    <a:pt x="451" y="33"/>
                  </a:lnTo>
                  <a:lnTo>
                    <a:pt x="455" y="33"/>
                  </a:lnTo>
                  <a:lnTo>
                    <a:pt x="484" y="33"/>
                  </a:lnTo>
                  <a:lnTo>
                    <a:pt x="489" y="33"/>
                  </a:lnTo>
                  <a:lnTo>
                    <a:pt x="494" y="33"/>
                  </a:lnTo>
                  <a:lnTo>
                    <a:pt x="510" y="33"/>
                  </a:lnTo>
                  <a:lnTo>
                    <a:pt x="541" y="33"/>
                  </a:lnTo>
                  <a:lnTo>
                    <a:pt x="546" y="33"/>
                  </a:lnTo>
                  <a:lnTo>
                    <a:pt x="563" y="33"/>
                  </a:lnTo>
                  <a:lnTo>
                    <a:pt x="572" y="33"/>
                  </a:lnTo>
                  <a:lnTo>
                    <a:pt x="575" y="33"/>
                  </a:lnTo>
                  <a:lnTo>
                    <a:pt x="584" y="33"/>
                  </a:lnTo>
                  <a:lnTo>
                    <a:pt x="589" y="33"/>
                  </a:lnTo>
                  <a:lnTo>
                    <a:pt x="599" y="33"/>
                  </a:lnTo>
                  <a:lnTo>
                    <a:pt x="612" y="33"/>
                  </a:lnTo>
                  <a:lnTo>
                    <a:pt x="625" y="33"/>
                  </a:lnTo>
                  <a:lnTo>
                    <a:pt x="637" y="33"/>
                  </a:lnTo>
                  <a:lnTo>
                    <a:pt x="651" y="33"/>
                  </a:lnTo>
                  <a:lnTo>
                    <a:pt x="654" y="33"/>
                  </a:lnTo>
                  <a:lnTo>
                    <a:pt x="665" y="33"/>
                  </a:lnTo>
                  <a:lnTo>
                    <a:pt x="665" y="33"/>
                  </a:lnTo>
                  <a:lnTo>
                    <a:pt x="683" y="33"/>
                  </a:lnTo>
                  <a:lnTo>
                    <a:pt x="688" y="33"/>
                  </a:lnTo>
                  <a:lnTo>
                    <a:pt x="688" y="19"/>
                  </a:lnTo>
                  <a:lnTo>
                    <a:pt x="692" y="19"/>
                  </a:lnTo>
                  <a:lnTo>
                    <a:pt x="705" y="19"/>
                  </a:lnTo>
                  <a:lnTo>
                    <a:pt x="709" y="19"/>
                  </a:lnTo>
                  <a:lnTo>
                    <a:pt x="723" y="19"/>
                  </a:lnTo>
                  <a:lnTo>
                    <a:pt x="734" y="19"/>
                  </a:lnTo>
                  <a:lnTo>
                    <a:pt x="741" y="19"/>
                  </a:lnTo>
                  <a:lnTo>
                    <a:pt x="746" y="19"/>
                  </a:lnTo>
                  <a:lnTo>
                    <a:pt x="757" y="19"/>
                  </a:lnTo>
                  <a:lnTo>
                    <a:pt x="757" y="0"/>
                  </a:lnTo>
                  <a:lnTo>
                    <a:pt x="764" y="0"/>
                  </a:lnTo>
                  <a:lnTo>
                    <a:pt x="771" y="0"/>
                  </a:lnTo>
                  <a:lnTo>
                    <a:pt x="779" y="0"/>
                  </a:lnTo>
                  <a:lnTo>
                    <a:pt x="790" y="0"/>
                  </a:lnTo>
                  <a:lnTo>
                    <a:pt x="793" y="0"/>
                  </a:lnTo>
                  <a:lnTo>
                    <a:pt x="818" y="0"/>
                  </a:lnTo>
                  <a:lnTo>
                    <a:pt x="822" y="0"/>
                  </a:lnTo>
                  <a:lnTo>
                    <a:pt x="835" y="0"/>
                  </a:lnTo>
                  <a:lnTo>
                    <a:pt x="845" y="0"/>
                  </a:lnTo>
                  <a:lnTo>
                    <a:pt x="846" y="0"/>
                  </a:lnTo>
                  <a:lnTo>
                    <a:pt x="854" y="0"/>
                  </a:lnTo>
                  <a:lnTo>
                    <a:pt x="858" y="0"/>
                  </a:lnTo>
                  <a:lnTo>
                    <a:pt x="868" y="0"/>
                  </a:lnTo>
                  <a:lnTo>
                    <a:pt x="881" y="0"/>
                  </a:lnTo>
                  <a:lnTo>
                    <a:pt x="882" y="0"/>
                  </a:lnTo>
                  <a:lnTo>
                    <a:pt x="892" y="0"/>
                  </a:lnTo>
                  <a:lnTo>
                    <a:pt x="897" y="0"/>
                  </a:lnTo>
                  <a:lnTo>
                    <a:pt x="900" y="0"/>
                  </a:lnTo>
                  <a:lnTo>
                    <a:pt x="910" y="0"/>
                  </a:lnTo>
                  <a:lnTo>
                    <a:pt x="916" y="0"/>
                  </a:lnTo>
                  <a:lnTo>
                    <a:pt x="924" y="0"/>
                  </a:lnTo>
                  <a:lnTo>
                    <a:pt x="925" y="0"/>
                  </a:lnTo>
                  <a:lnTo>
                    <a:pt x="933" y="0"/>
                  </a:lnTo>
                  <a:lnTo>
                    <a:pt x="954" y="0"/>
                  </a:lnTo>
                  <a:lnTo>
                    <a:pt x="986" y="0"/>
                  </a:lnTo>
                  <a:lnTo>
                    <a:pt x="991" y="0"/>
                  </a:lnTo>
                  <a:lnTo>
                    <a:pt x="1002" y="0"/>
                  </a:lnTo>
                  <a:lnTo>
                    <a:pt x="1029" y="0"/>
                  </a:lnTo>
                  <a:lnTo>
                    <a:pt x="1078" y="0"/>
                  </a:lnTo>
                  <a:lnTo>
                    <a:pt x="1089" y="0"/>
                  </a:lnTo>
                  <a:lnTo>
                    <a:pt x="1100" y="0"/>
                  </a:lnTo>
                  <a:lnTo>
                    <a:pt x="1115" y="0"/>
                  </a:lnTo>
                  <a:lnTo>
                    <a:pt x="1121" y="0"/>
                  </a:lnTo>
                  <a:lnTo>
                    <a:pt x="1151" y="0"/>
                  </a:lnTo>
                  <a:lnTo>
                    <a:pt x="1156" y="0"/>
                  </a:lnTo>
                  <a:lnTo>
                    <a:pt x="1161" y="0"/>
                  </a:lnTo>
                  <a:lnTo>
                    <a:pt x="1230" y="0"/>
                  </a:lnTo>
                  <a:lnTo>
                    <a:pt x="1290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827589E2-B007-2770-D8B6-53DFB0656C42}"/>
              </a:ext>
            </a:extLst>
          </p:cNvPr>
          <p:cNvGrpSpPr/>
          <p:nvPr/>
        </p:nvGrpSpPr>
        <p:grpSpPr>
          <a:xfrm>
            <a:off x="6306822" y="698448"/>
            <a:ext cx="4141083" cy="2791354"/>
            <a:chOff x="6597102" y="974214"/>
            <a:chExt cx="4141083" cy="2791354"/>
          </a:xfrm>
        </p:grpSpPr>
        <p:grpSp>
          <p:nvGrpSpPr>
            <p:cNvPr id="236" name="グループ化 235">
              <a:extLst>
                <a:ext uri="{FF2B5EF4-FFF2-40B4-BE49-F238E27FC236}">
                  <a16:creationId xmlns:a16="http://schemas.microsoft.com/office/drawing/2014/main" id="{5637447A-A220-9E15-B255-91213D6AE038}"/>
                </a:ext>
              </a:extLst>
            </p:cNvPr>
            <p:cNvGrpSpPr/>
            <p:nvPr/>
          </p:nvGrpSpPr>
          <p:grpSpPr>
            <a:xfrm>
              <a:off x="6597102" y="974214"/>
              <a:ext cx="4141083" cy="2791354"/>
              <a:chOff x="6597102" y="974214"/>
              <a:chExt cx="4141083" cy="2791354"/>
            </a:xfrm>
          </p:grpSpPr>
          <p:sp>
            <p:nvSpPr>
              <p:cNvPr id="172" name="Rectangle 22">
                <a:extLst>
                  <a:ext uri="{FF2B5EF4-FFF2-40B4-BE49-F238E27FC236}">
                    <a16:creationId xmlns:a16="http://schemas.microsoft.com/office/drawing/2014/main" id="{8B2FA7EC-6A41-F975-1900-6BBAC7EB74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7026" y="980735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3" name="Line 23">
                <a:extLst>
                  <a:ext uri="{FF2B5EF4-FFF2-40B4-BE49-F238E27FC236}">
                    <a16:creationId xmlns:a16="http://schemas.microsoft.com/office/drawing/2014/main" id="{9B1228F6-10B8-CE51-971B-C83D8B57E9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1359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4" name="Line 25">
                <a:extLst>
                  <a:ext uri="{FF2B5EF4-FFF2-40B4-BE49-F238E27FC236}">
                    <a16:creationId xmlns:a16="http://schemas.microsoft.com/office/drawing/2014/main" id="{BE0979E1-6978-A11C-8A0F-6744BA0D2E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74576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5" name="Line 27">
                <a:extLst>
                  <a:ext uri="{FF2B5EF4-FFF2-40B4-BE49-F238E27FC236}">
                    <a16:creationId xmlns:a16="http://schemas.microsoft.com/office/drawing/2014/main" id="{A5E73A6A-3798-CF26-F0F0-3A56FCCA63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97792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6" name="Line 29">
                <a:extLst>
                  <a:ext uri="{FF2B5EF4-FFF2-40B4-BE49-F238E27FC236}">
                    <a16:creationId xmlns:a16="http://schemas.microsoft.com/office/drawing/2014/main" id="{4EF827E4-0BAF-1807-0CA1-D011A1E9D1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19120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7" name="Line 31">
                <a:extLst>
                  <a:ext uri="{FF2B5EF4-FFF2-40B4-BE49-F238E27FC236}">
                    <a16:creationId xmlns:a16="http://schemas.microsoft.com/office/drawing/2014/main" id="{E9D05946-352C-06B9-0A68-6C426C283B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42337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8" name="Line 33">
                <a:extLst>
                  <a:ext uri="{FF2B5EF4-FFF2-40B4-BE49-F238E27FC236}">
                    <a16:creationId xmlns:a16="http://schemas.microsoft.com/office/drawing/2014/main" id="{9A44844B-9658-B14F-4AB4-92C5F1E633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65553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9" name="Line 35">
                <a:extLst>
                  <a:ext uri="{FF2B5EF4-FFF2-40B4-BE49-F238E27FC236}">
                    <a16:creationId xmlns:a16="http://schemas.microsoft.com/office/drawing/2014/main" id="{257D179F-218E-ED1F-6358-BDAA2BF30F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588770" y="2996898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80" name="Line 6">
                <a:extLst>
                  <a:ext uri="{FF2B5EF4-FFF2-40B4-BE49-F238E27FC236}">
                    <a16:creationId xmlns:a16="http://schemas.microsoft.com/office/drawing/2014/main" id="{2EB2D15F-50A1-B966-5F57-B72D716B6F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2994512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1" name="Line 8">
                <a:extLst>
                  <a:ext uri="{FF2B5EF4-FFF2-40B4-BE49-F238E27FC236}">
                    <a16:creationId xmlns:a16="http://schemas.microsoft.com/office/drawing/2014/main" id="{537004C1-B131-888B-CB60-D45A204B8B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258701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2" name="Line 9">
                <a:extLst>
                  <a:ext uri="{FF2B5EF4-FFF2-40B4-BE49-F238E27FC236}">
                    <a16:creationId xmlns:a16="http://schemas.microsoft.com/office/drawing/2014/main" id="{BE30B52C-44CB-C821-47FF-D9959D3DE5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2179521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3" name="Line 11">
                <a:extLst>
                  <a:ext uri="{FF2B5EF4-FFF2-40B4-BE49-F238E27FC236}">
                    <a16:creationId xmlns:a16="http://schemas.microsoft.com/office/drawing/2014/main" id="{D4390D76-1247-B684-6ECB-6676FE54F9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1772026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4" name="Line 12">
                <a:extLst>
                  <a:ext uri="{FF2B5EF4-FFF2-40B4-BE49-F238E27FC236}">
                    <a16:creationId xmlns:a16="http://schemas.microsoft.com/office/drawing/2014/main" id="{E15154B9-D2FC-9A56-BA46-816AA4D8FB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85367" y="1364531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5" name="Line 14">
                <a:extLst>
                  <a:ext uri="{FF2B5EF4-FFF2-40B4-BE49-F238E27FC236}">
                    <a16:creationId xmlns:a16="http://schemas.microsoft.com/office/drawing/2014/main" id="{43ECBC04-7BCC-2A1F-2B2A-0D3AE4C012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19206" y="980943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6" name="Line 23">
                <a:extLst>
                  <a:ext uri="{FF2B5EF4-FFF2-40B4-BE49-F238E27FC236}">
                    <a16:creationId xmlns:a16="http://schemas.microsoft.com/office/drawing/2014/main" id="{DC5C2F81-919D-F4A9-F88A-208C85C8AD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3047" y="2994513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87" name="図形グループ 54">
                <a:extLst>
                  <a:ext uri="{FF2B5EF4-FFF2-40B4-BE49-F238E27FC236}">
                    <a16:creationId xmlns:a16="http://schemas.microsoft.com/office/drawing/2014/main" id="{B7CC5933-C4D8-EC26-F672-31D676DC3041}"/>
                  </a:ext>
                </a:extLst>
              </p:cNvPr>
              <p:cNvGrpSpPr/>
              <p:nvPr/>
            </p:nvGrpSpPr>
            <p:grpSpPr>
              <a:xfrm>
                <a:off x="7143441" y="1235436"/>
                <a:ext cx="220989" cy="1868530"/>
                <a:chOff x="510218" y="1348283"/>
                <a:chExt cx="220989" cy="1868530"/>
              </a:xfrm>
            </p:grpSpPr>
            <p:sp>
              <p:nvSpPr>
                <p:cNvPr id="194" name="Rectangle 10">
                  <a:extLst>
                    <a:ext uri="{FF2B5EF4-FFF2-40B4-BE49-F238E27FC236}">
                      <a16:creationId xmlns:a16="http://schemas.microsoft.com/office/drawing/2014/main" id="{FFB05AF3-CD2A-5065-84F3-EA3BA9E2A1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95" name="Rectangle 13">
                  <a:extLst>
                    <a:ext uri="{FF2B5EF4-FFF2-40B4-BE49-F238E27FC236}">
                      <a16:creationId xmlns:a16="http://schemas.microsoft.com/office/drawing/2014/main" id="{5E9F6F84-7C27-D320-325D-6179E8F732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96" name="Rectangle 10">
                  <a:extLst>
                    <a:ext uri="{FF2B5EF4-FFF2-40B4-BE49-F238E27FC236}">
                      <a16:creationId xmlns:a16="http://schemas.microsoft.com/office/drawing/2014/main" id="{E77A11C9-718F-0743-E009-526F508ABB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4DFF09B6-5300-18D5-8D97-26364E1314E0}"/>
                  </a:ext>
                </a:extLst>
              </p:cNvPr>
              <p:cNvSpPr txBox="1"/>
              <p:nvPr/>
            </p:nvSpPr>
            <p:spPr>
              <a:xfrm>
                <a:off x="7315908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911FBB34-F6DA-3779-34A7-5E4DB663F892}"/>
                  </a:ext>
                </a:extLst>
              </p:cNvPr>
              <p:cNvSpPr txBox="1"/>
              <p:nvPr/>
            </p:nvSpPr>
            <p:spPr>
              <a:xfrm>
                <a:off x="8360447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FDAEB116-47EE-C845-65E6-651DF434A696}"/>
                  </a:ext>
                </a:extLst>
              </p:cNvPr>
              <p:cNvSpPr txBox="1"/>
              <p:nvPr/>
            </p:nvSpPr>
            <p:spPr>
              <a:xfrm>
                <a:off x="10449524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id="{73317B78-8021-CCC0-3AA1-67DB11CD4159}"/>
                  </a:ext>
                </a:extLst>
              </p:cNvPr>
              <p:cNvSpPr txBox="1"/>
              <p:nvPr/>
            </p:nvSpPr>
            <p:spPr>
              <a:xfrm>
                <a:off x="9404986" y="3134449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6E14ACF6-AA47-7BA7-9851-59F5CF5AF153}"/>
                  </a:ext>
                </a:extLst>
              </p:cNvPr>
              <p:cNvSpPr txBox="1"/>
              <p:nvPr/>
            </p:nvSpPr>
            <p:spPr>
              <a:xfrm rot="16200000">
                <a:off x="5714007" y="1857309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F40FD17D-EF94-E95C-F4E2-E468924DC3C4}"/>
                  </a:ext>
                </a:extLst>
              </p:cNvPr>
              <p:cNvSpPr txBox="1"/>
              <p:nvPr/>
            </p:nvSpPr>
            <p:spPr>
              <a:xfrm>
                <a:off x="8218214" y="3396236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2" name="Freeform 64">
              <a:extLst>
                <a:ext uri="{FF2B5EF4-FFF2-40B4-BE49-F238E27FC236}">
                  <a16:creationId xmlns:a16="http://schemas.microsoft.com/office/drawing/2014/main" id="{98A7F541-92A5-F8DD-381B-7D22737C8861}"/>
                </a:ext>
              </a:extLst>
            </p:cNvPr>
            <p:cNvSpPr>
              <a:spLocks/>
            </p:cNvSpPr>
            <p:nvPr/>
          </p:nvSpPr>
          <p:spPr bwMode="auto">
            <a:xfrm>
              <a:off x="7446845" y="2115680"/>
              <a:ext cx="2616043" cy="871852"/>
            </a:xfrm>
            <a:custGeom>
              <a:avLst/>
              <a:gdLst>
                <a:gd name="T0" fmla="*/ 92 w 1390"/>
                <a:gd name="T1" fmla="*/ 471 h 476"/>
                <a:gd name="T2" fmla="*/ 117 w 1390"/>
                <a:gd name="T3" fmla="*/ 461 h 476"/>
                <a:gd name="T4" fmla="*/ 126 w 1390"/>
                <a:gd name="T5" fmla="*/ 451 h 476"/>
                <a:gd name="T6" fmla="*/ 136 w 1390"/>
                <a:gd name="T7" fmla="*/ 436 h 476"/>
                <a:gd name="T8" fmla="*/ 150 w 1390"/>
                <a:gd name="T9" fmla="*/ 421 h 476"/>
                <a:gd name="T10" fmla="*/ 160 w 1390"/>
                <a:gd name="T11" fmla="*/ 406 h 476"/>
                <a:gd name="T12" fmla="*/ 167 w 1390"/>
                <a:gd name="T13" fmla="*/ 385 h 476"/>
                <a:gd name="T14" fmla="*/ 181 w 1390"/>
                <a:gd name="T15" fmla="*/ 370 h 476"/>
                <a:gd name="T16" fmla="*/ 190 w 1390"/>
                <a:gd name="T17" fmla="*/ 355 h 476"/>
                <a:gd name="T18" fmla="*/ 203 w 1390"/>
                <a:gd name="T19" fmla="*/ 334 h 476"/>
                <a:gd name="T20" fmla="*/ 216 w 1390"/>
                <a:gd name="T21" fmla="*/ 324 h 476"/>
                <a:gd name="T22" fmla="*/ 236 w 1390"/>
                <a:gd name="T23" fmla="*/ 319 h 476"/>
                <a:gd name="T24" fmla="*/ 251 w 1390"/>
                <a:gd name="T25" fmla="*/ 308 h 476"/>
                <a:gd name="T26" fmla="*/ 256 w 1390"/>
                <a:gd name="T27" fmla="*/ 292 h 476"/>
                <a:gd name="T28" fmla="*/ 279 w 1390"/>
                <a:gd name="T29" fmla="*/ 281 h 476"/>
                <a:gd name="T30" fmla="*/ 293 w 1390"/>
                <a:gd name="T31" fmla="*/ 276 h 476"/>
                <a:gd name="T32" fmla="*/ 321 w 1390"/>
                <a:gd name="T33" fmla="*/ 270 h 476"/>
                <a:gd name="T34" fmla="*/ 330 w 1390"/>
                <a:gd name="T35" fmla="*/ 259 h 476"/>
                <a:gd name="T36" fmla="*/ 339 w 1390"/>
                <a:gd name="T37" fmla="*/ 241 h 476"/>
                <a:gd name="T38" fmla="*/ 352 w 1390"/>
                <a:gd name="T39" fmla="*/ 236 h 476"/>
                <a:gd name="T40" fmla="*/ 373 w 1390"/>
                <a:gd name="T41" fmla="*/ 230 h 476"/>
                <a:gd name="T42" fmla="*/ 391 w 1390"/>
                <a:gd name="T43" fmla="*/ 224 h 476"/>
                <a:gd name="T44" fmla="*/ 408 w 1390"/>
                <a:gd name="T45" fmla="*/ 218 h 476"/>
                <a:gd name="T46" fmla="*/ 421 w 1390"/>
                <a:gd name="T47" fmla="*/ 205 h 476"/>
                <a:gd name="T48" fmla="*/ 445 w 1390"/>
                <a:gd name="T49" fmla="*/ 205 h 476"/>
                <a:gd name="T50" fmla="*/ 452 w 1390"/>
                <a:gd name="T51" fmla="*/ 178 h 476"/>
                <a:gd name="T52" fmla="*/ 461 w 1390"/>
                <a:gd name="T53" fmla="*/ 157 h 476"/>
                <a:gd name="T54" fmla="*/ 492 w 1390"/>
                <a:gd name="T55" fmla="*/ 157 h 476"/>
                <a:gd name="T56" fmla="*/ 511 w 1390"/>
                <a:gd name="T57" fmla="*/ 150 h 476"/>
                <a:gd name="T58" fmla="*/ 540 w 1390"/>
                <a:gd name="T59" fmla="*/ 150 h 476"/>
                <a:gd name="T60" fmla="*/ 571 w 1390"/>
                <a:gd name="T61" fmla="*/ 150 h 476"/>
                <a:gd name="T62" fmla="*/ 585 w 1390"/>
                <a:gd name="T63" fmla="*/ 135 h 476"/>
                <a:gd name="T64" fmla="*/ 599 w 1390"/>
                <a:gd name="T65" fmla="*/ 127 h 476"/>
                <a:gd name="T66" fmla="*/ 612 w 1390"/>
                <a:gd name="T67" fmla="*/ 110 h 476"/>
                <a:gd name="T68" fmla="*/ 633 w 1390"/>
                <a:gd name="T69" fmla="*/ 101 h 476"/>
                <a:gd name="T70" fmla="*/ 648 w 1390"/>
                <a:gd name="T71" fmla="*/ 92 h 476"/>
                <a:gd name="T72" fmla="*/ 665 w 1390"/>
                <a:gd name="T73" fmla="*/ 83 h 476"/>
                <a:gd name="T74" fmla="*/ 685 w 1390"/>
                <a:gd name="T75" fmla="*/ 73 h 476"/>
                <a:gd name="T76" fmla="*/ 697 w 1390"/>
                <a:gd name="T77" fmla="*/ 53 h 476"/>
                <a:gd name="T78" fmla="*/ 721 w 1390"/>
                <a:gd name="T79" fmla="*/ 53 h 476"/>
                <a:gd name="T80" fmla="*/ 744 w 1390"/>
                <a:gd name="T81" fmla="*/ 53 h 476"/>
                <a:gd name="T82" fmla="*/ 757 w 1390"/>
                <a:gd name="T83" fmla="*/ 27 h 476"/>
                <a:gd name="T84" fmla="*/ 781 w 1390"/>
                <a:gd name="T85" fmla="*/ 27 h 476"/>
                <a:gd name="T86" fmla="*/ 793 w 1390"/>
                <a:gd name="T87" fmla="*/ 0 h 476"/>
                <a:gd name="T88" fmla="*/ 832 w 1390"/>
                <a:gd name="T89" fmla="*/ 0 h 476"/>
                <a:gd name="T90" fmla="*/ 858 w 1390"/>
                <a:gd name="T91" fmla="*/ 0 h 476"/>
                <a:gd name="T92" fmla="*/ 891 w 1390"/>
                <a:gd name="T93" fmla="*/ 0 h 476"/>
                <a:gd name="T94" fmla="*/ 918 w 1390"/>
                <a:gd name="T95" fmla="*/ 0 h 476"/>
                <a:gd name="T96" fmla="*/ 960 w 1390"/>
                <a:gd name="T97" fmla="*/ 0 h 476"/>
                <a:gd name="T98" fmla="*/ 991 w 1390"/>
                <a:gd name="T99" fmla="*/ 0 h 476"/>
                <a:gd name="T100" fmla="*/ 1033 w 1390"/>
                <a:gd name="T101" fmla="*/ 0 h 476"/>
                <a:gd name="T102" fmla="*/ 1081 w 1390"/>
                <a:gd name="T103" fmla="*/ 0 h 476"/>
                <a:gd name="T104" fmla="*/ 1109 w 1390"/>
                <a:gd name="T105" fmla="*/ 0 h 476"/>
                <a:gd name="T106" fmla="*/ 1138 w 1390"/>
                <a:gd name="T107" fmla="*/ 0 h 476"/>
                <a:gd name="T108" fmla="*/ 1174 w 1390"/>
                <a:gd name="T109" fmla="*/ 0 h 476"/>
                <a:gd name="T110" fmla="*/ 1223 w 1390"/>
                <a:gd name="T111" fmla="*/ 0 h 476"/>
                <a:gd name="T112" fmla="*/ 1302 w 1390"/>
                <a:gd name="T113" fmla="*/ 0 h 476"/>
                <a:gd name="T114" fmla="*/ 1374 w 1390"/>
                <a:gd name="T115" fmla="*/ 0 h 4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390" h="476">
                  <a:moveTo>
                    <a:pt x="0" y="476"/>
                  </a:moveTo>
                  <a:lnTo>
                    <a:pt x="85" y="476"/>
                  </a:lnTo>
                  <a:lnTo>
                    <a:pt x="85" y="471"/>
                  </a:lnTo>
                  <a:lnTo>
                    <a:pt x="92" y="471"/>
                  </a:lnTo>
                  <a:lnTo>
                    <a:pt x="105" y="471"/>
                  </a:lnTo>
                  <a:lnTo>
                    <a:pt x="105" y="466"/>
                  </a:lnTo>
                  <a:lnTo>
                    <a:pt x="110" y="466"/>
                  </a:lnTo>
                  <a:lnTo>
                    <a:pt x="117" y="461"/>
                  </a:lnTo>
                  <a:lnTo>
                    <a:pt x="117" y="456"/>
                  </a:lnTo>
                  <a:lnTo>
                    <a:pt x="121" y="456"/>
                  </a:lnTo>
                  <a:lnTo>
                    <a:pt x="121" y="451"/>
                  </a:lnTo>
                  <a:lnTo>
                    <a:pt x="126" y="451"/>
                  </a:lnTo>
                  <a:lnTo>
                    <a:pt x="126" y="446"/>
                  </a:lnTo>
                  <a:lnTo>
                    <a:pt x="129" y="441"/>
                  </a:lnTo>
                  <a:lnTo>
                    <a:pt x="136" y="441"/>
                  </a:lnTo>
                  <a:lnTo>
                    <a:pt x="136" y="436"/>
                  </a:lnTo>
                  <a:lnTo>
                    <a:pt x="143" y="431"/>
                  </a:lnTo>
                  <a:lnTo>
                    <a:pt x="143" y="426"/>
                  </a:lnTo>
                  <a:lnTo>
                    <a:pt x="147" y="421"/>
                  </a:lnTo>
                  <a:lnTo>
                    <a:pt x="150" y="421"/>
                  </a:lnTo>
                  <a:lnTo>
                    <a:pt x="150" y="416"/>
                  </a:lnTo>
                  <a:lnTo>
                    <a:pt x="153" y="411"/>
                  </a:lnTo>
                  <a:lnTo>
                    <a:pt x="160" y="411"/>
                  </a:lnTo>
                  <a:lnTo>
                    <a:pt x="160" y="406"/>
                  </a:lnTo>
                  <a:lnTo>
                    <a:pt x="163" y="395"/>
                  </a:lnTo>
                  <a:lnTo>
                    <a:pt x="164" y="391"/>
                  </a:lnTo>
                  <a:lnTo>
                    <a:pt x="165" y="385"/>
                  </a:lnTo>
                  <a:lnTo>
                    <a:pt x="167" y="385"/>
                  </a:lnTo>
                  <a:lnTo>
                    <a:pt x="172" y="385"/>
                  </a:lnTo>
                  <a:lnTo>
                    <a:pt x="172" y="375"/>
                  </a:lnTo>
                  <a:lnTo>
                    <a:pt x="177" y="370"/>
                  </a:lnTo>
                  <a:lnTo>
                    <a:pt x="181" y="370"/>
                  </a:lnTo>
                  <a:lnTo>
                    <a:pt x="182" y="360"/>
                  </a:lnTo>
                  <a:lnTo>
                    <a:pt x="183" y="355"/>
                  </a:lnTo>
                  <a:lnTo>
                    <a:pt x="185" y="355"/>
                  </a:lnTo>
                  <a:lnTo>
                    <a:pt x="190" y="355"/>
                  </a:lnTo>
                  <a:lnTo>
                    <a:pt x="193" y="345"/>
                  </a:lnTo>
                  <a:lnTo>
                    <a:pt x="195" y="340"/>
                  </a:lnTo>
                  <a:lnTo>
                    <a:pt x="199" y="340"/>
                  </a:lnTo>
                  <a:lnTo>
                    <a:pt x="203" y="334"/>
                  </a:lnTo>
                  <a:lnTo>
                    <a:pt x="203" y="330"/>
                  </a:lnTo>
                  <a:lnTo>
                    <a:pt x="208" y="330"/>
                  </a:lnTo>
                  <a:lnTo>
                    <a:pt x="216" y="330"/>
                  </a:lnTo>
                  <a:lnTo>
                    <a:pt x="216" y="324"/>
                  </a:lnTo>
                  <a:lnTo>
                    <a:pt x="220" y="324"/>
                  </a:lnTo>
                  <a:lnTo>
                    <a:pt x="226" y="324"/>
                  </a:lnTo>
                  <a:lnTo>
                    <a:pt x="236" y="324"/>
                  </a:lnTo>
                  <a:lnTo>
                    <a:pt x="236" y="319"/>
                  </a:lnTo>
                  <a:lnTo>
                    <a:pt x="241" y="319"/>
                  </a:lnTo>
                  <a:lnTo>
                    <a:pt x="241" y="308"/>
                  </a:lnTo>
                  <a:lnTo>
                    <a:pt x="249" y="308"/>
                  </a:lnTo>
                  <a:lnTo>
                    <a:pt x="251" y="308"/>
                  </a:lnTo>
                  <a:lnTo>
                    <a:pt x="251" y="303"/>
                  </a:lnTo>
                  <a:lnTo>
                    <a:pt x="252" y="298"/>
                  </a:lnTo>
                  <a:lnTo>
                    <a:pt x="253" y="292"/>
                  </a:lnTo>
                  <a:lnTo>
                    <a:pt x="256" y="292"/>
                  </a:lnTo>
                  <a:lnTo>
                    <a:pt x="266" y="292"/>
                  </a:lnTo>
                  <a:lnTo>
                    <a:pt x="269" y="287"/>
                  </a:lnTo>
                  <a:lnTo>
                    <a:pt x="269" y="281"/>
                  </a:lnTo>
                  <a:lnTo>
                    <a:pt x="279" y="281"/>
                  </a:lnTo>
                  <a:lnTo>
                    <a:pt x="281" y="281"/>
                  </a:lnTo>
                  <a:lnTo>
                    <a:pt x="286" y="281"/>
                  </a:lnTo>
                  <a:lnTo>
                    <a:pt x="292" y="281"/>
                  </a:lnTo>
                  <a:lnTo>
                    <a:pt x="293" y="276"/>
                  </a:lnTo>
                  <a:lnTo>
                    <a:pt x="299" y="276"/>
                  </a:lnTo>
                  <a:lnTo>
                    <a:pt x="305" y="276"/>
                  </a:lnTo>
                  <a:lnTo>
                    <a:pt x="316" y="276"/>
                  </a:lnTo>
                  <a:lnTo>
                    <a:pt x="321" y="270"/>
                  </a:lnTo>
                  <a:lnTo>
                    <a:pt x="324" y="270"/>
                  </a:lnTo>
                  <a:lnTo>
                    <a:pt x="325" y="264"/>
                  </a:lnTo>
                  <a:lnTo>
                    <a:pt x="328" y="259"/>
                  </a:lnTo>
                  <a:lnTo>
                    <a:pt x="330" y="259"/>
                  </a:lnTo>
                  <a:lnTo>
                    <a:pt x="331" y="253"/>
                  </a:lnTo>
                  <a:lnTo>
                    <a:pt x="334" y="247"/>
                  </a:lnTo>
                  <a:lnTo>
                    <a:pt x="339" y="247"/>
                  </a:lnTo>
                  <a:lnTo>
                    <a:pt x="339" y="241"/>
                  </a:lnTo>
                  <a:lnTo>
                    <a:pt x="345" y="241"/>
                  </a:lnTo>
                  <a:lnTo>
                    <a:pt x="345" y="236"/>
                  </a:lnTo>
                  <a:lnTo>
                    <a:pt x="349" y="236"/>
                  </a:lnTo>
                  <a:lnTo>
                    <a:pt x="352" y="236"/>
                  </a:lnTo>
                  <a:lnTo>
                    <a:pt x="355" y="230"/>
                  </a:lnTo>
                  <a:lnTo>
                    <a:pt x="358" y="230"/>
                  </a:lnTo>
                  <a:lnTo>
                    <a:pt x="369" y="230"/>
                  </a:lnTo>
                  <a:lnTo>
                    <a:pt x="373" y="230"/>
                  </a:lnTo>
                  <a:lnTo>
                    <a:pt x="378" y="230"/>
                  </a:lnTo>
                  <a:lnTo>
                    <a:pt x="382" y="224"/>
                  </a:lnTo>
                  <a:lnTo>
                    <a:pt x="383" y="224"/>
                  </a:lnTo>
                  <a:lnTo>
                    <a:pt x="391" y="224"/>
                  </a:lnTo>
                  <a:lnTo>
                    <a:pt x="398" y="224"/>
                  </a:lnTo>
                  <a:lnTo>
                    <a:pt x="402" y="224"/>
                  </a:lnTo>
                  <a:lnTo>
                    <a:pt x="408" y="224"/>
                  </a:lnTo>
                  <a:lnTo>
                    <a:pt x="408" y="218"/>
                  </a:lnTo>
                  <a:lnTo>
                    <a:pt x="414" y="218"/>
                  </a:lnTo>
                  <a:lnTo>
                    <a:pt x="414" y="211"/>
                  </a:lnTo>
                  <a:lnTo>
                    <a:pt x="420" y="211"/>
                  </a:lnTo>
                  <a:lnTo>
                    <a:pt x="421" y="205"/>
                  </a:lnTo>
                  <a:lnTo>
                    <a:pt x="425" y="205"/>
                  </a:lnTo>
                  <a:lnTo>
                    <a:pt x="434" y="205"/>
                  </a:lnTo>
                  <a:lnTo>
                    <a:pt x="437" y="205"/>
                  </a:lnTo>
                  <a:lnTo>
                    <a:pt x="445" y="205"/>
                  </a:lnTo>
                  <a:lnTo>
                    <a:pt x="445" y="198"/>
                  </a:lnTo>
                  <a:lnTo>
                    <a:pt x="447" y="185"/>
                  </a:lnTo>
                  <a:lnTo>
                    <a:pt x="449" y="185"/>
                  </a:lnTo>
                  <a:lnTo>
                    <a:pt x="452" y="178"/>
                  </a:lnTo>
                  <a:lnTo>
                    <a:pt x="455" y="178"/>
                  </a:lnTo>
                  <a:lnTo>
                    <a:pt x="458" y="171"/>
                  </a:lnTo>
                  <a:lnTo>
                    <a:pt x="461" y="171"/>
                  </a:lnTo>
                  <a:lnTo>
                    <a:pt x="461" y="157"/>
                  </a:lnTo>
                  <a:lnTo>
                    <a:pt x="471" y="157"/>
                  </a:lnTo>
                  <a:lnTo>
                    <a:pt x="481" y="157"/>
                  </a:lnTo>
                  <a:lnTo>
                    <a:pt x="487" y="157"/>
                  </a:lnTo>
                  <a:lnTo>
                    <a:pt x="492" y="157"/>
                  </a:lnTo>
                  <a:lnTo>
                    <a:pt x="492" y="150"/>
                  </a:lnTo>
                  <a:lnTo>
                    <a:pt x="497" y="150"/>
                  </a:lnTo>
                  <a:lnTo>
                    <a:pt x="505" y="150"/>
                  </a:lnTo>
                  <a:lnTo>
                    <a:pt x="511" y="150"/>
                  </a:lnTo>
                  <a:lnTo>
                    <a:pt x="516" y="150"/>
                  </a:lnTo>
                  <a:lnTo>
                    <a:pt x="528" y="150"/>
                  </a:lnTo>
                  <a:lnTo>
                    <a:pt x="537" y="150"/>
                  </a:lnTo>
                  <a:lnTo>
                    <a:pt x="540" y="150"/>
                  </a:lnTo>
                  <a:lnTo>
                    <a:pt x="546" y="150"/>
                  </a:lnTo>
                  <a:lnTo>
                    <a:pt x="554" y="150"/>
                  </a:lnTo>
                  <a:lnTo>
                    <a:pt x="558" y="150"/>
                  </a:lnTo>
                  <a:lnTo>
                    <a:pt x="571" y="150"/>
                  </a:lnTo>
                  <a:lnTo>
                    <a:pt x="575" y="150"/>
                  </a:lnTo>
                  <a:lnTo>
                    <a:pt x="581" y="150"/>
                  </a:lnTo>
                  <a:lnTo>
                    <a:pt x="582" y="142"/>
                  </a:lnTo>
                  <a:lnTo>
                    <a:pt x="585" y="135"/>
                  </a:lnTo>
                  <a:lnTo>
                    <a:pt x="587" y="135"/>
                  </a:lnTo>
                  <a:lnTo>
                    <a:pt x="587" y="127"/>
                  </a:lnTo>
                  <a:lnTo>
                    <a:pt x="593" y="127"/>
                  </a:lnTo>
                  <a:lnTo>
                    <a:pt x="599" y="127"/>
                  </a:lnTo>
                  <a:lnTo>
                    <a:pt x="600" y="118"/>
                  </a:lnTo>
                  <a:lnTo>
                    <a:pt x="605" y="118"/>
                  </a:lnTo>
                  <a:lnTo>
                    <a:pt x="609" y="110"/>
                  </a:lnTo>
                  <a:lnTo>
                    <a:pt x="612" y="110"/>
                  </a:lnTo>
                  <a:lnTo>
                    <a:pt x="618" y="110"/>
                  </a:lnTo>
                  <a:lnTo>
                    <a:pt x="624" y="110"/>
                  </a:lnTo>
                  <a:lnTo>
                    <a:pt x="631" y="110"/>
                  </a:lnTo>
                  <a:lnTo>
                    <a:pt x="633" y="101"/>
                  </a:lnTo>
                  <a:lnTo>
                    <a:pt x="635" y="101"/>
                  </a:lnTo>
                  <a:lnTo>
                    <a:pt x="644" y="101"/>
                  </a:lnTo>
                  <a:lnTo>
                    <a:pt x="644" y="92"/>
                  </a:lnTo>
                  <a:lnTo>
                    <a:pt x="648" y="92"/>
                  </a:lnTo>
                  <a:lnTo>
                    <a:pt x="653" y="83"/>
                  </a:lnTo>
                  <a:lnTo>
                    <a:pt x="654" y="83"/>
                  </a:lnTo>
                  <a:lnTo>
                    <a:pt x="660" y="83"/>
                  </a:lnTo>
                  <a:lnTo>
                    <a:pt x="665" y="83"/>
                  </a:lnTo>
                  <a:lnTo>
                    <a:pt x="675" y="83"/>
                  </a:lnTo>
                  <a:lnTo>
                    <a:pt x="678" y="83"/>
                  </a:lnTo>
                  <a:lnTo>
                    <a:pt x="681" y="73"/>
                  </a:lnTo>
                  <a:lnTo>
                    <a:pt x="685" y="73"/>
                  </a:lnTo>
                  <a:lnTo>
                    <a:pt x="688" y="63"/>
                  </a:lnTo>
                  <a:lnTo>
                    <a:pt x="690" y="63"/>
                  </a:lnTo>
                  <a:lnTo>
                    <a:pt x="697" y="63"/>
                  </a:lnTo>
                  <a:lnTo>
                    <a:pt x="697" y="53"/>
                  </a:lnTo>
                  <a:lnTo>
                    <a:pt x="705" y="53"/>
                  </a:lnTo>
                  <a:lnTo>
                    <a:pt x="710" y="53"/>
                  </a:lnTo>
                  <a:lnTo>
                    <a:pt x="715" y="53"/>
                  </a:lnTo>
                  <a:lnTo>
                    <a:pt x="721" y="53"/>
                  </a:lnTo>
                  <a:lnTo>
                    <a:pt x="728" y="53"/>
                  </a:lnTo>
                  <a:lnTo>
                    <a:pt x="731" y="53"/>
                  </a:lnTo>
                  <a:lnTo>
                    <a:pt x="740" y="53"/>
                  </a:lnTo>
                  <a:lnTo>
                    <a:pt x="744" y="53"/>
                  </a:lnTo>
                  <a:lnTo>
                    <a:pt x="750" y="53"/>
                  </a:lnTo>
                  <a:lnTo>
                    <a:pt x="755" y="40"/>
                  </a:lnTo>
                  <a:lnTo>
                    <a:pt x="756" y="40"/>
                  </a:lnTo>
                  <a:lnTo>
                    <a:pt x="757" y="27"/>
                  </a:lnTo>
                  <a:lnTo>
                    <a:pt x="765" y="27"/>
                  </a:lnTo>
                  <a:lnTo>
                    <a:pt x="771" y="27"/>
                  </a:lnTo>
                  <a:lnTo>
                    <a:pt x="775" y="27"/>
                  </a:lnTo>
                  <a:lnTo>
                    <a:pt x="781" y="27"/>
                  </a:lnTo>
                  <a:lnTo>
                    <a:pt x="781" y="14"/>
                  </a:lnTo>
                  <a:lnTo>
                    <a:pt x="785" y="0"/>
                  </a:lnTo>
                  <a:lnTo>
                    <a:pt x="788" y="0"/>
                  </a:lnTo>
                  <a:lnTo>
                    <a:pt x="793" y="0"/>
                  </a:lnTo>
                  <a:lnTo>
                    <a:pt x="800" y="0"/>
                  </a:lnTo>
                  <a:lnTo>
                    <a:pt x="807" y="0"/>
                  </a:lnTo>
                  <a:lnTo>
                    <a:pt x="823" y="0"/>
                  </a:lnTo>
                  <a:lnTo>
                    <a:pt x="832" y="0"/>
                  </a:lnTo>
                  <a:lnTo>
                    <a:pt x="835" y="0"/>
                  </a:lnTo>
                  <a:lnTo>
                    <a:pt x="846" y="0"/>
                  </a:lnTo>
                  <a:lnTo>
                    <a:pt x="852" y="0"/>
                  </a:lnTo>
                  <a:lnTo>
                    <a:pt x="858" y="0"/>
                  </a:lnTo>
                  <a:lnTo>
                    <a:pt x="872" y="0"/>
                  </a:lnTo>
                  <a:lnTo>
                    <a:pt x="881" y="0"/>
                  </a:lnTo>
                  <a:lnTo>
                    <a:pt x="882" y="0"/>
                  </a:lnTo>
                  <a:lnTo>
                    <a:pt x="891" y="0"/>
                  </a:lnTo>
                  <a:lnTo>
                    <a:pt x="894" y="0"/>
                  </a:lnTo>
                  <a:lnTo>
                    <a:pt x="900" y="0"/>
                  </a:lnTo>
                  <a:lnTo>
                    <a:pt x="912" y="0"/>
                  </a:lnTo>
                  <a:lnTo>
                    <a:pt x="918" y="0"/>
                  </a:lnTo>
                  <a:lnTo>
                    <a:pt x="933" y="0"/>
                  </a:lnTo>
                  <a:lnTo>
                    <a:pt x="938" y="0"/>
                  </a:lnTo>
                  <a:lnTo>
                    <a:pt x="949" y="0"/>
                  </a:lnTo>
                  <a:lnTo>
                    <a:pt x="960" y="0"/>
                  </a:lnTo>
                  <a:lnTo>
                    <a:pt x="962" y="0"/>
                  </a:lnTo>
                  <a:lnTo>
                    <a:pt x="967" y="0"/>
                  </a:lnTo>
                  <a:lnTo>
                    <a:pt x="975" y="0"/>
                  </a:lnTo>
                  <a:lnTo>
                    <a:pt x="991" y="0"/>
                  </a:lnTo>
                  <a:lnTo>
                    <a:pt x="997" y="0"/>
                  </a:lnTo>
                  <a:lnTo>
                    <a:pt x="1009" y="0"/>
                  </a:lnTo>
                  <a:lnTo>
                    <a:pt x="1027" y="0"/>
                  </a:lnTo>
                  <a:lnTo>
                    <a:pt x="1033" y="0"/>
                  </a:lnTo>
                  <a:lnTo>
                    <a:pt x="1041" y="0"/>
                  </a:lnTo>
                  <a:lnTo>
                    <a:pt x="1065" y="0"/>
                  </a:lnTo>
                  <a:lnTo>
                    <a:pt x="1071" y="0"/>
                  </a:lnTo>
                  <a:lnTo>
                    <a:pt x="1081" y="0"/>
                  </a:lnTo>
                  <a:lnTo>
                    <a:pt x="1087" y="0"/>
                  </a:lnTo>
                  <a:lnTo>
                    <a:pt x="1095" y="0"/>
                  </a:lnTo>
                  <a:lnTo>
                    <a:pt x="1102" y="0"/>
                  </a:lnTo>
                  <a:lnTo>
                    <a:pt x="1109" y="0"/>
                  </a:lnTo>
                  <a:lnTo>
                    <a:pt x="1115" y="0"/>
                  </a:lnTo>
                  <a:lnTo>
                    <a:pt x="1120" y="0"/>
                  </a:lnTo>
                  <a:lnTo>
                    <a:pt x="1128" y="0"/>
                  </a:lnTo>
                  <a:lnTo>
                    <a:pt x="1138" y="0"/>
                  </a:lnTo>
                  <a:lnTo>
                    <a:pt x="1151" y="0"/>
                  </a:lnTo>
                  <a:lnTo>
                    <a:pt x="1156" y="0"/>
                  </a:lnTo>
                  <a:lnTo>
                    <a:pt x="1162" y="0"/>
                  </a:lnTo>
                  <a:lnTo>
                    <a:pt x="1174" y="0"/>
                  </a:lnTo>
                  <a:lnTo>
                    <a:pt x="1177" y="0"/>
                  </a:lnTo>
                  <a:lnTo>
                    <a:pt x="1191" y="0"/>
                  </a:lnTo>
                  <a:lnTo>
                    <a:pt x="1197" y="0"/>
                  </a:lnTo>
                  <a:lnTo>
                    <a:pt x="1223" y="0"/>
                  </a:lnTo>
                  <a:lnTo>
                    <a:pt x="1253" y="0"/>
                  </a:lnTo>
                  <a:lnTo>
                    <a:pt x="1259" y="0"/>
                  </a:lnTo>
                  <a:lnTo>
                    <a:pt x="1286" y="0"/>
                  </a:lnTo>
                  <a:lnTo>
                    <a:pt x="1302" y="0"/>
                  </a:lnTo>
                  <a:lnTo>
                    <a:pt x="1321" y="0"/>
                  </a:lnTo>
                  <a:lnTo>
                    <a:pt x="1343" y="0"/>
                  </a:lnTo>
                  <a:lnTo>
                    <a:pt x="1353" y="0"/>
                  </a:lnTo>
                  <a:lnTo>
                    <a:pt x="1374" y="0"/>
                  </a:lnTo>
                  <a:lnTo>
                    <a:pt x="1390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Freeform 65">
              <a:extLst>
                <a:ext uri="{FF2B5EF4-FFF2-40B4-BE49-F238E27FC236}">
                  <a16:creationId xmlns:a16="http://schemas.microsoft.com/office/drawing/2014/main" id="{DB9D3B78-8DA8-5CF2-E99F-FCDA213CE6BD}"/>
                </a:ext>
              </a:extLst>
            </p:cNvPr>
            <p:cNvSpPr>
              <a:spLocks/>
            </p:cNvSpPr>
            <p:nvPr/>
          </p:nvSpPr>
          <p:spPr bwMode="auto">
            <a:xfrm>
              <a:off x="7446845" y="2870308"/>
              <a:ext cx="2104127" cy="117224"/>
            </a:xfrm>
            <a:custGeom>
              <a:avLst/>
              <a:gdLst>
                <a:gd name="T0" fmla="*/ 0 w 1118"/>
                <a:gd name="T1" fmla="*/ 64 h 64"/>
                <a:gd name="T2" fmla="*/ 116 w 1118"/>
                <a:gd name="T3" fmla="*/ 64 h 64"/>
                <a:gd name="T4" fmla="*/ 116 w 1118"/>
                <a:gd name="T5" fmla="*/ 0 h 64"/>
                <a:gd name="T6" fmla="*/ 184 w 1118"/>
                <a:gd name="T7" fmla="*/ 0 h 64"/>
                <a:gd name="T8" fmla="*/ 210 w 1118"/>
                <a:gd name="T9" fmla="*/ 0 h 64"/>
                <a:gd name="T10" fmla="*/ 217 w 1118"/>
                <a:gd name="T11" fmla="*/ 0 h 64"/>
                <a:gd name="T12" fmla="*/ 344 w 1118"/>
                <a:gd name="T13" fmla="*/ 0 h 64"/>
                <a:gd name="T14" fmla="*/ 351 w 1118"/>
                <a:gd name="T15" fmla="*/ 0 h 64"/>
                <a:gd name="T16" fmla="*/ 395 w 1118"/>
                <a:gd name="T17" fmla="*/ 0 h 64"/>
                <a:gd name="T18" fmla="*/ 405 w 1118"/>
                <a:gd name="T19" fmla="*/ 0 h 64"/>
                <a:gd name="T20" fmla="*/ 415 w 1118"/>
                <a:gd name="T21" fmla="*/ 0 h 64"/>
                <a:gd name="T22" fmla="*/ 464 w 1118"/>
                <a:gd name="T23" fmla="*/ 0 h 64"/>
                <a:gd name="T24" fmla="*/ 490 w 1118"/>
                <a:gd name="T25" fmla="*/ 0 h 64"/>
                <a:gd name="T26" fmla="*/ 603 w 1118"/>
                <a:gd name="T27" fmla="*/ 0 h 64"/>
                <a:gd name="T28" fmla="*/ 617 w 1118"/>
                <a:gd name="T29" fmla="*/ 0 h 64"/>
                <a:gd name="T30" fmla="*/ 659 w 1118"/>
                <a:gd name="T31" fmla="*/ 0 h 64"/>
                <a:gd name="T32" fmla="*/ 669 w 1118"/>
                <a:gd name="T33" fmla="*/ 0 h 64"/>
                <a:gd name="T34" fmla="*/ 671 w 1118"/>
                <a:gd name="T35" fmla="*/ 0 h 64"/>
                <a:gd name="T36" fmla="*/ 712 w 1118"/>
                <a:gd name="T37" fmla="*/ 0 h 64"/>
                <a:gd name="T38" fmla="*/ 741 w 1118"/>
                <a:gd name="T39" fmla="*/ 0 h 64"/>
                <a:gd name="T40" fmla="*/ 744 w 1118"/>
                <a:gd name="T41" fmla="*/ 0 h 64"/>
                <a:gd name="T42" fmla="*/ 765 w 1118"/>
                <a:gd name="T43" fmla="*/ 0 h 64"/>
                <a:gd name="T44" fmla="*/ 802 w 1118"/>
                <a:gd name="T45" fmla="*/ 0 h 64"/>
                <a:gd name="T46" fmla="*/ 827 w 1118"/>
                <a:gd name="T47" fmla="*/ 0 h 64"/>
                <a:gd name="T48" fmla="*/ 841 w 1118"/>
                <a:gd name="T49" fmla="*/ 0 h 64"/>
                <a:gd name="T50" fmla="*/ 867 w 1118"/>
                <a:gd name="T51" fmla="*/ 0 h 64"/>
                <a:gd name="T52" fmla="*/ 900 w 1118"/>
                <a:gd name="T53" fmla="*/ 0 h 64"/>
                <a:gd name="T54" fmla="*/ 950 w 1118"/>
                <a:gd name="T55" fmla="*/ 0 h 64"/>
                <a:gd name="T56" fmla="*/ 991 w 1118"/>
                <a:gd name="T57" fmla="*/ 0 h 64"/>
                <a:gd name="T58" fmla="*/ 998 w 1118"/>
                <a:gd name="T59" fmla="*/ 0 h 64"/>
                <a:gd name="T60" fmla="*/ 1036 w 1118"/>
                <a:gd name="T61" fmla="*/ 0 h 64"/>
                <a:gd name="T62" fmla="*/ 1100 w 1118"/>
                <a:gd name="T63" fmla="*/ 0 h 64"/>
                <a:gd name="T64" fmla="*/ 1118 w 1118"/>
                <a:gd name="T6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118" h="64">
                  <a:moveTo>
                    <a:pt x="0" y="64"/>
                  </a:moveTo>
                  <a:lnTo>
                    <a:pt x="116" y="64"/>
                  </a:lnTo>
                  <a:lnTo>
                    <a:pt x="116" y="0"/>
                  </a:lnTo>
                  <a:lnTo>
                    <a:pt x="184" y="0"/>
                  </a:lnTo>
                  <a:lnTo>
                    <a:pt x="210" y="0"/>
                  </a:lnTo>
                  <a:lnTo>
                    <a:pt x="217" y="0"/>
                  </a:lnTo>
                  <a:lnTo>
                    <a:pt x="344" y="0"/>
                  </a:lnTo>
                  <a:lnTo>
                    <a:pt x="351" y="0"/>
                  </a:lnTo>
                  <a:lnTo>
                    <a:pt x="395" y="0"/>
                  </a:lnTo>
                  <a:lnTo>
                    <a:pt x="405" y="0"/>
                  </a:lnTo>
                  <a:lnTo>
                    <a:pt x="415" y="0"/>
                  </a:lnTo>
                  <a:lnTo>
                    <a:pt x="464" y="0"/>
                  </a:lnTo>
                  <a:lnTo>
                    <a:pt x="490" y="0"/>
                  </a:lnTo>
                  <a:lnTo>
                    <a:pt x="603" y="0"/>
                  </a:lnTo>
                  <a:lnTo>
                    <a:pt x="617" y="0"/>
                  </a:lnTo>
                  <a:lnTo>
                    <a:pt x="659" y="0"/>
                  </a:lnTo>
                  <a:lnTo>
                    <a:pt x="669" y="0"/>
                  </a:lnTo>
                  <a:lnTo>
                    <a:pt x="671" y="0"/>
                  </a:lnTo>
                  <a:lnTo>
                    <a:pt x="712" y="0"/>
                  </a:lnTo>
                  <a:lnTo>
                    <a:pt x="741" y="0"/>
                  </a:lnTo>
                  <a:lnTo>
                    <a:pt x="744" y="0"/>
                  </a:lnTo>
                  <a:lnTo>
                    <a:pt x="765" y="0"/>
                  </a:lnTo>
                  <a:lnTo>
                    <a:pt x="802" y="0"/>
                  </a:lnTo>
                  <a:lnTo>
                    <a:pt x="827" y="0"/>
                  </a:lnTo>
                  <a:lnTo>
                    <a:pt x="841" y="0"/>
                  </a:lnTo>
                  <a:lnTo>
                    <a:pt x="867" y="0"/>
                  </a:lnTo>
                  <a:lnTo>
                    <a:pt x="900" y="0"/>
                  </a:lnTo>
                  <a:lnTo>
                    <a:pt x="950" y="0"/>
                  </a:lnTo>
                  <a:lnTo>
                    <a:pt x="991" y="0"/>
                  </a:lnTo>
                  <a:lnTo>
                    <a:pt x="998" y="0"/>
                  </a:lnTo>
                  <a:lnTo>
                    <a:pt x="1036" y="0"/>
                  </a:lnTo>
                  <a:lnTo>
                    <a:pt x="1100" y="0"/>
                  </a:lnTo>
                  <a:lnTo>
                    <a:pt x="1118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Freeform 66">
              <a:extLst>
                <a:ext uri="{FF2B5EF4-FFF2-40B4-BE49-F238E27FC236}">
                  <a16:creationId xmlns:a16="http://schemas.microsoft.com/office/drawing/2014/main" id="{27CE8ACF-49A1-7A5E-A477-B9A64DA26601}"/>
                </a:ext>
              </a:extLst>
            </p:cNvPr>
            <p:cNvSpPr>
              <a:spLocks/>
            </p:cNvSpPr>
            <p:nvPr/>
          </p:nvSpPr>
          <p:spPr bwMode="auto">
            <a:xfrm>
              <a:off x="7446845" y="2841002"/>
              <a:ext cx="2446659" cy="146530"/>
            </a:xfrm>
            <a:custGeom>
              <a:avLst/>
              <a:gdLst>
                <a:gd name="T0" fmla="*/ 85 w 1300"/>
                <a:gd name="T1" fmla="*/ 80 h 80"/>
                <a:gd name="T2" fmla="*/ 101 w 1300"/>
                <a:gd name="T3" fmla="*/ 66 h 80"/>
                <a:gd name="T4" fmla="*/ 157 w 1300"/>
                <a:gd name="T5" fmla="*/ 66 h 80"/>
                <a:gd name="T6" fmla="*/ 189 w 1300"/>
                <a:gd name="T7" fmla="*/ 66 h 80"/>
                <a:gd name="T8" fmla="*/ 216 w 1300"/>
                <a:gd name="T9" fmla="*/ 66 h 80"/>
                <a:gd name="T10" fmla="*/ 252 w 1300"/>
                <a:gd name="T11" fmla="*/ 66 h 80"/>
                <a:gd name="T12" fmla="*/ 266 w 1300"/>
                <a:gd name="T13" fmla="*/ 66 h 80"/>
                <a:gd name="T14" fmla="*/ 280 w 1300"/>
                <a:gd name="T15" fmla="*/ 66 h 80"/>
                <a:gd name="T16" fmla="*/ 288 w 1300"/>
                <a:gd name="T17" fmla="*/ 50 h 80"/>
                <a:gd name="T18" fmla="*/ 315 w 1300"/>
                <a:gd name="T19" fmla="*/ 50 h 80"/>
                <a:gd name="T20" fmla="*/ 342 w 1300"/>
                <a:gd name="T21" fmla="*/ 50 h 80"/>
                <a:gd name="T22" fmla="*/ 353 w 1300"/>
                <a:gd name="T23" fmla="*/ 50 h 80"/>
                <a:gd name="T24" fmla="*/ 373 w 1300"/>
                <a:gd name="T25" fmla="*/ 50 h 80"/>
                <a:gd name="T26" fmla="*/ 386 w 1300"/>
                <a:gd name="T27" fmla="*/ 50 h 80"/>
                <a:gd name="T28" fmla="*/ 425 w 1300"/>
                <a:gd name="T29" fmla="*/ 50 h 80"/>
                <a:gd name="T30" fmla="*/ 434 w 1300"/>
                <a:gd name="T31" fmla="*/ 31 h 80"/>
                <a:gd name="T32" fmla="*/ 464 w 1300"/>
                <a:gd name="T33" fmla="*/ 31 h 80"/>
                <a:gd name="T34" fmla="*/ 484 w 1300"/>
                <a:gd name="T35" fmla="*/ 31 h 80"/>
                <a:gd name="T36" fmla="*/ 510 w 1300"/>
                <a:gd name="T37" fmla="*/ 31 h 80"/>
                <a:gd name="T38" fmla="*/ 546 w 1300"/>
                <a:gd name="T39" fmla="*/ 31 h 80"/>
                <a:gd name="T40" fmla="*/ 563 w 1300"/>
                <a:gd name="T41" fmla="*/ 31 h 80"/>
                <a:gd name="T42" fmla="*/ 584 w 1300"/>
                <a:gd name="T43" fmla="*/ 31 h 80"/>
                <a:gd name="T44" fmla="*/ 595 w 1300"/>
                <a:gd name="T45" fmla="*/ 31 h 80"/>
                <a:gd name="T46" fmla="*/ 611 w 1300"/>
                <a:gd name="T47" fmla="*/ 31 h 80"/>
                <a:gd name="T48" fmla="*/ 625 w 1300"/>
                <a:gd name="T49" fmla="*/ 31 h 80"/>
                <a:gd name="T50" fmla="*/ 649 w 1300"/>
                <a:gd name="T51" fmla="*/ 31 h 80"/>
                <a:gd name="T52" fmla="*/ 668 w 1300"/>
                <a:gd name="T53" fmla="*/ 31 h 80"/>
                <a:gd name="T54" fmla="*/ 698 w 1300"/>
                <a:gd name="T55" fmla="*/ 31 h 80"/>
                <a:gd name="T56" fmla="*/ 709 w 1300"/>
                <a:gd name="T57" fmla="*/ 31 h 80"/>
                <a:gd name="T58" fmla="*/ 730 w 1300"/>
                <a:gd name="T59" fmla="*/ 0 h 80"/>
                <a:gd name="T60" fmla="*/ 737 w 1300"/>
                <a:gd name="T61" fmla="*/ 0 h 80"/>
                <a:gd name="T62" fmla="*/ 760 w 1300"/>
                <a:gd name="T63" fmla="*/ 0 h 80"/>
                <a:gd name="T64" fmla="*/ 771 w 1300"/>
                <a:gd name="T65" fmla="*/ 0 h 80"/>
                <a:gd name="T66" fmla="*/ 790 w 1300"/>
                <a:gd name="T67" fmla="*/ 0 h 80"/>
                <a:gd name="T68" fmla="*/ 801 w 1300"/>
                <a:gd name="T69" fmla="*/ 0 h 80"/>
                <a:gd name="T70" fmla="*/ 818 w 1300"/>
                <a:gd name="T71" fmla="*/ 0 h 80"/>
                <a:gd name="T72" fmla="*/ 847 w 1300"/>
                <a:gd name="T73" fmla="*/ 0 h 80"/>
                <a:gd name="T74" fmla="*/ 860 w 1300"/>
                <a:gd name="T75" fmla="*/ 0 h 80"/>
                <a:gd name="T76" fmla="*/ 879 w 1300"/>
                <a:gd name="T77" fmla="*/ 0 h 80"/>
                <a:gd name="T78" fmla="*/ 892 w 1300"/>
                <a:gd name="T79" fmla="*/ 0 h 80"/>
                <a:gd name="T80" fmla="*/ 907 w 1300"/>
                <a:gd name="T81" fmla="*/ 0 h 80"/>
                <a:gd name="T82" fmla="*/ 925 w 1300"/>
                <a:gd name="T83" fmla="*/ 0 h 80"/>
                <a:gd name="T84" fmla="*/ 945 w 1300"/>
                <a:gd name="T85" fmla="*/ 0 h 80"/>
                <a:gd name="T86" fmla="*/ 1002 w 1300"/>
                <a:gd name="T87" fmla="*/ 0 h 80"/>
                <a:gd name="T88" fmla="*/ 1029 w 1300"/>
                <a:gd name="T89" fmla="*/ 0 h 80"/>
                <a:gd name="T90" fmla="*/ 1058 w 1300"/>
                <a:gd name="T91" fmla="*/ 0 h 80"/>
                <a:gd name="T92" fmla="*/ 1121 w 1300"/>
                <a:gd name="T93" fmla="*/ 0 h 80"/>
                <a:gd name="T94" fmla="*/ 1156 w 1300"/>
                <a:gd name="T95" fmla="*/ 0 h 80"/>
                <a:gd name="T96" fmla="*/ 1177 w 1300"/>
                <a:gd name="T97" fmla="*/ 0 h 80"/>
                <a:gd name="T98" fmla="*/ 1247 w 1300"/>
                <a:gd name="T99" fmla="*/ 0 h 80"/>
                <a:gd name="T100" fmla="*/ 1287 w 1300"/>
                <a:gd name="T101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300" h="80">
                  <a:moveTo>
                    <a:pt x="0" y="80"/>
                  </a:moveTo>
                  <a:lnTo>
                    <a:pt x="85" y="80"/>
                  </a:lnTo>
                  <a:lnTo>
                    <a:pt x="85" y="66"/>
                  </a:lnTo>
                  <a:lnTo>
                    <a:pt x="101" y="66"/>
                  </a:lnTo>
                  <a:lnTo>
                    <a:pt x="106" y="66"/>
                  </a:lnTo>
                  <a:lnTo>
                    <a:pt x="157" y="66"/>
                  </a:lnTo>
                  <a:lnTo>
                    <a:pt x="176" y="66"/>
                  </a:lnTo>
                  <a:lnTo>
                    <a:pt x="189" y="66"/>
                  </a:lnTo>
                  <a:lnTo>
                    <a:pt x="212" y="66"/>
                  </a:lnTo>
                  <a:lnTo>
                    <a:pt x="216" y="66"/>
                  </a:lnTo>
                  <a:lnTo>
                    <a:pt x="241" y="66"/>
                  </a:lnTo>
                  <a:lnTo>
                    <a:pt x="252" y="66"/>
                  </a:lnTo>
                  <a:lnTo>
                    <a:pt x="259" y="66"/>
                  </a:lnTo>
                  <a:lnTo>
                    <a:pt x="266" y="66"/>
                  </a:lnTo>
                  <a:lnTo>
                    <a:pt x="276" y="66"/>
                  </a:lnTo>
                  <a:lnTo>
                    <a:pt x="280" y="66"/>
                  </a:lnTo>
                  <a:lnTo>
                    <a:pt x="288" y="66"/>
                  </a:lnTo>
                  <a:lnTo>
                    <a:pt x="288" y="50"/>
                  </a:lnTo>
                  <a:lnTo>
                    <a:pt x="302" y="50"/>
                  </a:lnTo>
                  <a:lnTo>
                    <a:pt x="315" y="50"/>
                  </a:lnTo>
                  <a:lnTo>
                    <a:pt x="322" y="50"/>
                  </a:lnTo>
                  <a:lnTo>
                    <a:pt x="342" y="50"/>
                  </a:lnTo>
                  <a:lnTo>
                    <a:pt x="352" y="50"/>
                  </a:lnTo>
                  <a:lnTo>
                    <a:pt x="353" y="50"/>
                  </a:lnTo>
                  <a:lnTo>
                    <a:pt x="369" y="50"/>
                  </a:lnTo>
                  <a:lnTo>
                    <a:pt x="373" y="50"/>
                  </a:lnTo>
                  <a:lnTo>
                    <a:pt x="380" y="50"/>
                  </a:lnTo>
                  <a:lnTo>
                    <a:pt x="386" y="50"/>
                  </a:lnTo>
                  <a:lnTo>
                    <a:pt x="412" y="50"/>
                  </a:lnTo>
                  <a:lnTo>
                    <a:pt x="425" y="50"/>
                  </a:lnTo>
                  <a:lnTo>
                    <a:pt x="434" y="50"/>
                  </a:lnTo>
                  <a:lnTo>
                    <a:pt x="434" y="31"/>
                  </a:lnTo>
                  <a:lnTo>
                    <a:pt x="455" y="31"/>
                  </a:lnTo>
                  <a:lnTo>
                    <a:pt x="464" y="31"/>
                  </a:lnTo>
                  <a:lnTo>
                    <a:pt x="484" y="31"/>
                  </a:lnTo>
                  <a:lnTo>
                    <a:pt x="484" y="31"/>
                  </a:lnTo>
                  <a:lnTo>
                    <a:pt x="495" y="31"/>
                  </a:lnTo>
                  <a:lnTo>
                    <a:pt x="510" y="31"/>
                  </a:lnTo>
                  <a:lnTo>
                    <a:pt x="543" y="31"/>
                  </a:lnTo>
                  <a:lnTo>
                    <a:pt x="546" y="31"/>
                  </a:lnTo>
                  <a:lnTo>
                    <a:pt x="558" y="31"/>
                  </a:lnTo>
                  <a:lnTo>
                    <a:pt x="563" y="31"/>
                  </a:lnTo>
                  <a:lnTo>
                    <a:pt x="570" y="31"/>
                  </a:lnTo>
                  <a:lnTo>
                    <a:pt x="584" y="31"/>
                  </a:lnTo>
                  <a:lnTo>
                    <a:pt x="587" y="31"/>
                  </a:lnTo>
                  <a:lnTo>
                    <a:pt x="595" y="31"/>
                  </a:lnTo>
                  <a:lnTo>
                    <a:pt x="599" y="31"/>
                  </a:lnTo>
                  <a:lnTo>
                    <a:pt x="611" y="31"/>
                  </a:lnTo>
                  <a:lnTo>
                    <a:pt x="618" y="31"/>
                  </a:lnTo>
                  <a:lnTo>
                    <a:pt x="625" y="31"/>
                  </a:lnTo>
                  <a:lnTo>
                    <a:pt x="632" y="31"/>
                  </a:lnTo>
                  <a:lnTo>
                    <a:pt x="649" y="31"/>
                  </a:lnTo>
                  <a:lnTo>
                    <a:pt x="654" y="31"/>
                  </a:lnTo>
                  <a:lnTo>
                    <a:pt x="668" y="31"/>
                  </a:lnTo>
                  <a:lnTo>
                    <a:pt x="688" y="31"/>
                  </a:lnTo>
                  <a:lnTo>
                    <a:pt x="698" y="31"/>
                  </a:lnTo>
                  <a:lnTo>
                    <a:pt x="707" y="31"/>
                  </a:lnTo>
                  <a:lnTo>
                    <a:pt x="709" y="31"/>
                  </a:lnTo>
                  <a:lnTo>
                    <a:pt x="730" y="31"/>
                  </a:lnTo>
                  <a:lnTo>
                    <a:pt x="730" y="0"/>
                  </a:lnTo>
                  <a:lnTo>
                    <a:pt x="734" y="0"/>
                  </a:lnTo>
                  <a:lnTo>
                    <a:pt x="737" y="0"/>
                  </a:lnTo>
                  <a:lnTo>
                    <a:pt x="745" y="0"/>
                  </a:lnTo>
                  <a:lnTo>
                    <a:pt x="760" y="0"/>
                  </a:lnTo>
                  <a:lnTo>
                    <a:pt x="764" y="0"/>
                  </a:lnTo>
                  <a:lnTo>
                    <a:pt x="771" y="0"/>
                  </a:lnTo>
                  <a:lnTo>
                    <a:pt x="781" y="0"/>
                  </a:lnTo>
                  <a:lnTo>
                    <a:pt x="790" y="0"/>
                  </a:lnTo>
                  <a:lnTo>
                    <a:pt x="793" y="0"/>
                  </a:lnTo>
                  <a:lnTo>
                    <a:pt x="801" y="0"/>
                  </a:lnTo>
                  <a:lnTo>
                    <a:pt x="809" y="0"/>
                  </a:lnTo>
                  <a:lnTo>
                    <a:pt x="818" y="0"/>
                  </a:lnTo>
                  <a:lnTo>
                    <a:pt x="822" y="0"/>
                  </a:lnTo>
                  <a:lnTo>
                    <a:pt x="847" y="0"/>
                  </a:lnTo>
                  <a:lnTo>
                    <a:pt x="854" y="0"/>
                  </a:lnTo>
                  <a:lnTo>
                    <a:pt x="860" y="0"/>
                  </a:lnTo>
                  <a:lnTo>
                    <a:pt x="868" y="0"/>
                  </a:lnTo>
                  <a:lnTo>
                    <a:pt x="879" y="0"/>
                  </a:lnTo>
                  <a:lnTo>
                    <a:pt x="885" y="0"/>
                  </a:lnTo>
                  <a:lnTo>
                    <a:pt x="892" y="0"/>
                  </a:lnTo>
                  <a:lnTo>
                    <a:pt x="900" y="0"/>
                  </a:lnTo>
                  <a:lnTo>
                    <a:pt x="907" y="0"/>
                  </a:lnTo>
                  <a:lnTo>
                    <a:pt x="918" y="0"/>
                  </a:lnTo>
                  <a:lnTo>
                    <a:pt x="925" y="0"/>
                  </a:lnTo>
                  <a:lnTo>
                    <a:pt x="937" y="0"/>
                  </a:lnTo>
                  <a:lnTo>
                    <a:pt x="945" y="0"/>
                  </a:lnTo>
                  <a:lnTo>
                    <a:pt x="986" y="0"/>
                  </a:lnTo>
                  <a:lnTo>
                    <a:pt x="1002" y="0"/>
                  </a:lnTo>
                  <a:lnTo>
                    <a:pt x="1003" y="0"/>
                  </a:lnTo>
                  <a:lnTo>
                    <a:pt x="1029" y="0"/>
                  </a:lnTo>
                  <a:lnTo>
                    <a:pt x="1035" y="0"/>
                  </a:lnTo>
                  <a:lnTo>
                    <a:pt x="1058" y="0"/>
                  </a:lnTo>
                  <a:lnTo>
                    <a:pt x="1078" y="0"/>
                  </a:lnTo>
                  <a:lnTo>
                    <a:pt x="1121" y="0"/>
                  </a:lnTo>
                  <a:lnTo>
                    <a:pt x="1150" y="0"/>
                  </a:lnTo>
                  <a:lnTo>
                    <a:pt x="1156" y="0"/>
                  </a:lnTo>
                  <a:lnTo>
                    <a:pt x="1161" y="0"/>
                  </a:lnTo>
                  <a:lnTo>
                    <a:pt x="1177" y="0"/>
                  </a:lnTo>
                  <a:lnTo>
                    <a:pt x="1230" y="0"/>
                  </a:lnTo>
                  <a:lnTo>
                    <a:pt x="1247" y="0"/>
                  </a:lnTo>
                  <a:lnTo>
                    <a:pt x="1281" y="0"/>
                  </a:lnTo>
                  <a:lnTo>
                    <a:pt x="1287" y="0"/>
                  </a:lnTo>
                  <a:lnTo>
                    <a:pt x="1300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6A89FCA6-CC48-43BC-913D-2658F19D9DA4}"/>
              </a:ext>
            </a:extLst>
          </p:cNvPr>
          <p:cNvGrpSpPr/>
          <p:nvPr/>
        </p:nvGrpSpPr>
        <p:grpSpPr>
          <a:xfrm>
            <a:off x="1200815" y="3651120"/>
            <a:ext cx="4141083" cy="2791354"/>
            <a:chOff x="1491095" y="3926886"/>
            <a:chExt cx="4141083" cy="2791354"/>
          </a:xfrm>
        </p:grpSpPr>
        <p:grpSp>
          <p:nvGrpSpPr>
            <p:cNvPr id="237" name="グループ化 236">
              <a:extLst>
                <a:ext uri="{FF2B5EF4-FFF2-40B4-BE49-F238E27FC236}">
                  <a16:creationId xmlns:a16="http://schemas.microsoft.com/office/drawing/2014/main" id="{A5CFDFD5-C528-AF0C-CA84-2A9A0B7A4D43}"/>
                </a:ext>
              </a:extLst>
            </p:cNvPr>
            <p:cNvGrpSpPr/>
            <p:nvPr/>
          </p:nvGrpSpPr>
          <p:grpSpPr>
            <a:xfrm>
              <a:off x="1491095" y="3926886"/>
              <a:ext cx="4141083" cy="2791354"/>
              <a:chOff x="1491095" y="3926886"/>
              <a:chExt cx="4141083" cy="2791354"/>
            </a:xfrm>
          </p:grpSpPr>
          <p:sp>
            <p:nvSpPr>
              <p:cNvPr id="146" name="Rectangle 22">
                <a:extLst>
                  <a:ext uri="{FF2B5EF4-FFF2-40B4-BE49-F238E27FC236}">
                    <a16:creationId xmlns:a16="http://schemas.microsoft.com/office/drawing/2014/main" id="{F8387F59-90E3-22D9-674A-D80F2E727A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1019" y="3933407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7" name="Line 23">
                <a:extLst>
                  <a:ext uri="{FF2B5EF4-FFF2-40B4-BE49-F238E27FC236}">
                    <a16:creationId xmlns:a16="http://schemas.microsoft.com/office/drawing/2014/main" id="{8F660B38-C356-0E43-ACAD-E5710A6826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5352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8" name="Line 25">
                <a:extLst>
                  <a:ext uri="{FF2B5EF4-FFF2-40B4-BE49-F238E27FC236}">
                    <a16:creationId xmlns:a16="http://schemas.microsoft.com/office/drawing/2014/main" id="{08BE6380-FE7D-4B4F-8EB1-57E96EAA23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8569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9" name="Line 27">
                <a:extLst>
                  <a:ext uri="{FF2B5EF4-FFF2-40B4-BE49-F238E27FC236}">
                    <a16:creationId xmlns:a16="http://schemas.microsoft.com/office/drawing/2014/main" id="{EC850244-69CD-121D-49E3-66B3147B78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91785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0" name="Line 29">
                <a:extLst>
                  <a:ext uri="{FF2B5EF4-FFF2-40B4-BE49-F238E27FC236}">
                    <a16:creationId xmlns:a16="http://schemas.microsoft.com/office/drawing/2014/main" id="{513501E1-7AAC-5D2D-1273-CD6285DE9A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3113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1" name="Line 31">
                <a:extLst>
                  <a:ext uri="{FF2B5EF4-FFF2-40B4-BE49-F238E27FC236}">
                    <a16:creationId xmlns:a16="http://schemas.microsoft.com/office/drawing/2014/main" id="{74967617-1923-FAAD-400B-22B1D5F55E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6330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2" name="Line 33">
                <a:extLst>
                  <a:ext uri="{FF2B5EF4-FFF2-40B4-BE49-F238E27FC236}">
                    <a16:creationId xmlns:a16="http://schemas.microsoft.com/office/drawing/2014/main" id="{944DBB85-1797-64C7-3FF2-B8BB70E024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9546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3" name="Line 35">
                <a:extLst>
                  <a:ext uri="{FF2B5EF4-FFF2-40B4-BE49-F238E27FC236}">
                    <a16:creationId xmlns:a16="http://schemas.microsoft.com/office/drawing/2014/main" id="{D814AC7B-CFED-FCF6-8BFB-D5EE63E99B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2763" y="5949570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4" name="Line 6">
                <a:extLst>
                  <a:ext uri="{FF2B5EF4-FFF2-40B4-BE49-F238E27FC236}">
                    <a16:creationId xmlns:a16="http://schemas.microsoft.com/office/drawing/2014/main" id="{A0EC68A3-26BA-8B73-C15D-EF6FC49B87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5947184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5" name="Line 8">
                <a:extLst>
                  <a:ext uri="{FF2B5EF4-FFF2-40B4-BE49-F238E27FC236}">
                    <a16:creationId xmlns:a16="http://schemas.microsoft.com/office/drawing/2014/main" id="{EC0280D7-6ADD-CC2F-0B88-95FCB815BA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5539688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6" name="Line 9">
                <a:extLst>
                  <a:ext uri="{FF2B5EF4-FFF2-40B4-BE49-F238E27FC236}">
                    <a16:creationId xmlns:a16="http://schemas.microsoft.com/office/drawing/2014/main" id="{EA69896F-F9D9-B7F2-952E-08C47FC8D4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5132193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7" name="Line 11">
                <a:extLst>
                  <a:ext uri="{FF2B5EF4-FFF2-40B4-BE49-F238E27FC236}">
                    <a16:creationId xmlns:a16="http://schemas.microsoft.com/office/drawing/2014/main" id="{18DB1E96-AD4A-AA1B-5C2D-8B2E9995B3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4724698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8" name="Line 12">
                <a:extLst>
                  <a:ext uri="{FF2B5EF4-FFF2-40B4-BE49-F238E27FC236}">
                    <a16:creationId xmlns:a16="http://schemas.microsoft.com/office/drawing/2014/main" id="{595A27A6-6837-3E16-AA5C-C8FE7B83C1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79360" y="4317203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59" name="Line 14">
                <a:extLst>
                  <a:ext uri="{FF2B5EF4-FFF2-40B4-BE49-F238E27FC236}">
                    <a16:creationId xmlns:a16="http://schemas.microsoft.com/office/drawing/2014/main" id="{963DD90A-75CE-BA4F-F5C5-30306D3F11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13199" y="3933615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0" name="Line 23">
                <a:extLst>
                  <a:ext uri="{FF2B5EF4-FFF2-40B4-BE49-F238E27FC236}">
                    <a16:creationId xmlns:a16="http://schemas.microsoft.com/office/drawing/2014/main" id="{D2884F5F-5470-9CDD-6395-B0632887CF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7040" y="5947185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61" name="図形グループ 54">
                <a:extLst>
                  <a:ext uri="{FF2B5EF4-FFF2-40B4-BE49-F238E27FC236}">
                    <a16:creationId xmlns:a16="http://schemas.microsoft.com/office/drawing/2014/main" id="{DAA5A7E8-DC08-D2CC-A68E-8D50A0E23A42}"/>
                  </a:ext>
                </a:extLst>
              </p:cNvPr>
              <p:cNvGrpSpPr/>
              <p:nvPr/>
            </p:nvGrpSpPr>
            <p:grpSpPr>
              <a:xfrm>
                <a:off x="2037434" y="4188108"/>
                <a:ext cx="220989" cy="1868530"/>
                <a:chOff x="510218" y="1348283"/>
                <a:chExt cx="220989" cy="1868530"/>
              </a:xfrm>
            </p:grpSpPr>
            <p:sp>
              <p:nvSpPr>
                <p:cNvPr id="168" name="Rectangle 10">
                  <a:extLst>
                    <a:ext uri="{FF2B5EF4-FFF2-40B4-BE49-F238E27FC236}">
                      <a16:creationId xmlns:a16="http://schemas.microsoft.com/office/drawing/2014/main" id="{04B18B89-EB45-41FA-6767-D505B5AF25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69" name="Rectangle 13">
                  <a:extLst>
                    <a:ext uri="{FF2B5EF4-FFF2-40B4-BE49-F238E27FC236}">
                      <a16:creationId xmlns:a16="http://schemas.microsoft.com/office/drawing/2014/main" id="{A123525F-AA4E-9481-9187-4BCC019F95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70" name="Rectangle 10">
                  <a:extLst>
                    <a:ext uri="{FF2B5EF4-FFF2-40B4-BE49-F238E27FC236}">
                      <a16:creationId xmlns:a16="http://schemas.microsoft.com/office/drawing/2014/main" id="{B2216C31-71B4-61E1-EF34-40BD89A7E6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62" name="テキスト ボックス 161">
                <a:extLst>
                  <a:ext uri="{FF2B5EF4-FFF2-40B4-BE49-F238E27FC236}">
                    <a16:creationId xmlns:a16="http://schemas.microsoft.com/office/drawing/2014/main" id="{B0D4AA5E-BA4F-16E2-61DB-F9BADD33EDEC}"/>
                  </a:ext>
                </a:extLst>
              </p:cNvPr>
              <p:cNvSpPr txBox="1"/>
              <p:nvPr/>
            </p:nvSpPr>
            <p:spPr>
              <a:xfrm>
                <a:off x="2209901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E3220612-EDD0-EC5B-9A9E-5FC0E2FC4188}"/>
                  </a:ext>
                </a:extLst>
              </p:cNvPr>
              <p:cNvSpPr txBox="1"/>
              <p:nvPr/>
            </p:nvSpPr>
            <p:spPr>
              <a:xfrm>
                <a:off x="3254440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98C8FEAE-35D1-4824-B758-2DA60F197585}"/>
                  </a:ext>
                </a:extLst>
              </p:cNvPr>
              <p:cNvSpPr txBox="1"/>
              <p:nvPr/>
            </p:nvSpPr>
            <p:spPr>
              <a:xfrm>
                <a:off x="5343517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2F3EFF37-BFF0-6777-C6AC-42218627E01D}"/>
                  </a:ext>
                </a:extLst>
              </p:cNvPr>
              <p:cNvSpPr txBox="1"/>
              <p:nvPr/>
            </p:nvSpPr>
            <p:spPr>
              <a:xfrm>
                <a:off x="4298979" y="6087121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DFA09BA2-D80D-23ED-B13B-544DC9FA8CC4}"/>
                  </a:ext>
                </a:extLst>
              </p:cNvPr>
              <p:cNvSpPr txBox="1"/>
              <p:nvPr/>
            </p:nvSpPr>
            <p:spPr>
              <a:xfrm rot="16200000">
                <a:off x="608000" y="4809981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D2558AD1-564A-220A-57ED-8CA740F1401E}"/>
                  </a:ext>
                </a:extLst>
              </p:cNvPr>
              <p:cNvSpPr txBox="1"/>
              <p:nvPr/>
            </p:nvSpPr>
            <p:spPr>
              <a:xfrm>
                <a:off x="3112207" y="6348908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8" name="Freeform 101">
              <a:extLst>
                <a:ext uri="{FF2B5EF4-FFF2-40B4-BE49-F238E27FC236}">
                  <a16:creationId xmlns:a16="http://schemas.microsoft.com/office/drawing/2014/main" id="{7050B67D-498B-D2D5-C946-0F13E41ABAF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6888" y="4915487"/>
              <a:ext cx="2619193" cy="1026384"/>
            </a:xfrm>
            <a:custGeom>
              <a:avLst/>
              <a:gdLst>
                <a:gd name="T0" fmla="*/ 92 w 1390"/>
                <a:gd name="T1" fmla="*/ 549 h 556"/>
                <a:gd name="T2" fmla="*/ 116 w 1390"/>
                <a:gd name="T3" fmla="*/ 535 h 556"/>
                <a:gd name="T4" fmla="*/ 126 w 1390"/>
                <a:gd name="T5" fmla="*/ 522 h 556"/>
                <a:gd name="T6" fmla="*/ 138 w 1390"/>
                <a:gd name="T7" fmla="*/ 501 h 556"/>
                <a:gd name="T8" fmla="*/ 150 w 1390"/>
                <a:gd name="T9" fmla="*/ 488 h 556"/>
                <a:gd name="T10" fmla="*/ 164 w 1390"/>
                <a:gd name="T11" fmla="*/ 467 h 556"/>
                <a:gd name="T12" fmla="*/ 177 w 1390"/>
                <a:gd name="T13" fmla="*/ 439 h 556"/>
                <a:gd name="T14" fmla="*/ 184 w 1390"/>
                <a:gd name="T15" fmla="*/ 425 h 556"/>
                <a:gd name="T16" fmla="*/ 199 w 1390"/>
                <a:gd name="T17" fmla="*/ 411 h 556"/>
                <a:gd name="T18" fmla="*/ 212 w 1390"/>
                <a:gd name="T19" fmla="*/ 398 h 556"/>
                <a:gd name="T20" fmla="*/ 229 w 1390"/>
                <a:gd name="T21" fmla="*/ 390 h 556"/>
                <a:gd name="T22" fmla="*/ 241 w 1390"/>
                <a:gd name="T23" fmla="*/ 376 h 556"/>
                <a:gd name="T24" fmla="*/ 252 w 1390"/>
                <a:gd name="T25" fmla="*/ 361 h 556"/>
                <a:gd name="T26" fmla="*/ 269 w 1390"/>
                <a:gd name="T27" fmla="*/ 353 h 556"/>
                <a:gd name="T28" fmla="*/ 293 w 1390"/>
                <a:gd name="T29" fmla="*/ 346 h 556"/>
                <a:gd name="T30" fmla="*/ 316 w 1390"/>
                <a:gd name="T31" fmla="*/ 338 h 556"/>
                <a:gd name="T32" fmla="*/ 331 w 1390"/>
                <a:gd name="T33" fmla="*/ 323 h 556"/>
                <a:gd name="T34" fmla="*/ 339 w 1390"/>
                <a:gd name="T35" fmla="*/ 300 h 556"/>
                <a:gd name="T36" fmla="*/ 358 w 1390"/>
                <a:gd name="T37" fmla="*/ 292 h 556"/>
                <a:gd name="T38" fmla="*/ 383 w 1390"/>
                <a:gd name="T39" fmla="*/ 292 h 556"/>
                <a:gd name="T40" fmla="*/ 408 w 1390"/>
                <a:gd name="T41" fmla="*/ 292 h 556"/>
                <a:gd name="T42" fmla="*/ 420 w 1390"/>
                <a:gd name="T43" fmla="*/ 274 h 556"/>
                <a:gd name="T44" fmla="*/ 437 w 1390"/>
                <a:gd name="T45" fmla="*/ 256 h 556"/>
                <a:gd name="T46" fmla="*/ 451 w 1390"/>
                <a:gd name="T47" fmla="*/ 229 h 556"/>
                <a:gd name="T48" fmla="*/ 461 w 1390"/>
                <a:gd name="T49" fmla="*/ 210 h 556"/>
                <a:gd name="T50" fmla="*/ 490 w 1390"/>
                <a:gd name="T51" fmla="*/ 201 h 556"/>
                <a:gd name="T52" fmla="*/ 511 w 1390"/>
                <a:gd name="T53" fmla="*/ 191 h 556"/>
                <a:gd name="T54" fmla="*/ 541 w 1390"/>
                <a:gd name="T55" fmla="*/ 191 h 556"/>
                <a:gd name="T56" fmla="*/ 570 w 1390"/>
                <a:gd name="T57" fmla="*/ 191 h 556"/>
                <a:gd name="T58" fmla="*/ 585 w 1390"/>
                <a:gd name="T59" fmla="*/ 169 h 556"/>
                <a:gd name="T60" fmla="*/ 603 w 1390"/>
                <a:gd name="T61" fmla="*/ 158 h 556"/>
                <a:gd name="T62" fmla="*/ 618 w 1390"/>
                <a:gd name="T63" fmla="*/ 146 h 556"/>
                <a:gd name="T64" fmla="*/ 635 w 1390"/>
                <a:gd name="T65" fmla="*/ 133 h 556"/>
                <a:gd name="T66" fmla="*/ 653 w 1390"/>
                <a:gd name="T67" fmla="*/ 108 h 556"/>
                <a:gd name="T68" fmla="*/ 678 w 1390"/>
                <a:gd name="T69" fmla="*/ 108 h 556"/>
                <a:gd name="T70" fmla="*/ 697 w 1390"/>
                <a:gd name="T71" fmla="*/ 93 h 556"/>
                <a:gd name="T72" fmla="*/ 715 w 1390"/>
                <a:gd name="T73" fmla="*/ 77 h 556"/>
                <a:gd name="T74" fmla="*/ 731 w 1390"/>
                <a:gd name="T75" fmla="*/ 60 h 556"/>
                <a:gd name="T76" fmla="*/ 755 w 1390"/>
                <a:gd name="T77" fmla="*/ 41 h 556"/>
                <a:gd name="T78" fmla="*/ 771 w 1390"/>
                <a:gd name="T79" fmla="*/ 21 h 556"/>
                <a:gd name="T80" fmla="*/ 788 w 1390"/>
                <a:gd name="T81" fmla="*/ 0 h 556"/>
                <a:gd name="T82" fmla="*/ 835 w 1390"/>
                <a:gd name="T83" fmla="*/ 0 h 556"/>
                <a:gd name="T84" fmla="*/ 872 w 1390"/>
                <a:gd name="T85" fmla="*/ 0 h 556"/>
                <a:gd name="T86" fmla="*/ 910 w 1390"/>
                <a:gd name="T87" fmla="*/ 0 h 556"/>
                <a:gd name="T88" fmla="*/ 934 w 1390"/>
                <a:gd name="T89" fmla="*/ 0 h 556"/>
                <a:gd name="T90" fmla="*/ 962 w 1390"/>
                <a:gd name="T91" fmla="*/ 0 h 556"/>
                <a:gd name="T92" fmla="*/ 991 w 1390"/>
                <a:gd name="T93" fmla="*/ 0 h 556"/>
                <a:gd name="T94" fmla="*/ 1035 w 1390"/>
                <a:gd name="T95" fmla="*/ 0 h 556"/>
                <a:gd name="T96" fmla="*/ 1082 w 1390"/>
                <a:gd name="T97" fmla="*/ 0 h 556"/>
                <a:gd name="T98" fmla="*/ 1128 w 1390"/>
                <a:gd name="T99" fmla="*/ 0 h 556"/>
                <a:gd name="T100" fmla="*/ 1161 w 1390"/>
                <a:gd name="T101" fmla="*/ 0 h 556"/>
                <a:gd name="T102" fmla="*/ 1281 w 1390"/>
                <a:gd name="T103" fmla="*/ 0 h 5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1390" h="556">
                  <a:moveTo>
                    <a:pt x="0" y="556"/>
                  </a:moveTo>
                  <a:lnTo>
                    <a:pt x="85" y="556"/>
                  </a:lnTo>
                  <a:lnTo>
                    <a:pt x="85" y="549"/>
                  </a:lnTo>
                  <a:lnTo>
                    <a:pt x="92" y="549"/>
                  </a:lnTo>
                  <a:lnTo>
                    <a:pt x="110" y="549"/>
                  </a:lnTo>
                  <a:lnTo>
                    <a:pt x="110" y="542"/>
                  </a:lnTo>
                  <a:lnTo>
                    <a:pt x="116" y="542"/>
                  </a:lnTo>
                  <a:lnTo>
                    <a:pt x="116" y="535"/>
                  </a:lnTo>
                  <a:lnTo>
                    <a:pt x="117" y="529"/>
                  </a:lnTo>
                  <a:lnTo>
                    <a:pt x="121" y="529"/>
                  </a:lnTo>
                  <a:lnTo>
                    <a:pt x="121" y="522"/>
                  </a:lnTo>
                  <a:lnTo>
                    <a:pt x="126" y="522"/>
                  </a:lnTo>
                  <a:lnTo>
                    <a:pt x="126" y="515"/>
                  </a:lnTo>
                  <a:lnTo>
                    <a:pt x="129" y="508"/>
                  </a:lnTo>
                  <a:lnTo>
                    <a:pt x="137" y="508"/>
                  </a:lnTo>
                  <a:lnTo>
                    <a:pt x="138" y="501"/>
                  </a:lnTo>
                  <a:lnTo>
                    <a:pt x="147" y="501"/>
                  </a:lnTo>
                  <a:lnTo>
                    <a:pt x="147" y="494"/>
                  </a:lnTo>
                  <a:lnTo>
                    <a:pt x="150" y="494"/>
                  </a:lnTo>
                  <a:lnTo>
                    <a:pt x="150" y="488"/>
                  </a:lnTo>
                  <a:lnTo>
                    <a:pt x="153" y="480"/>
                  </a:lnTo>
                  <a:lnTo>
                    <a:pt x="160" y="480"/>
                  </a:lnTo>
                  <a:lnTo>
                    <a:pt x="162" y="474"/>
                  </a:lnTo>
                  <a:lnTo>
                    <a:pt x="164" y="467"/>
                  </a:lnTo>
                  <a:lnTo>
                    <a:pt x="165" y="460"/>
                  </a:lnTo>
                  <a:lnTo>
                    <a:pt x="172" y="460"/>
                  </a:lnTo>
                  <a:lnTo>
                    <a:pt x="172" y="446"/>
                  </a:lnTo>
                  <a:lnTo>
                    <a:pt x="177" y="439"/>
                  </a:lnTo>
                  <a:lnTo>
                    <a:pt x="182" y="439"/>
                  </a:lnTo>
                  <a:lnTo>
                    <a:pt x="182" y="432"/>
                  </a:lnTo>
                  <a:lnTo>
                    <a:pt x="183" y="425"/>
                  </a:lnTo>
                  <a:lnTo>
                    <a:pt x="184" y="425"/>
                  </a:lnTo>
                  <a:lnTo>
                    <a:pt x="190" y="425"/>
                  </a:lnTo>
                  <a:lnTo>
                    <a:pt x="193" y="419"/>
                  </a:lnTo>
                  <a:lnTo>
                    <a:pt x="195" y="411"/>
                  </a:lnTo>
                  <a:lnTo>
                    <a:pt x="199" y="411"/>
                  </a:lnTo>
                  <a:lnTo>
                    <a:pt x="199" y="404"/>
                  </a:lnTo>
                  <a:lnTo>
                    <a:pt x="203" y="404"/>
                  </a:lnTo>
                  <a:lnTo>
                    <a:pt x="203" y="398"/>
                  </a:lnTo>
                  <a:lnTo>
                    <a:pt x="212" y="398"/>
                  </a:lnTo>
                  <a:lnTo>
                    <a:pt x="216" y="398"/>
                  </a:lnTo>
                  <a:lnTo>
                    <a:pt x="216" y="390"/>
                  </a:lnTo>
                  <a:lnTo>
                    <a:pt x="220" y="390"/>
                  </a:lnTo>
                  <a:lnTo>
                    <a:pt x="229" y="390"/>
                  </a:lnTo>
                  <a:lnTo>
                    <a:pt x="236" y="390"/>
                  </a:lnTo>
                  <a:lnTo>
                    <a:pt x="236" y="383"/>
                  </a:lnTo>
                  <a:lnTo>
                    <a:pt x="241" y="383"/>
                  </a:lnTo>
                  <a:lnTo>
                    <a:pt x="241" y="376"/>
                  </a:lnTo>
                  <a:lnTo>
                    <a:pt x="249" y="376"/>
                  </a:lnTo>
                  <a:lnTo>
                    <a:pt x="251" y="376"/>
                  </a:lnTo>
                  <a:lnTo>
                    <a:pt x="251" y="368"/>
                  </a:lnTo>
                  <a:lnTo>
                    <a:pt x="252" y="361"/>
                  </a:lnTo>
                  <a:lnTo>
                    <a:pt x="258" y="361"/>
                  </a:lnTo>
                  <a:lnTo>
                    <a:pt x="266" y="361"/>
                  </a:lnTo>
                  <a:lnTo>
                    <a:pt x="266" y="353"/>
                  </a:lnTo>
                  <a:lnTo>
                    <a:pt x="269" y="353"/>
                  </a:lnTo>
                  <a:lnTo>
                    <a:pt x="269" y="346"/>
                  </a:lnTo>
                  <a:lnTo>
                    <a:pt x="283" y="346"/>
                  </a:lnTo>
                  <a:lnTo>
                    <a:pt x="286" y="346"/>
                  </a:lnTo>
                  <a:lnTo>
                    <a:pt x="293" y="346"/>
                  </a:lnTo>
                  <a:lnTo>
                    <a:pt x="293" y="338"/>
                  </a:lnTo>
                  <a:lnTo>
                    <a:pt x="299" y="338"/>
                  </a:lnTo>
                  <a:lnTo>
                    <a:pt x="308" y="338"/>
                  </a:lnTo>
                  <a:lnTo>
                    <a:pt x="316" y="338"/>
                  </a:lnTo>
                  <a:lnTo>
                    <a:pt x="321" y="331"/>
                  </a:lnTo>
                  <a:lnTo>
                    <a:pt x="324" y="331"/>
                  </a:lnTo>
                  <a:lnTo>
                    <a:pt x="325" y="323"/>
                  </a:lnTo>
                  <a:lnTo>
                    <a:pt x="331" y="323"/>
                  </a:lnTo>
                  <a:lnTo>
                    <a:pt x="331" y="315"/>
                  </a:lnTo>
                  <a:lnTo>
                    <a:pt x="334" y="308"/>
                  </a:lnTo>
                  <a:lnTo>
                    <a:pt x="339" y="308"/>
                  </a:lnTo>
                  <a:lnTo>
                    <a:pt x="339" y="300"/>
                  </a:lnTo>
                  <a:lnTo>
                    <a:pt x="349" y="300"/>
                  </a:lnTo>
                  <a:lnTo>
                    <a:pt x="352" y="300"/>
                  </a:lnTo>
                  <a:lnTo>
                    <a:pt x="355" y="292"/>
                  </a:lnTo>
                  <a:lnTo>
                    <a:pt x="358" y="292"/>
                  </a:lnTo>
                  <a:lnTo>
                    <a:pt x="369" y="292"/>
                  </a:lnTo>
                  <a:lnTo>
                    <a:pt x="373" y="292"/>
                  </a:lnTo>
                  <a:lnTo>
                    <a:pt x="378" y="292"/>
                  </a:lnTo>
                  <a:lnTo>
                    <a:pt x="383" y="292"/>
                  </a:lnTo>
                  <a:lnTo>
                    <a:pt x="391" y="292"/>
                  </a:lnTo>
                  <a:lnTo>
                    <a:pt x="395" y="292"/>
                  </a:lnTo>
                  <a:lnTo>
                    <a:pt x="402" y="292"/>
                  </a:lnTo>
                  <a:lnTo>
                    <a:pt x="408" y="292"/>
                  </a:lnTo>
                  <a:lnTo>
                    <a:pt x="408" y="283"/>
                  </a:lnTo>
                  <a:lnTo>
                    <a:pt x="414" y="283"/>
                  </a:lnTo>
                  <a:lnTo>
                    <a:pt x="414" y="274"/>
                  </a:lnTo>
                  <a:lnTo>
                    <a:pt x="420" y="274"/>
                  </a:lnTo>
                  <a:lnTo>
                    <a:pt x="421" y="265"/>
                  </a:lnTo>
                  <a:lnTo>
                    <a:pt x="434" y="265"/>
                  </a:lnTo>
                  <a:lnTo>
                    <a:pt x="434" y="256"/>
                  </a:lnTo>
                  <a:lnTo>
                    <a:pt x="437" y="256"/>
                  </a:lnTo>
                  <a:lnTo>
                    <a:pt x="445" y="256"/>
                  </a:lnTo>
                  <a:lnTo>
                    <a:pt x="445" y="247"/>
                  </a:lnTo>
                  <a:lnTo>
                    <a:pt x="447" y="229"/>
                  </a:lnTo>
                  <a:lnTo>
                    <a:pt x="451" y="229"/>
                  </a:lnTo>
                  <a:lnTo>
                    <a:pt x="452" y="219"/>
                  </a:lnTo>
                  <a:lnTo>
                    <a:pt x="455" y="219"/>
                  </a:lnTo>
                  <a:lnTo>
                    <a:pt x="458" y="210"/>
                  </a:lnTo>
                  <a:lnTo>
                    <a:pt x="461" y="210"/>
                  </a:lnTo>
                  <a:lnTo>
                    <a:pt x="461" y="201"/>
                  </a:lnTo>
                  <a:lnTo>
                    <a:pt x="471" y="201"/>
                  </a:lnTo>
                  <a:lnTo>
                    <a:pt x="481" y="201"/>
                  </a:lnTo>
                  <a:lnTo>
                    <a:pt x="490" y="201"/>
                  </a:lnTo>
                  <a:lnTo>
                    <a:pt x="492" y="201"/>
                  </a:lnTo>
                  <a:lnTo>
                    <a:pt x="492" y="191"/>
                  </a:lnTo>
                  <a:lnTo>
                    <a:pt x="498" y="191"/>
                  </a:lnTo>
                  <a:lnTo>
                    <a:pt x="511" y="191"/>
                  </a:lnTo>
                  <a:lnTo>
                    <a:pt x="516" y="191"/>
                  </a:lnTo>
                  <a:lnTo>
                    <a:pt x="528" y="191"/>
                  </a:lnTo>
                  <a:lnTo>
                    <a:pt x="537" y="191"/>
                  </a:lnTo>
                  <a:lnTo>
                    <a:pt x="541" y="191"/>
                  </a:lnTo>
                  <a:lnTo>
                    <a:pt x="546" y="191"/>
                  </a:lnTo>
                  <a:lnTo>
                    <a:pt x="554" y="191"/>
                  </a:lnTo>
                  <a:lnTo>
                    <a:pt x="558" y="191"/>
                  </a:lnTo>
                  <a:lnTo>
                    <a:pt x="570" y="191"/>
                  </a:lnTo>
                  <a:lnTo>
                    <a:pt x="579" y="191"/>
                  </a:lnTo>
                  <a:lnTo>
                    <a:pt x="581" y="191"/>
                  </a:lnTo>
                  <a:lnTo>
                    <a:pt x="582" y="180"/>
                  </a:lnTo>
                  <a:lnTo>
                    <a:pt x="585" y="169"/>
                  </a:lnTo>
                  <a:lnTo>
                    <a:pt x="587" y="169"/>
                  </a:lnTo>
                  <a:lnTo>
                    <a:pt x="587" y="158"/>
                  </a:lnTo>
                  <a:lnTo>
                    <a:pt x="593" y="158"/>
                  </a:lnTo>
                  <a:lnTo>
                    <a:pt x="603" y="158"/>
                  </a:lnTo>
                  <a:lnTo>
                    <a:pt x="609" y="158"/>
                  </a:lnTo>
                  <a:lnTo>
                    <a:pt x="609" y="146"/>
                  </a:lnTo>
                  <a:lnTo>
                    <a:pt x="613" y="146"/>
                  </a:lnTo>
                  <a:lnTo>
                    <a:pt x="618" y="146"/>
                  </a:lnTo>
                  <a:lnTo>
                    <a:pt x="624" y="146"/>
                  </a:lnTo>
                  <a:lnTo>
                    <a:pt x="631" y="146"/>
                  </a:lnTo>
                  <a:lnTo>
                    <a:pt x="633" y="133"/>
                  </a:lnTo>
                  <a:lnTo>
                    <a:pt x="635" y="133"/>
                  </a:lnTo>
                  <a:lnTo>
                    <a:pt x="644" y="133"/>
                  </a:lnTo>
                  <a:lnTo>
                    <a:pt x="644" y="120"/>
                  </a:lnTo>
                  <a:lnTo>
                    <a:pt x="648" y="120"/>
                  </a:lnTo>
                  <a:lnTo>
                    <a:pt x="653" y="108"/>
                  </a:lnTo>
                  <a:lnTo>
                    <a:pt x="654" y="108"/>
                  </a:lnTo>
                  <a:lnTo>
                    <a:pt x="659" y="108"/>
                  </a:lnTo>
                  <a:lnTo>
                    <a:pt x="675" y="108"/>
                  </a:lnTo>
                  <a:lnTo>
                    <a:pt x="678" y="108"/>
                  </a:lnTo>
                  <a:lnTo>
                    <a:pt x="685" y="108"/>
                  </a:lnTo>
                  <a:lnTo>
                    <a:pt x="688" y="93"/>
                  </a:lnTo>
                  <a:lnTo>
                    <a:pt x="690" y="93"/>
                  </a:lnTo>
                  <a:lnTo>
                    <a:pt x="697" y="93"/>
                  </a:lnTo>
                  <a:lnTo>
                    <a:pt x="697" y="77"/>
                  </a:lnTo>
                  <a:lnTo>
                    <a:pt x="705" y="77"/>
                  </a:lnTo>
                  <a:lnTo>
                    <a:pt x="710" y="77"/>
                  </a:lnTo>
                  <a:lnTo>
                    <a:pt x="715" y="77"/>
                  </a:lnTo>
                  <a:lnTo>
                    <a:pt x="721" y="77"/>
                  </a:lnTo>
                  <a:lnTo>
                    <a:pt x="728" y="77"/>
                  </a:lnTo>
                  <a:lnTo>
                    <a:pt x="730" y="60"/>
                  </a:lnTo>
                  <a:lnTo>
                    <a:pt x="731" y="60"/>
                  </a:lnTo>
                  <a:lnTo>
                    <a:pt x="737" y="60"/>
                  </a:lnTo>
                  <a:lnTo>
                    <a:pt x="745" y="60"/>
                  </a:lnTo>
                  <a:lnTo>
                    <a:pt x="750" y="60"/>
                  </a:lnTo>
                  <a:lnTo>
                    <a:pt x="755" y="41"/>
                  </a:lnTo>
                  <a:lnTo>
                    <a:pt x="756" y="41"/>
                  </a:lnTo>
                  <a:lnTo>
                    <a:pt x="757" y="21"/>
                  </a:lnTo>
                  <a:lnTo>
                    <a:pt x="765" y="21"/>
                  </a:lnTo>
                  <a:lnTo>
                    <a:pt x="771" y="21"/>
                  </a:lnTo>
                  <a:lnTo>
                    <a:pt x="777" y="21"/>
                  </a:lnTo>
                  <a:lnTo>
                    <a:pt x="785" y="21"/>
                  </a:lnTo>
                  <a:lnTo>
                    <a:pt x="785" y="0"/>
                  </a:lnTo>
                  <a:lnTo>
                    <a:pt x="788" y="0"/>
                  </a:lnTo>
                  <a:lnTo>
                    <a:pt x="795" y="0"/>
                  </a:lnTo>
                  <a:lnTo>
                    <a:pt x="800" y="0"/>
                  </a:lnTo>
                  <a:lnTo>
                    <a:pt x="823" y="0"/>
                  </a:lnTo>
                  <a:lnTo>
                    <a:pt x="835" y="0"/>
                  </a:lnTo>
                  <a:lnTo>
                    <a:pt x="847" y="0"/>
                  </a:lnTo>
                  <a:lnTo>
                    <a:pt x="853" y="0"/>
                  </a:lnTo>
                  <a:lnTo>
                    <a:pt x="860" y="0"/>
                  </a:lnTo>
                  <a:lnTo>
                    <a:pt x="872" y="0"/>
                  </a:lnTo>
                  <a:lnTo>
                    <a:pt x="882" y="0"/>
                  </a:lnTo>
                  <a:lnTo>
                    <a:pt x="891" y="0"/>
                  </a:lnTo>
                  <a:lnTo>
                    <a:pt x="897" y="0"/>
                  </a:lnTo>
                  <a:lnTo>
                    <a:pt x="910" y="0"/>
                  </a:lnTo>
                  <a:lnTo>
                    <a:pt x="913" y="0"/>
                  </a:lnTo>
                  <a:lnTo>
                    <a:pt x="918" y="0"/>
                  </a:lnTo>
                  <a:lnTo>
                    <a:pt x="927" y="0"/>
                  </a:lnTo>
                  <a:lnTo>
                    <a:pt x="934" y="0"/>
                  </a:lnTo>
                  <a:lnTo>
                    <a:pt x="937" y="0"/>
                  </a:lnTo>
                  <a:lnTo>
                    <a:pt x="945" y="0"/>
                  </a:lnTo>
                  <a:lnTo>
                    <a:pt x="949" y="0"/>
                  </a:lnTo>
                  <a:lnTo>
                    <a:pt x="962" y="0"/>
                  </a:lnTo>
                  <a:lnTo>
                    <a:pt x="969" y="0"/>
                  </a:lnTo>
                  <a:lnTo>
                    <a:pt x="975" y="0"/>
                  </a:lnTo>
                  <a:lnTo>
                    <a:pt x="990" y="0"/>
                  </a:lnTo>
                  <a:lnTo>
                    <a:pt x="991" y="0"/>
                  </a:lnTo>
                  <a:lnTo>
                    <a:pt x="1002" y="0"/>
                  </a:lnTo>
                  <a:lnTo>
                    <a:pt x="1003" y="0"/>
                  </a:lnTo>
                  <a:lnTo>
                    <a:pt x="1029" y="0"/>
                  </a:lnTo>
                  <a:lnTo>
                    <a:pt x="1035" y="0"/>
                  </a:lnTo>
                  <a:lnTo>
                    <a:pt x="1041" y="0"/>
                  </a:lnTo>
                  <a:lnTo>
                    <a:pt x="1058" y="0"/>
                  </a:lnTo>
                  <a:lnTo>
                    <a:pt x="1071" y="0"/>
                  </a:lnTo>
                  <a:lnTo>
                    <a:pt x="1082" y="0"/>
                  </a:lnTo>
                  <a:lnTo>
                    <a:pt x="1087" y="0"/>
                  </a:lnTo>
                  <a:lnTo>
                    <a:pt x="1100" y="0"/>
                  </a:lnTo>
                  <a:lnTo>
                    <a:pt x="1120" y="0"/>
                  </a:lnTo>
                  <a:lnTo>
                    <a:pt x="1128" y="0"/>
                  </a:lnTo>
                  <a:lnTo>
                    <a:pt x="1138" y="0"/>
                  </a:lnTo>
                  <a:lnTo>
                    <a:pt x="1150" y="0"/>
                  </a:lnTo>
                  <a:lnTo>
                    <a:pt x="1156" y="0"/>
                  </a:lnTo>
                  <a:lnTo>
                    <a:pt x="1161" y="0"/>
                  </a:lnTo>
                  <a:lnTo>
                    <a:pt x="1177" y="0"/>
                  </a:lnTo>
                  <a:lnTo>
                    <a:pt x="1191" y="0"/>
                  </a:lnTo>
                  <a:lnTo>
                    <a:pt x="1197" y="0"/>
                  </a:lnTo>
                  <a:lnTo>
                    <a:pt x="1281" y="0"/>
                  </a:lnTo>
                  <a:lnTo>
                    <a:pt x="1286" y="0"/>
                  </a:lnTo>
                  <a:lnTo>
                    <a:pt x="1302" y="0"/>
                  </a:lnTo>
                  <a:lnTo>
                    <a:pt x="1390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Freeform 102">
              <a:extLst>
                <a:ext uri="{FF2B5EF4-FFF2-40B4-BE49-F238E27FC236}">
                  <a16:creationId xmlns:a16="http://schemas.microsoft.com/office/drawing/2014/main" id="{E2938243-3328-5748-7B7A-363AB5311105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6888" y="5674198"/>
              <a:ext cx="2555126" cy="267673"/>
            </a:xfrm>
            <a:custGeom>
              <a:avLst/>
              <a:gdLst>
                <a:gd name="T0" fmla="*/ 105 w 1356"/>
                <a:gd name="T1" fmla="*/ 135 h 145"/>
                <a:gd name="T2" fmla="*/ 136 w 1356"/>
                <a:gd name="T3" fmla="*/ 124 h 145"/>
                <a:gd name="T4" fmla="*/ 157 w 1356"/>
                <a:gd name="T5" fmla="*/ 113 h 145"/>
                <a:gd name="T6" fmla="*/ 167 w 1356"/>
                <a:gd name="T7" fmla="*/ 103 h 145"/>
                <a:gd name="T8" fmla="*/ 181 w 1356"/>
                <a:gd name="T9" fmla="*/ 92 h 145"/>
                <a:gd name="T10" fmla="*/ 216 w 1356"/>
                <a:gd name="T11" fmla="*/ 92 h 145"/>
                <a:gd name="T12" fmla="*/ 252 w 1356"/>
                <a:gd name="T13" fmla="*/ 92 h 145"/>
                <a:gd name="T14" fmla="*/ 266 w 1356"/>
                <a:gd name="T15" fmla="*/ 81 h 145"/>
                <a:gd name="T16" fmla="*/ 288 w 1356"/>
                <a:gd name="T17" fmla="*/ 81 h 145"/>
                <a:gd name="T18" fmla="*/ 300 w 1356"/>
                <a:gd name="T19" fmla="*/ 69 h 145"/>
                <a:gd name="T20" fmla="*/ 322 w 1356"/>
                <a:gd name="T21" fmla="*/ 69 h 145"/>
                <a:gd name="T22" fmla="*/ 342 w 1356"/>
                <a:gd name="T23" fmla="*/ 57 h 145"/>
                <a:gd name="T24" fmla="*/ 353 w 1356"/>
                <a:gd name="T25" fmla="*/ 45 h 145"/>
                <a:gd name="T26" fmla="*/ 380 w 1356"/>
                <a:gd name="T27" fmla="*/ 45 h 145"/>
                <a:gd name="T28" fmla="*/ 411 w 1356"/>
                <a:gd name="T29" fmla="*/ 31 h 145"/>
                <a:gd name="T30" fmla="*/ 425 w 1356"/>
                <a:gd name="T31" fmla="*/ 31 h 145"/>
                <a:gd name="T32" fmla="*/ 449 w 1356"/>
                <a:gd name="T33" fmla="*/ 31 h 145"/>
                <a:gd name="T34" fmla="*/ 484 w 1356"/>
                <a:gd name="T35" fmla="*/ 17 h 145"/>
                <a:gd name="T36" fmla="*/ 532 w 1356"/>
                <a:gd name="T37" fmla="*/ 17 h 145"/>
                <a:gd name="T38" fmla="*/ 571 w 1356"/>
                <a:gd name="T39" fmla="*/ 17 h 145"/>
                <a:gd name="T40" fmla="*/ 587 w 1356"/>
                <a:gd name="T41" fmla="*/ 17 h 145"/>
                <a:gd name="T42" fmla="*/ 605 w 1356"/>
                <a:gd name="T43" fmla="*/ 0 h 145"/>
                <a:gd name="T44" fmla="*/ 627 w 1356"/>
                <a:gd name="T45" fmla="*/ 0 h 145"/>
                <a:gd name="T46" fmla="*/ 645 w 1356"/>
                <a:gd name="T47" fmla="*/ 0 h 145"/>
                <a:gd name="T48" fmla="*/ 665 w 1356"/>
                <a:gd name="T49" fmla="*/ 0 h 145"/>
                <a:gd name="T50" fmla="*/ 681 w 1356"/>
                <a:gd name="T51" fmla="*/ 0 h 145"/>
                <a:gd name="T52" fmla="*/ 709 w 1356"/>
                <a:gd name="T53" fmla="*/ 0 h 145"/>
                <a:gd name="T54" fmla="*/ 734 w 1356"/>
                <a:gd name="T55" fmla="*/ 0 h 145"/>
                <a:gd name="T56" fmla="*/ 758 w 1356"/>
                <a:gd name="T57" fmla="*/ 0 h 145"/>
                <a:gd name="T58" fmla="*/ 775 w 1356"/>
                <a:gd name="T59" fmla="*/ 0 h 145"/>
                <a:gd name="T60" fmla="*/ 793 w 1356"/>
                <a:gd name="T61" fmla="*/ 0 h 145"/>
                <a:gd name="T62" fmla="*/ 818 w 1356"/>
                <a:gd name="T63" fmla="*/ 0 h 145"/>
                <a:gd name="T64" fmla="*/ 838 w 1356"/>
                <a:gd name="T65" fmla="*/ 0 h 145"/>
                <a:gd name="T66" fmla="*/ 854 w 1356"/>
                <a:gd name="T67" fmla="*/ 0 h 145"/>
                <a:gd name="T68" fmla="*/ 873 w 1356"/>
                <a:gd name="T69" fmla="*/ 0 h 145"/>
                <a:gd name="T70" fmla="*/ 892 w 1356"/>
                <a:gd name="T71" fmla="*/ 0 h 145"/>
                <a:gd name="T72" fmla="*/ 912 w 1356"/>
                <a:gd name="T73" fmla="*/ 0 h 145"/>
                <a:gd name="T74" fmla="*/ 933 w 1356"/>
                <a:gd name="T75" fmla="*/ 0 h 145"/>
                <a:gd name="T76" fmla="*/ 986 w 1356"/>
                <a:gd name="T77" fmla="*/ 0 h 145"/>
                <a:gd name="T78" fmla="*/ 1033 w 1356"/>
                <a:gd name="T79" fmla="*/ 0 h 145"/>
                <a:gd name="T80" fmla="*/ 1089 w 1356"/>
                <a:gd name="T81" fmla="*/ 0 h 145"/>
                <a:gd name="T82" fmla="*/ 1118 w 1356"/>
                <a:gd name="T83" fmla="*/ 0 h 145"/>
                <a:gd name="T84" fmla="*/ 1223 w 1356"/>
                <a:gd name="T85" fmla="*/ 0 h 145"/>
                <a:gd name="T86" fmla="*/ 1290 w 1356"/>
                <a:gd name="T87" fmla="*/ 0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1356" h="145">
                  <a:moveTo>
                    <a:pt x="0" y="145"/>
                  </a:moveTo>
                  <a:lnTo>
                    <a:pt x="101" y="145"/>
                  </a:lnTo>
                  <a:lnTo>
                    <a:pt x="105" y="135"/>
                  </a:lnTo>
                  <a:lnTo>
                    <a:pt x="106" y="135"/>
                  </a:lnTo>
                  <a:lnTo>
                    <a:pt x="136" y="135"/>
                  </a:lnTo>
                  <a:lnTo>
                    <a:pt x="136" y="124"/>
                  </a:lnTo>
                  <a:lnTo>
                    <a:pt x="143" y="124"/>
                  </a:lnTo>
                  <a:lnTo>
                    <a:pt x="143" y="113"/>
                  </a:lnTo>
                  <a:lnTo>
                    <a:pt x="157" y="113"/>
                  </a:lnTo>
                  <a:lnTo>
                    <a:pt x="163" y="113"/>
                  </a:lnTo>
                  <a:lnTo>
                    <a:pt x="163" y="103"/>
                  </a:lnTo>
                  <a:lnTo>
                    <a:pt x="167" y="103"/>
                  </a:lnTo>
                  <a:lnTo>
                    <a:pt x="176" y="103"/>
                  </a:lnTo>
                  <a:lnTo>
                    <a:pt x="181" y="103"/>
                  </a:lnTo>
                  <a:lnTo>
                    <a:pt x="181" y="92"/>
                  </a:lnTo>
                  <a:lnTo>
                    <a:pt x="189" y="92"/>
                  </a:lnTo>
                  <a:lnTo>
                    <a:pt x="208" y="92"/>
                  </a:lnTo>
                  <a:lnTo>
                    <a:pt x="216" y="92"/>
                  </a:lnTo>
                  <a:lnTo>
                    <a:pt x="226" y="92"/>
                  </a:lnTo>
                  <a:lnTo>
                    <a:pt x="242" y="92"/>
                  </a:lnTo>
                  <a:lnTo>
                    <a:pt x="252" y="92"/>
                  </a:lnTo>
                  <a:lnTo>
                    <a:pt x="253" y="81"/>
                  </a:lnTo>
                  <a:lnTo>
                    <a:pt x="257" y="81"/>
                  </a:lnTo>
                  <a:lnTo>
                    <a:pt x="266" y="81"/>
                  </a:lnTo>
                  <a:lnTo>
                    <a:pt x="276" y="81"/>
                  </a:lnTo>
                  <a:lnTo>
                    <a:pt x="281" y="81"/>
                  </a:lnTo>
                  <a:lnTo>
                    <a:pt x="288" y="81"/>
                  </a:lnTo>
                  <a:lnTo>
                    <a:pt x="288" y="69"/>
                  </a:lnTo>
                  <a:lnTo>
                    <a:pt x="292" y="69"/>
                  </a:lnTo>
                  <a:lnTo>
                    <a:pt x="300" y="69"/>
                  </a:lnTo>
                  <a:lnTo>
                    <a:pt x="305" y="69"/>
                  </a:lnTo>
                  <a:lnTo>
                    <a:pt x="315" y="69"/>
                  </a:lnTo>
                  <a:lnTo>
                    <a:pt x="322" y="69"/>
                  </a:lnTo>
                  <a:lnTo>
                    <a:pt x="328" y="57"/>
                  </a:lnTo>
                  <a:lnTo>
                    <a:pt x="330" y="57"/>
                  </a:lnTo>
                  <a:lnTo>
                    <a:pt x="342" y="57"/>
                  </a:lnTo>
                  <a:lnTo>
                    <a:pt x="345" y="45"/>
                  </a:lnTo>
                  <a:lnTo>
                    <a:pt x="351" y="45"/>
                  </a:lnTo>
                  <a:lnTo>
                    <a:pt x="353" y="45"/>
                  </a:lnTo>
                  <a:lnTo>
                    <a:pt x="361" y="45"/>
                  </a:lnTo>
                  <a:lnTo>
                    <a:pt x="373" y="45"/>
                  </a:lnTo>
                  <a:lnTo>
                    <a:pt x="380" y="45"/>
                  </a:lnTo>
                  <a:lnTo>
                    <a:pt x="382" y="31"/>
                  </a:lnTo>
                  <a:lnTo>
                    <a:pt x="402" y="31"/>
                  </a:lnTo>
                  <a:lnTo>
                    <a:pt x="411" y="31"/>
                  </a:lnTo>
                  <a:lnTo>
                    <a:pt x="417" y="31"/>
                  </a:lnTo>
                  <a:lnTo>
                    <a:pt x="422" y="31"/>
                  </a:lnTo>
                  <a:lnTo>
                    <a:pt x="425" y="31"/>
                  </a:lnTo>
                  <a:lnTo>
                    <a:pt x="434" y="31"/>
                  </a:lnTo>
                  <a:lnTo>
                    <a:pt x="445" y="31"/>
                  </a:lnTo>
                  <a:lnTo>
                    <a:pt x="449" y="31"/>
                  </a:lnTo>
                  <a:lnTo>
                    <a:pt x="461" y="31"/>
                  </a:lnTo>
                  <a:lnTo>
                    <a:pt x="461" y="17"/>
                  </a:lnTo>
                  <a:lnTo>
                    <a:pt x="484" y="17"/>
                  </a:lnTo>
                  <a:lnTo>
                    <a:pt x="494" y="17"/>
                  </a:lnTo>
                  <a:lnTo>
                    <a:pt x="510" y="17"/>
                  </a:lnTo>
                  <a:lnTo>
                    <a:pt x="532" y="17"/>
                  </a:lnTo>
                  <a:lnTo>
                    <a:pt x="540" y="17"/>
                  </a:lnTo>
                  <a:lnTo>
                    <a:pt x="563" y="17"/>
                  </a:lnTo>
                  <a:lnTo>
                    <a:pt x="571" y="17"/>
                  </a:lnTo>
                  <a:lnTo>
                    <a:pt x="575" y="17"/>
                  </a:lnTo>
                  <a:lnTo>
                    <a:pt x="584" y="17"/>
                  </a:lnTo>
                  <a:lnTo>
                    <a:pt x="587" y="17"/>
                  </a:lnTo>
                  <a:lnTo>
                    <a:pt x="599" y="17"/>
                  </a:lnTo>
                  <a:lnTo>
                    <a:pt x="600" y="0"/>
                  </a:lnTo>
                  <a:lnTo>
                    <a:pt x="605" y="0"/>
                  </a:lnTo>
                  <a:lnTo>
                    <a:pt x="612" y="0"/>
                  </a:lnTo>
                  <a:lnTo>
                    <a:pt x="621" y="0"/>
                  </a:lnTo>
                  <a:lnTo>
                    <a:pt x="627" y="0"/>
                  </a:lnTo>
                  <a:lnTo>
                    <a:pt x="633" y="0"/>
                  </a:lnTo>
                  <a:lnTo>
                    <a:pt x="637" y="0"/>
                  </a:lnTo>
                  <a:lnTo>
                    <a:pt x="645" y="0"/>
                  </a:lnTo>
                  <a:lnTo>
                    <a:pt x="648" y="0"/>
                  </a:lnTo>
                  <a:lnTo>
                    <a:pt x="654" y="0"/>
                  </a:lnTo>
                  <a:lnTo>
                    <a:pt x="665" y="0"/>
                  </a:lnTo>
                  <a:lnTo>
                    <a:pt x="665" y="0"/>
                  </a:lnTo>
                  <a:lnTo>
                    <a:pt x="671" y="0"/>
                  </a:lnTo>
                  <a:lnTo>
                    <a:pt x="681" y="0"/>
                  </a:lnTo>
                  <a:lnTo>
                    <a:pt x="688" y="0"/>
                  </a:lnTo>
                  <a:lnTo>
                    <a:pt x="707" y="0"/>
                  </a:lnTo>
                  <a:lnTo>
                    <a:pt x="709" y="0"/>
                  </a:lnTo>
                  <a:lnTo>
                    <a:pt x="718" y="0"/>
                  </a:lnTo>
                  <a:lnTo>
                    <a:pt x="723" y="0"/>
                  </a:lnTo>
                  <a:lnTo>
                    <a:pt x="734" y="0"/>
                  </a:lnTo>
                  <a:lnTo>
                    <a:pt x="741" y="0"/>
                  </a:lnTo>
                  <a:lnTo>
                    <a:pt x="744" y="0"/>
                  </a:lnTo>
                  <a:lnTo>
                    <a:pt x="758" y="0"/>
                  </a:lnTo>
                  <a:lnTo>
                    <a:pt x="764" y="0"/>
                  </a:lnTo>
                  <a:lnTo>
                    <a:pt x="771" y="0"/>
                  </a:lnTo>
                  <a:lnTo>
                    <a:pt x="775" y="0"/>
                  </a:lnTo>
                  <a:lnTo>
                    <a:pt x="781" y="0"/>
                  </a:lnTo>
                  <a:lnTo>
                    <a:pt x="790" y="0"/>
                  </a:lnTo>
                  <a:lnTo>
                    <a:pt x="793" y="0"/>
                  </a:lnTo>
                  <a:lnTo>
                    <a:pt x="801" y="0"/>
                  </a:lnTo>
                  <a:lnTo>
                    <a:pt x="807" y="0"/>
                  </a:lnTo>
                  <a:lnTo>
                    <a:pt x="818" y="0"/>
                  </a:lnTo>
                  <a:lnTo>
                    <a:pt x="822" y="0"/>
                  </a:lnTo>
                  <a:lnTo>
                    <a:pt x="832" y="0"/>
                  </a:lnTo>
                  <a:lnTo>
                    <a:pt x="838" y="0"/>
                  </a:lnTo>
                  <a:lnTo>
                    <a:pt x="841" y="0"/>
                  </a:lnTo>
                  <a:lnTo>
                    <a:pt x="850" y="0"/>
                  </a:lnTo>
                  <a:lnTo>
                    <a:pt x="854" y="0"/>
                  </a:lnTo>
                  <a:lnTo>
                    <a:pt x="858" y="0"/>
                  </a:lnTo>
                  <a:lnTo>
                    <a:pt x="867" y="0"/>
                  </a:lnTo>
                  <a:lnTo>
                    <a:pt x="873" y="0"/>
                  </a:lnTo>
                  <a:lnTo>
                    <a:pt x="879" y="0"/>
                  </a:lnTo>
                  <a:lnTo>
                    <a:pt x="883" y="0"/>
                  </a:lnTo>
                  <a:lnTo>
                    <a:pt x="892" y="0"/>
                  </a:lnTo>
                  <a:lnTo>
                    <a:pt x="894" y="0"/>
                  </a:lnTo>
                  <a:lnTo>
                    <a:pt x="900" y="0"/>
                  </a:lnTo>
                  <a:lnTo>
                    <a:pt x="912" y="0"/>
                  </a:lnTo>
                  <a:lnTo>
                    <a:pt x="921" y="0"/>
                  </a:lnTo>
                  <a:lnTo>
                    <a:pt x="925" y="0"/>
                  </a:lnTo>
                  <a:lnTo>
                    <a:pt x="933" y="0"/>
                  </a:lnTo>
                  <a:lnTo>
                    <a:pt x="954" y="0"/>
                  </a:lnTo>
                  <a:lnTo>
                    <a:pt x="960" y="0"/>
                  </a:lnTo>
                  <a:lnTo>
                    <a:pt x="986" y="0"/>
                  </a:lnTo>
                  <a:lnTo>
                    <a:pt x="1009" y="0"/>
                  </a:lnTo>
                  <a:lnTo>
                    <a:pt x="1032" y="0"/>
                  </a:lnTo>
                  <a:lnTo>
                    <a:pt x="1033" y="0"/>
                  </a:lnTo>
                  <a:lnTo>
                    <a:pt x="1078" y="0"/>
                  </a:lnTo>
                  <a:lnTo>
                    <a:pt x="1081" y="0"/>
                  </a:lnTo>
                  <a:lnTo>
                    <a:pt x="1089" y="0"/>
                  </a:lnTo>
                  <a:lnTo>
                    <a:pt x="1097" y="0"/>
                  </a:lnTo>
                  <a:lnTo>
                    <a:pt x="1109" y="0"/>
                  </a:lnTo>
                  <a:lnTo>
                    <a:pt x="1118" y="0"/>
                  </a:lnTo>
                  <a:lnTo>
                    <a:pt x="1151" y="0"/>
                  </a:lnTo>
                  <a:lnTo>
                    <a:pt x="1162" y="0"/>
                  </a:lnTo>
                  <a:lnTo>
                    <a:pt x="1223" y="0"/>
                  </a:lnTo>
                  <a:lnTo>
                    <a:pt x="1230" y="0"/>
                  </a:lnTo>
                  <a:lnTo>
                    <a:pt x="1259" y="0"/>
                  </a:lnTo>
                  <a:lnTo>
                    <a:pt x="1290" y="0"/>
                  </a:lnTo>
                  <a:lnTo>
                    <a:pt x="1321" y="0"/>
                  </a:lnTo>
                  <a:lnTo>
                    <a:pt x="1356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Freeform 103">
              <a:extLst>
                <a:ext uri="{FF2B5EF4-FFF2-40B4-BE49-F238E27FC236}">
                  <a16:creationId xmlns:a16="http://schemas.microsoft.com/office/drawing/2014/main" id="{8E139F78-8E80-5A60-653D-7721B85DA6F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6888" y="5546824"/>
              <a:ext cx="2589044" cy="395047"/>
            </a:xfrm>
            <a:custGeom>
              <a:avLst/>
              <a:gdLst>
                <a:gd name="T0" fmla="*/ 0 w 1374"/>
                <a:gd name="T1" fmla="*/ 214 h 214"/>
                <a:gd name="T2" fmla="*/ 160 w 1374"/>
                <a:gd name="T3" fmla="*/ 214 h 214"/>
                <a:gd name="T4" fmla="*/ 160 w 1374"/>
                <a:gd name="T5" fmla="*/ 182 h 214"/>
                <a:gd name="T6" fmla="*/ 182 w 1374"/>
                <a:gd name="T7" fmla="*/ 182 h 214"/>
                <a:gd name="T8" fmla="*/ 193 w 1374"/>
                <a:gd name="T9" fmla="*/ 182 h 214"/>
                <a:gd name="T10" fmla="*/ 193 w 1374"/>
                <a:gd name="T11" fmla="*/ 150 h 214"/>
                <a:gd name="T12" fmla="*/ 210 w 1374"/>
                <a:gd name="T13" fmla="*/ 150 h 214"/>
                <a:gd name="T14" fmla="*/ 219 w 1374"/>
                <a:gd name="T15" fmla="*/ 150 h 214"/>
                <a:gd name="T16" fmla="*/ 241 w 1374"/>
                <a:gd name="T17" fmla="*/ 150 h 214"/>
                <a:gd name="T18" fmla="*/ 241 w 1374"/>
                <a:gd name="T19" fmla="*/ 118 h 214"/>
                <a:gd name="T20" fmla="*/ 280 w 1374"/>
                <a:gd name="T21" fmla="*/ 118 h 214"/>
                <a:gd name="T22" fmla="*/ 351 w 1374"/>
                <a:gd name="T23" fmla="*/ 118 h 214"/>
                <a:gd name="T24" fmla="*/ 370 w 1374"/>
                <a:gd name="T25" fmla="*/ 118 h 214"/>
                <a:gd name="T26" fmla="*/ 375 w 1374"/>
                <a:gd name="T27" fmla="*/ 118 h 214"/>
                <a:gd name="T28" fmla="*/ 386 w 1374"/>
                <a:gd name="T29" fmla="*/ 118 h 214"/>
                <a:gd name="T30" fmla="*/ 398 w 1374"/>
                <a:gd name="T31" fmla="*/ 118 h 214"/>
                <a:gd name="T32" fmla="*/ 423 w 1374"/>
                <a:gd name="T33" fmla="*/ 118 h 214"/>
                <a:gd name="T34" fmla="*/ 425 w 1374"/>
                <a:gd name="T35" fmla="*/ 118 h 214"/>
                <a:gd name="T36" fmla="*/ 440 w 1374"/>
                <a:gd name="T37" fmla="*/ 118 h 214"/>
                <a:gd name="T38" fmla="*/ 487 w 1374"/>
                <a:gd name="T39" fmla="*/ 118 h 214"/>
                <a:gd name="T40" fmla="*/ 547 w 1374"/>
                <a:gd name="T41" fmla="*/ 118 h 214"/>
                <a:gd name="T42" fmla="*/ 571 w 1374"/>
                <a:gd name="T43" fmla="*/ 118 h 214"/>
                <a:gd name="T44" fmla="*/ 595 w 1374"/>
                <a:gd name="T45" fmla="*/ 118 h 214"/>
                <a:gd name="T46" fmla="*/ 599 w 1374"/>
                <a:gd name="T47" fmla="*/ 118 h 214"/>
                <a:gd name="T48" fmla="*/ 628 w 1374"/>
                <a:gd name="T49" fmla="*/ 118 h 214"/>
                <a:gd name="T50" fmla="*/ 632 w 1374"/>
                <a:gd name="T51" fmla="*/ 118 h 214"/>
                <a:gd name="T52" fmla="*/ 657 w 1374"/>
                <a:gd name="T53" fmla="*/ 118 h 214"/>
                <a:gd name="T54" fmla="*/ 681 w 1374"/>
                <a:gd name="T55" fmla="*/ 118 h 214"/>
                <a:gd name="T56" fmla="*/ 681 w 1374"/>
                <a:gd name="T57" fmla="*/ 67 h 214"/>
                <a:gd name="T58" fmla="*/ 692 w 1374"/>
                <a:gd name="T59" fmla="*/ 67 h 214"/>
                <a:gd name="T60" fmla="*/ 711 w 1374"/>
                <a:gd name="T61" fmla="*/ 67 h 214"/>
                <a:gd name="T62" fmla="*/ 724 w 1374"/>
                <a:gd name="T63" fmla="*/ 67 h 214"/>
                <a:gd name="T64" fmla="*/ 734 w 1374"/>
                <a:gd name="T65" fmla="*/ 67 h 214"/>
                <a:gd name="T66" fmla="*/ 760 w 1374"/>
                <a:gd name="T67" fmla="*/ 67 h 214"/>
                <a:gd name="T68" fmla="*/ 765 w 1374"/>
                <a:gd name="T69" fmla="*/ 67 h 214"/>
                <a:gd name="T70" fmla="*/ 781 w 1374"/>
                <a:gd name="T71" fmla="*/ 67 h 214"/>
                <a:gd name="T72" fmla="*/ 781 w 1374"/>
                <a:gd name="T73" fmla="*/ 0 h 214"/>
                <a:gd name="T74" fmla="*/ 809 w 1374"/>
                <a:gd name="T75" fmla="*/ 0 h 214"/>
                <a:gd name="T76" fmla="*/ 826 w 1374"/>
                <a:gd name="T77" fmla="*/ 0 h 214"/>
                <a:gd name="T78" fmla="*/ 854 w 1374"/>
                <a:gd name="T79" fmla="*/ 0 h 214"/>
                <a:gd name="T80" fmla="*/ 882 w 1374"/>
                <a:gd name="T81" fmla="*/ 0 h 214"/>
                <a:gd name="T82" fmla="*/ 900 w 1374"/>
                <a:gd name="T83" fmla="*/ 0 h 214"/>
                <a:gd name="T84" fmla="*/ 907 w 1374"/>
                <a:gd name="T85" fmla="*/ 0 h 214"/>
                <a:gd name="T86" fmla="*/ 914 w 1374"/>
                <a:gd name="T87" fmla="*/ 0 h 214"/>
                <a:gd name="T88" fmla="*/ 950 w 1374"/>
                <a:gd name="T89" fmla="*/ 0 h 214"/>
                <a:gd name="T90" fmla="*/ 967 w 1374"/>
                <a:gd name="T91" fmla="*/ 0 h 214"/>
                <a:gd name="T92" fmla="*/ 991 w 1374"/>
                <a:gd name="T93" fmla="*/ 0 h 214"/>
                <a:gd name="T94" fmla="*/ 998 w 1374"/>
                <a:gd name="T95" fmla="*/ 0 h 214"/>
                <a:gd name="T96" fmla="*/ 1027 w 1374"/>
                <a:gd name="T97" fmla="*/ 0 h 214"/>
                <a:gd name="T98" fmla="*/ 1065 w 1374"/>
                <a:gd name="T99" fmla="*/ 0 h 214"/>
                <a:gd name="T100" fmla="*/ 1072 w 1374"/>
                <a:gd name="T101" fmla="*/ 0 h 214"/>
                <a:gd name="T102" fmla="*/ 1120 w 1374"/>
                <a:gd name="T103" fmla="*/ 0 h 214"/>
                <a:gd name="T104" fmla="*/ 1140 w 1374"/>
                <a:gd name="T105" fmla="*/ 0 h 214"/>
                <a:gd name="T106" fmla="*/ 1156 w 1374"/>
                <a:gd name="T107" fmla="*/ 0 h 214"/>
                <a:gd name="T108" fmla="*/ 1174 w 1374"/>
                <a:gd name="T109" fmla="*/ 0 h 214"/>
                <a:gd name="T110" fmla="*/ 1247 w 1374"/>
                <a:gd name="T111" fmla="*/ 0 h 214"/>
                <a:gd name="T112" fmla="*/ 1253 w 1374"/>
                <a:gd name="T113" fmla="*/ 0 h 214"/>
                <a:gd name="T114" fmla="*/ 1300 w 1374"/>
                <a:gd name="T115" fmla="*/ 0 h 214"/>
                <a:gd name="T116" fmla="*/ 1343 w 1374"/>
                <a:gd name="T117" fmla="*/ 0 h 214"/>
                <a:gd name="T118" fmla="*/ 1374 w 1374"/>
                <a:gd name="T119" fmla="*/ 0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1374" h="214">
                  <a:moveTo>
                    <a:pt x="0" y="214"/>
                  </a:moveTo>
                  <a:lnTo>
                    <a:pt x="160" y="214"/>
                  </a:lnTo>
                  <a:lnTo>
                    <a:pt x="160" y="182"/>
                  </a:lnTo>
                  <a:lnTo>
                    <a:pt x="182" y="182"/>
                  </a:lnTo>
                  <a:lnTo>
                    <a:pt x="193" y="182"/>
                  </a:lnTo>
                  <a:lnTo>
                    <a:pt x="193" y="150"/>
                  </a:lnTo>
                  <a:lnTo>
                    <a:pt x="210" y="150"/>
                  </a:lnTo>
                  <a:lnTo>
                    <a:pt x="219" y="150"/>
                  </a:lnTo>
                  <a:lnTo>
                    <a:pt x="241" y="150"/>
                  </a:lnTo>
                  <a:lnTo>
                    <a:pt x="241" y="118"/>
                  </a:lnTo>
                  <a:lnTo>
                    <a:pt x="280" y="118"/>
                  </a:lnTo>
                  <a:lnTo>
                    <a:pt x="351" y="118"/>
                  </a:lnTo>
                  <a:lnTo>
                    <a:pt x="370" y="118"/>
                  </a:lnTo>
                  <a:lnTo>
                    <a:pt x="375" y="118"/>
                  </a:lnTo>
                  <a:lnTo>
                    <a:pt x="386" y="118"/>
                  </a:lnTo>
                  <a:lnTo>
                    <a:pt x="398" y="118"/>
                  </a:lnTo>
                  <a:lnTo>
                    <a:pt x="423" y="118"/>
                  </a:lnTo>
                  <a:lnTo>
                    <a:pt x="425" y="118"/>
                  </a:lnTo>
                  <a:lnTo>
                    <a:pt x="440" y="118"/>
                  </a:lnTo>
                  <a:lnTo>
                    <a:pt x="487" y="118"/>
                  </a:lnTo>
                  <a:lnTo>
                    <a:pt x="547" y="118"/>
                  </a:lnTo>
                  <a:lnTo>
                    <a:pt x="571" y="118"/>
                  </a:lnTo>
                  <a:lnTo>
                    <a:pt x="595" y="118"/>
                  </a:lnTo>
                  <a:lnTo>
                    <a:pt x="599" y="118"/>
                  </a:lnTo>
                  <a:lnTo>
                    <a:pt x="628" y="118"/>
                  </a:lnTo>
                  <a:lnTo>
                    <a:pt x="632" y="118"/>
                  </a:lnTo>
                  <a:lnTo>
                    <a:pt x="657" y="118"/>
                  </a:lnTo>
                  <a:lnTo>
                    <a:pt x="681" y="118"/>
                  </a:lnTo>
                  <a:lnTo>
                    <a:pt x="681" y="67"/>
                  </a:lnTo>
                  <a:lnTo>
                    <a:pt x="692" y="67"/>
                  </a:lnTo>
                  <a:lnTo>
                    <a:pt x="711" y="67"/>
                  </a:lnTo>
                  <a:lnTo>
                    <a:pt x="724" y="67"/>
                  </a:lnTo>
                  <a:lnTo>
                    <a:pt x="734" y="67"/>
                  </a:lnTo>
                  <a:lnTo>
                    <a:pt x="760" y="67"/>
                  </a:lnTo>
                  <a:lnTo>
                    <a:pt x="765" y="67"/>
                  </a:lnTo>
                  <a:lnTo>
                    <a:pt x="781" y="67"/>
                  </a:lnTo>
                  <a:lnTo>
                    <a:pt x="781" y="0"/>
                  </a:lnTo>
                  <a:lnTo>
                    <a:pt x="809" y="0"/>
                  </a:lnTo>
                  <a:lnTo>
                    <a:pt x="826" y="0"/>
                  </a:lnTo>
                  <a:lnTo>
                    <a:pt x="854" y="0"/>
                  </a:lnTo>
                  <a:lnTo>
                    <a:pt x="882" y="0"/>
                  </a:lnTo>
                  <a:lnTo>
                    <a:pt x="900" y="0"/>
                  </a:lnTo>
                  <a:lnTo>
                    <a:pt x="907" y="0"/>
                  </a:lnTo>
                  <a:lnTo>
                    <a:pt x="914" y="0"/>
                  </a:lnTo>
                  <a:lnTo>
                    <a:pt x="950" y="0"/>
                  </a:lnTo>
                  <a:lnTo>
                    <a:pt x="967" y="0"/>
                  </a:lnTo>
                  <a:lnTo>
                    <a:pt x="991" y="0"/>
                  </a:lnTo>
                  <a:lnTo>
                    <a:pt x="998" y="0"/>
                  </a:lnTo>
                  <a:lnTo>
                    <a:pt x="1027" y="0"/>
                  </a:lnTo>
                  <a:lnTo>
                    <a:pt x="1065" y="0"/>
                  </a:lnTo>
                  <a:lnTo>
                    <a:pt x="1072" y="0"/>
                  </a:lnTo>
                  <a:lnTo>
                    <a:pt x="1120" y="0"/>
                  </a:lnTo>
                  <a:lnTo>
                    <a:pt x="1140" y="0"/>
                  </a:lnTo>
                  <a:lnTo>
                    <a:pt x="1156" y="0"/>
                  </a:lnTo>
                  <a:lnTo>
                    <a:pt x="1174" y="0"/>
                  </a:lnTo>
                  <a:lnTo>
                    <a:pt x="1247" y="0"/>
                  </a:lnTo>
                  <a:lnTo>
                    <a:pt x="1253" y="0"/>
                  </a:lnTo>
                  <a:lnTo>
                    <a:pt x="1300" y="0"/>
                  </a:lnTo>
                  <a:lnTo>
                    <a:pt x="1343" y="0"/>
                  </a:lnTo>
                  <a:lnTo>
                    <a:pt x="1374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DDBB6D79-7606-E8C5-2059-B3FFF6D3B6E2}"/>
              </a:ext>
            </a:extLst>
          </p:cNvPr>
          <p:cNvGrpSpPr/>
          <p:nvPr/>
        </p:nvGrpSpPr>
        <p:grpSpPr>
          <a:xfrm>
            <a:off x="6319428" y="3657844"/>
            <a:ext cx="4141083" cy="2791354"/>
            <a:chOff x="6609708" y="3933610"/>
            <a:chExt cx="4141083" cy="2791354"/>
          </a:xfrm>
        </p:grpSpPr>
        <p:grpSp>
          <p:nvGrpSpPr>
            <p:cNvPr id="238" name="グループ化 237">
              <a:extLst>
                <a:ext uri="{FF2B5EF4-FFF2-40B4-BE49-F238E27FC236}">
                  <a16:creationId xmlns:a16="http://schemas.microsoft.com/office/drawing/2014/main" id="{6B300AF1-6B55-2DF3-B1F3-F463643BCFE1}"/>
                </a:ext>
              </a:extLst>
            </p:cNvPr>
            <p:cNvGrpSpPr/>
            <p:nvPr/>
          </p:nvGrpSpPr>
          <p:grpSpPr>
            <a:xfrm>
              <a:off x="6609708" y="3933610"/>
              <a:ext cx="4141083" cy="2791354"/>
              <a:chOff x="6609708" y="3933610"/>
              <a:chExt cx="4141083" cy="2791354"/>
            </a:xfrm>
          </p:grpSpPr>
          <p:sp>
            <p:nvSpPr>
              <p:cNvPr id="120" name="Rectangle 22">
                <a:extLst>
                  <a:ext uri="{FF2B5EF4-FFF2-40B4-BE49-F238E27FC236}">
                    <a16:creationId xmlns:a16="http://schemas.microsoft.com/office/drawing/2014/main" id="{1838B9FE-F8D4-AC5A-2FD0-E12E20C52E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9632" y="3940131"/>
                <a:ext cx="3126078" cy="2010574"/>
              </a:xfrm>
              <a:prstGeom prst="rect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1" name="Line 23">
                <a:extLst>
                  <a:ext uri="{FF2B5EF4-FFF2-40B4-BE49-F238E27FC236}">
                    <a16:creationId xmlns:a16="http://schemas.microsoft.com/office/drawing/2014/main" id="{8B26A866-29A4-F543-962B-A9D019825C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63965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2" name="Line 25">
                <a:extLst>
                  <a:ext uri="{FF2B5EF4-FFF2-40B4-BE49-F238E27FC236}">
                    <a16:creationId xmlns:a16="http://schemas.microsoft.com/office/drawing/2014/main" id="{5C5B984E-8395-78DF-BDB1-DEAA2AA3B1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87182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3" name="Line 27">
                <a:extLst>
                  <a:ext uri="{FF2B5EF4-FFF2-40B4-BE49-F238E27FC236}">
                    <a16:creationId xmlns:a16="http://schemas.microsoft.com/office/drawing/2014/main" id="{642F76FD-7E61-4E59-F6B9-7D1DE33A8D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510398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4" name="Line 29">
                <a:extLst>
                  <a:ext uri="{FF2B5EF4-FFF2-40B4-BE49-F238E27FC236}">
                    <a16:creationId xmlns:a16="http://schemas.microsoft.com/office/drawing/2014/main" id="{ACFAFBD1-4EAA-B8C3-338A-266E0DD86A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1726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5" name="Line 31">
                <a:extLst>
                  <a:ext uri="{FF2B5EF4-FFF2-40B4-BE49-F238E27FC236}">
                    <a16:creationId xmlns:a16="http://schemas.microsoft.com/office/drawing/2014/main" id="{2FFBEF8C-A2BB-3B74-4AA1-51E74EAE0B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54943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6" name="Line 33">
                <a:extLst>
                  <a:ext uri="{FF2B5EF4-FFF2-40B4-BE49-F238E27FC236}">
                    <a16:creationId xmlns:a16="http://schemas.microsoft.com/office/drawing/2014/main" id="{0A155B83-5CB6-BC4E-B1BA-B1995754D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78159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7" name="Line 35">
                <a:extLst>
                  <a:ext uri="{FF2B5EF4-FFF2-40B4-BE49-F238E27FC236}">
                    <a16:creationId xmlns:a16="http://schemas.microsoft.com/office/drawing/2014/main" id="{542A0862-7BB7-96CD-EA65-902C8C049E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01376" y="5956294"/>
                <a:ext cx="0" cy="6708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8" name="Line 6">
                <a:extLst>
                  <a:ext uri="{FF2B5EF4-FFF2-40B4-BE49-F238E27FC236}">
                    <a16:creationId xmlns:a16="http://schemas.microsoft.com/office/drawing/2014/main" id="{B0A9B99C-6306-078C-AB2E-B9B7267F8E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5953908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29" name="Line 8">
                <a:extLst>
                  <a:ext uri="{FF2B5EF4-FFF2-40B4-BE49-F238E27FC236}">
                    <a16:creationId xmlns:a16="http://schemas.microsoft.com/office/drawing/2014/main" id="{CBC2C354-D538-EC1E-018E-D79A9329CC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554641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0" name="Line 9">
                <a:extLst>
                  <a:ext uri="{FF2B5EF4-FFF2-40B4-BE49-F238E27FC236}">
                    <a16:creationId xmlns:a16="http://schemas.microsoft.com/office/drawing/2014/main" id="{1EC8F8B0-5F55-9CE6-10CC-2DA4508431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513891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1" name="Line 11">
                <a:extLst>
                  <a:ext uri="{FF2B5EF4-FFF2-40B4-BE49-F238E27FC236}">
                    <a16:creationId xmlns:a16="http://schemas.microsoft.com/office/drawing/2014/main" id="{AAEDA363-1454-9FFF-7747-DC060D572E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4731422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2" name="Line 12">
                <a:extLst>
                  <a:ext uri="{FF2B5EF4-FFF2-40B4-BE49-F238E27FC236}">
                    <a16:creationId xmlns:a16="http://schemas.microsoft.com/office/drawing/2014/main" id="{0A26C4A2-EE72-09BB-B348-261FA17B53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97973" y="4323927"/>
                <a:ext cx="67681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3" name="Line 14">
                <a:extLst>
                  <a:ext uri="{FF2B5EF4-FFF2-40B4-BE49-F238E27FC236}">
                    <a16:creationId xmlns:a16="http://schemas.microsoft.com/office/drawing/2014/main" id="{6A52C521-A0E8-2101-0701-E7D969C45B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31812" y="3940339"/>
                <a:ext cx="33840" cy="0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4" name="Line 23">
                <a:extLst>
                  <a:ext uri="{FF2B5EF4-FFF2-40B4-BE49-F238E27FC236}">
                    <a16:creationId xmlns:a16="http://schemas.microsoft.com/office/drawing/2014/main" id="{A4C7B481-EB61-10FE-1936-75724AF5B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65653" y="5953909"/>
                <a:ext cx="0" cy="67681"/>
              </a:xfrm>
              <a:prstGeom prst="line">
                <a:avLst/>
              </a:prstGeom>
              <a:noFill/>
              <a:ln w="12700" cap="flat" cmpd="sng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135" name="図形グループ 54">
                <a:extLst>
                  <a:ext uri="{FF2B5EF4-FFF2-40B4-BE49-F238E27FC236}">
                    <a16:creationId xmlns:a16="http://schemas.microsoft.com/office/drawing/2014/main" id="{DDF5EE13-DE3C-C916-A17D-A1799195D072}"/>
                  </a:ext>
                </a:extLst>
              </p:cNvPr>
              <p:cNvGrpSpPr/>
              <p:nvPr/>
            </p:nvGrpSpPr>
            <p:grpSpPr>
              <a:xfrm>
                <a:off x="7156047" y="4194832"/>
                <a:ext cx="220989" cy="1868530"/>
                <a:chOff x="510218" y="1348283"/>
                <a:chExt cx="220989" cy="1868530"/>
              </a:xfrm>
            </p:grpSpPr>
            <p:sp>
              <p:nvSpPr>
                <p:cNvPr id="142" name="Rectangle 10">
                  <a:extLst>
                    <a:ext uri="{FF2B5EF4-FFF2-40B4-BE49-F238E27FC236}">
                      <a16:creationId xmlns:a16="http://schemas.microsoft.com/office/drawing/2014/main" id="{25AC9329-2D5A-C9FF-E92B-5ED72AB63F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2142458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2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3" name="Rectangle 13">
                  <a:extLst>
                    <a:ext uri="{FF2B5EF4-FFF2-40B4-BE49-F238E27FC236}">
                      <a16:creationId xmlns:a16="http://schemas.microsoft.com/office/drawing/2014/main" id="{B8F08616-DA6F-E7A0-2CC8-1F2205FD3D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0218" y="1348283"/>
                  <a:ext cx="20799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4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4" name="Rectangle 10">
                  <a:extLst>
                    <a:ext uri="{FF2B5EF4-FFF2-40B4-BE49-F238E27FC236}">
                      <a16:creationId xmlns:a16="http://schemas.microsoft.com/office/drawing/2014/main" id="{74C2AC60-FDBF-B5B2-AB94-35AA396403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7212" y="2970592"/>
                  <a:ext cx="1039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en-US" altLang="ja-JP" sz="1600" dirty="0">
                      <a:solidFill>
                        <a:srgbClr val="000000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  <a:cs typeface="Calibri" panose="020F0502020204030204" pitchFamily="34" charset="0"/>
                    </a:rPr>
                    <a:t>0</a:t>
                  </a:r>
                  <a:endParaRPr kumimoji="0" lang="ja-JP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E1F98BB6-B268-73FA-CD97-E428D5595D49}"/>
                  </a:ext>
                </a:extLst>
              </p:cNvPr>
              <p:cNvSpPr txBox="1"/>
              <p:nvPr/>
            </p:nvSpPr>
            <p:spPr>
              <a:xfrm>
                <a:off x="7328514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836B5292-5EA9-1754-7B76-E294AA883837}"/>
                  </a:ext>
                </a:extLst>
              </p:cNvPr>
              <p:cNvSpPr txBox="1"/>
              <p:nvPr/>
            </p:nvSpPr>
            <p:spPr>
              <a:xfrm>
                <a:off x="8373053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E506B1AD-0860-1879-1870-F17292AF5315}"/>
                  </a:ext>
                </a:extLst>
              </p:cNvPr>
              <p:cNvSpPr txBox="1"/>
              <p:nvPr/>
            </p:nvSpPr>
            <p:spPr>
              <a:xfrm>
                <a:off x="10462130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6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E3A09071-C257-2CC4-5A5D-DA1F160CA680}"/>
                  </a:ext>
                </a:extLst>
              </p:cNvPr>
              <p:cNvSpPr txBox="1"/>
              <p:nvPr/>
            </p:nvSpPr>
            <p:spPr>
              <a:xfrm>
                <a:off x="9417592" y="6093845"/>
                <a:ext cx="288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</a:t>
                </a:r>
                <a:endParaRPr lang="ja-JP" altLang="en-US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03E6B8F5-D83C-EF94-C8FB-B0256C6C9A9E}"/>
                  </a:ext>
                </a:extLst>
              </p:cNvPr>
              <p:cNvSpPr txBox="1"/>
              <p:nvPr/>
            </p:nvSpPr>
            <p:spPr>
              <a:xfrm rot="16200000">
                <a:off x="5726613" y="4816705"/>
                <a:ext cx="21355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Incidence of HCC (%)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C589EBFE-257A-D19D-2ADB-1A6C8886FB7B}"/>
                  </a:ext>
                </a:extLst>
              </p:cNvPr>
              <p:cNvSpPr txBox="1"/>
              <p:nvPr/>
            </p:nvSpPr>
            <p:spPr>
              <a:xfrm>
                <a:off x="8230820" y="6355632"/>
                <a:ext cx="15885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Calibri" panose="020F0502020204030204" pitchFamily="34" charset="0"/>
                    <a:cs typeface="Calibri" panose="020F0502020204030204" pitchFamily="34" charset="0"/>
                  </a:rPr>
                  <a:t>Years after SVR</a:t>
                </a:r>
                <a:endParaRPr kumimoji="1" lang="ja-JP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4" name="Freeform 138">
              <a:extLst>
                <a:ext uri="{FF2B5EF4-FFF2-40B4-BE49-F238E27FC236}">
                  <a16:creationId xmlns:a16="http://schemas.microsoft.com/office/drawing/2014/main" id="{7671977F-62E2-56D2-FF40-28D8A0779CF0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4971" y="4515832"/>
              <a:ext cx="2614117" cy="1440891"/>
            </a:xfrm>
            <a:custGeom>
              <a:avLst/>
              <a:gdLst>
                <a:gd name="T0" fmla="*/ 0 w 1390"/>
                <a:gd name="T1" fmla="*/ 781 h 781"/>
                <a:gd name="T2" fmla="*/ 117 w 1390"/>
                <a:gd name="T3" fmla="*/ 781 h 781"/>
                <a:gd name="T4" fmla="*/ 117 w 1390"/>
                <a:gd name="T5" fmla="*/ 739 h 781"/>
                <a:gd name="T6" fmla="*/ 121 w 1390"/>
                <a:gd name="T7" fmla="*/ 739 h 781"/>
                <a:gd name="T8" fmla="*/ 121 w 1390"/>
                <a:gd name="T9" fmla="*/ 696 h 781"/>
                <a:gd name="T10" fmla="*/ 129 w 1390"/>
                <a:gd name="T11" fmla="*/ 696 h 781"/>
                <a:gd name="T12" fmla="*/ 129 w 1390"/>
                <a:gd name="T13" fmla="*/ 653 h 781"/>
                <a:gd name="T14" fmla="*/ 162 w 1390"/>
                <a:gd name="T15" fmla="*/ 653 h 781"/>
                <a:gd name="T16" fmla="*/ 162 w 1390"/>
                <a:gd name="T17" fmla="*/ 611 h 781"/>
                <a:gd name="T18" fmla="*/ 165 w 1390"/>
                <a:gd name="T19" fmla="*/ 568 h 781"/>
                <a:gd name="T20" fmla="*/ 172 w 1390"/>
                <a:gd name="T21" fmla="*/ 568 h 781"/>
                <a:gd name="T22" fmla="*/ 172 w 1390"/>
                <a:gd name="T23" fmla="*/ 526 h 781"/>
                <a:gd name="T24" fmla="*/ 193 w 1390"/>
                <a:gd name="T25" fmla="*/ 526 h 781"/>
                <a:gd name="T26" fmla="*/ 193 w 1390"/>
                <a:gd name="T27" fmla="*/ 483 h 781"/>
                <a:gd name="T28" fmla="*/ 218 w 1390"/>
                <a:gd name="T29" fmla="*/ 483 h 781"/>
                <a:gd name="T30" fmla="*/ 220 w 1390"/>
                <a:gd name="T31" fmla="*/ 483 h 781"/>
                <a:gd name="T32" fmla="*/ 293 w 1390"/>
                <a:gd name="T33" fmla="*/ 483 h 781"/>
                <a:gd name="T34" fmla="*/ 293 w 1390"/>
                <a:gd name="T35" fmla="*/ 439 h 781"/>
                <a:gd name="T36" fmla="*/ 334 w 1390"/>
                <a:gd name="T37" fmla="*/ 439 h 781"/>
                <a:gd name="T38" fmla="*/ 334 w 1390"/>
                <a:gd name="T39" fmla="*/ 394 h 781"/>
                <a:gd name="T40" fmla="*/ 349 w 1390"/>
                <a:gd name="T41" fmla="*/ 394 h 781"/>
                <a:gd name="T42" fmla="*/ 354 w 1390"/>
                <a:gd name="T43" fmla="*/ 394 h 781"/>
                <a:gd name="T44" fmla="*/ 369 w 1390"/>
                <a:gd name="T45" fmla="*/ 394 h 781"/>
                <a:gd name="T46" fmla="*/ 378 w 1390"/>
                <a:gd name="T47" fmla="*/ 394 h 781"/>
                <a:gd name="T48" fmla="*/ 402 w 1390"/>
                <a:gd name="T49" fmla="*/ 394 h 781"/>
                <a:gd name="T50" fmla="*/ 414 w 1390"/>
                <a:gd name="T51" fmla="*/ 394 h 781"/>
                <a:gd name="T52" fmla="*/ 414 w 1390"/>
                <a:gd name="T53" fmla="*/ 342 h 781"/>
                <a:gd name="T54" fmla="*/ 447 w 1390"/>
                <a:gd name="T55" fmla="*/ 342 h 781"/>
                <a:gd name="T56" fmla="*/ 447 w 1390"/>
                <a:gd name="T57" fmla="*/ 289 h 781"/>
                <a:gd name="T58" fmla="*/ 452 w 1390"/>
                <a:gd name="T59" fmla="*/ 289 h 781"/>
                <a:gd name="T60" fmla="*/ 452 w 1390"/>
                <a:gd name="T61" fmla="*/ 237 h 781"/>
                <a:gd name="T62" fmla="*/ 462 w 1390"/>
                <a:gd name="T63" fmla="*/ 237 h 781"/>
                <a:gd name="T64" fmla="*/ 487 w 1390"/>
                <a:gd name="T65" fmla="*/ 237 h 781"/>
                <a:gd name="T66" fmla="*/ 498 w 1390"/>
                <a:gd name="T67" fmla="*/ 237 h 781"/>
                <a:gd name="T68" fmla="*/ 505 w 1390"/>
                <a:gd name="T69" fmla="*/ 237 h 781"/>
                <a:gd name="T70" fmla="*/ 537 w 1390"/>
                <a:gd name="T71" fmla="*/ 237 h 781"/>
                <a:gd name="T72" fmla="*/ 546 w 1390"/>
                <a:gd name="T73" fmla="*/ 237 h 781"/>
                <a:gd name="T74" fmla="*/ 581 w 1390"/>
                <a:gd name="T75" fmla="*/ 237 h 781"/>
                <a:gd name="T76" fmla="*/ 585 w 1390"/>
                <a:gd name="T77" fmla="*/ 159 h 781"/>
                <a:gd name="T78" fmla="*/ 609 w 1390"/>
                <a:gd name="T79" fmla="*/ 159 h 781"/>
                <a:gd name="T80" fmla="*/ 609 w 1390"/>
                <a:gd name="T81" fmla="*/ 82 h 781"/>
                <a:gd name="T82" fmla="*/ 613 w 1390"/>
                <a:gd name="T83" fmla="*/ 82 h 781"/>
                <a:gd name="T84" fmla="*/ 644 w 1390"/>
                <a:gd name="T85" fmla="*/ 82 h 781"/>
                <a:gd name="T86" fmla="*/ 644 w 1390"/>
                <a:gd name="T87" fmla="*/ 0 h 781"/>
                <a:gd name="T88" fmla="*/ 653 w 1390"/>
                <a:gd name="T89" fmla="*/ 0 h 781"/>
                <a:gd name="T90" fmla="*/ 675 w 1390"/>
                <a:gd name="T91" fmla="*/ 0 h 781"/>
                <a:gd name="T92" fmla="*/ 681 w 1390"/>
                <a:gd name="T93" fmla="*/ 0 h 781"/>
                <a:gd name="T94" fmla="*/ 736 w 1390"/>
                <a:gd name="T95" fmla="*/ 0 h 781"/>
                <a:gd name="T96" fmla="*/ 771 w 1390"/>
                <a:gd name="T97" fmla="*/ 0 h 781"/>
                <a:gd name="T98" fmla="*/ 827 w 1390"/>
                <a:gd name="T99" fmla="*/ 0 h 781"/>
                <a:gd name="T100" fmla="*/ 860 w 1390"/>
                <a:gd name="T101" fmla="*/ 0 h 781"/>
                <a:gd name="T102" fmla="*/ 962 w 1390"/>
                <a:gd name="T103" fmla="*/ 0 h 781"/>
                <a:gd name="T104" fmla="*/ 967 w 1390"/>
                <a:gd name="T105" fmla="*/ 0 h 781"/>
                <a:gd name="T106" fmla="*/ 975 w 1390"/>
                <a:gd name="T107" fmla="*/ 0 h 781"/>
                <a:gd name="T108" fmla="*/ 1151 w 1390"/>
                <a:gd name="T109" fmla="*/ 0 h 781"/>
                <a:gd name="T110" fmla="*/ 1177 w 1390"/>
                <a:gd name="T111" fmla="*/ 0 h 781"/>
                <a:gd name="T112" fmla="*/ 1374 w 1390"/>
                <a:gd name="T113" fmla="*/ 0 h 781"/>
                <a:gd name="T114" fmla="*/ 1390 w 1390"/>
                <a:gd name="T115" fmla="*/ 0 h 7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390" h="781">
                  <a:moveTo>
                    <a:pt x="0" y="781"/>
                  </a:moveTo>
                  <a:lnTo>
                    <a:pt x="117" y="781"/>
                  </a:lnTo>
                  <a:lnTo>
                    <a:pt x="117" y="739"/>
                  </a:lnTo>
                  <a:lnTo>
                    <a:pt x="121" y="739"/>
                  </a:lnTo>
                  <a:lnTo>
                    <a:pt x="121" y="696"/>
                  </a:lnTo>
                  <a:lnTo>
                    <a:pt x="129" y="696"/>
                  </a:lnTo>
                  <a:lnTo>
                    <a:pt x="129" y="653"/>
                  </a:lnTo>
                  <a:lnTo>
                    <a:pt x="162" y="653"/>
                  </a:lnTo>
                  <a:lnTo>
                    <a:pt x="162" y="611"/>
                  </a:lnTo>
                  <a:lnTo>
                    <a:pt x="165" y="568"/>
                  </a:lnTo>
                  <a:lnTo>
                    <a:pt x="172" y="568"/>
                  </a:lnTo>
                  <a:lnTo>
                    <a:pt x="172" y="526"/>
                  </a:lnTo>
                  <a:lnTo>
                    <a:pt x="193" y="526"/>
                  </a:lnTo>
                  <a:lnTo>
                    <a:pt x="193" y="483"/>
                  </a:lnTo>
                  <a:lnTo>
                    <a:pt x="218" y="483"/>
                  </a:lnTo>
                  <a:lnTo>
                    <a:pt x="220" y="483"/>
                  </a:lnTo>
                  <a:lnTo>
                    <a:pt x="293" y="483"/>
                  </a:lnTo>
                  <a:lnTo>
                    <a:pt x="293" y="439"/>
                  </a:lnTo>
                  <a:lnTo>
                    <a:pt x="334" y="439"/>
                  </a:lnTo>
                  <a:lnTo>
                    <a:pt x="334" y="394"/>
                  </a:lnTo>
                  <a:lnTo>
                    <a:pt x="349" y="394"/>
                  </a:lnTo>
                  <a:lnTo>
                    <a:pt x="354" y="394"/>
                  </a:lnTo>
                  <a:lnTo>
                    <a:pt x="369" y="394"/>
                  </a:lnTo>
                  <a:lnTo>
                    <a:pt x="378" y="394"/>
                  </a:lnTo>
                  <a:lnTo>
                    <a:pt x="402" y="394"/>
                  </a:lnTo>
                  <a:lnTo>
                    <a:pt x="414" y="394"/>
                  </a:lnTo>
                  <a:lnTo>
                    <a:pt x="414" y="342"/>
                  </a:lnTo>
                  <a:lnTo>
                    <a:pt x="447" y="342"/>
                  </a:lnTo>
                  <a:lnTo>
                    <a:pt x="447" y="289"/>
                  </a:lnTo>
                  <a:lnTo>
                    <a:pt x="452" y="289"/>
                  </a:lnTo>
                  <a:lnTo>
                    <a:pt x="452" y="237"/>
                  </a:lnTo>
                  <a:lnTo>
                    <a:pt x="462" y="237"/>
                  </a:lnTo>
                  <a:lnTo>
                    <a:pt x="487" y="237"/>
                  </a:lnTo>
                  <a:lnTo>
                    <a:pt x="498" y="237"/>
                  </a:lnTo>
                  <a:lnTo>
                    <a:pt x="505" y="237"/>
                  </a:lnTo>
                  <a:lnTo>
                    <a:pt x="537" y="237"/>
                  </a:lnTo>
                  <a:lnTo>
                    <a:pt x="546" y="237"/>
                  </a:lnTo>
                  <a:lnTo>
                    <a:pt x="581" y="237"/>
                  </a:lnTo>
                  <a:lnTo>
                    <a:pt x="585" y="159"/>
                  </a:lnTo>
                  <a:lnTo>
                    <a:pt x="609" y="159"/>
                  </a:lnTo>
                  <a:lnTo>
                    <a:pt x="609" y="82"/>
                  </a:lnTo>
                  <a:lnTo>
                    <a:pt x="613" y="82"/>
                  </a:lnTo>
                  <a:lnTo>
                    <a:pt x="644" y="82"/>
                  </a:lnTo>
                  <a:lnTo>
                    <a:pt x="644" y="0"/>
                  </a:lnTo>
                  <a:lnTo>
                    <a:pt x="653" y="0"/>
                  </a:lnTo>
                  <a:lnTo>
                    <a:pt x="675" y="0"/>
                  </a:lnTo>
                  <a:lnTo>
                    <a:pt x="681" y="0"/>
                  </a:lnTo>
                  <a:lnTo>
                    <a:pt x="736" y="0"/>
                  </a:lnTo>
                  <a:lnTo>
                    <a:pt x="771" y="0"/>
                  </a:lnTo>
                  <a:lnTo>
                    <a:pt x="827" y="0"/>
                  </a:lnTo>
                  <a:lnTo>
                    <a:pt x="860" y="0"/>
                  </a:lnTo>
                  <a:lnTo>
                    <a:pt x="962" y="0"/>
                  </a:lnTo>
                  <a:lnTo>
                    <a:pt x="967" y="0"/>
                  </a:lnTo>
                  <a:lnTo>
                    <a:pt x="975" y="0"/>
                  </a:lnTo>
                  <a:lnTo>
                    <a:pt x="1151" y="0"/>
                  </a:lnTo>
                  <a:lnTo>
                    <a:pt x="1177" y="0"/>
                  </a:lnTo>
                  <a:lnTo>
                    <a:pt x="1374" y="0"/>
                  </a:lnTo>
                  <a:lnTo>
                    <a:pt x="1390" y="0"/>
                  </a:lnTo>
                </a:path>
              </a:pathLst>
            </a:custGeom>
            <a:noFill/>
            <a:ln w="28575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Freeform 139">
              <a:extLst>
                <a:ext uri="{FF2B5EF4-FFF2-40B4-BE49-F238E27FC236}">
                  <a16:creationId xmlns:a16="http://schemas.microsoft.com/office/drawing/2014/main" id="{BEADF632-FBE4-0CB9-957E-5FD5CB2BCD4B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4971" y="5816508"/>
              <a:ext cx="2420409" cy="140215"/>
            </a:xfrm>
            <a:custGeom>
              <a:avLst/>
              <a:gdLst>
                <a:gd name="T0" fmla="*/ 101 w 1287"/>
                <a:gd name="T1" fmla="*/ 76 h 76"/>
                <a:gd name="T2" fmla="*/ 116 w 1287"/>
                <a:gd name="T3" fmla="*/ 76 h 76"/>
                <a:gd name="T4" fmla="*/ 176 w 1287"/>
                <a:gd name="T5" fmla="*/ 58 h 76"/>
                <a:gd name="T6" fmla="*/ 210 w 1287"/>
                <a:gd name="T7" fmla="*/ 58 h 76"/>
                <a:gd name="T8" fmla="*/ 226 w 1287"/>
                <a:gd name="T9" fmla="*/ 58 h 76"/>
                <a:gd name="T10" fmla="*/ 266 w 1287"/>
                <a:gd name="T11" fmla="*/ 58 h 76"/>
                <a:gd name="T12" fmla="*/ 288 w 1287"/>
                <a:gd name="T13" fmla="*/ 58 h 76"/>
                <a:gd name="T14" fmla="*/ 302 w 1287"/>
                <a:gd name="T15" fmla="*/ 39 h 76"/>
                <a:gd name="T16" fmla="*/ 315 w 1287"/>
                <a:gd name="T17" fmla="*/ 39 h 76"/>
                <a:gd name="T18" fmla="*/ 351 w 1287"/>
                <a:gd name="T19" fmla="*/ 39 h 76"/>
                <a:gd name="T20" fmla="*/ 380 w 1287"/>
                <a:gd name="T21" fmla="*/ 39 h 76"/>
                <a:gd name="T22" fmla="*/ 402 w 1287"/>
                <a:gd name="T23" fmla="*/ 39 h 76"/>
                <a:gd name="T24" fmla="*/ 417 w 1287"/>
                <a:gd name="T25" fmla="*/ 39 h 76"/>
                <a:gd name="T26" fmla="*/ 438 w 1287"/>
                <a:gd name="T27" fmla="*/ 39 h 76"/>
                <a:gd name="T28" fmla="*/ 464 w 1287"/>
                <a:gd name="T29" fmla="*/ 39 h 76"/>
                <a:gd name="T30" fmla="*/ 486 w 1287"/>
                <a:gd name="T31" fmla="*/ 39 h 76"/>
                <a:gd name="T32" fmla="*/ 510 w 1287"/>
                <a:gd name="T33" fmla="*/ 39 h 76"/>
                <a:gd name="T34" fmla="*/ 546 w 1287"/>
                <a:gd name="T35" fmla="*/ 39 h 76"/>
                <a:gd name="T36" fmla="*/ 584 w 1287"/>
                <a:gd name="T37" fmla="*/ 39 h 76"/>
                <a:gd name="T38" fmla="*/ 599 w 1287"/>
                <a:gd name="T39" fmla="*/ 39 h 76"/>
                <a:gd name="T40" fmla="*/ 625 w 1287"/>
                <a:gd name="T41" fmla="*/ 39 h 76"/>
                <a:gd name="T42" fmla="*/ 649 w 1287"/>
                <a:gd name="T43" fmla="*/ 39 h 76"/>
                <a:gd name="T44" fmla="*/ 659 w 1287"/>
                <a:gd name="T45" fmla="*/ 39 h 76"/>
                <a:gd name="T46" fmla="*/ 671 w 1287"/>
                <a:gd name="T47" fmla="*/ 39 h 76"/>
                <a:gd name="T48" fmla="*/ 709 w 1287"/>
                <a:gd name="T49" fmla="*/ 39 h 76"/>
                <a:gd name="T50" fmla="*/ 730 w 1287"/>
                <a:gd name="T51" fmla="*/ 39 h 76"/>
                <a:gd name="T52" fmla="*/ 734 w 1287"/>
                <a:gd name="T53" fmla="*/ 0 h 76"/>
                <a:gd name="T54" fmla="*/ 744 w 1287"/>
                <a:gd name="T55" fmla="*/ 0 h 76"/>
                <a:gd name="T56" fmla="*/ 764 w 1287"/>
                <a:gd name="T57" fmla="*/ 0 h 76"/>
                <a:gd name="T58" fmla="*/ 781 w 1287"/>
                <a:gd name="T59" fmla="*/ 0 h 76"/>
                <a:gd name="T60" fmla="*/ 793 w 1287"/>
                <a:gd name="T61" fmla="*/ 0 h 76"/>
                <a:gd name="T62" fmla="*/ 818 w 1287"/>
                <a:gd name="T63" fmla="*/ 0 h 76"/>
                <a:gd name="T64" fmla="*/ 835 w 1287"/>
                <a:gd name="T65" fmla="*/ 0 h 76"/>
                <a:gd name="T66" fmla="*/ 851 w 1287"/>
                <a:gd name="T67" fmla="*/ 0 h 76"/>
                <a:gd name="T68" fmla="*/ 860 w 1287"/>
                <a:gd name="T69" fmla="*/ 0 h 76"/>
                <a:gd name="T70" fmla="*/ 883 w 1287"/>
                <a:gd name="T71" fmla="*/ 0 h 76"/>
                <a:gd name="T72" fmla="*/ 900 w 1287"/>
                <a:gd name="T73" fmla="*/ 0 h 76"/>
                <a:gd name="T74" fmla="*/ 946 w 1287"/>
                <a:gd name="T75" fmla="*/ 0 h 76"/>
                <a:gd name="T76" fmla="*/ 986 w 1287"/>
                <a:gd name="T77" fmla="*/ 0 h 76"/>
                <a:gd name="T78" fmla="*/ 1009 w 1287"/>
                <a:gd name="T79" fmla="*/ 0 h 76"/>
                <a:gd name="T80" fmla="*/ 1036 w 1287"/>
                <a:gd name="T81" fmla="*/ 0 h 76"/>
                <a:gd name="T82" fmla="*/ 1089 w 1287"/>
                <a:gd name="T83" fmla="*/ 0 h 76"/>
                <a:gd name="T84" fmla="*/ 1115 w 1287"/>
                <a:gd name="T85" fmla="*/ 0 h 76"/>
                <a:gd name="T86" fmla="*/ 1151 w 1287"/>
                <a:gd name="T87" fmla="*/ 0 h 76"/>
                <a:gd name="T88" fmla="*/ 1230 w 1287"/>
                <a:gd name="T89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1287" h="76">
                  <a:moveTo>
                    <a:pt x="0" y="76"/>
                  </a:moveTo>
                  <a:lnTo>
                    <a:pt x="101" y="76"/>
                  </a:lnTo>
                  <a:lnTo>
                    <a:pt x="106" y="76"/>
                  </a:lnTo>
                  <a:lnTo>
                    <a:pt x="116" y="76"/>
                  </a:lnTo>
                  <a:lnTo>
                    <a:pt x="116" y="58"/>
                  </a:lnTo>
                  <a:lnTo>
                    <a:pt x="176" y="58"/>
                  </a:lnTo>
                  <a:lnTo>
                    <a:pt x="184" y="58"/>
                  </a:lnTo>
                  <a:lnTo>
                    <a:pt x="210" y="58"/>
                  </a:lnTo>
                  <a:lnTo>
                    <a:pt x="217" y="58"/>
                  </a:lnTo>
                  <a:lnTo>
                    <a:pt x="226" y="58"/>
                  </a:lnTo>
                  <a:lnTo>
                    <a:pt x="241" y="58"/>
                  </a:lnTo>
                  <a:lnTo>
                    <a:pt x="266" y="58"/>
                  </a:lnTo>
                  <a:lnTo>
                    <a:pt x="284" y="58"/>
                  </a:lnTo>
                  <a:lnTo>
                    <a:pt x="288" y="58"/>
                  </a:lnTo>
                  <a:lnTo>
                    <a:pt x="288" y="39"/>
                  </a:lnTo>
                  <a:lnTo>
                    <a:pt x="302" y="39"/>
                  </a:lnTo>
                  <a:lnTo>
                    <a:pt x="305" y="39"/>
                  </a:lnTo>
                  <a:lnTo>
                    <a:pt x="315" y="39"/>
                  </a:lnTo>
                  <a:lnTo>
                    <a:pt x="342" y="39"/>
                  </a:lnTo>
                  <a:lnTo>
                    <a:pt x="351" y="39"/>
                  </a:lnTo>
                  <a:lnTo>
                    <a:pt x="361" y="39"/>
                  </a:lnTo>
                  <a:lnTo>
                    <a:pt x="380" y="39"/>
                  </a:lnTo>
                  <a:lnTo>
                    <a:pt x="386" y="39"/>
                  </a:lnTo>
                  <a:lnTo>
                    <a:pt x="402" y="39"/>
                  </a:lnTo>
                  <a:lnTo>
                    <a:pt x="411" y="39"/>
                  </a:lnTo>
                  <a:lnTo>
                    <a:pt x="417" y="39"/>
                  </a:lnTo>
                  <a:lnTo>
                    <a:pt x="425" y="39"/>
                  </a:lnTo>
                  <a:lnTo>
                    <a:pt x="438" y="39"/>
                  </a:lnTo>
                  <a:lnTo>
                    <a:pt x="455" y="39"/>
                  </a:lnTo>
                  <a:lnTo>
                    <a:pt x="464" y="39"/>
                  </a:lnTo>
                  <a:lnTo>
                    <a:pt x="484" y="39"/>
                  </a:lnTo>
                  <a:lnTo>
                    <a:pt x="486" y="39"/>
                  </a:lnTo>
                  <a:lnTo>
                    <a:pt x="495" y="39"/>
                  </a:lnTo>
                  <a:lnTo>
                    <a:pt x="510" y="39"/>
                  </a:lnTo>
                  <a:lnTo>
                    <a:pt x="543" y="39"/>
                  </a:lnTo>
                  <a:lnTo>
                    <a:pt x="546" y="39"/>
                  </a:lnTo>
                  <a:lnTo>
                    <a:pt x="563" y="39"/>
                  </a:lnTo>
                  <a:lnTo>
                    <a:pt x="584" y="39"/>
                  </a:lnTo>
                  <a:lnTo>
                    <a:pt x="587" y="39"/>
                  </a:lnTo>
                  <a:lnTo>
                    <a:pt x="599" y="39"/>
                  </a:lnTo>
                  <a:lnTo>
                    <a:pt x="612" y="39"/>
                  </a:lnTo>
                  <a:lnTo>
                    <a:pt x="625" y="39"/>
                  </a:lnTo>
                  <a:lnTo>
                    <a:pt x="632" y="39"/>
                  </a:lnTo>
                  <a:lnTo>
                    <a:pt x="649" y="39"/>
                  </a:lnTo>
                  <a:lnTo>
                    <a:pt x="654" y="39"/>
                  </a:lnTo>
                  <a:lnTo>
                    <a:pt x="659" y="39"/>
                  </a:lnTo>
                  <a:lnTo>
                    <a:pt x="665" y="39"/>
                  </a:lnTo>
                  <a:lnTo>
                    <a:pt x="671" y="39"/>
                  </a:lnTo>
                  <a:lnTo>
                    <a:pt x="688" y="39"/>
                  </a:lnTo>
                  <a:lnTo>
                    <a:pt x="709" y="39"/>
                  </a:lnTo>
                  <a:lnTo>
                    <a:pt x="723" y="39"/>
                  </a:lnTo>
                  <a:lnTo>
                    <a:pt x="730" y="39"/>
                  </a:lnTo>
                  <a:lnTo>
                    <a:pt x="730" y="0"/>
                  </a:lnTo>
                  <a:lnTo>
                    <a:pt x="734" y="0"/>
                  </a:lnTo>
                  <a:lnTo>
                    <a:pt x="741" y="0"/>
                  </a:lnTo>
                  <a:lnTo>
                    <a:pt x="744" y="0"/>
                  </a:lnTo>
                  <a:lnTo>
                    <a:pt x="760" y="0"/>
                  </a:lnTo>
                  <a:lnTo>
                    <a:pt x="764" y="0"/>
                  </a:lnTo>
                  <a:lnTo>
                    <a:pt x="779" y="0"/>
                  </a:lnTo>
                  <a:lnTo>
                    <a:pt x="781" y="0"/>
                  </a:lnTo>
                  <a:lnTo>
                    <a:pt x="790" y="0"/>
                  </a:lnTo>
                  <a:lnTo>
                    <a:pt x="793" y="0"/>
                  </a:lnTo>
                  <a:lnTo>
                    <a:pt x="801" y="0"/>
                  </a:lnTo>
                  <a:lnTo>
                    <a:pt x="818" y="0"/>
                  </a:lnTo>
                  <a:lnTo>
                    <a:pt x="823" y="0"/>
                  </a:lnTo>
                  <a:lnTo>
                    <a:pt x="835" y="0"/>
                  </a:lnTo>
                  <a:lnTo>
                    <a:pt x="841" y="0"/>
                  </a:lnTo>
                  <a:lnTo>
                    <a:pt x="851" y="0"/>
                  </a:lnTo>
                  <a:lnTo>
                    <a:pt x="854" y="0"/>
                  </a:lnTo>
                  <a:lnTo>
                    <a:pt x="860" y="0"/>
                  </a:lnTo>
                  <a:lnTo>
                    <a:pt x="867" y="0"/>
                  </a:lnTo>
                  <a:lnTo>
                    <a:pt x="883" y="0"/>
                  </a:lnTo>
                  <a:lnTo>
                    <a:pt x="892" y="0"/>
                  </a:lnTo>
                  <a:lnTo>
                    <a:pt x="900" y="0"/>
                  </a:lnTo>
                  <a:lnTo>
                    <a:pt x="925" y="0"/>
                  </a:lnTo>
                  <a:lnTo>
                    <a:pt x="946" y="0"/>
                  </a:lnTo>
                  <a:lnTo>
                    <a:pt x="950" y="0"/>
                  </a:lnTo>
                  <a:lnTo>
                    <a:pt x="986" y="0"/>
                  </a:lnTo>
                  <a:lnTo>
                    <a:pt x="991" y="0"/>
                  </a:lnTo>
                  <a:lnTo>
                    <a:pt x="1009" y="0"/>
                  </a:lnTo>
                  <a:lnTo>
                    <a:pt x="1029" y="0"/>
                  </a:lnTo>
                  <a:lnTo>
                    <a:pt x="1036" y="0"/>
                  </a:lnTo>
                  <a:lnTo>
                    <a:pt x="1082" y="0"/>
                  </a:lnTo>
                  <a:lnTo>
                    <a:pt x="1089" y="0"/>
                  </a:lnTo>
                  <a:lnTo>
                    <a:pt x="1100" y="0"/>
                  </a:lnTo>
                  <a:lnTo>
                    <a:pt x="1115" y="0"/>
                  </a:lnTo>
                  <a:lnTo>
                    <a:pt x="1118" y="0"/>
                  </a:lnTo>
                  <a:lnTo>
                    <a:pt x="1151" y="0"/>
                  </a:lnTo>
                  <a:lnTo>
                    <a:pt x="1162" y="0"/>
                  </a:lnTo>
                  <a:lnTo>
                    <a:pt x="1230" y="0"/>
                  </a:lnTo>
                  <a:lnTo>
                    <a:pt x="1287" y="0"/>
                  </a:lnTo>
                </a:path>
              </a:pathLst>
            </a:custGeom>
            <a:noFill/>
            <a:ln w="28575" cap="flat">
              <a:solidFill>
                <a:srgbClr val="39B14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Freeform 140">
              <a:extLst>
                <a:ext uri="{FF2B5EF4-FFF2-40B4-BE49-F238E27FC236}">
                  <a16:creationId xmlns:a16="http://schemas.microsoft.com/office/drawing/2014/main" id="{C37AAC5F-B1B9-E330-A5FF-715E023E5C96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4971" y="5244580"/>
              <a:ext cx="2544533" cy="712143"/>
            </a:xfrm>
            <a:custGeom>
              <a:avLst/>
              <a:gdLst>
                <a:gd name="T0" fmla="*/ 92 w 1353"/>
                <a:gd name="T1" fmla="*/ 376 h 386"/>
                <a:gd name="T2" fmla="*/ 126 w 1353"/>
                <a:gd name="T3" fmla="*/ 366 h 386"/>
                <a:gd name="T4" fmla="*/ 138 w 1353"/>
                <a:gd name="T5" fmla="*/ 351 h 386"/>
                <a:gd name="T6" fmla="*/ 150 w 1353"/>
                <a:gd name="T7" fmla="*/ 337 h 386"/>
                <a:gd name="T8" fmla="*/ 160 w 1353"/>
                <a:gd name="T9" fmla="*/ 327 h 386"/>
                <a:gd name="T10" fmla="*/ 172 w 1353"/>
                <a:gd name="T11" fmla="*/ 312 h 386"/>
                <a:gd name="T12" fmla="*/ 182 w 1353"/>
                <a:gd name="T13" fmla="*/ 297 h 386"/>
                <a:gd name="T14" fmla="*/ 199 w 1353"/>
                <a:gd name="T15" fmla="*/ 282 h 386"/>
                <a:gd name="T16" fmla="*/ 208 w 1353"/>
                <a:gd name="T17" fmla="*/ 272 h 386"/>
                <a:gd name="T18" fmla="*/ 229 w 1353"/>
                <a:gd name="T19" fmla="*/ 267 h 386"/>
                <a:gd name="T20" fmla="*/ 241 w 1353"/>
                <a:gd name="T21" fmla="*/ 251 h 386"/>
                <a:gd name="T22" fmla="*/ 252 w 1353"/>
                <a:gd name="T23" fmla="*/ 241 h 386"/>
                <a:gd name="T24" fmla="*/ 266 w 1353"/>
                <a:gd name="T25" fmla="*/ 230 h 386"/>
                <a:gd name="T26" fmla="*/ 280 w 1353"/>
                <a:gd name="T27" fmla="*/ 225 h 386"/>
                <a:gd name="T28" fmla="*/ 308 w 1353"/>
                <a:gd name="T29" fmla="*/ 225 h 386"/>
                <a:gd name="T30" fmla="*/ 325 w 1353"/>
                <a:gd name="T31" fmla="*/ 214 h 386"/>
                <a:gd name="T32" fmla="*/ 339 w 1353"/>
                <a:gd name="T33" fmla="*/ 197 h 386"/>
                <a:gd name="T34" fmla="*/ 352 w 1353"/>
                <a:gd name="T35" fmla="*/ 191 h 386"/>
                <a:gd name="T36" fmla="*/ 373 w 1353"/>
                <a:gd name="T37" fmla="*/ 185 h 386"/>
                <a:gd name="T38" fmla="*/ 391 w 1353"/>
                <a:gd name="T39" fmla="*/ 179 h 386"/>
                <a:gd name="T40" fmla="*/ 408 w 1353"/>
                <a:gd name="T41" fmla="*/ 173 h 386"/>
                <a:gd name="T42" fmla="*/ 425 w 1353"/>
                <a:gd name="T43" fmla="*/ 167 h 386"/>
                <a:gd name="T44" fmla="*/ 445 w 1353"/>
                <a:gd name="T45" fmla="*/ 160 h 386"/>
                <a:gd name="T46" fmla="*/ 455 w 1353"/>
                <a:gd name="T47" fmla="*/ 147 h 386"/>
                <a:gd name="T48" fmla="*/ 471 w 1353"/>
                <a:gd name="T49" fmla="*/ 127 h 386"/>
                <a:gd name="T50" fmla="*/ 492 w 1353"/>
                <a:gd name="T51" fmla="*/ 120 h 386"/>
                <a:gd name="T52" fmla="*/ 528 w 1353"/>
                <a:gd name="T53" fmla="*/ 120 h 386"/>
                <a:gd name="T54" fmla="*/ 558 w 1353"/>
                <a:gd name="T55" fmla="*/ 120 h 386"/>
                <a:gd name="T56" fmla="*/ 582 w 1353"/>
                <a:gd name="T57" fmla="*/ 112 h 386"/>
                <a:gd name="T58" fmla="*/ 599 w 1353"/>
                <a:gd name="T59" fmla="*/ 105 h 386"/>
                <a:gd name="T60" fmla="*/ 618 w 1353"/>
                <a:gd name="T61" fmla="*/ 97 h 386"/>
                <a:gd name="T62" fmla="*/ 635 w 1353"/>
                <a:gd name="T63" fmla="*/ 89 h 386"/>
                <a:gd name="T64" fmla="*/ 654 w 1353"/>
                <a:gd name="T65" fmla="*/ 80 h 386"/>
                <a:gd name="T66" fmla="*/ 681 w 1353"/>
                <a:gd name="T67" fmla="*/ 71 h 386"/>
                <a:gd name="T68" fmla="*/ 697 w 1353"/>
                <a:gd name="T69" fmla="*/ 61 h 386"/>
                <a:gd name="T70" fmla="*/ 715 w 1353"/>
                <a:gd name="T71" fmla="*/ 51 h 386"/>
                <a:gd name="T72" fmla="*/ 737 w 1353"/>
                <a:gd name="T73" fmla="*/ 51 h 386"/>
                <a:gd name="T74" fmla="*/ 756 w 1353"/>
                <a:gd name="T75" fmla="*/ 39 h 386"/>
                <a:gd name="T76" fmla="*/ 775 w 1353"/>
                <a:gd name="T77" fmla="*/ 27 h 386"/>
                <a:gd name="T78" fmla="*/ 788 w 1353"/>
                <a:gd name="T79" fmla="*/ 0 h 386"/>
                <a:gd name="T80" fmla="*/ 822 w 1353"/>
                <a:gd name="T81" fmla="*/ 0 h 386"/>
                <a:gd name="T82" fmla="*/ 852 w 1353"/>
                <a:gd name="T83" fmla="*/ 0 h 386"/>
                <a:gd name="T84" fmla="*/ 882 w 1353"/>
                <a:gd name="T85" fmla="*/ 0 h 386"/>
                <a:gd name="T86" fmla="*/ 907 w 1353"/>
                <a:gd name="T87" fmla="*/ 0 h 386"/>
                <a:gd name="T88" fmla="*/ 933 w 1353"/>
                <a:gd name="T89" fmla="*/ 0 h 386"/>
                <a:gd name="T90" fmla="*/ 960 w 1353"/>
                <a:gd name="T91" fmla="*/ 0 h 386"/>
                <a:gd name="T92" fmla="*/ 991 w 1353"/>
                <a:gd name="T93" fmla="*/ 0 h 386"/>
                <a:gd name="T94" fmla="*/ 1033 w 1353"/>
                <a:gd name="T95" fmla="*/ 0 h 386"/>
                <a:gd name="T96" fmla="*/ 1071 w 1353"/>
                <a:gd name="T97" fmla="*/ 0 h 386"/>
                <a:gd name="T98" fmla="*/ 1095 w 1353"/>
                <a:gd name="T99" fmla="*/ 0 h 386"/>
                <a:gd name="T100" fmla="*/ 1128 w 1353"/>
                <a:gd name="T101" fmla="*/ 0 h 386"/>
                <a:gd name="T102" fmla="*/ 1161 w 1353"/>
                <a:gd name="T103" fmla="*/ 0 h 386"/>
                <a:gd name="T104" fmla="*/ 1197 w 1353"/>
                <a:gd name="T105" fmla="*/ 0 h 386"/>
                <a:gd name="T106" fmla="*/ 1259 w 1353"/>
                <a:gd name="T107" fmla="*/ 0 h 386"/>
                <a:gd name="T108" fmla="*/ 1321 w 1353"/>
                <a:gd name="T109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1353" h="386">
                  <a:moveTo>
                    <a:pt x="0" y="386"/>
                  </a:moveTo>
                  <a:lnTo>
                    <a:pt x="85" y="386"/>
                  </a:lnTo>
                  <a:lnTo>
                    <a:pt x="85" y="376"/>
                  </a:lnTo>
                  <a:lnTo>
                    <a:pt x="92" y="376"/>
                  </a:lnTo>
                  <a:lnTo>
                    <a:pt x="105" y="376"/>
                  </a:lnTo>
                  <a:lnTo>
                    <a:pt x="110" y="371"/>
                  </a:lnTo>
                  <a:lnTo>
                    <a:pt x="110" y="366"/>
                  </a:lnTo>
                  <a:lnTo>
                    <a:pt x="126" y="366"/>
                  </a:lnTo>
                  <a:lnTo>
                    <a:pt x="126" y="361"/>
                  </a:lnTo>
                  <a:lnTo>
                    <a:pt x="136" y="361"/>
                  </a:lnTo>
                  <a:lnTo>
                    <a:pt x="136" y="356"/>
                  </a:lnTo>
                  <a:lnTo>
                    <a:pt x="138" y="351"/>
                  </a:lnTo>
                  <a:lnTo>
                    <a:pt x="143" y="351"/>
                  </a:lnTo>
                  <a:lnTo>
                    <a:pt x="143" y="347"/>
                  </a:lnTo>
                  <a:lnTo>
                    <a:pt x="150" y="342"/>
                  </a:lnTo>
                  <a:lnTo>
                    <a:pt x="150" y="337"/>
                  </a:lnTo>
                  <a:lnTo>
                    <a:pt x="153" y="332"/>
                  </a:lnTo>
                  <a:lnTo>
                    <a:pt x="157" y="332"/>
                  </a:lnTo>
                  <a:lnTo>
                    <a:pt x="160" y="332"/>
                  </a:lnTo>
                  <a:lnTo>
                    <a:pt x="160" y="327"/>
                  </a:lnTo>
                  <a:lnTo>
                    <a:pt x="163" y="322"/>
                  </a:lnTo>
                  <a:lnTo>
                    <a:pt x="167" y="317"/>
                  </a:lnTo>
                  <a:lnTo>
                    <a:pt x="172" y="317"/>
                  </a:lnTo>
                  <a:lnTo>
                    <a:pt x="172" y="312"/>
                  </a:lnTo>
                  <a:lnTo>
                    <a:pt x="177" y="307"/>
                  </a:lnTo>
                  <a:lnTo>
                    <a:pt x="181" y="307"/>
                  </a:lnTo>
                  <a:lnTo>
                    <a:pt x="181" y="302"/>
                  </a:lnTo>
                  <a:lnTo>
                    <a:pt x="182" y="297"/>
                  </a:lnTo>
                  <a:lnTo>
                    <a:pt x="183" y="292"/>
                  </a:lnTo>
                  <a:lnTo>
                    <a:pt x="190" y="292"/>
                  </a:lnTo>
                  <a:lnTo>
                    <a:pt x="195" y="282"/>
                  </a:lnTo>
                  <a:lnTo>
                    <a:pt x="199" y="282"/>
                  </a:lnTo>
                  <a:lnTo>
                    <a:pt x="199" y="277"/>
                  </a:lnTo>
                  <a:lnTo>
                    <a:pt x="203" y="277"/>
                  </a:lnTo>
                  <a:lnTo>
                    <a:pt x="203" y="272"/>
                  </a:lnTo>
                  <a:lnTo>
                    <a:pt x="208" y="272"/>
                  </a:lnTo>
                  <a:lnTo>
                    <a:pt x="216" y="272"/>
                  </a:lnTo>
                  <a:lnTo>
                    <a:pt x="216" y="267"/>
                  </a:lnTo>
                  <a:lnTo>
                    <a:pt x="220" y="267"/>
                  </a:lnTo>
                  <a:lnTo>
                    <a:pt x="229" y="267"/>
                  </a:lnTo>
                  <a:lnTo>
                    <a:pt x="236" y="267"/>
                  </a:lnTo>
                  <a:lnTo>
                    <a:pt x="236" y="262"/>
                  </a:lnTo>
                  <a:lnTo>
                    <a:pt x="241" y="262"/>
                  </a:lnTo>
                  <a:lnTo>
                    <a:pt x="241" y="251"/>
                  </a:lnTo>
                  <a:lnTo>
                    <a:pt x="249" y="251"/>
                  </a:lnTo>
                  <a:lnTo>
                    <a:pt x="251" y="251"/>
                  </a:lnTo>
                  <a:lnTo>
                    <a:pt x="251" y="246"/>
                  </a:lnTo>
                  <a:lnTo>
                    <a:pt x="252" y="241"/>
                  </a:lnTo>
                  <a:lnTo>
                    <a:pt x="253" y="235"/>
                  </a:lnTo>
                  <a:lnTo>
                    <a:pt x="256" y="235"/>
                  </a:lnTo>
                  <a:lnTo>
                    <a:pt x="266" y="235"/>
                  </a:lnTo>
                  <a:lnTo>
                    <a:pt x="266" y="230"/>
                  </a:lnTo>
                  <a:lnTo>
                    <a:pt x="269" y="230"/>
                  </a:lnTo>
                  <a:lnTo>
                    <a:pt x="269" y="225"/>
                  </a:lnTo>
                  <a:lnTo>
                    <a:pt x="276" y="225"/>
                  </a:lnTo>
                  <a:lnTo>
                    <a:pt x="280" y="225"/>
                  </a:lnTo>
                  <a:lnTo>
                    <a:pt x="286" y="225"/>
                  </a:lnTo>
                  <a:lnTo>
                    <a:pt x="292" y="225"/>
                  </a:lnTo>
                  <a:lnTo>
                    <a:pt x="299" y="225"/>
                  </a:lnTo>
                  <a:lnTo>
                    <a:pt x="308" y="225"/>
                  </a:lnTo>
                  <a:lnTo>
                    <a:pt x="316" y="225"/>
                  </a:lnTo>
                  <a:lnTo>
                    <a:pt x="321" y="219"/>
                  </a:lnTo>
                  <a:lnTo>
                    <a:pt x="322" y="219"/>
                  </a:lnTo>
                  <a:lnTo>
                    <a:pt x="325" y="214"/>
                  </a:lnTo>
                  <a:lnTo>
                    <a:pt x="328" y="208"/>
                  </a:lnTo>
                  <a:lnTo>
                    <a:pt x="330" y="208"/>
                  </a:lnTo>
                  <a:lnTo>
                    <a:pt x="339" y="202"/>
                  </a:lnTo>
                  <a:lnTo>
                    <a:pt x="339" y="197"/>
                  </a:lnTo>
                  <a:lnTo>
                    <a:pt x="345" y="197"/>
                  </a:lnTo>
                  <a:lnTo>
                    <a:pt x="345" y="191"/>
                  </a:lnTo>
                  <a:lnTo>
                    <a:pt x="349" y="191"/>
                  </a:lnTo>
                  <a:lnTo>
                    <a:pt x="352" y="191"/>
                  </a:lnTo>
                  <a:lnTo>
                    <a:pt x="355" y="185"/>
                  </a:lnTo>
                  <a:lnTo>
                    <a:pt x="358" y="185"/>
                  </a:lnTo>
                  <a:lnTo>
                    <a:pt x="369" y="185"/>
                  </a:lnTo>
                  <a:lnTo>
                    <a:pt x="373" y="185"/>
                  </a:lnTo>
                  <a:lnTo>
                    <a:pt x="378" y="185"/>
                  </a:lnTo>
                  <a:lnTo>
                    <a:pt x="382" y="179"/>
                  </a:lnTo>
                  <a:lnTo>
                    <a:pt x="383" y="179"/>
                  </a:lnTo>
                  <a:lnTo>
                    <a:pt x="391" y="179"/>
                  </a:lnTo>
                  <a:lnTo>
                    <a:pt x="395" y="179"/>
                  </a:lnTo>
                  <a:lnTo>
                    <a:pt x="402" y="179"/>
                  </a:lnTo>
                  <a:lnTo>
                    <a:pt x="408" y="179"/>
                  </a:lnTo>
                  <a:lnTo>
                    <a:pt x="408" y="173"/>
                  </a:lnTo>
                  <a:lnTo>
                    <a:pt x="415" y="173"/>
                  </a:lnTo>
                  <a:lnTo>
                    <a:pt x="420" y="173"/>
                  </a:lnTo>
                  <a:lnTo>
                    <a:pt x="421" y="167"/>
                  </a:lnTo>
                  <a:lnTo>
                    <a:pt x="425" y="167"/>
                  </a:lnTo>
                  <a:lnTo>
                    <a:pt x="434" y="167"/>
                  </a:lnTo>
                  <a:lnTo>
                    <a:pt x="434" y="160"/>
                  </a:lnTo>
                  <a:lnTo>
                    <a:pt x="437" y="160"/>
                  </a:lnTo>
                  <a:lnTo>
                    <a:pt x="445" y="160"/>
                  </a:lnTo>
                  <a:lnTo>
                    <a:pt x="445" y="153"/>
                  </a:lnTo>
                  <a:lnTo>
                    <a:pt x="447" y="147"/>
                  </a:lnTo>
                  <a:lnTo>
                    <a:pt x="449" y="147"/>
                  </a:lnTo>
                  <a:lnTo>
                    <a:pt x="455" y="147"/>
                  </a:lnTo>
                  <a:lnTo>
                    <a:pt x="458" y="140"/>
                  </a:lnTo>
                  <a:lnTo>
                    <a:pt x="461" y="140"/>
                  </a:lnTo>
                  <a:lnTo>
                    <a:pt x="461" y="127"/>
                  </a:lnTo>
                  <a:lnTo>
                    <a:pt x="471" y="127"/>
                  </a:lnTo>
                  <a:lnTo>
                    <a:pt x="481" y="127"/>
                  </a:lnTo>
                  <a:lnTo>
                    <a:pt x="484" y="127"/>
                  </a:lnTo>
                  <a:lnTo>
                    <a:pt x="492" y="127"/>
                  </a:lnTo>
                  <a:lnTo>
                    <a:pt x="492" y="120"/>
                  </a:lnTo>
                  <a:lnTo>
                    <a:pt x="497" y="120"/>
                  </a:lnTo>
                  <a:lnTo>
                    <a:pt x="511" y="120"/>
                  </a:lnTo>
                  <a:lnTo>
                    <a:pt x="516" y="120"/>
                  </a:lnTo>
                  <a:lnTo>
                    <a:pt x="528" y="120"/>
                  </a:lnTo>
                  <a:lnTo>
                    <a:pt x="538" y="120"/>
                  </a:lnTo>
                  <a:lnTo>
                    <a:pt x="540" y="120"/>
                  </a:lnTo>
                  <a:lnTo>
                    <a:pt x="554" y="120"/>
                  </a:lnTo>
                  <a:lnTo>
                    <a:pt x="558" y="120"/>
                  </a:lnTo>
                  <a:lnTo>
                    <a:pt x="570" y="120"/>
                  </a:lnTo>
                  <a:lnTo>
                    <a:pt x="575" y="120"/>
                  </a:lnTo>
                  <a:lnTo>
                    <a:pt x="582" y="120"/>
                  </a:lnTo>
                  <a:lnTo>
                    <a:pt x="582" y="112"/>
                  </a:lnTo>
                  <a:lnTo>
                    <a:pt x="587" y="112"/>
                  </a:lnTo>
                  <a:lnTo>
                    <a:pt x="587" y="105"/>
                  </a:lnTo>
                  <a:lnTo>
                    <a:pt x="593" y="105"/>
                  </a:lnTo>
                  <a:lnTo>
                    <a:pt x="599" y="105"/>
                  </a:lnTo>
                  <a:lnTo>
                    <a:pt x="600" y="97"/>
                  </a:lnTo>
                  <a:lnTo>
                    <a:pt x="605" y="97"/>
                  </a:lnTo>
                  <a:lnTo>
                    <a:pt x="612" y="97"/>
                  </a:lnTo>
                  <a:lnTo>
                    <a:pt x="618" y="97"/>
                  </a:lnTo>
                  <a:lnTo>
                    <a:pt x="624" y="97"/>
                  </a:lnTo>
                  <a:lnTo>
                    <a:pt x="631" y="97"/>
                  </a:lnTo>
                  <a:lnTo>
                    <a:pt x="633" y="89"/>
                  </a:lnTo>
                  <a:lnTo>
                    <a:pt x="635" y="89"/>
                  </a:lnTo>
                  <a:lnTo>
                    <a:pt x="644" y="89"/>
                  </a:lnTo>
                  <a:lnTo>
                    <a:pt x="648" y="89"/>
                  </a:lnTo>
                  <a:lnTo>
                    <a:pt x="653" y="80"/>
                  </a:lnTo>
                  <a:lnTo>
                    <a:pt x="654" y="80"/>
                  </a:lnTo>
                  <a:lnTo>
                    <a:pt x="660" y="80"/>
                  </a:lnTo>
                  <a:lnTo>
                    <a:pt x="669" y="80"/>
                  </a:lnTo>
                  <a:lnTo>
                    <a:pt x="678" y="80"/>
                  </a:lnTo>
                  <a:lnTo>
                    <a:pt x="681" y="71"/>
                  </a:lnTo>
                  <a:lnTo>
                    <a:pt x="685" y="71"/>
                  </a:lnTo>
                  <a:lnTo>
                    <a:pt x="688" y="61"/>
                  </a:lnTo>
                  <a:lnTo>
                    <a:pt x="690" y="61"/>
                  </a:lnTo>
                  <a:lnTo>
                    <a:pt x="697" y="61"/>
                  </a:lnTo>
                  <a:lnTo>
                    <a:pt x="697" y="51"/>
                  </a:lnTo>
                  <a:lnTo>
                    <a:pt x="705" y="51"/>
                  </a:lnTo>
                  <a:lnTo>
                    <a:pt x="710" y="51"/>
                  </a:lnTo>
                  <a:lnTo>
                    <a:pt x="715" y="51"/>
                  </a:lnTo>
                  <a:lnTo>
                    <a:pt x="721" y="51"/>
                  </a:lnTo>
                  <a:lnTo>
                    <a:pt x="728" y="51"/>
                  </a:lnTo>
                  <a:lnTo>
                    <a:pt x="731" y="51"/>
                  </a:lnTo>
                  <a:lnTo>
                    <a:pt x="737" y="51"/>
                  </a:lnTo>
                  <a:lnTo>
                    <a:pt x="744" y="51"/>
                  </a:lnTo>
                  <a:lnTo>
                    <a:pt x="750" y="51"/>
                  </a:lnTo>
                  <a:lnTo>
                    <a:pt x="755" y="39"/>
                  </a:lnTo>
                  <a:lnTo>
                    <a:pt x="756" y="39"/>
                  </a:lnTo>
                  <a:lnTo>
                    <a:pt x="757" y="27"/>
                  </a:lnTo>
                  <a:lnTo>
                    <a:pt x="765" y="27"/>
                  </a:lnTo>
                  <a:lnTo>
                    <a:pt x="771" y="27"/>
                  </a:lnTo>
                  <a:lnTo>
                    <a:pt x="775" y="27"/>
                  </a:lnTo>
                  <a:lnTo>
                    <a:pt x="781" y="27"/>
                  </a:lnTo>
                  <a:lnTo>
                    <a:pt x="781" y="14"/>
                  </a:lnTo>
                  <a:lnTo>
                    <a:pt x="785" y="0"/>
                  </a:lnTo>
                  <a:lnTo>
                    <a:pt x="788" y="0"/>
                  </a:lnTo>
                  <a:lnTo>
                    <a:pt x="793" y="0"/>
                  </a:lnTo>
                  <a:lnTo>
                    <a:pt x="800" y="0"/>
                  </a:lnTo>
                  <a:lnTo>
                    <a:pt x="807" y="0"/>
                  </a:lnTo>
                  <a:lnTo>
                    <a:pt x="822" y="0"/>
                  </a:lnTo>
                  <a:lnTo>
                    <a:pt x="832" y="0"/>
                  </a:lnTo>
                  <a:lnTo>
                    <a:pt x="837" y="0"/>
                  </a:lnTo>
                  <a:lnTo>
                    <a:pt x="846" y="0"/>
                  </a:lnTo>
                  <a:lnTo>
                    <a:pt x="852" y="0"/>
                  </a:lnTo>
                  <a:lnTo>
                    <a:pt x="858" y="0"/>
                  </a:lnTo>
                  <a:lnTo>
                    <a:pt x="872" y="0"/>
                  </a:lnTo>
                  <a:lnTo>
                    <a:pt x="879" y="0"/>
                  </a:lnTo>
                  <a:lnTo>
                    <a:pt x="882" y="0"/>
                  </a:lnTo>
                  <a:lnTo>
                    <a:pt x="891" y="0"/>
                  </a:lnTo>
                  <a:lnTo>
                    <a:pt x="894" y="0"/>
                  </a:lnTo>
                  <a:lnTo>
                    <a:pt x="900" y="0"/>
                  </a:lnTo>
                  <a:lnTo>
                    <a:pt x="907" y="0"/>
                  </a:lnTo>
                  <a:lnTo>
                    <a:pt x="912" y="0"/>
                  </a:lnTo>
                  <a:lnTo>
                    <a:pt x="918" y="0"/>
                  </a:lnTo>
                  <a:lnTo>
                    <a:pt x="927" y="0"/>
                  </a:lnTo>
                  <a:lnTo>
                    <a:pt x="933" y="0"/>
                  </a:lnTo>
                  <a:lnTo>
                    <a:pt x="937" y="0"/>
                  </a:lnTo>
                  <a:lnTo>
                    <a:pt x="945" y="0"/>
                  </a:lnTo>
                  <a:lnTo>
                    <a:pt x="949" y="0"/>
                  </a:lnTo>
                  <a:lnTo>
                    <a:pt x="960" y="0"/>
                  </a:lnTo>
                  <a:lnTo>
                    <a:pt x="962" y="0"/>
                  </a:lnTo>
                  <a:lnTo>
                    <a:pt x="969" y="0"/>
                  </a:lnTo>
                  <a:lnTo>
                    <a:pt x="990" y="0"/>
                  </a:lnTo>
                  <a:lnTo>
                    <a:pt x="991" y="0"/>
                  </a:lnTo>
                  <a:lnTo>
                    <a:pt x="997" y="0"/>
                  </a:lnTo>
                  <a:lnTo>
                    <a:pt x="1003" y="0"/>
                  </a:lnTo>
                  <a:lnTo>
                    <a:pt x="1027" y="0"/>
                  </a:lnTo>
                  <a:lnTo>
                    <a:pt x="1033" y="0"/>
                  </a:lnTo>
                  <a:lnTo>
                    <a:pt x="1041" y="0"/>
                  </a:lnTo>
                  <a:lnTo>
                    <a:pt x="1058" y="0"/>
                  </a:lnTo>
                  <a:lnTo>
                    <a:pt x="1065" y="0"/>
                  </a:lnTo>
                  <a:lnTo>
                    <a:pt x="1071" y="0"/>
                  </a:lnTo>
                  <a:lnTo>
                    <a:pt x="1078" y="0"/>
                  </a:lnTo>
                  <a:lnTo>
                    <a:pt x="1081" y="0"/>
                  </a:lnTo>
                  <a:lnTo>
                    <a:pt x="1087" y="0"/>
                  </a:lnTo>
                  <a:lnTo>
                    <a:pt x="1095" y="0"/>
                  </a:lnTo>
                  <a:lnTo>
                    <a:pt x="1102" y="0"/>
                  </a:lnTo>
                  <a:lnTo>
                    <a:pt x="1109" y="0"/>
                  </a:lnTo>
                  <a:lnTo>
                    <a:pt x="1120" y="0"/>
                  </a:lnTo>
                  <a:lnTo>
                    <a:pt x="1128" y="0"/>
                  </a:lnTo>
                  <a:lnTo>
                    <a:pt x="1138" y="0"/>
                  </a:lnTo>
                  <a:lnTo>
                    <a:pt x="1150" y="0"/>
                  </a:lnTo>
                  <a:lnTo>
                    <a:pt x="1156" y="0"/>
                  </a:lnTo>
                  <a:lnTo>
                    <a:pt x="1161" y="0"/>
                  </a:lnTo>
                  <a:lnTo>
                    <a:pt x="1174" y="0"/>
                  </a:lnTo>
                  <a:lnTo>
                    <a:pt x="1177" y="0"/>
                  </a:lnTo>
                  <a:lnTo>
                    <a:pt x="1191" y="0"/>
                  </a:lnTo>
                  <a:lnTo>
                    <a:pt x="1197" y="0"/>
                  </a:lnTo>
                  <a:lnTo>
                    <a:pt x="1223" y="0"/>
                  </a:lnTo>
                  <a:lnTo>
                    <a:pt x="1247" y="0"/>
                  </a:lnTo>
                  <a:lnTo>
                    <a:pt x="1253" y="0"/>
                  </a:lnTo>
                  <a:lnTo>
                    <a:pt x="1259" y="0"/>
                  </a:lnTo>
                  <a:lnTo>
                    <a:pt x="1281" y="0"/>
                  </a:lnTo>
                  <a:lnTo>
                    <a:pt x="1286" y="0"/>
                  </a:lnTo>
                  <a:lnTo>
                    <a:pt x="1300" y="0"/>
                  </a:lnTo>
                  <a:lnTo>
                    <a:pt x="1321" y="0"/>
                  </a:lnTo>
                  <a:lnTo>
                    <a:pt x="1343" y="0"/>
                  </a:lnTo>
                  <a:lnTo>
                    <a:pt x="1353" y="0"/>
                  </a:lnTo>
                </a:path>
              </a:pathLst>
            </a:custGeom>
            <a:noFill/>
            <a:ln w="28575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BCD2B9-6BC8-BDB6-833B-8EF0C3C40112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27D71E5-A078-5831-4DE9-54FA5ECBCFE2}"/>
              </a:ext>
            </a:extLst>
          </p:cNvPr>
          <p:cNvSpPr txBox="1"/>
          <p:nvPr/>
        </p:nvSpPr>
        <p:spPr>
          <a:xfrm>
            <a:off x="886249" y="38268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2416637-C739-6487-96BA-7DDCD6BF913B}"/>
              </a:ext>
            </a:extLst>
          </p:cNvPr>
          <p:cNvSpPr txBox="1"/>
          <p:nvPr/>
        </p:nvSpPr>
        <p:spPr>
          <a:xfrm>
            <a:off x="6010058" y="382681"/>
            <a:ext cx="38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A3DE228-A4AB-8C33-EE05-3932BBE5B2B3}"/>
              </a:ext>
            </a:extLst>
          </p:cNvPr>
          <p:cNvSpPr txBox="1"/>
          <p:nvPr/>
        </p:nvSpPr>
        <p:spPr>
          <a:xfrm>
            <a:off x="886250" y="3325173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654D400-72EB-28D0-0954-12E0B26C702E}"/>
              </a:ext>
            </a:extLst>
          </p:cNvPr>
          <p:cNvSpPr txBox="1"/>
          <p:nvPr/>
        </p:nvSpPr>
        <p:spPr>
          <a:xfrm>
            <a:off x="6010059" y="3325174"/>
            <a:ext cx="39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D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42659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グループ化 140">
            <a:extLst>
              <a:ext uri="{FF2B5EF4-FFF2-40B4-BE49-F238E27FC236}">
                <a16:creationId xmlns:a16="http://schemas.microsoft.com/office/drawing/2014/main" id="{F7013330-9E51-8E22-3C03-323BE9318E7C}"/>
              </a:ext>
            </a:extLst>
          </p:cNvPr>
          <p:cNvGrpSpPr/>
          <p:nvPr/>
        </p:nvGrpSpPr>
        <p:grpSpPr>
          <a:xfrm>
            <a:off x="6319428" y="3643330"/>
            <a:ext cx="4141083" cy="2791354"/>
            <a:chOff x="1487880" y="741070"/>
            <a:chExt cx="4141083" cy="2791354"/>
          </a:xfrm>
        </p:grpSpPr>
        <p:sp>
          <p:nvSpPr>
            <p:cNvPr id="142" name="Rectangle 22">
              <a:extLst>
                <a:ext uri="{FF2B5EF4-FFF2-40B4-BE49-F238E27FC236}">
                  <a16:creationId xmlns:a16="http://schemas.microsoft.com/office/drawing/2014/main" id="{BA599720-7E88-3BC8-D301-64D308F850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3" name="Line 23">
              <a:extLst>
                <a:ext uri="{FF2B5EF4-FFF2-40B4-BE49-F238E27FC236}">
                  <a16:creationId xmlns:a16="http://schemas.microsoft.com/office/drawing/2014/main" id="{54DEAE32-F4F5-CA4E-F5B0-3557FAE79E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4" name="Line 25">
              <a:extLst>
                <a:ext uri="{FF2B5EF4-FFF2-40B4-BE49-F238E27FC236}">
                  <a16:creationId xmlns:a16="http://schemas.microsoft.com/office/drawing/2014/main" id="{A2D5E8EE-FAFB-AD4D-5984-3E78F349CA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5" name="Line 27">
              <a:extLst>
                <a:ext uri="{FF2B5EF4-FFF2-40B4-BE49-F238E27FC236}">
                  <a16:creationId xmlns:a16="http://schemas.microsoft.com/office/drawing/2014/main" id="{5DB41BE1-F997-6C3C-9DF0-A0F113C0D5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6" name="Line 29">
              <a:extLst>
                <a:ext uri="{FF2B5EF4-FFF2-40B4-BE49-F238E27FC236}">
                  <a16:creationId xmlns:a16="http://schemas.microsoft.com/office/drawing/2014/main" id="{ED38214D-EC02-E980-804F-6B253959A1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7" name="Line 31">
              <a:extLst>
                <a:ext uri="{FF2B5EF4-FFF2-40B4-BE49-F238E27FC236}">
                  <a16:creationId xmlns:a16="http://schemas.microsoft.com/office/drawing/2014/main" id="{B14879DC-D827-4AE8-1770-2ACD496077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8" name="Line 33">
              <a:extLst>
                <a:ext uri="{FF2B5EF4-FFF2-40B4-BE49-F238E27FC236}">
                  <a16:creationId xmlns:a16="http://schemas.microsoft.com/office/drawing/2014/main" id="{06D5CB23-4E7B-DBCE-1C64-7A1E14BA11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9" name="Line 35">
              <a:extLst>
                <a:ext uri="{FF2B5EF4-FFF2-40B4-BE49-F238E27FC236}">
                  <a16:creationId xmlns:a16="http://schemas.microsoft.com/office/drawing/2014/main" id="{F0FF1A52-FB27-745F-4AD8-59E503BC41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0" name="Line 6">
              <a:extLst>
                <a:ext uri="{FF2B5EF4-FFF2-40B4-BE49-F238E27FC236}">
                  <a16:creationId xmlns:a16="http://schemas.microsoft.com/office/drawing/2014/main" id="{A35DC27F-6280-353B-ADD0-63680D8E82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1" name="Line 8">
              <a:extLst>
                <a:ext uri="{FF2B5EF4-FFF2-40B4-BE49-F238E27FC236}">
                  <a16:creationId xmlns:a16="http://schemas.microsoft.com/office/drawing/2014/main" id="{FAE11857-D275-4593-EEAD-9D5BF52156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2" name="Line 9">
              <a:extLst>
                <a:ext uri="{FF2B5EF4-FFF2-40B4-BE49-F238E27FC236}">
                  <a16:creationId xmlns:a16="http://schemas.microsoft.com/office/drawing/2014/main" id="{D9EAB130-E9BA-8D59-F1D8-87EBAB5350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3" name="Line 11">
              <a:extLst>
                <a:ext uri="{FF2B5EF4-FFF2-40B4-BE49-F238E27FC236}">
                  <a16:creationId xmlns:a16="http://schemas.microsoft.com/office/drawing/2014/main" id="{5B540A3A-E121-9D83-613E-5BE210B171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4" name="Line 12">
              <a:extLst>
                <a:ext uri="{FF2B5EF4-FFF2-40B4-BE49-F238E27FC236}">
                  <a16:creationId xmlns:a16="http://schemas.microsoft.com/office/drawing/2014/main" id="{07C50F6F-81DB-7655-CF0A-1A82665474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5" name="Line 14">
              <a:extLst>
                <a:ext uri="{FF2B5EF4-FFF2-40B4-BE49-F238E27FC236}">
                  <a16:creationId xmlns:a16="http://schemas.microsoft.com/office/drawing/2014/main" id="{29A66B24-4F59-D5EF-A0B8-AC5C114A49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6" name="Line 23">
              <a:extLst>
                <a:ext uri="{FF2B5EF4-FFF2-40B4-BE49-F238E27FC236}">
                  <a16:creationId xmlns:a16="http://schemas.microsoft.com/office/drawing/2014/main" id="{578F6D0E-868B-0015-8109-8009B4C1AE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157" name="図形グループ 54">
              <a:extLst>
                <a:ext uri="{FF2B5EF4-FFF2-40B4-BE49-F238E27FC236}">
                  <a16:creationId xmlns:a16="http://schemas.microsoft.com/office/drawing/2014/main" id="{2AAA6E33-6FBE-54DD-8521-330F1356C1FE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164" name="Rectangle 10">
                <a:extLst>
                  <a:ext uri="{FF2B5EF4-FFF2-40B4-BE49-F238E27FC236}">
                    <a16:creationId xmlns:a16="http://schemas.microsoft.com/office/drawing/2014/main" id="{DFB4CE82-1D5C-1ACD-2B93-926184C7EE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5" name="Rectangle 13">
                <a:extLst>
                  <a:ext uri="{FF2B5EF4-FFF2-40B4-BE49-F238E27FC236}">
                    <a16:creationId xmlns:a16="http://schemas.microsoft.com/office/drawing/2014/main" id="{1748BB5F-7586-9267-8BF8-DA75780CAA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66" name="Rectangle 10">
                <a:extLst>
                  <a:ext uri="{FF2B5EF4-FFF2-40B4-BE49-F238E27FC236}">
                    <a16:creationId xmlns:a16="http://schemas.microsoft.com/office/drawing/2014/main" id="{79F6B16A-4DB0-9E3D-8445-1659B058D3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E8BB3E51-7F27-EE69-B12F-C57CCA54FF56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0DA0F85A-35C4-8E30-4768-E6E7B4F5368D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95BACCAC-61E8-4FFB-783B-2616CA13E45A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EF6BFE75-55E1-DF14-25FF-284C43EDA5FD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8829522B-59E0-DC33-297A-2E7C3B146CF4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9B8576AB-1515-D4B4-9D2F-DC475DD0D944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727B5219-8F5F-042D-2D53-01CA93BA6F7A}"/>
              </a:ext>
            </a:extLst>
          </p:cNvPr>
          <p:cNvGrpSpPr/>
          <p:nvPr/>
        </p:nvGrpSpPr>
        <p:grpSpPr>
          <a:xfrm>
            <a:off x="1200815" y="3636606"/>
            <a:ext cx="4141083" cy="2791354"/>
            <a:chOff x="1487880" y="741070"/>
            <a:chExt cx="4141083" cy="2791354"/>
          </a:xfrm>
        </p:grpSpPr>
        <p:sp>
          <p:nvSpPr>
            <p:cNvPr id="116" name="Rectangle 22">
              <a:extLst>
                <a:ext uri="{FF2B5EF4-FFF2-40B4-BE49-F238E27FC236}">
                  <a16:creationId xmlns:a16="http://schemas.microsoft.com/office/drawing/2014/main" id="{86CC5F82-6578-ADB2-E951-294A39C80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7" name="Line 23">
              <a:extLst>
                <a:ext uri="{FF2B5EF4-FFF2-40B4-BE49-F238E27FC236}">
                  <a16:creationId xmlns:a16="http://schemas.microsoft.com/office/drawing/2014/main" id="{B0C6DC00-D983-811D-BD2B-976B98ADEE9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8" name="Line 25">
              <a:extLst>
                <a:ext uri="{FF2B5EF4-FFF2-40B4-BE49-F238E27FC236}">
                  <a16:creationId xmlns:a16="http://schemas.microsoft.com/office/drawing/2014/main" id="{B51A1053-40ED-2BD1-EBA7-16FD71CD8F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9" name="Line 27">
              <a:extLst>
                <a:ext uri="{FF2B5EF4-FFF2-40B4-BE49-F238E27FC236}">
                  <a16:creationId xmlns:a16="http://schemas.microsoft.com/office/drawing/2014/main" id="{A42BB508-9B4A-1EC0-A182-7B57992B41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0" name="Line 29">
              <a:extLst>
                <a:ext uri="{FF2B5EF4-FFF2-40B4-BE49-F238E27FC236}">
                  <a16:creationId xmlns:a16="http://schemas.microsoft.com/office/drawing/2014/main" id="{B85797AB-B491-3505-1B42-478DC068E9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1" name="Line 31">
              <a:extLst>
                <a:ext uri="{FF2B5EF4-FFF2-40B4-BE49-F238E27FC236}">
                  <a16:creationId xmlns:a16="http://schemas.microsoft.com/office/drawing/2014/main" id="{96A40B12-794E-2D3E-CFE0-A48EA78094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2" name="Line 33">
              <a:extLst>
                <a:ext uri="{FF2B5EF4-FFF2-40B4-BE49-F238E27FC236}">
                  <a16:creationId xmlns:a16="http://schemas.microsoft.com/office/drawing/2014/main" id="{A691B7B5-4CC3-19F8-FF70-A08969CB20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3" name="Line 35">
              <a:extLst>
                <a:ext uri="{FF2B5EF4-FFF2-40B4-BE49-F238E27FC236}">
                  <a16:creationId xmlns:a16="http://schemas.microsoft.com/office/drawing/2014/main" id="{9522A849-1C2E-B86E-8447-2DE0AD8B9C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4" name="Line 6">
              <a:extLst>
                <a:ext uri="{FF2B5EF4-FFF2-40B4-BE49-F238E27FC236}">
                  <a16:creationId xmlns:a16="http://schemas.microsoft.com/office/drawing/2014/main" id="{09FD6458-E5A5-7B5E-EE09-C7225EDBAD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5" name="Line 8">
              <a:extLst>
                <a:ext uri="{FF2B5EF4-FFF2-40B4-BE49-F238E27FC236}">
                  <a16:creationId xmlns:a16="http://schemas.microsoft.com/office/drawing/2014/main" id="{D6E582BD-1987-B8EA-4D4D-9E8C9057FF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6" name="Line 9">
              <a:extLst>
                <a:ext uri="{FF2B5EF4-FFF2-40B4-BE49-F238E27FC236}">
                  <a16:creationId xmlns:a16="http://schemas.microsoft.com/office/drawing/2014/main" id="{D8F2A176-6F40-D599-0534-93643B9A06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7" name="Line 11">
              <a:extLst>
                <a:ext uri="{FF2B5EF4-FFF2-40B4-BE49-F238E27FC236}">
                  <a16:creationId xmlns:a16="http://schemas.microsoft.com/office/drawing/2014/main" id="{34826D9F-C381-21DC-C67F-E25AC466C4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8" name="Line 12">
              <a:extLst>
                <a:ext uri="{FF2B5EF4-FFF2-40B4-BE49-F238E27FC236}">
                  <a16:creationId xmlns:a16="http://schemas.microsoft.com/office/drawing/2014/main" id="{5A346EB4-7796-7FB5-B4C5-8CD8A95D70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29" name="Line 14">
              <a:extLst>
                <a:ext uri="{FF2B5EF4-FFF2-40B4-BE49-F238E27FC236}">
                  <a16:creationId xmlns:a16="http://schemas.microsoft.com/office/drawing/2014/main" id="{B84E56A1-9D7F-D982-1228-58D4D716BB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0" name="Line 23">
              <a:extLst>
                <a:ext uri="{FF2B5EF4-FFF2-40B4-BE49-F238E27FC236}">
                  <a16:creationId xmlns:a16="http://schemas.microsoft.com/office/drawing/2014/main" id="{DCA3F3E8-B0AC-CD00-0D6F-6876D41799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131" name="図形グループ 54">
              <a:extLst>
                <a:ext uri="{FF2B5EF4-FFF2-40B4-BE49-F238E27FC236}">
                  <a16:creationId xmlns:a16="http://schemas.microsoft.com/office/drawing/2014/main" id="{42F24EB9-EF1E-7310-AC27-06D25E7EC66B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138" name="Rectangle 10">
                <a:extLst>
                  <a:ext uri="{FF2B5EF4-FFF2-40B4-BE49-F238E27FC236}">
                    <a16:creationId xmlns:a16="http://schemas.microsoft.com/office/drawing/2014/main" id="{D4F181F8-9E26-E387-DEA4-A57B38691D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39" name="Rectangle 13">
                <a:extLst>
                  <a:ext uri="{FF2B5EF4-FFF2-40B4-BE49-F238E27FC236}">
                    <a16:creationId xmlns:a16="http://schemas.microsoft.com/office/drawing/2014/main" id="{57E168EC-C266-22E3-A5AB-7D46267EA2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40" name="Rectangle 10">
                <a:extLst>
                  <a:ext uri="{FF2B5EF4-FFF2-40B4-BE49-F238E27FC236}">
                    <a16:creationId xmlns:a16="http://schemas.microsoft.com/office/drawing/2014/main" id="{148AAB5F-9D30-0331-B7D5-7735888E12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D8613ACA-EEDC-AC84-BE60-0F98EED04375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F6A0C4B9-00FC-0C16-8276-0C60E7922747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4B4F7F64-2DE7-8CE1-22A6-EE85CA2E6E77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A42B9C6B-D3A7-A6E0-8ECC-CB27EF9E140A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4A0A6227-9745-C377-B5CC-C7968273710A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C4F451DA-853D-0B01-0274-C0A2B21FA6F5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2BFE45B6-E533-F95F-3C01-A1E351B172D7}"/>
              </a:ext>
            </a:extLst>
          </p:cNvPr>
          <p:cNvGrpSpPr/>
          <p:nvPr/>
        </p:nvGrpSpPr>
        <p:grpSpPr>
          <a:xfrm>
            <a:off x="6306822" y="683934"/>
            <a:ext cx="4141083" cy="2791354"/>
            <a:chOff x="1487880" y="741070"/>
            <a:chExt cx="4141083" cy="2791354"/>
          </a:xfrm>
        </p:grpSpPr>
        <p:sp>
          <p:nvSpPr>
            <p:cNvPr id="90" name="Rectangle 22">
              <a:extLst>
                <a:ext uri="{FF2B5EF4-FFF2-40B4-BE49-F238E27FC236}">
                  <a16:creationId xmlns:a16="http://schemas.microsoft.com/office/drawing/2014/main" id="{6653EDF6-DBDC-18E9-54EC-2C99113349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1" name="Line 23">
              <a:extLst>
                <a:ext uri="{FF2B5EF4-FFF2-40B4-BE49-F238E27FC236}">
                  <a16:creationId xmlns:a16="http://schemas.microsoft.com/office/drawing/2014/main" id="{7A14B0D1-A0FA-C99B-EE05-886CB42C88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2" name="Line 25">
              <a:extLst>
                <a:ext uri="{FF2B5EF4-FFF2-40B4-BE49-F238E27FC236}">
                  <a16:creationId xmlns:a16="http://schemas.microsoft.com/office/drawing/2014/main" id="{CD82A4A0-55DB-FAB0-CD62-270C4213BF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3" name="Line 27">
              <a:extLst>
                <a:ext uri="{FF2B5EF4-FFF2-40B4-BE49-F238E27FC236}">
                  <a16:creationId xmlns:a16="http://schemas.microsoft.com/office/drawing/2014/main" id="{5B1322EA-8B19-FCBB-FA1B-52BD432D7F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4" name="Line 29">
              <a:extLst>
                <a:ext uri="{FF2B5EF4-FFF2-40B4-BE49-F238E27FC236}">
                  <a16:creationId xmlns:a16="http://schemas.microsoft.com/office/drawing/2014/main" id="{B5BA4AF1-D3BE-7D5C-FCB9-D2EAF1A71B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5" name="Line 31">
              <a:extLst>
                <a:ext uri="{FF2B5EF4-FFF2-40B4-BE49-F238E27FC236}">
                  <a16:creationId xmlns:a16="http://schemas.microsoft.com/office/drawing/2014/main" id="{DDE3D95B-397B-98B4-3678-41CED84FAA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6" name="Line 33">
              <a:extLst>
                <a:ext uri="{FF2B5EF4-FFF2-40B4-BE49-F238E27FC236}">
                  <a16:creationId xmlns:a16="http://schemas.microsoft.com/office/drawing/2014/main" id="{C8488DE9-C0FD-9DFA-EE9D-FAF6496387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7" name="Line 35">
              <a:extLst>
                <a:ext uri="{FF2B5EF4-FFF2-40B4-BE49-F238E27FC236}">
                  <a16:creationId xmlns:a16="http://schemas.microsoft.com/office/drawing/2014/main" id="{C6CAEDAF-CDD0-E1A8-27EE-9CAF6F7EF8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8" name="Line 6">
              <a:extLst>
                <a:ext uri="{FF2B5EF4-FFF2-40B4-BE49-F238E27FC236}">
                  <a16:creationId xmlns:a16="http://schemas.microsoft.com/office/drawing/2014/main" id="{C5E11D93-2D54-6B07-30E9-F23BD6EB8B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99" name="Line 8">
              <a:extLst>
                <a:ext uri="{FF2B5EF4-FFF2-40B4-BE49-F238E27FC236}">
                  <a16:creationId xmlns:a16="http://schemas.microsoft.com/office/drawing/2014/main" id="{A9FE49C1-9166-F46F-0977-A955EA01E7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0" name="Line 9">
              <a:extLst>
                <a:ext uri="{FF2B5EF4-FFF2-40B4-BE49-F238E27FC236}">
                  <a16:creationId xmlns:a16="http://schemas.microsoft.com/office/drawing/2014/main" id="{FE501BDF-CC37-AA8C-2B63-5587739D67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1" name="Line 11">
              <a:extLst>
                <a:ext uri="{FF2B5EF4-FFF2-40B4-BE49-F238E27FC236}">
                  <a16:creationId xmlns:a16="http://schemas.microsoft.com/office/drawing/2014/main" id="{B65847F9-11E4-F28E-5E6E-D8BCE4ED87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2" name="Line 12">
              <a:extLst>
                <a:ext uri="{FF2B5EF4-FFF2-40B4-BE49-F238E27FC236}">
                  <a16:creationId xmlns:a16="http://schemas.microsoft.com/office/drawing/2014/main" id="{0F349AD5-D599-AE2F-EE00-326BFAA51F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3" name="Line 14">
              <a:extLst>
                <a:ext uri="{FF2B5EF4-FFF2-40B4-BE49-F238E27FC236}">
                  <a16:creationId xmlns:a16="http://schemas.microsoft.com/office/drawing/2014/main" id="{B3858556-5C87-6B9F-D949-AFEB839F54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4" name="Line 23">
              <a:extLst>
                <a:ext uri="{FF2B5EF4-FFF2-40B4-BE49-F238E27FC236}">
                  <a16:creationId xmlns:a16="http://schemas.microsoft.com/office/drawing/2014/main" id="{DF6EC652-0C31-1A60-C3F5-752157CE3A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105" name="図形グループ 54">
              <a:extLst>
                <a:ext uri="{FF2B5EF4-FFF2-40B4-BE49-F238E27FC236}">
                  <a16:creationId xmlns:a16="http://schemas.microsoft.com/office/drawing/2014/main" id="{BE53A381-DA5B-4209-4A2C-EB443E1BFC33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112" name="Rectangle 10">
                <a:extLst>
                  <a:ext uri="{FF2B5EF4-FFF2-40B4-BE49-F238E27FC236}">
                    <a16:creationId xmlns:a16="http://schemas.microsoft.com/office/drawing/2014/main" id="{7CCA53B0-A002-0F8A-FB35-B6ACF41436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13" name="Rectangle 13">
                <a:extLst>
                  <a:ext uri="{FF2B5EF4-FFF2-40B4-BE49-F238E27FC236}">
                    <a16:creationId xmlns:a16="http://schemas.microsoft.com/office/drawing/2014/main" id="{CD40AEC6-7B8C-CD62-B839-37C90C9A2F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114" name="Rectangle 10">
                <a:extLst>
                  <a:ext uri="{FF2B5EF4-FFF2-40B4-BE49-F238E27FC236}">
                    <a16:creationId xmlns:a16="http://schemas.microsoft.com/office/drawing/2014/main" id="{E30CFB6B-0D57-8AA9-E7BC-51AF433287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878806FB-50E9-C350-2932-032E0715DB07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C8A2114D-B23A-BA84-B1C0-14AA9AD0CC6D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F18279BC-FA2D-04E5-254D-79EC479F1DBB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4A1BED16-2948-AC83-6A46-9FD56A631D1C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0F9948E8-E29D-50F5-7EF1-93BD1E0374B3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8B0FABD0-74CD-C38E-C972-FD6D5228EBD8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43" name="Freeform 19">
            <a:extLst>
              <a:ext uri="{FF2B5EF4-FFF2-40B4-BE49-F238E27FC236}">
                <a16:creationId xmlns:a16="http://schemas.microsoft.com/office/drawing/2014/main" id="{04485E03-5A65-5469-2D7B-66CCD798DBBE}"/>
              </a:ext>
            </a:extLst>
          </p:cNvPr>
          <p:cNvSpPr>
            <a:spLocks/>
          </p:cNvSpPr>
          <p:nvPr/>
        </p:nvSpPr>
        <p:spPr bwMode="auto">
          <a:xfrm>
            <a:off x="2057524" y="1986444"/>
            <a:ext cx="3135521" cy="739757"/>
          </a:xfrm>
          <a:custGeom>
            <a:avLst/>
            <a:gdLst>
              <a:gd name="T0" fmla="*/ 97 w 1660"/>
              <a:gd name="T1" fmla="*/ 392 h 397"/>
              <a:gd name="T2" fmla="*/ 130 w 1660"/>
              <a:gd name="T3" fmla="*/ 387 h 397"/>
              <a:gd name="T4" fmla="*/ 155 w 1660"/>
              <a:gd name="T5" fmla="*/ 375 h 397"/>
              <a:gd name="T6" fmla="*/ 184 w 1660"/>
              <a:gd name="T7" fmla="*/ 370 h 397"/>
              <a:gd name="T8" fmla="*/ 218 w 1660"/>
              <a:gd name="T9" fmla="*/ 362 h 397"/>
              <a:gd name="T10" fmla="*/ 245 w 1660"/>
              <a:gd name="T11" fmla="*/ 357 h 397"/>
              <a:gd name="T12" fmla="*/ 275 w 1660"/>
              <a:gd name="T13" fmla="*/ 351 h 397"/>
              <a:gd name="T14" fmla="*/ 308 w 1660"/>
              <a:gd name="T15" fmla="*/ 341 h 397"/>
              <a:gd name="T16" fmla="*/ 332 w 1660"/>
              <a:gd name="T17" fmla="*/ 333 h 397"/>
              <a:gd name="T18" fmla="*/ 361 w 1660"/>
              <a:gd name="T19" fmla="*/ 322 h 397"/>
              <a:gd name="T20" fmla="*/ 389 w 1660"/>
              <a:gd name="T21" fmla="*/ 318 h 397"/>
              <a:gd name="T22" fmla="*/ 419 w 1660"/>
              <a:gd name="T23" fmla="*/ 312 h 397"/>
              <a:gd name="T24" fmla="*/ 449 w 1660"/>
              <a:gd name="T25" fmla="*/ 304 h 397"/>
              <a:gd name="T26" fmla="*/ 481 w 1660"/>
              <a:gd name="T27" fmla="*/ 299 h 397"/>
              <a:gd name="T28" fmla="*/ 510 w 1660"/>
              <a:gd name="T29" fmla="*/ 293 h 397"/>
              <a:gd name="T30" fmla="*/ 539 w 1660"/>
              <a:gd name="T31" fmla="*/ 287 h 397"/>
              <a:gd name="T32" fmla="*/ 563 w 1660"/>
              <a:gd name="T33" fmla="*/ 279 h 397"/>
              <a:gd name="T34" fmla="*/ 593 w 1660"/>
              <a:gd name="T35" fmla="*/ 270 h 397"/>
              <a:gd name="T36" fmla="*/ 624 w 1660"/>
              <a:gd name="T37" fmla="*/ 265 h 397"/>
              <a:gd name="T38" fmla="*/ 648 w 1660"/>
              <a:gd name="T39" fmla="*/ 254 h 397"/>
              <a:gd name="T40" fmla="*/ 678 w 1660"/>
              <a:gd name="T41" fmla="*/ 247 h 397"/>
              <a:gd name="T42" fmla="*/ 709 w 1660"/>
              <a:gd name="T43" fmla="*/ 242 h 397"/>
              <a:gd name="T44" fmla="*/ 737 w 1660"/>
              <a:gd name="T45" fmla="*/ 233 h 397"/>
              <a:gd name="T46" fmla="*/ 766 w 1660"/>
              <a:gd name="T47" fmla="*/ 225 h 397"/>
              <a:gd name="T48" fmla="*/ 801 w 1660"/>
              <a:gd name="T49" fmla="*/ 221 h 397"/>
              <a:gd name="T50" fmla="*/ 823 w 1660"/>
              <a:gd name="T51" fmla="*/ 212 h 397"/>
              <a:gd name="T52" fmla="*/ 852 w 1660"/>
              <a:gd name="T53" fmla="*/ 204 h 397"/>
              <a:gd name="T54" fmla="*/ 882 w 1660"/>
              <a:gd name="T55" fmla="*/ 198 h 397"/>
              <a:gd name="T56" fmla="*/ 907 w 1660"/>
              <a:gd name="T57" fmla="*/ 188 h 397"/>
              <a:gd name="T58" fmla="*/ 944 w 1660"/>
              <a:gd name="T59" fmla="*/ 186 h 397"/>
              <a:gd name="T60" fmla="*/ 972 w 1660"/>
              <a:gd name="T61" fmla="*/ 182 h 397"/>
              <a:gd name="T62" fmla="*/ 1003 w 1660"/>
              <a:gd name="T63" fmla="*/ 173 h 397"/>
              <a:gd name="T64" fmla="*/ 1033 w 1660"/>
              <a:gd name="T65" fmla="*/ 167 h 397"/>
              <a:gd name="T66" fmla="*/ 1060 w 1660"/>
              <a:gd name="T67" fmla="*/ 158 h 397"/>
              <a:gd name="T68" fmla="*/ 1087 w 1660"/>
              <a:gd name="T69" fmla="*/ 150 h 397"/>
              <a:gd name="T70" fmla="*/ 1119 w 1660"/>
              <a:gd name="T71" fmla="*/ 145 h 397"/>
              <a:gd name="T72" fmla="*/ 1147 w 1660"/>
              <a:gd name="T73" fmla="*/ 138 h 397"/>
              <a:gd name="T74" fmla="*/ 1183 w 1660"/>
              <a:gd name="T75" fmla="*/ 136 h 397"/>
              <a:gd name="T76" fmla="*/ 1213 w 1660"/>
              <a:gd name="T77" fmla="*/ 133 h 397"/>
              <a:gd name="T78" fmla="*/ 1244 w 1660"/>
              <a:gd name="T79" fmla="*/ 125 h 397"/>
              <a:gd name="T80" fmla="*/ 1274 w 1660"/>
              <a:gd name="T81" fmla="*/ 120 h 397"/>
              <a:gd name="T82" fmla="*/ 1305 w 1660"/>
              <a:gd name="T83" fmla="*/ 111 h 397"/>
              <a:gd name="T84" fmla="*/ 1327 w 1660"/>
              <a:gd name="T85" fmla="*/ 101 h 397"/>
              <a:gd name="T86" fmla="*/ 1357 w 1660"/>
              <a:gd name="T87" fmla="*/ 98 h 397"/>
              <a:gd name="T88" fmla="*/ 1393 w 1660"/>
              <a:gd name="T89" fmla="*/ 94 h 397"/>
              <a:gd name="T90" fmla="*/ 1422 w 1660"/>
              <a:gd name="T91" fmla="*/ 86 h 397"/>
              <a:gd name="T92" fmla="*/ 1453 w 1660"/>
              <a:gd name="T93" fmla="*/ 86 h 397"/>
              <a:gd name="T94" fmla="*/ 1490 w 1660"/>
              <a:gd name="T95" fmla="*/ 82 h 397"/>
              <a:gd name="T96" fmla="*/ 1520 w 1660"/>
              <a:gd name="T97" fmla="*/ 76 h 397"/>
              <a:gd name="T98" fmla="*/ 1547 w 1660"/>
              <a:gd name="T99" fmla="*/ 62 h 397"/>
              <a:gd name="T100" fmla="*/ 1571 w 1660"/>
              <a:gd name="T101" fmla="*/ 46 h 397"/>
              <a:gd name="T102" fmla="*/ 1604 w 1660"/>
              <a:gd name="T103" fmla="*/ 46 h 397"/>
              <a:gd name="T104" fmla="*/ 1634 w 1660"/>
              <a:gd name="T105" fmla="*/ 36 h 397"/>
              <a:gd name="T106" fmla="*/ 1654 w 1660"/>
              <a:gd name="T107" fmla="*/ 0 h 3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1660" h="397">
                <a:moveTo>
                  <a:pt x="0" y="397"/>
                </a:moveTo>
                <a:lnTo>
                  <a:pt x="79" y="397"/>
                </a:lnTo>
                <a:lnTo>
                  <a:pt x="79" y="394"/>
                </a:lnTo>
                <a:lnTo>
                  <a:pt x="84" y="394"/>
                </a:lnTo>
                <a:lnTo>
                  <a:pt x="90" y="392"/>
                </a:lnTo>
                <a:lnTo>
                  <a:pt x="97" y="392"/>
                </a:lnTo>
                <a:lnTo>
                  <a:pt x="101" y="391"/>
                </a:lnTo>
                <a:lnTo>
                  <a:pt x="116" y="391"/>
                </a:lnTo>
                <a:lnTo>
                  <a:pt x="119" y="391"/>
                </a:lnTo>
                <a:lnTo>
                  <a:pt x="127" y="391"/>
                </a:lnTo>
                <a:lnTo>
                  <a:pt x="130" y="390"/>
                </a:lnTo>
                <a:lnTo>
                  <a:pt x="130" y="387"/>
                </a:lnTo>
                <a:lnTo>
                  <a:pt x="137" y="383"/>
                </a:lnTo>
                <a:lnTo>
                  <a:pt x="140" y="381"/>
                </a:lnTo>
                <a:lnTo>
                  <a:pt x="142" y="380"/>
                </a:lnTo>
                <a:lnTo>
                  <a:pt x="148" y="377"/>
                </a:lnTo>
                <a:lnTo>
                  <a:pt x="154" y="376"/>
                </a:lnTo>
                <a:lnTo>
                  <a:pt x="155" y="375"/>
                </a:lnTo>
                <a:lnTo>
                  <a:pt x="160" y="375"/>
                </a:lnTo>
                <a:lnTo>
                  <a:pt x="166" y="373"/>
                </a:lnTo>
                <a:lnTo>
                  <a:pt x="173" y="372"/>
                </a:lnTo>
                <a:lnTo>
                  <a:pt x="179" y="371"/>
                </a:lnTo>
                <a:lnTo>
                  <a:pt x="179" y="370"/>
                </a:lnTo>
                <a:lnTo>
                  <a:pt x="184" y="370"/>
                </a:lnTo>
                <a:lnTo>
                  <a:pt x="190" y="368"/>
                </a:lnTo>
                <a:lnTo>
                  <a:pt x="196" y="365"/>
                </a:lnTo>
                <a:lnTo>
                  <a:pt x="198" y="363"/>
                </a:lnTo>
                <a:lnTo>
                  <a:pt x="204" y="362"/>
                </a:lnTo>
                <a:lnTo>
                  <a:pt x="208" y="362"/>
                </a:lnTo>
                <a:lnTo>
                  <a:pt x="218" y="362"/>
                </a:lnTo>
                <a:lnTo>
                  <a:pt x="220" y="360"/>
                </a:lnTo>
                <a:lnTo>
                  <a:pt x="230" y="359"/>
                </a:lnTo>
                <a:lnTo>
                  <a:pt x="233" y="359"/>
                </a:lnTo>
                <a:lnTo>
                  <a:pt x="243" y="359"/>
                </a:lnTo>
                <a:lnTo>
                  <a:pt x="244" y="359"/>
                </a:lnTo>
                <a:lnTo>
                  <a:pt x="245" y="357"/>
                </a:lnTo>
                <a:lnTo>
                  <a:pt x="253" y="356"/>
                </a:lnTo>
                <a:lnTo>
                  <a:pt x="256" y="355"/>
                </a:lnTo>
                <a:lnTo>
                  <a:pt x="265" y="355"/>
                </a:lnTo>
                <a:lnTo>
                  <a:pt x="270" y="353"/>
                </a:lnTo>
                <a:lnTo>
                  <a:pt x="272" y="351"/>
                </a:lnTo>
                <a:lnTo>
                  <a:pt x="275" y="351"/>
                </a:lnTo>
                <a:lnTo>
                  <a:pt x="280" y="350"/>
                </a:lnTo>
                <a:lnTo>
                  <a:pt x="286" y="348"/>
                </a:lnTo>
                <a:lnTo>
                  <a:pt x="292" y="347"/>
                </a:lnTo>
                <a:lnTo>
                  <a:pt x="298" y="345"/>
                </a:lnTo>
                <a:lnTo>
                  <a:pt x="299" y="345"/>
                </a:lnTo>
                <a:lnTo>
                  <a:pt x="308" y="341"/>
                </a:lnTo>
                <a:lnTo>
                  <a:pt x="313" y="341"/>
                </a:lnTo>
                <a:lnTo>
                  <a:pt x="313" y="339"/>
                </a:lnTo>
                <a:lnTo>
                  <a:pt x="319" y="338"/>
                </a:lnTo>
                <a:lnTo>
                  <a:pt x="322" y="338"/>
                </a:lnTo>
                <a:lnTo>
                  <a:pt x="328" y="336"/>
                </a:lnTo>
                <a:lnTo>
                  <a:pt x="332" y="333"/>
                </a:lnTo>
                <a:lnTo>
                  <a:pt x="335" y="332"/>
                </a:lnTo>
                <a:lnTo>
                  <a:pt x="342" y="331"/>
                </a:lnTo>
                <a:lnTo>
                  <a:pt x="346" y="331"/>
                </a:lnTo>
                <a:lnTo>
                  <a:pt x="350" y="327"/>
                </a:lnTo>
                <a:lnTo>
                  <a:pt x="355" y="327"/>
                </a:lnTo>
                <a:lnTo>
                  <a:pt x="361" y="322"/>
                </a:lnTo>
                <a:lnTo>
                  <a:pt x="367" y="322"/>
                </a:lnTo>
                <a:lnTo>
                  <a:pt x="370" y="321"/>
                </a:lnTo>
                <a:lnTo>
                  <a:pt x="372" y="321"/>
                </a:lnTo>
                <a:lnTo>
                  <a:pt x="382" y="319"/>
                </a:lnTo>
                <a:lnTo>
                  <a:pt x="384" y="319"/>
                </a:lnTo>
                <a:lnTo>
                  <a:pt x="389" y="318"/>
                </a:lnTo>
                <a:lnTo>
                  <a:pt x="391" y="315"/>
                </a:lnTo>
                <a:lnTo>
                  <a:pt x="395" y="315"/>
                </a:lnTo>
                <a:lnTo>
                  <a:pt x="401" y="315"/>
                </a:lnTo>
                <a:lnTo>
                  <a:pt x="408" y="315"/>
                </a:lnTo>
                <a:lnTo>
                  <a:pt x="413" y="314"/>
                </a:lnTo>
                <a:lnTo>
                  <a:pt x="419" y="312"/>
                </a:lnTo>
                <a:lnTo>
                  <a:pt x="425" y="311"/>
                </a:lnTo>
                <a:lnTo>
                  <a:pt x="431" y="310"/>
                </a:lnTo>
                <a:lnTo>
                  <a:pt x="436" y="309"/>
                </a:lnTo>
                <a:lnTo>
                  <a:pt x="437" y="309"/>
                </a:lnTo>
                <a:lnTo>
                  <a:pt x="444" y="305"/>
                </a:lnTo>
                <a:lnTo>
                  <a:pt x="449" y="304"/>
                </a:lnTo>
                <a:lnTo>
                  <a:pt x="452" y="303"/>
                </a:lnTo>
                <a:lnTo>
                  <a:pt x="455" y="303"/>
                </a:lnTo>
                <a:lnTo>
                  <a:pt x="463" y="299"/>
                </a:lnTo>
                <a:lnTo>
                  <a:pt x="467" y="299"/>
                </a:lnTo>
                <a:lnTo>
                  <a:pt x="473" y="299"/>
                </a:lnTo>
                <a:lnTo>
                  <a:pt x="481" y="299"/>
                </a:lnTo>
                <a:lnTo>
                  <a:pt x="484" y="299"/>
                </a:lnTo>
                <a:lnTo>
                  <a:pt x="492" y="299"/>
                </a:lnTo>
                <a:lnTo>
                  <a:pt x="494" y="297"/>
                </a:lnTo>
                <a:lnTo>
                  <a:pt x="497" y="296"/>
                </a:lnTo>
                <a:lnTo>
                  <a:pt x="508" y="295"/>
                </a:lnTo>
                <a:lnTo>
                  <a:pt x="510" y="293"/>
                </a:lnTo>
                <a:lnTo>
                  <a:pt x="515" y="292"/>
                </a:lnTo>
                <a:lnTo>
                  <a:pt x="517" y="291"/>
                </a:lnTo>
                <a:lnTo>
                  <a:pt x="522" y="291"/>
                </a:lnTo>
                <a:lnTo>
                  <a:pt x="528" y="289"/>
                </a:lnTo>
                <a:lnTo>
                  <a:pt x="534" y="289"/>
                </a:lnTo>
                <a:lnTo>
                  <a:pt x="539" y="287"/>
                </a:lnTo>
                <a:lnTo>
                  <a:pt x="546" y="286"/>
                </a:lnTo>
                <a:lnTo>
                  <a:pt x="546" y="285"/>
                </a:lnTo>
                <a:lnTo>
                  <a:pt x="551" y="285"/>
                </a:lnTo>
                <a:lnTo>
                  <a:pt x="557" y="284"/>
                </a:lnTo>
                <a:lnTo>
                  <a:pt x="562" y="279"/>
                </a:lnTo>
                <a:lnTo>
                  <a:pt x="563" y="279"/>
                </a:lnTo>
                <a:lnTo>
                  <a:pt x="569" y="279"/>
                </a:lnTo>
                <a:lnTo>
                  <a:pt x="575" y="276"/>
                </a:lnTo>
                <a:lnTo>
                  <a:pt x="581" y="274"/>
                </a:lnTo>
                <a:lnTo>
                  <a:pt x="582" y="272"/>
                </a:lnTo>
                <a:lnTo>
                  <a:pt x="589" y="270"/>
                </a:lnTo>
                <a:lnTo>
                  <a:pt x="593" y="270"/>
                </a:lnTo>
                <a:lnTo>
                  <a:pt x="599" y="269"/>
                </a:lnTo>
                <a:lnTo>
                  <a:pt x="609" y="268"/>
                </a:lnTo>
                <a:lnTo>
                  <a:pt x="612" y="268"/>
                </a:lnTo>
                <a:lnTo>
                  <a:pt x="615" y="266"/>
                </a:lnTo>
                <a:lnTo>
                  <a:pt x="619" y="266"/>
                </a:lnTo>
                <a:lnTo>
                  <a:pt x="624" y="265"/>
                </a:lnTo>
                <a:lnTo>
                  <a:pt x="629" y="263"/>
                </a:lnTo>
                <a:lnTo>
                  <a:pt x="634" y="261"/>
                </a:lnTo>
                <a:lnTo>
                  <a:pt x="635" y="261"/>
                </a:lnTo>
                <a:lnTo>
                  <a:pt x="642" y="256"/>
                </a:lnTo>
                <a:lnTo>
                  <a:pt x="644" y="254"/>
                </a:lnTo>
                <a:lnTo>
                  <a:pt x="648" y="254"/>
                </a:lnTo>
                <a:lnTo>
                  <a:pt x="654" y="254"/>
                </a:lnTo>
                <a:lnTo>
                  <a:pt x="660" y="251"/>
                </a:lnTo>
                <a:lnTo>
                  <a:pt x="669" y="249"/>
                </a:lnTo>
                <a:lnTo>
                  <a:pt x="670" y="248"/>
                </a:lnTo>
                <a:lnTo>
                  <a:pt x="673" y="248"/>
                </a:lnTo>
                <a:lnTo>
                  <a:pt x="678" y="247"/>
                </a:lnTo>
                <a:lnTo>
                  <a:pt x="684" y="247"/>
                </a:lnTo>
                <a:lnTo>
                  <a:pt x="690" y="247"/>
                </a:lnTo>
                <a:lnTo>
                  <a:pt x="695" y="246"/>
                </a:lnTo>
                <a:lnTo>
                  <a:pt x="700" y="243"/>
                </a:lnTo>
                <a:lnTo>
                  <a:pt x="701" y="243"/>
                </a:lnTo>
                <a:lnTo>
                  <a:pt x="709" y="242"/>
                </a:lnTo>
                <a:lnTo>
                  <a:pt x="713" y="236"/>
                </a:lnTo>
                <a:lnTo>
                  <a:pt x="714" y="236"/>
                </a:lnTo>
                <a:lnTo>
                  <a:pt x="721" y="236"/>
                </a:lnTo>
                <a:lnTo>
                  <a:pt x="726" y="234"/>
                </a:lnTo>
                <a:lnTo>
                  <a:pt x="731" y="233"/>
                </a:lnTo>
                <a:lnTo>
                  <a:pt x="737" y="233"/>
                </a:lnTo>
                <a:lnTo>
                  <a:pt x="744" y="232"/>
                </a:lnTo>
                <a:lnTo>
                  <a:pt x="744" y="229"/>
                </a:lnTo>
                <a:lnTo>
                  <a:pt x="750" y="226"/>
                </a:lnTo>
                <a:lnTo>
                  <a:pt x="757" y="226"/>
                </a:lnTo>
                <a:lnTo>
                  <a:pt x="762" y="226"/>
                </a:lnTo>
                <a:lnTo>
                  <a:pt x="766" y="225"/>
                </a:lnTo>
                <a:lnTo>
                  <a:pt x="768" y="225"/>
                </a:lnTo>
                <a:lnTo>
                  <a:pt x="774" y="225"/>
                </a:lnTo>
                <a:lnTo>
                  <a:pt x="780" y="225"/>
                </a:lnTo>
                <a:lnTo>
                  <a:pt x="786" y="225"/>
                </a:lnTo>
                <a:lnTo>
                  <a:pt x="792" y="223"/>
                </a:lnTo>
                <a:lnTo>
                  <a:pt x="801" y="221"/>
                </a:lnTo>
                <a:lnTo>
                  <a:pt x="804" y="220"/>
                </a:lnTo>
                <a:lnTo>
                  <a:pt x="807" y="218"/>
                </a:lnTo>
                <a:lnTo>
                  <a:pt x="810" y="218"/>
                </a:lnTo>
                <a:lnTo>
                  <a:pt x="816" y="215"/>
                </a:lnTo>
                <a:lnTo>
                  <a:pt x="818" y="212"/>
                </a:lnTo>
                <a:lnTo>
                  <a:pt x="823" y="212"/>
                </a:lnTo>
                <a:lnTo>
                  <a:pt x="828" y="212"/>
                </a:lnTo>
                <a:lnTo>
                  <a:pt x="834" y="209"/>
                </a:lnTo>
                <a:lnTo>
                  <a:pt x="842" y="209"/>
                </a:lnTo>
                <a:lnTo>
                  <a:pt x="844" y="206"/>
                </a:lnTo>
                <a:lnTo>
                  <a:pt x="846" y="206"/>
                </a:lnTo>
                <a:lnTo>
                  <a:pt x="852" y="204"/>
                </a:lnTo>
                <a:lnTo>
                  <a:pt x="858" y="204"/>
                </a:lnTo>
                <a:lnTo>
                  <a:pt x="864" y="204"/>
                </a:lnTo>
                <a:lnTo>
                  <a:pt x="870" y="203"/>
                </a:lnTo>
                <a:lnTo>
                  <a:pt x="874" y="199"/>
                </a:lnTo>
                <a:lnTo>
                  <a:pt x="876" y="199"/>
                </a:lnTo>
                <a:lnTo>
                  <a:pt x="882" y="198"/>
                </a:lnTo>
                <a:lnTo>
                  <a:pt x="889" y="196"/>
                </a:lnTo>
                <a:lnTo>
                  <a:pt x="891" y="194"/>
                </a:lnTo>
                <a:lnTo>
                  <a:pt x="895" y="193"/>
                </a:lnTo>
                <a:lnTo>
                  <a:pt x="900" y="191"/>
                </a:lnTo>
                <a:lnTo>
                  <a:pt x="903" y="188"/>
                </a:lnTo>
                <a:lnTo>
                  <a:pt x="907" y="188"/>
                </a:lnTo>
                <a:lnTo>
                  <a:pt x="912" y="188"/>
                </a:lnTo>
                <a:lnTo>
                  <a:pt x="918" y="186"/>
                </a:lnTo>
                <a:lnTo>
                  <a:pt x="924" y="186"/>
                </a:lnTo>
                <a:lnTo>
                  <a:pt x="930" y="186"/>
                </a:lnTo>
                <a:lnTo>
                  <a:pt x="936" y="186"/>
                </a:lnTo>
                <a:lnTo>
                  <a:pt x="944" y="186"/>
                </a:lnTo>
                <a:lnTo>
                  <a:pt x="949" y="184"/>
                </a:lnTo>
                <a:lnTo>
                  <a:pt x="954" y="184"/>
                </a:lnTo>
                <a:lnTo>
                  <a:pt x="961" y="184"/>
                </a:lnTo>
                <a:lnTo>
                  <a:pt x="967" y="184"/>
                </a:lnTo>
                <a:lnTo>
                  <a:pt x="972" y="184"/>
                </a:lnTo>
                <a:lnTo>
                  <a:pt x="972" y="182"/>
                </a:lnTo>
                <a:lnTo>
                  <a:pt x="978" y="179"/>
                </a:lnTo>
                <a:lnTo>
                  <a:pt x="985" y="179"/>
                </a:lnTo>
                <a:lnTo>
                  <a:pt x="989" y="177"/>
                </a:lnTo>
                <a:lnTo>
                  <a:pt x="992" y="177"/>
                </a:lnTo>
                <a:lnTo>
                  <a:pt x="997" y="175"/>
                </a:lnTo>
                <a:lnTo>
                  <a:pt x="1003" y="173"/>
                </a:lnTo>
                <a:lnTo>
                  <a:pt x="1010" y="173"/>
                </a:lnTo>
                <a:lnTo>
                  <a:pt x="1014" y="173"/>
                </a:lnTo>
                <a:lnTo>
                  <a:pt x="1020" y="173"/>
                </a:lnTo>
                <a:lnTo>
                  <a:pt x="1024" y="171"/>
                </a:lnTo>
                <a:lnTo>
                  <a:pt x="1027" y="168"/>
                </a:lnTo>
                <a:lnTo>
                  <a:pt x="1033" y="167"/>
                </a:lnTo>
                <a:lnTo>
                  <a:pt x="1037" y="164"/>
                </a:lnTo>
                <a:lnTo>
                  <a:pt x="1038" y="164"/>
                </a:lnTo>
                <a:lnTo>
                  <a:pt x="1045" y="164"/>
                </a:lnTo>
                <a:lnTo>
                  <a:pt x="1051" y="162"/>
                </a:lnTo>
                <a:lnTo>
                  <a:pt x="1057" y="160"/>
                </a:lnTo>
                <a:lnTo>
                  <a:pt x="1060" y="158"/>
                </a:lnTo>
                <a:lnTo>
                  <a:pt x="1063" y="156"/>
                </a:lnTo>
                <a:lnTo>
                  <a:pt x="1069" y="154"/>
                </a:lnTo>
                <a:lnTo>
                  <a:pt x="1074" y="154"/>
                </a:lnTo>
                <a:lnTo>
                  <a:pt x="1082" y="154"/>
                </a:lnTo>
                <a:lnTo>
                  <a:pt x="1083" y="152"/>
                </a:lnTo>
                <a:lnTo>
                  <a:pt x="1087" y="150"/>
                </a:lnTo>
                <a:lnTo>
                  <a:pt x="1093" y="150"/>
                </a:lnTo>
                <a:lnTo>
                  <a:pt x="1099" y="150"/>
                </a:lnTo>
                <a:lnTo>
                  <a:pt x="1105" y="150"/>
                </a:lnTo>
                <a:lnTo>
                  <a:pt x="1112" y="150"/>
                </a:lnTo>
                <a:lnTo>
                  <a:pt x="1117" y="150"/>
                </a:lnTo>
                <a:lnTo>
                  <a:pt x="1119" y="145"/>
                </a:lnTo>
                <a:lnTo>
                  <a:pt x="1124" y="143"/>
                </a:lnTo>
                <a:lnTo>
                  <a:pt x="1129" y="143"/>
                </a:lnTo>
                <a:lnTo>
                  <a:pt x="1133" y="141"/>
                </a:lnTo>
                <a:lnTo>
                  <a:pt x="1136" y="141"/>
                </a:lnTo>
                <a:lnTo>
                  <a:pt x="1141" y="141"/>
                </a:lnTo>
                <a:lnTo>
                  <a:pt x="1147" y="138"/>
                </a:lnTo>
                <a:lnTo>
                  <a:pt x="1153" y="138"/>
                </a:lnTo>
                <a:lnTo>
                  <a:pt x="1161" y="138"/>
                </a:lnTo>
                <a:lnTo>
                  <a:pt x="1167" y="138"/>
                </a:lnTo>
                <a:lnTo>
                  <a:pt x="1172" y="138"/>
                </a:lnTo>
                <a:lnTo>
                  <a:pt x="1177" y="138"/>
                </a:lnTo>
                <a:lnTo>
                  <a:pt x="1183" y="136"/>
                </a:lnTo>
                <a:lnTo>
                  <a:pt x="1190" y="136"/>
                </a:lnTo>
                <a:lnTo>
                  <a:pt x="1195" y="136"/>
                </a:lnTo>
                <a:lnTo>
                  <a:pt x="1202" y="136"/>
                </a:lnTo>
                <a:lnTo>
                  <a:pt x="1207" y="136"/>
                </a:lnTo>
                <a:lnTo>
                  <a:pt x="1210" y="133"/>
                </a:lnTo>
                <a:lnTo>
                  <a:pt x="1213" y="133"/>
                </a:lnTo>
                <a:lnTo>
                  <a:pt x="1216" y="128"/>
                </a:lnTo>
                <a:lnTo>
                  <a:pt x="1221" y="128"/>
                </a:lnTo>
                <a:lnTo>
                  <a:pt x="1225" y="128"/>
                </a:lnTo>
                <a:lnTo>
                  <a:pt x="1231" y="128"/>
                </a:lnTo>
                <a:lnTo>
                  <a:pt x="1237" y="125"/>
                </a:lnTo>
                <a:lnTo>
                  <a:pt x="1244" y="125"/>
                </a:lnTo>
                <a:lnTo>
                  <a:pt x="1244" y="123"/>
                </a:lnTo>
                <a:lnTo>
                  <a:pt x="1249" y="123"/>
                </a:lnTo>
                <a:lnTo>
                  <a:pt x="1255" y="123"/>
                </a:lnTo>
                <a:lnTo>
                  <a:pt x="1262" y="120"/>
                </a:lnTo>
                <a:lnTo>
                  <a:pt x="1267" y="120"/>
                </a:lnTo>
                <a:lnTo>
                  <a:pt x="1274" y="120"/>
                </a:lnTo>
                <a:lnTo>
                  <a:pt x="1279" y="117"/>
                </a:lnTo>
                <a:lnTo>
                  <a:pt x="1286" y="117"/>
                </a:lnTo>
                <a:lnTo>
                  <a:pt x="1290" y="114"/>
                </a:lnTo>
                <a:lnTo>
                  <a:pt x="1293" y="114"/>
                </a:lnTo>
                <a:lnTo>
                  <a:pt x="1298" y="111"/>
                </a:lnTo>
                <a:lnTo>
                  <a:pt x="1305" y="111"/>
                </a:lnTo>
                <a:lnTo>
                  <a:pt x="1311" y="111"/>
                </a:lnTo>
                <a:lnTo>
                  <a:pt x="1316" y="111"/>
                </a:lnTo>
                <a:lnTo>
                  <a:pt x="1316" y="107"/>
                </a:lnTo>
                <a:lnTo>
                  <a:pt x="1321" y="107"/>
                </a:lnTo>
                <a:lnTo>
                  <a:pt x="1322" y="104"/>
                </a:lnTo>
                <a:lnTo>
                  <a:pt x="1327" y="101"/>
                </a:lnTo>
                <a:lnTo>
                  <a:pt x="1334" y="101"/>
                </a:lnTo>
                <a:lnTo>
                  <a:pt x="1334" y="98"/>
                </a:lnTo>
                <a:lnTo>
                  <a:pt x="1340" y="98"/>
                </a:lnTo>
                <a:lnTo>
                  <a:pt x="1346" y="98"/>
                </a:lnTo>
                <a:lnTo>
                  <a:pt x="1352" y="98"/>
                </a:lnTo>
                <a:lnTo>
                  <a:pt x="1357" y="98"/>
                </a:lnTo>
                <a:lnTo>
                  <a:pt x="1363" y="98"/>
                </a:lnTo>
                <a:lnTo>
                  <a:pt x="1370" y="94"/>
                </a:lnTo>
                <a:lnTo>
                  <a:pt x="1376" y="94"/>
                </a:lnTo>
                <a:lnTo>
                  <a:pt x="1382" y="94"/>
                </a:lnTo>
                <a:lnTo>
                  <a:pt x="1389" y="94"/>
                </a:lnTo>
                <a:lnTo>
                  <a:pt x="1393" y="94"/>
                </a:lnTo>
                <a:lnTo>
                  <a:pt x="1399" y="94"/>
                </a:lnTo>
                <a:lnTo>
                  <a:pt x="1399" y="91"/>
                </a:lnTo>
                <a:lnTo>
                  <a:pt x="1406" y="91"/>
                </a:lnTo>
                <a:lnTo>
                  <a:pt x="1412" y="91"/>
                </a:lnTo>
                <a:lnTo>
                  <a:pt x="1419" y="91"/>
                </a:lnTo>
                <a:lnTo>
                  <a:pt x="1422" y="86"/>
                </a:lnTo>
                <a:lnTo>
                  <a:pt x="1423" y="86"/>
                </a:lnTo>
                <a:lnTo>
                  <a:pt x="1430" y="86"/>
                </a:lnTo>
                <a:lnTo>
                  <a:pt x="1437" y="86"/>
                </a:lnTo>
                <a:lnTo>
                  <a:pt x="1442" y="86"/>
                </a:lnTo>
                <a:lnTo>
                  <a:pt x="1448" y="86"/>
                </a:lnTo>
                <a:lnTo>
                  <a:pt x="1453" y="86"/>
                </a:lnTo>
                <a:lnTo>
                  <a:pt x="1460" y="82"/>
                </a:lnTo>
                <a:lnTo>
                  <a:pt x="1468" y="82"/>
                </a:lnTo>
                <a:lnTo>
                  <a:pt x="1472" y="82"/>
                </a:lnTo>
                <a:lnTo>
                  <a:pt x="1478" y="82"/>
                </a:lnTo>
                <a:lnTo>
                  <a:pt x="1484" y="82"/>
                </a:lnTo>
                <a:lnTo>
                  <a:pt x="1490" y="82"/>
                </a:lnTo>
                <a:lnTo>
                  <a:pt x="1496" y="82"/>
                </a:lnTo>
                <a:lnTo>
                  <a:pt x="1497" y="76"/>
                </a:lnTo>
                <a:lnTo>
                  <a:pt x="1502" y="76"/>
                </a:lnTo>
                <a:lnTo>
                  <a:pt x="1508" y="76"/>
                </a:lnTo>
                <a:lnTo>
                  <a:pt x="1516" y="76"/>
                </a:lnTo>
                <a:lnTo>
                  <a:pt x="1520" y="76"/>
                </a:lnTo>
                <a:lnTo>
                  <a:pt x="1526" y="76"/>
                </a:lnTo>
                <a:lnTo>
                  <a:pt x="1529" y="69"/>
                </a:lnTo>
                <a:lnTo>
                  <a:pt x="1532" y="69"/>
                </a:lnTo>
                <a:lnTo>
                  <a:pt x="1538" y="69"/>
                </a:lnTo>
                <a:lnTo>
                  <a:pt x="1544" y="69"/>
                </a:lnTo>
                <a:lnTo>
                  <a:pt x="1547" y="62"/>
                </a:lnTo>
                <a:lnTo>
                  <a:pt x="1549" y="54"/>
                </a:lnTo>
                <a:lnTo>
                  <a:pt x="1550" y="54"/>
                </a:lnTo>
                <a:lnTo>
                  <a:pt x="1557" y="54"/>
                </a:lnTo>
                <a:lnTo>
                  <a:pt x="1557" y="46"/>
                </a:lnTo>
                <a:lnTo>
                  <a:pt x="1562" y="46"/>
                </a:lnTo>
                <a:lnTo>
                  <a:pt x="1571" y="46"/>
                </a:lnTo>
                <a:lnTo>
                  <a:pt x="1576" y="46"/>
                </a:lnTo>
                <a:lnTo>
                  <a:pt x="1580" y="46"/>
                </a:lnTo>
                <a:lnTo>
                  <a:pt x="1590" y="46"/>
                </a:lnTo>
                <a:lnTo>
                  <a:pt x="1592" y="46"/>
                </a:lnTo>
                <a:lnTo>
                  <a:pt x="1598" y="46"/>
                </a:lnTo>
                <a:lnTo>
                  <a:pt x="1604" y="46"/>
                </a:lnTo>
                <a:lnTo>
                  <a:pt x="1610" y="46"/>
                </a:lnTo>
                <a:lnTo>
                  <a:pt x="1616" y="46"/>
                </a:lnTo>
                <a:lnTo>
                  <a:pt x="1623" y="46"/>
                </a:lnTo>
                <a:lnTo>
                  <a:pt x="1625" y="36"/>
                </a:lnTo>
                <a:lnTo>
                  <a:pt x="1628" y="36"/>
                </a:lnTo>
                <a:lnTo>
                  <a:pt x="1634" y="36"/>
                </a:lnTo>
                <a:lnTo>
                  <a:pt x="1640" y="36"/>
                </a:lnTo>
                <a:lnTo>
                  <a:pt x="1642" y="24"/>
                </a:lnTo>
                <a:lnTo>
                  <a:pt x="1642" y="12"/>
                </a:lnTo>
                <a:lnTo>
                  <a:pt x="1646" y="12"/>
                </a:lnTo>
                <a:lnTo>
                  <a:pt x="1650" y="0"/>
                </a:lnTo>
                <a:lnTo>
                  <a:pt x="1654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Freeform 21">
            <a:extLst>
              <a:ext uri="{FF2B5EF4-FFF2-40B4-BE49-F238E27FC236}">
                <a16:creationId xmlns:a16="http://schemas.microsoft.com/office/drawing/2014/main" id="{8AD32551-3850-7769-6D76-A817DE883EDC}"/>
              </a:ext>
            </a:extLst>
          </p:cNvPr>
          <p:cNvSpPr>
            <a:spLocks/>
          </p:cNvSpPr>
          <p:nvPr/>
        </p:nvSpPr>
        <p:spPr bwMode="auto">
          <a:xfrm>
            <a:off x="2057524" y="2396385"/>
            <a:ext cx="3135521" cy="329817"/>
          </a:xfrm>
          <a:custGeom>
            <a:avLst/>
            <a:gdLst>
              <a:gd name="T0" fmla="*/ 111 w 1660"/>
              <a:gd name="T1" fmla="*/ 177 h 177"/>
              <a:gd name="T2" fmla="*/ 124 w 1660"/>
              <a:gd name="T3" fmla="*/ 167 h 177"/>
              <a:gd name="T4" fmla="*/ 153 w 1660"/>
              <a:gd name="T5" fmla="*/ 167 h 177"/>
              <a:gd name="T6" fmla="*/ 183 w 1660"/>
              <a:gd name="T7" fmla="*/ 160 h 177"/>
              <a:gd name="T8" fmla="*/ 209 w 1660"/>
              <a:gd name="T9" fmla="*/ 157 h 177"/>
              <a:gd name="T10" fmla="*/ 232 w 1660"/>
              <a:gd name="T11" fmla="*/ 154 h 177"/>
              <a:gd name="T12" fmla="*/ 279 w 1660"/>
              <a:gd name="T13" fmla="*/ 151 h 177"/>
              <a:gd name="T14" fmla="*/ 313 w 1660"/>
              <a:gd name="T15" fmla="*/ 151 h 177"/>
              <a:gd name="T16" fmla="*/ 347 w 1660"/>
              <a:gd name="T17" fmla="*/ 151 h 177"/>
              <a:gd name="T18" fmla="*/ 383 w 1660"/>
              <a:gd name="T19" fmla="*/ 151 h 177"/>
              <a:gd name="T20" fmla="*/ 398 w 1660"/>
              <a:gd name="T21" fmla="*/ 144 h 177"/>
              <a:gd name="T22" fmla="*/ 417 w 1660"/>
              <a:gd name="T23" fmla="*/ 137 h 177"/>
              <a:gd name="T24" fmla="*/ 439 w 1660"/>
              <a:gd name="T25" fmla="*/ 137 h 177"/>
              <a:gd name="T26" fmla="*/ 482 w 1660"/>
              <a:gd name="T27" fmla="*/ 137 h 177"/>
              <a:gd name="T28" fmla="*/ 506 w 1660"/>
              <a:gd name="T29" fmla="*/ 137 h 177"/>
              <a:gd name="T30" fmla="*/ 546 w 1660"/>
              <a:gd name="T31" fmla="*/ 133 h 177"/>
              <a:gd name="T32" fmla="*/ 569 w 1660"/>
              <a:gd name="T33" fmla="*/ 133 h 177"/>
              <a:gd name="T34" fmla="*/ 599 w 1660"/>
              <a:gd name="T35" fmla="*/ 133 h 177"/>
              <a:gd name="T36" fmla="*/ 623 w 1660"/>
              <a:gd name="T37" fmla="*/ 133 h 177"/>
              <a:gd name="T38" fmla="*/ 648 w 1660"/>
              <a:gd name="T39" fmla="*/ 133 h 177"/>
              <a:gd name="T40" fmla="*/ 668 w 1660"/>
              <a:gd name="T41" fmla="*/ 129 h 177"/>
              <a:gd name="T42" fmla="*/ 684 w 1660"/>
              <a:gd name="T43" fmla="*/ 124 h 177"/>
              <a:gd name="T44" fmla="*/ 709 w 1660"/>
              <a:gd name="T45" fmla="*/ 124 h 177"/>
              <a:gd name="T46" fmla="*/ 731 w 1660"/>
              <a:gd name="T47" fmla="*/ 124 h 177"/>
              <a:gd name="T48" fmla="*/ 756 w 1660"/>
              <a:gd name="T49" fmla="*/ 124 h 177"/>
              <a:gd name="T50" fmla="*/ 774 w 1660"/>
              <a:gd name="T51" fmla="*/ 119 h 177"/>
              <a:gd name="T52" fmla="*/ 813 w 1660"/>
              <a:gd name="T53" fmla="*/ 114 h 177"/>
              <a:gd name="T54" fmla="*/ 835 w 1660"/>
              <a:gd name="T55" fmla="*/ 114 h 177"/>
              <a:gd name="T56" fmla="*/ 858 w 1660"/>
              <a:gd name="T57" fmla="*/ 114 h 177"/>
              <a:gd name="T58" fmla="*/ 876 w 1660"/>
              <a:gd name="T59" fmla="*/ 108 h 177"/>
              <a:gd name="T60" fmla="*/ 900 w 1660"/>
              <a:gd name="T61" fmla="*/ 108 h 177"/>
              <a:gd name="T62" fmla="*/ 927 w 1660"/>
              <a:gd name="T63" fmla="*/ 108 h 177"/>
              <a:gd name="T64" fmla="*/ 949 w 1660"/>
              <a:gd name="T65" fmla="*/ 108 h 177"/>
              <a:gd name="T66" fmla="*/ 967 w 1660"/>
              <a:gd name="T67" fmla="*/ 100 h 177"/>
              <a:gd name="T68" fmla="*/ 985 w 1660"/>
              <a:gd name="T69" fmla="*/ 92 h 177"/>
              <a:gd name="T70" fmla="*/ 1003 w 1660"/>
              <a:gd name="T71" fmla="*/ 84 h 177"/>
              <a:gd name="T72" fmla="*/ 1028 w 1660"/>
              <a:gd name="T73" fmla="*/ 84 h 177"/>
              <a:gd name="T74" fmla="*/ 1062 w 1660"/>
              <a:gd name="T75" fmla="*/ 84 h 177"/>
              <a:gd name="T76" fmla="*/ 1083 w 1660"/>
              <a:gd name="T77" fmla="*/ 84 h 177"/>
              <a:gd name="T78" fmla="*/ 1099 w 1660"/>
              <a:gd name="T79" fmla="*/ 74 h 177"/>
              <a:gd name="T80" fmla="*/ 1124 w 1660"/>
              <a:gd name="T81" fmla="*/ 74 h 177"/>
              <a:gd name="T82" fmla="*/ 1154 w 1660"/>
              <a:gd name="T83" fmla="*/ 74 h 177"/>
              <a:gd name="T84" fmla="*/ 1183 w 1660"/>
              <a:gd name="T85" fmla="*/ 74 h 177"/>
              <a:gd name="T86" fmla="*/ 1239 w 1660"/>
              <a:gd name="T87" fmla="*/ 74 h 177"/>
              <a:gd name="T88" fmla="*/ 1261 w 1660"/>
              <a:gd name="T89" fmla="*/ 74 h 177"/>
              <a:gd name="T90" fmla="*/ 1296 w 1660"/>
              <a:gd name="T91" fmla="*/ 74 h 177"/>
              <a:gd name="T92" fmla="*/ 1315 w 1660"/>
              <a:gd name="T93" fmla="*/ 74 h 177"/>
              <a:gd name="T94" fmla="*/ 1344 w 1660"/>
              <a:gd name="T95" fmla="*/ 57 h 177"/>
              <a:gd name="T96" fmla="*/ 1364 w 1660"/>
              <a:gd name="T97" fmla="*/ 57 h 177"/>
              <a:gd name="T98" fmla="*/ 1387 w 1660"/>
              <a:gd name="T99" fmla="*/ 57 h 177"/>
              <a:gd name="T100" fmla="*/ 1422 w 1660"/>
              <a:gd name="T101" fmla="*/ 57 h 177"/>
              <a:gd name="T102" fmla="*/ 1458 w 1660"/>
              <a:gd name="T103" fmla="*/ 57 h 177"/>
              <a:gd name="T104" fmla="*/ 1480 w 1660"/>
              <a:gd name="T105" fmla="*/ 57 h 177"/>
              <a:gd name="T106" fmla="*/ 1499 w 1660"/>
              <a:gd name="T107" fmla="*/ 32 h 177"/>
              <a:gd name="T108" fmla="*/ 1526 w 1660"/>
              <a:gd name="T109" fmla="*/ 32 h 177"/>
              <a:gd name="T110" fmla="*/ 1545 w 1660"/>
              <a:gd name="T111" fmla="*/ 0 h 177"/>
              <a:gd name="T112" fmla="*/ 1581 w 1660"/>
              <a:gd name="T113" fmla="*/ 0 h 177"/>
              <a:gd name="T114" fmla="*/ 1623 w 1660"/>
              <a:gd name="T115" fmla="*/ 0 h 177"/>
              <a:gd name="T116" fmla="*/ 1658 w 1660"/>
              <a:gd name="T117" fmla="*/ 0 h 1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1660" h="177">
                <a:moveTo>
                  <a:pt x="0" y="177"/>
                </a:moveTo>
                <a:lnTo>
                  <a:pt x="86" y="177"/>
                </a:lnTo>
                <a:lnTo>
                  <a:pt x="97" y="177"/>
                </a:lnTo>
                <a:lnTo>
                  <a:pt x="111" y="177"/>
                </a:lnTo>
                <a:lnTo>
                  <a:pt x="111" y="174"/>
                </a:lnTo>
                <a:lnTo>
                  <a:pt x="123" y="174"/>
                </a:lnTo>
                <a:lnTo>
                  <a:pt x="124" y="170"/>
                </a:lnTo>
                <a:lnTo>
                  <a:pt x="124" y="167"/>
                </a:lnTo>
                <a:lnTo>
                  <a:pt x="135" y="167"/>
                </a:lnTo>
                <a:lnTo>
                  <a:pt x="137" y="167"/>
                </a:lnTo>
                <a:lnTo>
                  <a:pt x="143" y="167"/>
                </a:lnTo>
                <a:lnTo>
                  <a:pt x="153" y="167"/>
                </a:lnTo>
                <a:lnTo>
                  <a:pt x="157" y="167"/>
                </a:lnTo>
                <a:lnTo>
                  <a:pt x="173" y="167"/>
                </a:lnTo>
                <a:lnTo>
                  <a:pt x="179" y="167"/>
                </a:lnTo>
                <a:lnTo>
                  <a:pt x="183" y="160"/>
                </a:lnTo>
                <a:lnTo>
                  <a:pt x="187" y="160"/>
                </a:lnTo>
                <a:lnTo>
                  <a:pt x="190" y="157"/>
                </a:lnTo>
                <a:lnTo>
                  <a:pt x="197" y="157"/>
                </a:lnTo>
                <a:lnTo>
                  <a:pt x="209" y="157"/>
                </a:lnTo>
                <a:lnTo>
                  <a:pt x="209" y="154"/>
                </a:lnTo>
                <a:lnTo>
                  <a:pt x="223" y="154"/>
                </a:lnTo>
                <a:lnTo>
                  <a:pt x="228" y="154"/>
                </a:lnTo>
                <a:lnTo>
                  <a:pt x="232" y="154"/>
                </a:lnTo>
                <a:lnTo>
                  <a:pt x="249" y="154"/>
                </a:lnTo>
                <a:lnTo>
                  <a:pt x="251" y="151"/>
                </a:lnTo>
                <a:lnTo>
                  <a:pt x="263" y="151"/>
                </a:lnTo>
                <a:lnTo>
                  <a:pt x="279" y="151"/>
                </a:lnTo>
                <a:lnTo>
                  <a:pt x="287" y="151"/>
                </a:lnTo>
                <a:lnTo>
                  <a:pt x="294" y="151"/>
                </a:lnTo>
                <a:lnTo>
                  <a:pt x="305" y="151"/>
                </a:lnTo>
                <a:lnTo>
                  <a:pt x="313" y="151"/>
                </a:lnTo>
                <a:lnTo>
                  <a:pt x="324" y="151"/>
                </a:lnTo>
                <a:lnTo>
                  <a:pt x="335" y="151"/>
                </a:lnTo>
                <a:lnTo>
                  <a:pt x="342" y="151"/>
                </a:lnTo>
                <a:lnTo>
                  <a:pt x="347" y="151"/>
                </a:lnTo>
                <a:lnTo>
                  <a:pt x="361" y="151"/>
                </a:lnTo>
                <a:lnTo>
                  <a:pt x="367" y="151"/>
                </a:lnTo>
                <a:lnTo>
                  <a:pt x="377" y="151"/>
                </a:lnTo>
                <a:lnTo>
                  <a:pt x="383" y="151"/>
                </a:lnTo>
                <a:lnTo>
                  <a:pt x="385" y="147"/>
                </a:lnTo>
                <a:lnTo>
                  <a:pt x="391" y="147"/>
                </a:lnTo>
                <a:lnTo>
                  <a:pt x="395" y="147"/>
                </a:lnTo>
                <a:lnTo>
                  <a:pt x="398" y="144"/>
                </a:lnTo>
                <a:lnTo>
                  <a:pt x="401" y="144"/>
                </a:lnTo>
                <a:lnTo>
                  <a:pt x="409" y="140"/>
                </a:lnTo>
                <a:lnTo>
                  <a:pt x="415" y="140"/>
                </a:lnTo>
                <a:lnTo>
                  <a:pt x="417" y="137"/>
                </a:lnTo>
                <a:lnTo>
                  <a:pt x="419" y="137"/>
                </a:lnTo>
                <a:lnTo>
                  <a:pt x="425" y="137"/>
                </a:lnTo>
                <a:lnTo>
                  <a:pt x="431" y="137"/>
                </a:lnTo>
                <a:lnTo>
                  <a:pt x="439" y="137"/>
                </a:lnTo>
                <a:lnTo>
                  <a:pt x="445" y="137"/>
                </a:lnTo>
                <a:lnTo>
                  <a:pt x="452" y="137"/>
                </a:lnTo>
                <a:lnTo>
                  <a:pt x="461" y="137"/>
                </a:lnTo>
                <a:lnTo>
                  <a:pt x="482" y="137"/>
                </a:lnTo>
                <a:lnTo>
                  <a:pt x="489" y="137"/>
                </a:lnTo>
                <a:lnTo>
                  <a:pt x="492" y="137"/>
                </a:lnTo>
                <a:lnTo>
                  <a:pt x="498" y="137"/>
                </a:lnTo>
                <a:lnTo>
                  <a:pt x="506" y="137"/>
                </a:lnTo>
                <a:lnTo>
                  <a:pt x="524" y="137"/>
                </a:lnTo>
                <a:lnTo>
                  <a:pt x="535" y="137"/>
                </a:lnTo>
                <a:lnTo>
                  <a:pt x="542" y="133"/>
                </a:lnTo>
                <a:lnTo>
                  <a:pt x="546" y="133"/>
                </a:lnTo>
                <a:lnTo>
                  <a:pt x="555" y="133"/>
                </a:lnTo>
                <a:lnTo>
                  <a:pt x="557" y="133"/>
                </a:lnTo>
                <a:lnTo>
                  <a:pt x="563" y="133"/>
                </a:lnTo>
                <a:lnTo>
                  <a:pt x="569" y="133"/>
                </a:lnTo>
                <a:lnTo>
                  <a:pt x="578" y="133"/>
                </a:lnTo>
                <a:lnTo>
                  <a:pt x="588" y="133"/>
                </a:lnTo>
                <a:lnTo>
                  <a:pt x="594" y="133"/>
                </a:lnTo>
                <a:lnTo>
                  <a:pt x="599" y="133"/>
                </a:lnTo>
                <a:lnTo>
                  <a:pt x="607" y="133"/>
                </a:lnTo>
                <a:lnTo>
                  <a:pt x="612" y="133"/>
                </a:lnTo>
                <a:lnTo>
                  <a:pt x="618" y="133"/>
                </a:lnTo>
                <a:lnTo>
                  <a:pt x="623" y="133"/>
                </a:lnTo>
                <a:lnTo>
                  <a:pt x="632" y="133"/>
                </a:lnTo>
                <a:lnTo>
                  <a:pt x="636" y="133"/>
                </a:lnTo>
                <a:lnTo>
                  <a:pt x="642" y="133"/>
                </a:lnTo>
                <a:lnTo>
                  <a:pt x="648" y="133"/>
                </a:lnTo>
                <a:lnTo>
                  <a:pt x="654" y="133"/>
                </a:lnTo>
                <a:lnTo>
                  <a:pt x="654" y="129"/>
                </a:lnTo>
                <a:lnTo>
                  <a:pt x="664" y="129"/>
                </a:lnTo>
                <a:lnTo>
                  <a:pt x="668" y="129"/>
                </a:lnTo>
                <a:lnTo>
                  <a:pt x="672" y="129"/>
                </a:lnTo>
                <a:lnTo>
                  <a:pt x="678" y="129"/>
                </a:lnTo>
                <a:lnTo>
                  <a:pt x="684" y="129"/>
                </a:lnTo>
                <a:lnTo>
                  <a:pt x="684" y="124"/>
                </a:lnTo>
                <a:lnTo>
                  <a:pt x="690" y="124"/>
                </a:lnTo>
                <a:lnTo>
                  <a:pt x="696" y="124"/>
                </a:lnTo>
                <a:lnTo>
                  <a:pt x="701" y="124"/>
                </a:lnTo>
                <a:lnTo>
                  <a:pt x="709" y="124"/>
                </a:lnTo>
                <a:lnTo>
                  <a:pt x="715" y="124"/>
                </a:lnTo>
                <a:lnTo>
                  <a:pt x="721" y="124"/>
                </a:lnTo>
                <a:lnTo>
                  <a:pt x="730" y="124"/>
                </a:lnTo>
                <a:lnTo>
                  <a:pt x="731" y="124"/>
                </a:lnTo>
                <a:lnTo>
                  <a:pt x="737" y="124"/>
                </a:lnTo>
                <a:lnTo>
                  <a:pt x="744" y="124"/>
                </a:lnTo>
                <a:lnTo>
                  <a:pt x="754" y="124"/>
                </a:lnTo>
                <a:lnTo>
                  <a:pt x="756" y="124"/>
                </a:lnTo>
                <a:lnTo>
                  <a:pt x="763" y="124"/>
                </a:lnTo>
                <a:lnTo>
                  <a:pt x="764" y="119"/>
                </a:lnTo>
                <a:lnTo>
                  <a:pt x="769" y="119"/>
                </a:lnTo>
                <a:lnTo>
                  <a:pt x="774" y="119"/>
                </a:lnTo>
                <a:lnTo>
                  <a:pt x="780" y="119"/>
                </a:lnTo>
                <a:lnTo>
                  <a:pt x="786" y="119"/>
                </a:lnTo>
                <a:lnTo>
                  <a:pt x="805" y="114"/>
                </a:lnTo>
                <a:lnTo>
                  <a:pt x="813" y="114"/>
                </a:lnTo>
                <a:lnTo>
                  <a:pt x="817" y="114"/>
                </a:lnTo>
                <a:lnTo>
                  <a:pt x="822" y="114"/>
                </a:lnTo>
                <a:lnTo>
                  <a:pt x="828" y="114"/>
                </a:lnTo>
                <a:lnTo>
                  <a:pt x="835" y="114"/>
                </a:lnTo>
                <a:lnTo>
                  <a:pt x="845" y="114"/>
                </a:lnTo>
                <a:lnTo>
                  <a:pt x="847" y="114"/>
                </a:lnTo>
                <a:lnTo>
                  <a:pt x="852" y="114"/>
                </a:lnTo>
                <a:lnTo>
                  <a:pt x="858" y="114"/>
                </a:lnTo>
                <a:lnTo>
                  <a:pt x="864" y="114"/>
                </a:lnTo>
                <a:lnTo>
                  <a:pt x="871" y="114"/>
                </a:lnTo>
                <a:lnTo>
                  <a:pt x="871" y="108"/>
                </a:lnTo>
                <a:lnTo>
                  <a:pt x="876" y="108"/>
                </a:lnTo>
                <a:lnTo>
                  <a:pt x="882" y="108"/>
                </a:lnTo>
                <a:lnTo>
                  <a:pt x="889" y="108"/>
                </a:lnTo>
                <a:lnTo>
                  <a:pt x="897" y="108"/>
                </a:lnTo>
                <a:lnTo>
                  <a:pt x="900" y="108"/>
                </a:lnTo>
                <a:lnTo>
                  <a:pt x="907" y="108"/>
                </a:lnTo>
                <a:lnTo>
                  <a:pt x="912" y="108"/>
                </a:lnTo>
                <a:lnTo>
                  <a:pt x="918" y="108"/>
                </a:lnTo>
                <a:lnTo>
                  <a:pt x="927" y="108"/>
                </a:lnTo>
                <a:lnTo>
                  <a:pt x="930" y="108"/>
                </a:lnTo>
                <a:lnTo>
                  <a:pt x="936" y="108"/>
                </a:lnTo>
                <a:lnTo>
                  <a:pt x="945" y="108"/>
                </a:lnTo>
                <a:lnTo>
                  <a:pt x="949" y="108"/>
                </a:lnTo>
                <a:lnTo>
                  <a:pt x="949" y="100"/>
                </a:lnTo>
                <a:lnTo>
                  <a:pt x="958" y="100"/>
                </a:lnTo>
                <a:lnTo>
                  <a:pt x="961" y="100"/>
                </a:lnTo>
                <a:lnTo>
                  <a:pt x="967" y="100"/>
                </a:lnTo>
                <a:lnTo>
                  <a:pt x="974" y="100"/>
                </a:lnTo>
                <a:lnTo>
                  <a:pt x="979" y="100"/>
                </a:lnTo>
                <a:lnTo>
                  <a:pt x="979" y="92"/>
                </a:lnTo>
                <a:lnTo>
                  <a:pt x="985" y="92"/>
                </a:lnTo>
                <a:lnTo>
                  <a:pt x="991" y="92"/>
                </a:lnTo>
                <a:lnTo>
                  <a:pt x="993" y="84"/>
                </a:lnTo>
                <a:lnTo>
                  <a:pt x="999" y="84"/>
                </a:lnTo>
                <a:lnTo>
                  <a:pt x="1003" y="84"/>
                </a:lnTo>
                <a:lnTo>
                  <a:pt x="1008" y="84"/>
                </a:lnTo>
                <a:lnTo>
                  <a:pt x="1014" y="84"/>
                </a:lnTo>
                <a:lnTo>
                  <a:pt x="1020" y="84"/>
                </a:lnTo>
                <a:lnTo>
                  <a:pt x="1028" y="84"/>
                </a:lnTo>
                <a:lnTo>
                  <a:pt x="1033" y="84"/>
                </a:lnTo>
                <a:lnTo>
                  <a:pt x="1044" y="84"/>
                </a:lnTo>
                <a:lnTo>
                  <a:pt x="1050" y="84"/>
                </a:lnTo>
                <a:lnTo>
                  <a:pt x="1062" y="84"/>
                </a:lnTo>
                <a:lnTo>
                  <a:pt x="1063" y="84"/>
                </a:lnTo>
                <a:lnTo>
                  <a:pt x="1072" y="84"/>
                </a:lnTo>
                <a:lnTo>
                  <a:pt x="1077" y="84"/>
                </a:lnTo>
                <a:lnTo>
                  <a:pt x="1083" y="84"/>
                </a:lnTo>
                <a:lnTo>
                  <a:pt x="1087" y="84"/>
                </a:lnTo>
                <a:lnTo>
                  <a:pt x="1087" y="74"/>
                </a:lnTo>
                <a:lnTo>
                  <a:pt x="1093" y="74"/>
                </a:lnTo>
                <a:lnTo>
                  <a:pt x="1099" y="74"/>
                </a:lnTo>
                <a:lnTo>
                  <a:pt x="1106" y="74"/>
                </a:lnTo>
                <a:lnTo>
                  <a:pt x="1116" y="74"/>
                </a:lnTo>
                <a:lnTo>
                  <a:pt x="1120" y="74"/>
                </a:lnTo>
                <a:lnTo>
                  <a:pt x="1124" y="74"/>
                </a:lnTo>
                <a:lnTo>
                  <a:pt x="1132" y="74"/>
                </a:lnTo>
                <a:lnTo>
                  <a:pt x="1135" y="74"/>
                </a:lnTo>
                <a:lnTo>
                  <a:pt x="1149" y="74"/>
                </a:lnTo>
                <a:lnTo>
                  <a:pt x="1154" y="74"/>
                </a:lnTo>
                <a:lnTo>
                  <a:pt x="1161" y="74"/>
                </a:lnTo>
                <a:lnTo>
                  <a:pt x="1170" y="74"/>
                </a:lnTo>
                <a:lnTo>
                  <a:pt x="1173" y="74"/>
                </a:lnTo>
                <a:lnTo>
                  <a:pt x="1183" y="74"/>
                </a:lnTo>
                <a:lnTo>
                  <a:pt x="1191" y="74"/>
                </a:lnTo>
                <a:lnTo>
                  <a:pt x="1197" y="74"/>
                </a:lnTo>
                <a:lnTo>
                  <a:pt x="1231" y="74"/>
                </a:lnTo>
                <a:lnTo>
                  <a:pt x="1239" y="74"/>
                </a:lnTo>
                <a:lnTo>
                  <a:pt x="1244" y="74"/>
                </a:lnTo>
                <a:lnTo>
                  <a:pt x="1252" y="74"/>
                </a:lnTo>
                <a:lnTo>
                  <a:pt x="1256" y="74"/>
                </a:lnTo>
                <a:lnTo>
                  <a:pt x="1261" y="74"/>
                </a:lnTo>
                <a:lnTo>
                  <a:pt x="1267" y="74"/>
                </a:lnTo>
                <a:lnTo>
                  <a:pt x="1274" y="74"/>
                </a:lnTo>
                <a:lnTo>
                  <a:pt x="1289" y="74"/>
                </a:lnTo>
                <a:lnTo>
                  <a:pt x="1296" y="74"/>
                </a:lnTo>
                <a:lnTo>
                  <a:pt x="1298" y="74"/>
                </a:lnTo>
                <a:lnTo>
                  <a:pt x="1306" y="74"/>
                </a:lnTo>
                <a:lnTo>
                  <a:pt x="1309" y="74"/>
                </a:lnTo>
                <a:lnTo>
                  <a:pt x="1315" y="74"/>
                </a:lnTo>
                <a:lnTo>
                  <a:pt x="1323" y="74"/>
                </a:lnTo>
                <a:lnTo>
                  <a:pt x="1323" y="57"/>
                </a:lnTo>
                <a:lnTo>
                  <a:pt x="1327" y="57"/>
                </a:lnTo>
                <a:lnTo>
                  <a:pt x="1344" y="57"/>
                </a:lnTo>
                <a:lnTo>
                  <a:pt x="1348" y="57"/>
                </a:lnTo>
                <a:lnTo>
                  <a:pt x="1351" y="57"/>
                </a:lnTo>
                <a:lnTo>
                  <a:pt x="1357" y="57"/>
                </a:lnTo>
                <a:lnTo>
                  <a:pt x="1364" y="57"/>
                </a:lnTo>
                <a:lnTo>
                  <a:pt x="1370" y="57"/>
                </a:lnTo>
                <a:lnTo>
                  <a:pt x="1379" y="57"/>
                </a:lnTo>
                <a:lnTo>
                  <a:pt x="1384" y="57"/>
                </a:lnTo>
                <a:lnTo>
                  <a:pt x="1387" y="57"/>
                </a:lnTo>
                <a:lnTo>
                  <a:pt x="1395" y="57"/>
                </a:lnTo>
                <a:lnTo>
                  <a:pt x="1402" y="57"/>
                </a:lnTo>
                <a:lnTo>
                  <a:pt x="1407" y="57"/>
                </a:lnTo>
                <a:lnTo>
                  <a:pt x="1422" y="57"/>
                </a:lnTo>
                <a:lnTo>
                  <a:pt x="1428" y="57"/>
                </a:lnTo>
                <a:lnTo>
                  <a:pt x="1429" y="57"/>
                </a:lnTo>
                <a:lnTo>
                  <a:pt x="1438" y="57"/>
                </a:lnTo>
                <a:lnTo>
                  <a:pt x="1458" y="57"/>
                </a:lnTo>
                <a:lnTo>
                  <a:pt x="1461" y="57"/>
                </a:lnTo>
                <a:lnTo>
                  <a:pt x="1467" y="57"/>
                </a:lnTo>
                <a:lnTo>
                  <a:pt x="1476" y="57"/>
                </a:lnTo>
                <a:lnTo>
                  <a:pt x="1480" y="57"/>
                </a:lnTo>
                <a:lnTo>
                  <a:pt x="1486" y="57"/>
                </a:lnTo>
                <a:lnTo>
                  <a:pt x="1492" y="57"/>
                </a:lnTo>
                <a:lnTo>
                  <a:pt x="1492" y="32"/>
                </a:lnTo>
                <a:lnTo>
                  <a:pt x="1499" y="32"/>
                </a:lnTo>
                <a:lnTo>
                  <a:pt x="1508" y="32"/>
                </a:lnTo>
                <a:lnTo>
                  <a:pt x="1516" y="32"/>
                </a:lnTo>
                <a:lnTo>
                  <a:pt x="1522" y="32"/>
                </a:lnTo>
                <a:lnTo>
                  <a:pt x="1526" y="32"/>
                </a:lnTo>
                <a:lnTo>
                  <a:pt x="1528" y="0"/>
                </a:lnTo>
                <a:lnTo>
                  <a:pt x="1535" y="0"/>
                </a:lnTo>
                <a:lnTo>
                  <a:pt x="1539" y="0"/>
                </a:lnTo>
                <a:lnTo>
                  <a:pt x="1545" y="0"/>
                </a:lnTo>
                <a:lnTo>
                  <a:pt x="1554" y="0"/>
                </a:lnTo>
                <a:lnTo>
                  <a:pt x="1563" y="0"/>
                </a:lnTo>
                <a:lnTo>
                  <a:pt x="1570" y="0"/>
                </a:lnTo>
                <a:lnTo>
                  <a:pt x="1581" y="0"/>
                </a:lnTo>
                <a:lnTo>
                  <a:pt x="1589" y="0"/>
                </a:lnTo>
                <a:lnTo>
                  <a:pt x="1602" y="0"/>
                </a:lnTo>
                <a:lnTo>
                  <a:pt x="1606" y="0"/>
                </a:lnTo>
                <a:lnTo>
                  <a:pt x="1623" y="0"/>
                </a:lnTo>
                <a:lnTo>
                  <a:pt x="1630" y="0"/>
                </a:lnTo>
                <a:lnTo>
                  <a:pt x="1636" y="0"/>
                </a:lnTo>
                <a:lnTo>
                  <a:pt x="1650" y="0"/>
                </a:lnTo>
                <a:lnTo>
                  <a:pt x="1658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Freeform 20">
            <a:extLst>
              <a:ext uri="{FF2B5EF4-FFF2-40B4-BE49-F238E27FC236}">
                <a16:creationId xmlns:a16="http://schemas.microsoft.com/office/drawing/2014/main" id="{A9B132AF-0E2D-AE2C-2BC6-A1BC66800AB8}"/>
              </a:ext>
            </a:extLst>
          </p:cNvPr>
          <p:cNvSpPr>
            <a:spLocks/>
          </p:cNvSpPr>
          <p:nvPr/>
        </p:nvSpPr>
        <p:spPr bwMode="auto">
          <a:xfrm>
            <a:off x="2057524" y="2726201"/>
            <a:ext cx="3137411" cy="0"/>
          </a:xfrm>
          <a:custGeom>
            <a:avLst/>
            <a:gdLst>
              <a:gd name="T0" fmla="*/ 0 w 1661"/>
              <a:gd name="T1" fmla="*/ 144 w 1661"/>
              <a:gd name="T2" fmla="*/ 160 w 1661"/>
              <a:gd name="T3" fmla="*/ 256 w 1661"/>
              <a:gd name="T4" fmla="*/ 296 w 1661"/>
              <a:gd name="T5" fmla="*/ 408 w 1661"/>
              <a:gd name="T6" fmla="*/ 472 w 1661"/>
              <a:gd name="T7" fmla="*/ 494 w 1661"/>
              <a:gd name="T8" fmla="*/ 542 w 1661"/>
              <a:gd name="T9" fmla="*/ 557 w 1661"/>
              <a:gd name="T10" fmla="*/ 578 w 1661"/>
              <a:gd name="T11" fmla="*/ 584 w 1661"/>
              <a:gd name="T12" fmla="*/ 594 w 1661"/>
              <a:gd name="T13" fmla="*/ 610 w 1661"/>
              <a:gd name="T14" fmla="*/ 618 w 1661"/>
              <a:gd name="T15" fmla="*/ 628 w 1661"/>
              <a:gd name="T16" fmla="*/ 648 w 1661"/>
              <a:gd name="T17" fmla="*/ 657 w 1661"/>
              <a:gd name="T18" fmla="*/ 668 w 1661"/>
              <a:gd name="T19" fmla="*/ 678 w 1661"/>
              <a:gd name="T20" fmla="*/ 684 w 1661"/>
              <a:gd name="T21" fmla="*/ 690 w 1661"/>
              <a:gd name="T22" fmla="*/ 695 w 1661"/>
              <a:gd name="T23" fmla="*/ 715 w 1661"/>
              <a:gd name="T24" fmla="*/ 724 w 1661"/>
              <a:gd name="T25" fmla="*/ 738 w 1661"/>
              <a:gd name="T26" fmla="*/ 744 w 1661"/>
              <a:gd name="T27" fmla="*/ 769 w 1661"/>
              <a:gd name="T28" fmla="*/ 777 w 1661"/>
              <a:gd name="T29" fmla="*/ 801 w 1661"/>
              <a:gd name="T30" fmla="*/ 838 w 1661"/>
              <a:gd name="T31" fmla="*/ 880 w 1661"/>
              <a:gd name="T32" fmla="*/ 882 w 1661"/>
              <a:gd name="T33" fmla="*/ 891 w 1661"/>
              <a:gd name="T34" fmla="*/ 900 w 1661"/>
              <a:gd name="T35" fmla="*/ 908 w 1661"/>
              <a:gd name="T36" fmla="*/ 912 w 1661"/>
              <a:gd name="T37" fmla="*/ 922 w 1661"/>
              <a:gd name="T38" fmla="*/ 929 w 1661"/>
              <a:gd name="T39" fmla="*/ 962 w 1661"/>
              <a:gd name="T40" fmla="*/ 1119 w 1661"/>
              <a:gd name="T41" fmla="*/ 1180 w 1661"/>
              <a:gd name="T42" fmla="*/ 1395 w 1661"/>
              <a:gd name="T43" fmla="*/ 1448 w 1661"/>
              <a:gd name="T44" fmla="*/ 1463 w 1661"/>
              <a:gd name="T45" fmla="*/ 1661 w 166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  <a:cxn ang="0">
                <a:pos x="T9" y="0"/>
              </a:cxn>
              <a:cxn ang="0">
                <a:pos x="T10" y="0"/>
              </a:cxn>
              <a:cxn ang="0">
                <a:pos x="T11" y="0"/>
              </a:cxn>
              <a:cxn ang="0">
                <a:pos x="T12" y="0"/>
              </a:cxn>
              <a:cxn ang="0">
                <a:pos x="T13" y="0"/>
              </a:cxn>
              <a:cxn ang="0">
                <a:pos x="T14" y="0"/>
              </a:cxn>
              <a:cxn ang="0">
                <a:pos x="T15" y="0"/>
              </a:cxn>
              <a:cxn ang="0">
                <a:pos x="T16" y="0"/>
              </a:cxn>
              <a:cxn ang="0">
                <a:pos x="T17" y="0"/>
              </a:cxn>
              <a:cxn ang="0">
                <a:pos x="T18" y="0"/>
              </a:cxn>
              <a:cxn ang="0">
                <a:pos x="T19" y="0"/>
              </a:cxn>
              <a:cxn ang="0">
                <a:pos x="T20" y="0"/>
              </a:cxn>
              <a:cxn ang="0">
                <a:pos x="T21" y="0"/>
              </a:cxn>
              <a:cxn ang="0">
                <a:pos x="T22" y="0"/>
              </a:cxn>
              <a:cxn ang="0">
                <a:pos x="T23" y="0"/>
              </a:cxn>
              <a:cxn ang="0">
                <a:pos x="T24" y="0"/>
              </a:cxn>
              <a:cxn ang="0">
                <a:pos x="T25" y="0"/>
              </a:cxn>
              <a:cxn ang="0">
                <a:pos x="T26" y="0"/>
              </a:cxn>
              <a:cxn ang="0">
                <a:pos x="T27" y="0"/>
              </a:cxn>
              <a:cxn ang="0">
                <a:pos x="T28" y="0"/>
              </a:cxn>
              <a:cxn ang="0">
                <a:pos x="T29" y="0"/>
              </a:cxn>
              <a:cxn ang="0">
                <a:pos x="T30" y="0"/>
              </a:cxn>
              <a:cxn ang="0">
                <a:pos x="T31" y="0"/>
              </a:cxn>
              <a:cxn ang="0">
                <a:pos x="T32" y="0"/>
              </a:cxn>
              <a:cxn ang="0">
                <a:pos x="T33" y="0"/>
              </a:cxn>
              <a:cxn ang="0">
                <a:pos x="T34" y="0"/>
              </a:cxn>
              <a:cxn ang="0">
                <a:pos x="T35" y="0"/>
              </a:cxn>
              <a:cxn ang="0">
                <a:pos x="T36" y="0"/>
              </a:cxn>
              <a:cxn ang="0">
                <a:pos x="T37" y="0"/>
              </a:cxn>
              <a:cxn ang="0">
                <a:pos x="T38" y="0"/>
              </a:cxn>
              <a:cxn ang="0">
                <a:pos x="T39" y="0"/>
              </a:cxn>
              <a:cxn ang="0">
                <a:pos x="T40" y="0"/>
              </a:cxn>
              <a:cxn ang="0">
                <a:pos x="T41" y="0"/>
              </a:cxn>
              <a:cxn ang="0">
                <a:pos x="T42" y="0"/>
              </a:cxn>
              <a:cxn ang="0">
                <a:pos x="T43" y="0"/>
              </a:cxn>
              <a:cxn ang="0">
                <a:pos x="T44" y="0"/>
              </a:cxn>
              <a:cxn ang="0">
                <a:pos x="T45" y="0"/>
              </a:cxn>
            </a:cxnLst>
            <a:rect l="0" t="0" r="r" b="b"/>
            <a:pathLst>
              <a:path w="1661">
                <a:moveTo>
                  <a:pt x="0" y="0"/>
                </a:moveTo>
                <a:lnTo>
                  <a:pt x="144" y="0"/>
                </a:lnTo>
                <a:lnTo>
                  <a:pt x="160" y="0"/>
                </a:lnTo>
                <a:lnTo>
                  <a:pt x="256" y="0"/>
                </a:lnTo>
                <a:lnTo>
                  <a:pt x="296" y="0"/>
                </a:lnTo>
                <a:lnTo>
                  <a:pt x="408" y="0"/>
                </a:lnTo>
                <a:lnTo>
                  <a:pt x="472" y="0"/>
                </a:lnTo>
                <a:lnTo>
                  <a:pt x="494" y="0"/>
                </a:lnTo>
                <a:lnTo>
                  <a:pt x="542" y="0"/>
                </a:lnTo>
                <a:lnTo>
                  <a:pt x="557" y="0"/>
                </a:lnTo>
                <a:lnTo>
                  <a:pt x="578" y="0"/>
                </a:lnTo>
                <a:lnTo>
                  <a:pt x="584" y="0"/>
                </a:lnTo>
                <a:lnTo>
                  <a:pt x="594" y="0"/>
                </a:lnTo>
                <a:lnTo>
                  <a:pt x="610" y="0"/>
                </a:lnTo>
                <a:lnTo>
                  <a:pt x="618" y="0"/>
                </a:lnTo>
                <a:lnTo>
                  <a:pt x="628" y="0"/>
                </a:lnTo>
                <a:lnTo>
                  <a:pt x="648" y="0"/>
                </a:lnTo>
                <a:lnTo>
                  <a:pt x="657" y="0"/>
                </a:lnTo>
                <a:lnTo>
                  <a:pt x="668" y="0"/>
                </a:lnTo>
                <a:lnTo>
                  <a:pt x="678" y="0"/>
                </a:lnTo>
                <a:lnTo>
                  <a:pt x="684" y="0"/>
                </a:lnTo>
                <a:lnTo>
                  <a:pt x="690" y="0"/>
                </a:lnTo>
                <a:lnTo>
                  <a:pt x="695" y="0"/>
                </a:lnTo>
                <a:lnTo>
                  <a:pt x="715" y="0"/>
                </a:lnTo>
                <a:lnTo>
                  <a:pt x="724" y="0"/>
                </a:lnTo>
                <a:lnTo>
                  <a:pt x="738" y="0"/>
                </a:lnTo>
                <a:lnTo>
                  <a:pt x="744" y="0"/>
                </a:lnTo>
                <a:lnTo>
                  <a:pt x="769" y="0"/>
                </a:lnTo>
                <a:lnTo>
                  <a:pt x="777" y="0"/>
                </a:lnTo>
                <a:lnTo>
                  <a:pt x="801" y="0"/>
                </a:lnTo>
                <a:lnTo>
                  <a:pt x="838" y="0"/>
                </a:lnTo>
                <a:lnTo>
                  <a:pt x="880" y="0"/>
                </a:lnTo>
                <a:lnTo>
                  <a:pt x="882" y="0"/>
                </a:lnTo>
                <a:lnTo>
                  <a:pt x="891" y="0"/>
                </a:lnTo>
                <a:lnTo>
                  <a:pt x="900" y="0"/>
                </a:lnTo>
                <a:lnTo>
                  <a:pt x="908" y="0"/>
                </a:lnTo>
                <a:lnTo>
                  <a:pt x="912" y="0"/>
                </a:lnTo>
                <a:lnTo>
                  <a:pt x="922" y="0"/>
                </a:lnTo>
                <a:lnTo>
                  <a:pt x="929" y="0"/>
                </a:lnTo>
                <a:lnTo>
                  <a:pt x="962" y="0"/>
                </a:lnTo>
                <a:lnTo>
                  <a:pt x="1119" y="0"/>
                </a:lnTo>
                <a:lnTo>
                  <a:pt x="1180" y="0"/>
                </a:lnTo>
                <a:lnTo>
                  <a:pt x="1395" y="0"/>
                </a:lnTo>
                <a:lnTo>
                  <a:pt x="1448" y="0"/>
                </a:lnTo>
                <a:lnTo>
                  <a:pt x="1463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5E3A1160-F477-F82B-E0FD-99E7D5E5E233}"/>
              </a:ext>
            </a:extLst>
          </p:cNvPr>
          <p:cNvGrpSpPr/>
          <p:nvPr/>
        </p:nvGrpSpPr>
        <p:grpSpPr>
          <a:xfrm>
            <a:off x="1197600" y="697927"/>
            <a:ext cx="4141083" cy="2791354"/>
            <a:chOff x="1487880" y="741070"/>
            <a:chExt cx="4141083" cy="2791354"/>
          </a:xfrm>
        </p:grpSpPr>
        <p:sp>
          <p:nvSpPr>
            <p:cNvPr id="46" name="Rectangle 22">
              <a:extLst>
                <a:ext uri="{FF2B5EF4-FFF2-40B4-BE49-F238E27FC236}">
                  <a16:creationId xmlns:a16="http://schemas.microsoft.com/office/drawing/2014/main" id="{1005C80F-01DD-CD96-144A-B524AE85CC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804" y="747591"/>
              <a:ext cx="3126078" cy="2010574"/>
            </a:xfrm>
            <a:prstGeom prst="rect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Line 23">
              <a:extLst>
                <a:ext uri="{FF2B5EF4-FFF2-40B4-BE49-F238E27FC236}">
                  <a16:creationId xmlns:a16="http://schemas.microsoft.com/office/drawing/2014/main" id="{66C4FEED-FC98-D204-5DC3-CFDA55DD2F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137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Line 25">
              <a:extLst>
                <a:ext uri="{FF2B5EF4-FFF2-40B4-BE49-F238E27FC236}">
                  <a16:creationId xmlns:a16="http://schemas.microsoft.com/office/drawing/2014/main" id="{1E7C67B3-3017-AE5F-EA50-47B5153B01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5354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" name="Line 27">
              <a:extLst>
                <a:ext uri="{FF2B5EF4-FFF2-40B4-BE49-F238E27FC236}">
                  <a16:creationId xmlns:a16="http://schemas.microsoft.com/office/drawing/2014/main" id="{70293940-2A45-4FD8-E418-3C5B5A68B8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570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" name="Line 29">
              <a:extLst>
                <a:ext uri="{FF2B5EF4-FFF2-40B4-BE49-F238E27FC236}">
                  <a16:creationId xmlns:a16="http://schemas.microsoft.com/office/drawing/2014/main" id="{48269F75-6FCC-E8FC-ACC2-96AA09A377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989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1" name="Line 31">
              <a:extLst>
                <a:ext uri="{FF2B5EF4-FFF2-40B4-BE49-F238E27FC236}">
                  <a16:creationId xmlns:a16="http://schemas.microsoft.com/office/drawing/2014/main" id="{7AA62F89-1EB8-D8AC-5A42-8E69A28963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3115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Line 33">
              <a:extLst>
                <a:ext uri="{FF2B5EF4-FFF2-40B4-BE49-F238E27FC236}">
                  <a16:creationId xmlns:a16="http://schemas.microsoft.com/office/drawing/2014/main" id="{BE63DC94-515B-09BC-FF41-090BF4DB33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6331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Line 35">
              <a:extLst>
                <a:ext uri="{FF2B5EF4-FFF2-40B4-BE49-F238E27FC236}">
                  <a16:creationId xmlns:a16="http://schemas.microsoft.com/office/drawing/2014/main" id="{B50D588B-952A-ECF4-559A-A13E74C61D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9548" y="2763754"/>
              <a:ext cx="0" cy="6708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" name="Line 6">
              <a:extLst>
                <a:ext uri="{FF2B5EF4-FFF2-40B4-BE49-F238E27FC236}">
                  <a16:creationId xmlns:a16="http://schemas.microsoft.com/office/drawing/2014/main" id="{B115048B-C350-04CF-A64B-4E7B349DF7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2761368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4" name="Line 8">
              <a:extLst>
                <a:ext uri="{FF2B5EF4-FFF2-40B4-BE49-F238E27FC236}">
                  <a16:creationId xmlns:a16="http://schemas.microsoft.com/office/drawing/2014/main" id="{66156174-E97C-4E49-1B8B-84A9BF586B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235387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5" name="Line 9">
              <a:extLst>
                <a:ext uri="{FF2B5EF4-FFF2-40B4-BE49-F238E27FC236}">
                  <a16:creationId xmlns:a16="http://schemas.microsoft.com/office/drawing/2014/main" id="{1DF7AB62-7AB6-E01C-FF2D-2581539BF0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94637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6" name="Line 11">
              <a:extLst>
                <a:ext uri="{FF2B5EF4-FFF2-40B4-BE49-F238E27FC236}">
                  <a16:creationId xmlns:a16="http://schemas.microsoft.com/office/drawing/2014/main" id="{0A06E783-4F34-618E-9A35-14CD94ECBF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1538882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7" name="Line 12">
              <a:extLst>
                <a:ext uri="{FF2B5EF4-FFF2-40B4-BE49-F238E27FC236}">
                  <a16:creationId xmlns:a16="http://schemas.microsoft.com/office/drawing/2014/main" id="{69C8ECAF-161B-1201-DB79-786ACBBDCF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6145" y="1131387"/>
              <a:ext cx="67681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8" name="Line 14">
              <a:extLst>
                <a:ext uri="{FF2B5EF4-FFF2-40B4-BE49-F238E27FC236}">
                  <a16:creationId xmlns:a16="http://schemas.microsoft.com/office/drawing/2014/main" id="{35107D5B-F663-DA0D-D5C5-A41FBC4B7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09984" y="747799"/>
              <a:ext cx="33840" cy="0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11" name="Line 23">
              <a:extLst>
                <a:ext uri="{FF2B5EF4-FFF2-40B4-BE49-F238E27FC236}">
                  <a16:creationId xmlns:a16="http://schemas.microsoft.com/office/drawing/2014/main" id="{D313D48C-A281-AB44-FC5A-5584226418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825" y="2761369"/>
              <a:ext cx="0" cy="67681"/>
            </a:xfrm>
            <a:prstGeom prst="line">
              <a:avLst/>
            </a:prstGeom>
            <a:noFill/>
            <a:ln w="12700" cap="flat" cmpd="sng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grpSp>
          <p:nvGrpSpPr>
            <p:cNvPr id="23" name="図形グループ 54">
              <a:extLst>
                <a:ext uri="{FF2B5EF4-FFF2-40B4-BE49-F238E27FC236}">
                  <a16:creationId xmlns:a16="http://schemas.microsoft.com/office/drawing/2014/main" id="{2CD3138F-19DF-1E8F-BFB8-A43C19CAE3A5}"/>
                </a:ext>
              </a:extLst>
            </p:cNvPr>
            <p:cNvGrpSpPr/>
            <p:nvPr/>
          </p:nvGrpSpPr>
          <p:grpSpPr>
            <a:xfrm>
              <a:off x="2034219" y="1002292"/>
              <a:ext cx="220989" cy="1868530"/>
              <a:chOff x="510218" y="1348283"/>
              <a:chExt cx="220989" cy="1868530"/>
            </a:xfrm>
          </p:grpSpPr>
          <p:sp>
            <p:nvSpPr>
              <p:cNvPr id="24" name="Rectangle 10">
                <a:extLst>
                  <a:ext uri="{FF2B5EF4-FFF2-40B4-BE49-F238E27FC236}">
                    <a16:creationId xmlns:a16="http://schemas.microsoft.com/office/drawing/2014/main" id="{0A352005-B8AD-B1C5-D886-F3FD15BF16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2142458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2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5" name="Rectangle 13">
                <a:extLst>
                  <a:ext uri="{FF2B5EF4-FFF2-40B4-BE49-F238E27FC236}">
                    <a16:creationId xmlns:a16="http://schemas.microsoft.com/office/drawing/2014/main" id="{BF811C73-0DDA-AA40-EA59-6964F85B57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18" y="1348283"/>
                <a:ext cx="20799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4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26" name="Rectangle 10">
                <a:extLst>
                  <a:ext uri="{FF2B5EF4-FFF2-40B4-BE49-F238E27FC236}">
                    <a16:creationId xmlns:a16="http://schemas.microsoft.com/office/drawing/2014/main" id="{7D42FA6C-38A3-A01E-350D-0418CE05C6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212" y="2970592"/>
                <a:ext cx="1039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en-US" altLang="ja-JP" sz="1600" dirty="0">
                    <a:solidFill>
                      <a:srgbClr val="000000"/>
                    </a:solidFill>
                    <a:latin typeface="Calibri" panose="020F0502020204030204" pitchFamily="34" charset="0"/>
                    <a:ea typeface="MS PGothic" panose="020B0600070205080204" pitchFamily="34" charset="-128"/>
                    <a:cs typeface="Calibri" panose="020F0502020204030204" pitchFamily="34" charset="0"/>
                  </a:rPr>
                  <a:t>0</a:t>
                </a:r>
                <a:endParaRPr kumimoji="0" lang="ja-JP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E63BACD-575B-D441-E776-DA76BF561A07}"/>
                </a:ext>
              </a:extLst>
            </p:cNvPr>
            <p:cNvSpPr txBox="1"/>
            <p:nvPr/>
          </p:nvSpPr>
          <p:spPr>
            <a:xfrm>
              <a:off x="2206686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0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47E0F02C-B3BB-322D-7A99-E09451472718}"/>
                </a:ext>
              </a:extLst>
            </p:cNvPr>
            <p:cNvSpPr txBox="1"/>
            <p:nvPr/>
          </p:nvSpPr>
          <p:spPr>
            <a:xfrm>
              <a:off x="3251225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2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38265A1-4111-AE59-751C-761448D60547}"/>
                </a:ext>
              </a:extLst>
            </p:cNvPr>
            <p:cNvSpPr txBox="1"/>
            <p:nvPr/>
          </p:nvSpPr>
          <p:spPr>
            <a:xfrm>
              <a:off x="5340302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6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0D08AA6-78E6-B385-BB9D-A2FB512AE1D4}"/>
                </a:ext>
              </a:extLst>
            </p:cNvPr>
            <p:cNvSpPr txBox="1"/>
            <p:nvPr/>
          </p:nvSpPr>
          <p:spPr>
            <a:xfrm>
              <a:off x="4295764" y="2901305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Calibri" panose="020F0502020204030204" pitchFamily="34" charset="0"/>
                  <a:ea typeface="MS PGothic" panose="020B0600070205080204" pitchFamily="34" charset="-128"/>
                  <a:cs typeface="Calibri" panose="020F0502020204030204" pitchFamily="34" charset="0"/>
                </a:rPr>
                <a:t>4</a:t>
              </a:r>
              <a:endParaRPr lang="ja-JP" altLang="en-US" sz="1600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97F11D48-C1F0-697F-815C-115A0D93D7B1}"/>
                </a:ext>
              </a:extLst>
            </p:cNvPr>
            <p:cNvSpPr txBox="1"/>
            <p:nvPr/>
          </p:nvSpPr>
          <p:spPr>
            <a:xfrm rot="16200000">
              <a:off x="604785" y="1624165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cidence of HCC (%)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8F127B2D-EFDD-4E86-0139-9BFCD70DF023}"/>
                </a:ext>
              </a:extLst>
            </p:cNvPr>
            <p:cNvSpPr txBox="1"/>
            <p:nvPr/>
          </p:nvSpPr>
          <p:spPr>
            <a:xfrm>
              <a:off x="3108992" y="3163092"/>
              <a:ext cx="1588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Years after SVR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73" name="Freeform 56">
            <a:extLst>
              <a:ext uri="{FF2B5EF4-FFF2-40B4-BE49-F238E27FC236}">
                <a16:creationId xmlns:a16="http://schemas.microsoft.com/office/drawing/2014/main" id="{B62AACB7-946B-FD14-941B-4A58662C6827}"/>
              </a:ext>
            </a:extLst>
          </p:cNvPr>
          <p:cNvSpPr>
            <a:spLocks/>
          </p:cNvSpPr>
          <p:nvPr/>
        </p:nvSpPr>
        <p:spPr bwMode="auto">
          <a:xfrm>
            <a:off x="7167890" y="1994674"/>
            <a:ext cx="3130400" cy="706355"/>
          </a:xfrm>
          <a:custGeom>
            <a:avLst/>
            <a:gdLst>
              <a:gd name="T0" fmla="*/ 97 w 1660"/>
              <a:gd name="T1" fmla="*/ 376 h 381"/>
              <a:gd name="T2" fmla="*/ 130 w 1660"/>
              <a:gd name="T3" fmla="*/ 373 h 381"/>
              <a:gd name="T4" fmla="*/ 154 w 1660"/>
              <a:gd name="T5" fmla="*/ 360 h 381"/>
              <a:gd name="T6" fmla="*/ 183 w 1660"/>
              <a:gd name="T7" fmla="*/ 353 h 381"/>
              <a:gd name="T8" fmla="*/ 208 w 1660"/>
              <a:gd name="T9" fmla="*/ 347 h 381"/>
              <a:gd name="T10" fmla="*/ 244 w 1660"/>
              <a:gd name="T11" fmla="*/ 343 h 381"/>
              <a:gd name="T12" fmla="*/ 272 w 1660"/>
              <a:gd name="T13" fmla="*/ 335 h 381"/>
              <a:gd name="T14" fmla="*/ 299 w 1660"/>
              <a:gd name="T15" fmla="*/ 328 h 381"/>
              <a:gd name="T16" fmla="*/ 328 w 1660"/>
              <a:gd name="T17" fmla="*/ 321 h 381"/>
              <a:gd name="T18" fmla="*/ 356 w 1660"/>
              <a:gd name="T19" fmla="*/ 311 h 381"/>
              <a:gd name="T20" fmla="*/ 385 w 1660"/>
              <a:gd name="T21" fmla="*/ 305 h 381"/>
              <a:gd name="T22" fmla="*/ 419 w 1660"/>
              <a:gd name="T23" fmla="*/ 300 h 381"/>
              <a:gd name="T24" fmla="*/ 445 w 1660"/>
              <a:gd name="T25" fmla="*/ 293 h 381"/>
              <a:gd name="T26" fmla="*/ 481 w 1660"/>
              <a:gd name="T27" fmla="*/ 288 h 381"/>
              <a:gd name="T28" fmla="*/ 514 w 1660"/>
              <a:gd name="T29" fmla="*/ 282 h 381"/>
              <a:gd name="T30" fmla="*/ 539 w 1660"/>
              <a:gd name="T31" fmla="*/ 276 h 381"/>
              <a:gd name="T32" fmla="*/ 563 w 1660"/>
              <a:gd name="T33" fmla="*/ 267 h 381"/>
              <a:gd name="T34" fmla="*/ 593 w 1660"/>
              <a:gd name="T35" fmla="*/ 258 h 381"/>
              <a:gd name="T36" fmla="*/ 626 w 1660"/>
              <a:gd name="T37" fmla="*/ 253 h 381"/>
              <a:gd name="T38" fmla="*/ 648 w 1660"/>
              <a:gd name="T39" fmla="*/ 242 h 381"/>
              <a:gd name="T40" fmla="*/ 678 w 1660"/>
              <a:gd name="T41" fmla="*/ 236 h 381"/>
              <a:gd name="T42" fmla="*/ 709 w 1660"/>
              <a:gd name="T43" fmla="*/ 231 h 381"/>
              <a:gd name="T44" fmla="*/ 737 w 1660"/>
              <a:gd name="T45" fmla="*/ 223 h 381"/>
              <a:gd name="T46" fmla="*/ 768 w 1660"/>
              <a:gd name="T47" fmla="*/ 215 h 381"/>
              <a:gd name="T48" fmla="*/ 801 w 1660"/>
              <a:gd name="T49" fmla="*/ 212 h 381"/>
              <a:gd name="T50" fmla="*/ 828 w 1660"/>
              <a:gd name="T51" fmla="*/ 205 h 381"/>
              <a:gd name="T52" fmla="*/ 852 w 1660"/>
              <a:gd name="T53" fmla="*/ 196 h 381"/>
              <a:gd name="T54" fmla="*/ 889 w 1660"/>
              <a:gd name="T55" fmla="*/ 192 h 381"/>
              <a:gd name="T56" fmla="*/ 916 w 1660"/>
              <a:gd name="T57" fmla="*/ 184 h 381"/>
              <a:gd name="T58" fmla="*/ 949 w 1660"/>
              <a:gd name="T59" fmla="*/ 183 h 381"/>
              <a:gd name="T60" fmla="*/ 978 w 1660"/>
              <a:gd name="T61" fmla="*/ 175 h 381"/>
              <a:gd name="T62" fmla="*/ 1010 w 1660"/>
              <a:gd name="T63" fmla="*/ 169 h 381"/>
              <a:gd name="T64" fmla="*/ 1038 w 1660"/>
              <a:gd name="T65" fmla="*/ 162 h 381"/>
              <a:gd name="T66" fmla="*/ 1063 w 1660"/>
              <a:gd name="T67" fmla="*/ 153 h 381"/>
              <a:gd name="T68" fmla="*/ 1093 w 1660"/>
              <a:gd name="T69" fmla="*/ 145 h 381"/>
              <a:gd name="T70" fmla="*/ 1124 w 1660"/>
              <a:gd name="T71" fmla="*/ 140 h 381"/>
              <a:gd name="T72" fmla="*/ 1153 w 1660"/>
              <a:gd name="T73" fmla="*/ 136 h 381"/>
              <a:gd name="T74" fmla="*/ 1190 w 1660"/>
              <a:gd name="T75" fmla="*/ 133 h 381"/>
              <a:gd name="T76" fmla="*/ 1221 w 1660"/>
              <a:gd name="T77" fmla="*/ 128 h 381"/>
              <a:gd name="T78" fmla="*/ 1249 w 1660"/>
              <a:gd name="T79" fmla="*/ 123 h 381"/>
              <a:gd name="T80" fmla="*/ 1279 w 1660"/>
              <a:gd name="T81" fmla="*/ 117 h 381"/>
              <a:gd name="T82" fmla="*/ 1309 w 1660"/>
              <a:gd name="T83" fmla="*/ 111 h 381"/>
              <a:gd name="T84" fmla="*/ 1334 w 1660"/>
              <a:gd name="T85" fmla="*/ 99 h 381"/>
              <a:gd name="T86" fmla="*/ 1369 w 1660"/>
              <a:gd name="T87" fmla="*/ 92 h 381"/>
              <a:gd name="T88" fmla="*/ 1399 w 1660"/>
              <a:gd name="T89" fmla="*/ 92 h 381"/>
              <a:gd name="T90" fmla="*/ 1430 w 1660"/>
              <a:gd name="T91" fmla="*/ 84 h 381"/>
              <a:gd name="T92" fmla="*/ 1460 w 1660"/>
              <a:gd name="T93" fmla="*/ 80 h 381"/>
              <a:gd name="T94" fmla="*/ 1496 w 1660"/>
              <a:gd name="T95" fmla="*/ 80 h 381"/>
              <a:gd name="T96" fmla="*/ 1526 w 1660"/>
              <a:gd name="T97" fmla="*/ 74 h 381"/>
              <a:gd name="T98" fmla="*/ 1549 w 1660"/>
              <a:gd name="T99" fmla="*/ 53 h 381"/>
              <a:gd name="T100" fmla="*/ 1576 w 1660"/>
              <a:gd name="T101" fmla="*/ 46 h 381"/>
              <a:gd name="T102" fmla="*/ 1610 w 1660"/>
              <a:gd name="T103" fmla="*/ 46 h 381"/>
              <a:gd name="T104" fmla="*/ 1640 w 1660"/>
              <a:gd name="T105" fmla="*/ 35 h 381"/>
              <a:gd name="T106" fmla="*/ 1660 w 1660"/>
              <a:gd name="T107" fmla="*/ 0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1660" h="381">
                <a:moveTo>
                  <a:pt x="0" y="381"/>
                </a:moveTo>
                <a:lnTo>
                  <a:pt x="79" y="381"/>
                </a:lnTo>
                <a:lnTo>
                  <a:pt x="79" y="378"/>
                </a:lnTo>
                <a:lnTo>
                  <a:pt x="84" y="378"/>
                </a:lnTo>
                <a:lnTo>
                  <a:pt x="90" y="376"/>
                </a:lnTo>
                <a:lnTo>
                  <a:pt x="97" y="376"/>
                </a:lnTo>
                <a:lnTo>
                  <a:pt x="101" y="375"/>
                </a:lnTo>
                <a:lnTo>
                  <a:pt x="111" y="375"/>
                </a:lnTo>
                <a:lnTo>
                  <a:pt x="116" y="374"/>
                </a:lnTo>
                <a:lnTo>
                  <a:pt x="121" y="374"/>
                </a:lnTo>
                <a:lnTo>
                  <a:pt x="127" y="374"/>
                </a:lnTo>
                <a:lnTo>
                  <a:pt x="130" y="373"/>
                </a:lnTo>
                <a:lnTo>
                  <a:pt x="130" y="371"/>
                </a:lnTo>
                <a:lnTo>
                  <a:pt x="137" y="367"/>
                </a:lnTo>
                <a:lnTo>
                  <a:pt x="140" y="366"/>
                </a:lnTo>
                <a:lnTo>
                  <a:pt x="142" y="364"/>
                </a:lnTo>
                <a:lnTo>
                  <a:pt x="148" y="361"/>
                </a:lnTo>
                <a:lnTo>
                  <a:pt x="154" y="360"/>
                </a:lnTo>
                <a:lnTo>
                  <a:pt x="155" y="359"/>
                </a:lnTo>
                <a:lnTo>
                  <a:pt x="160" y="359"/>
                </a:lnTo>
                <a:lnTo>
                  <a:pt x="166" y="357"/>
                </a:lnTo>
                <a:lnTo>
                  <a:pt x="173" y="356"/>
                </a:lnTo>
                <a:lnTo>
                  <a:pt x="179" y="355"/>
                </a:lnTo>
                <a:lnTo>
                  <a:pt x="183" y="353"/>
                </a:lnTo>
                <a:lnTo>
                  <a:pt x="184" y="353"/>
                </a:lnTo>
                <a:lnTo>
                  <a:pt x="190" y="352"/>
                </a:lnTo>
                <a:lnTo>
                  <a:pt x="196" y="350"/>
                </a:lnTo>
                <a:lnTo>
                  <a:pt x="199" y="347"/>
                </a:lnTo>
                <a:lnTo>
                  <a:pt x="206" y="347"/>
                </a:lnTo>
                <a:lnTo>
                  <a:pt x="208" y="347"/>
                </a:lnTo>
                <a:lnTo>
                  <a:pt x="218" y="347"/>
                </a:lnTo>
                <a:lnTo>
                  <a:pt x="220" y="345"/>
                </a:lnTo>
                <a:lnTo>
                  <a:pt x="229" y="343"/>
                </a:lnTo>
                <a:lnTo>
                  <a:pt x="234" y="343"/>
                </a:lnTo>
                <a:lnTo>
                  <a:pt x="243" y="343"/>
                </a:lnTo>
                <a:lnTo>
                  <a:pt x="244" y="343"/>
                </a:lnTo>
                <a:lnTo>
                  <a:pt x="245" y="342"/>
                </a:lnTo>
                <a:lnTo>
                  <a:pt x="251" y="339"/>
                </a:lnTo>
                <a:lnTo>
                  <a:pt x="256" y="338"/>
                </a:lnTo>
                <a:lnTo>
                  <a:pt x="265" y="338"/>
                </a:lnTo>
                <a:lnTo>
                  <a:pt x="270" y="337"/>
                </a:lnTo>
                <a:lnTo>
                  <a:pt x="272" y="335"/>
                </a:lnTo>
                <a:lnTo>
                  <a:pt x="275" y="335"/>
                </a:lnTo>
                <a:lnTo>
                  <a:pt x="280" y="334"/>
                </a:lnTo>
                <a:lnTo>
                  <a:pt x="286" y="332"/>
                </a:lnTo>
                <a:lnTo>
                  <a:pt x="292" y="331"/>
                </a:lnTo>
                <a:lnTo>
                  <a:pt x="292" y="329"/>
                </a:lnTo>
                <a:lnTo>
                  <a:pt x="299" y="328"/>
                </a:lnTo>
                <a:lnTo>
                  <a:pt x="305" y="325"/>
                </a:lnTo>
                <a:lnTo>
                  <a:pt x="313" y="325"/>
                </a:lnTo>
                <a:lnTo>
                  <a:pt x="316" y="323"/>
                </a:lnTo>
                <a:lnTo>
                  <a:pt x="319" y="323"/>
                </a:lnTo>
                <a:lnTo>
                  <a:pt x="322" y="323"/>
                </a:lnTo>
                <a:lnTo>
                  <a:pt x="328" y="321"/>
                </a:lnTo>
                <a:lnTo>
                  <a:pt x="334" y="317"/>
                </a:lnTo>
                <a:lnTo>
                  <a:pt x="335" y="317"/>
                </a:lnTo>
                <a:lnTo>
                  <a:pt x="342" y="317"/>
                </a:lnTo>
                <a:lnTo>
                  <a:pt x="346" y="317"/>
                </a:lnTo>
                <a:lnTo>
                  <a:pt x="355" y="313"/>
                </a:lnTo>
                <a:lnTo>
                  <a:pt x="356" y="311"/>
                </a:lnTo>
                <a:lnTo>
                  <a:pt x="361" y="310"/>
                </a:lnTo>
                <a:lnTo>
                  <a:pt x="367" y="310"/>
                </a:lnTo>
                <a:lnTo>
                  <a:pt x="372" y="309"/>
                </a:lnTo>
                <a:lnTo>
                  <a:pt x="382" y="306"/>
                </a:lnTo>
                <a:lnTo>
                  <a:pt x="383" y="306"/>
                </a:lnTo>
                <a:lnTo>
                  <a:pt x="385" y="305"/>
                </a:lnTo>
                <a:lnTo>
                  <a:pt x="389" y="305"/>
                </a:lnTo>
                <a:lnTo>
                  <a:pt x="395" y="303"/>
                </a:lnTo>
                <a:lnTo>
                  <a:pt x="401" y="303"/>
                </a:lnTo>
                <a:lnTo>
                  <a:pt x="408" y="303"/>
                </a:lnTo>
                <a:lnTo>
                  <a:pt x="413" y="302"/>
                </a:lnTo>
                <a:lnTo>
                  <a:pt x="419" y="300"/>
                </a:lnTo>
                <a:lnTo>
                  <a:pt x="419" y="299"/>
                </a:lnTo>
                <a:lnTo>
                  <a:pt x="425" y="299"/>
                </a:lnTo>
                <a:lnTo>
                  <a:pt x="431" y="297"/>
                </a:lnTo>
                <a:lnTo>
                  <a:pt x="438" y="296"/>
                </a:lnTo>
                <a:lnTo>
                  <a:pt x="444" y="294"/>
                </a:lnTo>
                <a:lnTo>
                  <a:pt x="445" y="293"/>
                </a:lnTo>
                <a:lnTo>
                  <a:pt x="449" y="293"/>
                </a:lnTo>
                <a:lnTo>
                  <a:pt x="455" y="292"/>
                </a:lnTo>
                <a:lnTo>
                  <a:pt x="463" y="288"/>
                </a:lnTo>
                <a:lnTo>
                  <a:pt x="467" y="288"/>
                </a:lnTo>
                <a:lnTo>
                  <a:pt x="473" y="288"/>
                </a:lnTo>
                <a:lnTo>
                  <a:pt x="481" y="288"/>
                </a:lnTo>
                <a:lnTo>
                  <a:pt x="484" y="288"/>
                </a:lnTo>
                <a:lnTo>
                  <a:pt x="492" y="288"/>
                </a:lnTo>
                <a:lnTo>
                  <a:pt x="492" y="287"/>
                </a:lnTo>
                <a:lnTo>
                  <a:pt x="497" y="285"/>
                </a:lnTo>
                <a:lnTo>
                  <a:pt x="508" y="284"/>
                </a:lnTo>
                <a:lnTo>
                  <a:pt x="514" y="282"/>
                </a:lnTo>
                <a:lnTo>
                  <a:pt x="514" y="281"/>
                </a:lnTo>
                <a:lnTo>
                  <a:pt x="515" y="281"/>
                </a:lnTo>
                <a:lnTo>
                  <a:pt x="522" y="280"/>
                </a:lnTo>
                <a:lnTo>
                  <a:pt x="528" y="278"/>
                </a:lnTo>
                <a:lnTo>
                  <a:pt x="534" y="278"/>
                </a:lnTo>
                <a:lnTo>
                  <a:pt x="539" y="276"/>
                </a:lnTo>
                <a:lnTo>
                  <a:pt x="539" y="274"/>
                </a:lnTo>
                <a:lnTo>
                  <a:pt x="546" y="274"/>
                </a:lnTo>
                <a:lnTo>
                  <a:pt x="551" y="273"/>
                </a:lnTo>
                <a:lnTo>
                  <a:pt x="557" y="272"/>
                </a:lnTo>
                <a:lnTo>
                  <a:pt x="558" y="268"/>
                </a:lnTo>
                <a:lnTo>
                  <a:pt x="563" y="267"/>
                </a:lnTo>
                <a:lnTo>
                  <a:pt x="569" y="267"/>
                </a:lnTo>
                <a:lnTo>
                  <a:pt x="575" y="264"/>
                </a:lnTo>
                <a:lnTo>
                  <a:pt x="575" y="262"/>
                </a:lnTo>
                <a:lnTo>
                  <a:pt x="582" y="261"/>
                </a:lnTo>
                <a:lnTo>
                  <a:pt x="588" y="258"/>
                </a:lnTo>
                <a:lnTo>
                  <a:pt x="593" y="258"/>
                </a:lnTo>
                <a:lnTo>
                  <a:pt x="593" y="256"/>
                </a:lnTo>
                <a:lnTo>
                  <a:pt x="600" y="256"/>
                </a:lnTo>
                <a:lnTo>
                  <a:pt x="609" y="255"/>
                </a:lnTo>
                <a:lnTo>
                  <a:pt x="613" y="255"/>
                </a:lnTo>
                <a:lnTo>
                  <a:pt x="618" y="254"/>
                </a:lnTo>
                <a:lnTo>
                  <a:pt x="626" y="253"/>
                </a:lnTo>
                <a:lnTo>
                  <a:pt x="628" y="251"/>
                </a:lnTo>
                <a:lnTo>
                  <a:pt x="629" y="251"/>
                </a:lnTo>
                <a:lnTo>
                  <a:pt x="635" y="250"/>
                </a:lnTo>
                <a:lnTo>
                  <a:pt x="637" y="245"/>
                </a:lnTo>
                <a:lnTo>
                  <a:pt x="642" y="245"/>
                </a:lnTo>
                <a:lnTo>
                  <a:pt x="648" y="242"/>
                </a:lnTo>
                <a:lnTo>
                  <a:pt x="654" y="242"/>
                </a:lnTo>
                <a:lnTo>
                  <a:pt x="657" y="239"/>
                </a:lnTo>
                <a:lnTo>
                  <a:pt x="660" y="239"/>
                </a:lnTo>
                <a:lnTo>
                  <a:pt x="668" y="239"/>
                </a:lnTo>
                <a:lnTo>
                  <a:pt x="673" y="237"/>
                </a:lnTo>
                <a:lnTo>
                  <a:pt x="678" y="236"/>
                </a:lnTo>
                <a:lnTo>
                  <a:pt x="684" y="236"/>
                </a:lnTo>
                <a:lnTo>
                  <a:pt x="690" y="236"/>
                </a:lnTo>
                <a:lnTo>
                  <a:pt x="695" y="235"/>
                </a:lnTo>
                <a:lnTo>
                  <a:pt x="700" y="232"/>
                </a:lnTo>
                <a:lnTo>
                  <a:pt x="704" y="232"/>
                </a:lnTo>
                <a:lnTo>
                  <a:pt x="709" y="231"/>
                </a:lnTo>
                <a:lnTo>
                  <a:pt x="712" y="227"/>
                </a:lnTo>
                <a:lnTo>
                  <a:pt x="714" y="225"/>
                </a:lnTo>
                <a:lnTo>
                  <a:pt x="721" y="225"/>
                </a:lnTo>
                <a:lnTo>
                  <a:pt x="726" y="224"/>
                </a:lnTo>
                <a:lnTo>
                  <a:pt x="731" y="223"/>
                </a:lnTo>
                <a:lnTo>
                  <a:pt x="737" y="223"/>
                </a:lnTo>
                <a:lnTo>
                  <a:pt x="742" y="221"/>
                </a:lnTo>
                <a:lnTo>
                  <a:pt x="744" y="221"/>
                </a:lnTo>
                <a:lnTo>
                  <a:pt x="750" y="217"/>
                </a:lnTo>
                <a:lnTo>
                  <a:pt x="756" y="217"/>
                </a:lnTo>
                <a:lnTo>
                  <a:pt x="762" y="217"/>
                </a:lnTo>
                <a:lnTo>
                  <a:pt x="768" y="215"/>
                </a:lnTo>
                <a:lnTo>
                  <a:pt x="774" y="215"/>
                </a:lnTo>
                <a:lnTo>
                  <a:pt x="780" y="215"/>
                </a:lnTo>
                <a:lnTo>
                  <a:pt x="786" y="215"/>
                </a:lnTo>
                <a:lnTo>
                  <a:pt x="790" y="214"/>
                </a:lnTo>
                <a:lnTo>
                  <a:pt x="792" y="214"/>
                </a:lnTo>
                <a:lnTo>
                  <a:pt x="801" y="212"/>
                </a:lnTo>
                <a:lnTo>
                  <a:pt x="804" y="211"/>
                </a:lnTo>
                <a:lnTo>
                  <a:pt x="810" y="209"/>
                </a:lnTo>
                <a:lnTo>
                  <a:pt x="812" y="208"/>
                </a:lnTo>
                <a:lnTo>
                  <a:pt x="816" y="208"/>
                </a:lnTo>
                <a:lnTo>
                  <a:pt x="823" y="205"/>
                </a:lnTo>
                <a:lnTo>
                  <a:pt x="828" y="205"/>
                </a:lnTo>
                <a:lnTo>
                  <a:pt x="833" y="202"/>
                </a:lnTo>
                <a:lnTo>
                  <a:pt x="834" y="202"/>
                </a:lnTo>
                <a:lnTo>
                  <a:pt x="842" y="202"/>
                </a:lnTo>
                <a:lnTo>
                  <a:pt x="846" y="197"/>
                </a:lnTo>
                <a:lnTo>
                  <a:pt x="850" y="196"/>
                </a:lnTo>
                <a:lnTo>
                  <a:pt x="852" y="196"/>
                </a:lnTo>
                <a:lnTo>
                  <a:pt x="858" y="196"/>
                </a:lnTo>
                <a:lnTo>
                  <a:pt x="864" y="196"/>
                </a:lnTo>
                <a:lnTo>
                  <a:pt x="870" y="196"/>
                </a:lnTo>
                <a:lnTo>
                  <a:pt x="876" y="192"/>
                </a:lnTo>
                <a:lnTo>
                  <a:pt x="882" y="192"/>
                </a:lnTo>
                <a:lnTo>
                  <a:pt x="889" y="192"/>
                </a:lnTo>
                <a:lnTo>
                  <a:pt x="891" y="191"/>
                </a:lnTo>
                <a:lnTo>
                  <a:pt x="895" y="189"/>
                </a:lnTo>
                <a:lnTo>
                  <a:pt x="900" y="188"/>
                </a:lnTo>
                <a:lnTo>
                  <a:pt x="907" y="186"/>
                </a:lnTo>
                <a:lnTo>
                  <a:pt x="912" y="186"/>
                </a:lnTo>
                <a:lnTo>
                  <a:pt x="916" y="184"/>
                </a:lnTo>
                <a:lnTo>
                  <a:pt x="918" y="184"/>
                </a:lnTo>
                <a:lnTo>
                  <a:pt x="924" y="184"/>
                </a:lnTo>
                <a:lnTo>
                  <a:pt x="930" y="184"/>
                </a:lnTo>
                <a:lnTo>
                  <a:pt x="936" y="184"/>
                </a:lnTo>
                <a:lnTo>
                  <a:pt x="944" y="184"/>
                </a:lnTo>
                <a:lnTo>
                  <a:pt x="949" y="183"/>
                </a:lnTo>
                <a:lnTo>
                  <a:pt x="954" y="181"/>
                </a:lnTo>
                <a:lnTo>
                  <a:pt x="961" y="181"/>
                </a:lnTo>
                <a:lnTo>
                  <a:pt x="967" y="181"/>
                </a:lnTo>
                <a:lnTo>
                  <a:pt x="972" y="181"/>
                </a:lnTo>
                <a:lnTo>
                  <a:pt x="972" y="179"/>
                </a:lnTo>
                <a:lnTo>
                  <a:pt x="978" y="175"/>
                </a:lnTo>
                <a:lnTo>
                  <a:pt x="985" y="175"/>
                </a:lnTo>
                <a:lnTo>
                  <a:pt x="991" y="173"/>
                </a:lnTo>
                <a:lnTo>
                  <a:pt x="993" y="171"/>
                </a:lnTo>
                <a:lnTo>
                  <a:pt x="997" y="171"/>
                </a:lnTo>
                <a:lnTo>
                  <a:pt x="1003" y="169"/>
                </a:lnTo>
                <a:lnTo>
                  <a:pt x="1010" y="169"/>
                </a:lnTo>
                <a:lnTo>
                  <a:pt x="1014" y="169"/>
                </a:lnTo>
                <a:lnTo>
                  <a:pt x="1020" y="169"/>
                </a:lnTo>
                <a:lnTo>
                  <a:pt x="1025" y="165"/>
                </a:lnTo>
                <a:lnTo>
                  <a:pt x="1027" y="165"/>
                </a:lnTo>
                <a:lnTo>
                  <a:pt x="1033" y="163"/>
                </a:lnTo>
                <a:lnTo>
                  <a:pt x="1038" y="162"/>
                </a:lnTo>
                <a:lnTo>
                  <a:pt x="1045" y="162"/>
                </a:lnTo>
                <a:lnTo>
                  <a:pt x="1046" y="159"/>
                </a:lnTo>
                <a:lnTo>
                  <a:pt x="1050" y="159"/>
                </a:lnTo>
                <a:lnTo>
                  <a:pt x="1058" y="157"/>
                </a:lnTo>
                <a:lnTo>
                  <a:pt x="1061" y="153"/>
                </a:lnTo>
                <a:lnTo>
                  <a:pt x="1063" y="153"/>
                </a:lnTo>
                <a:lnTo>
                  <a:pt x="1069" y="151"/>
                </a:lnTo>
                <a:lnTo>
                  <a:pt x="1074" y="151"/>
                </a:lnTo>
                <a:lnTo>
                  <a:pt x="1082" y="151"/>
                </a:lnTo>
                <a:lnTo>
                  <a:pt x="1085" y="147"/>
                </a:lnTo>
                <a:lnTo>
                  <a:pt x="1087" y="147"/>
                </a:lnTo>
                <a:lnTo>
                  <a:pt x="1093" y="145"/>
                </a:lnTo>
                <a:lnTo>
                  <a:pt x="1099" y="145"/>
                </a:lnTo>
                <a:lnTo>
                  <a:pt x="1105" y="145"/>
                </a:lnTo>
                <a:lnTo>
                  <a:pt x="1111" y="145"/>
                </a:lnTo>
                <a:lnTo>
                  <a:pt x="1117" y="145"/>
                </a:lnTo>
                <a:lnTo>
                  <a:pt x="1117" y="143"/>
                </a:lnTo>
                <a:lnTo>
                  <a:pt x="1124" y="140"/>
                </a:lnTo>
                <a:lnTo>
                  <a:pt x="1129" y="140"/>
                </a:lnTo>
                <a:lnTo>
                  <a:pt x="1135" y="138"/>
                </a:lnTo>
                <a:lnTo>
                  <a:pt x="1141" y="138"/>
                </a:lnTo>
                <a:lnTo>
                  <a:pt x="1145" y="136"/>
                </a:lnTo>
                <a:lnTo>
                  <a:pt x="1147" y="136"/>
                </a:lnTo>
                <a:lnTo>
                  <a:pt x="1153" y="136"/>
                </a:lnTo>
                <a:lnTo>
                  <a:pt x="1161" y="136"/>
                </a:lnTo>
                <a:lnTo>
                  <a:pt x="1167" y="136"/>
                </a:lnTo>
                <a:lnTo>
                  <a:pt x="1172" y="136"/>
                </a:lnTo>
                <a:lnTo>
                  <a:pt x="1177" y="136"/>
                </a:lnTo>
                <a:lnTo>
                  <a:pt x="1183" y="133"/>
                </a:lnTo>
                <a:lnTo>
                  <a:pt x="1190" y="133"/>
                </a:lnTo>
                <a:lnTo>
                  <a:pt x="1195" y="133"/>
                </a:lnTo>
                <a:lnTo>
                  <a:pt x="1202" y="133"/>
                </a:lnTo>
                <a:lnTo>
                  <a:pt x="1207" y="133"/>
                </a:lnTo>
                <a:lnTo>
                  <a:pt x="1210" y="131"/>
                </a:lnTo>
                <a:lnTo>
                  <a:pt x="1213" y="131"/>
                </a:lnTo>
                <a:lnTo>
                  <a:pt x="1221" y="128"/>
                </a:lnTo>
                <a:lnTo>
                  <a:pt x="1225" y="128"/>
                </a:lnTo>
                <a:lnTo>
                  <a:pt x="1231" y="128"/>
                </a:lnTo>
                <a:lnTo>
                  <a:pt x="1237" y="126"/>
                </a:lnTo>
                <a:lnTo>
                  <a:pt x="1244" y="126"/>
                </a:lnTo>
                <a:lnTo>
                  <a:pt x="1244" y="123"/>
                </a:lnTo>
                <a:lnTo>
                  <a:pt x="1249" y="123"/>
                </a:lnTo>
                <a:lnTo>
                  <a:pt x="1255" y="123"/>
                </a:lnTo>
                <a:lnTo>
                  <a:pt x="1261" y="120"/>
                </a:lnTo>
                <a:lnTo>
                  <a:pt x="1267" y="120"/>
                </a:lnTo>
                <a:lnTo>
                  <a:pt x="1274" y="120"/>
                </a:lnTo>
                <a:lnTo>
                  <a:pt x="1274" y="117"/>
                </a:lnTo>
                <a:lnTo>
                  <a:pt x="1279" y="117"/>
                </a:lnTo>
                <a:lnTo>
                  <a:pt x="1286" y="117"/>
                </a:lnTo>
                <a:lnTo>
                  <a:pt x="1293" y="114"/>
                </a:lnTo>
                <a:lnTo>
                  <a:pt x="1294" y="111"/>
                </a:lnTo>
                <a:lnTo>
                  <a:pt x="1298" y="111"/>
                </a:lnTo>
                <a:lnTo>
                  <a:pt x="1305" y="111"/>
                </a:lnTo>
                <a:lnTo>
                  <a:pt x="1309" y="111"/>
                </a:lnTo>
                <a:lnTo>
                  <a:pt x="1315" y="111"/>
                </a:lnTo>
                <a:lnTo>
                  <a:pt x="1321" y="108"/>
                </a:lnTo>
                <a:lnTo>
                  <a:pt x="1322" y="105"/>
                </a:lnTo>
                <a:lnTo>
                  <a:pt x="1323" y="99"/>
                </a:lnTo>
                <a:lnTo>
                  <a:pt x="1327" y="99"/>
                </a:lnTo>
                <a:lnTo>
                  <a:pt x="1334" y="99"/>
                </a:lnTo>
                <a:lnTo>
                  <a:pt x="1340" y="96"/>
                </a:lnTo>
                <a:lnTo>
                  <a:pt x="1346" y="96"/>
                </a:lnTo>
                <a:lnTo>
                  <a:pt x="1352" y="96"/>
                </a:lnTo>
                <a:lnTo>
                  <a:pt x="1357" y="96"/>
                </a:lnTo>
                <a:lnTo>
                  <a:pt x="1363" y="96"/>
                </a:lnTo>
                <a:lnTo>
                  <a:pt x="1369" y="92"/>
                </a:lnTo>
                <a:lnTo>
                  <a:pt x="1370" y="92"/>
                </a:lnTo>
                <a:lnTo>
                  <a:pt x="1376" y="92"/>
                </a:lnTo>
                <a:lnTo>
                  <a:pt x="1382" y="92"/>
                </a:lnTo>
                <a:lnTo>
                  <a:pt x="1387" y="92"/>
                </a:lnTo>
                <a:lnTo>
                  <a:pt x="1393" y="92"/>
                </a:lnTo>
                <a:lnTo>
                  <a:pt x="1399" y="92"/>
                </a:lnTo>
                <a:lnTo>
                  <a:pt x="1399" y="88"/>
                </a:lnTo>
                <a:lnTo>
                  <a:pt x="1406" y="88"/>
                </a:lnTo>
                <a:lnTo>
                  <a:pt x="1412" y="88"/>
                </a:lnTo>
                <a:lnTo>
                  <a:pt x="1419" y="88"/>
                </a:lnTo>
                <a:lnTo>
                  <a:pt x="1423" y="84"/>
                </a:lnTo>
                <a:lnTo>
                  <a:pt x="1430" y="84"/>
                </a:lnTo>
                <a:lnTo>
                  <a:pt x="1437" y="84"/>
                </a:lnTo>
                <a:lnTo>
                  <a:pt x="1442" y="84"/>
                </a:lnTo>
                <a:lnTo>
                  <a:pt x="1448" y="84"/>
                </a:lnTo>
                <a:lnTo>
                  <a:pt x="1453" y="84"/>
                </a:lnTo>
                <a:lnTo>
                  <a:pt x="1456" y="80"/>
                </a:lnTo>
                <a:lnTo>
                  <a:pt x="1460" y="80"/>
                </a:lnTo>
                <a:lnTo>
                  <a:pt x="1468" y="80"/>
                </a:lnTo>
                <a:lnTo>
                  <a:pt x="1472" y="80"/>
                </a:lnTo>
                <a:lnTo>
                  <a:pt x="1478" y="80"/>
                </a:lnTo>
                <a:lnTo>
                  <a:pt x="1484" y="80"/>
                </a:lnTo>
                <a:lnTo>
                  <a:pt x="1490" y="80"/>
                </a:lnTo>
                <a:lnTo>
                  <a:pt x="1496" y="80"/>
                </a:lnTo>
                <a:lnTo>
                  <a:pt x="1497" y="74"/>
                </a:lnTo>
                <a:lnTo>
                  <a:pt x="1502" y="74"/>
                </a:lnTo>
                <a:lnTo>
                  <a:pt x="1508" y="74"/>
                </a:lnTo>
                <a:lnTo>
                  <a:pt x="1516" y="74"/>
                </a:lnTo>
                <a:lnTo>
                  <a:pt x="1520" y="74"/>
                </a:lnTo>
                <a:lnTo>
                  <a:pt x="1526" y="74"/>
                </a:lnTo>
                <a:lnTo>
                  <a:pt x="1529" y="68"/>
                </a:lnTo>
                <a:lnTo>
                  <a:pt x="1532" y="68"/>
                </a:lnTo>
                <a:lnTo>
                  <a:pt x="1538" y="68"/>
                </a:lnTo>
                <a:lnTo>
                  <a:pt x="1544" y="68"/>
                </a:lnTo>
                <a:lnTo>
                  <a:pt x="1547" y="61"/>
                </a:lnTo>
                <a:lnTo>
                  <a:pt x="1549" y="53"/>
                </a:lnTo>
                <a:lnTo>
                  <a:pt x="1554" y="53"/>
                </a:lnTo>
                <a:lnTo>
                  <a:pt x="1557" y="53"/>
                </a:lnTo>
                <a:lnTo>
                  <a:pt x="1557" y="46"/>
                </a:lnTo>
                <a:lnTo>
                  <a:pt x="1562" y="46"/>
                </a:lnTo>
                <a:lnTo>
                  <a:pt x="1571" y="46"/>
                </a:lnTo>
                <a:lnTo>
                  <a:pt x="1576" y="46"/>
                </a:lnTo>
                <a:lnTo>
                  <a:pt x="1580" y="46"/>
                </a:lnTo>
                <a:lnTo>
                  <a:pt x="1589" y="46"/>
                </a:lnTo>
                <a:lnTo>
                  <a:pt x="1592" y="46"/>
                </a:lnTo>
                <a:lnTo>
                  <a:pt x="1598" y="46"/>
                </a:lnTo>
                <a:lnTo>
                  <a:pt x="1604" y="46"/>
                </a:lnTo>
                <a:lnTo>
                  <a:pt x="1610" y="46"/>
                </a:lnTo>
                <a:lnTo>
                  <a:pt x="1616" y="46"/>
                </a:lnTo>
                <a:lnTo>
                  <a:pt x="1623" y="46"/>
                </a:lnTo>
                <a:lnTo>
                  <a:pt x="1625" y="35"/>
                </a:lnTo>
                <a:lnTo>
                  <a:pt x="1628" y="35"/>
                </a:lnTo>
                <a:lnTo>
                  <a:pt x="1634" y="35"/>
                </a:lnTo>
                <a:lnTo>
                  <a:pt x="1640" y="35"/>
                </a:lnTo>
                <a:lnTo>
                  <a:pt x="1642" y="24"/>
                </a:lnTo>
                <a:lnTo>
                  <a:pt x="1642" y="12"/>
                </a:lnTo>
                <a:lnTo>
                  <a:pt x="1646" y="12"/>
                </a:lnTo>
                <a:lnTo>
                  <a:pt x="1650" y="0"/>
                </a:lnTo>
                <a:lnTo>
                  <a:pt x="1654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4" name="Freeform 57">
            <a:extLst>
              <a:ext uri="{FF2B5EF4-FFF2-40B4-BE49-F238E27FC236}">
                <a16:creationId xmlns:a16="http://schemas.microsoft.com/office/drawing/2014/main" id="{27CDA67C-BF89-2A78-12E4-936BE0E8112C}"/>
              </a:ext>
            </a:extLst>
          </p:cNvPr>
          <p:cNvSpPr>
            <a:spLocks/>
          </p:cNvSpPr>
          <p:nvPr/>
        </p:nvSpPr>
        <p:spPr bwMode="auto">
          <a:xfrm>
            <a:off x="7167890" y="2254227"/>
            <a:ext cx="3132286" cy="446802"/>
          </a:xfrm>
          <a:custGeom>
            <a:avLst/>
            <a:gdLst>
              <a:gd name="T0" fmla="*/ 0 w 1661"/>
              <a:gd name="T1" fmla="*/ 241 h 241"/>
              <a:gd name="T2" fmla="*/ 86 w 1661"/>
              <a:gd name="T3" fmla="*/ 241 h 241"/>
              <a:gd name="T4" fmla="*/ 144 w 1661"/>
              <a:gd name="T5" fmla="*/ 241 h 241"/>
              <a:gd name="T6" fmla="*/ 160 w 1661"/>
              <a:gd name="T7" fmla="*/ 241 h 241"/>
              <a:gd name="T8" fmla="*/ 201 w 1661"/>
              <a:gd name="T9" fmla="*/ 241 h 241"/>
              <a:gd name="T10" fmla="*/ 256 w 1661"/>
              <a:gd name="T11" fmla="*/ 241 h 241"/>
              <a:gd name="T12" fmla="*/ 296 w 1661"/>
              <a:gd name="T13" fmla="*/ 241 h 241"/>
              <a:gd name="T14" fmla="*/ 391 w 1661"/>
              <a:gd name="T15" fmla="*/ 241 h 241"/>
              <a:gd name="T16" fmla="*/ 405 w 1661"/>
              <a:gd name="T17" fmla="*/ 241 h 241"/>
              <a:gd name="T18" fmla="*/ 408 w 1661"/>
              <a:gd name="T19" fmla="*/ 241 h 241"/>
              <a:gd name="T20" fmla="*/ 452 w 1661"/>
              <a:gd name="T21" fmla="*/ 241 h 241"/>
              <a:gd name="T22" fmla="*/ 472 w 1661"/>
              <a:gd name="T23" fmla="*/ 241 h 241"/>
              <a:gd name="T24" fmla="*/ 542 w 1661"/>
              <a:gd name="T25" fmla="*/ 241 h 241"/>
              <a:gd name="T26" fmla="*/ 561 w 1661"/>
              <a:gd name="T27" fmla="*/ 241 h 241"/>
              <a:gd name="T28" fmla="*/ 573 w 1661"/>
              <a:gd name="T29" fmla="*/ 241 h 241"/>
              <a:gd name="T30" fmla="*/ 578 w 1661"/>
              <a:gd name="T31" fmla="*/ 241 h 241"/>
              <a:gd name="T32" fmla="*/ 584 w 1661"/>
              <a:gd name="T33" fmla="*/ 241 h 241"/>
              <a:gd name="T34" fmla="*/ 589 w 1661"/>
              <a:gd name="T35" fmla="*/ 241 h 241"/>
              <a:gd name="T36" fmla="*/ 594 w 1661"/>
              <a:gd name="T37" fmla="*/ 241 h 241"/>
              <a:gd name="T38" fmla="*/ 601 w 1661"/>
              <a:gd name="T39" fmla="*/ 241 h 241"/>
              <a:gd name="T40" fmla="*/ 628 w 1661"/>
              <a:gd name="T41" fmla="*/ 241 h 241"/>
              <a:gd name="T42" fmla="*/ 632 w 1661"/>
              <a:gd name="T43" fmla="*/ 241 h 241"/>
              <a:gd name="T44" fmla="*/ 647 w 1661"/>
              <a:gd name="T45" fmla="*/ 241 h 241"/>
              <a:gd name="T46" fmla="*/ 655 w 1661"/>
              <a:gd name="T47" fmla="*/ 241 h 241"/>
              <a:gd name="T48" fmla="*/ 668 w 1661"/>
              <a:gd name="T49" fmla="*/ 241 h 241"/>
              <a:gd name="T50" fmla="*/ 672 w 1661"/>
              <a:gd name="T51" fmla="*/ 241 h 241"/>
              <a:gd name="T52" fmla="*/ 678 w 1661"/>
              <a:gd name="T53" fmla="*/ 241 h 241"/>
              <a:gd name="T54" fmla="*/ 684 w 1661"/>
              <a:gd name="T55" fmla="*/ 241 h 241"/>
              <a:gd name="T56" fmla="*/ 690 w 1661"/>
              <a:gd name="T57" fmla="*/ 241 h 241"/>
              <a:gd name="T58" fmla="*/ 712 w 1661"/>
              <a:gd name="T59" fmla="*/ 241 h 241"/>
              <a:gd name="T60" fmla="*/ 738 w 1661"/>
              <a:gd name="T61" fmla="*/ 241 h 241"/>
              <a:gd name="T62" fmla="*/ 744 w 1661"/>
              <a:gd name="T63" fmla="*/ 241 h 241"/>
              <a:gd name="T64" fmla="*/ 765 w 1661"/>
              <a:gd name="T65" fmla="*/ 241 h 241"/>
              <a:gd name="T66" fmla="*/ 769 w 1661"/>
              <a:gd name="T67" fmla="*/ 241 h 241"/>
              <a:gd name="T68" fmla="*/ 801 w 1661"/>
              <a:gd name="T69" fmla="*/ 241 h 241"/>
              <a:gd name="T70" fmla="*/ 832 w 1661"/>
              <a:gd name="T71" fmla="*/ 241 h 241"/>
              <a:gd name="T72" fmla="*/ 838 w 1661"/>
              <a:gd name="T73" fmla="*/ 241 h 241"/>
              <a:gd name="T74" fmla="*/ 850 w 1661"/>
              <a:gd name="T75" fmla="*/ 241 h 241"/>
              <a:gd name="T76" fmla="*/ 880 w 1661"/>
              <a:gd name="T77" fmla="*/ 241 h 241"/>
              <a:gd name="T78" fmla="*/ 891 w 1661"/>
              <a:gd name="T79" fmla="*/ 241 h 241"/>
              <a:gd name="T80" fmla="*/ 903 w 1661"/>
              <a:gd name="T81" fmla="*/ 241 h 241"/>
              <a:gd name="T82" fmla="*/ 907 w 1661"/>
              <a:gd name="T83" fmla="*/ 241 h 241"/>
              <a:gd name="T84" fmla="*/ 917 w 1661"/>
              <a:gd name="T85" fmla="*/ 241 h 241"/>
              <a:gd name="T86" fmla="*/ 924 w 1661"/>
              <a:gd name="T87" fmla="*/ 241 h 241"/>
              <a:gd name="T88" fmla="*/ 962 w 1661"/>
              <a:gd name="T89" fmla="*/ 241 h 241"/>
              <a:gd name="T90" fmla="*/ 979 w 1661"/>
              <a:gd name="T91" fmla="*/ 241 h 241"/>
              <a:gd name="T92" fmla="*/ 979 w 1661"/>
              <a:gd name="T93" fmla="*/ 0 h 241"/>
              <a:gd name="T94" fmla="*/ 1003 w 1661"/>
              <a:gd name="T95" fmla="*/ 0 h 241"/>
              <a:gd name="T96" fmla="*/ 1009 w 1661"/>
              <a:gd name="T97" fmla="*/ 0 h 241"/>
              <a:gd name="T98" fmla="*/ 1020 w 1661"/>
              <a:gd name="T99" fmla="*/ 0 h 241"/>
              <a:gd name="T100" fmla="*/ 1023 w 1661"/>
              <a:gd name="T101" fmla="*/ 0 h 241"/>
              <a:gd name="T102" fmla="*/ 1257 w 1661"/>
              <a:gd name="T103" fmla="*/ 0 h 241"/>
              <a:gd name="T104" fmla="*/ 1395 w 1661"/>
              <a:gd name="T105" fmla="*/ 0 h 241"/>
              <a:gd name="T106" fmla="*/ 1448 w 1661"/>
              <a:gd name="T107" fmla="*/ 0 h 241"/>
              <a:gd name="T108" fmla="*/ 1661 w 1661"/>
              <a:gd name="T109" fmla="*/ 0 h 2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1661" h="241">
                <a:moveTo>
                  <a:pt x="0" y="241"/>
                </a:moveTo>
                <a:lnTo>
                  <a:pt x="86" y="241"/>
                </a:lnTo>
                <a:lnTo>
                  <a:pt x="144" y="241"/>
                </a:lnTo>
                <a:lnTo>
                  <a:pt x="160" y="241"/>
                </a:lnTo>
                <a:lnTo>
                  <a:pt x="201" y="241"/>
                </a:lnTo>
                <a:lnTo>
                  <a:pt x="256" y="241"/>
                </a:lnTo>
                <a:lnTo>
                  <a:pt x="296" y="241"/>
                </a:lnTo>
                <a:lnTo>
                  <a:pt x="391" y="241"/>
                </a:lnTo>
                <a:lnTo>
                  <a:pt x="405" y="241"/>
                </a:lnTo>
                <a:lnTo>
                  <a:pt x="408" y="241"/>
                </a:lnTo>
                <a:lnTo>
                  <a:pt x="452" y="241"/>
                </a:lnTo>
                <a:lnTo>
                  <a:pt x="472" y="241"/>
                </a:lnTo>
                <a:lnTo>
                  <a:pt x="542" y="241"/>
                </a:lnTo>
                <a:lnTo>
                  <a:pt x="561" y="241"/>
                </a:lnTo>
                <a:lnTo>
                  <a:pt x="573" y="241"/>
                </a:lnTo>
                <a:lnTo>
                  <a:pt x="578" y="241"/>
                </a:lnTo>
                <a:lnTo>
                  <a:pt x="584" y="241"/>
                </a:lnTo>
                <a:lnTo>
                  <a:pt x="589" y="241"/>
                </a:lnTo>
                <a:lnTo>
                  <a:pt x="594" y="241"/>
                </a:lnTo>
                <a:lnTo>
                  <a:pt x="601" y="241"/>
                </a:lnTo>
                <a:lnTo>
                  <a:pt x="628" y="241"/>
                </a:lnTo>
                <a:lnTo>
                  <a:pt x="632" y="241"/>
                </a:lnTo>
                <a:lnTo>
                  <a:pt x="647" y="241"/>
                </a:lnTo>
                <a:lnTo>
                  <a:pt x="655" y="241"/>
                </a:lnTo>
                <a:lnTo>
                  <a:pt x="668" y="241"/>
                </a:lnTo>
                <a:lnTo>
                  <a:pt x="672" y="241"/>
                </a:lnTo>
                <a:lnTo>
                  <a:pt x="678" y="241"/>
                </a:lnTo>
                <a:lnTo>
                  <a:pt x="684" y="241"/>
                </a:lnTo>
                <a:lnTo>
                  <a:pt x="690" y="241"/>
                </a:lnTo>
                <a:lnTo>
                  <a:pt x="712" y="241"/>
                </a:lnTo>
                <a:lnTo>
                  <a:pt x="738" y="241"/>
                </a:lnTo>
                <a:lnTo>
                  <a:pt x="744" y="241"/>
                </a:lnTo>
                <a:lnTo>
                  <a:pt x="765" y="241"/>
                </a:lnTo>
                <a:lnTo>
                  <a:pt x="769" y="241"/>
                </a:lnTo>
                <a:lnTo>
                  <a:pt x="801" y="241"/>
                </a:lnTo>
                <a:lnTo>
                  <a:pt x="832" y="241"/>
                </a:lnTo>
                <a:lnTo>
                  <a:pt x="838" y="241"/>
                </a:lnTo>
                <a:lnTo>
                  <a:pt x="850" y="241"/>
                </a:lnTo>
                <a:lnTo>
                  <a:pt x="880" y="241"/>
                </a:lnTo>
                <a:lnTo>
                  <a:pt x="891" y="241"/>
                </a:lnTo>
                <a:lnTo>
                  <a:pt x="903" y="241"/>
                </a:lnTo>
                <a:lnTo>
                  <a:pt x="907" y="241"/>
                </a:lnTo>
                <a:lnTo>
                  <a:pt x="917" y="241"/>
                </a:lnTo>
                <a:lnTo>
                  <a:pt x="924" y="241"/>
                </a:lnTo>
                <a:lnTo>
                  <a:pt x="962" y="241"/>
                </a:lnTo>
                <a:lnTo>
                  <a:pt x="979" y="241"/>
                </a:lnTo>
                <a:lnTo>
                  <a:pt x="979" y="0"/>
                </a:lnTo>
                <a:lnTo>
                  <a:pt x="1003" y="0"/>
                </a:lnTo>
                <a:lnTo>
                  <a:pt x="1009" y="0"/>
                </a:lnTo>
                <a:lnTo>
                  <a:pt x="1020" y="0"/>
                </a:lnTo>
                <a:lnTo>
                  <a:pt x="1023" y="0"/>
                </a:lnTo>
                <a:lnTo>
                  <a:pt x="1257" y="0"/>
                </a:lnTo>
                <a:lnTo>
                  <a:pt x="1395" y="0"/>
                </a:lnTo>
                <a:lnTo>
                  <a:pt x="1448" y="0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5" name="Freeform 58">
            <a:extLst>
              <a:ext uri="{FF2B5EF4-FFF2-40B4-BE49-F238E27FC236}">
                <a16:creationId xmlns:a16="http://schemas.microsoft.com/office/drawing/2014/main" id="{D548F111-37FB-526F-554C-3F05D7DA6C6B}"/>
              </a:ext>
            </a:extLst>
          </p:cNvPr>
          <p:cNvSpPr>
            <a:spLocks/>
          </p:cNvSpPr>
          <p:nvPr/>
        </p:nvSpPr>
        <p:spPr bwMode="auto">
          <a:xfrm>
            <a:off x="7167890" y="2283890"/>
            <a:ext cx="3130400" cy="417139"/>
          </a:xfrm>
          <a:custGeom>
            <a:avLst/>
            <a:gdLst>
              <a:gd name="T0" fmla="*/ 123 w 1660"/>
              <a:gd name="T1" fmla="*/ 222 h 225"/>
              <a:gd name="T2" fmla="*/ 137 w 1660"/>
              <a:gd name="T3" fmla="*/ 215 h 225"/>
              <a:gd name="T4" fmla="*/ 173 w 1660"/>
              <a:gd name="T5" fmla="*/ 211 h 225"/>
              <a:gd name="T6" fmla="*/ 193 w 1660"/>
              <a:gd name="T7" fmla="*/ 205 h 225"/>
              <a:gd name="T8" fmla="*/ 209 w 1660"/>
              <a:gd name="T9" fmla="*/ 201 h 225"/>
              <a:gd name="T10" fmla="*/ 263 w 1660"/>
              <a:gd name="T11" fmla="*/ 198 h 225"/>
              <a:gd name="T12" fmla="*/ 313 w 1660"/>
              <a:gd name="T13" fmla="*/ 198 h 225"/>
              <a:gd name="T14" fmla="*/ 335 w 1660"/>
              <a:gd name="T15" fmla="*/ 191 h 225"/>
              <a:gd name="T16" fmla="*/ 362 w 1660"/>
              <a:gd name="T17" fmla="*/ 187 h 225"/>
              <a:gd name="T18" fmla="*/ 383 w 1660"/>
              <a:gd name="T19" fmla="*/ 187 h 225"/>
              <a:gd name="T20" fmla="*/ 401 w 1660"/>
              <a:gd name="T21" fmla="*/ 177 h 225"/>
              <a:gd name="T22" fmla="*/ 419 w 1660"/>
              <a:gd name="T23" fmla="*/ 173 h 225"/>
              <a:gd name="T24" fmla="*/ 444 w 1660"/>
              <a:gd name="T25" fmla="*/ 169 h 225"/>
              <a:gd name="T26" fmla="*/ 473 w 1660"/>
              <a:gd name="T27" fmla="*/ 169 h 225"/>
              <a:gd name="T28" fmla="*/ 498 w 1660"/>
              <a:gd name="T29" fmla="*/ 169 h 225"/>
              <a:gd name="T30" fmla="*/ 539 w 1660"/>
              <a:gd name="T31" fmla="*/ 169 h 225"/>
              <a:gd name="T32" fmla="*/ 557 w 1660"/>
              <a:gd name="T33" fmla="*/ 169 h 225"/>
              <a:gd name="T34" fmla="*/ 581 w 1660"/>
              <a:gd name="T35" fmla="*/ 169 h 225"/>
              <a:gd name="T36" fmla="*/ 607 w 1660"/>
              <a:gd name="T37" fmla="*/ 169 h 225"/>
              <a:gd name="T38" fmla="*/ 625 w 1660"/>
              <a:gd name="T39" fmla="*/ 165 h 225"/>
              <a:gd name="T40" fmla="*/ 648 w 1660"/>
              <a:gd name="T41" fmla="*/ 165 h 225"/>
              <a:gd name="T42" fmla="*/ 668 w 1660"/>
              <a:gd name="T43" fmla="*/ 161 h 225"/>
              <a:gd name="T44" fmla="*/ 690 w 1660"/>
              <a:gd name="T45" fmla="*/ 156 h 225"/>
              <a:gd name="T46" fmla="*/ 715 w 1660"/>
              <a:gd name="T47" fmla="*/ 156 h 225"/>
              <a:gd name="T48" fmla="*/ 741 w 1660"/>
              <a:gd name="T49" fmla="*/ 156 h 225"/>
              <a:gd name="T50" fmla="*/ 757 w 1660"/>
              <a:gd name="T51" fmla="*/ 151 h 225"/>
              <a:gd name="T52" fmla="*/ 774 w 1660"/>
              <a:gd name="T53" fmla="*/ 145 h 225"/>
              <a:gd name="T54" fmla="*/ 805 w 1660"/>
              <a:gd name="T55" fmla="*/ 140 h 225"/>
              <a:gd name="T56" fmla="*/ 822 w 1660"/>
              <a:gd name="T57" fmla="*/ 134 h 225"/>
              <a:gd name="T58" fmla="*/ 852 w 1660"/>
              <a:gd name="T59" fmla="*/ 134 h 225"/>
              <a:gd name="T60" fmla="*/ 871 w 1660"/>
              <a:gd name="T61" fmla="*/ 128 h 225"/>
              <a:gd name="T62" fmla="*/ 882 w 1660"/>
              <a:gd name="T63" fmla="*/ 115 h 225"/>
              <a:gd name="T64" fmla="*/ 900 w 1660"/>
              <a:gd name="T65" fmla="*/ 108 h 225"/>
              <a:gd name="T66" fmla="*/ 918 w 1660"/>
              <a:gd name="T67" fmla="*/ 102 h 225"/>
              <a:gd name="T68" fmla="*/ 944 w 1660"/>
              <a:gd name="T69" fmla="*/ 102 h 225"/>
              <a:gd name="T70" fmla="*/ 971 w 1660"/>
              <a:gd name="T71" fmla="*/ 102 h 225"/>
              <a:gd name="T72" fmla="*/ 993 w 1660"/>
              <a:gd name="T73" fmla="*/ 102 h 225"/>
              <a:gd name="T74" fmla="*/ 1008 w 1660"/>
              <a:gd name="T75" fmla="*/ 93 h 225"/>
              <a:gd name="T76" fmla="*/ 1033 w 1660"/>
              <a:gd name="T77" fmla="*/ 93 h 225"/>
              <a:gd name="T78" fmla="*/ 1057 w 1660"/>
              <a:gd name="T79" fmla="*/ 93 h 225"/>
              <a:gd name="T80" fmla="*/ 1083 w 1660"/>
              <a:gd name="T81" fmla="*/ 93 h 225"/>
              <a:gd name="T82" fmla="*/ 1108 w 1660"/>
              <a:gd name="T83" fmla="*/ 93 h 225"/>
              <a:gd name="T84" fmla="*/ 1124 w 1660"/>
              <a:gd name="T85" fmla="*/ 81 h 225"/>
              <a:gd name="T86" fmla="*/ 1161 w 1660"/>
              <a:gd name="T87" fmla="*/ 81 h 225"/>
              <a:gd name="T88" fmla="*/ 1183 w 1660"/>
              <a:gd name="T89" fmla="*/ 81 h 225"/>
              <a:gd name="T90" fmla="*/ 1210 w 1660"/>
              <a:gd name="T91" fmla="*/ 81 h 225"/>
              <a:gd name="T92" fmla="*/ 1238 w 1660"/>
              <a:gd name="T93" fmla="*/ 67 h 225"/>
              <a:gd name="T94" fmla="*/ 1267 w 1660"/>
              <a:gd name="T95" fmla="*/ 67 h 225"/>
              <a:gd name="T96" fmla="*/ 1298 w 1660"/>
              <a:gd name="T97" fmla="*/ 67 h 225"/>
              <a:gd name="T98" fmla="*/ 1329 w 1660"/>
              <a:gd name="T99" fmla="*/ 67 h 225"/>
              <a:gd name="T100" fmla="*/ 1357 w 1660"/>
              <a:gd name="T101" fmla="*/ 67 h 225"/>
              <a:gd name="T102" fmla="*/ 1391 w 1660"/>
              <a:gd name="T103" fmla="*/ 67 h 225"/>
              <a:gd name="T104" fmla="*/ 1413 w 1660"/>
              <a:gd name="T105" fmla="*/ 67 h 225"/>
              <a:gd name="T106" fmla="*/ 1439 w 1660"/>
              <a:gd name="T107" fmla="*/ 67 h 225"/>
              <a:gd name="T108" fmla="*/ 1467 w 1660"/>
              <a:gd name="T109" fmla="*/ 67 h 225"/>
              <a:gd name="T110" fmla="*/ 1492 w 1660"/>
              <a:gd name="T111" fmla="*/ 38 h 225"/>
              <a:gd name="T112" fmla="*/ 1516 w 1660"/>
              <a:gd name="T113" fmla="*/ 38 h 225"/>
              <a:gd name="T114" fmla="*/ 1535 w 1660"/>
              <a:gd name="T115" fmla="*/ 0 h 225"/>
              <a:gd name="T116" fmla="*/ 1570 w 1660"/>
              <a:gd name="T117" fmla="*/ 0 h 225"/>
              <a:gd name="T118" fmla="*/ 1613 w 1660"/>
              <a:gd name="T119" fmla="*/ 0 h 225"/>
              <a:gd name="T120" fmla="*/ 1636 w 1660"/>
              <a:gd name="T121" fmla="*/ 0 h 2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1660" h="225">
                <a:moveTo>
                  <a:pt x="0" y="225"/>
                </a:moveTo>
                <a:lnTo>
                  <a:pt x="91" y="225"/>
                </a:lnTo>
                <a:lnTo>
                  <a:pt x="119" y="225"/>
                </a:lnTo>
                <a:lnTo>
                  <a:pt x="123" y="222"/>
                </a:lnTo>
                <a:lnTo>
                  <a:pt x="124" y="222"/>
                </a:lnTo>
                <a:lnTo>
                  <a:pt x="130" y="218"/>
                </a:lnTo>
                <a:lnTo>
                  <a:pt x="130" y="215"/>
                </a:lnTo>
                <a:lnTo>
                  <a:pt x="137" y="215"/>
                </a:lnTo>
                <a:lnTo>
                  <a:pt x="143" y="211"/>
                </a:lnTo>
                <a:lnTo>
                  <a:pt x="149" y="211"/>
                </a:lnTo>
                <a:lnTo>
                  <a:pt x="155" y="211"/>
                </a:lnTo>
                <a:lnTo>
                  <a:pt x="173" y="211"/>
                </a:lnTo>
                <a:lnTo>
                  <a:pt x="179" y="211"/>
                </a:lnTo>
                <a:lnTo>
                  <a:pt x="179" y="208"/>
                </a:lnTo>
                <a:lnTo>
                  <a:pt x="186" y="208"/>
                </a:lnTo>
                <a:lnTo>
                  <a:pt x="193" y="205"/>
                </a:lnTo>
                <a:lnTo>
                  <a:pt x="193" y="201"/>
                </a:lnTo>
                <a:lnTo>
                  <a:pt x="197" y="201"/>
                </a:lnTo>
                <a:lnTo>
                  <a:pt x="204" y="201"/>
                </a:lnTo>
                <a:lnTo>
                  <a:pt x="209" y="201"/>
                </a:lnTo>
                <a:lnTo>
                  <a:pt x="228" y="198"/>
                </a:lnTo>
                <a:lnTo>
                  <a:pt x="232" y="198"/>
                </a:lnTo>
                <a:lnTo>
                  <a:pt x="257" y="198"/>
                </a:lnTo>
                <a:lnTo>
                  <a:pt x="263" y="198"/>
                </a:lnTo>
                <a:lnTo>
                  <a:pt x="276" y="198"/>
                </a:lnTo>
                <a:lnTo>
                  <a:pt x="285" y="198"/>
                </a:lnTo>
                <a:lnTo>
                  <a:pt x="292" y="198"/>
                </a:lnTo>
                <a:lnTo>
                  <a:pt x="313" y="198"/>
                </a:lnTo>
                <a:lnTo>
                  <a:pt x="313" y="195"/>
                </a:lnTo>
                <a:lnTo>
                  <a:pt x="334" y="195"/>
                </a:lnTo>
                <a:lnTo>
                  <a:pt x="335" y="195"/>
                </a:lnTo>
                <a:lnTo>
                  <a:pt x="335" y="191"/>
                </a:lnTo>
                <a:lnTo>
                  <a:pt x="342" y="191"/>
                </a:lnTo>
                <a:lnTo>
                  <a:pt x="347" y="191"/>
                </a:lnTo>
                <a:lnTo>
                  <a:pt x="357" y="191"/>
                </a:lnTo>
                <a:lnTo>
                  <a:pt x="362" y="187"/>
                </a:lnTo>
                <a:lnTo>
                  <a:pt x="370" y="187"/>
                </a:lnTo>
                <a:lnTo>
                  <a:pt x="373" y="187"/>
                </a:lnTo>
                <a:lnTo>
                  <a:pt x="377" y="187"/>
                </a:lnTo>
                <a:lnTo>
                  <a:pt x="383" y="187"/>
                </a:lnTo>
                <a:lnTo>
                  <a:pt x="384" y="184"/>
                </a:lnTo>
                <a:lnTo>
                  <a:pt x="395" y="184"/>
                </a:lnTo>
                <a:lnTo>
                  <a:pt x="401" y="180"/>
                </a:lnTo>
                <a:lnTo>
                  <a:pt x="401" y="177"/>
                </a:lnTo>
                <a:lnTo>
                  <a:pt x="408" y="177"/>
                </a:lnTo>
                <a:lnTo>
                  <a:pt x="413" y="177"/>
                </a:lnTo>
                <a:lnTo>
                  <a:pt x="417" y="173"/>
                </a:lnTo>
                <a:lnTo>
                  <a:pt x="419" y="173"/>
                </a:lnTo>
                <a:lnTo>
                  <a:pt x="425" y="173"/>
                </a:lnTo>
                <a:lnTo>
                  <a:pt x="432" y="173"/>
                </a:lnTo>
                <a:lnTo>
                  <a:pt x="437" y="173"/>
                </a:lnTo>
                <a:lnTo>
                  <a:pt x="444" y="169"/>
                </a:lnTo>
                <a:lnTo>
                  <a:pt x="453" y="169"/>
                </a:lnTo>
                <a:lnTo>
                  <a:pt x="455" y="169"/>
                </a:lnTo>
                <a:lnTo>
                  <a:pt x="461" y="169"/>
                </a:lnTo>
                <a:lnTo>
                  <a:pt x="473" y="169"/>
                </a:lnTo>
                <a:lnTo>
                  <a:pt x="482" y="169"/>
                </a:lnTo>
                <a:lnTo>
                  <a:pt x="489" y="169"/>
                </a:lnTo>
                <a:lnTo>
                  <a:pt x="494" y="169"/>
                </a:lnTo>
                <a:lnTo>
                  <a:pt x="498" y="169"/>
                </a:lnTo>
                <a:lnTo>
                  <a:pt x="506" y="169"/>
                </a:lnTo>
                <a:lnTo>
                  <a:pt x="510" y="169"/>
                </a:lnTo>
                <a:lnTo>
                  <a:pt x="520" y="169"/>
                </a:lnTo>
                <a:lnTo>
                  <a:pt x="539" y="169"/>
                </a:lnTo>
                <a:lnTo>
                  <a:pt x="541" y="169"/>
                </a:lnTo>
                <a:lnTo>
                  <a:pt x="546" y="169"/>
                </a:lnTo>
                <a:lnTo>
                  <a:pt x="552" y="169"/>
                </a:lnTo>
                <a:lnTo>
                  <a:pt x="557" y="169"/>
                </a:lnTo>
                <a:lnTo>
                  <a:pt x="564" y="169"/>
                </a:lnTo>
                <a:lnTo>
                  <a:pt x="569" y="169"/>
                </a:lnTo>
                <a:lnTo>
                  <a:pt x="578" y="169"/>
                </a:lnTo>
                <a:lnTo>
                  <a:pt x="581" y="169"/>
                </a:lnTo>
                <a:lnTo>
                  <a:pt x="591" y="169"/>
                </a:lnTo>
                <a:lnTo>
                  <a:pt x="594" y="169"/>
                </a:lnTo>
                <a:lnTo>
                  <a:pt x="599" y="169"/>
                </a:lnTo>
                <a:lnTo>
                  <a:pt x="607" y="169"/>
                </a:lnTo>
                <a:lnTo>
                  <a:pt x="612" y="169"/>
                </a:lnTo>
                <a:lnTo>
                  <a:pt x="618" y="169"/>
                </a:lnTo>
                <a:lnTo>
                  <a:pt x="623" y="169"/>
                </a:lnTo>
                <a:lnTo>
                  <a:pt x="625" y="165"/>
                </a:lnTo>
                <a:lnTo>
                  <a:pt x="632" y="165"/>
                </a:lnTo>
                <a:lnTo>
                  <a:pt x="636" y="165"/>
                </a:lnTo>
                <a:lnTo>
                  <a:pt x="642" y="165"/>
                </a:lnTo>
                <a:lnTo>
                  <a:pt x="648" y="165"/>
                </a:lnTo>
                <a:lnTo>
                  <a:pt x="657" y="165"/>
                </a:lnTo>
                <a:lnTo>
                  <a:pt x="664" y="165"/>
                </a:lnTo>
                <a:lnTo>
                  <a:pt x="664" y="161"/>
                </a:lnTo>
                <a:lnTo>
                  <a:pt x="668" y="161"/>
                </a:lnTo>
                <a:lnTo>
                  <a:pt x="673" y="161"/>
                </a:lnTo>
                <a:lnTo>
                  <a:pt x="678" y="161"/>
                </a:lnTo>
                <a:lnTo>
                  <a:pt x="684" y="161"/>
                </a:lnTo>
                <a:lnTo>
                  <a:pt x="690" y="156"/>
                </a:lnTo>
                <a:lnTo>
                  <a:pt x="695" y="156"/>
                </a:lnTo>
                <a:lnTo>
                  <a:pt x="701" y="156"/>
                </a:lnTo>
                <a:lnTo>
                  <a:pt x="709" y="156"/>
                </a:lnTo>
                <a:lnTo>
                  <a:pt x="715" y="156"/>
                </a:lnTo>
                <a:lnTo>
                  <a:pt x="721" y="156"/>
                </a:lnTo>
                <a:lnTo>
                  <a:pt x="730" y="156"/>
                </a:lnTo>
                <a:lnTo>
                  <a:pt x="732" y="156"/>
                </a:lnTo>
                <a:lnTo>
                  <a:pt x="741" y="156"/>
                </a:lnTo>
                <a:lnTo>
                  <a:pt x="744" y="156"/>
                </a:lnTo>
                <a:lnTo>
                  <a:pt x="749" y="151"/>
                </a:lnTo>
                <a:lnTo>
                  <a:pt x="752" y="151"/>
                </a:lnTo>
                <a:lnTo>
                  <a:pt x="757" y="151"/>
                </a:lnTo>
                <a:lnTo>
                  <a:pt x="763" y="151"/>
                </a:lnTo>
                <a:lnTo>
                  <a:pt x="766" y="145"/>
                </a:lnTo>
                <a:lnTo>
                  <a:pt x="768" y="145"/>
                </a:lnTo>
                <a:lnTo>
                  <a:pt x="774" y="145"/>
                </a:lnTo>
                <a:lnTo>
                  <a:pt x="780" y="145"/>
                </a:lnTo>
                <a:lnTo>
                  <a:pt x="786" y="145"/>
                </a:lnTo>
                <a:lnTo>
                  <a:pt x="791" y="140"/>
                </a:lnTo>
                <a:lnTo>
                  <a:pt x="805" y="140"/>
                </a:lnTo>
                <a:lnTo>
                  <a:pt x="813" y="140"/>
                </a:lnTo>
                <a:lnTo>
                  <a:pt x="815" y="134"/>
                </a:lnTo>
                <a:lnTo>
                  <a:pt x="817" y="134"/>
                </a:lnTo>
                <a:lnTo>
                  <a:pt x="822" y="134"/>
                </a:lnTo>
                <a:lnTo>
                  <a:pt x="828" y="134"/>
                </a:lnTo>
                <a:lnTo>
                  <a:pt x="837" y="134"/>
                </a:lnTo>
                <a:lnTo>
                  <a:pt x="842" y="134"/>
                </a:lnTo>
                <a:lnTo>
                  <a:pt x="852" y="134"/>
                </a:lnTo>
                <a:lnTo>
                  <a:pt x="858" y="134"/>
                </a:lnTo>
                <a:lnTo>
                  <a:pt x="864" y="134"/>
                </a:lnTo>
                <a:lnTo>
                  <a:pt x="865" y="128"/>
                </a:lnTo>
                <a:lnTo>
                  <a:pt x="871" y="128"/>
                </a:lnTo>
                <a:lnTo>
                  <a:pt x="871" y="121"/>
                </a:lnTo>
                <a:lnTo>
                  <a:pt x="877" y="121"/>
                </a:lnTo>
                <a:lnTo>
                  <a:pt x="880" y="115"/>
                </a:lnTo>
                <a:lnTo>
                  <a:pt x="882" y="115"/>
                </a:lnTo>
                <a:lnTo>
                  <a:pt x="887" y="108"/>
                </a:lnTo>
                <a:lnTo>
                  <a:pt x="889" y="108"/>
                </a:lnTo>
                <a:lnTo>
                  <a:pt x="895" y="108"/>
                </a:lnTo>
                <a:lnTo>
                  <a:pt x="900" y="108"/>
                </a:lnTo>
                <a:lnTo>
                  <a:pt x="900" y="102"/>
                </a:lnTo>
                <a:lnTo>
                  <a:pt x="907" y="102"/>
                </a:lnTo>
                <a:lnTo>
                  <a:pt x="912" y="102"/>
                </a:lnTo>
                <a:lnTo>
                  <a:pt x="918" y="102"/>
                </a:lnTo>
                <a:lnTo>
                  <a:pt x="927" y="102"/>
                </a:lnTo>
                <a:lnTo>
                  <a:pt x="930" y="102"/>
                </a:lnTo>
                <a:lnTo>
                  <a:pt x="938" y="102"/>
                </a:lnTo>
                <a:lnTo>
                  <a:pt x="944" y="102"/>
                </a:lnTo>
                <a:lnTo>
                  <a:pt x="949" y="102"/>
                </a:lnTo>
                <a:lnTo>
                  <a:pt x="958" y="102"/>
                </a:lnTo>
                <a:lnTo>
                  <a:pt x="961" y="102"/>
                </a:lnTo>
                <a:lnTo>
                  <a:pt x="971" y="102"/>
                </a:lnTo>
                <a:lnTo>
                  <a:pt x="974" y="102"/>
                </a:lnTo>
                <a:lnTo>
                  <a:pt x="981" y="102"/>
                </a:lnTo>
                <a:lnTo>
                  <a:pt x="985" y="102"/>
                </a:lnTo>
                <a:lnTo>
                  <a:pt x="993" y="102"/>
                </a:lnTo>
                <a:lnTo>
                  <a:pt x="993" y="93"/>
                </a:lnTo>
                <a:lnTo>
                  <a:pt x="999" y="93"/>
                </a:lnTo>
                <a:lnTo>
                  <a:pt x="1003" y="93"/>
                </a:lnTo>
                <a:lnTo>
                  <a:pt x="1008" y="93"/>
                </a:lnTo>
                <a:lnTo>
                  <a:pt x="1014" y="93"/>
                </a:lnTo>
                <a:lnTo>
                  <a:pt x="1020" y="93"/>
                </a:lnTo>
                <a:lnTo>
                  <a:pt x="1027" y="93"/>
                </a:lnTo>
                <a:lnTo>
                  <a:pt x="1033" y="93"/>
                </a:lnTo>
                <a:lnTo>
                  <a:pt x="1040" y="93"/>
                </a:lnTo>
                <a:lnTo>
                  <a:pt x="1044" y="93"/>
                </a:lnTo>
                <a:lnTo>
                  <a:pt x="1052" y="93"/>
                </a:lnTo>
                <a:lnTo>
                  <a:pt x="1057" y="93"/>
                </a:lnTo>
                <a:lnTo>
                  <a:pt x="1063" y="93"/>
                </a:lnTo>
                <a:lnTo>
                  <a:pt x="1072" y="93"/>
                </a:lnTo>
                <a:lnTo>
                  <a:pt x="1077" y="93"/>
                </a:lnTo>
                <a:lnTo>
                  <a:pt x="1083" y="93"/>
                </a:lnTo>
                <a:lnTo>
                  <a:pt x="1088" y="93"/>
                </a:lnTo>
                <a:lnTo>
                  <a:pt x="1093" y="93"/>
                </a:lnTo>
                <a:lnTo>
                  <a:pt x="1099" y="93"/>
                </a:lnTo>
                <a:lnTo>
                  <a:pt x="1108" y="93"/>
                </a:lnTo>
                <a:lnTo>
                  <a:pt x="1113" y="93"/>
                </a:lnTo>
                <a:lnTo>
                  <a:pt x="1117" y="93"/>
                </a:lnTo>
                <a:lnTo>
                  <a:pt x="1120" y="81"/>
                </a:lnTo>
                <a:lnTo>
                  <a:pt x="1124" y="81"/>
                </a:lnTo>
                <a:lnTo>
                  <a:pt x="1130" y="81"/>
                </a:lnTo>
                <a:lnTo>
                  <a:pt x="1137" y="81"/>
                </a:lnTo>
                <a:lnTo>
                  <a:pt x="1153" y="81"/>
                </a:lnTo>
                <a:lnTo>
                  <a:pt x="1161" y="81"/>
                </a:lnTo>
                <a:lnTo>
                  <a:pt x="1167" y="81"/>
                </a:lnTo>
                <a:lnTo>
                  <a:pt x="1172" y="81"/>
                </a:lnTo>
                <a:lnTo>
                  <a:pt x="1177" y="81"/>
                </a:lnTo>
                <a:lnTo>
                  <a:pt x="1183" y="81"/>
                </a:lnTo>
                <a:lnTo>
                  <a:pt x="1191" y="81"/>
                </a:lnTo>
                <a:lnTo>
                  <a:pt x="1197" y="81"/>
                </a:lnTo>
                <a:lnTo>
                  <a:pt x="1204" y="81"/>
                </a:lnTo>
                <a:lnTo>
                  <a:pt x="1210" y="81"/>
                </a:lnTo>
                <a:lnTo>
                  <a:pt x="1216" y="81"/>
                </a:lnTo>
                <a:lnTo>
                  <a:pt x="1216" y="67"/>
                </a:lnTo>
                <a:lnTo>
                  <a:pt x="1234" y="67"/>
                </a:lnTo>
                <a:lnTo>
                  <a:pt x="1238" y="67"/>
                </a:lnTo>
                <a:lnTo>
                  <a:pt x="1244" y="67"/>
                </a:lnTo>
                <a:lnTo>
                  <a:pt x="1256" y="67"/>
                </a:lnTo>
                <a:lnTo>
                  <a:pt x="1261" y="67"/>
                </a:lnTo>
                <a:lnTo>
                  <a:pt x="1267" y="67"/>
                </a:lnTo>
                <a:lnTo>
                  <a:pt x="1279" y="67"/>
                </a:lnTo>
                <a:lnTo>
                  <a:pt x="1290" y="67"/>
                </a:lnTo>
                <a:lnTo>
                  <a:pt x="1296" y="67"/>
                </a:lnTo>
                <a:lnTo>
                  <a:pt x="1298" y="67"/>
                </a:lnTo>
                <a:lnTo>
                  <a:pt x="1308" y="67"/>
                </a:lnTo>
                <a:lnTo>
                  <a:pt x="1310" y="67"/>
                </a:lnTo>
                <a:lnTo>
                  <a:pt x="1318" y="67"/>
                </a:lnTo>
                <a:lnTo>
                  <a:pt x="1329" y="67"/>
                </a:lnTo>
                <a:lnTo>
                  <a:pt x="1342" y="67"/>
                </a:lnTo>
                <a:lnTo>
                  <a:pt x="1346" y="67"/>
                </a:lnTo>
                <a:lnTo>
                  <a:pt x="1351" y="67"/>
                </a:lnTo>
                <a:lnTo>
                  <a:pt x="1357" y="67"/>
                </a:lnTo>
                <a:lnTo>
                  <a:pt x="1364" y="67"/>
                </a:lnTo>
                <a:lnTo>
                  <a:pt x="1370" y="67"/>
                </a:lnTo>
                <a:lnTo>
                  <a:pt x="1382" y="67"/>
                </a:lnTo>
                <a:lnTo>
                  <a:pt x="1391" y="67"/>
                </a:lnTo>
                <a:lnTo>
                  <a:pt x="1396" y="67"/>
                </a:lnTo>
                <a:lnTo>
                  <a:pt x="1402" y="67"/>
                </a:lnTo>
                <a:lnTo>
                  <a:pt x="1407" y="67"/>
                </a:lnTo>
                <a:lnTo>
                  <a:pt x="1413" y="67"/>
                </a:lnTo>
                <a:lnTo>
                  <a:pt x="1421" y="67"/>
                </a:lnTo>
                <a:lnTo>
                  <a:pt x="1423" y="67"/>
                </a:lnTo>
                <a:lnTo>
                  <a:pt x="1429" y="67"/>
                </a:lnTo>
                <a:lnTo>
                  <a:pt x="1439" y="67"/>
                </a:lnTo>
                <a:lnTo>
                  <a:pt x="1448" y="67"/>
                </a:lnTo>
                <a:lnTo>
                  <a:pt x="1453" y="67"/>
                </a:lnTo>
                <a:lnTo>
                  <a:pt x="1463" y="67"/>
                </a:lnTo>
                <a:lnTo>
                  <a:pt x="1467" y="67"/>
                </a:lnTo>
                <a:lnTo>
                  <a:pt x="1478" y="67"/>
                </a:lnTo>
                <a:lnTo>
                  <a:pt x="1486" y="67"/>
                </a:lnTo>
                <a:lnTo>
                  <a:pt x="1492" y="67"/>
                </a:lnTo>
                <a:lnTo>
                  <a:pt x="1492" y="38"/>
                </a:lnTo>
                <a:lnTo>
                  <a:pt x="1496" y="38"/>
                </a:lnTo>
                <a:lnTo>
                  <a:pt x="1504" y="38"/>
                </a:lnTo>
                <a:lnTo>
                  <a:pt x="1512" y="38"/>
                </a:lnTo>
                <a:lnTo>
                  <a:pt x="1516" y="38"/>
                </a:lnTo>
                <a:lnTo>
                  <a:pt x="1522" y="38"/>
                </a:lnTo>
                <a:lnTo>
                  <a:pt x="1528" y="38"/>
                </a:lnTo>
                <a:lnTo>
                  <a:pt x="1528" y="0"/>
                </a:lnTo>
                <a:lnTo>
                  <a:pt x="1535" y="0"/>
                </a:lnTo>
                <a:lnTo>
                  <a:pt x="1539" y="0"/>
                </a:lnTo>
                <a:lnTo>
                  <a:pt x="1545" y="0"/>
                </a:lnTo>
                <a:lnTo>
                  <a:pt x="1550" y="0"/>
                </a:lnTo>
                <a:lnTo>
                  <a:pt x="1570" y="0"/>
                </a:lnTo>
                <a:lnTo>
                  <a:pt x="1584" y="0"/>
                </a:lnTo>
                <a:lnTo>
                  <a:pt x="1596" y="0"/>
                </a:lnTo>
                <a:lnTo>
                  <a:pt x="1606" y="0"/>
                </a:lnTo>
                <a:lnTo>
                  <a:pt x="1613" y="0"/>
                </a:lnTo>
                <a:lnTo>
                  <a:pt x="1619" y="0"/>
                </a:lnTo>
                <a:lnTo>
                  <a:pt x="1625" y="0"/>
                </a:lnTo>
                <a:lnTo>
                  <a:pt x="1630" y="0"/>
                </a:lnTo>
                <a:lnTo>
                  <a:pt x="1636" y="0"/>
                </a:lnTo>
                <a:lnTo>
                  <a:pt x="1650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9" name="Freeform 93">
            <a:extLst>
              <a:ext uri="{FF2B5EF4-FFF2-40B4-BE49-F238E27FC236}">
                <a16:creationId xmlns:a16="http://schemas.microsoft.com/office/drawing/2014/main" id="{C047A6EC-92E4-99CC-23F9-3984903CE943}"/>
              </a:ext>
            </a:extLst>
          </p:cNvPr>
          <p:cNvSpPr>
            <a:spLocks/>
          </p:cNvSpPr>
          <p:nvPr/>
        </p:nvSpPr>
        <p:spPr bwMode="auto">
          <a:xfrm>
            <a:off x="2053410" y="4576366"/>
            <a:ext cx="3139059" cy="1089582"/>
          </a:xfrm>
          <a:custGeom>
            <a:avLst/>
            <a:gdLst>
              <a:gd name="T0" fmla="*/ 97 w 1661"/>
              <a:gd name="T1" fmla="*/ 580 h 588"/>
              <a:gd name="T2" fmla="*/ 124 w 1661"/>
              <a:gd name="T3" fmla="*/ 571 h 588"/>
              <a:gd name="T4" fmla="*/ 140 w 1661"/>
              <a:gd name="T5" fmla="*/ 551 h 588"/>
              <a:gd name="T6" fmla="*/ 148 w 1661"/>
              <a:gd name="T7" fmla="*/ 534 h 588"/>
              <a:gd name="T8" fmla="*/ 169 w 1661"/>
              <a:gd name="T9" fmla="*/ 522 h 588"/>
              <a:gd name="T10" fmla="*/ 190 w 1661"/>
              <a:gd name="T11" fmla="*/ 509 h 588"/>
              <a:gd name="T12" fmla="*/ 208 w 1661"/>
              <a:gd name="T13" fmla="*/ 497 h 588"/>
              <a:gd name="T14" fmla="*/ 254 w 1661"/>
              <a:gd name="T15" fmla="*/ 492 h 588"/>
              <a:gd name="T16" fmla="*/ 277 w 1661"/>
              <a:gd name="T17" fmla="*/ 488 h 588"/>
              <a:gd name="T18" fmla="*/ 292 w 1661"/>
              <a:gd name="T19" fmla="*/ 475 h 588"/>
              <a:gd name="T20" fmla="*/ 324 w 1661"/>
              <a:gd name="T21" fmla="*/ 461 h 588"/>
              <a:gd name="T22" fmla="*/ 342 w 1661"/>
              <a:gd name="T23" fmla="*/ 448 h 588"/>
              <a:gd name="T24" fmla="*/ 373 w 1661"/>
              <a:gd name="T25" fmla="*/ 439 h 588"/>
              <a:gd name="T26" fmla="*/ 408 w 1661"/>
              <a:gd name="T27" fmla="*/ 434 h 588"/>
              <a:gd name="T28" fmla="*/ 436 w 1661"/>
              <a:gd name="T29" fmla="*/ 425 h 588"/>
              <a:gd name="T30" fmla="*/ 455 w 1661"/>
              <a:gd name="T31" fmla="*/ 420 h 588"/>
              <a:gd name="T32" fmla="*/ 486 w 1661"/>
              <a:gd name="T33" fmla="*/ 411 h 588"/>
              <a:gd name="T34" fmla="*/ 522 w 1661"/>
              <a:gd name="T35" fmla="*/ 401 h 588"/>
              <a:gd name="T36" fmla="*/ 539 w 1661"/>
              <a:gd name="T37" fmla="*/ 391 h 588"/>
              <a:gd name="T38" fmla="*/ 558 w 1661"/>
              <a:gd name="T39" fmla="*/ 376 h 588"/>
              <a:gd name="T40" fmla="*/ 582 w 1661"/>
              <a:gd name="T41" fmla="*/ 371 h 588"/>
              <a:gd name="T42" fmla="*/ 602 w 1661"/>
              <a:gd name="T43" fmla="*/ 361 h 588"/>
              <a:gd name="T44" fmla="*/ 634 w 1661"/>
              <a:gd name="T45" fmla="*/ 345 h 588"/>
              <a:gd name="T46" fmla="*/ 654 w 1661"/>
              <a:gd name="T47" fmla="*/ 340 h 588"/>
              <a:gd name="T48" fmla="*/ 678 w 1661"/>
              <a:gd name="T49" fmla="*/ 329 h 588"/>
              <a:gd name="T50" fmla="*/ 707 w 1661"/>
              <a:gd name="T51" fmla="*/ 323 h 588"/>
              <a:gd name="T52" fmla="*/ 724 w 1661"/>
              <a:gd name="T53" fmla="*/ 312 h 588"/>
              <a:gd name="T54" fmla="*/ 742 w 1661"/>
              <a:gd name="T55" fmla="*/ 301 h 588"/>
              <a:gd name="T56" fmla="*/ 768 w 1661"/>
              <a:gd name="T57" fmla="*/ 295 h 588"/>
              <a:gd name="T58" fmla="*/ 797 w 1661"/>
              <a:gd name="T59" fmla="*/ 289 h 588"/>
              <a:gd name="T60" fmla="*/ 816 w 1661"/>
              <a:gd name="T61" fmla="*/ 276 h 588"/>
              <a:gd name="T62" fmla="*/ 844 w 1661"/>
              <a:gd name="T63" fmla="*/ 270 h 588"/>
              <a:gd name="T64" fmla="*/ 870 w 1661"/>
              <a:gd name="T65" fmla="*/ 263 h 588"/>
              <a:gd name="T66" fmla="*/ 887 w 1661"/>
              <a:gd name="T67" fmla="*/ 244 h 588"/>
              <a:gd name="T68" fmla="*/ 903 w 1661"/>
              <a:gd name="T69" fmla="*/ 231 h 588"/>
              <a:gd name="T70" fmla="*/ 933 w 1661"/>
              <a:gd name="T71" fmla="*/ 231 h 588"/>
              <a:gd name="T72" fmla="*/ 954 w 1661"/>
              <a:gd name="T73" fmla="*/ 224 h 588"/>
              <a:gd name="T74" fmla="*/ 976 w 1661"/>
              <a:gd name="T75" fmla="*/ 208 h 588"/>
              <a:gd name="T76" fmla="*/ 997 w 1661"/>
              <a:gd name="T77" fmla="*/ 193 h 588"/>
              <a:gd name="T78" fmla="*/ 1027 w 1661"/>
              <a:gd name="T79" fmla="*/ 176 h 588"/>
              <a:gd name="T80" fmla="*/ 1058 w 1661"/>
              <a:gd name="T81" fmla="*/ 168 h 588"/>
              <a:gd name="T82" fmla="*/ 1082 w 1661"/>
              <a:gd name="T83" fmla="*/ 160 h 588"/>
              <a:gd name="T84" fmla="*/ 1109 w 1661"/>
              <a:gd name="T85" fmla="*/ 151 h 588"/>
              <a:gd name="T86" fmla="*/ 1140 w 1661"/>
              <a:gd name="T87" fmla="*/ 141 h 588"/>
              <a:gd name="T88" fmla="*/ 1177 w 1661"/>
              <a:gd name="T89" fmla="*/ 141 h 588"/>
              <a:gd name="T90" fmla="*/ 1227 w 1661"/>
              <a:gd name="T91" fmla="*/ 131 h 588"/>
              <a:gd name="T92" fmla="*/ 1257 w 1661"/>
              <a:gd name="T93" fmla="*/ 131 h 588"/>
              <a:gd name="T94" fmla="*/ 1279 w 1661"/>
              <a:gd name="T95" fmla="*/ 119 h 588"/>
              <a:gd name="T96" fmla="*/ 1317 w 1661"/>
              <a:gd name="T97" fmla="*/ 119 h 588"/>
              <a:gd name="T98" fmla="*/ 1346 w 1661"/>
              <a:gd name="T99" fmla="*/ 119 h 588"/>
              <a:gd name="T100" fmla="*/ 1382 w 1661"/>
              <a:gd name="T101" fmla="*/ 119 h 588"/>
              <a:gd name="T102" fmla="*/ 1413 w 1661"/>
              <a:gd name="T103" fmla="*/ 119 h 588"/>
              <a:gd name="T104" fmla="*/ 1448 w 1661"/>
              <a:gd name="T105" fmla="*/ 119 h 588"/>
              <a:gd name="T106" fmla="*/ 1473 w 1661"/>
              <a:gd name="T107" fmla="*/ 101 h 588"/>
              <a:gd name="T108" fmla="*/ 1496 w 1661"/>
              <a:gd name="T109" fmla="*/ 79 h 588"/>
              <a:gd name="T110" fmla="*/ 1528 w 1661"/>
              <a:gd name="T111" fmla="*/ 79 h 588"/>
              <a:gd name="T112" fmla="*/ 1553 w 1661"/>
              <a:gd name="T113" fmla="*/ 52 h 588"/>
              <a:gd name="T114" fmla="*/ 1599 w 1661"/>
              <a:gd name="T115" fmla="*/ 52 h 588"/>
              <a:gd name="T116" fmla="*/ 1655 w 1661"/>
              <a:gd name="T117" fmla="*/ 52 h 5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1661" h="588">
                <a:moveTo>
                  <a:pt x="0" y="588"/>
                </a:moveTo>
                <a:lnTo>
                  <a:pt x="79" y="588"/>
                </a:lnTo>
                <a:lnTo>
                  <a:pt x="79" y="584"/>
                </a:lnTo>
                <a:lnTo>
                  <a:pt x="84" y="584"/>
                </a:lnTo>
                <a:lnTo>
                  <a:pt x="97" y="580"/>
                </a:lnTo>
                <a:lnTo>
                  <a:pt x="97" y="576"/>
                </a:lnTo>
                <a:lnTo>
                  <a:pt x="101" y="576"/>
                </a:lnTo>
                <a:lnTo>
                  <a:pt x="119" y="576"/>
                </a:lnTo>
                <a:lnTo>
                  <a:pt x="123" y="571"/>
                </a:lnTo>
                <a:lnTo>
                  <a:pt x="124" y="571"/>
                </a:lnTo>
                <a:lnTo>
                  <a:pt x="130" y="567"/>
                </a:lnTo>
                <a:lnTo>
                  <a:pt x="130" y="563"/>
                </a:lnTo>
                <a:lnTo>
                  <a:pt x="132" y="559"/>
                </a:lnTo>
                <a:lnTo>
                  <a:pt x="134" y="551"/>
                </a:lnTo>
                <a:lnTo>
                  <a:pt x="140" y="551"/>
                </a:lnTo>
                <a:lnTo>
                  <a:pt x="140" y="547"/>
                </a:lnTo>
                <a:lnTo>
                  <a:pt x="142" y="547"/>
                </a:lnTo>
                <a:lnTo>
                  <a:pt x="143" y="542"/>
                </a:lnTo>
                <a:lnTo>
                  <a:pt x="148" y="538"/>
                </a:lnTo>
                <a:lnTo>
                  <a:pt x="148" y="534"/>
                </a:lnTo>
                <a:lnTo>
                  <a:pt x="149" y="530"/>
                </a:lnTo>
                <a:lnTo>
                  <a:pt x="160" y="530"/>
                </a:lnTo>
                <a:lnTo>
                  <a:pt x="160" y="530"/>
                </a:lnTo>
                <a:lnTo>
                  <a:pt x="164" y="522"/>
                </a:lnTo>
                <a:lnTo>
                  <a:pt x="169" y="522"/>
                </a:lnTo>
                <a:lnTo>
                  <a:pt x="169" y="518"/>
                </a:lnTo>
                <a:lnTo>
                  <a:pt x="179" y="518"/>
                </a:lnTo>
                <a:lnTo>
                  <a:pt x="186" y="513"/>
                </a:lnTo>
                <a:lnTo>
                  <a:pt x="190" y="513"/>
                </a:lnTo>
                <a:lnTo>
                  <a:pt x="190" y="509"/>
                </a:lnTo>
                <a:lnTo>
                  <a:pt x="193" y="505"/>
                </a:lnTo>
                <a:lnTo>
                  <a:pt x="196" y="505"/>
                </a:lnTo>
                <a:lnTo>
                  <a:pt x="198" y="497"/>
                </a:lnTo>
                <a:lnTo>
                  <a:pt x="206" y="497"/>
                </a:lnTo>
                <a:lnTo>
                  <a:pt x="208" y="497"/>
                </a:lnTo>
                <a:lnTo>
                  <a:pt x="222" y="497"/>
                </a:lnTo>
                <a:lnTo>
                  <a:pt x="233" y="497"/>
                </a:lnTo>
                <a:lnTo>
                  <a:pt x="243" y="497"/>
                </a:lnTo>
                <a:lnTo>
                  <a:pt x="251" y="497"/>
                </a:lnTo>
                <a:lnTo>
                  <a:pt x="254" y="492"/>
                </a:lnTo>
                <a:lnTo>
                  <a:pt x="257" y="492"/>
                </a:lnTo>
                <a:lnTo>
                  <a:pt x="263" y="492"/>
                </a:lnTo>
                <a:lnTo>
                  <a:pt x="266" y="488"/>
                </a:lnTo>
                <a:lnTo>
                  <a:pt x="271" y="488"/>
                </a:lnTo>
                <a:lnTo>
                  <a:pt x="277" y="488"/>
                </a:lnTo>
                <a:lnTo>
                  <a:pt x="281" y="483"/>
                </a:lnTo>
                <a:lnTo>
                  <a:pt x="281" y="479"/>
                </a:lnTo>
                <a:lnTo>
                  <a:pt x="289" y="479"/>
                </a:lnTo>
                <a:lnTo>
                  <a:pt x="292" y="479"/>
                </a:lnTo>
                <a:lnTo>
                  <a:pt x="292" y="475"/>
                </a:lnTo>
                <a:lnTo>
                  <a:pt x="298" y="470"/>
                </a:lnTo>
                <a:lnTo>
                  <a:pt x="299" y="470"/>
                </a:lnTo>
                <a:lnTo>
                  <a:pt x="302" y="461"/>
                </a:lnTo>
                <a:lnTo>
                  <a:pt x="313" y="461"/>
                </a:lnTo>
                <a:lnTo>
                  <a:pt x="324" y="461"/>
                </a:lnTo>
                <a:lnTo>
                  <a:pt x="324" y="457"/>
                </a:lnTo>
                <a:lnTo>
                  <a:pt x="331" y="457"/>
                </a:lnTo>
                <a:lnTo>
                  <a:pt x="331" y="452"/>
                </a:lnTo>
                <a:lnTo>
                  <a:pt x="335" y="448"/>
                </a:lnTo>
                <a:lnTo>
                  <a:pt x="342" y="448"/>
                </a:lnTo>
                <a:lnTo>
                  <a:pt x="348" y="448"/>
                </a:lnTo>
                <a:lnTo>
                  <a:pt x="348" y="443"/>
                </a:lnTo>
                <a:lnTo>
                  <a:pt x="355" y="443"/>
                </a:lnTo>
                <a:lnTo>
                  <a:pt x="355" y="439"/>
                </a:lnTo>
                <a:lnTo>
                  <a:pt x="373" y="439"/>
                </a:lnTo>
                <a:lnTo>
                  <a:pt x="389" y="439"/>
                </a:lnTo>
                <a:lnTo>
                  <a:pt x="389" y="434"/>
                </a:lnTo>
                <a:lnTo>
                  <a:pt x="397" y="434"/>
                </a:lnTo>
                <a:lnTo>
                  <a:pt x="401" y="434"/>
                </a:lnTo>
                <a:lnTo>
                  <a:pt x="408" y="434"/>
                </a:lnTo>
                <a:lnTo>
                  <a:pt x="414" y="434"/>
                </a:lnTo>
                <a:lnTo>
                  <a:pt x="419" y="434"/>
                </a:lnTo>
                <a:lnTo>
                  <a:pt x="428" y="434"/>
                </a:lnTo>
                <a:lnTo>
                  <a:pt x="431" y="430"/>
                </a:lnTo>
                <a:lnTo>
                  <a:pt x="436" y="425"/>
                </a:lnTo>
                <a:lnTo>
                  <a:pt x="440" y="425"/>
                </a:lnTo>
                <a:lnTo>
                  <a:pt x="440" y="420"/>
                </a:lnTo>
                <a:lnTo>
                  <a:pt x="444" y="420"/>
                </a:lnTo>
                <a:lnTo>
                  <a:pt x="449" y="420"/>
                </a:lnTo>
                <a:lnTo>
                  <a:pt x="455" y="420"/>
                </a:lnTo>
                <a:lnTo>
                  <a:pt x="457" y="411"/>
                </a:lnTo>
                <a:lnTo>
                  <a:pt x="463" y="411"/>
                </a:lnTo>
                <a:lnTo>
                  <a:pt x="467" y="411"/>
                </a:lnTo>
                <a:lnTo>
                  <a:pt x="478" y="411"/>
                </a:lnTo>
                <a:lnTo>
                  <a:pt x="486" y="411"/>
                </a:lnTo>
                <a:lnTo>
                  <a:pt x="495" y="411"/>
                </a:lnTo>
                <a:lnTo>
                  <a:pt x="495" y="406"/>
                </a:lnTo>
                <a:lnTo>
                  <a:pt x="508" y="406"/>
                </a:lnTo>
                <a:lnTo>
                  <a:pt x="508" y="401"/>
                </a:lnTo>
                <a:lnTo>
                  <a:pt x="522" y="401"/>
                </a:lnTo>
                <a:lnTo>
                  <a:pt x="530" y="401"/>
                </a:lnTo>
                <a:lnTo>
                  <a:pt x="534" y="401"/>
                </a:lnTo>
                <a:lnTo>
                  <a:pt x="535" y="396"/>
                </a:lnTo>
                <a:lnTo>
                  <a:pt x="539" y="396"/>
                </a:lnTo>
                <a:lnTo>
                  <a:pt x="539" y="391"/>
                </a:lnTo>
                <a:lnTo>
                  <a:pt x="546" y="391"/>
                </a:lnTo>
                <a:lnTo>
                  <a:pt x="546" y="386"/>
                </a:lnTo>
                <a:lnTo>
                  <a:pt x="555" y="386"/>
                </a:lnTo>
                <a:lnTo>
                  <a:pt x="557" y="386"/>
                </a:lnTo>
                <a:lnTo>
                  <a:pt x="558" y="376"/>
                </a:lnTo>
                <a:lnTo>
                  <a:pt x="565" y="376"/>
                </a:lnTo>
                <a:lnTo>
                  <a:pt x="570" y="376"/>
                </a:lnTo>
                <a:lnTo>
                  <a:pt x="575" y="376"/>
                </a:lnTo>
                <a:lnTo>
                  <a:pt x="575" y="371"/>
                </a:lnTo>
                <a:lnTo>
                  <a:pt x="582" y="371"/>
                </a:lnTo>
                <a:lnTo>
                  <a:pt x="585" y="366"/>
                </a:lnTo>
                <a:lnTo>
                  <a:pt x="589" y="366"/>
                </a:lnTo>
                <a:lnTo>
                  <a:pt x="595" y="366"/>
                </a:lnTo>
                <a:lnTo>
                  <a:pt x="602" y="366"/>
                </a:lnTo>
                <a:lnTo>
                  <a:pt x="602" y="361"/>
                </a:lnTo>
                <a:lnTo>
                  <a:pt x="619" y="361"/>
                </a:lnTo>
                <a:lnTo>
                  <a:pt x="621" y="355"/>
                </a:lnTo>
                <a:lnTo>
                  <a:pt x="628" y="355"/>
                </a:lnTo>
                <a:lnTo>
                  <a:pt x="629" y="350"/>
                </a:lnTo>
                <a:lnTo>
                  <a:pt x="634" y="345"/>
                </a:lnTo>
                <a:lnTo>
                  <a:pt x="635" y="345"/>
                </a:lnTo>
                <a:lnTo>
                  <a:pt x="635" y="340"/>
                </a:lnTo>
                <a:lnTo>
                  <a:pt x="642" y="340"/>
                </a:lnTo>
                <a:lnTo>
                  <a:pt x="648" y="340"/>
                </a:lnTo>
                <a:lnTo>
                  <a:pt x="654" y="340"/>
                </a:lnTo>
                <a:lnTo>
                  <a:pt x="656" y="334"/>
                </a:lnTo>
                <a:lnTo>
                  <a:pt x="664" y="334"/>
                </a:lnTo>
                <a:lnTo>
                  <a:pt x="664" y="329"/>
                </a:lnTo>
                <a:lnTo>
                  <a:pt x="668" y="329"/>
                </a:lnTo>
                <a:lnTo>
                  <a:pt x="678" y="329"/>
                </a:lnTo>
                <a:lnTo>
                  <a:pt x="688" y="329"/>
                </a:lnTo>
                <a:lnTo>
                  <a:pt x="690" y="329"/>
                </a:lnTo>
                <a:lnTo>
                  <a:pt x="699" y="329"/>
                </a:lnTo>
                <a:lnTo>
                  <a:pt x="701" y="329"/>
                </a:lnTo>
                <a:lnTo>
                  <a:pt x="707" y="323"/>
                </a:lnTo>
                <a:lnTo>
                  <a:pt x="709" y="323"/>
                </a:lnTo>
                <a:lnTo>
                  <a:pt x="712" y="318"/>
                </a:lnTo>
                <a:lnTo>
                  <a:pt x="715" y="318"/>
                </a:lnTo>
                <a:lnTo>
                  <a:pt x="721" y="318"/>
                </a:lnTo>
                <a:lnTo>
                  <a:pt x="724" y="312"/>
                </a:lnTo>
                <a:lnTo>
                  <a:pt x="727" y="312"/>
                </a:lnTo>
                <a:lnTo>
                  <a:pt x="732" y="312"/>
                </a:lnTo>
                <a:lnTo>
                  <a:pt x="732" y="306"/>
                </a:lnTo>
                <a:lnTo>
                  <a:pt x="737" y="306"/>
                </a:lnTo>
                <a:lnTo>
                  <a:pt x="742" y="301"/>
                </a:lnTo>
                <a:lnTo>
                  <a:pt x="747" y="301"/>
                </a:lnTo>
                <a:lnTo>
                  <a:pt x="747" y="295"/>
                </a:lnTo>
                <a:lnTo>
                  <a:pt x="755" y="295"/>
                </a:lnTo>
                <a:lnTo>
                  <a:pt x="767" y="295"/>
                </a:lnTo>
                <a:lnTo>
                  <a:pt x="768" y="295"/>
                </a:lnTo>
                <a:lnTo>
                  <a:pt x="774" y="295"/>
                </a:lnTo>
                <a:lnTo>
                  <a:pt x="780" y="295"/>
                </a:lnTo>
                <a:lnTo>
                  <a:pt x="788" y="295"/>
                </a:lnTo>
                <a:lnTo>
                  <a:pt x="797" y="295"/>
                </a:lnTo>
                <a:lnTo>
                  <a:pt x="797" y="289"/>
                </a:lnTo>
                <a:lnTo>
                  <a:pt x="801" y="289"/>
                </a:lnTo>
                <a:lnTo>
                  <a:pt x="801" y="282"/>
                </a:lnTo>
                <a:lnTo>
                  <a:pt x="812" y="282"/>
                </a:lnTo>
                <a:lnTo>
                  <a:pt x="816" y="282"/>
                </a:lnTo>
                <a:lnTo>
                  <a:pt x="816" y="276"/>
                </a:lnTo>
                <a:lnTo>
                  <a:pt x="824" y="276"/>
                </a:lnTo>
                <a:lnTo>
                  <a:pt x="832" y="276"/>
                </a:lnTo>
                <a:lnTo>
                  <a:pt x="833" y="270"/>
                </a:lnTo>
                <a:lnTo>
                  <a:pt x="838" y="270"/>
                </a:lnTo>
                <a:lnTo>
                  <a:pt x="844" y="270"/>
                </a:lnTo>
                <a:lnTo>
                  <a:pt x="844" y="263"/>
                </a:lnTo>
                <a:lnTo>
                  <a:pt x="846" y="263"/>
                </a:lnTo>
                <a:lnTo>
                  <a:pt x="859" y="263"/>
                </a:lnTo>
                <a:lnTo>
                  <a:pt x="864" y="263"/>
                </a:lnTo>
                <a:lnTo>
                  <a:pt x="870" y="263"/>
                </a:lnTo>
                <a:lnTo>
                  <a:pt x="870" y="257"/>
                </a:lnTo>
                <a:lnTo>
                  <a:pt x="871" y="251"/>
                </a:lnTo>
                <a:lnTo>
                  <a:pt x="877" y="251"/>
                </a:lnTo>
                <a:lnTo>
                  <a:pt x="882" y="251"/>
                </a:lnTo>
                <a:lnTo>
                  <a:pt x="887" y="244"/>
                </a:lnTo>
                <a:lnTo>
                  <a:pt x="891" y="244"/>
                </a:lnTo>
                <a:lnTo>
                  <a:pt x="893" y="237"/>
                </a:lnTo>
                <a:lnTo>
                  <a:pt x="896" y="237"/>
                </a:lnTo>
                <a:lnTo>
                  <a:pt x="900" y="237"/>
                </a:lnTo>
                <a:lnTo>
                  <a:pt x="903" y="231"/>
                </a:lnTo>
                <a:lnTo>
                  <a:pt x="907" y="231"/>
                </a:lnTo>
                <a:lnTo>
                  <a:pt x="915" y="231"/>
                </a:lnTo>
                <a:lnTo>
                  <a:pt x="919" y="231"/>
                </a:lnTo>
                <a:lnTo>
                  <a:pt x="924" y="231"/>
                </a:lnTo>
                <a:lnTo>
                  <a:pt x="933" y="231"/>
                </a:lnTo>
                <a:lnTo>
                  <a:pt x="934" y="224"/>
                </a:lnTo>
                <a:lnTo>
                  <a:pt x="936" y="224"/>
                </a:lnTo>
                <a:lnTo>
                  <a:pt x="944" y="224"/>
                </a:lnTo>
                <a:lnTo>
                  <a:pt x="949" y="224"/>
                </a:lnTo>
                <a:lnTo>
                  <a:pt x="954" y="224"/>
                </a:lnTo>
                <a:lnTo>
                  <a:pt x="961" y="224"/>
                </a:lnTo>
                <a:lnTo>
                  <a:pt x="971" y="224"/>
                </a:lnTo>
                <a:lnTo>
                  <a:pt x="972" y="224"/>
                </a:lnTo>
                <a:lnTo>
                  <a:pt x="972" y="216"/>
                </a:lnTo>
                <a:lnTo>
                  <a:pt x="976" y="208"/>
                </a:lnTo>
                <a:lnTo>
                  <a:pt x="979" y="208"/>
                </a:lnTo>
                <a:lnTo>
                  <a:pt x="979" y="201"/>
                </a:lnTo>
                <a:lnTo>
                  <a:pt x="988" y="201"/>
                </a:lnTo>
                <a:lnTo>
                  <a:pt x="989" y="193"/>
                </a:lnTo>
                <a:lnTo>
                  <a:pt x="997" y="193"/>
                </a:lnTo>
                <a:lnTo>
                  <a:pt x="1016" y="193"/>
                </a:lnTo>
                <a:lnTo>
                  <a:pt x="1024" y="193"/>
                </a:lnTo>
                <a:lnTo>
                  <a:pt x="1024" y="184"/>
                </a:lnTo>
                <a:lnTo>
                  <a:pt x="1025" y="176"/>
                </a:lnTo>
                <a:lnTo>
                  <a:pt x="1027" y="176"/>
                </a:lnTo>
                <a:lnTo>
                  <a:pt x="1037" y="176"/>
                </a:lnTo>
                <a:lnTo>
                  <a:pt x="1037" y="168"/>
                </a:lnTo>
                <a:lnTo>
                  <a:pt x="1040" y="168"/>
                </a:lnTo>
                <a:lnTo>
                  <a:pt x="1055" y="168"/>
                </a:lnTo>
                <a:lnTo>
                  <a:pt x="1058" y="168"/>
                </a:lnTo>
                <a:lnTo>
                  <a:pt x="1060" y="160"/>
                </a:lnTo>
                <a:lnTo>
                  <a:pt x="1067" y="160"/>
                </a:lnTo>
                <a:lnTo>
                  <a:pt x="1072" y="160"/>
                </a:lnTo>
                <a:lnTo>
                  <a:pt x="1074" y="160"/>
                </a:lnTo>
                <a:lnTo>
                  <a:pt x="1082" y="160"/>
                </a:lnTo>
                <a:lnTo>
                  <a:pt x="1085" y="151"/>
                </a:lnTo>
                <a:lnTo>
                  <a:pt x="1089" y="151"/>
                </a:lnTo>
                <a:lnTo>
                  <a:pt x="1093" y="151"/>
                </a:lnTo>
                <a:lnTo>
                  <a:pt x="1100" y="151"/>
                </a:lnTo>
                <a:lnTo>
                  <a:pt x="1109" y="151"/>
                </a:lnTo>
                <a:lnTo>
                  <a:pt x="1112" y="151"/>
                </a:lnTo>
                <a:lnTo>
                  <a:pt x="1125" y="151"/>
                </a:lnTo>
                <a:lnTo>
                  <a:pt x="1133" y="151"/>
                </a:lnTo>
                <a:lnTo>
                  <a:pt x="1133" y="141"/>
                </a:lnTo>
                <a:lnTo>
                  <a:pt x="1140" y="141"/>
                </a:lnTo>
                <a:lnTo>
                  <a:pt x="1150" y="141"/>
                </a:lnTo>
                <a:lnTo>
                  <a:pt x="1157" y="141"/>
                </a:lnTo>
                <a:lnTo>
                  <a:pt x="1167" y="141"/>
                </a:lnTo>
                <a:lnTo>
                  <a:pt x="1174" y="141"/>
                </a:lnTo>
                <a:lnTo>
                  <a:pt x="1177" y="141"/>
                </a:lnTo>
                <a:lnTo>
                  <a:pt x="1181" y="131"/>
                </a:lnTo>
                <a:lnTo>
                  <a:pt x="1183" y="131"/>
                </a:lnTo>
                <a:lnTo>
                  <a:pt x="1190" y="131"/>
                </a:lnTo>
                <a:lnTo>
                  <a:pt x="1202" y="131"/>
                </a:lnTo>
                <a:lnTo>
                  <a:pt x="1227" y="131"/>
                </a:lnTo>
                <a:lnTo>
                  <a:pt x="1231" y="131"/>
                </a:lnTo>
                <a:lnTo>
                  <a:pt x="1237" y="131"/>
                </a:lnTo>
                <a:lnTo>
                  <a:pt x="1247" y="131"/>
                </a:lnTo>
                <a:lnTo>
                  <a:pt x="1253" y="131"/>
                </a:lnTo>
                <a:lnTo>
                  <a:pt x="1257" y="131"/>
                </a:lnTo>
                <a:lnTo>
                  <a:pt x="1263" y="131"/>
                </a:lnTo>
                <a:lnTo>
                  <a:pt x="1270" y="131"/>
                </a:lnTo>
                <a:lnTo>
                  <a:pt x="1274" y="131"/>
                </a:lnTo>
                <a:lnTo>
                  <a:pt x="1274" y="119"/>
                </a:lnTo>
                <a:lnTo>
                  <a:pt x="1279" y="119"/>
                </a:lnTo>
                <a:lnTo>
                  <a:pt x="1286" y="119"/>
                </a:lnTo>
                <a:lnTo>
                  <a:pt x="1298" y="119"/>
                </a:lnTo>
                <a:lnTo>
                  <a:pt x="1306" y="119"/>
                </a:lnTo>
                <a:lnTo>
                  <a:pt x="1309" y="119"/>
                </a:lnTo>
                <a:lnTo>
                  <a:pt x="1317" y="119"/>
                </a:lnTo>
                <a:lnTo>
                  <a:pt x="1322" y="119"/>
                </a:lnTo>
                <a:lnTo>
                  <a:pt x="1327" y="119"/>
                </a:lnTo>
                <a:lnTo>
                  <a:pt x="1339" y="119"/>
                </a:lnTo>
                <a:lnTo>
                  <a:pt x="1342" y="119"/>
                </a:lnTo>
                <a:lnTo>
                  <a:pt x="1346" y="119"/>
                </a:lnTo>
                <a:lnTo>
                  <a:pt x="1359" y="119"/>
                </a:lnTo>
                <a:lnTo>
                  <a:pt x="1363" y="119"/>
                </a:lnTo>
                <a:lnTo>
                  <a:pt x="1375" y="119"/>
                </a:lnTo>
                <a:lnTo>
                  <a:pt x="1376" y="119"/>
                </a:lnTo>
                <a:lnTo>
                  <a:pt x="1382" y="119"/>
                </a:lnTo>
                <a:lnTo>
                  <a:pt x="1390" y="119"/>
                </a:lnTo>
                <a:lnTo>
                  <a:pt x="1393" y="119"/>
                </a:lnTo>
                <a:lnTo>
                  <a:pt x="1399" y="119"/>
                </a:lnTo>
                <a:lnTo>
                  <a:pt x="1408" y="119"/>
                </a:lnTo>
                <a:lnTo>
                  <a:pt x="1413" y="119"/>
                </a:lnTo>
                <a:lnTo>
                  <a:pt x="1423" y="119"/>
                </a:lnTo>
                <a:lnTo>
                  <a:pt x="1426" y="119"/>
                </a:lnTo>
                <a:lnTo>
                  <a:pt x="1432" y="119"/>
                </a:lnTo>
                <a:lnTo>
                  <a:pt x="1443" y="119"/>
                </a:lnTo>
                <a:lnTo>
                  <a:pt x="1448" y="119"/>
                </a:lnTo>
                <a:lnTo>
                  <a:pt x="1456" y="119"/>
                </a:lnTo>
                <a:lnTo>
                  <a:pt x="1456" y="101"/>
                </a:lnTo>
                <a:lnTo>
                  <a:pt x="1463" y="101"/>
                </a:lnTo>
                <a:lnTo>
                  <a:pt x="1468" y="101"/>
                </a:lnTo>
                <a:lnTo>
                  <a:pt x="1473" y="101"/>
                </a:lnTo>
                <a:lnTo>
                  <a:pt x="1482" y="101"/>
                </a:lnTo>
                <a:lnTo>
                  <a:pt x="1484" y="101"/>
                </a:lnTo>
                <a:lnTo>
                  <a:pt x="1490" y="101"/>
                </a:lnTo>
                <a:lnTo>
                  <a:pt x="1492" y="79"/>
                </a:lnTo>
                <a:lnTo>
                  <a:pt x="1496" y="79"/>
                </a:lnTo>
                <a:lnTo>
                  <a:pt x="1502" y="79"/>
                </a:lnTo>
                <a:lnTo>
                  <a:pt x="1510" y="79"/>
                </a:lnTo>
                <a:lnTo>
                  <a:pt x="1517" y="79"/>
                </a:lnTo>
                <a:lnTo>
                  <a:pt x="1522" y="79"/>
                </a:lnTo>
                <a:lnTo>
                  <a:pt x="1528" y="79"/>
                </a:lnTo>
                <a:lnTo>
                  <a:pt x="1529" y="52"/>
                </a:lnTo>
                <a:lnTo>
                  <a:pt x="1532" y="52"/>
                </a:lnTo>
                <a:lnTo>
                  <a:pt x="1543" y="52"/>
                </a:lnTo>
                <a:lnTo>
                  <a:pt x="1544" y="52"/>
                </a:lnTo>
                <a:lnTo>
                  <a:pt x="1553" y="52"/>
                </a:lnTo>
                <a:lnTo>
                  <a:pt x="1559" y="52"/>
                </a:lnTo>
                <a:lnTo>
                  <a:pt x="1571" y="52"/>
                </a:lnTo>
                <a:lnTo>
                  <a:pt x="1591" y="52"/>
                </a:lnTo>
                <a:lnTo>
                  <a:pt x="1593" y="52"/>
                </a:lnTo>
                <a:lnTo>
                  <a:pt x="1599" y="52"/>
                </a:lnTo>
                <a:lnTo>
                  <a:pt x="1619" y="52"/>
                </a:lnTo>
                <a:lnTo>
                  <a:pt x="1623" y="52"/>
                </a:lnTo>
                <a:lnTo>
                  <a:pt x="1628" y="52"/>
                </a:lnTo>
                <a:lnTo>
                  <a:pt x="1649" y="52"/>
                </a:lnTo>
                <a:lnTo>
                  <a:pt x="1655" y="52"/>
                </a:lnTo>
                <a:lnTo>
                  <a:pt x="1660" y="52"/>
                </a:lnTo>
                <a:lnTo>
                  <a:pt x="1661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0" name="Freeform 94">
            <a:extLst>
              <a:ext uri="{FF2B5EF4-FFF2-40B4-BE49-F238E27FC236}">
                <a16:creationId xmlns:a16="http://schemas.microsoft.com/office/drawing/2014/main" id="{A0681777-318D-09AE-E829-7A4F8469C68E}"/>
              </a:ext>
            </a:extLst>
          </p:cNvPr>
          <p:cNvSpPr>
            <a:spLocks/>
          </p:cNvSpPr>
          <p:nvPr/>
        </p:nvSpPr>
        <p:spPr bwMode="auto">
          <a:xfrm>
            <a:off x="2053410" y="5135981"/>
            <a:ext cx="3137168" cy="529967"/>
          </a:xfrm>
          <a:custGeom>
            <a:avLst/>
            <a:gdLst>
              <a:gd name="T0" fmla="*/ 92 w 1660"/>
              <a:gd name="T1" fmla="*/ 282 h 286"/>
              <a:gd name="T2" fmla="*/ 130 w 1660"/>
              <a:gd name="T3" fmla="*/ 281 h 286"/>
              <a:gd name="T4" fmla="*/ 154 w 1660"/>
              <a:gd name="T5" fmla="*/ 277 h 286"/>
              <a:gd name="T6" fmla="*/ 186 w 1660"/>
              <a:gd name="T7" fmla="*/ 274 h 286"/>
              <a:gd name="T8" fmla="*/ 209 w 1660"/>
              <a:gd name="T9" fmla="*/ 271 h 286"/>
              <a:gd name="T10" fmla="*/ 244 w 1660"/>
              <a:gd name="T11" fmla="*/ 267 h 286"/>
              <a:gd name="T12" fmla="*/ 270 w 1660"/>
              <a:gd name="T13" fmla="*/ 263 h 286"/>
              <a:gd name="T14" fmla="*/ 302 w 1660"/>
              <a:gd name="T15" fmla="*/ 263 h 286"/>
              <a:gd name="T16" fmla="*/ 325 w 1660"/>
              <a:gd name="T17" fmla="*/ 258 h 286"/>
              <a:gd name="T18" fmla="*/ 355 w 1660"/>
              <a:gd name="T19" fmla="*/ 256 h 286"/>
              <a:gd name="T20" fmla="*/ 377 w 1660"/>
              <a:gd name="T21" fmla="*/ 251 h 286"/>
              <a:gd name="T22" fmla="*/ 401 w 1660"/>
              <a:gd name="T23" fmla="*/ 247 h 286"/>
              <a:gd name="T24" fmla="*/ 425 w 1660"/>
              <a:gd name="T25" fmla="*/ 240 h 286"/>
              <a:gd name="T26" fmla="*/ 455 w 1660"/>
              <a:gd name="T27" fmla="*/ 236 h 286"/>
              <a:gd name="T28" fmla="*/ 484 w 1660"/>
              <a:gd name="T29" fmla="*/ 235 h 286"/>
              <a:gd name="T30" fmla="*/ 514 w 1660"/>
              <a:gd name="T31" fmla="*/ 231 h 286"/>
              <a:gd name="T32" fmla="*/ 534 w 1660"/>
              <a:gd name="T33" fmla="*/ 228 h 286"/>
              <a:gd name="T34" fmla="*/ 563 w 1660"/>
              <a:gd name="T35" fmla="*/ 223 h 286"/>
              <a:gd name="T36" fmla="*/ 591 w 1660"/>
              <a:gd name="T37" fmla="*/ 219 h 286"/>
              <a:gd name="T38" fmla="*/ 612 w 1660"/>
              <a:gd name="T39" fmla="*/ 216 h 286"/>
              <a:gd name="T40" fmla="*/ 642 w 1660"/>
              <a:gd name="T41" fmla="*/ 213 h 286"/>
              <a:gd name="T42" fmla="*/ 668 w 1660"/>
              <a:gd name="T43" fmla="*/ 207 h 286"/>
              <a:gd name="T44" fmla="*/ 690 w 1660"/>
              <a:gd name="T45" fmla="*/ 202 h 286"/>
              <a:gd name="T46" fmla="*/ 714 w 1660"/>
              <a:gd name="T47" fmla="*/ 196 h 286"/>
              <a:gd name="T48" fmla="*/ 744 w 1660"/>
              <a:gd name="T49" fmla="*/ 196 h 286"/>
              <a:gd name="T50" fmla="*/ 768 w 1660"/>
              <a:gd name="T51" fmla="*/ 191 h 286"/>
              <a:gd name="T52" fmla="*/ 801 w 1660"/>
              <a:gd name="T53" fmla="*/ 189 h 286"/>
              <a:gd name="T54" fmla="*/ 822 w 1660"/>
              <a:gd name="T55" fmla="*/ 186 h 286"/>
              <a:gd name="T56" fmla="*/ 852 w 1660"/>
              <a:gd name="T57" fmla="*/ 182 h 286"/>
              <a:gd name="T58" fmla="*/ 880 w 1660"/>
              <a:gd name="T59" fmla="*/ 180 h 286"/>
              <a:gd name="T60" fmla="*/ 900 w 1660"/>
              <a:gd name="T61" fmla="*/ 174 h 286"/>
              <a:gd name="T62" fmla="*/ 930 w 1660"/>
              <a:gd name="T63" fmla="*/ 172 h 286"/>
              <a:gd name="T64" fmla="*/ 961 w 1660"/>
              <a:gd name="T65" fmla="*/ 169 h 286"/>
              <a:gd name="T66" fmla="*/ 991 w 1660"/>
              <a:gd name="T67" fmla="*/ 169 h 286"/>
              <a:gd name="T68" fmla="*/ 1014 w 1660"/>
              <a:gd name="T69" fmla="*/ 167 h 286"/>
              <a:gd name="T70" fmla="*/ 1045 w 1660"/>
              <a:gd name="T71" fmla="*/ 164 h 286"/>
              <a:gd name="T72" fmla="*/ 1069 w 1660"/>
              <a:gd name="T73" fmla="*/ 157 h 286"/>
              <a:gd name="T74" fmla="*/ 1093 w 1660"/>
              <a:gd name="T75" fmla="*/ 151 h 286"/>
              <a:gd name="T76" fmla="*/ 1117 w 1660"/>
              <a:gd name="T77" fmla="*/ 149 h 286"/>
              <a:gd name="T78" fmla="*/ 1141 w 1660"/>
              <a:gd name="T79" fmla="*/ 143 h 286"/>
              <a:gd name="T80" fmla="*/ 1172 w 1660"/>
              <a:gd name="T81" fmla="*/ 143 h 286"/>
              <a:gd name="T82" fmla="*/ 1204 w 1660"/>
              <a:gd name="T83" fmla="*/ 143 h 286"/>
              <a:gd name="T84" fmla="*/ 1225 w 1660"/>
              <a:gd name="T85" fmla="*/ 137 h 286"/>
              <a:gd name="T86" fmla="*/ 1255 w 1660"/>
              <a:gd name="T87" fmla="*/ 133 h 286"/>
              <a:gd name="T88" fmla="*/ 1279 w 1660"/>
              <a:gd name="T89" fmla="*/ 130 h 286"/>
              <a:gd name="T90" fmla="*/ 1298 w 1660"/>
              <a:gd name="T91" fmla="*/ 118 h 286"/>
              <a:gd name="T92" fmla="*/ 1323 w 1660"/>
              <a:gd name="T93" fmla="*/ 110 h 286"/>
              <a:gd name="T94" fmla="*/ 1340 w 1660"/>
              <a:gd name="T95" fmla="*/ 102 h 286"/>
              <a:gd name="T96" fmla="*/ 1370 w 1660"/>
              <a:gd name="T97" fmla="*/ 98 h 286"/>
              <a:gd name="T98" fmla="*/ 1399 w 1660"/>
              <a:gd name="T99" fmla="*/ 98 h 286"/>
              <a:gd name="T100" fmla="*/ 1423 w 1660"/>
              <a:gd name="T101" fmla="*/ 93 h 286"/>
              <a:gd name="T102" fmla="*/ 1453 w 1660"/>
              <a:gd name="T103" fmla="*/ 93 h 286"/>
              <a:gd name="T104" fmla="*/ 1484 w 1660"/>
              <a:gd name="T105" fmla="*/ 93 h 286"/>
              <a:gd name="T106" fmla="*/ 1508 w 1660"/>
              <a:gd name="T107" fmla="*/ 85 h 286"/>
              <a:gd name="T108" fmla="*/ 1528 w 1660"/>
              <a:gd name="T109" fmla="*/ 70 h 286"/>
              <a:gd name="T110" fmla="*/ 1549 w 1660"/>
              <a:gd name="T111" fmla="*/ 51 h 286"/>
              <a:gd name="T112" fmla="*/ 1570 w 1660"/>
              <a:gd name="T113" fmla="*/ 42 h 286"/>
              <a:gd name="T114" fmla="*/ 1598 w 1660"/>
              <a:gd name="T115" fmla="*/ 42 h 286"/>
              <a:gd name="T116" fmla="*/ 1625 w 1660"/>
              <a:gd name="T117" fmla="*/ 28 h 286"/>
              <a:gd name="T118" fmla="*/ 1642 w 1660"/>
              <a:gd name="T119" fmla="*/ 0 h 2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660" h="286">
                <a:moveTo>
                  <a:pt x="0" y="286"/>
                </a:moveTo>
                <a:lnTo>
                  <a:pt x="79" y="286"/>
                </a:lnTo>
                <a:lnTo>
                  <a:pt x="84" y="283"/>
                </a:lnTo>
                <a:lnTo>
                  <a:pt x="84" y="282"/>
                </a:lnTo>
                <a:lnTo>
                  <a:pt x="92" y="282"/>
                </a:lnTo>
                <a:lnTo>
                  <a:pt x="105" y="282"/>
                </a:lnTo>
                <a:lnTo>
                  <a:pt x="116" y="282"/>
                </a:lnTo>
                <a:lnTo>
                  <a:pt x="121" y="282"/>
                </a:lnTo>
                <a:lnTo>
                  <a:pt x="127" y="282"/>
                </a:lnTo>
                <a:lnTo>
                  <a:pt x="130" y="281"/>
                </a:lnTo>
                <a:lnTo>
                  <a:pt x="137" y="280"/>
                </a:lnTo>
                <a:lnTo>
                  <a:pt x="143" y="278"/>
                </a:lnTo>
                <a:lnTo>
                  <a:pt x="144" y="277"/>
                </a:lnTo>
                <a:lnTo>
                  <a:pt x="148" y="277"/>
                </a:lnTo>
                <a:lnTo>
                  <a:pt x="154" y="277"/>
                </a:lnTo>
                <a:lnTo>
                  <a:pt x="160" y="277"/>
                </a:lnTo>
                <a:lnTo>
                  <a:pt x="166" y="277"/>
                </a:lnTo>
                <a:lnTo>
                  <a:pt x="173" y="277"/>
                </a:lnTo>
                <a:lnTo>
                  <a:pt x="183" y="275"/>
                </a:lnTo>
                <a:lnTo>
                  <a:pt x="186" y="274"/>
                </a:lnTo>
                <a:lnTo>
                  <a:pt x="190" y="273"/>
                </a:lnTo>
                <a:lnTo>
                  <a:pt x="197" y="272"/>
                </a:lnTo>
                <a:lnTo>
                  <a:pt x="206" y="272"/>
                </a:lnTo>
                <a:lnTo>
                  <a:pt x="209" y="272"/>
                </a:lnTo>
                <a:lnTo>
                  <a:pt x="209" y="271"/>
                </a:lnTo>
                <a:lnTo>
                  <a:pt x="215" y="271"/>
                </a:lnTo>
                <a:lnTo>
                  <a:pt x="220" y="268"/>
                </a:lnTo>
                <a:lnTo>
                  <a:pt x="228" y="267"/>
                </a:lnTo>
                <a:lnTo>
                  <a:pt x="235" y="267"/>
                </a:lnTo>
                <a:lnTo>
                  <a:pt x="244" y="267"/>
                </a:lnTo>
                <a:lnTo>
                  <a:pt x="249" y="263"/>
                </a:lnTo>
                <a:lnTo>
                  <a:pt x="253" y="263"/>
                </a:lnTo>
                <a:lnTo>
                  <a:pt x="256" y="263"/>
                </a:lnTo>
                <a:lnTo>
                  <a:pt x="265" y="263"/>
                </a:lnTo>
                <a:lnTo>
                  <a:pt x="270" y="263"/>
                </a:lnTo>
                <a:lnTo>
                  <a:pt x="275" y="263"/>
                </a:lnTo>
                <a:lnTo>
                  <a:pt x="281" y="263"/>
                </a:lnTo>
                <a:lnTo>
                  <a:pt x="287" y="263"/>
                </a:lnTo>
                <a:lnTo>
                  <a:pt x="292" y="263"/>
                </a:lnTo>
                <a:lnTo>
                  <a:pt x="302" y="263"/>
                </a:lnTo>
                <a:lnTo>
                  <a:pt x="305" y="262"/>
                </a:lnTo>
                <a:lnTo>
                  <a:pt x="313" y="262"/>
                </a:lnTo>
                <a:lnTo>
                  <a:pt x="319" y="259"/>
                </a:lnTo>
                <a:lnTo>
                  <a:pt x="322" y="259"/>
                </a:lnTo>
                <a:lnTo>
                  <a:pt x="325" y="258"/>
                </a:lnTo>
                <a:lnTo>
                  <a:pt x="332" y="258"/>
                </a:lnTo>
                <a:lnTo>
                  <a:pt x="335" y="257"/>
                </a:lnTo>
                <a:lnTo>
                  <a:pt x="342" y="257"/>
                </a:lnTo>
                <a:lnTo>
                  <a:pt x="346" y="257"/>
                </a:lnTo>
                <a:lnTo>
                  <a:pt x="355" y="256"/>
                </a:lnTo>
                <a:lnTo>
                  <a:pt x="361" y="253"/>
                </a:lnTo>
                <a:lnTo>
                  <a:pt x="367" y="253"/>
                </a:lnTo>
                <a:lnTo>
                  <a:pt x="372" y="253"/>
                </a:lnTo>
                <a:lnTo>
                  <a:pt x="374" y="252"/>
                </a:lnTo>
                <a:lnTo>
                  <a:pt x="377" y="251"/>
                </a:lnTo>
                <a:lnTo>
                  <a:pt x="383" y="251"/>
                </a:lnTo>
                <a:lnTo>
                  <a:pt x="389" y="249"/>
                </a:lnTo>
                <a:lnTo>
                  <a:pt x="398" y="248"/>
                </a:lnTo>
                <a:lnTo>
                  <a:pt x="398" y="247"/>
                </a:lnTo>
                <a:lnTo>
                  <a:pt x="401" y="247"/>
                </a:lnTo>
                <a:lnTo>
                  <a:pt x="408" y="244"/>
                </a:lnTo>
                <a:lnTo>
                  <a:pt x="413" y="243"/>
                </a:lnTo>
                <a:lnTo>
                  <a:pt x="417" y="240"/>
                </a:lnTo>
                <a:lnTo>
                  <a:pt x="419" y="240"/>
                </a:lnTo>
                <a:lnTo>
                  <a:pt x="425" y="240"/>
                </a:lnTo>
                <a:lnTo>
                  <a:pt x="431" y="240"/>
                </a:lnTo>
                <a:lnTo>
                  <a:pt x="438" y="240"/>
                </a:lnTo>
                <a:lnTo>
                  <a:pt x="444" y="239"/>
                </a:lnTo>
                <a:lnTo>
                  <a:pt x="452" y="237"/>
                </a:lnTo>
                <a:lnTo>
                  <a:pt x="455" y="236"/>
                </a:lnTo>
                <a:lnTo>
                  <a:pt x="461" y="235"/>
                </a:lnTo>
                <a:lnTo>
                  <a:pt x="471" y="235"/>
                </a:lnTo>
                <a:lnTo>
                  <a:pt x="473" y="235"/>
                </a:lnTo>
                <a:lnTo>
                  <a:pt x="481" y="235"/>
                </a:lnTo>
                <a:lnTo>
                  <a:pt x="484" y="235"/>
                </a:lnTo>
                <a:lnTo>
                  <a:pt x="492" y="235"/>
                </a:lnTo>
                <a:lnTo>
                  <a:pt x="492" y="234"/>
                </a:lnTo>
                <a:lnTo>
                  <a:pt x="497" y="232"/>
                </a:lnTo>
                <a:lnTo>
                  <a:pt x="506" y="231"/>
                </a:lnTo>
                <a:lnTo>
                  <a:pt x="514" y="231"/>
                </a:lnTo>
                <a:lnTo>
                  <a:pt x="517" y="230"/>
                </a:lnTo>
                <a:lnTo>
                  <a:pt x="517" y="228"/>
                </a:lnTo>
                <a:lnTo>
                  <a:pt x="524" y="228"/>
                </a:lnTo>
                <a:lnTo>
                  <a:pt x="527" y="228"/>
                </a:lnTo>
                <a:lnTo>
                  <a:pt x="534" y="228"/>
                </a:lnTo>
                <a:lnTo>
                  <a:pt x="539" y="227"/>
                </a:lnTo>
                <a:lnTo>
                  <a:pt x="546" y="227"/>
                </a:lnTo>
                <a:lnTo>
                  <a:pt x="552" y="227"/>
                </a:lnTo>
                <a:lnTo>
                  <a:pt x="557" y="226"/>
                </a:lnTo>
                <a:lnTo>
                  <a:pt x="563" y="223"/>
                </a:lnTo>
                <a:lnTo>
                  <a:pt x="569" y="223"/>
                </a:lnTo>
                <a:lnTo>
                  <a:pt x="573" y="222"/>
                </a:lnTo>
                <a:lnTo>
                  <a:pt x="578" y="222"/>
                </a:lnTo>
                <a:lnTo>
                  <a:pt x="581" y="222"/>
                </a:lnTo>
                <a:lnTo>
                  <a:pt x="591" y="219"/>
                </a:lnTo>
                <a:lnTo>
                  <a:pt x="593" y="219"/>
                </a:lnTo>
                <a:lnTo>
                  <a:pt x="599" y="217"/>
                </a:lnTo>
                <a:lnTo>
                  <a:pt x="602" y="216"/>
                </a:lnTo>
                <a:lnTo>
                  <a:pt x="607" y="216"/>
                </a:lnTo>
                <a:lnTo>
                  <a:pt x="612" y="216"/>
                </a:lnTo>
                <a:lnTo>
                  <a:pt x="618" y="216"/>
                </a:lnTo>
                <a:lnTo>
                  <a:pt x="623" y="216"/>
                </a:lnTo>
                <a:lnTo>
                  <a:pt x="629" y="215"/>
                </a:lnTo>
                <a:lnTo>
                  <a:pt x="635" y="215"/>
                </a:lnTo>
                <a:lnTo>
                  <a:pt x="642" y="213"/>
                </a:lnTo>
                <a:lnTo>
                  <a:pt x="644" y="210"/>
                </a:lnTo>
                <a:lnTo>
                  <a:pt x="648" y="210"/>
                </a:lnTo>
                <a:lnTo>
                  <a:pt x="654" y="210"/>
                </a:lnTo>
                <a:lnTo>
                  <a:pt x="660" y="207"/>
                </a:lnTo>
                <a:lnTo>
                  <a:pt x="668" y="207"/>
                </a:lnTo>
                <a:lnTo>
                  <a:pt x="672" y="205"/>
                </a:lnTo>
                <a:lnTo>
                  <a:pt x="673" y="204"/>
                </a:lnTo>
                <a:lnTo>
                  <a:pt x="678" y="204"/>
                </a:lnTo>
                <a:lnTo>
                  <a:pt x="684" y="204"/>
                </a:lnTo>
                <a:lnTo>
                  <a:pt x="690" y="202"/>
                </a:lnTo>
                <a:lnTo>
                  <a:pt x="695" y="201"/>
                </a:lnTo>
                <a:lnTo>
                  <a:pt x="701" y="199"/>
                </a:lnTo>
                <a:lnTo>
                  <a:pt x="709" y="199"/>
                </a:lnTo>
                <a:lnTo>
                  <a:pt x="711" y="196"/>
                </a:lnTo>
                <a:lnTo>
                  <a:pt x="714" y="196"/>
                </a:lnTo>
                <a:lnTo>
                  <a:pt x="721" y="196"/>
                </a:lnTo>
                <a:lnTo>
                  <a:pt x="727" y="196"/>
                </a:lnTo>
                <a:lnTo>
                  <a:pt x="731" y="196"/>
                </a:lnTo>
                <a:lnTo>
                  <a:pt x="737" y="196"/>
                </a:lnTo>
                <a:lnTo>
                  <a:pt x="744" y="196"/>
                </a:lnTo>
                <a:lnTo>
                  <a:pt x="754" y="194"/>
                </a:lnTo>
                <a:lnTo>
                  <a:pt x="756" y="194"/>
                </a:lnTo>
                <a:lnTo>
                  <a:pt x="762" y="194"/>
                </a:lnTo>
                <a:lnTo>
                  <a:pt x="766" y="191"/>
                </a:lnTo>
                <a:lnTo>
                  <a:pt x="768" y="191"/>
                </a:lnTo>
                <a:lnTo>
                  <a:pt x="774" y="191"/>
                </a:lnTo>
                <a:lnTo>
                  <a:pt x="780" y="191"/>
                </a:lnTo>
                <a:lnTo>
                  <a:pt x="786" y="191"/>
                </a:lnTo>
                <a:lnTo>
                  <a:pt x="792" y="189"/>
                </a:lnTo>
                <a:lnTo>
                  <a:pt x="801" y="189"/>
                </a:lnTo>
                <a:lnTo>
                  <a:pt x="804" y="189"/>
                </a:lnTo>
                <a:lnTo>
                  <a:pt x="810" y="187"/>
                </a:lnTo>
                <a:lnTo>
                  <a:pt x="817" y="187"/>
                </a:lnTo>
                <a:lnTo>
                  <a:pt x="818" y="186"/>
                </a:lnTo>
                <a:lnTo>
                  <a:pt x="822" y="186"/>
                </a:lnTo>
                <a:lnTo>
                  <a:pt x="828" y="186"/>
                </a:lnTo>
                <a:lnTo>
                  <a:pt x="834" y="184"/>
                </a:lnTo>
                <a:lnTo>
                  <a:pt x="842" y="184"/>
                </a:lnTo>
                <a:lnTo>
                  <a:pt x="847" y="184"/>
                </a:lnTo>
                <a:lnTo>
                  <a:pt x="852" y="182"/>
                </a:lnTo>
                <a:lnTo>
                  <a:pt x="858" y="182"/>
                </a:lnTo>
                <a:lnTo>
                  <a:pt x="864" y="182"/>
                </a:lnTo>
                <a:lnTo>
                  <a:pt x="871" y="182"/>
                </a:lnTo>
                <a:lnTo>
                  <a:pt x="876" y="182"/>
                </a:lnTo>
                <a:lnTo>
                  <a:pt x="880" y="180"/>
                </a:lnTo>
                <a:lnTo>
                  <a:pt x="882" y="180"/>
                </a:lnTo>
                <a:lnTo>
                  <a:pt x="889" y="180"/>
                </a:lnTo>
                <a:lnTo>
                  <a:pt x="895" y="178"/>
                </a:lnTo>
                <a:lnTo>
                  <a:pt x="900" y="176"/>
                </a:lnTo>
                <a:lnTo>
                  <a:pt x="900" y="174"/>
                </a:lnTo>
                <a:lnTo>
                  <a:pt x="907" y="174"/>
                </a:lnTo>
                <a:lnTo>
                  <a:pt x="912" y="174"/>
                </a:lnTo>
                <a:lnTo>
                  <a:pt x="918" y="172"/>
                </a:lnTo>
                <a:lnTo>
                  <a:pt x="924" y="172"/>
                </a:lnTo>
                <a:lnTo>
                  <a:pt x="930" y="172"/>
                </a:lnTo>
                <a:lnTo>
                  <a:pt x="936" y="172"/>
                </a:lnTo>
                <a:lnTo>
                  <a:pt x="944" y="172"/>
                </a:lnTo>
                <a:lnTo>
                  <a:pt x="949" y="172"/>
                </a:lnTo>
                <a:lnTo>
                  <a:pt x="954" y="169"/>
                </a:lnTo>
                <a:lnTo>
                  <a:pt x="961" y="169"/>
                </a:lnTo>
                <a:lnTo>
                  <a:pt x="967" y="169"/>
                </a:lnTo>
                <a:lnTo>
                  <a:pt x="974" y="169"/>
                </a:lnTo>
                <a:lnTo>
                  <a:pt x="978" y="169"/>
                </a:lnTo>
                <a:lnTo>
                  <a:pt x="985" y="169"/>
                </a:lnTo>
                <a:lnTo>
                  <a:pt x="991" y="169"/>
                </a:lnTo>
                <a:lnTo>
                  <a:pt x="993" y="167"/>
                </a:lnTo>
                <a:lnTo>
                  <a:pt x="997" y="167"/>
                </a:lnTo>
                <a:lnTo>
                  <a:pt x="1003" y="167"/>
                </a:lnTo>
                <a:lnTo>
                  <a:pt x="1008" y="167"/>
                </a:lnTo>
                <a:lnTo>
                  <a:pt x="1014" y="167"/>
                </a:lnTo>
                <a:lnTo>
                  <a:pt x="1020" y="167"/>
                </a:lnTo>
                <a:lnTo>
                  <a:pt x="1027" y="167"/>
                </a:lnTo>
                <a:lnTo>
                  <a:pt x="1033" y="164"/>
                </a:lnTo>
                <a:lnTo>
                  <a:pt x="1038" y="164"/>
                </a:lnTo>
                <a:lnTo>
                  <a:pt x="1045" y="164"/>
                </a:lnTo>
                <a:lnTo>
                  <a:pt x="1046" y="162"/>
                </a:lnTo>
                <a:lnTo>
                  <a:pt x="1050" y="162"/>
                </a:lnTo>
                <a:lnTo>
                  <a:pt x="1060" y="159"/>
                </a:lnTo>
                <a:lnTo>
                  <a:pt x="1063" y="159"/>
                </a:lnTo>
                <a:lnTo>
                  <a:pt x="1069" y="157"/>
                </a:lnTo>
                <a:lnTo>
                  <a:pt x="1075" y="157"/>
                </a:lnTo>
                <a:lnTo>
                  <a:pt x="1081" y="157"/>
                </a:lnTo>
                <a:lnTo>
                  <a:pt x="1083" y="154"/>
                </a:lnTo>
                <a:lnTo>
                  <a:pt x="1087" y="154"/>
                </a:lnTo>
                <a:lnTo>
                  <a:pt x="1093" y="151"/>
                </a:lnTo>
                <a:lnTo>
                  <a:pt x="1100" y="151"/>
                </a:lnTo>
                <a:lnTo>
                  <a:pt x="1105" y="151"/>
                </a:lnTo>
                <a:lnTo>
                  <a:pt x="1113" y="151"/>
                </a:lnTo>
                <a:lnTo>
                  <a:pt x="1117" y="151"/>
                </a:lnTo>
                <a:lnTo>
                  <a:pt x="1117" y="149"/>
                </a:lnTo>
                <a:lnTo>
                  <a:pt x="1120" y="143"/>
                </a:lnTo>
                <a:lnTo>
                  <a:pt x="1124" y="143"/>
                </a:lnTo>
                <a:lnTo>
                  <a:pt x="1129" y="143"/>
                </a:lnTo>
                <a:lnTo>
                  <a:pt x="1135" y="143"/>
                </a:lnTo>
                <a:lnTo>
                  <a:pt x="1141" y="143"/>
                </a:lnTo>
                <a:lnTo>
                  <a:pt x="1147" y="143"/>
                </a:lnTo>
                <a:lnTo>
                  <a:pt x="1153" y="143"/>
                </a:lnTo>
                <a:lnTo>
                  <a:pt x="1161" y="143"/>
                </a:lnTo>
                <a:lnTo>
                  <a:pt x="1167" y="143"/>
                </a:lnTo>
                <a:lnTo>
                  <a:pt x="1172" y="143"/>
                </a:lnTo>
                <a:lnTo>
                  <a:pt x="1177" y="143"/>
                </a:lnTo>
                <a:lnTo>
                  <a:pt x="1183" y="143"/>
                </a:lnTo>
                <a:lnTo>
                  <a:pt x="1190" y="143"/>
                </a:lnTo>
                <a:lnTo>
                  <a:pt x="1195" y="143"/>
                </a:lnTo>
                <a:lnTo>
                  <a:pt x="1204" y="143"/>
                </a:lnTo>
                <a:lnTo>
                  <a:pt x="1209" y="143"/>
                </a:lnTo>
                <a:lnTo>
                  <a:pt x="1213" y="143"/>
                </a:lnTo>
                <a:lnTo>
                  <a:pt x="1216" y="137"/>
                </a:lnTo>
                <a:lnTo>
                  <a:pt x="1221" y="137"/>
                </a:lnTo>
                <a:lnTo>
                  <a:pt x="1225" y="137"/>
                </a:lnTo>
                <a:lnTo>
                  <a:pt x="1232" y="137"/>
                </a:lnTo>
                <a:lnTo>
                  <a:pt x="1238" y="133"/>
                </a:lnTo>
                <a:lnTo>
                  <a:pt x="1244" y="133"/>
                </a:lnTo>
                <a:lnTo>
                  <a:pt x="1250" y="133"/>
                </a:lnTo>
                <a:lnTo>
                  <a:pt x="1255" y="133"/>
                </a:lnTo>
                <a:lnTo>
                  <a:pt x="1259" y="130"/>
                </a:lnTo>
                <a:lnTo>
                  <a:pt x="1261" y="130"/>
                </a:lnTo>
                <a:lnTo>
                  <a:pt x="1267" y="130"/>
                </a:lnTo>
                <a:lnTo>
                  <a:pt x="1274" y="130"/>
                </a:lnTo>
                <a:lnTo>
                  <a:pt x="1279" y="130"/>
                </a:lnTo>
                <a:lnTo>
                  <a:pt x="1285" y="130"/>
                </a:lnTo>
                <a:lnTo>
                  <a:pt x="1290" y="126"/>
                </a:lnTo>
                <a:lnTo>
                  <a:pt x="1292" y="126"/>
                </a:lnTo>
                <a:lnTo>
                  <a:pt x="1294" y="118"/>
                </a:lnTo>
                <a:lnTo>
                  <a:pt x="1298" y="118"/>
                </a:lnTo>
                <a:lnTo>
                  <a:pt x="1305" y="118"/>
                </a:lnTo>
                <a:lnTo>
                  <a:pt x="1310" y="118"/>
                </a:lnTo>
                <a:lnTo>
                  <a:pt x="1316" y="118"/>
                </a:lnTo>
                <a:lnTo>
                  <a:pt x="1321" y="118"/>
                </a:lnTo>
                <a:lnTo>
                  <a:pt x="1323" y="110"/>
                </a:lnTo>
                <a:lnTo>
                  <a:pt x="1323" y="106"/>
                </a:lnTo>
                <a:lnTo>
                  <a:pt x="1327" y="106"/>
                </a:lnTo>
                <a:lnTo>
                  <a:pt x="1334" y="106"/>
                </a:lnTo>
                <a:lnTo>
                  <a:pt x="1334" y="102"/>
                </a:lnTo>
                <a:lnTo>
                  <a:pt x="1340" y="102"/>
                </a:lnTo>
                <a:lnTo>
                  <a:pt x="1346" y="102"/>
                </a:lnTo>
                <a:lnTo>
                  <a:pt x="1351" y="102"/>
                </a:lnTo>
                <a:lnTo>
                  <a:pt x="1357" y="102"/>
                </a:lnTo>
                <a:lnTo>
                  <a:pt x="1364" y="102"/>
                </a:lnTo>
                <a:lnTo>
                  <a:pt x="1370" y="98"/>
                </a:lnTo>
                <a:lnTo>
                  <a:pt x="1376" y="98"/>
                </a:lnTo>
                <a:lnTo>
                  <a:pt x="1383" y="98"/>
                </a:lnTo>
                <a:lnTo>
                  <a:pt x="1387" y="98"/>
                </a:lnTo>
                <a:lnTo>
                  <a:pt x="1394" y="98"/>
                </a:lnTo>
                <a:lnTo>
                  <a:pt x="1399" y="98"/>
                </a:lnTo>
                <a:lnTo>
                  <a:pt x="1406" y="98"/>
                </a:lnTo>
                <a:lnTo>
                  <a:pt x="1412" y="98"/>
                </a:lnTo>
                <a:lnTo>
                  <a:pt x="1419" y="98"/>
                </a:lnTo>
                <a:lnTo>
                  <a:pt x="1422" y="93"/>
                </a:lnTo>
                <a:lnTo>
                  <a:pt x="1423" y="93"/>
                </a:lnTo>
                <a:lnTo>
                  <a:pt x="1430" y="93"/>
                </a:lnTo>
                <a:lnTo>
                  <a:pt x="1437" y="93"/>
                </a:lnTo>
                <a:lnTo>
                  <a:pt x="1442" y="93"/>
                </a:lnTo>
                <a:lnTo>
                  <a:pt x="1448" y="93"/>
                </a:lnTo>
                <a:lnTo>
                  <a:pt x="1453" y="93"/>
                </a:lnTo>
                <a:lnTo>
                  <a:pt x="1460" y="93"/>
                </a:lnTo>
                <a:lnTo>
                  <a:pt x="1467" y="93"/>
                </a:lnTo>
                <a:lnTo>
                  <a:pt x="1472" y="93"/>
                </a:lnTo>
                <a:lnTo>
                  <a:pt x="1478" y="93"/>
                </a:lnTo>
                <a:lnTo>
                  <a:pt x="1484" y="93"/>
                </a:lnTo>
                <a:lnTo>
                  <a:pt x="1490" y="93"/>
                </a:lnTo>
                <a:lnTo>
                  <a:pt x="1496" y="93"/>
                </a:lnTo>
                <a:lnTo>
                  <a:pt x="1497" y="85"/>
                </a:lnTo>
                <a:lnTo>
                  <a:pt x="1502" y="85"/>
                </a:lnTo>
                <a:lnTo>
                  <a:pt x="1508" y="85"/>
                </a:lnTo>
                <a:lnTo>
                  <a:pt x="1516" y="85"/>
                </a:lnTo>
                <a:lnTo>
                  <a:pt x="1518" y="78"/>
                </a:lnTo>
                <a:lnTo>
                  <a:pt x="1520" y="78"/>
                </a:lnTo>
                <a:lnTo>
                  <a:pt x="1526" y="78"/>
                </a:lnTo>
                <a:lnTo>
                  <a:pt x="1528" y="70"/>
                </a:lnTo>
                <a:lnTo>
                  <a:pt x="1532" y="70"/>
                </a:lnTo>
                <a:lnTo>
                  <a:pt x="1538" y="70"/>
                </a:lnTo>
                <a:lnTo>
                  <a:pt x="1545" y="70"/>
                </a:lnTo>
                <a:lnTo>
                  <a:pt x="1547" y="60"/>
                </a:lnTo>
                <a:lnTo>
                  <a:pt x="1549" y="51"/>
                </a:lnTo>
                <a:lnTo>
                  <a:pt x="1555" y="51"/>
                </a:lnTo>
                <a:lnTo>
                  <a:pt x="1557" y="51"/>
                </a:lnTo>
                <a:lnTo>
                  <a:pt x="1557" y="42"/>
                </a:lnTo>
                <a:lnTo>
                  <a:pt x="1562" y="42"/>
                </a:lnTo>
                <a:lnTo>
                  <a:pt x="1570" y="42"/>
                </a:lnTo>
                <a:lnTo>
                  <a:pt x="1576" y="42"/>
                </a:lnTo>
                <a:lnTo>
                  <a:pt x="1580" y="42"/>
                </a:lnTo>
                <a:lnTo>
                  <a:pt x="1589" y="42"/>
                </a:lnTo>
                <a:lnTo>
                  <a:pt x="1592" y="42"/>
                </a:lnTo>
                <a:lnTo>
                  <a:pt x="1598" y="42"/>
                </a:lnTo>
                <a:lnTo>
                  <a:pt x="1604" y="42"/>
                </a:lnTo>
                <a:lnTo>
                  <a:pt x="1610" y="42"/>
                </a:lnTo>
                <a:lnTo>
                  <a:pt x="1618" y="42"/>
                </a:lnTo>
                <a:lnTo>
                  <a:pt x="1623" y="42"/>
                </a:lnTo>
                <a:lnTo>
                  <a:pt x="1625" y="28"/>
                </a:lnTo>
                <a:lnTo>
                  <a:pt x="1628" y="28"/>
                </a:lnTo>
                <a:lnTo>
                  <a:pt x="1636" y="28"/>
                </a:lnTo>
                <a:lnTo>
                  <a:pt x="1642" y="28"/>
                </a:lnTo>
                <a:lnTo>
                  <a:pt x="1642" y="14"/>
                </a:lnTo>
                <a:lnTo>
                  <a:pt x="1642" y="0"/>
                </a:lnTo>
                <a:lnTo>
                  <a:pt x="1646" y="0"/>
                </a:lnTo>
                <a:lnTo>
                  <a:pt x="1654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1" name="Freeform 95">
            <a:extLst>
              <a:ext uri="{FF2B5EF4-FFF2-40B4-BE49-F238E27FC236}">
                <a16:creationId xmlns:a16="http://schemas.microsoft.com/office/drawing/2014/main" id="{E3034BCA-A207-965F-35F8-F9634286B8C1}"/>
              </a:ext>
            </a:extLst>
          </p:cNvPr>
          <p:cNvSpPr>
            <a:spLocks/>
          </p:cNvSpPr>
          <p:nvPr/>
        </p:nvSpPr>
        <p:spPr bwMode="auto">
          <a:xfrm>
            <a:off x="2053410" y="4820966"/>
            <a:ext cx="3137168" cy="844982"/>
          </a:xfrm>
          <a:custGeom>
            <a:avLst/>
            <a:gdLst>
              <a:gd name="T0" fmla="*/ 90 w 1660"/>
              <a:gd name="T1" fmla="*/ 456 h 456"/>
              <a:gd name="T2" fmla="*/ 137 w 1660"/>
              <a:gd name="T3" fmla="*/ 447 h 456"/>
              <a:gd name="T4" fmla="*/ 155 w 1660"/>
              <a:gd name="T5" fmla="*/ 443 h 456"/>
              <a:gd name="T6" fmla="*/ 179 w 1660"/>
              <a:gd name="T7" fmla="*/ 439 h 456"/>
              <a:gd name="T8" fmla="*/ 204 w 1660"/>
              <a:gd name="T9" fmla="*/ 430 h 456"/>
              <a:gd name="T10" fmla="*/ 232 w 1660"/>
              <a:gd name="T11" fmla="*/ 430 h 456"/>
              <a:gd name="T12" fmla="*/ 272 w 1660"/>
              <a:gd name="T13" fmla="*/ 425 h 456"/>
              <a:gd name="T14" fmla="*/ 280 w 1660"/>
              <a:gd name="T15" fmla="*/ 417 h 456"/>
              <a:gd name="T16" fmla="*/ 313 w 1660"/>
              <a:gd name="T17" fmla="*/ 407 h 456"/>
              <a:gd name="T18" fmla="*/ 335 w 1660"/>
              <a:gd name="T19" fmla="*/ 403 h 456"/>
              <a:gd name="T20" fmla="*/ 357 w 1660"/>
              <a:gd name="T21" fmla="*/ 389 h 456"/>
              <a:gd name="T22" fmla="*/ 374 w 1660"/>
              <a:gd name="T23" fmla="*/ 384 h 456"/>
              <a:gd name="T24" fmla="*/ 395 w 1660"/>
              <a:gd name="T25" fmla="*/ 380 h 456"/>
              <a:gd name="T26" fmla="*/ 419 w 1660"/>
              <a:gd name="T27" fmla="*/ 375 h 456"/>
              <a:gd name="T28" fmla="*/ 437 w 1660"/>
              <a:gd name="T29" fmla="*/ 365 h 456"/>
              <a:gd name="T30" fmla="*/ 493 w 1660"/>
              <a:gd name="T31" fmla="*/ 365 h 456"/>
              <a:gd name="T32" fmla="*/ 522 w 1660"/>
              <a:gd name="T33" fmla="*/ 365 h 456"/>
              <a:gd name="T34" fmla="*/ 541 w 1660"/>
              <a:gd name="T35" fmla="*/ 355 h 456"/>
              <a:gd name="T36" fmla="*/ 563 w 1660"/>
              <a:gd name="T37" fmla="*/ 355 h 456"/>
              <a:gd name="T38" fmla="*/ 583 w 1660"/>
              <a:gd name="T39" fmla="*/ 345 h 456"/>
              <a:gd name="T40" fmla="*/ 611 w 1660"/>
              <a:gd name="T41" fmla="*/ 345 h 456"/>
              <a:gd name="T42" fmla="*/ 624 w 1660"/>
              <a:gd name="T43" fmla="*/ 339 h 456"/>
              <a:gd name="T44" fmla="*/ 637 w 1660"/>
              <a:gd name="T45" fmla="*/ 328 h 456"/>
              <a:gd name="T46" fmla="*/ 673 w 1660"/>
              <a:gd name="T47" fmla="*/ 328 h 456"/>
              <a:gd name="T48" fmla="*/ 696 w 1660"/>
              <a:gd name="T49" fmla="*/ 328 h 456"/>
              <a:gd name="T50" fmla="*/ 713 w 1660"/>
              <a:gd name="T51" fmla="*/ 316 h 456"/>
              <a:gd name="T52" fmla="*/ 729 w 1660"/>
              <a:gd name="T53" fmla="*/ 310 h 456"/>
              <a:gd name="T54" fmla="*/ 744 w 1660"/>
              <a:gd name="T55" fmla="*/ 303 h 456"/>
              <a:gd name="T56" fmla="*/ 764 w 1660"/>
              <a:gd name="T57" fmla="*/ 296 h 456"/>
              <a:gd name="T58" fmla="*/ 790 w 1660"/>
              <a:gd name="T59" fmla="*/ 296 h 456"/>
              <a:gd name="T60" fmla="*/ 812 w 1660"/>
              <a:gd name="T61" fmla="*/ 282 h 456"/>
              <a:gd name="T62" fmla="*/ 832 w 1660"/>
              <a:gd name="T63" fmla="*/ 275 h 456"/>
              <a:gd name="T64" fmla="*/ 848 w 1660"/>
              <a:gd name="T65" fmla="*/ 267 h 456"/>
              <a:gd name="T66" fmla="*/ 865 w 1660"/>
              <a:gd name="T67" fmla="*/ 259 h 456"/>
              <a:gd name="T68" fmla="*/ 882 w 1660"/>
              <a:gd name="T69" fmla="*/ 252 h 456"/>
              <a:gd name="T70" fmla="*/ 907 w 1660"/>
              <a:gd name="T71" fmla="*/ 252 h 456"/>
              <a:gd name="T72" fmla="*/ 930 w 1660"/>
              <a:gd name="T73" fmla="*/ 252 h 456"/>
              <a:gd name="T74" fmla="*/ 949 w 1660"/>
              <a:gd name="T75" fmla="*/ 243 h 456"/>
              <a:gd name="T76" fmla="*/ 968 w 1660"/>
              <a:gd name="T77" fmla="*/ 233 h 456"/>
              <a:gd name="T78" fmla="*/ 989 w 1660"/>
              <a:gd name="T79" fmla="*/ 223 h 456"/>
              <a:gd name="T80" fmla="*/ 997 w 1660"/>
              <a:gd name="T81" fmla="*/ 202 h 456"/>
              <a:gd name="T82" fmla="*/ 1024 w 1660"/>
              <a:gd name="T83" fmla="*/ 202 h 456"/>
              <a:gd name="T84" fmla="*/ 1050 w 1660"/>
              <a:gd name="T85" fmla="*/ 202 h 456"/>
              <a:gd name="T86" fmla="*/ 1063 w 1660"/>
              <a:gd name="T87" fmla="*/ 177 h 456"/>
              <a:gd name="T88" fmla="*/ 1105 w 1660"/>
              <a:gd name="T89" fmla="*/ 177 h 456"/>
              <a:gd name="T90" fmla="*/ 1136 w 1660"/>
              <a:gd name="T91" fmla="*/ 177 h 456"/>
              <a:gd name="T92" fmla="*/ 1158 w 1660"/>
              <a:gd name="T93" fmla="*/ 163 h 456"/>
              <a:gd name="T94" fmla="*/ 1200 w 1660"/>
              <a:gd name="T95" fmla="*/ 163 h 456"/>
              <a:gd name="T96" fmla="*/ 1214 w 1660"/>
              <a:gd name="T97" fmla="*/ 147 h 456"/>
              <a:gd name="T98" fmla="*/ 1244 w 1660"/>
              <a:gd name="T99" fmla="*/ 147 h 456"/>
              <a:gd name="T100" fmla="*/ 1267 w 1660"/>
              <a:gd name="T101" fmla="*/ 130 h 456"/>
              <a:gd name="T102" fmla="*/ 1305 w 1660"/>
              <a:gd name="T103" fmla="*/ 130 h 456"/>
              <a:gd name="T104" fmla="*/ 1335 w 1660"/>
              <a:gd name="T105" fmla="*/ 111 h 456"/>
              <a:gd name="T106" fmla="*/ 1363 w 1660"/>
              <a:gd name="T107" fmla="*/ 111 h 456"/>
              <a:gd name="T108" fmla="*/ 1391 w 1660"/>
              <a:gd name="T109" fmla="*/ 111 h 456"/>
              <a:gd name="T110" fmla="*/ 1408 w 1660"/>
              <a:gd name="T111" fmla="*/ 86 h 456"/>
              <a:gd name="T112" fmla="*/ 1438 w 1660"/>
              <a:gd name="T113" fmla="*/ 86 h 456"/>
              <a:gd name="T114" fmla="*/ 1463 w 1660"/>
              <a:gd name="T115" fmla="*/ 86 h 456"/>
              <a:gd name="T116" fmla="*/ 1486 w 1660"/>
              <a:gd name="T117" fmla="*/ 86 h 456"/>
              <a:gd name="T118" fmla="*/ 1518 w 1660"/>
              <a:gd name="T119" fmla="*/ 86 h 456"/>
              <a:gd name="T120" fmla="*/ 1543 w 1660"/>
              <a:gd name="T121" fmla="*/ 86 h 456"/>
              <a:gd name="T122" fmla="*/ 1596 w 1660"/>
              <a:gd name="T123" fmla="*/ 86 h 456"/>
              <a:gd name="T124" fmla="*/ 1634 w 1660"/>
              <a:gd name="T125" fmla="*/ 86 h 4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1660" h="456">
                <a:moveTo>
                  <a:pt x="0" y="456"/>
                </a:moveTo>
                <a:lnTo>
                  <a:pt x="79" y="456"/>
                </a:lnTo>
                <a:lnTo>
                  <a:pt x="86" y="456"/>
                </a:lnTo>
                <a:lnTo>
                  <a:pt x="90" y="456"/>
                </a:lnTo>
                <a:lnTo>
                  <a:pt x="111" y="456"/>
                </a:lnTo>
                <a:lnTo>
                  <a:pt x="111" y="452"/>
                </a:lnTo>
                <a:lnTo>
                  <a:pt x="130" y="452"/>
                </a:lnTo>
                <a:lnTo>
                  <a:pt x="137" y="447"/>
                </a:lnTo>
                <a:lnTo>
                  <a:pt x="137" y="443"/>
                </a:lnTo>
                <a:lnTo>
                  <a:pt x="143" y="443"/>
                </a:lnTo>
                <a:lnTo>
                  <a:pt x="149" y="443"/>
                </a:lnTo>
                <a:lnTo>
                  <a:pt x="155" y="443"/>
                </a:lnTo>
                <a:lnTo>
                  <a:pt x="155" y="439"/>
                </a:lnTo>
                <a:lnTo>
                  <a:pt x="160" y="439"/>
                </a:lnTo>
                <a:lnTo>
                  <a:pt x="173" y="439"/>
                </a:lnTo>
                <a:lnTo>
                  <a:pt x="179" y="439"/>
                </a:lnTo>
                <a:lnTo>
                  <a:pt x="179" y="434"/>
                </a:lnTo>
                <a:lnTo>
                  <a:pt x="185" y="434"/>
                </a:lnTo>
                <a:lnTo>
                  <a:pt x="197" y="434"/>
                </a:lnTo>
                <a:lnTo>
                  <a:pt x="204" y="430"/>
                </a:lnTo>
                <a:lnTo>
                  <a:pt x="213" y="430"/>
                </a:lnTo>
                <a:lnTo>
                  <a:pt x="220" y="430"/>
                </a:lnTo>
                <a:lnTo>
                  <a:pt x="230" y="430"/>
                </a:lnTo>
                <a:lnTo>
                  <a:pt x="232" y="430"/>
                </a:lnTo>
                <a:lnTo>
                  <a:pt x="244" y="430"/>
                </a:lnTo>
                <a:lnTo>
                  <a:pt x="244" y="425"/>
                </a:lnTo>
                <a:lnTo>
                  <a:pt x="256" y="425"/>
                </a:lnTo>
                <a:lnTo>
                  <a:pt x="272" y="425"/>
                </a:lnTo>
                <a:lnTo>
                  <a:pt x="272" y="421"/>
                </a:lnTo>
                <a:lnTo>
                  <a:pt x="276" y="421"/>
                </a:lnTo>
                <a:lnTo>
                  <a:pt x="280" y="421"/>
                </a:lnTo>
                <a:lnTo>
                  <a:pt x="280" y="417"/>
                </a:lnTo>
                <a:lnTo>
                  <a:pt x="286" y="417"/>
                </a:lnTo>
                <a:lnTo>
                  <a:pt x="296" y="412"/>
                </a:lnTo>
                <a:lnTo>
                  <a:pt x="313" y="412"/>
                </a:lnTo>
                <a:lnTo>
                  <a:pt x="313" y="407"/>
                </a:lnTo>
                <a:lnTo>
                  <a:pt x="319" y="407"/>
                </a:lnTo>
                <a:lnTo>
                  <a:pt x="328" y="407"/>
                </a:lnTo>
                <a:lnTo>
                  <a:pt x="335" y="407"/>
                </a:lnTo>
                <a:lnTo>
                  <a:pt x="335" y="403"/>
                </a:lnTo>
                <a:lnTo>
                  <a:pt x="348" y="403"/>
                </a:lnTo>
                <a:lnTo>
                  <a:pt x="349" y="398"/>
                </a:lnTo>
                <a:lnTo>
                  <a:pt x="357" y="394"/>
                </a:lnTo>
                <a:lnTo>
                  <a:pt x="357" y="389"/>
                </a:lnTo>
                <a:lnTo>
                  <a:pt x="361" y="389"/>
                </a:lnTo>
                <a:lnTo>
                  <a:pt x="367" y="389"/>
                </a:lnTo>
                <a:lnTo>
                  <a:pt x="370" y="384"/>
                </a:lnTo>
                <a:lnTo>
                  <a:pt x="374" y="384"/>
                </a:lnTo>
                <a:lnTo>
                  <a:pt x="385" y="384"/>
                </a:lnTo>
                <a:lnTo>
                  <a:pt x="385" y="380"/>
                </a:lnTo>
                <a:lnTo>
                  <a:pt x="394" y="380"/>
                </a:lnTo>
                <a:lnTo>
                  <a:pt x="395" y="380"/>
                </a:lnTo>
                <a:lnTo>
                  <a:pt x="405" y="380"/>
                </a:lnTo>
                <a:lnTo>
                  <a:pt x="408" y="380"/>
                </a:lnTo>
                <a:lnTo>
                  <a:pt x="416" y="380"/>
                </a:lnTo>
                <a:lnTo>
                  <a:pt x="419" y="375"/>
                </a:lnTo>
                <a:lnTo>
                  <a:pt x="419" y="370"/>
                </a:lnTo>
                <a:lnTo>
                  <a:pt x="432" y="370"/>
                </a:lnTo>
                <a:lnTo>
                  <a:pt x="437" y="370"/>
                </a:lnTo>
                <a:lnTo>
                  <a:pt x="437" y="365"/>
                </a:lnTo>
                <a:lnTo>
                  <a:pt x="446" y="365"/>
                </a:lnTo>
                <a:lnTo>
                  <a:pt x="452" y="365"/>
                </a:lnTo>
                <a:lnTo>
                  <a:pt x="472" y="365"/>
                </a:lnTo>
                <a:lnTo>
                  <a:pt x="493" y="365"/>
                </a:lnTo>
                <a:lnTo>
                  <a:pt x="508" y="365"/>
                </a:lnTo>
                <a:lnTo>
                  <a:pt x="510" y="365"/>
                </a:lnTo>
                <a:lnTo>
                  <a:pt x="515" y="365"/>
                </a:lnTo>
                <a:lnTo>
                  <a:pt x="522" y="365"/>
                </a:lnTo>
                <a:lnTo>
                  <a:pt x="522" y="355"/>
                </a:lnTo>
                <a:lnTo>
                  <a:pt x="528" y="355"/>
                </a:lnTo>
                <a:lnTo>
                  <a:pt x="535" y="355"/>
                </a:lnTo>
                <a:lnTo>
                  <a:pt x="541" y="355"/>
                </a:lnTo>
                <a:lnTo>
                  <a:pt x="546" y="355"/>
                </a:lnTo>
                <a:lnTo>
                  <a:pt x="551" y="355"/>
                </a:lnTo>
                <a:lnTo>
                  <a:pt x="561" y="355"/>
                </a:lnTo>
                <a:lnTo>
                  <a:pt x="563" y="355"/>
                </a:lnTo>
                <a:lnTo>
                  <a:pt x="569" y="355"/>
                </a:lnTo>
                <a:lnTo>
                  <a:pt x="573" y="350"/>
                </a:lnTo>
                <a:lnTo>
                  <a:pt x="577" y="350"/>
                </a:lnTo>
                <a:lnTo>
                  <a:pt x="583" y="345"/>
                </a:lnTo>
                <a:lnTo>
                  <a:pt x="588" y="345"/>
                </a:lnTo>
                <a:lnTo>
                  <a:pt x="594" y="345"/>
                </a:lnTo>
                <a:lnTo>
                  <a:pt x="601" y="345"/>
                </a:lnTo>
                <a:lnTo>
                  <a:pt x="611" y="345"/>
                </a:lnTo>
                <a:lnTo>
                  <a:pt x="614" y="345"/>
                </a:lnTo>
                <a:lnTo>
                  <a:pt x="615" y="339"/>
                </a:lnTo>
                <a:lnTo>
                  <a:pt x="619" y="339"/>
                </a:lnTo>
                <a:lnTo>
                  <a:pt x="624" y="339"/>
                </a:lnTo>
                <a:lnTo>
                  <a:pt x="629" y="339"/>
                </a:lnTo>
                <a:lnTo>
                  <a:pt x="636" y="339"/>
                </a:lnTo>
                <a:lnTo>
                  <a:pt x="636" y="334"/>
                </a:lnTo>
                <a:lnTo>
                  <a:pt x="637" y="328"/>
                </a:lnTo>
                <a:lnTo>
                  <a:pt x="651" y="328"/>
                </a:lnTo>
                <a:lnTo>
                  <a:pt x="663" y="328"/>
                </a:lnTo>
                <a:lnTo>
                  <a:pt x="671" y="328"/>
                </a:lnTo>
                <a:lnTo>
                  <a:pt x="673" y="328"/>
                </a:lnTo>
                <a:lnTo>
                  <a:pt x="678" y="328"/>
                </a:lnTo>
                <a:lnTo>
                  <a:pt x="684" y="328"/>
                </a:lnTo>
                <a:lnTo>
                  <a:pt x="690" y="328"/>
                </a:lnTo>
                <a:lnTo>
                  <a:pt x="696" y="328"/>
                </a:lnTo>
                <a:lnTo>
                  <a:pt x="698" y="322"/>
                </a:lnTo>
                <a:lnTo>
                  <a:pt x="706" y="322"/>
                </a:lnTo>
                <a:lnTo>
                  <a:pt x="710" y="322"/>
                </a:lnTo>
                <a:lnTo>
                  <a:pt x="713" y="316"/>
                </a:lnTo>
                <a:lnTo>
                  <a:pt x="719" y="316"/>
                </a:lnTo>
                <a:lnTo>
                  <a:pt x="721" y="316"/>
                </a:lnTo>
                <a:lnTo>
                  <a:pt x="726" y="316"/>
                </a:lnTo>
                <a:lnTo>
                  <a:pt x="729" y="310"/>
                </a:lnTo>
                <a:lnTo>
                  <a:pt x="732" y="310"/>
                </a:lnTo>
                <a:lnTo>
                  <a:pt x="737" y="310"/>
                </a:lnTo>
                <a:lnTo>
                  <a:pt x="744" y="310"/>
                </a:lnTo>
                <a:lnTo>
                  <a:pt x="744" y="303"/>
                </a:lnTo>
                <a:lnTo>
                  <a:pt x="749" y="296"/>
                </a:lnTo>
                <a:lnTo>
                  <a:pt x="753" y="296"/>
                </a:lnTo>
                <a:lnTo>
                  <a:pt x="760" y="296"/>
                </a:lnTo>
                <a:lnTo>
                  <a:pt x="764" y="296"/>
                </a:lnTo>
                <a:lnTo>
                  <a:pt x="769" y="296"/>
                </a:lnTo>
                <a:lnTo>
                  <a:pt x="774" y="296"/>
                </a:lnTo>
                <a:lnTo>
                  <a:pt x="781" y="296"/>
                </a:lnTo>
                <a:lnTo>
                  <a:pt x="790" y="296"/>
                </a:lnTo>
                <a:lnTo>
                  <a:pt x="790" y="289"/>
                </a:lnTo>
                <a:lnTo>
                  <a:pt x="807" y="289"/>
                </a:lnTo>
                <a:lnTo>
                  <a:pt x="812" y="289"/>
                </a:lnTo>
                <a:lnTo>
                  <a:pt x="812" y="282"/>
                </a:lnTo>
                <a:lnTo>
                  <a:pt x="815" y="275"/>
                </a:lnTo>
                <a:lnTo>
                  <a:pt x="816" y="275"/>
                </a:lnTo>
                <a:lnTo>
                  <a:pt x="826" y="275"/>
                </a:lnTo>
                <a:lnTo>
                  <a:pt x="832" y="275"/>
                </a:lnTo>
                <a:lnTo>
                  <a:pt x="834" y="275"/>
                </a:lnTo>
                <a:lnTo>
                  <a:pt x="843" y="275"/>
                </a:lnTo>
                <a:lnTo>
                  <a:pt x="844" y="267"/>
                </a:lnTo>
                <a:lnTo>
                  <a:pt x="848" y="267"/>
                </a:lnTo>
                <a:lnTo>
                  <a:pt x="852" y="267"/>
                </a:lnTo>
                <a:lnTo>
                  <a:pt x="860" y="267"/>
                </a:lnTo>
                <a:lnTo>
                  <a:pt x="865" y="267"/>
                </a:lnTo>
                <a:lnTo>
                  <a:pt x="865" y="259"/>
                </a:lnTo>
                <a:lnTo>
                  <a:pt x="871" y="259"/>
                </a:lnTo>
                <a:lnTo>
                  <a:pt x="874" y="252"/>
                </a:lnTo>
                <a:lnTo>
                  <a:pt x="877" y="252"/>
                </a:lnTo>
                <a:lnTo>
                  <a:pt x="882" y="252"/>
                </a:lnTo>
                <a:lnTo>
                  <a:pt x="891" y="252"/>
                </a:lnTo>
                <a:lnTo>
                  <a:pt x="895" y="252"/>
                </a:lnTo>
                <a:lnTo>
                  <a:pt x="900" y="252"/>
                </a:lnTo>
                <a:lnTo>
                  <a:pt x="907" y="252"/>
                </a:lnTo>
                <a:lnTo>
                  <a:pt x="912" y="252"/>
                </a:lnTo>
                <a:lnTo>
                  <a:pt x="919" y="252"/>
                </a:lnTo>
                <a:lnTo>
                  <a:pt x="927" y="252"/>
                </a:lnTo>
                <a:lnTo>
                  <a:pt x="930" y="252"/>
                </a:lnTo>
                <a:lnTo>
                  <a:pt x="938" y="252"/>
                </a:lnTo>
                <a:lnTo>
                  <a:pt x="944" y="252"/>
                </a:lnTo>
                <a:lnTo>
                  <a:pt x="944" y="243"/>
                </a:lnTo>
                <a:lnTo>
                  <a:pt x="949" y="243"/>
                </a:lnTo>
                <a:lnTo>
                  <a:pt x="955" y="243"/>
                </a:lnTo>
                <a:lnTo>
                  <a:pt x="961" y="243"/>
                </a:lnTo>
                <a:lnTo>
                  <a:pt x="961" y="233"/>
                </a:lnTo>
                <a:lnTo>
                  <a:pt x="968" y="233"/>
                </a:lnTo>
                <a:lnTo>
                  <a:pt x="974" y="233"/>
                </a:lnTo>
                <a:lnTo>
                  <a:pt x="974" y="223"/>
                </a:lnTo>
                <a:lnTo>
                  <a:pt x="981" y="223"/>
                </a:lnTo>
                <a:lnTo>
                  <a:pt x="989" y="223"/>
                </a:lnTo>
                <a:lnTo>
                  <a:pt x="992" y="223"/>
                </a:lnTo>
                <a:lnTo>
                  <a:pt x="993" y="212"/>
                </a:lnTo>
                <a:lnTo>
                  <a:pt x="997" y="212"/>
                </a:lnTo>
                <a:lnTo>
                  <a:pt x="997" y="202"/>
                </a:lnTo>
                <a:lnTo>
                  <a:pt x="1003" y="202"/>
                </a:lnTo>
                <a:lnTo>
                  <a:pt x="1009" y="202"/>
                </a:lnTo>
                <a:lnTo>
                  <a:pt x="1014" y="202"/>
                </a:lnTo>
                <a:lnTo>
                  <a:pt x="1024" y="202"/>
                </a:lnTo>
                <a:lnTo>
                  <a:pt x="1030" y="202"/>
                </a:lnTo>
                <a:lnTo>
                  <a:pt x="1033" y="202"/>
                </a:lnTo>
                <a:lnTo>
                  <a:pt x="1044" y="202"/>
                </a:lnTo>
                <a:lnTo>
                  <a:pt x="1050" y="202"/>
                </a:lnTo>
                <a:lnTo>
                  <a:pt x="1050" y="189"/>
                </a:lnTo>
                <a:lnTo>
                  <a:pt x="1057" y="189"/>
                </a:lnTo>
                <a:lnTo>
                  <a:pt x="1061" y="177"/>
                </a:lnTo>
                <a:lnTo>
                  <a:pt x="1063" y="177"/>
                </a:lnTo>
                <a:lnTo>
                  <a:pt x="1083" y="177"/>
                </a:lnTo>
                <a:lnTo>
                  <a:pt x="1095" y="177"/>
                </a:lnTo>
                <a:lnTo>
                  <a:pt x="1099" y="177"/>
                </a:lnTo>
                <a:lnTo>
                  <a:pt x="1105" y="177"/>
                </a:lnTo>
                <a:lnTo>
                  <a:pt x="1112" y="177"/>
                </a:lnTo>
                <a:lnTo>
                  <a:pt x="1124" y="177"/>
                </a:lnTo>
                <a:lnTo>
                  <a:pt x="1130" y="177"/>
                </a:lnTo>
                <a:lnTo>
                  <a:pt x="1136" y="177"/>
                </a:lnTo>
                <a:lnTo>
                  <a:pt x="1141" y="177"/>
                </a:lnTo>
                <a:lnTo>
                  <a:pt x="1145" y="163"/>
                </a:lnTo>
                <a:lnTo>
                  <a:pt x="1150" y="163"/>
                </a:lnTo>
                <a:lnTo>
                  <a:pt x="1158" y="163"/>
                </a:lnTo>
                <a:lnTo>
                  <a:pt x="1167" y="163"/>
                </a:lnTo>
                <a:lnTo>
                  <a:pt x="1172" y="163"/>
                </a:lnTo>
                <a:lnTo>
                  <a:pt x="1177" y="163"/>
                </a:lnTo>
                <a:lnTo>
                  <a:pt x="1200" y="163"/>
                </a:lnTo>
                <a:lnTo>
                  <a:pt x="1203" y="163"/>
                </a:lnTo>
                <a:lnTo>
                  <a:pt x="1207" y="163"/>
                </a:lnTo>
                <a:lnTo>
                  <a:pt x="1210" y="147"/>
                </a:lnTo>
                <a:lnTo>
                  <a:pt x="1214" y="147"/>
                </a:lnTo>
                <a:lnTo>
                  <a:pt x="1223" y="147"/>
                </a:lnTo>
                <a:lnTo>
                  <a:pt x="1226" y="147"/>
                </a:lnTo>
                <a:lnTo>
                  <a:pt x="1241" y="147"/>
                </a:lnTo>
                <a:lnTo>
                  <a:pt x="1244" y="147"/>
                </a:lnTo>
                <a:lnTo>
                  <a:pt x="1244" y="130"/>
                </a:lnTo>
                <a:lnTo>
                  <a:pt x="1249" y="130"/>
                </a:lnTo>
                <a:lnTo>
                  <a:pt x="1267" y="130"/>
                </a:lnTo>
                <a:lnTo>
                  <a:pt x="1267" y="130"/>
                </a:lnTo>
                <a:lnTo>
                  <a:pt x="1274" y="130"/>
                </a:lnTo>
                <a:lnTo>
                  <a:pt x="1290" y="130"/>
                </a:lnTo>
                <a:lnTo>
                  <a:pt x="1293" y="130"/>
                </a:lnTo>
                <a:lnTo>
                  <a:pt x="1305" y="130"/>
                </a:lnTo>
                <a:lnTo>
                  <a:pt x="1316" y="130"/>
                </a:lnTo>
                <a:lnTo>
                  <a:pt x="1316" y="111"/>
                </a:lnTo>
                <a:lnTo>
                  <a:pt x="1323" y="111"/>
                </a:lnTo>
                <a:lnTo>
                  <a:pt x="1335" y="111"/>
                </a:lnTo>
                <a:lnTo>
                  <a:pt x="1343" y="111"/>
                </a:lnTo>
                <a:lnTo>
                  <a:pt x="1353" y="111"/>
                </a:lnTo>
                <a:lnTo>
                  <a:pt x="1357" y="111"/>
                </a:lnTo>
                <a:lnTo>
                  <a:pt x="1363" y="111"/>
                </a:lnTo>
                <a:lnTo>
                  <a:pt x="1370" y="111"/>
                </a:lnTo>
                <a:lnTo>
                  <a:pt x="1376" y="111"/>
                </a:lnTo>
                <a:lnTo>
                  <a:pt x="1382" y="111"/>
                </a:lnTo>
                <a:lnTo>
                  <a:pt x="1391" y="111"/>
                </a:lnTo>
                <a:lnTo>
                  <a:pt x="1395" y="111"/>
                </a:lnTo>
                <a:lnTo>
                  <a:pt x="1399" y="111"/>
                </a:lnTo>
                <a:lnTo>
                  <a:pt x="1399" y="86"/>
                </a:lnTo>
                <a:lnTo>
                  <a:pt x="1408" y="86"/>
                </a:lnTo>
                <a:lnTo>
                  <a:pt x="1421" y="86"/>
                </a:lnTo>
                <a:lnTo>
                  <a:pt x="1429" y="86"/>
                </a:lnTo>
                <a:lnTo>
                  <a:pt x="1429" y="86"/>
                </a:lnTo>
                <a:lnTo>
                  <a:pt x="1438" y="86"/>
                </a:lnTo>
                <a:lnTo>
                  <a:pt x="1444" y="86"/>
                </a:lnTo>
                <a:lnTo>
                  <a:pt x="1448" y="86"/>
                </a:lnTo>
                <a:lnTo>
                  <a:pt x="1453" y="86"/>
                </a:lnTo>
                <a:lnTo>
                  <a:pt x="1463" y="86"/>
                </a:lnTo>
                <a:lnTo>
                  <a:pt x="1469" y="86"/>
                </a:lnTo>
                <a:lnTo>
                  <a:pt x="1474" y="86"/>
                </a:lnTo>
                <a:lnTo>
                  <a:pt x="1479" y="86"/>
                </a:lnTo>
                <a:lnTo>
                  <a:pt x="1486" y="86"/>
                </a:lnTo>
                <a:lnTo>
                  <a:pt x="1493" y="86"/>
                </a:lnTo>
                <a:lnTo>
                  <a:pt x="1497" y="86"/>
                </a:lnTo>
                <a:lnTo>
                  <a:pt x="1505" y="86"/>
                </a:lnTo>
                <a:lnTo>
                  <a:pt x="1518" y="86"/>
                </a:lnTo>
                <a:lnTo>
                  <a:pt x="1522" y="86"/>
                </a:lnTo>
                <a:lnTo>
                  <a:pt x="1526" y="86"/>
                </a:lnTo>
                <a:lnTo>
                  <a:pt x="1535" y="86"/>
                </a:lnTo>
                <a:lnTo>
                  <a:pt x="1543" y="86"/>
                </a:lnTo>
                <a:lnTo>
                  <a:pt x="1544" y="86"/>
                </a:lnTo>
                <a:lnTo>
                  <a:pt x="1550" y="86"/>
                </a:lnTo>
                <a:lnTo>
                  <a:pt x="1585" y="86"/>
                </a:lnTo>
                <a:lnTo>
                  <a:pt x="1596" y="86"/>
                </a:lnTo>
                <a:lnTo>
                  <a:pt x="1613" y="86"/>
                </a:lnTo>
                <a:lnTo>
                  <a:pt x="1619" y="86"/>
                </a:lnTo>
                <a:lnTo>
                  <a:pt x="1629" y="86"/>
                </a:lnTo>
                <a:lnTo>
                  <a:pt x="1634" y="86"/>
                </a:lnTo>
                <a:lnTo>
                  <a:pt x="1650" y="86"/>
                </a:lnTo>
                <a:lnTo>
                  <a:pt x="1650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5" name="Freeform 130">
            <a:extLst>
              <a:ext uri="{FF2B5EF4-FFF2-40B4-BE49-F238E27FC236}">
                <a16:creationId xmlns:a16="http://schemas.microsoft.com/office/drawing/2014/main" id="{04288835-ABAE-EBDB-D6FB-3E6FB1FFF00A}"/>
              </a:ext>
            </a:extLst>
          </p:cNvPr>
          <p:cNvSpPr>
            <a:spLocks/>
          </p:cNvSpPr>
          <p:nvPr/>
        </p:nvSpPr>
        <p:spPr bwMode="auto">
          <a:xfrm>
            <a:off x="7183376" y="4648572"/>
            <a:ext cx="3133387" cy="1024100"/>
          </a:xfrm>
          <a:custGeom>
            <a:avLst/>
            <a:gdLst>
              <a:gd name="T0" fmla="*/ 84 w 1660"/>
              <a:gd name="T1" fmla="*/ 540 h 549"/>
              <a:gd name="T2" fmla="*/ 134 w 1660"/>
              <a:gd name="T3" fmla="*/ 521 h 549"/>
              <a:gd name="T4" fmla="*/ 149 w 1660"/>
              <a:gd name="T5" fmla="*/ 507 h 549"/>
              <a:gd name="T6" fmla="*/ 175 w 1660"/>
              <a:gd name="T7" fmla="*/ 497 h 549"/>
              <a:gd name="T8" fmla="*/ 190 w 1660"/>
              <a:gd name="T9" fmla="*/ 483 h 549"/>
              <a:gd name="T10" fmla="*/ 208 w 1660"/>
              <a:gd name="T11" fmla="*/ 473 h 549"/>
              <a:gd name="T12" fmla="*/ 271 w 1660"/>
              <a:gd name="T13" fmla="*/ 469 h 549"/>
              <a:gd name="T14" fmla="*/ 281 w 1660"/>
              <a:gd name="T15" fmla="*/ 454 h 549"/>
              <a:gd name="T16" fmla="*/ 313 w 1660"/>
              <a:gd name="T17" fmla="*/ 444 h 549"/>
              <a:gd name="T18" fmla="*/ 340 w 1660"/>
              <a:gd name="T19" fmla="*/ 434 h 549"/>
              <a:gd name="T20" fmla="*/ 382 w 1660"/>
              <a:gd name="T21" fmla="*/ 429 h 549"/>
              <a:gd name="T22" fmla="*/ 411 w 1660"/>
              <a:gd name="T23" fmla="*/ 424 h 549"/>
              <a:gd name="T24" fmla="*/ 457 w 1660"/>
              <a:gd name="T25" fmla="*/ 419 h 549"/>
              <a:gd name="T26" fmla="*/ 495 w 1660"/>
              <a:gd name="T27" fmla="*/ 398 h 549"/>
              <a:gd name="T28" fmla="*/ 522 w 1660"/>
              <a:gd name="T29" fmla="*/ 388 h 549"/>
              <a:gd name="T30" fmla="*/ 547 w 1660"/>
              <a:gd name="T31" fmla="*/ 382 h 549"/>
              <a:gd name="T32" fmla="*/ 569 w 1660"/>
              <a:gd name="T33" fmla="*/ 377 h 549"/>
              <a:gd name="T34" fmla="*/ 615 w 1660"/>
              <a:gd name="T35" fmla="*/ 366 h 549"/>
              <a:gd name="T36" fmla="*/ 634 w 1660"/>
              <a:gd name="T37" fmla="*/ 354 h 549"/>
              <a:gd name="T38" fmla="*/ 654 w 1660"/>
              <a:gd name="T39" fmla="*/ 343 h 549"/>
              <a:gd name="T40" fmla="*/ 690 w 1660"/>
              <a:gd name="T41" fmla="*/ 337 h 549"/>
              <a:gd name="T42" fmla="*/ 712 w 1660"/>
              <a:gd name="T43" fmla="*/ 325 h 549"/>
              <a:gd name="T44" fmla="*/ 732 w 1660"/>
              <a:gd name="T45" fmla="*/ 319 h 549"/>
              <a:gd name="T46" fmla="*/ 770 w 1660"/>
              <a:gd name="T47" fmla="*/ 313 h 549"/>
              <a:gd name="T48" fmla="*/ 801 w 1660"/>
              <a:gd name="T49" fmla="*/ 307 h 549"/>
              <a:gd name="T50" fmla="*/ 832 w 1660"/>
              <a:gd name="T51" fmla="*/ 300 h 549"/>
              <a:gd name="T52" fmla="*/ 846 w 1660"/>
              <a:gd name="T53" fmla="*/ 287 h 549"/>
              <a:gd name="T54" fmla="*/ 878 w 1660"/>
              <a:gd name="T55" fmla="*/ 280 h 549"/>
              <a:gd name="T56" fmla="*/ 900 w 1660"/>
              <a:gd name="T57" fmla="*/ 273 h 549"/>
              <a:gd name="T58" fmla="*/ 938 w 1660"/>
              <a:gd name="T59" fmla="*/ 266 h 549"/>
              <a:gd name="T60" fmla="*/ 968 w 1660"/>
              <a:gd name="T61" fmla="*/ 266 h 549"/>
              <a:gd name="T62" fmla="*/ 989 w 1660"/>
              <a:gd name="T63" fmla="*/ 249 h 549"/>
              <a:gd name="T64" fmla="*/ 1027 w 1660"/>
              <a:gd name="T65" fmla="*/ 241 h 549"/>
              <a:gd name="T66" fmla="*/ 1058 w 1660"/>
              <a:gd name="T67" fmla="*/ 232 h 549"/>
              <a:gd name="T68" fmla="*/ 1085 w 1660"/>
              <a:gd name="T69" fmla="*/ 205 h 549"/>
              <a:gd name="T70" fmla="*/ 1130 w 1660"/>
              <a:gd name="T71" fmla="*/ 205 h 549"/>
              <a:gd name="T72" fmla="*/ 1147 w 1660"/>
              <a:gd name="T73" fmla="*/ 185 h 549"/>
              <a:gd name="T74" fmla="*/ 1188 w 1660"/>
              <a:gd name="T75" fmla="*/ 185 h 549"/>
              <a:gd name="T76" fmla="*/ 1227 w 1660"/>
              <a:gd name="T77" fmla="*/ 185 h 549"/>
              <a:gd name="T78" fmla="*/ 1253 w 1660"/>
              <a:gd name="T79" fmla="*/ 174 h 549"/>
              <a:gd name="T80" fmla="*/ 1280 w 1660"/>
              <a:gd name="T81" fmla="*/ 174 h 549"/>
              <a:gd name="T82" fmla="*/ 1314 w 1660"/>
              <a:gd name="T83" fmla="*/ 174 h 549"/>
              <a:gd name="T84" fmla="*/ 1335 w 1660"/>
              <a:gd name="T85" fmla="*/ 160 h 549"/>
              <a:gd name="T86" fmla="*/ 1363 w 1660"/>
              <a:gd name="T87" fmla="*/ 160 h 549"/>
              <a:gd name="T88" fmla="*/ 1393 w 1660"/>
              <a:gd name="T89" fmla="*/ 160 h 549"/>
              <a:gd name="T90" fmla="*/ 1421 w 1660"/>
              <a:gd name="T91" fmla="*/ 143 h 549"/>
              <a:gd name="T92" fmla="*/ 1463 w 1660"/>
              <a:gd name="T93" fmla="*/ 143 h 549"/>
              <a:gd name="T94" fmla="*/ 1490 w 1660"/>
              <a:gd name="T95" fmla="*/ 143 h 549"/>
              <a:gd name="T96" fmla="*/ 1522 w 1660"/>
              <a:gd name="T97" fmla="*/ 143 h 549"/>
              <a:gd name="T98" fmla="*/ 1546 w 1660"/>
              <a:gd name="T99" fmla="*/ 110 h 549"/>
              <a:gd name="T100" fmla="*/ 1591 w 1660"/>
              <a:gd name="T101" fmla="*/ 110 h 549"/>
              <a:gd name="T102" fmla="*/ 1629 w 1660"/>
              <a:gd name="T103" fmla="*/ 110 h 549"/>
              <a:gd name="T104" fmla="*/ 1650 w 1660"/>
              <a:gd name="T105" fmla="*/ 0 h 5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660" h="549">
                <a:moveTo>
                  <a:pt x="0" y="549"/>
                </a:moveTo>
                <a:lnTo>
                  <a:pt x="79" y="549"/>
                </a:lnTo>
                <a:lnTo>
                  <a:pt x="79" y="544"/>
                </a:lnTo>
                <a:lnTo>
                  <a:pt x="84" y="544"/>
                </a:lnTo>
                <a:lnTo>
                  <a:pt x="84" y="540"/>
                </a:lnTo>
                <a:lnTo>
                  <a:pt x="97" y="540"/>
                </a:lnTo>
                <a:lnTo>
                  <a:pt x="119" y="535"/>
                </a:lnTo>
                <a:lnTo>
                  <a:pt x="130" y="535"/>
                </a:lnTo>
                <a:lnTo>
                  <a:pt x="130" y="526"/>
                </a:lnTo>
                <a:lnTo>
                  <a:pt x="134" y="521"/>
                </a:lnTo>
                <a:lnTo>
                  <a:pt x="140" y="521"/>
                </a:lnTo>
                <a:lnTo>
                  <a:pt x="140" y="511"/>
                </a:lnTo>
                <a:lnTo>
                  <a:pt x="143" y="511"/>
                </a:lnTo>
                <a:lnTo>
                  <a:pt x="143" y="507"/>
                </a:lnTo>
                <a:lnTo>
                  <a:pt x="149" y="507"/>
                </a:lnTo>
                <a:lnTo>
                  <a:pt x="160" y="507"/>
                </a:lnTo>
                <a:lnTo>
                  <a:pt x="164" y="502"/>
                </a:lnTo>
                <a:lnTo>
                  <a:pt x="169" y="502"/>
                </a:lnTo>
                <a:lnTo>
                  <a:pt x="169" y="497"/>
                </a:lnTo>
                <a:lnTo>
                  <a:pt x="175" y="497"/>
                </a:lnTo>
                <a:lnTo>
                  <a:pt x="181" y="493"/>
                </a:lnTo>
                <a:lnTo>
                  <a:pt x="184" y="493"/>
                </a:lnTo>
                <a:lnTo>
                  <a:pt x="184" y="488"/>
                </a:lnTo>
                <a:lnTo>
                  <a:pt x="190" y="488"/>
                </a:lnTo>
                <a:lnTo>
                  <a:pt x="190" y="483"/>
                </a:lnTo>
                <a:lnTo>
                  <a:pt x="196" y="483"/>
                </a:lnTo>
                <a:lnTo>
                  <a:pt x="196" y="478"/>
                </a:lnTo>
                <a:lnTo>
                  <a:pt x="198" y="473"/>
                </a:lnTo>
                <a:lnTo>
                  <a:pt x="204" y="473"/>
                </a:lnTo>
                <a:lnTo>
                  <a:pt x="208" y="473"/>
                </a:lnTo>
                <a:lnTo>
                  <a:pt x="218" y="473"/>
                </a:lnTo>
                <a:lnTo>
                  <a:pt x="233" y="469"/>
                </a:lnTo>
                <a:lnTo>
                  <a:pt x="243" y="469"/>
                </a:lnTo>
                <a:lnTo>
                  <a:pt x="257" y="469"/>
                </a:lnTo>
                <a:lnTo>
                  <a:pt x="271" y="469"/>
                </a:lnTo>
                <a:lnTo>
                  <a:pt x="275" y="469"/>
                </a:lnTo>
                <a:lnTo>
                  <a:pt x="277" y="464"/>
                </a:lnTo>
                <a:lnTo>
                  <a:pt x="280" y="464"/>
                </a:lnTo>
                <a:lnTo>
                  <a:pt x="280" y="459"/>
                </a:lnTo>
                <a:lnTo>
                  <a:pt x="281" y="454"/>
                </a:lnTo>
                <a:lnTo>
                  <a:pt x="289" y="454"/>
                </a:lnTo>
                <a:lnTo>
                  <a:pt x="289" y="449"/>
                </a:lnTo>
                <a:lnTo>
                  <a:pt x="295" y="449"/>
                </a:lnTo>
                <a:lnTo>
                  <a:pt x="302" y="449"/>
                </a:lnTo>
                <a:lnTo>
                  <a:pt x="313" y="444"/>
                </a:lnTo>
                <a:lnTo>
                  <a:pt x="313" y="439"/>
                </a:lnTo>
                <a:lnTo>
                  <a:pt x="319" y="439"/>
                </a:lnTo>
                <a:lnTo>
                  <a:pt x="334" y="439"/>
                </a:lnTo>
                <a:lnTo>
                  <a:pt x="334" y="434"/>
                </a:lnTo>
                <a:lnTo>
                  <a:pt x="340" y="434"/>
                </a:lnTo>
                <a:lnTo>
                  <a:pt x="345" y="434"/>
                </a:lnTo>
                <a:lnTo>
                  <a:pt x="348" y="434"/>
                </a:lnTo>
                <a:lnTo>
                  <a:pt x="348" y="429"/>
                </a:lnTo>
                <a:lnTo>
                  <a:pt x="357" y="429"/>
                </a:lnTo>
                <a:lnTo>
                  <a:pt x="382" y="429"/>
                </a:lnTo>
                <a:lnTo>
                  <a:pt x="388" y="429"/>
                </a:lnTo>
                <a:lnTo>
                  <a:pt x="389" y="429"/>
                </a:lnTo>
                <a:lnTo>
                  <a:pt x="389" y="424"/>
                </a:lnTo>
                <a:lnTo>
                  <a:pt x="405" y="424"/>
                </a:lnTo>
                <a:lnTo>
                  <a:pt x="411" y="424"/>
                </a:lnTo>
                <a:lnTo>
                  <a:pt x="416" y="424"/>
                </a:lnTo>
                <a:lnTo>
                  <a:pt x="416" y="419"/>
                </a:lnTo>
                <a:lnTo>
                  <a:pt x="431" y="419"/>
                </a:lnTo>
                <a:lnTo>
                  <a:pt x="446" y="419"/>
                </a:lnTo>
                <a:lnTo>
                  <a:pt x="457" y="419"/>
                </a:lnTo>
                <a:lnTo>
                  <a:pt x="457" y="409"/>
                </a:lnTo>
                <a:lnTo>
                  <a:pt x="486" y="409"/>
                </a:lnTo>
                <a:lnTo>
                  <a:pt x="494" y="409"/>
                </a:lnTo>
                <a:lnTo>
                  <a:pt x="494" y="403"/>
                </a:lnTo>
                <a:lnTo>
                  <a:pt x="495" y="398"/>
                </a:lnTo>
                <a:lnTo>
                  <a:pt x="508" y="398"/>
                </a:lnTo>
                <a:lnTo>
                  <a:pt x="508" y="393"/>
                </a:lnTo>
                <a:lnTo>
                  <a:pt x="515" y="393"/>
                </a:lnTo>
                <a:lnTo>
                  <a:pt x="517" y="388"/>
                </a:lnTo>
                <a:lnTo>
                  <a:pt x="522" y="388"/>
                </a:lnTo>
                <a:lnTo>
                  <a:pt x="522" y="382"/>
                </a:lnTo>
                <a:lnTo>
                  <a:pt x="530" y="382"/>
                </a:lnTo>
                <a:lnTo>
                  <a:pt x="537" y="382"/>
                </a:lnTo>
                <a:lnTo>
                  <a:pt x="541" y="382"/>
                </a:lnTo>
                <a:lnTo>
                  <a:pt x="547" y="382"/>
                </a:lnTo>
                <a:lnTo>
                  <a:pt x="551" y="382"/>
                </a:lnTo>
                <a:lnTo>
                  <a:pt x="557" y="382"/>
                </a:lnTo>
                <a:lnTo>
                  <a:pt x="557" y="377"/>
                </a:lnTo>
                <a:lnTo>
                  <a:pt x="563" y="377"/>
                </a:lnTo>
                <a:lnTo>
                  <a:pt x="569" y="377"/>
                </a:lnTo>
                <a:lnTo>
                  <a:pt x="577" y="372"/>
                </a:lnTo>
                <a:lnTo>
                  <a:pt x="581" y="372"/>
                </a:lnTo>
                <a:lnTo>
                  <a:pt x="604" y="372"/>
                </a:lnTo>
                <a:lnTo>
                  <a:pt x="615" y="372"/>
                </a:lnTo>
                <a:lnTo>
                  <a:pt x="615" y="366"/>
                </a:lnTo>
                <a:lnTo>
                  <a:pt x="619" y="366"/>
                </a:lnTo>
                <a:lnTo>
                  <a:pt x="621" y="360"/>
                </a:lnTo>
                <a:lnTo>
                  <a:pt x="624" y="360"/>
                </a:lnTo>
                <a:lnTo>
                  <a:pt x="629" y="360"/>
                </a:lnTo>
                <a:lnTo>
                  <a:pt x="634" y="354"/>
                </a:lnTo>
                <a:lnTo>
                  <a:pt x="636" y="354"/>
                </a:lnTo>
                <a:lnTo>
                  <a:pt x="636" y="349"/>
                </a:lnTo>
                <a:lnTo>
                  <a:pt x="637" y="343"/>
                </a:lnTo>
                <a:lnTo>
                  <a:pt x="651" y="343"/>
                </a:lnTo>
                <a:lnTo>
                  <a:pt x="654" y="343"/>
                </a:lnTo>
                <a:lnTo>
                  <a:pt x="656" y="337"/>
                </a:lnTo>
                <a:lnTo>
                  <a:pt x="670" y="337"/>
                </a:lnTo>
                <a:lnTo>
                  <a:pt x="679" y="337"/>
                </a:lnTo>
                <a:lnTo>
                  <a:pt x="684" y="337"/>
                </a:lnTo>
                <a:lnTo>
                  <a:pt x="690" y="337"/>
                </a:lnTo>
                <a:lnTo>
                  <a:pt x="697" y="337"/>
                </a:lnTo>
                <a:lnTo>
                  <a:pt x="698" y="331"/>
                </a:lnTo>
                <a:lnTo>
                  <a:pt x="707" y="331"/>
                </a:lnTo>
                <a:lnTo>
                  <a:pt x="711" y="331"/>
                </a:lnTo>
                <a:lnTo>
                  <a:pt x="712" y="325"/>
                </a:lnTo>
                <a:lnTo>
                  <a:pt x="713" y="319"/>
                </a:lnTo>
                <a:lnTo>
                  <a:pt x="714" y="319"/>
                </a:lnTo>
                <a:lnTo>
                  <a:pt x="721" y="319"/>
                </a:lnTo>
                <a:lnTo>
                  <a:pt x="728" y="319"/>
                </a:lnTo>
                <a:lnTo>
                  <a:pt x="732" y="319"/>
                </a:lnTo>
                <a:lnTo>
                  <a:pt x="737" y="319"/>
                </a:lnTo>
                <a:lnTo>
                  <a:pt x="747" y="319"/>
                </a:lnTo>
                <a:lnTo>
                  <a:pt x="747" y="313"/>
                </a:lnTo>
                <a:lnTo>
                  <a:pt x="764" y="313"/>
                </a:lnTo>
                <a:lnTo>
                  <a:pt x="770" y="313"/>
                </a:lnTo>
                <a:lnTo>
                  <a:pt x="774" y="313"/>
                </a:lnTo>
                <a:lnTo>
                  <a:pt x="780" y="313"/>
                </a:lnTo>
                <a:lnTo>
                  <a:pt x="790" y="313"/>
                </a:lnTo>
                <a:lnTo>
                  <a:pt x="790" y="307"/>
                </a:lnTo>
                <a:lnTo>
                  <a:pt x="801" y="307"/>
                </a:lnTo>
                <a:lnTo>
                  <a:pt x="801" y="300"/>
                </a:lnTo>
                <a:lnTo>
                  <a:pt x="807" y="300"/>
                </a:lnTo>
                <a:lnTo>
                  <a:pt x="810" y="300"/>
                </a:lnTo>
                <a:lnTo>
                  <a:pt x="827" y="300"/>
                </a:lnTo>
                <a:lnTo>
                  <a:pt x="832" y="300"/>
                </a:lnTo>
                <a:lnTo>
                  <a:pt x="832" y="293"/>
                </a:lnTo>
                <a:lnTo>
                  <a:pt x="834" y="293"/>
                </a:lnTo>
                <a:lnTo>
                  <a:pt x="844" y="293"/>
                </a:lnTo>
                <a:lnTo>
                  <a:pt x="844" y="287"/>
                </a:lnTo>
                <a:lnTo>
                  <a:pt x="846" y="287"/>
                </a:lnTo>
                <a:lnTo>
                  <a:pt x="862" y="287"/>
                </a:lnTo>
                <a:lnTo>
                  <a:pt x="865" y="287"/>
                </a:lnTo>
                <a:lnTo>
                  <a:pt x="865" y="280"/>
                </a:lnTo>
                <a:lnTo>
                  <a:pt x="873" y="280"/>
                </a:lnTo>
                <a:lnTo>
                  <a:pt x="878" y="280"/>
                </a:lnTo>
                <a:lnTo>
                  <a:pt x="882" y="280"/>
                </a:lnTo>
                <a:lnTo>
                  <a:pt x="891" y="280"/>
                </a:lnTo>
                <a:lnTo>
                  <a:pt x="893" y="273"/>
                </a:lnTo>
                <a:lnTo>
                  <a:pt x="895" y="273"/>
                </a:lnTo>
                <a:lnTo>
                  <a:pt x="900" y="273"/>
                </a:lnTo>
                <a:lnTo>
                  <a:pt x="903" y="266"/>
                </a:lnTo>
                <a:lnTo>
                  <a:pt x="909" y="266"/>
                </a:lnTo>
                <a:lnTo>
                  <a:pt x="920" y="266"/>
                </a:lnTo>
                <a:lnTo>
                  <a:pt x="924" y="266"/>
                </a:lnTo>
                <a:lnTo>
                  <a:pt x="938" y="266"/>
                </a:lnTo>
                <a:lnTo>
                  <a:pt x="947" y="266"/>
                </a:lnTo>
                <a:lnTo>
                  <a:pt x="949" y="266"/>
                </a:lnTo>
                <a:lnTo>
                  <a:pt x="955" y="266"/>
                </a:lnTo>
                <a:lnTo>
                  <a:pt x="961" y="266"/>
                </a:lnTo>
                <a:lnTo>
                  <a:pt x="968" y="266"/>
                </a:lnTo>
                <a:lnTo>
                  <a:pt x="972" y="266"/>
                </a:lnTo>
                <a:lnTo>
                  <a:pt x="976" y="257"/>
                </a:lnTo>
                <a:lnTo>
                  <a:pt x="980" y="257"/>
                </a:lnTo>
                <a:lnTo>
                  <a:pt x="988" y="257"/>
                </a:lnTo>
                <a:lnTo>
                  <a:pt x="989" y="249"/>
                </a:lnTo>
                <a:lnTo>
                  <a:pt x="997" y="249"/>
                </a:lnTo>
                <a:lnTo>
                  <a:pt x="997" y="241"/>
                </a:lnTo>
                <a:lnTo>
                  <a:pt x="1010" y="241"/>
                </a:lnTo>
                <a:lnTo>
                  <a:pt x="1020" y="241"/>
                </a:lnTo>
                <a:lnTo>
                  <a:pt x="1027" y="241"/>
                </a:lnTo>
                <a:lnTo>
                  <a:pt x="1027" y="232"/>
                </a:lnTo>
                <a:lnTo>
                  <a:pt x="1037" y="232"/>
                </a:lnTo>
                <a:lnTo>
                  <a:pt x="1043" y="232"/>
                </a:lnTo>
                <a:lnTo>
                  <a:pt x="1045" y="232"/>
                </a:lnTo>
                <a:lnTo>
                  <a:pt x="1058" y="232"/>
                </a:lnTo>
                <a:lnTo>
                  <a:pt x="1061" y="223"/>
                </a:lnTo>
                <a:lnTo>
                  <a:pt x="1072" y="223"/>
                </a:lnTo>
                <a:lnTo>
                  <a:pt x="1082" y="223"/>
                </a:lnTo>
                <a:lnTo>
                  <a:pt x="1083" y="214"/>
                </a:lnTo>
                <a:lnTo>
                  <a:pt x="1085" y="205"/>
                </a:lnTo>
                <a:lnTo>
                  <a:pt x="1095" y="205"/>
                </a:lnTo>
                <a:lnTo>
                  <a:pt x="1105" y="205"/>
                </a:lnTo>
                <a:lnTo>
                  <a:pt x="1112" y="205"/>
                </a:lnTo>
                <a:lnTo>
                  <a:pt x="1124" y="205"/>
                </a:lnTo>
                <a:lnTo>
                  <a:pt x="1130" y="205"/>
                </a:lnTo>
                <a:lnTo>
                  <a:pt x="1133" y="195"/>
                </a:lnTo>
                <a:lnTo>
                  <a:pt x="1136" y="195"/>
                </a:lnTo>
                <a:lnTo>
                  <a:pt x="1145" y="195"/>
                </a:lnTo>
                <a:lnTo>
                  <a:pt x="1145" y="185"/>
                </a:lnTo>
                <a:lnTo>
                  <a:pt x="1147" y="185"/>
                </a:lnTo>
                <a:lnTo>
                  <a:pt x="1157" y="185"/>
                </a:lnTo>
                <a:lnTo>
                  <a:pt x="1170" y="185"/>
                </a:lnTo>
                <a:lnTo>
                  <a:pt x="1172" y="185"/>
                </a:lnTo>
                <a:lnTo>
                  <a:pt x="1179" y="185"/>
                </a:lnTo>
                <a:lnTo>
                  <a:pt x="1188" y="185"/>
                </a:lnTo>
                <a:lnTo>
                  <a:pt x="1200" y="185"/>
                </a:lnTo>
                <a:lnTo>
                  <a:pt x="1203" y="185"/>
                </a:lnTo>
                <a:lnTo>
                  <a:pt x="1208" y="185"/>
                </a:lnTo>
                <a:lnTo>
                  <a:pt x="1223" y="185"/>
                </a:lnTo>
                <a:lnTo>
                  <a:pt x="1227" y="185"/>
                </a:lnTo>
                <a:lnTo>
                  <a:pt x="1232" y="185"/>
                </a:lnTo>
                <a:lnTo>
                  <a:pt x="1241" y="185"/>
                </a:lnTo>
                <a:lnTo>
                  <a:pt x="1244" y="185"/>
                </a:lnTo>
                <a:lnTo>
                  <a:pt x="1244" y="174"/>
                </a:lnTo>
                <a:lnTo>
                  <a:pt x="1253" y="174"/>
                </a:lnTo>
                <a:lnTo>
                  <a:pt x="1255" y="174"/>
                </a:lnTo>
                <a:lnTo>
                  <a:pt x="1264" y="174"/>
                </a:lnTo>
                <a:lnTo>
                  <a:pt x="1268" y="174"/>
                </a:lnTo>
                <a:lnTo>
                  <a:pt x="1278" y="174"/>
                </a:lnTo>
                <a:lnTo>
                  <a:pt x="1280" y="174"/>
                </a:lnTo>
                <a:lnTo>
                  <a:pt x="1286" y="174"/>
                </a:lnTo>
                <a:lnTo>
                  <a:pt x="1294" y="174"/>
                </a:lnTo>
                <a:lnTo>
                  <a:pt x="1300" y="174"/>
                </a:lnTo>
                <a:lnTo>
                  <a:pt x="1305" y="174"/>
                </a:lnTo>
                <a:lnTo>
                  <a:pt x="1314" y="174"/>
                </a:lnTo>
                <a:lnTo>
                  <a:pt x="1316" y="174"/>
                </a:lnTo>
                <a:lnTo>
                  <a:pt x="1316" y="160"/>
                </a:lnTo>
                <a:lnTo>
                  <a:pt x="1322" y="160"/>
                </a:lnTo>
                <a:lnTo>
                  <a:pt x="1327" y="160"/>
                </a:lnTo>
                <a:lnTo>
                  <a:pt x="1335" y="160"/>
                </a:lnTo>
                <a:lnTo>
                  <a:pt x="1342" y="160"/>
                </a:lnTo>
                <a:lnTo>
                  <a:pt x="1348" y="160"/>
                </a:lnTo>
                <a:lnTo>
                  <a:pt x="1353" y="160"/>
                </a:lnTo>
                <a:lnTo>
                  <a:pt x="1359" y="160"/>
                </a:lnTo>
                <a:lnTo>
                  <a:pt x="1363" y="160"/>
                </a:lnTo>
                <a:lnTo>
                  <a:pt x="1374" y="160"/>
                </a:lnTo>
                <a:lnTo>
                  <a:pt x="1376" y="160"/>
                </a:lnTo>
                <a:lnTo>
                  <a:pt x="1382" y="160"/>
                </a:lnTo>
                <a:lnTo>
                  <a:pt x="1389" y="160"/>
                </a:lnTo>
                <a:lnTo>
                  <a:pt x="1393" y="160"/>
                </a:lnTo>
                <a:lnTo>
                  <a:pt x="1399" y="160"/>
                </a:lnTo>
                <a:lnTo>
                  <a:pt x="1399" y="143"/>
                </a:lnTo>
                <a:lnTo>
                  <a:pt x="1411" y="143"/>
                </a:lnTo>
                <a:lnTo>
                  <a:pt x="1412" y="143"/>
                </a:lnTo>
                <a:lnTo>
                  <a:pt x="1421" y="143"/>
                </a:lnTo>
                <a:lnTo>
                  <a:pt x="1427" y="143"/>
                </a:lnTo>
                <a:lnTo>
                  <a:pt x="1443" y="143"/>
                </a:lnTo>
                <a:lnTo>
                  <a:pt x="1448" y="143"/>
                </a:lnTo>
                <a:lnTo>
                  <a:pt x="1459" y="143"/>
                </a:lnTo>
                <a:lnTo>
                  <a:pt x="1463" y="143"/>
                </a:lnTo>
                <a:lnTo>
                  <a:pt x="1468" y="143"/>
                </a:lnTo>
                <a:lnTo>
                  <a:pt x="1473" y="143"/>
                </a:lnTo>
                <a:lnTo>
                  <a:pt x="1479" y="143"/>
                </a:lnTo>
                <a:lnTo>
                  <a:pt x="1484" y="143"/>
                </a:lnTo>
                <a:lnTo>
                  <a:pt x="1490" y="143"/>
                </a:lnTo>
                <a:lnTo>
                  <a:pt x="1496" y="143"/>
                </a:lnTo>
                <a:lnTo>
                  <a:pt x="1505" y="143"/>
                </a:lnTo>
                <a:lnTo>
                  <a:pt x="1510" y="143"/>
                </a:lnTo>
                <a:lnTo>
                  <a:pt x="1516" y="143"/>
                </a:lnTo>
                <a:lnTo>
                  <a:pt x="1522" y="143"/>
                </a:lnTo>
                <a:lnTo>
                  <a:pt x="1526" y="143"/>
                </a:lnTo>
                <a:lnTo>
                  <a:pt x="1529" y="110"/>
                </a:lnTo>
                <a:lnTo>
                  <a:pt x="1532" y="110"/>
                </a:lnTo>
                <a:lnTo>
                  <a:pt x="1543" y="110"/>
                </a:lnTo>
                <a:lnTo>
                  <a:pt x="1546" y="110"/>
                </a:lnTo>
                <a:lnTo>
                  <a:pt x="1555" y="110"/>
                </a:lnTo>
                <a:lnTo>
                  <a:pt x="1559" y="110"/>
                </a:lnTo>
                <a:lnTo>
                  <a:pt x="1564" y="110"/>
                </a:lnTo>
                <a:lnTo>
                  <a:pt x="1576" y="110"/>
                </a:lnTo>
                <a:lnTo>
                  <a:pt x="1591" y="110"/>
                </a:lnTo>
                <a:lnTo>
                  <a:pt x="1593" y="110"/>
                </a:lnTo>
                <a:lnTo>
                  <a:pt x="1602" y="110"/>
                </a:lnTo>
                <a:lnTo>
                  <a:pt x="1610" y="110"/>
                </a:lnTo>
                <a:lnTo>
                  <a:pt x="1621" y="110"/>
                </a:lnTo>
                <a:lnTo>
                  <a:pt x="1629" y="110"/>
                </a:lnTo>
                <a:lnTo>
                  <a:pt x="1638" y="110"/>
                </a:lnTo>
                <a:lnTo>
                  <a:pt x="1642" y="110"/>
                </a:lnTo>
                <a:lnTo>
                  <a:pt x="1642" y="56"/>
                </a:lnTo>
                <a:lnTo>
                  <a:pt x="1650" y="56"/>
                </a:lnTo>
                <a:lnTo>
                  <a:pt x="1650" y="0"/>
                </a:lnTo>
                <a:lnTo>
                  <a:pt x="1654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D5485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6" name="Freeform 131">
            <a:extLst>
              <a:ext uri="{FF2B5EF4-FFF2-40B4-BE49-F238E27FC236}">
                <a16:creationId xmlns:a16="http://schemas.microsoft.com/office/drawing/2014/main" id="{290024FA-75FB-CEB1-BB0E-BED7DFC51869}"/>
              </a:ext>
            </a:extLst>
          </p:cNvPr>
          <p:cNvSpPr>
            <a:spLocks/>
          </p:cNvSpPr>
          <p:nvPr/>
        </p:nvSpPr>
        <p:spPr bwMode="auto">
          <a:xfrm>
            <a:off x="7183376" y="5487998"/>
            <a:ext cx="3133387" cy="184674"/>
          </a:xfrm>
          <a:custGeom>
            <a:avLst/>
            <a:gdLst>
              <a:gd name="T0" fmla="*/ 144 w 1660"/>
              <a:gd name="T1" fmla="*/ 99 h 99"/>
              <a:gd name="T2" fmla="*/ 160 w 1660"/>
              <a:gd name="T3" fmla="*/ 99 h 99"/>
              <a:gd name="T4" fmla="*/ 187 w 1660"/>
              <a:gd name="T5" fmla="*/ 89 h 99"/>
              <a:gd name="T6" fmla="*/ 236 w 1660"/>
              <a:gd name="T7" fmla="*/ 78 h 99"/>
              <a:gd name="T8" fmla="*/ 272 w 1660"/>
              <a:gd name="T9" fmla="*/ 78 h 99"/>
              <a:gd name="T10" fmla="*/ 334 w 1660"/>
              <a:gd name="T11" fmla="*/ 78 h 99"/>
              <a:gd name="T12" fmla="*/ 383 w 1660"/>
              <a:gd name="T13" fmla="*/ 78 h 99"/>
              <a:gd name="T14" fmla="*/ 398 w 1660"/>
              <a:gd name="T15" fmla="*/ 67 h 99"/>
              <a:gd name="T16" fmla="*/ 409 w 1660"/>
              <a:gd name="T17" fmla="*/ 57 h 99"/>
              <a:gd name="T18" fmla="*/ 461 w 1660"/>
              <a:gd name="T19" fmla="*/ 57 h 99"/>
              <a:gd name="T20" fmla="*/ 498 w 1660"/>
              <a:gd name="T21" fmla="*/ 57 h 99"/>
              <a:gd name="T22" fmla="*/ 557 w 1660"/>
              <a:gd name="T23" fmla="*/ 57 h 99"/>
              <a:gd name="T24" fmla="*/ 578 w 1660"/>
              <a:gd name="T25" fmla="*/ 57 h 99"/>
              <a:gd name="T26" fmla="*/ 599 w 1660"/>
              <a:gd name="T27" fmla="*/ 57 h 99"/>
              <a:gd name="T28" fmla="*/ 618 w 1660"/>
              <a:gd name="T29" fmla="*/ 57 h 99"/>
              <a:gd name="T30" fmla="*/ 636 w 1660"/>
              <a:gd name="T31" fmla="*/ 57 h 99"/>
              <a:gd name="T32" fmla="*/ 657 w 1660"/>
              <a:gd name="T33" fmla="*/ 57 h 99"/>
              <a:gd name="T34" fmla="*/ 673 w 1660"/>
              <a:gd name="T35" fmla="*/ 57 h 99"/>
              <a:gd name="T36" fmla="*/ 690 w 1660"/>
              <a:gd name="T37" fmla="*/ 57 h 99"/>
              <a:gd name="T38" fmla="*/ 712 w 1660"/>
              <a:gd name="T39" fmla="*/ 57 h 99"/>
              <a:gd name="T40" fmla="*/ 732 w 1660"/>
              <a:gd name="T41" fmla="*/ 57 h 99"/>
              <a:gd name="T42" fmla="*/ 754 w 1660"/>
              <a:gd name="T43" fmla="*/ 57 h 99"/>
              <a:gd name="T44" fmla="*/ 777 w 1660"/>
              <a:gd name="T45" fmla="*/ 57 h 99"/>
              <a:gd name="T46" fmla="*/ 801 w 1660"/>
              <a:gd name="T47" fmla="*/ 35 h 99"/>
              <a:gd name="T48" fmla="*/ 835 w 1660"/>
              <a:gd name="T49" fmla="*/ 35 h 99"/>
              <a:gd name="T50" fmla="*/ 866 w 1660"/>
              <a:gd name="T51" fmla="*/ 35 h 99"/>
              <a:gd name="T52" fmla="*/ 882 w 1660"/>
              <a:gd name="T53" fmla="*/ 35 h 99"/>
              <a:gd name="T54" fmla="*/ 908 w 1660"/>
              <a:gd name="T55" fmla="*/ 35 h 99"/>
              <a:gd name="T56" fmla="*/ 929 w 1660"/>
              <a:gd name="T57" fmla="*/ 35 h 99"/>
              <a:gd name="T58" fmla="*/ 962 w 1660"/>
              <a:gd name="T59" fmla="*/ 35 h 99"/>
              <a:gd name="T60" fmla="*/ 993 w 1660"/>
              <a:gd name="T61" fmla="*/ 0 h 99"/>
              <a:gd name="T62" fmla="*/ 1020 w 1660"/>
              <a:gd name="T63" fmla="*/ 0 h 99"/>
              <a:gd name="T64" fmla="*/ 1098 w 1660"/>
              <a:gd name="T65" fmla="*/ 0 h 99"/>
              <a:gd name="T66" fmla="*/ 1134 w 1660"/>
              <a:gd name="T67" fmla="*/ 0 h 99"/>
              <a:gd name="T68" fmla="*/ 1197 w 1660"/>
              <a:gd name="T69" fmla="*/ 0 h 99"/>
              <a:gd name="T70" fmla="*/ 1261 w 1660"/>
              <a:gd name="T71" fmla="*/ 0 h 99"/>
              <a:gd name="T72" fmla="*/ 1290 w 1660"/>
              <a:gd name="T73" fmla="*/ 0 h 99"/>
              <a:gd name="T74" fmla="*/ 1344 w 1660"/>
              <a:gd name="T75" fmla="*/ 0 h 99"/>
              <a:gd name="T76" fmla="*/ 1385 w 1660"/>
              <a:gd name="T77" fmla="*/ 0 h 99"/>
              <a:gd name="T78" fmla="*/ 1402 w 1660"/>
              <a:gd name="T79" fmla="*/ 0 h 99"/>
              <a:gd name="T80" fmla="*/ 1448 w 1660"/>
              <a:gd name="T81" fmla="*/ 0 h 99"/>
              <a:gd name="T82" fmla="*/ 1511 w 1660"/>
              <a:gd name="T83" fmla="*/ 0 h 99"/>
              <a:gd name="T84" fmla="*/ 1535 w 1660"/>
              <a:gd name="T85" fmla="*/ 0 h 99"/>
              <a:gd name="T86" fmla="*/ 1660 w 1660"/>
              <a:gd name="T87" fmla="*/ 0 h 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1660" h="99">
                <a:moveTo>
                  <a:pt x="0" y="99"/>
                </a:moveTo>
                <a:lnTo>
                  <a:pt x="141" y="99"/>
                </a:lnTo>
                <a:lnTo>
                  <a:pt x="144" y="99"/>
                </a:lnTo>
                <a:lnTo>
                  <a:pt x="153" y="99"/>
                </a:lnTo>
                <a:lnTo>
                  <a:pt x="158" y="99"/>
                </a:lnTo>
                <a:lnTo>
                  <a:pt x="160" y="99"/>
                </a:lnTo>
                <a:lnTo>
                  <a:pt x="173" y="99"/>
                </a:lnTo>
                <a:lnTo>
                  <a:pt x="186" y="99"/>
                </a:lnTo>
                <a:lnTo>
                  <a:pt x="187" y="89"/>
                </a:lnTo>
                <a:lnTo>
                  <a:pt x="209" y="89"/>
                </a:lnTo>
                <a:lnTo>
                  <a:pt x="209" y="78"/>
                </a:lnTo>
                <a:lnTo>
                  <a:pt x="236" y="78"/>
                </a:lnTo>
                <a:lnTo>
                  <a:pt x="256" y="78"/>
                </a:lnTo>
                <a:lnTo>
                  <a:pt x="268" y="78"/>
                </a:lnTo>
                <a:lnTo>
                  <a:pt x="272" y="78"/>
                </a:lnTo>
                <a:lnTo>
                  <a:pt x="296" y="78"/>
                </a:lnTo>
                <a:lnTo>
                  <a:pt x="324" y="78"/>
                </a:lnTo>
                <a:lnTo>
                  <a:pt x="334" y="78"/>
                </a:lnTo>
                <a:lnTo>
                  <a:pt x="349" y="78"/>
                </a:lnTo>
                <a:lnTo>
                  <a:pt x="369" y="78"/>
                </a:lnTo>
                <a:lnTo>
                  <a:pt x="383" y="78"/>
                </a:lnTo>
                <a:lnTo>
                  <a:pt x="391" y="78"/>
                </a:lnTo>
                <a:lnTo>
                  <a:pt x="398" y="78"/>
                </a:lnTo>
                <a:lnTo>
                  <a:pt x="398" y="67"/>
                </a:lnTo>
                <a:lnTo>
                  <a:pt x="401" y="67"/>
                </a:lnTo>
                <a:lnTo>
                  <a:pt x="401" y="57"/>
                </a:lnTo>
                <a:lnTo>
                  <a:pt x="409" y="57"/>
                </a:lnTo>
                <a:lnTo>
                  <a:pt x="425" y="57"/>
                </a:lnTo>
                <a:lnTo>
                  <a:pt x="448" y="57"/>
                </a:lnTo>
                <a:lnTo>
                  <a:pt x="461" y="57"/>
                </a:lnTo>
                <a:lnTo>
                  <a:pt x="472" y="57"/>
                </a:lnTo>
                <a:lnTo>
                  <a:pt x="494" y="57"/>
                </a:lnTo>
                <a:lnTo>
                  <a:pt x="498" y="57"/>
                </a:lnTo>
                <a:lnTo>
                  <a:pt x="542" y="57"/>
                </a:lnTo>
                <a:lnTo>
                  <a:pt x="546" y="57"/>
                </a:lnTo>
                <a:lnTo>
                  <a:pt x="557" y="57"/>
                </a:lnTo>
                <a:lnTo>
                  <a:pt x="564" y="57"/>
                </a:lnTo>
                <a:lnTo>
                  <a:pt x="573" y="57"/>
                </a:lnTo>
                <a:lnTo>
                  <a:pt x="578" y="57"/>
                </a:lnTo>
                <a:lnTo>
                  <a:pt x="584" y="57"/>
                </a:lnTo>
                <a:lnTo>
                  <a:pt x="594" y="57"/>
                </a:lnTo>
                <a:lnTo>
                  <a:pt x="599" y="57"/>
                </a:lnTo>
                <a:lnTo>
                  <a:pt x="610" y="57"/>
                </a:lnTo>
                <a:lnTo>
                  <a:pt x="612" y="57"/>
                </a:lnTo>
                <a:lnTo>
                  <a:pt x="618" y="57"/>
                </a:lnTo>
                <a:lnTo>
                  <a:pt x="623" y="57"/>
                </a:lnTo>
                <a:lnTo>
                  <a:pt x="632" y="57"/>
                </a:lnTo>
                <a:lnTo>
                  <a:pt x="636" y="57"/>
                </a:lnTo>
                <a:lnTo>
                  <a:pt x="643" y="57"/>
                </a:lnTo>
                <a:lnTo>
                  <a:pt x="648" y="57"/>
                </a:lnTo>
                <a:lnTo>
                  <a:pt x="657" y="57"/>
                </a:lnTo>
                <a:lnTo>
                  <a:pt x="663" y="57"/>
                </a:lnTo>
                <a:lnTo>
                  <a:pt x="668" y="57"/>
                </a:lnTo>
                <a:lnTo>
                  <a:pt x="673" y="57"/>
                </a:lnTo>
                <a:lnTo>
                  <a:pt x="678" y="57"/>
                </a:lnTo>
                <a:lnTo>
                  <a:pt x="684" y="57"/>
                </a:lnTo>
                <a:lnTo>
                  <a:pt x="690" y="57"/>
                </a:lnTo>
                <a:lnTo>
                  <a:pt x="695" y="57"/>
                </a:lnTo>
                <a:lnTo>
                  <a:pt x="704" y="57"/>
                </a:lnTo>
                <a:lnTo>
                  <a:pt x="712" y="57"/>
                </a:lnTo>
                <a:lnTo>
                  <a:pt x="715" y="57"/>
                </a:lnTo>
                <a:lnTo>
                  <a:pt x="724" y="57"/>
                </a:lnTo>
                <a:lnTo>
                  <a:pt x="732" y="57"/>
                </a:lnTo>
                <a:lnTo>
                  <a:pt x="738" y="57"/>
                </a:lnTo>
                <a:lnTo>
                  <a:pt x="744" y="57"/>
                </a:lnTo>
                <a:lnTo>
                  <a:pt x="754" y="57"/>
                </a:lnTo>
                <a:lnTo>
                  <a:pt x="764" y="57"/>
                </a:lnTo>
                <a:lnTo>
                  <a:pt x="769" y="57"/>
                </a:lnTo>
                <a:lnTo>
                  <a:pt x="777" y="57"/>
                </a:lnTo>
                <a:lnTo>
                  <a:pt x="786" y="57"/>
                </a:lnTo>
                <a:lnTo>
                  <a:pt x="791" y="35"/>
                </a:lnTo>
                <a:lnTo>
                  <a:pt x="801" y="35"/>
                </a:lnTo>
                <a:lnTo>
                  <a:pt x="822" y="35"/>
                </a:lnTo>
                <a:lnTo>
                  <a:pt x="830" y="35"/>
                </a:lnTo>
                <a:lnTo>
                  <a:pt x="835" y="35"/>
                </a:lnTo>
                <a:lnTo>
                  <a:pt x="852" y="35"/>
                </a:lnTo>
                <a:lnTo>
                  <a:pt x="858" y="35"/>
                </a:lnTo>
                <a:lnTo>
                  <a:pt x="866" y="35"/>
                </a:lnTo>
                <a:lnTo>
                  <a:pt x="871" y="35"/>
                </a:lnTo>
                <a:lnTo>
                  <a:pt x="877" y="35"/>
                </a:lnTo>
                <a:lnTo>
                  <a:pt x="882" y="35"/>
                </a:lnTo>
                <a:lnTo>
                  <a:pt x="889" y="35"/>
                </a:lnTo>
                <a:lnTo>
                  <a:pt x="900" y="35"/>
                </a:lnTo>
                <a:lnTo>
                  <a:pt x="908" y="35"/>
                </a:lnTo>
                <a:lnTo>
                  <a:pt x="912" y="35"/>
                </a:lnTo>
                <a:lnTo>
                  <a:pt x="918" y="35"/>
                </a:lnTo>
                <a:lnTo>
                  <a:pt x="929" y="35"/>
                </a:lnTo>
                <a:lnTo>
                  <a:pt x="941" y="35"/>
                </a:lnTo>
                <a:lnTo>
                  <a:pt x="945" y="35"/>
                </a:lnTo>
                <a:lnTo>
                  <a:pt x="962" y="35"/>
                </a:lnTo>
                <a:lnTo>
                  <a:pt x="975" y="35"/>
                </a:lnTo>
                <a:lnTo>
                  <a:pt x="993" y="35"/>
                </a:lnTo>
                <a:lnTo>
                  <a:pt x="993" y="0"/>
                </a:lnTo>
                <a:lnTo>
                  <a:pt x="1008" y="0"/>
                </a:lnTo>
                <a:lnTo>
                  <a:pt x="1017" y="0"/>
                </a:lnTo>
                <a:lnTo>
                  <a:pt x="1020" y="0"/>
                </a:lnTo>
                <a:lnTo>
                  <a:pt x="1028" y="0"/>
                </a:lnTo>
                <a:lnTo>
                  <a:pt x="1083" y="0"/>
                </a:lnTo>
                <a:lnTo>
                  <a:pt x="1098" y="0"/>
                </a:lnTo>
                <a:lnTo>
                  <a:pt x="1106" y="0"/>
                </a:lnTo>
                <a:lnTo>
                  <a:pt x="1119" y="0"/>
                </a:lnTo>
                <a:lnTo>
                  <a:pt x="1134" y="0"/>
                </a:lnTo>
                <a:lnTo>
                  <a:pt x="1135" y="0"/>
                </a:lnTo>
                <a:lnTo>
                  <a:pt x="1180" y="0"/>
                </a:lnTo>
                <a:lnTo>
                  <a:pt x="1197" y="0"/>
                </a:lnTo>
                <a:lnTo>
                  <a:pt x="1226" y="0"/>
                </a:lnTo>
                <a:lnTo>
                  <a:pt x="1238" y="0"/>
                </a:lnTo>
                <a:lnTo>
                  <a:pt x="1261" y="0"/>
                </a:lnTo>
                <a:lnTo>
                  <a:pt x="1269" y="0"/>
                </a:lnTo>
                <a:lnTo>
                  <a:pt x="1279" y="0"/>
                </a:lnTo>
                <a:lnTo>
                  <a:pt x="1290" y="0"/>
                </a:lnTo>
                <a:lnTo>
                  <a:pt x="1300" y="0"/>
                </a:lnTo>
                <a:lnTo>
                  <a:pt x="1315" y="0"/>
                </a:lnTo>
                <a:lnTo>
                  <a:pt x="1344" y="0"/>
                </a:lnTo>
                <a:lnTo>
                  <a:pt x="1360" y="0"/>
                </a:lnTo>
                <a:lnTo>
                  <a:pt x="1367" y="0"/>
                </a:lnTo>
                <a:lnTo>
                  <a:pt x="1385" y="0"/>
                </a:lnTo>
                <a:lnTo>
                  <a:pt x="1387" y="0"/>
                </a:lnTo>
                <a:lnTo>
                  <a:pt x="1395" y="0"/>
                </a:lnTo>
                <a:lnTo>
                  <a:pt x="1402" y="0"/>
                </a:lnTo>
                <a:lnTo>
                  <a:pt x="1407" y="0"/>
                </a:lnTo>
                <a:lnTo>
                  <a:pt x="1415" y="0"/>
                </a:lnTo>
                <a:lnTo>
                  <a:pt x="1448" y="0"/>
                </a:lnTo>
                <a:lnTo>
                  <a:pt x="1463" y="0"/>
                </a:lnTo>
                <a:lnTo>
                  <a:pt x="1481" y="0"/>
                </a:lnTo>
                <a:lnTo>
                  <a:pt x="1511" y="0"/>
                </a:lnTo>
                <a:lnTo>
                  <a:pt x="1517" y="0"/>
                </a:lnTo>
                <a:lnTo>
                  <a:pt x="1522" y="0"/>
                </a:lnTo>
                <a:lnTo>
                  <a:pt x="1535" y="0"/>
                </a:lnTo>
                <a:lnTo>
                  <a:pt x="1563" y="0"/>
                </a:lnTo>
                <a:lnTo>
                  <a:pt x="1625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39B143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7" name="Freeform 132">
            <a:extLst>
              <a:ext uri="{FF2B5EF4-FFF2-40B4-BE49-F238E27FC236}">
                <a16:creationId xmlns:a16="http://schemas.microsoft.com/office/drawing/2014/main" id="{7D317069-8A0D-AB8B-D331-68CBD7A3AD4A}"/>
              </a:ext>
            </a:extLst>
          </p:cNvPr>
          <p:cNvSpPr>
            <a:spLocks/>
          </p:cNvSpPr>
          <p:nvPr/>
        </p:nvSpPr>
        <p:spPr bwMode="auto">
          <a:xfrm>
            <a:off x="7183376" y="5077612"/>
            <a:ext cx="3133387" cy="595060"/>
          </a:xfrm>
          <a:custGeom>
            <a:avLst/>
            <a:gdLst>
              <a:gd name="T0" fmla="*/ 97 w 1660"/>
              <a:gd name="T1" fmla="*/ 316 h 319"/>
              <a:gd name="T2" fmla="*/ 123 w 1660"/>
              <a:gd name="T3" fmla="*/ 315 h 319"/>
              <a:gd name="T4" fmla="*/ 142 w 1660"/>
              <a:gd name="T5" fmla="*/ 307 h 319"/>
              <a:gd name="T6" fmla="*/ 166 w 1660"/>
              <a:gd name="T7" fmla="*/ 302 h 319"/>
              <a:gd name="T8" fmla="*/ 190 w 1660"/>
              <a:gd name="T9" fmla="*/ 298 h 319"/>
              <a:gd name="T10" fmla="*/ 220 w 1660"/>
              <a:gd name="T11" fmla="*/ 295 h 319"/>
              <a:gd name="T12" fmla="*/ 251 w 1660"/>
              <a:gd name="T13" fmla="*/ 289 h 319"/>
              <a:gd name="T14" fmla="*/ 275 w 1660"/>
              <a:gd name="T15" fmla="*/ 285 h 319"/>
              <a:gd name="T16" fmla="*/ 305 w 1660"/>
              <a:gd name="T17" fmla="*/ 281 h 319"/>
              <a:gd name="T18" fmla="*/ 328 w 1660"/>
              <a:gd name="T19" fmla="*/ 277 h 319"/>
              <a:gd name="T20" fmla="*/ 355 w 1660"/>
              <a:gd name="T21" fmla="*/ 270 h 319"/>
              <a:gd name="T22" fmla="*/ 377 w 1660"/>
              <a:gd name="T23" fmla="*/ 262 h 319"/>
              <a:gd name="T24" fmla="*/ 401 w 1660"/>
              <a:gd name="T25" fmla="*/ 259 h 319"/>
              <a:gd name="T26" fmla="*/ 425 w 1660"/>
              <a:gd name="T27" fmla="*/ 255 h 319"/>
              <a:gd name="T28" fmla="*/ 449 w 1660"/>
              <a:gd name="T29" fmla="*/ 248 h 319"/>
              <a:gd name="T30" fmla="*/ 481 w 1660"/>
              <a:gd name="T31" fmla="*/ 246 h 319"/>
              <a:gd name="T32" fmla="*/ 506 w 1660"/>
              <a:gd name="T33" fmla="*/ 243 h 319"/>
              <a:gd name="T34" fmla="*/ 539 w 1660"/>
              <a:gd name="T35" fmla="*/ 239 h 319"/>
              <a:gd name="T36" fmla="*/ 563 w 1660"/>
              <a:gd name="T37" fmla="*/ 232 h 319"/>
              <a:gd name="T38" fmla="*/ 585 w 1660"/>
              <a:gd name="T39" fmla="*/ 225 h 319"/>
              <a:gd name="T40" fmla="*/ 612 w 1660"/>
              <a:gd name="T41" fmla="*/ 221 h 319"/>
              <a:gd name="T42" fmla="*/ 635 w 1660"/>
              <a:gd name="T43" fmla="*/ 218 h 319"/>
              <a:gd name="T44" fmla="*/ 660 w 1660"/>
              <a:gd name="T45" fmla="*/ 211 h 319"/>
              <a:gd name="T46" fmla="*/ 684 w 1660"/>
              <a:gd name="T47" fmla="*/ 207 h 319"/>
              <a:gd name="T48" fmla="*/ 711 w 1660"/>
              <a:gd name="T49" fmla="*/ 199 h 319"/>
              <a:gd name="T50" fmla="*/ 737 w 1660"/>
              <a:gd name="T51" fmla="*/ 196 h 319"/>
              <a:gd name="T52" fmla="*/ 762 w 1660"/>
              <a:gd name="T53" fmla="*/ 190 h 319"/>
              <a:gd name="T54" fmla="*/ 786 w 1660"/>
              <a:gd name="T55" fmla="*/ 187 h 319"/>
              <a:gd name="T56" fmla="*/ 812 w 1660"/>
              <a:gd name="T57" fmla="*/ 183 h 319"/>
              <a:gd name="T58" fmla="*/ 834 w 1660"/>
              <a:gd name="T59" fmla="*/ 177 h 319"/>
              <a:gd name="T60" fmla="*/ 864 w 1660"/>
              <a:gd name="T61" fmla="*/ 172 h 319"/>
              <a:gd name="T62" fmla="*/ 887 w 1660"/>
              <a:gd name="T63" fmla="*/ 164 h 319"/>
              <a:gd name="T64" fmla="*/ 907 w 1660"/>
              <a:gd name="T65" fmla="*/ 158 h 319"/>
              <a:gd name="T66" fmla="*/ 936 w 1660"/>
              <a:gd name="T67" fmla="*/ 157 h 319"/>
              <a:gd name="T68" fmla="*/ 961 w 1660"/>
              <a:gd name="T69" fmla="*/ 153 h 319"/>
              <a:gd name="T70" fmla="*/ 985 w 1660"/>
              <a:gd name="T71" fmla="*/ 147 h 319"/>
              <a:gd name="T72" fmla="*/ 1014 w 1660"/>
              <a:gd name="T73" fmla="*/ 145 h 319"/>
              <a:gd name="T74" fmla="*/ 1038 w 1660"/>
              <a:gd name="T75" fmla="*/ 138 h 319"/>
              <a:gd name="T76" fmla="*/ 1063 w 1660"/>
              <a:gd name="T77" fmla="*/ 132 h 319"/>
              <a:gd name="T78" fmla="*/ 1087 w 1660"/>
              <a:gd name="T79" fmla="*/ 127 h 319"/>
              <a:gd name="T80" fmla="*/ 1117 w 1660"/>
              <a:gd name="T81" fmla="*/ 127 h 319"/>
              <a:gd name="T82" fmla="*/ 1141 w 1660"/>
              <a:gd name="T83" fmla="*/ 120 h 319"/>
              <a:gd name="T84" fmla="*/ 1172 w 1660"/>
              <a:gd name="T85" fmla="*/ 120 h 319"/>
              <a:gd name="T86" fmla="*/ 1202 w 1660"/>
              <a:gd name="T87" fmla="*/ 117 h 319"/>
              <a:gd name="T88" fmla="*/ 1221 w 1660"/>
              <a:gd name="T89" fmla="*/ 109 h 319"/>
              <a:gd name="T90" fmla="*/ 1249 w 1660"/>
              <a:gd name="T91" fmla="*/ 106 h 319"/>
              <a:gd name="T92" fmla="*/ 1274 w 1660"/>
              <a:gd name="T93" fmla="*/ 103 h 319"/>
              <a:gd name="T94" fmla="*/ 1298 w 1660"/>
              <a:gd name="T95" fmla="*/ 93 h 319"/>
              <a:gd name="T96" fmla="*/ 1322 w 1660"/>
              <a:gd name="T97" fmla="*/ 90 h 319"/>
              <a:gd name="T98" fmla="*/ 1340 w 1660"/>
              <a:gd name="T99" fmla="*/ 79 h 319"/>
              <a:gd name="T100" fmla="*/ 1370 w 1660"/>
              <a:gd name="T101" fmla="*/ 75 h 319"/>
              <a:gd name="T102" fmla="*/ 1399 w 1660"/>
              <a:gd name="T103" fmla="*/ 75 h 319"/>
              <a:gd name="T104" fmla="*/ 1423 w 1660"/>
              <a:gd name="T105" fmla="*/ 71 h 319"/>
              <a:gd name="T106" fmla="*/ 1453 w 1660"/>
              <a:gd name="T107" fmla="*/ 71 h 319"/>
              <a:gd name="T108" fmla="*/ 1478 w 1660"/>
              <a:gd name="T109" fmla="*/ 66 h 319"/>
              <a:gd name="T110" fmla="*/ 1497 w 1660"/>
              <a:gd name="T111" fmla="*/ 55 h 319"/>
              <a:gd name="T112" fmla="*/ 1526 w 1660"/>
              <a:gd name="T113" fmla="*/ 55 h 319"/>
              <a:gd name="T114" fmla="*/ 1547 w 1660"/>
              <a:gd name="T115" fmla="*/ 40 h 319"/>
              <a:gd name="T116" fmla="*/ 1562 w 1660"/>
              <a:gd name="T117" fmla="*/ 24 h 319"/>
              <a:gd name="T118" fmla="*/ 1592 w 1660"/>
              <a:gd name="T119" fmla="*/ 24 h 319"/>
              <a:gd name="T120" fmla="*/ 1623 w 1660"/>
              <a:gd name="T121" fmla="*/ 24 h 319"/>
              <a:gd name="T122" fmla="*/ 1642 w 1660"/>
              <a:gd name="T123" fmla="*/ 0 h 3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660" h="319">
                <a:moveTo>
                  <a:pt x="0" y="319"/>
                </a:moveTo>
                <a:lnTo>
                  <a:pt x="79" y="319"/>
                </a:lnTo>
                <a:lnTo>
                  <a:pt x="84" y="317"/>
                </a:lnTo>
                <a:lnTo>
                  <a:pt x="90" y="316"/>
                </a:lnTo>
                <a:lnTo>
                  <a:pt x="97" y="316"/>
                </a:lnTo>
                <a:lnTo>
                  <a:pt x="101" y="316"/>
                </a:lnTo>
                <a:lnTo>
                  <a:pt x="111" y="316"/>
                </a:lnTo>
                <a:lnTo>
                  <a:pt x="111" y="315"/>
                </a:lnTo>
                <a:lnTo>
                  <a:pt x="116" y="315"/>
                </a:lnTo>
                <a:lnTo>
                  <a:pt x="123" y="315"/>
                </a:lnTo>
                <a:lnTo>
                  <a:pt x="124" y="314"/>
                </a:lnTo>
                <a:lnTo>
                  <a:pt x="130" y="312"/>
                </a:lnTo>
                <a:lnTo>
                  <a:pt x="132" y="310"/>
                </a:lnTo>
                <a:lnTo>
                  <a:pt x="137" y="309"/>
                </a:lnTo>
                <a:lnTo>
                  <a:pt x="142" y="307"/>
                </a:lnTo>
                <a:lnTo>
                  <a:pt x="148" y="305"/>
                </a:lnTo>
                <a:lnTo>
                  <a:pt x="149" y="304"/>
                </a:lnTo>
                <a:lnTo>
                  <a:pt x="154" y="304"/>
                </a:lnTo>
                <a:lnTo>
                  <a:pt x="162" y="303"/>
                </a:lnTo>
                <a:lnTo>
                  <a:pt x="166" y="302"/>
                </a:lnTo>
                <a:lnTo>
                  <a:pt x="173" y="302"/>
                </a:lnTo>
                <a:lnTo>
                  <a:pt x="179" y="302"/>
                </a:lnTo>
                <a:lnTo>
                  <a:pt x="185" y="299"/>
                </a:lnTo>
                <a:lnTo>
                  <a:pt x="190" y="299"/>
                </a:lnTo>
                <a:lnTo>
                  <a:pt x="190" y="298"/>
                </a:lnTo>
                <a:lnTo>
                  <a:pt x="197" y="296"/>
                </a:lnTo>
                <a:lnTo>
                  <a:pt x="206" y="295"/>
                </a:lnTo>
                <a:lnTo>
                  <a:pt x="211" y="295"/>
                </a:lnTo>
                <a:lnTo>
                  <a:pt x="218" y="295"/>
                </a:lnTo>
                <a:lnTo>
                  <a:pt x="220" y="295"/>
                </a:lnTo>
                <a:lnTo>
                  <a:pt x="228" y="293"/>
                </a:lnTo>
                <a:lnTo>
                  <a:pt x="232" y="293"/>
                </a:lnTo>
                <a:lnTo>
                  <a:pt x="244" y="293"/>
                </a:lnTo>
                <a:lnTo>
                  <a:pt x="245" y="291"/>
                </a:lnTo>
                <a:lnTo>
                  <a:pt x="251" y="289"/>
                </a:lnTo>
                <a:lnTo>
                  <a:pt x="256" y="288"/>
                </a:lnTo>
                <a:lnTo>
                  <a:pt x="263" y="288"/>
                </a:lnTo>
                <a:lnTo>
                  <a:pt x="270" y="287"/>
                </a:lnTo>
                <a:lnTo>
                  <a:pt x="272" y="285"/>
                </a:lnTo>
                <a:lnTo>
                  <a:pt x="275" y="285"/>
                </a:lnTo>
                <a:lnTo>
                  <a:pt x="281" y="285"/>
                </a:lnTo>
                <a:lnTo>
                  <a:pt x="286" y="285"/>
                </a:lnTo>
                <a:lnTo>
                  <a:pt x="292" y="285"/>
                </a:lnTo>
                <a:lnTo>
                  <a:pt x="299" y="283"/>
                </a:lnTo>
                <a:lnTo>
                  <a:pt x="305" y="281"/>
                </a:lnTo>
                <a:lnTo>
                  <a:pt x="313" y="281"/>
                </a:lnTo>
                <a:lnTo>
                  <a:pt x="313" y="280"/>
                </a:lnTo>
                <a:lnTo>
                  <a:pt x="319" y="278"/>
                </a:lnTo>
                <a:lnTo>
                  <a:pt x="322" y="278"/>
                </a:lnTo>
                <a:lnTo>
                  <a:pt x="328" y="277"/>
                </a:lnTo>
                <a:lnTo>
                  <a:pt x="335" y="274"/>
                </a:lnTo>
                <a:lnTo>
                  <a:pt x="335" y="273"/>
                </a:lnTo>
                <a:lnTo>
                  <a:pt x="342" y="273"/>
                </a:lnTo>
                <a:lnTo>
                  <a:pt x="346" y="273"/>
                </a:lnTo>
                <a:lnTo>
                  <a:pt x="355" y="270"/>
                </a:lnTo>
                <a:lnTo>
                  <a:pt x="357" y="266"/>
                </a:lnTo>
                <a:lnTo>
                  <a:pt x="361" y="266"/>
                </a:lnTo>
                <a:lnTo>
                  <a:pt x="367" y="266"/>
                </a:lnTo>
                <a:lnTo>
                  <a:pt x="372" y="264"/>
                </a:lnTo>
                <a:lnTo>
                  <a:pt x="377" y="262"/>
                </a:lnTo>
                <a:lnTo>
                  <a:pt x="384" y="262"/>
                </a:lnTo>
                <a:lnTo>
                  <a:pt x="384" y="261"/>
                </a:lnTo>
                <a:lnTo>
                  <a:pt x="391" y="260"/>
                </a:lnTo>
                <a:lnTo>
                  <a:pt x="395" y="259"/>
                </a:lnTo>
                <a:lnTo>
                  <a:pt x="401" y="259"/>
                </a:lnTo>
                <a:lnTo>
                  <a:pt x="408" y="259"/>
                </a:lnTo>
                <a:lnTo>
                  <a:pt x="413" y="258"/>
                </a:lnTo>
                <a:lnTo>
                  <a:pt x="419" y="256"/>
                </a:lnTo>
                <a:lnTo>
                  <a:pt x="419" y="255"/>
                </a:lnTo>
                <a:lnTo>
                  <a:pt x="425" y="255"/>
                </a:lnTo>
                <a:lnTo>
                  <a:pt x="431" y="254"/>
                </a:lnTo>
                <a:lnTo>
                  <a:pt x="437" y="252"/>
                </a:lnTo>
                <a:lnTo>
                  <a:pt x="440" y="249"/>
                </a:lnTo>
                <a:lnTo>
                  <a:pt x="444" y="249"/>
                </a:lnTo>
                <a:lnTo>
                  <a:pt x="449" y="248"/>
                </a:lnTo>
                <a:lnTo>
                  <a:pt x="455" y="247"/>
                </a:lnTo>
                <a:lnTo>
                  <a:pt x="461" y="246"/>
                </a:lnTo>
                <a:lnTo>
                  <a:pt x="467" y="246"/>
                </a:lnTo>
                <a:lnTo>
                  <a:pt x="473" y="246"/>
                </a:lnTo>
                <a:lnTo>
                  <a:pt x="481" y="246"/>
                </a:lnTo>
                <a:lnTo>
                  <a:pt x="484" y="246"/>
                </a:lnTo>
                <a:lnTo>
                  <a:pt x="492" y="246"/>
                </a:lnTo>
                <a:lnTo>
                  <a:pt x="497" y="244"/>
                </a:lnTo>
                <a:lnTo>
                  <a:pt x="500" y="243"/>
                </a:lnTo>
                <a:lnTo>
                  <a:pt x="506" y="243"/>
                </a:lnTo>
                <a:lnTo>
                  <a:pt x="510" y="243"/>
                </a:lnTo>
                <a:lnTo>
                  <a:pt x="522" y="242"/>
                </a:lnTo>
                <a:lnTo>
                  <a:pt x="528" y="241"/>
                </a:lnTo>
                <a:lnTo>
                  <a:pt x="534" y="241"/>
                </a:lnTo>
                <a:lnTo>
                  <a:pt x="539" y="239"/>
                </a:lnTo>
                <a:lnTo>
                  <a:pt x="539" y="237"/>
                </a:lnTo>
                <a:lnTo>
                  <a:pt x="546" y="237"/>
                </a:lnTo>
                <a:lnTo>
                  <a:pt x="552" y="236"/>
                </a:lnTo>
                <a:lnTo>
                  <a:pt x="557" y="235"/>
                </a:lnTo>
                <a:lnTo>
                  <a:pt x="563" y="232"/>
                </a:lnTo>
                <a:lnTo>
                  <a:pt x="569" y="232"/>
                </a:lnTo>
                <a:lnTo>
                  <a:pt x="573" y="231"/>
                </a:lnTo>
                <a:lnTo>
                  <a:pt x="575" y="229"/>
                </a:lnTo>
                <a:lnTo>
                  <a:pt x="582" y="227"/>
                </a:lnTo>
                <a:lnTo>
                  <a:pt x="585" y="225"/>
                </a:lnTo>
                <a:lnTo>
                  <a:pt x="588" y="223"/>
                </a:lnTo>
                <a:lnTo>
                  <a:pt x="593" y="223"/>
                </a:lnTo>
                <a:lnTo>
                  <a:pt x="599" y="222"/>
                </a:lnTo>
                <a:lnTo>
                  <a:pt x="607" y="221"/>
                </a:lnTo>
                <a:lnTo>
                  <a:pt x="612" y="221"/>
                </a:lnTo>
                <a:lnTo>
                  <a:pt x="618" y="221"/>
                </a:lnTo>
                <a:lnTo>
                  <a:pt x="625" y="221"/>
                </a:lnTo>
                <a:lnTo>
                  <a:pt x="628" y="218"/>
                </a:lnTo>
                <a:lnTo>
                  <a:pt x="629" y="218"/>
                </a:lnTo>
                <a:lnTo>
                  <a:pt x="635" y="218"/>
                </a:lnTo>
                <a:lnTo>
                  <a:pt x="642" y="216"/>
                </a:lnTo>
                <a:lnTo>
                  <a:pt x="644" y="213"/>
                </a:lnTo>
                <a:lnTo>
                  <a:pt x="648" y="213"/>
                </a:lnTo>
                <a:lnTo>
                  <a:pt x="654" y="213"/>
                </a:lnTo>
                <a:lnTo>
                  <a:pt x="660" y="211"/>
                </a:lnTo>
                <a:lnTo>
                  <a:pt x="668" y="209"/>
                </a:lnTo>
                <a:lnTo>
                  <a:pt x="672" y="208"/>
                </a:lnTo>
                <a:lnTo>
                  <a:pt x="673" y="207"/>
                </a:lnTo>
                <a:lnTo>
                  <a:pt x="678" y="207"/>
                </a:lnTo>
                <a:lnTo>
                  <a:pt x="684" y="207"/>
                </a:lnTo>
                <a:lnTo>
                  <a:pt x="690" y="206"/>
                </a:lnTo>
                <a:lnTo>
                  <a:pt x="695" y="204"/>
                </a:lnTo>
                <a:lnTo>
                  <a:pt x="701" y="203"/>
                </a:lnTo>
                <a:lnTo>
                  <a:pt x="709" y="202"/>
                </a:lnTo>
                <a:lnTo>
                  <a:pt x="711" y="199"/>
                </a:lnTo>
                <a:lnTo>
                  <a:pt x="715" y="199"/>
                </a:lnTo>
                <a:lnTo>
                  <a:pt x="721" y="199"/>
                </a:lnTo>
                <a:lnTo>
                  <a:pt x="726" y="197"/>
                </a:lnTo>
                <a:lnTo>
                  <a:pt x="731" y="196"/>
                </a:lnTo>
                <a:lnTo>
                  <a:pt x="737" y="196"/>
                </a:lnTo>
                <a:lnTo>
                  <a:pt x="742" y="194"/>
                </a:lnTo>
                <a:lnTo>
                  <a:pt x="744" y="194"/>
                </a:lnTo>
                <a:lnTo>
                  <a:pt x="750" y="190"/>
                </a:lnTo>
                <a:lnTo>
                  <a:pt x="756" y="190"/>
                </a:lnTo>
                <a:lnTo>
                  <a:pt x="762" y="190"/>
                </a:lnTo>
                <a:lnTo>
                  <a:pt x="764" y="189"/>
                </a:lnTo>
                <a:lnTo>
                  <a:pt x="768" y="187"/>
                </a:lnTo>
                <a:lnTo>
                  <a:pt x="774" y="187"/>
                </a:lnTo>
                <a:lnTo>
                  <a:pt x="780" y="187"/>
                </a:lnTo>
                <a:lnTo>
                  <a:pt x="786" y="187"/>
                </a:lnTo>
                <a:lnTo>
                  <a:pt x="792" y="187"/>
                </a:lnTo>
                <a:lnTo>
                  <a:pt x="802" y="186"/>
                </a:lnTo>
                <a:lnTo>
                  <a:pt x="804" y="186"/>
                </a:lnTo>
                <a:lnTo>
                  <a:pt x="810" y="184"/>
                </a:lnTo>
                <a:lnTo>
                  <a:pt x="812" y="183"/>
                </a:lnTo>
                <a:lnTo>
                  <a:pt x="816" y="181"/>
                </a:lnTo>
                <a:lnTo>
                  <a:pt x="823" y="178"/>
                </a:lnTo>
                <a:lnTo>
                  <a:pt x="828" y="178"/>
                </a:lnTo>
                <a:lnTo>
                  <a:pt x="833" y="177"/>
                </a:lnTo>
                <a:lnTo>
                  <a:pt x="834" y="177"/>
                </a:lnTo>
                <a:lnTo>
                  <a:pt x="842" y="177"/>
                </a:lnTo>
                <a:lnTo>
                  <a:pt x="847" y="173"/>
                </a:lnTo>
                <a:lnTo>
                  <a:pt x="852" y="172"/>
                </a:lnTo>
                <a:lnTo>
                  <a:pt x="858" y="172"/>
                </a:lnTo>
                <a:lnTo>
                  <a:pt x="864" y="172"/>
                </a:lnTo>
                <a:lnTo>
                  <a:pt x="870" y="172"/>
                </a:lnTo>
                <a:lnTo>
                  <a:pt x="870" y="170"/>
                </a:lnTo>
                <a:lnTo>
                  <a:pt x="876" y="167"/>
                </a:lnTo>
                <a:lnTo>
                  <a:pt x="882" y="165"/>
                </a:lnTo>
                <a:lnTo>
                  <a:pt x="887" y="164"/>
                </a:lnTo>
                <a:lnTo>
                  <a:pt x="889" y="164"/>
                </a:lnTo>
                <a:lnTo>
                  <a:pt x="895" y="162"/>
                </a:lnTo>
                <a:lnTo>
                  <a:pt x="900" y="160"/>
                </a:lnTo>
                <a:lnTo>
                  <a:pt x="900" y="158"/>
                </a:lnTo>
                <a:lnTo>
                  <a:pt x="907" y="158"/>
                </a:lnTo>
                <a:lnTo>
                  <a:pt x="912" y="158"/>
                </a:lnTo>
                <a:lnTo>
                  <a:pt x="918" y="157"/>
                </a:lnTo>
                <a:lnTo>
                  <a:pt x="924" y="157"/>
                </a:lnTo>
                <a:lnTo>
                  <a:pt x="930" y="157"/>
                </a:lnTo>
                <a:lnTo>
                  <a:pt x="936" y="157"/>
                </a:lnTo>
                <a:lnTo>
                  <a:pt x="944" y="157"/>
                </a:lnTo>
                <a:lnTo>
                  <a:pt x="949" y="155"/>
                </a:lnTo>
                <a:lnTo>
                  <a:pt x="949" y="153"/>
                </a:lnTo>
                <a:lnTo>
                  <a:pt x="954" y="153"/>
                </a:lnTo>
                <a:lnTo>
                  <a:pt x="961" y="153"/>
                </a:lnTo>
                <a:lnTo>
                  <a:pt x="967" y="153"/>
                </a:lnTo>
                <a:lnTo>
                  <a:pt x="972" y="153"/>
                </a:lnTo>
                <a:lnTo>
                  <a:pt x="978" y="149"/>
                </a:lnTo>
                <a:lnTo>
                  <a:pt x="979" y="147"/>
                </a:lnTo>
                <a:lnTo>
                  <a:pt x="985" y="147"/>
                </a:lnTo>
                <a:lnTo>
                  <a:pt x="991" y="147"/>
                </a:lnTo>
                <a:lnTo>
                  <a:pt x="997" y="145"/>
                </a:lnTo>
                <a:lnTo>
                  <a:pt x="1003" y="145"/>
                </a:lnTo>
                <a:lnTo>
                  <a:pt x="1009" y="145"/>
                </a:lnTo>
                <a:lnTo>
                  <a:pt x="1014" y="145"/>
                </a:lnTo>
                <a:lnTo>
                  <a:pt x="1020" y="145"/>
                </a:lnTo>
                <a:lnTo>
                  <a:pt x="1025" y="141"/>
                </a:lnTo>
                <a:lnTo>
                  <a:pt x="1027" y="141"/>
                </a:lnTo>
                <a:lnTo>
                  <a:pt x="1033" y="141"/>
                </a:lnTo>
                <a:lnTo>
                  <a:pt x="1038" y="138"/>
                </a:lnTo>
                <a:lnTo>
                  <a:pt x="1044" y="138"/>
                </a:lnTo>
                <a:lnTo>
                  <a:pt x="1050" y="136"/>
                </a:lnTo>
                <a:lnTo>
                  <a:pt x="1051" y="134"/>
                </a:lnTo>
                <a:lnTo>
                  <a:pt x="1057" y="134"/>
                </a:lnTo>
                <a:lnTo>
                  <a:pt x="1063" y="132"/>
                </a:lnTo>
                <a:lnTo>
                  <a:pt x="1069" y="129"/>
                </a:lnTo>
                <a:lnTo>
                  <a:pt x="1074" y="129"/>
                </a:lnTo>
                <a:lnTo>
                  <a:pt x="1083" y="129"/>
                </a:lnTo>
                <a:lnTo>
                  <a:pt x="1087" y="129"/>
                </a:lnTo>
                <a:lnTo>
                  <a:pt x="1087" y="127"/>
                </a:lnTo>
                <a:lnTo>
                  <a:pt x="1093" y="127"/>
                </a:lnTo>
                <a:lnTo>
                  <a:pt x="1099" y="127"/>
                </a:lnTo>
                <a:lnTo>
                  <a:pt x="1105" y="127"/>
                </a:lnTo>
                <a:lnTo>
                  <a:pt x="1111" y="127"/>
                </a:lnTo>
                <a:lnTo>
                  <a:pt x="1117" y="127"/>
                </a:lnTo>
                <a:lnTo>
                  <a:pt x="1119" y="122"/>
                </a:lnTo>
                <a:lnTo>
                  <a:pt x="1124" y="120"/>
                </a:lnTo>
                <a:lnTo>
                  <a:pt x="1129" y="120"/>
                </a:lnTo>
                <a:lnTo>
                  <a:pt x="1136" y="120"/>
                </a:lnTo>
                <a:lnTo>
                  <a:pt x="1141" y="120"/>
                </a:lnTo>
                <a:lnTo>
                  <a:pt x="1147" y="120"/>
                </a:lnTo>
                <a:lnTo>
                  <a:pt x="1153" y="120"/>
                </a:lnTo>
                <a:lnTo>
                  <a:pt x="1161" y="120"/>
                </a:lnTo>
                <a:lnTo>
                  <a:pt x="1167" y="120"/>
                </a:lnTo>
                <a:lnTo>
                  <a:pt x="1172" y="120"/>
                </a:lnTo>
                <a:lnTo>
                  <a:pt x="1177" y="120"/>
                </a:lnTo>
                <a:lnTo>
                  <a:pt x="1183" y="117"/>
                </a:lnTo>
                <a:lnTo>
                  <a:pt x="1190" y="117"/>
                </a:lnTo>
                <a:lnTo>
                  <a:pt x="1195" y="117"/>
                </a:lnTo>
                <a:lnTo>
                  <a:pt x="1202" y="117"/>
                </a:lnTo>
                <a:lnTo>
                  <a:pt x="1207" y="117"/>
                </a:lnTo>
                <a:lnTo>
                  <a:pt x="1210" y="114"/>
                </a:lnTo>
                <a:lnTo>
                  <a:pt x="1213" y="114"/>
                </a:lnTo>
                <a:lnTo>
                  <a:pt x="1216" y="109"/>
                </a:lnTo>
                <a:lnTo>
                  <a:pt x="1221" y="109"/>
                </a:lnTo>
                <a:lnTo>
                  <a:pt x="1225" y="109"/>
                </a:lnTo>
                <a:lnTo>
                  <a:pt x="1231" y="109"/>
                </a:lnTo>
                <a:lnTo>
                  <a:pt x="1237" y="106"/>
                </a:lnTo>
                <a:lnTo>
                  <a:pt x="1244" y="106"/>
                </a:lnTo>
                <a:lnTo>
                  <a:pt x="1249" y="106"/>
                </a:lnTo>
                <a:lnTo>
                  <a:pt x="1256" y="106"/>
                </a:lnTo>
                <a:lnTo>
                  <a:pt x="1259" y="103"/>
                </a:lnTo>
                <a:lnTo>
                  <a:pt x="1261" y="103"/>
                </a:lnTo>
                <a:lnTo>
                  <a:pt x="1267" y="103"/>
                </a:lnTo>
                <a:lnTo>
                  <a:pt x="1274" y="103"/>
                </a:lnTo>
                <a:lnTo>
                  <a:pt x="1279" y="100"/>
                </a:lnTo>
                <a:lnTo>
                  <a:pt x="1287" y="100"/>
                </a:lnTo>
                <a:lnTo>
                  <a:pt x="1290" y="97"/>
                </a:lnTo>
                <a:lnTo>
                  <a:pt x="1293" y="97"/>
                </a:lnTo>
                <a:lnTo>
                  <a:pt x="1298" y="93"/>
                </a:lnTo>
                <a:lnTo>
                  <a:pt x="1305" y="93"/>
                </a:lnTo>
                <a:lnTo>
                  <a:pt x="1309" y="93"/>
                </a:lnTo>
                <a:lnTo>
                  <a:pt x="1315" y="93"/>
                </a:lnTo>
                <a:lnTo>
                  <a:pt x="1321" y="93"/>
                </a:lnTo>
                <a:lnTo>
                  <a:pt x="1322" y="90"/>
                </a:lnTo>
                <a:lnTo>
                  <a:pt x="1323" y="86"/>
                </a:lnTo>
                <a:lnTo>
                  <a:pt x="1327" y="83"/>
                </a:lnTo>
                <a:lnTo>
                  <a:pt x="1334" y="83"/>
                </a:lnTo>
                <a:lnTo>
                  <a:pt x="1334" y="79"/>
                </a:lnTo>
                <a:lnTo>
                  <a:pt x="1340" y="79"/>
                </a:lnTo>
                <a:lnTo>
                  <a:pt x="1346" y="79"/>
                </a:lnTo>
                <a:lnTo>
                  <a:pt x="1351" y="79"/>
                </a:lnTo>
                <a:lnTo>
                  <a:pt x="1357" y="79"/>
                </a:lnTo>
                <a:lnTo>
                  <a:pt x="1363" y="79"/>
                </a:lnTo>
                <a:lnTo>
                  <a:pt x="1370" y="75"/>
                </a:lnTo>
                <a:lnTo>
                  <a:pt x="1376" y="75"/>
                </a:lnTo>
                <a:lnTo>
                  <a:pt x="1382" y="75"/>
                </a:lnTo>
                <a:lnTo>
                  <a:pt x="1389" y="75"/>
                </a:lnTo>
                <a:lnTo>
                  <a:pt x="1395" y="75"/>
                </a:lnTo>
                <a:lnTo>
                  <a:pt x="1399" y="75"/>
                </a:lnTo>
                <a:lnTo>
                  <a:pt x="1406" y="75"/>
                </a:lnTo>
                <a:lnTo>
                  <a:pt x="1412" y="75"/>
                </a:lnTo>
                <a:lnTo>
                  <a:pt x="1419" y="75"/>
                </a:lnTo>
                <a:lnTo>
                  <a:pt x="1422" y="71"/>
                </a:lnTo>
                <a:lnTo>
                  <a:pt x="1423" y="71"/>
                </a:lnTo>
                <a:lnTo>
                  <a:pt x="1429" y="71"/>
                </a:lnTo>
                <a:lnTo>
                  <a:pt x="1437" y="71"/>
                </a:lnTo>
                <a:lnTo>
                  <a:pt x="1442" y="71"/>
                </a:lnTo>
                <a:lnTo>
                  <a:pt x="1448" y="71"/>
                </a:lnTo>
                <a:lnTo>
                  <a:pt x="1453" y="71"/>
                </a:lnTo>
                <a:lnTo>
                  <a:pt x="1456" y="66"/>
                </a:lnTo>
                <a:lnTo>
                  <a:pt x="1460" y="66"/>
                </a:lnTo>
                <a:lnTo>
                  <a:pt x="1467" y="66"/>
                </a:lnTo>
                <a:lnTo>
                  <a:pt x="1472" y="66"/>
                </a:lnTo>
                <a:lnTo>
                  <a:pt x="1478" y="66"/>
                </a:lnTo>
                <a:lnTo>
                  <a:pt x="1484" y="66"/>
                </a:lnTo>
                <a:lnTo>
                  <a:pt x="1490" y="66"/>
                </a:lnTo>
                <a:lnTo>
                  <a:pt x="1492" y="61"/>
                </a:lnTo>
                <a:lnTo>
                  <a:pt x="1496" y="61"/>
                </a:lnTo>
                <a:lnTo>
                  <a:pt x="1497" y="55"/>
                </a:lnTo>
                <a:lnTo>
                  <a:pt x="1502" y="55"/>
                </a:lnTo>
                <a:lnTo>
                  <a:pt x="1508" y="55"/>
                </a:lnTo>
                <a:lnTo>
                  <a:pt x="1516" y="55"/>
                </a:lnTo>
                <a:lnTo>
                  <a:pt x="1520" y="55"/>
                </a:lnTo>
                <a:lnTo>
                  <a:pt x="1526" y="55"/>
                </a:lnTo>
                <a:lnTo>
                  <a:pt x="1528" y="48"/>
                </a:lnTo>
                <a:lnTo>
                  <a:pt x="1532" y="48"/>
                </a:lnTo>
                <a:lnTo>
                  <a:pt x="1538" y="48"/>
                </a:lnTo>
                <a:lnTo>
                  <a:pt x="1544" y="48"/>
                </a:lnTo>
                <a:lnTo>
                  <a:pt x="1547" y="40"/>
                </a:lnTo>
                <a:lnTo>
                  <a:pt x="1549" y="33"/>
                </a:lnTo>
                <a:lnTo>
                  <a:pt x="1550" y="33"/>
                </a:lnTo>
                <a:lnTo>
                  <a:pt x="1557" y="33"/>
                </a:lnTo>
                <a:lnTo>
                  <a:pt x="1557" y="24"/>
                </a:lnTo>
                <a:lnTo>
                  <a:pt x="1562" y="24"/>
                </a:lnTo>
                <a:lnTo>
                  <a:pt x="1570" y="24"/>
                </a:lnTo>
                <a:lnTo>
                  <a:pt x="1578" y="24"/>
                </a:lnTo>
                <a:lnTo>
                  <a:pt x="1580" y="24"/>
                </a:lnTo>
                <a:lnTo>
                  <a:pt x="1589" y="24"/>
                </a:lnTo>
                <a:lnTo>
                  <a:pt x="1592" y="24"/>
                </a:lnTo>
                <a:lnTo>
                  <a:pt x="1598" y="24"/>
                </a:lnTo>
                <a:lnTo>
                  <a:pt x="1604" y="24"/>
                </a:lnTo>
                <a:lnTo>
                  <a:pt x="1613" y="24"/>
                </a:lnTo>
                <a:lnTo>
                  <a:pt x="1616" y="24"/>
                </a:lnTo>
                <a:lnTo>
                  <a:pt x="1623" y="24"/>
                </a:lnTo>
                <a:lnTo>
                  <a:pt x="1625" y="13"/>
                </a:lnTo>
                <a:lnTo>
                  <a:pt x="1628" y="13"/>
                </a:lnTo>
                <a:lnTo>
                  <a:pt x="1634" y="13"/>
                </a:lnTo>
                <a:lnTo>
                  <a:pt x="1640" y="13"/>
                </a:lnTo>
                <a:lnTo>
                  <a:pt x="1642" y="0"/>
                </a:lnTo>
                <a:lnTo>
                  <a:pt x="1646" y="0"/>
                </a:lnTo>
                <a:lnTo>
                  <a:pt x="1654" y="0"/>
                </a:lnTo>
                <a:lnTo>
                  <a:pt x="1660" y="0"/>
                </a:lnTo>
              </a:path>
            </a:pathLst>
          </a:custGeom>
          <a:noFill/>
          <a:ln w="28575" cap="flat">
            <a:solidFill>
              <a:srgbClr val="406FD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E7B87AA-B34C-1D52-B4AC-30429977A523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54D2545-A726-4B52-D894-0E5B50816209}"/>
              </a:ext>
            </a:extLst>
          </p:cNvPr>
          <p:cNvSpPr txBox="1"/>
          <p:nvPr/>
        </p:nvSpPr>
        <p:spPr>
          <a:xfrm>
            <a:off x="886249" y="38268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C8A3F86-CA16-A66F-59B7-BF3302578C49}"/>
              </a:ext>
            </a:extLst>
          </p:cNvPr>
          <p:cNvSpPr txBox="1"/>
          <p:nvPr/>
        </p:nvSpPr>
        <p:spPr>
          <a:xfrm>
            <a:off x="6010058" y="382681"/>
            <a:ext cx="38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60F6D29-02CB-5180-F190-244FBAB597D2}"/>
              </a:ext>
            </a:extLst>
          </p:cNvPr>
          <p:cNvSpPr txBox="1"/>
          <p:nvPr/>
        </p:nvSpPr>
        <p:spPr>
          <a:xfrm>
            <a:off x="886250" y="3325173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9BA1FA4-2292-1FA8-7349-8459FAA6CEF7}"/>
              </a:ext>
            </a:extLst>
          </p:cNvPr>
          <p:cNvSpPr txBox="1"/>
          <p:nvPr/>
        </p:nvSpPr>
        <p:spPr>
          <a:xfrm>
            <a:off x="6010059" y="3325174"/>
            <a:ext cx="39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D)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63650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53" descr="A group of graphs with text&#10;&#10;AI-generated content may be incorrect.">
            <a:extLst>
              <a:ext uri="{FF2B5EF4-FFF2-40B4-BE49-F238E27FC236}">
                <a16:creationId xmlns:a16="http://schemas.microsoft.com/office/drawing/2014/main" id="{4B5EA359-214F-2D43-5BD3-C29EA8D8AF3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8000" y="629602"/>
            <a:ext cx="8636000" cy="559879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39C164F-D2C1-C380-BABB-EF8E43B64394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86827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54" descr="A group of graphs with different colored lines&#10;&#10;AI-generated content may be incorrect.">
            <a:extLst>
              <a:ext uri="{FF2B5EF4-FFF2-40B4-BE49-F238E27FC236}">
                <a16:creationId xmlns:a16="http://schemas.microsoft.com/office/drawing/2014/main" id="{7D56070F-2181-4E2F-F83F-B1C9DCF92C9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8000" y="190500"/>
            <a:ext cx="8636000" cy="6477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01389B4-7AEC-8DC8-DBB8-1655D410C74B}"/>
              </a:ext>
            </a:extLst>
          </p:cNvPr>
          <p:cNvSpPr txBox="1"/>
          <p:nvPr/>
        </p:nvSpPr>
        <p:spPr>
          <a:xfrm>
            <a:off x="9517135" y="6370819"/>
            <a:ext cx="256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6134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4</TotalTime>
  <Words>422</Words>
  <Application>Microsoft Macintosh PowerPoint</Application>
  <PresentationFormat>ワイド画面</PresentationFormat>
  <Paragraphs>254</Paragraphs>
  <Slides>9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4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豊田 秀徳</cp:lastModifiedBy>
  <cp:revision>38</cp:revision>
  <dcterms:created xsi:type="dcterms:W3CDTF">2024-12-27T08:09:53Z</dcterms:created>
  <dcterms:modified xsi:type="dcterms:W3CDTF">2026-01-27T04:31:09Z</dcterms:modified>
</cp:coreProperties>
</file>